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89" r:id="rId3"/>
    <p:sldId id="292" r:id="rId4"/>
    <p:sldId id="291" r:id="rId5"/>
    <p:sldId id="285" r:id="rId6"/>
    <p:sldId id="286" r:id="rId7"/>
    <p:sldId id="284" r:id="rId8"/>
    <p:sldId id="290" r:id="rId9"/>
    <p:sldId id="263" r:id="rId10"/>
    <p:sldId id="265" r:id="rId11"/>
    <p:sldId id="258" r:id="rId12"/>
    <p:sldId id="280" r:id="rId13"/>
    <p:sldId id="295" r:id="rId14"/>
    <p:sldId id="274" r:id="rId15"/>
    <p:sldId id="276" r:id="rId16"/>
    <p:sldId id="275" r:id="rId17"/>
    <p:sldId id="277" r:id="rId18"/>
    <p:sldId id="293" r:id="rId19"/>
    <p:sldId id="278" r:id="rId20"/>
    <p:sldId id="279" r:id="rId21"/>
    <p:sldId id="294" r:id="rId22"/>
    <p:sldId id="325" r:id="rId23"/>
    <p:sldId id="298" r:id="rId24"/>
    <p:sldId id="282" r:id="rId25"/>
    <p:sldId id="283" r:id="rId26"/>
    <p:sldId id="296" r:id="rId27"/>
    <p:sldId id="281" r:id="rId28"/>
    <p:sldId id="297" r:id="rId2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BA70F89-4ADC-4EE9-93DF-E6B6F3DD6C04}">
          <p14:sldIdLst>
            <p14:sldId id="288"/>
            <p14:sldId id="289"/>
            <p14:sldId id="292"/>
            <p14:sldId id="291"/>
            <p14:sldId id="285"/>
            <p14:sldId id="286"/>
            <p14:sldId id="284"/>
            <p14:sldId id="290"/>
            <p14:sldId id="263"/>
            <p14:sldId id="265"/>
            <p14:sldId id="258"/>
            <p14:sldId id="280"/>
            <p14:sldId id="295"/>
            <p14:sldId id="274"/>
            <p14:sldId id="276"/>
            <p14:sldId id="275"/>
            <p14:sldId id="277"/>
            <p14:sldId id="293"/>
            <p14:sldId id="278"/>
            <p14:sldId id="279"/>
            <p14:sldId id="294"/>
            <p14:sldId id="325"/>
            <p14:sldId id="298"/>
            <p14:sldId id="282"/>
            <p14:sldId id="283"/>
            <p14:sldId id="296"/>
            <p14:sldId id="281"/>
            <p14:sldId id="29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my Zhou" initials="TZ" lastIdx="1" clrIdx="0">
    <p:extLst>
      <p:ext uri="{19B8F6BF-5375-455C-9EA6-DF929625EA0E}">
        <p15:presenceInfo xmlns:p15="http://schemas.microsoft.com/office/powerpoint/2012/main" userId="4293e806ee17a8e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105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commentAuthors" Target="commentAuthors.xml"/><Relationship Id="rId8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PARCL%20paper\linear%20correlation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PARCL%20paper\linear%20correlation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PARCL%20paper\linear%20correlation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PARCL%20paper\linear%20correlation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ox%20Sync\PARCL%20data\PARCL%20paper\Data%20relabelled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ox%20Sync\PARCL%20data\PARCL%20paper\Data%20relabelled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4-27-19,alablue\alamarblue%20roundup.xlsx" TargetMode="Externa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ox%20Sync\PARCL%20data\FHVCL2\T%20to%20C%20RNA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ntrols!$B$1</c:f>
              <c:strCache>
                <c:ptCount val="1"/>
                <c:pt idx="0">
                  <c:v>4SU+, UV+</c:v>
                </c:pt>
              </c:strCache>
            </c:strRef>
          </c:tx>
          <c:spPr>
            <a:ln w="19050" cap="rnd">
              <a:solidFill>
                <a:srgbClr val="FF0000">
                  <a:alpha val="60000"/>
                </a:srgbClr>
              </a:solidFill>
              <a:round/>
            </a:ln>
            <a:effectLst/>
          </c:spPr>
          <c:marker>
            <c:symbol val="none"/>
          </c:marker>
          <c:xVal>
            <c:numRef>
              <c:f>controls!$A$2:$A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B$2:$B$345</c:f>
              <c:numCache>
                <c:formatCode>0.0000%</c:formatCode>
                <c:ptCount val="344"/>
                <c:pt idx="0">
                  <c:v>1.1136192626034613E-3</c:v>
                </c:pt>
                <c:pt idx="1">
                  <c:v>1.9146239516759701E-3</c:v>
                </c:pt>
                <c:pt idx="2">
                  <c:v>1.9146052185699764E-3</c:v>
                </c:pt>
                <c:pt idx="3">
                  <c:v>1.4676360937262774E-3</c:v>
                </c:pt>
                <c:pt idx="4">
                  <c:v>1.3241889342777548E-3</c:v>
                </c:pt>
                <c:pt idx="5">
                  <c:v>2.2933399746798665E-3</c:v>
                </c:pt>
                <c:pt idx="6">
                  <c:v>2.5358643674829734E-3</c:v>
                </c:pt>
                <c:pt idx="7">
                  <c:v>1.5495274897654667E-3</c:v>
                </c:pt>
                <c:pt idx="8">
                  <c:v>2.2802553886035236E-3</c:v>
                </c:pt>
                <c:pt idx="9">
                  <c:v>3.2313397847832251E-3</c:v>
                </c:pt>
                <c:pt idx="10">
                  <c:v>2.0776718217303228E-3</c:v>
                </c:pt>
                <c:pt idx="11">
                  <c:v>3.0060144868760308E-3</c:v>
                </c:pt>
                <c:pt idx="12">
                  <c:v>2.1666564773491471E-3</c:v>
                </c:pt>
                <c:pt idx="13">
                  <c:v>2.7053032647377379E-3</c:v>
                </c:pt>
                <c:pt idx="14">
                  <c:v>3.828193951263415E-3</c:v>
                </c:pt>
                <c:pt idx="15">
                  <c:v>3.0646412288832976E-3</c:v>
                </c:pt>
                <c:pt idx="16">
                  <c:v>2.1604875043138836E-3</c:v>
                </c:pt>
                <c:pt idx="17">
                  <c:v>2.6848144405135451E-3</c:v>
                </c:pt>
                <c:pt idx="18">
                  <c:v>1.7107533967178135E-3</c:v>
                </c:pt>
                <c:pt idx="19">
                  <c:v>1.6674586268031568E-3</c:v>
                </c:pt>
                <c:pt idx="20">
                  <c:v>1.885015275748391E-3</c:v>
                </c:pt>
                <c:pt idx="21">
                  <c:v>2.0873276022017441E-3</c:v>
                </c:pt>
                <c:pt idx="22">
                  <c:v>1.9613077564273689E-3</c:v>
                </c:pt>
                <c:pt idx="23">
                  <c:v>1.4536250669567102E-3</c:v>
                </c:pt>
                <c:pt idx="24">
                  <c:v>2.1754040144891457E-3</c:v>
                </c:pt>
                <c:pt idx="25">
                  <c:v>2.5911665958861848E-3</c:v>
                </c:pt>
                <c:pt idx="26">
                  <c:v>1.9044434008833333E-3</c:v>
                </c:pt>
                <c:pt idx="27">
                  <c:v>2.2183958997369487E-3</c:v>
                </c:pt>
                <c:pt idx="28">
                  <c:v>1.9472838799911238E-3</c:v>
                </c:pt>
                <c:pt idx="29">
                  <c:v>2.6495253647110186E-3</c:v>
                </c:pt>
                <c:pt idx="30">
                  <c:v>1.7228866999495394E-3</c:v>
                </c:pt>
                <c:pt idx="31">
                  <c:v>1.1090290259665762E-3</c:v>
                </c:pt>
                <c:pt idx="32">
                  <c:v>2.1404925732707073E-3</c:v>
                </c:pt>
                <c:pt idx="33">
                  <c:v>1.8811859314245315E-3</c:v>
                </c:pt>
                <c:pt idx="34">
                  <c:v>2.1844499037248521E-3</c:v>
                </c:pt>
                <c:pt idx="35">
                  <c:v>2.4312322042544902E-3</c:v>
                </c:pt>
                <c:pt idx="36">
                  <c:v>2.3907720852697628E-3</c:v>
                </c:pt>
                <c:pt idx="37">
                  <c:v>2.9766394596115959E-3</c:v>
                </c:pt>
                <c:pt idx="38">
                  <c:v>2.1898394606364516E-3</c:v>
                </c:pt>
                <c:pt idx="39">
                  <c:v>2.6014736297828335E-3</c:v>
                </c:pt>
                <c:pt idx="40">
                  <c:v>2.7370196133307558E-3</c:v>
                </c:pt>
                <c:pt idx="41">
                  <c:v>1.7004392801473714E-3</c:v>
                </c:pt>
                <c:pt idx="42">
                  <c:v>2.5758465150766191E-3</c:v>
                </c:pt>
                <c:pt idx="43">
                  <c:v>3.1006883282110711E-3</c:v>
                </c:pt>
                <c:pt idx="44">
                  <c:v>2.5833551218070413E-3</c:v>
                </c:pt>
                <c:pt idx="45">
                  <c:v>3.397220870721549E-3</c:v>
                </c:pt>
                <c:pt idx="46">
                  <c:v>2.9778468847360962E-3</c:v>
                </c:pt>
                <c:pt idx="47">
                  <c:v>3.4422015150666345E-3</c:v>
                </c:pt>
                <c:pt idx="48">
                  <c:v>3.4070590885413002E-3</c:v>
                </c:pt>
                <c:pt idx="49">
                  <c:v>1.3156997260903435E-3</c:v>
                </c:pt>
                <c:pt idx="50">
                  <c:v>1.36934301346885E-3</c:v>
                </c:pt>
                <c:pt idx="51">
                  <c:v>2.9784935835429163E-3</c:v>
                </c:pt>
                <c:pt idx="52">
                  <c:v>1.2442109628810396E-3</c:v>
                </c:pt>
                <c:pt idx="53">
                  <c:v>1.7020455253310873E-3</c:v>
                </c:pt>
                <c:pt idx="54">
                  <c:v>2.1568163286777662E-3</c:v>
                </c:pt>
                <c:pt idx="55">
                  <c:v>2.211718148840277E-3</c:v>
                </c:pt>
                <c:pt idx="56">
                  <c:v>1.688683517681284E-3</c:v>
                </c:pt>
                <c:pt idx="57">
                  <c:v>2.2431448836624738E-3</c:v>
                </c:pt>
                <c:pt idx="58">
                  <c:v>2.8349972243744454E-3</c:v>
                </c:pt>
                <c:pt idx="59">
                  <c:v>2.3118735531927094E-3</c:v>
                </c:pt>
                <c:pt idx="60">
                  <c:v>2.8742969961572237E-3</c:v>
                </c:pt>
                <c:pt idx="61">
                  <c:v>2.0132724409033693E-3</c:v>
                </c:pt>
                <c:pt idx="62">
                  <c:v>2.0367364117364118E-3</c:v>
                </c:pt>
                <c:pt idx="63">
                  <c:v>1.8228330153373402E-3</c:v>
                </c:pt>
                <c:pt idx="64">
                  <c:v>2.3095423920488031E-3</c:v>
                </c:pt>
                <c:pt idx="65">
                  <c:v>4.1557367411726069E-3</c:v>
                </c:pt>
                <c:pt idx="66">
                  <c:v>2.0874837592031181E-3</c:v>
                </c:pt>
                <c:pt idx="67">
                  <c:v>2.1141139984204344E-3</c:v>
                </c:pt>
                <c:pt idx="68">
                  <c:v>2.6319545545374096E-3</c:v>
                </c:pt>
                <c:pt idx="69">
                  <c:v>2.6211062986462945E-3</c:v>
                </c:pt>
                <c:pt idx="70">
                  <c:v>1.5190764015478588E-3</c:v>
                </c:pt>
                <c:pt idx="71">
                  <c:v>1.9234159867925437E-3</c:v>
                </c:pt>
                <c:pt idx="72">
                  <c:v>1.2261973456433929E-3</c:v>
                </c:pt>
                <c:pt idx="73">
                  <c:v>1.6318698440293245E-3</c:v>
                </c:pt>
                <c:pt idx="74">
                  <c:v>2.605266302832331E-3</c:v>
                </c:pt>
                <c:pt idx="75">
                  <c:v>2.712592474743457E-3</c:v>
                </c:pt>
                <c:pt idx="76">
                  <c:v>2.4373644809521549E-3</c:v>
                </c:pt>
                <c:pt idx="77">
                  <c:v>2.0404062263305149E-3</c:v>
                </c:pt>
                <c:pt idx="78">
                  <c:v>1.5134529147982064E-3</c:v>
                </c:pt>
                <c:pt idx="79">
                  <c:v>2.2862440388740054E-3</c:v>
                </c:pt>
                <c:pt idx="80">
                  <c:v>1.9364626773502481E-3</c:v>
                </c:pt>
                <c:pt idx="81">
                  <c:v>3.2911984641073836E-3</c:v>
                </c:pt>
                <c:pt idx="82">
                  <c:v>2.8045504819086743E-3</c:v>
                </c:pt>
                <c:pt idx="83">
                  <c:v>2.2231540305545226E-3</c:v>
                </c:pt>
                <c:pt idx="84">
                  <c:v>2.2268325309794056E-3</c:v>
                </c:pt>
                <c:pt idx="85">
                  <c:v>2.2736916265701681E-3</c:v>
                </c:pt>
                <c:pt idx="86">
                  <c:v>1.3693940431359123E-3</c:v>
                </c:pt>
                <c:pt idx="87">
                  <c:v>3.7168258803662192E-3</c:v>
                </c:pt>
                <c:pt idx="88">
                  <c:v>2.7142335402901823E-3</c:v>
                </c:pt>
                <c:pt idx="89">
                  <c:v>2.2539249382545466E-3</c:v>
                </c:pt>
                <c:pt idx="90">
                  <c:v>2.1463499069626552E-3</c:v>
                </c:pt>
                <c:pt idx="91">
                  <c:v>1.5711193352419524E-3</c:v>
                </c:pt>
                <c:pt idx="92">
                  <c:v>1.5713578789273094E-3</c:v>
                </c:pt>
                <c:pt idx="93">
                  <c:v>1.9061060281617026E-3</c:v>
                </c:pt>
                <c:pt idx="94">
                  <c:v>1.3120929895596037E-3</c:v>
                </c:pt>
                <c:pt idx="95">
                  <c:v>2.0931696569090339E-3</c:v>
                </c:pt>
                <c:pt idx="96">
                  <c:v>2.2682485421274884E-3</c:v>
                </c:pt>
                <c:pt idx="97">
                  <c:v>1.5110839616120373E-3</c:v>
                </c:pt>
                <c:pt idx="98">
                  <c:v>2.3601990979833149E-3</c:v>
                </c:pt>
                <c:pt idx="99">
                  <c:v>1.2645777715329493E-3</c:v>
                </c:pt>
                <c:pt idx="100">
                  <c:v>2.1408758838926435E-3</c:v>
                </c:pt>
                <c:pt idx="101">
                  <c:v>1.0813797458362933E-3</c:v>
                </c:pt>
                <c:pt idx="102">
                  <c:v>1.7244379756047399E-3</c:v>
                </c:pt>
                <c:pt idx="103">
                  <c:v>2.16739927297063E-3</c:v>
                </c:pt>
                <c:pt idx="104">
                  <c:v>2.2611343738104302E-3</c:v>
                </c:pt>
                <c:pt idx="105">
                  <c:v>2.5026624068157613E-3</c:v>
                </c:pt>
                <c:pt idx="106">
                  <c:v>1.5108852413982556E-3</c:v>
                </c:pt>
                <c:pt idx="107">
                  <c:v>1.691039695318761E-3</c:v>
                </c:pt>
                <c:pt idx="108">
                  <c:v>2.1135970027922101E-3</c:v>
                </c:pt>
                <c:pt idx="109">
                  <c:v>2.3830049692662447E-3</c:v>
                </c:pt>
                <c:pt idx="110">
                  <c:v>1.5207579962436576E-3</c:v>
                </c:pt>
                <c:pt idx="111">
                  <c:v>3.1109668343883567E-3</c:v>
                </c:pt>
                <c:pt idx="112">
                  <c:v>2.7679834327055176E-3</c:v>
                </c:pt>
                <c:pt idx="113">
                  <c:v>1.9873727473062311E-3</c:v>
                </c:pt>
                <c:pt idx="114">
                  <c:v>1.7098793769918098E-3</c:v>
                </c:pt>
                <c:pt idx="115">
                  <c:v>1.9677950406420414E-3</c:v>
                </c:pt>
                <c:pt idx="116">
                  <c:v>2.2821536863833632E-3</c:v>
                </c:pt>
                <c:pt idx="117">
                  <c:v>2.9129130970705292E-3</c:v>
                </c:pt>
                <c:pt idx="118">
                  <c:v>2.1013396039975484E-3</c:v>
                </c:pt>
                <c:pt idx="119">
                  <c:v>2.8109231597530896E-3</c:v>
                </c:pt>
                <c:pt idx="120">
                  <c:v>3.7534063447992186E-3</c:v>
                </c:pt>
                <c:pt idx="121">
                  <c:v>2.6179174847658806E-3</c:v>
                </c:pt>
                <c:pt idx="122">
                  <c:v>1.469208355968196E-3</c:v>
                </c:pt>
                <c:pt idx="123">
                  <c:v>3.2159159740478703E-3</c:v>
                </c:pt>
                <c:pt idx="124">
                  <c:v>2.6360666387651712E-3</c:v>
                </c:pt>
                <c:pt idx="125">
                  <c:v>4.1595302177636411E-3</c:v>
                </c:pt>
                <c:pt idx="126">
                  <c:v>1.3502241372067762E-3</c:v>
                </c:pt>
                <c:pt idx="127">
                  <c:v>1.3638476404824228E-3</c:v>
                </c:pt>
                <c:pt idx="128">
                  <c:v>2.5131927331429583E-3</c:v>
                </c:pt>
                <c:pt idx="129">
                  <c:v>2.5160167482217626E-3</c:v>
                </c:pt>
                <c:pt idx="130">
                  <c:v>1.9553496848659733E-3</c:v>
                </c:pt>
                <c:pt idx="131">
                  <c:v>2.137954955108632E-3</c:v>
                </c:pt>
                <c:pt idx="132">
                  <c:v>1.8599951140426856E-3</c:v>
                </c:pt>
                <c:pt idx="133">
                  <c:v>2.9083966076106746E-3</c:v>
                </c:pt>
                <c:pt idx="134">
                  <c:v>3.1667935940915739E-3</c:v>
                </c:pt>
                <c:pt idx="135">
                  <c:v>1.5819136328780639E-3</c:v>
                </c:pt>
                <c:pt idx="136">
                  <c:v>1.6069048540349972E-3</c:v>
                </c:pt>
                <c:pt idx="137">
                  <c:v>2.3003467351908166E-3</c:v>
                </c:pt>
                <c:pt idx="138">
                  <c:v>1.8799226422636863E-3</c:v>
                </c:pt>
                <c:pt idx="139">
                  <c:v>2.1861433737061864E-3</c:v>
                </c:pt>
                <c:pt idx="140">
                  <c:v>2.5348475387106674E-3</c:v>
                </c:pt>
                <c:pt idx="141">
                  <c:v>2.1373754302595081E-3</c:v>
                </c:pt>
                <c:pt idx="142">
                  <c:v>1.7240739070697639E-3</c:v>
                </c:pt>
                <c:pt idx="143">
                  <c:v>2.1002440824203893E-3</c:v>
                </c:pt>
                <c:pt idx="144">
                  <c:v>2.7487129645097116E-3</c:v>
                </c:pt>
                <c:pt idx="145">
                  <c:v>1.3518199315546934E-3</c:v>
                </c:pt>
                <c:pt idx="146">
                  <c:v>1.5212350584753536E-3</c:v>
                </c:pt>
                <c:pt idx="147">
                  <c:v>1.4345987591896634E-3</c:v>
                </c:pt>
                <c:pt idx="148">
                  <c:v>2.7081174438687394E-3</c:v>
                </c:pt>
                <c:pt idx="149">
                  <c:v>2.9868223046558753E-3</c:v>
                </c:pt>
                <c:pt idx="150">
                  <c:v>2.0486739777970464E-3</c:v>
                </c:pt>
                <c:pt idx="151">
                  <c:v>2.0031169577773484E-3</c:v>
                </c:pt>
                <c:pt idx="152">
                  <c:v>2.0639459555296929E-3</c:v>
                </c:pt>
                <c:pt idx="153">
                  <c:v>2.6054573646230724E-3</c:v>
                </c:pt>
                <c:pt idx="154">
                  <c:v>1.8653530938396393E-3</c:v>
                </c:pt>
                <c:pt idx="155">
                  <c:v>2.13798725359419E-3</c:v>
                </c:pt>
                <c:pt idx="156">
                  <c:v>1.960529973130733E-3</c:v>
                </c:pt>
                <c:pt idx="157">
                  <c:v>1.7460428554062866E-3</c:v>
                </c:pt>
                <c:pt idx="158">
                  <c:v>2.4677063357093753E-3</c:v>
                </c:pt>
                <c:pt idx="159">
                  <c:v>2.7461494209206658E-3</c:v>
                </c:pt>
                <c:pt idx="160">
                  <c:v>3.8308470676708525E-3</c:v>
                </c:pt>
                <c:pt idx="161">
                  <c:v>2.5470557762044552E-3</c:v>
                </c:pt>
                <c:pt idx="162">
                  <c:v>2.3319310070067582E-3</c:v>
                </c:pt>
                <c:pt idx="163">
                  <c:v>2.8586906391607674E-3</c:v>
                </c:pt>
                <c:pt idx="164">
                  <c:v>1.9917857013048378E-3</c:v>
                </c:pt>
                <c:pt idx="165">
                  <c:v>1.904948868118645E-3</c:v>
                </c:pt>
                <c:pt idx="166">
                  <c:v>1.7879341864716636E-3</c:v>
                </c:pt>
                <c:pt idx="167">
                  <c:v>2.0051929355510423E-3</c:v>
                </c:pt>
                <c:pt idx="168">
                  <c:v>1.0763511329238546E-3</c:v>
                </c:pt>
                <c:pt idx="169">
                  <c:v>1.8060667918969493E-3</c:v>
                </c:pt>
                <c:pt idx="170">
                  <c:v>2.2141030583624835E-3</c:v>
                </c:pt>
                <c:pt idx="171">
                  <c:v>3.0594004140435662E-3</c:v>
                </c:pt>
                <c:pt idx="172">
                  <c:v>2.652067867375305E-3</c:v>
                </c:pt>
                <c:pt idx="173">
                  <c:v>2.1132653495397622E-3</c:v>
                </c:pt>
                <c:pt idx="174">
                  <c:v>1.4693469221871386E-3</c:v>
                </c:pt>
                <c:pt idx="175">
                  <c:v>2.9499147372677248E-3</c:v>
                </c:pt>
                <c:pt idx="176">
                  <c:v>2.7803974990394356E-3</c:v>
                </c:pt>
                <c:pt idx="177">
                  <c:v>2.4713744132236035E-3</c:v>
                </c:pt>
                <c:pt idx="178">
                  <c:v>2.6019979627213753E-3</c:v>
                </c:pt>
                <c:pt idx="179">
                  <c:v>2.6225431522682854E-3</c:v>
                </c:pt>
                <c:pt idx="180">
                  <c:v>1.9895885331241534E-3</c:v>
                </c:pt>
                <c:pt idx="181">
                  <c:v>3.4184900410865839E-3</c:v>
                </c:pt>
                <c:pt idx="182">
                  <c:v>2.4989316161930768E-3</c:v>
                </c:pt>
                <c:pt idx="183">
                  <c:v>2.7871099929192341E-3</c:v>
                </c:pt>
                <c:pt idx="184">
                  <c:v>2.0179859077941432E-3</c:v>
                </c:pt>
                <c:pt idx="185">
                  <c:v>2.4936900937309616E-3</c:v>
                </c:pt>
                <c:pt idx="186">
                  <c:v>2.9255369476771692E-3</c:v>
                </c:pt>
                <c:pt idx="187">
                  <c:v>2.9591355644397765E-3</c:v>
                </c:pt>
                <c:pt idx="188">
                  <c:v>2.8777755489376149E-3</c:v>
                </c:pt>
                <c:pt idx="189">
                  <c:v>1.5108016522219602E-3</c:v>
                </c:pt>
                <c:pt idx="190">
                  <c:v>2.6066028608665755E-3</c:v>
                </c:pt>
                <c:pt idx="191">
                  <c:v>3.6629730294794063E-3</c:v>
                </c:pt>
                <c:pt idx="192">
                  <c:v>1.6335489059410918E-3</c:v>
                </c:pt>
                <c:pt idx="193">
                  <c:v>2.8301644068232691E-3</c:v>
                </c:pt>
                <c:pt idx="194">
                  <c:v>2.5201002852943718E-3</c:v>
                </c:pt>
                <c:pt idx="195">
                  <c:v>2.1289842263602205E-3</c:v>
                </c:pt>
                <c:pt idx="196">
                  <c:v>2.3271624307080849E-3</c:v>
                </c:pt>
                <c:pt idx="197">
                  <c:v>1.6788625925681763E-3</c:v>
                </c:pt>
                <c:pt idx="198">
                  <c:v>2.1737013130749684E-3</c:v>
                </c:pt>
                <c:pt idx="199">
                  <c:v>2.1099687080911936E-3</c:v>
                </c:pt>
                <c:pt idx="200">
                  <c:v>1.3134961731794184E-3</c:v>
                </c:pt>
                <c:pt idx="201">
                  <c:v>1.9788179996133928E-3</c:v>
                </c:pt>
                <c:pt idx="202">
                  <c:v>1.9159528553302726E-3</c:v>
                </c:pt>
                <c:pt idx="203">
                  <c:v>1.3439415116654123E-3</c:v>
                </c:pt>
                <c:pt idx="204">
                  <c:v>2.1681362483391715E-3</c:v>
                </c:pt>
                <c:pt idx="205">
                  <c:v>1.9590598938589842E-3</c:v>
                </c:pt>
                <c:pt idx="206">
                  <c:v>2.0993263355788814E-3</c:v>
                </c:pt>
                <c:pt idx="207">
                  <c:v>2.3653054440381516E-3</c:v>
                </c:pt>
                <c:pt idx="208">
                  <c:v>2.0518242983830867E-3</c:v>
                </c:pt>
                <c:pt idx="209">
                  <c:v>3.6430680335035543E-3</c:v>
                </c:pt>
                <c:pt idx="210">
                  <c:v>2.9283591112902415E-3</c:v>
                </c:pt>
                <c:pt idx="211">
                  <c:v>2.4981565765719951E-3</c:v>
                </c:pt>
                <c:pt idx="212">
                  <c:v>2.1065407392423427E-3</c:v>
                </c:pt>
                <c:pt idx="213">
                  <c:v>1.7548520610772415E-3</c:v>
                </c:pt>
                <c:pt idx="214">
                  <c:v>2.4602684997503013E-3</c:v>
                </c:pt>
                <c:pt idx="215">
                  <c:v>2.1764065762771684E-3</c:v>
                </c:pt>
                <c:pt idx="216">
                  <c:v>2.5996406162547502E-3</c:v>
                </c:pt>
                <c:pt idx="217">
                  <c:v>2.4992813567983646E-3</c:v>
                </c:pt>
                <c:pt idx="218">
                  <c:v>3.3441469089574767E-3</c:v>
                </c:pt>
                <c:pt idx="219">
                  <c:v>2.8650880593241762E-3</c:v>
                </c:pt>
                <c:pt idx="220">
                  <c:v>2.4389004623748792E-3</c:v>
                </c:pt>
                <c:pt idx="221">
                  <c:v>1.693544955533807E-3</c:v>
                </c:pt>
                <c:pt idx="222">
                  <c:v>3.6117968039495909E-3</c:v>
                </c:pt>
                <c:pt idx="223">
                  <c:v>2.2927538711609206E-3</c:v>
                </c:pt>
                <c:pt idx="224">
                  <c:v>1.7585399963998393E-3</c:v>
                </c:pt>
                <c:pt idx="225">
                  <c:v>1.5105740181268882E-3</c:v>
                </c:pt>
                <c:pt idx="226">
                  <c:v>1.7485379733986469E-3</c:v>
                </c:pt>
                <c:pt idx="227">
                  <c:v>1.6858402902342644E-3</c:v>
                </c:pt>
                <c:pt idx="228">
                  <c:v>1.208617635585796E-3</c:v>
                </c:pt>
                <c:pt idx="229">
                  <c:v>2.8192161820480405E-3</c:v>
                </c:pt>
                <c:pt idx="230">
                  <c:v>2.2602261451199943E-3</c:v>
                </c:pt>
                <c:pt idx="231">
                  <c:v>2.6880412571762186E-3</c:v>
                </c:pt>
                <c:pt idx="232">
                  <c:v>2.8525129425188297E-3</c:v>
                </c:pt>
                <c:pt idx="233">
                  <c:v>1.966675771647091E-3</c:v>
                </c:pt>
                <c:pt idx="234">
                  <c:v>2.8454870575267627E-3</c:v>
                </c:pt>
                <c:pt idx="235">
                  <c:v>2.6198802679153576E-3</c:v>
                </c:pt>
                <c:pt idx="236">
                  <c:v>2.3840758112147406E-3</c:v>
                </c:pt>
                <c:pt idx="237">
                  <c:v>2.1291567083601246E-3</c:v>
                </c:pt>
                <c:pt idx="238">
                  <c:v>2.2867442056943312E-3</c:v>
                </c:pt>
                <c:pt idx="239">
                  <c:v>1.6730980480522773E-3</c:v>
                </c:pt>
                <c:pt idx="240">
                  <c:v>2.294740318530455E-3</c:v>
                </c:pt>
                <c:pt idx="241">
                  <c:v>3.1865900054349381E-3</c:v>
                </c:pt>
                <c:pt idx="242">
                  <c:v>2.665292039856367E-3</c:v>
                </c:pt>
                <c:pt idx="243">
                  <c:v>2.4264948230988668E-3</c:v>
                </c:pt>
                <c:pt idx="244">
                  <c:v>3.1689694511344911E-3</c:v>
                </c:pt>
                <c:pt idx="245">
                  <c:v>2.1297045730473492E-3</c:v>
                </c:pt>
                <c:pt idx="246">
                  <c:v>3.520185591446655E-3</c:v>
                </c:pt>
                <c:pt idx="247">
                  <c:v>3.0436034676226131E-3</c:v>
                </c:pt>
                <c:pt idx="248">
                  <c:v>1.9923236940025198E-3</c:v>
                </c:pt>
                <c:pt idx="249">
                  <c:v>1.2169588485844468E-3</c:v>
                </c:pt>
                <c:pt idx="250">
                  <c:v>3.1046497657094799E-3</c:v>
                </c:pt>
                <c:pt idx="251">
                  <c:v>1.6324855707901052E-3</c:v>
                </c:pt>
                <c:pt idx="252">
                  <c:v>2.5420861179257254E-3</c:v>
                </c:pt>
                <c:pt idx="253">
                  <c:v>2.175739075208457E-3</c:v>
                </c:pt>
                <c:pt idx="254">
                  <c:v>1.9285717273894837E-3</c:v>
                </c:pt>
                <c:pt idx="255">
                  <c:v>1.6111256004913302E-3</c:v>
                </c:pt>
                <c:pt idx="256">
                  <c:v>1.3072811850483323E-3</c:v>
                </c:pt>
                <c:pt idx="257">
                  <c:v>1.1477882037533513E-3</c:v>
                </c:pt>
                <c:pt idx="258">
                  <c:v>2.5507876154263988E-3</c:v>
                </c:pt>
                <c:pt idx="259">
                  <c:v>2.4864964760632712E-3</c:v>
                </c:pt>
                <c:pt idx="260">
                  <c:v>2.1721094476338182E-3</c:v>
                </c:pt>
                <c:pt idx="261">
                  <c:v>1.9308325270359365E-3</c:v>
                </c:pt>
                <c:pt idx="262">
                  <c:v>2.8777778252893813E-3</c:v>
                </c:pt>
                <c:pt idx="263">
                  <c:v>2.6337504863459707E-3</c:v>
                </c:pt>
                <c:pt idx="264">
                  <c:v>2.201570827247778E-3</c:v>
                </c:pt>
                <c:pt idx="265">
                  <c:v>2.1563320508619262E-3</c:v>
                </c:pt>
                <c:pt idx="266">
                  <c:v>2.6838564198090661E-3</c:v>
                </c:pt>
                <c:pt idx="267">
                  <c:v>2.743884640084068E-3</c:v>
                </c:pt>
                <c:pt idx="268">
                  <c:v>1.8599366532035268E-3</c:v>
                </c:pt>
                <c:pt idx="269">
                  <c:v>1.71737816073621E-3</c:v>
                </c:pt>
                <c:pt idx="270">
                  <c:v>2.6662590252868007E-3</c:v>
                </c:pt>
                <c:pt idx="271">
                  <c:v>2.3377954268878499E-3</c:v>
                </c:pt>
                <c:pt idx="272">
                  <c:v>1.9791747584292241E-3</c:v>
                </c:pt>
                <c:pt idx="273">
                  <c:v>3.0992390350657712E-3</c:v>
                </c:pt>
                <c:pt idx="274">
                  <c:v>2.0499884411928687E-3</c:v>
                </c:pt>
                <c:pt idx="275">
                  <c:v>2.3847431105523172E-3</c:v>
                </c:pt>
                <c:pt idx="276">
                  <c:v>2.375191382327209E-3</c:v>
                </c:pt>
                <c:pt idx="277">
                  <c:v>3.3310443080139802E-3</c:v>
                </c:pt>
                <c:pt idx="278">
                  <c:v>1.8150301471284329E-3</c:v>
                </c:pt>
                <c:pt idx="279">
                  <c:v>2.443234544026892E-3</c:v>
                </c:pt>
                <c:pt idx="280">
                  <c:v>2.1939005158971227E-3</c:v>
                </c:pt>
                <c:pt idx="281">
                  <c:v>3.4796026010423062E-3</c:v>
                </c:pt>
                <c:pt idx="282">
                  <c:v>2.185845289382302E-3</c:v>
                </c:pt>
                <c:pt idx="283">
                  <c:v>1.7865960407595278E-3</c:v>
                </c:pt>
                <c:pt idx="284">
                  <c:v>1.7598866643970261E-3</c:v>
                </c:pt>
                <c:pt idx="285">
                  <c:v>1.7354634212395298E-3</c:v>
                </c:pt>
                <c:pt idx="286">
                  <c:v>2.5536304439841119E-3</c:v>
                </c:pt>
                <c:pt idx="287">
                  <c:v>2.2621085644547339E-3</c:v>
                </c:pt>
                <c:pt idx="288">
                  <c:v>8.7829956728362082E-4</c:v>
                </c:pt>
                <c:pt idx="289">
                  <c:v>1.9367884577646446E-3</c:v>
                </c:pt>
                <c:pt idx="290">
                  <c:v>2.396468241021184E-3</c:v>
                </c:pt>
                <c:pt idx="291">
                  <c:v>2.7733904122397429E-3</c:v>
                </c:pt>
                <c:pt idx="292">
                  <c:v>2.957130410037815E-3</c:v>
                </c:pt>
                <c:pt idx="293">
                  <c:v>3.0991216693305127E-3</c:v>
                </c:pt>
                <c:pt idx="294">
                  <c:v>2.8605330571439347E-3</c:v>
                </c:pt>
                <c:pt idx="295">
                  <c:v>1.8197809319361428E-3</c:v>
                </c:pt>
                <c:pt idx="296">
                  <c:v>2.1529192876760875E-3</c:v>
                </c:pt>
                <c:pt idx="297">
                  <c:v>3.5088994044861839E-3</c:v>
                </c:pt>
                <c:pt idx="298">
                  <c:v>3.2036383280776913E-3</c:v>
                </c:pt>
                <c:pt idx="299">
                  <c:v>1.5673630236671817E-3</c:v>
                </c:pt>
                <c:pt idx="300">
                  <c:v>1.2685161067718465E-3</c:v>
                </c:pt>
                <c:pt idx="301">
                  <c:v>1.8593557212134959E-3</c:v>
                </c:pt>
                <c:pt idx="302">
                  <c:v>1.5993823075226119E-3</c:v>
                </c:pt>
                <c:pt idx="303">
                  <c:v>2.2779043280182231E-3</c:v>
                </c:pt>
                <c:pt idx="304">
                  <c:v>2.4845000225181273E-3</c:v>
                </c:pt>
                <c:pt idx="305">
                  <c:v>2.1069077279572759E-3</c:v>
                </c:pt>
                <c:pt idx="306">
                  <c:v>1.6430785316852757E-3</c:v>
                </c:pt>
                <c:pt idx="307">
                  <c:v>2.3102763590044581E-3</c:v>
                </c:pt>
                <c:pt idx="308">
                  <c:v>1.9200653072104492E-3</c:v>
                </c:pt>
                <c:pt idx="309">
                  <c:v>1.8104379674705178E-3</c:v>
                </c:pt>
                <c:pt idx="310">
                  <c:v>2.5995051343355824E-3</c:v>
                </c:pt>
                <c:pt idx="311">
                  <c:v>2.0304700951320892E-3</c:v>
                </c:pt>
                <c:pt idx="312">
                  <c:v>1.7965171171801238E-3</c:v>
                </c:pt>
                <c:pt idx="313">
                  <c:v>2.1088982324796689E-3</c:v>
                </c:pt>
                <c:pt idx="314">
                  <c:v>2.8692398202264532E-3</c:v>
                </c:pt>
                <c:pt idx="315">
                  <c:v>1.6730332188965716E-3</c:v>
                </c:pt>
                <c:pt idx="316">
                  <c:v>1.9051070582012655E-3</c:v>
                </c:pt>
                <c:pt idx="317">
                  <c:v>9.6953590235739952E-4</c:v>
                </c:pt>
                <c:pt idx="318">
                  <c:v>2.3568494534353885E-3</c:v>
                </c:pt>
                <c:pt idx="319">
                  <c:v>2.5934905591066051E-3</c:v>
                </c:pt>
                <c:pt idx="320">
                  <c:v>1.5651122256607264E-3</c:v>
                </c:pt>
                <c:pt idx="321">
                  <c:v>1.8808156800633538E-3</c:v>
                </c:pt>
                <c:pt idx="322">
                  <c:v>1.3685239491691105E-3</c:v>
                </c:pt>
                <c:pt idx="323">
                  <c:v>1.8930184091698506E-3</c:v>
                </c:pt>
                <c:pt idx="324">
                  <c:v>1.7331332189822757E-3</c:v>
                </c:pt>
                <c:pt idx="325">
                  <c:v>2.0664935444936177E-3</c:v>
                </c:pt>
                <c:pt idx="326">
                  <c:v>9.1749594184487265E-4</c:v>
                </c:pt>
                <c:pt idx="327">
                  <c:v>1.3035381750465549E-3</c:v>
                </c:pt>
                <c:pt idx="328">
                  <c:v>1.375687843921961E-3</c:v>
                </c:pt>
                <c:pt idx="329">
                  <c:v>1.9766887056097064E-3</c:v>
                </c:pt>
                <c:pt idx="330">
                  <c:v>3.0578813250819077E-3</c:v>
                </c:pt>
                <c:pt idx="331">
                  <c:v>3.8302887448438423E-3</c:v>
                </c:pt>
                <c:pt idx="332">
                  <c:v>9.582716264482969E-4</c:v>
                </c:pt>
                <c:pt idx="333">
                  <c:v>1.8299058905542E-3</c:v>
                </c:pt>
                <c:pt idx="334">
                  <c:v>1.2752778283840408E-3</c:v>
                </c:pt>
                <c:pt idx="335">
                  <c:v>1.6655236602331734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A27-447B-801F-BD53CCA4EA9F}"/>
            </c:ext>
          </c:extLst>
        </c:ser>
        <c:ser>
          <c:idx val="1"/>
          <c:order val="1"/>
          <c:tx>
            <c:strRef>
              <c:f>controls!$C$1</c:f>
              <c:strCache>
                <c:ptCount val="1"/>
                <c:pt idx="0">
                  <c:v>4SU+, UV-</c:v>
                </c:pt>
              </c:strCache>
            </c:strRef>
          </c:tx>
          <c:spPr>
            <a:ln w="19050" cap="rnd">
              <a:solidFill>
                <a:schemeClr val="tx1">
                  <a:alpha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controls!$A$2:$A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C$2:$C$345</c:f>
              <c:numCache>
                <c:formatCode>0.000%</c:formatCode>
                <c:ptCount val="344"/>
                <c:pt idx="0">
                  <c:v>1.3706975327444412E-3</c:v>
                </c:pt>
                <c:pt idx="1">
                  <c:v>1.8930919354283552E-3</c:v>
                </c:pt>
                <c:pt idx="2">
                  <c:v>1.7283950617283952E-3</c:v>
                </c:pt>
                <c:pt idx="3">
                  <c:v>1.8537544110421226E-3</c:v>
                </c:pt>
                <c:pt idx="4">
                  <c:v>1.1169831452244802E-3</c:v>
                </c:pt>
                <c:pt idx="5">
                  <c:v>1.7895736684883608E-3</c:v>
                </c:pt>
                <c:pt idx="6">
                  <c:v>1.9906371411704945E-3</c:v>
                </c:pt>
                <c:pt idx="7">
                  <c:v>1.2057620031041957E-3</c:v>
                </c:pt>
                <c:pt idx="8">
                  <c:v>2.1841606878723785E-3</c:v>
                </c:pt>
                <c:pt idx="9">
                  <c:v>2.6391018723613715E-3</c:v>
                </c:pt>
                <c:pt idx="10">
                  <c:v>2.0757827569865776E-3</c:v>
                </c:pt>
                <c:pt idx="11">
                  <c:v>2.4535599860555455E-3</c:v>
                </c:pt>
                <c:pt idx="12">
                  <c:v>1.8649930228097906E-3</c:v>
                </c:pt>
                <c:pt idx="13">
                  <c:v>2.6025554147884075E-3</c:v>
                </c:pt>
                <c:pt idx="14">
                  <c:v>2.48908942199431E-3</c:v>
                </c:pt>
                <c:pt idx="15">
                  <c:v>2.6070493787566859E-3</c:v>
                </c:pt>
                <c:pt idx="16">
                  <c:v>2.0310531900151604E-3</c:v>
                </c:pt>
                <c:pt idx="17">
                  <c:v>2.4469972598375558E-3</c:v>
                </c:pt>
                <c:pt idx="18">
                  <c:v>1.2613549961983273E-3</c:v>
                </c:pt>
                <c:pt idx="19">
                  <c:v>1.4089345447004273E-3</c:v>
                </c:pt>
                <c:pt idx="20">
                  <c:v>1.4100112338599944E-3</c:v>
                </c:pt>
                <c:pt idx="21">
                  <c:v>1.2031032738778666E-3</c:v>
                </c:pt>
                <c:pt idx="22">
                  <c:v>1.9475672091403596E-3</c:v>
                </c:pt>
                <c:pt idx="23">
                  <c:v>1.2510106063378481E-3</c:v>
                </c:pt>
                <c:pt idx="24">
                  <c:v>1.6107053132608711E-3</c:v>
                </c:pt>
                <c:pt idx="25">
                  <c:v>1.9904153073254079E-3</c:v>
                </c:pt>
                <c:pt idx="26">
                  <c:v>1.8657044352540296E-3</c:v>
                </c:pt>
                <c:pt idx="27">
                  <c:v>1.5984291169342509E-3</c:v>
                </c:pt>
                <c:pt idx="28">
                  <c:v>1.7239322731924136E-3</c:v>
                </c:pt>
                <c:pt idx="29">
                  <c:v>1.5689595059022762E-3</c:v>
                </c:pt>
                <c:pt idx="30">
                  <c:v>1.5487222708921305E-3</c:v>
                </c:pt>
                <c:pt idx="31">
                  <c:v>1.0885524111435908E-3</c:v>
                </c:pt>
                <c:pt idx="32">
                  <c:v>2.2022019400849196E-3</c:v>
                </c:pt>
                <c:pt idx="33">
                  <c:v>1.8099369085173502E-3</c:v>
                </c:pt>
                <c:pt idx="34">
                  <c:v>1.8939914888266289E-3</c:v>
                </c:pt>
                <c:pt idx="35">
                  <c:v>1.6108120850194475E-3</c:v>
                </c:pt>
                <c:pt idx="36">
                  <c:v>1.9693834899362278E-3</c:v>
                </c:pt>
                <c:pt idx="37">
                  <c:v>2.8218153325692019E-3</c:v>
                </c:pt>
                <c:pt idx="38">
                  <c:v>2.1313883696932206E-3</c:v>
                </c:pt>
                <c:pt idx="39">
                  <c:v>2.7163258076641221E-3</c:v>
                </c:pt>
                <c:pt idx="40">
                  <c:v>2.7153953092687246E-3</c:v>
                </c:pt>
                <c:pt idx="41">
                  <c:v>1.706515108684332E-3</c:v>
                </c:pt>
                <c:pt idx="42">
                  <c:v>2.5030880326856382E-3</c:v>
                </c:pt>
                <c:pt idx="43">
                  <c:v>1.6317757244643622E-3</c:v>
                </c:pt>
                <c:pt idx="44">
                  <c:v>2.1980723839496461E-3</c:v>
                </c:pt>
                <c:pt idx="45">
                  <c:v>2.7957382280156678E-3</c:v>
                </c:pt>
                <c:pt idx="46">
                  <c:v>2.2629734673837733E-3</c:v>
                </c:pt>
                <c:pt idx="47">
                  <c:v>2.9178642975350578E-3</c:v>
                </c:pt>
                <c:pt idx="48">
                  <c:v>2.5291786191341671E-3</c:v>
                </c:pt>
                <c:pt idx="49">
                  <c:v>1.1310585328017427E-3</c:v>
                </c:pt>
                <c:pt idx="50">
                  <c:v>1.1724517601748774E-3</c:v>
                </c:pt>
                <c:pt idx="51">
                  <c:v>2.2211110206644727E-3</c:v>
                </c:pt>
                <c:pt idx="52">
                  <c:v>1.1114987188894636E-3</c:v>
                </c:pt>
                <c:pt idx="53">
                  <c:v>1.4768432475583441E-3</c:v>
                </c:pt>
                <c:pt idx="54">
                  <c:v>1.659788264848376E-3</c:v>
                </c:pt>
                <c:pt idx="55">
                  <c:v>1.695927027681825E-3</c:v>
                </c:pt>
                <c:pt idx="56">
                  <c:v>1.3672964430269312E-3</c:v>
                </c:pt>
                <c:pt idx="57">
                  <c:v>2.1317986788260373E-3</c:v>
                </c:pt>
                <c:pt idx="58">
                  <c:v>2.0977291092897075E-3</c:v>
                </c:pt>
                <c:pt idx="59">
                  <c:v>2.0583064508058087E-3</c:v>
                </c:pt>
                <c:pt idx="60">
                  <c:v>2.8126034672847113E-3</c:v>
                </c:pt>
                <c:pt idx="61">
                  <c:v>1.7517254857961845E-3</c:v>
                </c:pt>
                <c:pt idx="62">
                  <c:v>1.912594838104969E-3</c:v>
                </c:pt>
                <c:pt idx="63">
                  <c:v>1.2987294097274833E-3</c:v>
                </c:pt>
                <c:pt idx="64">
                  <c:v>2.0448537108993807E-3</c:v>
                </c:pt>
                <c:pt idx="65">
                  <c:v>4.1180937067309843E-3</c:v>
                </c:pt>
                <c:pt idx="66">
                  <c:v>1.7319277108433734E-3</c:v>
                </c:pt>
                <c:pt idx="67">
                  <c:v>1.5345874380114219E-3</c:v>
                </c:pt>
                <c:pt idx="68">
                  <c:v>2.0446107766531755E-3</c:v>
                </c:pt>
                <c:pt idx="69">
                  <c:v>3.1677820430071001E-3</c:v>
                </c:pt>
                <c:pt idx="70">
                  <c:v>1.7348561515107706E-3</c:v>
                </c:pt>
                <c:pt idx="71">
                  <c:v>1.9300567914940861E-3</c:v>
                </c:pt>
                <c:pt idx="72">
                  <c:v>1.2384059580137676E-3</c:v>
                </c:pt>
                <c:pt idx="73">
                  <c:v>1.2404969076184231E-3</c:v>
                </c:pt>
                <c:pt idx="74">
                  <c:v>2.3666390270867884E-3</c:v>
                </c:pt>
                <c:pt idx="75">
                  <c:v>2.0368180758973649E-3</c:v>
                </c:pt>
                <c:pt idx="76">
                  <c:v>2.2475393319383091E-3</c:v>
                </c:pt>
                <c:pt idx="77">
                  <c:v>1.7977898730001649E-3</c:v>
                </c:pt>
                <c:pt idx="78">
                  <c:v>1.4231016840036595E-3</c:v>
                </c:pt>
                <c:pt idx="79">
                  <c:v>1.559066218849774E-3</c:v>
                </c:pt>
                <c:pt idx="80">
                  <c:v>1.7593328995252212E-3</c:v>
                </c:pt>
                <c:pt idx="81">
                  <c:v>1.8153396197872018E-3</c:v>
                </c:pt>
                <c:pt idx="82">
                  <c:v>2.2915092269813024E-3</c:v>
                </c:pt>
                <c:pt idx="83">
                  <c:v>2.1458704186885806E-3</c:v>
                </c:pt>
                <c:pt idx="84">
                  <c:v>1.9890642394080281E-3</c:v>
                </c:pt>
                <c:pt idx="85">
                  <c:v>1.8669645113689171E-3</c:v>
                </c:pt>
                <c:pt idx="86">
                  <c:v>1.2876511727724898E-3</c:v>
                </c:pt>
                <c:pt idx="87">
                  <c:v>3.342900277054266E-3</c:v>
                </c:pt>
                <c:pt idx="88">
                  <c:v>2.3445489237522757E-3</c:v>
                </c:pt>
                <c:pt idx="89">
                  <c:v>2.4079600278635377E-3</c:v>
                </c:pt>
                <c:pt idx="90">
                  <c:v>1.8522187858059736E-3</c:v>
                </c:pt>
                <c:pt idx="91">
                  <c:v>1.6122880621337679E-3</c:v>
                </c:pt>
                <c:pt idx="92">
                  <c:v>1.380160411096837E-3</c:v>
                </c:pt>
                <c:pt idx="93">
                  <c:v>2.0650701144359013E-3</c:v>
                </c:pt>
                <c:pt idx="94">
                  <c:v>1.4934926392148496E-3</c:v>
                </c:pt>
                <c:pt idx="95">
                  <c:v>1.8256981083515636E-3</c:v>
                </c:pt>
                <c:pt idx="96">
                  <c:v>1.9483722459717199E-3</c:v>
                </c:pt>
                <c:pt idx="97">
                  <c:v>1.4876916122138659E-3</c:v>
                </c:pt>
                <c:pt idx="98">
                  <c:v>1.9805301112450985E-3</c:v>
                </c:pt>
                <c:pt idx="99">
                  <c:v>9.924287292110191E-4</c:v>
                </c:pt>
                <c:pt idx="100">
                  <c:v>1.4766307139188494E-3</c:v>
                </c:pt>
                <c:pt idx="101">
                  <c:v>1.3588504288108839E-3</c:v>
                </c:pt>
                <c:pt idx="102">
                  <c:v>1.6233633805114818E-3</c:v>
                </c:pt>
                <c:pt idx="103">
                  <c:v>2.1565463775530284E-3</c:v>
                </c:pt>
                <c:pt idx="104">
                  <c:v>2.1895108254770851E-3</c:v>
                </c:pt>
                <c:pt idx="105">
                  <c:v>2.3687544758442132E-3</c:v>
                </c:pt>
                <c:pt idx="106">
                  <c:v>1.5873391930630908E-3</c:v>
                </c:pt>
                <c:pt idx="107">
                  <c:v>1.6502399660868116E-3</c:v>
                </c:pt>
                <c:pt idx="108">
                  <c:v>1.6007069185305365E-3</c:v>
                </c:pt>
                <c:pt idx="109">
                  <c:v>2.4573202276254526E-3</c:v>
                </c:pt>
                <c:pt idx="110">
                  <c:v>1.6164605978748932E-3</c:v>
                </c:pt>
                <c:pt idx="111">
                  <c:v>2.5854223545958466E-3</c:v>
                </c:pt>
                <c:pt idx="112">
                  <c:v>2.1727884117951372E-3</c:v>
                </c:pt>
                <c:pt idx="113">
                  <c:v>1.8180812675413734E-3</c:v>
                </c:pt>
                <c:pt idx="114">
                  <c:v>1.3836699811441051E-3</c:v>
                </c:pt>
                <c:pt idx="115">
                  <c:v>1.899733382246009E-3</c:v>
                </c:pt>
                <c:pt idx="116">
                  <c:v>2.0255083372536721E-3</c:v>
                </c:pt>
                <c:pt idx="117">
                  <c:v>2.1268766099707477E-3</c:v>
                </c:pt>
                <c:pt idx="118">
                  <c:v>1.7999224061718893E-3</c:v>
                </c:pt>
                <c:pt idx="119">
                  <c:v>2.4276329622856707E-3</c:v>
                </c:pt>
                <c:pt idx="120">
                  <c:v>2.1383218764758358E-3</c:v>
                </c:pt>
                <c:pt idx="121">
                  <c:v>2.1309632863611852E-3</c:v>
                </c:pt>
                <c:pt idx="122">
                  <c:v>1.0487380603997763E-3</c:v>
                </c:pt>
                <c:pt idx="123">
                  <c:v>2.9303703327019158E-3</c:v>
                </c:pt>
                <c:pt idx="124">
                  <c:v>2.2253164717925241E-3</c:v>
                </c:pt>
                <c:pt idx="125">
                  <c:v>1.9427617791876071E-3</c:v>
                </c:pt>
                <c:pt idx="126">
                  <c:v>1.6021409884069799E-3</c:v>
                </c:pt>
                <c:pt idx="127">
                  <c:v>1.1646315942714684E-3</c:v>
                </c:pt>
                <c:pt idx="128">
                  <c:v>2.013524577735998E-3</c:v>
                </c:pt>
                <c:pt idx="129">
                  <c:v>1.9634203532906051E-3</c:v>
                </c:pt>
                <c:pt idx="130">
                  <c:v>1.4808958164693185E-3</c:v>
                </c:pt>
                <c:pt idx="131">
                  <c:v>2.2030753362072349E-3</c:v>
                </c:pt>
                <c:pt idx="132">
                  <c:v>1.9535108321078161E-3</c:v>
                </c:pt>
                <c:pt idx="133">
                  <c:v>2.1887239574762203E-3</c:v>
                </c:pt>
                <c:pt idx="134">
                  <c:v>2.3460950791603903E-3</c:v>
                </c:pt>
                <c:pt idx="135">
                  <c:v>1.3933627193354243E-3</c:v>
                </c:pt>
                <c:pt idx="136">
                  <c:v>1.4640977762688848E-3</c:v>
                </c:pt>
                <c:pt idx="137">
                  <c:v>1.6054375231023012E-3</c:v>
                </c:pt>
                <c:pt idx="138">
                  <c:v>1.9343387643614026E-3</c:v>
                </c:pt>
                <c:pt idx="139">
                  <c:v>1.3670227362814948E-3</c:v>
                </c:pt>
                <c:pt idx="140">
                  <c:v>1.9808243755477083E-3</c:v>
                </c:pt>
                <c:pt idx="141">
                  <c:v>1.7712997496285984E-3</c:v>
                </c:pt>
                <c:pt idx="142">
                  <c:v>1.7762542848239328E-3</c:v>
                </c:pt>
                <c:pt idx="143">
                  <c:v>1.6410411775101619E-3</c:v>
                </c:pt>
                <c:pt idx="144">
                  <c:v>2.5344763324636603E-3</c:v>
                </c:pt>
                <c:pt idx="145">
                  <c:v>1.1312049555668622E-3</c:v>
                </c:pt>
                <c:pt idx="146">
                  <c:v>1.5088884371258838E-3</c:v>
                </c:pt>
                <c:pt idx="147">
                  <c:v>1.2616974719493459E-3</c:v>
                </c:pt>
                <c:pt idx="148">
                  <c:v>2.1411907577258637E-3</c:v>
                </c:pt>
                <c:pt idx="149">
                  <c:v>2.5835217624249687E-3</c:v>
                </c:pt>
                <c:pt idx="150">
                  <c:v>1.4597428882311587E-3</c:v>
                </c:pt>
                <c:pt idx="151">
                  <c:v>1.945193936731895E-3</c:v>
                </c:pt>
                <c:pt idx="152">
                  <c:v>1.9710696368384225E-3</c:v>
                </c:pt>
                <c:pt idx="153">
                  <c:v>2.3147724569525518E-3</c:v>
                </c:pt>
                <c:pt idx="154">
                  <c:v>1.7922364732863331E-3</c:v>
                </c:pt>
                <c:pt idx="155">
                  <c:v>1.779147940422687E-3</c:v>
                </c:pt>
                <c:pt idx="156">
                  <c:v>1.8463824649391659E-3</c:v>
                </c:pt>
                <c:pt idx="157">
                  <c:v>1.5498555313236872E-3</c:v>
                </c:pt>
                <c:pt idx="158">
                  <c:v>2.1204287332616842E-3</c:v>
                </c:pt>
                <c:pt idx="159">
                  <c:v>2.4694317038715607E-3</c:v>
                </c:pt>
                <c:pt idx="160">
                  <c:v>1.3825299173479404E-3</c:v>
                </c:pt>
                <c:pt idx="161">
                  <c:v>2.4695113119550418E-3</c:v>
                </c:pt>
                <c:pt idx="162">
                  <c:v>1.9805843828344443E-3</c:v>
                </c:pt>
                <c:pt idx="163">
                  <c:v>1.8360597714879826E-3</c:v>
                </c:pt>
                <c:pt idx="164">
                  <c:v>1.6819532644184437E-3</c:v>
                </c:pt>
                <c:pt idx="165">
                  <c:v>1.6379986368333492E-3</c:v>
                </c:pt>
                <c:pt idx="166">
                  <c:v>1.6923230744733246E-3</c:v>
                </c:pt>
                <c:pt idx="167">
                  <c:v>1.6895034943695622E-3</c:v>
                </c:pt>
                <c:pt idx="168">
                  <c:v>1.0459355539922356E-3</c:v>
                </c:pt>
                <c:pt idx="169">
                  <c:v>1.4294082323598866E-3</c:v>
                </c:pt>
                <c:pt idx="170">
                  <c:v>1.9507049630991644E-3</c:v>
                </c:pt>
                <c:pt idx="171">
                  <c:v>2.3960566104459409E-3</c:v>
                </c:pt>
                <c:pt idx="172">
                  <c:v>2.2576149133250096E-3</c:v>
                </c:pt>
                <c:pt idx="173">
                  <c:v>1.5735127766336979E-3</c:v>
                </c:pt>
                <c:pt idx="174">
                  <c:v>1.3184080490776502E-3</c:v>
                </c:pt>
                <c:pt idx="175">
                  <c:v>2.7104291814431499E-3</c:v>
                </c:pt>
                <c:pt idx="176">
                  <c:v>2.0742949155164291E-3</c:v>
                </c:pt>
                <c:pt idx="177">
                  <c:v>2.3620855349542895E-3</c:v>
                </c:pt>
                <c:pt idx="178">
                  <c:v>2.2446084505018944E-3</c:v>
                </c:pt>
                <c:pt idx="179">
                  <c:v>1.9158737675980539E-3</c:v>
                </c:pt>
                <c:pt idx="180">
                  <c:v>2.2400959537164427E-3</c:v>
                </c:pt>
                <c:pt idx="181">
                  <c:v>2.9540049695534866E-3</c:v>
                </c:pt>
                <c:pt idx="182">
                  <c:v>2.2439711142317078E-3</c:v>
                </c:pt>
                <c:pt idx="183">
                  <c:v>2.6897877108237058E-3</c:v>
                </c:pt>
                <c:pt idx="184">
                  <c:v>1.8018874131037054E-3</c:v>
                </c:pt>
                <c:pt idx="185">
                  <c:v>2.0077277181046755E-3</c:v>
                </c:pt>
                <c:pt idx="186">
                  <c:v>2.895431652281955E-3</c:v>
                </c:pt>
                <c:pt idx="187">
                  <c:v>2.6806439535754399E-3</c:v>
                </c:pt>
                <c:pt idx="188">
                  <c:v>2.6813785218947907E-3</c:v>
                </c:pt>
                <c:pt idx="189">
                  <c:v>1.3012044578439754E-3</c:v>
                </c:pt>
                <c:pt idx="190">
                  <c:v>2.0303152413130407E-3</c:v>
                </c:pt>
                <c:pt idx="191">
                  <c:v>2.7534336698641151E-3</c:v>
                </c:pt>
                <c:pt idx="192">
                  <c:v>1.7112708116545266E-3</c:v>
                </c:pt>
                <c:pt idx="193">
                  <c:v>2.3861422107731432E-3</c:v>
                </c:pt>
                <c:pt idx="194">
                  <c:v>2.3047024234672691E-3</c:v>
                </c:pt>
                <c:pt idx="195">
                  <c:v>2.0936151007735094E-3</c:v>
                </c:pt>
                <c:pt idx="196">
                  <c:v>2.0409187480134499E-3</c:v>
                </c:pt>
                <c:pt idx="197">
                  <c:v>1.6992317617196395E-3</c:v>
                </c:pt>
                <c:pt idx="198">
                  <c:v>2.2968107869442652E-3</c:v>
                </c:pt>
                <c:pt idx="199">
                  <c:v>1.4823700784028105E-3</c:v>
                </c:pt>
                <c:pt idx="200">
                  <c:v>1.3235588592973905E-3</c:v>
                </c:pt>
                <c:pt idx="201">
                  <c:v>1.6682824564597963E-3</c:v>
                </c:pt>
                <c:pt idx="202">
                  <c:v>1.6817746915102436E-3</c:v>
                </c:pt>
                <c:pt idx="203">
                  <c:v>1.334184778890232E-3</c:v>
                </c:pt>
                <c:pt idx="204">
                  <c:v>1.9264609474737484E-3</c:v>
                </c:pt>
                <c:pt idx="205">
                  <c:v>1.7741322304528646E-3</c:v>
                </c:pt>
                <c:pt idx="206">
                  <c:v>2.0115010530799629E-3</c:v>
                </c:pt>
                <c:pt idx="207">
                  <c:v>2.2803772326166721E-3</c:v>
                </c:pt>
                <c:pt idx="208">
                  <c:v>1.5699904122722914E-3</c:v>
                </c:pt>
                <c:pt idx="209">
                  <c:v>3.3773411114522566E-3</c:v>
                </c:pt>
                <c:pt idx="210">
                  <c:v>2.3356530569576773E-3</c:v>
                </c:pt>
                <c:pt idx="211">
                  <c:v>2.5035356422832724E-3</c:v>
                </c:pt>
                <c:pt idx="212">
                  <c:v>1.9329432500966471E-3</c:v>
                </c:pt>
                <c:pt idx="213">
                  <c:v>1.470501349053693E-3</c:v>
                </c:pt>
                <c:pt idx="214">
                  <c:v>2.6994601079784043E-3</c:v>
                </c:pt>
                <c:pt idx="215">
                  <c:v>2.1984474318447159E-3</c:v>
                </c:pt>
                <c:pt idx="216">
                  <c:v>1.4350143501435015E-3</c:v>
                </c:pt>
                <c:pt idx="217">
                  <c:v>2.4673797878053383E-3</c:v>
                </c:pt>
                <c:pt idx="218">
                  <c:v>2.924718346638812E-3</c:v>
                </c:pt>
                <c:pt idx="219">
                  <c:v>2.3409332118958549E-3</c:v>
                </c:pt>
                <c:pt idx="220">
                  <c:v>1.6931216931216932E-3</c:v>
                </c:pt>
                <c:pt idx="221">
                  <c:v>1.3424345847554038E-3</c:v>
                </c:pt>
                <c:pt idx="222">
                  <c:v>1.9514022776767385E-3</c:v>
                </c:pt>
                <c:pt idx="223">
                  <c:v>2.3281314559959318E-3</c:v>
                </c:pt>
                <c:pt idx="224">
                  <c:v>1.5702108568864963E-3</c:v>
                </c:pt>
                <c:pt idx="225">
                  <c:v>1.2632403804582794E-3</c:v>
                </c:pt>
                <c:pt idx="226">
                  <c:v>1.4976562651953761E-3</c:v>
                </c:pt>
                <c:pt idx="227">
                  <c:v>1.4089491643128535E-3</c:v>
                </c:pt>
                <c:pt idx="228">
                  <c:v>8.7713165237620055E-4</c:v>
                </c:pt>
                <c:pt idx="229">
                  <c:v>1.497495784360607E-3</c:v>
                </c:pt>
                <c:pt idx="230">
                  <c:v>1.7295158569295935E-3</c:v>
                </c:pt>
                <c:pt idx="231">
                  <c:v>2.2277615211396505E-3</c:v>
                </c:pt>
                <c:pt idx="232">
                  <c:v>2.1490014346685557E-3</c:v>
                </c:pt>
                <c:pt idx="233">
                  <c:v>1.9150302862940261E-3</c:v>
                </c:pt>
                <c:pt idx="234">
                  <c:v>2.557590076786769E-3</c:v>
                </c:pt>
                <c:pt idx="235">
                  <c:v>2.1969033011977799E-3</c:v>
                </c:pt>
                <c:pt idx="236">
                  <c:v>1.5295757346688085E-3</c:v>
                </c:pt>
                <c:pt idx="237">
                  <c:v>1.8907449535116836E-3</c:v>
                </c:pt>
                <c:pt idx="238">
                  <c:v>1.699442960362992E-3</c:v>
                </c:pt>
                <c:pt idx="239">
                  <c:v>1.377303373282536E-3</c:v>
                </c:pt>
                <c:pt idx="240">
                  <c:v>1.9914984770894001E-3</c:v>
                </c:pt>
                <c:pt idx="241">
                  <c:v>2.4706435998565796E-3</c:v>
                </c:pt>
                <c:pt idx="242">
                  <c:v>1.67294495214467E-3</c:v>
                </c:pt>
                <c:pt idx="243">
                  <c:v>2.2651536601833904E-3</c:v>
                </c:pt>
                <c:pt idx="244">
                  <c:v>1.8387285937204933E-3</c:v>
                </c:pt>
                <c:pt idx="245">
                  <c:v>1.9714238324289742E-3</c:v>
                </c:pt>
                <c:pt idx="246">
                  <c:v>2.5740572810398245E-3</c:v>
                </c:pt>
                <c:pt idx="247">
                  <c:v>2.5423373672373733E-3</c:v>
                </c:pt>
                <c:pt idx="248">
                  <c:v>1.933210546280512E-3</c:v>
                </c:pt>
                <c:pt idx="249">
                  <c:v>1.3987272032202208E-3</c:v>
                </c:pt>
                <c:pt idx="250">
                  <c:v>1.9622437242032614E-3</c:v>
                </c:pt>
                <c:pt idx="251">
                  <c:v>1.6820224437024578E-3</c:v>
                </c:pt>
                <c:pt idx="252">
                  <c:v>2.4557898130495178E-3</c:v>
                </c:pt>
                <c:pt idx="253">
                  <c:v>1.859764532292275E-3</c:v>
                </c:pt>
                <c:pt idx="254">
                  <c:v>1.4032136343626188E-3</c:v>
                </c:pt>
                <c:pt idx="255">
                  <c:v>1.5538141590821031E-3</c:v>
                </c:pt>
                <c:pt idx="256">
                  <c:v>1.3695670624908375E-3</c:v>
                </c:pt>
                <c:pt idx="257">
                  <c:v>1.1423251010292661E-3</c:v>
                </c:pt>
                <c:pt idx="258">
                  <c:v>2.0934651679603206E-3</c:v>
                </c:pt>
                <c:pt idx="259">
                  <c:v>1.7366953279414551E-3</c:v>
                </c:pt>
                <c:pt idx="260">
                  <c:v>1.9382969087042964E-3</c:v>
                </c:pt>
                <c:pt idx="261">
                  <c:v>1.8330258664677945E-3</c:v>
                </c:pt>
                <c:pt idx="262">
                  <c:v>2.7174338653343151E-3</c:v>
                </c:pt>
                <c:pt idx="263">
                  <c:v>1.9920084846255298E-3</c:v>
                </c:pt>
                <c:pt idx="264">
                  <c:v>1.6881522406384285E-3</c:v>
                </c:pt>
                <c:pt idx="265">
                  <c:v>2.2009650385168881E-3</c:v>
                </c:pt>
                <c:pt idx="266">
                  <c:v>2.5164738234836298E-3</c:v>
                </c:pt>
                <c:pt idx="267">
                  <c:v>2.391312573309622E-3</c:v>
                </c:pt>
                <c:pt idx="268">
                  <c:v>1.2178822806852246E-3</c:v>
                </c:pt>
                <c:pt idx="269">
                  <c:v>1.3896820235882845E-3</c:v>
                </c:pt>
                <c:pt idx="270">
                  <c:v>1.802767184594535E-3</c:v>
                </c:pt>
                <c:pt idx="271">
                  <c:v>1.9328393504650797E-3</c:v>
                </c:pt>
                <c:pt idx="272">
                  <c:v>1.8547066909587523E-3</c:v>
                </c:pt>
                <c:pt idx="273">
                  <c:v>2.7341804971612255E-3</c:v>
                </c:pt>
                <c:pt idx="274">
                  <c:v>1.6173461120679825E-3</c:v>
                </c:pt>
                <c:pt idx="275">
                  <c:v>1.8838692564594108E-3</c:v>
                </c:pt>
                <c:pt idx="276">
                  <c:v>1.9492063301077176E-3</c:v>
                </c:pt>
                <c:pt idx="277">
                  <c:v>2.544207867195958E-3</c:v>
                </c:pt>
                <c:pt idx="278">
                  <c:v>1.7032087541512153E-3</c:v>
                </c:pt>
                <c:pt idx="279">
                  <c:v>1.2280979761850862E-3</c:v>
                </c:pt>
                <c:pt idx="280">
                  <c:v>2.0694634275384683E-3</c:v>
                </c:pt>
                <c:pt idx="281">
                  <c:v>2.5354480439845118E-3</c:v>
                </c:pt>
                <c:pt idx="282">
                  <c:v>1.8812367086536888E-3</c:v>
                </c:pt>
                <c:pt idx="283">
                  <c:v>1.6390670326382475E-3</c:v>
                </c:pt>
                <c:pt idx="284">
                  <c:v>1.6796927749519665E-3</c:v>
                </c:pt>
                <c:pt idx="285">
                  <c:v>1.7675504418876104E-3</c:v>
                </c:pt>
                <c:pt idx="286">
                  <c:v>2.3985897448247297E-3</c:v>
                </c:pt>
                <c:pt idx="287">
                  <c:v>1.6984580103436332E-3</c:v>
                </c:pt>
                <c:pt idx="288">
                  <c:v>9.8427307977378407E-4</c:v>
                </c:pt>
                <c:pt idx="289">
                  <c:v>1.6963774367301963E-3</c:v>
                </c:pt>
                <c:pt idx="290">
                  <c:v>2.1440760425783674E-3</c:v>
                </c:pt>
                <c:pt idx="291">
                  <c:v>1.7285832191088787E-3</c:v>
                </c:pt>
                <c:pt idx="292">
                  <c:v>1.8793031206844829E-3</c:v>
                </c:pt>
                <c:pt idx="293">
                  <c:v>2.4605601319596655E-3</c:v>
                </c:pt>
                <c:pt idx="294">
                  <c:v>1.9790275101374917E-3</c:v>
                </c:pt>
                <c:pt idx="295">
                  <c:v>1.7803441527704839E-3</c:v>
                </c:pt>
                <c:pt idx="296">
                  <c:v>1.7663338654374746E-3</c:v>
                </c:pt>
                <c:pt idx="297">
                  <c:v>2.8609276618046923E-3</c:v>
                </c:pt>
                <c:pt idx="298">
                  <c:v>2.662485944550944E-3</c:v>
                </c:pt>
                <c:pt idx="299">
                  <c:v>1.6702475572316462E-3</c:v>
                </c:pt>
                <c:pt idx="300">
                  <c:v>1.3393591232899965E-3</c:v>
                </c:pt>
                <c:pt idx="301">
                  <c:v>1.6390050970371624E-3</c:v>
                </c:pt>
                <c:pt idx="302">
                  <c:v>1.3255738764953119E-3</c:v>
                </c:pt>
                <c:pt idx="303">
                  <c:v>1.9013110365645354E-3</c:v>
                </c:pt>
                <c:pt idx="304">
                  <c:v>2.4551524509042752E-3</c:v>
                </c:pt>
                <c:pt idx="305">
                  <c:v>1.9630420706284956E-3</c:v>
                </c:pt>
                <c:pt idx="306">
                  <c:v>1.7086756007511786E-3</c:v>
                </c:pt>
                <c:pt idx="307">
                  <c:v>2.3287026211517947E-3</c:v>
                </c:pt>
                <c:pt idx="308">
                  <c:v>1.8522257151738304E-3</c:v>
                </c:pt>
                <c:pt idx="309">
                  <c:v>1.7935579505311691E-3</c:v>
                </c:pt>
                <c:pt idx="310">
                  <c:v>2.1659607239122064E-3</c:v>
                </c:pt>
                <c:pt idx="311">
                  <c:v>1.5250284073919024E-3</c:v>
                </c:pt>
                <c:pt idx="312">
                  <c:v>1.8338834983828481E-3</c:v>
                </c:pt>
                <c:pt idx="313">
                  <c:v>1.8918466432278588E-3</c:v>
                </c:pt>
                <c:pt idx="314">
                  <c:v>3.227251365799213E-3</c:v>
                </c:pt>
                <c:pt idx="315">
                  <c:v>1.7446739594528938E-3</c:v>
                </c:pt>
                <c:pt idx="316">
                  <c:v>1.5766008634120767E-3</c:v>
                </c:pt>
                <c:pt idx="317">
                  <c:v>8.2893041838582606E-4</c:v>
                </c:pt>
                <c:pt idx="318">
                  <c:v>2.4780128856670054E-3</c:v>
                </c:pt>
                <c:pt idx="319">
                  <c:v>1.9518473410733565E-3</c:v>
                </c:pt>
                <c:pt idx="320">
                  <c:v>1.1970066905539526E-3</c:v>
                </c:pt>
                <c:pt idx="321">
                  <c:v>1.9389040692442364E-3</c:v>
                </c:pt>
                <c:pt idx="322">
                  <c:v>1.4806642666356986E-3</c:v>
                </c:pt>
                <c:pt idx="323">
                  <c:v>1.5589909077033774E-3</c:v>
                </c:pt>
                <c:pt idx="324">
                  <c:v>1.750610483592208E-3</c:v>
                </c:pt>
                <c:pt idx="325">
                  <c:v>1.7988053217485745E-3</c:v>
                </c:pt>
                <c:pt idx="326">
                  <c:v>9.9737676248770352E-4</c:v>
                </c:pt>
                <c:pt idx="327">
                  <c:v>1.7012010479398455E-3</c:v>
                </c:pt>
                <c:pt idx="328">
                  <c:v>1.2319906916258856E-3</c:v>
                </c:pt>
                <c:pt idx="329">
                  <c:v>1.2484852935776447E-3</c:v>
                </c:pt>
                <c:pt idx="330">
                  <c:v>2.8608378727906884E-3</c:v>
                </c:pt>
                <c:pt idx="331">
                  <c:v>2.3034154090548053E-3</c:v>
                </c:pt>
                <c:pt idx="332">
                  <c:v>1.1741682974559687E-3</c:v>
                </c:pt>
                <c:pt idx="333">
                  <c:v>1.1746280344557558E-3</c:v>
                </c:pt>
                <c:pt idx="334">
                  <c:v>1.1585248117397182E-3</c:v>
                </c:pt>
                <c:pt idx="335">
                  <c:v>2.015376576845562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A27-447B-801F-BD53CCA4EA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8872272"/>
        <c:axId val="658869320"/>
      </c:scatterChart>
      <c:valAx>
        <c:axId val="658872272"/>
        <c:scaling>
          <c:orientation val="minMax"/>
          <c:max val="1400"/>
          <c:min val="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58869320"/>
        <c:crosses val="autoZero"/>
        <c:crossBetween val="midCat"/>
        <c:majorUnit val="500"/>
      </c:valAx>
      <c:valAx>
        <c:axId val="658869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U-C mutation rate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261082677165354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88722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b="1"/>
              <a:t>Correlation Coefficiency = 0.72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4SUdose'!$D$1</c:f>
              <c:strCache>
                <c:ptCount val="1"/>
                <c:pt idx="0">
                  <c:v>fold change:2A/2B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2629301545640129"/>
                  <c:y val="-4.565434529017205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4SUdose'!$B$2:$B$708</c:f>
              <c:numCache>
                <c:formatCode>0.00</c:formatCode>
                <c:ptCount val="707"/>
                <c:pt idx="0">
                  <c:v>0.73804126180437857</c:v>
                </c:pt>
                <c:pt idx="1">
                  <c:v>1.4853137674126557</c:v>
                </c:pt>
                <c:pt idx="2">
                  <c:v>1.1375647434098501</c:v>
                </c:pt>
                <c:pt idx="3">
                  <c:v>1.0448099379878024</c:v>
                </c:pt>
                <c:pt idx="4">
                  <c:v>1.2427326047771849</c:v>
                </c:pt>
                <c:pt idx="5">
                  <c:v>1.0678836628303374</c:v>
                </c:pt>
                <c:pt idx="6">
                  <c:v>1.1178217207481196</c:v>
                </c:pt>
                <c:pt idx="7">
                  <c:v>1.5614528273206323</c:v>
                </c:pt>
                <c:pt idx="8">
                  <c:v>1.075298092961309</c:v>
                </c:pt>
                <c:pt idx="9">
                  <c:v>1.2135650687932136</c:v>
                </c:pt>
                <c:pt idx="10">
                  <c:v>1.313106763244132</c:v>
                </c:pt>
                <c:pt idx="11">
                  <c:v>1.2355988017464556</c:v>
                </c:pt>
                <c:pt idx="12">
                  <c:v>1.1751334883943474</c:v>
                </c:pt>
                <c:pt idx="13">
                  <c:v>1.1303842700310094</c:v>
                </c:pt>
                <c:pt idx="14">
                  <c:v>1.0159386273794757</c:v>
                </c:pt>
                <c:pt idx="15">
                  <c:v>1.1515427631957582</c:v>
                </c:pt>
                <c:pt idx="16">
                  <c:v>1.4802385394219573</c:v>
                </c:pt>
                <c:pt idx="17">
                  <c:v>0.94496786774409736</c:v>
                </c:pt>
                <c:pt idx="18">
                  <c:v>1.1214316098239792</c:v>
                </c:pt>
                <c:pt idx="19">
                  <c:v>1.0293052146363206</c:v>
                </c:pt>
                <c:pt idx="20">
                  <c:v>1.1621299044418305</c:v>
                </c:pt>
                <c:pt idx="21">
                  <c:v>1.1597943294341044</c:v>
                </c:pt>
                <c:pt idx="22">
                  <c:v>1.4205923047527074</c:v>
                </c:pt>
                <c:pt idx="23">
                  <c:v>1.0479145636169165</c:v>
                </c:pt>
                <c:pt idx="24">
                  <c:v>1.230951402932255</c:v>
                </c:pt>
                <c:pt idx="25">
                  <c:v>1.1868682365915695</c:v>
                </c:pt>
                <c:pt idx="26">
                  <c:v>1.0364371856313785</c:v>
                </c:pt>
                <c:pt idx="27">
                  <c:v>1.2545845073908062</c:v>
                </c:pt>
                <c:pt idx="28">
                  <c:v>0.98536642194157009</c:v>
                </c:pt>
                <c:pt idx="29">
                  <c:v>1.1561674876955848</c:v>
                </c:pt>
                <c:pt idx="30">
                  <c:v>1.0703357167117828</c:v>
                </c:pt>
                <c:pt idx="31">
                  <c:v>0.96048232635132724</c:v>
                </c:pt>
                <c:pt idx="32">
                  <c:v>1.0453430493962454</c:v>
                </c:pt>
                <c:pt idx="33">
                  <c:v>1.7515010484865319</c:v>
                </c:pt>
                <c:pt idx="34">
                  <c:v>1.0948178437618652</c:v>
                </c:pt>
                <c:pt idx="35">
                  <c:v>2.3894267043401136</c:v>
                </c:pt>
                <c:pt idx="36">
                  <c:v>1.3159266398314373</c:v>
                </c:pt>
                <c:pt idx="37">
                  <c:v>1.283383477931842</c:v>
                </c:pt>
                <c:pt idx="38">
                  <c:v>1.1445509926772179</c:v>
                </c:pt>
                <c:pt idx="39">
                  <c:v>1.3839672282712354</c:v>
                </c:pt>
                <c:pt idx="40">
                  <c:v>1.0741147633199231</c:v>
                </c:pt>
                <c:pt idx="41">
                  <c:v>1.0735580027449434</c:v>
                </c:pt>
                <c:pt idx="42">
                  <c:v>1.0786344204512595</c:v>
                </c:pt>
                <c:pt idx="43">
                  <c:v>1.311655639175334</c:v>
                </c:pt>
                <c:pt idx="44">
                  <c:v>1.0764370243356474</c:v>
                </c:pt>
                <c:pt idx="45">
                  <c:v>1.0235456702697308</c:v>
                </c:pt>
                <c:pt idx="46">
                  <c:v>1.5751573817561242</c:v>
                </c:pt>
                <c:pt idx="47">
                  <c:v>1.0569835772674143</c:v>
                </c:pt>
                <c:pt idx="48">
                  <c:v>2.5703686647116055</c:v>
                </c:pt>
                <c:pt idx="49">
                  <c:v>1.239637168936027</c:v>
                </c:pt>
                <c:pt idx="50">
                  <c:v>1.7053095168706902</c:v>
                </c:pt>
                <c:pt idx="51">
                  <c:v>1.0672962841557003</c:v>
                </c:pt>
                <c:pt idx="52">
                  <c:v>1.1918367675738823</c:v>
                </c:pt>
                <c:pt idx="53">
                  <c:v>0.91255771245994743</c:v>
                </c:pt>
                <c:pt idx="54">
                  <c:v>1.5803747405450164</c:v>
                </c:pt>
                <c:pt idx="55">
                  <c:v>1.2828029291062666</c:v>
                </c:pt>
                <c:pt idx="56">
                  <c:v>1.3699126544223155</c:v>
                </c:pt>
                <c:pt idx="57">
                  <c:v>1.3471420053994614</c:v>
                </c:pt>
                <c:pt idx="58">
                  <c:v>0.99271185439070397</c:v>
                </c:pt>
                <c:pt idx="59">
                  <c:v>1.1796352598006323</c:v>
                </c:pt>
                <c:pt idx="60">
                  <c:v>1.1713089305850335</c:v>
                </c:pt>
                <c:pt idx="61">
                  <c:v>1.6870027357193198</c:v>
                </c:pt>
                <c:pt idx="62">
                  <c:v>1.1578306738858126</c:v>
                </c:pt>
                <c:pt idx="63">
                  <c:v>1.1328429409601102</c:v>
                </c:pt>
                <c:pt idx="64">
                  <c:v>0.97100319878077879</c:v>
                </c:pt>
                <c:pt idx="65">
                  <c:v>0.89873750777351091</c:v>
                </c:pt>
                <c:pt idx="66">
                  <c:v>1.0044377237420772</c:v>
                </c:pt>
                <c:pt idx="67">
                  <c:v>1.2285282467622887</c:v>
                </c:pt>
                <c:pt idx="68">
                  <c:v>1.1225457328628612</c:v>
                </c:pt>
                <c:pt idx="69">
                  <c:v>1.2585826052618589</c:v>
                </c:pt>
                <c:pt idx="70">
                  <c:v>0.98208536613746078</c:v>
                </c:pt>
                <c:pt idx="71">
                  <c:v>0.86892091529873439</c:v>
                </c:pt>
                <c:pt idx="72">
                  <c:v>1.0755620937774841</c:v>
                </c:pt>
                <c:pt idx="73">
                  <c:v>1.3417108685736927</c:v>
                </c:pt>
                <c:pt idx="74">
                  <c:v>1.0788688255274537</c:v>
                </c:pt>
                <c:pt idx="75">
                  <c:v>1.0198637298451552</c:v>
                </c:pt>
                <c:pt idx="76">
                  <c:v>1.3291204066340678</c:v>
                </c:pt>
                <c:pt idx="77">
                  <c:v>1.2335999147972077</c:v>
                </c:pt>
                <c:pt idx="78">
                  <c:v>1.2162243080346327</c:v>
                </c:pt>
                <c:pt idx="79">
                  <c:v>0.85295366807404172</c:v>
                </c:pt>
                <c:pt idx="80">
                  <c:v>0.87943650980082888</c:v>
                </c:pt>
                <c:pt idx="81">
                  <c:v>1.0562517213814044</c:v>
                </c:pt>
                <c:pt idx="82">
                  <c:v>1.3410239183359083</c:v>
                </c:pt>
                <c:pt idx="83">
                  <c:v>1.1039678212666191</c:v>
                </c:pt>
                <c:pt idx="84">
                  <c:v>1.1880304324868298</c:v>
                </c:pt>
                <c:pt idx="85">
                  <c:v>1.7396753036829002</c:v>
                </c:pt>
                <c:pt idx="86">
                  <c:v>1.1169171054483671</c:v>
                </c:pt>
                <c:pt idx="87">
                  <c:v>1.4329364543987804</c:v>
                </c:pt>
                <c:pt idx="88">
                  <c:v>1.1432653089318654</c:v>
                </c:pt>
                <c:pt idx="89">
                  <c:v>1.197092579723988</c:v>
                </c:pt>
                <c:pt idx="90">
                  <c:v>1.141404357408675</c:v>
                </c:pt>
                <c:pt idx="91">
                  <c:v>1.2048376326559456</c:v>
                </c:pt>
                <c:pt idx="92">
                  <c:v>1.0287846991114269</c:v>
                </c:pt>
                <c:pt idx="93">
                  <c:v>0.97190278638289329</c:v>
                </c:pt>
                <c:pt idx="94">
                  <c:v>1.2643624921334171</c:v>
                </c:pt>
                <c:pt idx="95">
                  <c:v>1.4495937387783748</c:v>
                </c:pt>
                <c:pt idx="96">
                  <c:v>1.1778088920875986</c:v>
                </c:pt>
                <c:pt idx="97">
                  <c:v>1.0733869686145441</c:v>
                </c:pt>
                <c:pt idx="98">
                  <c:v>1.2559658948068675</c:v>
                </c:pt>
                <c:pt idx="99">
                  <c:v>0.8033831244367764</c:v>
                </c:pt>
                <c:pt idx="100">
                  <c:v>1.703872387431252</c:v>
                </c:pt>
                <c:pt idx="101">
                  <c:v>1.44494798577839</c:v>
                </c:pt>
                <c:pt idx="102">
                  <c:v>1.0735445099500254</c:v>
                </c:pt>
                <c:pt idx="103">
                  <c:v>1.220626889144738</c:v>
                </c:pt>
                <c:pt idx="104">
                  <c:v>1.5589094082986008</c:v>
                </c:pt>
                <c:pt idx="105">
                  <c:v>1.2721516142214957</c:v>
                </c:pt>
                <c:pt idx="106">
                  <c:v>1.3874823089261468</c:v>
                </c:pt>
                <c:pt idx="107">
                  <c:v>1.3538443682743015</c:v>
                </c:pt>
                <c:pt idx="108">
                  <c:v>0.88908102221388396</c:v>
                </c:pt>
                <c:pt idx="109">
                  <c:v>1.0362924386131669</c:v>
                </c:pt>
                <c:pt idx="110">
                  <c:v>1.2232641294203928</c:v>
                </c:pt>
                <c:pt idx="111">
                  <c:v>1.2301186543927389</c:v>
                </c:pt>
                <c:pt idx="112">
                  <c:v>0.90362328895536115</c:v>
                </c:pt>
                <c:pt idx="113">
                  <c:v>0.93780637058383942</c:v>
                </c:pt>
                <c:pt idx="114">
                  <c:v>1.1342532926148021</c:v>
                </c:pt>
                <c:pt idx="115">
                  <c:v>0.91249121417226831</c:v>
                </c:pt>
                <c:pt idx="116">
                  <c:v>0.93897712078280993</c:v>
                </c:pt>
                <c:pt idx="117">
                  <c:v>1.5954399903090366</c:v>
                </c:pt>
                <c:pt idx="118">
                  <c:v>0.98378222094667145</c:v>
                </c:pt>
                <c:pt idx="119">
                  <c:v>1.9699391770244732</c:v>
                </c:pt>
                <c:pt idx="120">
                  <c:v>1.0859507309474357</c:v>
                </c:pt>
                <c:pt idx="121">
                  <c:v>1.4776240996043613</c:v>
                </c:pt>
                <c:pt idx="122">
                  <c:v>1.563659376613336</c:v>
                </c:pt>
                <c:pt idx="123">
                  <c:v>1.2180746475406143</c:v>
                </c:pt>
                <c:pt idx="124">
                  <c:v>1.1309252959967819</c:v>
                </c:pt>
                <c:pt idx="125">
                  <c:v>1.3388757790282568</c:v>
                </c:pt>
                <c:pt idx="126">
                  <c:v>1.4350556017853089</c:v>
                </c:pt>
                <c:pt idx="127">
                  <c:v>1.0240995847496728</c:v>
                </c:pt>
                <c:pt idx="128">
                  <c:v>1.4485930151687549</c:v>
                </c:pt>
                <c:pt idx="129">
                  <c:v>0.9041321347172111</c:v>
                </c:pt>
                <c:pt idx="130">
                  <c:v>1.6278685424021904</c:v>
                </c:pt>
                <c:pt idx="131">
                  <c:v>1.1589461121620415</c:v>
                </c:pt>
                <c:pt idx="132">
                  <c:v>1.4143339456542523</c:v>
                </c:pt>
                <c:pt idx="133">
                  <c:v>1.4136629954296847</c:v>
                </c:pt>
                <c:pt idx="134">
                  <c:v>1.2720887845414806</c:v>
                </c:pt>
                <c:pt idx="135">
                  <c:v>1.1268681884529783</c:v>
                </c:pt>
                <c:pt idx="136">
                  <c:v>1.360726014091673</c:v>
                </c:pt>
                <c:pt idx="137">
                  <c:v>1.1322397232160371</c:v>
                </c:pt>
                <c:pt idx="138">
                  <c:v>1.1017662419168657</c:v>
                </c:pt>
                <c:pt idx="139">
                  <c:v>1.3607941614885137</c:v>
                </c:pt>
                <c:pt idx="140">
                  <c:v>1.1445572410614555</c:v>
                </c:pt>
                <c:pt idx="141">
                  <c:v>1.0277862907966004</c:v>
                </c:pt>
                <c:pt idx="142">
                  <c:v>1.349853095065604</c:v>
                </c:pt>
                <c:pt idx="143">
                  <c:v>1.8792940880936899</c:v>
                </c:pt>
                <c:pt idx="144">
                  <c:v>1.1149948402744823</c:v>
                </c:pt>
                <c:pt idx="145">
                  <c:v>1.390941684403171</c:v>
                </c:pt>
                <c:pt idx="146">
                  <c:v>0.96804506789994293</c:v>
                </c:pt>
                <c:pt idx="147">
                  <c:v>1.9540874267973156</c:v>
                </c:pt>
                <c:pt idx="148">
                  <c:v>1.6546807718887884</c:v>
                </c:pt>
                <c:pt idx="149">
                  <c:v>1.0492723338012815</c:v>
                </c:pt>
                <c:pt idx="150">
                  <c:v>1.6957418990788018</c:v>
                </c:pt>
                <c:pt idx="151">
                  <c:v>1.2783988069338881</c:v>
                </c:pt>
                <c:pt idx="152">
                  <c:v>1.1081771721862648</c:v>
                </c:pt>
                <c:pt idx="153">
                  <c:v>0.94622005372512463</c:v>
                </c:pt>
                <c:pt idx="154">
                  <c:v>1.5121344091656701</c:v>
                </c:pt>
                <c:pt idx="155">
                  <c:v>0.98809558166835021</c:v>
                </c:pt>
                <c:pt idx="156">
                  <c:v>1.2409459774025364</c:v>
                </c:pt>
                <c:pt idx="157">
                  <c:v>1.1132500423791374</c:v>
                </c:pt>
                <c:pt idx="158">
                  <c:v>0.99019354225100142</c:v>
                </c:pt>
                <c:pt idx="159">
                  <c:v>0.92920029498646994</c:v>
                </c:pt>
                <c:pt idx="160">
                  <c:v>1.2713851392489504</c:v>
                </c:pt>
                <c:pt idx="161">
                  <c:v>1.0369036600170234</c:v>
                </c:pt>
                <c:pt idx="162">
                  <c:v>1.4090283932326497</c:v>
                </c:pt>
                <c:pt idx="163">
                  <c:v>1.094838684049336</c:v>
                </c:pt>
                <c:pt idx="164">
                  <c:v>1.5774131191011231</c:v>
                </c:pt>
                <c:pt idx="165">
                  <c:v>1.2465269238027796</c:v>
                </c:pt>
                <c:pt idx="166">
                  <c:v>0.98705411020180245</c:v>
                </c:pt>
                <c:pt idx="167">
                  <c:v>1.1307404251767239</c:v>
                </c:pt>
                <c:pt idx="168">
                  <c:v>1.1613913620680019</c:v>
                </c:pt>
                <c:pt idx="169">
                  <c:v>1.0502314290468737</c:v>
                </c:pt>
                <c:pt idx="170">
                  <c:v>1.013130142154024</c:v>
                </c:pt>
                <c:pt idx="171">
                  <c:v>1.0453026641814005</c:v>
                </c:pt>
                <c:pt idx="172">
                  <c:v>1.2414650155157294</c:v>
                </c:pt>
                <c:pt idx="173">
                  <c:v>1.1744606343121284</c:v>
                </c:pt>
                <c:pt idx="174">
                  <c:v>1.1396124328429107</c:v>
                </c:pt>
                <c:pt idx="175">
                  <c:v>1.2002638391532336</c:v>
                </c:pt>
                <c:pt idx="176">
                  <c:v>1.3856875613788975</c:v>
                </c:pt>
                <c:pt idx="177">
                  <c:v>1.0556345555913118</c:v>
                </c:pt>
                <c:pt idx="178">
                  <c:v>1.1364340400584223</c:v>
                </c:pt>
                <c:pt idx="179">
                  <c:v>0.96941994083581173</c:v>
                </c:pt>
                <c:pt idx="180">
                  <c:v>0.97724341334217246</c:v>
                </c:pt>
                <c:pt idx="181">
                  <c:v>1.1067750977246811</c:v>
                </c:pt>
                <c:pt idx="182">
                  <c:v>1.162495992394929</c:v>
                </c:pt>
                <c:pt idx="183">
                  <c:v>1.2783844652445147</c:v>
                </c:pt>
                <c:pt idx="184">
                  <c:v>1.2106690422124367</c:v>
                </c:pt>
                <c:pt idx="185">
                  <c:v>1.2964266586698361</c:v>
                </c:pt>
                <c:pt idx="186">
                  <c:v>1.415536134177628</c:v>
                </c:pt>
                <c:pt idx="187">
                  <c:v>1.3972291924368263</c:v>
                </c:pt>
                <c:pt idx="188">
                  <c:v>1.2212452715667932</c:v>
                </c:pt>
                <c:pt idx="189">
                  <c:v>1.0623578848336694</c:v>
                </c:pt>
                <c:pt idx="190">
                  <c:v>1.3722155575425516</c:v>
                </c:pt>
                <c:pt idx="191">
                  <c:v>0.96665641277381464</c:v>
                </c:pt>
                <c:pt idx="192">
                  <c:v>1.094382652817196</c:v>
                </c:pt>
                <c:pt idx="193">
                  <c:v>1.4548483700300481</c:v>
                </c:pt>
                <c:pt idx="194">
                  <c:v>1.4777466165527628</c:v>
                </c:pt>
                <c:pt idx="195">
                  <c:v>1.2200849127879896</c:v>
                </c:pt>
                <c:pt idx="196">
                  <c:v>1.2247660305760488</c:v>
                </c:pt>
                <c:pt idx="197">
                  <c:v>1.3468983198971356</c:v>
                </c:pt>
                <c:pt idx="198">
                  <c:v>1.3671412382052448</c:v>
                </c:pt>
                <c:pt idx="199">
                  <c:v>1.2793987996594691</c:v>
                </c:pt>
                <c:pt idx="200">
                  <c:v>1.2468762648209688</c:v>
                </c:pt>
                <c:pt idx="201">
                  <c:v>1.3162376506883917</c:v>
                </c:pt>
                <c:pt idx="202">
                  <c:v>1.1976404709892634</c:v>
                </c:pt>
                <c:pt idx="203">
                  <c:v>1.217124804617149</c:v>
                </c:pt>
                <c:pt idx="204">
                  <c:v>1.0868874197614307</c:v>
                </c:pt>
                <c:pt idx="205">
                  <c:v>1.1072655538273128</c:v>
                </c:pt>
                <c:pt idx="206">
                  <c:v>1.1056984098835489</c:v>
                </c:pt>
                <c:pt idx="207">
                  <c:v>1.2024374742981045</c:v>
                </c:pt>
                <c:pt idx="208">
                  <c:v>1.3327126883342297</c:v>
                </c:pt>
                <c:pt idx="209">
                  <c:v>1.2895518357240654</c:v>
                </c:pt>
                <c:pt idx="210">
                  <c:v>1.1961721518701562</c:v>
                </c:pt>
                <c:pt idx="211">
                  <c:v>1.1304294172843141</c:v>
                </c:pt>
                <c:pt idx="212">
                  <c:v>1.263435249720406</c:v>
                </c:pt>
                <c:pt idx="213">
                  <c:v>2.3535003941131056</c:v>
                </c:pt>
                <c:pt idx="214">
                  <c:v>1.1265937397371053</c:v>
                </c:pt>
                <c:pt idx="215">
                  <c:v>1.513748520753496</c:v>
                </c:pt>
                <c:pt idx="216">
                  <c:v>1.0552656241763025</c:v>
                </c:pt>
                <c:pt idx="217">
                  <c:v>1.3987402420424435</c:v>
                </c:pt>
                <c:pt idx="218">
                  <c:v>1.2944500885495278</c:v>
                </c:pt>
                <c:pt idx="219">
                  <c:v>1.3379556145781271</c:v>
                </c:pt>
                <c:pt idx="220">
                  <c:v>0.93105472734508343</c:v>
                </c:pt>
                <c:pt idx="221">
                  <c:v>1.0372455112740389</c:v>
                </c:pt>
                <c:pt idx="222">
                  <c:v>1.0967600203180632</c:v>
                </c:pt>
                <c:pt idx="223">
                  <c:v>1.1877350907998689</c:v>
                </c:pt>
                <c:pt idx="224">
                  <c:v>1.1698760301624676</c:v>
                </c:pt>
                <c:pt idx="225">
                  <c:v>1.1850040964207986</c:v>
                </c:pt>
                <c:pt idx="226">
                  <c:v>0.95007581539195973</c:v>
                </c:pt>
                <c:pt idx="227">
                  <c:v>1.2411293764944991</c:v>
                </c:pt>
                <c:pt idx="228">
                  <c:v>1.6398035104290092</c:v>
                </c:pt>
                <c:pt idx="229">
                  <c:v>1.0562944143183228</c:v>
                </c:pt>
                <c:pt idx="230">
                  <c:v>1.0015106984059596</c:v>
                </c:pt>
                <c:pt idx="231">
                  <c:v>0.91949218060732396</c:v>
                </c:pt>
                <c:pt idx="232">
                  <c:v>1.1164056604817834</c:v>
                </c:pt>
                <c:pt idx="233">
                  <c:v>1.2128730041902216</c:v>
                </c:pt>
                <c:pt idx="234">
                  <c:v>1.0954559170041698</c:v>
                </c:pt>
                <c:pt idx="235">
                  <c:v>1.2597578009676698</c:v>
                </c:pt>
                <c:pt idx="236">
                  <c:v>1.1327037639188986</c:v>
                </c:pt>
                <c:pt idx="237">
                  <c:v>0.95182201160537849</c:v>
                </c:pt>
                <c:pt idx="238">
                  <c:v>1.3268209141851957</c:v>
                </c:pt>
                <c:pt idx="239">
                  <c:v>1.0791060267106447</c:v>
                </c:pt>
                <c:pt idx="240">
                  <c:v>1.2424241022169358</c:v>
                </c:pt>
                <c:pt idx="241">
                  <c:v>1.3143094148160865</c:v>
                </c:pt>
                <c:pt idx="242">
                  <c:v>1.1098444329238206</c:v>
                </c:pt>
                <c:pt idx="243">
                  <c:v>1.2013938510695972</c:v>
                </c:pt>
                <c:pt idx="244">
                  <c:v>1.2225210148600727</c:v>
                </c:pt>
                <c:pt idx="245">
                  <c:v>1.1149655514767158</c:v>
                </c:pt>
                <c:pt idx="246">
                  <c:v>1.0463019258932695</c:v>
                </c:pt>
                <c:pt idx="247">
                  <c:v>1.0760203722622705</c:v>
                </c:pt>
                <c:pt idx="248">
                  <c:v>1.394557515457334</c:v>
                </c:pt>
                <c:pt idx="249">
                  <c:v>1.0095942842130394</c:v>
                </c:pt>
                <c:pt idx="250">
                  <c:v>1.4179275161942924</c:v>
                </c:pt>
                <c:pt idx="251">
                  <c:v>1.1911272236671571</c:v>
                </c:pt>
                <c:pt idx="252">
                  <c:v>1.4577933440135751</c:v>
                </c:pt>
                <c:pt idx="253">
                  <c:v>1.3879252393576897</c:v>
                </c:pt>
                <c:pt idx="254">
                  <c:v>1.2516324100319196</c:v>
                </c:pt>
                <c:pt idx="255">
                  <c:v>1.7677288051851745</c:v>
                </c:pt>
                <c:pt idx="256">
                  <c:v>1.0878150576749728</c:v>
                </c:pt>
                <c:pt idx="257">
                  <c:v>0.88752973496226661</c:v>
                </c:pt>
                <c:pt idx="258">
                  <c:v>1.8814639995232043</c:v>
                </c:pt>
                <c:pt idx="259">
                  <c:v>1.8029988221989244</c:v>
                </c:pt>
                <c:pt idx="260">
                  <c:v>0.99042138902462207</c:v>
                </c:pt>
                <c:pt idx="261">
                  <c:v>1.1103647446189282</c:v>
                </c:pt>
                <c:pt idx="262">
                  <c:v>1.1596088985208393</c:v>
                </c:pt>
                <c:pt idx="263">
                  <c:v>1.1554664941525794</c:v>
                </c:pt>
                <c:pt idx="264">
                  <c:v>1.0724921093674358</c:v>
                </c:pt>
                <c:pt idx="265">
                  <c:v>1.0319956524098368</c:v>
                </c:pt>
                <c:pt idx="266">
                  <c:v>1.0655783214297256</c:v>
                </c:pt>
                <c:pt idx="267">
                  <c:v>1.0817263617120858</c:v>
                </c:pt>
                <c:pt idx="268">
                  <c:v>1.2929132918889084</c:v>
                </c:pt>
                <c:pt idx="269">
                  <c:v>1.3656432005322447</c:v>
                </c:pt>
                <c:pt idx="270">
                  <c:v>1.1639267896682179</c:v>
                </c:pt>
                <c:pt idx="271">
                  <c:v>1.0390227742291791</c:v>
                </c:pt>
                <c:pt idx="272">
                  <c:v>1.2262827551728461</c:v>
                </c:pt>
                <c:pt idx="273">
                  <c:v>1.2292339220156185</c:v>
                </c:pt>
                <c:pt idx="274">
                  <c:v>1.2640447995345419</c:v>
                </c:pt>
                <c:pt idx="275">
                  <c:v>1.2092340024017842</c:v>
                </c:pt>
                <c:pt idx="276">
                  <c:v>1.5983325182189172</c:v>
                </c:pt>
                <c:pt idx="277">
                  <c:v>1.1824514121609357</c:v>
                </c:pt>
                <c:pt idx="278">
                  <c:v>1.1065904187694084</c:v>
                </c:pt>
                <c:pt idx="279">
                  <c:v>1.0767314654045959</c:v>
                </c:pt>
                <c:pt idx="280">
                  <c:v>1.032833001377113</c:v>
                </c:pt>
                <c:pt idx="281">
                  <c:v>1.423698215440323</c:v>
                </c:pt>
                <c:pt idx="282">
                  <c:v>1.3879409863882555</c:v>
                </c:pt>
                <c:pt idx="283">
                  <c:v>2.0793985040703924</c:v>
                </c:pt>
                <c:pt idx="284">
                  <c:v>1.1723170050861837</c:v>
                </c:pt>
                <c:pt idx="285">
                  <c:v>1.0410368963094203</c:v>
                </c:pt>
                <c:pt idx="286">
                  <c:v>1.0485495992312186</c:v>
                </c:pt>
                <c:pt idx="287">
                  <c:v>1.1604933533431425</c:v>
                </c:pt>
                <c:pt idx="288">
                  <c:v>1.179028584896497</c:v>
                </c:pt>
                <c:pt idx="289">
                  <c:v>1.5031895999826435</c:v>
                </c:pt>
                <c:pt idx="290">
                  <c:v>1.0221210341760576</c:v>
                </c:pt>
                <c:pt idx="291">
                  <c:v>0.96743890083711714</c:v>
                </c:pt>
                <c:pt idx="292">
                  <c:v>1.0100396243845107</c:v>
                </c:pt>
                <c:pt idx="293">
                  <c:v>1.2270567920842701</c:v>
                </c:pt>
                <c:pt idx="294">
                  <c:v>1.5788482912719641</c:v>
                </c:pt>
                <c:pt idx="295">
                  <c:v>0.97246595960075988</c:v>
                </c:pt>
                <c:pt idx="296">
                  <c:v>1.0285589558393269</c:v>
                </c:pt>
                <c:pt idx="297">
                  <c:v>1.07858291486124</c:v>
                </c:pt>
                <c:pt idx="298">
                  <c:v>2.8344812405501019</c:v>
                </c:pt>
                <c:pt idx="299">
                  <c:v>1.3943936069830551</c:v>
                </c:pt>
                <c:pt idx="300">
                  <c:v>0.97016919050975869</c:v>
                </c:pt>
                <c:pt idx="301">
                  <c:v>1.0749266137128644</c:v>
                </c:pt>
                <c:pt idx="302">
                  <c:v>1.2520908113945228</c:v>
                </c:pt>
                <c:pt idx="303">
                  <c:v>1.1833198782089942</c:v>
                </c:pt>
                <c:pt idx="304">
                  <c:v>1.166352257038459</c:v>
                </c:pt>
                <c:pt idx="305">
                  <c:v>1.2897594071178042</c:v>
                </c:pt>
                <c:pt idx="306">
                  <c:v>1.3765208157291671</c:v>
                </c:pt>
                <c:pt idx="307">
                  <c:v>1.2984877202784431</c:v>
                </c:pt>
                <c:pt idx="308">
                  <c:v>1.1942513491264977</c:v>
                </c:pt>
                <c:pt idx="309">
                  <c:v>1.2236319845857417</c:v>
                </c:pt>
                <c:pt idx="310">
                  <c:v>1.0067808434622987</c:v>
                </c:pt>
                <c:pt idx="311">
                  <c:v>1.146499685973223</c:v>
                </c:pt>
                <c:pt idx="312">
                  <c:v>0.95980033391830122</c:v>
                </c:pt>
                <c:pt idx="313">
                  <c:v>1.6889583943849216</c:v>
                </c:pt>
                <c:pt idx="314">
                  <c:v>1.1195550916922903</c:v>
                </c:pt>
                <c:pt idx="315">
                  <c:v>1.4687323473286029</c:v>
                </c:pt>
                <c:pt idx="316">
                  <c:v>1.6837724898975919</c:v>
                </c:pt>
                <c:pt idx="317">
                  <c:v>1.310016012076304</c:v>
                </c:pt>
                <c:pt idx="318">
                  <c:v>1.3071160906611941</c:v>
                </c:pt>
                <c:pt idx="319">
                  <c:v>1.3527437551491488</c:v>
                </c:pt>
                <c:pt idx="320">
                  <c:v>0.86099662981185776</c:v>
                </c:pt>
                <c:pt idx="321">
                  <c:v>1.3498276370444016</c:v>
                </c:pt>
                <c:pt idx="322">
                  <c:v>1.0619462870284362</c:v>
                </c:pt>
                <c:pt idx="323">
                  <c:v>0.92694369431926493</c:v>
                </c:pt>
                <c:pt idx="324">
                  <c:v>1.1695857078824357</c:v>
                </c:pt>
                <c:pt idx="325">
                  <c:v>1.2593517780701593</c:v>
                </c:pt>
                <c:pt idx="326">
                  <c:v>1.0895436521718123</c:v>
                </c:pt>
                <c:pt idx="327">
                  <c:v>0.98785355925785689</c:v>
                </c:pt>
                <c:pt idx="328">
                  <c:v>1.0934497789632265</c:v>
                </c:pt>
                <c:pt idx="329">
                  <c:v>1.5321660771848533</c:v>
                </c:pt>
                <c:pt idx="330">
                  <c:v>1.2833179723502304</c:v>
                </c:pt>
                <c:pt idx="331">
                  <c:v>1.3993329332387654</c:v>
                </c:pt>
                <c:pt idx="332">
                  <c:v>1.1199230946234942</c:v>
                </c:pt>
                <c:pt idx="333">
                  <c:v>1.6929697145762219</c:v>
                </c:pt>
                <c:pt idx="334">
                  <c:v>1.0100890816877706</c:v>
                </c:pt>
                <c:pt idx="335">
                  <c:v>1.1472720419487663</c:v>
                </c:pt>
                <c:pt idx="336">
                  <c:v>1.0247354347520141</c:v>
                </c:pt>
                <c:pt idx="337">
                  <c:v>0.92215374526272842</c:v>
                </c:pt>
                <c:pt idx="338">
                  <c:v>1.0580938746256412</c:v>
                </c:pt>
                <c:pt idx="339">
                  <c:v>0.88950462682238807</c:v>
                </c:pt>
                <c:pt idx="340">
                  <c:v>0.96738798268151993</c:v>
                </c:pt>
                <c:pt idx="341">
                  <c:v>0.70735049902215374</c:v>
                </c:pt>
                <c:pt idx="342">
                  <c:v>1.4111045711028916</c:v>
                </c:pt>
                <c:pt idx="343">
                  <c:v>1.2657474392014756</c:v>
                </c:pt>
                <c:pt idx="344">
                  <c:v>1.837478488069842</c:v>
                </c:pt>
                <c:pt idx="345">
                  <c:v>1.3643656073655315</c:v>
                </c:pt>
                <c:pt idx="346">
                  <c:v>0.89179684652011137</c:v>
                </c:pt>
                <c:pt idx="347">
                  <c:v>1.0444582995412779</c:v>
                </c:pt>
                <c:pt idx="348">
                  <c:v>1.3175324529686274</c:v>
                </c:pt>
                <c:pt idx="349">
                  <c:v>1.8013863975784361</c:v>
                </c:pt>
                <c:pt idx="350">
                  <c:v>1.2510230429297555</c:v>
                </c:pt>
                <c:pt idx="351">
                  <c:v>1.2709653754142662</c:v>
                </c:pt>
                <c:pt idx="352">
                  <c:v>1.4129629825964616</c:v>
                </c:pt>
                <c:pt idx="353">
                  <c:v>1.1337270260174641</c:v>
                </c:pt>
                <c:pt idx="354">
                  <c:v>1.3248294083295509</c:v>
                </c:pt>
                <c:pt idx="355">
                  <c:v>0.98249973366452092</c:v>
                </c:pt>
                <c:pt idx="356">
                  <c:v>1.1509770633796168</c:v>
                </c:pt>
                <c:pt idx="357">
                  <c:v>1.3008440935370589</c:v>
                </c:pt>
                <c:pt idx="358">
                  <c:v>0.99917998853719103</c:v>
                </c:pt>
                <c:pt idx="359">
                  <c:v>1.2085907409077605</c:v>
                </c:pt>
                <c:pt idx="360">
                  <c:v>1.0054414128555706</c:v>
                </c:pt>
                <c:pt idx="361">
                  <c:v>1.2676450096896004</c:v>
                </c:pt>
                <c:pt idx="362">
                  <c:v>0.93482944514292643</c:v>
                </c:pt>
                <c:pt idx="363">
                  <c:v>1.2488079540999963</c:v>
                </c:pt>
                <c:pt idx="364">
                  <c:v>1.3754320592361828</c:v>
                </c:pt>
                <c:pt idx="365">
                  <c:v>1.2697039114220896</c:v>
                </c:pt>
                <c:pt idx="366">
                  <c:v>0.82836677329198238</c:v>
                </c:pt>
                <c:pt idx="367">
                  <c:v>1.0754240447572345</c:v>
                </c:pt>
                <c:pt idx="368">
                  <c:v>0.91322899416884273</c:v>
                </c:pt>
                <c:pt idx="369">
                  <c:v>0.95885354317036231</c:v>
                </c:pt>
                <c:pt idx="370">
                  <c:v>1.1954737969676994</c:v>
                </c:pt>
                <c:pt idx="371">
                  <c:v>1.2372736401385449</c:v>
                </c:pt>
                <c:pt idx="372">
                  <c:v>1.028205499212606</c:v>
                </c:pt>
                <c:pt idx="373">
                  <c:v>1.0399088086380039</c:v>
                </c:pt>
                <c:pt idx="374">
                  <c:v>1.2124409666406359</c:v>
                </c:pt>
                <c:pt idx="375">
                  <c:v>0.90327387725874519</c:v>
                </c:pt>
                <c:pt idx="376">
                  <c:v>1.046746174328703</c:v>
                </c:pt>
                <c:pt idx="377">
                  <c:v>1.468638821042261</c:v>
                </c:pt>
                <c:pt idx="378">
                  <c:v>1.1281139886909732</c:v>
                </c:pt>
                <c:pt idx="379">
                  <c:v>1.0063242867973194</c:v>
                </c:pt>
                <c:pt idx="380">
                  <c:v>0.91986704372408234</c:v>
                </c:pt>
                <c:pt idx="381">
                  <c:v>0.87182836264682517</c:v>
                </c:pt>
                <c:pt idx="382">
                  <c:v>0.9828494206453352</c:v>
                </c:pt>
                <c:pt idx="383">
                  <c:v>0.95604381451916298</c:v>
                </c:pt>
                <c:pt idx="384">
                  <c:v>1.0599700080630428</c:v>
                </c:pt>
                <c:pt idx="385">
                  <c:v>1.004923121492044</c:v>
                </c:pt>
                <c:pt idx="386">
                  <c:v>1.3784666479093912</c:v>
                </c:pt>
                <c:pt idx="387">
                  <c:v>1.3343604617460667</c:v>
                </c:pt>
                <c:pt idx="388">
                  <c:v>1.1251739226831841</c:v>
                </c:pt>
                <c:pt idx="389">
                  <c:v>1.2892585190974741</c:v>
                </c:pt>
                <c:pt idx="390">
                  <c:v>0.94703860172860543</c:v>
                </c:pt>
                <c:pt idx="391">
                  <c:v>0.91526596652850378</c:v>
                </c:pt>
                <c:pt idx="392">
                  <c:v>0.95035871564852914</c:v>
                </c:pt>
                <c:pt idx="393">
                  <c:v>0.9418022914554306</c:v>
                </c:pt>
                <c:pt idx="394">
                  <c:v>0.93170533559697377</c:v>
                </c:pt>
                <c:pt idx="395">
                  <c:v>1.1145361623802399</c:v>
                </c:pt>
                <c:pt idx="396">
                  <c:v>1.1573207325648192</c:v>
                </c:pt>
                <c:pt idx="397">
                  <c:v>1.1100747049788287</c:v>
                </c:pt>
                <c:pt idx="398">
                  <c:v>1.2088906149055259</c:v>
                </c:pt>
                <c:pt idx="399">
                  <c:v>1.0556260947159721</c:v>
                </c:pt>
                <c:pt idx="400">
                  <c:v>1.04549841107793</c:v>
                </c:pt>
                <c:pt idx="401">
                  <c:v>1.1311302756803807</c:v>
                </c:pt>
                <c:pt idx="402">
                  <c:v>1.1558456914376281</c:v>
                </c:pt>
                <c:pt idx="403">
                  <c:v>1.001111463497302</c:v>
                </c:pt>
                <c:pt idx="404">
                  <c:v>1.1370624720107478</c:v>
                </c:pt>
                <c:pt idx="405">
                  <c:v>1.2664026033791336</c:v>
                </c:pt>
                <c:pt idx="406">
                  <c:v>1.770557359799247</c:v>
                </c:pt>
                <c:pt idx="407">
                  <c:v>1.6405139902511756</c:v>
                </c:pt>
                <c:pt idx="408">
                  <c:v>1.2130671261233335</c:v>
                </c:pt>
                <c:pt idx="409">
                  <c:v>1.7074829038777055</c:v>
                </c:pt>
                <c:pt idx="410">
                  <c:v>0.97938926395168313</c:v>
                </c:pt>
                <c:pt idx="411">
                  <c:v>1.4907111688957044</c:v>
                </c:pt>
                <c:pt idx="412">
                  <c:v>0.98194737950921085</c:v>
                </c:pt>
                <c:pt idx="413">
                  <c:v>1.0517453575897477</c:v>
                </c:pt>
                <c:pt idx="414">
                  <c:v>1.1111153433965546</c:v>
                </c:pt>
                <c:pt idx="415">
                  <c:v>1.1877286929711277</c:v>
                </c:pt>
                <c:pt idx="416">
                  <c:v>1.1697069471872137</c:v>
                </c:pt>
                <c:pt idx="417">
                  <c:v>1.2477546520896918</c:v>
                </c:pt>
                <c:pt idx="418">
                  <c:v>0.91815206869499599</c:v>
                </c:pt>
                <c:pt idx="419">
                  <c:v>1.0719772347572363</c:v>
                </c:pt>
                <c:pt idx="420">
                  <c:v>1.143212004667217</c:v>
                </c:pt>
                <c:pt idx="421">
                  <c:v>1.3526188018768923</c:v>
                </c:pt>
                <c:pt idx="422">
                  <c:v>1.1178761563375053</c:v>
                </c:pt>
                <c:pt idx="423">
                  <c:v>1.0944155924929642</c:v>
                </c:pt>
                <c:pt idx="424">
                  <c:v>1.260416777266482</c:v>
                </c:pt>
                <c:pt idx="425">
                  <c:v>1.117329251381427</c:v>
                </c:pt>
                <c:pt idx="426">
                  <c:v>0.95583301763218309</c:v>
                </c:pt>
                <c:pt idx="427">
                  <c:v>1.0689277170763567</c:v>
                </c:pt>
                <c:pt idx="428">
                  <c:v>1.2004285499397858</c:v>
                </c:pt>
                <c:pt idx="429">
                  <c:v>0.95359796033806909</c:v>
                </c:pt>
                <c:pt idx="430">
                  <c:v>0.93546120849574321</c:v>
                </c:pt>
                <c:pt idx="431">
                  <c:v>1.1074125393438059</c:v>
                </c:pt>
                <c:pt idx="432">
                  <c:v>1.174557335697765</c:v>
                </c:pt>
                <c:pt idx="433">
                  <c:v>1.1130106148584358</c:v>
                </c:pt>
                <c:pt idx="434">
                  <c:v>1.562670198922349</c:v>
                </c:pt>
                <c:pt idx="435">
                  <c:v>1.1372582702226837</c:v>
                </c:pt>
                <c:pt idx="436">
                  <c:v>1.4955067443840531</c:v>
                </c:pt>
                <c:pt idx="437">
                  <c:v>1.3347328314810798</c:v>
                </c:pt>
                <c:pt idx="438">
                  <c:v>1.1484858796730681</c:v>
                </c:pt>
                <c:pt idx="439">
                  <c:v>1.3504448822994071</c:v>
                </c:pt>
                <c:pt idx="440">
                  <c:v>1.0557923352952168</c:v>
                </c:pt>
                <c:pt idx="441">
                  <c:v>1.2052722566174914</c:v>
                </c:pt>
                <c:pt idx="442">
                  <c:v>1.2152984851224471</c:v>
                </c:pt>
                <c:pt idx="443">
                  <c:v>1.1023567750509</c:v>
                </c:pt>
                <c:pt idx="444">
                  <c:v>1.105722581363384</c:v>
                </c:pt>
                <c:pt idx="445">
                  <c:v>1.0404592088534184</c:v>
                </c:pt>
                <c:pt idx="446">
                  <c:v>1.2018688794506378</c:v>
                </c:pt>
                <c:pt idx="447">
                  <c:v>1.1456106664566215</c:v>
                </c:pt>
                <c:pt idx="448">
                  <c:v>1.1422485523368786</c:v>
                </c:pt>
                <c:pt idx="449">
                  <c:v>1.1821625170119492</c:v>
                </c:pt>
                <c:pt idx="450">
                  <c:v>1.203299461684874</c:v>
                </c:pt>
                <c:pt idx="451">
                  <c:v>1.2480070412893882</c:v>
                </c:pt>
                <c:pt idx="452">
                  <c:v>1.1097466449018796</c:v>
                </c:pt>
                <c:pt idx="453">
                  <c:v>1.5602629273008968</c:v>
                </c:pt>
                <c:pt idx="454">
                  <c:v>1.3445632871569315</c:v>
                </c:pt>
                <c:pt idx="455">
                  <c:v>1.0126455077605609</c:v>
                </c:pt>
                <c:pt idx="456">
                  <c:v>1.1504507297779007</c:v>
                </c:pt>
                <c:pt idx="457">
                  <c:v>1.9445876178572448</c:v>
                </c:pt>
                <c:pt idx="458">
                  <c:v>1.3198771415012236</c:v>
                </c:pt>
                <c:pt idx="459">
                  <c:v>1.1242988675963885</c:v>
                </c:pt>
                <c:pt idx="460">
                  <c:v>1.2300326408412141</c:v>
                </c:pt>
                <c:pt idx="461">
                  <c:v>1.0633311027019645</c:v>
                </c:pt>
                <c:pt idx="462">
                  <c:v>1.2719390641645647</c:v>
                </c:pt>
                <c:pt idx="463">
                  <c:v>1.1554399285047821</c:v>
                </c:pt>
                <c:pt idx="464">
                  <c:v>1.0746020348584655</c:v>
                </c:pt>
                <c:pt idx="465">
                  <c:v>1.5931525250966272</c:v>
                </c:pt>
                <c:pt idx="466">
                  <c:v>1.1804505195457713</c:v>
                </c:pt>
                <c:pt idx="467">
                  <c:v>2.4249318618014004</c:v>
                </c:pt>
                <c:pt idx="468">
                  <c:v>1.0213301118479123</c:v>
                </c:pt>
                <c:pt idx="469">
                  <c:v>1.0733846044377189</c:v>
                </c:pt>
                <c:pt idx="470">
                  <c:v>1.6008971204747398</c:v>
                </c:pt>
                <c:pt idx="471">
                  <c:v>1.3447872442117925</c:v>
                </c:pt>
                <c:pt idx="472">
                  <c:v>1.0010456262944378</c:v>
                </c:pt>
                <c:pt idx="473">
                  <c:v>1.3146836118206917</c:v>
                </c:pt>
                <c:pt idx="474">
                  <c:v>1.5621758955670972</c:v>
                </c:pt>
                <c:pt idx="475">
                  <c:v>1.1758675729247499</c:v>
                </c:pt>
                <c:pt idx="476">
                  <c:v>1.1533062719143945</c:v>
                </c:pt>
                <c:pt idx="477">
                  <c:v>1.1016213577810317</c:v>
                </c:pt>
                <c:pt idx="478">
                  <c:v>1.318631066437095</c:v>
                </c:pt>
                <c:pt idx="479">
                  <c:v>1.1589176245549413</c:v>
                </c:pt>
                <c:pt idx="480">
                  <c:v>1.0184590220852148</c:v>
                </c:pt>
                <c:pt idx="481">
                  <c:v>0.95492526710978554</c:v>
                </c:pt>
                <c:pt idx="482">
                  <c:v>1.7222295048502083</c:v>
                </c:pt>
                <c:pt idx="483">
                  <c:v>1.1552069647669905</c:v>
                </c:pt>
                <c:pt idx="484">
                  <c:v>1.088121912880432</c:v>
                </c:pt>
                <c:pt idx="485">
                  <c:v>1.5014544118957607</c:v>
                </c:pt>
                <c:pt idx="486">
                  <c:v>1.0362676991104891</c:v>
                </c:pt>
                <c:pt idx="487">
                  <c:v>0.98024118900365609</c:v>
                </c:pt>
                <c:pt idx="488">
                  <c:v>1.0908819808344223</c:v>
                </c:pt>
                <c:pt idx="489">
                  <c:v>1.0658037717577045</c:v>
                </c:pt>
                <c:pt idx="490">
                  <c:v>0.93937527181550196</c:v>
                </c:pt>
                <c:pt idx="491">
                  <c:v>1.1244520249540131</c:v>
                </c:pt>
                <c:pt idx="492">
                  <c:v>1.2938803426434169</c:v>
                </c:pt>
                <c:pt idx="493">
                  <c:v>1.0989438158720006</c:v>
                </c:pt>
                <c:pt idx="494">
                  <c:v>1.1821764544732443</c:v>
                </c:pt>
                <c:pt idx="495">
                  <c:v>1.0005848723176656</c:v>
                </c:pt>
                <c:pt idx="496">
                  <c:v>1.0656951063801612</c:v>
                </c:pt>
                <c:pt idx="497">
                  <c:v>1.2766131503760707</c:v>
                </c:pt>
                <c:pt idx="498">
                  <c:v>1.1587285392494053</c:v>
                </c:pt>
                <c:pt idx="499">
                  <c:v>0.96408836237420148</c:v>
                </c:pt>
                <c:pt idx="500">
                  <c:v>1.4482418349926862</c:v>
                </c:pt>
                <c:pt idx="501">
                  <c:v>1.0796892657101165</c:v>
                </c:pt>
                <c:pt idx="502">
                  <c:v>1.1037688990544336</c:v>
                </c:pt>
                <c:pt idx="503">
                  <c:v>1.4995672105454108</c:v>
                </c:pt>
                <c:pt idx="504">
                  <c:v>1.1519308961892354</c:v>
                </c:pt>
                <c:pt idx="505">
                  <c:v>1.3940528399450856</c:v>
                </c:pt>
                <c:pt idx="506">
                  <c:v>1.4672827322019364</c:v>
                </c:pt>
                <c:pt idx="507">
                  <c:v>2.1323573395833462</c:v>
                </c:pt>
                <c:pt idx="508">
                  <c:v>1.3999039561483604</c:v>
                </c:pt>
                <c:pt idx="509">
                  <c:v>1.0014676586492481</c:v>
                </c:pt>
                <c:pt idx="510">
                  <c:v>1.0019585455521143</c:v>
                </c:pt>
                <c:pt idx="511">
                  <c:v>1.1560329347070606</c:v>
                </c:pt>
                <c:pt idx="512">
                  <c:v>1.1908289120375579</c:v>
                </c:pt>
                <c:pt idx="513">
                  <c:v>0.99435991367584919</c:v>
                </c:pt>
                <c:pt idx="514">
                  <c:v>0.92687797255876214</c:v>
                </c:pt>
                <c:pt idx="515">
                  <c:v>1.0852152305779945</c:v>
                </c:pt>
                <c:pt idx="516">
                  <c:v>1.1938705208803881</c:v>
                </c:pt>
                <c:pt idx="517">
                  <c:v>1.0201926197318152</c:v>
                </c:pt>
                <c:pt idx="518">
                  <c:v>1.1291164351434562</c:v>
                </c:pt>
                <c:pt idx="519">
                  <c:v>1.0832195303336998</c:v>
                </c:pt>
                <c:pt idx="520">
                  <c:v>1.5519916649275778</c:v>
                </c:pt>
                <c:pt idx="521">
                  <c:v>1.7562815746823992</c:v>
                </c:pt>
                <c:pt idx="522">
                  <c:v>0.95647460851996957</c:v>
                </c:pt>
                <c:pt idx="523">
                  <c:v>1.2885287997104939</c:v>
                </c:pt>
                <c:pt idx="524">
                  <c:v>1.702505106587838</c:v>
                </c:pt>
                <c:pt idx="525">
                  <c:v>1.1634026863297131</c:v>
                </c:pt>
                <c:pt idx="526">
                  <c:v>1.4824724342917408</c:v>
                </c:pt>
                <c:pt idx="527">
                  <c:v>1.3987610795841803</c:v>
                </c:pt>
                <c:pt idx="528">
                  <c:v>1.0811627782129489</c:v>
                </c:pt>
                <c:pt idx="529">
                  <c:v>1.0335042824491869</c:v>
                </c:pt>
                <c:pt idx="530">
                  <c:v>0.93504952292540389</c:v>
                </c:pt>
                <c:pt idx="531">
                  <c:v>1.0844203771244549</c:v>
                </c:pt>
                <c:pt idx="532">
                  <c:v>1.0588496156848983</c:v>
                </c:pt>
                <c:pt idx="533">
                  <c:v>1.1635924625738081</c:v>
                </c:pt>
                <c:pt idx="534">
                  <c:v>1.2389369581308827</c:v>
                </c:pt>
                <c:pt idx="535">
                  <c:v>1.0912674616429716</c:v>
                </c:pt>
                <c:pt idx="536">
                  <c:v>1.0946000741794231</c:v>
                </c:pt>
                <c:pt idx="537">
                  <c:v>1.2957603490493648</c:v>
                </c:pt>
                <c:pt idx="538">
                  <c:v>1.2594225469027036</c:v>
                </c:pt>
                <c:pt idx="539">
                  <c:v>0.94856104569497612</c:v>
                </c:pt>
                <c:pt idx="540">
                  <c:v>1.1051938061135587</c:v>
                </c:pt>
                <c:pt idx="541">
                  <c:v>1.0661350716347868</c:v>
                </c:pt>
                <c:pt idx="542">
                  <c:v>1.3293861188755178</c:v>
                </c:pt>
                <c:pt idx="543">
                  <c:v>1.3013109524825448</c:v>
                </c:pt>
                <c:pt idx="544">
                  <c:v>1.0892307468808895</c:v>
                </c:pt>
                <c:pt idx="545">
                  <c:v>1.1786553391541941</c:v>
                </c:pt>
                <c:pt idx="546">
                  <c:v>0.96093922268520537</c:v>
                </c:pt>
                <c:pt idx="547">
                  <c:v>1.1375105817133011</c:v>
                </c:pt>
                <c:pt idx="548">
                  <c:v>1.072221156710162</c:v>
                </c:pt>
                <c:pt idx="549">
                  <c:v>1.0572690532279037</c:v>
                </c:pt>
                <c:pt idx="550">
                  <c:v>1.0621985584605362</c:v>
                </c:pt>
                <c:pt idx="551">
                  <c:v>1.139153332563424</c:v>
                </c:pt>
                <c:pt idx="552">
                  <c:v>1.0509943788507135</c:v>
                </c:pt>
                <c:pt idx="553">
                  <c:v>1.2261592834022599</c:v>
                </c:pt>
                <c:pt idx="554">
                  <c:v>0.98906479544416193</c:v>
                </c:pt>
                <c:pt idx="555">
                  <c:v>1.1190735256519639</c:v>
                </c:pt>
                <c:pt idx="556">
                  <c:v>0.99380958016874443</c:v>
                </c:pt>
                <c:pt idx="557">
                  <c:v>1.191315454129763</c:v>
                </c:pt>
                <c:pt idx="558">
                  <c:v>1.3225156735759487</c:v>
                </c:pt>
                <c:pt idx="559">
                  <c:v>1.2510210774496726</c:v>
                </c:pt>
                <c:pt idx="560">
                  <c:v>1.0349281920543292</c:v>
                </c:pt>
                <c:pt idx="561">
                  <c:v>1.2956751403843056</c:v>
                </c:pt>
                <c:pt idx="562">
                  <c:v>0.97477141983601923</c:v>
                </c:pt>
                <c:pt idx="563">
                  <c:v>0.87770256779174183</c:v>
                </c:pt>
                <c:pt idx="564">
                  <c:v>1.0701723100687128</c:v>
                </c:pt>
                <c:pt idx="565">
                  <c:v>1.055223931326654</c:v>
                </c:pt>
                <c:pt idx="566">
                  <c:v>1.0666033692327563</c:v>
                </c:pt>
                <c:pt idx="567">
                  <c:v>1.5107236395790147</c:v>
                </c:pt>
                <c:pt idx="568">
                  <c:v>1.3007726308857874</c:v>
                </c:pt>
                <c:pt idx="569">
                  <c:v>1.4800265768906187</c:v>
                </c:pt>
                <c:pt idx="570">
                  <c:v>1.0593957504460267</c:v>
                </c:pt>
                <c:pt idx="571">
                  <c:v>1.2655327797610163</c:v>
                </c:pt>
                <c:pt idx="572">
                  <c:v>1.612511215151881</c:v>
                </c:pt>
                <c:pt idx="573">
                  <c:v>1.2863614905334897</c:v>
                </c:pt>
                <c:pt idx="574">
                  <c:v>1.0552892510300145</c:v>
                </c:pt>
                <c:pt idx="575">
                  <c:v>1.2222385654706336</c:v>
                </c:pt>
                <c:pt idx="576">
                  <c:v>1.4944835398374838</c:v>
                </c:pt>
                <c:pt idx="577">
                  <c:v>1.019932256602115</c:v>
                </c:pt>
                <c:pt idx="578">
                  <c:v>1.2492583781701976</c:v>
                </c:pt>
                <c:pt idx="579">
                  <c:v>1.1567230293621511</c:v>
                </c:pt>
                <c:pt idx="580">
                  <c:v>1.360443602691406</c:v>
                </c:pt>
                <c:pt idx="581">
                  <c:v>1.0396152403199306</c:v>
                </c:pt>
                <c:pt idx="582">
                  <c:v>1.0117354658915276</c:v>
                </c:pt>
                <c:pt idx="583">
                  <c:v>0.95686037621626807</c:v>
                </c:pt>
                <c:pt idx="584">
                  <c:v>1.1001722791583832</c:v>
                </c:pt>
                <c:pt idx="585">
                  <c:v>1.0656935510546564</c:v>
                </c:pt>
                <c:pt idx="586">
                  <c:v>1.0557029176686614</c:v>
                </c:pt>
                <c:pt idx="587">
                  <c:v>1.3212253983958164</c:v>
                </c:pt>
                <c:pt idx="588">
                  <c:v>1.1060117716542937</c:v>
                </c:pt>
                <c:pt idx="589">
                  <c:v>1.5751502322649369</c:v>
                </c:pt>
                <c:pt idx="590">
                  <c:v>1.187513391830435</c:v>
                </c:pt>
                <c:pt idx="591">
                  <c:v>1.4340982716211568</c:v>
                </c:pt>
                <c:pt idx="592">
                  <c:v>1.1581578247320226</c:v>
                </c:pt>
                <c:pt idx="593">
                  <c:v>1.2364195711093284</c:v>
                </c:pt>
                <c:pt idx="594">
                  <c:v>1.4389645735746017</c:v>
                </c:pt>
                <c:pt idx="595">
                  <c:v>1.0017184080238402</c:v>
                </c:pt>
                <c:pt idx="596">
                  <c:v>1.220475619311012</c:v>
                </c:pt>
                <c:pt idx="597">
                  <c:v>1.0856333866940826</c:v>
                </c:pt>
                <c:pt idx="598">
                  <c:v>1.6178823876052739</c:v>
                </c:pt>
                <c:pt idx="599">
                  <c:v>1.1954125283934989</c:v>
                </c:pt>
                <c:pt idx="600">
                  <c:v>1.3754331224247756</c:v>
                </c:pt>
                <c:pt idx="601">
                  <c:v>1.1518636532717252</c:v>
                </c:pt>
                <c:pt idx="602">
                  <c:v>1.0871414702080964</c:v>
                </c:pt>
                <c:pt idx="603">
                  <c:v>0.95437444681946504</c:v>
                </c:pt>
                <c:pt idx="604">
                  <c:v>0.94985719469132601</c:v>
                </c:pt>
                <c:pt idx="605">
                  <c:v>0.97445093668787564</c:v>
                </c:pt>
                <c:pt idx="606">
                  <c:v>1.1620673371736752</c:v>
                </c:pt>
                <c:pt idx="607">
                  <c:v>1.2193330554879596</c:v>
                </c:pt>
                <c:pt idx="608">
                  <c:v>1.3421166670897413</c:v>
                </c:pt>
                <c:pt idx="609">
                  <c:v>1.5836521570602509</c:v>
                </c:pt>
                <c:pt idx="610">
                  <c:v>1.410612409080797</c:v>
                </c:pt>
                <c:pt idx="611">
                  <c:v>1.0082836025610677</c:v>
                </c:pt>
                <c:pt idx="612">
                  <c:v>1.007464253233668</c:v>
                </c:pt>
                <c:pt idx="613">
                  <c:v>1.0099493988018806</c:v>
                </c:pt>
                <c:pt idx="614">
                  <c:v>1.0474473017137003</c:v>
                </c:pt>
                <c:pt idx="615">
                  <c:v>1.212833340898221</c:v>
                </c:pt>
                <c:pt idx="616">
                  <c:v>0.89973970123007896</c:v>
                </c:pt>
                <c:pt idx="617">
                  <c:v>1.1164542173667995</c:v>
                </c:pt>
                <c:pt idx="618">
                  <c:v>0.96589313001274724</c:v>
                </c:pt>
                <c:pt idx="619">
                  <c:v>1.1029358218228336</c:v>
                </c:pt>
                <c:pt idx="620">
                  <c:v>1.1895764545056677</c:v>
                </c:pt>
                <c:pt idx="621">
                  <c:v>1.2960043438406068</c:v>
                </c:pt>
                <c:pt idx="622">
                  <c:v>2.1724547327255399</c:v>
                </c:pt>
                <c:pt idx="623">
                  <c:v>0.99217270987189732</c:v>
                </c:pt>
                <c:pt idx="624">
                  <c:v>1.5544189050782522</c:v>
                </c:pt>
                <c:pt idx="625">
                  <c:v>1.4247313867116314</c:v>
                </c:pt>
                <c:pt idx="626">
                  <c:v>1.3600174583245077</c:v>
                </c:pt>
                <c:pt idx="627">
                  <c:v>1.3301969974068459</c:v>
                </c:pt>
                <c:pt idx="628">
                  <c:v>1.1006245418866907</c:v>
                </c:pt>
                <c:pt idx="629">
                  <c:v>0.93414864692063271</c:v>
                </c:pt>
                <c:pt idx="630">
                  <c:v>1.088960128203845</c:v>
                </c:pt>
                <c:pt idx="631">
                  <c:v>1.2689546378843986</c:v>
                </c:pt>
                <c:pt idx="632">
                  <c:v>0.98343431868930342</c:v>
                </c:pt>
                <c:pt idx="633">
                  <c:v>1.3050906373568558</c:v>
                </c:pt>
                <c:pt idx="634">
                  <c:v>1.7551550706329861</c:v>
                </c:pt>
                <c:pt idx="635">
                  <c:v>1.4961814076165829</c:v>
                </c:pt>
                <c:pt idx="636">
                  <c:v>1.1900275101438946</c:v>
                </c:pt>
                <c:pt idx="637">
                  <c:v>0.97940160007141364</c:v>
                </c:pt>
                <c:pt idx="638">
                  <c:v>1.4094208950812572</c:v>
                </c:pt>
                <c:pt idx="639">
                  <c:v>1.1383711527315032</c:v>
                </c:pt>
                <c:pt idx="640">
                  <c:v>1.2065774739457926</c:v>
                </c:pt>
                <c:pt idx="641">
                  <c:v>1.5372391197544715</c:v>
                </c:pt>
                <c:pt idx="642">
                  <c:v>0.96640737884937122</c:v>
                </c:pt>
                <c:pt idx="643">
                  <c:v>1.1024371152430865</c:v>
                </c:pt>
                <c:pt idx="644">
                  <c:v>0.97626935553354399</c:v>
                </c:pt>
                <c:pt idx="645">
                  <c:v>1.2935991167092302</c:v>
                </c:pt>
                <c:pt idx="646">
                  <c:v>1.1138247778674666</c:v>
                </c:pt>
                <c:pt idx="647">
                  <c:v>1.0833128388372735</c:v>
                </c:pt>
                <c:pt idx="648">
                  <c:v>1.0040990758211139</c:v>
                </c:pt>
                <c:pt idx="649">
                  <c:v>1.1813150769440131</c:v>
                </c:pt>
                <c:pt idx="650">
                  <c:v>1.1438803646430109</c:v>
                </c:pt>
                <c:pt idx="651">
                  <c:v>1.5047379020346208</c:v>
                </c:pt>
                <c:pt idx="652">
                  <c:v>1.5864116358163642</c:v>
                </c:pt>
                <c:pt idx="653">
                  <c:v>1.4420775445518028</c:v>
                </c:pt>
                <c:pt idx="654">
                  <c:v>1.21422192687818</c:v>
                </c:pt>
                <c:pt idx="655">
                  <c:v>1.1579953762082267</c:v>
                </c:pt>
                <c:pt idx="656">
                  <c:v>1.1959958691691488</c:v>
                </c:pt>
                <c:pt idx="657">
                  <c:v>1.1413199432465215</c:v>
                </c:pt>
                <c:pt idx="658">
                  <c:v>1.1046398941054971</c:v>
                </c:pt>
                <c:pt idx="659">
                  <c:v>1.2498050096776776</c:v>
                </c:pt>
                <c:pt idx="660">
                  <c:v>1.1177229971720934</c:v>
                </c:pt>
                <c:pt idx="661">
                  <c:v>1.2094700305046751</c:v>
                </c:pt>
                <c:pt idx="662">
                  <c:v>1.0348635326540687</c:v>
                </c:pt>
                <c:pt idx="663">
                  <c:v>1.3281812222498901</c:v>
                </c:pt>
                <c:pt idx="664">
                  <c:v>0.96184502954959794</c:v>
                </c:pt>
                <c:pt idx="665">
                  <c:v>1.2168495560782158</c:v>
                </c:pt>
                <c:pt idx="666">
                  <c:v>1.0629376606757051</c:v>
                </c:pt>
                <c:pt idx="667">
                  <c:v>1.0020802696480913</c:v>
                </c:pt>
                <c:pt idx="668">
                  <c:v>1.0749846190638523</c:v>
                </c:pt>
                <c:pt idx="669">
                  <c:v>1.6119796438033238</c:v>
                </c:pt>
                <c:pt idx="670">
                  <c:v>1.1759350405746802</c:v>
                </c:pt>
                <c:pt idx="671">
                  <c:v>1.0023324716716233</c:v>
                </c:pt>
                <c:pt idx="672">
                  <c:v>1.7434516701043603</c:v>
                </c:pt>
                <c:pt idx="673">
                  <c:v>1.0683257737370069</c:v>
                </c:pt>
                <c:pt idx="674">
                  <c:v>1.2061117045690999</c:v>
                </c:pt>
                <c:pt idx="675">
                  <c:v>1.0126047284258106</c:v>
                </c:pt>
                <c:pt idx="676">
                  <c:v>1.5717571026110173</c:v>
                </c:pt>
                <c:pt idx="677">
                  <c:v>1.0107118700724926</c:v>
                </c:pt>
                <c:pt idx="678">
                  <c:v>1.1552903293428864</c:v>
                </c:pt>
                <c:pt idx="679">
                  <c:v>1.0174442412145657</c:v>
                </c:pt>
                <c:pt idx="680">
                  <c:v>1.5723912046646127</c:v>
                </c:pt>
                <c:pt idx="681">
                  <c:v>1.3837693462509788</c:v>
                </c:pt>
                <c:pt idx="682">
                  <c:v>1.3065904265157804</c:v>
                </c:pt>
                <c:pt idx="683">
                  <c:v>1.2359340657847464</c:v>
                </c:pt>
                <c:pt idx="684">
                  <c:v>1.4162934971176673</c:v>
                </c:pt>
                <c:pt idx="685">
                  <c:v>1.5407443291165317</c:v>
                </c:pt>
                <c:pt idx="686">
                  <c:v>1.3789816603055891</c:v>
                </c:pt>
                <c:pt idx="687">
                  <c:v>1.4949339347517339</c:v>
                </c:pt>
                <c:pt idx="688">
                  <c:v>1.3672143778013479</c:v>
                </c:pt>
                <c:pt idx="689">
                  <c:v>0.99174315028382554</c:v>
                </c:pt>
                <c:pt idx="690">
                  <c:v>0.94573435417423202</c:v>
                </c:pt>
                <c:pt idx="691">
                  <c:v>1.1816162604688099</c:v>
                </c:pt>
                <c:pt idx="692">
                  <c:v>1.1511463624115164</c:v>
                </c:pt>
                <c:pt idx="693">
                  <c:v>1.1046986100314236</c:v>
                </c:pt>
                <c:pt idx="694">
                  <c:v>1.4520722748603829</c:v>
                </c:pt>
                <c:pt idx="695">
                  <c:v>1.5003331374292643</c:v>
                </c:pt>
                <c:pt idx="696">
                  <c:v>1.0548517844995131</c:v>
                </c:pt>
                <c:pt idx="697">
                  <c:v>1.183173592942131</c:v>
                </c:pt>
                <c:pt idx="698">
                  <c:v>1.1197465855910012</c:v>
                </c:pt>
                <c:pt idx="699">
                  <c:v>1.2361534737546336</c:v>
                </c:pt>
                <c:pt idx="700">
                  <c:v>1.0162864379991037</c:v>
                </c:pt>
                <c:pt idx="701">
                  <c:v>1.3123677322490097</c:v>
                </c:pt>
                <c:pt idx="702">
                  <c:v>1.3585094422425801</c:v>
                </c:pt>
                <c:pt idx="703">
                  <c:v>1.0661255589626404</c:v>
                </c:pt>
                <c:pt idx="704">
                  <c:v>0.85987789103738643</c:v>
                </c:pt>
                <c:pt idx="705">
                  <c:v>1.1240100149496104</c:v>
                </c:pt>
                <c:pt idx="706">
                  <c:v>1.2138086993392461</c:v>
                </c:pt>
              </c:numCache>
            </c:numRef>
          </c:xVal>
          <c:yVal>
            <c:numRef>
              <c:f>'4SUdose'!$D$2:$D$708</c:f>
              <c:numCache>
                <c:formatCode>0.00</c:formatCode>
                <c:ptCount val="707"/>
                <c:pt idx="0">
                  <c:v>1.4839799944475758</c:v>
                </c:pt>
                <c:pt idx="1">
                  <c:v>1.2370239076273284</c:v>
                </c:pt>
                <c:pt idx="2">
                  <c:v>1.1674039507911622</c:v>
                </c:pt>
                <c:pt idx="3">
                  <c:v>0.91259849935584758</c:v>
                </c:pt>
                <c:pt idx="4">
                  <c:v>1.1019202800998689</c:v>
                </c:pt>
                <c:pt idx="5">
                  <c:v>0.87294953493067762</c:v>
                </c:pt>
                <c:pt idx="6">
                  <c:v>1.0224275387754098</c:v>
                </c:pt>
                <c:pt idx="7">
                  <c:v>1.2433810689781837</c:v>
                </c:pt>
                <c:pt idx="8">
                  <c:v>0.88480563675508839</c:v>
                </c:pt>
                <c:pt idx="9">
                  <c:v>1.0840031290614183</c:v>
                </c:pt>
                <c:pt idx="10">
                  <c:v>1.1911065157623089</c:v>
                </c:pt>
                <c:pt idx="11">
                  <c:v>1.002629625026586</c:v>
                </c:pt>
                <c:pt idx="12">
                  <c:v>1.0409946894801256</c:v>
                </c:pt>
                <c:pt idx="13">
                  <c:v>1.0990462466381714</c:v>
                </c:pt>
                <c:pt idx="14">
                  <c:v>1.0739707076326712</c:v>
                </c:pt>
                <c:pt idx="15">
                  <c:v>1.0996731170295653</c:v>
                </c:pt>
                <c:pt idx="16">
                  <c:v>1.1917432205645715</c:v>
                </c:pt>
                <c:pt idx="17">
                  <c:v>1.0230253072838043</c:v>
                </c:pt>
                <c:pt idx="18">
                  <c:v>0.99455545310491034</c:v>
                </c:pt>
                <c:pt idx="19">
                  <c:v>0.83921575572428042</c:v>
                </c:pt>
                <c:pt idx="20">
                  <c:v>1.1219519513911664</c:v>
                </c:pt>
                <c:pt idx="21">
                  <c:v>0.94068235708334647</c:v>
                </c:pt>
                <c:pt idx="22">
                  <c:v>1.2134479007743837</c:v>
                </c:pt>
                <c:pt idx="23">
                  <c:v>1.1296423603543204</c:v>
                </c:pt>
                <c:pt idx="24">
                  <c:v>1.1500672938025309</c:v>
                </c:pt>
                <c:pt idx="25">
                  <c:v>1.0626286767783544</c:v>
                </c:pt>
                <c:pt idx="26">
                  <c:v>1.0001080010900836</c:v>
                </c:pt>
                <c:pt idx="27">
                  <c:v>1.2056433565465428</c:v>
                </c:pt>
                <c:pt idx="28">
                  <c:v>1.1519368904418366</c:v>
                </c:pt>
                <c:pt idx="29">
                  <c:v>1.0788561779292598</c:v>
                </c:pt>
                <c:pt idx="30">
                  <c:v>1.0318810971185974</c:v>
                </c:pt>
                <c:pt idx="31">
                  <c:v>1.0339036248473987</c:v>
                </c:pt>
                <c:pt idx="32">
                  <c:v>1.0112622649118201</c:v>
                </c:pt>
                <c:pt idx="33">
                  <c:v>1.421808210923923</c:v>
                </c:pt>
                <c:pt idx="34">
                  <c:v>0.98705127523142089</c:v>
                </c:pt>
                <c:pt idx="35">
                  <c:v>2.0050703690484095</c:v>
                </c:pt>
                <c:pt idx="36">
                  <c:v>1.1446529215483763</c:v>
                </c:pt>
                <c:pt idx="37">
                  <c:v>1.0881749387739426</c:v>
                </c:pt>
                <c:pt idx="38">
                  <c:v>1.0956963587328488</c:v>
                </c:pt>
                <c:pt idx="39">
                  <c:v>1.2879364175961592</c:v>
                </c:pt>
                <c:pt idx="40">
                  <c:v>0.99766496419112061</c:v>
                </c:pt>
                <c:pt idx="41">
                  <c:v>1.0194395073192692</c:v>
                </c:pt>
                <c:pt idx="42">
                  <c:v>0.96460252500023269</c:v>
                </c:pt>
                <c:pt idx="43">
                  <c:v>1.4288733650964542</c:v>
                </c:pt>
                <c:pt idx="44">
                  <c:v>0.94017781909004683</c:v>
                </c:pt>
                <c:pt idx="45">
                  <c:v>1.121046862941544</c:v>
                </c:pt>
                <c:pt idx="46">
                  <c:v>1.5987032931299514</c:v>
                </c:pt>
                <c:pt idx="47">
                  <c:v>0.94169916827016498</c:v>
                </c:pt>
                <c:pt idx="48">
                  <c:v>1.6597299392195903</c:v>
                </c:pt>
                <c:pt idx="49">
                  <c:v>1.1526094015696109</c:v>
                </c:pt>
                <c:pt idx="50">
                  <c:v>1.3961568205208672</c:v>
                </c:pt>
                <c:pt idx="51">
                  <c:v>1.0909681754978036</c:v>
                </c:pt>
                <c:pt idx="52">
                  <c:v>1.0304037287018779</c:v>
                </c:pt>
                <c:pt idx="53">
                  <c:v>0.91949641469602816</c:v>
                </c:pt>
                <c:pt idx="54">
                  <c:v>1.3513642864245599</c:v>
                </c:pt>
                <c:pt idx="55">
                  <c:v>0.98893321870729745</c:v>
                </c:pt>
                <c:pt idx="56">
                  <c:v>1.2282426637249082</c:v>
                </c:pt>
                <c:pt idx="57">
                  <c:v>1.2326608079327817</c:v>
                </c:pt>
                <c:pt idx="58">
                  <c:v>1.0475760147080422</c:v>
                </c:pt>
                <c:pt idx="59">
                  <c:v>1.4128028366872358</c:v>
                </c:pt>
                <c:pt idx="60">
                  <c:v>1.1157546194855976</c:v>
                </c:pt>
                <c:pt idx="61">
                  <c:v>1.6082012577942943</c:v>
                </c:pt>
                <c:pt idx="62">
                  <c:v>1.2909692936389914</c:v>
                </c:pt>
                <c:pt idx="63">
                  <c:v>1.1370849990499097</c:v>
                </c:pt>
                <c:pt idx="64">
                  <c:v>1.0566434711080044</c:v>
                </c:pt>
                <c:pt idx="65">
                  <c:v>0.8385545997932411</c:v>
                </c:pt>
                <c:pt idx="66">
                  <c:v>1.0144382759726454</c:v>
                </c:pt>
                <c:pt idx="67">
                  <c:v>1.0606103220127647</c:v>
                </c:pt>
                <c:pt idx="68">
                  <c:v>0.88754902662517177</c:v>
                </c:pt>
                <c:pt idx="69">
                  <c:v>1.0662046774854037</c:v>
                </c:pt>
                <c:pt idx="70">
                  <c:v>1.1436551184272297</c:v>
                </c:pt>
                <c:pt idx="71">
                  <c:v>1.0112489529291635</c:v>
                </c:pt>
                <c:pt idx="72">
                  <c:v>1.048882463998863</c:v>
                </c:pt>
                <c:pt idx="73">
                  <c:v>1.0721128167308211</c:v>
                </c:pt>
                <c:pt idx="74">
                  <c:v>1.061113107593072</c:v>
                </c:pt>
                <c:pt idx="75">
                  <c:v>0.98506644569225266</c:v>
                </c:pt>
                <c:pt idx="76">
                  <c:v>1.5258611722700397</c:v>
                </c:pt>
                <c:pt idx="77">
                  <c:v>0.98463757767819704</c:v>
                </c:pt>
                <c:pt idx="78">
                  <c:v>1.3677111014929124</c:v>
                </c:pt>
                <c:pt idx="79">
                  <c:v>1.0179814600254526</c:v>
                </c:pt>
                <c:pt idx="80">
                  <c:v>0.84658057153190935</c:v>
                </c:pt>
                <c:pt idx="81">
                  <c:v>0.94538564199681119</c:v>
                </c:pt>
                <c:pt idx="82">
                  <c:v>1.0871117979366034</c:v>
                </c:pt>
                <c:pt idx="83">
                  <c:v>1.0299153362471551</c:v>
                </c:pt>
                <c:pt idx="84">
                  <c:v>1.3852175518429954</c:v>
                </c:pt>
                <c:pt idx="85">
                  <c:v>1.6179504956712074</c:v>
                </c:pt>
                <c:pt idx="86">
                  <c:v>1.0173414351880661</c:v>
                </c:pt>
                <c:pt idx="87">
                  <c:v>1.468445135088714</c:v>
                </c:pt>
                <c:pt idx="88">
                  <c:v>1.0174600643678864</c:v>
                </c:pt>
                <c:pt idx="89">
                  <c:v>1.0995966311580259</c:v>
                </c:pt>
                <c:pt idx="90">
                  <c:v>1.3536495867988056</c:v>
                </c:pt>
                <c:pt idx="91">
                  <c:v>1.0510842476895919</c:v>
                </c:pt>
                <c:pt idx="92">
                  <c:v>1.057019819979987</c:v>
                </c:pt>
                <c:pt idx="93">
                  <c:v>0.82204771079050165</c:v>
                </c:pt>
                <c:pt idx="94">
                  <c:v>1.4230359799318433</c:v>
                </c:pt>
                <c:pt idx="95">
                  <c:v>1.100997947645264</c:v>
                </c:pt>
                <c:pt idx="96">
                  <c:v>1.0742829663555609</c:v>
                </c:pt>
                <c:pt idx="97">
                  <c:v>0.84044136588716833</c:v>
                </c:pt>
                <c:pt idx="98">
                  <c:v>1.1606719544124442</c:v>
                </c:pt>
                <c:pt idx="99">
                  <c:v>0.8713576886097788</c:v>
                </c:pt>
                <c:pt idx="100">
                  <c:v>1.4968701353441649</c:v>
                </c:pt>
                <c:pt idx="101">
                  <c:v>1.134395730645221</c:v>
                </c:pt>
                <c:pt idx="102">
                  <c:v>1.3204375594510123</c:v>
                </c:pt>
                <c:pt idx="103">
                  <c:v>0.98710261182606318</c:v>
                </c:pt>
                <c:pt idx="104">
                  <c:v>1.3964908233871838</c:v>
                </c:pt>
                <c:pt idx="105">
                  <c:v>1.2129020732382647</c:v>
                </c:pt>
                <c:pt idx="106">
                  <c:v>1.3742631889968295</c:v>
                </c:pt>
                <c:pt idx="107">
                  <c:v>1.2300711129027315</c:v>
                </c:pt>
                <c:pt idx="108">
                  <c:v>0.97305815528600459</c:v>
                </c:pt>
                <c:pt idx="109">
                  <c:v>1.1812806042246582</c:v>
                </c:pt>
                <c:pt idx="110">
                  <c:v>1.2617542832335511</c:v>
                </c:pt>
                <c:pt idx="111">
                  <c:v>0.9882374443477806</c:v>
                </c:pt>
                <c:pt idx="112">
                  <c:v>1.4174793597878956</c:v>
                </c:pt>
                <c:pt idx="113">
                  <c:v>0.91651971671803101</c:v>
                </c:pt>
                <c:pt idx="114">
                  <c:v>1.0395301704310749</c:v>
                </c:pt>
                <c:pt idx="115">
                  <c:v>1.0206782630330586</c:v>
                </c:pt>
                <c:pt idx="116">
                  <c:v>1.0155518694461221</c:v>
                </c:pt>
                <c:pt idx="117">
                  <c:v>1.6480944527555106</c:v>
                </c:pt>
                <c:pt idx="118">
                  <c:v>0.82146717170877381</c:v>
                </c:pt>
                <c:pt idx="119">
                  <c:v>1.0953777590710458</c:v>
                </c:pt>
                <c:pt idx="120">
                  <c:v>1.634358134605187</c:v>
                </c:pt>
                <c:pt idx="121">
                  <c:v>1.3551978465679677</c:v>
                </c:pt>
                <c:pt idx="122">
                  <c:v>1.9779694376900117</c:v>
                </c:pt>
                <c:pt idx="123">
                  <c:v>1.2725270893396743</c:v>
                </c:pt>
                <c:pt idx="124">
                  <c:v>1.0051144143995512</c:v>
                </c:pt>
                <c:pt idx="125">
                  <c:v>1.1005545848682434</c:v>
                </c:pt>
                <c:pt idx="126">
                  <c:v>1.2163005375669882</c:v>
                </c:pt>
                <c:pt idx="127">
                  <c:v>1.4761632783155223</c:v>
                </c:pt>
                <c:pt idx="128">
                  <c:v>2.151121829704282</c:v>
                </c:pt>
                <c:pt idx="129">
                  <c:v>1.37469807920868</c:v>
                </c:pt>
                <c:pt idx="130">
                  <c:v>0.94582304794075622</c:v>
                </c:pt>
                <c:pt idx="131">
                  <c:v>1.1007025970244175</c:v>
                </c:pt>
                <c:pt idx="132">
                  <c:v>1.3609978021159288</c:v>
                </c:pt>
                <c:pt idx="133">
                  <c:v>1.1670682245950352</c:v>
                </c:pt>
                <c:pt idx="134">
                  <c:v>1.093328250399934</c:v>
                </c:pt>
                <c:pt idx="135">
                  <c:v>1.4741593447362213</c:v>
                </c:pt>
                <c:pt idx="136">
                  <c:v>1.2351255755657404</c:v>
                </c:pt>
                <c:pt idx="137">
                  <c:v>1.0483261523293075</c:v>
                </c:pt>
                <c:pt idx="138">
                  <c:v>1.0085248606101636</c:v>
                </c:pt>
                <c:pt idx="139">
                  <c:v>1.1475222750184444</c:v>
                </c:pt>
                <c:pt idx="140">
                  <c:v>1.119626584153131</c:v>
                </c:pt>
                <c:pt idx="141">
                  <c:v>0.8147094876472929</c:v>
                </c:pt>
                <c:pt idx="142">
                  <c:v>1.1936411565465319</c:v>
                </c:pt>
                <c:pt idx="143">
                  <c:v>1.3757816385484676</c:v>
                </c:pt>
                <c:pt idx="144">
                  <c:v>1.2485261773152978</c:v>
                </c:pt>
                <c:pt idx="145">
                  <c:v>1.3243551198779948</c:v>
                </c:pt>
                <c:pt idx="146">
                  <c:v>1.118942499440839</c:v>
                </c:pt>
                <c:pt idx="147">
                  <c:v>1.5104723881411708</c:v>
                </c:pt>
                <c:pt idx="148">
                  <c:v>1.5418012136868502</c:v>
                </c:pt>
                <c:pt idx="149">
                  <c:v>1.0475798981259759</c:v>
                </c:pt>
                <c:pt idx="150">
                  <c:v>1.3034183453831627</c:v>
                </c:pt>
                <c:pt idx="151">
                  <c:v>1.1283011170542916</c:v>
                </c:pt>
                <c:pt idx="152">
                  <c:v>1.137545027303309</c:v>
                </c:pt>
                <c:pt idx="153">
                  <c:v>1.2567543396073011</c:v>
                </c:pt>
                <c:pt idx="154">
                  <c:v>1.2984083570750238</c:v>
                </c:pt>
                <c:pt idx="155">
                  <c:v>1.1867558402851501</c:v>
                </c:pt>
                <c:pt idx="156">
                  <c:v>1.3746322602336725</c:v>
                </c:pt>
                <c:pt idx="157">
                  <c:v>1.3082958720704625</c:v>
                </c:pt>
                <c:pt idx="158">
                  <c:v>1.0411490993399342</c:v>
                </c:pt>
                <c:pt idx="159">
                  <c:v>0.94233742674765353</c:v>
                </c:pt>
                <c:pt idx="160">
                  <c:v>1.1977819186864067</c:v>
                </c:pt>
                <c:pt idx="161">
                  <c:v>1.0185548422373822</c:v>
                </c:pt>
                <c:pt idx="162">
                  <c:v>1.2226063829134874</c:v>
                </c:pt>
                <c:pt idx="163">
                  <c:v>1.0558385033662316</c:v>
                </c:pt>
                <c:pt idx="164">
                  <c:v>1.609729878912928</c:v>
                </c:pt>
                <c:pt idx="165">
                  <c:v>1.1469624795586968</c:v>
                </c:pt>
                <c:pt idx="166">
                  <c:v>1.1489074667872976</c:v>
                </c:pt>
                <c:pt idx="167">
                  <c:v>0.88389387118246177</c:v>
                </c:pt>
                <c:pt idx="168">
                  <c:v>1.0585097775471466</c:v>
                </c:pt>
                <c:pt idx="169">
                  <c:v>0.99455463230277552</c:v>
                </c:pt>
                <c:pt idx="170">
                  <c:v>0.74100600858196108</c:v>
                </c:pt>
                <c:pt idx="171">
                  <c:v>0.84385096945695748</c:v>
                </c:pt>
                <c:pt idx="172">
                  <c:v>1.0082409434399218</c:v>
                </c:pt>
                <c:pt idx="173">
                  <c:v>1.173476743059245</c:v>
                </c:pt>
                <c:pt idx="174">
                  <c:v>0.99704510316903527</c:v>
                </c:pt>
                <c:pt idx="175">
                  <c:v>1.4485425365283557</c:v>
                </c:pt>
                <c:pt idx="176">
                  <c:v>1.2932084539231286</c:v>
                </c:pt>
                <c:pt idx="177">
                  <c:v>1.0989059379586632</c:v>
                </c:pt>
                <c:pt idx="178">
                  <c:v>1.0018662988985307</c:v>
                </c:pt>
                <c:pt idx="179">
                  <c:v>1.1947953532156703</c:v>
                </c:pt>
                <c:pt idx="180">
                  <c:v>0.98716185761218622</c:v>
                </c:pt>
                <c:pt idx="181">
                  <c:v>0.90749973145046459</c:v>
                </c:pt>
                <c:pt idx="182">
                  <c:v>1.0823495472344593</c:v>
                </c:pt>
                <c:pt idx="183">
                  <c:v>1.4102831317406028</c:v>
                </c:pt>
                <c:pt idx="184">
                  <c:v>1.3889020470197582</c:v>
                </c:pt>
                <c:pt idx="185">
                  <c:v>1.3885573554485722</c:v>
                </c:pt>
                <c:pt idx="186">
                  <c:v>1.1227554837255176</c:v>
                </c:pt>
                <c:pt idx="187">
                  <c:v>1.2377259270220315</c:v>
                </c:pt>
                <c:pt idx="188">
                  <c:v>0.95133956660509833</c:v>
                </c:pt>
                <c:pt idx="189">
                  <c:v>1.0163270391802437</c:v>
                </c:pt>
                <c:pt idx="190">
                  <c:v>1.2997847287653201</c:v>
                </c:pt>
                <c:pt idx="191">
                  <c:v>1.3371806866112821</c:v>
                </c:pt>
                <c:pt idx="192">
                  <c:v>1.4734400040127094</c:v>
                </c:pt>
                <c:pt idx="193">
                  <c:v>1.5984307869065826</c:v>
                </c:pt>
                <c:pt idx="194">
                  <c:v>0.99571955969141812</c:v>
                </c:pt>
                <c:pt idx="195">
                  <c:v>0.94786172184111239</c:v>
                </c:pt>
                <c:pt idx="196">
                  <c:v>1.2180234891037574</c:v>
                </c:pt>
                <c:pt idx="197">
                  <c:v>1.5168575196953231</c:v>
                </c:pt>
                <c:pt idx="198">
                  <c:v>1.3715136685198979</c:v>
                </c:pt>
                <c:pt idx="199">
                  <c:v>1.3155007451026071</c:v>
                </c:pt>
                <c:pt idx="200">
                  <c:v>1.2031838440818781</c:v>
                </c:pt>
                <c:pt idx="201">
                  <c:v>1.6255443667897034</c:v>
                </c:pt>
                <c:pt idx="202">
                  <c:v>1.4507073073227523</c:v>
                </c:pt>
                <c:pt idx="203">
                  <c:v>1.3300193621077026</c:v>
                </c:pt>
                <c:pt idx="204">
                  <c:v>1.0928926215248038</c:v>
                </c:pt>
                <c:pt idx="205">
                  <c:v>1.1710229346444183</c:v>
                </c:pt>
                <c:pt idx="206">
                  <c:v>1.0501680935732203</c:v>
                </c:pt>
                <c:pt idx="207">
                  <c:v>1.1622240983397099</c:v>
                </c:pt>
                <c:pt idx="208">
                  <c:v>1.4290694179331955</c:v>
                </c:pt>
                <c:pt idx="209">
                  <c:v>1.0750196317249849</c:v>
                </c:pt>
                <c:pt idx="210">
                  <c:v>1.0841013551782845</c:v>
                </c:pt>
                <c:pt idx="211">
                  <c:v>1.4006807132696215</c:v>
                </c:pt>
                <c:pt idx="212">
                  <c:v>1.2963839393009327</c:v>
                </c:pt>
                <c:pt idx="213">
                  <c:v>2.1697094581497303</c:v>
                </c:pt>
                <c:pt idx="214">
                  <c:v>1.3089221796713286</c:v>
                </c:pt>
                <c:pt idx="215">
                  <c:v>1.1386542531164019</c:v>
                </c:pt>
                <c:pt idx="216">
                  <c:v>1.0947113123708012</c:v>
                </c:pt>
                <c:pt idx="217">
                  <c:v>1.3019902178872478</c:v>
                </c:pt>
                <c:pt idx="218">
                  <c:v>1.3873718288621972</c:v>
                </c:pt>
                <c:pt idx="219">
                  <c:v>1.3777848992919668</c:v>
                </c:pt>
                <c:pt idx="220">
                  <c:v>1.0383928210443736</c:v>
                </c:pt>
                <c:pt idx="221">
                  <c:v>0.8822293513386984</c:v>
                </c:pt>
                <c:pt idx="222">
                  <c:v>0.87166012738861898</c:v>
                </c:pt>
                <c:pt idx="223">
                  <c:v>0.9468356078185507</c:v>
                </c:pt>
                <c:pt idx="224">
                  <c:v>1.079243309214541</c:v>
                </c:pt>
                <c:pt idx="225">
                  <c:v>0.88163045775704374</c:v>
                </c:pt>
                <c:pt idx="226">
                  <c:v>1.0623887973010304</c:v>
                </c:pt>
                <c:pt idx="227">
                  <c:v>1.2505719904660988</c:v>
                </c:pt>
                <c:pt idx="228">
                  <c:v>1.3746905568421761</c:v>
                </c:pt>
                <c:pt idx="229">
                  <c:v>1.0636581864599874</c:v>
                </c:pt>
                <c:pt idx="230">
                  <c:v>0.88372456900806684</c:v>
                </c:pt>
                <c:pt idx="231">
                  <c:v>0.99589335891561326</c:v>
                </c:pt>
                <c:pt idx="232">
                  <c:v>0.88478889079265999</c:v>
                </c:pt>
                <c:pt idx="233">
                  <c:v>1.137956797968767</c:v>
                </c:pt>
                <c:pt idx="234">
                  <c:v>1.119120228228397</c:v>
                </c:pt>
                <c:pt idx="235">
                  <c:v>0.98314568592221463</c:v>
                </c:pt>
                <c:pt idx="236">
                  <c:v>1.1537708142185694</c:v>
                </c:pt>
                <c:pt idx="237">
                  <c:v>1.0584033873281473</c:v>
                </c:pt>
                <c:pt idx="238">
                  <c:v>1.2222345634055503</c:v>
                </c:pt>
                <c:pt idx="239">
                  <c:v>1.0154970336038851</c:v>
                </c:pt>
                <c:pt idx="240">
                  <c:v>1.1460157037052481</c:v>
                </c:pt>
                <c:pt idx="241">
                  <c:v>1.3265880357592057</c:v>
                </c:pt>
                <c:pt idx="242">
                  <c:v>1.1670983916778743</c:v>
                </c:pt>
                <c:pt idx="243">
                  <c:v>1.1810769646890955</c:v>
                </c:pt>
                <c:pt idx="244">
                  <c:v>1.1195283780030552</c:v>
                </c:pt>
                <c:pt idx="245">
                  <c:v>1.0784593268748877</c:v>
                </c:pt>
                <c:pt idx="246">
                  <c:v>0.97095809442121717</c:v>
                </c:pt>
                <c:pt idx="247">
                  <c:v>1.0196614448255437</c:v>
                </c:pt>
                <c:pt idx="248">
                  <c:v>1.3648261158905048</c:v>
                </c:pt>
                <c:pt idx="249">
                  <c:v>1.0253992705177255</c:v>
                </c:pt>
                <c:pt idx="250">
                  <c:v>1.2742959793748814</c:v>
                </c:pt>
                <c:pt idx="251">
                  <c:v>1.2172484304741849</c:v>
                </c:pt>
                <c:pt idx="252">
                  <c:v>1.312673360719713</c:v>
                </c:pt>
                <c:pt idx="253">
                  <c:v>1.2899354489466692</c:v>
                </c:pt>
                <c:pt idx="254">
                  <c:v>1.0837680677582482</c:v>
                </c:pt>
                <c:pt idx="255">
                  <c:v>1.5212723661037932</c:v>
                </c:pt>
                <c:pt idx="256">
                  <c:v>0.99033092384607535</c:v>
                </c:pt>
                <c:pt idx="257">
                  <c:v>0.97741904785836597</c:v>
                </c:pt>
                <c:pt idx="258">
                  <c:v>1.7952602773277155</c:v>
                </c:pt>
                <c:pt idx="259">
                  <c:v>1.6142050787214743</c:v>
                </c:pt>
                <c:pt idx="260">
                  <c:v>1.0332792643951223</c:v>
                </c:pt>
                <c:pt idx="261">
                  <c:v>1.1260117903572699</c:v>
                </c:pt>
                <c:pt idx="262">
                  <c:v>1.067509876272279</c:v>
                </c:pt>
                <c:pt idx="263">
                  <c:v>1.0940783779743573</c:v>
                </c:pt>
                <c:pt idx="264">
                  <c:v>0.98037053057890977</c:v>
                </c:pt>
                <c:pt idx="265">
                  <c:v>1.0004137843256731</c:v>
                </c:pt>
                <c:pt idx="266">
                  <c:v>1.1217365170084612</c:v>
                </c:pt>
                <c:pt idx="267">
                  <c:v>1.0039832789288474</c:v>
                </c:pt>
                <c:pt idx="268">
                  <c:v>1.3122564521532412</c:v>
                </c:pt>
                <c:pt idx="269">
                  <c:v>1.3218604076306113</c:v>
                </c:pt>
                <c:pt idx="270">
                  <c:v>1.0382109304395915</c:v>
                </c:pt>
                <c:pt idx="271">
                  <c:v>0.99843748539525823</c:v>
                </c:pt>
                <c:pt idx="272">
                  <c:v>1.0247643535846753</c:v>
                </c:pt>
                <c:pt idx="273">
                  <c:v>1.2096358587380125</c:v>
                </c:pt>
                <c:pt idx="274">
                  <c:v>1.3251756098194571</c:v>
                </c:pt>
                <c:pt idx="275">
                  <c:v>1.1732424430418582</c:v>
                </c:pt>
                <c:pt idx="276">
                  <c:v>1.5987617509654208</c:v>
                </c:pt>
                <c:pt idx="277">
                  <c:v>1.1898551915708466</c:v>
                </c:pt>
                <c:pt idx="278">
                  <c:v>1.0506032088033839</c:v>
                </c:pt>
                <c:pt idx="279">
                  <c:v>1.1332386714858798</c:v>
                </c:pt>
                <c:pt idx="280">
                  <c:v>1.0642788700570509</c:v>
                </c:pt>
                <c:pt idx="281">
                  <c:v>1.3179608514698982</c:v>
                </c:pt>
                <c:pt idx="282">
                  <c:v>1.2214053411741446</c:v>
                </c:pt>
                <c:pt idx="283">
                  <c:v>2.2460556360420258</c:v>
                </c:pt>
                <c:pt idx="284">
                  <c:v>1.0889252510128877</c:v>
                </c:pt>
                <c:pt idx="285">
                  <c:v>1.0293623242156968</c:v>
                </c:pt>
                <c:pt idx="286">
                  <c:v>1.1002747986860117</c:v>
                </c:pt>
                <c:pt idx="287">
                  <c:v>1.1093771930599978</c:v>
                </c:pt>
                <c:pt idx="288">
                  <c:v>1.1359130967627755</c:v>
                </c:pt>
                <c:pt idx="289">
                  <c:v>1.2486484555504469</c:v>
                </c:pt>
                <c:pt idx="290">
                  <c:v>0.91282656193723044</c:v>
                </c:pt>
                <c:pt idx="291">
                  <c:v>1.0620651655615101</c:v>
                </c:pt>
                <c:pt idx="292">
                  <c:v>0.93875702018755691</c:v>
                </c:pt>
                <c:pt idx="293">
                  <c:v>1.0375062083237632</c:v>
                </c:pt>
                <c:pt idx="294">
                  <c:v>1.5998706389141217</c:v>
                </c:pt>
                <c:pt idx="295">
                  <c:v>1.1618256905119138</c:v>
                </c:pt>
                <c:pt idx="296">
                  <c:v>0.96428696714301054</c:v>
                </c:pt>
                <c:pt idx="297">
                  <c:v>1.047950765023044</c:v>
                </c:pt>
                <c:pt idx="298">
                  <c:v>2.2434985036237616</c:v>
                </c:pt>
                <c:pt idx="299">
                  <c:v>1.2093244588878409</c:v>
                </c:pt>
                <c:pt idx="300">
                  <c:v>1.2233524965741469</c:v>
                </c:pt>
                <c:pt idx="301">
                  <c:v>1.0141642631562826</c:v>
                </c:pt>
                <c:pt idx="302">
                  <c:v>1.6853196186685213</c:v>
                </c:pt>
                <c:pt idx="303">
                  <c:v>2.3504931341448012</c:v>
                </c:pt>
                <c:pt idx="304">
                  <c:v>1.1986756377638887</c:v>
                </c:pt>
                <c:pt idx="305">
                  <c:v>1.2881922581032053</c:v>
                </c:pt>
                <c:pt idx="306">
                  <c:v>1.3128062624103378</c:v>
                </c:pt>
                <c:pt idx="307">
                  <c:v>1.417444909996612</c:v>
                </c:pt>
                <c:pt idx="308">
                  <c:v>0.99254351700003873</c:v>
                </c:pt>
                <c:pt idx="309">
                  <c:v>1.1829752493130401</c:v>
                </c:pt>
                <c:pt idx="310">
                  <c:v>0.90725524401588431</c:v>
                </c:pt>
                <c:pt idx="311">
                  <c:v>1.2051440037172931</c:v>
                </c:pt>
                <c:pt idx="312">
                  <c:v>0.89814601678406258</c:v>
                </c:pt>
                <c:pt idx="313">
                  <c:v>1.3588826414039143</c:v>
                </c:pt>
                <c:pt idx="314">
                  <c:v>1.2057143631289455</c:v>
                </c:pt>
                <c:pt idx="315">
                  <c:v>2.1131724126017093</c:v>
                </c:pt>
                <c:pt idx="316">
                  <c:v>1.3092891172406886</c:v>
                </c:pt>
                <c:pt idx="317">
                  <c:v>1.4469332987886205</c:v>
                </c:pt>
                <c:pt idx="318">
                  <c:v>1.100931796483489</c:v>
                </c:pt>
                <c:pt idx="319">
                  <c:v>1.1022296372947606</c:v>
                </c:pt>
                <c:pt idx="320">
                  <c:v>0.93802332001754929</c:v>
                </c:pt>
                <c:pt idx="321">
                  <c:v>1.1375825824787382</c:v>
                </c:pt>
                <c:pt idx="322">
                  <c:v>1.0671873701495773</c:v>
                </c:pt>
                <c:pt idx="323">
                  <c:v>0.98649304570296192</c:v>
                </c:pt>
                <c:pt idx="324">
                  <c:v>1.195590965678508</c:v>
                </c:pt>
                <c:pt idx="325">
                  <c:v>1.0306240844961838</c:v>
                </c:pt>
                <c:pt idx="326">
                  <c:v>0.87989821225017928</c:v>
                </c:pt>
                <c:pt idx="327">
                  <c:v>0.92369970255589318</c:v>
                </c:pt>
                <c:pt idx="328">
                  <c:v>0.93117687449325692</c:v>
                </c:pt>
                <c:pt idx="329">
                  <c:v>1.0188420653186341</c:v>
                </c:pt>
                <c:pt idx="330">
                  <c:v>1.2237552007305137</c:v>
                </c:pt>
                <c:pt idx="331">
                  <c:v>1.2161700983921286</c:v>
                </c:pt>
                <c:pt idx="332">
                  <c:v>1.0527207501422597</c:v>
                </c:pt>
                <c:pt idx="333">
                  <c:v>1.6748382764063405</c:v>
                </c:pt>
                <c:pt idx="334">
                  <c:v>0.98163939725041505</c:v>
                </c:pt>
                <c:pt idx="335">
                  <c:v>1.3286332292479834</c:v>
                </c:pt>
                <c:pt idx="336">
                  <c:v>0.91311970674824294</c:v>
                </c:pt>
                <c:pt idx="337">
                  <c:v>0.92557793591122595</c:v>
                </c:pt>
                <c:pt idx="338">
                  <c:v>0.91567775305493737</c:v>
                </c:pt>
                <c:pt idx="339">
                  <c:v>1.0226056261339282</c:v>
                </c:pt>
                <c:pt idx="340">
                  <c:v>1.0490237710593122</c:v>
                </c:pt>
                <c:pt idx="341">
                  <c:v>0.99403314518996833</c:v>
                </c:pt>
                <c:pt idx="342">
                  <c:v>1.0137688855997791</c:v>
                </c:pt>
                <c:pt idx="343">
                  <c:v>1.0699861086005695</c:v>
                </c:pt>
                <c:pt idx="344">
                  <c:v>1.2249248056078605</c:v>
                </c:pt>
                <c:pt idx="345">
                  <c:v>1.3616123870256276</c:v>
                </c:pt>
                <c:pt idx="346">
                  <c:v>0.95189203267395184</c:v>
                </c:pt>
                <c:pt idx="347">
                  <c:v>0.94807106190459434</c:v>
                </c:pt>
                <c:pt idx="348">
                  <c:v>1.2698037195373755</c:v>
                </c:pt>
                <c:pt idx="349">
                  <c:v>1.1274890922728646</c:v>
                </c:pt>
                <c:pt idx="350">
                  <c:v>1.1313930346241172</c:v>
                </c:pt>
                <c:pt idx="351">
                  <c:v>1.1445495883909291</c:v>
                </c:pt>
                <c:pt idx="352">
                  <c:v>1.1126247655445436</c:v>
                </c:pt>
                <c:pt idx="353">
                  <c:v>1.1537896469908793</c:v>
                </c:pt>
                <c:pt idx="354">
                  <c:v>1.2257648321744465</c:v>
                </c:pt>
                <c:pt idx="355">
                  <c:v>1.2415482569691132</c:v>
                </c:pt>
                <c:pt idx="356">
                  <c:v>1.1732669651954057</c:v>
                </c:pt>
                <c:pt idx="357">
                  <c:v>0.96918121831779924</c:v>
                </c:pt>
                <c:pt idx="358">
                  <c:v>1.0732325910919576</c:v>
                </c:pt>
                <c:pt idx="359">
                  <c:v>0.93483716671733175</c:v>
                </c:pt>
                <c:pt idx="360">
                  <c:v>1.3884899056638929</c:v>
                </c:pt>
                <c:pt idx="361">
                  <c:v>1.0333441140774322</c:v>
                </c:pt>
                <c:pt idx="362">
                  <c:v>0.94461225891971046</c:v>
                </c:pt>
                <c:pt idx="363">
                  <c:v>1.2620017923348548</c:v>
                </c:pt>
                <c:pt idx="364">
                  <c:v>1.7439310598673263</c:v>
                </c:pt>
                <c:pt idx="365">
                  <c:v>0.82390462713892232</c:v>
                </c:pt>
                <c:pt idx="366">
                  <c:v>1.1229693018474309</c:v>
                </c:pt>
                <c:pt idx="367">
                  <c:v>0.92068409019612008</c:v>
                </c:pt>
                <c:pt idx="368">
                  <c:v>0.89562104016123811</c:v>
                </c:pt>
                <c:pt idx="369">
                  <c:v>0.89564173171007988</c:v>
                </c:pt>
                <c:pt idx="370">
                  <c:v>1.3806909409591555</c:v>
                </c:pt>
                <c:pt idx="371">
                  <c:v>1.1541071581287949</c:v>
                </c:pt>
                <c:pt idx="372">
                  <c:v>0.91204058719522374</c:v>
                </c:pt>
                <c:pt idx="373">
                  <c:v>1.0770865717488372</c:v>
                </c:pt>
                <c:pt idx="374">
                  <c:v>1.4005956559294244</c:v>
                </c:pt>
                <c:pt idx="375">
                  <c:v>1.0259626521561833</c:v>
                </c:pt>
                <c:pt idx="376">
                  <c:v>1.0027958173012717</c:v>
                </c:pt>
                <c:pt idx="377">
                  <c:v>1.0628722825366144</c:v>
                </c:pt>
                <c:pt idx="378">
                  <c:v>1.0261378059873447</c:v>
                </c:pt>
                <c:pt idx="379">
                  <c:v>0.93552125664568386</c:v>
                </c:pt>
                <c:pt idx="380">
                  <c:v>1.1877567109887117</c:v>
                </c:pt>
                <c:pt idx="381">
                  <c:v>1.0902888140728748</c:v>
                </c:pt>
                <c:pt idx="382">
                  <c:v>0.92499860254114974</c:v>
                </c:pt>
                <c:pt idx="383">
                  <c:v>1.0573973429592882</c:v>
                </c:pt>
                <c:pt idx="384">
                  <c:v>1.2194289896285304</c:v>
                </c:pt>
                <c:pt idx="385">
                  <c:v>0.86746556760876992</c:v>
                </c:pt>
                <c:pt idx="386">
                  <c:v>1.4582278960295918</c:v>
                </c:pt>
                <c:pt idx="387">
                  <c:v>1.1116500797466939</c:v>
                </c:pt>
                <c:pt idx="388">
                  <c:v>1.1492144955691843</c:v>
                </c:pt>
                <c:pt idx="389">
                  <c:v>1.1939266369755324</c:v>
                </c:pt>
                <c:pt idx="390">
                  <c:v>0.84025512788556633</c:v>
                </c:pt>
                <c:pt idx="391">
                  <c:v>0.95589848080783868</c:v>
                </c:pt>
                <c:pt idx="392">
                  <c:v>0.96752917135924033</c:v>
                </c:pt>
                <c:pt idx="393">
                  <c:v>0.90614763370747964</c:v>
                </c:pt>
                <c:pt idx="394">
                  <c:v>1.1719458826712843</c:v>
                </c:pt>
                <c:pt idx="395">
                  <c:v>1.1144213325972789</c:v>
                </c:pt>
                <c:pt idx="396">
                  <c:v>1.0346274364572046</c:v>
                </c:pt>
                <c:pt idx="397">
                  <c:v>1.0955685371628685</c:v>
                </c:pt>
                <c:pt idx="398">
                  <c:v>1.2399977171623642</c:v>
                </c:pt>
                <c:pt idx="399">
                  <c:v>1.0485235368922416</c:v>
                </c:pt>
                <c:pt idx="400">
                  <c:v>1.2480874446367762</c:v>
                </c:pt>
                <c:pt idx="401">
                  <c:v>1.0372457730948297</c:v>
                </c:pt>
                <c:pt idx="402">
                  <c:v>0.94372841458649903</c:v>
                </c:pt>
                <c:pt idx="403">
                  <c:v>1.0037965482353173</c:v>
                </c:pt>
                <c:pt idx="404">
                  <c:v>0.95391418823703922</c:v>
                </c:pt>
                <c:pt idx="405">
                  <c:v>1.2291763542159482</c:v>
                </c:pt>
                <c:pt idx="406">
                  <c:v>1.643862242449468</c:v>
                </c:pt>
                <c:pt idx="407">
                  <c:v>1.4299087878225585</c:v>
                </c:pt>
                <c:pt idx="408">
                  <c:v>1.2965167997780283</c:v>
                </c:pt>
                <c:pt idx="409">
                  <c:v>1.3464278762585624</c:v>
                </c:pt>
                <c:pt idx="410">
                  <c:v>1.2104808764238955</c:v>
                </c:pt>
                <c:pt idx="411">
                  <c:v>1.2804879261177955</c:v>
                </c:pt>
                <c:pt idx="412">
                  <c:v>1.0317567576367346</c:v>
                </c:pt>
                <c:pt idx="413">
                  <c:v>1.1233717914698345</c:v>
                </c:pt>
                <c:pt idx="414">
                  <c:v>1.0625872210637841</c:v>
                </c:pt>
                <c:pt idx="415">
                  <c:v>1.2952020056662386</c:v>
                </c:pt>
                <c:pt idx="416">
                  <c:v>1.2831733372246286</c:v>
                </c:pt>
                <c:pt idx="417">
                  <c:v>1.2733616915136288</c:v>
                </c:pt>
                <c:pt idx="418">
                  <c:v>0.75862003835268921</c:v>
                </c:pt>
                <c:pt idx="419">
                  <c:v>1.0633776013612948</c:v>
                </c:pt>
                <c:pt idx="420">
                  <c:v>1.0526229577974167</c:v>
                </c:pt>
                <c:pt idx="421">
                  <c:v>1.0464377587145517</c:v>
                </c:pt>
                <c:pt idx="422">
                  <c:v>1.4478911444541236</c:v>
                </c:pt>
                <c:pt idx="423">
                  <c:v>1.0826202624175476</c:v>
                </c:pt>
                <c:pt idx="424">
                  <c:v>1.1070491111101712</c:v>
                </c:pt>
                <c:pt idx="425">
                  <c:v>1.0426964772004328</c:v>
                </c:pt>
                <c:pt idx="426">
                  <c:v>1.0625857892777928</c:v>
                </c:pt>
                <c:pt idx="427">
                  <c:v>1.086523615642897</c:v>
                </c:pt>
                <c:pt idx="428">
                  <c:v>1.0698368011102424</c:v>
                </c:pt>
                <c:pt idx="429">
                  <c:v>0.96248818942503167</c:v>
                </c:pt>
                <c:pt idx="430">
                  <c:v>0.92050666447906027</c:v>
                </c:pt>
                <c:pt idx="431">
                  <c:v>1.0814178126626446</c:v>
                </c:pt>
                <c:pt idx="432">
                  <c:v>1.087323226908109</c:v>
                </c:pt>
                <c:pt idx="433">
                  <c:v>1.0344282560636173</c:v>
                </c:pt>
                <c:pt idx="434">
                  <c:v>1.4571954386159356</c:v>
                </c:pt>
                <c:pt idx="435">
                  <c:v>0.93226967347211975</c:v>
                </c:pt>
                <c:pt idx="436">
                  <c:v>1.4835638325023885</c:v>
                </c:pt>
                <c:pt idx="437">
                  <c:v>1.2917664218063105</c:v>
                </c:pt>
                <c:pt idx="438">
                  <c:v>1.0624860686863986</c:v>
                </c:pt>
                <c:pt idx="439">
                  <c:v>1.3857024782623037</c:v>
                </c:pt>
                <c:pt idx="440">
                  <c:v>0.98759090670129734</c:v>
                </c:pt>
                <c:pt idx="441">
                  <c:v>1.0697282811730551</c:v>
                </c:pt>
                <c:pt idx="442">
                  <c:v>1.0844281364074821</c:v>
                </c:pt>
                <c:pt idx="443">
                  <c:v>1.0037270114796133</c:v>
                </c:pt>
                <c:pt idx="444">
                  <c:v>1.0488775144033473</c:v>
                </c:pt>
                <c:pt idx="445">
                  <c:v>1.0861199946471898</c:v>
                </c:pt>
                <c:pt idx="446">
                  <c:v>1.0777168950891647</c:v>
                </c:pt>
                <c:pt idx="447">
                  <c:v>1.200675167226104</c:v>
                </c:pt>
                <c:pt idx="448">
                  <c:v>1.1667834190584785</c:v>
                </c:pt>
                <c:pt idx="449">
                  <c:v>1.0609506057722975</c:v>
                </c:pt>
                <c:pt idx="450">
                  <c:v>1.1618494124351155</c:v>
                </c:pt>
                <c:pt idx="451">
                  <c:v>1.1438166139140025</c:v>
                </c:pt>
                <c:pt idx="452">
                  <c:v>0.95112631632418243</c:v>
                </c:pt>
                <c:pt idx="453">
                  <c:v>1.4016938810118482</c:v>
                </c:pt>
                <c:pt idx="454">
                  <c:v>1.0297248727339499</c:v>
                </c:pt>
                <c:pt idx="455">
                  <c:v>0.9914262273928619</c:v>
                </c:pt>
                <c:pt idx="456">
                  <c:v>1.111056473274834</c:v>
                </c:pt>
                <c:pt idx="457">
                  <c:v>1.9482371216672385</c:v>
                </c:pt>
                <c:pt idx="458">
                  <c:v>1.0976890932275367</c:v>
                </c:pt>
                <c:pt idx="459">
                  <c:v>1.2352026846531599</c:v>
                </c:pt>
                <c:pt idx="460">
                  <c:v>1.1005504579076486</c:v>
                </c:pt>
                <c:pt idx="461">
                  <c:v>1.1660434304346456</c:v>
                </c:pt>
                <c:pt idx="462">
                  <c:v>1.2357585955910571</c:v>
                </c:pt>
                <c:pt idx="463">
                  <c:v>1.0463376020173745</c:v>
                </c:pt>
                <c:pt idx="464">
                  <c:v>1.0935586449445271</c:v>
                </c:pt>
                <c:pt idx="465">
                  <c:v>1.4914587060690294</c:v>
                </c:pt>
                <c:pt idx="466">
                  <c:v>1.2287235611539904</c:v>
                </c:pt>
                <c:pt idx="467">
                  <c:v>2.4889784840486975</c:v>
                </c:pt>
                <c:pt idx="468">
                  <c:v>1.1710577915960272</c:v>
                </c:pt>
                <c:pt idx="469">
                  <c:v>0.96862038769162984</c:v>
                </c:pt>
                <c:pt idx="470">
                  <c:v>1.2515851223477936</c:v>
                </c:pt>
                <c:pt idx="471">
                  <c:v>1.3028367305933852</c:v>
                </c:pt>
                <c:pt idx="472">
                  <c:v>0.96464338692286422</c:v>
                </c:pt>
                <c:pt idx="473">
                  <c:v>1.260231635533446</c:v>
                </c:pt>
                <c:pt idx="474">
                  <c:v>1.5222396288490438</c:v>
                </c:pt>
                <c:pt idx="475">
                  <c:v>1.1727288662897668</c:v>
                </c:pt>
                <c:pt idx="476">
                  <c:v>1.1302115559829256</c:v>
                </c:pt>
                <c:pt idx="477">
                  <c:v>1.171893987440062</c:v>
                </c:pt>
                <c:pt idx="478">
                  <c:v>1.0185698324945593</c:v>
                </c:pt>
                <c:pt idx="479">
                  <c:v>1.0259598806024242</c:v>
                </c:pt>
                <c:pt idx="480">
                  <c:v>0.88431910492658949</c:v>
                </c:pt>
                <c:pt idx="481">
                  <c:v>1.0288276486898238</c:v>
                </c:pt>
                <c:pt idx="482">
                  <c:v>1.5258574559621865</c:v>
                </c:pt>
                <c:pt idx="483">
                  <c:v>1.2067549643207394</c:v>
                </c:pt>
                <c:pt idx="484">
                  <c:v>1.1660678725422891</c:v>
                </c:pt>
                <c:pt idx="485">
                  <c:v>1.5548150652119732</c:v>
                </c:pt>
                <c:pt idx="486">
                  <c:v>1.0136144905374125</c:v>
                </c:pt>
                <c:pt idx="487">
                  <c:v>0.88478137659888989</c:v>
                </c:pt>
                <c:pt idx="488">
                  <c:v>1.0598698885353959</c:v>
                </c:pt>
                <c:pt idx="489">
                  <c:v>1.1002633974257452</c:v>
                </c:pt>
                <c:pt idx="490">
                  <c:v>0.89636592861128761</c:v>
                </c:pt>
                <c:pt idx="491">
                  <c:v>1.1552068563566376</c:v>
                </c:pt>
                <c:pt idx="492">
                  <c:v>1.3478857877636587</c:v>
                </c:pt>
                <c:pt idx="493">
                  <c:v>0.87109368375156193</c:v>
                </c:pt>
                <c:pt idx="494">
                  <c:v>1.2513886578521241</c:v>
                </c:pt>
                <c:pt idx="495">
                  <c:v>0.93867632820976321</c:v>
                </c:pt>
                <c:pt idx="496">
                  <c:v>1.084878644705191</c:v>
                </c:pt>
                <c:pt idx="497">
                  <c:v>1.1592697219573327</c:v>
                </c:pt>
                <c:pt idx="498">
                  <c:v>1.0875917312407606</c:v>
                </c:pt>
                <c:pt idx="499">
                  <c:v>0.90730864265536137</c:v>
                </c:pt>
                <c:pt idx="500">
                  <c:v>1.3398980371061477</c:v>
                </c:pt>
                <c:pt idx="501">
                  <c:v>1.0389771549256643</c:v>
                </c:pt>
                <c:pt idx="502">
                  <c:v>1.0523942214127977</c:v>
                </c:pt>
                <c:pt idx="503">
                  <c:v>1.4389131989604895</c:v>
                </c:pt>
                <c:pt idx="504">
                  <c:v>1.2137267432758079</c:v>
                </c:pt>
                <c:pt idx="505">
                  <c:v>1.275889901983789</c:v>
                </c:pt>
                <c:pt idx="506">
                  <c:v>1.5145574718056527</c:v>
                </c:pt>
                <c:pt idx="507">
                  <c:v>1.8811006628884432</c:v>
                </c:pt>
                <c:pt idx="508">
                  <c:v>1.5565944416826496</c:v>
                </c:pt>
                <c:pt idx="509">
                  <c:v>1.0344741694806174</c:v>
                </c:pt>
                <c:pt idx="510">
                  <c:v>0.81121651449774479</c:v>
                </c:pt>
                <c:pt idx="511">
                  <c:v>0.92333426819472053</c:v>
                </c:pt>
                <c:pt idx="512">
                  <c:v>1.2280858727838107</c:v>
                </c:pt>
                <c:pt idx="513">
                  <c:v>1.0429275185940423</c:v>
                </c:pt>
                <c:pt idx="514">
                  <c:v>0.98671320185406042</c:v>
                </c:pt>
                <c:pt idx="515">
                  <c:v>1.0898131987902135</c:v>
                </c:pt>
                <c:pt idx="516">
                  <c:v>1.1265565863014653</c:v>
                </c:pt>
                <c:pt idx="517">
                  <c:v>0.92482652733528881</c:v>
                </c:pt>
                <c:pt idx="518">
                  <c:v>1.0752518025055575</c:v>
                </c:pt>
                <c:pt idx="519">
                  <c:v>1.1178594284280781</c:v>
                </c:pt>
                <c:pt idx="520">
                  <c:v>1.252989867665057</c:v>
                </c:pt>
                <c:pt idx="521">
                  <c:v>1.588747243778901</c:v>
                </c:pt>
                <c:pt idx="522">
                  <c:v>1.0431459902117601</c:v>
                </c:pt>
                <c:pt idx="523">
                  <c:v>1.2225308857011208</c:v>
                </c:pt>
                <c:pt idx="524">
                  <c:v>1.4718445792754142</c:v>
                </c:pt>
                <c:pt idx="525">
                  <c:v>1.1540529907099564</c:v>
                </c:pt>
                <c:pt idx="526">
                  <c:v>1.4497958140326914</c:v>
                </c:pt>
                <c:pt idx="527">
                  <c:v>1.2292516934398687</c:v>
                </c:pt>
                <c:pt idx="528">
                  <c:v>1.0392870823723286</c:v>
                </c:pt>
                <c:pt idx="529">
                  <c:v>0.9505830352121406</c:v>
                </c:pt>
                <c:pt idx="530">
                  <c:v>1.0500985518437047</c:v>
                </c:pt>
                <c:pt idx="531">
                  <c:v>1.1061190134038588</c:v>
                </c:pt>
                <c:pt idx="532">
                  <c:v>1.0874080257766541</c:v>
                </c:pt>
                <c:pt idx="533">
                  <c:v>1.0303072073771935</c:v>
                </c:pt>
                <c:pt idx="534">
                  <c:v>1.1363025397638975</c:v>
                </c:pt>
                <c:pt idx="535">
                  <c:v>0.94060873986231108</c:v>
                </c:pt>
                <c:pt idx="536">
                  <c:v>1.1558476731001865</c:v>
                </c:pt>
                <c:pt idx="537">
                  <c:v>1.2051865774564423</c:v>
                </c:pt>
                <c:pt idx="538">
                  <c:v>1.2657276378759215</c:v>
                </c:pt>
                <c:pt idx="539">
                  <c:v>0.99318335782115685</c:v>
                </c:pt>
                <c:pt idx="540">
                  <c:v>1.0303436343729222</c:v>
                </c:pt>
                <c:pt idx="541">
                  <c:v>1.1673150827861136</c:v>
                </c:pt>
                <c:pt idx="542">
                  <c:v>1.2088643030422848</c:v>
                </c:pt>
                <c:pt idx="543">
                  <c:v>1.4895430012508679</c:v>
                </c:pt>
                <c:pt idx="544">
                  <c:v>0.99514634581335937</c:v>
                </c:pt>
                <c:pt idx="545">
                  <c:v>1.1374312185764388</c:v>
                </c:pt>
                <c:pt idx="546">
                  <c:v>0.97541871624860055</c:v>
                </c:pt>
                <c:pt idx="547">
                  <c:v>1.0816361240437204</c:v>
                </c:pt>
                <c:pt idx="548">
                  <c:v>1.1053581650479145</c:v>
                </c:pt>
                <c:pt idx="549">
                  <c:v>1.1638235929204857</c:v>
                </c:pt>
                <c:pt idx="550">
                  <c:v>1.0826113764437741</c:v>
                </c:pt>
                <c:pt idx="551">
                  <c:v>1.125149824589448</c:v>
                </c:pt>
                <c:pt idx="552">
                  <c:v>1.068962225520842</c:v>
                </c:pt>
                <c:pt idx="553">
                  <c:v>1.3007624878033228</c:v>
                </c:pt>
                <c:pt idx="554">
                  <c:v>0.95068858533020761</c:v>
                </c:pt>
                <c:pt idx="555">
                  <c:v>1.0233413996186675</c:v>
                </c:pt>
                <c:pt idx="556">
                  <c:v>1.0165696709892309</c:v>
                </c:pt>
                <c:pt idx="557">
                  <c:v>1.0539911034977658</c:v>
                </c:pt>
                <c:pt idx="558">
                  <c:v>1.2428489472493687</c:v>
                </c:pt>
                <c:pt idx="559">
                  <c:v>1.0977110885854824</c:v>
                </c:pt>
                <c:pt idx="560">
                  <c:v>1.0943832095298751</c:v>
                </c:pt>
                <c:pt idx="561">
                  <c:v>1.1253340063568193</c:v>
                </c:pt>
                <c:pt idx="562">
                  <c:v>1.1519217264172545</c:v>
                </c:pt>
                <c:pt idx="563">
                  <c:v>1.0045609504585655</c:v>
                </c:pt>
                <c:pt idx="564">
                  <c:v>0.98450274718724662</c:v>
                </c:pt>
                <c:pt idx="565">
                  <c:v>1.097097677387866</c:v>
                </c:pt>
                <c:pt idx="566">
                  <c:v>0.92761594073961751</c:v>
                </c:pt>
                <c:pt idx="567">
                  <c:v>1.1266441673374494</c:v>
                </c:pt>
                <c:pt idx="568">
                  <c:v>1.0437887454558454</c:v>
                </c:pt>
                <c:pt idx="569">
                  <c:v>1.3702841584853602</c:v>
                </c:pt>
                <c:pt idx="570">
                  <c:v>1.081542389088014</c:v>
                </c:pt>
                <c:pt idx="571">
                  <c:v>1.1945559311452281</c:v>
                </c:pt>
                <c:pt idx="572">
                  <c:v>1.4323280372104512</c:v>
                </c:pt>
                <c:pt idx="573">
                  <c:v>1.1576139583935101</c:v>
                </c:pt>
                <c:pt idx="574">
                  <c:v>1.115609058059005</c:v>
                </c:pt>
                <c:pt idx="575">
                  <c:v>1.1567947554295164</c:v>
                </c:pt>
                <c:pt idx="576">
                  <c:v>1.4927891075214237</c:v>
                </c:pt>
                <c:pt idx="577">
                  <c:v>0.98708813506268778</c:v>
                </c:pt>
                <c:pt idx="578">
                  <c:v>1.2696712718236549</c:v>
                </c:pt>
                <c:pt idx="579">
                  <c:v>1.2686998457267207</c:v>
                </c:pt>
                <c:pt idx="580">
                  <c:v>1.4816733805334461</c:v>
                </c:pt>
                <c:pt idx="581">
                  <c:v>0.99911728247982912</c:v>
                </c:pt>
                <c:pt idx="582">
                  <c:v>1.0032517364230615</c:v>
                </c:pt>
                <c:pt idx="583">
                  <c:v>0.89487357917686583</c:v>
                </c:pt>
                <c:pt idx="584">
                  <c:v>1.1580761915959497</c:v>
                </c:pt>
                <c:pt idx="585">
                  <c:v>1.1765355997245759</c:v>
                </c:pt>
                <c:pt idx="586">
                  <c:v>1.0805980972370082</c:v>
                </c:pt>
                <c:pt idx="587">
                  <c:v>1.3080047416217788</c:v>
                </c:pt>
                <c:pt idx="588">
                  <c:v>1.0365731949978847</c:v>
                </c:pt>
                <c:pt idx="589">
                  <c:v>1.6405374902647047</c:v>
                </c:pt>
                <c:pt idx="590">
                  <c:v>1.203246273737038</c:v>
                </c:pt>
                <c:pt idx="591">
                  <c:v>1.1866004187906583</c:v>
                </c:pt>
                <c:pt idx="592">
                  <c:v>1.0070976557664626</c:v>
                </c:pt>
                <c:pt idx="593">
                  <c:v>1.0994583300375798</c:v>
                </c:pt>
                <c:pt idx="594">
                  <c:v>1.1691505541752689</c:v>
                </c:pt>
                <c:pt idx="595">
                  <c:v>1.1425230155037915</c:v>
                </c:pt>
                <c:pt idx="596">
                  <c:v>1.0543718460787286</c:v>
                </c:pt>
                <c:pt idx="597">
                  <c:v>1.0869875458220148</c:v>
                </c:pt>
                <c:pt idx="598">
                  <c:v>1.295812071688468</c:v>
                </c:pt>
                <c:pt idx="599">
                  <c:v>1.3009679935829688</c:v>
                </c:pt>
                <c:pt idx="600">
                  <c:v>1.247667228690658</c:v>
                </c:pt>
                <c:pt idx="601">
                  <c:v>0.99485750461461553</c:v>
                </c:pt>
                <c:pt idx="602">
                  <c:v>0.9779006132311957</c:v>
                </c:pt>
                <c:pt idx="603">
                  <c:v>0.99088821193969934</c:v>
                </c:pt>
                <c:pt idx="604">
                  <c:v>1.1395329132470855</c:v>
                </c:pt>
                <c:pt idx="605">
                  <c:v>1.1098032301094134</c:v>
                </c:pt>
                <c:pt idx="606">
                  <c:v>1.2187112698997113</c:v>
                </c:pt>
                <c:pt idx="607">
                  <c:v>1.2570671665188318</c:v>
                </c:pt>
                <c:pt idx="608">
                  <c:v>1.3810148783472058</c:v>
                </c:pt>
                <c:pt idx="609">
                  <c:v>1.4517256627003989</c:v>
                </c:pt>
                <c:pt idx="610">
                  <c:v>1.229843375307816</c:v>
                </c:pt>
                <c:pt idx="611">
                  <c:v>1.0549668346299723</c:v>
                </c:pt>
                <c:pt idx="612">
                  <c:v>1.0637940454076609</c:v>
                </c:pt>
                <c:pt idx="613">
                  <c:v>0.85646750741755151</c:v>
                </c:pt>
                <c:pt idx="614">
                  <c:v>0.99891015010959583</c:v>
                </c:pt>
                <c:pt idx="615">
                  <c:v>1.1073991212867802</c:v>
                </c:pt>
                <c:pt idx="616">
                  <c:v>1.0287517515064386</c:v>
                </c:pt>
                <c:pt idx="617">
                  <c:v>1.0314718063267272</c:v>
                </c:pt>
                <c:pt idx="618">
                  <c:v>0.99524727678901714</c:v>
                </c:pt>
                <c:pt idx="619">
                  <c:v>1.0653581353275325</c:v>
                </c:pt>
                <c:pt idx="620">
                  <c:v>1.1843357770374163</c:v>
                </c:pt>
                <c:pt idx="621">
                  <c:v>1.2279460348970754</c:v>
                </c:pt>
                <c:pt idx="622">
                  <c:v>1.9588755237115212</c:v>
                </c:pt>
                <c:pt idx="623">
                  <c:v>0.91155603275190344</c:v>
                </c:pt>
                <c:pt idx="624">
                  <c:v>1.4376200411131779</c:v>
                </c:pt>
                <c:pt idx="625">
                  <c:v>1.2037378638787992</c:v>
                </c:pt>
                <c:pt idx="626">
                  <c:v>1.3731705499580962</c:v>
                </c:pt>
                <c:pt idx="627">
                  <c:v>1.2442625423551921</c:v>
                </c:pt>
                <c:pt idx="628">
                  <c:v>1.017997197831386</c:v>
                </c:pt>
                <c:pt idx="629">
                  <c:v>1.0251509736828579</c:v>
                </c:pt>
                <c:pt idx="630">
                  <c:v>1.0375580243531302</c:v>
                </c:pt>
                <c:pt idx="631">
                  <c:v>1.4061368999938022</c:v>
                </c:pt>
                <c:pt idx="632">
                  <c:v>1.0304080408296834</c:v>
                </c:pt>
                <c:pt idx="633">
                  <c:v>1.2722296617622542</c:v>
                </c:pt>
                <c:pt idx="634">
                  <c:v>1.5668689498035544</c:v>
                </c:pt>
                <c:pt idx="635">
                  <c:v>1.3681357599891759</c:v>
                </c:pt>
                <c:pt idx="636">
                  <c:v>1.2165710343234093</c:v>
                </c:pt>
                <c:pt idx="637">
                  <c:v>1.0222630596606463</c:v>
                </c:pt>
                <c:pt idx="638">
                  <c:v>1.0006908731787696</c:v>
                </c:pt>
                <c:pt idx="639">
                  <c:v>1.0120538958319036</c:v>
                </c:pt>
                <c:pt idx="640">
                  <c:v>1.2273928427464507</c:v>
                </c:pt>
                <c:pt idx="641">
                  <c:v>1.2814507524689365</c:v>
                </c:pt>
                <c:pt idx="642">
                  <c:v>0.92625110389170151</c:v>
                </c:pt>
                <c:pt idx="643">
                  <c:v>1.0858897161009526</c:v>
                </c:pt>
                <c:pt idx="644">
                  <c:v>1.0150637935648466</c:v>
                </c:pt>
                <c:pt idx="645">
                  <c:v>1.1122322631812098</c:v>
                </c:pt>
                <c:pt idx="646">
                  <c:v>1.1372086662232732</c:v>
                </c:pt>
                <c:pt idx="647">
                  <c:v>1.0110999684290676</c:v>
                </c:pt>
                <c:pt idx="648">
                  <c:v>1.0069987202776716</c:v>
                </c:pt>
                <c:pt idx="649">
                  <c:v>1.2267733571140915</c:v>
                </c:pt>
                <c:pt idx="650">
                  <c:v>1.1508700137897505</c:v>
                </c:pt>
                <c:pt idx="651">
                  <c:v>1.5436154794573256</c:v>
                </c:pt>
                <c:pt idx="652">
                  <c:v>1.9854705548857112</c:v>
                </c:pt>
                <c:pt idx="653">
                  <c:v>1.4841564990316181</c:v>
                </c:pt>
                <c:pt idx="654">
                  <c:v>1.1330322358326614</c:v>
                </c:pt>
                <c:pt idx="655">
                  <c:v>1.1249261161288555</c:v>
                </c:pt>
                <c:pt idx="656">
                  <c:v>1.1468580524179297</c:v>
                </c:pt>
                <c:pt idx="657">
                  <c:v>1.084494890481386</c:v>
                </c:pt>
                <c:pt idx="658">
                  <c:v>1.0193242663320798</c:v>
                </c:pt>
                <c:pt idx="659">
                  <c:v>1.1855497663362367</c:v>
                </c:pt>
                <c:pt idx="660">
                  <c:v>1.077020126613174</c:v>
                </c:pt>
                <c:pt idx="661">
                  <c:v>1.166845869381979</c:v>
                </c:pt>
                <c:pt idx="662">
                  <c:v>1.0319953149020278</c:v>
                </c:pt>
                <c:pt idx="663">
                  <c:v>1.3314771024858141</c:v>
                </c:pt>
                <c:pt idx="664">
                  <c:v>0.91056385467577583</c:v>
                </c:pt>
                <c:pt idx="665">
                  <c:v>1.2052275618803601</c:v>
                </c:pt>
                <c:pt idx="666">
                  <c:v>1.0082864289342091</c:v>
                </c:pt>
                <c:pt idx="667">
                  <c:v>1.0945190230333282</c:v>
                </c:pt>
                <c:pt idx="668">
                  <c:v>1.0190282442533529</c:v>
                </c:pt>
                <c:pt idx="669">
                  <c:v>1.229013796312602</c:v>
                </c:pt>
                <c:pt idx="670">
                  <c:v>1.1622571518895626</c:v>
                </c:pt>
                <c:pt idx="671">
                  <c:v>1.1046374883310373</c:v>
                </c:pt>
                <c:pt idx="672">
                  <c:v>1.6595619381351361</c:v>
                </c:pt>
                <c:pt idx="673">
                  <c:v>1.0920526014688308</c:v>
                </c:pt>
                <c:pt idx="674">
                  <c:v>1.1917824799969081</c:v>
                </c:pt>
                <c:pt idx="675">
                  <c:v>1.0257317891717141</c:v>
                </c:pt>
                <c:pt idx="676">
                  <c:v>1.3551638675367093</c:v>
                </c:pt>
                <c:pt idx="677">
                  <c:v>1.0952379006959745</c:v>
                </c:pt>
                <c:pt idx="678">
                  <c:v>1.1076560737295642</c:v>
                </c:pt>
                <c:pt idx="679">
                  <c:v>1.0231044991171945</c:v>
                </c:pt>
                <c:pt idx="680">
                  <c:v>1.5701776335250932</c:v>
                </c:pt>
                <c:pt idx="681">
                  <c:v>1.4313358409785959</c:v>
                </c:pt>
                <c:pt idx="682">
                  <c:v>1.257196474507654</c:v>
                </c:pt>
                <c:pt idx="683">
                  <c:v>1.1632706910548247</c:v>
                </c:pt>
                <c:pt idx="684">
                  <c:v>1.3482836096722124</c:v>
                </c:pt>
                <c:pt idx="685">
                  <c:v>1.4687187906332686</c:v>
                </c:pt>
                <c:pt idx="686">
                  <c:v>1.3162882221653833</c:v>
                </c:pt>
                <c:pt idx="687">
                  <c:v>1.2461833287174691</c:v>
                </c:pt>
                <c:pt idx="688">
                  <c:v>1.182731212825882</c:v>
                </c:pt>
                <c:pt idx="689">
                  <c:v>1.0099554778134867</c:v>
                </c:pt>
                <c:pt idx="690">
                  <c:v>0.88983341261663407</c:v>
                </c:pt>
                <c:pt idx="691">
                  <c:v>1.0711789692342482</c:v>
                </c:pt>
                <c:pt idx="692">
                  <c:v>1.1904955645207287</c:v>
                </c:pt>
                <c:pt idx="693">
                  <c:v>1.0303448198965828</c:v>
                </c:pt>
                <c:pt idx="694">
                  <c:v>1.2595777460176703</c:v>
                </c:pt>
                <c:pt idx="695">
                  <c:v>1.4525997287720627</c:v>
                </c:pt>
                <c:pt idx="696">
                  <c:v>1.0275013511764415</c:v>
                </c:pt>
                <c:pt idx="697">
                  <c:v>1.1849339488029158</c:v>
                </c:pt>
                <c:pt idx="698">
                  <c:v>1.0844254963543687</c:v>
                </c:pt>
                <c:pt idx="699">
                  <c:v>1.1899504484193935</c:v>
                </c:pt>
                <c:pt idx="700">
                  <c:v>1.0066283747636688</c:v>
                </c:pt>
                <c:pt idx="701">
                  <c:v>1.1036290958781856</c:v>
                </c:pt>
                <c:pt idx="702">
                  <c:v>1.3874025854346597</c:v>
                </c:pt>
                <c:pt idx="703">
                  <c:v>1.1627557011299547</c:v>
                </c:pt>
                <c:pt idx="704">
                  <c:v>1.0893150029335299</c:v>
                </c:pt>
                <c:pt idx="705">
                  <c:v>1.0780663010950542</c:v>
                </c:pt>
                <c:pt idx="706">
                  <c:v>1.2349958710129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C14-48CA-A57F-BFBF601079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6294832"/>
        <c:axId val="1275021776"/>
      </c:scatterChart>
      <c:valAx>
        <c:axId val="1276294832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4SU40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5021776"/>
        <c:crosses val="autoZero"/>
        <c:crossBetween val="midCat"/>
      </c:valAx>
      <c:valAx>
        <c:axId val="1275021776"/>
        <c:scaling>
          <c:orientation val="minMax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4SU1.5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62948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b="1" i="0" baseline="0">
                <a:effectLst/>
              </a:rPr>
              <a:t>Correlation Coefficiency = 0.63 </a:t>
            </a:r>
            <a:endParaRPr lang="en-US" sz="10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4SUdose'!$F$1</c:f>
              <c:strCache>
                <c:ptCount val="1"/>
                <c:pt idx="0">
                  <c:v>fold change: 1A/1B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4944116360454943"/>
                  <c:y val="7.0358705161854815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4SUdose'!$B$2:$B$708</c:f>
              <c:numCache>
                <c:formatCode>0.00</c:formatCode>
                <c:ptCount val="707"/>
                <c:pt idx="0">
                  <c:v>0.73804126180437857</c:v>
                </c:pt>
                <c:pt idx="1">
                  <c:v>1.4853137674126557</c:v>
                </c:pt>
                <c:pt idx="2">
                  <c:v>1.1375647434098501</c:v>
                </c:pt>
                <c:pt idx="3">
                  <c:v>1.0448099379878024</c:v>
                </c:pt>
                <c:pt idx="4">
                  <c:v>1.2427326047771849</c:v>
                </c:pt>
                <c:pt idx="5">
                  <c:v>1.0678836628303374</c:v>
                </c:pt>
                <c:pt idx="6">
                  <c:v>1.1178217207481196</c:v>
                </c:pt>
                <c:pt idx="7">
                  <c:v>1.5614528273206323</c:v>
                </c:pt>
                <c:pt idx="8">
                  <c:v>1.075298092961309</c:v>
                </c:pt>
                <c:pt idx="9">
                  <c:v>1.2135650687932136</c:v>
                </c:pt>
                <c:pt idx="10">
                  <c:v>1.313106763244132</c:v>
                </c:pt>
                <c:pt idx="11">
                  <c:v>1.2355988017464556</c:v>
                </c:pt>
                <c:pt idx="12">
                  <c:v>1.1751334883943474</c:v>
                </c:pt>
                <c:pt idx="13">
                  <c:v>1.1303842700310094</c:v>
                </c:pt>
                <c:pt idx="14">
                  <c:v>1.0159386273794757</c:v>
                </c:pt>
                <c:pt idx="15">
                  <c:v>1.1515427631957582</c:v>
                </c:pt>
                <c:pt idx="16">
                  <c:v>1.4802385394219573</c:v>
                </c:pt>
                <c:pt idx="17">
                  <c:v>0.94496786774409736</c:v>
                </c:pt>
                <c:pt idx="18">
                  <c:v>1.1214316098239792</c:v>
                </c:pt>
                <c:pt idx="19">
                  <c:v>1.0293052146363206</c:v>
                </c:pt>
                <c:pt idx="20">
                  <c:v>1.1621299044418305</c:v>
                </c:pt>
                <c:pt idx="21">
                  <c:v>1.1597943294341044</c:v>
                </c:pt>
                <c:pt idx="22">
                  <c:v>1.4205923047527074</c:v>
                </c:pt>
                <c:pt idx="23">
                  <c:v>1.0479145636169165</c:v>
                </c:pt>
                <c:pt idx="24">
                  <c:v>1.230951402932255</c:v>
                </c:pt>
                <c:pt idx="25">
                  <c:v>1.1868682365915695</c:v>
                </c:pt>
                <c:pt idx="26">
                  <c:v>1.0364371856313785</c:v>
                </c:pt>
                <c:pt idx="27">
                  <c:v>1.2545845073908062</c:v>
                </c:pt>
                <c:pt idx="28">
                  <c:v>0.98536642194157009</c:v>
                </c:pt>
                <c:pt idx="29">
                  <c:v>1.1561674876955848</c:v>
                </c:pt>
                <c:pt idx="30">
                  <c:v>1.0703357167117828</c:v>
                </c:pt>
                <c:pt idx="31">
                  <c:v>0.96048232635132724</c:v>
                </c:pt>
                <c:pt idx="32">
                  <c:v>1.0453430493962454</c:v>
                </c:pt>
                <c:pt idx="33">
                  <c:v>1.7515010484865319</c:v>
                </c:pt>
                <c:pt idx="34">
                  <c:v>1.0948178437618652</c:v>
                </c:pt>
                <c:pt idx="35">
                  <c:v>2.3894267043401136</c:v>
                </c:pt>
                <c:pt idx="36">
                  <c:v>1.3159266398314373</c:v>
                </c:pt>
                <c:pt idx="37">
                  <c:v>1.283383477931842</c:v>
                </c:pt>
                <c:pt idx="38">
                  <c:v>1.1445509926772179</c:v>
                </c:pt>
                <c:pt idx="39">
                  <c:v>1.3839672282712354</c:v>
                </c:pt>
                <c:pt idx="40">
                  <c:v>1.0741147633199231</c:v>
                </c:pt>
                <c:pt idx="41">
                  <c:v>1.0735580027449434</c:v>
                </c:pt>
                <c:pt idx="42">
                  <c:v>1.0786344204512595</c:v>
                </c:pt>
                <c:pt idx="43">
                  <c:v>1.311655639175334</c:v>
                </c:pt>
                <c:pt idx="44">
                  <c:v>1.0764370243356474</c:v>
                </c:pt>
                <c:pt idx="45">
                  <c:v>1.0235456702697308</c:v>
                </c:pt>
                <c:pt idx="46">
                  <c:v>1.5751573817561242</c:v>
                </c:pt>
                <c:pt idx="47">
                  <c:v>1.0569835772674143</c:v>
                </c:pt>
                <c:pt idx="48">
                  <c:v>2.5703686647116055</c:v>
                </c:pt>
                <c:pt idx="49">
                  <c:v>1.239637168936027</c:v>
                </c:pt>
                <c:pt idx="50">
                  <c:v>1.7053095168706902</c:v>
                </c:pt>
                <c:pt idx="51">
                  <c:v>1.0672962841557003</c:v>
                </c:pt>
                <c:pt idx="52">
                  <c:v>1.1918367675738823</c:v>
                </c:pt>
                <c:pt idx="53">
                  <c:v>0.91255771245994743</c:v>
                </c:pt>
                <c:pt idx="54">
                  <c:v>1.5803747405450164</c:v>
                </c:pt>
                <c:pt idx="55">
                  <c:v>1.2828029291062666</c:v>
                </c:pt>
                <c:pt idx="56">
                  <c:v>1.3699126544223155</c:v>
                </c:pt>
                <c:pt idx="57">
                  <c:v>1.3471420053994614</c:v>
                </c:pt>
                <c:pt idx="58">
                  <c:v>0.99271185439070397</c:v>
                </c:pt>
                <c:pt idx="59">
                  <c:v>1.1796352598006323</c:v>
                </c:pt>
                <c:pt idx="60">
                  <c:v>1.1713089305850335</c:v>
                </c:pt>
                <c:pt idx="61">
                  <c:v>1.6870027357193198</c:v>
                </c:pt>
                <c:pt idx="62">
                  <c:v>1.1578306738858126</c:v>
                </c:pt>
                <c:pt idx="63">
                  <c:v>1.1328429409601102</c:v>
                </c:pt>
                <c:pt idx="64">
                  <c:v>0.97100319878077879</c:v>
                </c:pt>
                <c:pt idx="65">
                  <c:v>0.89873750777351091</c:v>
                </c:pt>
                <c:pt idx="66">
                  <c:v>1.0044377237420772</c:v>
                </c:pt>
                <c:pt idx="67">
                  <c:v>1.2285282467622887</c:v>
                </c:pt>
                <c:pt idx="68">
                  <c:v>1.1225457328628612</c:v>
                </c:pt>
                <c:pt idx="69">
                  <c:v>1.2585826052618589</c:v>
                </c:pt>
                <c:pt idx="70">
                  <c:v>0.98208536613746078</c:v>
                </c:pt>
                <c:pt idx="71">
                  <c:v>0.86892091529873439</c:v>
                </c:pt>
                <c:pt idx="72">
                  <c:v>1.0755620937774841</c:v>
                </c:pt>
                <c:pt idx="73">
                  <c:v>1.3417108685736927</c:v>
                </c:pt>
                <c:pt idx="74">
                  <c:v>1.0788688255274537</c:v>
                </c:pt>
                <c:pt idx="75">
                  <c:v>1.0198637298451552</c:v>
                </c:pt>
                <c:pt idx="76">
                  <c:v>1.3291204066340678</c:v>
                </c:pt>
                <c:pt idx="77">
                  <c:v>1.2335999147972077</c:v>
                </c:pt>
                <c:pt idx="78">
                  <c:v>1.2162243080346327</c:v>
                </c:pt>
                <c:pt idx="79">
                  <c:v>0.85295366807404172</c:v>
                </c:pt>
                <c:pt idx="80">
                  <c:v>0.87943650980082888</c:v>
                </c:pt>
                <c:pt idx="81">
                  <c:v>1.0562517213814044</c:v>
                </c:pt>
                <c:pt idx="82">
                  <c:v>1.3410239183359083</c:v>
                </c:pt>
                <c:pt idx="83">
                  <c:v>1.1039678212666191</c:v>
                </c:pt>
                <c:pt idx="84">
                  <c:v>1.1880304324868298</c:v>
                </c:pt>
                <c:pt idx="85">
                  <c:v>1.7396753036829002</c:v>
                </c:pt>
                <c:pt idx="86">
                  <c:v>1.1169171054483671</c:v>
                </c:pt>
                <c:pt idx="87">
                  <c:v>1.4329364543987804</c:v>
                </c:pt>
                <c:pt idx="88">
                  <c:v>1.1432653089318654</c:v>
                </c:pt>
                <c:pt idx="89">
                  <c:v>1.197092579723988</c:v>
                </c:pt>
                <c:pt idx="90">
                  <c:v>1.141404357408675</c:v>
                </c:pt>
                <c:pt idx="91">
                  <c:v>1.2048376326559456</c:v>
                </c:pt>
                <c:pt idx="92">
                  <c:v>1.0287846991114269</c:v>
                </c:pt>
                <c:pt idx="93">
                  <c:v>0.97190278638289329</c:v>
                </c:pt>
                <c:pt idx="94">
                  <c:v>1.2643624921334171</c:v>
                </c:pt>
                <c:pt idx="95">
                  <c:v>1.4495937387783748</c:v>
                </c:pt>
                <c:pt idx="96">
                  <c:v>1.1778088920875986</c:v>
                </c:pt>
                <c:pt idx="97">
                  <c:v>1.0733869686145441</c:v>
                </c:pt>
                <c:pt idx="98">
                  <c:v>1.2559658948068675</c:v>
                </c:pt>
                <c:pt idx="99">
                  <c:v>0.8033831244367764</c:v>
                </c:pt>
                <c:pt idx="100">
                  <c:v>1.703872387431252</c:v>
                </c:pt>
                <c:pt idx="101">
                  <c:v>1.44494798577839</c:v>
                </c:pt>
                <c:pt idx="102">
                  <c:v>1.0735445099500254</c:v>
                </c:pt>
                <c:pt idx="103">
                  <c:v>1.220626889144738</c:v>
                </c:pt>
                <c:pt idx="104">
                  <c:v>1.5589094082986008</c:v>
                </c:pt>
                <c:pt idx="105">
                  <c:v>1.2721516142214957</c:v>
                </c:pt>
                <c:pt idx="106">
                  <c:v>1.3874823089261468</c:v>
                </c:pt>
                <c:pt idx="107">
                  <c:v>1.3538443682743015</c:v>
                </c:pt>
                <c:pt idx="108">
                  <c:v>0.88908102221388396</c:v>
                </c:pt>
                <c:pt idx="109">
                  <c:v>1.0362924386131669</c:v>
                </c:pt>
                <c:pt idx="110">
                  <c:v>1.2232641294203928</c:v>
                </c:pt>
                <c:pt idx="111">
                  <c:v>1.2301186543927389</c:v>
                </c:pt>
                <c:pt idx="112">
                  <c:v>0.90362328895536115</c:v>
                </c:pt>
                <c:pt idx="113">
                  <c:v>0.93780637058383942</c:v>
                </c:pt>
                <c:pt idx="114">
                  <c:v>1.1342532926148021</c:v>
                </c:pt>
                <c:pt idx="115">
                  <c:v>0.91249121417226831</c:v>
                </c:pt>
                <c:pt idx="116">
                  <c:v>0.93897712078280993</c:v>
                </c:pt>
                <c:pt idx="117">
                  <c:v>1.5954399903090366</c:v>
                </c:pt>
                <c:pt idx="118">
                  <c:v>0.98378222094667145</c:v>
                </c:pt>
                <c:pt idx="119">
                  <c:v>1.9699391770244732</c:v>
                </c:pt>
                <c:pt idx="120">
                  <c:v>1.0859507309474357</c:v>
                </c:pt>
                <c:pt idx="121">
                  <c:v>1.4776240996043613</c:v>
                </c:pt>
                <c:pt idx="122">
                  <c:v>1.563659376613336</c:v>
                </c:pt>
                <c:pt idx="123">
                  <c:v>1.2180746475406143</c:v>
                </c:pt>
                <c:pt idx="124">
                  <c:v>1.1309252959967819</c:v>
                </c:pt>
                <c:pt idx="125">
                  <c:v>1.3388757790282568</c:v>
                </c:pt>
                <c:pt idx="126">
                  <c:v>1.4350556017853089</c:v>
                </c:pt>
                <c:pt idx="127">
                  <c:v>1.0240995847496728</c:v>
                </c:pt>
                <c:pt idx="128">
                  <c:v>1.4485930151687549</c:v>
                </c:pt>
                <c:pt idx="129">
                  <c:v>0.9041321347172111</c:v>
                </c:pt>
                <c:pt idx="130">
                  <c:v>1.6278685424021904</c:v>
                </c:pt>
                <c:pt idx="131">
                  <c:v>1.1589461121620415</c:v>
                </c:pt>
                <c:pt idx="132">
                  <c:v>1.4143339456542523</c:v>
                </c:pt>
                <c:pt idx="133">
                  <c:v>1.4136629954296847</c:v>
                </c:pt>
                <c:pt idx="134">
                  <c:v>1.2720887845414806</c:v>
                </c:pt>
                <c:pt idx="135">
                  <c:v>1.1268681884529783</c:v>
                </c:pt>
                <c:pt idx="136">
                  <c:v>1.360726014091673</c:v>
                </c:pt>
                <c:pt idx="137">
                  <c:v>1.1322397232160371</c:v>
                </c:pt>
                <c:pt idx="138">
                  <c:v>1.1017662419168657</c:v>
                </c:pt>
                <c:pt idx="139">
                  <c:v>1.3607941614885137</c:v>
                </c:pt>
                <c:pt idx="140">
                  <c:v>1.1445572410614555</c:v>
                </c:pt>
                <c:pt idx="141">
                  <c:v>1.0277862907966004</c:v>
                </c:pt>
                <c:pt idx="142">
                  <c:v>1.349853095065604</c:v>
                </c:pt>
                <c:pt idx="143">
                  <c:v>1.8792940880936899</c:v>
                </c:pt>
                <c:pt idx="144">
                  <c:v>1.1149948402744823</c:v>
                </c:pt>
                <c:pt idx="145">
                  <c:v>1.390941684403171</c:v>
                </c:pt>
                <c:pt idx="146">
                  <c:v>0.96804506789994293</c:v>
                </c:pt>
                <c:pt idx="147">
                  <c:v>1.9540874267973156</c:v>
                </c:pt>
                <c:pt idx="148">
                  <c:v>1.6546807718887884</c:v>
                </c:pt>
                <c:pt idx="149">
                  <c:v>1.0492723338012815</c:v>
                </c:pt>
                <c:pt idx="150">
                  <c:v>1.6957418990788018</c:v>
                </c:pt>
                <c:pt idx="151">
                  <c:v>1.2783988069338881</c:v>
                </c:pt>
                <c:pt idx="152">
                  <c:v>1.1081771721862648</c:v>
                </c:pt>
                <c:pt idx="153">
                  <c:v>0.94622005372512463</c:v>
                </c:pt>
                <c:pt idx="154">
                  <c:v>1.5121344091656701</c:v>
                </c:pt>
                <c:pt idx="155">
                  <c:v>0.98809558166835021</c:v>
                </c:pt>
                <c:pt idx="156">
                  <c:v>1.2409459774025364</c:v>
                </c:pt>
                <c:pt idx="157">
                  <c:v>1.1132500423791374</c:v>
                </c:pt>
                <c:pt idx="158">
                  <c:v>0.99019354225100142</c:v>
                </c:pt>
                <c:pt idx="159">
                  <c:v>0.92920029498646994</c:v>
                </c:pt>
                <c:pt idx="160">
                  <c:v>1.2713851392489504</c:v>
                </c:pt>
                <c:pt idx="161">
                  <c:v>1.0369036600170234</c:v>
                </c:pt>
                <c:pt idx="162">
                  <c:v>1.4090283932326497</c:v>
                </c:pt>
                <c:pt idx="163">
                  <c:v>1.094838684049336</c:v>
                </c:pt>
                <c:pt idx="164">
                  <c:v>1.5774131191011231</c:v>
                </c:pt>
                <c:pt idx="165">
                  <c:v>1.2465269238027796</c:v>
                </c:pt>
                <c:pt idx="166">
                  <c:v>0.98705411020180245</c:v>
                </c:pt>
                <c:pt idx="167">
                  <c:v>1.1307404251767239</c:v>
                </c:pt>
                <c:pt idx="168">
                  <c:v>1.1613913620680019</c:v>
                </c:pt>
                <c:pt idx="169">
                  <c:v>1.0502314290468737</c:v>
                </c:pt>
                <c:pt idx="170">
                  <c:v>1.013130142154024</c:v>
                </c:pt>
                <c:pt idx="171">
                  <c:v>1.0453026641814005</c:v>
                </c:pt>
                <c:pt idx="172">
                  <c:v>1.2414650155157294</c:v>
                </c:pt>
                <c:pt idx="173">
                  <c:v>1.1744606343121284</c:v>
                </c:pt>
                <c:pt idx="174">
                  <c:v>1.1396124328429107</c:v>
                </c:pt>
                <c:pt idx="175">
                  <c:v>1.2002638391532336</c:v>
                </c:pt>
                <c:pt idx="176">
                  <c:v>1.3856875613788975</c:v>
                </c:pt>
                <c:pt idx="177">
                  <c:v>1.0556345555913118</c:v>
                </c:pt>
                <c:pt idx="178">
                  <c:v>1.1364340400584223</c:v>
                </c:pt>
                <c:pt idx="179">
                  <c:v>0.96941994083581173</c:v>
                </c:pt>
                <c:pt idx="180">
                  <c:v>0.97724341334217246</c:v>
                </c:pt>
                <c:pt idx="181">
                  <c:v>1.1067750977246811</c:v>
                </c:pt>
                <c:pt idx="182">
                  <c:v>1.162495992394929</c:v>
                </c:pt>
                <c:pt idx="183">
                  <c:v>1.2783844652445147</c:v>
                </c:pt>
                <c:pt idx="184">
                  <c:v>1.2106690422124367</c:v>
                </c:pt>
                <c:pt idx="185">
                  <c:v>1.2964266586698361</c:v>
                </c:pt>
                <c:pt idx="186">
                  <c:v>1.415536134177628</c:v>
                </c:pt>
                <c:pt idx="187">
                  <c:v>1.3972291924368263</c:v>
                </c:pt>
                <c:pt idx="188">
                  <c:v>1.2212452715667932</c:v>
                </c:pt>
                <c:pt idx="189">
                  <c:v>1.0623578848336694</c:v>
                </c:pt>
                <c:pt idx="190">
                  <c:v>1.3722155575425516</c:v>
                </c:pt>
                <c:pt idx="191">
                  <c:v>0.96665641277381464</c:v>
                </c:pt>
                <c:pt idx="192">
                  <c:v>1.094382652817196</c:v>
                </c:pt>
                <c:pt idx="193">
                  <c:v>1.4548483700300481</c:v>
                </c:pt>
                <c:pt idx="194">
                  <c:v>1.4777466165527628</c:v>
                </c:pt>
                <c:pt idx="195">
                  <c:v>1.2200849127879896</c:v>
                </c:pt>
                <c:pt idx="196">
                  <c:v>1.2247660305760488</c:v>
                </c:pt>
                <c:pt idx="197">
                  <c:v>1.3468983198971356</c:v>
                </c:pt>
                <c:pt idx="198">
                  <c:v>1.3671412382052448</c:v>
                </c:pt>
                <c:pt idx="199">
                  <c:v>1.2793987996594691</c:v>
                </c:pt>
                <c:pt idx="200">
                  <c:v>1.2468762648209688</c:v>
                </c:pt>
                <c:pt idx="201">
                  <c:v>1.3162376506883917</c:v>
                </c:pt>
                <c:pt idx="202">
                  <c:v>1.1976404709892634</c:v>
                </c:pt>
                <c:pt idx="203">
                  <c:v>1.217124804617149</c:v>
                </c:pt>
                <c:pt idx="204">
                  <c:v>1.0868874197614307</c:v>
                </c:pt>
                <c:pt idx="205">
                  <c:v>1.1072655538273128</c:v>
                </c:pt>
                <c:pt idx="206">
                  <c:v>1.1056984098835489</c:v>
                </c:pt>
                <c:pt idx="207">
                  <c:v>1.2024374742981045</c:v>
                </c:pt>
                <c:pt idx="208">
                  <c:v>1.3327126883342297</c:v>
                </c:pt>
                <c:pt idx="209">
                  <c:v>1.2895518357240654</c:v>
                </c:pt>
                <c:pt idx="210">
                  <c:v>1.1961721518701562</c:v>
                </c:pt>
                <c:pt idx="211">
                  <c:v>1.1304294172843141</c:v>
                </c:pt>
                <c:pt idx="212">
                  <c:v>1.263435249720406</c:v>
                </c:pt>
                <c:pt idx="213">
                  <c:v>2.3535003941131056</c:v>
                </c:pt>
                <c:pt idx="214">
                  <c:v>1.1265937397371053</c:v>
                </c:pt>
                <c:pt idx="215">
                  <c:v>1.513748520753496</c:v>
                </c:pt>
                <c:pt idx="216">
                  <c:v>1.0552656241763025</c:v>
                </c:pt>
                <c:pt idx="217">
                  <c:v>1.3987402420424435</c:v>
                </c:pt>
                <c:pt idx="218">
                  <c:v>1.2944500885495278</c:v>
                </c:pt>
                <c:pt idx="219">
                  <c:v>1.3379556145781271</c:v>
                </c:pt>
                <c:pt idx="220">
                  <c:v>0.93105472734508343</c:v>
                </c:pt>
                <c:pt idx="221">
                  <c:v>1.0372455112740389</c:v>
                </c:pt>
                <c:pt idx="222">
                  <c:v>1.0967600203180632</c:v>
                </c:pt>
                <c:pt idx="223">
                  <c:v>1.1877350907998689</c:v>
                </c:pt>
                <c:pt idx="224">
                  <c:v>1.1698760301624676</c:v>
                </c:pt>
                <c:pt idx="225">
                  <c:v>1.1850040964207986</c:v>
                </c:pt>
                <c:pt idx="226">
                  <c:v>0.95007581539195973</c:v>
                </c:pt>
                <c:pt idx="227">
                  <c:v>1.2411293764944991</c:v>
                </c:pt>
                <c:pt idx="228">
                  <c:v>1.6398035104290092</c:v>
                </c:pt>
                <c:pt idx="229">
                  <c:v>1.0562944143183228</c:v>
                </c:pt>
                <c:pt idx="230">
                  <c:v>1.0015106984059596</c:v>
                </c:pt>
                <c:pt idx="231">
                  <c:v>0.91949218060732396</c:v>
                </c:pt>
                <c:pt idx="232">
                  <c:v>1.1164056604817834</c:v>
                </c:pt>
                <c:pt idx="233">
                  <c:v>1.2128730041902216</c:v>
                </c:pt>
                <c:pt idx="234">
                  <c:v>1.0954559170041698</c:v>
                </c:pt>
                <c:pt idx="235">
                  <c:v>1.2597578009676698</c:v>
                </c:pt>
                <c:pt idx="236">
                  <c:v>1.1327037639188986</c:v>
                </c:pt>
                <c:pt idx="237">
                  <c:v>0.95182201160537849</c:v>
                </c:pt>
                <c:pt idx="238">
                  <c:v>1.3268209141851957</c:v>
                </c:pt>
                <c:pt idx="239">
                  <c:v>1.0791060267106447</c:v>
                </c:pt>
                <c:pt idx="240">
                  <c:v>1.2424241022169358</c:v>
                </c:pt>
                <c:pt idx="241">
                  <c:v>1.3143094148160865</c:v>
                </c:pt>
                <c:pt idx="242">
                  <c:v>1.1098444329238206</c:v>
                </c:pt>
                <c:pt idx="243">
                  <c:v>1.2013938510695972</c:v>
                </c:pt>
                <c:pt idx="244">
                  <c:v>1.2225210148600727</c:v>
                </c:pt>
                <c:pt idx="245">
                  <c:v>1.1149655514767158</c:v>
                </c:pt>
                <c:pt idx="246">
                  <c:v>1.0463019258932695</c:v>
                </c:pt>
                <c:pt idx="247">
                  <c:v>1.0760203722622705</c:v>
                </c:pt>
                <c:pt idx="248">
                  <c:v>1.394557515457334</c:v>
                </c:pt>
                <c:pt idx="249">
                  <c:v>1.0095942842130394</c:v>
                </c:pt>
                <c:pt idx="250">
                  <c:v>1.4179275161942924</c:v>
                </c:pt>
                <c:pt idx="251">
                  <c:v>1.1911272236671571</c:v>
                </c:pt>
                <c:pt idx="252">
                  <c:v>1.4577933440135751</c:v>
                </c:pt>
                <c:pt idx="253">
                  <c:v>1.3879252393576897</c:v>
                </c:pt>
                <c:pt idx="254">
                  <c:v>1.2516324100319196</c:v>
                </c:pt>
                <c:pt idx="255">
                  <c:v>1.7677288051851745</c:v>
                </c:pt>
                <c:pt idx="256">
                  <c:v>1.0878150576749728</c:v>
                </c:pt>
                <c:pt idx="257">
                  <c:v>0.88752973496226661</c:v>
                </c:pt>
                <c:pt idx="258">
                  <c:v>1.8814639995232043</c:v>
                </c:pt>
                <c:pt idx="259">
                  <c:v>1.8029988221989244</c:v>
                </c:pt>
                <c:pt idx="260">
                  <c:v>0.99042138902462207</c:v>
                </c:pt>
                <c:pt idx="261">
                  <c:v>1.1103647446189282</c:v>
                </c:pt>
                <c:pt idx="262">
                  <c:v>1.1596088985208393</c:v>
                </c:pt>
                <c:pt idx="263">
                  <c:v>1.1554664941525794</c:v>
                </c:pt>
                <c:pt idx="264">
                  <c:v>1.0724921093674358</c:v>
                </c:pt>
                <c:pt idx="265">
                  <c:v>1.0319956524098368</c:v>
                </c:pt>
                <c:pt idx="266">
                  <c:v>1.0655783214297256</c:v>
                </c:pt>
                <c:pt idx="267">
                  <c:v>1.0817263617120858</c:v>
                </c:pt>
                <c:pt idx="268">
                  <c:v>1.2929132918889084</c:v>
                </c:pt>
                <c:pt idx="269">
                  <c:v>1.3656432005322447</c:v>
                </c:pt>
                <c:pt idx="270">
                  <c:v>1.1639267896682179</c:v>
                </c:pt>
                <c:pt idx="271">
                  <c:v>1.0390227742291791</c:v>
                </c:pt>
                <c:pt idx="272">
                  <c:v>1.2262827551728461</c:v>
                </c:pt>
                <c:pt idx="273">
                  <c:v>1.2292339220156185</c:v>
                </c:pt>
                <c:pt idx="274">
                  <c:v>1.2640447995345419</c:v>
                </c:pt>
                <c:pt idx="275">
                  <c:v>1.2092340024017842</c:v>
                </c:pt>
                <c:pt idx="276">
                  <c:v>1.5983325182189172</c:v>
                </c:pt>
                <c:pt idx="277">
                  <c:v>1.1824514121609357</c:v>
                </c:pt>
                <c:pt idx="278">
                  <c:v>1.1065904187694084</c:v>
                </c:pt>
                <c:pt idx="279">
                  <c:v>1.0767314654045959</c:v>
                </c:pt>
                <c:pt idx="280">
                  <c:v>1.032833001377113</c:v>
                </c:pt>
                <c:pt idx="281">
                  <c:v>1.423698215440323</c:v>
                </c:pt>
                <c:pt idx="282">
                  <c:v>1.3879409863882555</c:v>
                </c:pt>
                <c:pt idx="283">
                  <c:v>2.0793985040703924</c:v>
                </c:pt>
                <c:pt idx="284">
                  <c:v>1.1723170050861837</c:v>
                </c:pt>
                <c:pt idx="285">
                  <c:v>1.0410368963094203</c:v>
                </c:pt>
                <c:pt idx="286">
                  <c:v>1.0485495992312186</c:v>
                </c:pt>
                <c:pt idx="287">
                  <c:v>1.1604933533431425</c:v>
                </c:pt>
                <c:pt idx="288">
                  <c:v>1.179028584896497</c:v>
                </c:pt>
                <c:pt idx="289">
                  <c:v>1.5031895999826435</c:v>
                </c:pt>
                <c:pt idx="290">
                  <c:v>1.0221210341760576</c:v>
                </c:pt>
                <c:pt idx="291">
                  <c:v>0.96743890083711714</c:v>
                </c:pt>
                <c:pt idx="292">
                  <c:v>1.0100396243845107</c:v>
                </c:pt>
                <c:pt idx="293">
                  <c:v>1.2270567920842701</c:v>
                </c:pt>
                <c:pt idx="294">
                  <c:v>1.5788482912719641</c:v>
                </c:pt>
                <c:pt idx="295">
                  <c:v>0.97246595960075988</c:v>
                </c:pt>
                <c:pt idx="296">
                  <c:v>1.0285589558393269</c:v>
                </c:pt>
                <c:pt idx="297">
                  <c:v>1.07858291486124</c:v>
                </c:pt>
                <c:pt idx="298">
                  <c:v>2.8344812405501019</c:v>
                </c:pt>
                <c:pt idx="299">
                  <c:v>1.3943936069830551</c:v>
                </c:pt>
                <c:pt idx="300">
                  <c:v>0.97016919050975869</c:v>
                </c:pt>
                <c:pt idx="301">
                  <c:v>1.0749266137128644</c:v>
                </c:pt>
                <c:pt idx="302">
                  <c:v>1.2520908113945228</c:v>
                </c:pt>
                <c:pt idx="303">
                  <c:v>1.1833198782089942</c:v>
                </c:pt>
                <c:pt idx="304">
                  <c:v>1.166352257038459</c:v>
                </c:pt>
                <c:pt idx="305">
                  <c:v>1.2897594071178042</c:v>
                </c:pt>
                <c:pt idx="306">
                  <c:v>1.3765208157291671</c:v>
                </c:pt>
                <c:pt idx="307">
                  <c:v>1.2984877202784431</c:v>
                </c:pt>
                <c:pt idx="308">
                  <c:v>1.1942513491264977</c:v>
                </c:pt>
                <c:pt idx="309">
                  <c:v>1.2236319845857417</c:v>
                </c:pt>
                <c:pt idx="310">
                  <c:v>1.0067808434622987</c:v>
                </c:pt>
                <c:pt idx="311">
                  <c:v>1.146499685973223</c:v>
                </c:pt>
                <c:pt idx="312">
                  <c:v>0.95980033391830122</c:v>
                </c:pt>
                <c:pt idx="313">
                  <c:v>1.6889583943849216</c:v>
                </c:pt>
                <c:pt idx="314">
                  <c:v>1.1195550916922903</c:v>
                </c:pt>
                <c:pt idx="315">
                  <c:v>1.4687323473286029</c:v>
                </c:pt>
                <c:pt idx="316">
                  <c:v>1.6837724898975919</c:v>
                </c:pt>
                <c:pt idx="317">
                  <c:v>1.310016012076304</c:v>
                </c:pt>
                <c:pt idx="318">
                  <c:v>1.3071160906611941</c:v>
                </c:pt>
                <c:pt idx="319">
                  <c:v>1.3527437551491488</c:v>
                </c:pt>
                <c:pt idx="320">
                  <c:v>0.86099662981185776</c:v>
                </c:pt>
                <c:pt idx="321">
                  <c:v>1.3498276370444016</c:v>
                </c:pt>
                <c:pt idx="322">
                  <c:v>1.0619462870284362</c:v>
                </c:pt>
                <c:pt idx="323">
                  <c:v>0.92694369431926493</c:v>
                </c:pt>
                <c:pt idx="324">
                  <c:v>1.1695857078824357</c:v>
                </c:pt>
                <c:pt idx="325">
                  <c:v>1.2593517780701593</c:v>
                </c:pt>
                <c:pt idx="326">
                  <c:v>1.0895436521718123</c:v>
                </c:pt>
                <c:pt idx="327">
                  <c:v>0.98785355925785689</c:v>
                </c:pt>
                <c:pt idx="328">
                  <c:v>1.0934497789632265</c:v>
                </c:pt>
                <c:pt idx="329">
                  <c:v>1.5321660771848533</c:v>
                </c:pt>
                <c:pt idx="330">
                  <c:v>1.2833179723502304</c:v>
                </c:pt>
                <c:pt idx="331">
                  <c:v>1.3993329332387654</c:v>
                </c:pt>
                <c:pt idx="332">
                  <c:v>1.1199230946234942</c:v>
                </c:pt>
                <c:pt idx="333">
                  <c:v>1.6929697145762219</c:v>
                </c:pt>
                <c:pt idx="334">
                  <c:v>1.0100890816877706</c:v>
                </c:pt>
                <c:pt idx="335">
                  <c:v>1.1472720419487663</c:v>
                </c:pt>
                <c:pt idx="336">
                  <c:v>1.0247354347520141</c:v>
                </c:pt>
                <c:pt idx="337">
                  <c:v>0.92215374526272842</c:v>
                </c:pt>
                <c:pt idx="338">
                  <c:v>1.0580938746256412</c:v>
                </c:pt>
                <c:pt idx="339">
                  <c:v>0.88950462682238807</c:v>
                </c:pt>
                <c:pt idx="340">
                  <c:v>0.96738798268151993</c:v>
                </c:pt>
                <c:pt idx="341">
                  <c:v>0.70735049902215374</c:v>
                </c:pt>
                <c:pt idx="342">
                  <c:v>1.4111045711028916</c:v>
                </c:pt>
                <c:pt idx="343">
                  <c:v>1.2657474392014756</c:v>
                </c:pt>
                <c:pt idx="344">
                  <c:v>1.837478488069842</c:v>
                </c:pt>
                <c:pt idx="345">
                  <c:v>1.3643656073655315</c:v>
                </c:pt>
                <c:pt idx="346">
                  <c:v>0.89179684652011137</c:v>
                </c:pt>
                <c:pt idx="347">
                  <c:v>1.0444582995412779</c:v>
                </c:pt>
                <c:pt idx="348">
                  <c:v>1.3175324529686274</c:v>
                </c:pt>
                <c:pt idx="349">
                  <c:v>1.8013863975784361</c:v>
                </c:pt>
                <c:pt idx="350">
                  <c:v>1.2510230429297555</c:v>
                </c:pt>
                <c:pt idx="351">
                  <c:v>1.2709653754142662</c:v>
                </c:pt>
                <c:pt idx="352">
                  <c:v>1.4129629825964616</c:v>
                </c:pt>
                <c:pt idx="353">
                  <c:v>1.1337270260174641</c:v>
                </c:pt>
                <c:pt idx="354">
                  <c:v>1.3248294083295509</c:v>
                </c:pt>
                <c:pt idx="355">
                  <c:v>0.98249973366452092</c:v>
                </c:pt>
                <c:pt idx="356">
                  <c:v>1.1509770633796168</c:v>
                </c:pt>
                <c:pt idx="357">
                  <c:v>1.3008440935370589</c:v>
                </c:pt>
                <c:pt idx="358">
                  <c:v>0.99917998853719103</c:v>
                </c:pt>
                <c:pt idx="359">
                  <c:v>1.2085907409077605</c:v>
                </c:pt>
                <c:pt idx="360">
                  <c:v>1.0054414128555706</c:v>
                </c:pt>
                <c:pt idx="361">
                  <c:v>1.2676450096896004</c:v>
                </c:pt>
                <c:pt idx="362">
                  <c:v>0.93482944514292643</c:v>
                </c:pt>
                <c:pt idx="363">
                  <c:v>1.2488079540999963</c:v>
                </c:pt>
                <c:pt idx="364">
                  <c:v>1.3754320592361828</c:v>
                </c:pt>
                <c:pt idx="365">
                  <c:v>1.2697039114220896</c:v>
                </c:pt>
                <c:pt idx="366">
                  <c:v>0.82836677329198238</c:v>
                </c:pt>
                <c:pt idx="367">
                  <c:v>1.0754240447572345</c:v>
                </c:pt>
                <c:pt idx="368">
                  <c:v>0.91322899416884273</c:v>
                </c:pt>
                <c:pt idx="369">
                  <c:v>0.95885354317036231</c:v>
                </c:pt>
                <c:pt idx="370">
                  <c:v>1.1954737969676994</c:v>
                </c:pt>
                <c:pt idx="371">
                  <c:v>1.2372736401385449</c:v>
                </c:pt>
                <c:pt idx="372">
                  <c:v>1.028205499212606</c:v>
                </c:pt>
                <c:pt idx="373">
                  <c:v>1.0399088086380039</c:v>
                </c:pt>
                <c:pt idx="374">
                  <c:v>1.2124409666406359</c:v>
                </c:pt>
                <c:pt idx="375">
                  <c:v>0.90327387725874519</c:v>
                </c:pt>
                <c:pt idx="376">
                  <c:v>1.046746174328703</c:v>
                </c:pt>
                <c:pt idx="377">
                  <c:v>1.468638821042261</c:v>
                </c:pt>
                <c:pt idx="378">
                  <c:v>1.1281139886909732</c:v>
                </c:pt>
                <c:pt idx="379">
                  <c:v>1.0063242867973194</c:v>
                </c:pt>
                <c:pt idx="380">
                  <c:v>0.91986704372408234</c:v>
                </c:pt>
                <c:pt idx="381">
                  <c:v>0.87182836264682517</c:v>
                </c:pt>
                <c:pt idx="382">
                  <c:v>0.9828494206453352</c:v>
                </c:pt>
                <c:pt idx="383">
                  <c:v>0.95604381451916298</c:v>
                </c:pt>
                <c:pt idx="384">
                  <c:v>1.0599700080630428</c:v>
                </c:pt>
                <c:pt idx="385">
                  <c:v>1.004923121492044</c:v>
                </c:pt>
                <c:pt idx="386">
                  <c:v>1.3784666479093912</c:v>
                </c:pt>
                <c:pt idx="387">
                  <c:v>1.3343604617460667</c:v>
                </c:pt>
                <c:pt idx="388">
                  <c:v>1.1251739226831841</c:v>
                </c:pt>
                <c:pt idx="389">
                  <c:v>1.2892585190974741</c:v>
                </c:pt>
                <c:pt idx="390">
                  <c:v>0.94703860172860543</c:v>
                </c:pt>
                <c:pt idx="391">
                  <c:v>0.91526596652850378</c:v>
                </c:pt>
                <c:pt idx="392">
                  <c:v>0.95035871564852914</c:v>
                </c:pt>
                <c:pt idx="393">
                  <c:v>0.9418022914554306</c:v>
                </c:pt>
                <c:pt idx="394">
                  <c:v>0.93170533559697377</c:v>
                </c:pt>
                <c:pt idx="395">
                  <c:v>1.1145361623802399</c:v>
                </c:pt>
                <c:pt idx="396">
                  <c:v>1.1573207325648192</c:v>
                </c:pt>
                <c:pt idx="397">
                  <c:v>1.1100747049788287</c:v>
                </c:pt>
                <c:pt idx="398">
                  <c:v>1.2088906149055259</c:v>
                </c:pt>
                <c:pt idx="399">
                  <c:v>1.0556260947159721</c:v>
                </c:pt>
                <c:pt idx="400">
                  <c:v>1.04549841107793</c:v>
                </c:pt>
                <c:pt idx="401">
                  <c:v>1.1311302756803807</c:v>
                </c:pt>
                <c:pt idx="402">
                  <c:v>1.1558456914376281</c:v>
                </c:pt>
                <c:pt idx="403">
                  <c:v>1.001111463497302</c:v>
                </c:pt>
                <c:pt idx="404">
                  <c:v>1.1370624720107478</c:v>
                </c:pt>
                <c:pt idx="405">
                  <c:v>1.2664026033791336</c:v>
                </c:pt>
                <c:pt idx="406">
                  <c:v>1.770557359799247</c:v>
                </c:pt>
                <c:pt idx="407">
                  <c:v>1.6405139902511756</c:v>
                </c:pt>
                <c:pt idx="408">
                  <c:v>1.2130671261233335</c:v>
                </c:pt>
                <c:pt idx="409">
                  <c:v>1.7074829038777055</c:v>
                </c:pt>
                <c:pt idx="410">
                  <c:v>0.97938926395168313</c:v>
                </c:pt>
                <c:pt idx="411">
                  <c:v>1.4907111688957044</c:v>
                </c:pt>
                <c:pt idx="412">
                  <c:v>0.98194737950921085</c:v>
                </c:pt>
                <c:pt idx="413">
                  <c:v>1.0517453575897477</c:v>
                </c:pt>
                <c:pt idx="414">
                  <c:v>1.1111153433965546</c:v>
                </c:pt>
                <c:pt idx="415">
                  <c:v>1.1877286929711277</c:v>
                </c:pt>
                <c:pt idx="416">
                  <c:v>1.1697069471872137</c:v>
                </c:pt>
                <c:pt idx="417">
                  <c:v>1.2477546520896918</c:v>
                </c:pt>
                <c:pt idx="418">
                  <c:v>0.91815206869499599</c:v>
                </c:pt>
                <c:pt idx="419">
                  <c:v>1.0719772347572363</c:v>
                </c:pt>
                <c:pt idx="420">
                  <c:v>1.143212004667217</c:v>
                </c:pt>
                <c:pt idx="421">
                  <c:v>1.3526188018768923</c:v>
                </c:pt>
                <c:pt idx="422">
                  <c:v>1.1178761563375053</c:v>
                </c:pt>
                <c:pt idx="423">
                  <c:v>1.0944155924929642</c:v>
                </c:pt>
                <c:pt idx="424">
                  <c:v>1.260416777266482</c:v>
                </c:pt>
                <c:pt idx="425">
                  <c:v>1.117329251381427</c:v>
                </c:pt>
                <c:pt idx="426">
                  <c:v>0.95583301763218309</c:v>
                </c:pt>
                <c:pt idx="427">
                  <c:v>1.0689277170763567</c:v>
                </c:pt>
                <c:pt idx="428">
                  <c:v>1.2004285499397858</c:v>
                </c:pt>
                <c:pt idx="429">
                  <c:v>0.95359796033806909</c:v>
                </c:pt>
                <c:pt idx="430">
                  <c:v>0.93546120849574321</c:v>
                </c:pt>
                <c:pt idx="431">
                  <c:v>1.1074125393438059</c:v>
                </c:pt>
                <c:pt idx="432">
                  <c:v>1.174557335697765</c:v>
                </c:pt>
                <c:pt idx="433">
                  <c:v>1.1130106148584358</c:v>
                </c:pt>
                <c:pt idx="434">
                  <c:v>1.562670198922349</c:v>
                </c:pt>
                <c:pt idx="435">
                  <c:v>1.1372582702226837</c:v>
                </c:pt>
                <c:pt idx="436">
                  <c:v>1.4955067443840531</c:v>
                </c:pt>
                <c:pt idx="437">
                  <c:v>1.3347328314810798</c:v>
                </c:pt>
                <c:pt idx="438">
                  <c:v>1.1484858796730681</c:v>
                </c:pt>
                <c:pt idx="439">
                  <c:v>1.3504448822994071</c:v>
                </c:pt>
                <c:pt idx="440">
                  <c:v>1.0557923352952168</c:v>
                </c:pt>
                <c:pt idx="441">
                  <c:v>1.2052722566174914</c:v>
                </c:pt>
                <c:pt idx="442">
                  <c:v>1.2152984851224471</c:v>
                </c:pt>
                <c:pt idx="443">
                  <c:v>1.1023567750509</c:v>
                </c:pt>
                <c:pt idx="444">
                  <c:v>1.105722581363384</c:v>
                </c:pt>
                <c:pt idx="445">
                  <c:v>1.0404592088534184</c:v>
                </c:pt>
                <c:pt idx="446">
                  <c:v>1.2018688794506378</c:v>
                </c:pt>
                <c:pt idx="447">
                  <c:v>1.1456106664566215</c:v>
                </c:pt>
                <c:pt idx="448">
                  <c:v>1.1422485523368786</c:v>
                </c:pt>
                <c:pt idx="449">
                  <c:v>1.1821625170119492</c:v>
                </c:pt>
                <c:pt idx="450">
                  <c:v>1.203299461684874</c:v>
                </c:pt>
                <c:pt idx="451">
                  <c:v>1.2480070412893882</c:v>
                </c:pt>
                <c:pt idx="452">
                  <c:v>1.1097466449018796</c:v>
                </c:pt>
                <c:pt idx="453">
                  <c:v>1.5602629273008968</c:v>
                </c:pt>
                <c:pt idx="454">
                  <c:v>1.3445632871569315</c:v>
                </c:pt>
                <c:pt idx="455">
                  <c:v>1.0126455077605609</c:v>
                </c:pt>
                <c:pt idx="456">
                  <c:v>1.1504507297779007</c:v>
                </c:pt>
                <c:pt idx="457">
                  <c:v>1.9445876178572448</c:v>
                </c:pt>
                <c:pt idx="458">
                  <c:v>1.3198771415012236</c:v>
                </c:pt>
                <c:pt idx="459">
                  <c:v>1.1242988675963885</c:v>
                </c:pt>
                <c:pt idx="460">
                  <c:v>1.2300326408412141</c:v>
                </c:pt>
                <c:pt idx="461">
                  <c:v>1.0633311027019645</c:v>
                </c:pt>
                <c:pt idx="462">
                  <c:v>1.2719390641645647</c:v>
                </c:pt>
                <c:pt idx="463">
                  <c:v>1.1554399285047821</c:v>
                </c:pt>
                <c:pt idx="464">
                  <c:v>1.0746020348584655</c:v>
                </c:pt>
                <c:pt idx="465">
                  <c:v>1.5931525250966272</c:v>
                </c:pt>
                <c:pt idx="466">
                  <c:v>1.1804505195457713</c:v>
                </c:pt>
                <c:pt idx="467">
                  <c:v>2.4249318618014004</c:v>
                </c:pt>
                <c:pt idx="468">
                  <c:v>1.0213301118479123</c:v>
                </c:pt>
                <c:pt idx="469">
                  <c:v>1.0733846044377189</c:v>
                </c:pt>
                <c:pt idx="470">
                  <c:v>1.6008971204747398</c:v>
                </c:pt>
                <c:pt idx="471">
                  <c:v>1.3447872442117925</c:v>
                </c:pt>
                <c:pt idx="472">
                  <c:v>1.0010456262944378</c:v>
                </c:pt>
                <c:pt idx="473">
                  <c:v>1.3146836118206917</c:v>
                </c:pt>
                <c:pt idx="474">
                  <c:v>1.5621758955670972</c:v>
                </c:pt>
                <c:pt idx="475">
                  <c:v>1.1758675729247499</c:v>
                </c:pt>
                <c:pt idx="476">
                  <c:v>1.1533062719143945</c:v>
                </c:pt>
                <c:pt idx="477">
                  <c:v>1.1016213577810317</c:v>
                </c:pt>
                <c:pt idx="478">
                  <c:v>1.318631066437095</c:v>
                </c:pt>
                <c:pt idx="479">
                  <c:v>1.1589176245549413</c:v>
                </c:pt>
                <c:pt idx="480">
                  <c:v>1.0184590220852148</c:v>
                </c:pt>
                <c:pt idx="481">
                  <c:v>0.95492526710978554</c:v>
                </c:pt>
                <c:pt idx="482">
                  <c:v>1.7222295048502083</c:v>
                </c:pt>
                <c:pt idx="483">
                  <c:v>1.1552069647669905</c:v>
                </c:pt>
                <c:pt idx="484">
                  <c:v>1.088121912880432</c:v>
                </c:pt>
                <c:pt idx="485">
                  <c:v>1.5014544118957607</c:v>
                </c:pt>
                <c:pt idx="486">
                  <c:v>1.0362676991104891</c:v>
                </c:pt>
                <c:pt idx="487">
                  <c:v>0.98024118900365609</c:v>
                </c:pt>
                <c:pt idx="488">
                  <c:v>1.0908819808344223</c:v>
                </c:pt>
                <c:pt idx="489">
                  <c:v>1.0658037717577045</c:v>
                </c:pt>
                <c:pt idx="490">
                  <c:v>0.93937527181550196</c:v>
                </c:pt>
                <c:pt idx="491">
                  <c:v>1.1244520249540131</c:v>
                </c:pt>
                <c:pt idx="492">
                  <c:v>1.2938803426434169</c:v>
                </c:pt>
                <c:pt idx="493">
                  <c:v>1.0989438158720006</c:v>
                </c:pt>
                <c:pt idx="494">
                  <c:v>1.1821764544732443</c:v>
                </c:pt>
                <c:pt idx="495">
                  <c:v>1.0005848723176656</c:v>
                </c:pt>
                <c:pt idx="496">
                  <c:v>1.0656951063801612</c:v>
                </c:pt>
                <c:pt idx="497">
                  <c:v>1.2766131503760707</c:v>
                </c:pt>
                <c:pt idx="498">
                  <c:v>1.1587285392494053</c:v>
                </c:pt>
                <c:pt idx="499">
                  <c:v>0.96408836237420148</c:v>
                </c:pt>
                <c:pt idx="500">
                  <c:v>1.4482418349926862</c:v>
                </c:pt>
                <c:pt idx="501">
                  <c:v>1.0796892657101165</c:v>
                </c:pt>
                <c:pt idx="502">
                  <c:v>1.1037688990544336</c:v>
                </c:pt>
                <c:pt idx="503">
                  <c:v>1.4995672105454108</c:v>
                </c:pt>
                <c:pt idx="504">
                  <c:v>1.1519308961892354</c:v>
                </c:pt>
                <c:pt idx="505">
                  <c:v>1.3940528399450856</c:v>
                </c:pt>
                <c:pt idx="506">
                  <c:v>1.4672827322019364</c:v>
                </c:pt>
                <c:pt idx="507">
                  <c:v>2.1323573395833462</c:v>
                </c:pt>
                <c:pt idx="508">
                  <c:v>1.3999039561483604</c:v>
                </c:pt>
                <c:pt idx="509">
                  <c:v>1.0014676586492481</c:v>
                </c:pt>
                <c:pt idx="510">
                  <c:v>1.0019585455521143</c:v>
                </c:pt>
                <c:pt idx="511">
                  <c:v>1.1560329347070606</c:v>
                </c:pt>
                <c:pt idx="512">
                  <c:v>1.1908289120375579</c:v>
                </c:pt>
                <c:pt idx="513">
                  <c:v>0.99435991367584919</c:v>
                </c:pt>
                <c:pt idx="514">
                  <c:v>0.92687797255876214</c:v>
                </c:pt>
                <c:pt idx="515">
                  <c:v>1.0852152305779945</c:v>
                </c:pt>
                <c:pt idx="516">
                  <c:v>1.1938705208803881</c:v>
                </c:pt>
                <c:pt idx="517">
                  <c:v>1.0201926197318152</c:v>
                </c:pt>
                <c:pt idx="518">
                  <c:v>1.1291164351434562</c:v>
                </c:pt>
                <c:pt idx="519">
                  <c:v>1.0832195303336998</c:v>
                </c:pt>
                <c:pt idx="520">
                  <c:v>1.5519916649275778</c:v>
                </c:pt>
                <c:pt idx="521">
                  <c:v>1.7562815746823992</c:v>
                </c:pt>
                <c:pt idx="522">
                  <c:v>0.95647460851996957</c:v>
                </c:pt>
                <c:pt idx="523">
                  <c:v>1.2885287997104939</c:v>
                </c:pt>
                <c:pt idx="524">
                  <c:v>1.702505106587838</c:v>
                </c:pt>
                <c:pt idx="525">
                  <c:v>1.1634026863297131</c:v>
                </c:pt>
                <c:pt idx="526">
                  <c:v>1.4824724342917408</c:v>
                </c:pt>
                <c:pt idx="527">
                  <c:v>1.3987610795841803</c:v>
                </c:pt>
                <c:pt idx="528">
                  <c:v>1.0811627782129489</c:v>
                </c:pt>
                <c:pt idx="529">
                  <c:v>1.0335042824491869</c:v>
                </c:pt>
                <c:pt idx="530">
                  <c:v>0.93504952292540389</c:v>
                </c:pt>
                <c:pt idx="531">
                  <c:v>1.0844203771244549</c:v>
                </c:pt>
                <c:pt idx="532">
                  <c:v>1.0588496156848983</c:v>
                </c:pt>
                <c:pt idx="533">
                  <c:v>1.1635924625738081</c:v>
                </c:pt>
                <c:pt idx="534">
                  <c:v>1.2389369581308827</c:v>
                </c:pt>
                <c:pt idx="535">
                  <c:v>1.0912674616429716</c:v>
                </c:pt>
                <c:pt idx="536">
                  <c:v>1.0946000741794231</c:v>
                </c:pt>
                <c:pt idx="537">
                  <c:v>1.2957603490493648</c:v>
                </c:pt>
                <c:pt idx="538">
                  <c:v>1.2594225469027036</c:v>
                </c:pt>
                <c:pt idx="539">
                  <c:v>0.94856104569497612</c:v>
                </c:pt>
                <c:pt idx="540">
                  <c:v>1.1051938061135587</c:v>
                </c:pt>
                <c:pt idx="541">
                  <c:v>1.0661350716347868</c:v>
                </c:pt>
                <c:pt idx="542">
                  <c:v>1.3293861188755178</c:v>
                </c:pt>
                <c:pt idx="543">
                  <c:v>1.3013109524825448</c:v>
                </c:pt>
                <c:pt idx="544">
                  <c:v>1.0892307468808895</c:v>
                </c:pt>
                <c:pt idx="545">
                  <c:v>1.1786553391541941</c:v>
                </c:pt>
                <c:pt idx="546">
                  <c:v>0.96093922268520537</c:v>
                </c:pt>
                <c:pt idx="547">
                  <c:v>1.1375105817133011</c:v>
                </c:pt>
                <c:pt idx="548">
                  <c:v>1.072221156710162</c:v>
                </c:pt>
                <c:pt idx="549">
                  <c:v>1.0572690532279037</c:v>
                </c:pt>
                <c:pt idx="550">
                  <c:v>1.0621985584605362</c:v>
                </c:pt>
                <c:pt idx="551">
                  <c:v>1.139153332563424</c:v>
                </c:pt>
                <c:pt idx="552">
                  <c:v>1.0509943788507135</c:v>
                </c:pt>
                <c:pt idx="553">
                  <c:v>1.2261592834022599</c:v>
                </c:pt>
                <c:pt idx="554">
                  <c:v>0.98906479544416193</c:v>
                </c:pt>
                <c:pt idx="555">
                  <c:v>1.1190735256519639</c:v>
                </c:pt>
                <c:pt idx="556">
                  <c:v>0.99380958016874443</c:v>
                </c:pt>
                <c:pt idx="557">
                  <c:v>1.191315454129763</c:v>
                </c:pt>
                <c:pt idx="558">
                  <c:v>1.3225156735759487</c:v>
                </c:pt>
                <c:pt idx="559">
                  <c:v>1.2510210774496726</c:v>
                </c:pt>
                <c:pt idx="560">
                  <c:v>1.0349281920543292</c:v>
                </c:pt>
                <c:pt idx="561">
                  <c:v>1.2956751403843056</c:v>
                </c:pt>
                <c:pt idx="562">
                  <c:v>0.97477141983601923</c:v>
                </c:pt>
                <c:pt idx="563">
                  <c:v>0.87770256779174183</c:v>
                </c:pt>
                <c:pt idx="564">
                  <c:v>1.0701723100687128</c:v>
                </c:pt>
                <c:pt idx="565">
                  <c:v>1.055223931326654</c:v>
                </c:pt>
                <c:pt idx="566">
                  <c:v>1.0666033692327563</c:v>
                </c:pt>
                <c:pt idx="567">
                  <c:v>1.5107236395790147</c:v>
                </c:pt>
                <c:pt idx="568">
                  <c:v>1.3007726308857874</c:v>
                </c:pt>
                <c:pt idx="569">
                  <c:v>1.4800265768906187</c:v>
                </c:pt>
                <c:pt idx="570">
                  <c:v>1.0593957504460267</c:v>
                </c:pt>
                <c:pt idx="571">
                  <c:v>1.2655327797610163</c:v>
                </c:pt>
                <c:pt idx="572">
                  <c:v>1.612511215151881</c:v>
                </c:pt>
                <c:pt idx="573">
                  <c:v>1.2863614905334897</c:v>
                </c:pt>
                <c:pt idx="574">
                  <c:v>1.0552892510300145</c:v>
                </c:pt>
                <c:pt idx="575">
                  <c:v>1.2222385654706336</c:v>
                </c:pt>
                <c:pt idx="576">
                  <c:v>1.4944835398374838</c:v>
                </c:pt>
                <c:pt idx="577">
                  <c:v>1.019932256602115</c:v>
                </c:pt>
                <c:pt idx="578">
                  <c:v>1.2492583781701976</c:v>
                </c:pt>
                <c:pt idx="579">
                  <c:v>1.1567230293621511</c:v>
                </c:pt>
                <c:pt idx="580">
                  <c:v>1.360443602691406</c:v>
                </c:pt>
                <c:pt idx="581">
                  <c:v>1.0396152403199306</c:v>
                </c:pt>
                <c:pt idx="582">
                  <c:v>1.0117354658915276</c:v>
                </c:pt>
                <c:pt idx="583">
                  <c:v>0.95686037621626807</c:v>
                </c:pt>
                <c:pt idx="584">
                  <c:v>1.1001722791583832</c:v>
                </c:pt>
                <c:pt idx="585">
                  <c:v>1.0656935510546564</c:v>
                </c:pt>
                <c:pt idx="586">
                  <c:v>1.0557029176686614</c:v>
                </c:pt>
                <c:pt idx="587">
                  <c:v>1.3212253983958164</c:v>
                </c:pt>
                <c:pt idx="588">
                  <c:v>1.1060117716542937</c:v>
                </c:pt>
                <c:pt idx="589">
                  <c:v>1.5751502322649369</c:v>
                </c:pt>
                <c:pt idx="590">
                  <c:v>1.187513391830435</c:v>
                </c:pt>
                <c:pt idx="591">
                  <c:v>1.4340982716211568</c:v>
                </c:pt>
                <c:pt idx="592">
                  <c:v>1.1581578247320226</c:v>
                </c:pt>
                <c:pt idx="593">
                  <c:v>1.2364195711093284</c:v>
                </c:pt>
                <c:pt idx="594">
                  <c:v>1.4389645735746017</c:v>
                </c:pt>
                <c:pt idx="595">
                  <c:v>1.0017184080238402</c:v>
                </c:pt>
                <c:pt idx="596">
                  <c:v>1.220475619311012</c:v>
                </c:pt>
                <c:pt idx="597">
                  <c:v>1.0856333866940826</c:v>
                </c:pt>
                <c:pt idx="598">
                  <c:v>1.6178823876052739</c:v>
                </c:pt>
                <c:pt idx="599">
                  <c:v>1.1954125283934989</c:v>
                </c:pt>
                <c:pt idx="600">
                  <c:v>1.3754331224247756</c:v>
                </c:pt>
                <c:pt idx="601">
                  <c:v>1.1518636532717252</c:v>
                </c:pt>
                <c:pt idx="602">
                  <c:v>1.0871414702080964</c:v>
                </c:pt>
                <c:pt idx="603">
                  <c:v>0.95437444681946504</c:v>
                </c:pt>
                <c:pt idx="604">
                  <c:v>0.94985719469132601</c:v>
                </c:pt>
                <c:pt idx="605">
                  <c:v>0.97445093668787564</c:v>
                </c:pt>
                <c:pt idx="606">
                  <c:v>1.1620673371736752</c:v>
                </c:pt>
                <c:pt idx="607">
                  <c:v>1.2193330554879596</c:v>
                </c:pt>
                <c:pt idx="608">
                  <c:v>1.3421166670897413</c:v>
                </c:pt>
                <c:pt idx="609">
                  <c:v>1.5836521570602509</c:v>
                </c:pt>
                <c:pt idx="610">
                  <c:v>1.410612409080797</c:v>
                </c:pt>
                <c:pt idx="611">
                  <c:v>1.0082836025610677</c:v>
                </c:pt>
                <c:pt idx="612">
                  <c:v>1.007464253233668</c:v>
                </c:pt>
                <c:pt idx="613">
                  <c:v>1.0099493988018806</c:v>
                </c:pt>
                <c:pt idx="614">
                  <c:v>1.0474473017137003</c:v>
                </c:pt>
                <c:pt idx="615">
                  <c:v>1.212833340898221</c:v>
                </c:pt>
                <c:pt idx="616">
                  <c:v>0.89973970123007896</c:v>
                </c:pt>
                <c:pt idx="617">
                  <c:v>1.1164542173667995</c:v>
                </c:pt>
                <c:pt idx="618">
                  <c:v>0.96589313001274724</c:v>
                </c:pt>
                <c:pt idx="619">
                  <c:v>1.1029358218228336</c:v>
                </c:pt>
                <c:pt idx="620">
                  <c:v>1.1895764545056677</c:v>
                </c:pt>
                <c:pt idx="621">
                  <c:v>1.2960043438406068</c:v>
                </c:pt>
                <c:pt idx="622">
                  <c:v>2.1724547327255399</c:v>
                </c:pt>
                <c:pt idx="623">
                  <c:v>0.99217270987189732</c:v>
                </c:pt>
                <c:pt idx="624">
                  <c:v>1.5544189050782522</c:v>
                </c:pt>
                <c:pt idx="625">
                  <c:v>1.4247313867116314</c:v>
                </c:pt>
                <c:pt idx="626">
                  <c:v>1.3600174583245077</c:v>
                </c:pt>
                <c:pt idx="627">
                  <c:v>1.3301969974068459</c:v>
                </c:pt>
                <c:pt idx="628">
                  <c:v>1.1006245418866907</c:v>
                </c:pt>
                <c:pt idx="629">
                  <c:v>0.93414864692063271</c:v>
                </c:pt>
                <c:pt idx="630">
                  <c:v>1.088960128203845</c:v>
                </c:pt>
                <c:pt idx="631">
                  <c:v>1.2689546378843986</c:v>
                </c:pt>
                <c:pt idx="632">
                  <c:v>0.98343431868930342</c:v>
                </c:pt>
                <c:pt idx="633">
                  <c:v>1.3050906373568558</c:v>
                </c:pt>
                <c:pt idx="634">
                  <c:v>1.7551550706329861</c:v>
                </c:pt>
                <c:pt idx="635">
                  <c:v>1.4961814076165829</c:v>
                </c:pt>
                <c:pt idx="636">
                  <c:v>1.1900275101438946</c:v>
                </c:pt>
                <c:pt idx="637">
                  <c:v>0.97940160007141364</c:v>
                </c:pt>
                <c:pt idx="638">
                  <c:v>1.4094208950812572</c:v>
                </c:pt>
                <c:pt idx="639">
                  <c:v>1.1383711527315032</c:v>
                </c:pt>
                <c:pt idx="640">
                  <c:v>1.2065774739457926</c:v>
                </c:pt>
                <c:pt idx="641">
                  <c:v>1.5372391197544715</c:v>
                </c:pt>
                <c:pt idx="642">
                  <c:v>0.96640737884937122</c:v>
                </c:pt>
                <c:pt idx="643">
                  <c:v>1.1024371152430865</c:v>
                </c:pt>
                <c:pt idx="644">
                  <c:v>0.97626935553354399</c:v>
                </c:pt>
                <c:pt idx="645">
                  <c:v>1.2935991167092302</c:v>
                </c:pt>
                <c:pt idx="646">
                  <c:v>1.1138247778674666</c:v>
                </c:pt>
                <c:pt idx="647">
                  <c:v>1.0833128388372735</c:v>
                </c:pt>
                <c:pt idx="648">
                  <c:v>1.0040990758211139</c:v>
                </c:pt>
                <c:pt idx="649">
                  <c:v>1.1813150769440131</c:v>
                </c:pt>
                <c:pt idx="650">
                  <c:v>1.1438803646430109</c:v>
                </c:pt>
                <c:pt idx="651">
                  <c:v>1.5047379020346208</c:v>
                </c:pt>
                <c:pt idx="652">
                  <c:v>1.5864116358163642</c:v>
                </c:pt>
                <c:pt idx="653">
                  <c:v>1.4420775445518028</c:v>
                </c:pt>
                <c:pt idx="654">
                  <c:v>1.21422192687818</c:v>
                </c:pt>
                <c:pt idx="655">
                  <c:v>1.1579953762082267</c:v>
                </c:pt>
                <c:pt idx="656">
                  <c:v>1.1959958691691488</c:v>
                </c:pt>
                <c:pt idx="657">
                  <c:v>1.1413199432465215</c:v>
                </c:pt>
                <c:pt idx="658">
                  <c:v>1.1046398941054971</c:v>
                </c:pt>
                <c:pt idx="659">
                  <c:v>1.2498050096776776</c:v>
                </c:pt>
                <c:pt idx="660">
                  <c:v>1.1177229971720934</c:v>
                </c:pt>
                <c:pt idx="661">
                  <c:v>1.2094700305046751</c:v>
                </c:pt>
                <c:pt idx="662">
                  <c:v>1.0348635326540687</c:v>
                </c:pt>
                <c:pt idx="663">
                  <c:v>1.3281812222498901</c:v>
                </c:pt>
                <c:pt idx="664">
                  <c:v>0.96184502954959794</c:v>
                </c:pt>
                <c:pt idx="665">
                  <c:v>1.2168495560782158</c:v>
                </c:pt>
                <c:pt idx="666">
                  <c:v>1.0629376606757051</c:v>
                </c:pt>
                <c:pt idx="667">
                  <c:v>1.0020802696480913</c:v>
                </c:pt>
                <c:pt idx="668">
                  <c:v>1.0749846190638523</c:v>
                </c:pt>
                <c:pt idx="669">
                  <c:v>1.6119796438033238</c:v>
                </c:pt>
                <c:pt idx="670">
                  <c:v>1.1759350405746802</c:v>
                </c:pt>
                <c:pt idx="671">
                  <c:v>1.0023324716716233</c:v>
                </c:pt>
                <c:pt idx="672">
                  <c:v>1.7434516701043603</c:v>
                </c:pt>
                <c:pt idx="673">
                  <c:v>1.0683257737370069</c:v>
                </c:pt>
                <c:pt idx="674">
                  <c:v>1.2061117045690999</c:v>
                </c:pt>
                <c:pt idx="675">
                  <c:v>1.0126047284258106</c:v>
                </c:pt>
                <c:pt idx="676">
                  <c:v>1.5717571026110173</c:v>
                </c:pt>
                <c:pt idx="677">
                  <c:v>1.0107118700724926</c:v>
                </c:pt>
                <c:pt idx="678">
                  <c:v>1.1552903293428864</c:v>
                </c:pt>
                <c:pt idx="679">
                  <c:v>1.0174442412145657</c:v>
                </c:pt>
                <c:pt idx="680">
                  <c:v>1.5723912046646127</c:v>
                </c:pt>
                <c:pt idx="681">
                  <c:v>1.3837693462509788</c:v>
                </c:pt>
                <c:pt idx="682">
                  <c:v>1.3065904265157804</c:v>
                </c:pt>
                <c:pt idx="683">
                  <c:v>1.2359340657847464</c:v>
                </c:pt>
                <c:pt idx="684">
                  <c:v>1.4162934971176673</c:v>
                </c:pt>
                <c:pt idx="685">
                  <c:v>1.5407443291165317</c:v>
                </c:pt>
                <c:pt idx="686">
                  <c:v>1.3789816603055891</c:v>
                </c:pt>
                <c:pt idx="687">
                  <c:v>1.4949339347517339</c:v>
                </c:pt>
                <c:pt idx="688">
                  <c:v>1.3672143778013479</c:v>
                </c:pt>
                <c:pt idx="689">
                  <c:v>0.99174315028382554</c:v>
                </c:pt>
                <c:pt idx="690">
                  <c:v>0.94573435417423202</c:v>
                </c:pt>
                <c:pt idx="691">
                  <c:v>1.1816162604688099</c:v>
                </c:pt>
                <c:pt idx="692">
                  <c:v>1.1511463624115164</c:v>
                </c:pt>
                <c:pt idx="693">
                  <c:v>1.1046986100314236</c:v>
                </c:pt>
                <c:pt idx="694">
                  <c:v>1.4520722748603829</c:v>
                </c:pt>
                <c:pt idx="695">
                  <c:v>1.5003331374292643</c:v>
                </c:pt>
                <c:pt idx="696">
                  <c:v>1.0548517844995131</c:v>
                </c:pt>
                <c:pt idx="697">
                  <c:v>1.183173592942131</c:v>
                </c:pt>
                <c:pt idx="698">
                  <c:v>1.1197465855910012</c:v>
                </c:pt>
                <c:pt idx="699">
                  <c:v>1.2361534737546336</c:v>
                </c:pt>
                <c:pt idx="700">
                  <c:v>1.0162864379991037</c:v>
                </c:pt>
                <c:pt idx="701">
                  <c:v>1.3123677322490097</c:v>
                </c:pt>
                <c:pt idx="702">
                  <c:v>1.3585094422425801</c:v>
                </c:pt>
                <c:pt idx="703">
                  <c:v>1.0661255589626404</c:v>
                </c:pt>
                <c:pt idx="704">
                  <c:v>0.85987789103738643</c:v>
                </c:pt>
                <c:pt idx="705">
                  <c:v>1.1240100149496104</c:v>
                </c:pt>
                <c:pt idx="706">
                  <c:v>1.2138086993392461</c:v>
                </c:pt>
              </c:numCache>
            </c:numRef>
          </c:xVal>
          <c:yVal>
            <c:numRef>
              <c:f>'4SUdose'!$F$2:$F$708</c:f>
              <c:numCache>
                <c:formatCode>0.00</c:formatCode>
                <c:ptCount val="707"/>
                <c:pt idx="0">
                  <c:v>1.3371088908562034</c:v>
                </c:pt>
                <c:pt idx="1">
                  <c:v>1.2976826712345966</c:v>
                </c:pt>
                <c:pt idx="2">
                  <c:v>1.075089376931238</c:v>
                </c:pt>
                <c:pt idx="3">
                  <c:v>1.0083875849092538</c:v>
                </c:pt>
                <c:pt idx="4">
                  <c:v>1.0221651749321465</c:v>
                </c:pt>
                <c:pt idx="5">
                  <c:v>1.0276113636284232</c:v>
                </c:pt>
                <c:pt idx="6">
                  <c:v>0.95682683840305349</c:v>
                </c:pt>
                <c:pt idx="7">
                  <c:v>1.6802282709322331</c:v>
                </c:pt>
                <c:pt idx="8">
                  <c:v>1.0591877747617962</c:v>
                </c:pt>
                <c:pt idx="9">
                  <c:v>1.2599214686968274</c:v>
                </c:pt>
                <c:pt idx="10">
                  <c:v>1.0941377464358821</c:v>
                </c:pt>
                <c:pt idx="11">
                  <c:v>1.0508885397905949</c:v>
                </c:pt>
                <c:pt idx="12">
                  <c:v>1.1286847563896742</c:v>
                </c:pt>
                <c:pt idx="13">
                  <c:v>1.2484010612389158</c:v>
                </c:pt>
                <c:pt idx="14">
                  <c:v>0.99356763057681208</c:v>
                </c:pt>
                <c:pt idx="15">
                  <c:v>1.2095058965298882</c:v>
                </c:pt>
                <c:pt idx="16">
                  <c:v>1.2953519568832805</c:v>
                </c:pt>
                <c:pt idx="17">
                  <c:v>1.1551983003394686</c:v>
                </c:pt>
                <c:pt idx="18">
                  <c:v>1.0584812534781449</c:v>
                </c:pt>
                <c:pt idx="19">
                  <c:v>1.02455764381095</c:v>
                </c:pt>
                <c:pt idx="20">
                  <c:v>1.1972248988670313</c:v>
                </c:pt>
                <c:pt idx="21">
                  <c:v>1.0343505299298634</c:v>
                </c:pt>
                <c:pt idx="22">
                  <c:v>1.1769255301855275</c:v>
                </c:pt>
                <c:pt idx="23">
                  <c:v>1.071892658237853</c:v>
                </c:pt>
                <c:pt idx="24">
                  <c:v>1.2646228170095626</c:v>
                </c:pt>
                <c:pt idx="25">
                  <c:v>1.1890299261340591</c:v>
                </c:pt>
                <c:pt idx="26">
                  <c:v>1.06138155645139</c:v>
                </c:pt>
                <c:pt idx="27">
                  <c:v>1.0793378774476012</c:v>
                </c:pt>
                <c:pt idx="28">
                  <c:v>1.0097626541409679</c:v>
                </c:pt>
                <c:pt idx="29">
                  <c:v>1.2453565961231479</c:v>
                </c:pt>
                <c:pt idx="30">
                  <c:v>1.0146949208630129</c:v>
                </c:pt>
                <c:pt idx="31">
                  <c:v>1.1428652469616027</c:v>
                </c:pt>
                <c:pt idx="32">
                  <c:v>1.0478157046972143</c:v>
                </c:pt>
                <c:pt idx="33">
                  <c:v>1.3386680881993358</c:v>
                </c:pt>
                <c:pt idx="34">
                  <c:v>1.2206775596789643</c:v>
                </c:pt>
                <c:pt idx="35">
                  <c:v>1.8724200426561348</c:v>
                </c:pt>
                <c:pt idx="36">
                  <c:v>1.299638470203746</c:v>
                </c:pt>
                <c:pt idx="37">
                  <c:v>1.2777424482126674</c:v>
                </c:pt>
                <c:pt idx="38">
                  <c:v>1.1523159439518569</c:v>
                </c:pt>
                <c:pt idx="39">
                  <c:v>1.2685842713129207</c:v>
                </c:pt>
                <c:pt idx="40">
                  <c:v>1.1886388166883912</c:v>
                </c:pt>
                <c:pt idx="41">
                  <c:v>1.1112520627762696</c:v>
                </c:pt>
                <c:pt idx="42">
                  <c:v>1.1614012188687293</c:v>
                </c:pt>
                <c:pt idx="43">
                  <c:v>1.3647711393891599</c:v>
                </c:pt>
                <c:pt idx="44">
                  <c:v>1.1116211625536958</c:v>
                </c:pt>
                <c:pt idx="45">
                  <c:v>1.104276980537868</c:v>
                </c:pt>
                <c:pt idx="46">
                  <c:v>1.3503501690026638</c:v>
                </c:pt>
                <c:pt idx="47">
                  <c:v>1.1653170650899944</c:v>
                </c:pt>
                <c:pt idx="48">
                  <c:v>1.9909949566665035</c:v>
                </c:pt>
                <c:pt idx="49">
                  <c:v>1.1478293286509185</c:v>
                </c:pt>
                <c:pt idx="50">
                  <c:v>1.7031952528684691</c:v>
                </c:pt>
                <c:pt idx="51">
                  <c:v>1.116246085358594</c:v>
                </c:pt>
                <c:pt idx="52">
                  <c:v>1.0542841755907413</c:v>
                </c:pt>
                <c:pt idx="53">
                  <c:v>1.135874780550892</c:v>
                </c:pt>
                <c:pt idx="54">
                  <c:v>1.3442076062947288</c:v>
                </c:pt>
                <c:pt idx="55">
                  <c:v>1.2082960447732365</c:v>
                </c:pt>
                <c:pt idx="56">
                  <c:v>1.4414062795496476</c:v>
                </c:pt>
                <c:pt idx="57">
                  <c:v>1.2454322417398112</c:v>
                </c:pt>
                <c:pt idx="58">
                  <c:v>1.2662518781728134</c:v>
                </c:pt>
                <c:pt idx="59">
                  <c:v>1.2856569769197865</c:v>
                </c:pt>
                <c:pt idx="60">
                  <c:v>1.0154167988371094</c:v>
                </c:pt>
                <c:pt idx="61">
                  <c:v>1.5012692321275118</c:v>
                </c:pt>
                <c:pt idx="62">
                  <c:v>1.0721086327046894</c:v>
                </c:pt>
                <c:pt idx="63">
                  <c:v>1.0499952210501518</c:v>
                </c:pt>
                <c:pt idx="64">
                  <c:v>1.0718103979683551</c:v>
                </c:pt>
                <c:pt idx="65">
                  <c:v>1.2952035731730172</c:v>
                </c:pt>
                <c:pt idx="66">
                  <c:v>1.1836379655319025</c:v>
                </c:pt>
                <c:pt idx="67">
                  <c:v>0.95365917394962518</c:v>
                </c:pt>
                <c:pt idx="68">
                  <c:v>0.96452956906038734</c:v>
                </c:pt>
                <c:pt idx="69">
                  <c:v>1.3002308059602754</c:v>
                </c:pt>
                <c:pt idx="70">
                  <c:v>1.2005782004146255</c:v>
                </c:pt>
                <c:pt idx="71">
                  <c:v>1.1332544578423391</c:v>
                </c:pt>
                <c:pt idx="72">
                  <c:v>1.18884614860293</c:v>
                </c:pt>
                <c:pt idx="73">
                  <c:v>1.1729173853985562</c:v>
                </c:pt>
                <c:pt idx="74">
                  <c:v>1.3023206052956298</c:v>
                </c:pt>
                <c:pt idx="75">
                  <c:v>0.95605110500481461</c:v>
                </c:pt>
                <c:pt idx="76">
                  <c:v>1.5261675953054521</c:v>
                </c:pt>
                <c:pt idx="77">
                  <c:v>1.1064393609735075</c:v>
                </c:pt>
                <c:pt idx="78">
                  <c:v>1.1413888995306543</c:v>
                </c:pt>
                <c:pt idx="79">
                  <c:v>1.1156546764838045</c:v>
                </c:pt>
                <c:pt idx="80">
                  <c:v>1.3943657195927288</c:v>
                </c:pt>
                <c:pt idx="81">
                  <c:v>1.1828337041654244</c:v>
                </c:pt>
                <c:pt idx="82">
                  <c:v>1.1856614594064359</c:v>
                </c:pt>
                <c:pt idx="83">
                  <c:v>1.0761765610331779</c:v>
                </c:pt>
                <c:pt idx="84">
                  <c:v>1.0541660143463041</c:v>
                </c:pt>
                <c:pt idx="85">
                  <c:v>1.4922116951915241</c:v>
                </c:pt>
                <c:pt idx="86">
                  <c:v>1.1474177891118125</c:v>
                </c:pt>
                <c:pt idx="87">
                  <c:v>1.6510984318440123</c:v>
                </c:pt>
                <c:pt idx="88">
                  <c:v>1.2682809958700669</c:v>
                </c:pt>
                <c:pt idx="89">
                  <c:v>1.3454945956481872</c:v>
                </c:pt>
                <c:pt idx="90">
                  <c:v>1.1884305490215354</c:v>
                </c:pt>
                <c:pt idx="91">
                  <c:v>1.3543300932538298</c:v>
                </c:pt>
                <c:pt idx="92">
                  <c:v>0.99333119258043612</c:v>
                </c:pt>
                <c:pt idx="93">
                  <c:v>0.95440944028848529</c:v>
                </c:pt>
                <c:pt idx="94">
                  <c:v>1.3209957116048245</c:v>
                </c:pt>
                <c:pt idx="95">
                  <c:v>1.4189382405617983</c:v>
                </c:pt>
                <c:pt idx="96">
                  <c:v>1.2873615547110842</c:v>
                </c:pt>
                <c:pt idx="97">
                  <c:v>1.4166673437605795</c:v>
                </c:pt>
                <c:pt idx="98">
                  <c:v>1.4180149939000875</c:v>
                </c:pt>
                <c:pt idx="99">
                  <c:v>1.3188135933522886</c:v>
                </c:pt>
                <c:pt idx="100">
                  <c:v>1.2162122126187902</c:v>
                </c:pt>
                <c:pt idx="101">
                  <c:v>0.87220066830529985</c:v>
                </c:pt>
                <c:pt idx="102">
                  <c:v>1.3610696975274557</c:v>
                </c:pt>
                <c:pt idx="103">
                  <c:v>1.4719138979878335</c:v>
                </c:pt>
                <c:pt idx="104">
                  <c:v>1.6350625078246561</c:v>
                </c:pt>
                <c:pt idx="105">
                  <c:v>1.214036533009224</c:v>
                </c:pt>
                <c:pt idx="106">
                  <c:v>1.2784135281521603</c:v>
                </c:pt>
                <c:pt idx="107">
                  <c:v>1.3220744343464983</c:v>
                </c:pt>
                <c:pt idx="108">
                  <c:v>1.0580345820965038</c:v>
                </c:pt>
                <c:pt idx="109">
                  <c:v>1.0352738299542867</c:v>
                </c:pt>
                <c:pt idx="110">
                  <c:v>1.0802895103473227</c:v>
                </c:pt>
                <c:pt idx="111">
                  <c:v>1.0951905155465174</c:v>
                </c:pt>
                <c:pt idx="112">
                  <c:v>0.99702002777103838</c:v>
                </c:pt>
                <c:pt idx="113">
                  <c:v>0.95857360641611988</c:v>
                </c:pt>
                <c:pt idx="114">
                  <c:v>0.85371194710561527</c:v>
                </c:pt>
                <c:pt idx="115">
                  <c:v>1.2974915228835311</c:v>
                </c:pt>
                <c:pt idx="116">
                  <c:v>0.84953377023611354</c:v>
                </c:pt>
                <c:pt idx="117">
                  <c:v>1.5316779511142329</c:v>
                </c:pt>
                <c:pt idx="118">
                  <c:v>0.85525495982948019</c:v>
                </c:pt>
                <c:pt idx="119">
                  <c:v>0.96059829324451396</c:v>
                </c:pt>
                <c:pt idx="120">
                  <c:v>1.0093788392980572</c:v>
                </c:pt>
                <c:pt idx="121">
                  <c:v>1.293432611088517</c:v>
                </c:pt>
                <c:pt idx="122">
                  <c:v>1.6681282318701298</c:v>
                </c:pt>
                <c:pt idx="123">
                  <c:v>0.98779809403288577</c:v>
                </c:pt>
                <c:pt idx="124">
                  <c:v>1.1334415405952127</c:v>
                </c:pt>
                <c:pt idx="125">
                  <c:v>0.9422765048682108</c:v>
                </c:pt>
                <c:pt idx="126">
                  <c:v>1.1779009174806696</c:v>
                </c:pt>
                <c:pt idx="127">
                  <c:v>1.0233912148296622</c:v>
                </c:pt>
                <c:pt idx="128">
                  <c:v>1.1791310716535579</c:v>
                </c:pt>
                <c:pt idx="129">
                  <c:v>0.79903519224462016</c:v>
                </c:pt>
                <c:pt idx="130">
                  <c:v>0.94419067340682539</c:v>
                </c:pt>
                <c:pt idx="131">
                  <c:v>1.21037117299968</c:v>
                </c:pt>
                <c:pt idx="132">
                  <c:v>0.96610609351777754</c:v>
                </c:pt>
                <c:pt idx="133">
                  <c:v>1.3422776163661145</c:v>
                </c:pt>
                <c:pt idx="134">
                  <c:v>1.2086460775808345</c:v>
                </c:pt>
                <c:pt idx="135">
                  <c:v>1.2183164251159464</c:v>
                </c:pt>
                <c:pt idx="136">
                  <c:v>1.4161172421522825</c:v>
                </c:pt>
                <c:pt idx="137">
                  <c:v>1.4397812320629426</c:v>
                </c:pt>
                <c:pt idx="138">
                  <c:v>0.93536126523849683</c:v>
                </c:pt>
                <c:pt idx="139">
                  <c:v>1.1218753580469165</c:v>
                </c:pt>
                <c:pt idx="140">
                  <c:v>1.1965085820638313</c:v>
                </c:pt>
                <c:pt idx="141">
                  <c:v>1.4229698981908721</c:v>
                </c:pt>
                <c:pt idx="142">
                  <c:v>1.2648592705848654</c:v>
                </c:pt>
                <c:pt idx="143">
                  <c:v>1.2841274932872098</c:v>
                </c:pt>
                <c:pt idx="144">
                  <c:v>0.99775362927918732</c:v>
                </c:pt>
                <c:pt idx="145">
                  <c:v>1.537956183477291</c:v>
                </c:pt>
                <c:pt idx="146">
                  <c:v>1.2976841402012111</c:v>
                </c:pt>
                <c:pt idx="147">
                  <c:v>1.8110533932012922</c:v>
                </c:pt>
                <c:pt idx="148">
                  <c:v>1.1963914094819235</c:v>
                </c:pt>
                <c:pt idx="149">
                  <c:v>1.3713872891680949</c:v>
                </c:pt>
                <c:pt idx="150">
                  <c:v>1.2707005872045205</c:v>
                </c:pt>
                <c:pt idx="151">
                  <c:v>1.0985952652471782</c:v>
                </c:pt>
                <c:pt idx="152">
                  <c:v>1.5381643792888335</c:v>
                </c:pt>
                <c:pt idx="153">
                  <c:v>1.3275854953438533</c:v>
                </c:pt>
                <c:pt idx="154">
                  <c:v>0.86729334724853269</c:v>
                </c:pt>
                <c:pt idx="155">
                  <c:v>1.4901206672756115</c:v>
                </c:pt>
                <c:pt idx="156">
                  <c:v>1.280383444181828</c:v>
                </c:pt>
                <c:pt idx="157">
                  <c:v>0.93204206543517265</c:v>
                </c:pt>
                <c:pt idx="158">
                  <c:v>1.1777560223238266</c:v>
                </c:pt>
                <c:pt idx="159">
                  <c:v>0.88909505083739837</c:v>
                </c:pt>
                <c:pt idx="160">
                  <c:v>1.1672131149875817</c:v>
                </c:pt>
                <c:pt idx="161">
                  <c:v>1.051816235412754</c:v>
                </c:pt>
                <c:pt idx="162">
                  <c:v>1.2106916368884599</c:v>
                </c:pt>
                <c:pt idx="163">
                  <c:v>1.2126727608044467</c:v>
                </c:pt>
                <c:pt idx="164">
                  <c:v>1.6568886956065494</c:v>
                </c:pt>
                <c:pt idx="165">
                  <c:v>1.2693383330440984</c:v>
                </c:pt>
                <c:pt idx="166">
                  <c:v>0.92251735806621349</c:v>
                </c:pt>
                <c:pt idx="167">
                  <c:v>1.1255886762002647</c:v>
                </c:pt>
                <c:pt idx="168">
                  <c:v>0.95591936617357798</c:v>
                </c:pt>
                <c:pt idx="169">
                  <c:v>0.93287108964586052</c:v>
                </c:pt>
                <c:pt idx="170">
                  <c:v>1.5350086979486071</c:v>
                </c:pt>
                <c:pt idx="171">
                  <c:v>1.1125336066763807</c:v>
                </c:pt>
                <c:pt idx="172">
                  <c:v>1.0782651743988609</c:v>
                </c:pt>
                <c:pt idx="173">
                  <c:v>1.2912015409934925</c:v>
                </c:pt>
                <c:pt idx="174">
                  <c:v>1.0547461934584919</c:v>
                </c:pt>
                <c:pt idx="175">
                  <c:v>1.3035251929264702</c:v>
                </c:pt>
                <c:pt idx="176">
                  <c:v>1.1458507141138505</c:v>
                </c:pt>
                <c:pt idx="177">
                  <c:v>0.9343858738365749</c:v>
                </c:pt>
                <c:pt idx="178">
                  <c:v>0.90578751649576572</c:v>
                </c:pt>
                <c:pt idx="179">
                  <c:v>1.0350532585651282</c:v>
                </c:pt>
                <c:pt idx="180">
                  <c:v>1.1802703151232201</c:v>
                </c:pt>
                <c:pt idx="181">
                  <c:v>0.97187726263678254</c:v>
                </c:pt>
                <c:pt idx="182">
                  <c:v>1.0437755625108081</c:v>
                </c:pt>
                <c:pt idx="183">
                  <c:v>1.1850888245817357</c:v>
                </c:pt>
                <c:pt idx="184">
                  <c:v>1.2655345306911399</c:v>
                </c:pt>
                <c:pt idx="185">
                  <c:v>1.2813748028506944</c:v>
                </c:pt>
                <c:pt idx="186">
                  <c:v>1.2667729210817451</c:v>
                </c:pt>
                <c:pt idx="187">
                  <c:v>1.1028110848321984</c:v>
                </c:pt>
                <c:pt idx="188">
                  <c:v>0.96275514161887221</c:v>
                </c:pt>
                <c:pt idx="189">
                  <c:v>1.1337928891462288</c:v>
                </c:pt>
                <c:pt idx="190">
                  <c:v>1.3297235980110433</c:v>
                </c:pt>
                <c:pt idx="191">
                  <c:v>0.87691909625541598</c:v>
                </c:pt>
                <c:pt idx="192">
                  <c:v>1.3410537491455501</c:v>
                </c:pt>
                <c:pt idx="193">
                  <c:v>1.1101935495050077</c:v>
                </c:pt>
                <c:pt idx="194">
                  <c:v>1.2702522930593254</c:v>
                </c:pt>
                <c:pt idx="195">
                  <c:v>0.95578511459042437</c:v>
                </c:pt>
                <c:pt idx="196">
                  <c:v>1.1183779412016199</c:v>
                </c:pt>
                <c:pt idx="197">
                  <c:v>1.4034979522127691</c:v>
                </c:pt>
                <c:pt idx="198">
                  <c:v>1.4898547655429286</c:v>
                </c:pt>
                <c:pt idx="199">
                  <c:v>1.4204135220341232</c:v>
                </c:pt>
                <c:pt idx="200">
                  <c:v>1.2518196551927232</c:v>
                </c:pt>
                <c:pt idx="201">
                  <c:v>1.1545677113163226</c:v>
                </c:pt>
                <c:pt idx="202">
                  <c:v>1.069147408817557</c:v>
                </c:pt>
                <c:pt idx="203">
                  <c:v>1.288768607653759</c:v>
                </c:pt>
                <c:pt idx="204">
                  <c:v>1.3018671572447875</c:v>
                </c:pt>
                <c:pt idx="205">
                  <c:v>1.0717701579905838</c:v>
                </c:pt>
                <c:pt idx="206">
                  <c:v>1.177760331108928</c:v>
                </c:pt>
                <c:pt idx="207">
                  <c:v>1.0882924885195653</c:v>
                </c:pt>
                <c:pt idx="208">
                  <c:v>1.3223465836661779</c:v>
                </c:pt>
                <c:pt idx="209">
                  <c:v>1.2663262507802786</c:v>
                </c:pt>
                <c:pt idx="210">
                  <c:v>0.97286305929782013</c:v>
                </c:pt>
                <c:pt idx="211">
                  <c:v>1.3141053497715431</c:v>
                </c:pt>
                <c:pt idx="212">
                  <c:v>1.1601180436218266</c:v>
                </c:pt>
                <c:pt idx="213">
                  <c:v>1.8081056631016141</c:v>
                </c:pt>
                <c:pt idx="214">
                  <c:v>0.95892586688177428</c:v>
                </c:pt>
                <c:pt idx="215">
                  <c:v>0.99550115981182163</c:v>
                </c:pt>
                <c:pt idx="216">
                  <c:v>1.0123605871049008</c:v>
                </c:pt>
                <c:pt idx="217">
                  <c:v>1.3953874346505493</c:v>
                </c:pt>
                <c:pt idx="218">
                  <c:v>1.4522383781160011</c:v>
                </c:pt>
                <c:pt idx="219">
                  <c:v>1.0647629357377255</c:v>
                </c:pt>
                <c:pt idx="220">
                  <c:v>0.89647252112391129</c:v>
                </c:pt>
                <c:pt idx="221">
                  <c:v>0.95895713218040568</c:v>
                </c:pt>
                <c:pt idx="222">
                  <c:v>0.98143944657859794</c:v>
                </c:pt>
                <c:pt idx="223">
                  <c:v>1.1838490632431546</c:v>
                </c:pt>
                <c:pt idx="224">
                  <c:v>1.0845407901364099</c:v>
                </c:pt>
                <c:pt idx="225">
                  <c:v>1.161026620253492</c:v>
                </c:pt>
                <c:pt idx="226">
                  <c:v>1.0508708588884714</c:v>
                </c:pt>
                <c:pt idx="227">
                  <c:v>1.0567150312553764</c:v>
                </c:pt>
                <c:pt idx="228">
                  <c:v>1.2478986483104499</c:v>
                </c:pt>
                <c:pt idx="229">
                  <c:v>1.1247880420851508</c:v>
                </c:pt>
                <c:pt idx="230">
                  <c:v>1.0919825723805812</c:v>
                </c:pt>
                <c:pt idx="231">
                  <c:v>1.1888148531137805</c:v>
                </c:pt>
                <c:pt idx="232">
                  <c:v>1.0438890656219952</c:v>
                </c:pt>
                <c:pt idx="233">
                  <c:v>1.140509096534478</c:v>
                </c:pt>
                <c:pt idx="234">
                  <c:v>1.137749012603879</c:v>
                </c:pt>
                <c:pt idx="235">
                  <c:v>1.1000022058035064</c:v>
                </c:pt>
                <c:pt idx="236">
                  <c:v>1.0473277640019485</c:v>
                </c:pt>
                <c:pt idx="237">
                  <c:v>1.1169714414651253</c:v>
                </c:pt>
                <c:pt idx="238">
                  <c:v>1.2278793510022512</c:v>
                </c:pt>
                <c:pt idx="239">
                  <c:v>0.9101180418162359</c:v>
                </c:pt>
                <c:pt idx="240">
                  <c:v>1.1892030769766027</c:v>
                </c:pt>
                <c:pt idx="241">
                  <c:v>1.1048078748128307</c:v>
                </c:pt>
                <c:pt idx="242">
                  <c:v>1.1252843720189882</c:v>
                </c:pt>
                <c:pt idx="243">
                  <c:v>1.1202134304273246</c:v>
                </c:pt>
                <c:pt idx="244">
                  <c:v>1.0818046578284204</c:v>
                </c:pt>
                <c:pt idx="245">
                  <c:v>1.0319103515723067</c:v>
                </c:pt>
                <c:pt idx="246">
                  <c:v>1.1036352551244981</c:v>
                </c:pt>
                <c:pt idx="247">
                  <c:v>1.0601371142825042</c:v>
                </c:pt>
                <c:pt idx="248">
                  <c:v>1.2405142430518277</c:v>
                </c:pt>
                <c:pt idx="249">
                  <c:v>1.0672808824392168</c:v>
                </c:pt>
                <c:pt idx="250">
                  <c:v>1.2364080838725469</c:v>
                </c:pt>
                <c:pt idx="251">
                  <c:v>1.101426433566782</c:v>
                </c:pt>
                <c:pt idx="252">
                  <c:v>1.1532475938891278</c:v>
                </c:pt>
                <c:pt idx="253">
                  <c:v>1.1848395611162896</c:v>
                </c:pt>
                <c:pt idx="254">
                  <c:v>1.0592223397746092</c:v>
                </c:pt>
                <c:pt idx="255">
                  <c:v>1.5145857411615453</c:v>
                </c:pt>
                <c:pt idx="256">
                  <c:v>0.99547380402065011</c:v>
                </c:pt>
                <c:pt idx="257">
                  <c:v>1.1938444899653586</c:v>
                </c:pt>
                <c:pt idx="258">
                  <c:v>1.7339761005493068</c:v>
                </c:pt>
                <c:pt idx="259">
                  <c:v>1.4107944236633554</c:v>
                </c:pt>
                <c:pt idx="260">
                  <c:v>1.0686868065720074</c:v>
                </c:pt>
                <c:pt idx="261">
                  <c:v>1.2528364199207283</c:v>
                </c:pt>
                <c:pt idx="262">
                  <c:v>1.065029772001683</c:v>
                </c:pt>
                <c:pt idx="263">
                  <c:v>1.1959509510637534</c:v>
                </c:pt>
                <c:pt idx="264">
                  <c:v>1.1752621846110449</c:v>
                </c:pt>
                <c:pt idx="265">
                  <c:v>1.0664062070009037</c:v>
                </c:pt>
                <c:pt idx="266">
                  <c:v>1.0367544555370398</c:v>
                </c:pt>
                <c:pt idx="267">
                  <c:v>0.99598740427388954</c:v>
                </c:pt>
                <c:pt idx="268">
                  <c:v>1.3333585001352775</c:v>
                </c:pt>
                <c:pt idx="269">
                  <c:v>1.1781112902294073</c:v>
                </c:pt>
                <c:pt idx="270">
                  <c:v>1.1729257493183149</c:v>
                </c:pt>
                <c:pt idx="271">
                  <c:v>1.1018368488929333</c:v>
                </c:pt>
                <c:pt idx="272">
                  <c:v>1.0734371573809072</c:v>
                </c:pt>
                <c:pt idx="273">
                  <c:v>1.1338577278676558</c:v>
                </c:pt>
                <c:pt idx="274">
                  <c:v>1.2708630803748058</c:v>
                </c:pt>
                <c:pt idx="275">
                  <c:v>1.1817599014965252</c:v>
                </c:pt>
                <c:pt idx="276">
                  <c:v>1.567390935539986</c:v>
                </c:pt>
                <c:pt idx="277">
                  <c:v>1.1963038685845413</c:v>
                </c:pt>
                <c:pt idx="278">
                  <c:v>1.1962979955401596</c:v>
                </c:pt>
                <c:pt idx="279">
                  <c:v>1.104315758249379</c:v>
                </c:pt>
                <c:pt idx="280">
                  <c:v>0.91464700150603828</c:v>
                </c:pt>
                <c:pt idx="281">
                  <c:v>1.311289329297219</c:v>
                </c:pt>
                <c:pt idx="282">
                  <c:v>1.1948198153853997</c:v>
                </c:pt>
                <c:pt idx="283">
                  <c:v>1.8705931021834752</c:v>
                </c:pt>
                <c:pt idx="284">
                  <c:v>1.1032054158850668</c:v>
                </c:pt>
                <c:pt idx="285">
                  <c:v>1.1106876070479363</c:v>
                </c:pt>
                <c:pt idx="286">
                  <c:v>1.0314656863386253</c:v>
                </c:pt>
                <c:pt idx="287">
                  <c:v>0.98514866118680178</c:v>
                </c:pt>
                <c:pt idx="288">
                  <c:v>1.2844875553201518</c:v>
                </c:pt>
                <c:pt idx="289">
                  <c:v>1.4078127904760114</c:v>
                </c:pt>
                <c:pt idx="290">
                  <c:v>1.0607160033713914</c:v>
                </c:pt>
                <c:pt idx="291">
                  <c:v>1.0720175340955471</c:v>
                </c:pt>
                <c:pt idx="292">
                  <c:v>1.1937888029636172</c:v>
                </c:pt>
                <c:pt idx="293">
                  <c:v>1.3667462727162578</c:v>
                </c:pt>
                <c:pt idx="294">
                  <c:v>1.4527707319302576</c:v>
                </c:pt>
                <c:pt idx="295">
                  <c:v>1.0842203898647262</c:v>
                </c:pt>
                <c:pt idx="296">
                  <c:v>1.0790879386513839</c:v>
                </c:pt>
                <c:pt idx="297">
                  <c:v>1.0202281788526806</c:v>
                </c:pt>
                <c:pt idx="298">
                  <c:v>2.1540006844278188</c:v>
                </c:pt>
                <c:pt idx="299">
                  <c:v>1.3600803930742054</c:v>
                </c:pt>
                <c:pt idx="300">
                  <c:v>1.1277944430497253</c:v>
                </c:pt>
                <c:pt idx="301">
                  <c:v>1.2066581597473394</c:v>
                </c:pt>
                <c:pt idx="302">
                  <c:v>1.2541957831167401</c:v>
                </c:pt>
                <c:pt idx="303">
                  <c:v>0.98208007249869078</c:v>
                </c:pt>
                <c:pt idx="304">
                  <c:v>1.2056777355018762</c:v>
                </c:pt>
                <c:pt idx="305">
                  <c:v>1.3438323514162254</c:v>
                </c:pt>
                <c:pt idx="306">
                  <c:v>1.4217505483689865</c:v>
                </c:pt>
                <c:pt idx="307">
                  <c:v>0.92379117592940607</c:v>
                </c:pt>
                <c:pt idx="308">
                  <c:v>1.0842079682736678</c:v>
                </c:pt>
                <c:pt idx="309">
                  <c:v>1.1312139845852014</c:v>
                </c:pt>
                <c:pt idx="310">
                  <c:v>1.1512910015208095</c:v>
                </c:pt>
                <c:pt idx="311">
                  <c:v>0.99006296453063891</c:v>
                </c:pt>
                <c:pt idx="312">
                  <c:v>0.79252999443330174</c:v>
                </c:pt>
                <c:pt idx="313">
                  <c:v>1.3382585502392752</c:v>
                </c:pt>
                <c:pt idx="314">
                  <c:v>1.1903021966431384</c:v>
                </c:pt>
                <c:pt idx="315">
                  <c:v>1.1916626318089092</c:v>
                </c:pt>
                <c:pt idx="316">
                  <c:v>1.3643706129333104</c:v>
                </c:pt>
                <c:pt idx="317">
                  <c:v>1.1472952025951417</c:v>
                </c:pt>
                <c:pt idx="318">
                  <c:v>0.97770664222628956</c:v>
                </c:pt>
                <c:pt idx="319">
                  <c:v>1.7294640325556494</c:v>
                </c:pt>
                <c:pt idx="320">
                  <c:v>0.82157202763838011</c:v>
                </c:pt>
                <c:pt idx="321">
                  <c:v>1.0316772812835286</c:v>
                </c:pt>
                <c:pt idx="322">
                  <c:v>1.3444896023843391</c:v>
                </c:pt>
                <c:pt idx="323">
                  <c:v>0.83235969139022736</c:v>
                </c:pt>
                <c:pt idx="324">
                  <c:v>0.94137162318177336</c:v>
                </c:pt>
                <c:pt idx="325">
                  <c:v>1.114105653382762</c:v>
                </c:pt>
                <c:pt idx="326">
                  <c:v>0.93071349263564462</c:v>
                </c:pt>
                <c:pt idx="327">
                  <c:v>1.0026122632895782</c:v>
                </c:pt>
                <c:pt idx="328">
                  <c:v>0.91195090972445036</c:v>
                </c:pt>
                <c:pt idx="329">
                  <c:v>1.6285843822383423</c:v>
                </c:pt>
                <c:pt idx="330">
                  <c:v>1.244371706489569</c:v>
                </c:pt>
                <c:pt idx="331">
                  <c:v>0.94975963099578642</c:v>
                </c:pt>
                <c:pt idx="332">
                  <c:v>0.99078132348236247</c:v>
                </c:pt>
                <c:pt idx="333">
                  <c:v>0.78254214123006838</c:v>
                </c:pt>
                <c:pt idx="334">
                  <c:v>1.0739478283171509</c:v>
                </c:pt>
                <c:pt idx="335">
                  <c:v>1.3808584477421324</c:v>
                </c:pt>
                <c:pt idx="336">
                  <c:v>0.81509012204407572</c:v>
                </c:pt>
                <c:pt idx="337">
                  <c:v>1.11968675648829</c:v>
                </c:pt>
                <c:pt idx="338">
                  <c:v>1.2159011149204977</c:v>
                </c:pt>
                <c:pt idx="339">
                  <c:v>1.3422495390588869</c:v>
                </c:pt>
                <c:pt idx="340">
                  <c:v>0.93179469827530514</c:v>
                </c:pt>
                <c:pt idx="341">
                  <c:v>1.0576186643864327</c:v>
                </c:pt>
                <c:pt idx="342">
                  <c:v>1.2008674842955429</c:v>
                </c:pt>
                <c:pt idx="343">
                  <c:v>1.0540519525216752</c:v>
                </c:pt>
                <c:pt idx="344">
                  <c:v>1.7294769795218443</c:v>
                </c:pt>
                <c:pt idx="345">
                  <c:v>1.7100564609850097</c:v>
                </c:pt>
                <c:pt idx="346">
                  <c:v>1.1000806396480967</c:v>
                </c:pt>
                <c:pt idx="347">
                  <c:v>1.0855635966142128</c:v>
                </c:pt>
                <c:pt idx="348">
                  <c:v>0.99166833407223609</c:v>
                </c:pt>
                <c:pt idx="349">
                  <c:v>1.2488971076711295</c:v>
                </c:pt>
                <c:pt idx="350">
                  <c:v>0.98005896357096223</c:v>
                </c:pt>
                <c:pt idx="351">
                  <c:v>1.2760072011623573</c:v>
                </c:pt>
                <c:pt idx="352">
                  <c:v>1.3512747988653415</c:v>
                </c:pt>
                <c:pt idx="353">
                  <c:v>0.91961607371209908</c:v>
                </c:pt>
                <c:pt idx="354">
                  <c:v>0.99930864398557573</c:v>
                </c:pt>
                <c:pt idx="355">
                  <c:v>1.3197887405261099</c:v>
                </c:pt>
                <c:pt idx="356">
                  <c:v>1.2657057464490833</c:v>
                </c:pt>
                <c:pt idx="357">
                  <c:v>1.1273642511674222</c:v>
                </c:pt>
                <c:pt idx="358">
                  <c:v>1.2224561929355344</c:v>
                </c:pt>
                <c:pt idx="359">
                  <c:v>1.0264494268617979</c:v>
                </c:pt>
                <c:pt idx="360">
                  <c:v>0.91642626759873813</c:v>
                </c:pt>
                <c:pt idx="361">
                  <c:v>1.2156230717400474</c:v>
                </c:pt>
                <c:pt idx="362">
                  <c:v>0.97022969904994283</c:v>
                </c:pt>
                <c:pt idx="363">
                  <c:v>0.97255107566983034</c:v>
                </c:pt>
                <c:pt idx="364">
                  <c:v>1.2268972638100155</c:v>
                </c:pt>
                <c:pt idx="365">
                  <c:v>0.99449410615049072</c:v>
                </c:pt>
                <c:pt idx="366">
                  <c:v>1.0167387979665059</c:v>
                </c:pt>
                <c:pt idx="367">
                  <c:v>1.1170852145651318</c:v>
                </c:pt>
                <c:pt idx="368">
                  <c:v>1.0060225396727094</c:v>
                </c:pt>
                <c:pt idx="369">
                  <c:v>1.0676547590325636</c:v>
                </c:pt>
                <c:pt idx="370">
                  <c:v>1.1848560510557831</c:v>
                </c:pt>
                <c:pt idx="371">
                  <c:v>1.211588049312498</c:v>
                </c:pt>
                <c:pt idx="372">
                  <c:v>1.0150521288106555</c:v>
                </c:pt>
                <c:pt idx="373">
                  <c:v>1.2876888029427334</c:v>
                </c:pt>
                <c:pt idx="374">
                  <c:v>1.2016994852158018</c:v>
                </c:pt>
                <c:pt idx="375">
                  <c:v>1.1356898015257726</c:v>
                </c:pt>
                <c:pt idx="376">
                  <c:v>1.0560212306014698</c:v>
                </c:pt>
                <c:pt idx="377">
                  <c:v>0.9571732724339177</c:v>
                </c:pt>
                <c:pt idx="378">
                  <c:v>1.1806260229312495</c:v>
                </c:pt>
                <c:pt idx="379">
                  <c:v>1.1126913419118867</c:v>
                </c:pt>
                <c:pt idx="380">
                  <c:v>1.018617768453016</c:v>
                </c:pt>
                <c:pt idx="381">
                  <c:v>1.1180796874228551</c:v>
                </c:pt>
                <c:pt idx="382">
                  <c:v>1.2050938798108302</c:v>
                </c:pt>
                <c:pt idx="383">
                  <c:v>1.2366916823545362</c:v>
                </c:pt>
                <c:pt idx="384">
                  <c:v>1.1273267378692133</c:v>
                </c:pt>
                <c:pt idx="385">
                  <c:v>1.1476457688013419</c:v>
                </c:pt>
                <c:pt idx="386">
                  <c:v>1.2348859837670112</c:v>
                </c:pt>
                <c:pt idx="387">
                  <c:v>1.3101662962324954</c:v>
                </c:pt>
                <c:pt idx="388">
                  <c:v>1.009737669658352</c:v>
                </c:pt>
                <c:pt idx="389">
                  <c:v>1.026720986144291</c:v>
                </c:pt>
                <c:pt idx="390">
                  <c:v>1.0095064148657387</c:v>
                </c:pt>
                <c:pt idx="391">
                  <c:v>1.1198942912441878</c:v>
                </c:pt>
                <c:pt idx="392">
                  <c:v>1.0371401232672104</c:v>
                </c:pt>
                <c:pt idx="393">
                  <c:v>1.1832770884558961</c:v>
                </c:pt>
                <c:pt idx="394">
                  <c:v>1.0137364109552895</c:v>
                </c:pt>
                <c:pt idx="395">
                  <c:v>1.1119951487474977</c:v>
                </c:pt>
                <c:pt idx="396">
                  <c:v>1.42616107749329</c:v>
                </c:pt>
                <c:pt idx="397">
                  <c:v>1.1920069500362176</c:v>
                </c:pt>
                <c:pt idx="398">
                  <c:v>1.1951445179608506</c:v>
                </c:pt>
                <c:pt idx="399">
                  <c:v>1.2706423973023895</c:v>
                </c:pt>
                <c:pt idx="400">
                  <c:v>1.0612554397974325</c:v>
                </c:pt>
                <c:pt idx="401">
                  <c:v>1.0927600127465393</c:v>
                </c:pt>
                <c:pt idx="402">
                  <c:v>1.2437722807984479</c:v>
                </c:pt>
                <c:pt idx="403">
                  <c:v>1.013289478775262</c:v>
                </c:pt>
                <c:pt idx="404">
                  <c:v>1.0913660083971719</c:v>
                </c:pt>
                <c:pt idx="405">
                  <c:v>1.187568990624456</c:v>
                </c:pt>
                <c:pt idx="406">
                  <c:v>1.4013969539610258</c:v>
                </c:pt>
                <c:pt idx="407">
                  <c:v>1.3259394761664456</c:v>
                </c:pt>
                <c:pt idx="408">
                  <c:v>1.1236851825579715</c:v>
                </c:pt>
                <c:pt idx="409">
                  <c:v>1.4563453407441873</c:v>
                </c:pt>
                <c:pt idx="410">
                  <c:v>1.1594381355379615</c:v>
                </c:pt>
                <c:pt idx="411">
                  <c:v>1.19597712461525</c:v>
                </c:pt>
                <c:pt idx="412">
                  <c:v>0.99677978688127067</c:v>
                </c:pt>
                <c:pt idx="413">
                  <c:v>0.95150103635925931</c:v>
                </c:pt>
                <c:pt idx="414">
                  <c:v>1.0965564149018514</c:v>
                </c:pt>
                <c:pt idx="415">
                  <c:v>0.98663995315603037</c:v>
                </c:pt>
                <c:pt idx="416">
                  <c:v>1.3185582628710004</c:v>
                </c:pt>
                <c:pt idx="417">
                  <c:v>1.200793410066562</c:v>
                </c:pt>
                <c:pt idx="418">
                  <c:v>1.1501256961994002</c:v>
                </c:pt>
                <c:pt idx="419">
                  <c:v>1.121179551143586</c:v>
                </c:pt>
                <c:pt idx="420">
                  <c:v>1.1602705186323945</c:v>
                </c:pt>
                <c:pt idx="421">
                  <c:v>1.1550926202436369</c:v>
                </c:pt>
                <c:pt idx="422">
                  <c:v>1.2368995833553351</c:v>
                </c:pt>
                <c:pt idx="423">
                  <c:v>1.0220746328915138</c:v>
                </c:pt>
                <c:pt idx="424">
                  <c:v>1.176036947713428</c:v>
                </c:pt>
                <c:pt idx="425">
                  <c:v>1.145289439232511</c:v>
                </c:pt>
                <c:pt idx="426">
                  <c:v>1.0333579579363825</c:v>
                </c:pt>
                <c:pt idx="427">
                  <c:v>1.2239579864490018</c:v>
                </c:pt>
                <c:pt idx="428">
                  <c:v>1.0864033992311077</c:v>
                </c:pt>
                <c:pt idx="429">
                  <c:v>1.1438515923319053</c:v>
                </c:pt>
                <c:pt idx="430">
                  <c:v>1.0597048813333623</c:v>
                </c:pt>
                <c:pt idx="431">
                  <c:v>1.0664187868698776</c:v>
                </c:pt>
                <c:pt idx="432">
                  <c:v>1.1759495648221336</c:v>
                </c:pt>
                <c:pt idx="433">
                  <c:v>1.0022978029668772</c:v>
                </c:pt>
                <c:pt idx="434">
                  <c:v>1.3877531687914679</c:v>
                </c:pt>
                <c:pt idx="435">
                  <c:v>1.0910851795218328</c:v>
                </c:pt>
                <c:pt idx="436">
                  <c:v>1.3288778164747386</c:v>
                </c:pt>
                <c:pt idx="437">
                  <c:v>1.1561200046059057</c:v>
                </c:pt>
                <c:pt idx="438">
                  <c:v>1.232645340969301</c:v>
                </c:pt>
                <c:pt idx="439">
                  <c:v>1.2061009085634169</c:v>
                </c:pt>
                <c:pt idx="440">
                  <c:v>1.0709011006973554</c:v>
                </c:pt>
                <c:pt idx="441">
                  <c:v>1.4752170699396618</c:v>
                </c:pt>
                <c:pt idx="442">
                  <c:v>1.1618807843136087</c:v>
                </c:pt>
                <c:pt idx="443">
                  <c:v>1.0718805249499497</c:v>
                </c:pt>
                <c:pt idx="444">
                  <c:v>0.9706012226772911</c:v>
                </c:pt>
                <c:pt idx="445">
                  <c:v>1.0295788625024676</c:v>
                </c:pt>
                <c:pt idx="446">
                  <c:v>1.1771582945312051</c:v>
                </c:pt>
                <c:pt idx="447">
                  <c:v>1.107097602956862</c:v>
                </c:pt>
                <c:pt idx="448">
                  <c:v>1.0387900384101205</c:v>
                </c:pt>
                <c:pt idx="449">
                  <c:v>1.1319512514709522</c:v>
                </c:pt>
                <c:pt idx="450">
                  <c:v>1.110993475347877</c:v>
                </c:pt>
                <c:pt idx="451">
                  <c:v>1.1238400979586283</c:v>
                </c:pt>
                <c:pt idx="452">
                  <c:v>1.2007587355669684</c:v>
                </c:pt>
                <c:pt idx="453">
                  <c:v>1.4311014491531191</c:v>
                </c:pt>
                <c:pt idx="454">
                  <c:v>1.0925977635396991</c:v>
                </c:pt>
                <c:pt idx="455">
                  <c:v>1.1568173366082926</c:v>
                </c:pt>
                <c:pt idx="456">
                  <c:v>1.1062103118487587</c:v>
                </c:pt>
                <c:pt idx="457">
                  <c:v>1.8573149160374995</c:v>
                </c:pt>
                <c:pt idx="458">
                  <c:v>1.3625820478226005</c:v>
                </c:pt>
                <c:pt idx="459">
                  <c:v>1.0096832616259364</c:v>
                </c:pt>
                <c:pt idx="460">
                  <c:v>1.1169942720913688</c:v>
                </c:pt>
                <c:pt idx="461">
                  <c:v>1.1470479128388211</c:v>
                </c:pt>
                <c:pt idx="462">
                  <c:v>1.1295840781828665</c:v>
                </c:pt>
                <c:pt idx="463">
                  <c:v>1.1872664204197854</c:v>
                </c:pt>
                <c:pt idx="464">
                  <c:v>1.0286218173561354</c:v>
                </c:pt>
                <c:pt idx="465">
                  <c:v>1.574773901440319</c:v>
                </c:pt>
                <c:pt idx="466">
                  <c:v>1.0787834715127429</c:v>
                </c:pt>
                <c:pt idx="467">
                  <c:v>1.8739379842518005</c:v>
                </c:pt>
                <c:pt idx="468">
                  <c:v>1.0478625522005776</c:v>
                </c:pt>
                <c:pt idx="469">
                  <c:v>0.97930181544694661</c:v>
                </c:pt>
                <c:pt idx="470">
                  <c:v>1.1877078504314829</c:v>
                </c:pt>
                <c:pt idx="471">
                  <c:v>1.1724925121283192</c:v>
                </c:pt>
                <c:pt idx="472">
                  <c:v>1.0619376889300622</c:v>
                </c:pt>
                <c:pt idx="473">
                  <c:v>1.3486970877503159</c:v>
                </c:pt>
                <c:pt idx="474">
                  <c:v>1.3784475352052721</c:v>
                </c:pt>
                <c:pt idx="475">
                  <c:v>1.1193086059267152</c:v>
                </c:pt>
                <c:pt idx="476">
                  <c:v>1.1412602047570104</c:v>
                </c:pt>
                <c:pt idx="477">
                  <c:v>1.1782142044137507</c:v>
                </c:pt>
                <c:pt idx="478">
                  <c:v>1.223820812913454</c:v>
                </c:pt>
                <c:pt idx="479">
                  <c:v>1.432472484276065</c:v>
                </c:pt>
                <c:pt idx="480">
                  <c:v>1.1672715791851538</c:v>
                </c:pt>
                <c:pt idx="481">
                  <c:v>1.1173330524208396</c:v>
                </c:pt>
                <c:pt idx="482">
                  <c:v>1.5240418078773657</c:v>
                </c:pt>
                <c:pt idx="483">
                  <c:v>1.1397470168279604</c:v>
                </c:pt>
                <c:pt idx="484">
                  <c:v>1.2091970153978473</c:v>
                </c:pt>
                <c:pt idx="485">
                  <c:v>1.3523135417106551</c:v>
                </c:pt>
                <c:pt idx="486">
                  <c:v>1.0481468216022505</c:v>
                </c:pt>
                <c:pt idx="487">
                  <c:v>1.2268110199666642</c:v>
                </c:pt>
                <c:pt idx="488">
                  <c:v>1.0879762439219569</c:v>
                </c:pt>
                <c:pt idx="489">
                  <c:v>0.98900682142763408</c:v>
                </c:pt>
                <c:pt idx="490">
                  <c:v>1.222319851519978</c:v>
                </c:pt>
                <c:pt idx="491">
                  <c:v>1.2241485476006946</c:v>
                </c:pt>
                <c:pt idx="492">
                  <c:v>1.3750117070424301</c:v>
                </c:pt>
                <c:pt idx="493">
                  <c:v>1.0555582306370637</c:v>
                </c:pt>
                <c:pt idx="494">
                  <c:v>1.0452677066896774</c:v>
                </c:pt>
                <c:pt idx="495">
                  <c:v>0.96707742353542581</c:v>
                </c:pt>
                <c:pt idx="496">
                  <c:v>1.4933034173650501</c:v>
                </c:pt>
                <c:pt idx="497">
                  <c:v>1.309240573748981</c:v>
                </c:pt>
                <c:pt idx="498">
                  <c:v>1.1698903735698625</c:v>
                </c:pt>
                <c:pt idx="499">
                  <c:v>1.015613255198476</c:v>
                </c:pt>
                <c:pt idx="500">
                  <c:v>1.3105693037199957</c:v>
                </c:pt>
                <c:pt idx="501">
                  <c:v>1.1333061253198871</c:v>
                </c:pt>
                <c:pt idx="502">
                  <c:v>1.1410233234953182</c:v>
                </c:pt>
                <c:pt idx="503">
                  <c:v>1.3222078059662474</c:v>
                </c:pt>
                <c:pt idx="504">
                  <c:v>1.2134190032296037</c:v>
                </c:pt>
                <c:pt idx="505">
                  <c:v>1.2158317804651626</c:v>
                </c:pt>
                <c:pt idx="506">
                  <c:v>1.3919980712741133</c:v>
                </c:pt>
                <c:pt idx="507">
                  <c:v>1.5268721238547096</c:v>
                </c:pt>
                <c:pt idx="508">
                  <c:v>1.142998826570468</c:v>
                </c:pt>
                <c:pt idx="509">
                  <c:v>1.1523623246639352</c:v>
                </c:pt>
                <c:pt idx="510">
                  <c:v>1.0538249945754115</c:v>
                </c:pt>
                <c:pt idx="511">
                  <c:v>1.099959529903344</c:v>
                </c:pt>
                <c:pt idx="512">
                  <c:v>1.1256805538019721</c:v>
                </c:pt>
                <c:pt idx="513">
                  <c:v>1.0871838086573506</c:v>
                </c:pt>
                <c:pt idx="514">
                  <c:v>1.1656432664007084</c:v>
                </c:pt>
                <c:pt idx="515">
                  <c:v>1.0658061454770811</c:v>
                </c:pt>
                <c:pt idx="516">
                  <c:v>1.214752202681149</c:v>
                </c:pt>
                <c:pt idx="517">
                  <c:v>1.1714395049113135</c:v>
                </c:pt>
                <c:pt idx="518">
                  <c:v>1.1232640893379189</c:v>
                </c:pt>
                <c:pt idx="519">
                  <c:v>1.0931383903440852</c:v>
                </c:pt>
                <c:pt idx="520">
                  <c:v>1.3097795018358964</c:v>
                </c:pt>
                <c:pt idx="521">
                  <c:v>1.5616362698005657</c:v>
                </c:pt>
                <c:pt idx="522">
                  <c:v>1.0105009735781638</c:v>
                </c:pt>
                <c:pt idx="523">
                  <c:v>1.1110968713731308</c:v>
                </c:pt>
                <c:pt idx="524">
                  <c:v>1.8778580466319723</c:v>
                </c:pt>
                <c:pt idx="525">
                  <c:v>1.1811370467378504</c:v>
                </c:pt>
                <c:pt idx="526">
                  <c:v>1.2050990869544682</c:v>
                </c:pt>
                <c:pt idx="527">
                  <c:v>1.1245410744161033</c:v>
                </c:pt>
                <c:pt idx="528">
                  <c:v>1.2866309188261946</c:v>
                </c:pt>
                <c:pt idx="529">
                  <c:v>1.0378893300352596</c:v>
                </c:pt>
                <c:pt idx="530">
                  <c:v>1.0708681535994882</c:v>
                </c:pt>
                <c:pt idx="531">
                  <c:v>1.1657853309146855</c:v>
                </c:pt>
                <c:pt idx="532">
                  <c:v>1.1878470230249569</c:v>
                </c:pt>
                <c:pt idx="533">
                  <c:v>1.1702804140839898</c:v>
                </c:pt>
                <c:pt idx="534">
                  <c:v>1.1034701830910163</c:v>
                </c:pt>
                <c:pt idx="535">
                  <c:v>0.93518761212201229</c:v>
                </c:pt>
                <c:pt idx="536">
                  <c:v>0.94287937436036873</c:v>
                </c:pt>
                <c:pt idx="537">
                  <c:v>1.4091256091258941</c:v>
                </c:pt>
                <c:pt idx="538">
                  <c:v>1.2986711741907426</c:v>
                </c:pt>
                <c:pt idx="539">
                  <c:v>0.99520478994191064</c:v>
                </c:pt>
                <c:pt idx="540">
                  <c:v>1.1027025748928905</c:v>
                </c:pt>
                <c:pt idx="541">
                  <c:v>0.99321898648404316</c:v>
                </c:pt>
                <c:pt idx="542">
                  <c:v>1.1210467556923025</c:v>
                </c:pt>
                <c:pt idx="543">
                  <c:v>1.6596836360065785</c:v>
                </c:pt>
                <c:pt idx="544">
                  <c:v>1.1613954696032094</c:v>
                </c:pt>
                <c:pt idx="545">
                  <c:v>1.0081820932830561</c:v>
                </c:pt>
                <c:pt idx="546">
                  <c:v>1.1037581151376037</c:v>
                </c:pt>
                <c:pt idx="547">
                  <c:v>1.0771616500199157</c:v>
                </c:pt>
                <c:pt idx="548">
                  <c:v>1.0664687819364214</c:v>
                </c:pt>
                <c:pt idx="549">
                  <c:v>1.0388037631423863</c:v>
                </c:pt>
                <c:pt idx="550">
                  <c:v>0.98259151391554167</c:v>
                </c:pt>
                <c:pt idx="551">
                  <c:v>1.2168332679196574</c:v>
                </c:pt>
                <c:pt idx="552">
                  <c:v>1.262576210977566</c:v>
                </c:pt>
                <c:pt idx="553">
                  <c:v>1.1266842734328906</c:v>
                </c:pt>
                <c:pt idx="554">
                  <c:v>1.1041557297022009</c:v>
                </c:pt>
                <c:pt idx="555">
                  <c:v>1.1342706203767794</c:v>
                </c:pt>
                <c:pt idx="556">
                  <c:v>1.0047485983887563</c:v>
                </c:pt>
                <c:pt idx="557">
                  <c:v>1.0481809328793312</c:v>
                </c:pt>
                <c:pt idx="558">
                  <c:v>1.2611586092543656</c:v>
                </c:pt>
                <c:pt idx="559">
                  <c:v>1.2641554275209799</c:v>
                </c:pt>
                <c:pt idx="560">
                  <c:v>1.1482166372292462</c:v>
                </c:pt>
                <c:pt idx="561">
                  <c:v>1.1531613201037314</c:v>
                </c:pt>
                <c:pt idx="562">
                  <c:v>1.0189891612376829</c:v>
                </c:pt>
                <c:pt idx="563">
                  <c:v>0.94246134134383386</c:v>
                </c:pt>
                <c:pt idx="564">
                  <c:v>1.3265293064112631</c:v>
                </c:pt>
                <c:pt idx="565">
                  <c:v>0.95199288132215054</c:v>
                </c:pt>
                <c:pt idx="566">
                  <c:v>1.0797236129963677</c:v>
                </c:pt>
                <c:pt idx="567">
                  <c:v>1.0528957628134863</c:v>
                </c:pt>
                <c:pt idx="568">
                  <c:v>1.2095840640414426</c:v>
                </c:pt>
                <c:pt idx="569">
                  <c:v>1.1979267168025258</c:v>
                </c:pt>
                <c:pt idx="570">
                  <c:v>1.0681425829537685</c:v>
                </c:pt>
                <c:pt idx="571">
                  <c:v>1.2124543448430842</c:v>
                </c:pt>
                <c:pt idx="572">
                  <c:v>1.1491324310841546</c:v>
                </c:pt>
                <c:pt idx="573">
                  <c:v>1.3557813601975348</c:v>
                </c:pt>
                <c:pt idx="574">
                  <c:v>1.0045864892247762</c:v>
                </c:pt>
                <c:pt idx="575">
                  <c:v>1.326482686615075</c:v>
                </c:pt>
                <c:pt idx="576">
                  <c:v>1.2705261578914859</c:v>
                </c:pt>
                <c:pt idx="577">
                  <c:v>1.1502760387479989</c:v>
                </c:pt>
                <c:pt idx="578">
                  <c:v>1.1752746133646628</c:v>
                </c:pt>
                <c:pt idx="579">
                  <c:v>1.116117915322278</c:v>
                </c:pt>
                <c:pt idx="580">
                  <c:v>1.3302280436685929</c:v>
                </c:pt>
                <c:pt idx="581">
                  <c:v>0.98275879693305246</c:v>
                </c:pt>
                <c:pt idx="582">
                  <c:v>1.0022956111320622</c:v>
                </c:pt>
                <c:pt idx="583">
                  <c:v>0.99755735939776446</c:v>
                </c:pt>
                <c:pt idx="584">
                  <c:v>1.1081804682528686</c:v>
                </c:pt>
                <c:pt idx="585">
                  <c:v>1.219192887228757</c:v>
                </c:pt>
                <c:pt idx="586">
                  <c:v>0.9735645146288876</c:v>
                </c:pt>
                <c:pt idx="587">
                  <c:v>1.2059863340269135</c:v>
                </c:pt>
                <c:pt idx="588">
                  <c:v>1.1332784200088075</c:v>
                </c:pt>
                <c:pt idx="589">
                  <c:v>1.4412038185528042</c:v>
                </c:pt>
                <c:pt idx="590">
                  <c:v>1.2679408839439561</c:v>
                </c:pt>
                <c:pt idx="591">
                  <c:v>1.103287310085191</c:v>
                </c:pt>
                <c:pt idx="592">
                  <c:v>0.88579044043477162</c:v>
                </c:pt>
                <c:pt idx="593">
                  <c:v>1.0839857519874199</c:v>
                </c:pt>
                <c:pt idx="594">
                  <c:v>1.2566328932834121</c:v>
                </c:pt>
                <c:pt idx="595">
                  <c:v>1.20632992095693</c:v>
                </c:pt>
                <c:pt idx="596">
                  <c:v>1.1297184098607649</c:v>
                </c:pt>
                <c:pt idx="597">
                  <c:v>1.2170151763411221</c:v>
                </c:pt>
                <c:pt idx="598">
                  <c:v>1.5655941364570998</c:v>
                </c:pt>
                <c:pt idx="599">
                  <c:v>1.2212849959978287</c:v>
                </c:pt>
                <c:pt idx="600">
                  <c:v>1.3088690949470467</c:v>
                </c:pt>
                <c:pt idx="601">
                  <c:v>1.2057025635567373</c:v>
                </c:pt>
                <c:pt idx="602">
                  <c:v>1.1207364455705027</c:v>
                </c:pt>
                <c:pt idx="603">
                  <c:v>1.0079350246674788</c:v>
                </c:pt>
                <c:pt idx="604">
                  <c:v>0.98471154894813551</c:v>
                </c:pt>
                <c:pt idx="605">
                  <c:v>1.0888332898308684</c:v>
                </c:pt>
                <c:pt idx="606">
                  <c:v>1.1618130014966475</c:v>
                </c:pt>
                <c:pt idx="607">
                  <c:v>1.2431075893792125</c:v>
                </c:pt>
                <c:pt idx="608">
                  <c:v>1.1004046565491288</c:v>
                </c:pt>
                <c:pt idx="609">
                  <c:v>1.2938259244424815</c:v>
                </c:pt>
                <c:pt idx="610">
                  <c:v>1.2994122026680106</c:v>
                </c:pt>
                <c:pt idx="611">
                  <c:v>1.0165391981100504</c:v>
                </c:pt>
                <c:pt idx="612">
                  <c:v>1.1257630521553001</c:v>
                </c:pt>
                <c:pt idx="613">
                  <c:v>1.2627381296215112</c:v>
                </c:pt>
                <c:pt idx="614">
                  <c:v>1.0014089750987984</c:v>
                </c:pt>
                <c:pt idx="615">
                  <c:v>1.2118988895491607</c:v>
                </c:pt>
                <c:pt idx="616">
                  <c:v>1.006028115999539</c:v>
                </c:pt>
                <c:pt idx="617">
                  <c:v>0.97213972967890738</c:v>
                </c:pt>
                <c:pt idx="618">
                  <c:v>1.1705604700620225</c:v>
                </c:pt>
                <c:pt idx="619">
                  <c:v>1.0817820813746455</c:v>
                </c:pt>
                <c:pt idx="620">
                  <c:v>1.1088366579773203</c:v>
                </c:pt>
                <c:pt idx="621">
                  <c:v>1.1075241344070259</c:v>
                </c:pt>
                <c:pt idx="622">
                  <c:v>1.6786334669268377</c:v>
                </c:pt>
                <c:pt idx="623">
                  <c:v>1.0805361767447401</c:v>
                </c:pt>
                <c:pt idx="624">
                  <c:v>1.2792121326893859</c:v>
                </c:pt>
                <c:pt idx="625">
                  <c:v>1.2543970846605916</c:v>
                </c:pt>
                <c:pt idx="626">
                  <c:v>1.2364519817348514</c:v>
                </c:pt>
                <c:pt idx="627">
                  <c:v>1.3587130639076646</c:v>
                </c:pt>
                <c:pt idx="628">
                  <c:v>0.93146122348693339</c:v>
                </c:pt>
                <c:pt idx="629">
                  <c:v>1.2089250456548275</c:v>
                </c:pt>
                <c:pt idx="630">
                  <c:v>1.1246455597463954</c:v>
                </c:pt>
                <c:pt idx="631">
                  <c:v>1.4390258321841982</c:v>
                </c:pt>
                <c:pt idx="632">
                  <c:v>1.0206291678764494</c:v>
                </c:pt>
                <c:pt idx="633">
                  <c:v>1.2345848763387683</c:v>
                </c:pt>
                <c:pt idx="634">
                  <c:v>1.5005246675807526</c:v>
                </c:pt>
                <c:pt idx="635">
                  <c:v>1.3272571735568426</c:v>
                </c:pt>
                <c:pt idx="636">
                  <c:v>1.2932684140489208</c:v>
                </c:pt>
                <c:pt idx="637">
                  <c:v>1.0555374560425277</c:v>
                </c:pt>
                <c:pt idx="638">
                  <c:v>1.1859367077754834</c:v>
                </c:pt>
                <c:pt idx="639">
                  <c:v>1.0543564578745763</c:v>
                </c:pt>
                <c:pt idx="640">
                  <c:v>1.0310128360436368</c:v>
                </c:pt>
                <c:pt idx="641">
                  <c:v>1.1885497239654812</c:v>
                </c:pt>
                <c:pt idx="642">
                  <c:v>1.0935245998371892</c:v>
                </c:pt>
                <c:pt idx="643">
                  <c:v>1.0509041810947801</c:v>
                </c:pt>
                <c:pt idx="644">
                  <c:v>1.3682342613068637</c:v>
                </c:pt>
                <c:pt idx="645">
                  <c:v>1.1827907113081713</c:v>
                </c:pt>
                <c:pt idx="646">
                  <c:v>1.1213637637959115</c:v>
                </c:pt>
                <c:pt idx="647">
                  <c:v>1.0678803310458358</c:v>
                </c:pt>
                <c:pt idx="648">
                  <c:v>1.0908293848885013</c:v>
                </c:pt>
                <c:pt idx="649">
                  <c:v>1.1704633248653742</c:v>
                </c:pt>
                <c:pt idx="650">
                  <c:v>1.2657077020257028</c:v>
                </c:pt>
                <c:pt idx="651">
                  <c:v>1.5865639757567374</c:v>
                </c:pt>
                <c:pt idx="652">
                  <c:v>1.2933040159932219</c:v>
                </c:pt>
                <c:pt idx="653">
                  <c:v>1.1183218863968303</c:v>
                </c:pt>
                <c:pt idx="654">
                  <c:v>1.1081477536966011</c:v>
                </c:pt>
                <c:pt idx="655">
                  <c:v>0.91830629745232528</c:v>
                </c:pt>
                <c:pt idx="656">
                  <c:v>1.1574626624176041</c:v>
                </c:pt>
                <c:pt idx="657">
                  <c:v>1.2240968181264051</c:v>
                </c:pt>
                <c:pt idx="658">
                  <c:v>1.173357124496168</c:v>
                </c:pt>
                <c:pt idx="659">
                  <c:v>1.2032132871944317</c:v>
                </c:pt>
                <c:pt idx="660">
                  <c:v>1.1083881016558008</c:v>
                </c:pt>
                <c:pt idx="661">
                  <c:v>1.097238913509812</c:v>
                </c:pt>
                <c:pt idx="662">
                  <c:v>1.0884405464321294</c:v>
                </c:pt>
                <c:pt idx="663">
                  <c:v>1.2672077669868633</c:v>
                </c:pt>
                <c:pt idx="664">
                  <c:v>1.1097469238263298</c:v>
                </c:pt>
                <c:pt idx="665">
                  <c:v>1.0230529539260618</c:v>
                </c:pt>
                <c:pt idx="666">
                  <c:v>1.1540465975076979</c:v>
                </c:pt>
                <c:pt idx="667">
                  <c:v>1.0813081761226893</c:v>
                </c:pt>
                <c:pt idx="668">
                  <c:v>0.97949747598878756</c:v>
                </c:pt>
                <c:pt idx="669">
                  <c:v>1.4215045691328014</c:v>
                </c:pt>
                <c:pt idx="670">
                  <c:v>1.0493201087452697</c:v>
                </c:pt>
                <c:pt idx="671">
                  <c:v>1.1381661989776368</c:v>
                </c:pt>
                <c:pt idx="672">
                  <c:v>1.4180036970558783</c:v>
                </c:pt>
                <c:pt idx="673">
                  <c:v>1.2076078700518877</c:v>
                </c:pt>
                <c:pt idx="674">
                  <c:v>1.1927929218800053</c:v>
                </c:pt>
                <c:pt idx="675">
                  <c:v>1.1427523052424491</c:v>
                </c:pt>
                <c:pt idx="676">
                  <c:v>1.5022479262738264</c:v>
                </c:pt>
                <c:pt idx="677">
                  <c:v>0.9988632562288603</c:v>
                </c:pt>
                <c:pt idx="678">
                  <c:v>1.1098154470755401</c:v>
                </c:pt>
                <c:pt idx="679">
                  <c:v>0.98943610982294261</c:v>
                </c:pt>
                <c:pt idx="680">
                  <c:v>1.4426632716309744</c:v>
                </c:pt>
                <c:pt idx="681">
                  <c:v>1.2439600201847143</c:v>
                </c:pt>
                <c:pt idx="682">
                  <c:v>1.1915230311217575</c:v>
                </c:pt>
                <c:pt idx="683">
                  <c:v>1.2906767869186206</c:v>
                </c:pt>
                <c:pt idx="684">
                  <c:v>1.2847015897283747</c:v>
                </c:pt>
                <c:pt idx="685">
                  <c:v>1.3211191581851391</c:v>
                </c:pt>
                <c:pt idx="686">
                  <c:v>1.3600265721977243</c:v>
                </c:pt>
                <c:pt idx="687">
                  <c:v>1.2461243266969479</c:v>
                </c:pt>
                <c:pt idx="688">
                  <c:v>1.1572725094118999</c:v>
                </c:pt>
                <c:pt idx="689">
                  <c:v>1.0401098098264683</c:v>
                </c:pt>
                <c:pt idx="690">
                  <c:v>1.0566082834777371</c:v>
                </c:pt>
                <c:pt idx="691">
                  <c:v>1.0602924800475115</c:v>
                </c:pt>
                <c:pt idx="692">
                  <c:v>1.047428332741742</c:v>
                </c:pt>
                <c:pt idx="693">
                  <c:v>1.049063485013825</c:v>
                </c:pt>
                <c:pt idx="694">
                  <c:v>1.3216862776117884</c:v>
                </c:pt>
                <c:pt idx="695">
                  <c:v>1.4753194764270576</c:v>
                </c:pt>
                <c:pt idx="696">
                  <c:v>1.0395992139760661</c:v>
                </c:pt>
                <c:pt idx="697">
                  <c:v>1.0421472551988535</c:v>
                </c:pt>
                <c:pt idx="698">
                  <c:v>1.3664276127087971</c:v>
                </c:pt>
                <c:pt idx="699">
                  <c:v>1.1089850984780782</c:v>
                </c:pt>
                <c:pt idx="700">
                  <c:v>1.0954397496119246</c:v>
                </c:pt>
                <c:pt idx="701">
                  <c:v>1.0768430145094761</c:v>
                </c:pt>
                <c:pt idx="702">
                  <c:v>1.0451347274141152</c:v>
                </c:pt>
                <c:pt idx="703">
                  <c:v>1.2877862785745795</c:v>
                </c:pt>
                <c:pt idx="704">
                  <c:v>1.0885793854623633</c:v>
                </c:pt>
                <c:pt idx="705">
                  <c:v>1.0709081061084784</c:v>
                </c:pt>
                <c:pt idx="706">
                  <c:v>1.49520721345586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BF0-464C-9DE7-15205AFFE1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1479040"/>
        <c:axId val="1275047568"/>
      </c:scatterChart>
      <c:valAx>
        <c:axId val="911479040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4SU40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5047568"/>
        <c:crosses val="autoZero"/>
        <c:crossBetween val="midCat"/>
      </c:valAx>
      <c:valAx>
        <c:axId val="1275047568"/>
        <c:scaling>
          <c:orientation val="minMax"/>
          <c:max val="2.5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4SU16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1479040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b="1"/>
              <a:t>Corelation coefficiency =0.68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triplicate!$C$1</c:f>
              <c:strCache>
                <c:ptCount val="1"/>
                <c:pt idx="0">
                  <c:v>FCCD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9.1293015456401283E-2"/>
                  <c:y val="-4.2350174978127736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triplicate!$B$2:$B$708</c:f>
              <c:numCache>
                <c:formatCode>0.00</c:formatCode>
                <c:ptCount val="707"/>
                <c:pt idx="0">
                  <c:v>1.4853137674126557</c:v>
                </c:pt>
                <c:pt idx="1">
                  <c:v>1.1375647434098501</c:v>
                </c:pt>
                <c:pt idx="2">
                  <c:v>1.0448099379878024</c:v>
                </c:pt>
                <c:pt idx="3">
                  <c:v>1.2427326047771849</c:v>
                </c:pt>
                <c:pt idx="4">
                  <c:v>1.0678836628303374</c:v>
                </c:pt>
                <c:pt idx="5">
                  <c:v>1.1178217207481196</c:v>
                </c:pt>
                <c:pt idx="6">
                  <c:v>1.5614528273206323</c:v>
                </c:pt>
                <c:pt idx="7">
                  <c:v>1.075298092961309</c:v>
                </c:pt>
                <c:pt idx="8">
                  <c:v>1.2135650687932136</c:v>
                </c:pt>
                <c:pt idx="9">
                  <c:v>1.313106763244132</c:v>
                </c:pt>
                <c:pt idx="10">
                  <c:v>1.2355988017464556</c:v>
                </c:pt>
                <c:pt idx="11">
                  <c:v>1.1751334883943474</c:v>
                </c:pt>
                <c:pt idx="12">
                  <c:v>1.1303842700310094</c:v>
                </c:pt>
                <c:pt idx="13">
                  <c:v>1.0159386273794757</c:v>
                </c:pt>
                <c:pt idx="14">
                  <c:v>1.1515427631957582</c:v>
                </c:pt>
                <c:pt idx="15">
                  <c:v>1.4802385394219573</c:v>
                </c:pt>
                <c:pt idx="16">
                  <c:v>0.94496786774409736</c:v>
                </c:pt>
                <c:pt idx="17">
                  <c:v>1.1214316098239792</c:v>
                </c:pt>
                <c:pt idx="18">
                  <c:v>1.0293052146363206</c:v>
                </c:pt>
                <c:pt idx="19">
                  <c:v>1.1621299044418305</c:v>
                </c:pt>
                <c:pt idx="20">
                  <c:v>1.1597943294341044</c:v>
                </c:pt>
                <c:pt idx="21">
                  <c:v>1.4205923047527074</c:v>
                </c:pt>
                <c:pt idx="22">
                  <c:v>1.0479145636169165</c:v>
                </c:pt>
                <c:pt idx="23">
                  <c:v>1.230951402932255</c:v>
                </c:pt>
                <c:pt idx="24">
                  <c:v>1.1868682365915695</c:v>
                </c:pt>
                <c:pt idx="25">
                  <c:v>1.0364371856313785</c:v>
                </c:pt>
                <c:pt idx="26">
                  <c:v>1.2545845073908062</c:v>
                </c:pt>
                <c:pt idx="27">
                  <c:v>0.98536642194157009</c:v>
                </c:pt>
                <c:pt idx="28">
                  <c:v>1.1561674876955848</c:v>
                </c:pt>
                <c:pt idx="29">
                  <c:v>1.0703357167117828</c:v>
                </c:pt>
                <c:pt idx="30">
                  <c:v>0.96048232635132724</c:v>
                </c:pt>
                <c:pt idx="31">
                  <c:v>1.0453430493962454</c:v>
                </c:pt>
                <c:pt idx="32">
                  <c:v>1.7515010484865319</c:v>
                </c:pt>
                <c:pt idx="33">
                  <c:v>1.0948178437618652</c:v>
                </c:pt>
                <c:pt idx="34">
                  <c:v>2.3894267043401136</c:v>
                </c:pt>
                <c:pt idx="35">
                  <c:v>1.3159266398314373</c:v>
                </c:pt>
                <c:pt idx="36">
                  <c:v>1.283383477931842</c:v>
                </c:pt>
                <c:pt idx="37">
                  <c:v>1.1445509926772179</c:v>
                </c:pt>
                <c:pt idx="38">
                  <c:v>1.3839672282712354</c:v>
                </c:pt>
                <c:pt idx="39">
                  <c:v>1.0741147633199231</c:v>
                </c:pt>
                <c:pt idx="40">
                  <c:v>1.0735580027449434</c:v>
                </c:pt>
                <c:pt idx="41">
                  <c:v>1.0786344204512595</c:v>
                </c:pt>
                <c:pt idx="42">
                  <c:v>1.311655639175334</c:v>
                </c:pt>
                <c:pt idx="43">
                  <c:v>1.0764370243356474</c:v>
                </c:pt>
                <c:pt idx="44">
                  <c:v>1.0235456702697308</c:v>
                </c:pt>
                <c:pt idx="45">
                  <c:v>1.5751573817561242</c:v>
                </c:pt>
                <c:pt idx="46">
                  <c:v>1.0569835772674143</c:v>
                </c:pt>
                <c:pt idx="47">
                  <c:v>2.5703686647116055</c:v>
                </c:pt>
                <c:pt idx="48">
                  <c:v>1.239637168936027</c:v>
                </c:pt>
                <c:pt idx="49">
                  <c:v>1.7053095168706902</c:v>
                </c:pt>
                <c:pt idx="50">
                  <c:v>1.0672962841557003</c:v>
                </c:pt>
                <c:pt idx="51">
                  <c:v>1.1918367675738823</c:v>
                </c:pt>
                <c:pt idx="52">
                  <c:v>0.91255771245994743</c:v>
                </c:pt>
                <c:pt idx="53">
                  <c:v>1.5803747405450164</c:v>
                </c:pt>
                <c:pt idx="54">
                  <c:v>1.2828029291062666</c:v>
                </c:pt>
                <c:pt idx="55">
                  <c:v>1.3699126544223155</c:v>
                </c:pt>
                <c:pt idx="56">
                  <c:v>1.3471420053994614</c:v>
                </c:pt>
                <c:pt idx="57">
                  <c:v>0.99271185439070397</c:v>
                </c:pt>
                <c:pt idx="58">
                  <c:v>1.1796352598006323</c:v>
                </c:pt>
                <c:pt idx="59">
                  <c:v>1.1713089305850335</c:v>
                </c:pt>
                <c:pt idx="60">
                  <c:v>1.6870027357193198</c:v>
                </c:pt>
                <c:pt idx="61">
                  <c:v>1.1578306738858126</c:v>
                </c:pt>
                <c:pt idx="62">
                  <c:v>1.1328429409601102</c:v>
                </c:pt>
                <c:pt idx="63">
                  <c:v>0.97100319878077879</c:v>
                </c:pt>
                <c:pt idx="64">
                  <c:v>0.89873750777351091</c:v>
                </c:pt>
                <c:pt idx="65">
                  <c:v>1.0044377237420772</c:v>
                </c:pt>
                <c:pt idx="66">
                  <c:v>1.2285282467622887</c:v>
                </c:pt>
                <c:pt idx="67">
                  <c:v>1.1225457328628612</c:v>
                </c:pt>
                <c:pt idx="68">
                  <c:v>1.2585826052618589</c:v>
                </c:pt>
                <c:pt idx="69">
                  <c:v>0.98208536613746078</c:v>
                </c:pt>
                <c:pt idx="70">
                  <c:v>0.86892091529873439</c:v>
                </c:pt>
                <c:pt idx="71">
                  <c:v>1.0755620937774841</c:v>
                </c:pt>
                <c:pt idx="72">
                  <c:v>1.3417108685736927</c:v>
                </c:pt>
                <c:pt idx="73">
                  <c:v>1.0788688255274537</c:v>
                </c:pt>
                <c:pt idx="74">
                  <c:v>1.0198637298451552</c:v>
                </c:pt>
                <c:pt idx="75">
                  <c:v>1.3291204066340678</c:v>
                </c:pt>
                <c:pt idx="76">
                  <c:v>1.2335999147972077</c:v>
                </c:pt>
                <c:pt idx="77">
                  <c:v>1.2162243080346327</c:v>
                </c:pt>
                <c:pt idx="78">
                  <c:v>0.85295366807404172</c:v>
                </c:pt>
                <c:pt idx="79">
                  <c:v>0.87943650980082888</c:v>
                </c:pt>
                <c:pt idx="80">
                  <c:v>1.0562517213814044</c:v>
                </c:pt>
                <c:pt idx="81">
                  <c:v>1.3410239183359083</c:v>
                </c:pt>
                <c:pt idx="82">
                  <c:v>1.1039678212666191</c:v>
                </c:pt>
                <c:pt idx="83">
                  <c:v>1.1880304324868298</c:v>
                </c:pt>
                <c:pt idx="84">
                  <c:v>1.7396753036829002</c:v>
                </c:pt>
                <c:pt idx="85">
                  <c:v>1.1169171054483671</c:v>
                </c:pt>
                <c:pt idx="86">
                  <c:v>1.4329364543987804</c:v>
                </c:pt>
                <c:pt idx="87">
                  <c:v>1.1432653089318654</c:v>
                </c:pt>
                <c:pt idx="88">
                  <c:v>1.197092579723988</c:v>
                </c:pt>
                <c:pt idx="89">
                  <c:v>1.141404357408675</c:v>
                </c:pt>
                <c:pt idx="90">
                  <c:v>1.2048376326559456</c:v>
                </c:pt>
                <c:pt idx="91">
                  <c:v>1.0287846991114269</c:v>
                </c:pt>
                <c:pt idx="92">
                  <c:v>0.97190278638289329</c:v>
                </c:pt>
                <c:pt idx="93">
                  <c:v>1.2643624921334171</c:v>
                </c:pt>
                <c:pt idx="94">
                  <c:v>1.4495937387783748</c:v>
                </c:pt>
                <c:pt idx="95">
                  <c:v>1.1778088920875986</c:v>
                </c:pt>
                <c:pt idx="96">
                  <c:v>1.0733869686145441</c:v>
                </c:pt>
                <c:pt idx="97">
                  <c:v>1.2559658948068675</c:v>
                </c:pt>
                <c:pt idx="98">
                  <c:v>0.8033831244367764</c:v>
                </c:pt>
                <c:pt idx="99">
                  <c:v>1.703872387431252</c:v>
                </c:pt>
                <c:pt idx="100">
                  <c:v>1.44494798577839</c:v>
                </c:pt>
                <c:pt idx="101">
                  <c:v>1.0735445099500254</c:v>
                </c:pt>
                <c:pt idx="102">
                  <c:v>1.220626889144738</c:v>
                </c:pt>
                <c:pt idx="103">
                  <c:v>1.5589094082986008</c:v>
                </c:pt>
                <c:pt idx="104">
                  <c:v>1.2721516142214957</c:v>
                </c:pt>
                <c:pt idx="105">
                  <c:v>1.3874823089261468</c:v>
                </c:pt>
                <c:pt idx="106">
                  <c:v>1.3538443682743015</c:v>
                </c:pt>
                <c:pt idx="107">
                  <c:v>0.88908102221388396</c:v>
                </c:pt>
                <c:pt idx="108">
                  <c:v>1.0362924386131669</c:v>
                </c:pt>
                <c:pt idx="109">
                  <c:v>1.2232641294203928</c:v>
                </c:pt>
                <c:pt idx="110">
                  <c:v>1.2301186543927389</c:v>
                </c:pt>
                <c:pt idx="111">
                  <c:v>0.90362328895536115</c:v>
                </c:pt>
                <c:pt idx="112">
                  <c:v>0.93780637058383942</c:v>
                </c:pt>
                <c:pt idx="113">
                  <c:v>1.1342532926148021</c:v>
                </c:pt>
                <c:pt idx="114">
                  <c:v>0.91249121417226831</c:v>
                </c:pt>
                <c:pt idx="115">
                  <c:v>0.93897712078280993</c:v>
                </c:pt>
                <c:pt idx="116">
                  <c:v>1.5954399903090366</c:v>
                </c:pt>
                <c:pt idx="117">
                  <c:v>0.98378222094667145</c:v>
                </c:pt>
                <c:pt idx="118">
                  <c:v>1.9699391770244732</c:v>
                </c:pt>
                <c:pt idx="119">
                  <c:v>1.0859507309474357</c:v>
                </c:pt>
                <c:pt idx="120">
                  <c:v>1.4776240996043613</c:v>
                </c:pt>
                <c:pt idx="121">
                  <c:v>1.563659376613336</c:v>
                </c:pt>
                <c:pt idx="122">
                  <c:v>1.2180746475406143</c:v>
                </c:pt>
                <c:pt idx="123">
                  <c:v>1.1309252959967819</c:v>
                </c:pt>
                <c:pt idx="124">
                  <c:v>1.3388757790282568</c:v>
                </c:pt>
                <c:pt idx="125">
                  <c:v>1.4350556017853089</c:v>
                </c:pt>
                <c:pt idx="126">
                  <c:v>1.0240995847496728</c:v>
                </c:pt>
                <c:pt idx="127">
                  <c:v>1.4485930151687549</c:v>
                </c:pt>
                <c:pt idx="128">
                  <c:v>0.9041321347172111</c:v>
                </c:pt>
                <c:pt idx="129">
                  <c:v>1.6278685424021904</c:v>
                </c:pt>
                <c:pt idx="130">
                  <c:v>1.1589461121620415</c:v>
                </c:pt>
                <c:pt idx="131">
                  <c:v>1.4143339456542523</c:v>
                </c:pt>
                <c:pt idx="132">
                  <c:v>1.4136629954296847</c:v>
                </c:pt>
                <c:pt idx="133">
                  <c:v>1.2720887845414806</c:v>
                </c:pt>
                <c:pt idx="134">
                  <c:v>1.1268681884529783</c:v>
                </c:pt>
                <c:pt idx="135">
                  <c:v>1.360726014091673</c:v>
                </c:pt>
                <c:pt idx="136">
                  <c:v>1.1322397232160371</c:v>
                </c:pt>
                <c:pt idx="137">
                  <c:v>1.1017662419168657</c:v>
                </c:pt>
                <c:pt idx="138">
                  <c:v>1.3607941614885137</c:v>
                </c:pt>
                <c:pt idx="139">
                  <c:v>1.1445572410614555</c:v>
                </c:pt>
                <c:pt idx="140">
                  <c:v>1.0277862907966004</c:v>
                </c:pt>
                <c:pt idx="141">
                  <c:v>1.349853095065604</c:v>
                </c:pt>
                <c:pt idx="142">
                  <c:v>1.8792940880936899</c:v>
                </c:pt>
                <c:pt idx="143">
                  <c:v>1.1149948402744823</c:v>
                </c:pt>
                <c:pt idx="144">
                  <c:v>1.390941684403171</c:v>
                </c:pt>
                <c:pt idx="145">
                  <c:v>0.96804506789994293</c:v>
                </c:pt>
                <c:pt idx="146">
                  <c:v>1.9540874267973156</c:v>
                </c:pt>
                <c:pt idx="147">
                  <c:v>1.6546807718887884</c:v>
                </c:pt>
                <c:pt idx="148">
                  <c:v>1.0492723338012815</c:v>
                </c:pt>
                <c:pt idx="149">
                  <c:v>1.6957418990788018</c:v>
                </c:pt>
                <c:pt idx="150">
                  <c:v>1.2783988069338881</c:v>
                </c:pt>
                <c:pt idx="151">
                  <c:v>1.1081771721862648</c:v>
                </c:pt>
                <c:pt idx="152">
                  <c:v>0.94622005372512463</c:v>
                </c:pt>
                <c:pt idx="153">
                  <c:v>1.5121344091656701</c:v>
                </c:pt>
                <c:pt idx="154">
                  <c:v>0.98809558166835021</c:v>
                </c:pt>
                <c:pt idx="155">
                  <c:v>1.2409459774025364</c:v>
                </c:pt>
                <c:pt idx="156">
                  <c:v>1.1132500423791374</c:v>
                </c:pt>
                <c:pt idx="157">
                  <c:v>0.99019354225100142</c:v>
                </c:pt>
                <c:pt idx="158">
                  <c:v>0.92920029498646994</c:v>
                </c:pt>
                <c:pt idx="159">
                  <c:v>1.2713851392489504</c:v>
                </c:pt>
                <c:pt idx="160">
                  <c:v>1.0369036600170234</c:v>
                </c:pt>
                <c:pt idx="161">
                  <c:v>1.4090283932326497</c:v>
                </c:pt>
                <c:pt idx="162">
                  <c:v>1.094838684049336</c:v>
                </c:pt>
                <c:pt idx="163">
                  <c:v>1.5774131191011231</c:v>
                </c:pt>
                <c:pt idx="164">
                  <c:v>1.2465269238027796</c:v>
                </c:pt>
                <c:pt idx="165">
                  <c:v>0.98705411020180245</c:v>
                </c:pt>
                <c:pt idx="166">
                  <c:v>1.1307404251767239</c:v>
                </c:pt>
                <c:pt idx="167">
                  <c:v>1.1613913620680019</c:v>
                </c:pt>
                <c:pt idx="168">
                  <c:v>1.0502314290468737</c:v>
                </c:pt>
                <c:pt idx="169">
                  <c:v>1.013130142154024</c:v>
                </c:pt>
                <c:pt idx="170">
                  <c:v>1.0453026641814005</c:v>
                </c:pt>
                <c:pt idx="171">
                  <c:v>1.2414650155157294</c:v>
                </c:pt>
                <c:pt idx="172">
                  <c:v>1.1744606343121284</c:v>
                </c:pt>
                <c:pt idx="173">
                  <c:v>1.1396124328429107</c:v>
                </c:pt>
                <c:pt idx="174">
                  <c:v>1.2002638391532336</c:v>
                </c:pt>
                <c:pt idx="175">
                  <c:v>1.3856875613788975</c:v>
                </c:pt>
                <c:pt idx="176">
                  <c:v>1.0556345555913118</c:v>
                </c:pt>
                <c:pt idx="177">
                  <c:v>1.1364340400584223</c:v>
                </c:pt>
                <c:pt idx="178">
                  <c:v>0.96941994083581173</c:v>
                </c:pt>
                <c:pt idx="179">
                  <c:v>0.97724341334217246</c:v>
                </c:pt>
                <c:pt idx="180">
                  <c:v>1.1067750977246811</c:v>
                </c:pt>
                <c:pt idx="181">
                  <c:v>1.162495992394929</c:v>
                </c:pt>
                <c:pt idx="182">
                  <c:v>1.2783844652445147</c:v>
                </c:pt>
                <c:pt idx="183">
                  <c:v>1.2106690422124367</c:v>
                </c:pt>
                <c:pt idx="184">
                  <c:v>1.2964266586698361</c:v>
                </c:pt>
                <c:pt idx="185">
                  <c:v>1.415536134177628</c:v>
                </c:pt>
                <c:pt idx="186">
                  <c:v>1.3972291924368263</c:v>
                </c:pt>
                <c:pt idx="187">
                  <c:v>1.2212452715667932</c:v>
                </c:pt>
                <c:pt idx="188">
                  <c:v>1.0623578848336694</c:v>
                </c:pt>
                <c:pt idx="189">
                  <c:v>1.3722155575425516</c:v>
                </c:pt>
                <c:pt idx="190">
                  <c:v>0.96665641277381464</c:v>
                </c:pt>
                <c:pt idx="191">
                  <c:v>1.094382652817196</c:v>
                </c:pt>
                <c:pt idx="192">
                  <c:v>1.4548483700300481</c:v>
                </c:pt>
                <c:pt idx="193">
                  <c:v>1.4777466165527628</c:v>
                </c:pt>
                <c:pt idx="194">
                  <c:v>1.2200849127879896</c:v>
                </c:pt>
                <c:pt idx="195">
                  <c:v>1.2247660305760488</c:v>
                </c:pt>
                <c:pt idx="196">
                  <c:v>1.3468983198971356</c:v>
                </c:pt>
                <c:pt idx="197">
                  <c:v>1.3671412382052448</c:v>
                </c:pt>
                <c:pt idx="198">
                  <c:v>1.2793987996594691</c:v>
                </c:pt>
                <c:pt idx="199">
                  <c:v>1.2468762648209688</c:v>
                </c:pt>
                <c:pt idx="200">
                  <c:v>1.3162376506883917</c:v>
                </c:pt>
                <c:pt idx="201">
                  <c:v>1.1976404709892634</c:v>
                </c:pt>
                <c:pt idx="202">
                  <c:v>1.217124804617149</c:v>
                </c:pt>
                <c:pt idx="203">
                  <c:v>1.0868874197614307</c:v>
                </c:pt>
                <c:pt idx="204">
                  <c:v>1.1072655538273128</c:v>
                </c:pt>
                <c:pt idx="205">
                  <c:v>1.1056984098835489</c:v>
                </c:pt>
                <c:pt idx="206">
                  <c:v>1.2024374742981045</c:v>
                </c:pt>
                <c:pt idx="207">
                  <c:v>1.3327126883342297</c:v>
                </c:pt>
                <c:pt idx="208">
                  <c:v>1.2895518357240654</c:v>
                </c:pt>
                <c:pt idx="209">
                  <c:v>1.1961721518701562</c:v>
                </c:pt>
                <c:pt idx="210">
                  <c:v>1.1304294172843141</c:v>
                </c:pt>
                <c:pt idx="211">
                  <c:v>1.263435249720406</c:v>
                </c:pt>
                <c:pt idx="212">
                  <c:v>2.3535003941131056</c:v>
                </c:pt>
                <c:pt idx="213">
                  <c:v>1.1265937397371053</c:v>
                </c:pt>
                <c:pt idx="214">
                  <c:v>1.513748520753496</c:v>
                </c:pt>
                <c:pt idx="215">
                  <c:v>1.0552656241763025</c:v>
                </c:pt>
                <c:pt idx="216">
                  <c:v>1.3987402420424435</c:v>
                </c:pt>
                <c:pt idx="217">
                  <c:v>1.2944500885495278</c:v>
                </c:pt>
                <c:pt idx="218">
                  <c:v>1.3379556145781271</c:v>
                </c:pt>
                <c:pt idx="219">
                  <c:v>0.93105472734508343</c:v>
                </c:pt>
                <c:pt idx="220">
                  <c:v>1.0372455112740389</c:v>
                </c:pt>
                <c:pt idx="221">
                  <c:v>1.0967600203180632</c:v>
                </c:pt>
                <c:pt idx="222">
                  <c:v>1.1877350907998689</c:v>
                </c:pt>
                <c:pt idx="223">
                  <c:v>1.1698760301624676</c:v>
                </c:pt>
                <c:pt idx="224">
                  <c:v>1.1850040964207986</c:v>
                </c:pt>
                <c:pt idx="225">
                  <c:v>0.95007581539195973</c:v>
                </c:pt>
                <c:pt idx="226">
                  <c:v>1.2411293764944991</c:v>
                </c:pt>
                <c:pt idx="227">
                  <c:v>1.6398035104290092</c:v>
                </c:pt>
                <c:pt idx="228">
                  <c:v>1.0562944143183228</c:v>
                </c:pt>
                <c:pt idx="229">
                  <c:v>1.0015106984059596</c:v>
                </c:pt>
                <c:pt idx="230">
                  <c:v>0.91949218060732396</c:v>
                </c:pt>
                <c:pt idx="231">
                  <c:v>1.1164056604817834</c:v>
                </c:pt>
                <c:pt idx="232">
                  <c:v>1.2128730041902216</c:v>
                </c:pt>
                <c:pt idx="233">
                  <c:v>1.0954559170041698</c:v>
                </c:pt>
                <c:pt idx="234">
                  <c:v>1.2597578009676698</c:v>
                </c:pt>
                <c:pt idx="235">
                  <c:v>1.1327037639188986</c:v>
                </c:pt>
                <c:pt idx="236">
                  <c:v>0.95182201160537849</c:v>
                </c:pt>
                <c:pt idx="237">
                  <c:v>1.3268209141851957</c:v>
                </c:pt>
                <c:pt idx="238">
                  <c:v>1.0791060267106447</c:v>
                </c:pt>
                <c:pt idx="239">
                  <c:v>1.2424241022169358</c:v>
                </c:pt>
                <c:pt idx="240">
                  <c:v>1.3143094148160865</c:v>
                </c:pt>
                <c:pt idx="241">
                  <c:v>1.1098444329238206</c:v>
                </c:pt>
                <c:pt idx="242">
                  <c:v>1.2013938510695972</c:v>
                </c:pt>
                <c:pt idx="243">
                  <c:v>1.2225210148600727</c:v>
                </c:pt>
                <c:pt idx="244">
                  <c:v>1.1149655514767158</c:v>
                </c:pt>
                <c:pt idx="245">
                  <c:v>1.0463019258932695</c:v>
                </c:pt>
                <c:pt idx="246">
                  <c:v>1.0760203722622705</c:v>
                </c:pt>
                <c:pt idx="247">
                  <c:v>1.394557515457334</c:v>
                </c:pt>
                <c:pt idx="248">
                  <c:v>1.0095942842130394</c:v>
                </c:pt>
                <c:pt idx="249">
                  <c:v>1.4179275161942924</c:v>
                </c:pt>
                <c:pt idx="250">
                  <c:v>1.1911272236671571</c:v>
                </c:pt>
                <c:pt idx="251">
                  <c:v>1.4577933440135751</c:v>
                </c:pt>
                <c:pt idx="252">
                  <c:v>1.3879252393576897</c:v>
                </c:pt>
                <c:pt idx="253">
                  <c:v>1.2516324100319196</c:v>
                </c:pt>
                <c:pt idx="254">
                  <c:v>1.7677288051851745</c:v>
                </c:pt>
                <c:pt idx="255">
                  <c:v>1.0878150576749728</c:v>
                </c:pt>
                <c:pt idx="256">
                  <c:v>0.88752973496226661</c:v>
                </c:pt>
                <c:pt idx="257">
                  <c:v>1.8814639995232043</c:v>
                </c:pt>
                <c:pt idx="258">
                  <c:v>1.8029988221989244</c:v>
                </c:pt>
                <c:pt idx="259">
                  <c:v>0.99042138902462207</c:v>
                </c:pt>
                <c:pt idx="260">
                  <c:v>1.1103647446189282</c:v>
                </c:pt>
                <c:pt idx="261">
                  <c:v>1.1596088985208393</c:v>
                </c:pt>
                <c:pt idx="262">
                  <c:v>1.1554664941525794</c:v>
                </c:pt>
                <c:pt idx="263">
                  <c:v>1.0724921093674358</c:v>
                </c:pt>
                <c:pt idx="264">
                  <c:v>1.0319956524098368</c:v>
                </c:pt>
                <c:pt idx="265">
                  <c:v>1.0655783214297256</c:v>
                </c:pt>
                <c:pt idx="266">
                  <c:v>1.0817263617120858</c:v>
                </c:pt>
                <c:pt idx="267">
                  <c:v>1.2929132918889084</c:v>
                </c:pt>
                <c:pt idx="268">
                  <c:v>1.3656432005322447</c:v>
                </c:pt>
                <c:pt idx="269">
                  <c:v>1.1639267896682179</c:v>
                </c:pt>
                <c:pt idx="270">
                  <c:v>1.0390227742291791</c:v>
                </c:pt>
                <c:pt idx="271">
                  <c:v>1.2262827551728461</c:v>
                </c:pt>
                <c:pt idx="272">
                  <c:v>1.2292339220156185</c:v>
                </c:pt>
                <c:pt idx="273">
                  <c:v>1.2640447995345419</c:v>
                </c:pt>
                <c:pt idx="274">
                  <c:v>1.2092340024017842</c:v>
                </c:pt>
                <c:pt idx="275">
                  <c:v>1.5983325182189172</c:v>
                </c:pt>
                <c:pt idx="276">
                  <c:v>1.1824514121609357</c:v>
                </c:pt>
                <c:pt idx="277">
                  <c:v>1.1065904187694084</c:v>
                </c:pt>
                <c:pt idx="278">
                  <c:v>1.0767314654045959</c:v>
                </c:pt>
                <c:pt idx="279">
                  <c:v>1.032833001377113</c:v>
                </c:pt>
                <c:pt idx="280">
                  <c:v>1.423698215440323</c:v>
                </c:pt>
                <c:pt idx="281">
                  <c:v>1.3879409863882555</c:v>
                </c:pt>
                <c:pt idx="282">
                  <c:v>2.0793985040703924</c:v>
                </c:pt>
                <c:pt idx="283">
                  <c:v>1.1723170050861837</c:v>
                </c:pt>
                <c:pt idx="284">
                  <c:v>1.0410368963094203</c:v>
                </c:pt>
                <c:pt idx="285">
                  <c:v>1.0485495992312186</c:v>
                </c:pt>
                <c:pt idx="286">
                  <c:v>1.1604933533431425</c:v>
                </c:pt>
                <c:pt idx="287">
                  <c:v>1.179028584896497</c:v>
                </c:pt>
                <c:pt idx="288">
                  <c:v>1.5031895999826435</c:v>
                </c:pt>
                <c:pt idx="289">
                  <c:v>1.0221210341760576</c:v>
                </c:pt>
                <c:pt idx="290">
                  <c:v>0.96743890083711714</c:v>
                </c:pt>
                <c:pt idx="291">
                  <c:v>1.0100396243845107</c:v>
                </c:pt>
                <c:pt idx="292">
                  <c:v>1.2270567920842701</c:v>
                </c:pt>
                <c:pt idx="293">
                  <c:v>1.5788482912719641</c:v>
                </c:pt>
                <c:pt idx="294">
                  <c:v>0.97246595960075988</c:v>
                </c:pt>
                <c:pt idx="295">
                  <c:v>1.0285589558393269</c:v>
                </c:pt>
                <c:pt idx="296">
                  <c:v>1.07858291486124</c:v>
                </c:pt>
                <c:pt idx="297">
                  <c:v>2.8344812405501019</c:v>
                </c:pt>
                <c:pt idx="298">
                  <c:v>1.3943936069830551</c:v>
                </c:pt>
                <c:pt idx="299">
                  <c:v>0.97016919050975869</c:v>
                </c:pt>
                <c:pt idx="300">
                  <c:v>1.0749266137128644</c:v>
                </c:pt>
                <c:pt idx="301">
                  <c:v>1.2520908113945228</c:v>
                </c:pt>
                <c:pt idx="302">
                  <c:v>1.1833198782089942</c:v>
                </c:pt>
                <c:pt idx="303">
                  <c:v>1.166352257038459</c:v>
                </c:pt>
                <c:pt idx="304">
                  <c:v>1.2897594071178042</c:v>
                </c:pt>
                <c:pt idx="305">
                  <c:v>1.3765208157291671</c:v>
                </c:pt>
                <c:pt idx="306">
                  <c:v>1.2984877202784431</c:v>
                </c:pt>
                <c:pt idx="307">
                  <c:v>1.1942513491264977</c:v>
                </c:pt>
                <c:pt idx="308">
                  <c:v>1.2236319845857417</c:v>
                </c:pt>
                <c:pt idx="309">
                  <c:v>1.0067808434622987</c:v>
                </c:pt>
                <c:pt idx="310">
                  <c:v>1.146499685973223</c:v>
                </c:pt>
                <c:pt idx="311">
                  <c:v>0.95980033391830122</c:v>
                </c:pt>
                <c:pt idx="312">
                  <c:v>1.6889583943849216</c:v>
                </c:pt>
                <c:pt idx="313">
                  <c:v>1.1195550916922903</c:v>
                </c:pt>
                <c:pt idx="314">
                  <c:v>1.4687323473286029</c:v>
                </c:pt>
                <c:pt idx="315">
                  <c:v>1.6837724898975919</c:v>
                </c:pt>
                <c:pt idx="316">
                  <c:v>1.310016012076304</c:v>
                </c:pt>
                <c:pt idx="317">
                  <c:v>1.3071160906611941</c:v>
                </c:pt>
                <c:pt idx="318">
                  <c:v>1.3527437551491488</c:v>
                </c:pt>
                <c:pt idx="319">
                  <c:v>0.86099662981185776</c:v>
                </c:pt>
                <c:pt idx="320">
                  <c:v>1.3498276370444016</c:v>
                </c:pt>
                <c:pt idx="321">
                  <c:v>1.0619462870284362</c:v>
                </c:pt>
                <c:pt idx="322">
                  <c:v>0.92694369431926493</c:v>
                </c:pt>
                <c:pt idx="323">
                  <c:v>1.1695857078824357</c:v>
                </c:pt>
                <c:pt idx="324">
                  <c:v>1.2593517780701593</c:v>
                </c:pt>
                <c:pt idx="325">
                  <c:v>1.0895436521718123</c:v>
                </c:pt>
                <c:pt idx="326">
                  <c:v>0.98785355925785689</c:v>
                </c:pt>
                <c:pt idx="327">
                  <c:v>1.0934497789632265</c:v>
                </c:pt>
                <c:pt idx="328">
                  <c:v>1.5321660771848533</c:v>
                </c:pt>
                <c:pt idx="329">
                  <c:v>1.2833179723502304</c:v>
                </c:pt>
                <c:pt idx="330">
                  <c:v>1.3993329332387654</c:v>
                </c:pt>
                <c:pt idx="331">
                  <c:v>1.1199230946234942</c:v>
                </c:pt>
                <c:pt idx="332">
                  <c:v>1.6929697145762219</c:v>
                </c:pt>
                <c:pt idx="333">
                  <c:v>1.0100890816877706</c:v>
                </c:pt>
                <c:pt idx="334">
                  <c:v>1.1472720419487663</c:v>
                </c:pt>
                <c:pt idx="335">
                  <c:v>1.0247354347520141</c:v>
                </c:pt>
                <c:pt idx="336">
                  <c:v>0.92215374526272842</c:v>
                </c:pt>
                <c:pt idx="337">
                  <c:v>1.0580938746256412</c:v>
                </c:pt>
                <c:pt idx="338">
                  <c:v>0.88950462682238807</c:v>
                </c:pt>
                <c:pt idx="339">
                  <c:v>0.96738798268151993</c:v>
                </c:pt>
                <c:pt idx="340">
                  <c:v>0.70735049902215374</c:v>
                </c:pt>
                <c:pt idx="341">
                  <c:v>1.4111045711028916</c:v>
                </c:pt>
                <c:pt idx="342">
                  <c:v>1.2657474392014756</c:v>
                </c:pt>
                <c:pt idx="343">
                  <c:v>1.837478488069842</c:v>
                </c:pt>
                <c:pt idx="344">
                  <c:v>1.3643656073655315</c:v>
                </c:pt>
                <c:pt idx="345">
                  <c:v>0.89179684652011137</c:v>
                </c:pt>
                <c:pt idx="346">
                  <c:v>1.0444582995412779</c:v>
                </c:pt>
                <c:pt idx="347">
                  <c:v>1.3175324529686274</c:v>
                </c:pt>
                <c:pt idx="348">
                  <c:v>1.8013863975784361</c:v>
                </c:pt>
                <c:pt idx="349">
                  <c:v>1.2510230429297555</c:v>
                </c:pt>
                <c:pt idx="350">
                  <c:v>1.2709653754142662</c:v>
                </c:pt>
                <c:pt idx="351">
                  <c:v>1.4129629825964616</c:v>
                </c:pt>
                <c:pt idx="352">
                  <c:v>1.1337270260174641</c:v>
                </c:pt>
                <c:pt idx="353">
                  <c:v>1.3248294083295509</c:v>
                </c:pt>
                <c:pt idx="354">
                  <c:v>0.98249973366452092</c:v>
                </c:pt>
                <c:pt idx="355">
                  <c:v>1.1509770633796168</c:v>
                </c:pt>
                <c:pt idx="356">
                  <c:v>1.3008440935370589</c:v>
                </c:pt>
                <c:pt idx="357">
                  <c:v>0.99917998853719103</c:v>
                </c:pt>
                <c:pt idx="358">
                  <c:v>1.2085907409077605</c:v>
                </c:pt>
                <c:pt idx="359">
                  <c:v>1.0054414128555706</c:v>
                </c:pt>
                <c:pt idx="360">
                  <c:v>1.2676450096896004</c:v>
                </c:pt>
                <c:pt idx="361">
                  <c:v>0.93482944514292643</c:v>
                </c:pt>
                <c:pt idx="362">
                  <c:v>1.2488079540999963</c:v>
                </c:pt>
                <c:pt idx="363">
                  <c:v>1.3754320592361828</c:v>
                </c:pt>
                <c:pt idx="364">
                  <c:v>1.2697039114220896</c:v>
                </c:pt>
                <c:pt idx="365">
                  <c:v>0.82836677329198238</c:v>
                </c:pt>
                <c:pt idx="366">
                  <c:v>1.0754240447572345</c:v>
                </c:pt>
                <c:pt idx="367">
                  <c:v>0.91322899416884273</c:v>
                </c:pt>
                <c:pt idx="368">
                  <c:v>0.95885354317036231</c:v>
                </c:pt>
                <c:pt idx="369">
                  <c:v>1.1954737969676994</c:v>
                </c:pt>
                <c:pt idx="370">
                  <c:v>1.2372736401385449</c:v>
                </c:pt>
                <c:pt idx="371">
                  <c:v>1.028205499212606</c:v>
                </c:pt>
                <c:pt idx="372">
                  <c:v>1.0399088086380039</c:v>
                </c:pt>
                <c:pt idx="373">
                  <c:v>1.2124409666406359</c:v>
                </c:pt>
                <c:pt idx="374">
                  <c:v>0.90327387725874519</c:v>
                </c:pt>
                <c:pt idx="375">
                  <c:v>1.046746174328703</c:v>
                </c:pt>
                <c:pt idx="376">
                  <c:v>1.468638821042261</c:v>
                </c:pt>
                <c:pt idx="377">
                  <c:v>1.1281139886909732</c:v>
                </c:pt>
                <c:pt idx="378">
                  <c:v>1.0063242867973194</c:v>
                </c:pt>
                <c:pt idx="379">
                  <c:v>0.91986704372408234</c:v>
                </c:pt>
                <c:pt idx="380">
                  <c:v>0.87182836264682517</c:v>
                </c:pt>
                <c:pt idx="381">
                  <c:v>0.9828494206453352</c:v>
                </c:pt>
                <c:pt idx="382">
                  <c:v>0.95604381451916298</c:v>
                </c:pt>
                <c:pt idx="383">
                  <c:v>1.0599700080630428</c:v>
                </c:pt>
                <c:pt idx="384">
                  <c:v>1.004923121492044</c:v>
                </c:pt>
                <c:pt idx="385">
                  <c:v>1.3784666479093912</c:v>
                </c:pt>
                <c:pt idx="386">
                  <c:v>1.3343604617460667</c:v>
                </c:pt>
                <c:pt idx="387">
                  <c:v>1.1251739226831841</c:v>
                </c:pt>
                <c:pt idx="388">
                  <c:v>1.2892585190974741</c:v>
                </c:pt>
                <c:pt idx="389">
                  <c:v>0.94703860172860543</c:v>
                </c:pt>
                <c:pt idx="390">
                  <c:v>0.91526596652850378</c:v>
                </c:pt>
                <c:pt idx="391">
                  <c:v>0.95035871564852914</c:v>
                </c:pt>
                <c:pt idx="392">
                  <c:v>0.9418022914554306</c:v>
                </c:pt>
                <c:pt idx="393">
                  <c:v>0.93170533559697377</c:v>
                </c:pt>
                <c:pt idx="394">
                  <c:v>1.1145361623802399</c:v>
                </c:pt>
                <c:pt idx="395">
                  <c:v>1.1573207325648192</c:v>
                </c:pt>
                <c:pt idx="396">
                  <c:v>1.1100747049788287</c:v>
                </c:pt>
                <c:pt idx="397">
                  <c:v>1.2088906149055259</c:v>
                </c:pt>
                <c:pt idx="398">
                  <c:v>1.0556260947159721</c:v>
                </c:pt>
                <c:pt idx="399">
                  <c:v>1.04549841107793</c:v>
                </c:pt>
                <c:pt idx="400">
                  <c:v>1.1311302756803807</c:v>
                </c:pt>
                <c:pt idx="401">
                  <c:v>1.1558456914376281</c:v>
                </c:pt>
                <c:pt idx="402">
                  <c:v>1.001111463497302</c:v>
                </c:pt>
                <c:pt idx="403">
                  <c:v>1.1370624720107478</c:v>
                </c:pt>
                <c:pt idx="404">
                  <c:v>1.2664026033791336</c:v>
                </c:pt>
                <c:pt idx="405">
                  <c:v>1.770557359799247</c:v>
                </c:pt>
                <c:pt idx="406">
                  <c:v>1.6405139902511756</c:v>
                </c:pt>
                <c:pt idx="407">
                  <c:v>1.2130671261233335</c:v>
                </c:pt>
                <c:pt idx="408">
                  <c:v>1.7074829038777055</c:v>
                </c:pt>
                <c:pt idx="409">
                  <c:v>0.97938926395168313</c:v>
                </c:pt>
                <c:pt idx="410">
                  <c:v>1.4907111688957044</c:v>
                </c:pt>
                <c:pt idx="411">
                  <c:v>0.98194737950921085</c:v>
                </c:pt>
                <c:pt idx="412">
                  <c:v>1.0517453575897477</c:v>
                </c:pt>
                <c:pt idx="413">
                  <c:v>1.1111153433965546</c:v>
                </c:pt>
                <c:pt idx="414">
                  <c:v>1.1877286929711277</c:v>
                </c:pt>
                <c:pt idx="415">
                  <c:v>1.1697069471872137</c:v>
                </c:pt>
                <c:pt idx="416">
                  <c:v>1.2477546520896918</c:v>
                </c:pt>
                <c:pt idx="417">
                  <c:v>0.91815206869499599</c:v>
                </c:pt>
                <c:pt idx="418">
                  <c:v>1.0719772347572363</c:v>
                </c:pt>
                <c:pt idx="419">
                  <c:v>1.143212004667217</c:v>
                </c:pt>
                <c:pt idx="420">
                  <c:v>1.3526188018768923</c:v>
                </c:pt>
                <c:pt idx="421">
                  <c:v>1.1178761563375053</c:v>
                </c:pt>
                <c:pt idx="422">
                  <c:v>1.0944155924929642</c:v>
                </c:pt>
                <c:pt idx="423">
                  <c:v>1.260416777266482</c:v>
                </c:pt>
                <c:pt idx="424">
                  <c:v>1.117329251381427</c:v>
                </c:pt>
                <c:pt idx="425">
                  <c:v>0.95583301763218309</c:v>
                </c:pt>
                <c:pt idx="426">
                  <c:v>1.0689277170763567</c:v>
                </c:pt>
                <c:pt idx="427">
                  <c:v>1.2004285499397858</c:v>
                </c:pt>
                <c:pt idx="428">
                  <c:v>0.95359796033806909</c:v>
                </c:pt>
                <c:pt idx="429">
                  <c:v>0.93546120849574321</c:v>
                </c:pt>
                <c:pt idx="430">
                  <c:v>1.1074125393438059</c:v>
                </c:pt>
                <c:pt idx="431">
                  <c:v>1.174557335697765</c:v>
                </c:pt>
                <c:pt idx="432">
                  <c:v>1.1130106148584358</c:v>
                </c:pt>
                <c:pt idx="433">
                  <c:v>1.562670198922349</c:v>
                </c:pt>
                <c:pt idx="434">
                  <c:v>1.1372582702226837</c:v>
                </c:pt>
                <c:pt idx="435">
                  <c:v>1.4955067443840531</c:v>
                </c:pt>
                <c:pt idx="436">
                  <c:v>1.3347328314810798</c:v>
                </c:pt>
                <c:pt idx="437">
                  <c:v>1.1484858796730681</c:v>
                </c:pt>
                <c:pt idx="438">
                  <c:v>1.3504448822994071</c:v>
                </c:pt>
                <c:pt idx="439">
                  <c:v>1.0557923352952168</c:v>
                </c:pt>
                <c:pt idx="440">
                  <c:v>1.2052722566174914</c:v>
                </c:pt>
                <c:pt idx="441">
                  <c:v>1.2152984851224471</c:v>
                </c:pt>
                <c:pt idx="442">
                  <c:v>1.1023567750509</c:v>
                </c:pt>
                <c:pt idx="443">
                  <c:v>1.105722581363384</c:v>
                </c:pt>
                <c:pt idx="444">
                  <c:v>1.0404592088534184</c:v>
                </c:pt>
                <c:pt idx="445">
                  <c:v>1.2018688794506378</c:v>
                </c:pt>
                <c:pt idx="446">
                  <c:v>1.1456106664566215</c:v>
                </c:pt>
                <c:pt idx="447">
                  <c:v>1.1422485523368786</c:v>
                </c:pt>
                <c:pt idx="448">
                  <c:v>1.1821625170119492</c:v>
                </c:pt>
                <c:pt idx="449">
                  <c:v>1.203299461684874</c:v>
                </c:pt>
                <c:pt idx="450">
                  <c:v>1.2480070412893882</c:v>
                </c:pt>
                <c:pt idx="451">
                  <c:v>1.1097466449018796</c:v>
                </c:pt>
                <c:pt idx="452">
                  <c:v>1.5602629273008968</c:v>
                </c:pt>
                <c:pt idx="453">
                  <c:v>1.3445632871569315</c:v>
                </c:pt>
                <c:pt idx="454">
                  <c:v>1.0126455077605609</c:v>
                </c:pt>
                <c:pt idx="455">
                  <c:v>1.1504507297779007</c:v>
                </c:pt>
                <c:pt idx="456">
                  <c:v>1.9445876178572448</c:v>
                </c:pt>
                <c:pt idx="457">
                  <c:v>1.3198771415012236</c:v>
                </c:pt>
                <c:pt idx="458">
                  <c:v>1.1242988675963885</c:v>
                </c:pt>
                <c:pt idx="459">
                  <c:v>1.2300326408412141</c:v>
                </c:pt>
                <c:pt idx="460">
                  <c:v>1.0633311027019645</c:v>
                </c:pt>
                <c:pt idx="461">
                  <c:v>1.2719390641645647</c:v>
                </c:pt>
                <c:pt idx="462">
                  <c:v>1.1554399285047821</c:v>
                </c:pt>
                <c:pt idx="463">
                  <c:v>1.0746020348584655</c:v>
                </c:pt>
                <c:pt idx="464">
                  <c:v>1.5931525250966272</c:v>
                </c:pt>
                <c:pt idx="465">
                  <c:v>1.1804505195457713</c:v>
                </c:pt>
                <c:pt idx="466">
                  <c:v>2.4249318618014004</c:v>
                </c:pt>
                <c:pt idx="467">
                  <c:v>1.0213301118479123</c:v>
                </c:pt>
                <c:pt idx="468">
                  <c:v>1.0733846044377189</c:v>
                </c:pt>
                <c:pt idx="469">
                  <c:v>1.6008971204747398</c:v>
                </c:pt>
                <c:pt idx="470">
                  <c:v>1.3447872442117925</c:v>
                </c:pt>
                <c:pt idx="471">
                  <c:v>1.0010456262944378</c:v>
                </c:pt>
                <c:pt idx="472">
                  <c:v>1.3146836118206917</c:v>
                </c:pt>
                <c:pt idx="473">
                  <c:v>1.5621758955670972</c:v>
                </c:pt>
                <c:pt idx="474">
                  <c:v>1.1758675729247499</c:v>
                </c:pt>
                <c:pt idx="475">
                  <c:v>1.1533062719143945</c:v>
                </c:pt>
                <c:pt idx="476">
                  <c:v>1.1016213577810317</c:v>
                </c:pt>
                <c:pt idx="477">
                  <c:v>1.318631066437095</c:v>
                </c:pt>
                <c:pt idx="478">
                  <c:v>1.1589176245549413</c:v>
                </c:pt>
                <c:pt idx="479">
                  <c:v>1.0184590220852148</c:v>
                </c:pt>
                <c:pt idx="480">
                  <c:v>0.95492526710978554</c:v>
                </c:pt>
                <c:pt idx="481">
                  <c:v>1.7222295048502083</c:v>
                </c:pt>
                <c:pt idx="482">
                  <c:v>1.1552069647669905</c:v>
                </c:pt>
                <c:pt idx="483">
                  <c:v>1.088121912880432</c:v>
                </c:pt>
                <c:pt idx="484">
                  <c:v>1.5014544118957607</c:v>
                </c:pt>
                <c:pt idx="485">
                  <c:v>1.0362676991104891</c:v>
                </c:pt>
                <c:pt idx="486">
                  <c:v>0.98024118900365609</c:v>
                </c:pt>
                <c:pt idx="487">
                  <c:v>1.0908819808344223</c:v>
                </c:pt>
                <c:pt idx="488">
                  <c:v>1.0658037717577045</c:v>
                </c:pt>
                <c:pt idx="489">
                  <c:v>0.93937527181550196</c:v>
                </c:pt>
                <c:pt idx="490">
                  <c:v>1.1244520249540131</c:v>
                </c:pt>
                <c:pt idx="491">
                  <c:v>1.2938803426434169</c:v>
                </c:pt>
                <c:pt idx="492">
                  <c:v>1.0989438158720006</c:v>
                </c:pt>
                <c:pt idx="493">
                  <c:v>1.1821764544732443</c:v>
                </c:pt>
                <c:pt idx="494">
                  <c:v>1.0005848723176656</c:v>
                </c:pt>
                <c:pt idx="495">
                  <c:v>1.0656951063801612</c:v>
                </c:pt>
                <c:pt idx="496">
                  <c:v>1.2766131503760707</c:v>
                </c:pt>
                <c:pt idx="497">
                  <c:v>1.1587285392494053</c:v>
                </c:pt>
                <c:pt idx="498">
                  <c:v>0.96408836237420148</c:v>
                </c:pt>
                <c:pt idx="499">
                  <c:v>1.4482418349926862</c:v>
                </c:pt>
                <c:pt idx="500">
                  <c:v>1.0796892657101165</c:v>
                </c:pt>
                <c:pt idx="501">
                  <c:v>1.1037688990544336</c:v>
                </c:pt>
                <c:pt idx="502">
                  <c:v>1.4995672105454108</c:v>
                </c:pt>
                <c:pt idx="503">
                  <c:v>1.1519308961892354</c:v>
                </c:pt>
                <c:pt idx="504">
                  <c:v>1.3940528399450856</c:v>
                </c:pt>
                <c:pt idx="505">
                  <c:v>1.4672827322019364</c:v>
                </c:pt>
                <c:pt idx="506">
                  <c:v>2.1323573395833462</c:v>
                </c:pt>
                <c:pt idx="507">
                  <c:v>1.3999039561483604</c:v>
                </c:pt>
                <c:pt idx="508">
                  <c:v>1.0014676586492481</c:v>
                </c:pt>
                <c:pt idx="509">
                  <c:v>1.0019585455521143</c:v>
                </c:pt>
                <c:pt idx="510">
                  <c:v>1.1560329347070606</c:v>
                </c:pt>
                <c:pt idx="511">
                  <c:v>1.1908289120375579</c:v>
                </c:pt>
                <c:pt idx="512">
                  <c:v>0.99435991367584919</c:v>
                </c:pt>
                <c:pt idx="513">
                  <c:v>0.92687797255876214</c:v>
                </c:pt>
                <c:pt idx="514">
                  <c:v>1.0852152305779945</c:v>
                </c:pt>
                <c:pt idx="515">
                  <c:v>1.1938705208803881</c:v>
                </c:pt>
                <c:pt idx="516">
                  <c:v>1.0201926197318152</c:v>
                </c:pt>
                <c:pt idx="517">
                  <c:v>1.1291164351434562</c:v>
                </c:pt>
                <c:pt idx="518">
                  <c:v>1.0832195303336998</c:v>
                </c:pt>
                <c:pt idx="519">
                  <c:v>1.5519916649275778</c:v>
                </c:pt>
                <c:pt idx="520">
                  <c:v>1.7562815746823992</c:v>
                </c:pt>
                <c:pt idx="521">
                  <c:v>0.95647460851996957</c:v>
                </c:pt>
                <c:pt idx="522">
                  <c:v>1.2885287997104939</c:v>
                </c:pt>
                <c:pt idx="523">
                  <c:v>1.702505106587838</c:v>
                </c:pt>
                <c:pt idx="524">
                  <c:v>1.1634026863297131</c:v>
                </c:pt>
                <c:pt idx="525">
                  <c:v>1.4824724342917408</c:v>
                </c:pt>
                <c:pt idx="526">
                  <c:v>1.3987610795841803</c:v>
                </c:pt>
                <c:pt idx="527">
                  <c:v>1.0811627782129489</c:v>
                </c:pt>
                <c:pt idx="528">
                  <c:v>1.0335042824491869</c:v>
                </c:pt>
                <c:pt idx="529">
                  <c:v>0.93504952292540389</c:v>
                </c:pt>
                <c:pt idx="530">
                  <c:v>1.0844203771244549</c:v>
                </c:pt>
                <c:pt idx="531">
                  <c:v>1.0588496156848983</c:v>
                </c:pt>
                <c:pt idx="532">
                  <c:v>1.1635924625738081</c:v>
                </c:pt>
                <c:pt idx="533">
                  <c:v>1.2389369581308827</c:v>
                </c:pt>
                <c:pt idx="534">
                  <c:v>1.0912674616429716</c:v>
                </c:pt>
                <c:pt idx="535">
                  <c:v>1.0946000741794231</c:v>
                </c:pt>
                <c:pt idx="536">
                  <c:v>1.2957603490493648</c:v>
                </c:pt>
                <c:pt idx="537">
                  <c:v>1.2594225469027036</c:v>
                </c:pt>
                <c:pt idx="538">
                  <c:v>0.94856104569497612</c:v>
                </c:pt>
                <c:pt idx="539">
                  <c:v>1.1051938061135587</c:v>
                </c:pt>
                <c:pt idx="540">
                  <c:v>1.0661350716347868</c:v>
                </c:pt>
                <c:pt idx="541">
                  <c:v>1.3293861188755178</c:v>
                </c:pt>
                <c:pt idx="542">
                  <c:v>1.3013109524825448</c:v>
                </c:pt>
                <c:pt idx="543">
                  <c:v>1.0892307468808895</c:v>
                </c:pt>
                <c:pt idx="544">
                  <c:v>1.1786553391541941</c:v>
                </c:pt>
                <c:pt idx="545">
                  <c:v>0.96093922268520537</c:v>
                </c:pt>
                <c:pt idx="546">
                  <c:v>1.1375105817133011</c:v>
                </c:pt>
                <c:pt idx="547">
                  <c:v>1.072221156710162</c:v>
                </c:pt>
                <c:pt idx="548">
                  <c:v>1.0572690532279037</c:v>
                </c:pt>
                <c:pt idx="549">
                  <c:v>1.0621985584605362</c:v>
                </c:pt>
                <c:pt idx="550">
                  <c:v>1.139153332563424</c:v>
                </c:pt>
                <c:pt idx="551">
                  <c:v>1.0509943788507135</c:v>
                </c:pt>
                <c:pt idx="552">
                  <c:v>1.2261592834022599</c:v>
                </c:pt>
                <c:pt idx="553">
                  <c:v>0.98906479544416193</c:v>
                </c:pt>
                <c:pt idx="554">
                  <c:v>1.1190735256519639</c:v>
                </c:pt>
                <c:pt idx="555">
                  <c:v>0.99380958016874443</c:v>
                </c:pt>
                <c:pt idx="556">
                  <c:v>1.191315454129763</c:v>
                </c:pt>
                <c:pt idx="557">
                  <c:v>1.3225156735759487</c:v>
                </c:pt>
                <c:pt idx="558">
                  <c:v>1.2510210774496726</c:v>
                </c:pt>
                <c:pt idx="559">
                  <c:v>1.0349281920543292</c:v>
                </c:pt>
                <c:pt idx="560">
                  <c:v>1.2956751403843056</c:v>
                </c:pt>
                <c:pt idx="561">
                  <c:v>0.97477141983601923</c:v>
                </c:pt>
                <c:pt idx="562">
                  <c:v>0.87770256779174183</c:v>
                </c:pt>
                <c:pt idx="563">
                  <c:v>1.0701723100687128</c:v>
                </c:pt>
                <c:pt idx="564">
                  <c:v>1.055223931326654</c:v>
                </c:pt>
                <c:pt idx="565">
                  <c:v>1.0666033692327563</c:v>
                </c:pt>
                <c:pt idx="566">
                  <c:v>1.5107236395790147</c:v>
                </c:pt>
                <c:pt idx="567">
                  <c:v>1.3007726308857874</c:v>
                </c:pt>
                <c:pt idx="568">
                  <c:v>1.4800265768906187</c:v>
                </c:pt>
                <c:pt idx="569">
                  <c:v>1.0593957504460267</c:v>
                </c:pt>
                <c:pt idx="570">
                  <c:v>1.2655327797610163</c:v>
                </c:pt>
                <c:pt idx="571">
                  <c:v>1.612511215151881</c:v>
                </c:pt>
                <c:pt idx="572">
                  <c:v>1.2863614905334897</c:v>
                </c:pt>
                <c:pt idx="573">
                  <c:v>1.0552892510300145</c:v>
                </c:pt>
                <c:pt idx="574">
                  <c:v>1.2222385654706336</c:v>
                </c:pt>
                <c:pt idx="575">
                  <c:v>1.4944835398374838</c:v>
                </c:pt>
                <c:pt idx="576">
                  <c:v>1.019932256602115</c:v>
                </c:pt>
                <c:pt idx="577">
                  <c:v>1.2492583781701976</c:v>
                </c:pt>
                <c:pt idx="578">
                  <c:v>1.1567230293621511</c:v>
                </c:pt>
                <c:pt idx="579">
                  <c:v>1.360443602691406</c:v>
                </c:pt>
                <c:pt idx="580">
                  <c:v>1.0396152403199306</c:v>
                </c:pt>
                <c:pt idx="581">
                  <c:v>1.0117354658915276</c:v>
                </c:pt>
                <c:pt idx="582">
                  <c:v>0.95686037621626807</c:v>
                </c:pt>
                <c:pt idx="583">
                  <c:v>1.1001722791583832</c:v>
                </c:pt>
                <c:pt idx="584">
                  <c:v>1.0656935510546564</c:v>
                </c:pt>
                <c:pt idx="585">
                  <c:v>1.0557029176686614</c:v>
                </c:pt>
                <c:pt idx="586">
                  <c:v>1.3212253983958164</c:v>
                </c:pt>
                <c:pt idx="587">
                  <c:v>1.1060117716542937</c:v>
                </c:pt>
                <c:pt idx="588">
                  <c:v>1.5751502322649369</c:v>
                </c:pt>
                <c:pt idx="589">
                  <c:v>1.187513391830435</c:v>
                </c:pt>
                <c:pt idx="590">
                  <c:v>1.4340982716211568</c:v>
                </c:pt>
                <c:pt idx="591">
                  <c:v>1.1581578247320226</c:v>
                </c:pt>
                <c:pt idx="592">
                  <c:v>1.2364195711093284</c:v>
                </c:pt>
                <c:pt idx="593">
                  <c:v>1.4389645735746017</c:v>
                </c:pt>
                <c:pt idx="594">
                  <c:v>1.0017184080238402</c:v>
                </c:pt>
                <c:pt idx="595">
                  <c:v>1.220475619311012</c:v>
                </c:pt>
                <c:pt idx="596">
                  <c:v>1.0856333866940826</c:v>
                </c:pt>
                <c:pt idx="597">
                  <c:v>1.6178823876052739</c:v>
                </c:pt>
                <c:pt idx="598">
                  <c:v>1.1954125283934989</c:v>
                </c:pt>
                <c:pt idx="599">
                  <c:v>1.3754331224247756</c:v>
                </c:pt>
                <c:pt idx="600">
                  <c:v>1.1518636532717252</c:v>
                </c:pt>
                <c:pt idx="601">
                  <c:v>1.0871414702080964</c:v>
                </c:pt>
                <c:pt idx="602">
                  <c:v>0.95437444681946504</c:v>
                </c:pt>
                <c:pt idx="603">
                  <c:v>0.94985719469132601</c:v>
                </c:pt>
                <c:pt idx="604">
                  <c:v>0.97445093668787564</c:v>
                </c:pt>
                <c:pt idx="605">
                  <c:v>1.1620673371736752</c:v>
                </c:pt>
                <c:pt idx="606">
                  <c:v>1.2193330554879596</c:v>
                </c:pt>
                <c:pt idx="607">
                  <c:v>1.3421166670897413</c:v>
                </c:pt>
                <c:pt idx="608">
                  <c:v>1.5836521570602509</c:v>
                </c:pt>
                <c:pt idx="609">
                  <c:v>1.410612409080797</c:v>
                </c:pt>
                <c:pt idx="610">
                  <c:v>1.0082836025610677</c:v>
                </c:pt>
                <c:pt idx="611">
                  <c:v>1.007464253233668</c:v>
                </c:pt>
                <c:pt idx="612">
                  <c:v>1.0099493988018806</c:v>
                </c:pt>
                <c:pt idx="613">
                  <c:v>1.0474473017137003</c:v>
                </c:pt>
                <c:pt idx="614">
                  <c:v>1.212833340898221</c:v>
                </c:pt>
                <c:pt idx="615">
                  <c:v>0.89973970123007896</c:v>
                </c:pt>
                <c:pt idx="616">
                  <c:v>1.1164542173667995</c:v>
                </c:pt>
                <c:pt idx="617">
                  <c:v>0.96589313001274724</c:v>
                </c:pt>
                <c:pt idx="618">
                  <c:v>1.1029358218228336</c:v>
                </c:pt>
                <c:pt idx="619">
                  <c:v>1.1895764545056677</c:v>
                </c:pt>
                <c:pt idx="620">
                  <c:v>1.2960043438406068</c:v>
                </c:pt>
                <c:pt idx="621">
                  <c:v>2.1724547327255399</c:v>
                </c:pt>
                <c:pt idx="622">
                  <c:v>0.99217270987189732</c:v>
                </c:pt>
                <c:pt idx="623">
                  <c:v>1.5544189050782522</c:v>
                </c:pt>
                <c:pt idx="624">
                  <c:v>1.4247313867116314</c:v>
                </c:pt>
                <c:pt idx="625">
                  <c:v>1.3600174583245077</c:v>
                </c:pt>
                <c:pt idx="626">
                  <c:v>1.3301969974068459</c:v>
                </c:pt>
                <c:pt idx="627">
                  <c:v>1.1006245418866907</c:v>
                </c:pt>
                <c:pt idx="628">
                  <c:v>0.93414864692063271</c:v>
                </c:pt>
                <c:pt idx="629">
                  <c:v>1.088960128203845</c:v>
                </c:pt>
                <c:pt idx="630">
                  <c:v>1.2689546378843986</c:v>
                </c:pt>
                <c:pt idx="631">
                  <c:v>0.98343431868930342</c:v>
                </c:pt>
                <c:pt idx="632">
                  <c:v>1.3050906373568558</c:v>
                </c:pt>
                <c:pt idx="633">
                  <c:v>1.7551550706329861</c:v>
                </c:pt>
                <c:pt idx="634">
                  <c:v>1.4961814076165829</c:v>
                </c:pt>
                <c:pt idx="635">
                  <c:v>1.1900275101438946</c:v>
                </c:pt>
                <c:pt idx="636">
                  <c:v>0.97940160007141364</c:v>
                </c:pt>
                <c:pt idx="637">
                  <c:v>1.4094208950812572</c:v>
                </c:pt>
                <c:pt idx="638">
                  <c:v>1.1383711527315032</c:v>
                </c:pt>
                <c:pt idx="639">
                  <c:v>1.2065774739457926</c:v>
                </c:pt>
                <c:pt idx="640">
                  <c:v>1.5372391197544715</c:v>
                </c:pt>
                <c:pt idx="641">
                  <c:v>0.96640737884937122</c:v>
                </c:pt>
                <c:pt idx="642">
                  <c:v>1.1024371152430865</c:v>
                </c:pt>
                <c:pt idx="643">
                  <c:v>0.97626935553354399</c:v>
                </c:pt>
                <c:pt idx="644">
                  <c:v>1.2935991167092302</c:v>
                </c:pt>
                <c:pt idx="645">
                  <c:v>1.1138247778674666</c:v>
                </c:pt>
                <c:pt idx="646">
                  <c:v>1.0833128388372735</c:v>
                </c:pt>
                <c:pt idx="647">
                  <c:v>1.0040990758211139</c:v>
                </c:pt>
                <c:pt idx="648">
                  <c:v>1.1813150769440131</c:v>
                </c:pt>
                <c:pt idx="649">
                  <c:v>1.1438803646430109</c:v>
                </c:pt>
                <c:pt idx="650">
                  <c:v>1.5047379020346208</c:v>
                </c:pt>
                <c:pt idx="651">
                  <c:v>1.5864116358163642</c:v>
                </c:pt>
                <c:pt idx="652">
                  <c:v>1.4420775445518028</c:v>
                </c:pt>
                <c:pt idx="653">
                  <c:v>1.21422192687818</c:v>
                </c:pt>
                <c:pt idx="654">
                  <c:v>1.1579953762082267</c:v>
                </c:pt>
                <c:pt idx="655">
                  <c:v>1.1959958691691488</c:v>
                </c:pt>
                <c:pt idx="656">
                  <c:v>1.1413199432465215</c:v>
                </c:pt>
                <c:pt idx="657">
                  <c:v>1.1046398941054971</c:v>
                </c:pt>
                <c:pt idx="658">
                  <c:v>1.2498050096776776</c:v>
                </c:pt>
                <c:pt idx="659">
                  <c:v>1.1177229971720934</c:v>
                </c:pt>
                <c:pt idx="660">
                  <c:v>1.2094700305046751</c:v>
                </c:pt>
                <c:pt idx="661">
                  <c:v>1.0348635326540687</c:v>
                </c:pt>
                <c:pt idx="662">
                  <c:v>1.3281812222498901</c:v>
                </c:pt>
                <c:pt idx="663">
                  <c:v>0.96184502954959794</c:v>
                </c:pt>
                <c:pt idx="664">
                  <c:v>1.2168495560782158</c:v>
                </c:pt>
                <c:pt idx="665">
                  <c:v>1.0629376606757051</c:v>
                </c:pt>
                <c:pt idx="666">
                  <c:v>1.0020802696480913</c:v>
                </c:pt>
                <c:pt idx="667">
                  <c:v>1.0749846190638523</c:v>
                </c:pt>
                <c:pt idx="668">
                  <c:v>1.6119796438033238</c:v>
                </c:pt>
                <c:pt idx="669">
                  <c:v>1.1759350405746802</c:v>
                </c:pt>
                <c:pt idx="670">
                  <c:v>1.0023324716716233</c:v>
                </c:pt>
                <c:pt idx="671">
                  <c:v>1.7434516701043603</c:v>
                </c:pt>
                <c:pt idx="672">
                  <c:v>1.0683257737370069</c:v>
                </c:pt>
                <c:pt idx="673">
                  <c:v>1.2061117045690999</c:v>
                </c:pt>
                <c:pt idx="674">
                  <c:v>1.0126047284258106</c:v>
                </c:pt>
                <c:pt idx="675">
                  <c:v>1.5717571026110173</c:v>
                </c:pt>
                <c:pt idx="676">
                  <c:v>1.0107118700724926</c:v>
                </c:pt>
                <c:pt idx="677">
                  <c:v>1.1552903293428864</c:v>
                </c:pt>
                <c:pt idx="678">
                  <c:v>1.0174442412145657</c:v>
                </c:pt>
                <c:pt idx="679">
                  <c:v>1.5723912046646127</c:v>
                </c:pt>
                <c:pt idx="680">
                  <c:v>1.3837693462509788</c:v>
                </c:pt>
                <c:pt idx="681">
                  <c:v>1.3065904265157804</c:v>
                </c:pt>
                <c:pt idx="682">
                  <c:v>1.2359340657847464</c:v>
                </c:pt>
                <c:pt idx="683">
                  <c:v>1.4162934971176673</c:v>
                </c:pt>
                <c:pt idx="684">
                  <c:v>1.5407443291165317</c:v>
                </c:pt>
                <c:pt idx="685">
                  <c:v>1.3789816603055891</c:v>
                </c:pt>
                <c:pt idx="686">
                  <c:v>1.4949339347517339</c:v>
                </c:pt>
                <c:pt idx="687">
                  <c:v>1.3672143778013479</c:v>
                </c:pt>
                <c:pt idx="688">
                  <c:v>0.99174315028382554</c:v>
                </c:pt>
                <c:pt idx="689">
                  <c:v>0.94573435417423202</c:v>
                </c:pt>
                <c:pt idx="690">
                  <c:v>1.1816162604688099</c:v>
                </c:pt>
                <c:pt idx="691">
                  <c:v>1.1511463624115164</c:v>
                </c:pt>
                <c:pt idx="692">
                  <c:v>1.1046986100314236</c:v>
                </c:pt>
                <c:pt idx="693">
                  <c:v>1.4520722748603829</c:v>
                </c:pt>
                <c:pt idx="694">
                  <c:v>1.5003331374292643</c:v>
                </c:pt>
                <c:pt idx="695">
                  <c:v>1.0548517844995131</c:v>
                </c:pt>
                <c:pt idx="696">
                  <c:v>1.183173592942131</c:v>
                </c:pt>
                <c:pt idx="697">
                  <c:v>1.1197465855910012</c:v>
                </c:pt>
                <c:pt idx="698">
                  <c:v>1.2361534737546336</c:v>
                </c:pt>
                <c:pt idx="699">
                  <c:v>1.0162864379991037</c:v>
                </c:pt>
                <c:pt idx="700">
                  <c:v>1.3123677322490097</c:v>
                </c:pt>
                <c:pt idx="701">
                  <c:v>1.3585094422425801</c:v>
                </c:pt>
                <c:pt idx="702">
                  <c:v>1.0661255589626404</c:v>
                </c:pt>
                <c:pt idx="703">
                  <c:v>0.85987789103738643</c:v>
                </c:pt>
                <c:pt idx="704">
                  <c:v>1.1240100149496104</c:v>
                </c:pt>
                <c:pt idx="705">
                  <c:v>1.2138086993392461</c:v>
                </c:pt>
              </c:numCache>
            </c:numRef>
          </c:xVal>
          <c:yVal>
            <c:numRef>
              <c:f>triplicate!$C$2:$C$708</c:f>
              <c:numCache>
                <c:formatCode>0.00</c:formatCode>
                <c:ptCount val="707"/>
                <c:pt idx="0">
                  <c:v>1.4988597463843549</c:v>
                </c:pt>
                <c:pt idx="1">
                  <c:v>1.0860532602278896</c:v>
                </c:pt>
                <c:pt idx="2">
                  <c:v>0.92506255222824829</c:v>
                </c:pt>
                <c:pt idx="3">
                  <c:v>1.1432223960712591</c:v>
                </c:pt>
                <c:pt idx="4">
                  <c:v>0.89057899837241927</c:v>
                </c:pt>
                <c:pt idx="5">
                  <c:v>1.3571373046887303</c:v>
                </c:pt>
                <c:pt idx="6">
                  <c:v>1.5879467713720525</c:v>
                </c:pt>
                <c:pt idx="7">
                  <c:v>0.90193258267700993</c:v>
                </c:pt>
                <c:pt idx="8">
                  <c:v>0.90059089841289686</c:v>
                </c:pt>
                <c:pt idx="9">
                  <c:v>1.3781083791683411</c:v>
                </c:pt>
                <c:pt idx="10">
                  <c:v>1.0239407068606274</c:v>
                </c:pt>
                <c:pt idx="11">
                  <c:v>1.0091371087825918</c:v>
                </c:pt>
                <c:pt idx="12">
                  <c:v>1.1545133945278814</c:v>
                </c:pt>
                <c:pt idx="13">
                  <c:v>1.1085953300342235</c:v>
                </c:pt>
                <c:pt idx="14">
                  <c:v>1.1886735410913012</c:v>
                </c:pt>
                <c:pt idx="15">
                  <c:v>1.2564561442079618</c:v>
                </c:pt>
                <c:pt idx="16">
                  <c:v>1.0734035149170953</c:v>
                </c:pt>
                <c:pt idx="17">
                  <c:v>0.86953122181509745</c:v>
                </c:pt>
                <c:pt idx="18">
                  <c:v>0.89256019169163847</c:v>
                </c:pt>
                <c:pt idx="19">
                  <c:v>0.92006247436797295</c:v>
                </c:pt>
                <c:pt idx="20">
                  <c:v>1.1093147406093762</c:v>
                </c:pt>
                <c:pt idx="21">
                  <c:v>1.2846239976708533</c:v>
                </c:pt>
                <c:pt idx="22">
                  <c:v>1.1299514761867426</c:v>
                </c:pt>
                <c:pt idx="23">
                  <c:v>1.1812154122777967</c:v>
                </c:pt>
                <c:pt idx="24">
                  <c:v>1.0735280253462158</c:v>
                </c:pt>
                <c:pt idx="25">
                  <c:v>1.1084017803092119</c:v>
                </c:pt>
                <c:pt idx="26">
                  <c:v>1.0296353968392817</c:v>
                </c:pt>
                <c:pt idx="27">
                  <c:v>1.0082058741227231</c:v>
                </c:pt>
                <c:pt idx="28">
                  <c:v>0.99816665807002036</c:v>
                </c:pt>
                <c:pt idx="29">
                  <c:v>1.1762802257172833</c:v>
                </c:pt>
                <c:pt idx="30">
                  <c:v>1.1078193346252483</c:v>
                </c:pt>
                <c:pt idx="31">
                  <c:v>0.92201961502737895</c:v>
                </c:pt>
                <c:pt idx="32">
                  <c:v>1.2197810263725628</c:v>
                </c:pt>
                <c:pt idx="33">
                  <c:v>0.99728473464043932</c:v>
                </c:pt>
                <c:pt idx="34">
                  <c:v>2.2324954334842779</c:v>
                </c:pt>
                <c:pt idx="35">
                  <c:v>1.1408223944087124</c:v>
                </c:pt>
                <c:pt idx="36">
                  <c:v>1.240740998675663</c:v>
                </c:pt>
                <c:pt idx="37">
                  <c:v>1.0440808626194331</c:v>
                </c:pt>
                <c:pt idx="38">
                  <c:v>1.5182970620520817</c:v>
                </c:pt>
                <c:pt idx="39">
                  <c:v>0.8868388679221757</c:v>
                </c:pt>
                <c:pt idx="40">
                  <c:v>1.1555588397627319</c:v>
                </c:pt>
                <c:pt idx="41">
                  <c:v>1.0005461294062408</c:v>
                </c:pt>
                <c:pt idx="42">
                  <c:v>1.1522966606984901</c:v>
                </c:pt>
                <c:pt idx="43">
                  <c:v>1.0396009531967416</c:v>
                </c:pt>
                <c:pt idx="44">
                  <c:v>0.89391306622980993</c:v>
                </c:pt>
                <c:pt idx="45">
                  <c:v>1.3955948063037169</c:v>
                </c:pt>
                <c:pt idx="46">
                  <c:v>1.1261129114791175</c:v>
                </c:pt>
                <c:pt idx="47">
                  <c:v>1.7926306283909275</c:v>
                </c:pt>
                <c:pt idx="48">
                  <c:v>1.1230893834832942</c:v>
                </c:pt>
                <c:pt idx="49">
                  <c:v>1.5945007074764939</c:v>
                </c:pt>
                <c:pt idx="50">
                  <c:v>1.0511725304696828</c:v>
                </c:pt>
                <c:pt idx="51">
                  <c:v>0.99195991554440865</c:v>
                </c:pt>
                <c:pt idx="52">
                  <c:v>0.97543382932346145</c:v>
                </c:pt>
                <c:pt idx="53">
                  <c:v>1.5684915489557956</c:v>
                </c:pt>
                <c:pt idx="54">
                  <c:v>1.1911603801621498</c:v>
                </c:pt>
                <c:pt idx="55">
                  <c:v>1.2849766062692827</c:v>
                </c:pt>
                <c:pt idx="56">
                  <c:v>1.292202870081643</c:v>
                </c:pt>
                <c:pt idx="57">
                  <c:v>1.0380948871873321</c:v>
                </c:pt>
                <c:pt idx="58">
                  <c:v>1.5248133882383084</c:v>
                </c:pt>
                <c:pt idx="59">
                  <c:v>1.2161171955388617</c:v>
                </c:pt>
                <c:pt idx="60">
                  <c:v>1.4541286298056466</c:v>
                </c:pt>
                <c:pt idx="61">
                  <c:v>1.2245179779499789</c:v>
                </c:pt>
                <c:pt idx="62">
                  <c:v>1.6375611880899017</c:v>
                </c:pt>
                <c:pt idx="63">
                  <c:v>0.93224941721927879</c:v>
                </c:pt>
                <c:pt idx="64">
                  <c:v>1.1077498839588125</c:v>
                </c:pt>
                <c:pt idx="65">
                  <c:v>0.92629535593873502</c:v>
                </c:pt>
                <c:pt idx="66">
                  <c:v>1.1121872587162769</c:v>
                </c:pt>
                <c:pt idx="67">
                  <c:v>1.0757770140873626</c:v>
                </c:pt>
                <c:pt idx="68">
                  <c:v>1.1383679313217583</c:v>
                </c:pt>
                <c:pt idx="69">
                  <c:v>1.053279845214584</c:v>
                </c:pt>
                <c:pt idx="70">
                  <c:v>1.0744051109297095</c:v>
                </c:pt>
                <c:pt idx="71">
                  <c:v>1.1889449077232208</c:v>
                </c:pt>
                <c:pt idx="72">
                  <c:v>1.2229292176674524</c:v>
                </c:pt>
                <c:pt idx="73">
                  <c:v>0.98807039798016294</c:v>
                </c:pt>
                <c:pt idx="74">
                  <c:v>1.1427424399293056</c:v>
                </c:pt>
                <c:pt idx="75">
                  <c:v>1.3346418979407226</c:v>
                </c:pt>
                <c:pt idx="76">
                  <c:v>1.3326991546799631</c:v>
                </c:pt>
                <c:pt idx="77">
                  <c:v>1.2430394556776032</c:v>
                </c:pt>
                <c:pt idx="78">
                  <c:v>1.2473066297183162</c:v>
                </c:pt>
                <c:pt idx="79">
                  <c:v>1.0232075262634812</c:v>
                </c:pt>
                <c:pt idx="80">
                  <c:v>1.0620797293713438</c:v>
                </c:pt>
                <c:pt idx="81">
                  <c:v>1.4891092535032506</c:v>
                </c:pt>
                <c:pt idx="82">
                  <c:v>1.0745243564414655</c:v>
                </c:pt>
                <c:pt idx="83">
                  <c:v>1.2265929049491802</c:v>
                </c:pt>
                <c:pt idx="84">
                  <c:v>1.4684037609296545</c:v>
                </c:pt>
                <c:pt idx="85">
                  <c:v>0.93486680634394248</c:v>
                </c:pt>
                <c:pt idx="86">
                  <c:v>1.3248252894883938</c:v>
                </c:pt>
                <c:pt idx="87">
                  <c:v>1.3397267867976062</c:v>
                </c:pt>
                <c:pt idx="88">
                  <c:v>0.86011489991176437</c:v>
                </c:pt>
                <c:pt idx="89">
                  <c:v>1.0934221785869094</c:v>
                </c:pt>
                <c:pt idx="90">
                  <c:v>1.1976964644037613</c:v>
                </c:pt>
                <c:pt idx="91">
                  <c:v>0.8852325621969247</c:v>
                </c:pt>
                <c:pt idx="92">
                  <c:v>1.0624976643064254</c:v>
                </c:pt>
                <c:pt idx="93">
                  <c:v>0.9794730980926758</c:v>
                </c:pt>
                <c:pt idx="94">
                  <c:v>1.284011859863601</c:v>
                </c:pt>
                <c:pt idx="95">
                  <c:v>1.3170009438756147</c:v>
                </c:pt>
                <c:pt idx="96">
                  <c:v>1.0710456651203237</c:v>
                </c:pt>
                <c:pt idx="97">
                  <c:v>1.4934152995094794</c:v>
                </c:pt>
                <c:pt idx="98">
                  <c:v>1.1325604418774222</c:v>
                </c:pt>
                <c:pt idx="99">
                  <c:v>1.4564812606075057</c:v>
                </c:pt>
                <c:pt idx="100">
                  <c:v>1.1797119629939583</c:v>
                </c:pt>
                <c:pt idx="101">
                  <c:v>1.4438761552108397</c:v>
                </c:pt>
                <c:pt idx="102">
                  <c:v>0.9608335101527643</c:v>
                </c:pt>
                <c:pt idx="103">
                  <c:v>2.139105658135577</c:v>
                </c:pt>
                <c:pt idx="104">
                  <c:v>0.88930964150938541</c:v>
                </c:pt>
                <c:pt idx="105">
                  <c:v>1.167151476378409</c:v>
                </c:pt>
                <c:pt idx="106">
                  <c:v>0.99099849946409435</c:v>
                </c:pt>
                <c:pt idx="107">
                  <c:v>1.5895327805363739</c:v>
                </c:pt>
                <c:pt idx="108">
                  <c:v>0.90084089748948115</c:v>
                </c:pt>
                <c:pt idx="109">
                  <c:v>1.3261975522710765</c:v>
                </c:pt>
                <c:pt idx="110">
                  <c:v>1.0971270023067865</c:v>
                </c:pt>
                <c:pt idx="111">
                  <c:v>1.468933948629328</c:v>
                </c:pt>
                <c:pt idx="112">
                  <c:v>1.0197658212512339</c:v>
                </c:pt>
                <c:pt idx="113">
                  <c:v>0.75647985829874009</c:v>
                </c:pt>
                <c:pt idx="114">
                  <c:v>1.055093593892489</c:v>
                </c:pt>
                <c:pt idx="115">
                  <c:v>0.83829844821651411</c:v>
                </c:pt>
                <c:pt idx="116">
                  <c:v>1.255547520437037</c:v>
                </c:pt>
                <c:pt idx="117">
                  <c:v>0.89041063652230423</c:v>
                </c:pt>
                <c:pt idx="118">
                  <c:v>1.4609634821412076</c:v>
                </c:pt>
                <c:pt idx="119">
                  <c:v>1.3055477679281422</c:v>
                </c:pt>
                <c:pt idx="120">
                  <c:v>0.87539715057713119</c:v>
                </c:pt>
                <c:pt idx="121">
                  <c:v>1.406522608399901</c:v>
                </c:pt>
                <c:pt idx="122">
                  <c:v>0.93129426424402717</c:v>
                </c:pt>
                <c:pt idx="123">
                  <c:v>0.9468109942368188</c:v>
                </c:pt>
                <c:pt idx="124">
                  <c:v>0.97039214046866706</c:v>
                </c:pt>
                <c:pt idx="125">
                  <c:v>1.4821314710646709</c:v>
                </c:pt>
                <c:pt idx="126">
                  <c:v>1.099330012993377</c:v>
                </c:pt>
                <c:pt idx="127">
                  <c:v>1.9436818522766395</c:v>
                </c:pt>
                <c:pt idx="128">
                  <c:v>1.6689197966984566</c:v>
                </c:pt>
                <c:pt idx="129">
                  <c:v>1.0069710806268499</c:v>
                </c:pt>
                <c:pt idx="130">
                  <c:v>0.97854844209539238</c:v>
                </c:pt>
                <c:pt idx="131">
                  <c:v>1.2654647133843202</c:v>
                </c:pt>
                <c:pt idx="132">
                  <c:v>1.6628694149913319</c:v>
                </c:pt>
                <c:pt idx="133">
                  <c:v>0.92851554788028823</c:v>
                </c:pt>
                <c:pt idx="134">
                  <c:v>1.2113554620621922</c:v>
                </c:pt>
                <c:pt idx="135">
                  <c:v>1.5236822226943323</c:v>
                </c:pt>
                <c:pt idx="136">
                  <c:v>0.68707884255836682</c:v>
                </c:pt>
                <c:pt idx="137">
                  <c:v>1.2207943114574986</c:v>
                </c:pt>
                <c:pt idx="138">
                  <c:v>0.93698990151830275</c:v>
                </c:pt>
                <c:pt idx="139">
                  <c:v>1.2105282184405346</c:v>
                </c:pt>
                <c:pt idx="140">
                  <c:v>1.0785454855681547</c:v>
                </c:pt>
                <c:pt idx="141">
                  <c:v>1.4011196943857016</c:v>
                </c:pt>
                <c:pt idx="142">
                  <c:v>1.4125350859107577</c:v>
                </c:pt>
                <c:pt idx="143">
                  <c:v>1.103688534747695</c:v>
                </c:pt>
                <c:pt idx="144">
                  <c:v>1.5831445193128688</c:v>
                </c:pt>
                <c:pt idx="145">
                  <c:v>0.80642302941901556</c:v>
                </c:pt>
                <c:pt idx="146">
                  <c:v>2.0103724095735616</c:v>
                </c:pt>
                <c:pt idx="147">
                  <c:v>1.8368653397331454</c:v>
                </c:pt>
                <c:pt idx="148">
                  <c:v>1.0444273442326655</c:v>
                </c:pt>
                <c:pt idx="149">
                  <c:v>1.8231254119523537</c:v>
                </c:pt>
                <c:pt idx="150">
                  <c:v>1.0735463026722902</c:v>
                </c:pt>
                <c:pt idx="151">
                  <c:v>1.1772912078903224</c:v>
                </c:pt>
                <c:pt idx="152">
                  <c:v>1.5189869339538216</c:v>
                </c:pt>
                <c:pt idx="153">
                  <c:v>1.4378656620068755</c:v>
                </c:pt>
                <c:pt idx="154">
                  <c:v>0.99089292237925786</c:v>
                </c:pt>
                <c:pt idx="155">
                  <c:v>1.4689137359518651</c:v>
                </c:pt>
                <c:pt idx="156">
                  <c:v>1.0904975366112339</c:v>
                </c:pt>
                <c:pt idx="157">
                  <c:v>1.2410235203422628</c:v>
                </c:pt>
                <c:pt idx="158">
                  <c:v>0.84011169008200881</c:v>
                </c:pt>
                <c:pt idx="159">
                  <c:v>1.4311071376286411</c:v>
                </c:pt>
                <c:pt idx="160">
                  <c:v>1.0332463207949094</c:v>
                </c:pt>
                <c:pt idx="161">
                  <c:v>1.73202762691268</c:v>
                </c:pt>
                <c:pt idx="162">
                  <c:v>1.1358926736369723</c:v>
                </c:pt>
                <c:pt idx="163">
                  <c:v>2.0457261719571158</c:v>
                </c:pt>
                <c:pt idx="164">
                  <c:v>1.2319894053578957</c:v>
                </c:pt>
                <c:pt idx="165">
                  <c:v>1.0015955760183524</c:v>
                </c:pt>
                <c:pt idx="166">
                  <c:v>1.0482870163525979</c:v>
                </c:pt>
                <c:pt idx="167">
                  <c:v>0.92166350807188868</c:v>
                </c:pt>
                <c:pt idx="168">
                  <c:v>0.89614121249370504</c:v>
                </c:pt>
                <c:pt idx="169">
                  <c:v>1.1391946299564941</c:v>
                </c:pt>
                <c:pt idx="170">
                  <c:v>0.85938166639625513</c:v>
                </c:pt>
                <c:pt idx="171">
                  <c:v>1.1091850921435402</c:v>
                </c:pt>
                <c:pt idx="172">
                  <c:v>0.9565126508947811</c:v>
                </c:pt>
                <c:pt idx="173">
                  <c:v>0.99897868164362325</c:v>
                </c:pt>
                <c:pt idx="174">
                  <c:v>1.2990447215934462</c:v>
                </c:pt>
                <c:pt idx="175">
                  <c:v>1.3192653675974972</c:v>
                </c:pt>
                <c:pt idx="176">
                  <c:v>1.0567955742953208</c:v>
                </c:pt>
                <c:pt idx="177">
                  <c:v>1.0896917904210688</c:v>
                </c:pt>
                <c:pt idx="178">
                  <c:v>0.91904673067676768</c:v>
                </c:pt>
                <c:pt idx="179">
                  <c:v>1.0227980817245577</c:v>
                </c:pt>
                <c:pt idx="180">
                  <c:v>1.290402063996507</c:v>
                </c:pt>
                <c:pt idx="181">
                  <c:v>1.1400327866188342</c:v>
                </c:pt>
                <c:pt idx="182">
                  <c:v>1.5120933245360439</c:v>
                </c:pt>
                <c:pt idx="183">
                  <c:v>1.4927711955760758</c:v>
                </c:pt>
                <c:pt idx="184">
                  <c:v>1.3856409365808569</c:v>
                </c:pt>
                <c:pt idx="185">
                  <c:v>1.5449347440317989</c:v>
                </c:pt>
                <c:pt idx="186">
                  <c:v>1.2258985827086755</c:v>
                </c:pt>
                <c:pt idx="187">
                  <c:v>1.0890973924057605</c:v>
                </c:pt>
                <c:pt idx="188">
                  <c:v>1.2422932545437824</c:v>
                </c:pt>
                <c:pt idx="189">
                  <c:v>1.6924210565603042</c:v>
                </c:pt>
                <c:pt idx="190">
                  <c:v>1.2885079130386929</c:v>
                </c:pt>
                <c:pt idx="191">
                  <c:v>1.1393707977054055</c:v>
                </c:pt>
                <c:pt idx="192">
                  <c:v>1.0464678162147854</c:v>
                </c:pt>
                <c:pt idx="193">
                  <c:v>1.3486428281413472</c:v>
                </c:pt>
                <c:pt idx="194">
                  <c:v>1.5898997219129503</c:v>
                </c:pt>
                <c:pt idx="195">
                  <c:v>1.1982863653469549</c:v>
                </c:pt>
                <c:pt idx="196">
                  <c:v>1.8769183847896393</c:v>
                </c:pt>
                <c:pt idx="197">
                  <c:v>1.7209137597589688</c:v>
                </c:pt>
                <c:pt idx="198">
                  <c:v>1.4725078287318953</c:v>
                </c:pt>
                <c:pt idx="199">
                  <c:v>1.2707956583618494</c:v>
                </c:pt>
                <c:pt idx="200">
                  <c:v>1.5330509313536738</c:v>
                </c:pt>
                <c:pt idx="201">
                  <c:v>1.2978306533524748</c:v>
                </c:pt>
                <c:pt idx="202">
                  <c:v>1.292728352904448</c:v>
                </c:pt>
                <c:pt idx="203">
                  <c:v>1.3677726428568024</c:v>
                </c:pt>
                <c:pt idx="204">
                  <c:v>1.2504548328477905</c:v>
                </c:pt>
                <c:pt idx="205">
                  <c:v>1.0702955854032314</c:v>
                </c:pt>
                <c:pt idx="206">
                  <c:v>1.3240538783857394</c:v>
                </c:pt>
                <c:pt idx="207">
                  <c:v>1.3895973704889528</c:v>
                </c:pt>
                <c:pt idx="208">
                  <c:v>1.3664461169925142</c:v>
                </c:pt>
                <c:pt idx="209">
                  <c:v>1.0566581546834124</c:v>
                </c:pt>
                <c:pt idx="210">
                  <c:v>1.1932401671278572</c:v>
                </c:pt>
                <c:pt idx="211">
                  <c:v>1.2587187110655644</c:v>
                </c:pt>
                <c:pt idx="212">
                  <c:v>2.1376122024614777</c:v>
                </c:pt>
                <c:pt idx="213">
                  <c:v>1.5198306188859236</c:v>
                </c:pt>
                <c:pt idx="214">
                  <c:v>1.4745975518057477</c:v>
                </c:pt>
                <c:pt idx="215">
                  <c:v>1.012555908123393</c:v>
                </c:pt>
                <c:pt idx="216">
                  <c:v>1.3570240156173565</c:v>
                </c:pt>
                <c:pt idx="217">
                  <c:v>1.245840985745406</c:v>
                </c:pt>
                <c:pt idx="218">
                  <c:v>1.3150468986291968</c:v>
                </c:pt>
                <c:pt idx="219">
                  <c:v>1.1042118654658624</c:v>
                </c:pt>
                <c:pt idx="220">
                  <c:v>1.0000692310772141</c:v>
                </c:pt>
                <c:pt idx="221">
                  <c:v>0.88996645101486749</c:v>
                </c:pt>
                <c:pt idx="222">
                  <c:v>1.2519950527408037</c:v>
                </c:pt>
                <c:pt idx="223">
                  <c:v>1.4251936997152552</c:v>
                </c:pt>
                <c:pt idx="224">
                  <c:v>0.94692490871854895</c:v>
                </c:pt>
                <c:pt idx="225">
                  <c:v>1.0901876553700001</c:v>
                </c:pt>
                <c:pt idx="226">
                  <c:v>1.3102922848163034</c:v>
                </c:pt>
                <c:pt idx="227">
                  <c:v>1.3495625897365247</c:v>
                </c:pt>
                <c:pt idx="228">
                  <c:v>1.1631071796671337</c:v>
                </c:pt>
                <c:pt idx="229">
                  <c:v>0.98535753081352884</c:v>
                </c:pt>
                <c:pt idx="230">
                  <c:v>1.0459813469803998</c:v>
                </c:pt>
                <c:pt idx="231">
                  <c:v>0.97457568156348262</c:v>
                </c:pt>
                <c:pt idx="232">
                  <c:v>1.3196165019128852</c:v>
                </c:pt>
                <c:pt idx="233">
                  <c:v>1.3953845724938267</c:v>
                </c:pt>
                <c:pt idx="234">
                  <c:v>1.1315548697940083</c:v>
                </c:pt>
                <c:pt idx="235">
                  <c:v>0.99757180929684974</c:v>
                </c:pt>
                <c:pt idx="236">
                  <c:v>1.0118925912616517</c:v>
                </c:pt>
                <c:pt idx="237">
                  <c:v>1.3504787242889524</c:v>
                </c:pt>
                <c:pt idx="238">
                  <c:v>0.98079557812222928</c:v>
                </c:pt>
                <c:pt idx="239">
                  <c:v>1.1467674889535147</c:v>
                </c:pt>
                <c:pt idx="240">
                  <c:v>1.0583633824266383</c:v>
                </c:pt>
                <c:pt idx="241">
                  <c:v>1.277855833889993</c:v>
                </c:pt>
                <c:pt idx="242">
                  <c:v>1.3082604142368868</c:v>
                </c:pt>
                <c:pt idx="243">
                  <c:v>1.2111397274296454</c:v>
                </c:pt>
                <c:pt idx="244">
                  <c:v>1.1196875870996097</c:v>
                </c:pt>
                <c:pt idx="245">
                  <c:v>1.0982780818019211</c:v>
                </c:pt>
                <c:pt idx="246">
                  <c:v>1.0191654002998487</c:v>
                </c:pt>
                <c:pt idx="247">
                  <c:v>1.3345729920262661</c:v>
                </c:pt>
                <c:pt idx="248">
                  <c:v>1.0553639170902314</c:v>
                </c:pt>
                <c:pt idx="249">
                  <c:v>1.3969210624153148</c:v>
                </c:pt>
                <c:pt idx="250">
                  <c:v>1.1306456176240949</c:v>
                </c:pt>
                <c:pt idx="251">
                  <c:v>1.336741175942018</c:v>
                </c:pt>
                <c:pt idx="252">
                  <c:v>1.3623561580164079</c:v>
                </c:pt>
                <c:pt idx="253">
                  <c:v>1.2038719925521717</c:v>
                </c:pt>
                <c:pt idx="254">
                  <c:v>1.5000336036334447</c:v>
                </c:pt>
                <c:pt idx="255">
                  <c:v>0.94521986810798364</c:v>
                </c:pt>
                <c:pt idx="256">
                  <c:v>1.0345255583445399</c:v>
                </c:pt>
                <c:pt idx="257">
                  <c:v>1.720993495242527</c:v>
                </c:pt>
                <c:pt idx="258">
                  <c:v>1.7459095695536131</c:v>
                </c:pt>
                <c:pt idx="259">
                  <c:v>1.0271706445884785</c:v>
                </c:pt>
                <c:pt idx="260">
                  <c:v>1.1915637855583687</c:v>
                </c:pt>
                <c:pt idx="261">
                  <c:v>0.98003304991748863</c:v>
                </c:pt>
                <c:pt idx="262">
                  <c:v>1.0440137292703129</c:v>
                </c:pt>
                <c:pt idx="263">
                  <c:v>1.1175678589215057</c:v>
                </c:pt>
                <c:pt idx="264">
                  <c:v>1.0855490381130921</c:v>
                </c:pt>
                <c:pt idx="265">
                  <c:v>1.050069348981008</c:v>
                </c:pt>
                <c:pt idx="266">
                  <c:v>0.95912963139567275</c:v>
                </c:pt>
                <c:pt idx="267">
                  <c:v>1.6032479864624147</c:v>
                </c:pt>
                <c:pt idx="268">
                  <c:v>1.242388461046968</c:v>
                </c:pt>
                <c:pt idx="269">
                  <c:v>1.0972877502055181</c:v>
                </c:pt>
                <c:pt idx="270">
                  <c:v>1.2319246377226503</c:v>
                </c:pt>
                <c:pt idx="271">
                  <c:v>0.92625611071762715</c:v>
                </c:pt>
                <c:pt idx="272">
                  <c:v>1.2371859412503026</c:v>
                </c:pt>
                <c:pt idx="273">
                  <c:v>1.302314655721357</c:v>
                </c:pt>
                <c:pt idx="274">
                  <c:v>1.1869472069020528</c:v>
                </c:pt>
                <c:pt idx="275">
                  <c:v>1.9141463262401803</c:v>
                </c:pt>
                <c:pt idx="276">
                  <c:v>1.0393266064034641</c:v>
                </c:pt>
                <c:pt idx="277">
                  <c:v>1.1075374246919933</c:v>
                </c:pt>
                <c:pt idx="278">
                  <c:v>1.0884279755249531</c:v>
                </c:pt>
                <c:pt idx="279">
                  <c:v>1.0116183616767587</c:v>
                </c:pt>
                <c:pt idx="280">
                  <c:v>1.1297463725830275</c:v>
                </c:pt>
                <c:pt idx="281">
                  <c:v>1.1807655930619219</c:v>
                </c:pt>
                <c:pt idx="282">
                  <c:v>1.6873803912319512</c:v>
                </c:pt>
                <c:pt idx="283">
                  <c:v>1.1490179367833286</c:v>
                </c:pt>
                <c:pt idx="284">
                  <c:v>1.1418464034917328</c:v>
                </c:pt>
                <c:pt idx="285">
                  <c:v>1.0557668400715783</c:v>
                </c:pt>
                <c:pt idx="286">
                  <c:v>1.0013324171014708</c:v>
                </c:pt>
                <c:pt idx="287">
                  <c:v>1.3264272948125257</c:v>
                </c:pt>
                <c:pt idx="288">
                  <c:v>1.2434130162733148</c:v>
                </c:pt>
                <c:pt idx="289">
                  <c:v>1.0071457213321269</c:v>
                </c:pt>
                <c:pt idx="290">
                  <c:v>1.2247944368090358</c:v>
                </c:pt>
                <c:pt idx="291">
                  <c:v>1.0031984725391327</c:v>
                </c:pt>
                <c:pt idx="292">
                  <c:v>1.0091525411002311</c:v>
                </c:pt>
                <c:pt idx="293">
                  <c:v>1.4733383928055621</c:v>
                </c:pt>
                <c:pt idx="294">
                  <c:v>1.1799132054695134</c:v>
                </c:pt>
                <c:pt idx="295">
                  <c:v>1.0070461340207488</c:v>
                </c:pt>
                <c:pt idx="296">
                  <c:v>1.0134303435255445</c:v>
                </c:pt>
                <c:pt idx="297">
                  <c:v>2.0243460682958587</c:v>
                </c:pt>
                <c:pt idx="298">
                  <c:v>1.2319106282738796</c:v>
                </c:pt>
                <c:pt idx="299">
                  <c:v>0.96967672114907477</c:v>
                </c:pt>
                <c:pt idx="300">
                  <c:v>1.1664630315164757</c:v>
                </c:pt>
                <c:pt idx="301">
                  <c:v>1.5147307403095138</c:v>
                </c:pt>
                <c:pt idx="302">
                  <c:v>1.860640605695997</c:v>
                </c:pt>
                <c:pt idx="303">
                  <c:v>1.2037906692879363</c:v>
                </c:pt>
                <c:pt idx="304">
                  <c:v>1.3755328536350868</c:v>
                </c:pt>
                <c:pt idx="305">
                  <c:v>1.4992172248995275</c:v>
                </c:pt>
                <c:pt idx="306">
                  <c:v>1.2904020866951083</c:v>
                </c:pt>
                <c:pt idx="307">
                  <c:v>0.94859979546450768</c:v>
                </c:pt>
                <c:pt idx="308">
                  <c:v>1.2962979343660102</c:v>
                </c:pt>
                <c:pt idx="309">
                  <c:v>1.1573404712185988</c:v>
                </c:pt>
                <c:pt idx="310">
                  <c:v>1.1557754060737424</c:v>
                </c:pt>
                <c:pt idx="311">
                  <c:v>0.88102162694331054</c:v>
                </c:pt>
                <c:pt idx="312">
                  <c:v>1.1173649242896164</c:v>
                </c:pt>
                <c:pt idx="313">
                  <c:v>1.5591334613631571</c:v>
                </c:pt>
                <c:pt idx="314">
                  <c:v>1.3526218240766039</c:v>
                </c:pt>
                <c:pt idx="315">
                  <c:v>1.2680347320435406</c:v>
                </c:pt>
                <c:pt idx="316">
                  <c:v>1.3300581795698916</c:v>
                </c:pt>
                <c:pt idx="317">
                  <c:v>1.5618641805628497</c:v>
                </c:pt>
                <c:pt idx="318">
                  <c:v>1.2007467269036685</c:v>
                </c:pt>
                <c:pt idx="319">
                  <c:v>0.96138734092519706</c:v>
                </c:pt>
                <c:pt idx="320">
                  <c:v>1.2859331403047471</c:v>
                </c:pt>
                <c:pt idx="321">
                  <c:v>1.5712430401848214</c:v>
                </c:pt>
                <c:pt idx="322">
                  <c:v>0.88201870802686289</c:v>
                </c:pt>
                <c:pt idx="323">
                  <c:v>1.3043202452318645</c:v>
                </c:pt>
                <c:pt idx="324">
                  <c:v>0.93499825304004469</c:v>
                </c:pt>
                <c:pt idx="325">
                  <c:v>1.0773927076867631</c:v>
                </c:pt>
                <c:pt idx="326">
                  <c:v>0.98193926505652496</c:v>
                </c:pt>
                <c:pt idx="327">
                  <c:v>1.0257076703190624</c:v>
                </c:pt>
                <c:pt idx="328">
                  <c:v>1.519092895652953</c:v>
                </c:pt>
                <c:pt idx="329">
                  <c:v>1.3251014498658036</c:v>
                </c:pt>
                <c:pt idx="330">
                  <c:v>0.91513816518094693</c:v>
                </c:pt>
                <c:pt idx="331">
                  <c:v>1.1731951560815777</c:v>
                </c:pt>
                <c:pt idx="332">
                  <c:v>1.396917020258035</c:v>
                </c:pt>
                <c:pt idx="333">
                  <c:v>1.0461473348625252</c:v>
                </c:pt>
                <c:pt idx="334">
                  <c:v>1.3005390248624877</c:v>
                </c:pt>
                <c:pt idx="335">
                  <c:v>0.97001072456815562</c:v>
                </c:pt>
                <c:pt idx="336">
                  <c:v>0.86699570259867875</c:v>
                </c:pt>
                <c:pt idx="337">
                  <c:v>0.95342286293554612</c:v>
                </c:pt>
                <c:pt idx="338">
                  <c:v>0.77623423894629995</c:v>
                </c:pt>
                <c:pt idx="339">
                  <c:v>0.81931947769102409</c:v>
                </c:pt>
                <c:pt idx="340">
                  <c:v>1.1563195775495665</c:v>
                </c:pt>
                <c:pt idx="341">
                  <c:v>1.2024029813715964</c:v>
                </c:pt>
                <c:pt idx="342">
                  <c:v>1.2578211477916135</c:v>
                </c:pt>
                <c:pt idx="343">
                  <c:v>1.2591954094513227</c:v>
                </c:pt>
                <c:pt idx="344">
                  <c:v>1.3018394131107822</c:v>
                </c:pt>
                <c:pt idx="345">
                  <c:v>1.1437825724411093</c:v>
                </c:pt>
                <c:pt idx="346">
                  <c:v>1.3225084200849417</c:v>
                </c:pt>
                <c:pt idx="347">
                  <c:v>1.2242614913955181</c:v>
                </c:pt>
                <c:pt idx="348">
                  <c:v>1.3970624801321219</c:v>
                </c:pt>
                <c:pt idx="349">
                  <c:v>1.127773191500584</c:v>
                </c:pt>
                <c:pt idx="350">
                  <c:v>0.89198945903014837</c:v>
                </c:pt>
                <c:pt idx="351">
                  <c:v>1.3422564128791286</c:v>
                </c:pt>
                <c:pt idx="352">
                  <c:v>0.90400605763605801</c:v>
                </c:pt>
                <c:pt idx="353">
                  <c:v>1.1060238871126928</c:v>
                </c:pt>
                <c:pt idx="354">
                  <c:v>1.0451975996945932</c:v>
                </c:pt>
                <c:pt idx="355">
                  <c:v>0.93250945775535943</c:v>
                </c:pt>
                <c:pt idx="356">
                  <c:v>1.1650793316449428</c:v>
                </c:pt>
                <c:pt idx="357">
                  <c:v>0.87099629411781554</c:v>
                </c:pt>
                <c:pt idx="358">
                  <c:v>0.97748452987160805</c:v>
                </c:pt>
                <c:pt idx="359">
                  <c:v>1.0256859610170794</c:v>
                </c:pt>
                <c:pt idx="360">
                  <c:v>1.095582622374399</c:v>
                </c:pt>
                <c:pt idx="361">
                  <c:v>1.1291441470985493</c:v>
                </c:pt>
                <c:pt idx="362">
                  <c:v>1.4853578223201986</c:v>
                </c:pt>
                <c:pt idx="363">
                  <c:v>1.1217894393802519</c:v>
                </c:pt>
                <c:pt idx="364">
                  <c:v>1.1481957568218266</c:v>
                </c:pt>
                <c:pt idx="365">
                  <c:v>0.94522056599727255</c:v>
                </c:pt>
                <c:pt idx="366">
                  <c:v>1.0902457838987294</c:v>
                </c:pt>
                <c:pt idx="367">
                  <c:v>0.9237699734698136</c:v>
                </c:pt>
                <c:pt idx="368">
                  <c:v>1.2042123319116991</c:v>
                </c:pt>
                <c:pt idx="369">
                  <c:v>1.3028887092868087</c:v>
                </c:pt>
                <c:pt idx="370">
                  <c:v>1.3793221460911784</c:v>
                </c:pt>
                <c:pt idx="371">
                  <c:v>1.1383505403490999</c:v>
                </c:pt>
                <c:pt idx="372">
                  <c:v>1.0623558430545634</c:v>
                </c:pt>
                <c:pt idx="373">
                  <c:v>1.0049068573710362</c:v>
                </c:pt>
                <c:pt idx="374">
                  <c:v>0.98943062268093307</c:v>
                </c:pt>
                <c:pt idx="375">
                  <c:v>0.9428825252411478</c:v>
                </c:pt>
                <c:pt idx="376">
                  <c:v>1.20368830570313</c:v>
                </c:pt>
                <c:pt idx="377">
                  <c:v>1.014261788150129</c:v>
                </c:pt>
                <c:pt idx="378">
                  <c:v>1.0362714656715426</c:v>
                </c:pt>
                <c:pt idx="379">
                  <c:v>1.0360456327405998</c:v>
                </c:pt>
                <c:pt idx="380">
                  <c:v>0.95201442540331926</c:v>
                </c:pt>
                <c:pt idx="381">
                  <c:v>0.98927182945932801</c:v>
                </c:pt>
                <c:pt idx="382">
                  <c:v>1.2075121299747673</c:v>
                </c:pt>
                <c:pt idx="383">
                  <c:v>1.302204318789943</c:v>
                </c:pt>
                <c:pt idx="384">
                  <c:v>1.0992182315420425</c:v>
                </c:pt>
                <c:pt idx="385">
                  <c:v>1.2529576452650175</c:v>
                </c:pt>
                <c:pt idx="386">
                  <c:v>0.99495542245791524</c:v>
                </c:pt>
                <c:pt idx="387">
                  <c:v>1.1970930673396059</c:v>
                </c:pt>
                <c:pt idx="388">
                  <c:v>1.1119555770034963</c:v>
                </c:pt>
                <c:pt idx="389">
                  <c:v>1.0193873022024915</c:v>
                </c:pt>
                <c:pt idx="390">
                  <c:v>0.98828328048653702</c:v>
                </c:pt>
                <c:pt idx="391">
                  <c:v>1.0561722454600795</c:v>
                </c:pt>
                <c:pt idx="392">
                  <c:v>0.9364582503911808</c:v>
                </c:pt>
                <c:pt idx="393">
                  <c:v>1.0391084193070177</c:v>
                </c:pt>
                <c:pt idx="394">
                  <c:v>1.1543864539499062</c:v>
                </c:pt>
                <c:pt idx="395">
                  <c:v>1.0842784897618263</c:v>
                </c:pt>
                <c:pt idx="396">
                  <c:v>1.043164643639378</c:v>
                </c:pt>
                <c:pt idx="397">
                  <c:v>1.1508608267894342</c:v>
                </c:pt>
                <c:pt idx="398">
                  <c:v>0.96298752613808247</c:v>
                </c:pt>
                <c:pt idx="399">
                  <c:v>1.0644184739493618</c:v>
                </c:pt>
                <c:pt idx="400">
                  <c:v>1.1225832252875414</c:v>
                </c:pt>
                <c:pt idx="401">
                  <c:v>1.0329443631431379</c:v>
                </c:pt>
                <c:pt idx="402">
                  <c:v>0.92885073838216192</c:v>
                </c:pt>
                <c:pt idx="403">
                  <c:v>1.2556143406030469</c:v>
                </c:pt>
                <c:pt idx="404">
                  <c:v>1.2468066274879608</c:v>
                </c:pt>
                <c:pt idx="405">
                  <c:v>1.3542998274858646</c:v>
                </c:pt>
                <c:pt idx="406">
                  <c:v>1.5736276758701102</c:v>
                </c:pt>
                <c:pt idx="407">
                  <c:v>1.0352258293062573</c:v>
                </c:pt>
                <c:pt idx="408">
                  <c:v>1.674335618371211</c:v>
                </c:pt>
                <c:pt idx="409">
                  <c:v>0.89855578365159805</c:v>
                </c:pt>
                <c:pt idx="410">
                  <c:v>1.0835566448526945</c:v>
                </c:pt>
                <c:pt idx="411">
                  <c:v>1.0111756425964946</c:v>
                </c:pt>
                <c:pt idx="412">
                  <c:v>0.89143051469628398</c:v>
                </c:pt>
                <c:pt idx="413">
                  <c:v>0.96956489613791896</c:v>
                </c:pt>
                <c:pt idx="414">
                  <c:v>1.1368811675948369</c:v>
                </c:pt>
                <c:pt idx="415">
                  <c:v>1.2702122721546425</c:v>
                </c:pt>
                <c:pt idx="416">
                  <c:v>1.0814158015640445</c:v>
                </c:pt>
                <c:pt idx="417">
                  <c:v>0.94365165614579871</c:v>
                </c:pt>
                <c:pt idx="418">
                  <c:v>1.089383808365749</c:v>
                </c:pt>
                <c:pt idx="419">
                  <c:v>0.89468668066156387</c:v>
                </c:pt>
                <c:pt idx="420">
                  <c:v>1.069088350719545</c:v>
                </c:pt>
                <c:pt idx="421">
                  <c:v>1.2853403598484849</c:v>
                </c:pt>
                <c:pt idx="422">
                  <c:v>1.1015280752196366</c:v>
                </c:pt>
                <c:pt idx="423">
                  <c:v>1.1150231121006382</c:v>
                </c:pt>
                <c:pt idx="424">
                  <c:v>1.0693109162405425</c:v>
                </c:pt>
                <c:pt idx="425">
                  <c:v>1.1282819412717418</c:v>
                </c:pt>
                <c:pt idx="426">
                  <c:v>1.1069707890225258</c:v>
                </c:pt>
                <c:pt idx="427">
                  <c:v>0.99903804872390956</c:v>
                </c:pt>
                <c:pt idx="428">
                  <c:v>1.0670644702855552</c:v>
                </c:pt>
                <c:pt idx="429">
                  <c:v>0.95877298033805436</c:v>
                </c:pt>
                <c:pt idx="430">
                  <c:v>1.0528097506374734</c:v>
                </c:pt>
                <c:pt idx="431">
                  <c:v>1.1597140533289241</c:v>
                </c:pt>
                <c:pt idx="432">
                  <c:v>0.92561664443093383</c:v>
                </c:pt>
                <c:pt idx="433">
                  <c:v>1.5295476328038622</c:v>
                </c:pt>
                <c:pt idx="434">
                  <c:v>0.9981630838669443</c:v>
                </c:pt>
                <c:pt idx="435">
                  <c:v>1.5117231179109218</c:v>
                </c:pt>
                <c:pt idx="436">
                  <c:v>1.2484218473734761</c:v>
                </c:pt>
                <c:pt idx="437">
                  <c:v>1.3094971756730984</c:v>
                </c:pt>
                <c:pt idx="438">
                  <c:v>1.363599115160897</c:v>
                </c:pt>
                <c:pt idx="439">
                  <c:v>0.97081052651725919</c:v>
                </c:pt>
                <c:pt idx="440">
                  <c:v>1.5833514006048797</c:v>
                </c:pt>
                <c:pt idx="441">
                  <c:v>1.3533636839477787</c:v>
                </c:pt>
                <c:pt idx="442">
                  <c:v>1.0611312300755302</c:v>
                </c:pt>
                <c:pt idx="443">
                  <c:v>0.97607446894865457</c:v>
                </c:pt>
                <c:pt idx="444">
                  <c:v>0.93379165418665455</c:v>
                </c:pt>
                <c:pt idx="445">
                  <c:v>1.1026042098022732</c:v>
                </c:pt>
                <c:pt idx="446">
                  <c:v>1.2108047302018652</c:v>
                </c:pt>
                <c:pt idx="447">
                  <c:v>1.1396580078107732</c:v>
                </c:pt>
                <c:pt idx="448">
                  <c:v>1.1271691309359517</c:v>
                </c:pt>
                <c:pt idx="449">
                  <c:v>0.98743663012057536</c:v>
                </c:pt>
                <c:pt idx="450">
                  <c:v>1.3495725612037417</c:v>
                </c:pt>
                <c:pt idx="451">
                  <c:v>1.076749849615048</c:v>
                </c:pt>
                <c:pt idx="452">
                  <c:v>1.2834859940379924</c:v>
                </c:pt>
                <c:pt idx="453">
                  <c:v>1.0732735105033733</c:v>
                </c:pt>
                <c:pt idx="454">
                  <c:v>1.0080947102440045</c:v>
                </c:pt>
                <c:pt idx="455">
                  <c:v>1.0617967604402425</c:v>
                </c:pt>
                <c:pt idx="456">
                  <c:v>1.9675546535823463</c:v>
                </c:pt>
                <c:pt idx="457">
                  <c:v>0.97640386267906454</c:v>
                </c:pt>
                <c:pt idx="458">
                  <c:v>1.286414888314364</c:v>
                </c:pt>
                <c:pt idx="459">
                  <c:v>1.2391114529336695</c:v>
                </c:pt>
                <c:pt idx="460">
                  <c:v>1.2296052354429834</c:v>
                </c:pt>
                <c:pt idx="461">
                  <c:v>1.287751893730807</c:v>
                </c:pt>
                <c:pt idx="462">
                  <c:v>1.1558515661802569</c:v>
                </c:pt>
                <c:pt idx="463">
                  <c:v>1.1835063936392798</c:v>
                </c:pt>
                <c:pt idx="464">
                  <c:v>1.6127343250480806</c:v>
                </c:pt>
                <c:pt idx="465">
                  <c:v>1.2521131104595551</c:v>
                </c:pt>
                <c:pt idx="466">
                  <c:v>2.1746292157913274</c:v>
                </c:pt>
                <c:pt idx="467">
                  <c:v>1.532764832618843</c:v>
                </c:pt>
                <c:pt idx="468">
                  <c:v>1.0966812889035442</c:v>
                </c:pt>
                <c:pt idx="469">
                  <c:v>1.3881446197839</c:v>
                </c:pt>
                <c:pt idx="470">
                  <c:v>1.37664283217681</c:v>
                </c:pt>
                <c:pt idx="471">
                  <c:v>0.92858274289310117</c:v>
                </c:pt>
                <c:pt idx="472">
                  <c:v>1.2572334495190807</c:v>
                </c:pt>
                <c:pt idx="473">
                  <c:v>1.3948988182698536</c:v>
                </c:pt>
                <c:pt idx="474">
                  <c:v>1.166644924150021</c:v>
                </c:pt>
                <c:pt idx="475">
                  <c:v>1.207423596687893</c:v>
                </c:pt>
                <c:pt idx="476">
                  <c:v>1.3264888953660579</c:v>
                </c:pt>
                <c:pt idx="477">
                  <c:v>1.1425497095091588</c:v>
                </c:pt>
                <c:pt idx="478">
                  <c:v>1.0375230377216427</c:v>
                </c:pt>
                <c:pt idx="479">
                  <c:v>1.074345175016082</c:v>
                </c:pt>
                <c:pt idx="480">
                  <c:v>1.37019431749781</c:v>
                </c:pt>
                <c:pt idx="481">
                  <c:v>1.4173155878991084</c:v>
                </c:pt>
                <c:pt idx="482">
                  <c:v>1.1215248400980329</c:v>
                </c:pt>
                <c:pt idx="483">
                  <c:v>1.1199890032511495</c:v>
                </c:pt>
                <c:pt idx="484">
                  <c:v>1.2180881806216646</c:v>
                </c:pt>
                <c:pt idx="485">
                  <c:v>1.1234026011344829</c:v>
                </c:pt>
                <c:pt idx="486">
                  <c:v>1.0130374703305038</c:v>
                </c:pt>
                <c:pt idx="487">
                  <c:v>1.0075759183177457</c:v>
                </c:pt>
                <c:pt idx="488">
                  <c:v>0.95266578233575017</c:v>
                </c:pt>
                <c:pt idx="489">
                  <c:v>1.2013486106190405</c:v>
                </c:pt>
                <c:pt idx="490">
                  <c:v>0.95546097584000544</c:v>
                </c:pt>
                <c:pt idx="491">
                  <c:v>1.4466380400333609</c:v>
                </c:pt>
                <c:pt idx="492">
                  <c:v>1.0408004041269654</c:v>
                </c:pt>
                <c:pt idx="493">
                  <c:v>1.0260860718983993</c:v>
                </c:pt>
                <c:pt idx="494">
                  <c:v>0.99254565248776516</c:v>
                </c:pt>
                <c:pt idx="495">
                  <c:v>1.1341020000692679</c:v>
                </c:pt>
                <c:pt idx="496">
                  <c:v>1.0938897675103121</c:v>
                </c:pt>
                <c:pt idx="497">
                  <c:v>1.0933059070775093</c:v>
                </c:pt>
                <c:pt idx="498">
                  <c:v>1.1578177624322312</c:v>
                </c:pt>
                <c:pt idx="499">
                  <c:v>1.3497966250319908</c:v>
                </c:pt>
                <c:pt idx="500">
                  <c:v>1.0454180360099377</c:v>
                </c:pt>
                <c:pt idx="501">
                  <c:v>0.9382610567123062</c:v>
                </c:pt>
                <c:pt idx="502">
                  <c:v>1.2755520367648006</c:v>
                </c:pt>
                <c:pt idx="503">
                  <c:v>1.2336830510037409</c:v>
                </c:pt>
                <c:pt idx="504">
                  <c:v>1.2849188240206777</c:v>
                </c:pt>
                <c:pt idx="505">
                  <c:v>1.3849603779048205</c:v>
                </c:pt>
                <c:pt idx="506">
                  <c:v>1.7751674359059613</c:v>
                </c:pt>
                <c:pt idx="507">
                  <c:v>1.5960276985797797</c:v>
                </c:pt>
                <c:pt idx="508">
                  <c:v>1.1178413216820171</c:v>
                </c:pt>
                <c:pt idx="509">
                  <c:v>0.95205544270265052</c:v>
                </c:pt>
                <c:pt idx="510">
                  <c:v>1.0440266480659826</c:v>
                </c:pt>
                <c:pt idx="511">
                  <c:v>1.085375040425782</c:v>
                </c:pt>
                <c:pt idx="512">
                  <c:v>0.96194785231283497</c:v>
                </c:pt>
                <c:pt idx="513">
                  <c:v>1.1015485577203576</c:v>
                </c:pt>
                <c:pt idx="514">
                  <c:v>0.95094479728663595</c:v>
                </c:pt>
                <c:pt idx="515">
                  <c:v>0.99331687483983522</c:v>
                </c:pt>
                <c:pt idx="516">
                  <c:v>0.92868245494192758</c:v>
                </c:pt>
                <c:pt idx="517">
                  <c:v>1.1617050926155064</c:v>
                </c:pt>
                <c:pt idx="518">
                  <c:v>0.97925717397096812</c:v>
                </c:pt>
                <c:pt idx="519">
                  <c:v>1.3284864239370195</c:v>
                </c:pt>
                <c:pt idx="520">
                  <c:v>1.4757598107814611</c:v>
                </c:pt>
                <c:pt idx="521">
                  <c:v>1.0721105200459602</c:v>
                </c:pt>
                <c:pt idx="522">
                  <c:v>1.2498640938529839</c:v>
                </c:pt>
                <c:pt idx="523">
                  <c:v>1.3052964632036397</c:v>
                </c:pt>
                <c:pt idx="524">
                  <c:v>1.1578206707519676</c:v>
                </c:pt>
                <c:pt idx="525">
                  <c:v>1.6264507061210416</c:v>
                </c:pt>
                <c:pt idx="526">
                  <c:v>1.1052172298098</c:v>
                </c:pt>
                <c:pt idx="527">
                  <c:v>1.2952745304588456</c:v>
                </c:pt>
                <c:pt idx="528">
                  <c:v>0.96228111253645188</c:v>
                </c:pt>
                <c:pt idx="529">
                  <c:v>1.0679747363713314</c:v>
                </c:pt>
                <c:pt idx="530">
                  <c:v>1.079401641023733</c:v>
                </c:pt>
                <c:pt idx="531">
                  <c:v>1.0591377503490853</c:v>
                </c:pt>
                <c:pt idx="532">
                  <c:v>1.1127131083885826</c:v>
                </c:pt>
                <c:pt idx="533">
                  <c:v>1.2389835615118827</c:v>
                </c:pt>
                <c:pt idx="534">
                  <c:v>1.1007325799293157</c:v>
                </c:pt>
                <c:pt idx="535">
                  <c:v>1.0892322580425846</c:v>
                </c:pt>
                <c:pt idx="536">
                  <c:v>1.2089505783752641</c:v>
                </c:pt>
                <c:pt idx="537">
                  <c:v>1.3881510929069303</c:v>
                </c:pt>
                <c:pt idx="538">
                  <c:v>0.98368500671880488</c:v>
                </c:pt>
                <c:pt idx="539">
                  <c:v>0.97530628988540813</c:v>
                </c:pt>
                <c:pt idx="540">
                  <c:v>0.91512073195916455</c:v>
                </c:pt>
                <c:pt idx="541">
                  <c:v>1.2911248695993818</c:v>
                </c:pt>
                <c:pt idx="542">
                  <c:v>1.2766178120091916</c:v>
                </c:pt>
                <c:pt idx="543">
                  <c:v>1.1680565101162053</c:v>
                </c:pt>
                <c:pt idx="544">
                  <c:v>0.97534087897659461</c:v>
                </c:pt>
                <c:pt idx="545">
                  <c:v>1.0608747383148109</c:v>
                </c:pt>
                <c:pt idx="546">
                  <c:v>1.0798834640082002</c:v>
                </c:pt>
                <c:pt idx="547">
                  <c:v>1.1476911524529765</c:v>
                </c:pt>
                <c:pt idx="548">
                  <c:v>0.98262761927284326</c:v>
                </c:pt>
                <c:pt idx="549">
                  <c:v>1.0668921492137273</c:v>
                </c:pt>
                <c:pt idx="550">
                  <c:v>1.2454940249259971</c:v>
                </c:pt>
                <c:pt idx="551">
                  <c:v>1.0662806223827193</c:v>
                </c:pt>
                <c:pt idx="552">
                  <c:v>1.3308838370199765</c:v>
                </c:pt>
                <c:pt idx="553">
                  <c:v>0.98293485631474375</c:v>
                </c:pt>
                <c:pt idx="554">
                  <c:v>0.85792152759928109</c:v>
                </c:pt>
                <c:pt idx="555">
                  <c:v>0.92562095613905016</c:v>
                </c:pt>
                <c:pt idx="556">
                  <c:v>1.0697365081936356</c:v>
                </c:pt>
                <c:pt idx="557">
                  <c:v>1.3881027005524882</c:v>
                </c:pt>
                <c:pt idx="558">
                  <c:v>1.1886241013759313</c:v>
                </c:pt>
                <c:pt idx="559">
                  <c:v>1.0498925571580118</c:v>
                </c:pt>
                <c:pt idx="560">
                  <c:v>1.1978152122770895</c:v>
                </c:pt>
                <c:pt idx="561">
                  <c:v>1.1350041693102797</c:v>
                </c:pt>
                <c:pt idx="562">
                  <c:v>1.0508103179525459</c:v>
                </c:pt>
                <c:pt idx="563">
                  <c:v>1.0693158872358872</c:v>
                </c:pt>
                <c:pt idx="564">
                  <c:v>1.0277646311488018</c:v>
                </c:pt>
                <c:pt idx="565">
                  <c:v>1.1268760337661492</c:v>
                </c:pt>
                <c:pt idx="566">
                  <c:v>1.2931813177463205</c:v>
                </c:pt>
                <c:pt idx="567">
                  <c:v>1.0807381852481541</c:v>
                </c:pt>
                <c:pt idx="568">
                  <c:v>1.4619008308396466</c:v>
                </c:pt>
                <c:pt idx="569">
                  <c:v>1.0635202781042141</c:v>
                </c:pt>
                <c:pt idx="570">
                  <c:v>1.1046030312211845</c:v>
                </c:pt>
                <c:pt idx="571">
                  <c:v>1.4683768631696998</c:v>
                </c:pt>
                <c:pt idx="572">
                  <c:v>1.0832901612615156</c:v>
                </c:pt>
                <c:pt idx="573">
                  <c:v>0.93981730077681336</c:v>
                </c:pt>
                <c:pt idx="574">
                  <c:v>1.2619552070987934</c:v>
                </c:pt>
                <c:pt idx="575">
                  <c:v>1.3915168944124714</c:v>
                </c:pt>
                <c:pt idx="576">
                  <c:v>1.041292150781167</c:v>
                </c:pt>
                <c:pt idx="577">
                  <c:v>1.3538461185673956</c:v>
                </c:pt>
                <c:pt idx="578">
                  <c:v>1.3703116089331444</c:v>
                </c:pt>
                <c:pt idx="579">
                  <c:v>1.2782057880846578</c:v>
                </c:pt>
                <c:pt idx="580">
                  <c:v>0.97198983091724922</c:v>
                </c:pt>
                <c:pt idx="581">
                  <c:v>1.1371960712837694</c:v>
                </c:pt>
                <c:pt idx="582">
                  <c:v>1.033744240219896</c:v>
                </c:pt>
                <c:pt idx="583">
                  <c:v>1.0461086516946896</c:v>
                </c:pt>
                <c:pt idx="584">
                  <c:v>1.0520999808977176</c:v>
                </c:pt>
                <c:pt idx="585">
                  <c:v>1.0143739750949798</c:v>
                </c:pt>
                <c:pt idx="586">
                  <c:v>1.2950966401150648</c:v>
                </c:pt>
                <c:pt idx="587">
                  <c:v>1.0086071899333595</c:v>
                </c:pt>
                <c:pt idx="588">
                  <c:v>1.5726195763930977</c:v>
                </c:pt>
                <c:pt idx="589">
                  <c:v>1.0625383756554454</c:v>
                </c:pt>
                <c:pt idx="590">
                  <c:v>1.0155659473266228</c:v>
                </c:pt>
                <c:pt idx="591">
                  <c:v>0.95292348392636739</c:v>
                </c:pt>
                <c:pt idx="592">
                  <c:v>1.2316772583034528</c:v>
                </c:pt>
                <c:pt idx="593">
                  <c:v>1.4561210588421347</c:v>
                </c:pt>
                <c:pt idx="594">
                  <c:v>1.1523031087804234</c:v>
                </c:pt>
                <c:pt idx="595">
                  <c:v>1.2424510912924682</c:v>
                </c:pt>
                <c:pt idx="596">
                  <c:v>1.1167679904431838</c:v>
                </c:pt>
                <c:pt idx="597">
                  <c:v>1.4294707714129837</c:v>
                </c:pt>
                <c:pt idx="598">
                  <c:v>1.1150041805200108</c:v>
                </c:pt>
                <c:pt idx="599">
                  <c:v>1.5924889593724996</c:v>
                </c:pt>
                <c:pt idx="600">
                  <c:v>1.2058848779849545</c:v>
                </c:pt>
                <c:pt idx="601">
                  <c:v>0.90518442089772788</c:v>
                </c:pt>
                <c:pt idx="602">
                  <c:v>0.95354690903739303</c:v>
                </c:pt>
                <c:pt idx="603">
                  <c:v>0.89161599413844483</c:v>
                </c:pt>
                <c:pt idx="604">
                  <c:v>0.89544242411118125</c:v>
                </c:pt>
                <c:pt idx="605">
                  <c:v>0.93590969263636159</c:v>
                </c:pt>
                <c:pt idx="606">
                  <c:v>1.3018247079192253</c:v>
                </c:pt>
                <c:pt idx="607">
                  <c:v>1.1484665519257111</c:v>
                </c:pt>
                <c:pt idx="608">
                  <c:v>1.2393772740317075</c:v>
                </c:pt>
                <c:pt idx="609">
                  <c:v>1.1971090869458547</c:v>
                </c:pt>
                <c:pt idx="610">
                  <c:v>0.93243605624128867</c:v>
                </c:pt>
                <c:pt idx="611">
                  <c:v>1.0143973050750497</c:v>
                </c:pt>
                <c:pt idx="612">
                  <c:v>1.0857169600615799</c:v>
                </c:pt>
                <c:pt idx="613">
                  <c:v>1.1091432710605151</c:v>
                </c:pt>
                <c:pt idx="614">
                  <c:v>1.2507874961828809</c:v>
                </c:pt>
                <c:pt idx="615">
                  <c:v>1.1678201447983494</c:v>
                </c:pt>
                <c:pt idx="616">
                  <c:v>1.0315875666518102</c:v>
                </c:pt>
                <c:pt idx="617">
                  <c:v>0.95267227375461483</c:v>
                </c:pt>
                <c:pt idx="618">
                  <c:v>1.266252878634001</c:v>
                </c:pt>
                <c:pt idx="619">
                  <c:v>1.2364495319674715</c:v>
                </c:pt>
                <c:pt idx="620">
                  <c:v>1.1035047724368454</c:v>
                </c:pt>
                <c:pt idx="621">
                  <c:v>2.3085428848714771</c:v>
                </c:pt>
                <c:pt idx="622">
                  <c:v>0.95398003841896661</c:v>
                </c:pt>
                <c:pt idx="623">
                  <c:v>1.236133507757718</c:v>
                </c:pt>
                <c:pt idx="624">
                  <c:v>1.2016300052329631</c:v>
                </c:pt>
                <c:pt idx="625">
                  <c:v>1.2037979480114045</c:v>
                </c:pt>
                <c:pt idx="626">
                  <c:v>1.463913184501439</c:v>
                </c:pt>
                <c:pt idx="627">
                  <c:v>1.0410763488845067</c:v>
                </c:pt>
                <c:pt idx="628">
                  <c:v>0.97199460841215546</c:v>
                </c:pt>
                <c:pt idx="629">
                  <c:v>1.0326478870105031</c:v>
                </c:pt>
                <c:pt idx="630">
                  <c:v>1.3296491819056948</c:v>
                </c:pt>
                <c:pt idx="631">
                  <c:v>1.0573990069039343</c:v>
                </c:pt>
                <c:pt idx="632">
                  <c:v>1.3526560770407321</c:v>
                </c:pt>
                <c:pt idx="633">
                  <c:v>1.6510968867513054</c:v>
                </c:pt>
                <c:pt idx="634">
                  <c:v>1.3828772845319794</c:v>
                </c:pt>
                <c:pt idx="635">
                  <c:v>1.2180961690269847</c:v>
                </c:pt>
                <c:pt idx="636">
                  <c:v>0.9788362490793322</c:v>
                </c:pt>
                <c:pt idx="637">
                  <c:v>1.5236766194299141</c:v>
                </c:pt>
                <c:pt idx="638">
                  <c:v>1.1445426945941211</c:v>
                </c:pt>
                <c:pt idx="639">
                  <c:v>1.2802453927734065</c:v>
                </c:pt>
                <c:pt idx="640">
                  <c:v>1.3397792066086149</c:v>
                </c:pt>
                <c:pt idx="641">
                  <c:v>0.8807425785308961</c:v>
                </c:pt>
                <c:pt idx="642">
                  <c:v>0.96766904429571066</c:v>
                </c:pt>
                <c:pt idx="643">
                  <c:v>0.94432134110432886</c:v>
                </c:pt>
                <c:pt idx="644">
                  <c:v>1.2085944041170225</c:v>
                </c:pt>
                <c:pt idx="645">
                  <c:v>1.3094510414638996</c:v>
                </c:pt>
                <c:pt idx="646">
                  <c:v>1.1136468778695592</c:v>
                </c:pt>
                <c:pt idx="647">
                  <c:v>1.1952428567697331</c:v>
                </c:pt>
                <c:pt idx="648">
                  <c:v>1.714864088705891</c:v>
                </c:pt>
                <c:pt idx="649">
                  <c:v>1.1601202304010636</c:v>
                </c:pt>
                <c:pt idx="650">
                  <c:v>1.5731621118977741</c:v>
                </c:pt>
                <c:pt idx="651">
                  <c:v>1.9099232458108246</c:v>
                </c:pt>
                <c:pt idx="652">
                  <c:v>1.3260468583886205</c:v>
                </c:pt>
                <c:pt idx="653">
                  <c:v>1.0974282525349806</c:v>
                </c:pt>
                <c:pt idx="654">
                  <c:v>1.0863780738405868</c:v>
                </c:pt>
                <c:pt idx="655">
                  <c:v>1.1743768117657387</c:v>
                </c:pt>
                <c:pt idx="656">
                  <c:v>1.1885222406297578</c:v>
                </c:pt>
                <c:pt idx="657">
                  <c:v>1.1060288239129552</c:v>
                </c:pt>
                <c:pt idx="658">
                  <c:v>1.2392885924006514</c:v>
                </c:pt>
                <c:pt idx="659">
                  <c:v>1.0190341400568153</c:v>
                </c:pt>
                <c:pt idx="660">
                  <c:v>1.2320406773275414</c:v>
                </c:pt>
                <c:pt idx="661">
                  <c:v>1.0432467312890843</c:v>
                </c:pt>
                <c:pt idx="662">
                  <c:v>1.5284310766898455</c:v>
                </c:pt>
                <c:pt idx="663">
                  <c:v>1.0006388306105167</c:v>
                </c:pt>
                <c:pt idx="664">
                  <c:v>1.024042163524028</c:v>
                </c:pt>
                <c:pt idx="665">
                  <c:v>0.83765165774673445</c:v>
                </c:pt>
                <c:pt idx="666">
                  <c:v>1.0833410370772754</c:v>
                </c:pt>
                <c:pt idx="667">
                  <c:v>1.0352119435853322</c:v>
                </c:pt>
                <c:pt idx="668">
                  <c:v>1.4743732954274955</c:v>
                </c:pt>
                <c:pt idx="669">
                  <c:v>1.152549372981903</c:v>
                </c:pt>
                <c:pt idx="670">
                  <c:v>1.1365857385899831</c:v>
                </c:pt>
                <c:pt idx="671">
                  <c:v>1.6349324063871695</c:v>
                </c:pt>
                <c:pt idx="672">
                  <c:v>1.1957265132609851</c:v>
                </c:pt>
                <c:pt idx="673">
                  <c:v>1.1357416703561729</c:v>
                </c:pt>
                <c:pt idx="674">
                  <c:v>1.0077879784578614</c:v>
                </c:pt>
                <c:pt idx="675">
                  <c:v>1.4407442246174105</c:v>
                </c:pt>
                <c:pt idx="676">
                  <c:v>1.0867274091720247</c:v>
                </c:pt>
                <c:pt idx="677">
                  <c:v>1.1071683166090767</c:v>
                </c:pt>
                <c:pt idx="678">
                  <c:v>1.3178564049801682</c:v>
                </c:pt>
                <c:pt idx="679">
                  <c:v>1.5736016551557501</c:v>
                </c:pt>
                <c:pt idx="680">
                  <c:v>1.5330343556711061</c:v>
                </c:pt>
                <c:pt idx="681">
                  <c:v>1.3109184964776452</c:v>
                </c:pt>
                <c:pt idx="682">
                  <c:v>1.202683117479</c:v>
                </c:pt>
                <c:pt idx="683">
                  <c:v>1.0232009957782962</c:v>
                </c:pt>
                <c:pt idx="684">
                  <c:v>1.4747602482674742</c:v>
                </c:pt>
                <c:pt idx="685">
                  <c:v>1.3901536847638205</c:v>
                </c:pt>
                <c:pt idx="686">
                  <c:v>1.2255492266387531</c:v>
                </c:pt>
                <c:pt idx="687">
                  <c:v>1.2557011866480188</c:v>
                </c:pt>
                <c:pt idx="688">
                  <c:v>0.9261858552718788</c:v>
                </c:pt>
                <c:pt idx="689">
                  <c:v>0.98787914819623668</c:v>
                </c:pt>
                <c:pt idx="690">
                  <c:v>1.1500238836830123</c:v>
                </c:pt>
                <c:pt idx="691">
                  <c:v>1.1807432567971112</c:v>
                </c:pt>
                <c:pt idx="692">
                  <c:v>0.94832127477375427</c:v>
                </c:pt>
                <c:pt idx="693">
                  <c:v>1.5787987821119258</c:v>
                </c:pt>
                <c:pt idx="694">
                  <c:v>1.547295408689114</c:v>
                </c:pt>
                <c:pt idx="695">
                  <c:v>1.1865806143634456</c:v>
                </c:pt>
                <c:pt idx="696">
                  <c:v>1.0814449022041894</c:v>
                </c:pt>
                <c:pt idx="697">
                  <c:v>0.97095384764618842</c:v>
                </c:pt>
                <c:pt idx="698">
                  <c:v>1.2588996623438808</c:v>
                </c:pt>
                <c:pt idx="699">
                  <c:v>1.1260784832851516</c:v>
                </c:pt>
                <c:pt idx="700">
                  <c:v>0.89288259249582036</c:v>
                </c:pt>
                <c:pt idx="701">
                  <c:v>1.1808879989915761</c:v>
                </c:pt>
                <c:pt idx="702">
                  <c:v>1.2255847393447576</c:v>
                </c:pt>
                <c:pt idx="703">
                  <c:v>1.1072707654856586</c:v>
                </c:pt>
                <c:pt idx="704">
                  <c:v>0.96057531029855758</c:v>
                </c:pt>
                <c:pt idx="705">
                  <c:v>0.867493317155085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A8-455B-AC3F-F301D67138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9984104"/>
        <c:axId val="659976888"/>
      </c:scatterChart>
      <c:valAx>
        <c:axId val="659984104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AR-CL triplicate 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976888"/>
        <c:crosses val="autoZero"/>
        <c:crossBetween val="midCat"/>
      </c:valAx>
      <c:valAx>
        <c:axId val="659976888"/>
        <c:scaling>
          <c:orientation val="minMax"/>
          <c:max val="3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AR-CL triplicate</a:t>
                </a:r>
                <a:r>
                  <a:rPr lang="en-US" baseline="0"/>
                  <a:t> 1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984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b="1" i="0" baseline="0">
                <a:effectLst/>
              </a:rPr>
              <a:t>Corelation coefficiency =0.61 </a:t>
            </a:r>
            <a:endParaRPr lang="en-US" sz="10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triplicate!$D$1</c:f>
              <c:strCache>
                <c:ptCount val="1"/>
                <c:pt idx="0">
                  <c:v>FCp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0314486730825322"/>
                  <c:y val="-1.1836541265675123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triplicate!$B$2:$B$708</c:f>
              <c:numCache>
                <c:formatCode>0.00</c:formatCode>
                <c:ptCount val="707"/>
                <c:pt idx="0">
                  <c:v>1.4853137674126557</c:v>
                </c:pt>
                <c:pt idx="1">
                  <c:v>1.1375647434098501</c:v>
                </c:pt>
                <c:pt idx="2">
                  <c:v>1.0448099379878024</c:v>
                </c:pt>
                <c:pt idx="3">
                  <c:v>1.2427326047771849</c:v>
                </c:pt>
                <c:pt idx="4">
                  <c:v>1.0678836628303374</c:v>
                </c:pt>
                <c:pt idx="5">
                  <c:v>1.1178217207481196</c:v>
                </c:pt>
                <c:pt idx="6">
                  <c:v>1.5614528273206323</c:v>
                </c:pt>
                <c:pt idx="7">
                  <c:v>1.075298092961309</c:v>
                </c:pt>
                <c:pt idx="8">
                  <c:v>1.2135650687932136</c:v>
                </c:pt>
                <c:pt idx="9">
                  <c:v>1.313106763244132</c:v>
                </c:pt>
                <c:pt idx="10">
                  <c:v>1.2355988017464556</c:v>
                </c:pt>
                <c:pt idx="11">
                  <c:v>1.1751334883943474</c:v>
                </c:pt>
                <c:pt idx="12">
                  <c:v>1.1303842700310094</c:v>
                </c:pt>
                <c:pt idx="13">
                  <c:v>1.0159386273794757</c:v>
                </c:pt>
                <c:pt idx="14">
                  <c:v>1.1515427631957582</c:v>
                </c:pt>
                <c:pt idx="15">
                  <c:v>1.4802385394219573</c:v>
                </c:pt>
                <c:pt idx="16">
                  <c:v>0.94496786774409736</c:v>
                </c:pt>
                <c:pt idx="17">
                  <c:v>1.1214316098239792</c:v>
                </c:pt>
                <c:pt idx="18">
                  <c:v>1.0293052146363206</c:v>
                </c:pt>
                <c:pt idx="19">
                  <c:v>1.1621299044418305</c:v>
                </c:pt>
                <c:pt idx="20">
                  <c:v>1.1597943294341044</c:v>
                </c:pt>
                <c:pt idx="21">
                  <c:v>1.4205923047527074</c:v>
                </c:pt>
                <c:pt idx="22">
                  <c:v>1.0479145636169165</c:v>
                </c:pt>
                <c:pt idx="23">
                  <c:v>1.230951402932255</c:v>
                </c:pt>
                <c:pt idx="24">
                  <c:v>1.1868682365915695</c:v>
                </c:pt>
                <c:pt idx="25">
                  <c:v>1.0364371856313785</c:v>
                </c:pt>
                <c:pt idx="26">
                  <c:v>1.2545845073908062</c:v>
                </c:pt>
                <c:pt idx="27">
                  <c:v>0.98536642194157009</c:v>
                </c:pt>
                <c:pt idx="28">
                  <c:v>1.1561674876955848</c:v>
                </c:pt>
                <c:pt idx="29">
                  <c:v>1.0703357167117828</c:v>
                </c:pt>
                <c:pt idx="30">
                  <c:v>0.96048232635132724</c:v>
                </c:pt>
                <c:pt idx="31">
                  <c:v>1.0453430493962454</c:v>
                </c:pt>
                <c:pt idx="32">
                  <c:v>1.7515010484865319</c:v>
                </c:pt>
                <c:pt idx="33">
                  <c:v>1.0948178437618652</c:v>
                </c:pt>
                <c:pt idx="34">
                  <c:v>2.3894267043401136</c:v>
                </c:pt>
                <c:pt idx="35">
                  <c:v>1.3159266398314373</c:v>
                </c:pt>
                <c:pt idx="36">
                  <c:v>1.283383477931842</c:v>
                </c:pt>
                <c:pt idx="37">
                  <c:v>1.1445509926772179</c:v>
                </c:pt>
                <c:pt idx="38">
                  <c:v>1.3839672282712354</c:v>
                </c:pt>
                <c:pt idx="39">
                  <c:v>1.0741147633199231</c:v>
                </c:pt>
                <c:pt idx="40">
                  <c:v>1.0735580027449434</c:v>
                </c:pt>
                <c:pt idx="41">
                  <c:v>1.0786344204512595</c:v>
                </c:pt>
                <c:pt idx="42">
                  <c:v>1.311655639175334</c:v>
                </c:pt>
                <c:pt idx="43">
                  <c:v>1.0764370243356474</c:v>
                </c:pt>
                <c:pt idx="44">
                  <c:v>1.0235456702697308</c:v>
                </c:pt>
                <c:pt idx="45">
                  <c:v>1.5751573817561242</c:v>
                </c:pt>
                <c:pt idx="46">
                  <c:v>1.0569835772674143</c:v>
                </c:pt>
                <c:pt idx="47">
                  <c:v>2.5703686647116055</c:v>
                </c:pt>
                <c:pt idx="48">
                  <c:v>1.239637168936027</c:v>
                </c:pt>
                <c:pt idx="49">
                  <c:v>1.7053095168706902</c:v>
                </c:pt>
                <c:pt idx="50">
                  <c:v>1.0672962841557003</c:v>
                </c:pt>
                <c:pt idx="51">
                  <c:v>1.1918367675738823</c:v>
                </c:pt>
                <c:pt idx="52">
                  <c:v>0.91255771245994743</c:v>
                </c:pt>
                <c:pt idx="53">
                  <c:v>1.5803747405450164</c:v>
                </c:pt>
                <c:pt idx="54">
                  <c:v>1.2828029291062666</c:v>
                </c:pt>
                <c:pt idx="55">
                  <c:v>1.3699126544223155</c:v>
                </c:pt>
                <c:pt idx="56">
                  <c:v>1.3471420053994614</c:v>
                </c:pt>
                <c:pt idx="57">
                  <c:v>0.99271185439070397</c:v>
                </c:pt>
                <c:pt idx="58">
                  <c:v>1.1796352598006323</c:v>
                </c:pt>
                <c:pt idx="59">
                  <c:v>1.1713089305850335</c:v>
                </c:pt>
                <c:pt idx="60">
                  <c:v>1.6870027357193198</c:v>
                </c:pt>
                <c:pt idx="61">
                  <c:v>1.1578306738858126</c:v>
                </c:pt>
                <c:pt idx="62">
                  <c:v>1.1328429409601102</c:v>
                </c:pt>
                <c:pt idx="63">
                  <c:v>0.97100319878077879</c:v>
                </c:pt>
                <c:pt idx="64">
                  <c:v>0.89873750777351091</c:v>
                </c:pt>
                <c:pt idx="65">
                  <c:v>1.0044377237420772</c:v>
                </c:pt>
                <c:pt idx="66">
                  <c:v>1.2285282467622887</c:v>
                </c:pt>
                <c:pt idx="67">
                  <c:v>1.1225457328628612</c:v>
                </c:pt>
                <c:pt idx="68">
                  <c:v>1.2585826052618589</c:v>
                </c:pt>
                <c:pt idx="69">
                  <c:v>0.98208536613746078</c:v>
                </c:pt>
                <c:pt idx="70">
                  <c:v>0.86892091529873439</c:v>
                </c:pt>
                <c:pt idx="71">
                  <c:v>1.0755620937774841</c:v>
                </c:pt>
                <c:pt idx="72">
                  <c:v>1.3417108685736927</c:v>
                </c:pt>
                <c:pt idx="73">
                  <c:v>1.0788688255274537</c:v>
                </c:pt>
                <c:pt idx="74">
                  <c:v>1.0198637298451552</c:v>
                </c:pt>
                <c:pt idx="75">
                  <c:v>1.3291204066340678</c:v>
                </c:pt>
                <c:pt idx="76">
                  <c:v>1.2335999147972077</c:v>
                </c:pt>
                <c:pt idx="77">
                  <c:v>1.2162243080346327</c:v>
                </c:pt>
                <c:pt idx="78">
                  <c:v>0.85295366807404172</c:v>
                </c:pt>
                <c:pt idx="79">
                  <c:v>0.87943650980082888</c:v>
                </c:pt>
                <c:pt idx="80">
                  <c:v>1.0562517213814044</c:v>
                </c:pt>
                <c:pt idx="81">
                  <c:v>1.3410239183359083</c:v>
                </c:pt>
                <c:pt idx="82">
                  <c:v>1.1039678212666191</c:v>
                </c:pt>
                <c:pt idx="83">
                  <c:v>1.1880304324868298</c:v>
                </c:pt>
                <c:pt idx="84">
                  <c:v>1.7396753036829002</c:v>
                </c:pt>
                <c:pt idx="85">
                  <c:v>1.1169171054483671</c:v>
                </c:pt>
                <c:pt idx="86">
                  <c:v>1.4329364543987804</c:v>
                </c:pt>
                <c:pt idx="87">
                  <c:v>1.1432653089318654</c:v>
                </c:pt>
                <c:pt idx="88">
                  <c:v>1.197092579723988</c:v>
                </c:pt>
                <c:pt idx="89">
                  <c:v>1.141404357408675</c:v>
                </c:pt>
                <c:pt idx="90">
                  <c:v>1.2048376326559456</c:v>
                </c:pt>
                <c:pt idx="91">
                  <c:v>1.0287846991114269</c:v>
                </c:pt>
                <c:pt idx="92">
                  <c:v>0.97190278638289329</c:v>
                </c:pt>
                <c:pt idx="93">
                  <c:v>1.2643624921334171</c:v>
                </c:pt>
                <c:pt idx="94">
                  <c:v>1.4495937387783748</c:v>
                </c:pt>
                <c:pt idx="95">
                  <c:v>1.1778088920875986</c:v>
                </c:pt>
                <c:pt idx="96">
                  <c:v>1.0733869686145441</c:v>
                </c:pt>
                <c:pt idx="97">
                  <c:v>1.2559658948068675</c:v>
                </c:pt>
                <c:pt idx="98">
                  <c:v>0.8033831244367764</c:v>
                </c:pt>
                <c:pt idx="99">
                  <c:v>1.703872387431252</c:v>
                </c:pt>
                <c:pt idx="100">
                  <c:v>1.44494798577839</c:v>
                </c:pt>
                <c:pt idx="101">
                  <c:v>1.0735445099500254</c:v>
                </c:pt>
                <c:pt idx="102">
                  <c:v>1.220626889144738</c:v>
                </c:pt>
                <c:pt idx="103">
                  <c:v>1.5589094082986008</c:v>
                </c:pt>
                <c:pt idx="104">
                  <c:v>1.2721516142214957</c:v>
                </c:pt>
                <c:pt idx="105">
                  <c:v>1.3874823089261468</c:v>
                </c:pt>
                <c:pt idx="106">
                  <c:v>1.3538443682743015</c:v>
                </c:pt>
                <c:pt idx="107">
                  <c:v>0.88908102221388396</c:v>
                </c:pt>
                <c:pt idx="108">
                  <c:v>1.0362924386131669</c:v>
                </c:pt>
                <c:pt idx="109">
                  <c:v>1.2232641294203928</c:v>
                </c:pt>
                <c:pt idx="110">
                  <c:v>1.2301186543927389</c:v>
                </c:pt>
                <c:pt idx="111">
                  <c:v>0.90362328895536115</c:v>
                </c:pt>
                <c:pt idx="112">
                  <c:v>0.93780637058383942</c:v>
                </c:pt>
                <c:pt idx="113">
                  <c:v>1.1342532926148021</c:v>
                </c:pt>
                <c:pt idx="114">
                  <c:v>0.91249121417226831</c:v>
                </c:pt>
                <c:pt idx="115">
                  <c:v>0.93897712078280993</c:v>
                </c:pt>
                <c:pt idx="116">
                  <c:v>1.5954399903090366</c:v>
                </c:pt>
                <c:pt idx="117">
                  <c:v>0.98378222094667145</c:v>
                </c:pt>
                <c:pt idx="118">
                  <c:v>1.9699391770244732</c:v>
                </c:pt>
                <c:pt idx="119">
                  <c:v>1.0859507309474357</c:v>
                </c:pt>
                <c:pt idx="120">
                  <c:v>1.4776240996043613</c:v>
                </c:pt>
                <c:pt idx="121">
                  <c:v>1.563659376613336</c:v>
                </c:pt>
                <c:pt idx="122">
                  <c:v>1.2180746475406143</c:v>
                </c:pt>
                <c:pt idx="123">
                  <c:v>1.1309252959967819</c:v>
                </c:pt>
                <c:pt idx="124">
                  <c:v>1.3388757790282568</c:v>
                </c:pt>
                <c:pt idx="125">
                  <c:v>1.4350556017853089</c:v>
                </c:pt>
                <c:pt idx="126">
                  <c:v>1.0240995847496728</c:v>
                </c:pt>
                <c:pt idx="127">
                  <c:v>1.4485930151687549</c:v>
                </c:pt>
                <c:pt idx="128">
                  <c:v>0.9041321347172111</c:v>
                </c:pt>
                <c:pt idx="129">
                  <c:v>1.6278685424021904</c:v>
                </c:pt>
                <c:pt idx="130">
                  <c:v>1.1589461121620415</c:v>
                </c:pt>
                <c:pt idx="131">
                  <c:v>1.4143339456542523</c:v>
                </c:pt>
                <c:pt idx="132">
                  <c:v>1.4136629954296847</c:v>
                </c:pt>
                <c:pt idx="133">
                  <c:v>1.2720887845414806</c:v>
                </c:pt>
                <c:pt idx="134">
                  <c:v>1.1268681884529783</c:v>
                </c:pt>
                <c:pt idx="135">
                  <c:v>1.360726014091673</c:v>
                </c:pt>
                <c:pt idx="136">
                  <c:v>1.1322397232160371</c:v>
                </c:pt>
                <c:pt idx="137">
                  <c:v>1.1017662419168657</c:v>
                </c:pt>
                <c:pt idx="138">
                  <c:v>1.3607941614885137</c:v>
                </c:pt>
                <c:pt idx="139">
                  <c:v>1.1445572410614555</c:v>
                </c:pt>
                <c:pt idx="140">
                  <c:v>1.0277862907966004</c:v>
                </c:pt>
                <c:pt idx="141">
                  <c:v>1.349853095065604</c:v>
                </c:pt>
                <c:pt idx="142">
                  <c:v>1.8792940880936899</c:v>
                </c:pt>
                <c:pt idx="143">
                  <c:v>1.1149948402744823</c:v>
                </c:pt>
                <c:pt idx="144">
                  <c:v>1.390941684403171</c:v>
                </c:pt>
                <c:pt idx="145">
                  <c:v>0.96804506789994293</c:v>
                </c:pt>
                <c:pt idx="146">
                  <c:v>1.9540874267973156</c:v>
                </c:pt>
                <c:pt idx="147">
                  <c:v>1.6546807718887884</c:v>
                </c:pt>
                <c:pt idx="148">
                  <c:v>1.0492723338012815</c:v>
                </c:pt>
                <c:pt idx="149">
                  <c:v>1.6957418990788018</c:v>
                </c:pt>
                <c:pt idx="150">
                  <c:v>1.2783988069338881</c:v>
                </c:pt>
                <c:pt idx="151">
                  <c:v>1.1081771721862648</c:v>
                </c:pt>
                <c:pt idx="152">
                  <c:v>0.94622005372512463</c:v>
                </c:pt>
                <c:pt idx="153">
                  <c:v>1.5121344091656701</c:v>
                </c:pt>
                <c:pt idx="154">
                  <c:v>0.98809558166835021</c:v>
                </c:pt>
                <c:pt idx="155">
                  <c:v>1.2409459774025364</c:v>
                </c:pt>
                <c:pt idx="156">
                  <c:v>1.1132500423791374</c:v>
                </c:pt>
                <c:pt idx="157">
                  <c:v>0.99019354225100142</c:v>
                </c:pt>
                <c:pt idx="158">
                  <c:v>0.92920029498646994</c:v>
                </c:pt>
                <c:pt idx="159">
                  <c:v>1.2713851392489504</c:v>
                </c:pt>
                <c:pt idx="160">
                  <c:v>1.0369036600170234</c:v>
                </c:pt>
                <c:pt idx="161">
                  <c:v>1.4090283932326497</c:v>
                </c:pt>
                <c:pt idx="162">
                  <c:v>1.094838684049336</c:v>
                </c:pt>
                <c:pt idx="163">
                  <c:v>1.5774131191011231</c:v>
                </c:pt>
                <c:pt idx="164">
                  <c:v>1.2465269238027796</c:v>
                </c:pt>
                <c:pt idx="165">
                  <c:v>0.98705411020180245</c:v>
                </c:pt>
                <c:pt idx="166">
                  <c:v>1.1307404251767239</c:v>
                </c:pt>
                <c:pt idx="167">
                  <c:v>1.1613913620680019</c:v>
                </c:pt>
                <c:pt idx="168">
                  <c:v>1.0502314290468737</c:v>
                </c:pt>
                <c:pt idx="169">
                  <c:v>1.013130142154024</c:v>
                </c:pt>
                <c:pt idx="170">
                  <c:v>1.0453026641814005</c:v>
                </c:pt>
                <c:pt idx="171">
                  <c:v>1.2414650155157294</c:v>
                </c:pt>
                <c:pt idx="172">
                  <c:v>1.1744606343121284</c:v>
                </c:pt>
                <c:pt idx="173">
                  <c:v>1.1396124328429107</c:v>
                </c:pt>
                <c:pt idx="174">
                  <c:v>1.2002638391532336</c:v>
                </c:pt>
                <c:pt idx="175">
                  <c:v>1.3856875613788975</c:v>
                </c:pt>
                <c:pt idx="176">
                  <c:v>1.0556345555913118</c:v>
                </c:pt>
                <c:pt idx="177">
                  <c:v>1.1364340400584223</c:v>
                </c:pt>
                <c:pt idx="178">
                  <c:v>0.96941994083581173</c:v>
                </c:pt>
                <c:pt idx="179">
                  <c:v>0.97724341334217246</c:v>
                </c:pt>
                <c:pt idx="180">
                  <c:v>1.1067750977246811</c:v>
                </c:pt>
                <c:pt idx="181">
                  <c:v>1.162495992394929</c:v>
                </c:pt>
                <c:pt idx="182">
                  <c:v>1.2783844652445147</c:v>
                </c:pt>
                <c:pt idx="183">
                  <c:v>1.2106690422124367</c:v>
                </c:pt>
                <c:pt idx="184">
                  <c:v>1.2964266586698361</c:v>
                </c:pt>
                <c:pt idx="185">
                  <c:v>1.415536134177628</c:v>
                </c:pt>
                <c:pt idx="186">
                  <c:v>1.3972291924368263</c:v>
                </c:pt>
                <c:pt idx="187">
                  <c:v>1.2212452715667932</c:v>
                </c:pt>
                <c:pt idx="188">
                  <c:v>1.0623578848336694</c:v>
                </c:pt>
                <c:pt idx="189">
                  <c:v>1.3722155575425516</c:v>
                </c:pt>
                <c:pt idx="190">
                  <c:v>0.96665641277381464</c:v>
                </c:pt>
                <c:pt idx="191">
                  <c:v>1.094382652817196</c:v>
                </c:pt>
                <c:pt idx="192">
                  <c:v>1.4548483700300481</c:v>
                </c:pt>
                <c:pt idx="193">
                  <c:v>1.4777466165527628</c:v>
                </c:pt>
                <c:pt idx="194">
                  <c:v>1.2200849127879896</c:v>
                </c:pt>
                <c:pt idx="195">
                  <c:v>1.2247660305760488</c:v>
                </c:pt>
                <c:pt idx="196">
                  <c:v>1.3468983198971356</c:v>
                </c:pt>
                <c:pt idx="197">
                  <c:v>1.3671412382052448</c:v>
                </c:pt>
                <c:pt idx="198">
                  <c:v>1.2793987996594691</c:v>
                </c:pt>
                <c:pt idx="199">
                  <c:v>1.2468762648209688</c:v>
                </c:pt>
                <c:pt idx="200">
                  <c:v>1.3162376506883917</c:v>
                </c:pt>
                <c:pt idx="201">
                  <c:v>1.1976404709892634</c:v>
                </c:pt>
                <c:pt idx="202">
                  <c:v>1.217124804617149</c:v>
                </c:pt>
                <c:pt idx="203">
                  <c:v>1.0868874197614307</c:v>
                </c:pt>
                <c:pt idx="204">
                  <c:v>1.1072655538273128</c:v>
                </c:pt>
                <c:pt idx="205">
                  <c:v>1.1056984098835489</c:v>
                </c:pt>
                <c:pt idx="206">
                  <c:v>1.2024374742981045</c:v>
                </c:pt>
                <c:pt idx="207">
                  <c:v>1.3327126883342297</c:v>
                </c:pt>
                <c:pt idx="208">
                  <c:v>1.2895518357240654</c:v>
                </c:pt>
                <c:pt idx="209">
                  <c:v>1.1961721518701562</c:v>
                </c:pt>
                <c:pt idx="210">
                  <c:v>1.1304294172843141</c:v>
                </c:pt>
                <c:pt idx="211">
                  <c:v>1.263435249720406</c:v>
                </c:pt>
                <c:pt idx="212">
                  <c:v>2.3535003941131056</c:v>
                </c:pt>
                <c:pt idx="213">
                  <c:v>1.1265937397371053</c:v>
                </c:pt>
                <c:pt idx="214">
                  <c:v>1.513748520753496</c:v>
                </c:pt>
                <c:pt idx="215">
                  <c:v>1.0552656241763025</c:v>
                </c:pt>
                <c:pt idx="216">
                  <c:v>1.3987402420424435</c:v>
                </c:pt>
                <c:pt idx="217">
                  <c:v>1.2944500885495278</c:v>
                </c:pt>
                <c:pt idx="218">
                  <c:v>1.3379556145781271</c:v>
                </c:pt>
                <c:pt idx="219">
                  <c:v>0.93105472734508343</c:v>
                </c:pt>
                <c:pt idx="220">
                  <c:v>1.0372455112740389</c:v>
                </c:pt>
                <c:pt idx="221">
                  <c:v>1.0967600203180632</c:v>
                </c:pt>
                <c:pt idx="222">
                  <c:v>1.1877350907998689</c:v>
                </c:pt>
                <c:pt idx="223">
                  <c:v>1.1698760301624676</c:v>
                </c:pt>
                <c:pt idx="224">
                  <c:v>1.1850040964207986</c:v>
                </c:pt>
                <c:pt idx="225">
                  <c:v>0.95007581539195973</c:v>
                </c:pt>
                <c:pt idx="226">
                  <c:v>1.2411293764944991</c:v>
                </c:pt>
                <c:pt idx="227">
                  <c:v>1.6398035104290092</c:v>
                </c:pt>
                <c:pt idx="228">
                  <c:v>1.0562944143183228</c:v>
                </c:pt>
                <c:pt idx="229">
                  <c:v>1.0015106984059596</c:v>
                </c:pt>
                <c:pt idx="230">
                  <c:v>0.91949218060732396</c:v>
                </c:pt>
                <c:pt idx="231">
                  <c:v>1.1164056604817834</c:v>
                </c:pt>
                <c:pt idx="232">
                  <c:v>1.2128730041902216</c:v>
                </c:pt>
                <c:pt idx="233">
                  <c:v>1.0954559170041698</c:v>
                </c:pt>
                <c:pt idx="234">
                  <c:v>1.2597578009676698</c:v>
                </c:pt>
                <c:pt idx="235">
                  <c:v>1.1327037639188986</c:v>
                </c:pt>
                <c:pt idx="236">
                  <c:v>0.95182201160537849</c:v>
                </c:pt>
                <c:pt idx="237">
                  <c:v>1.3268209141851957</c:v>
                </c:pt>
                <c:pt idx="238">
                  <c:v>1.0791060267106447</c:v>
                </c:pt>
                <c:pt idx="239">
                  <c:v>1.2424241022169358</c:v>
                </c:pt>
                <c:pt idx="240">
                  <c:v>1.3143094148160865</c:v>
                </c:pt>
                <c:pt idx="241">
                  <c:v>1.1098444329238206</c:v>
                </c:pt>
                <c:pt idx="242">
                  <c:v>1.2013938510695972</c:v>
                </c:pt>
                <c:pt idx="243">
                  <c:v>1.2225210148600727</c:v>
                </c:pt>
                <c:pt idx="244">
                  <c:v>1.1149655514767158</c:v>
                </c:pt>
                <c:pt idx="245">
                  <c:v>1.0463019258932695</c:v>
                </c:pt>
                <c:pt idx="246">
                  <c:v>1.0760203722622705</c:v>
                </c:pt>
                <c:pt idx="247">
                  <c:v>1.394557515457334</c:v>
                </c:pt>
                <c:pt idx="248">
                  <c:v>1.0095942842130394</c:v>
                </c:pt>
                <c:pt idx="249">
                  <c:v>1.4179275161942924</c:v>
                </c:pt>
                <c:pt idx="250">
                  <c:v>1.1911272236671571</c:v>
                </c:pt>
                <c:pt idx="251">
                  <c:v>1.4577933440135751</c:v>
                </c:pt>
                <c:pt idx="252">
                  <c:v>1.3879252393576897</c:v>
                </c:pt>
                <c:pt idx="253">
                  <c:v>1.2516324100319196</c:v>
                </c:pt>
                <c:pt idx="254">
                  <c:v>1.7677288051851745</c:v>
                </c:pt>
                <c:pt idx="255">
                  <c:v>1.0878150576749728</c:v>
                </c:pt>
                <c:pt idx="256">
                  <c:v>0.88752973496226661</c:v>
                </c:pt>
                <c:pt idx="257">
                  <c:v>1.8814639995232043</c:v>
                </c:pt>
                <c:pt idx="258">
                  <c:v>1.8029988221989244</c:v>
                </c:pt>
                <c:pt idx="259">
                  <c:v>0.99042138902462207</c:v>
                </c:pt>
                <c:pt idx="260">
                  <c:v>1.1103647446189282</c:v>
                </c:pt>
                <c:pt idx="261">
                  <c:v>1.1596088985208393</c:v>
                </c:pt>
                <c:pt idx="262">
                  <c:v>1.1554664941525794</c:v>
                </c:pt>
                <c:pt idx="263">
                  <c:v>1.0724921093674358</c:v>
                </c:pt>
                <c:pt idx="264">
                  <c:v>1.0319956524098368</c:v>
                </c:pt>
                <c:pt idx="265">
                  <c:v>1.0655783214297256</c:v>
                </c:pt>
                <c:pt idx="266">
                  <c:v>1.0817263617120858</c:v>
                </c:pt>
                <c:pt idx="267">
                  <c:v>1.2929132918889084</c:v>
                </c:pt>
                <c:pt idx="268">
                  <c:v>1.3656432005322447</c:v>
                </c:pt>
                <c:pt idx="269">
                  <c:v>1.1639267896682179</c:v>
                </c:pt>
                <c:pt idx="270">
                  <c:v>1.0390227742291791</c:v>
                </c:pt>
                <c:pt idx="271">
                  <c:v>1.2262827551728461</c:v>
                </c:pt>
                <c:pt idx="272">
                  <c:v>1.2292339220156185</c:v>
                </c:pt>
                <c:pt idx="273">
                  <c:v>1.2640447995345419</c:v>
                </c:pt>
                <c:pt idx="274">
                  <c:v>1.2092340024017842</c:v>
                </c:pt>
                <c:pt idx="275">
                  <c:v>1.5983325182189172</c:v>
                </c:pt>
                <c:pt idx="276">
                  <c:v>1.1824514121609357</c:v>
                </c:pt>
                <c:pt idx="277">
                  <c:v>1.1065904187694084</c:v>
                </c:pt>
                <c:pt idx="278">
                  <c:v>1.0767314654045959</c:v>
                </c:pt>
                <c:pt idx="279">
                  <c:v>1.032833001377113</c:v>
                </c:pt>
                <c:pt idx="280">
                  <c:v>1.423698215440323</c:v>
                </c:pt>
                <c:pt idx="281">
                  <c:v>1.3879409863882555</c:v>
                </c:pt>
                <c:pt idx="282">
                  <c:v>2.0793985040703924</c:v>
                </c:pt>
                <c:pt idx="283">
                  <c:v>1.1723170050861837</c:v>
                </c:pt>
                <c:pt idx="284">
                  <c:v>1.0410368963094203</c:v>
                </c:pt>
                <c:pt idx="285">
                  <c:v>1.0485495992312186</c:v>
                </c:pt>
                <c:pt idx="286">
                  <c:v>1.1604933533431425</c:v>
                </c:pt>
                <c:pt idx="287">
                  <c:v>1.179028584896497</c:v>
                </c:pt>
                <c:pt idx="288">
                  <c:v>1.5031895999826435</c:v>
                </c:pt>
                <c:pt idx="289">
                  <c:v>1.0221210341760576</c:v>
                </c:pt>
                <c:pt idx="290">
                  <c:v>0.96743890083711714</c:v>
                </c:pt>
                <c:pt idx="291">
                  <c:v>1.0100396243845107</c:v>
                </c:pt>
                <c:pt idx="292">
                  <c:v>1.2270567920842701</c:v>
                </c:pt>
                <c:pt idx="293">
                  <c:v>1.5788482912719641</c:v>
                </c:pt>
                <c:pt idx="294">
                  <c:v>0.97246595960075988</c:v>
                </c:pt>
                <c:pt idx="295">
                  <c:v>1.0285589558393269</c:v>
                </c:pt>
                <c:pt idx="296">
                  <c:v>1.07858291486124</c:v>
                </c:pt>
                <c:pt idx="297">
                  <c:v>2.8344812405501019</c:v>
                </c:pt>
                <c:pt idx="298">
                  <c:v>1.3943936069830551</c:v>
                </c:pt>
                <c:pt idx="299">
                  <c:v>0.97016919050975869</c:v>
                </c:pt>
                <c:pt idx="300">
                  <c:v>1.0749266137128644</c:v>
                </c:pt>
                <c:pt idx="301">
                  <c:v>1.2520908113945228</c:v>
                </c:pt>
                <c:pt idx="302">
                  <c:v>1.1833198782089942</c:v>
                </c:pt>
                <c:pt idx="303">
                  <c:v>1.166352257038459</c:v>
                </c:pt>
                <c:pt idx="304">
                  <c:v>1.2897594071178042</c:v>
                </c:pt>
                <c:pt idx="305">
                  <c:v>1.3765208157291671</c:v>
                </c:pt>
                <c:pt idx="306">
                  <c:v>1.2984877202784431</c:v>
                </c:pt>
                <c:pt idx="307">
                  <c:v>1.1942513491264977</c:v>
                </c:pt>
                <c:pt idx="308">
                  <c:v>1.2236319845857417</c:v>
                </c:pt>
                <c:pt idx="309">
                  <c:v>1.0067808434622987</c:v>
                </c:pt>
                <c:pt idx="310">
                  <c:v>1.146499685973223</c:v>
                </c:pt>
                <c:pt idx="311">
                  <c:v>0.95980033391830122</c:v>
                </c:pt>
                <c:pt idx="312">
                  <c:v>1.6889583943849216</c:v>
                </c:pt>
                <c:pt idx="313">
                  <c:v>1.1195550916922903</c:v>
                </c:pt>
                <c:pt idx="314">
                  <c:v>1.4687323473286029</c:v>
                </c:pt>
                <c:pt idx="315">
                  <c:v>1.6837724898975919</c:v>
                </c:pt>
                <c:pt idx="316">
                  <c:v>1.310016012076304</c:v>
                </c:pt>
                <c:pt idx="317">
                  <c:v>1.3071160906611941</c:v>
                </c:pt>
                <c:pt idx="318">
                  <c:v>1.3527437551491488</c:v>
                </c:pt>
                <c:pt idx="319">
                  <c:v>0.86099662981185776</c:v>
                </c:pt>
                <c:pt idx="320">
                  <c:v>1.3498276370444016</c:v>
                </c:pt>
                <c:pt idx="321">
                  <c:v>1.0619462870284362</c:v>
                </c:pt>
                <c:pt idx="322">
                  <c:v>0.92694369431926493</c:v>
                </c:pt>
                <c:pt idx="323">
                  <c:v>1.1695857078824357</c:v>
                </c:pt>
                <c:pt idx="324">
                  <c:v>1.2593517780701593</c:v>
                </c:pt>
                <c:pt idx="325">
                  <c:v>1.0895436521718123</c:v>
                </c:pt>
                <c:pt idx="326">
                  <c:v>0.98785355925785689</c:v>
                </c:pt>
                <c:pt idx="327">
                  <c:v>1.0934497789632265</c:v>
                </c:pt>
                <c:pt idx="328">
                  <c:v>1.5321660771848533</c:v>
                </c:pt>
                <c:pt idx="329">
                  <c:v>1.2833179723502304</c:v>
                </c:pt>
                <c:pt idx="330">
                  <c:v>1.3993329332387654</c:v>
                </c:pt>
                <c:pt idx="331">
                  <c:v>1.1199230946234942</c:v>
                </c:pt>
                <c:pt idx="332">
                  <c:v>1.6929697145762219</c:v>
                </c:pt>
                <c:pt idx="333">
                  <c:v>1.0100890816877706</c:v>
                </c:pt>
                <c:pt idx="334">
                  <c:v>1.1472720419487663</c:v>
                </c:pt>
                <c:pt idx="335">
                  <c:v>1.0247354347520141</c:v>
                </c:pt>
                <c:pt idx="336">
                  <c:v>0.92215374526272842</c:v>
                </c:pt>
                <c:pt idx="337">
                  <c:v>1.0580938746256412</c:v>
                </c:pt>
                <c:pt idx="338">
                  <c:v>0.88950462682238807</c:v>
                </c:pt>
                <c:pt idx="339">
                  <c:v>0.96738798268151993</c:v>
                </c:pt>
                <c:pt idx="340">
                  <c:v>0.70735049902215374</c:v>
                </c:pt>
                <c:pt idx="341">
                  <c:v>1.4111045711028916</c:v>
                </c:pt>
                <c:pt idx="342">
                  <c:v>1.2657474392014756</c:v>
                </c:pt>
                <c:pt idx="343">
                  <c:v>1.837478488069842</c:v>
                </c:pt>
                <c:pt idx="344">
                  <c:v>1.3643656073655315</c:v>
                </c:pt>
                <c:pt idx="345">
                  <c:v>0.89179684652011137</c:v>
                </c:pt>
                <c:pt idx="346">
                  <c:v>1.0444582995412779</c:v>
                </c:pt>
                <c:pt idx="347">
                  <c:v>1.3175324529686274</c:v>
                </c:pt>
                <c:pt idx="348">
                  <c:v>1.8013863975784361</c:v>
                </c:pt>
                <c:pt idx="349">
                  <c:v>1.2510230429297555</c:v>
                </c:pt>
                <c:pt idx="350">
                  <c:v>1.2709653754142662</c:v>
                </c:pt>
                <c:pt idx="351">
                  <c:v>1.4129629825964616</c:v>
                </c:pt>
                <c:pt idx="352">
                  <c:v>1.1337270260174641</c:v>
                </c:pt>
                <c:pt idx="353">
                  <c:v>1.3248294083295509</c:v>
                </c:pt>
                <c:pt idx="354">
                  <c:v>0.98249973366452092</c:v>
                </c:pt>
                <c:pt idx="355">
                  <c:v>1.1509770633796168</c:v>
                </c:pt>
                <c:pt idx="356">
                  <c:v>1.3008440935370589</c:v>
                </c:pt>
                <c:pt idx="357">
                  <c:v>0.99917998853719103</c:v>
                </c:pt>
                <c:pt idx="358">
                  <c:v>1.2085907409077605</c:v>
                </c:pt>
                <c:pt idx="359">
                  <c:v>1.0054414128555706</c:v>
                </c:pt>
                <c:pt idx="360">
                  <c:v>1.2676450096896004</c:v>
                </c:pt>
                <c:pt idx="361">
                  <c:v>0.93482944514292643</c:v>
                </c:pt>
                <c:pt idx="362">
                  <c:v>1.2488079540999963</c:v>
                </c:pt>
                <c:pt idx="363">
                  <c:v>1.3754320592361828</c:v>
                </c:pt>
                <c:pt idx="364">
                  <c:v>1.2697039114220896</c:v>
                </c:pt>
                <c:pt idx="365">
                  <c:v>0.82836677329198238</c:v>
                </c:pt>
                <c:pt idx="366">
                  <c:v>1.0754240447572345</c:v>
                </c:pt>
                <c:pt idx="367">
                  <c:v>0.91322899416884273</c:v>
                </c:pt>
                <c:pt idx="368">
                  <c:v>0.95885354317036231</c:v>
                </c:pt>
                <c:pt idx="369">
                  <c:v>1.1954737969676994</c:v>
                </c:pt>
                <c:pt idx="370">
                  <c:v>1.2372736401385449</c:v>
                </c:pt>
                <c:pt idx="371">
                  <c:v>1.028205499212606</c:v>
                </c:pt>
                <c:pt idx="372">
                  <c:v>1.0399088086380039</c:v>
                </c:pt>
                <c:pt idx="373">
                  <c:v>1.2124409666406359</c:v>
                </c:pt>
                <c:pt idx="374">
                  <c:v>0.90327387725874519</c:v>
                </c:pt>
                <c:pt idx="375">
                  <c:v>1.046746174328703</c:v>
                </c:pt>
                <c:pt idx="376">
                  <c:v>1.468638821042261</c:v>
                </c:pt>
                <c:pt idx="377">
                  <c:v>1.1281139886909732</c:v>
                </c:pt>
                <c:pt idx="378">
                  <c:v>1.0063242867973194</c:v>
                </c:pt>
                <c:pt idx="379">
                  <c:v>0.91986704372408234</c:v>
                </c:pt>
                <c:pt idx="380">
                  <c:v>0.87182836264682517</c:v>
                </c:pt>
                <c:pt idx="381">
                  <c:v>0.9828494206453352</c:v>
                </c:pt>
                <c:pt idx="382">
                  <c:v>0.95604381451916298</c:v>
                </c:pt>
                <c:pt idx="383">
                  <c:v>1.0599700080630428</c:v>
                </c:pt>
                <c:pt idx="384">
                  <c:v>1.004923121492044</c:v>
                </c:pt>
                <c:pt idx="385">
                  <c:v>1.3784666479093912</c:v>
                </c:pt>
                <c:pt idx="386">
                  <c:v>1.3343604617460667</c:v>
                </c:pt>
                <c:pt idx="387">
                  <c:v>1.1251739226831841</c:v>
                </c:pt>
                <c:pt idx="388">
                  <c:v>1.2892585190974741</c:v>
                </c:pt>
                <c:pt idx="389">
                  <c:v>0.94703860172860543</c:v>
                </c:pt>
                <c:pt idx="390">
                  <c:v>0.91526596652850378</c:v>
                </c:pt>
                <c:pt idx="391">
                  <c:v>0.95035871564852914</c:v>
                </c:pt>
                <c:pt idx="392">
                  <c:v>0.9418022914554306</c:v>
                </c:pt>
                <c:pt idx="393">
                  <c:v>0.93170533559697377</c:v>
                </c:pt>
                <c:pt idx="394">
                  <c:v>1.1145361623802399</c:v>
                </c:pt>
                <c:pt idx="395">
                  <c:v>1.1573207325648192</c:v>
                </c:pt>
                <c:pt idx="396">
                  <c:v>1.1100747049788287</c:v>
                </c:pt>
                <c:pt idx="397">
                  <c:v>1.2088906149055259</c:v>
                </c:pt>
                <c:pt idx="398">
                  <c:v>1.0556260947159721</c:v>
                </c:pt>
                <c:pt idx="399">
                  <c:v>1.04549841107793</c:v>
                </c:pt>
                <c:pt idx="400">
                  <c:v>1.1311302756803807</c:v>
                </c:pt>
                <c:pt idx="401">
                  <c:v>1.1558456914376281</c:v>
                </c:pt>
                <c:pt idx="402">
                  <c:v>1.001111463497302</c:v>
                </c:pt>
                <c:pt idx="403">
                  <c:v>1.1370624720107478</c:v>
                </c:pt>
                <c:pt idx="404">
                  <c:v>1.2664026033791336</c:v>
                </c:pt>
                <c:pt idx="405">
                  <c:v>1.770557359799247</c:v>
                </c:pt>
                <c:pt idx="406">
                  <c:v>1.6405139902511756</c:v>
                </c:pt>
                <c:pt idx="407">
                  <c:v>1.2130671261233335</c:v>
                </c:pt>
                <c:pt idx="408">
                  <c:v>1.7074829038777055</c:v>
                </c:pt>
                <c:pt idx="409">
                  <c:v>0.97938926395168313</c:v>
                </c:pt>
                <c:pt idx="410">
                  <c:v>1.4907111688957044</c:v>
                </c:pt>
                <c:pt idx="411">
                  <c:v>0.98194737950921085</c:v>
                </c:pt>
                <c:pt idx="412">
                  <c:v>1.0517453575897477</c:v>
                </c:pt>
                <c:pt idx="413">
                  <c:v>1.1111153433965546</c:v>
                </c:pt>
                <c:pt idx="414">
                  <c:v>1.1877286929711277</c:v>
                </c:pt>
                <c:pt idx="415">
                  <c:v>1.1697069471872137</c:v>
                </c:pt>
                <c:pt idx="416">
                  <c:v>1.2477546520896918</c:v>
                </c:pt>
                <c:pt idx="417">
                  <c:v>0.91815206869499599</c:v>
                </c:pt>
                <c:pt idx="418">
                  <c:v>1.0719772347572363</c:v>
                </c:pt>
                <c:pt idx="419">
                  <c:v>1.143212004667217</c:v>
                </c:pt>
                <c:pt idx="420">
                  <c:v>1.3526188018768923</c:v>
                </c:pt>
                <c:pt idx="421">
                  <c:v>1.1178761563375053</c:v>
                </c:pt>
                <c:pt idx="422">
                  <c:v>1.0944155924929642</c:v>
                </c:pt>
                <c:pt idx="423">
                  <c:v>1.260416777266482</c:v>
                </c:pt>
                <c:pt idx="424">
                  <c:v>1.117329251381427</c:v>
                </c:pt>
                <c:pt idx="425">
                  <c:v>0.95583301763218309</c:v>
                </c:pt>
                <c:pt idx="426">
                  <c:v>1.0689277170763567</c:v>
                </c:pt>
                <c:pt idx="427">
                  <c:v>1.2004285499397858</c:v>
                </c:pt>
                <c:pt idx="428">
                  <c:v>0.95359796033806909</c:v>
                </c:pt>
                <c:pt idx="429">
                  <c:v>0.93546120849574321</c:v>
                </c:pt>
                <c:pt idx="430">
                  <c:v>1.1074125393438059</c:v>
                </c:pt>
                <c:pt idx="431">
                  <c:v>1.174557335697765</c:v>
                </c:pt>
                <c:pt idx="432">
                  <c:v>1.1130106148584358</c:v>
                </c:pt>
                <c:pt idx="433">
                  <c:v>1.562670198922349</c:v>
                </c:pt>
                <c:pt idx="434">
                  <c:v>1.1372582702226837</c:v>
                </c:pt>
                <c:pt idx="435">
                  <c:v>1.4955067443840531</c:v>
                </c:pt>
                <c:pt idx="436">
                  <c:v>1.3347328314810798</c:v>
                </c:pt>
                <c:pt idx="437">
                  <c:v>1.1484858796730681</c:v>
                </c:pt>
                <c:pt idx="438">
                  <c:v>1.3504448822994071</c:v>
                </c:pt>
                <c:pt idx="439">
                  <c:v>1.0557923352952168</c:v>
                </c:pt>
                <c:pt idx="440">
                  <c:v>1.2052722566174914</c:v>
                </c:pt>
                <c:pt idx="441">
                  <c:v>1.2152984851224471</c:v>
                </c:pt>
                <c:pt idx="442">
                  <c:v>1.1023567750509</c:v>
                </c:pt>
                <c:pt idx="443">
                  <c:v>1.105722581363384</c:v>
                </c:pt>
                <c:pt idx="444">
                  <c:v>1.0404592088534184</c:v>
                </c:pt>
                <c:pt idx="445">
                  <c:v>1.2018688794506378</c:v>
                </c:pt>
                <c:pt idx="446">
                  <c:v>1.1456106664566215</c:v>
                </c:pt>
                <c:pt idx="447">
                  <c:v>1.1422485523368786</c:v>
                </c:pt>
                <c:pt idx="448">
                  <c:v>1.1821625170119492</c:v>
                </c:pt>
                <c:pt idx="449">
                  <c:v>1.203299461684874</c:v>
                </c:pt>
                <c:pt idx="450">
                  <c:v>1.2480070412893882</c:v>
                </c:pt>
                <c:pt idx="451">
                  <c:v>1.1097466449018796</c:v>
                </c:pt>
                <c:pt idx="452">
                  <c:v>1.5602629273008968</c:v>
                </c:pt>
                <c:pt idx="453">
                  <c:v>1.3445632871569315</c:v>
                </c:pt>
                <c:pt idx="454">
                  <c:v>1.0126455077605609</c:v>
                </c:pt>
                <c:pt idx="455">
                  <c:v>1.1504507297779007</c:v>
                </c:pt>
                <c:pt idx="456">
                  <c:v>1.9445876178572448</c:v>
                </c:pt>
                <c:pt idx="457">
                  <c:v>1.3198771415012236</c:v>
                </c:pt>
                <c:pt idx="458">
                  <c:v>1.1242988675963885</c:v>
                </c:pt>
                <c:pt idx="459">
                  <c:v>1.2300326408412141</c:v>
                </c:pt>
                <c:pt idx="460">
                  <c:v>1.0633311027019645</c:v>
                </c:pt>
                <c:pt idx="461">
                  <c:v>1.2719390641645647</c:v>
                </c:pt>
                <c:pt idx="462">
                  <c:v>1.1554399285047821</c:v>
                </c:pt>
                <c:pt idx="463">
                  <c:v>1.0746020348584655</c:v>
                </c:pt>
                <c:pt idx="464">
                  <c:v>1.5931525250966272</c:v>
                </c:pt>
                <c:pt idx="465">
                  <c:v>1.1804505195457713</c:v>
                </c:pt>
                <c:pt idx="466">
                  <c:v>2.4249318618014004</c:v>
                </c:pt>
                <c:pt idx="467">
                  <c:v>1.0213301118479123</c:v>
                </c:pt>
                <c:pt idx="468">
                  <c:v>1.0733846044377189</c:v>
                </c:pt>
                <c:pt idx="469">
                  <c:v>1.6008971204747398</c:v>
                </c:pt>
                <c:pt idx="470">
                  <c:v>1.3447872442117925</c:v>
                </c:pt>
                <c:pt idx="471">
                  <c:v>1.0010456262944378</c:v>
                </c:pt>
                <c:pt idx="472">
                  <c:v>1.3146836118206917</c:v>
                </c:pt>
                <c:pt idx="473">
                  <c:v>1.5621758955670972</c:v>
                </c:pt>
                <c:pt idx="474">
                  <c:v>1.1758675729247499</c:v>
                </c:pt>
                <c:pt idx="475">
                  <c:v>1.1533062719143945</c:v>
                </c:pt>
                <c:pt idx="476">
                  <c:v>1.1016213577810317</c:v>
                </c:pt>
                <c:pt idx="477">
                  <c:v>1.318631066437095</c:v>
                </c:pt>
                <c:pt idx="478">
                  <c:v>1.1589176245549413</c:v>
                </c:pt>
                <c:pt idx="479">
                  <c:v>1.0184590220852148</c:v>
                </c:pt>
                <c:pt idx="480">
                  <c:v>0.95492526710978554</c:v>
                </c:pt>
                <c:pt idx="481">
                  <c:v>1.7222295048502083</c:v>
                </c:pt>
                <c:pt idx="482">
                  <c:v>1.1552069647669905</c:v>
                </c:pt>
                <c:pt idx="483">
                  <c:v>1.088121912880432</c:v>
                </c:pt>
                <c:pt idx="484">
                  <c:v>1.5014544118957607</c:v>
                </c:pt>
                <c:pt idx="485">
                  <c:v>1.0362676991104891</c:v>
                </c:pt>
                <c:pt idx="486">
                  <c:v>0.98024118900365609</c:v>
                </c:pt>
                <c:pt idx="487">
                  <c:v>1.0908819808344223</c:v>
                </c:pt>
                <c:pt idx="488">
                  <c:v>1.0658037717577045</c:v>
                </c:pt>
                <c:pt idx="489">
                  <c:v>0.93937527181550196</c:v>
                </c:pt>
                <c:pt idx="490">
                  <c:v>1.1244520249540131</c:v>
                </c:pt>
                <c:pt idx="491">
                  <c:v>1.2938803426434169</c:v>
                </c:pt>
                <c:pt idx="492">
                  <c:v>1.0989438158720006</c:v>
                </c:pt>
                <c:pt idx="493">
                  <c:v>1.1821764544732443</c:v>
                </c:pt>
                <c:pt idx="494">
                  <c:v>1.0005848723176656</c:v>
                </c:pt>
                <c:pt idx="495">
                  <c:v>1.0656951063801612</c:v>
                </c:pt>
                <c:pt idx="496">
                  <c:v>1.2766131503760707</c:v>
                </c:pt>
                <c:pt idx="497">
                  <c:v>1.1587285392494053</c:v>
                </c:pt>
                <c:pt idx="498">
                  <c:v>0.96408836237420148</c:v>
                </c:pt>
                <c:pt idx="499">
                  <c:v>1.4482418349926862</c:v>
                </c:pt>
                <c:pt idx="500">
                  <c:v>1.0796892657101165</c:v>
                </c:pt>
                <c:pt idx="501">
                  <c:v>1.1037688990544336</c:v>
                </c:pt>
                <c:pt idx="502">
                  <c:v>1.4995672105454108</c:v>
                </c:pt>
                <c:pt idx="503">
                  <c:v>1.1519308961892354</c:v>
                </c:pt>
                <c:pt idx="504">
                  <c:v>1.3940528399450856</c:v>
                </c:pt>
                <c:pt idx="505">
                  <c:v>1.4672827322019364</c:v>
                </c:pt>
                <c:pt idx="506">
                  <c:v>2.1323573395833462</c:v>
                </c:pt>
                <c:pt idx="507">
                  <c:v>1.3999039561483604</c:v>
                </c:pt>
                <c:pt idx="508">
                  <c:v>1.0014676586492481</c:v>
                </c:pt>
                <c:pt idx="509">
                  <c:v>1.0019585455521143</c:v>
                </c:pt>
                <c:pt idx="510">
                  <c:v>1.1560329347070606</c:v>
                </c:pt>
                <c:pt idx="511">
                  <c:v>1.1908289120375579</c:v>
                </c:pt>
                <c:pt idx="512">
                  <c:v>0.99435991367584919</c:v>
                </c:pt>
                <c:pt idx="513">
                  <c:v>0.92687797255876214</c:v>
                </c:pt>
                <c:pt idx="514">
                  <c:v>1.0852152305779945</c:v>
                </c:pt>
                <c:pt idx="515">
                  <c:v>1.1938705208803881</c:v>
                </c:pt>
                <c:pt idx="516">
                  <c:v>1.0201926197318152</c:v>
                </c:pt>
                <c:pt idx="517">
                  <c:v>1.1291164351434562</c:v>
                </c:pt>
                <c:pt idx="518">
                  <c:v>1.0832195303336998</c:v>
                </c:pt>
                <c:pt idx="519">
                  <c:v>1.5519916649275778</c:v>
                </c:pt>
                <c:pt idx="520">
                  <c:v>1.7562815746823992</c:v>
                </c:pt>
                <c:pt idx="521">
                  <c:v>0.95647460851996957</c:v>
                </c:pt>
                <c:pt idx="522">
                  <c:v>1.2885287997104939</c:v>
                </c:pt>
                <c:pt idx="523">
                  <c:v>1.702505106587838</c:v>
                </c:pt>
                <c:pt idx="524">
                  <c:v>1.1634026863297131</c:v>
                </c:pt>
                <c:pt idx="525">
                  <c:v>1.4824724342917408</c:v>
                </c:pt>
                <c:pt idx="526">
                  <c:v>1.3987610795841803</c:v>
                </c:pt>
                <c:pt idx="527">
                  <c:v>1.0811627782129489</c:v>
                </c:pt>
                <c:pt idx="528">
                  <c:v>1.0335042824491869</c:v>
                </c:pt>
                <c:pt idx="529">
                  <c:v>0.93504952292540389</c:v>
                </c:pt>
                <c:pt idx="530">
                  <c:v>1.0844203771244549</c:v>
                </c:pt>
                <c:pt idx="531">
                  <c:v>1.0588496156848983</c:v>
                </c:pt>
                <c:pt idx="532">
                  <c:v>1.1635924625738081</c:v>
                </c:pt>
                <c:pt idx="533">
                  <c:v>1.2389369581308827</c:v>
                </c:pt>
                <c:pt idx="534">
                  <c:v>1.0912674616429716</c:v>
                </c:pt>
                <c:pt idx="535">
                  <c:v>1.0946000741794231</c:v>
                </c:pt>
                <c:pt idx="536">
                  <c:v>1.2957603490493648</c:v>
                </c:pt>
                <c:pt idx="537">
                  <c:v>1.2594225469027036</c:v>
                </c:pt>
                <c:pt idx="538">
                  <c:v>0.94856104569497612</c:v>
                </c:pt>
                <c:pt idx="539">
                  <c:v>1.1051938061135587</c:v>
                </c:pt>
                <c:pt idx="540">
                  <c:v>1.0661350716347868</c:v>
                </c:pt>
                <c:pt idx="541">
                  <c:v>1.3293861188755178</c:v>
                </c:pt>
                <c:pt idx="542">
                  <c:v>1.3013109524825448</c:v>
                </c:pt>
                <c:pt idx="543">
                  <c:v>1.0892307468808895</c:v>
                </c:pt>
                <c:pt idx="544">
                  <c:v>1.1786553391541941</c:v>
                </c:pt>
                <c:pt idx="545">
                  <c:v>0.96093922268520537</c:v>
                </c:pt>
                <c:pt idx="546">
                  <c:v>1.1375105817133011</c:v>
                </c:pt>
                <c:pt idx="547">
                  <c:v>1.072221156710162</c:v>
                </c:pt>
                <c:pt idx="548">
                  <c:v>1.0572690532279037</c:v>
                </c:pt>
                <c:pt idx="549">
                  <c:v>1.0621985584605362</c:v>
                </c:pt>
                <c:pt idx="550">
                  <c:v>1.139153332563424</c:v>
                </c:pt>
                <c:pt idx="551">
                  <c:v>1.0509943788507135</c:v>
                </c:pt>
                <c:pt idx="552">
                  <c:v>1.2261592834022599</c:v>
                </c:pt>
                <c:pt idx="553">
                  <c:v>0.98906479544416193</c:v>
                </c:pt>
                <c:pt idx="554">
                  <c:v>1.1190735256519639</c:v>
                </c:pt>
                <c:pt idx="555">
                  <c:v>0.99380958016874443</c:v>
                </c:pt>
                <c:pt idx="556">
                  <c:v>1.191315454129763</c:v>
                </c:pt>
                <c:pt idx="557">
                  <c:v>1.3225156735759487</c:v>
                </c:pt>
                <c:pt idx="558">
                  <c:v>1.2510210774496726</c:v>
                </c:pt>
                <c:pt idx="559">
                  <c:v>1.0349281920543292</c:v>
                </c:pt>
                <c:pt idx="560">
                  <c:v>1.2956751403843056</c:v>
                </c:pt>
                <c:pt idx="561">
                  <c:v>0.97477141983601923</c:v>
                </c:pt>
                <c:pt idx="562">
                  <c:v>0.87770256779174183</c:v>
                </c:pt>
                <c:pt idx="563">
                  <c:v>1.0701723100687128</c:v>
                </c:pt>
                <c:pt idx="564">
                  <c:v>1.055223931326654</c:v>
                </c:pt>
                <c:pt idx="565">
                  <c:v>1.0666033692327563</c:v>
                </c:pt>
                <c:pt idx="566">
                  <c:v>1.5107236395790147</c:v>
                </c:pt>
                <c:pt idx="567">
                  <c:v>1.3007726308857874</c:v>
                </c:pt>
                <c:pt idx="568">
                  <c:v>1.4800265768906187</c:v>
                </c:pt>
                <c:pt idx="569">
                  <c:v>1.0593957504460267</c:v>
                </c:pt>
                <c:pt idx="570">
                  <c:v>1.2655327797610163</c:v>
                </c:pt>
                <c:pt idx="571">
                  <c:v>1.612511215151881</c:v>
                </c:pt>
                <c:pt idx="572">
                  <c:v>1.2863614905334897</c:v>
                </c:pt>
                <c:pt idx="573">
                  <c:v>1.0552892510300145</c:v>
                </c:pt>
                <c:pt idx="574">
                  <c:v>1.2222385654706336</c:v>
                </c:pt>
                <c:pt idx="575">
                  <c:v>1.4944835398374838</c:v>
                </c:pt>
                <c:pt idx="576">
                  <c:v>1.019932256602115</c:v>
                </c:pt>
                <c:pt idx="577">
                  <c:v>1.2492583781701976</c:v>
                </c:pt>
                <c:pt idx="578">
                  <c:v>1.1567230293621511</c:v>
                </c:pt>
                <c:pt idx="579">
                  <c:v>1.360443602691406</c:v>
                </c:pt>
                <c:pt idx="580">
                  <c:v>1.0396152403199306</c:v>
                </c:pt>
                <c:pt idx="581">
                  <c:v>1.0117354658915276</c:v>
                </c:pt>
                <c:pt idx="582">
                  <c:v>0.95686037621626807</c:v>
                </c:pt>
                <c:pt idx="583">
                  <c:v>1.1001722791583832</c:v>
                </c:pt>
                <c:pt idx="584">
                  <c:v>1.0656935510546564</c:v>
                </c:pt>
                <c:pt idx="585">
                  <c:v>1.0557029176686614</c:v>
                </c:pt>
                <c:pt idx="586">
                  <c:v>1.3212253983958164</c:v>
                </c:pt>
                <c:pt idx="587">
                  <c:v>1.1060117716542937</c:v>
                </c:pt>
                <c:pt idx="588">
                  <c:v>1.5751502322649369</c:v>
                </c:pt>
                <c:pt idx="589">
                  <c:v>1.187513391830435</c:v>
                </c:pt>
                <c:pt idx="590">
                  <c:v>1.4340982716211568</c:v>
                </c:pt>
                <c:pt idx="591">
                  <c:v>1.1581578247320226</c:v>
                </c:pt>
                <c:pt idx="592">
                  <c:v>1.2364195711093284</c:v>
                </c:pt>
                <c:pt idx="593">
                  <c:v>1.4389645735746017</c:v>
                </c:pt>
                <c:pt idx="594">
                  <c:v>1.0017184080238402</c:v>
                </c:pt>
                <c:pt idx="595">
                  <c:v>1.220475619311012</c:v>
                </c:pt>
                <c:pt idx="596">
                  <c:v>1.0856333866940826</c:v>
                </c:pt>
                <c:pt idx="597">
                  <c:v>1.6178823876052739</c:v>
                </c:pt>
                <c:pt idx="598">
                  <c:v>1.1954125283934989</c:v>
                </c:pt>
                <c:pt idx="599">
                  <c:v>1.3754331224247756</c:v>
                </c:pt>
                <c:pt idx="600">
                  <c:v>1.1518636532717252</c:v>
                </c:pt>
                <c:pt idx="601">
                  <c:v>1.0871414702080964</c:v>
                </c:pt>
                <c:pt idx="602">
                  <c:v>0.95437444681946504</c:v>
                </c:pt>
                <c:pt idx="603">
                  <c:v>0.94985719469132601</c:v>
                </c:pt>
                <c:pt idx="604">
                  <c:v>0.97445093668787564</c:v>
                </c:pt>
                <c:pt idx="605">
                  <c:v>1.1620673371736752</c:v>
                </c:pt>
                <c:pt idx="606">
                  <c:v>1.2193330554879596</c:v>
                </c:pt>
                <c:pt idx="607">
                  <c:v>1.3421166670897413</c:v>
                </c:pt>
                <c:pt idx="608">
                  <c:v>1.5836521570602509</c:v>
                </c:pt>
                <c:pt idx="609">
                  <c:v>1.410612409080797</c:v>
                </c:pt>
                <c:pt idx="610">
                  <c:v>1.0082836025610677</c:v>
                </c:pt>
                <c:pt idx="611">
                  <c:v>1.007464253233668</c:v>
                </c:pt>
                <c:pt idx="612">
                  <c:v>1.0099493988018806</c:v>
                </c:pt>
                <c:pt idx="613">
                  <c:v>1.0474473017137003</c:v>
                </c:pt>
                <c:pt idx="614">
                  <c:v>1.212833340898221</c:v>
                </c:pt>
                <c:pt idx="615">
                  <c:v>0.89973970123007896</c:v>
                </c:pt>
                <c:pt idx="616">
                  <c:v>1.1164542173667995</c:v>
                </c:pt>
                <c:pt idx="617">
                  <c:v>0.96589313001274724</c:v>
                </c:pt>
                <c:pt idx="618">
                  <c:v>1.1029358218228336</c:v>
                </c:pt>
                <c:pt idx="619">
                  <c:v>1.1895764545056677</c:v>
                </c:pt>
                <c:pt idx="620">
                  <c:v>1.2960043438406068</c:v>
                </c:pt>
                <c:pt idx="621">
                  <c:v>2.1724547327255399</c:v>
                </c:pt>
                <c:pt idx="622">
                  <c:v>0.99217270987189732</c:v>
                </c:pt>
                <c:pt idx="623">
                  <c:v>1.5544189050782522</c:v>
                </c:pt>
                <c:pt idx="624">
                  <c:v>1.4247313867116314</c:v>
                </c:pt>
                <c:pt idx="625">
                  <c:v>1.3600174583245077</c:v>
                </c:pt>
                <c:pt idx="626">
                  <c:v>1.3301969974068459</c:v>
                </c:pt>
                <c:pt idx="627">
                  <c:v>1.1006245418866907</c:v>
                </c:pt>
                <c:pt idx="628">
                  <c:v>0.93414864692063271</c:v>
                </c:pt>
                <c:pt idx="629">
                  <c:v>1.088960128203845</c:v>
                </c:pt>
                <c:pt idx="630">
                  <c:v>1.2689546378843986</c:v>
                </c:pt>
                <c:pt idx="631">
                  <c:v>0.98343431868930342</c:v>
                </c:pt>
                <c:pt idx="632">
                  <c:v>1.3050906373568558</c:v>
                </c:pt>
                <c:pt idx="633">
                  <c:v>1.7551550706329861</c:v>
                </c:pt>
                <c:pt idx="634">
                  <c:v>1.4961814076165829</c:v>
                </c:pt>
                <c:pt idx="635">
                  <c:v>1.1900275101438946</c:v>
                </c:pt>
                <c:pt idx="636">
                  <c:v>0.97940160007141364</c:v>
                </c:pt>
                <c:pt idx="637">
                  <c:v>1.4094208950812572</c:v>
                </c:pt>
                <c:pt idx="638">
                  <c:v>1.1383711527315032</c:v>
                </c:pt>
                <c:pt idx="639">
                  <c:v>1.2065774739457926</c:v>
                </c:pt>
                <c:pt idx="640">
                  <c:v>1.5372391197544715</c:v>
                </c:pt>
                <c:pt idx="641">
                  <c:v>0.96640737884937122</c:v>
                </c:pt>
                <c:pt idx="642">
                  <c:v>1.1024371152430865</c:v>
                </c:pt>
                <c:pt idx="643">
                  <c:v>0.97626935553354399</c:v>
                </c:pt>
                <c:pt idx="644">
                  <c:v>1.2935991167092302</c:v>
                </c:pt>
                <c:pt idx="645">
                  <c:v>1.1138247778674666</c:v>
                </c:pt>
                <c:pt idx="646">
                  <c:v>1.0833128388372735</c:v>
                </c:pt>
                <c:pt idx="647">
                  <c:v>1.0040990758211139</c:v>
                </c:pt>
                <c:pt idx="648">
                  <c:v>1.1813150769440131</c:v>
                </c:pt>
                <c:pt idx="649">
                  <c:v>1.1438803646430109</c:v>
                </c:pt>
                <c:pt idx="650">
                  <c:v>1.5047379020346208</c:v>
                </c:pt>
                <c:pt idx="651">
                  <c:v>1.5864116358163642</c:v>
                </c:pt>
                <c:pt idx="652">
                  <c:v>1.4420775445518028</c:v>
                </c:pt>
                <c:pt idx="653">
                  <c:v>1.21422192687818</c:v>
                </c:pt>
                <c:pt idx="654">
                  <c:v>1.1579953762082267</c:v>
                </c:pt>
                <c:pt idx="655">
                  <c:v>1.1959958691691488</c:v>
                </c:pt>
                <c:pt idx="656">
                  <c:v>1.1413199432465215</c:v>
                </c:pt>
                <c:pt idx="657">
                  <c:v>1.1046398941054971</c:v>
                </c:pt>
                <c:pt idx="658">
                  <c:v>1.2498050096776776</c:v>
                </c:pt>
                <c:pt idx="659">
                  <c:v>1.1177229971720934</c:v>
                </c:pt>
                <c:pt idx="660">
                  <c:v>1.2094700305046751</c:v>
                </c:pt>
                <c:pt idx="661">
                  <c:v>1.0348635326540687</c:v>
                </c:pt>
                <c:pt idx="662">
                  <c:v>1.3281812222498901</c:v>
                </c:pt>
                <c:pt idx="663">
                  <c:v>0.96184502954959794</c:v>
                </c:pt>
                <c:pt idx="664">
                  <c:v>1.2168495560782158</c:v>
                </c:pt>
                <c:pt idx="665">
                  <c:v>1.0629376606757051</c:v>
                </c:pt>
                <c:pt idx="666">
                  <c:v>1.0020802696480913</c:v>
                </c:pt>
                <c:pt idx="667">
                  <c:v>1.0749846190638523</c:v>
                </c:pt>
                <c:pt idx="668">
                  <c:v>1.6119796438033238</c:v>
                </c:pt>
                <c:pt idx="669">
                  <c:v>1.1759350405746802</c:v>
                </c:pt>
                <c:pt idx="670">
                  <c:v>1.0023324716716233</c:v>
                </c:pt>
                <c:pt idx="671">
                  <c:v>1.7434516701043603</c:v>
                </c:pt>
                <c:pt idx="672">
                  <c:v>1.0683257737370069</c:v>
                </c:pt>
                <c:pt idx="673">
                  <c:v>1.2061117045690999</c:v>
                </c:pt>
                <c:pt idx="674">
                  <c:v>1.0126047284258106</c:v>
                </c:pt>
                <c:pt idx="675">
                  <c:v>1.5717571026110173</c:v>
                </c:pt>
                <c:pt idx="676">
                  <c:v>1.0107118700724926</c:v>
                </c:pt>
                <c:pt idx="677">
                  <c:v>1.1552903293428864</c:v>
                </c:pt>
                <c:pt idx="678">
                  <c:v>1.0174442412145657</c:v>
                </c:pt>
                <c:pt idx="679">
                  <c:v>1.5723912046646127</c:v>
                </c:pt>
                <c:pt idx="680">
                  <c:v>1.3837693462509788</c:v>
                </c:pt>
                <c:pt idx="681">
                  <c:v>1.3065904265157804</c:v>
                </c:pt>
                <c:pt idx="682">
                  <c:v>1.2359340657847464</c:v>
                </c:pt>
                <c:pt idx="683">
                  <c:v>1.4162934971176673</c:v>
                </c:pt>
                <c:pt idx="684">
                  <c:v>1.5407443291165317</c:v>
                </c:pt>
                <c:pt idx="685">
                  <c:v>1.3789816603055891</c:v>
                </c:pt>
                <c:pt idx="686">
                  <c:v>1.4949339347517339</c:v>
                </c:pt>
                <c:pt idx="687">
                  <c:v>1.3672143778013479</c:v>
                </c:pt>
                <c:pt idx="688">
                  <c:v>0.99174315028382554</c:v>
                </c:pt>
                <c:pt idx="689">
                  <c:v>0.94573435417423202</c:v>
                </c:pt>
                <c:pt idx="690">
                  <c:v>1.1816162604688099</c:v>
                </c:pt>
                <c:pt idx="691">
                  <c:v>1.1511463624115164</c:v>
                </c:pt>
                <c:pt idx="692">
                  <c:v>1.1046986100314236</c:v>
                </c:pt>
                <c:pt idx="693">
                  <c:v>1.4520722748603829</c:v>
                </c:pt>
                <c:pt idx="694">
                  <c:v>1.5003331374292643</c:v>
                </c:pt>
                <c:pt idx="695">
                  <c:v>1.0548517844995131</c:v>
                </c:pt>
                <c:pt idx="696">
                  <c:v>1.183173592942131</c:v>
                </c:pt>
                <c:pt idx="697">
                  <c:v>1.1197465855910012</c:v>
                </c:pt>
                <c:pt idx="698">
                  <c:v>1.2361534737546336</c:v>
                </c:pt>
                <c:pt idx="699">
                  <c:v>1.0162864379991037</c:v>
                </c:pt>
                <c:pt idx="700">
                  <c:v>1.3123677322490097</c:v>
                </c:pt>
                <c:pt idx="701">
                  <c:v>1.3585094422425801</c:v>
                </c:pt>
                <c:pt idx="702">
                  <c:v>1.0661255589626404</c:v>
                </c:pt>
                <c:pt idx="703">
                  <c:v>0.85987789103738643</c:v>
                </c:pt>
                <c:pt idx="704">
                  <c:v>1.1240100149496104</c:v>
                </c:pt>
                <c:pt idx="705">
                  <c:v>1.2138086993392461</c:v>
                </c:pt>
              </c:numCache>
            </c:numRef>
          </c:xVal>
          <c:yVal>
            <c:numRef>
              <c:f>triplicate!$D$2:$D$708</c:f>
              <c:numCache>
                <c:formatCode>General</c:formatCode>
                <c:ptCount val="707"/>
                <c:pt idx="0">
                  <c:v>1.0107956332902268</c:v>
                </c:pt>
                <c:pt idx="1">
                  <c:v>1.4345396306702272</c:v>
                </c:pt>
                <c:pt idx="2">
                  <c:v>1.0047897149715117</c:v>
                </c:pt>
                <c:pt idx="3">
                  <c:v>1.2262455245191124</c:v>
                </c:pt>
                <c:pt idx="4">
                  <c:v>1.0468072135763271</c:v>
                </c:pt>
                <c:pt idx="5">
                  <c:v>2.3119683891080909</c:v>
                </c:pt>
                <c:pt idx="6">
                  <c:v>2.5272113388734523</c:v>
                </c:pt>
                <c:pt idx="7">
                  <c:v>1.0328620608802004</c:v>
                </c:pt>
                <c:pt idx="8">
                  <c:v>1.5699271664828129</c:v>
                </c:pt>
                <c:pt idx="9">
                  <c:v>1.6382731473757135</c:v>
                </c:pt>
                <c:pt idx="10">
                  <c:v>1.1063735046853125</c:v>
                </c:pt>
                <c:pt idx="11">
                  <c:v>1.3825415879725649</c:v>
                </c:pt>
                <c:pt idx="12">
                  <c:v>1.2289089305799579</c:v>
                </c:pt>
                <c:pt idx="13">
                  <c:v>1.6140709314188697</c:v>
                </c:pt>
                <c:pt idx="14">
                  <c:v>1.7068724305646594</c:v>
                </c:pt>
                <c:pt idx="15">
                  <c:v>2.7400158891055852</c:v>
                </c:pt>
                <c:pt idx="16">
                  <c:v>0.88297695179298419</c:v>
                </c:pt>
                <c:pt idx="17">
                  <c:v>1.4120395413982414</c:v>
                </c:pt>
                <c:pt idx="18">
                  <c:v>0.94995096433065473</c:v>
                </c:pt>
                <c:pt idx="19">
                  <c:v>1.4077367105322296</c:v>
                </c:pt>
                <c:pt idx="20">
                  <c:v>1.2405246401694772</c:v>
                </c:pt>
                <c:pt idx="21">
                  <c:v>1.711476935284318</c:v>
                </c:pt>
                <c:pt idx="22">
                  <c:v>1.4119378754198639</c:v>
                </c:pt>
                <c:pt idx="23">
                  <c:v>1.1763064012176037</c:v>
                </c:pt>
                <c:pt idx="24">
                  <c:v>1.0720508566400069</c:v>
                </c:pt>
                <c:pt idx="25">
                  <c:v>1.2638914614401091</c:v>
                </c:pt>
                <c:pt idx="26">
                  <c:v>1.8841921929475496</c:v>
                </c:pt>
                <c:pt idx="27">
                  <c:v>1.8444082407879321</c:v>
                </c:pt>
                <c:pt idx="28">
                  <c:v>1.3195248202425538</c:v>
                </c:pt>
                <c:pt idx="29">
                  <c:v>1.8218389803052633</c:v>
                </c:pt>
                <c:pt idx="30">
                  <c:v>1.1143453590599115</c:v>
                </c:pt>
                <c:pt idx="31">
                  <c:v>1.1898170379344775</c:v>
                </c:pt>
                <c:pt idx="32">
                  <c:v>2.1063068456053213</c:v>
                </c:pt>
                <c:pt idx="33">
                  <c:v>1.3960656795915589</c:v>
                </c:pt>
                <c:pt idx="34">
                  <c:v>4.0559718033112979</c:v>
                </c:pt>
                <c:pt idx="35">
                  <c:v>1.2066365003108745</c:v>
                </c:pt>
                <c:pt idx="36">
                  <c:v>1.7497823854728984</c:v>
                </c:pt>
                <c:pt idx="37">
                  <c:v>1.365292103623176</c:v>
                </c:pt>
                <c:pt idx="38">
                  <c:v>1.538962671532508</c:v>
                </c:pt>
                <c:pt idx="39">
                  <c:v>1.1981981542470836</c:v>
                </c:pt>
                <c:pt idx="40">
                  <c:v>1.0868982190642376</c:v>
                </c:pt>
                <c:pt idx="41">
                  <c:v>1.5531207479702964</c:v>
                </c:pt>
                <c:pt idx="42">
                  <c:v>1.6616727204030004</c:v>
                </c:pt>
                <c:pt idx="43">
                  <c:v>1.6224655418775324</c:v>
                </c:pt>
                <c:pt idx="44">
                  <c:v>1.7691430216948727</c:v>
                </c:pt>
                <c:pt idx="45">
                  <c:v>2.1259327785275119</c:v>
                </c:pt>
                <c:pt idx="46">
                  <c:v>1.09747953865586</c:v>
                </c:pt>
                <c:pt idx="47">
                  <c:v>3.3181031072594016</c:v>
                </c:pt>
                <c:pt idx="48">
                  <c:v>1.484208567625257</c:v>
                </c:pt>
                <c:pt idx="49">
                  <c:v>1.2008560115370732</c:v>
                </c:pt>
                <c:pt idx="50">
                  <c:v>1.2793581232118147</c:v>
                </c:pt>
                <c:pt idx="51">
                  <c:v>1.8667110890504788</c:v>
                </c:pt>
                <c:pt idx="52">
                  <c:v>0.97819882431877581</c:v>
                </c:pt>
                <c:pt idx="53">
                  <c:v>1.4122809437908375</c:v>
                </c:pt>
                <c:pt idx="54">
                  <c:v>1.097234800068525</c:v>
                </c:pt>
                <c:pt idx="55">
                  <c:v>1.7858348594983555</c:v>
                </c:pt>
                <c:pt idx="56">
                  <c:v>1.6660820578231295</c:v>
                </c:pt>
                <c:pt idx="57">
                  <c:v>1.7639212531932238</c:v>
                </c:pt>
                <c:pt idx="58">
                  <c:v>1.4094322542532798</c:v>
                </c:pt>
                <c:pt idx="59">
                  <c:v>1.8641375296764315</c:v>
                </c:pt>
                <c:pt idx="60">
                  <c:v>2.4617603491929803</c:v>
                </c:pt>
                <c:pt idx="61">
                  <c:v>1.2203895829711648</c:v>
                </c:pt>
                <c:pt idx="62">
                  <c:v>1.2220483714813932</c:v>
                </c:pt>
                <c:pt idx="63">
                  <c:v>0.96076700188496766</c:v>
                </c:pt>
                <c:pt idx="64">
                  <c:v>0.82657073471031872</c:v>
                </c:pt>
                <c:pt idx="65">
                  <c:v>1.1964999657197366</c:v>
                </c:pt>
                <c:pt idx="66">
                  <c:v>1.5957722534375631</c:v>
                </c:pt>
                <c:pt idx="67">
                  <c:v>1.3851432663726937</c:v>
                </c:pt>
                <c:pt idx="68">
                  <c:v>1.2475451741961028</c:v>
                </c:pt>
                <c:pt idx="69">
                  <c:v>0.80319561755140256</c:v>
                </c:pt>
                <c:pt idx="70">
                  <c:v>1.2133167996317287</c:v>
                </c:pt>
                <c:pt idx="71">
                  <c:v>1.1783859483549768</c:v>
                </c:pt>
                <c:pt idx="72">
                  <c:v>2.0208311383148252</c:v>
                </c:pt>
                <c:pt idx="73">
                  <c:v>1.6275702830041501</c:v>
                </c:pt>
                <c:pt idx="74">
                  <c:v>0.88781722812282704</c:v>
                </c:pt>
                <c:pt idx="75">
                  <c:v>1.3234006266256799</c:v>
                </c:pt>
                <c:pt idx="76">
                  <c:v>2.2391370892524374</c:v>
                </c:pt>
                <c:pt idx="77">
                  <c:v>2.0452399611115597</c:v>
                </c:pt>
                <c:pt idx="78">
                  <c:v>1.1548885584416955</c:v>
                </c:pt>
                <c:pt idx="79">
                  <c:v>1.1886082203251844</c:v>
                </c:pt>
                <c:pt idx="80">
                  <c:v>2.2828664643422831</c:v>
                </c:pt>
                <c:pt idx="81">
                  <c:v>2.3060242231956698</c:v>
                </c:pt>
                <c:pt idx="82">
                  <c:v>0.96157486003751569</c:v>
                </c:pt>
                <c:pt idx="83">
                  <c:v>1.5036855178139714</c:v>
                </c:pt>
                <c:pt idx="84">
                  <c:v>1.6882200316274694</c:v>
                </c:pt>
                <c:pt idx="85">
                  <c:v>1.3978861602482151</c:v>
                </c:pt>
                <c:pt idx="86">
                  <c:v>1.3369366269074718</c:v>
                </c:pt>
                <c:pt idx="87">
                  <c:v>1.4987221149133505</c:v>
                </c:pt>
                <c:pt idx="88">
                  <c:v>1.4682471164780231</c:v>
                </c:pt>
                <c:pt idx="89">
                  <c:v>1.3320076279441138</c:v>
                </c:pt>
                <c:pt idx="90">
                  <c:v>1.5339958461295407</c:v>
                </c:pt>
                <c:pt idx="91">
                  <c:v>1.353927477958117</c:v>
                </c:pt>
                <c:pt idx="92">
                  <c:v>0.82366205316238961</c:v>
                </c:pt>
                <c:pt idx="93">
                  <c:v>1.5604109299912479</c:v>
                </c:pt>
                <c:pt idx="94">
                  <c:v>1.2479222038161781</c:v>
                </c:pt>
                <c:pt idx="95">
                  <c:v>1.9342490495847244</c:v>
                </c:pt>
                <c:pt idx="96">
                  <c:v>1.8915682492902268</c:v>
                </c:pt>
                <c:pt idx="97">
                  <c:v>1.6460026908987253</c:v>
                </c:pt>
                <c:pt idx="98">
                  <c:v>1.5476855787143966</c:v>
                </c:pt>
                <c:pt idx="99">
                  <c:v>3.2774781357520379</c:v>
                </c:pt>
                <c:pt idx="100">
                  <c:v>1.7967346981893473</c:v>
                </c:pt>
                <c:pt idx="101">
                  <c:v>2.7193434025754128</c:v>
                </c:pt>
                <c:pt idx="102">
                  <c:v>1.3831109495148528</c:v>
                </c:pt>
                <c:pt idx="103">
                  <c:v>3.5479901179838835</c:v>
                </c:pt>
                <c:pt idx="104">
                  <c:v>1.0736380837508988</c:v>
                </c:pt>
                <c:pt idx="105">
                  <c:v>2.255794203961849</c:v>
                </c:pt>
                <c:pt idx="106">
                  <c:v>1.5636448542264019</c:v>
                </c:pt>
                <c:pt idx="107">
                  <c:v>1.8393517502898871</c:v>
                </c:pt>
                <c:pt idx="108">
                  <c:v>0.72548766973846646</c:v>
                </c:pt>
                <c:pt idx="109">
                  <c:v>1.2249124777928728</c:v>
                </c:pt>
                <c:pt idx="110">
                  <c:v>0.78072083633696965</c:v>
                </c:pt>
                <c:pt idx="111">
                  <c:v>1.6366383358682959</c:v>
                </c:pt>
                <c:pt idx="112">
                  <c:v>1.1673922969005526</c:v>
                </c:pt>
                <c:pt idx="113">
                  <c:v>1.0752612019968479</c:v>
                </c:pt>
                <c:pt idx="114">
                  <c:v>0.77789462103763041</c:v>
                </c:pt>
                <c:pt idx="115">
                  <c:v>1.3233693092538406</c:v>
                </c:pt>
                <c:pt idx="116">
                  <c:v>2.0751827405564711</c:v>
                </c:pt>
                <c:pt idx="117">
                  <c:v>0.79147882933274072</c:v>
                </c:pt>
                <c:pt idx="118">
                  <c:v>1.7175024444801128</c:v>
                </c:pt>
                <c:pt idx="119">
                  <c:v>0.94323931636634484</c:v>
                </c:pt>
                <c:pt idx="120">
                  <c:v>2.980143756188582</c:v>
                </c:pt>
                <c:pt idx="121">
                  <c:v>2.360072115879122</c:v>
                </c:pt>
                <c:pt idx="122">
                  <c:v>0.9049017097828036</c:v>
                </c:pt>
                <c:pt idx="123">
                  <c:v>1.7756262055876268</c:v>
                </c:pt>
                <c:pt idx="124">
                  <c:v>1.566529562905246</c:v>
                </c:pt>
                <c:pt idx="125">
                  <c:v>1.0327357499714529</c:v>
                </c:pt>
                <c:pt idx="126">
                  <c:v>2.1700214332939529</c:v>
                </c:pt>
                <c:pt idx="127">
                  <c:v>2.0245500188198386</c:v>
                </c:pt>
                <c:pt idx="128">
                  <c:v>1.2167475921120237</c:v>
                </c:pt>
                <c:pt idx="129">
                  <c:v>1.0464317410937725</c:v>
                </c:pt>
                <c:pt idx="130">
                  <c:v>0.76638656318560927</c:v>
                </c:pt>
                <c:pt idx="131">
                  <c:v>1.663004923554672</c:v>
                </c:pt>
                <c:pt idx="132">
                  <c:v>1.2887129743906203</c:v>
                </c:pt>
                <c:pt idx="133">
                  <c:v>0.90845858806522706</c:v>
                </c:pt>
                <c:pt idx="134">
                  <c:v>1.9450328583817476</c:v>
                </c:pt>
                <c:pt idx="135">
                  <c:v>1.1667253920741647</c:v>
                </c:pt>
                <c:pt idx="136">
                  <c:v>0.86398055053183331</c:v>
                </c:pt>
                <c:pt idx="137">
                  <c:v>1.3826723861822974</c:v>
                </c:pt>
                <c:pt idx="138">
                  <c:v>0.88925321172373739</c:v>
                </c:pt>
                <c:pt idx="139">
                  <c:v>1.1243491141643043</c:v>
                </c:pt>
                <c:pt idx="140">
                  <c:v>0.83436658077572645</c:v>
                </c:pt>
                <c:pt idx="141">
                  <c:v>2.0815225044242522</c:v>
                </c:pt>
                <c:pt idx="142">
                  <c:v>0.99512283053803696</c:v>
                </c:pt>
                <c:pt idx="143">
                  <c:v>1.3452500024526488</c:v>
                </c:pt>
                <c:pt idx="144">
                  <c:v>3.5535916526405948</c:v>
                </c:pt>
                <c:pt idx="145">
                  <c:v>1.2045113485110788</c:v>
                </c:pt>
                <c:pt idx="146">
                  <c:v>1.6840025527575071</c:v>
                </c:pt>
                <c:pt idx="147">
                  <c:v>3.5545211731889439</c:v>
                </c:pt>
                <c:pt idx="148">
                  <c:v>1.3526074775739871</c:v>
                </c:pt>
                <c:pt idx="149">
                  <c:v>2.4520125630592498</c:v>
                </c:pt>
                <c:pt idx="150">
                  <c:v>2.4105654024963905</c:v>
                </c:pt>
                <c:pt idx="151">
                  <c:v>1.4668089805540052</c:v>
                </c:pt>
                <c:pt idx="152">
                  <c:v>1.82620325530836</c:v>
                </c:pt>
                <c:pt idx="153">
                  <c:v>0.96125542106774242</c:v>
                </c:pt>
                <c:pt idx="154">
                  <c:v>0.89112905723368718</c:v>
                </c:pt>
                <c:pt idx="155">
                  <c:v>2.1742777767782737</c:v>
                </c:pt>
                <c:pt idx="156">
                  <c:v>1.498369680377406</c:v>
                </c:pt>
                <c:pt idx="157">
                  <c:v>2.2143788589767364</c:v>
                </c:pt>
                <c:pt idx="158">
                  <c:v>1.0748557422030391</c:v>
                </c:pt>
                <c:pt idx="159">
                  <c:v>1.0996070877090718</c:v>
                </c:pt>
                <c:pt idx="160">
                  <c:v>1.2482285813708689</c:v>
                </c:pt>
                <c:pt idx="161">
                  <c:v>2.2115264394618417</c:v>
                </c:pt>
                <c:pt idx="162">
                  <c:v>1.5291938122814672</c:v>
                </c:pt>
                <c:pt idx="163">
                  <c:v>1.5556334699592966</c:v>
                </c:pt>
                <c:pt idx="164">
                  <c:v>2.5321409111624877</c:v>
                </c:pt>
                <c:pt idx="165">
                  <c:v>1.3824071065773198</c:v>
                </c:pt>
                <c:pt idx="166">
                  <c:v>1.743496747291001</c:v>
                </c:pt>
                <c:pt idx="167">
                  <c:v>1.1033248496040202</c:v>
                </c:pt>
                <c:pt idx="168">
                  <c:v>1.1845175638946324</c:v>
                </c:pt>
                <c:pt idx="169">
                  <c:v>0.75942354469376272</c:v>
                </c:pt>
                <c:pt idx="170">
                  <c:v>0.78833286281451642</c:v>
                </c:pt>
                <c:pt idx="171">
                  <c:v>1.6204343560600643</c:v>
                </c:pt>
                <c:pt idx="172">
                  <c:v>1.3970035430534351</c:v>
                </c:pt>
                <c:pt idx="173">
                  <c:v>1.1316221875747827</c:v>
                </c:pt>
                <c:pt idx="174">
                  <c:v>1.0038171875388628</c:v>
                </c:pt>
                <c:pt idx="175">
                  <c:v>2.073144208532677</c:v>
                </c:pt>
                <c:pt idx="176">
                  <c:v>1.8377811872990064</c:v>
                </c:pt>
                <c:pt idx="177">
                  <c:v>0.93259025068622292</c:v>
                </c:pt>
                <c:pt idx="178">
                  <c:v>0.99692316082433641</c:v>
                </c:pt>
                <c:pt idx="179">
                  <c:v>1.1708826764089248</c:v>
                </c:pt>
                <c:pt idx="180">
                  <c:v>1.3264966365571955</c:v>
                </c:pt>
                <c:pt idx="181">
                  <c:v>1.2851779043013534</c:v>
                </c:pt>
                <c:pt idx="182">
                  <c:v>2.0963525607894899</c:v>
                </c:pt>
                <c:pt idx="183">
                  <c:v>1.6482670921672447</c:v>
                </c:pt>
                <c:pt idx="184">
                  <c:v>0.97804724005680721</c:v>
                </c:pt>
                <c:pt idx="185">
                  <c:v>2.1454926596011576</c:v>
                </c:pt>
                <c:pt idx="186">
                  <c:v>1.6570438004614239</c:v>
                </c:pt>
                <c:pt idx="187">
                  <c:v>1.4729345942581238</c:v>
                </c:pt>
                <c:pt idx="188">
                  <c:v>1.9075516000144725</c:v>
                </c:pt>
                <c:pt idx="189">
                  <c:v>1.6435675455156518</c:v>
                </c:pt>
                <c:pt idx="190">
                  <c:v>1.3403423407423323</c:v>
                </c:pt>
                <c:pt idx="191">
                  <c:v>1.043417402326251</c:v>
                </c:pt>
                <c:pt idx="192">
                  <c:v>1.4707687703375583</c:v>
                </c:pt>
                <c:pt idx="193">
                  <c:v>1.5921919803575997</c:v>
                </c:pt>
                <c:pt idx="194">
                  <c:v>1.2323206510881322</c:v>
                </c:pt>
                <c:pt idx="195">
                  <c:v>1.2940473702899169</c:v>
                </c:pt>
                <c:pt idx="196">
                  <c:v>1.4140461491360081</c:v>
                </c:pt>
                <c:pt idx="197">
                  <c:v>2.4557767136654958</c:v>
                </c:pt>
                <c:pt idx="198">
                  <c:v>2.0082140513271902</c:v>
                </c:pt>
                <c:pt idx="199">
                  <c:v>1.1238508943331604</c:v>
                </c:pt>
                <c:pt idx="200">
                  <c:v>3.0208032614642093</c:v>
                </c:pt>
                <c:pt idx="201">
                  <c:v>1.4383694308402637</c:v>
                </c:pt>
                <c:pt idx="202">
                  <c:v>2.3158987464816176</c:v>
                </c:pt>
                <c:pt idx="203">
                  <c:v>1.4510850258044317</c:v>
                </c:pt>
                <c:pt idx="204">
                  <c:v>0.91386336785559774</c:v>
                </c:pt>
                <c:pt idx="205">
                  <c:v>1.8659938440284027</c:v>
                </c:pt>
                <c:pt idx="206">
                  <c:v>1.9392247074885103</c:v>
                </c:pt>
                <c:pt idx="207">
                  <c:v>3.195937498168548</c:v>
                </c:pt>
                <c:pt idx="208">
                  <c:v>1.5027670238347914</c:v>
                </c:pt>
                <c:pt idx="209">
                  <c:v>0.930498367421279</c:v>
                </c:pt>
                <c:pt idx="210">
                  <c:v>1.221222848786867</c:v>
                </c:pt>
                <c:pt idx="211">
                  <c:v>1.1722107715201748</c:v>
                </c:pt>
                <c:pt idx="212">
                  <c:v>2.0682806999461478</c:v>
                </c:pt>
                <c:pt idx="213">
                  <c:v>1.4991551082337349</c:v>
                </c:pt>
                <c:pt idx="214">
                  <c:v>1.7979269991059914</c:v>
                </c:pt>
                <c:pt idx="215">
                  <c:v>1.3434466088207293</c:v>
                </c:pt>
                <c:pt idx="216">
                  <c:v>3.2609756686231099</c:v>
                </c:pt>
                <c:pt idx="217">
                  <c:v>1.9785897050661112</c:v>
                </c:pt>
                <c:pt idx="218">
                  <c:v>1.4711058010611253</c:v>
                </c:pt>
                <c:pt idx="219">
                  <c:v>1.3804565828227224</c:v>
                </c:pt>
                <c:pt idx="220">
                  <c:v>1.1879543801651649</c:v>
                </c:pt>
                <c:pt idx="221">
                  <c:v>0.81521064148522182</c:v>
                </c:pt>
                <c:pt idx="222">
                  <c:v>1.2963833806783613</c:v>
                </c:pt>
                <c:pt idx="223">
                  <c:v>1.9312231698141047</c:v>
                </c:pt>
                <c:pt idx="224">
                  <c:v>1.0924845423390275</c:v>
                </c:pt>
                <c:pt idx="225">
                  <c:v>1.105117956953461</c:v>
                </c:pt>
                <c:pt idx="226">
                  <c:v>1.028924475286769</c:v>
                </c:pt>
                <c:pt idx="227">
                  <c:v>1.5367559478759174</c:v>
                </c:pt>
                <c:pt idx="228">
                  <c:v>1.6252316288865014</c:v>
                </c:pt>
                <c:pt idx="229">
                  <c:v>1.4170975231035559</c:v>
                </c:pt>
                <c:pt idx="230">
                  <c:v>1.4815016021843852</c:v>
                </c:pt>
                <c:pt idx="231">
                  <c:v>1.0066186303931244</c:v>
                </c:pt>
                <c:pt idx="232">
                  <c:v>1.0679849059199351</c:v>
                </c:pt>
                <c:pt idx="233">
                  <c:v>1.5516823191092424</c:v>
                </c:pt>
                <c:pt idx="234">
                  <c:v>1.5607458736372171</c:v>
                </c:pt>
                <c:pt idx="235">
                  <c:v>1.0474162199689858</c:v>
                </c:pt>
                <c:pt idx="236">
                  <c:v>1.1518105203670028</c:v>
                </c:pt>
                <c:pt idx="237">
                  <c:v>1.4973587680030394</c:v>
                </c:pt>
                <c:pt idx="238">
                  <c:v>1.0110032957615702</c:v>
                </c:pt>
                <c:pt idx="239">
                  <c:v>1.9413978757105381</c:v>
                </c:pt>
                <c:pt idx="240">
                  <c:v>1.4158161309971318</c:v>
                </c:pt>
                <c:pt idx="241">
                  <c:v>1.6448856632519249</c:v>
                </c:pt>
                <c:pt idx="242">
                  <c:v>1.7648334650920334</c:v>
                </c:pt>
                <c:pt idx="243">
                  <c:v>1.2642037337544312</c:v>
                </c:pt>
                <c:pt idx="244">
                  <c:v>1.0992589728720519</c:v>
                </c:pt>
                <c:pt idx="245">
                  <c:v>1.3543347060169559</c:v>
                </c:pt>
                <c:pt idx="246">
                  <c:v>1.1245735434721185</c:v>
                </c:pt>
                <c:pt idx="247">
                  <c:v>2.5211660349067726</c:v>
                </c:pt>
                <c:pt idx="248">
                  <c:v>1.0491188790132173</c:v>
                </c:pt>
                <c:pt idx="249">
                  <c:v>2.3104884762802422</c:v>
                </c:pt>
                <c:pt idx="250">
                  <c:v>1.523378487128527</c:v>
                </c:pt>
                <c:pt idx="251">
                  <c:v>2.1334920739811265</c:v>
                </c:pt>
                <c:pt idx="252">
                  <c:v>1.4595326699142732</c:v>
                </c:pt>
                <c:pt idx="253">
                  <c:v>1.2433959345214896</c:v>
                </c:pt>
                <c:pt idx="254">
                  <c:v>2.3288615642565405</c:v>
                </c:pt>
                <c:pt idx="255">
                  <c:v>0.99563837992705273</c:v>
                </c:pt>
                <c:pt idx="256">
                  <c:v>1.1000913729368151</c:v>
                </c:pt>
                <c:pt idx="257">
                  <c:v>3.1627033366992681</c:v>
                </c:pt>
                <c:pt idx="258">
                  <c:v>2.3631868079984204</c:v>
                </c:pt>
                <c:pt idx="259">
                  <c:v>1.1380451917725651</c:v>
                </c:pt>
                <c:pt idx="260">
                  <c:v>1.4627022340241695</c:v>
                </c:pt>
                <c:pt idx="261">
                  <c:v>1.1883521614683201</c:v>
                </c:pt>
                <c:pt idx="262">
                  <c:v>1.1174293598903422</c:v>
                </c:pt>
                <c:pt idx="263">
                  <c:v>1.230282480434995</c:v>
                </c:pt>
                <c:pt idx="264">
                  <c:v>1.2288291018129756</c:v>
                </c:pt>
                <c:pt idx="265">
                  <c:v>1.3826011198697297</c:v>
                </c:pt>
                <c:pt idx="266">
                  <c:v>1.6315019676838409</c:v>
                </c:pt>
                <c:pt idx="267">
                  <c:v>2.3645688582099629</c:v>
                </c:pt>
                <c:pt idx="268">
                  <c:v>2.1704635707675317</c:v>
                </c:pt>
                <c:pt idx="269">
                  <c:v>1.7315968276956288</c:v>
                </c:pt>
                <c:pt idx="270">
                  <c:v>1.6609459067353283</c:v>
                </c:pt>
                <c:pt idx="271">
                  <c:v>1.0460961327649267</c:v>
                </c:pt>
                <c:pt idx="272">
                  <c:v>1.6611038804482792</c:v>
                </c:pt>
                <c:pt idx="273">
                  <c:v>1.3824093370767574</c:v>
                </c:pt>
                <c:pt idx="274">
                  <c:v>1.6710489211664228</c:v>
                </c:pt>
                <c:pt idx="275">
                  <c:v>2.4975891815709796</c:v>
                </c:pt>
                <c:pt idx="276">
                  <c:v>1.5241795891798935</c:v>
                </c:pt>
                <c:pt idx="277">
                  <c:v>1.4985815938377096</c:v>
                </c:pt>
                <c:pt idx="278">
                  <c:v>1.2636401248012739</c:v>
                </c:pt>
                <c:pt idx="279">
                  <c:v>1.228200297130396</c:v>
                </c:pt>
                <c:pt idx="280">
                  <c:v>1.9618443237659087</c:v>
                </c:pt>
                <c:pt idx="281">
                  <c:v>2.1360962075731766</c:v>
                </c:pt>
                <c:pt idx="282">
                  <c:v>3.3640421506252753</c:v>
                </c:pt>
                <c:pt idx="283">
                  <c:v>1.5080042468908788</c:v>
                </c:pt>
                <c:pt idx="284">
                  <c:v>1.2458507397250489</c:v>
                </c:pt>
                <c:pt idx="285">
                  <c:v>1.2732545040605523</c:v>
                </c:pt>
                <c:pt idx="286">
                  <c:v>1.2982589833866609</c:v>
                </c:pt>
                <c:pt idx="287">
                  <c:v>1.3472064569892162</c:v>
                </c:pt>
                <c:pt idx="288">
                  <c:v>1.9179166068506375</c:v>
                </c:pt>
                <c:pt idx="289">
                  <c:v>1.0208002208982458</c:v>
                </c:pt>
                <c:pt idx="290">
                  <c:v>1.0273699862721926</c:v>
                </c:pt>
                <c:pt idx="291">
                  <c:v>1.2349199988503128</c:v>
                </c:pt>
                <c:pt idx="292">
                  <c:v>1.2473791693650376</c:v>
                </c:pt>
                <c:pt idx="293">
                  <c:v>2.5746840863797944</c:v>
                </c:pt>
                <c:pt idx="294">
                  <c:v>1.8195523861788514</c:v>
                </c:pt>
                <c:pt idx="295">
                  <c:v>1.313572388233599</c:v>
                </c:pt>
                <c:pt idx="296">
                  <c:v>0.77590393157443971</c:v>
                </c:pt>
                <c:pt idx="297">
                  <c:v>3.2743210435146697</c:v>
                </c:pt>
                <c:pt idx="298">
                  <c:v>2.3591649132841206</c:v>
                </c:pt>
                <c:pt idx="299">
                  <c:v>1.1547433574403285</c:v>
                </c:pt>
                <c:pt idx="300">
                  <c:v>1.0754032494424985</c:v>
                </c:pt>
                <c:pt idx="301">
                  <c:v>1.363271847227024</c:v>
                </c:pt>
                <c:pt idx="302">
                  <c:v>0.59193982881180507</c:v>
                </c:pt>
                <c:pt idx="303">
                  <c:v>0.69087809016266666</c:v>
                </c:pt>
                <c:pt idx="304">
                  <c:v>1.8735225133855864</c:v>
                </c:pt>
                <c:pt idx="305">
                  <c:v>2.6893207653966935</c:v>
                </c:pt>
                <c:pt idx="306">
                  <c:v>0.67531358935647934</c:v>
                </c:pt>
                <c:pt idx="307">
                  <c:v>1.1338064876668505</c:v>
                </c:pt>
                <c:pt idx="308">
                  <c:v>1.780513556462318</c:v>
                </c:pt>
                <c:pt idx="309">
                  <c:v>0.93127861014378788</c:v>
                </c:pt>
                <c:pt idx="310">
                  <c:v>1.482524832364269</c:v>
                </c:pt>
                <c:pt idx="311">
                  <c:v>0.88734346076711634</c:v>
                </c:pt>
                <c:pt idx="312">
                  <c:v>2.3695821793546483</c:v>
                </c:pt>
                <c:pt idx="313">
                  <c:v>0.8982082782414883</c:v>
                </c:pt>
                <c:pt idx="314">
                  <c:v>1.0797335060322935</c:v>
                </c:pt>
                <c:pt idx="315">
                  <c:v>1.7477445082750067</c:v>
                </c:pt>
                <c:pt idx="316">
                  <c:v>1.182504254180814</c:v>
                </c:pt>
                <c:pt idx="317">
                  <c:v>1.136304835907016</c:v>
                </c:pt>
                <c:pt idx="318">
                  <c:v>1.3100002808161353</c:v>
                </c:pt>
                <c:pt idx="319">
                  <c:v>1.5909672349986537</c:v>
                </c:pt>
                <c:pt idx="320">
                  <c:v>1.9263205225455902</c:v>
                </c:pt>
                <c:pt idx="321">
                  <c:v>1.925700082277366</c:v>
                </c:pt>
                <c:pt idx="322">
                  <c:v>0.77107243339142284</c:v>
                </c:pt>
                <c:pt idx="323">
                  <c:v>1.6086845805352519</c:v>
                </c:pt>
                <c:pt idx="324">
                  <c:v>1.2915892206702035</c:v>
                </c:pt>
                <c:pt idx="325">
                  <c:v>0.92266623254784674</c:v>
                </c:pt>
                <c:pt idx="326">
                  <c:v>2.1766973119650821</c:v>
                </c:pt>
                <c:pt idx="327">
                  <c:v>0.75887212839711293</c:v>
                </c:pt>
                <c:pt idx="328">
                  <c:v>1.9793464229780207</c:v>
                </c:pt>
                <c:pt idx="329">
                  <c:v>0.77875796930342378</c:v>
                </c:pt>
                <c:pt idx="330">
                  <c:v>0.7009457218440206</c:v>
                </c:pt>
                <c:pt idx="331">
                  <c:v>0.52814689230590439</c:v>
                </c:pt>
                <c:pt idx="332">
                  <c:v>1.5826624111603054</c:v>
                </c:pt>
                <c:pt idx="333">
                  <c:v>0.91205137686976778</c:v>
                </c:pt>
                <c:pt idx="334">
                  <c:v>1.15867046776327</c:v>
                </c:pt>
                <c:pt idx="335">
                  <c:v>1.1499704304013492</c:v>
                </c:pt>
                <c:pt idx="336">
                  <c:v>1.0595112559506754</c:v>
                </c:pt>
                <c:pt idx="337">
                  <c:v>0.74926125270120281</c:v>
                </c:pt>
                <c:pt idx="338">
                  <c:v>1.4481194462737734</c:v>
                </c:pt>
                <c:pt idx="339">
                  <c:v>1.71981107222193</c:v>
                </c:pt>
                <c:pt idx="340">
                  <c:v>0.94527893219693682</c:v>
                </c:pt>
                <c:pt idx="341">
                  <c:v>1.6743751578042938</c:v>
                </c:pt>
                <c:pt idx="342">
                  <c:v>1.078906385948996</c:v>
                </c:pt>
                <c:pt idx="343">
                  <c:v>0.8436780049211714</c:v>
                </c:pt>
                <c:pt idx="344">
                  <c:v>1.2028239739478459</c:v>
                </c:pt>
                <c:pt idx="345">
                  <c:v>1.1985107977123119</c:v>
                </c:pt>
                <c:pt idx="346">
                  <c:v>1.2915396318640402</c:v>
                </c:pt>
                <c:pt idx="347">
                  <c:v>2.3844244543349959</c:v>
                </c:pt>
                <c:pt idx="348">
                  <c:v>1.2251598973277626</c:v>
                </c:pt>
                <c:pt idx="349">
                  <c:v>1.5883207013101781</c:v>
                </c:pt>
                <c:pt idx="350">
                  <c:v>1.2710048678949484</c:v>
                </c:pt>
                <c:pt idx="351">
                  <c:v>0.89748839892070509</c:v>
                </c:pt>
                <c:pt idx="352">
                  <c:v>1.0577280712955681</c:v>
                </c:pt>
                <c:pt idx="353">
                  <c:v>0.96396926187020515</c:v>
                </c:pt>
                <c:pt idx="354">
                  <c:v>0.75591341408204549</c:v>
                </c:pt>
                <c:pt idx="355">
                  <c:v>0.88202784742785223</c:v>
                </c:pt>
                <c:pt idx="356">
                  <c:v>1.8548019124394837</c:v>
                </c:pt>
                <c:pt idx="357">
                  <c:v>1.3791945228644165</c:v>
                </c:pt>
                <c:pt idx="358">
                  <c:v>0.8035835556779144</c:v>
                </c:pt>
                <c:pt idx="359">
                  <c:v>1.0246292365947456</c:v>
                </c:pt>
                <c:pt idx="360">
                  <c:v>0.94322740034838826</c:v>
                </c:pt>
                <c:pt idx="361">
                  <c:v>0.92425991449880229</c:v>
                </c:pt>
                <c:pt idx="362">
                  <c:v>1.5946063541758542</c:v>
                </c:pt>
                <c:pt idx="363">
                  <c:v>0.57733779757264192</c:v>
                </c:pt>
                <c:pt idx="364">
                  <c:v>1.160262035708302</c:v>
                </c:pt>
                <c:pt idx="365">
                  <c:v>1.2090226898717429</c:v>
                </c:pt>
                <c:pt idx="366">
                  <c:v>1.4092214986967548</c:v>
                </c:pt>
                <c:pt idx="367">
                  <c:v>1.6212315131548856</c:v>
                </c:pt>
                <c:pt idx="368">
                  <c:v>1.2863300658196151</c:v>
                </c:pt>
                <c:pt idx="369">
                  <c:v>1.2338242176420604</c:v>
                </c:pt>
                <c:pt idx="370">
                  <c:v>1.3207533521693609</c:v>
                </c:pt>
                <c:pt idx="371">
                  <c:v>1.2873213176211111</c:v>
                </c:pt>
                <c:pt idx="372">
                  <c:v>1.2822120596321658</c:v>
                </c:pt>
                <c:pt idx="373">
                  <c:v>1.7348356818458937</c:v>
                </c:pt>
                <c:pt idx="374">
                  <c:v>1.0027547246523392</c:v>
                </c:pt>
                <c:pt idx="375">
                  <c:v>1.4281374589620874</c:v>
                </c:pt>
                <c:pt idx="376">
                  <c:v>1.6097982627094325</c:v>
                </c:pt>
                <c:pt idx="377">
                  <c:v>1.6095432336543336</c:v>
                </c:pt>
                <c:pt idx="378">
                  <c:v>1.5091417295066749</c:v>
                </c:pt>
                <c:pt idx="379">
                  <c:v>0.9191097600870578</c:v>
                </c:pt>
                <c:pt idx="380">
                  <c:v>1.2380551242977422</c:v>
                </c:pt>
                <c:pt idx="381">
                  <c:v>1.3220219704123171</c:v>
                </c:pt>
                <c:pt idx="382">
                  <c:v>1.1033470920485728</c:v>
                </c:pt>
                <c:pt idx="383">
                  <c:v>1.2110951488787145</c:v>
                </c:pt>
                <c:pt idx="384">
                  <c:v>0.90912987156174729</c:v>
                </c:pt>
                <c:pt idx="385">
                  <c:v>2.8085479959120203</c:v>
                </c:pt>
                <c:pt idx="386">
                  <c:v>1.4542218263922846</c:v>
                </c:pt>
                <c:pt idx="387">
                  <c:v>1.7111839494685008</c:v>
                </c:pt>
                <c:pt idx="388">
                  <c:v>2.7042394464603667</c:v>
                </c:pt>
                <c:pt idx="389">
                  <c:v>1.1199832516922894</c:v>
                </c:pt>
                <c:pt idx="390">
                  <c:v>1.0252633910887901</c:v>
                </c:pt>
                <c:pt idx="391">
                  <c:v>0.98602601257081957</c:v>
                </c:pt>
                <c:pt idx="392">
                  <c:v>0.995672416206694</c:v>
                </c:pt>
                <c:pt idx="393">
                  <c:v>1.5803831111217208</c:v>
                </c:pt>
                <c:pt idx="394">
                  <c:v>1.0866580312832153</c:v>
                </c:pt>
                <c:pt idx="395">
                  <c:v>1.5706977995201787</c:v>
                </c:pt>
                <c:pt idx="396">
                  <c:v>1.1917742663778288</c:v>
                </c:pt>
                <c:pt idx="397">
                  <c:v>1.4701680365546874</c:v>
                </c:pt>
                <c:pt idx="398">
                  <c:v>1.392479309072681</c:v>
                </c:pt>
                <c:pt idx="399">
                  <c:v>1.2338562590344651</c:v>
                </c:pt>
                <c:pt idx="400">
                  <c:v>1.4527979580844779</c:v>
                </c:pt>
                <c:pt idx="401">
                  <c:v>1.3121131572339733</c:v>
                </c:pt>
                <c:pt idx="402">
                  <c:v>1.0722578773310925</c:v>
                </c:pt>
                <c:pt idx="403">
                  <c:v>1.1982153620747478</c:v>
                </c:pt>
                <c:pt idx="404">
                  <c:v>1.0755620407009139</c:v>
                </c:pt>
                <c:pt idx="405">
                  <c:v>2.2383602976914756</c:v>
                </c:pt>
                <c:pt idx="406">
                  <c:v>2.4569696865487205</c:v>
                </c:pt>
                <c:pt idx="407">
                  <c:v>1.3463361991578249</c:v>
                </c:pt>
                <c:pt idx="408">
                  <c:v>2.4862348764243891</c:v>
                </c:pt>
                <c:pt idx="409">
                  <c:v>1.1070259934262177</c:v>
                </c:pt>
                <c:pt idx="410">
                  <c:v>1.1406390759065341</c:v>
                </c:pt>
                <c:pt idx="411">
                  <c:v>0.88568711802732436</c:v>
                </c:pt>
                <c:pt idx="412">
                  <c:v>1.2502640966599479</c:v>
                </c:pt>
                <c:pt idx="413">
                  <c:v>1.0715478632663806</c:v>
                </c:pt>
                <c:pt idx="414">
                  <c:v>1.7625346624313021</c:v>
                </c:pt>
                <c:pt idx="415">
                  <c:v>1.9705041527533564</c:v>
                </c:pt>
                <c:pt idx="416">
                  <c:v>1.8425732058728266</c:v>
                </c:pt>
                <c:pt idx="417">
                  <c:v>1.8515917542062343</c:v>
                </c:pt>
                <c:pt idx="418">
                  <c:v>1.7652049289851157</c:v>
                </c:pt>
                <c:pt idx="419">
                  <c:v>1.5446242529214134</c:v>
                </c:pt>
                <c:pt idx="420">
                  <c:v>1.5837050550589717</c:v>
                </c:pt>
                <c:pt idx="421">
                  <c:v>1.5850411633897339</c:v>
                </c:pt>
                <c:pt idx="422">
                  <c:v>1.1893214652550286</c:v>
                </c:pt>
                <c:pt idx="423">
                  <c:v>1.5232590849616474</c:v>
                </c:pt>
                <c:pt idx="424">
                  <c:v>1.0892994330825474</c:v>
                </c:pt>
                <c:pt idx="425">
                  <c:v>1.3979562761004578</c:v>
                </c:pt>
                <c:pt idx="426">
                  <c:v>1.0759316617988823</c:v>
                </c:pt>
                <c:pt idx="427">
                  <c:v>1.3989237701711514</c:v>
                </c:pt>
                <c:pt idx="428">
                  <c:v>1.3089952318224751</c:v>
                </c:pt>
                <c:pt idx="429">
                  <c:v>1.1525116590674731</c:v>
                </c:pt>
                <c:pt idx="430">
                  <c:v>1.3197471515141741</c:v>
                </c:pt>
                <c:pt idx="431">
                  <c:v>1.9767714767380218</c:v>
                </c:pt>
                <c:pt idx="432">
                  <c:v>1.4670519111396887</c:v>
                </c:pt>
                <c:pt idx="433">
                  <c:v>2.2093036715557339</c:v>
                </c:pt>
                <c:pt idx="434">
                  <c:v>1.532111221461109</c:v>
                </c:pt>
                <c:pt idx="435">
                  <c:v>2.0122547523554739</c:v>
                </c:pt>
                <c:pt idx="436">
                  <c:v>1.538587181111934</c:v>
                </c:pt>
                <c:pt idx="437">
                  <c:v>1.2846098705256535</c:v>
                </c:pt>
                <c:pt idx="438">
                  <c:v>1.6171418021977335</c:v>
                </c:pt>
                <c:pt idx="439">
                  <c:v>1.098401580132679</c:v>
                </c:pt>
                <c:pt idx="440">
                  <c:v>1.8486728841894671</c:v>
                </c:pt>
                <c:pt idx="441">
                  <c:v>2.3939658507308623</c:v>
                </c:pt>
                <c:pt idx="442">
                  <c:v>1.6030860972645957</c:v>
                </c:pt>
                <c:pt idx="443">
                  <c:v>0.98928096604499227</c:v>
                </c:pt>
                <c:pt idx="444">
                  <c:v>1.1685488326752043</c:v>
                </c:pt>
                <c:pt idx="445">
                  <c:v>1.5468018069827936</c:v>
                </c:pt>
                <c:pt idx="446">
                  <c:v>1.0578407400218175</c:v>
                </c:pt>
                <c:pt idx="447">
                  <c:v>1.2461404388435671</c:v>
                </c:pt>
                <c:pt idx="448">
                  <c:v>1.3833858574225866</c:v>
                </c:pt>
                <c:pt idx="449">
                  <c:v>1.4657488069141003</c:v>
                </c:pt>
                <c:pt idx="450">
                  <c:v>1.6944193239447543</c:v>
                </c:pt>
                <c:pt idx="451">
                  <c:v>1.3143014270937114</c:v>
                </c:pt>
                <c:pt idx="452">
                  <c:v>2.1037851656124937</c:v>
                </c:pt>
                <c:pt idx="453">
                  <c:v>1.239957400746744</c:v>
                </c:pt>
                <c:pt idx="454">
                  <c:v>1.2893371093652768</c:v>
                </c:pt>
                <c:pt idx="455">
                  <c:v>1.1485321095294798</c:v>
                </c:pt>
                <c:pt idx="456">
                  <c:v>3.8144251835053593</c:v>
                </c:pt>
                <c:pt idx="457">
                  <c:v>1.4579321956283819</c:v>
                </c:pt>
                <c:pt idx="458">
                  <c:v>0.73549937243943453</c:v>
                </c:pt>
                <c:pt idx="459">
                  <c:v>1.8923577810240459</c:v>
                </c:pt>
                <c:pt idx="460">
                  <c:v>2.0853622879724876</c:v>
                </c:pt>
                <c:pt idx="461">
                  <c:v>1.3982358762244338</c:v>
                </c:pt>
                <c:pt idx="462">
                  <c:v>1.2067556631181837</c:v>
                </c:pt>
                <c:pt idx="463">
                  <c:v>1.4072409026208053</c:v>
                </c:pt>
                <c:pt idx="464">
                  <c:v>2.2920045529061288</c:v>
                </c:pt>
                <c:pt idx="465">
                  <c:v>1.3155168409187319</c:v>
                </c:pt>
                <c:pt idx="466">
                  <c:v>3.4265126017246148</c:v>
                </c:pt>
                <c:pt idx="467">
                  <c:v>1.562304588269682</c:v>
                </c:pt>
                <c:pt idx="468">
                  <c:v>1.3868014425009585</c:v>
                </c:pt>
                <c:pt idx="469">
                  <c:v>2.5554765750591892</c:v>
                </c:pt>
                <c:pt idx="470">
                  <c:v>2.4897701722488979</c:v>
                </c:pt>
                <c:pt idx="471">
                  <c:v>0.85204900923134375</c:v>
                </c:pt>
                <c:pt idx="472">
                  <c:v>2.1680081924411092</c:v>
                </c:pt>
                <c:pt idx="473">
                  <c:v>1.6696442960276288</c:v>
                </c:pt>
                <c:pt idx="474">
                  <c:v>1.4135010334622709</c:v>
                </c:pt>
                <c:pt idx="475">
                  <c:v>1.7288008185992125</c:v>
                </c:pt>
                <c:pt idx="476">
                  <c:v>1.2055323510599045</c:v>
                </c:pt>
                <c:pt idx="477">
                  <c:v>1.2293200469084178</c:v>
                </c:pt>
                <c:pt idx="478">
                  <c:v>1.5593182916229467</c:v>
                </c:pt>
                <c:pt idx="479">
                  <c:v>1.327475720329828</c:v>
                </c:pt>
                <c:pt idx="480">
                  <c:v>1.7849301774132811</c:v>
                </c:pt>
                <c:pt idx="481">
                  <c:v>2.6034747715149646</c:v>
                </c:pt>
                <c:pt idx="482">
                  <c:v>1.4147784608430447</c:v>
                </c:pt>
                <c:pt idx="483">
                  <c:v>1.0083302057177299</c:v>
                </c:pt>
                <c:pt idx="484">
                  <c:v>1.6507979276946403</c:v>
                </c:pt>
                <c:pt idx="485">
                  <c:v>1.2786465272471341</c:v>
                </c:pt>
                <c:pt idx="486">
                  <c:v>1.3158886585560319</c:v>
                </c:pt>
                <c:pt idx="487">
                  <c:v>0.98536004186592052</c:v>
                </c:pt>
                <c:pt idx="488">
                  <c:v>1.1349771113136597</c:v>
                </c:pt>
                <c:pt idx="489">
                  <c:v>1.3715654734842562</c:v>
                </c:pt>
                <c:pt idx="490">
                  <c:v>1.2295786038908885</c:v>
                </c:pt>
                <c:pt idx="491">
                  <c:v>1.4441380478579369</c:v>
                </c:pt>
                <c:pt idx="492">
                  <c:v>1.465104246527793</c:v>
                </c:pt>
                <c:pt idx="493">
                  <c:v>1.3888189200518932</c:v>
                </c:pt>
                <c:pt idx="494">
                  <c:v>1.0291867148871234</c:v>
                </c:pt>
                <c:pt idx="495">
                  <c:v>1.795194834288393</c:v>
                </c:pt>
                <c:pt idx="496">
                  <c:v>1.6378558921268329</c:v>
                </c:pt>
                <c:pt idx="497">
                  <c:v>1.7148040160658875</c:v>
                </c:pt>
                <c:pt idx="498">
                  <c:v>0.99075747069597764</c:v>
                </c:pt>
                <c:pt idx="499">
                  <c:v>2.2103261657789441</c:v>
                </c:pt>
                <c:pt idx="500">
                  <c:v>1.2102228694105017</c:v>
                </c:pt>
                <c:pt idx="501">
                  <c:v>1.3352806609196406</c:v>
                </c:pt>
                <c:pt idx="502">
                  <c:v>2.4595834165986727</c:v>
                </c:pt>
                <c:pt idx="503">
                  <c:v>1.2278433294070075</c:v>
                </c:pt>
                <c:pt idx="504">
                  <c:v>1.9221541514284635</c:v>
                </c:pt>
                <c:pt idx="505">
                  <c:v>1.9511334055332152</c:v>
                </c:pt>
                <c:pt idx="506">
                  <c:v>2.7130873087080101</c:v>
                </c:pt>
                <c:pt idx="507">
                  <c:v>1.6078994740171562</c:v>
                </c:pt>
                <c:pt idx="508">
                  <c:v>1.6977798189129287</c:v>
                </c:pt>
                <c:pt idx="509">
                  <c:v>1.2810125023006407</c:v>
                </c:pt>
                <c:pt idx="510">
                  <c:v>1.8310090174359657</c:v>
                </c:pt>
                <c:pt idx="511">
                  <c:v>1.5899578786279329</c:v>
                </c:pt>
                <c:pt idx="512">
                  <c:v>1.3108617283793096</c:v>
                </c:pt>
                <c:pt idx="513">
                  <c:v>0.94549816915439311</c:v>
                </c:pt>
                <c:pt idx="514">
                  <c:v>1.1239144556122269</c:v>
                </c:pt>
                <c:pt idx="515">
                  <c:v>1.942949965820612</c:v>
                </c:pt>
                <c:pt idx="516">
                  <c:v>1.2787464301366382</c:v>
                </c:pt>
                <c:pt idx="517">
                  <c:v>1.2429146458820708</c:v>
                </c:pt>
                <c:pt idx="518">
                  <c:v>1.2609165556504285</c:v>
                </c:pt>
                <c:pt idx="519">
                  <c:v>2.4088594205804799</c:v>
                </c:pt>
                <c:pt idx="520">
                  <c:v>2.4294475946299876</c:v>
                </c:pt>
                <c:pt idx="521">
                  <c:v>1.1946908587561451</c:v>
                </c:pt>
                <c:pt idx="522">
                  <c:v>1.8358798496232751</c:v>
                </c:pt>
                <c:pt idx="523">
                  <c:v>2.262822135728229</c:v>
                </c:pt>
                <c:pt idx="524">
                  <c:v>1.431909566389826</c:v>
                </c:pt>
                <c:pt idx="525">
                  <c:v>2.3180649900971653</c:v>
                </c:pt>
                <c:pt idx="526">
                  <c:v>1.3909496875263685</c:v>
                </c:pt>
                <c:pt idx="527">
                  <c:v>2.0274290463868687</c:v>
                </c:pt>
                <c:pt idx="528">
                  <c:v>1.2612988463645656</c:v>
                </c:pt>
                <c:pt idx="529">
                  <c:v>1.2372178407576178</c:v>
                </c:pt>
                <c:pt idx="530">
                  <c:v>1.391929535851935</c:v>
                </c:pt>
                <c:pt idx="531">
                  <c:v>2.4595259403514356</c:v>
                </c:pt>
                <c:pt idx="532">
                  <c:v>1.3044763661012575</c:v>
                </c:pt>
                <c:pt idx="533">
                  <c:v>1.6065474758604505</c:v>
                </c:pt>
                <c:pt idx="534">
                  <c:v>1.4321884735818076</c:v>
                </c:pt>
                <c:pt idx="535">
                  <c:v>1.0556193972140946</c:v>
                </c:pt>
                <c:pt idx="536">
                  <c:v>1.18640103615186</c:v>
                </c:pt>
                <c:pt idx="537">
                  <c:v>0.98644957572268221</c:v>
                </c:pt>
                <c:pt idx="538">
                  <c:v>1.1417511801547306</c:v>
                </c:pt>
                <c:pt idx="539">
                  <c:v>1.138111421784342</c:v>
                </c:pt>
                <c:pt idx="540">
                  <c:v>1.4357322027623323</c:v>
                </c:pt>
                <c:pt idx="541">
                  <c:v>1.543212697455963</c:v>
                </c:pt>
                <c:pt idx="542">
                  <c:v>2.3008357235946888</c:v>
                </c:pt>
                <c:pt idx="543">
                  <c:v>1.5073453755633224</c:v>
                </c:pt>
                <c:pt idx="544">
                  <c:v>1.9979455966728463</c:v>
                </c:pt>
                <c:pt idx="545">
                  <c:v>1.1601610437274934</c:v>
                </c:pt>
                <c:pt idx="546">
                  <c:v>1.1522785688913797</c:v>
                </c:pt>
                <c:pt idx="547">
                  <c:v>1.2834800795225287</c:v>
                </c:pt>
                <c:pt idx="548">
                  <c:v>1.3406859860594691</c:v>
                </c:pt>
                <c:pt idx="549">
                  <c:v>1.1494991201830469</c:v>
                </c:pt>
                <c:pt idx="550">
                  <c:v>1.7090901051133509</c:v>
                </c:pt>
                <c:pt idx="551">
                  <c:v>1.693644508393332</c:v>
                </c:pt>
                <c:pt idx="552">
                  <c:v>1.2452010710759769</c:v>
                </c:pt>
                <c:pt idx="553">
                  <c:v>0.8184031296047114</c:v>
                </c:pt>
                <c:pt idx="554">
                  <c:v>0.99136273760960736</c:v>
                </c:pt>
                <c:pt idx="555">
                  <c:v>1.190139479777099</c:v>
                </c:pt>
                <c:pt idx="556">
                  <c:v>1.593216379605741</c:v>
                </c:pt>
                <c:pt idx="557">
                  <c:v>2.1001366386763185</c:v>
                </c:pt>
                <c:pt idx="558">
                  <c:v>1.394992522569509</c:v>
                </c:pt>
                <c:pt idx="559">
                  <c:v>1.6252387810405784</c:v>
                </c:pt>
                <c:pt idx="560">
                  <c:v>1.3182633418369278</c:v>
                </c:pt>
                <c:pt idx="561">
                  <c:v>1.2332135856432027</c:v>
                </c:pt>
                <c:pt idx="562">
                  <c:v>0.95259240236654841</c:v>
                </c:pt>
                <c:pt idx="563">
                  <c:v>1.2994381473058205</c:v>
                </c:pt>
                <c:pt idx="564">
                  <c:v>1.390761687850625</c:v>
                </c:pt>
                <c:pt idx="565">
                  <c:v>1.273040273635168</c:v>
                </c:pt>
                <c:pt idx="566">
                  <c:v>1.3078903933581378</c:v>
                </c:pt>
                <c:pt idx="567">
                  <c:v>1.297595510655418</c:v>
                </c:pt>
                <c:pt idx="568">
                  <c:v>2.3548416778004548</c:v>
                </c:pt>
                <c:pt idx="569">
                  <c:v>0.96614462546382185</c:v>
                </c:pt>
                <c:pt idx="570">
                  <c:v>1.6780080287273902</c:v>
                </c:pt>
                <c:pt idx="571">
                  <c:v>1.3757879263291035</c:v>
                </c:pt>
                <c:pt idx="572">
                  <c:v>1.3807143695613211</c:v>
                </c:pt>
                <c:pt idx="573">
                  <c:v>1.0684919561494091</c:v>
                </c:pt>
                <c:pt idx="574">
                  <c:v>1.7961616376755372</c:v>
                </c:pt>
                <c:pt idx="575">
                  <c:v>1.9647062541312095</c:v>
                </c:pt>
                <c:pt idx="576">
                  <c:v>1.2312619293582829</c:v>
                </c:pt>
                <c:pt idx="577">
                  <c:v>1.8136543523841706</c:v>
                </c:pt>
                <c:pt idx="578">
                  <c:v>1.4268250172220118</c:v>
                </c:pt>
                <c:pt idx="579">
                  <c:v>2.4655984797241701</c:v>
                </c:pt>
                <c:pt idx="580">
                  <c:v>1.1973794450724518</c:v>
                </c:pt>
                <c:pt idx="581">
                  <c:v>1.7411880205512915</c:v>
                </c:pt>
                <c:pt idx="582">
                  <c:v>0.9281902181217162</c:v>
                </c:pt>
                <c:pt idx="583">
                  <c:v>1.1102320468080096</c:v>
                </c:pt>
                <c:pt idx="584">
                  <c:v>1.2489959330697966</c:v>
                </c:pt>
                <c:pt idx="585">
                  <c:v>1.5588653230222598</c:v>
                </c:pt>
                <c:pt idx="586">
                  <c:v>1.8981372868694839</c:v>
                </c:pt>
                <c:pt idx="587">
                  <c:v>1.2031480003289845</c:v>
                </c:pt>
                <c:pt idx="588">
                  <c:v>2.1450920819279586</c:v>
                </c:pt>
                <c:pt idx="589">
                  <c:v>1.556257794487407</c:v>
                </c:pt>
                <c:pt idx="590">
                  <c:v>1.7116267240525735</c:v>
                </c:pt>
                <c:pt idx="591">
                  <c:v>1.0091283659711794</c:v>
                </c:pt>
                <c:pt idx="592">
                  <c:v>1.5158576546376814</c:v>
                </c:pt>
                <c:pt idx="593">
                  <c:v>1.7824190130386808</c:v>
                </c:pt>
                <c:pt idx="594">
                  <c:v>1.3906732057908386</c:v>
                </c:pt>
                <c:pt idx="595">
                  <c:v>1.6743245055675844</c:v>
                </c:pt>
                <c:pt idx="596">
                  <c:v>1.2762879190054097</c:v>
                </c:pt>
                <c:pt idx="597">
                  <c:v>2.2103952612875117</c:v>
                </c:pt>
                <c:pt idx="598">
                  <c:v>1.3434522225638044</c:v>
                </c:pt>
                <c:pt idx="599">
                  <c:v>2.0359601800588707</c:v>
                </c:pt>
                <c:pt idx="600">
                  <c:v>1.5388927213482353</c:v>
                </c:pt>
                <c:pt idx="601">
                  <c:v>1.3576841222947493</c:v>
                </c:pt>
                <c:pt idx="602">
                  <c:v>0.9470090047826738</c:v>
                </c:pt>
                <c:pt idx="603">
                  <c:v>1.3394743288200148</c:v>
                </c:pt>
                <c:pt idx="604">
                  <c:v>1.0446996932750712</c:v>
                </c:pt>
                <c:pt idx="605">
                  <c:v>1.9983931802908055</c:v>
                </c:pt>
                <c:pt idx="606">
                  <c:v>1.8830116409727389</c:v>
                </c:pt>
                <c:pt idx="607">
                  <c:v>1.5353426299433894</c:v>
                </c:pt>
                <c:pt idx="608">
                  <c:v>2.0979942863855321</c:v>
                </c:pt>
                <c:pt idx="609">
                  <c:v>1.5927767314368362</c:v>
                </c:pt>
                <c:pt idx="610">
                  <c:v>1.3431818134550142</c:v>
                </c:pt>
                <c:pt idx="611">
                  <c:v>1.4524431343528597</c:v>
                </c:pt>
                <c:pt idx="612">
                  <c:v>1.5753728813971868</c:v>
                </c:pt>
                <c:pt idx="613">
                  <c:v>1.4986830950904366</c:v>
                </c:pt>
                <c:pt idx="614">
                  <c:v>1.4823081999636158</c:v>
                </c:pt>
                <c:pt idx="615">
                  <c:v>1.1710961779160145</c:v>
                </c:pt>
                <c:pt idx="616">
                  <c:v>1.1357354115126572</c:v>
                </c:pt>
                <c:pt idx="617">
                  <c:v>1.6628407660148601</c:v>
                </c:pt>
                <c:pt idx="618">
                  <c:v>1.3254377089011737</c:v>
                </c:pt>
                <c:pt idx="619">
                  <c:v>1.2409318449922688</c:v>
                </c:pt>
                <c:pt idx="620">
                  <c:v>2.2177471133894957</c:v>
                </c:pt>
                <c:pt idx="621">
                  <c:v>3.3839421571858841</c:v>
                </c:pt>
                <c:pt idx="622">
                  <c:v>1.0547974535379128</c:v>
                </c:pt>
                <c:pt idx="623">
                  <c:v>2.0870511777047258</c:v>
                </c:pt>
                <c:pt idx="624">
                  <c:v>1.5967850271354516</c:v>
                </c:pt>
                <c:pt idx="625">
                  <c:v>1.6012909344508397</c:v>
                </c:pt>
                <c:pt idx="626">
                  <c:v>1.6571513649102512</c:v>
                </c:pt>
                <c:pt idx="627">
                  <c:v>1.1283502483807073</c:v>
                </c:pt>
                <c:pt idx="628">
                  <c:v>1.413110130407836</c:v>
                </c:pt>
                <c:pt idx="629">
                  <c:v>1.3177383501290467</c:v>
                </c:pt>
                <c:pt idx="630">
                  <c:v>1.7931429870198179</c:v>
                </c:pt>
                <c:pt idx="631">
                  <c:v>1.2414883867650377</c:v>
                </c:pt>
                <c:pt idx="632">
                  <c:v>2.0527939490861646</c:v>
                </c:pt>
                <c:pt idx="633">
                  <c:v>2.7002806545327158</c:v>
                </c:pt>
                <c:pt idx="634">
                  <c:v>1.7471702817161934</c:v>
                </c:pt>
                <c:pt idx="635">
                  <c:v>1.5170778304967287</c:v>
                </c:pt>
                <c:pt idx="636">
                  <c:v>1.1187077108994399</c:v>
                </c:pt>
                <c:pt idx="637">
                  <c:v>0.90923536869505428</c:v>
                </c:pt>
                <c:pt idx="638">
                  <c:v>1.3406056385832827</c:v>
                </c:pt>
                <c:pt idx="639">
                  <c:v>1.8397197493869726</c:v>
                </c:pt>
                <c:pt idx="640">
                  <c:v>2.1478415072791606</c:v>
                </c:pt>
                <c:pt idx="641">
                  <c:v>1.2228480308146683</c:v>
                </c:pt>
                <c:pt idx="642">
                  <c:v>1.3323840974914258</c:v>
                </c:pt>
                <c:pt idx="643">
                  <c:v>1.4512097564977167</c:v>
                </c:pt>
                <c:pt idx="644">
                  <c:v>2.0329518125091304</c:v>
                </c:pt>
                <c:pt idx="645">
                  <c:v>1.3409543631042069</c:v>
                </c:pt>
                <c:pt idx="646">
                  <c:v>0.84149910688496032</c:v>
                </c:pt>
                <c:pt idx="647">
                  <c:v>1.2555264052849306</c:v>
                </c:pt>
                <c:pt idx="648">
                  <c:v>1.3235784417059548</c:v>
                </c:pt>
                <c:pt idx="649">
                  <c:v>1.6227051606089131</c:v>
                </c:pt>
                <c:pt idx="650">
                  <c:v>2.2298046811350942</c:v>
                </c:pt>
                <c:pt idx="651">
                  <c:v>1.9074493010254971</c:v>
                </c:pt>
                <c:pt idx="652">
                  <c:v>2.531471082213903</c:v>
                </c:pt>
                <c:pt idx="653">
                  <c:v>1.6840638037636275</c:v>
                </c:pt>
                <c:pt idx="654">
                  <c:v>1.6689163166701073</c:v>
                </c:pt>
                <c:pt idx="655">
                  <c:v>1.2654438756328124</c:v>
                </c:pt>
                <c:pt idx="656">
                  <c:v>1.4407521589788808</c:v>
                </c:pt>
                <c:pt idx="657">
                  <c:v>1.9338747264665392</c:v>
                </c:pt>
                <c:pt idx="658">
                  <c:v>1.8559373508833712</c:v>
                </c:pt>
                <c:pt idx="659">
                  <c:v>1.0103035289515403</c:v>
                </c:pt>
                <c:pt idx="660">
                  <c:v>1.442918546237459</c:v>
                </c:pt>
                <c:pt idx="661">
                  <c:v>1.3235417242226288</c:v>
                </c:pt>
                <c:pt idx="662">
                  <c:v>1.0201075923269163</c:v>
                </c:pt>
                <c:pt idx="663">
                  <c:v>1.0104874930557828</c:v>
                </c:pt>
                <c:pt idx="664">
                  <c:v>1.1514969408633102</c:v>
                </c:pt>
                <c:pt idx="665">
                  <c:v>1.3431774352366856</c:v>
                </c:pt>
                <c:pt idx="666">
                  <c:v>1.4491999205490613</c:v>
                </c:pt>
                <c:pt idx="667">
                  <c:v>1.1837373833084743</c:v>
                </c:pt>
                <c:pt idx="668">
                  <c:v>1.9383130468865366</c:v>
                </c:pt>
                <c:pt idx="669">
                  <c:v>1.6041229321633577</c:v>
                </c:pt>
                <c:pt idx="670">
                  <c:v>1.1882091526307701</c:v>
                </c:pt>
                <c:pt idx="671">
                  <c:v>3.1096301111530442</c:v>
                </c:pt>
                <c:pt idx="672">
                  <c:v>1.2496940128513505</c:v>
                </c:pt>
                <c:pt idx="673">
                  <c:v>1.9673905389876911</c:v>
                </c:pt>
                <c:pt idx="674">
                  <c:v>1.3821517002346642</c:v>
                </c:pt>
                <c:pt idx="675">
                  <c:v>2.2283182384344231</c:v>
                </c:pt>
                <c:pt idx="676">
                  <c:v>1.0890345677072439</c:v>
                </c:pt>
                <c:pt idx="677">
                  <c:v>1.4373321636209793</c:v>
                </c:pt>
                <c:pt idx="678">
                  <c:v>1.750609480136166</c:v>
                </c:pt>
                <c:pt idx="679">
                  <c:v>2.5961648564094042</c:v>
                </c:pt>
                <c:pt idx="680">
                  <c:v>2.3296910759369887</c:v>
                </c:pt>
                <c:pt idx="681">
                  <c:v>1.8223457978519564</c:v>
                </c:pt>
                <c:pt idx="682">
                  <c:v>2.0398976460830509</c:v>
                </c:pt>
                <c:pt idx="683">
                  <c:v>2.2917771225293517</c:v>
                </c:pt>
                <c:pt idx="684">
                  <c:v>1.4126262409055883</c:v>
                </c:pt>
                <c:pt idx="685">
                  <c:v>2.2333656657923715</c:v>
                </c:pt>
                <c:pt idx="686">
                  <c:v>2.0789696147141705</c:v>
                </c:pt>
                <c:pt idx="687">
                  <c:v>2.2951355422661948</c:v>
                </c:pt>
                <c:pt idx="688">
                  <c:v>1.081473668938046</c:v>
                </c:pt>
                <c:pt idx="689">
                  <c:v>0.93711102990575212</c:v>
                </c:pt>
                <c:pt idx="690">
                  <c:v>2.365751211828683</c:v>
                </c:pt>
                <c:pt idx="691">
                  <c:v>1.724451655863346</c:v>
                </c:pt>
                <c:pt idx="692">
                  <c:v>1.264805419809115</c:v>
                </c:pt>
                <c:pt idx="693">
                  <c:v>1.870912627397926</c:v>
                </c:pt>
                <c:pt idx="694">
                  <c:v>2.5771610955091662</c:v>
                </c:pt>
                <c:pt idx="695">
                  <c:v>1.2145049688085872</c:v>
                </c:pt>
                <c:pt idx="696">
                  <c:v>1.3962736262397704</c:v>
                </c:pt>
                <c:pt idx="697">
                  <c:v>1.774703283401956</c:v>
                </c:pt>
                <c:pt idx="698">
                  <c:v>1.1127086467933045</c:v>
                </c:pt>
                <c:pt idx="699">
                  <c:v>1.7615260021306853</c:v>
                </c:pt>
                <c:pt idx="700">
                  <c:v>1.4826509768073188</c:v>
                </c:pt>
                <c:pt idx="701">
                  <c:v>1.597909806145976</c:v>
                </c:pt>
                <c:pt idx="702">
                  <c:v>1.1919869366627018</c:v>
                </c:pt>
                <c:pt idx="703">
                  <c:v>1.2455499122929066</c:v>
                </c:pt>
                <c:pt idx="704">
                  <c:v>0.76613462063220794</c:v>
                </c:pt>
                <c:pt idx="705">
                  <c:v>1.38231085645964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1A8-4171-ABCE-FB156F0AB6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9962128"/>
        <c:axId val="659962456"/>
      </c:scatterChart>
      <c:valAx>
        <c:axId val="659962128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PAR-CL triplicate 1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962456"/>
        <c:crosses val="autoZero"/>
        <c:crossBetween val="midCat"/>
        <c:majorUnit val="0.5"/>
      </c:valAx>
      <c:valAx>
        <c:axId val="659962456"/>
        <c:scaling>
          <c:orientation val="minMax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PAR-CL</a:t>
                </a:r>
                <a:r>
                  <a:rPr lang="en-US" baseline="0" dirty="0"/>
                  <a:t> triplicate 3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99621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/C mutation rate: RNA 1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strRef>
              <c:f>'RNA1 DMS error rate'!$D$1</c:f>
              <c:strCache>
                <c:ptCount val="1"/>
                <c:pt idx="0">
                  <c:v>DMS-</c:v>
                </c:pt>
              </c:strCache>
            </c:strRef>
          </c:tx>
          <c:spPr>
            <a:ln>
              <a:solidFill>
                <a:srgbClr val="0070C0">
                  <a:alpha val="90000"/>
                </a:srgbClr>
              </a:solidFill>
            </a:ln>
          </c:spPr>
          <c:marker>
            <c:symbol val="none"/>
          </c:marker>
          <c:xVal>
            <c:numRef>
              <c:f>'RNA1 DMS error rate'!$B$2:$B$1587</c:f>
              <c:numCache>
                <c:formatCode>General</c:formatCode>
                <c:ptCount val="1586"/>
                <c:pt idx="0">
                  <c:v>14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5</c:v>
                </c:pt>
                <c:pt idx="17">
                  <c:v>36</c:v>
                </c:pt>
                <c:pt idx="18">
                  <c:v>37</c:v>
                </c:pt>
                <c:pt idx="19">
                  <c:v>38</c:v>
                </c:pt>
                <c:pt idx="20">
                  <c:v>39</c:v>
                </c:pt>
                <c:pt idx="21">
                  <c:v>40</c:v>
                </c:pt>
                <c:pt idx="22">
                  <c:v>43</c:v>
                </c:pt>
                <c:pt idx="23">
                  <c:v>44</c:v>
                </c:pt>
                <c:pt idx="24">
                  <c:v>46</c:v>
                </c:pt>
                <c:pt idx="25">
                  <c:v>48</c:v>
                </c:pt>
                <c:pt idx="26">
                  <c:v>49</c:v>
                </c:pt>
                <c:pt idx="27">
                  <c:v>50</c:v>
                </c:pt>
                <c:pt idx="28">
                  <c:v>51</c:v>
                </c:pt>
                <c:pt idx="29">
                  <c:v>55</c:v>
                </c:pt>
                <c:pt idx="30">
                  <c:v>58</c:v>
                </c:pt>
                <c:pt idx="31">
                  <c:v>63</c:v>
                </c:pt>
                <c:pt idx="32">
                  <c:v>65</c:v>
                </c:pt>
                <c:pt idx="33">
                  <c:v>66</c:v>
                </c:pt>
                <c:pt idx="34">
                  <c:v>67</c:v>
                </c:pt>
                <c:pt idx="35">
                  <c:v>68</c:v>
                </c:pt>
                <c:pt idx="36">
                  <c:v>69</c:v>
                </c:pt>
                <c:pt idx="37">
                  <c:v>70</c:v>
                </c:pt>
                <c:pt idx="38">
                  <c:v>71</c:v>
                </c:pt>
                <c:pt idx="39">
                  <c:v>73</c:v>
                </c:pt>
                <c:pt idx="40">
                  <c:v>75</c:v>
                </c:pt>
                <c:pt idx="41">
                  <c:v>76</c:v>
                </c:pt>
                <c:pt idx="42">
                  <c:v>77</c:v>
                </c:pt>
                <c:pt idx="43">
                  <c:v>78</c:v>
                </c:pt>
                <c:pt idx="44">
                  <c:v>79</c:v>
                </c:pt>
                <c:pt idx="45">
                  <c:v>81</c:v>
                </c:pt>
                <c:pt idx="46">
                  <c:v>82</c:v>
                </c:pt>
                <c:pt idx="47">
                  <c:v>83</c:v>
                </c:pt>
                <c:pt idx="48">
                  <c:v>86</c:v>
                </c:pt>
                <c:pt idx="49">
                  <c:v>87</c:v>
                </c:pt>
                <c:pt idx="50">
                  <c:v>93</c:v>
                </c:pt>
                <c:pt idx="51">
                  <c:v>96</c:v>
                </c:pt>
                <c:pt idx="52">
                  <c:v>100</c:v>
                </c:pt>
                <c:pt idx="53">
                  <c:v>104</c:v>
                </c:pt>
                <c:pt idx="54">
                  <c:v>105</c:v>
                </c:pt>
                <c:pt idx="55">
                  <c:v>106</c:v>
                </c:pt>
                <c:pt idx="56">
                  <c:v>107</c:v>
                </c:pt>
                <c:pt idx="57">
                  <c:v>108</c:v>
                </c:pt>
                <c:pt idx="58">
                  <c:v>111</c:v>
                </c:pt>
                <c:pt idx="59">
                  <c:v>113</c:v>
                </c:pt>
                <c:pt idx="60">
                  <c:v>120</c:v>
                </c:pt>
                <c:pt idx="61">
                  <c:v>125</c:v>
                </c:pt>
                <c:pt idx="62">
                  <c:v>126</c:v>
                </c:pt>
                <c:pt idx="63">
                  <c:v>129</c:v>
                </c:pt>
                <c:pt idx="64">
                  <c:v>134</c:v>
                </c:pt>
                <c:pt idx="65">
                  <c:v>135</c:v>
                </c:pt>
                <c:pt idx="66">
                  <c:v>138</c:v>
                </c:pt>
                <c:pt idx="67">
                  <c:v>139</c:v>
                </c:pt>
                <c:pt idx="68">
                  <c:v>141</c:v>
                </c:pt>
                <c:pt idx="69">
                  <c:v>143</c:v>
                </c:pt>
                <c:pt idx="70">
                  <c:v>144</c:v>
                </c:pt>
                <c:pt idx="71">
                  <c:v>145</c:v>
                </c:pt>
                <c:pt idx="72">
                  <c:v>146</c:v>
                </c:pt>
                <c:pt idx="73">
                  <c:v>150</c:v>
                </c:pt>
                <c:pt idx="74">
                  <c:v>156</c:v>
                </c:pt>
                <c:pt idx="75">
                  <c:v>158</c:v>
                </c:pt>
                <c:pt idx="76">
                  <c:v>164</c:v>
                </c:pt>
                <c:pt idx="77">
                  <c:v>165</c:v>
                </c:pt>
                <c:pt idx="78">
                  <c:v>166</c:v>
                </c:pt>
                <c:pt idx="79">
                  <c:v>170</c:v>
                </c:pt>
                <c:pt idx="80">
                  <c:v>172</c:v>
                </c:pt>
                <c:pt idx="81">
                  <c:v>173</c:v>
                </c:pt>
                <c:pt idx="82">
                  <c:v>174</c:v>
                </c:pt>
                <c:pt idx="83">
                  <c:v>176</c:v>
                </c:pt>
                <c:pt idx="84">
                  <c:v>178</c:v>
                </c:pt>
                <c:pt idx="85">
                  <c:v>179</c:v>
                </c:pt>
                <c:pt idx="86">
                  <c:v>181</c:v>
                </c:pt>
                <c:pt idx="87">
                  <c:v>182</c:v>
                </c:pt>
                <c:pt idx="88">
                  <c:v>184</c:v>
                </c:pt>
                <c:pt idx="89">
                  <c:v>189</c:v>
                </c:pt>
                <c:pt idx="90">
                  <c:v>193</c:v>
                </c:pt>
                <c:pt idx="91">
                  <c:v>194</c:v>
                </c:pt>
                <c:pt idx="92">
                  <c:v>195</c:v>
                </c:pt>
                <c:pt idx="93">
                  <c:v>196</c:v>
                </c:pt>
                <c:pt idx="94">
                  <c:v>198</c:v>
                </c:pt>
                <c:pt idx="95">
                  <c:v>202</c:v>
                </c:pt>
                <c:pt idx="96">
                  <c:v>203</c:v>
                </c:pt>
                <c:pt idx="97">
                  <c:v>204</c:v>
                </c:pt>
                <c:pt idx="98">
                  <c:v>205</c:v>
                </c:pt>
                <c:pt idx="99">
                  <c:v>207</c:v>
                </c:pt>
                <c:pt idx="100">
                  <c:v>209</c:v>
                </c:pt>
                <c:pt idx="101">
                  <c:v>210</c:v>
                </c:pt>
                <c:pt idx="102">
                  <c:v>214</c:v>
                </c:pt>
                <c:pt idx="103">
                  <c:v>215</c:v>
                </c:pt>
                <c:pt idx="104">
                  <c:v>216</c:v>
                </c:pt>
                <c:pt idx="105">
                  <c:v>217</c:v>
                </c:pt>
                <c:pt idx="106">
                  <c:v>221</c:v>
                </c:pt>
                <c:pt idx="107">
                  <c:v>225</c:v>
                </c:pt>
                <c:pt idx="108">
                  <c:v>226</c:v>
                </c:pt>
                <c:pt idx="109">
                  <c:v>230</c:v>
                </c:pt>
                <c:pt idx="110">
                  <c:v>231</c:v>
                </c:pt>
                <c:pt idx="111">
                  <c:v>232</c:v>
                </c:pt>
                <c:pt idx="112">
                  <c:v>233</c:v>
                </c:pt>
                <c:pt idx="113">
                  <c:v>234</c:v>
                </c:pt>
                <c:pt idx="114">
                  <c:v>235</c:v>
                </c:pt>
                <c:pt idx="115">
                  <c:v>236</c:v>
                </c:pt>
                <c:pt idx="116">
                  <c:v>238</c:v>
                </c:pt>
                <c:pt idx="117">
                  <c:v>239</c:v>
                </c:pt>
                <c:pt idx="118">
                  <c:v>241</c:v>
                </c:pt>
                <c:pt idx="119">
                  <c:v>242</c:v>
                </c:pt>
                <c:pt idx="120">
                  <c:v>243</c:v>
                </c:pt>
                <c:pt idx="121">
                  <c:v>244</c:v>
                </c:pt>
                <c:pt idx="122">
                  <c:v>245</c:v>
                </c:pt>
                <c:pt idx="123">
                  <c:v>247</c:v>
                </c:pt>
                <c:pt idx="124">
                  <c:v>249</c:v>
                </c:pt>
                <c:pt idx="125">
                  <c:v>251</c:v>
                </c:pt>
                <c:pt idx="126">
                  <c:v>253</c:v>
                </c:pt>
                <c:pt idx="127">
                  <c:v>254</c:v>
                </c:pt>
                <c:pt idx="128">
                  <c:v>255</c:v>
                </c:pt>
                <c:pt idx="129">
                  <c:v>256</c:v>
                </c:pt>
                <c:pt idx="130">
                  <c:v>261</c:v>
                </c:pt>
                <c:pt idx="131">
                  <c:v>263</c:v>
                </c:pt>
                <c:pt idx="132">
                  <c:v>265</c:v>
                </c:pt>
                <c:pt idx="133">
                  <c:v>266</c:v>
                </c:pt>
                <c:pt idx="134">
                  <c:v>268</c:v>
                </c:pt>
                <c:pt idx="135">
                  <c:v>272</c:v>
                </c:pt>
                <c:pt idx="136">
                  <c:v>273</c:v>
                </c:pt>
                <c:pt idx="137">
                  <c:v>274</c:v>
                </c:pt>
                <c:pt idx="138">
                  <c:v>276</c:v>
                </c:pt>
                <c:pt idx="139">
                  <c:v>277</c:v>
                </c:pt>
                <c:pt idx="140">
                  <c:v>280</c:v>
                </c:pt>
                <c:pt idx="141">
                  <c:v>283</c:v>
                </c:pt>
                <c:pt idx="142">
                  <c:v>284</c:v>
                </c:pt>
                <c:pt idx="143">
                  <c:v>285</c:v>
                </c:pt>
                <c:pt idx="144">
                  <c:v>289</c:v>
                </c:pt>
                <c:pt idx="145">
                  <c:v>290</c:v>
                </c:pt>
                <c:pt idx="146">
                  <c:v>292</c:v>
                </c:pt>
                <c:pt idx="147">
                  <c:v>293</c:v>
                </c:pt>
                <c:pt idx="148">
                  <c:v>295</c:v>
                </c:pt>
                <c:pt idx="149">
                  <c:v>296</c:v>
                </c:pt>
                <c:pt idx="150">
                  <c:v>298</c:v>
                </c:pt>
                <c:pt idx="151">
                  <c:v>303</c:v>
                </c:pt>
                <c:pt idx="152">
                  <c:v>305</c:v>
                </c:pt>
                <c:pt idx="153">
                  <c:v>306</c:v>
                </c:pt>
                <c:pt idx="154">
                  <c:v>308</c:v>
                </c:pt>
                <c:pt idx="155">
                  <c:v>309</c:v>
                </c:pt>
                <c:pt idx="156">
                  <c:v>310</c:v>
                </c:pt>
                <c:pt idx="157">
                  <c:v>311</c:v>
                </c:pt>
                <c:pt idx="158">
                  <c:v>312</c:v>
                </c:pt>
                <c:pt idx="159">
                  <c:v>316</c:v>
                </c:pt>
                <c:pt idx="160">
                  <c:v>317</c:v>
                </c:pt>
                <c:pt idx="161">
                  <c:v>318</c:v>
                </c:pt>
                <c:pt idx="162">
                  <c:v>320</c:v>
                </c:pt>
                <c:pt idx="163">
                  <c:v>321</c:v>
                </c:pt>
                <c:pt idx="164">
                  <c:v>326</c:v>
                </c:pt>
                <c:pt idx="165">
                  <c:v>327</c:v>
                </c:pt>
                <c:pt idx="166">
                  <c:v>332</c:v>
                </c:pt>
                <c:pt idx="167">
                  <c:v>333</c:v>
                </c:pt>
                <c:pt idx="168">
                  <c:v>336</c:v>
                </c:pt>
                <c:pt idx="169">
                  <c:v>337</c:v>
                </c:pt>
                <c:pt idx="170">
                  <c:v>341</c:v>
                </c:pt>
                <c:pt idx="171">
                  <c:v>344</c:v>
                </c:pt>
                <c:pt idx="172">
                  <c:v>345</c:v>
                </c:pt>
                <c:pt idx="173">
                  <c:v>347</c:v>
                </c:pt>
                <c:pt idx="174">
                  <c:v>348</c:v>
                </c:pt>
                <c:pt idx="175">
                  <c:v>349</c:v>
                </c:pt>
                <c:pt idx="176">
                  <c:v>352</c:v>
                </c:pt>
                <c:pt idx="177">
                  <c:v>358</c:v>
                </c:pt>
                <c:pt idx="178">
                  <c:v>360</c:v>
                </c:pt>
                <c:pt idx="179">
                  <c:v>362</c:v>
                </c:pt>
                <c:pt idx="180">
                  <c:v>363</c:v>
                </c:pt>
                <c:pt idx="181">
                  <c:v>365</c:v>
                </c:pt>
                <c:pt idx="182">
                  <c:v>368</c:v>
                </c:pt>
                <c:pt idx="183">
                  <c:v>369</c:v>
                </c:pt>
                <c:pt idx="184">
                  <c:v>370</c:v>
                </c:pt>
                <c:pt idx="185">
                  <c:v>372</c:v>
                </c:pt>
                <c:pt idx="186">
                  <c:v>373</c:v>
                </c:pt>
                <c:pt idx="187">
                  <c:v>374</c:v>
                </c:pt>
                <c:pt idx="188">
                  <c:v>377</c:v>
                </c:pt>
                <c:pt idx="189">
                  <c:v>378</c:v>
                </c:pt>
                <c:pt idx="190">
                  <c:v>384</c:v>
                </c:pt>
                <c:pt idx="191">
                  <c:v>387</c:v>
                </c:pt>
                <c:pt idx="192">
                  <c:v>389</c:v>
                </c:pt>
                <c:pt idx="193">
                  <c:v>390</c:v>
                </c:pt>
                <c:pt idx="194">
                  <c:v>391</c:v>
                </c:pt>
                <c:pt idx="195">
                  <c:v>392</c:v>
                </c:pt>
                <c:pt idx="196">
                  <c:v>393</c:v>
                </c:pt>
                <c:pt idx="197">
                  <c:v>398</c:v>
                </c:pt>
                <c:pt idx="198">
                  <c:v>402</c:v>
                </c:pt>
                <c:pt idx="199">
                  <c:v>403</c:v>
                </c:pt>
                <c:pt idx="200">
                  <c:v>404</c:v>
                </c:pt>
                <c:pt idx="201">
                  <c:v>405</c:v>
                </c:pt>
                <c:pt idx="202">
                  <c:v>406</c:v>
                </c:pt>
                <c:pt idx="203">
                  <c:v>407</c:v>
                </c:pt>
                <c:pt idx="204">
                  <c:v>408</c:v>
                </c:pt>
                <c:pt idx="205">
                  <c:v>409</c:v>
                </c:pt>
                <c:pt idx="206">
                  <c:v>410</c:v>
                </c:pt>
                <c:pt idx="207">
                  <c:v>411</c:v>
                </c:pt>
                <c:pt idx="208">
                  <c:v>412</c:v>
                </c:pt>
                <c:pt idx="209">
                  <c:v>413</c:v>
                </c:pt>
                <c:pt idx="210">
                  <c:v>414</c:v>
                </c:pt>
                <c:pt idx="211">
                  <c:v>415</c:v>
                </c:pt>
                <c:pt idx="212">
                  <c:v>416</c:v>
                </c:pt>
                <c:pt idx="213">
                  <c:v>417</c:v>
                </c:pt>
                <c:pt idx="214">
                  <c:v>419</c:v>
                </c:pt>
                <c:pt idx="215">
                  <c:v>420</c:v>
                </c:pt>
                <c:pt idx="216">
                  <c:v>421</c:v>
                </c:pt>
                <c:pt idx="217">
                  <c:v>423</c:v>
                </c:pt>
                <c:pt idx="218">
                  <c:v>424</c:v>
                </c:pt>
                <c:pt idx="219">
                  <c:v>425</c:v>
                </c:pt>
                <c:pt idx="220">
                  <c:v>429</c:v>
                </c:pt>
                <c:pt idx="221">
                  <c:v>430</c:v>
                </c:pt>
                <c:pt idx="222">
                  <c:v>433</c:v>
                </c:pt>
                <c:pt idx="223">
                  <c:v>435</c:v>
                </c:pt>
                <c:pt idx="224">
                  <c:v>436</c:v>
                </c:pt>
                <c:pt idx="225">
                  <c:v>437</c:v>
                </c:pt>
                <c:pt idx="226">
                  <c:v>438</c:v>
                </c:pt>
                <c:pt idx="227">
                  <c:v>439</c:v>
                </c:pt>
                <c:pt idx="228">
                  <c:v>440</c:v>
                </c:pt>
                <c:pt idx="229">
                  <c:v>444</c:v>
                </c:pt>
                <c:pt idx="230">
                  <c:v>445</c:v>
                </c:pt>
                <c:pt idx="231">
                  <c:v>446</c:v>
                </c:pt>
                <c:pt idx="232">
                  <c:v>447</c:v>
                </c:pt>
                <c:pt idx="233">
                  <c:v>450</c:v>
                </c:pt>
                <c:pt idx="234">
                  <c:v>452</c:v>
                </c:pt>
                <c:pt idx="235">
                  <c:v>453</c:v>
                </c:pt>
                <c:pt idx="236">
                  <c:v>456</c:v>
                </c:pt>
                <c:pt idx="237">
                  <c:v>461</c:v>
                </c:pt>
                <c:pt idx="238">
                  <c:v>467</c:v>
                </c:pt>
                <c:pt idx="239">
                  <c:v>468</c:v>
                </c:pt>
                <c:pt idx="240">
                  <c:v>469</c:v>
                </c:pt>
                <c:pt idx="241">
                  <c:v>470</c:v>
                </c:pt>
                <c:pt idx="242">
                  <c:v>471</c:v>
                </c:pt>
                <c:pt idx="243">
                  <c:v>473</c:v>
                </c:pt>
                <c:pt idx="244">
                  <c:v>477</c:v>
                </c:pt>
                <c:pt idx="245">
                  <c:v>478</c:v>
                </c:pt>
                <c:pt idx="246">
                  <c:v>481</c:v>
                </c:pt>
                <c:pt idx="247">
                  <c:v>482</c:v>
                </c:pt>
                <c:pt idx="248">
                  <c:v>485</c:v>
                </c:pt>
                <c:pt idx="249">
                  <c:v>486</c:v>
                </c:pt>
                <c:pt idx="250">
                  <c:v>487</c:v>
                </c:pt>
                <c:pt idx="251">
                  <c:v>488</c:v>
                </c:pt>
                <c:pt idx="252">
                  <c:v>489</c:v>
                </c:pt>
                <c:pt idx="253">
                  <c:v>490</c:v>
                </c:pt>
                <c:pt idx="254">
                  <c:v>491</c:v>
                </c:pt>
                <c:pt idx="255">
                  <c:v>494</c:v>
                </c:pt>
                <c:pt idx="256">
                  <c:v>497</c:v>
                </c:pt>
                <c:pt idx="257">
                  <c:v>500</c:v>
                </c:pt>
                <c:pt idx="258">
                  <c:v>503</c:v>
                </c:pt>
                <c:pt idx="259">
                  <c:v>504</c:v>
                </c:pt>
                <c:pt idx="260">
                  <c:v>507</c:v>
                </c:pt>
                <c:pt idx="261">
                  <c:v>508</c:v>
                </c:pt>
                <c:pt idx="262">
                  <c:v>510</c:v>
                </c:pt>
                <c:pt idx="263">
                  <c:v>513</c:v>
                </c:pt>
                <c:pt idx="264">
                  <c:v>521</c:v>
                </c:pt>
                <c:pt idx="265">
                  <c:v>527</c:v>
                </c:pt>
                <c:pt idx="266">
                  <c:v>530</c:v>
                </c:pt>
                <c:pt idx="267">
                  <c:v>533</c:v>
                </c:pt>
                <c:pt idx="268">
                  <c:v>537</c:v>
                </c:pt>
                <c:pt idx="269">
                  <c:v>538</c:v>
                </c:pt>
                <c:pt idx="270">
                  <c:v>539</c:v>
                </c:pt>
                <c:pt idx="271">
                  <c:v>540</c:v>
                </c:pt>
                <c:pt idx="272">
                  <c:v>542</c:v>
                </c:pt>
                <c:pt idx="273">
                  <c:v>544</c:v>
                </c:pt>
                <c:pt idx="274">
                  <c:v>545</c:v>
                </c:pt>
                <c:pt idx="275">
                  <c:v>548</c:v>
                </c:pt>
                <c:pt idx="276">
                  <c:v>553</c:v>
                </c:pt>
                <c:pt idx="277">
                  <c:v>558</c:v>
                </c:pt>
                <c:pt idx="278">
                  <c:v>560</c:v>
                </c:pt>
                <c:pt idx="279">
                  <c:v>562</c:v>
                </c:pt>
                <c:pt idx="280">
                  <c:v>563</c:v>
                </c:pt>
                <c:pt idx="281">
                  <c:v>564</c:v>
                </c:pt>
                <c:pt idx="282">
                  <c:v>565</c:v>
                </c:pt>
                <c:pt idx="283">
                  <c:v>568</c:v>
                </c:pt>
                <c:pt idx="284">
                  <c:v>571</c:v>
                </c:pt>
                <c:pt idx="285">
                  <c:v>572</c:v>
                </c:pt>
                <c:pt idx="286">
                  <c:v>573</c:v>
                </c:pt>
                <c:pt idx="287">
                  <c:v>576</c:v>
                </c:pt>
                <c:pt idx="288">
                  <c:v>582</c:v>
                </c:pt>
                <c:pt idx="289">
                  <c:v>583</c:v>
                </c:pt>
                <c:pt idx="290">
                  <c:v>584</c:v>
                </c:pt>
                <c:pt idx="291">
                  <c:v>585</c:v>
                </c:pt>
                <c:pt idx="292">
                  <c:v>586</c:v>
                </c:pt>
                <c:pt idx="293">
                  <c:v>587</c:v>
                </c:pt>
                <c:pt idx="294">
                  <c:v>588</c:v>
                </c:pt>
                <c:pt idx="295">
                  <c:v>592</c:v>
                </c:pt>
                <c:pt idx="296">
                  <c:v>593</c:v>
                </c:pt>
                <c:pt idx="297">
                  <c:v>594</c:v>
                </c:pt>
                <c:pt idx="298">
                  <c:v>595</c:v>
                </c:pt>
                <c:pt idx="299">
                  <c:v>596</c:v>
                </c:pt>
                <c:pt idx="300">
                  <c:v>598</c:v>
                </c:pt>
                <c:pt idx="301">
                  <c:v>599</c:v>
                </c:pt>
                <c:pt idx="302">
                  <c:v>601</c:v>
                </c:pt>
                <c:pt idx="303">
                  <c:v>602</c:v>
                </c:pt>
                <c:pt idx="304">
                  <c:v>603</c:v>
                </c:pt>
                <c:pt idx="305">
                  <c:v>607</c:v>
                </c:pt>
                <c:pt idx="306">
                  <c:v>609</c:v>
                </c:pt>
                <c:pt idx="307">
                  <c:v>617</c:v>
                </c:pt>
                <c:pt idx="308">
                  <c:v>620</c:v>
                </c:pt>
                <c:pt idx="309">
                  <c:v>623</c:v>
                </c:pt>
                <c:pt idx="310">
                  <c:v>624</c:v>
                </c:pt>
                <c:pt idx="311">
                  <c:v>626</c:v>
                </c:pt>
                <c:pt idx="312">
                  <c:v>627</c:v>
                </c:pt>
                <c:pt idx="313">
                  <c:v>628</c:v>
                </c:pt>
                <c:pt idx="314">
                  <c:v>629</c:v>
                </c:pt>
                <c:pt idx="315">
                  <c:v>630</c:v>
                </c:pt>
                <c:pt idx="316">
                  <c:v>633</c:v>
                </c:pt>
                <c:pt idx="317">
                  <c:v>634</c:v>
                </c:pt>
                <c:pt idx="318">
                  <c:v>635</c:v>
                </c:pt>
                <c:pt idx="319">
                  <c:v>636</c:v>
                </c:pt>
                <c:pt idx="320">
                  <c:v>637</c:v>
                </c:pt>
                <c:pt idx="321">
                  <c:v>640</c:v>
                </c:pt>
                <c:pt idx="322">
                  <c:v>641</c:v>
                </c:pt>
                <c:pt idx="323">
                  <c:v>643</c:v>
                </c:pt>
                <c:pt idx="324">
                  <c:v>644</c:v>
                </c:pt>
                <c:pt idx="325">
                  <c:v>645</c:v>
                </c:pt>
                <c:pt idx="326">
                  <c:v>646</c:v>
                </c:pt>
                <c:pt idx="327">
                  <c:v>647</c:v>
                </c:pt>
                <c:pt idx="328">
                  <c:v>648</c:v>
                </c:pt>
                <c:pt idx="329">
                  <c:v>656</c:v>
                </c:pt>
                <c:pt idx="330">
                  <c:v>657</c:v>
                </c:pt>
                <c:pt idx="331">
                  <c:v>659</c:v>
                </c:pt>
                <c:pt idx="332">
                  <c:v>661</c:v>
                </c:pt>
                <c:pt idx="333">
                  <c:v>662</c:v>
                </c:pt>
                <c:pt idx="334">
                  <c:v>667</c:v>
                </c:pt>
                <c:pt idx="335">
                  <c:v>669</c:v>
                </c:pt>
                <c:pt idx="336">
                  <c:v>675</c:v>
                </c:pt>
                <c:pt idx="337">
                  <c:v>677</c:v>
                </c:pt>
                <c:pt idx="338">
                  <c:v>678</c:v>
                </c:pt>
                <c:pt idx="339">
                  <c:v>680</c:v>
                </c:pt>
                <c:pt idx="340">
                  <c:v>681</c:v>
                </c:pt>
                <c:pt idx="341">
                  <c:v>687</c:v>
                </c:pt>
                <c:pt idx="342">
                  <c:v>688</c:v>
                </c:pt>
                <c:pt idx="343">
                  <c:v>689</c:v>
                </c:pt>
                <c:pt idx="344">
                  <c:v>691</c:v>
                </c:pt>
                <c:pt idx="345">
                  <c:v>692</c:v>
                </c:pt>
                <c:pt idx="346">
                  <c:v>693</c:v>
                </c:pt>
                <c:pt idx="347">
                  <c:v>701</c:v>
                </c:pt>
                <c:pt idx="348">
                  <c:v>708</c:v>
                </c:pt>
                <c:pt idx="349">
                  <c:v>710</c:v>
                </c:pt>
                <c:pt idx="350">
                  <c:v>711</c:v>
                </c:pt>
                <c:pt idx="351">
                  <c:v>713</c:v>
                </c:pt>
                <c:pt idx="352">
                  <c:v>719</c:v>
                </c:pt>
                <c:pt idx="353">
                  <c:v>724</c:v>
                </c:pt>
                <c:pt idx="354">
                  <c:v>726</c:v>
                </c:pt>
                <c:pt idx="355">
                  <c:v>728</c:v>
                </c:pt>
                <c:pt idx="356">
                  <c:v>730</c:v>
                </c:pt>
                <c:pt idx="357">
                  <c:v>732</c:v>
                </c:pt>
                <c:pt idx="358">
                  <c:v>733</c:v>
                </c:pt>
                <c:pt idx="359">
                  <c:v>735</c:v>
                </c:pt>
                <c:pt idx="360">
                  <c:v>738</c:v>
                </c:pt>
                <c:pt idx="361">
                  <c:v>739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7</c:v>
                </c:pt>
                <c:pt idx="367">
                  <c:v>751</c:v>
                </c:pt>
                <c:pt idx="368">
                  <c:v>752</c:v>
                </c:pt>
                <c:pt idx="369">
                  <c:v>755</c:v>
                </c:pt>
                <c:pt idx="370">
                  <c:v>765</c:v>
                </c:pt>
                <c:pt idx="371">
                  <c:v>766</c:v>
                </c:pt>
                <c:pt idx="372">
                  <c:v>767</c:v>
                </c:pt>
                <c:pt idx="373">
                  <c:v>768</c:v>
                </c:pt>
                <c:pt idx="374">
                  <c:v>769</c:v>
                </c:pt>
                <c:pt idx="375">
                  <c:v>771</c:v>
                </c:pt>
                <c:pt idx="376">
                  <c:v>772</c:v>
                </c:pt>
                <c:pt idx="377">
                  <c:v>773</c:v>
                </c:pt>
                <c:pt idx="378">
                  <c:v>774</c:v>
                </c:pt>
                <c:pt idx="379">
                  <c:v>775</c:v>
                </c:pt>
                <c:pt idx="380">
                  <c:v>778</c:v>
                </c:pt>
                <c:pt idx="381">
                  <c:v>780</c:v>
                </c:pt>
                <c:pt idx="382">
                  <c:v>781</c:v>
                </c:pt>
                <c:pt idx="383">
                  <c:v>784</c:v>
                </c:pt>
                <c:pt idx="384">
                  <c:v>794</c:v>
                </c:pt>
                <c:pt idx="385">
                  <c:v>796</c:v>
                </c:pt>
                <c:pt idx="386">
                  <c:v>797</c:v>
                </c:pt>
                <c:pt idx="387">
                  <c:v>804</c:v>
                </c:pt>
                <c:pt idx="388">
                  <c:v>806</c:v>
                </c:pt>
                <c:pt idx="389">
                  <c:v>808</c:v>
                </c:pt>
                <c:pt idx="390">
                  <c:v>809</c:v>
                </c:pt>
                <c:pt idx="391">
                  <c:v>811</c:v>
                </c:pt>
                <c:pt idx="392">
                  <c:v>812</c:v>
                </c:pt>
                <c:pt idx="393">
                  <c:v>813</c:v>
                </c:pt>
                <c:pt idx="394">
                  <c:v>814</c:v>
                </c:pt>
                <c:pt idx="395">
                  <c:v>816</c:v>
                </c:pt>
                <c:pt idx="396">
                  <c:v>817</c:v>
                </c:pt>
                <c:pt idx="397">
                  <c:v>818</c:v>
                </c:pt>
                <c:pt idx="398">
                  <c:v>820</c:v>
                </c:pt>
                <c:pt idx="399">
                  <c:v>821</c:v>
                </c:pt>
                <c:pt idx="400">
                  <c:v>826</c:v>
                </c:pt>
                <c:pt idx="401">
                  <c:v>828</c:v>
                </c:pt>
                <c:pt idx="402">
                  <c:v>829</c:v>
                </c:pt>
                <c:pt idx="403">
                  <c:v>830</c:v>
                </c:pt>
                <c:pt idx="404">
                  <c:v>835</c:v>
                </c:pt>
                <c:pt idx="405">
                  <c:v>836</c:v>
                </c:pt>
                <c:pt idx="406">
                  <c:v>839</c:v>
                </c:pt>
                <c:pt idx="407">
                  <c:v>844</c:v>
                </c:pt>
                <c:pt idx="408">
                  <c:v>845</c:v>
                </c:pt>
                <c:pt idx="409">
                  <c:v>846</c:v>
                </c:pt>
                <c:pt idx="410">
                  <c:v>848</c:v>
                </c:pt>
                <c:pt idx="411">
                  <c:v>850</c:v>
                </c:pt>
                <c:pt idx="412">
                  <c:v>854</c:v>
                </c:pt>
                <c:pt idx="413">
                  <c:v>855</c:v>
                </c:pt>
                <c:pt idx="414">
                  <c:v>856</c:v>
                </c:pt>
                <c:pt idx="415">
                  <c:v>861</c:v>
                </c:pt>
                <c:pt idx="416">
                  <c:v>863</c:v>
                </c:pt>
                <c:pt idx="417">
                  <c:v>864</c:v>
                </c:pt>
                <c:pt idx="418">
                  <c:v>865</c:v>
                </c:pt>
                <c:pt idx="419">
                  <c:v>866</c:v>
                </c:pt>
                <c:pt idx="420">
                  <c:v>868</c:v>
                </c:pt>
                <c:pt idx="421">
                  <c:v>870</c:v>
                </c:pt>
                <c:pt idx="422">
                  <c:v>871</c:v>
                </c:pt>
                <c:pt idx="423">
                  <c:v>872</c:v>
                </c:pt>
                <c:pt idx="424">
                  <c:v>874</c:v>
                </c:pt>
                <c:pt idx="425">
                  <c:v>875</c:v>
                </c:pt>
                <c:pt idx="426">
                  <c:v>876</c:v>
                </c:pt>
                <c:pt idx="427">
                  <c:v>878</c:v>
                </c:pt>
                <c:pt idx="428">
                  <c:v>882</c:v>
                </c:pt>
                <c:pt idx="429">
                  <c:v>883</c:v>
                </c:pt>
                <c:pt idx="430">
                  <c:v>889</c:v>
                </c:pt>
                <c:pt idx="431">
                  <c:v>891</c:v>
                </c:pt>
                <c:pt idx="432">
                  <c:v>895</c:v>
                </c:pt>
                <c:pt idx="433">
                  <c:v>896</c:v>
                </c:pt>
                <c:pt idx="434">
                  <c:v>901</c:v>
                </c:pt>
                <c:pt idx="435">
                  <c:v>905</c:v>
                </c:pt>
                <c:pt idx="436">
                  <c:v>907</c:v>
                </c:pt>
                <c:pt idx="437">
                  <c:v>908</c:v>
                </c:pt>
                <c:pt idx="438">
                  <c:v>909</c:v>
                </c:pt>
                <c:pt idx="439">
                  <c:v>911</c:v>
                </c:pt>
                <c:pt idx="440">
                  <c:v>912</c:v>
                </c:pt>
                <c:pt idx="441">
                  <c:v>913</c:v>
                </c:pt>
                <c:pt idx="442">
                  <c:v>915</c:v>
                </c:pt>
                <c:pt idx="443">
                  <c:v>916</c:v>
                </c:pt>
                <c:pt idx="444">
                  <c:v>917</c:v>
                </c:pt>
                <c:pt idx="445">
                  <c:v>918</c:v>
                </c:pt>
                <c:pt idx="446">
                  <c:v>922</c:v>
                </c:pt>
                <c:pt idx="447">
                  <c:v>924</c:v>
                </c:pt>
                <c:pt idx="448">
                  <c:v>925</c:v>
                </c:pt>
                <c:pt idx="449">
                  <c:v>926</c:v>
                </c:pt>
                <c:pt idx="450">
                  <c:v>927</c:v>
                </c:pt>
                <c:pt idx="451">
                  <c:v>928</c:v>
                </c:pt>
                <c:pt idx="452">
                  <c:v>931</c:v>
                </c:pt>
                <c:pt idx="453">
                  <c:v>932</c:v>
                </c:pt>
                <c:pt idx="454">
                  <c:v>933</c:v>
                </c:pt>
                <c:pt idx="455">
                  <c:v>934</c:v>
                </c:pt>
                <c:pt idx="456">
                  <c:v>937</c:v>
                </c:pt>
                <c:pt idx="457">
                  <c:v>941</c:v>
                </c:pt>
                <c:pt idx="458">
                  <c:v>942</c:v>
                </c:pt>
                <c:pt idx="459">
                  <c:v>944</c:v>
                </c:pt>
                <c:pt idx="460">
                  <c:v>945</c:v>
                </c:pt>
                <c:pt idx="461">
                  <c:v>946</c:v>
                </c:pt>
                <c:pt idx="462">
                  <c:v>947</c:v>
                </c:pt>
                <c:pt idx="463">
                  <c:v>950</c:v>
                </c:pt>
                <c:pt idx="464">
                  <c:v>951</c:v>
                </c:pt>
                <c:pt idx="465">
                  <c:v>953</c:v>
                </c:pt>
                <c:pt idx="466">
                  <c:v>954</c:v>
                </c:pt>
                <c:pt idx="467">
                  <c:v>955</c:v>
                </c:pt>
                <c:pt idx="468">
                  <c:v>956</c:v>
                </c:pt>
                <c:pt idx="469">
                  <c:v>957</c:v>
                </c:pt>
                <c:pt idx="470">
                  <c:v>958</c:v>
                </c:pt>
                <c:pt idx="471">
                  <c:v>959</c:v>
                </c:pt>
                <c:pt idx="472">
                  <c:v>960</c:v>
                </c:pt>
                <c:pt idx="473">
                  <c:v>961</c:v>
                </c:pt>
                <c:pt idx="474">
                  <c:v>962</c:v>
                </c:pt>
                <c:pt idx="475">
                  <c:v>970</c:v>
                </c:pt>
                <c:pt idx="476">
                  <c:v>971</c:v>
                </c:pt>
                <c:pt idx="477">
                  <c:v>972</c:v>
                </c:pt>
                <c:pt idx="478">
                  <c:v>973</c:v>
                </c:pt>
                <c:pt idx="479">
                  <c:v>975</c:v>
                </c:pt>
                <c:pt idx="480">
                  <c:v>980</c:v>
                </c:pt>
                <c:pt idx="481">
                  <c:v>983</c:v>
                </c:pt>
                <c:pt idx="482">
                  <c:v>988</c:v>
                </c:pt>
                <c:pt idx="483">
                  <c:v>989</c:v>
                </c:pt>
                <c:pt idx="484">
                  <c:v>990</c:v>
                </c:pt>
                <c:pt idx="485">
                  <c:v>992</c:v>
                </c:pt>
                <c:pt idx="486">
                  <c:v>993</c:v>
                </c:pt>
                <c:pt idx="487">
                  <c:v>994</c:v>
                </c:pt>
                <c:pt idx="488">
                  <c:v>995</c:v>
                </c:pt>
                <c:pt idx="489">
                  <c:v>997</c:v>
                </c:pt>
                <c:pt idx="490">
                  <c:v>998</c:v>
                </c:pt>
                <c:pt idx="491">
                  <c:v>1001</c:v>
                </c:pt>
                <c:pt idx="492">
                  <c:v>1002</c:v>
                </c:pt>
                <c:pt idx="493">
                  <c:v>1003</c:v>
                </c:pt>
                <c:pt idx="494">
                  <c:v>1006</c:v>
                </c:pt>
                <c:pt idx="495">
                  <c:v>1013</c:v>
                </c:pt>
                <c:pt idx="496">
                  <c:v>1014</c:v>
                </c:pt>
                <c:pt idx="497">
                  <c:v>1015</c:v>
                </c:pt>
                <c:pt idx="498">
                  <c:v>1017</c:v>
                </c:pt>
                <c:pt idx="499">
                  <c:v>1021</c:v>
                </c:pt>
                <c:pt idx="500">
                  <c:v>1023</c:v>
                </c:pt>
                <c:pt idx="501">
                  <c:v>1025</c:v>
                </c:pt>
                <c:pt idx="502">
                  <c:v>1026</c:v>
                </c:pt>
                <c:pt idx="503">
                  <c:v>1031</c:v>
                </c:pt>
                <c:pt idx="504">
                  <c:v>1033</c:v>
                </c:pt>
                <c:pt idx="505">
                  <c:v>1034</c:v>
                </c:pt>
                <c:pt idx="506">
                  <c:v>1037</c:v>
                </c:pt>
                <c:pt idx="507">
                  <c:v>1039</c:v>
                </c:pt>
                <c:pt idx="508">
                  <c:v>1040</c:v>
                </c:pt>
                <c:pt idx="509">
                  <c:v>1042</c:v>
                </c:pt>
                <c:pt idx="510">
                  <c:v>1045</c:v>
                </c:pt>
                <c:pt idx="511">
                  <c:v>1046</c:v>
                </c:pt>
                <c:pt idx="512">
                  <c:v>1048</c:v>
                </c:pt>
                <c:pt idx="513">
                  <c:v>1050</c:v>
                </c:pt>
                <c:pt idx="514">
                  <c:v>1052</c:v>
                </c:pt>
                <c:pt idx="515">
                  <c:v>1054</c:v>
                </c:pt>
                <c:pt idx="516">
                  <c:v>1055</c:v>
                </c:pt>
                <c:pt idx="517">
                  <c:v>1056</c:v>
                </c:pt>
                <c:pt idx="518">
                  <c:v>1058</c:v>
                </c:pt>
                <c:pt idx="519">
                  <c:v>1059</c:v>
                </c:pt>
                <c:pt idx="520">
                  <c:v>1060</c:v>
                </c:pt>
                <c:pt idx="521">
                  <c:v>1061</c:v>
                </c:pt>
                <c:pt idx="522">
                  <c:v>1067</c:v>
                </c:pt>
                <c:pt idx="523">
                  <c:v>1069</c:v>
                </c:pt>
                <c:pt idx="524">
                  <c:v>1072</c:v>
                </c:pt>
                <c:pt idx="525">
                  <c:v>1074</c:v>
                </c:pt>
                <c:pt idx="526">
                  <c:v>1076</c:v>
                </c:pt>
                <c:pt idx="527">
                  <c:v>1080</c:v>
                </c:pt>
                <c:pt idx="528">
                  <c:v>1083</c:v>
                </c:pt>
                <c:pt idx="529">
                  <c:v>1085</c:v>
                </c:pt>
                <c:pt idx="530">
                  <c:v>1086</c:v>
                </c:pt>
                <c:pt idx="531">
                  <c:v>1088</c:v>
                </c:pt>
                <c:pt idx="532">
                  <c:v>1089</c:v>
                </c:pt>
                <c:pt idx="533">
                  <c:v>1090</c:v>
                </c:pt>
                <c:pt idx="534">
                  <c:v>1091</c:v>
                </c:pt>
                <c:pt idx="535">
                  <c:v>1092</c:v>
                </c:pt>
                <c:pt idx="536">
                  <c:v>1093</c:v>
                </c:pt>
                <c:pt idx="537">
                  <c:v>1094</c:v>
                </c:pt>
                <c:pt idx="538">
                  <c:v>1095</c:v>
                </c:pt>
                <c:pt idx="539">
                  <c:v>1097</c:v>
                </c:pt>
                <c:pt idx="540">
                  <c:v>1101</c:v>
                </c:pt>
                <c:pt idx="541">
                  <c:v>1102</c:v>
                </c:pt>
                <c:pt idx="542">
                  <c:v>1103</c:v>
                </c:pt>
                <c:pt idx="543">
                  <c:v>1104</c:v>
                </c:pt>
                <c:pt idx="544">
                  <c:v>1106</c:v>
                </c:pt>
                <c:pt idx="545">
                  <c:v>1108</c:v>
                </c:pt>
                <c:pt idx="546">
                  <c:v>1111</c:v>
                </c:pt>
                <c:pt idx="547">
                  <c:v>1114</c:v>
                </c:pt>
                <c:pt idx="548">
                  <c:v>1116</c:v>
                </c:pt>
                <c:pt idx="549">
                  <c:v>1120</c:v>
                </c:pt>
                <c:pt idx="550">
                  <c:v>1125</c:v>
                </c:pt>
                <c:pt idx="551">
                  <c:v>1126</c:v>
                </c:pt>
                <c:pt idx="552">
                  <c:v>1127</c:v>
                </c:pt>
                <c:pt idx="553">
                  <c:v>1128</c:v>
                </c:pt>
                <c:pt idx="554">
                  <c:v>1129</c:v>
                </c:pt>
                <c:pt idx="555">
                  <c:v>1130</c:v>
                </c:pt>
                <c:pt idx="556">
                  <c:v>1133</c:v>
                </c:pt>
                <c:pt idx="557">
                  <c:v>1134</c:v>
                </c:pt>
                <c:pt idx="558">
                  <c:v>1135</c:v>
                </c:pt>
                <c:pt idx="559">
                  <c:v>1136</c:v>
                </c:pt>
                <c:pt idx="560">
                  <c:v>1138</c:v>
                </c:pt>
                <c:pt idx="561">
                  <c:v>1139</c:v>
                </c:pt>
                <c:pt idx="562">
                  <c:v>1140</c:v>
                </c:pt>
                <c:pt idx="563">
                  <c:v>1142</c:v>
                </c:pt>
                <c:pt idx="564">
                  <c:v>1143</c:v>
                </c:pt>
                <c:pt idx="565">
                  <c:v>1144</c:v>
                </c:pt>
                <c:pt idx="566">
                  <c:v>1145</c:v>
                </c:pt>
                <c:pt idx="567">
                  <c:v>1146</c:v>
                </c:pt>
                <c:pt idx="568">
                  <c:v>1148</c:v>
                </c:pt>
                <c:pt idx="569">
                  <c:v>1149</c:v>
                </c:pt>
                <c:pt idx="570">
                  <c:v>1150</c:v>
                </c:pt>
                <c:pt idx="571">
                  <c:v>1153</c:v>
                </c:pt>
                <c:pt idx="572">
                  <c:v>1158</c:v>
                </c:pt>
                <c:pt idx="573">
                  <c:v>1159</c:v>
                </c:pt>
                <c:pt idx="574">
                  <c:v>1160</c:v>
                </c:pt>
                <c:pt idx="575">
                  <c:v>1163</c:v>
                </c:pt>
                <c:pt idx="576">
                  <c:v>1166</c:v>
                </c:pt>
                <c:pt idx="577">
                  <c:v>1168</c:v>
                </c:pt>
                <c:pt idx="578">
                  <c:v>1169</c:v>
                </c:pt>
                <c:pt idx="579">
                  <c:v>1173</c:v>
                </c:pt>
                <c:pt idx="580">
                  <c:v>1174</c:v>
                </c:pt>
                <c:pt idx="581">
                  <c:v>1175</c:v>
                </c:pt>
                <c:pt idx="582">
                  <c:v>1177</c:v>
                </c:pt>
                <c:pt idx="583">
                  <c:v>1178</c:v>
                </c:pt>
                <c:pt idx="584">
                  <c:v>1182</c:v>
                </c:pt>
                <c:pt idx="585">
                  <c:v>1187</c:v>
                </c:pt>
                <c:pt idx="586">
                  <c:v>1188</c:v>
                </c:pt>
                <c:pt idx="587">
                  <c:v>1189</c:v>
                </c:pt>
                <c:pt idx="588">
                  <c:v>1190</c:v>
                </c:pt>
                <c:pt idx="589">
                  <c:v>1191</c:v>
                </c:pt>
                <c:pt idx="590">
                  <c:v>1192</c:v>
                </c:pt>
                <c:pt idx="591">
                  <c:v>1195</c:v>
                </c:pt>
                <c:pt idx="592">
                  <c:v>1198</c:v>
                </c:pt>
                <c:pt idx="593">
                  <c:v>1199</c:v>
                </c:pt>
                <c:pt idx="594">
                  <c:v>1200</c:v>
                </c:pt>
                <c:pt idx="595">
                  <c:v>1201</c:v>
                </c:pt>
                <c:pt idx="596">
                  <c:v>1202</c:v>
                </c:pt>
                <c:pt idx="597">
                  <c:v>1208</c:v>
                </c:pt>
                <c:pt idx="598">
                  <c:v>1210</c:v>
                </c:pt>
                <c:pt idx="599">
                  <c:v>1211</c:v>
                </c:pt>
                <c:pt idx="600">
                  <c:v>1212</c:v>
                </c:pt>
                <c:pt idx="601">
                  <c:v>1213</c:v>
                </c:pt>
                <c:pt idx="602">
                  <c:v>1214</c:v>
                </c:pt>
                <c:pt idx="603">
                  <c:v>1216</c:v>
                </c:pt>
                <c:pt idx="604">
                  <c:v>1217</c:v>
                </c:pt>
                <c:pt idx="605">
                  <c:v>1218</c:v>
                </c:pt>
                <c:pt idx="606">
                  <c:v>1219</c:v>
                </c:pt>
                <c:pt idx="607">
                  <c:v>1222</c:v>
                </c:pt>
                <c:pt idx="608">
                  <c:v>1223</c:v>
                </c:pt>
                <c:pt idx="609">
                  <c:v>1224</c:v>
                </c:pt>
                <c:pt idx="610">
                  <c:v>1225</c:v>
                </c:pt>
                <c:pt idx="611">
                  <c:v>1227</c:v>
                </c:pt>
                <c:pt idx="612">
                  <c:v>1230</c:v>
                </c:pt>
                <c:pt idx="613">
                  <c:v>1231</c:v>
                </c:pt>
                <c:pt idx="614">
                  <c:v>1232</c:v>
                </c:pt>
                <c:pt idx="615">
                  <c:v>1237</c:v>
                </c:pt>
                <c:pt idx="616">
                  <c:v>1238</c:v>
                </c:pt>
                <c:pt idx="617">
                  <c:v>1239</c:v>
                </c:pt>
                <c:pt idx="618">
                  <c:v>1242</c:v>
                </c:pt>
                <c:pt idx="619">
                  <c:v>1243</c:v>
                </c:pt>
                <c:pt idx="620">
                  <c:v>1244</c:v>
                </c:pt>
                <c:pt idx="621">
                  <c:v>1245</c:v>
                </c:pt>
                <c:pt idx="622">
                  <c:v>1246</c:v>
                </c:pt>
                <c:pt idx="623">
                  <c:v>1250</c:v>
                </c:pt>
                <c:pt idx="624">
                  <c:v>1251</c:v>
                </c:pt>
                <c:pt idx="625">
                  <c:v>1253</c:v>
                </c:pt>
                <c:pt idx="626">
                  <c:v>1254</c:v>
                </c:pt>
                <c:pt idx="627">
                  <c:v>1256</c:v>
                </c:pt>
                <c:pt idx="628">
                  <c:v>1260</c:v>
                </c:pt>
                <c:pt idx="629">
                  <c:v>1261</c:v>
                </c:pt>
                <c:pt idx="630">
                  <c:v>1262</c:v>
                </c:pt>
                <c:pt idx="631">
                  <c:v>1263</c:v>
                </c:pt>
                <c:pt idx="632">
                  <c:v>1265</c:v>
                </c:pt>
                <c:pt idx="633">
                  <c:v>1266</c:v>
                </c:pt>
                <c:pt idx="634">
                  <c:v>1270</c:v>
                </c:pt>
                <c:pt idx="635">
                  <c:v>1272</c:v>
                </c:pt>
                <c:pt idx="636">
                  <c:v>1274</c:v>
                </c:pt>
                <c:pt idx="637">
                  <c:v>1276</c:v>
                </c:pt>
                <c:pt idx="638">
                  <c:v>1278</c:v>
                </c:pt>
                <c:pt idx="639">
                  <c:v>1279</c:v>
                </c:pt>
                <c:pt idx="640">
                  <c:v>1280</c:v>
                </c:pt>
                <c:pt idx="641">
                  <c:v>1281</c:v>
                </c:pt>
                <c:pt idx="642">
                  <c:v>1283</c:v>
                </c:pt>
                <c:pt idx="643">
                  <c:v>1284</c:v>
                </c:pt>
                <c:pt idx="644">
                  <c:v>1285</c:v>
                </c:pt>
                <c:pt idx="645">
                  <c:v>1286</c:v>
                </c:pt>
                <c:pt idx="646">
                  <c:v>1287</c:v>
                </c:pt>
                <c:pt idx="647">
                  <c:v>1288</c:v>
                </c:pt>
                <c:pt idx="648">
                  <c:v>1291</c:v>
                </c:pt>
                <c:pt idx="649">
                  <c:v>1292</c:v>
                </c:pt>
                <c:pt idx="650">
                  <c:v>1294</c:v>
                </c:pt>
                <c:pt idx="651">
                  <c:v>1296</c:v>
                </c:pt>
                <c:pt idx="652">
                  <c:v>1300</c:v>
                </c:pt>
                <c:pt idx="653">
                  <c:v>1304</c:v>
                </c:pt>
                <c:pt idx="654">
                  <c:v>1305</c:v>
                </c:pt>
                <c:pt idx="655">
                  <c:v>1309</c:v>
                </c:pt>
                <c:pt idx="656">
                  <c:v>1312</c:v>
                </c:pt>
                <c:pt idx="657">
                  <c:v>1315</c:v>
                </c:pt>
                <c:pt idx="658">
                  <c:v>1318</c:v>
                </c:pt>
                <c:pt idx="659">
                  <c:v>1319</c:v>
                </c:pt>
                <c:pt idx="660">
                  <c:v>1320</c:v>
                </c:pt>
                <c:pt idx="661">
                  <c:v>1321</c:v>
                </c:pt>
                <c:pt idx="662">
                  <c:v>1324</c:v>
                </c:pt>
                <c:pt idx="663">
                  <c:v>1326</c:v>
                </c:pt>
                <c:pt idx="664">
                  <c:v>1327</c:v>
                </c:pt>
                <c:pt idx="665">
                  <c:v>1328</c:v>
                </c:pt>
                <c:pt idx="666">
                  <c:v>1330</c:v>
                </c:pt>
                <c:pt idx="667">
                  <c:v>1332</c:v>
                </c:pt>
                <c:pt idx="668">
                  <c:v>1337</c:v>
                </c:pt>
                <c:pt idx="669">
                  <c:v>1338</c:v>
                </c:pt>
                <c:pt idx="670">
                  <c:v>1339</c:v>
                </c:pt>
                <c:pt idx="671">
                  <c:v>1340</c:v>
                </c:pt>
                <c:pt idx="672">
                  <c:v>1341</c:v>
                </c:pt>
                <c:pt idx="673">
                  <c:v>1342</c:v>
                </c:pt>
                <c:pt idx="674">
                  <c:v>1346</c:v>
                </c:pt>
                <c:pt idx="675">
                  <c:v>1349</c:v>
                </c:pt>
                <c:pt idx="676">
                  <c:v>1350</c:v>
                </c:pt>
                <c:pt idx="677">
                  <c:v>1352</c:v>
                </c:pt>
                <c:pt idx="678">
                  <c:v>1353</c:v>
                </c:pt>
                <c:pt idx="679">
                  <c:v>1354</c:v>
                </c:pt>
                <c:pt idx="680">
                  <c:v>1358</c:v>
                </c:pt>
                <c:pt idx="681">
                  <c:v>1359</c:v>
                </c:pt>
                <c:pt idx="682">
                  <c:v>1360</c:v>
                </c:pt>
                <c:pt idx="683">
                  <c:v>1363</c:v>
                </c:pt>
                <c:pt idx="684">
                  <c:v>1369</c:v>
                </c:pt>
                <c:pt idx="685">
                  <c:v>1370</c:v>
                </c:pt>
                <c:pt idx="686">
                  <c:v>1377</c:v>
                </c:pt>
                <c:pt idx="687">
                  <c:v>1379</c:v>
                </c:pt>
                <c:pt idx="688">
                  <c:v>1380</c:v>
                </c:pt>
                <c:pt idx="689">
                  <c:v>1381</c:v>
                </c:pt>
                <c:pt idx="690">
                  <c:v>1382</c:v>
                </c:pt>
                <c:pt idx="691">
                  <c:v>1385</c:v>
                </c:pt>
                <c:pt idx="692">
                  <c:v>1387</c:v>
                </c:pt>
                <c:pt idx="693">
                  <c:v>1388</c:v>
                </c:pt>
                <c:pt idx="694">
                  <c:v>1390</c:v>
                </c:pt>
                <c:pt idx="695">
                  <c:v>1391</c:v>
                </c:pt>
                <c:pt idx="696">
                  <c:v>1392</c:v>
                </c:pt>
                <c:pt idx="697">
                  <c:v>1393</c:v>
                </c:pt>
                <c:pt idx="698">
                  <c:v>1394</c:v>
                </c:pt>
                <c:pt idx="699">
                  <c:v>1395</c:v>
                </c:pt>
                <c:pt idx="700">
                  <c:v>1396</c:v>
                </c:pt>
                <c:pt idx="701">
                  <c:v>1398</c:v>
                </c:pt>
                <c:pt idx="702">
                  <c:v>1400</c:v>
                </c:pt>
                <c:pt idx="703">
                  <c:v>1401</c:v>
                </c:pt>
                <c:pt idx="704">
                  <c:v>1402</c:v>
                </c:pt>
                <c:pt idx="705">
                  <c:v>1404</c:v>
                </c:pt>
                <c:pt idx="706">
                  <c:v>1405</c:v>
                </c:pt>
                <c:pt idx="707">
                  <c:v>1407</c:v>
                </c:pt>
                <c:pt idx="708">
                  <c:v>1409</c:v>
                </c:pt>
                <c:pt idx="709">
                  <c:v>1410</c:v>
                </c:pt>
                <c:pt idx="710">
                  <c:v>1411</c:v>
                </c:pt>
                <c:pt idx="711">
                  <c:v>1412</c:v>
                </c:pt>
                <c:pt idx="712">
                  <c:v>1413</c:v>
                </c:pt>
                <c:pt idx="713">
                  <c:v>1414</c:v>
                </c:pt>
                <c:pt idx="714">
                  <c:v>1416</c:v>
                </c:pt>
                <c:pt idx="715">
                  <c:v>1418</c:v>
                </c:pt>
                <c:pt idx="716">
                  <c:v>1419</c:v>
                </c:pt>
                <c:pt idx="717">
                  <c:v>1421</c:v>
                </c:pt>
                <c:pt idx="718">
                  <c:v>1422</c:v>
                </c:pt>
                <c:pt idx="719">
                  <c:v>1423</c:v>
                </c:pt>
                <c:pt idx="720">
                  <c:v>1424</c:v>
                </c:pt>
                <c:pt idx="721">
                  <c:v>1432</c:v>
                </c:pt>
                <c:pt idx="722">
                  <c:v>1433</c:v>
                </c:pt>
                <c:pt idx="723">
                  <c:v>1434</c:v>
                </c:pt>
                <c:pt idx="724">
                  <c:v>1438</c:v>
                </c:pt>
                <c:pt idx="725">
                  <c:v>1441</c:v>
                </c:pt>
                <c:pt idx="726">
                  <c:v>1442</c:v>
                </c:pt>
                <c:pt idx="727">
                  <c:v>1447</c:v>
                </c:pt>
                <c:pt idx="728">
                  <c:v>1448</c:v>
                </c:pt>
                <c:pt idx="729">
                  <c:v>1449</c:v>
                </c:pt>
                <c:pt idx="730">
                  <c:v>1452</c:v>
                </c:pt>
                <c:pt idx="731">
                  <c:v>1453</c:v>
                </c:pt>
                <c:pt idx="732">
                  <c:v>1454</c:v>
                </c:pt>
                <c:pt idx="733">
                  <c:v>1455</c:v>
                </c:pt>
                <c:pt idx="734">
                  <c:v>1457</c:v>
                </c:pt>
                <c:pt idx="735">
                  <c:v>1459</c:v>
                </c:pt>
                <c:pt idx="736">
                  <c:v>1463</c:v>
                </c:pt>
                <c:pt idx="737">
                  <c:v>1464</c:v>
                </c:pt>
                <c:pt idx="738">
                  <c:v>1465</c:v>
                </c:pt>
                <c:pt idx="739">
                  <c:v>1466</c:v>
                </c:pt>
                <c:pt idx="740">
                  <c:v>1472</c:v>
                </c:pt>
                <c:pt idx="741">
                  <c:v>1474</c:v>
                </c:pt>
                <c:pt idx="742">
                  <c:v>1478</c:v>
                </c:pt>
                <c:pt idx="743">
                  <c:v>1479</c:v>
                </c:pt>
                <c:pt idx="744">
                  <c:v>1481</c:v>
                </c:pt>
                <c:pt idx="745">
                  <c:v>1482</c:v>
                </c:pt>
                <c:pt idx="746">
                  <c:v>1483</c:v>
                </c:pt>
                <c:pt idx="747">
                  <c:v>1484</c:v>
                </c:pt>
                <c:pt idx="748">
                  <c:v>1486</c:v>
                </c:pt>
                <c:pt idx="749">
                  <c:v>1490</c:v>
                </c:pt>
                <c:pt idx="750">
                  <c:v>1491</c:v>
                </c:pt>
                <c:pt idx="751">
                  <c:v>1492</c:v>
                </c:pt>
                <c:pt idx="752">
                  <c:v>1495</c:v>
                </c:pt>
                <c:pt idx="753">
                  <c:v>1498</c:v>
                </c:pt>
                <c:pt idx="754">
                  <c:v>1499</c:v>
                </c:pt>
                <c:pt idx="755">
                  <c:v>1501</c:v>
                </c:pt>
                <c:pt idx="756">
                  <c:v>1502</c:v>
                </c:pt>
                <c:pt idx="757">
                  <c:v>1503</c:v>
                </c:pt>
                <c:pt idx="758">
                  <c:v>1504</c:v>
                </c:pt>
                <c:pt idx="759">
                  <c:v>1505</c:v>
                </c:pt>
                <c:pt idx="760">
                  <c:v>1508</c:v>
                </c:pt>
                <c:pt idx="761">
                  <c:v>1509</c:v>
                </c:pt>
                <c:pt idx="762">
                  <c:v>1510</c:v>
                </c:pt>
                <c:pt idx="763">
                  <c:v>1511</c:v>
                </c:pt>
                <c:pt idx="764">
                  <c:v>1512</c:v>
                </c:pt>
                <c:pt idx="765">
                  <c:v>1513</c:v>
                </c:pt>
                <c:pt idx="766">
                  <c:v>1514</c:v>
                </c:pt>
                <c:pt idx="767">
                  <c:v>1515</c:v>
                </c:pt>
                <c:pt idx="768">
                  <c:v>1518</c:v>
                </c:pt>
                <c:pt idx="769">
                  <c:v>1519</c:v>
                </c:pt>
                <c:pt idx="770">
                  <c:v>1520</c:v>
                </c:pt>
                <c:pt idx="771">
                  <c:v>1521</c:v>
                </c:pt>
                <c:pt idx="772">
                  <c:v>1522</c:v>
                </c:pt>
                <c:pt idx="773">
                  <c:v>1525</c:v>
                </c:pt>
                <c:pt idx="774">
                  <c:v>1529</c:v>
                </c:pt>
                <c:pt idx="775">
                  <c:v>1536</c:v>
                </c:pt>
                <c:pt idx="776">
                  <c:v>1538</c:v>
                </c:pt>
                <c:pt idx="777">
                  <c:v>1539</c:v>
                </c:pt>
                <c:pt idx="778">
                  <c:v>1540</c:v>
                </c:pt>
                <c:pt idx="779">
                  <c:v>1543</c:v>
                </c:pt>
                <c:pt idx="780">
                  <c:v>1548</c:v>
                </c:pt>
                <c:pt idx="781">
                  <c:v>1552</c:v>
                </c:pt>
                <c:pt idx="782">
                  <c:v>1553</c:v>
                </c:pt>
                <c:pt idx="783">
                  <c:v>1554</c:v>
                </c:pt>
                <c:pt idx="784">
                  <c:v>1555</c:v>
                </c:pt>
                <c:pt idx="785">
                  <c:v>1556</c:v>
                </c:pt>
                <c:pt idx="786">
                  <c:v>1558</c:v>
                </c:pt>
                <c:pt idx="787">
                  <c:v>1561</c:v>
                </c:pt>
                <c:pt idx="788">
                  <c:v>1562</c:v>
                </c:pt>
                <c:pt idx="789">
                  <c:v>1563</c:v>
                </c:pt>
                <c:pt idx="790">
                  <c:v>1567</c:v>
                </c:pt>
                <c:pt idx="791">
                  <c:v>1571</c:v>
                </c:pt>
                <c:pt idx="792">
                  <c:v>1574</c:v>
                </c:pt>
                <c:pt idx="793">
                  <c:v>1578</c:v>
                </c:pt>
                <c:pt idx="794">
                  <c:v>1579</c:v>
                </c:pt>
                <c:pt idx="795">
                  <c:v>1580</c:v>
                </c:pt>
                <c:pt idx="796">
                  <c:v>1581</c:v>
                </c:pt>
                <c:pt idx="797">
                  <c:v>1582</c:v>
                </c:pt>
                <c:pt idx="798">
                  <c:v>1583</c:v>
                </c:pt>
                <c:pt idx="799">
                  <c:v>1585</c:v>
                </c:pt>
                <c:pt idx="800">
                  <c:v>1586</c:v>
                </c:pt>
                <c:pt idx="801">
                  <c:v>1587</c:v>
                </c:pt>
                <c:pt idx="802">
                  <c:v>1589</c:v>
                </c:pt>
                <c:pt idx="803">
                  <c:v>1590</c:v>
                </c:pt>
                <c:pt idx="804">
                  <c:v>1591</c:v>
                </c:pt>
                <c:pt idx="805">
                  <c:v>1592</c:v>
                </c:pt>
                <c:pt idx="806">
                  <c:v>1596</c:v>
                </c:pt>
                <c:pt idx="807">
                  <c:v>1597</c:v>
                </c:pt>
                <c:pt idx="808">
                  <c:v>1600</c:v>
                </c:pt>
                <c:pt idx="809">
                  <c:v>1601</c:v>
                </c:pt>
                <c:pt idx="810">
                  <c:v>1602</c:v>
                </c:pt>
                <c:pt idx="811">
                  <c:v>1604</c:v>
                </c:pt>
                <c:pt idx="812">
                  <c:v>1606</c:v>
                </c:pt>
                <c:pt idx="813">
                  <c:v>1608</c:v>
                </c:pt>
                <c:pt idx="814">
                  <c:v>1609</c:v>
                </c:pt>
                <c:pt idx="815">
                  <c:v>1612</c:v>
                </c:pt>
                <c:pt idx="816">
                  <c:v>1614</c:v>
                </c:pt>
                <c:pt idx="817">
                  <c:v>1615</c:v>
                </c:pt>
                <c:pt idx="818">
                  <c:v>1617</c:v>
                </c:pt>
                <c:pt idx="819">
                  <c:v>1619</c:v>
                </c:pt>
                <c:pt idx="820">
                  <c:v>1620</c:v>
                </c:pt>
                <c:pt idx="821">
                  <c:v>1627</c:v>
                </c:pt>
                <c:pt idx="822">
                  <c:v>1628</c:v>
                </c:pt>
                <c:pt idx="823">
                  <c:v>1629</c:v>
                </c:pt>
                <c:pt idx="824">
                  <c:v>1631</c:v>
                </c:pt>
                <c:pt idx="825">
                  <c:v>1632</c:v>
                </c:pt>
                <c:pt idx="826">
                  <c:v>1633</c:v>
                </c:pt>
                <c:pt idx="827">
                  <c:v>1635</c:v>
                </c:pt>
                <c:pt idx="828">
                  <c:v>1636</c:v>
                </c:pt>
                <c:pt idx="829">
                  <c:v>1641</c:v>
                </c:pt>
                <c:pt idx="830">
                  <c:v>1642</c:v>
                </c:pt>
                <c:pt idx="831">
                  <c:v>1644</c:v>
                </c:pt>
                <c:pt idx="832">
                  <c:v>1648</c:v>
                </c:pt>
                <c:pt idx="833">
                  <c:v>1649</c:v>
                </c:pt>
                <c:pt idx="834">
                  <c:v>1650</c:v>
                </c:pt>
                <c:pt idx="835">
                  <c:v>1655</c:v>
                </c:pt>
                <c:pt idx="836">
                  <c:v>1656</c:v>
                </c:pt>
                <c:pt idx="837">
                  <c:v>1657</c:v>
                </c:pt>
                <c:pt idx="838">
                  <c:v>1659</c:v>
                </c:pt>
                <c:pt idx="839">
                  <c:v>1661</c:v>
                </c:pt>
                <c:pt idx="840">
                  <c:v>1662</c:v>
                </c:pt>
                <c:pt idx="841">
                  <c:v>1663</c:v>
                </c:pt>
                <c:pt idx="842">
                  <c:v>1664</c:v>
                </c:pt>
                <c:pt idx="843">
                  <c:v>1665</c:v>
                </c:pt>
                <c:pt idx="844">
                  <c:v>1668</c:v>
                </c:pt>
                <c:pt idx="845">
                  <c:v>1670</c:v>
                </c:pt>
                <c:pt idx="846">
                  <c:v>1673</c:v>
                </c:pt>
                <c:pt idx="847">
                  <c:v>1676</c:v>
                </c:pt>
                <c:pt idx="848">
                  <c:v>1679</c:v>
                </c:pt>
                <c:pt idx="849">
                  <c:v>1681</c:v>
                </c:pt>
                <c:pt idx="850">
                  <c:v>1683</c:v>
                </c:pt>
                <c:pt idx="851">
                  <c:v>1687</c:v>
                </c:pt>
                <c:pt idx="852">
                  <c:v>1689</c:v>
                </c:pt>
                <c:pt idx="853">
                  <c:v>1690</c:v>
                </c:pt>
                <c:pt idx="854">
                  <c:v>1691</c:v>
                </c:pt>
                <c:pt idx="855">
                  <c:v>1694</c:v>
                </c:pt>
                <c:pt idx="856">
                  <c:v>1695</c:v>
                </c:pt>
                <c:pt idx="857">
                  <c:v>1697</c:v>
                </c:pt>
                <c:pt idx="858">
                  <c:v>1698</c:v>
                </c:pt>
                <c:pt idx="859">
                  <c:v>1699</c:v>
                </c:pt>
                <c:pt idx="860">
                  <c:v>1700</c:v>
                </c:pt>
                <c:pt idx="861">
                  <c:v>1701</c:v>
                </c:pt>
                <c:pt idx="862">
                  <c:v>1702</c:v>
                </c:pt>
                <c:pt idx="863">
                  <c:v>1703</c:v>
                </c:pt>
                <c:pt idx="864">
                  <c:v>1706</c:v>
                </c:pt>
                <c:pt idx="865">
                  <c:v>1707</c:v>
                </c:pt>
                <c:pt idx="866">
                  <c:v>1708</c:v>
                </c:pt>
                <c:pt idx="867">
                  <c:v>1709</c:v>
                </c:pt>
                <c:pt idx="868">
                  <c:v>1715</c:v>
                </c:pt>
                <c:pt idx="869">
                  <c:v>1718</c:v>
                </c:pt>
                <c:pt idx="870">
                  <c:v>1719</c:v>
                </c:pt>
                <c:pt idx="871">
                  <c:v>1720</c:v>
                </c:pt>
                <c:pt idx="872">
                  <c:v>1721</c:v>
                </c:pt>
                <c:pt idx="873">
                  <c:v>1722</c:v>
                </c:pt>
                <c:pt idx="874">
                  <c:v>1726</c:v>
                </c:pt>
                <c:pt idx="875">
                  <c:v>1729</c:v>
                </c:pt>
                <c:pt idx="876">
                  <c:v>1730</c:v>
                </c:pt>
                <c:pt idx="877">
                  <c:v>1731</c:v>
                </c:pt>
                <c:pt idx="878">
                  <c:v>1732</c:v>
                </c:pt>
                <c:pt idx="879">
                  <c:v>1733</c:v>
                </c:pt>
                <c:pt idx="880">
                  <c:v>1735</c:v>
                </c:pt>
                <c:pt idx="881">
                  <c:v>1736</c:v>
                </c:pt>
                <c:pt idx="882">
                  <c:v>1739</c:v>
                </c:pt>
                <c:pt idx="883">
                  <c:v>1741</c:v>
                </c:pt>
                <c:pt idx="884">
                  <c:v>1743</c:v>
                </c:pt>
                <c:pt idx="885">
                  <c:v>1745</c:v>
                </c:pt>
                <c:pt idx="886">
                  <c:v>1746</c:v>
                </c:pt>
                <c:pt idx="887">
                  <c:v>1748</c:v>
                </c:pt>
                <c:pt idx="888">
                  <c:v>1749</c:v>
                </c:pt>
                <c:pt idx="889">
                  <c:v>1760</c:v>
                </c:pt>
                <c:pt idx="890">
                  <c:v>1768</c:v>
                </c:pt>
                <c:pt idx="891">
                  <c:v>1772</c:v>
                </c:pt>
                <c:pt idx="892">
                  <c:v>1773</c:v>
                </c:pt>
                <c:pt idx="893">
                  <c:v>1778</c:v>
                </c:pt>
                <c:pt idx="894">
                  <c:v>1781</c:v>
                </c:pt>
                <c:pt idx="895">
                  <c:v>1784</c:v>
                </c:pt>
                <c:pt idx="896">
                  <c:v>1785</c:v>
                </c:pt>
                <c:pt idx="897">
                  <c:v>1788</c:v>
                </c:pt>
                <c:pt idx="898">
                  <c:v>1789</c:v>
                </c:pt>
                <c:pt idx="899">
                  <c:v>1791</c:v>
                </c:pt>
                <c:pt idx="900">
                  <c:v>1793</c:v>
                </c:pt>
                <c:pt idx="901">
                  <c:v>1794</c:v>
                </c:pt>
                <c:pt idx="902">
                  <c:v>1795</c:v>
                </c:pt>
                <c:pt idx="903">
                  <c:v>1796</c:v>
                </c:pt>
                <c:pt idx="904">
                  <c:v>1799</c:v>
                </c:pt>
                <c:pt idx="905">
                  <c:v>1800</c:v>
                </c:pt>
                <c:pt idx="906">
                  <c:v>1803</c:v>
                </c:pt>
                <c:pt idx="907">
                  <c:v>1805</c:v>
                </c:pt>
                <c:pt idx="908">
                  <c:v>1806</c:v>
                </c:pt>
                <c:pt idx="909">
                  <c:v>1807</c:v>
                </c:pt>
                <c:pt idx="910">
                  <c:v>1808</c:v>
                </c:pt>
                <c:pt idx="911">
                  <c:v>1809</c:v>
                </c:pt>
                <c:pt idx="912">
                  <c:v>1810</c:v>
                </c:pt>
                <c:pt idx="913">
                  <c:v>1812</c:v>
                </c:pt>
                <c:pt idx="914">
                  <c:v>1814</c:v>
                </c:pt>
                <c:pt idx="915">
                  <c:v>1818</c:v>
                </c:pt>
                <c:pt idx="916">
                  <c:v>1819</c:v>
                </c:pt>
                <c:pt idx="917">
                  <c:v>1826</c:v>
                </c:pt>
                <c:pt idx="918">
                  <c:v>1827</c:v>
                </c:pt>
                <c:pt idx="919">
                  <c:v>1828</c:v>
                </c:pt>
                <c:pt idx="920">
                  <c:v>1830</c:v>
                </c:pt>
                <c:pt idx="921">
                  <c:v>1834</c:v>
                </c:pt>
                <c:pt idx="922">
                  <c:v>1837</c:v>
                </c:pt>
                <c:pt idx="923">
                  <c:v>1838</c:v>
                </c:pt>
                <c:pt idx="924">
                  <c:v>1839</c:v>
                </c:pt>
                <c:pt idx="925">
                  <c:v>1840</c:v>
                </c:pt>
                <c:pt idx="926">
                  <c:v>1842</c:v>
                </c:pt>
                <c:pt idx="927">
                  <c:v>1843</c:v>
                </c:pt>
                <c:pt idx="928">
                  <c:v>1844</c:v>
                </c:pt>
                <c:pt idx="929">
                  <c:v>1845</c:v>
                </c:pt>
                <c:pt idx="930">
                  <c:v>1846</c:v>
                </c:pt>
                <c:pt idx="931">
                  <c:v>1848</c:v>
                </c:pt>
                <c:pt idx="932">
                  <c:v>1850</c:v>
                </c:pt>
                <c:pt idx="933">
                  <c:v>1851</c:v>
                </c:pt>
                <c:pt idx="934">
                  <c:v>1852</c:v>
                </c:pt>
                <c:pt idx="935">
                  <c:v>1853</c:v>
                </c:pt>
                <c:pt idx="936">
                  <c:v>1854</c:v>
                </c:pt>
                <c:pt idx="937">
                  <c:v>1855</c:v>
                </c:pt>
                <c:pt idx="938">
                  <c:v>1856</c:v>
                </c:pt>
                <c:pt idx="939">
                  <c:v>1859</c:v>
                </c:pt>
                <c:pt idx="940">
                  <c:v>1860</c:v>
                </c:pt>
                <c:pt idx="941">
                  <c:v>1861</c:v>
                </c:pt>
                <c:pt idx="942">
                  <c:v>1867</c:v>
                </c:pt>
                <c:pt idx="943">
                  <c:v>1868</c:v>
                </c:pt>
                <c:pt idx="944">
                  <c:v>1869</c:v>
                </c:pt>
                <c:pt idx="945">
                  <c:v>1871</c:v>
                </c:pt>
                <c:pt idx="946">
                  <c:v>1872</c:v>
                </c:pt>
                <c:pt idx="947">
                  <c:v>1875</c:v>
                </c:pt>
                <c:pt idx="948">
                  <c:v>1876</c:v>
                </c:pt>
                <c:pt idx="949">
                  <c:v>1878</c:v>
                </c:pt>
                <c:pt idx="950">
                  <c:v>1879</c:v>
                </c:pt>
                <c:pt idx="951">
                  <c:v>1880</c:v>
                </c:pt>
                <c:pt idx="952">
                  <c:v>1881</c:v>
                </c:pt>
                <c:pt idx="953">
                  <c:v>1883</c:v>
                </c:pt>
                <c:pt idx="954">
                  <c:v>1884</c:v>
                </c:pt>
                <c:pt idx="955">
                  <c:v>1886</c:v>
                </c:pt>
                <c:pt idx="956">
                  <c:v>1887</c:v>
                </c:pt>
                <c:pt idx="957">
                  <c:v>1888</c:v>
                </c:pt>
                <c:pt idx="958">
                  <c:v>1890</c:v>
                </c:pt>
                <c:pt idx="959">
                  <c:v>1892</c:v>
                </c:pt>
                <c:pt idx="960">
                  <c:v>1895</c:v>
                </c:pt>
                <c:pt idx="961">
                  <c:v>1897</c:v>
                </c:pt>
                <c:pt idx="962">
                  <c:v>1899</c:v>
                </c:pt>
                <c:pt idx="963">
                  <c:v>1900</c:v>
                </c:pt>
                <c:pt idx="964">
                  <c:v>1904</c:v>
                </c:pt>
                <c:pt idx="965">
                  <c:v>1905</c:v>
                </c:pt>
                <c:pt idx="966">
                  <c:v>1908</c:v>
                </c:pt>
                <c:pt idx="967">
                  <c:v>1909</c:v>
                </c:pt>
                <c:pt idx="968">
                  <c:v>1913</c:v>
                </c:pt>
                <c:pt idx="969">
                  <c:v>1914</c:v>
                </c:pt>
                <c:pt idx="970">
                  <c:v>1915</c:v>
                </c:pt>
                <c:pt idx="971">
                  <c:v>1916</c:v>
                </c:pt>
                <c:pt idx="972">
                  <c:v>1918</c:v>
                </c:pt>
                <c:pt idx="973">
                  <c:v>1920</c:v>
                </c:pt>
                <c:pt idx="974">
                  <c:v>1921</c:v>
                </c:pt>
                <c:pt idx="975">
                  <c:v>1923</c:v>
                </c:pt>
                <c:pt idx="976">
                  <c:v>1924</c:v>
                </c:pt>
                <c:pt idx="977">
                  <c:v>1925</c:v>
                </c:pt>
                <c:pt idx="978">
                  <c:v>1930</c:v>
                </c:pt>
                <c:pt idx="979">
                  <c:v>1931</c:v>
                </c:pt>
                <c:pt idx="980">
                  <c:v>1932</c:v>
                </c:pt>
                <c:pt idx="981">
                  <c:v>1934</c:v>
                </c:pt>
                <c:pt idx="982">
                  <c:v>1936</c:v>
                </c:pt>
                <c:pt idx="983">
                  <c:v>1937</c:v>
                </c:pt>
                <c:pt idx="984">
                  <c:v>1938</c:v>
                </c:pt>
                <c:pt idx="985">
                  <c:v>1940</c:v>
                </c:pt>
                <c:pt idx="986">
                  <c:v>1942</c:v>
                </c:pt>
                <c:pt idx="987">
                  <c:v>1943</c:v>
                </c:pt>
                <c:pt idx="988">
                  <c:v>1944</c:v>
                </c:pt>
                <c:pt idx="989">
                  <c:v>1945</c:v>
                </c:pt>
                <c:pt idx="990">
                  <c:v>1947</c:v>
                </c:pt>
                <c:pt idx="991">
                  <c:v>1956</c:v>
                </c:pt>
                <c:pt idx="992">
                  <c:v>1957</c:v>
                </c:pt>
                <c:pt idx="993">
                  <c:v>1959</c:v>
                </c:pt>
                <c:pt idx="994">
                  <c:v>1961</c:v>
                </c:pt>
                <c:pt idx="995">
                  <c:v>1964</c:v>
                </c:pt>
                <c:pt idx="996">
                  <c:v>1966</c:v>
                </c:pt>
                <c:pt idx="997">
                  <c:v>1967</c:v>
                </c:pt>
                <c:pt idx="998">
                  <c:v>1974</c:v>
                </c:pt>
                <c:pt idx="999">
                  <c:v>1977</c:v>
                </c:pt>
                <c:pt idx="1000">
                  <c:v>1981</c:v>
                </c:pt>
                <c:pt idx="1001">
                  <c:v>1982</c:v>
                </c:pt>
                <c:pt idx="1002">
                  <c:v>1983</c:v>
                </c:pt>
                <c:pt idx="1003">
                  <c:v>1984</c:v>
                </c:pt>
                <c:pt idx="1004">
                  <c:v>1989</c:v>
                </c:pt>
                <c:pt idx="1005">
                  <c:v>1990</c:v>
                </c:pt>
                <c:pt idx="1006">
                  <c:v>1993</c:v>
                </c:pt>
                <c:pt idx="1007">
                  <c:v>1994</c:v>
                </c:pt>
                <c:pt idx="1008">
                  <c:v>1995</c:v>
                </c:pt>
                <c:pt idx="1009">
                  <c:v>1996</c:v>
                </c:pt>
                <c:pt idx="1010">
                  <c:v>1997</c:v>
                </c:pt>
                <c:pt idx="1011">
                  <c:v>1998</c:v>
                </c:pt>
                <c:pt idx="1012">
                  <c:v>1999</c:v>
                </c:pt>
                <c:pt idx="1013">
                  <c:v>2000</c:v>
                </c:pt>
                <c:pt idx="1014">
                  <c:v>2001</c:v>
                </c:pt>
                <c:pt idx="1015">
                  <c:v>2002</c:v>
                </c:pt>
                <c:pt idx="1016">
                  <c:v>2003</c:v>
                </c:pt>
                <c:pt idx="1017">
                  <c:v>2005</c:v>
                </c:pt>
                <c:pt idx="1018">
                  <c:v>2006</c:v>
                </c:pt>
                <c:pt idx="1019">
                  <c:v>2007</c:v>
                </c:pt>
                <c:pt idx="1020">
                  <c:v>2008</c:v>
                </c:pt>
                <c:pt idx="1021">
                  <c:v>2009</c:v>
                </c:pt>
                <c:pt idx="1022">
                  <c:v>2011</c:v>
                </c:pt>
                <c:pt idx="1023">
                  <c:v>2012</c:v>
                </c:pt>
                <c:pt idx="1024">
                  <c:v>2013</c:v>
                </c:pt>
                <c:pt idx="1025">
                  <c:v>2014</c:v>
                </c:pt>
                <c:pt idx="1026">
                  <c:v>2015</c:v>
                </c:pt>
                <c:pt idx="1027">
                  <c:v>2016</c:v>
                </c:pt>
                <c:pt idx="1028">
                  <c:v>2017</c:v>
                </c:pt>
                <c:pt idx="1029">
                  <c:v>2018</c:v>
                </c:pt>
                <c:pt idx="1030">
                  <c:v>2019</c:v>
                </c:pt>
                <c:pt idx="1031">
                  <c:v>2021</c:v>
                </c:pt>
                <c:pt idx="1032">
                  <c:v>2022</c:v>
                </c:pt>
                <c:pt idx="1033">
                  <c:v>2023</c:v>
                </c:pt>
                <c:pt idx="1034">
                  <c:v>2024</c:v>
                </c:pt>
                <c:pt idx="1035">
                  <c:v>2028</c:v>
                </c:pt>
                <c:pt idx="1036">
                  <c:v>2034</c:v>
                </c:pt>
                <c:pt idx="1037">
                  <c:v>2036</c:v>
                </c:pt>
                <c:pt idx="1038">
                  <c:v>2037</c:v>
                </c:pt>
                <c:pt idx="1039">
                  <c:v>2041</c:v>
                </c:pt>
                <c:pt idx="1040">
                  <c:v>2042</c:v>
                </c:pt>
                <c:pt idx="1041">
                  <c:v>2043</c:v>
                </c:pt>
                <c:pt idx="1042">
                  <c:v>2045</c:v>
                </c:pt>
                <c:pt idx="1043">
                  <c:v>2047</c:v>
                </c:pt>
                <c:pt idx="1044">
                  <c:v>2050</c:v>
                </c:pt>
                <c:pt idx="1045">
                  <c:v>2051</c:v>
                </c:pt>
                <c:pt idx="1046">
                  <c:v>2052</c:v>
                </c:pt>
                <c:pt idx="1047">
                  <c:v>2057</c:v>
                </c:pt>
                <c:pt idx="1048">
                  <c:v>2059</c:v>
                </c:pt>
                <c:pt idx="1049">
                  <c:v>2060</c:v>
                </c:pt>
                <c:pt idx="1050">
                  <c:v>2062</c:v>
                </c:pt>
                <c:pt idx="1051">
                  <c:v>2063</c:v>
                </c:pt>
                <c:pt idx="1052">
                  <c:v>2066</c:v>
                </c:pt>
                <c:pt idx="1053">
                  <c:v>2069</c:v>
                </c:pt>
                <c:pt idx="1054">
                  <c:v>2072</c:v>
                </c:pt>
                <c:pt idx="1055">
                  <c:v>2073</c:v>
                </c:pt>
                <c:pt idx="1056">
                  <c:v>2074</c:v>
                </c:pt>
                <c:pt idx="1057">
                  <c:v>2075</c:v>
                </c:pt>
                <c:pt idx="1058">
                  <c:v>2078</c:v>
                </c:pt>
                <c:pt idx="1059">
                  <c:v>2079</c:v>
                </c:pt>
                <c:pt idx="1060">
                  <c:v>2081</c:v>
                </c:pt>
                <c:pt idx="1061">
                  <c:v>2088</c:v>
                </c:pt>
                <c:pt idx="1062">
                  <c:v>2089</c:v>
                </c:pt>
                <c:pt idx="1063">
                  <c:v>2094</c:v>
                </c:pt>
                <c:pt idx="1064">
                  <c:v>2095</c:v>
                </c:pt>
                <c:pt idx="1065">
                  <c:v>2097</c:v>
                </c:pt>
                <c:pt idx="1066">
                  <c:v>2100</c:v>
                </c:pt>
                <c:pt idx="1067">
                  <c:v>2101</c:v>
                </c:pt>
                <c:pt idx="1068">
                  <c:v>2102</c:v>
                </c:pt>
                <c:pt idx="1069">
                  <c:v>2104</c:v>
                </c:pt>
                <c:pt idx="1070">
                  <c:v>2105</c:v>
                </c:pt>
                <c:pt idx="1071">
                  <c:v>2109</c:v>
                </c:pt>
                <c:pt idx="1072">
                  <c:v>2114</c:v>
                </c:pt>
                <c:pt idx="1073">
                  <c:v>2117</c:v>
                </c:pt>
                <c:pt idx="1074">
                  <c:v>2122</c:v>
                </c:pt>
                <c:pt idx="1075">
                  <c:v>2126</c:v>
                </c:pt>
                <c:pt idx="1076">
                  <c:v>2127</c:v>
                </c:pt>
                <c:pt idx="1077">
                  <c:v>2128</c:v>
                </c:pt>
                <c:pt idx="1078">
                  <c:v>2132</c:v>
                </c:pt>
                <c:pt idx="1079">
                  <c:v>2134</c:v>
                </c:pt>
                <c:pt idx="1080">
                  <c:v>2136</c:v>
                </c:pt>
                <c:pt idx="1081">
                  <c:v>2137</c:v>
                </c:pt>
                <c:pt idx="1082">
                  <c:v>2140</c:v>
                </c:pt>
                <c:pt idx="1083">
                  <c:v>2141</c:v>
                </c:pt>
                <c:pt idx="1084">
                  <c:v>2142</c:v>
                </c:pt>
                <c:pt idx="1085">
                  <c:v>2143</c:v>
                </c:pt>
                <c:pt idx="1086">
                  <c:v>2144</c:v>
                </c:pt>
                <c:pt idx="1087">
                  <c:v>2145</c:v>
                </c:pt>
                <c:pt idx="1088">
                  <c:v>2147</c:v>
                </c:pt>
                <c:pt idx="1089">
                  <c:v>2148</c:v>
                </c:pt>
                <c:pt idx="1090">
                  <c:v>2149</c:v>
                </c:pt>
                <c:pt idx="1091">
                  <c:v>2152</c:v>
                </c:pt>
                <c:pt idx="1092">
                  <c:v>2153</c:v>
                </c:pt>
                <c:pt idx="1093">
                  <c:v>2155</c:v>
                </c:pt>
                <c:pt idx="1094">
                  <c:v>2157</c:v>
                </c:pt>
                <c:pt idx="1095">
                  <c:v>2159</c:v>
                </c:pt>
                <c:pt idx="1096">
                  <c:v>2162</c:v>
                </c:pt>
                <c:pt idx="1097">
                  <c:v>2163</c:v>
                </c:pt>
                <c:pt idx="1098">
                  <c:v>2164</c:v>
                </c:pt>
                <c:pt idx="1099">
                  <c:v>2165</c:v>
                </c:pt>
                <c:pt idx="1100">
                  <c:v>2172</c:v>
                </c:pt>
                <c:pt idx="1101">
                  <c:v>2175</c:v>
                </c:pt>
                <c:pt idx="1102">
                  <c:v>2176</c:v>
                </c:pt>
                <c:pt idx="1103">
                  <c:v>2178</c:v>
                </c:pt>
                <c:pt idx="1104">
                  <c:v>2180</c:v>
                </c:pt>
                <c:pt idx="1105">
                  <c:v>2181</c:v>
                </c:pt>
                <c:pt idx="1106">
                  <c:v>2182</c:v>
                </c:pt>
                <c:pt idx="1107">
                  <c:v>2184</c:v>
                </c:pt>
                <c:pt idx="1108">
                  <c:v>2185</c:v>
                </c:pt>
                <c:pt idx="1109">
                  <c:v>2186</c:v>
                </c:pt>
                <c:pt idx="1110">
                  <c:v>2187</c:v>
                </c:pt>
                <c:pt idx="1111">
                  <c:v>2192</c:v>
                </c:pt>
                <c:pt idx="1112">
                  <c:v>2193</c:v>
                </c:pt>
                <c:pt idx="1113">
                  <c:v>2194</c:v>
                </c:pt>
                <c:pt idx="1114">
                  <c:v>2196</c:v>
                </c:pt>
                <c:pt idx="1115">
                  <c:v>2198</c:v>
                </c:pt>
                <c:pt idx="1116">
                  <c:v>2199</c:v>
                </c:pt>
                <c:pt idx="1117">
                  <c:v>2200</c:v>
                </c:pt>
                <c:pt idx="1118">
                  <c:v>2201</c:v>
                </c:pt>
                <c:pt idx="1119">
                  <c:v>2203</c:v>
                </c:pt>
                <c:pt idx="1120">
                  <c:v>2204</c:v>
                </c:pt>
                <c:pt idx="1121">
                  <c:v>2205</c:v>
                </c:pt>
                <c:pt idx="1122">
                  <c:v>2207</c:v>
                </c:pt>
                <c:pt idx="1123">
                  <c:v>2209</c:v>
                </c:pt>
                <c:pt idx="1124">
                  <c:v>2211</c:v>
                </c:pt>
                <c:pt idx="1125">
                  <c:v>2215</c:v>
                </c:pt>
                <c:pt idx="1126">
                  <c:v>2223</c:v>
                </c:pt>
                <c:pt idx="1127">
                  <c:v>2224</c:v>
                </c:pt>
                <c:pt idx="1128">
                  <c:v>2228</c:v>
                </c:pt>
                <c:pt idx="1129">
                  <c:v>2230</c:v>
                </c:pt>
                <c:pt idx="1130">
                  <c:v>2235</c:v>
                </c:pt>
                <c:pt idx="1131">
                  <c:v>2243</c:v>
                </c:pt>
                <c:pt idx="1132">
                  <c:v>2244</c:v>
                </c:pt>
                <c:pt idx="1133">
                  <c:v>2245</c:v>
                </c:pt>
                <c:pt idx="1134">
                  <c:v>2246</c:v>
                </c:pt>
                <c:pt idx="1135">
                  <c:v>2248</c:v>
                </c:pt>
                <c:pt idx="1136">
                  <c:v>2250</c:v>
                </c:pt>
                <c:pt idx="1137">
                  <c:v>2252</c:v>
                </c:pt>
                <c:pt idx="1138">
                  <c:v>2253</c:v>
                </c:pt>
                <c:pt idx="1139">
                  <c:v>2254</c:v>
                </c:pt>
                <c:pt idx="1140">
                  <c:v>2255</c:v>
                </c:pt>
                <c:pt idx="1141">
                  <c:v>2257</c:v>
                </c:pt>
                <c:pt idx="1142">
                  <c:v>2258</c:v>
                </c:pt>
                <c:pt idx="1143">
                  <c:v>2260</c:v>
                </c:pt>
                <c:pt idx="1144">
                  <c:v>2261</c:v>
                </c:pt>
                <c:pt idx="1145">
                  <c:v>2262</c:v>
                </c:pt>
                <c:pt idx="1146">
                  <c:v>2263</c:v>
                </c:pt>
                <c:pt idx="1147">
                  <c:v>2264</c:v>
                </c:pt>
                <c:pt idx="1148">
                  <c:v>2265</c:v>
                </c:pt>
                <c:pt idx="1149">
                  <c:v>2266</c:v>
                </c:pt>
                <c:pt idx="1150">
                  <c:v>2269</c:v>
                </c:pt>
                <c:pt idx="1151">
                  <c:v>2270</c:v>
                </c:pt>
                <c:pt idx="1152">
                  <c:v>2271</c:v>
                </c:pt>
                <c:pt idx="1153">
                  <c:v>2273</c:v>
                </c:pt>
                <c:pt idx="1154">
                  <c:v>2274</c:v>
                </c:pt>
                <c:pt idx="1155">
                  <c:v>2275</c:v>
                </c:pt>
                <c:pt idx="1156">
                  <c:v>2276</c:v>
                </c:pt>
                <c:pt idx="1157">
                  <c:v>2277</c:v>
                </c:pt>
                <c:pt idx="1158">
                  <c:v>2278</c:v>
                </c:pt>
                <c:pt idx="1159">
                  <c:v>2281</c:v>
                </c:pt>
                <c:pt idx="1160">
                  <c:v>2284</c:v>
                </c:pt>
                <c:pt idx="1161">
                  <c:v>2285</c:v>
                </c:pt>
                <c:pt idx="1162">
                  <c:v>2287</c:v>
                </c:pt>
                <c:pt idx="1163">
                  <c:v>2290</c:v>
                </c:pt>
                <c:pt idx="1164">
                  <c:v>2292</c:v>
                </c:pt>
                <c:pt idx="1165">
                  <c:v>2293</c:v>
                </c:pt>
                <c:pt idx="1166">
                  <c:v>2294</c:v>
                </c:pt>
                <c:pt idx="1167">
                  <c:v>2295</c:v>
                </c:pt>
                <c:pt idx="1168">
                  <c:v>2296</c:v>
                </c:pt>
                <c:pt idx="1169">
                  <c:v>2298</c:v>
                </c:pt>
                <c:pt idx="1170">
                  <c:v>2299</c:v>
                </c:pt>
                <c:pt idx="1171">
                  <c:v>2300</c:v>
                </c:pt>
                <c:pt idx="1172">
                  <c:v>2302</c:v>
                </c:pt>
                <c:pt idx="1173">
                  <c:v>2305</c:v>
                </c:pt>
                <c:pt idx="1174">
                  <c:v>2306</c:v>
                </c:pt>
                <c:pt idx="1175">
                  <c:v>2307</c:v>
                </c:pt>
                <c:pt idx="1176">
                  <c:v>2308</c:v>
                </c:pt>
                <c:pt idx="1177">
                  <c:v>2309</c:v>
                </c:pt>
                <c:pt idx="1178">
                  <c:v>2310</c:v>
                </c:pt>
                <c:pt idx="1179">
                  <c:v>2311</c:v>
                </c:pt>
                <c:pt idx="1180">
                  <c:v>2313</c:v>
                </c:pt>
                <c:pt idx="1181">
                  <c:v>2315</c:v>
                </c:pt>
                <c:pt idx="1182">
                  <c:v>2317</c:v>
                </c:pt>
                <c:pt idx="1183">
                  <c:v>2318</c:v>
                </c:pt>
                <c:pt idx="1184">
                  <c:v>2319</c:v>
                </c:pt>
                <c:pt idx="1185">
                  <c:v>2320</c:v>
                </c:pt>
                <c:pt idx="1186">
                  <c:v>2321</c:v>
                </c:pt>
                <c:pt idx="1187">
                  <c:v>2323</c:v>
                </c:pt>
                <c:pt idx="1188">
                  <c:v>2325</c:v>
                </c:pt>
                <c:pt idx="1189">
                  <c:v>2326</c:v>
                </c:pt>
                <c:pt idx="1190">
                  <c:v>2327</c:v>
                </c:pt>
                <c:pt idx="1191">
                  <c:v>2328</c:v>
                </c:pt>
                <c:pt idx="1192">
                  <c:v>2331</c:v>
                </c:pt>
                <c:pt idx="1193">
                  <c:v>2333</c:v>
                </c:pt>
                <c:pt idx="1194">
                  <c:v>2336</c:v>
                </c:pt>
                <c:pt idx="1195">
                  <c:v>2339</c:v>
                </c:pt>
                <c:pt idx="1196">
                  <c:v>2342</c:v>
                </c:pt>
                <c:pt idx="1197">
                  <c:v>2346</c:v>
                </c:pt>
                <c:pt idx="1198">
                  <c:v>2348</c:v>
                </c:pt>
                <c:pt idx="1199">
                  <c:v>2349</c:v>
                </c:pt>
                <c:pt idx="1200">
                  <c:v>2350</c:v>
                </c:pt>
                <c:pt idx="1201">
                  <c:v>2355</c:v>
                </c:pt>
                <c:pt idx="1202">
                  <c:v>2357</c:v>
                </c:pt>
                <c:pt idx="1203">
                  <c:v>2358</c:v>
                </c:pt>
                <c:pt idx="1204">
                  <c:v>2361</c:v>
                </c:pt>
                <c:pt idx="1205">
                  <c:v>2363</c:v>
                </c:pt>
                <c:pt idx="1206">
                  <c:v>2365</c:v>
                </c:pt>
                <c:pt idx="1207">
                  <c:v>2367</c:v>
                </c:pt>
                <c:pt idx="1208">
                  <c:v>2371</c:v>
                </c:pt>
                <c:pt idx="1209">
                  <c:v>2372</c:v>
                </c:pt>
                <c:pt idx="1210">
                  <c:v>2373</c:v>
                </c:pt>
                <c:pt idx="1211">
                  <c:v>2375</c:v>
                </c:pt>
                <c:pt idx="1212">
                  <c:v>2378</c:v>
                </c:pt>
                <c:pt idx="1213">
                  <c:v>2380</c:v>
                </c:pt>
                <c:pt idx="1214">
                  <c:v>2383</c:v>
                </c:pt>
                <c:pt idx="1215">
                  <c:v>2384</c:v>
                </c:pt>
                <c:pt idx="1216">
                  <c:v>2386</c:v>
                </c:pt>
                <c:pt idx="1217">
                  <c:v>2387</c:v>
                </c:pt>
                <c:pt idx="1218">
                  <c:v>2391</c:v>
                </c:pt>
                <c:pt idx="1219">
                  <c:v>2392</c:v>
                </c:pt>
                <c:pt idx="1220">
                  <c:v>2396</c:v>
                </c:pt>
                <c:pt idx="1221">
                  <c:v>2399</c:v>
                </c:pt>
                <c:pt idx="1222">
                  <c:v>2402</c:v>
                </c:pt>
                <c:pt idx="1223">
                  <c:v>2406</c:v>
                </c:pt>
                <c:pt idx="1224">
                  <c:v>2407</c:v>
                </c:pt>
                <c:pt idx="1225">
                  <c:v>2408</c:v>
                </c:pt>
                <c:pt idx="1226">
                  <c:v>2409</c:v>
                </c:pt>
                <c:pt idx="1227">
                  <c:v>2410</c:v>
                </c:pt>
                <c:pt idx="1228">
                  <c:v>2415</c:v>
                </c:pt>
                <c:pt idx="1229">
                  <c:v>2416</c:v>
                </c:pt>
                <c:pt idx="1230">
                  <c:v>2418</c:v>
                </c:pt>
                <c:pt idx="1231">
                  <c:v>2419</c:v>
                </c:pt>
                <c:pt idx="1232">
                  <c:v>2421</c:v>
                </c:pt>
                <c:pt idx="1233">
                  <c:v>2422</c:v>
                </c:pt>
                <c:pt idx="1234">
                  <c:v>2424</c:v>
                </c:pt>
                <c:pt idx="1235">
                  <c:v>2426</c:v>
                </c:pt>
                <c:pt idx="1236">
                  <c:v>2427</c:v>
                </c:pt>
                <c:pt idx="1237">
                  <c:v>2431</c:v>
                </c:pt>
                <c:pt idx="1238">
                  <c:v>2432</c:v>
                </c:pt>
                <c:pt idx="1239">
                  <c:v>2433</c:v>
                </c:pt>
                <c:pt idx="1240">
                  <c:v>2434</c:v>
                </c:pt>
                <c:pt idx="1241">
                  <c:v>2435</c:v>
                </c:pt>
                <c:pt idx="1242">
                  <c:v>2438</c:v>
                </c:pt>
                <c:pt idx="1243">
                  <c:v>2441</c:v>
                </c:pt>
                <c:pt idx="1244">
                  <c:v>2442</c:v>
                </c:pt>
                <c:pt idx="1245">
                  <c:v>2443</c:v>
                </c:pt>
                <c:pt idx="1246">
                  <c:v>2444</c:v>
                </c:pt>
                <c:pt idx="1247">
                  <c:v>2447</c:v>
                </c:pt>
                <c:pt idx="1248">
                  <c:v>2449</c:v>
                </c:pt>
                <c:pt idx="1249">
                  <c:v>2450</c:v>
                </c:pt>
                <c:pt idx="1250">
                  <c:v>2455</c:v>
                </c:pt>
                <c:pt idx="1251">
                  <c:v>2458</c:v>
                </c:pt>
                <c:pt idx="1252">
                  <c:v>2459</c:v>
                </c:pt>
                <c:pt idx="1253">
                  <c:v>2460</c:v>
                </c:pt>
                <c:pt idx="1254">
                  <c:v>2461</c:v>
                </c:pt>
                <c:pt idx="1255">
                  <c:v>2462</c:v>
                </c:pt>
                <c:pt idx="1256">
                  <c:v>2463</c:v>
                </c:pt>
                <c:pt idx="1257">
                  <c:v>2464</c:v>
                </c:pt>
                <c:pt idx="1258">
                  <c:v>2467</c:v>
                </c:pt>
                <c:pt idx="1259">
                  <c:v>2469</c:v>
                </c:pt>
                <c:pt idx="1260">
                  <c:v>2470</c:v>
                </c:pt>
                <c:pt idx="1261">
                  <c:v>2472</c:v>
                </c:pt>
                <c:pt idx="1262">
                  <c:v>2473</c:v>
                </c:pt>
                <c:pt idx="1263">
                  <c:v>2476</c:v>
                </c:pt>
                <c:pt idx="1264">
                  <c:v>2477</c:v>
                </c:pt>
                <c:pt idx="1265">
                  <c:v>2479</c:v>
                </c:pt>
                <c:pt idx="1266">
                  <c:v>2480</c:v>
                </c:pt>
                <c:pt idx="1267">
                  <c:v>2481</c:v>
                </c:pt>
                <c:pt idx="1268">
                  <c:v>2483</c:v>
                </c:pt>
                <c:pt idx="1269">
                  <c:v>2485</c:v>
                </c:pt>
                <c:pt idx="1270">
                  <c:v>2486</c:v>
                </c:pt>
                <c:pt idx="1271">
                  <c:v>2488</c:v>
                </c:pt>
                <c:pt idx="1272">
                  <c:v>2489</c:v>
                </c:pt>
                <c:pt idx="1273">
                  <c:v>2490</c:v>
                </c:pt>
                <c:pt idx="1274">
                  <c:v>2492</c:v>
                </c:pt>
                <c:pt idx="1275">
                  <c:v>2493</c:v>
                </c:pt>
                <c:pt idx="1276">
                  <c:v>2500</c:v>
                </c:pt>
                <c:pt idx="1277">
                  <c:v>2501</c:v>
                </c:pt>
                <c:pt idx="1278">
                  <c:v>2507</c:v>
                </c:pt>
                <c:pt idx="1279">
                  <c:v>2508</c:v>
                </c:pt>
                <c:pt idx="1280">
                  <c:v>2511</c:v>
                </c:pt>
                <c:pt idx="1281">
                  <c:v>2513</c:v>
                </c:pt>
                <c:pt idx="1282">
                  <c:v>2514</c:v>
                </c:pt>
                <c:pt idx="1283">
                  <c:v>2518</c:v>
                </c:pt>
                <c:pt idx="1284">
                  <c:v>2519</c:v>
                </c:pt>
                <c:pt idx="1285">
                  <c:v>2520</c:v>
                </c:pt>
                <c:pt idx="1286">
                  <c:v>2521</c:v>
                </c:pt>
                <c:pt idx="1287">
                  <c:v>2522</c:v>
                </c:pt>
                <c:pt idx="1288">
                  <c:v>2524</c:v>
                </c:pt>
                <c:pt idx="1289">
                  <c:v>2525</c:v>
                </c:pt>
                <c:pt idx="1290">
                  <c:v>2527</c:v>
                </c:pt>
                <c:pt idx="1291">
                  <c:v>2528</c:v>
                </c:pt>
                <c:pt idx="1292">
                  <c:v>2530</c:v>
                </c:pt>
                <c:pt idx="1293">
                  <c:v>2531</c:v>
                </c:pt>
                <c:pt idx="1294">
                  <c:v>2532</c:v>
                </c:pt>
                <c:pt idx="1295">
                  <c:v>2534</c:v>
                </c:pt>
                <c:pt idx="1296">
                  <c:v>2535</c:v>
                </c:pt>
                <c:pt idx="1297">
                  <c:v>2537</c:v>
                </c:pt>
                <c:pt idx="1298">
                  <c:v>2538</c:v>
                </c:pt>
                <c:pt idx="1299">
                  <c:v>2539</c:v>
                </c:pt>
                <c:pt idx="1300">
                  <c:v>2540</c:v>
                </c:pt>
                <c:pt idx="1301">
                  <c:v>2545</c:v>
                </c:pt>
                <c:pt idx="1302">
                  <c:v>2548</c:v>
                </c:pt>
                <c:pt idx="1303">
                  <c:v>2549</c:v>
                </c:pt>
                <c:pt idx="1304">
                  <c:v>2551</c:v>
                </c:pt>
                <c:pt idx="1305">
                  <c:v>2552</c:v>
                </c:pt>
                <c:pt idx="1306">
                  <c:v>2559</c:v>
                </c:pt>
                <c:pt idx="1307">
                  <c:v>2560</c:v>
                </c:pt>
                <c:pt idx="1308">
                  <c:v>2562</c:v>
                </c:pt>
                <c:pt idx="1309">
                  <c:v>2563</c:v>
                </c:pt>
                <c:pt idx="1310">
                  <c:v>2564</c:v>
                </c:pt>
                <c:pt idx="1311">
                  <c:v>2565</c:v>
                </c:pt>
                <c:pt idx="1312">
                  <c:v>2566</c:v>
                </c:pt>
                <c:pt idx="1313">
                  <c:v>2569</c:v>
                </c:pt>
                <c:pt idx="1314">
                  <c:v>2570</c:v>
                </c:pt>
                <c:pt idx="1315">
                  <c:v>2571</c:v>
                </c:pt>
                <c:pt idx="1316">
                  <c:v>2573</c:v>
                </c:pt>
                <c:pt idx="1317">
                  <c:v>2574</c:v>
                </c:pt>
                <c:pt idx="1318">
                  <c:v>2575</c:v>
                </c:pt>
                <c:pt idx="1319">
                  <c:v>2579</c:v>
                </c:pt>
                <c:pt idx="1320">
                  <c:v>2580</c:v>
                </c:pt>
                <c:pt idx="1321">
                  <c:v>2582</c:v>
                </c:pt>
                <c:pt idx="1322">
                  <c:v>2583</c:v>
                </c:pt>
                <c:pt idx="1323">
                  <c:v>2585</c:v>
                </c:pt>
                <c:pt idx="1324">
                  <c:v>2587</c:v>
                </c:pt>
                <c:pt idx="1325">
                  <c:v>2588</c:v>
                </c:pt>
                <c:pt idx="1326">
                  <c:v>2592</c:v>
                </c:pt>
                <c:pt idx="1327">
                  <c:v>2594</c:v>
                </c:pt>
                <c:pt idx="1328">
                  <c:v>2597</c:v>
                </c:pt>
                <c:pt idx="1329">
                  <c:v>2598</c:v>
                </c:pt>
                <c:pt idx="1330">
                  <c:v>2599</c:v>
                </c:pt>
                <c:pt idx="1331">
                  <c:v>2601</c:v>
                </c:pt>
                <c:pt idx="1332">
                  <c:v>2602</c:v>
                </c:pt>
                <c:pt idx="1333">
                  <c:v>2608</c:v>
                </c:pt>
                <c:pt idx="1334">
                  <c:v>2615</c:v>
                </c:pt>
                <c:pt idx="1335">
                  <c:v>2616</c:v>
                </c:pt>
                <c:pt idx="1336">
                  <c:v>2618</c:v>
                </c:pt>
                <c:pt idx="1337">
                  <c:v>2619</c:v>
                </c:pt>
                <c:pt idx="1338">
                  <c:v>2620</c:v>
                </c:pt>
                <c:pt idx="1339">
                  <c:v>2623</c:v>
                </c:pt>
                <c:pt idx="1340">
                  <c:v>2624</c:v>
                </c:pt>
                <c:pt idx="1341">
                  <c:v>2627</c:v>
                </c:pt>
                <c:pt idx="1342">
                  <c:v>2631</c:v>
                </c:pt>
                <c:pt idx="1343">
                  <c:v>2636</c:v>
                </c:pt>
                <c:pt idx="1344">
                  <c:v>2638</c:v>
                </c:pt>
                <c:pt idx="1345">
                  <c:v>2639</c:v>
                </c:pt>
                <c:pt idx="1346">
                  <c:v>2640</c:v>
                </c:pt>
                <c:pt idx="1347">
                  <c:v>2641</c:v>
                </c:pt>
                <c:pt idx="1348">
                  <c:v>2644</c:v>
                </c:pt>
                <c:pt idx="1349">
                  <c:v>2645</c:v>
                </c:pt>
                <c:pt idx="1350">
                  <c:v>2646</c:v>
                </c:pt>
                <c:pt idx="1351">
                  <c:v>2647</c:v>
                </c:pt>
                <c:pt idx="1352">
                  <c:v>2648</c:v>
                </c:pt>
                <c:pt idx="1353">
                  <c:v>2651</c:v>
                </c:pt>
                <c:pt idx="1354">
                  <c:v>2652</c:v>
                </c:pt>
                <c:pt idx="1355">
                  <c:v>2653</c:v>
                </c:pt>
                <c:pt idx="1356">
                  <c:v>2655</c:v>
                </c:pt>
                <c:pt idx="1357">
                  <c:v>2657</c:v>
                </c:pt>
                <c:pt idx="1358">
                  <c:v>2660</c:v>
                </c:pt>
                <c:pt idx="1359">
                  <c:v>2662</c:v>
                </c:pt>
                <c:pt idx="1360">
                  <c:v>2664</c:v>
                </c:pt>
                <c:pt idx="1361">
                  <c:v>2666</c:v>
                </c:pt>
                <c:pt idx="1362">
                  <c:v>2667</c:v>
                </c:pt>
                <c:pt idx="1363">
                  <c:v>2669</c:v>
                </c:pt>
                <c:pt idx="1364">
                  <c:v>2672</c:v>
                </c:pt>
                <c:pt idx="1365">
                  <c:v>2677</c:v>
                </c:pt>
                <c:pt idx="1366">
                  <c:v>2678</c:v>
                </c:pt>
                <c:pt idx="1367">
                  <c:v>2684</c:v>
                </c:pt>
                <c:pt idx="1368">
                  <c:v>2687</c:v>
                </c:pt>
                <c:pt idx="1369">
                  <c:v>2688</c:v>
                </c:pt>
                <c:pt idx="1370">
                  <c:v>2690</c:v>
                </c:pt>
                <c:pt idx="1371">
                  <c:v>2691</c:v>
                </c:pt>
                <c:pt idx="1372">
                  <c:v>2694</c:v>
                </c:pt>
                <c:pt idx="1373">
                  <c:v>2699</c:v>
                </c:pt>
                <c:pt idx="1374">
                  <c:v>2701</c:v>
                </c:pt>
                <c:pt idx="1375">
                  <c:v>2702</c:v>
                </c:pt>
                <c:pt idx="1376">
                  <c:v>2704</c:v>
                </c:pt>
                <c:pt idx="1377">
                  <c:v>2705</c:v>
                </c:pt>
                <c:pt idx="1378">
                  <c:v>2706</c:v>
                </c:pt>
                <c:pt idx="1379">
                  <c:v>2708</c:v>
                </c:pt>
                <c:pt idx="1380">
                  <c:v>2709</c:v>
                </c:pt>
                <c:pt idx="1381">
                  <c:v>2714</c:v>
                </c:pt>
                <c:pt idx="1382">
                  <c:v>2715</c:v>
                </c:pt>
                <c:pt idx="1383">
                  <c:v>2717</c:v>
                </c:pt>
                <c:pt idx="1384">
                  <c:v>2718</c:v>
                </c:pt>
                <c:pt idx="1385">
                  <c:v>2720</c:v>
                </c:pt>
                <c:pt idx="1386">
                  <c:v>2724</c:v>
                </c:pt>
                <c:pt idx="1387">
                  <c:v>2725</c:v>
                </c:pt>
                <c:pt idx="1388">
                  <c:v>2726</c:v>
                </c:pt>
                <c:pt idx="1389">
                  <c:v>2727</c:v>
                </c:pt>
                <c:pt idx="1390">
                  <c:v>2728</c:v>
                </c:pt>
                <c:pt idx="1391">
                  <c:v>2733</c:v>
                </c:pt>
                <c:pt idx="1392">
                  <c:v>2734</c:v>
                </c:pt>
                <c:pt idx="1393">
                  <c:v>2735</c:v>
                </c:pt>
                <c:pt idx="1394">
                  <c:v>2736</c:v>
                </c:pt>
                <c:pt idx="1395">
                  <c:v>2738</c:v>
                </c:pt>
                <c:pt idx="1396">
                  <c:v>2741</c:v>
                </c:pt>
                <c:pt idx="1397">
                  <c:v>2742</c:v>
                </c:pt>
                <c:pt idx="1398">
                  <c:v>2743</c:v>
                </c:pt>
                <c:pt idx="1399">
                  <c:v>2744</c:v>
                </c:pt>
                <c:pt idx="1400">
                  <c:v>2746</c:v>
                </c:pt>
                <c:pt idx="1401">
                  <c:v>2747</c:v>
                </c:pt>
                <c:pt idx="1402">
                  <c:v>2748</c:v>
                </c:pt>
                <c:pt idx="1403">
                  <c:v>2749</c:v>
                </c:pt>
                <c:pt idx="1404">
                  <c:v>2750</c:v>
                </c:pt>
                <c:pt idx="1405">
                  <c:v>2752</c:v>
                </c:pt>
                <c:pt idx="1406">
                  <c:v>2754</c:v>
                </c:pt>
                <c:pt idx="1407">
                  <c:v>2756</c:v>
                </c:pt>
                <c:pt idx="1408">
                  <c:v>2758</c:v>
                </c:pt>
                <c:pt idx="1409">
                  <c:v>2759</c:v>
                </c:pt>
                <c:pt idx="1410">
                  <c:v>2761</c:v>
                </c:pt>
                <c:pt idx="1411">
                  <c:v>2762</c:v>
                </c:pt>
                <c:pt idx="1412">
                  <c:v>2763</c:v>
                </c:pt>
                <c:pt idx="1413">
                  <c:v>2766</c:v>
                </c:pt>
                <c:pt idx="1414">
                  <c:v>2767</c:v>
                </c:pt>
                <c:pt idx="1415">
                  <c:v>2768</c:v>
                </c:pt>
                <c:pt idx="1416">
                  <c:v>2771</c:v>
                </c:pt>
                <c:pt idx="1417">
                  <c:v>2772</c:v>
                </c:pt>
                <c:pt idx="1418">
                  <c:v>2773</c:v>
                </c:pt>
                <c:pt idx="1419">
                  <c:v>2775</c:v>
                </c:pt>
                <c:pt idx="1420">
                  <c:v>2776</c:v>
                </c:pt>
                <c:pt idx="1421">
                  <c:v>2777</c:v>
                </c:pt>
                <c:pt idx="1422">
                  <c:v>2779</c:v>
                </c:pt>
                <c:pt idx="1423">
                  <c:v>2780</c:v>
                </c:pt>
                <c:pt idx="1424">
                  <c:v>2783</c:v>
                </c:pt>
                <c:pt idx="1425">
                  <c:v>2784</c:v>
                </c:pt>
                <c:pt idx="1426">
                  <c:v>2785</c:v>
                </c:pt>
                <c:pt idx="1427">
                  <c:v>2786</c:v>
                </c:pt>
                <c:pt idx="1428">
                  <c:v>2787</c:v>
                </c:pt>
                <c:pt idx="1429">
                  <c:v>2790</c:v>
                </c:pt>
                <c:pt idx="1430">
                  <c:v>2796</c:v>
                </c:pt>
                <c:pt idx="1431">
                  <c:v>2797</c:v>
                </c:pt>
                <c:pt idx="1432">
                  <c:v>2799</c:v>
                </c:pt>
                <c:pt idx="1433">
                  <c:v>2800</c:v>
                </c:pt>
                <c:pt idx="1434">
                  <c:v>2802</c:v>
                </c:pt>
                <c:pt idx="1435">
                  <c:v>2803</c:v>
                </c:pt>
                <c:pt idx="1436">
                  <c:v>2804</c:v>
                </c:pt>
                <c:pt idx="1437">
                  <c:v>2809</c:v>
                </c:pt>
                <c:pt idx="1438">
                  <c:v>2810</c:v>
                </c:pt>
                <c:pt idx="1439">
                  <c:v>2813</c:v>
                </c:pt>
                <c:pt idx="1440">
                  <c:v>2815</c:v>
                </c:pt>
                <c:pt idx="1441">
                  <c:v>2817</c:v>
                </c:pt>
                <c:pt idx="1442">
                  <c:v>2818</c:v>
                </c:pt>
                <c:pt idx="1443">
                  <c:v>2819</c:v>
                </c:pt>
                <c:pt idx="1444">
                  <c:v>2820</c:v>
                </c:pt>
                <c:pt idx="1445">
                  <c:v>2821</c:v>
                </c:pt>
                <c:pt idx="1446">
                  <c:v>2823</c:v>
                </c:pt>
                <c:pt idx="1447">
                  <c:v>2824</c:v>
                </c:pt>
                <c:pt idx="1448">
                  <c:v>2826</c:v>
                </c:pt>
                <c:pt idx="1449">
                  <c:v>2827</c:v>
                </c:pt>
                <c:pt idx="1450">
                  <c:v>2828</c:v>
                </c:pt>
                <c:pt idx="1451">
                  <c:v>2829</c:v>
                </c:pt>
                <c:pt idx="1452">
                  <c:v>2831</c:v>
                </c:pt>
                <c:pt idx="1453">
                  <c:v>2832</c:v>
                </c:pt>
                <c:pt idx="1454">
                  <c:v>2833</c:v>
                </c:pt>
                <c:pt idx="1455">
                  <c:v>2834</c:v>
                </c:pt>
                <c:pt idx="1456">
                  <c:v>2835</c:v>
                </c:pt>
                <c:pt idx="1457">
                  <c:v>2836</c:v>
                </c:pt>
                <c:pt idx="1458">
                  <c:v>2840</c:v>
                </c:pt>
                <c:pt idx="1459">
                  <c:v>2842</c:v>
                </c:pt>
                <c:pt idx="1460">
                  <c:v>2843</c:v>
                </c:pt>
                <c:pt idx="1461">
                  <c:v>2847</c:v>
                </c:pt>
                <c:pt idx="1462">
                  <c:v>2848</c:v>
                </c:pt>
                <c:pt idx="1463">
                  <c:v>2849</c:v>
                </c:pt>
                <c:pt idx="1464">
                  <c:v>2851</c:v>
                </c:pt>
                <c:pt idx="1465">
                  <c:v>2853</c:v>
                </c:pt>
                <c:pt idx="1466">
                  <c:v>2854</c:v>
                </c:pt>
                <c:pt idx="1467">
                  <c:v>2855</c:v>
                </c:pt>
                <c:pt idx="1468">
                  <c:v>2856</c:v>
                </c:pt>
                <c:pt idx="1469">
                  <c:v>2857</c:v>
                </c:pt>
                <c:pt idx="1470">
                  <c:v>2858</c:v>
                </c:pt>
                <c:pt idx="1471">
                  <c:v>2861</c:v>
                </c:pt>
                <c:pt idx="1472">
                  <c:v>2862</c:v>
                </c:pt>
                <c:pt idx="1473">
                  <c:v>2863</c:v>
                </c:pt>
                <c:pt idx="1474">
                  <c:v>2865</c:v>
                </c:pt>
                <c:pt idx="1475">
                  <c:v>2869</c:v>
                </c:pt>
                <c:pt idx="1476">
                  <c:v>2870</c:v>
                </c:pt>
                <c:pt idx="1477">
                  <c:v>2872</c:v>
                </c:pt>
                <c:pt idx="1478">
                  <c:v>2873</c:v>
                </c:pt>
                <c:pt idx="1479">
                  <c:v>2874</c:v>
                </c:pt>
                <c:pt idx="1480">
                  <c:v>2875</c:v>
                </c:pt>
                <c:pt idx="1481">
                  <c:v>2876</c:v>
                </c:pt>
                <c:pt idx="1482">
                  <c:v>2877</c:v>
                </c:pt>
                <c:pt idx="1483">
                  <c:v>2880</c:v>
                </c:pt>
                <c:pt idx="1484">
                  <c:v>2881</c:v>
                </c:pt>
                <c:pt idx="1485">
                  <c:v>2882</c:v>
                </c:pt>
                <c:pt idx="1486">
                  <c:v>2883</c:v>
                </c:pt>
                <c:pt idx="1487">
                  <c:v>2884</c:v>
                </c:pt>
                <c:pt idx="1488">
                  <c:v>2885</c:v>
                </c:pt>
                <c:pt idx="1489">
                  <c:v>2887</c:v>
                </c:pt>
                <c:pt idx="1490">
                  <c:v>2888</c:v>
                </c:pt>
                <c:pt idx="1491">
                  <c:v>2889</c:v>
                </c:pt>
                <c:pt idx="1492">
                  <c:v>2893</c:v>
                </c:pt>
                <c:pt idx="1493">
                  <c:v>2894</c:v>
                </c:pt>
                <c:pt idx="1494">
                  <c:v>2897</c:v>
                </c:pt>
                <c:pt idx="1495">
                  <c:v>2900</c:v>
                </c:pt>
                <c:pt idx="1496">
                  <c:v>2905</c:v>
                </c:pt>
                <c:pt idx="1497">
                  <c:v>2906</c:v>
                </c:pt>
                <c:pt idx="1498">
                  <c:v>2907</c:v>
                </c:pt>
                <c:pt idx="1499">
                  <c:v>2908</c:v>
                </c:pt>
                <c:pt idx="1500">
                  <c:v>2910</c:v>
                </c:pt>
                <c:pt idx="1501">
                  <c:v>2911</c:v>
                </c:pt>
                <c:pt idx="1502">
                  <c:v>2912</c:v>
                </c:pt>
                <c:pt idx="1503">
                  <c:v>2915</c:v>
                </c:pt>
                <c:pt idx="1504">
                  <c:v>2919</c:v>
                </c:pt>
                <c:pt idx="1505">
                  <c:v>2921</c:v>
                </c:pt>
                <c:pt idx="1506">
                  <c:v>2922</c:v>
                </c:pt>
                <c:pt idx="1507">
                  <c:v>2923</c:v>
                </c:pt>
                <c:pt idx="1508">
                  <c:v>2924</c:v>
                </c:pt>
                <c:pt idx="1509">
                  <c:v>2925</c:v>
                </c:pt>
                <c:pt idx="1510">
                  <c:v>2926</c:v>
                </c:pt>
                <c:pt idx="1511">
                  <c:v>2927</c:v>
                </c:pt>
                <c:pt idx="1512">
                  <c:v>2929</c:v>
                </c:pt>
                <c:pt idx="1513">
                  <c:v>2937</c:v>
                </c:pt>
                <c:pt idx="1514">
                  <c:v>2938</c:v>
                </c:pt>
                <c:pt idx="1515">
                  <c:v>2940</c:v>
                </c:pt>
                <c:pt idx="1516">
                  <c:v>2941</c:v>
                </c:pt>
                <c:pt idx="1517">
                  <c:v>2942</c:v>
                </c:pt>
                <c:pt idx="1518">
                  <c:v>2944</c:v>
                </c:pt>
                <c:pt idx="1519">
                  <c:v>2946</c:v>
                </c:pt>
                <c:pt idx="1520">
                  <c:v>2950</c:v>
                </c:pt>
                <c:pt idx="1521">
                  <c:v>2951</c:v>
                </c:pt>
                <c:pt idx="1522">
                  <c:v>2952</c:v>
                </c:pt>
                <c:pt idx="1523">
                  <c:v>2955</c:v>
                </c:pt>
                <c:pt idx="1524">
                  <c:v>2956</c:v>
                </c:pt>
                <c:pt idx="1525">
                  <c:v>2957</c:v>
                </c:pt>
                <c:pt idx="1526">
                  <c:v>2958</c:v>
                </c:pt>
                <c:pt idx="1527">
                  <c:v>2959</c:v>
                </c:pt>
                <c:pt idx="1528">
                  <c:v>2961</c:v>
                </c:pt>
                <c:pt idx="1529">
                  <c:v>2964</c:v>
                </c:pt>
                <c:pt idx="1530">
                  <c:v>2967</c:v>
                </c:pt>
                <c:pt idx="1531">
                  <c:v>2968</c:v>
                </c:pt>
                <c:pt idx="1532">
                  <c:v>2969</c:v>
                </c:pt>
                <c:pt idx="1533">
                  <c:v>2970</c:v>
                </c:pt>
                <c:pt idx="1534">
                  <c:v>2971</c:v>
                </c:pt>
                <c:pt idx="1535">
                  <c:v>2972</c:v>
                </c:pt>
                <c:pt idx="1536">
                  <c:v>2973</c:v>
                </c:pt>
                <c:pt idx="1537">
                  <c:v>2974</c:v>
                </c:pt>
                <c:pt idx="1538">
                  <c:v>2975</c:v>
                </c:pt>
                <c:pt idx="1539">
                  <c:v>2976</c:v>
                </c:pt>
                <c:pt idx="1540">
                  <c:v>2977</c:v>
                </c:pt>
                <c:pt idx="1541">
                  <c:v>2978</c:v>
                </c:pt>
                <c:pt idx="1542">
                  <c:v>2980</c:v>
                </c:pt>
                <c:pt idx="1543">
                  <c:v>2982</c:v>
                </c:pt>
                <c:pt idx="1544">
                  <c:v>2983</c:v>
                </c:pt>
                <c:pt idx="1545">
                  <c:v>2985</c:v>
                </c:pt>
                <c:pt idx="1546">
                  <c:v>2986</c:v>
                </c:pt>
                <c:pt idx="1547">
                  <c:v>2987</c:v>
                </c:pt>
                <c:pt idx="1548">
                  <c:v>2989</c:v>
                </c:pt>
                <c:pt idx="1549">
                  <c:v>2990</c:v>
                </c:pt>
                <c:pt idx="1550">
                  <c:v>2992</c:v>
                </c:pt>
                <c:pt idx="1551">
                  <c:v>2993</c:v>
                </c:pt>
                <c:pt idx="1552">
                  <c:v>2995</c:v>
                </c:pt>
                <c:pt idx="1553">
                  <c:v>2996</c:v>
                </c:pt>
                <c:pt idx="1554">
                  <c:v>2997</c:v>
                </c:pt>
                <c:pt idx="1555">
                  <c:v>2999</c:v>
                </c:pt>
                <c:pt idx="1556">
                  <c:v>3003</c:v>
                </c:pt>
                <c:pt idx="1557">
                  <c:v>3005</c:v>
                </c:pt>
                <c:pt idx="1558">
                  <c:v>3007</c:v>
                </c:pt>
                <c:pt idx="1559">
                  <c:v>3008</c:v>
                </c:pt>
                <c:pt idx="1560">
                  <c:v>3010</c:v>
                </c:pt>
                <c:pt idx="1561">
                  <c:v>3011</c:v>
                </c:pt>
                <c:pt idx="1562">
                  <c:v>3012</c:v>
                </c:pt>
                <c:pt idx="1563">
                  <c:v>3013</c:v>
                </c:pt>
                <c:pt idx="1564">
                  <c:v>3014</c:v>
                </c:pt>
                <c:pt idx="1565">
                  <c:v>3016</c:v>
                </c:pt>
                <c:pt idx="1566">
                  <c:v>3017</c:v>
                </c:pt>
                <c:pt idx="1567">
                  <c:v>3020</c:v>
                </c:pt>
                <c:pt idx="1568">
                  <c:v>3021</c:v>
                </c:pt>
                <c:pt idx="1569">
                  <c:v>3022</c:v>
                </c:pt>
                <c:pt idx="1570">
                  <c:v>3023</c:v>
                </c:pt>
                <c:pt idx="1571">
                  <c:v>3024</c:v>
                </c:pt>
                <c:pt idx="1572">
                  <c:v>3025</c:v>
                </c:pt>
                <c:pt idx="1573">
                  <c:v>3026</c:v>
                </c:pt>
                <c:pt idx="1574">
                  <c:v>3027</c:v>
                </c:pt>
                <c:pt idx="1575">
                  <c:v>3028</c:v>
                </c:pt>
                <c:pt idx="1576">
                  <c:v>3031</c:v>
                </c:pt>
                <c:pt idx="1577">
                  <c:v>3032</c:v>
                </c:pt>
                <c:pt idx="1578">
                  <c:v>3036</c:v>
                </c:pt>
                <c:pt idx="1579">
                  <c:v>3037</c:v>
                </c:pt>
                <c:pt idx="1580">
                  <c:v>3038</c:v>
                </c:pt>
                <c:pt idx="1581">
                  <c:v>3039</c:v>
                </c:pt>
                <c:pt idx="1582">
                  <c:v>3040</c:v>
                </c:pt>
                <c:pt idx="1583">
                  <c:v>3041</c:v>
                </c:pt>
                <c:pt idx="1584">
                  <c:v>3042</c:v>
                </c:pt>
                <c:pt idx="1585">
                  <c:v>3043</c:v>
                </c:pt>
              </c:numCache>
            </c:numRef>
          </c:xVal>
          <c:yVal>
            <c:numRef>
              <c:f>'RNA1 DMS error rate'!$D$2:$D$1587</c:f>
              <c:numCache>
                <c:formatCode>General</c:formatCode>
                <c:ptCount val="1586"/>
                <c:pt idx="0">
                  <c:v>1.494396E-3</c:v>
                </c:pt>
                <c:pt idx="1">
                  <c:v>5.4600930000000001E-3</c:v>
                </c:pt>
                <c:pt idx="2">
                  <c:v>2.878158E-3</c:v>
                </c:pt>
                <c:pt idx="3">
                  <c:v>1.0928960000000001E-3</c:v>
                </c:pt>
                <c:pt idx="4">
                  <c:v>1.4040999999999999E-3</c:v>
                </c:pt>
                <c:pt idx="5">
                  <c:v>2.7266500000000001E-4</c:v>
                </c:pt>
                <c:pt idx="6">
                  <c:v>2.5504009999999999E-3</c:v>
                </c:pt>
                <c:pt idx="7">
                  <c:v>3.9280729999999998E-3</c:v>
                </c:pt>
                <c:pt idx="8">
                  <c:v>1.80072E-3</c:v>
                </c:pt>
                <c:pt idx="9">
                  <c:v>1.4110935999999999E-2</c:v>
                </c:pt>
                <c:pt idx="10">
                  <c:v>3.759676E-3</c:v>
                </c:pt>
                <c:pt idx="11">
                  <c:v>1.0113030000000001E-3</c:v>
                </c:pt>
                <c:pt idx="12">
                  <c:v>2.7784210000000001E-3</c:v>
                </c:pt>
                <c:pt idx="13">
                  <c:v>2.0695599999999998E-3</c:v>
                </c:pt>
                <c:pt idx="14">
                  <c:v>7.2186099999999997E-4</c:v>
                </c:pt>
                <c:pt idx="15">
                  <c:v>6.9474100000000002E-4</c:v>
                </c:pt>
                <c:pt idx="16">
                  <c:v>1.445609E-3</c:v>
                </c:pt>
                <c:pt idx="17">
                  <c:v>2.7166650000000001E-3</c:v>
                </c:pt>
                <c:pt idx="18">
                  <c:v>1.671332E-3</c:v>
                </c:pt>
                <c:pt idx="19">
                  <c:v>7.4844099999999997E-4</c:v>
                </c:pt>
                <c:pt idx="20">
                  <c:v>1.870762E-3</c:v>
                </c:pt>
                <c:pt idx="21">
                  <c:v>1.7811509999999999E-3</c:v>
                </c:pt>
                <c:pt idx="22">
                  <c:v>1.6576449999999999E-3</c:v>
                </c:pt>
                <c:pt idx="23">
                  <c:v>3.6788100000000002E-4</c:v>
                </c:pt>
                <c:pt idx="24">
                  <c:v>7.1877200000000001E-4</c:v>
                </c:pt>
                <c:pt idx="25">
                  <c:v>2.1163699999999998E-3</c:v>
                </c:pt>
                <c:pt idx="26">
                  <c:v>1.6961470000000001E-3</c:v>
                </c:pt>
                <c:pt idx="27">
                  <c:v>3.2969599999999998E-3</c:v>
                </c:pt>
                <c:pt idx="28">
                  <c:v>2.7338739999999999E-3</c:v>
                </c:pt>
                <c:pt idx="29">
                  <c:v>1.6358410000000001E-3</c:v>
                </c:pt>
                <c:pt idx="30">
                  <c:v>4.5179970000000002E-3</c:v>
                </c:pt>
                <c:pt idx="31">
                  <c:v>2.9041850000000001E-3</c:v>
                </c:pt>
                <c:pt idx="32">
                  <c:v>2.719253E-3</c:v>
                </c:pt>
                <c:pt idx="33">
                  <c:v>1.9984690000000001E-3</c:v>
                </c:pt>
                <c:pt idx="34">
                  <c:v>1.016121E-3</c:v>
                </c:pt>
                <c:pt idx="35">
                  <c:v>2.6060089999999998E-3</c:v>
                </c:pt>
                <c:pt idx="36">
                  <c:v>9.6886179999999995E-3</c:v>
                </c:pt>
                <c:pt idx="37">
                  <c:v>1.2561130000000001E-3</c:v>
                </c:pt>
                <c:pt idx="38">
                  <c:v>6.6701219999999997E-3</c:v>
                </c:pt>
                <c:pt idx="39">
                  <c:v>2.013174E-3</c:v>
                </c:pt>
                <c:pt idx="40">
                  <c:v>3.0048620000000001E-3</c:v>
                </c:pt>
                <c:pt idx="41">
                  <c:v>6.8965520000000002E-3</c:v>
                </c:pt>
                <c:pt idx="42">
                  <c:v>4.896989E-3</c:v>
                </c:pt>
                <c:pt idx="43">
                  <c:v>8.2028799999999996E-4</c:v>
                </c:pt>
                <c:pt idx="44">
                  <c:v>1.8641479999999999E-3</c:v>
                </c:pt>
                <c:pt idx="45">
                  <c:v>2.3505750000000001E-3</c:v>
                </c:pt>
                <c:pt idx="46">
                  <c:v>3.594131E-3</c:v>
                </c:pt>
                <c:pt idx="47">
                  <c:v>4.1042200000000002E-4</c:v>
                </c:pt>
                <c:pt idx="48">
                  <c:v>2.9922439999999998E-3</c:v>
                </c:pt>
                <c:pt idx="49">
                  <c:v>2.7398330000000001E-3</c:v>
                </c:pt>
                <c:pt idx="50">
                  <c:v>1.65094E-3</c:v>
                </c:pt>
                <c:pt idx="51">
                  <c:v>4.5882400000000004E-3</c:v>
                </c:pt>
                <c:pt idx="52">
                  <c:v>2.521489E-3</c:v>
                </c:pt>
                <c:pt idx="53">
                  <c:v>9.2973100000000005E-4</c:v>
                </c:pt>
                <c:pt idx="54">
                  <c:v>2.9922830000000001E-3</c:v>
                </c:pt>
                <c:pt idx="55">
                  <c:v>4.057199E-3</c:v>
                </c:pt>
                <c:pt idx="56">
                  <c:v>5.65512E-4</c:v>
                </c:pt>
                <c:pt idx="57">
                  <c:v>2.7028410000000001E-3</c:v>
                </c:pt>
                <c:pt idx="58">
                  <c:v>1.46721E-3</c:v>
                </c:pt>
                <c:pt idx="59">
                  <c:v>2.822026E-3</c:v>
                </c:pt>
                <c:pt idx="60">
                  <c:v>3.359618E-3</c:v>
                </c:pt>
                <c:pt idx="61">
                  <c:v>1.9414059999999999E-3</c:v>
                </c:pt>
                <c:pt idx="62">
                  <c:v>1.839203E-3</c:v>
                </c:pt>
                <c:pt idx="63">
                  <c:v>2.2940149999999999E-3</c:v>
                </c:pt>
                <c:pt idx="64">
                  <c:v>2.0840759999999998E-3</c:v>
                </c:pt>
                <c:pt idx="65">
                  <c:v>3.9449079999999996E-3</c:v>
                </c:pt>
                <c:pt idx="66">
                  <c:v>7.88863E-4</c:v>
                </c:pt>
                <c:pt idx="67">
                  <c:v>3.3644920000000002E-3</c:v>
                </c:pt>
                <c:pt idx="68">
                  <c:v>2.8609299999999998E-3</c:v>
                </c:pt>
                <c:pt idx="69">
                  <c:v>1.1916380000000001E-3</c:v>
                </c:pt>
                <c:pt idx="70">
                  <c:v>9.5451300000000004E-4</c:v>
                </c:pt>
                <c:pt idx="71">
                  <c:v>1.951976E-3</c:v>
                </c:pt>
                <c:pt idx="72">
                  <c:v>2.6953789999999999E-3</c:v>
                </c:pt>
                <c:pt idx="73">
                  <c:v>1.9557039999999999E-3</c:v>
                </c:pt>
                <c:pt idx="74">
                  <c:v>2.764163E-3</c:v>
                </c:pt>
                <c:pt idx="75">
                  <c:v>2.2915750000000001E-3</c:v>
                </c:pt>
                <c:pt idx="76">
                  <c:v>3.3801270000000001E-3</c:v>
                </c:pt>
                <c:pt idx="77">
                  <c:v>2.8671790000000001E-3</c:v>
                </c:pt>
                <c:pt idx="78">
                  <c:v>2.8359879999999998E-3</c:v>
                </c:pt>
                <c:pt idx="79">
                  <c:v>3.6882490000000002E-3</c:v>
                </c:pt>
                <c:pt idx="80">
                  <c:v>8.3618199999999998E-4</c:v>
                </c:pt>
                <c:pt idx="81">
                  <c:v>1.9586759999999999E-3</c:v>
                </c:pt>
                <c:pt idx="82">
                  <c:v>2.6089669999999998E-3</c:v>
                </c:pt>
                <c:pt idx="83">
                  <c:v>1.147501E-3</c:v>
                </c:pt>
                <c:pt idx="84">
                  <c:v>1.0120000000000001E-3</c:v>
                </c:pt>
                <c:pt idx="85">
                  <c:v>5.4271899999999999E-4</c:v>
                </c:pt>
                <c:pt idx="86">
                  <c:v>5.0980600000000002E-4</c:v>
                </c:pt>
                <c:pt idx="87">
                  <c:v>2.2803939999999998E-3</c:v>
                </c:pt>
                <c:pt idx="88">
                  <c:v>6.3476319999999998E-3</c:v>
                </c:pt>
                <c:pt idx="89">
                  <c:v>3.9913259999999999E-3</c:v>
                </c:pt>
                <c:pt idx="90">
                  <c:v>2.902193E-3</c:v>
                </c:pt>
                <c:pt idx="91">
                  <c:v>2.8649050000000001E-3</c:v>
                </c:pt>
                <c:pt idx="92">
                  <c:v>4.0155E-3</c:v>
                </c:pt>
                <c:pt idx="93">
                  <c:v>1.9916859999999999E-3</c:v>
                </c:pt>
                <c:pt idx="94">
                  <c:v>3.8164829999999999E-3</c:v>
                </c:pt>
                <c:pt idx="95">
                  <c:v>7.061711E-3</c:v>
                </c:pt>
                <c:pt idx="96">
                  <c:v>4.5991349999999999E-3</c:v>
                </c:pt>
                <c:pt idx="97">
                  <c:v>4.6295240000000003E-3</c:v>
                </c:pt>
                <c:pt idx="98">
                  <c:v>5.8774480000000004E-3</c:v>
                </c:pt>
                <c:pt idx="99">
                  <c:v>2.6455630000000001E-3</c:v>
                </c:pt>
                <c:pt idx="100">
                  <c:v>1.595593E-3</c:v>
                </c:pt>
                <c:pt idx="101">
                  <c:v>2.0908749999999999E-3</c:v>
                </c:pt>
                <c:pt idx="102">
                  <c:v>9.3436099999999998E-4</c:v>
                </c:pt>
                <c:pt idx="103">
                  <c:v>3.8522230000000001E-3</c:v>
                </c:pt>
                <c:pt idx="104">
                  <c:v>6.832266E-3</c:v>
                </c:pt>
                <c:pt idx="105">
                  <c:v>2.4763430000000002E-3</c:v>
                </c:pt>
                <c:pt idx="106">
                  <c:v>1.60976E-3</c:v>
                </c:pt>
                <c:pt idx="107">
                  <c:v>9.6193299999999999E-4</c:v>
                </c:pt>
                <c:pt idx="108">
                  <c:v>2.6105999999999998E-3</c:v>
                </c:pt>
                <c:pt idx="109">
                  <c:v>3.1108759999999998E-3</c:v>
                </c:pt>
                <c:pt idx="110">
                  <c:v>5.23413E-3</c:v>
                </c:pt>
                <c:pt idx="111">
                  <c:v>3.3557610000000001E-3</c:v>
                </c:pt>
                <c:pt idx="112">
                  <c:v>3.3323200000000002E-3</c:v>
                </c:pt>
                <c:pt idx="113">
                  <c:v>3.7908310000000001E-3</c:v>
                </c:pt>
                <c:pt idx="114">
                  <c:v>2.8752439999999999E-3</c:v>
                </c:pt>
                <c:pt idx="115">
                  <c:v>4.4983929999999998E-3</c:v>
                </c:pt>
                <c:pt idx="116">
                  <c:v>2.9083960000000002E-3</c:v>
                </c:pt>
                <c:pt idx="117">
                  <c:v>2.4636129999999999E-3</c:v>
                </c:pt>
                <c:pt idx="118">
                  <c:v>2.658859E-3</c:v>
                </c:pt>
                <c:pt idx="119">
                  <c:v>8.4102500000000002E-4</c:v>
                </c:pt>
                <c:pt idx="120">
                  <c:v>2.351634E-3</c:v>
                </c:pt>
                <c:pt idx="121">
                  <c:v>3.089091E-3</c:v>
                </c:pt>
                <c:pt idx="122">
                  <c:v>2.2953579999999999E-3</c:v>
                </c:pt>
                <c:pt idx="123">
                  <c:v>1.729738E-3</c:v>
                </c:pt>
                <c:pt idx="124">
                  <c:v>3.3570050000000001E-3</c:v>
                </c:pt>
                <c:pt idx="125">
                  <c:v>3.6365799999999999E-3</c:v>
                </c:pt>
                <c:pt idx="126">
                  <c:v>3.3276899999999999E-3</c:v>
                </c:pt>
                <c:pt idx="127">
                  <c:v>1.536188E-3</c:v>
                </c:pt>
                <c:pt idx="128">
                  <c:v>3.6859979999999998E-3</c:v>
                </c:pt>
                <c:pt idx="129">
                  <c:v>4.4016139999999999E-3</c:v>
                </c:pt>
                <c:pt idx="130">
                  <c:v>6.9972199999999995E-4</c:v>
                </c:pt>
                <c:pt idx="131">
                  <c:v>1.807213E-3</c:v>
                </c:pt>
                <c:pt idx="132">
                  <c:v>6.6303599999999999E-4</c:v>
                </c:pt>
                <c:pt idx="133">
                  <c:v>1.935338E-3</c:v>
                </c:pt>
                <c:pt idx="134">
                  <c:v>6.00575E-4</c:v>
                </c:pt>
                <c:pt idx="135">
                  <c:v>2.6246860000000002E-3</c:v>
                </c:pt>
                <c:pt idx="136">
                  <c:v>5.7017799999999996E-4</c:v>
                </c:pt>
                <c:pt idx="137">
                  <c:v>6.1041079999999996E-3</c:v>
                </c:pt>
                <c:pt idx="138">
                  <c:v>7.7172700000000005E-4</c:v>
                </c:pt>
                <c:pt idx="139">
                  <c:v>6.0867400000000002E-4</c:v>
                </c:pt>
                <c:pt idx="140">
                  <c:v>3.0364530000000002E-3</c:v>
                </c:pt>
                <c:pt idx="141">
                  <c:v>3.0638850000000001E-3</c:v>
                </c:pt>
                <c:pt idx="142">
                  <c:v>8.0811999999999995E-4</c:v>
                </c:pt>
                <c:pt idx="143">
                  <c:v>2.2475009999999998E-3</c:v>
                </c:pt>
                <c:pt idx="144">
                  <c:v>5.8134789999999999E-3</c:v>
                </c:pt>
                <c:pt idx="145">
                  <c:v>4.107154E-3</c:v>
                </c:pt>
                <c:pt idx="146">
                  <c:v>1.87777E-3</c:v>
                </c:pt>
                <c:pt idx="147">
                  <c:v>1.478102E-3</c:v>
                </c:pt>
                <c:pt idx="148">
                  <c:v>1.770333E-3</c:v>
                </c:pt>
                <c:pt idx="149">
                  <c:v>2.077513E-3</c:v>
                </c:pt>
                <c:pt idx="150">
                  <c:v>5.0357910000000004E-3</c:v>
                </c:pt>
                <c:pt idx="151">
                  <c:v>9.0710499999999996E-4</c:v>
                </c:pt>
                <c:pt idx="152">
                  <c:v>1.7194689999999999E-3</c:v>
                </c:pt>
                <c:pt idx="153">
                  <c:v>9.3965699999999999E-3</c:v>
                </c:pt>
                <c:pt idx="154">
                  <c:v>3.803046E-3</c:v>
                </c:pt>
                <c:pt idx="155">
                  <c:v>1.8466159999999999E-3</c:v>
                </c:pt>
                <c:pt idx="156">
                  <c:v>2.0402889999999998E-3</c:v>
                </c:pt>
                <c:pt idx="157">
                  <c:v>3.8619570000000001E-3</c:v>
                </c:pt>
                <c:pt idx="158">
                  <c:v>2.408416E-3</c:v>
                </c:pt>
                <c:pt idx="159">
                  <c:v>7.2013100000000005E-4</c:v>
                </c:pt>
                <c:pt idx="160">
                  <c:v>1.8036199999999999E-3</c:v>
                </c:pt>
                <c:pt idx="161">
                  <c:v>3.9769280000000002E-3</c:v>
                </c:pt>
                <c:pt idx="162">
                  <c:v>9.4483299999999996E-4</c:v>
                </c:pt>
                <c:pt idx="163">
                  <c:v>1.702846E-3</c:v>
                </c:pt>
                <c:pt idx="164">
                  <c:v>2.6652310000000001E-3</c:v>
                </c:pt>
                <c:pt idx="165">
                  <c:v>7.3125660000000004E-3</c:v>
                </c:pt>
                <c:pt idx="166">
                  <c:v>8.0242099999999999E-4</c:v>
                </c:pt>
                <c:pt idx="167">
                  <c:v>1.9704330000000002E-3</c:v>
                </c:pt>
                <c:pt idx="168">
                  <c:v>1.8568040000000001E-3</c:v>
                </c:pt>
                <c:pt idx="169">
                  <c:v>7.8379600000000002E-4</c:v>
                </c:pt>
                <c:pt idx="170">
                  <c:v>9.5916209999999998E-3</c:v>
                </c:pt>
                <c:pt idx="171">
                  <c:v>1.269472E-3</c:v>
                </c:pt>
                <c:pt idx="172">
                  <c:v>2.8885669999999999E-3</c:v>
                </c:pt>
                <c:pt idx="173">
                  <c:v>2.4096009999999999E-3</c:v>
                </c:pt>
                <c:pt idx="174">
                  <c:v>2.7221680000000001E-3</c:v>
                </c:pt>
                <c:pt idx="175">
                  <c:v>3.9510580000000003E-3</c:v>
                </c:pt>
                <c:pt idx="176">
                  <c:v>2.867419E-3</c:v>
                </c:pt>
                <c:pt idx="177">
                  <c:v>2.4765920000000001E-3</c:v>
                </c:pt>
                <c:pt idx="178">
                  <c:v>1.2851970000000001E-3</c:v>
                </c:pt>
                <c:pt idx="179">
                  <c:v>4.8472380000000002E-3</c:v>
                </c:pt>
                <c:pt idx="180">
                  <c:v>2.2721400000000002E-3</c:v>
                </c:pt>
                <c:pt idx="181">
                  <c:v>5.1053039999999997E-3</c:v>
                </c:pt>
                <c:pt idx="182">
                  <c:v>1.1157109999999999E-3</c:v>
                </c:pt>
                <c:pt idx="183">
                  <c:v>2.624875E-3</c:v>
                </c:pt>
                <c:pt idx="184">
                  <c:v>1.4931402999999999E-2</c:v>
                </c:pt>
                <c:pt idx="185">
                  <c:v>1.568669E-3</c:v>
                </c:pt>
                <c:pt idx="186">
                  <c:v>8.0505869999999997E-3</c:v>
                </c:pt>
                <c:pt idx="187">
                  <c:v>1.0783570000000001E-3</c:v>
                </c:pt>
                <c:pt idx="188">
                  <c:v>6.7798200000000004E-4</c:v>
                </c:pt>
                <c:pt idx="189">
                  <c:v>1.1957820000000001E-3</c:v>
                </c:pt>
                <c:pt idx="190">
                  <c:v>5.2939570000000002E-3</c:v>
                </c:pt>
                <c:pt idx="191">
                  <c:v>5.2743180000000001E-3</c:v>
                </c:pt>
                <c:pt idx="192">
                  <c:v>9.8716699999999995E-4</c:v>
                </c:pt>
                <c:pt idx="193">
                  <c:v>2.7678580000000002E-3</c:v>
                </c:pt>
                <c:pt idx="194">
                  <c:v>1.89511E-3</c:v>
                </c:pt>
                <c:pt idx="195">
                  <c:v>2.837095E-3</c:v>
                </c:pt>
                <c:pt idx="196">
                  <c:v>1.5772220000000001E-3</c:v>
                </c:pt>
                <c:pt idx="197">
                  <c:v>8.0694040000000005E-3</c:v>
                </c:pt>
                <c:pt idx="198">
                  <c:v>1.2894409999999999E-3</c:v>
                </c:pt>
                <c:pt idx="199">
                  <c:v>3.744584E-3</c:v>
                </c:pt>
                <c:pt idx="200">
                  <c:v>5.1279059999999998E-3</c:v>
                </c:pt>
                <c:pt idx="201">
                  <c:v>2.2956059999999999E-3</c:v>
                </c:pt>
                <c:pt idx="202">
                  <c:v>3.0509629999999999E-3</c:v>
                </c:pt>
                <c:pt idx="203">
                  <c:v>1.988891E-3</c:v>
                </c:pt>
                <c:pt idx="204">
                  <c:v>8.4270899999999997E-4</c:v>
                </c:pt>
                <c:pt idx="205">
                  <c:v>1.9762209999999998E-3</c:v>
                </c:pt>
                <c:pt idx="206">
                  <c:v>4.3423760000000002E-3</c:v>
                </c:pt>
                <c:pt idx="207">
                  <c:v>5.79979E-4</c:v>
                </c:pt>
                <c:pt idx="208">
                  <c:v>3.9962779999999998E-3</c:v>
                </c:pt>
                <c:pt idx="209">
                  <c:v>9.9572799999999998E-4</c:v>
                </c:pt>
                <c:pt idx="210">
                  <c:v>2.1849259999999998E-3</c:v>
                </c:pt>
                <c:pt idx="211">
                  <c:v>2.080274E-3</c:v>
                </c:pt>
                <c:pt idx="212">
                  <c:v>2.4716400000000002E-3</c:v>
                </c:pt>
                <c:pt idx="213">
                  <c:v>5.0156899999999999E-4</c:v>
                </c:pt>
                <c:pt idx="214">
                  <c:v>8.3926699999999999E-4</c:v>
                </c:pt>
                <c:pt idx="215">
                  <c:v>2.8623049999999999E-3</c:v>
                </c:pt>
                <c:pt idx="216">
                  <c:v>2.6683399999999999E-3</c:v>
                </c:pt>
                <c:pt idx="217">
                  <c:v>6.5357700000000002E-4</c:v>
                </c:pt>
                <c:pt idx="218">
                  <c:v>2.425913E-3</c:v>
                </c:pt>
                <c:pt idx="219">
                  <c:v>7.2630700000000004E-4</c:v>
                </c:pt>
                <c:pt idx="220">
                  <c:v>2.6151490000000002E-3</c:v>
                </c:pt>
                <c:pt idx="221">
                  <c:v>1.2178390000000001E-3</c:v>
                </c:pt>
                <c:pt idx="222">
                  <c:v>1.3049559999999999E-3</c:v>
                </c:pt>
                <c:pt idx="223">
                  <c:v>2.8089510000000001E-3</c:v>
                </c:pt>
                <c:pt idx="224">
                  <c:v>3.1045069999999998E-3</c:v>
                </c:pt>
                <c:pt idx="225">
                  <c:v>3.0904629999999999E-3</c:v>
                </c:pt>
                <c:pt idx="226">
                  <c:v>5.4325200000000004E-4</c:v>
                </c:pt>
                <c:pt idx="227">
                  <c:v>2.4726359999999998E-3</c:v>
                </c:pt>
                <c:pt idx="228">
                  <c:v>1.842921E-3</c:v>
                </c:pt>
                <c:pt idx="229">
                  <c:v>3.290585E-3</c:v>
                </c:pt>
                <c:pt idx="230">
                  <c:v>6.7101800000000001E-4</c:v>
                </c:pt>
                <c:pt idx="231">
                  <c:v>1.882447E-3</c:v>
                </c:pt>
                <c:pt idx="232">
                  <c:v>2.2402920000000001E-3</c:v>
                </c:pt>
                <c:pt idx="233">
                  <c:v>6.8669900000000003E-4</c:v>
                </c:pt>
                <c:pt idx="234">
                  <c:v>1.659163E-3</c:v>
                </c:pt>
                <c:pt idx="235">
                  <c:v>1.3382240000000001E-3</c:v>
                </c:pt>
                <c:pt idx="236">
                  <c:v>8.3311599999999996E-4</c:v>
                </c:pt>
                <c:pt idx="237">
                  <c:v>3.2869269999999998E-3</c:v>
                </c:pt>
                <c:pt idx="238">
                  <c:v>1.2265279999999999E-3</c:v>
                </c:pt>
                <c:pt idx="239">
                  <c:v>4.1465800000000004E-3</c:v>
                </c:pt>
                <c:pt idx="240">
                  <c:v>1.67698E-3</c:v>
                </c:pt>
                <c:pt idx="241">
                  <c:v>3.766957E-3</c:v>
                </c:pt>
                <c:pt idx="242">
                  <c:v>2.6602040000000002E-3</c:v>
                </c:pt>
                <c:pt idx="243">
                  <c:v>3.590139E-3</c:v>
                </c:pt>
                <c:pt idx="244">
                  <c:v>5.6596900000000004E-4</c:v>
                </c:pt>
                <c:pt idx="245">
                  <c:v>9.9769199999999989E-4</c:v>
                </c:pt>
                <c:pt idx="246">
                  <c:v>5.0733000000000002E-3</c:v>
                </c:pt>
                <c:pt idx="247">
                  <c:v>2.0414270000000002E-3</c:v>
                </c:pt>
                <c:pt idx="248">
                  <c:v>6.7795119999999997E-3</c:v>
                </c:pt>
                <c:pt idx="249">
                  <c:v>5.3395600000000004E-4</c:v>
                </c:pt>
                <c:pt idx="250">
                  <c:v>3.630056E-3</c:v>
                </c:pt>
                <c:pt idx="251">
                  <c:v>9.2507799999999997E-4</c:v>
                </c:pt>
                <c:pt idx="252">
                  <c:v>2.6799969999999999E-3</c:v>
                </c:pt>
                <c:pt idx="253">
                  <c:v>6.03419E-4</c:v>
                </c:pt>
                <c:pt idx="254">
                  <c:v>5.285611E-3</c:v>
                </c:pt>
                <c:pt idx="255">
                  <c:v>1.5155940000000001E-3</c:v>
                </c:pt>
                <c:pt idx="256">
                  <c:v>3.592118E-3</c:v>
                </c:pt>
                <c:pt idx="257">
                  <c:v>2.6118629999999999E-3</c:v>
                </c:pt>
                <c:pt idx="258">
                  <c:v>2.7397490000000001E-3</c:v>
                </c:pt>
                <c:pt idx="259">
                  <c:v>2.0029499999999999E-3</c:v>
                </c:pt>
                <c:pt idx="260">
                  <c:v>3.5805839999999999E-3</c:v>
                </c:pt>
                <c:pt idx="261">
                  <c:v>2.3655550000000001E-3</c:v>
                </c:pt>
                <c:pt idx="262">
                  <c:v>3.947491E-3</c:v>
                </c:pt>
                <c:pt idx="263">
                  <c:v>1.865607E-3</c:v>
                </c:pt>
                <c:pt idx="264">
                  <c:v>2.8430370000000001E-3</c:v>
                </c:pt>
                <c:pt idx="265">
                  <c:v>2.7866639999999999E-3</c:v>
                </c:pt>
                <c:pt idx="266">
                  <c:v>1.3132350000000001E-3</c:v>
                </c:pt>
                <c:pt idx="267">
                  <c:v>1.447374E-3</c:v>
                </c:pt>
                <c:pt idx="268">
                  <c:v>2.836206E-3</c:v>
                </c:pt>
                <c:pt idx="269">
                  <c:v>3.9416850000000003E-3</c:v>
                </c:pt>
                <c:pt idx="270">
                  <c:v>1.1880930000000001E-3</c:v>
                </c:pt>
                <c:pt idx="271">
                  <c:v>5.3932779999999996E-3</c:v>
                </c:pt>
                <c:pt idx="272">
                  <c:v>2.1217330000000002E-3</c:v>
                </c:pt>
                <c:pt idx="273">
                  <c:v>6.5794400000000004E-4</c:v>
                </c:pt>
                <c:pt idx="274">
                  <c:v>3.1078690000000001E-3</c:v>
                </c:pt>
                <c:pt idx="275">
                  <c:v>2.500716E-3</c:v>
                </c:pt>
                <c:pt idx="276">
                  <c:v>1.76851E-3</c:v>
                </c:pt>
                <c:pt idx="277">
                  <c:v>5.3665880000000003E-3</c:v>
                </c:pt>
                <c:pt idx="278">
                  <c:v>2.62977E-3</c:v>
                </c:pt>
                <c:pt idx="279">
                  <c:v>6.2460300000000005E-4</c:v>
                </c:pt>
                <c:pt idx="280">
                  <c:v>5.1890749999999996E-3</c:v>
                </c:pt>
                <c:pt idx="281">
                  <c:v>8.4664400000000002E-4</c:v>
                </c:pt>
                <c:pt idx="282">
                  <c:v>4.5633790000000002E-3</c:v>
                </c:pt>
                <c:pt idx="283">
                  <c:v>1.014355E-3</c:v>
                </c:pt>
                <c:pt idx="284">
                  <c:v>6.9608199999999999E-4</c:v>
                </c:pt>
                <c:pt idx="285">
                  <c:v>2.995185E-3</c:v>
                </c:pt>
                <c:pt idx="286">
                  <c:v>2.806645E-3</c:v>
                </c:pt>
                <c:pt idx="287">
                  <c:v>1.2785990000000001E-3</c:v>
                </c:pt>
                <c:pt idx="288">
                  <c:v>1.7091540000000001E-3</c:v>
                </c:pt>
                <c:pt idx="289">
                  <c:v>1.425572E-3</c:v>
                </c:pt>
                <c:pt idx="290">
                  <c:v>5.6539440000000002E-3</c:v>
                </c:pt>
                <c:pt idx="291">
                  <c:v>1.0225845000000001E-2</c:v>
                </c:pt>
                <c:pt idx="292">
                  <c:v>7.8777840000000005E-3</c:v>
                </c:pt>
                <c:pt idx="293">
                  <c:v>1.344437E-3</c:v>
                </c:pt>
                <c:pt idx="294">
                  <c:v>1.689189E-3</c:v>
                </c:pt>
                <c:pt idx="295">
                  <c:v>1.573199E-3</c:v>
                </c:pt>
                <c:pt idx="296">
                  <c:v>2.955432E-3</c:v>
                </c:pt>
                <c:pt idx="297">
                  <c:v>9.5676300000000001E-4</c:v>
                </c:pt>
                <c:pt idx="298">
                  <c:v>3.5463830000000002E-3</c:v>
                </c:pt>
                <c:pt idx="299">
                  <c:v>1.215816E-3</c:v>
                </c:pt>
                <c:pt idx="300">
                  <c:v>4.2559970000000001E-3</c:v>
                </c:pt>
                <c:pt idx="301">
                  <c:v>4.2149900000000001E-3</c:v>
                </c:pt>
                <c:pt idx="302">
                  <c:v>3.1948329999999998E-3</c:v>
                </c:pt>
                <c:pt idx="303">
                  <c:v>2.7716809999999998E-3</c:v>
                </c:pt>
                <c:pt idx="304">
                  <c:v>4.6031830000000003E-3</c:v>
                </c:pt>
                <c:pt idx="305">
                  <c:v>5.4064409999999997E-3</c:v>
                </c:pt>
                <c:pt idx="306">
                  <c:v>4.9371099999999998E-3</c:v>
                </c:pt>
                <c:pt idx="307">
                  <c:v>3.2518249999999999E-3</c:v>
                </c:pt>
                <c:pt idx="308">
                  <c:v>7.6209699999999999E-4</c:v>
                </c:pt>
                <c:pt idx="309">
                  <c:v>2.696716E-3</c:v>
                </c:pt>
                <c:pt idx="310">
                  <c:v>4.8315759999999998E-3</c:v>
                </c:pt>
                <c:pt idx="311">
                  <c:v>9.3529799999999999E-4</c:v>
                </c:pt>
                <c:pt idx="312">
                  <c:v>2.9563459999999999E-3</c:v>
                </c:pt>
                <c:pt idx="313">
                  <c:v>7.1026100000000001E-4</c:v>
                </c:pt>
                <c:pt idx="314">
                  <c:v>1.134365E-3</c:v>
                </c:pt>
                <c:pt idx="315">
                  <c:v>2.0873799999999998E-3</c:v>
                </c:pt>
                <c:pt idx="316">
                  <c:v>5.0681900000000004E-4</c:v>
                </c:pt>
                <c:pt idx="317">
                  <c:v>2.5109860000000002E-3</c:v>
                </c:pt>
                <c:pt idx="318">
                  <c:v>8.3821600000000003E-4</c:v>
                </c:pt>
                <c:pt idx="319">
                  <c:v>4.3679579999999999E-3</c:v>
                </c:pt>
                <c:pt idx="320">
                  <c:v>4.5548369999999999E-3</c:v>
                </c:pt>
                <c:pt idx="321">
                  <c:v>3.8090899999999998E-3</c:v>
                </c:pt>
                <c:pt idx="322">
                  <c:v>2.7959740000000001E-3</c:v>
                </c:pt>
                <c:pt idx="323">
                  <c:v>2.6040820000000002E-3</c:v>
                </c:pt>
                <c:pt idx="324">
                  <c:v>2.7717789999999998E-3</c:v>
                </c:pt>
                <c:pt idx="325">
                  <c:v>5.9522399999999999E-4</c:v>
                </c:pt>
                <c:pt idx="326">
                  <c:v>2.5753579999999998E-3</c:v>
                </c:pt>
                <c:pt idx="327">
                  <c:v>2.863684E-3</c:v>
                </c:pt>
                <c:pt idx="328">
                  <c:v>1.9501360000000001E-3</c:v>
                </c:pt>
                <c:pt idx="329">
                  <c:v>3.073732E-3</c:v>
                </c:pt>
                <c:pt idx="330">
                  <c:v>3.2170850000000002E-3</c:v>
                </c:pt>
                <c:pt idx="331">
                  <c:v>1.3352139999999999E-3</c:v>
                </c:pt>
                <c:pt idx="332">
                  <c:v>1.4754429999999999E-3</c:v>
                </c:pt>
                <c:pt idx="333">
                  <c:v>2.205959E-3</c:v>
                </c:pt>
                <c:pt idx="334">
                  <c:v>2.2872560000000001E-3</c:v>
                </c:pt>
                <c:pt idx="335">
                  <c:v>1.836676E-3</c:v>
                </c:pt>
                <c:pt idx="336">
                  <c:v>1.0596035E-2</c:v>
                </c:pt>
                <c:pt idx="337">
                  <c:v>3.8539870000000001E-3</c:v>
                </c:pt>
                <c:pt idx="338">
                  <c:v>2.124304E-3</c:v>
                </c:pt>
                <c:pt idx="339">
                  <c:v>8.7839049999999998E-3</c:v>
                </c:pt>
                <c:pt idx="340">
                  <c:v>4.1645520000000002E-3</c:v>
                </c:pt>
                <c:pt idx="341">
                  <c:v>9.4255399999999996E-4</c:v>
                </c:pt>
                <c:pt idx="342">
                  <c:v>2.0264250000000001E-3</c:v>
                </c:pt>
                <c:pt idx="343">
                  <c:v>2.1735080000000002E-3</c:v>
                </c:pt>
                <c:pt idx="344">
                  <c:v>8.8037800000000002E-4</c:v>
                </c:pt>
                <c:pt idx="345">
                  <c:v>6.8844900000000005E-4</c:v>
                </c:pt>
                <c:pt idx="346">
                  <c:v>4.3219560000000001E-3</c:v>
                </c:pt>
                <c:pt idx="347">
                  <c:v>4.0636459999999998E-3</c:v>
                </c:pt>
                <c:pt idx="348">
                  <c:v>2.5202369999999998E-3</c:v>
                </c:pt>
                <c:pt idx="349">
                  <c:v>6.8181129999999998E-3</c:v>
                </c:pt>
                <c:pt idx="350">
                  <c:v>2.4304750000000001E-3</c:v>
                </c:pt>
                <c:pt idx="351">
                  <c:v>3.1573159999999999E-3</c:v>
                </c:pt>
                <c:pt idx="352">
                  <c:v>3.6720070000000001E-3</c:v>
                </c:pt>
                <c:pt idx="353">
                  <c:v>1.1617279999999999E-3</c:v>
                </c:pt>
                <c:pt idx="354">
                  <c:v>1.287811E-3</c:v>
                </c:pt>
                <c:pt idx="355">
                  <c:v>9.3668400000000002E-4</c:v>
                </c:pt>
                <c:pt idx="356">
                  <c:v>2.4436169999999999E-3</c:v>
                </c:pt>
                <c:pt idx="357">
                  <c:v>1.4187200000000001E-3</c:v>
                </c:pt>
                <c:pt idx="358">
                  <c:v>2.7071880000000001E-3</c:v>
                </c:pt>
                <c:pt idx="359">
                  <c:v>4.3770279999999998E-3</c:v>
                </c:pt>
                <c:pt idx="360">
                  <c:v>7.2901599999999997E-4</c:v>
                </c:pt>
                <c:pt idx="361">
                  <c:v>2.0883439999999998E-3</c:v>
                </c:pt>
                <c:pt idx="362">
                  <c:v>3.1284260000000001E-3</c:v>
                </c:pt>
                <c:pt idx="363">
                  <c:v>2.3409630000000002E-3</c:v>
                </c:pt>
                <c:pt idx="364">
                  <c:v>9.02336E-4</c:v>
                </c:pt>
                <c:pt idx="365">
                  <c:v>2.9307809999999999E-3</c:v>
                </c:pt>
                <c:pt idx="366">
                  <c:v>1.6448719999999999E-3</c:v>
                </c:pt>
                <c:pt idx="367">
                  <c:v>2.8519539999999999E-3</c:v>
                </c:pt>
                <c:pt idx="368">
                  <c:v>3.4872879999999998E-3</c:v>
                </c:pt>
                <c:pt idx="369">
                  <c:v>6.4004509999999997E-3</c:v>
                </c:pt>
                <c:pt idx="370">
                  <c:v>2.0573409999999999E-3</c:v>
                </c:pt>
                <c:pt idx="371">
                  <c:v>9.9688199999999993E-4</c:v>
                </c:pt>
                <c:pt idx="372">
                  <c:v>3.545631E-3</c:v>
                </c:pt>
                <c:pt idx="373">
                  <c:v>4.2564430000000004E-3</c:v>
                </c:pt>
                <c:pt idx="374">
                  <c:v>7.0441500000000001E-4</c:v>
                </c:pt>
                <c:pt idx="375">
                  <c:v>2.7157069999999999E-3</c:v>
                </c:pt>
                <c:pt idx="376">
                  <c:v>3.9322009999999998E-3</c:v>
                </c:pt>
                <c:pt idx="377">
                  <c:v>1.051642E-3</c:v>
                </c:pt>
                <c:pt idx="378">
                  <c:v>2.0686400000000001E-3</c:v>
                </c:pt>
                <c:pt idx="379">
                  <c:v>5.4953000000000001E-4</c:v>
                </c:pt>
                <c:pt idx="380">
                  <c:v>2.0437229999999999E-3</c:v>
                </c:pt>
                <c:pt idx="381">
                  <c:v>2.8117649999999999E-3</c:v>
                </c:pt>
                <c:pt idx="382">
                  <c:v>3.0279399999999998E-3</c:v>
                </c:pt>
                <c:pt idx="383">
                  <c:v>2.81205E-3</c:v>
                </c:pt>
                <c:pt idx="384">
                  <c:v>3.2206790000000002E-3</c:v>
                </c:pt>
                <c:pt idx="385">
                  <c:v>4.134876E-3</c:v>
                </c:pt>
                <c:pt idx="386">
                  <c:v>6.1804850000000003E-3</c:v>
                </c:pt>
                <c:pt idx="387">
                  <c:v>1.780001E-3</c:v>
                </c:pt>
                <c:pt idx="388">
                  <c:v>1.481879E-3</c:v>
                </c:pt>
                <c:pt idx="389">
                  <c:v>2.5682639999999998E-3</c:v>
                </c:pt>
                <c:pt idx="390">
                  <c:v>1.0357546E-2</c:v>
                </c:pt>
                <c:pt idx="391">
                  <c:v>1.440506E-3</c:v>
                </c:pt>
                <c:pt idx="392">
                  <c:v>2.1807100000000002E-3</c:v>
                </c:pt>
                <c:pt idx="393">
                  <c:v>4.4755089999999999E-3</c:v>
                </c:pt>
                <c:pt idx="394">
                  <c:v>3.0435280000000002E-3</c:v>
                </c:pt>
                <c:pt idx="395">
                  <c:v>1.0319540000000001E-3</c:v>
                </c:pt>
                <c:pt idx="396">
                  <c:v>2.5201400000000001E-3</c:v>
                </c:pt>
                <c:pt idx="397">
                  <c:v>3.283799E-3</c:v>
                </c:pt>
                <c:pt idx="398">
                  <c:v>1.526358E-3</c:v>
                </c:pt>
                <c:pt idx="399">
                  <c:v>1.901437E-3</c:v>
                </c:pt>
                <c:pt idx="400">
                  <c:v>3.045355E-3</c:v>
                </c:pt>
                <c:pt idx="401">
                  <c:v>4.9861769999999996E-3</c:v>
                </c:pt>
                <c:pt idx="402">
                  <c:v>1.466841E-3</c:v>
                </c:pt>
                <c:pt idx="403">
                  <c:v>2.9441020000000001E-3</c:v>
                </c:pt>
                <c:pt idx="404">
                  <c:v>2.2520999999999999E-3</c:v>
                </c:pt>
                <c:pt idx="405">
                  <c:v>5.8104599999999999E-4</c:v>
                </c:pt>
                <c:pt idx="406">
                  <c:v>2.3272990000000001E-3</c:v>
                </c:pt>
                <c:pt idx="407">
                  <c:v>6.3660599999999996E-4</c:v>
                </c:pt>
                <c:pt idx="408">
                  <c:v>2.667025E-3</c:v>
                </c:pt>
                <c:pt idx="409">
                  <c:v>3.8781219999999999E-3</c:v>
                </c:pt>
                <c:pt idx="410">
                  <c:v>2.306415E-3</c:v>
                </c:pt>
                <c:pt idx="411">
                  <c:v>2.6125979999999998E-3</c:v>
                </c:pt>
                <c:pt idx="412">
                  <c:v>4.7206239999999997E-3</c:v>
                </c:pt>
                <c:pt idx="413">
                  <c:v>5.9286900000000003E-3</c:v>
                </c:pt>
                <c:pt idx="414">
                  <c:v>7.3968500000000002E-4</c:v>
                </c:pt>
                <c:pt idx="415">
                  <c:v>1.022013E-3</c:v>
                </c:pt>
                <c:pt idx="416">
                  <c:v>2.0147720000000002E-3</c:v>
                </c:pt>
                <c:pt idx="417">
                  <c:v>1.15872E-3</c:v>
                </c:pt>
                <c:pt idx="418">
                  <c:v>2.8663289999999999E-3</c:v>
                </c:pt>
                <c:pt idx="419">
                  <c:v>1.2430049999999999E-3</c:v>
                </c:pt>
                <c:pt idx="420">
                  <c:v>2.4692210000000002E-3</c:v>
                </c:pt>
                <c:pt idx="421">
                  <c:v>1.550561E-3</c:v>
                </c:pt>
                <c:pt idx="422">
                  <c:v>6.1760139999999996E-3</c:v>
                </c:pt>
                <c:pt idx="423">
                  <c:v>2.4033029999999999E-3</c:v>
                </c:pt>
                <c:pt idx="424">
                  <c:v>8.1626799999999998E-4</c:v>
                </c:pt>
                <c:pt idx="425">
                  <c:v>2.6946050000000001E-3</c:v>
                </c:pt>
                <c:pt idx="426">
                  <c:v>2.115656E-3</c:v>
                </c:pt>
                <c:pt idx="427">
                  <c:v>1.3902330000000001E-3</c:v>
                </c:pt>
                <c:pt idx="428">
                  <c:v>1.146937E-3</c:v>
                </c:pt>
                <c:pt idx="429">
                  <c:v>3.8761730000000001E-3</c:v>
                </c:pt>
                <c:pt idx="430">
                  <c:v>1.301955E-3</c:v>
                </c:pt>
                <c:pt idx="431">
                  <c:v>5.0093999999999998E-3</c:v>
                </c:pt>
                <c:pt idx="432">
                  <c:v>1.9647390000000001E-3</c:v>
                </c:pt>
                <c:pt idx="433">
                  <c:v>2.6581510000000001E-3</c:v>
                </c:pt>
                <c:pt idx="434">
                  <c:v>2.9215669999999999E-3</c:v>
                </c:pt>
                <c:pt idx="435">
                  <c:v>2.8792190000000001E-3</c:v>
                </c:pt>
                <c:pt idx="436">
                  <c:v>2.0289380000000001E-3</c:v>
                </c:pt>
                <c:pt idx="437">
                  <c:v>6.7846099999999999E-4</c:v>
                </c:pt>
                <c:pt idx="438">
                  <c:v>5.3734760000000003E-3</c:v>
                </c:pt>
                <c:pt idx="439">
                  <c:v>2.7441810000000001E-3</c:v>
                </c:pt>
                <c:pt idx="440">
                  <c:v>2.3848939999999998E-3</c:v>
                </c:pt>
                <c:pt idx="441">
                  <c:v>2.7375899999999998E-3</c:v>
                </c:pt>
                <c:pt idx="442">
                  <c:v>5.8028029999999996E-3</c:v>
                </c:pt>
                <c:pt idx="443">
                  <c:v>6.3818600000000001E-4</c:v>
                </c:pt>
                <c:pt idx="444">
                  <c:v>5.9144899999999997E-3</c:v>
                </c:pt>
                <c:pt idx="445">
                  <c:v>1.211747E-3</c:v>
                </c:pt>
                <c:pt idx="446">
                  <c:v>1.422422E-3</c:v>
                </c:pt>
                <c:pt idx="447">
                  <c:v>5.2378980000000004E-3</c:v>
                </c:pt>
                <c:pt idx="448">
                  <c:v>2.2518120000000002E-3</c:v>
                </c:pt>
                <c:pt idx="449">
                  <c:v>3.2575949999999998E-3</c:v>
                </c:pt>
                <c:pt idx="450">
                  <c:v>5.8754410000000003E-3</c:v>
                </c:pt>
                <c:pt idx="451">
                  <c:v>1.8359994000000001E-2</c:v>
                </c:pt>
                <c:pt idx="452">
                  <c:v>3.0978379999999999E-3</c:v>
                </c:pt>
                <c:pt idx="453">
                  <c:v>3.1599280000000002E-3</c:v>
                </c:pt>
                <c:pt idx="454">
                  <c:v>8.4357459999999992E-3</c:v>
                </c:pt>
                <c:pt idx="455">
                  <c:v>8.3173700000000004E-4</c:v>
                </c:pt>
                <c:pt idx="456">
                  <c:v>1.843536E-3</c:v>
                </c:pt>
                <c:pt idx="457">
                  <c:v>2.9876920000000001E-3</c:v>
                </c:pt>
                <c:pt idx="458">
                  <c:v>2.702893E-3</c:v>
                </c:pt>
                <c:pt idx="459">
                  <c:v>2.2546879999999999E-3</c:v>
                </c:pt>
                <c:pt idx="460">
                  <c:v>4.4440369999999996E-3</c:v>
                </c:pt>
                <c:pt idx="461">
                  <c:v>4.1969160000000002E-3</c:v>
                </c:pt>
                <c:pt idx="462">
                  <c:v>3.3183829999999998E-3</c:v>
                </c:pt>
                <c:pt idx="463">
                  <c:v>2.5671180000000002E-3</c:v>
                </c:pt>
                <c:pt idx="464">
                  <c:v>1.004366E-3</c:v>
                </c:pt>
                <c:pt idx="465">
                  <c:v>2.6462489999999998E-3</c:v>
                </c:pt>
                <c:pt idx="466">
                  <c:v>2.6748029999999999E-3</c:v>
                </c:pt>
                <c:pt idx="467">
                  <c:v>2.9761399999999999E-3</c:v>
                </c:pt>
                <c:pt idx="468">
                  <c:v>7.3317360000000002E-3</c:v>
                </c:pt>
                <c:pt idx="469">
                  <c:v>5.1927450000000003E-3</c:v>
                </c:pt>
                <c:pt idx="470">
                  <c:v>6.1195650000000004E-3</c:v>
                </c:pt>
                <c:pt idx="471">
                  <c:v>2.5491110000000002E-3</c:v>
                </c:pt>
                <c:pt idx="472">
                  <c:v>2.4895519999999999E-3</c:v>
                </c:pt>
                <c:pt idx="473">
                  <c:v>2.4783629999999999E-3</c:v>
                </c:pt>
                <c:pt idx="474">
                  <c:v>2.6502449999999999E-3</c:v>
                </c:pt>
                <c:pt idx="475">
                  <c:v>4.4929710000000001E-3</c:v>
                </c:pt>
                <c:pt idx="476">
                  <c:v>2.991502E-3</c:v>
                </c:pt>
                <c:pt idx="477">
                  <c:v>1.533717E-3</c:v>
                </c:pt>
                <c:pt idx="478">
                  <c:v>2.5708089999999999E-3</c:v>
                </c:pt>
                <c:pt idx="479">
                  <c:v>2.1126370000000001E-3</c:v>
                </c:pt>
                <c:pt idx="480">
                  <c:v>2.7607090000000001E-3</c:v>
                </c:pt>
                <c:pt idx="481">
                  <c:v>2.8853049999999999E-3</c:v>
                </c:pt>
                <c:pt idx="482">
                  <c:v>5.5057689999999998E-3</c:v>
                </c:pt>
                <c:pt idx="483">
                  <c:v>4.3479899999999998E-4</c:v>
                </c:pt>
                <c:pt idx="484">
                  <c:v>1.684261E-3</c:v>
                </c:pt>
                <c:pt idx="485">
                  <c:v>4.1111960000000001E-3</c:v>
                </c:pt>
                <c:pt idx="486">
                  <c:v>5.7260899999999997E-4</c:v>
                </c:pt>
                <c:pt idx="487">
                  <c:v>4.0735859999999997E-3</c:v>
                </c:pt>
                <c:pt idx="488">
                  <c:v>2.995607E-3</c:v>
                </c:pt>
                <c:pt idx="489">
                  <c:v>3.2029900000000002E-3</c:v>
                </c:pt>
                <c:pt idx="490">
                  <c:v>4.8955159999999999E-3</c:v>
                </c:pt>
                <c:pt idx="491">
                  <c:v>4.0305690000000003E-3</c:v>
                </c:pt>
                <c:pt idx="492">
                  <c:v>4.070522E-3</c:v>
                </c:pt>
                <c:pt idx="493">
                  <c:v>2.2735149999999998E-3</c:v>
                </c:pt>
                <c:pt idx="494">
                  <c:v>2.4257739999999999E-3</c:v>
                </c:pt>
                <c:pt idx="495">
                  <c:v>1.409102E-3</c:v>
                </c:pt>
                <c:pt idx="496">
                  <c:v>2.7014320000000001E-3</c:v>
                </c:pt>
                <c:pt idx="497">
                  <c:v>1.7582349999999999E-3</c:v>
                </c:pt>
                <c:pt idx="498">
                  <c:v>3.312083E-3</c:v>
                </c:pt>
                <c:pt idx="499">
                  <c:v>3.2779480000000001E-3</c:v>
                </c:pt>
                <c:pt idx="500">
                  <c:v>2.7406679999999999E-3</c:v>
                </c:pt>
                <c:pt idx="501">
                  <c:v>3.4410420000000001E-3</c:v>
                </c:pt>
                <c:pt idx="502">
                  <c:v>4.2413360000000001E-3</c:v>
                </c:pt>
                <c:pt idx="503">
                  <c:v>3.8794430000000002E-3</c:v>
                </c:pt>
                <c:pt idx="504">
                  <c:v>1.0386550000000001E-3</c:v>
                </c:pt>
                <c:pt idx="505">
                  <c:v>1.878429E-3</c:v>
                </c:pt>
                <c:pt idx="506">
                  <c:v>1.5499649999999999E-3</c:v>
                </c:pt>
                <c:pt idx="507">
                  <c:v>2.6802140000000002E-3</c:v>
                </c:pt>
                <c:pt idx="508">
                  <c:v>3.1045159999999999E-3</c:v>
                </c:pt>
                <c:pt idx="509">
                  <c:v>3.8117870000000001E-3</c:v>
                </c:pt>
                <c:pt idx="510">
                  <c:v>2.4060900000000001E-3</c:v>
                </c:pt>
                <c:pt idx="511">
                  <c:v>7.192983E-3</c:v>
                </c:pt>
                <c:pt idx="512">
                  <c:v>1.6053580000000001E-3</c:v>
                </c:pt>
                <c:pt idx="513">
                  <c:v>2.918066E-3</c:v>
                </c:pt>
                <c:pt idx="514">
                  <c:v>4.8172359999999999E-3</c:v>
                </c:pt>
                <c:pt idx="515">
                  <c:v>7.2269700000000001E-3</c:v>
                </c:pt>
                <c:pt idx="516">
                  <c:v>6.6546820000000003E-3</c:v>
                </c:pt>
                <c:pt idx="517">
                  <c:v>4.1402449999999999E-3</c:v>
                </c:pt>
                <c:pt idx="518">
                  <c:v>4.3311319999999997E-3</c:v>
                </c:pt>
                <c:pt idx="519">
                  <c:v>3.2195489999999999E-3</c:v>
                </c:pt>
                <c:pt idx="520">
                  <c:v>3.3045209999999999E-3</c:v>
                </c:pt>
                <c:pt idx="521">
                  <c:v>4.7279990000000001E-3</c:v>
                </c:pt>
                <c:pt idx="522">
                  <c:v>3.030207E-3</c:v>
                </c:pt>
                <c:pt idx="523">
                  <c:v>1.9049729999999999E-3</c:v>
                </c:pt>
                <c:pt idx="524">
                  <c:v>1.4330429999999999E-3</c:v>
                </c:pt>
                <c:pt idx="525">
                  <c:v>6.8815599999999999E-4</c:v>
                </c:pt>
                <c:pt idx="526">
                  <c:v>3.206993E-3</c:v>
                </c:pt>
                <c:pt idx="527">
                  <c:v>2.5229250000000001E-3</c:v>
                </c:pt>
                <c:pt idx="528">
                  <c:v>1.038296E-3</c:v>
                </c:pt>
                <c:pt idx="529">
                  <c:v>2.0849620000000001E-3</c:v>
                </c:pt>
                <c:pt idx="530">
                  <c:v>1.4787240000000001E-3</c:v>
                </c:pt>
                <c:pt idx="531">
                  <c:v>3.379047E-3</c:v>
                </c:pt>
                <c:pt idx="532">
                  <c:v>1.8893320000000001E-3</c:v>
                </c:pt>
                <c:pt idx="533">
                  <c:v>2.7666779999999998E-3</c:v>
                </c:pt>
                <c:pt idx="534">
                  <c:v>1.1503920000000001E-3</c:v>
                </c:pt>
                <c:pt idx="535">
                  <c:v>2.0040449999999999E-3</c:v>
                </c:pt>
                <c:pt idx="536">
                  <c:v>8.2796900000000001E-4</c:v>
                </c:pt>
                <c:pt idx="537">
                  <c:v>2.1045170000000002E-3</c:v>
                </c:pt>
                <c:pt idx="538">
                  <c:v>1.8068520000000001E-3</c:v>
                </c:pt>
                <c:pt idx="539">
                  <c:v>3.3694329999999998E-3</c:v>
                </c:pt>
                <c:pt idx="540">
                  <c:v>3.107369E-3</c:v>
                </c:pt>
                <c:pt idx="541">
                  <c:v>3.0776829999999999E-3</c:v>
                </c:pt>
                <c:pt idx="542">
                  <c:v>2.1832890000000001E-3</c:v>
                </c:pt>
                <c:pt idx="543">
                  <c:v>1.0647829999999999E-3</c:v>
                </c:pt>
                <c:pt idx="544">
                  <c:v>3.7698810000000001E-3</c:v>
                </c:pt>
                <c:pt idx="545">
                  <c:v>2.8963529999999999E-3</c:v>
                </c:pt>
                <c:pt idx="546">
                  <c:v>8.0937200000000004E-4</c:v>
                </c:pt>
                <c:pt idx="547">
                  <c:v>1.8835950000000001E-3</c:v>
                </c:pt>
                <c:pt idx="548">
                  <c:v>2.2917599999999999E-3</c:v>
                </c:pt>
                <c:pt idx="549">
                  <c:v>1.4379009999999999E-3</c:v>
                </c:pt>
                <c:pt idx="550">
                  <c:v>3.3418380000000002E-3</c:v>
                </c:pt>
                <c:pt idx="551">
                  <c:v>1.339778E-3</c:v>
                </c:pt>
                <c:pt idx="552">
                  <c:v>4.7443829999999996E-3</c:v>
                </c:pt>
                <c:pt idx="553">
                  <c:v>1.125628E-3</c:v>
                </c:pt>
                <c:pt idx="554">
                  <c:v>4.3341680000000002E-3</c:v>
                </c:pt>
                <c:pt idx="555">
                  <c:v>2.8742080000000001E-3</c:v>
                </c:pt>
                <c:pt idx="556">
                  <c:v>4.4962719999999999E-3</c:v>
                </c:pt>
                <c:pt idx="557">
                  <c:v>6.8339200000000001E-4</c:v>
                </c:pt>
                <c:pt idx="558">
                  <c:v>1.0830429999999999E-3</c:v>
                </c:pt>
                <c:pt idx="559">
                  <c:v>4.8344470000000004E-3</c:v>
                </c:pt>
                <c:pt idx="560">
                  <c:v>1.515354E-3</c:v>
                </c:pt>
                <c:pt idx="561">
                  <c:v>4.5629370000000004E-3</c:v>
                </c:pt>
                <c:pt idx="562">
                  <c:v>2.787248E-3</c:v>
                </c:pt>
                <c:pt idx="563">
                  <c:v>1.450378E-3</c:v>
                </c:pt>
                <c:pt idx="564">
                  <c:v>5.2034E-4</c:v>
                </c:pt>
                <c:pt idx="565">
                  <c:v>3.536057E-3</c:v>
                </c:pt>
                <c:pt idx="566">
                  <c:v>7.6134100000000001E-4</c:v>
                </c:pt>
                <c:pt idx="567">
                  <c:v>3.3899849999999999E-3</c:v>
                </c:pt>
                <c:pt idx="568">
                  <c:v>1.349013E-3</c:v>
                </c:pt>
                <c:pt idx="569">
                  <c:v>1.3612120000000001E-3</c:v>
                </c:pt>
                <c:pt idx="570">
                  <c:v>3.3204409999999999E-3</c:v>
                </c:pt>
                <c:pt idx="571">
                  <c:v>3.5228009999999999E-3</c:v>
                </c:pt>
                <c:pt idx="572">
                  <c:v>2.008719E-3</c:v>
                </c:pt>
                <c:pt idx="573">
                  <c:v>6.3776350000000004E-3</c:v>
                </c:pt>
                <c:pt idx="574">
                  <c:v>2.7909580000000001E-3</c:v>
                </c:pt>
                <c:pt idx="575">
                  <c:v>3.1354949999999999E-3</c:v>
                </c:pt>
                <c:pt idx="576">
                  <c:v>1.9152819999999999E-3</c:v>
                </c:pt>
                <c:pt idx="577">
                  <c:v>1.619538E-3</c:v>
                </c:pt>
                <c:pt idx="578">
                  <c:v>2.063886E-3</c:v>
                </c:pt>
                <c:pt idx="579">
                  <c:v>1.201578E-3</c:v>
                </c:pt>
                <c:pt idx="580">
                  <c:v>2.8052419999999999E-3</c:v>
                </c:pt>
                <c:pt idx="581">
                  <c:v>2.3233860000000002E-3</c:v>
                </c:pt>
                <c:pt idx="582">
                  <c:v>1.0691460999999999E-2</c:v>
                </c:pt>
                <c:pt idx="583">
                  <c:v>5.1740709999999997E-3</c:v>
                </c:pt>
                <c:pt idx="584">
                  <c:v>2.7170390000000001E-3</c:v>
                </c:pt>
                <c:pt idx="585">
                  <c:v>3.8111270000000001E-3</c:v>
                </c:pt>
                <c:pt idx="586">
                  <c:v>4.3235210000000003E-3</c:v>
                </c:pt>
                <c:pt idx="587">
                  <c:v>2.119891E-3</c:v>
                </c:pt>
                <c:pt idx="588">
                  <c:v>2.13146E-3</c:v>
                </c:pt>
                <c:pt idx="589">
                  <c:v>2.4271399999999999E-3</c:v>
                </c:pt>
                <c:pt idx="590">
                  <c:v>2.151409E-3</c:v>
                </c:pt>
                <c:pt idx="591">
                  <c:v>3.6110589999999998E-3</c:v>
                </c:pt>
                <c:pt idx="592">
                  <c:v>1.8240660000000001E-3</c:v>
                </c:pt>
                <c:pt idx="593">
                  <c:v>5.1377259999999996E-3</c:v>
                </c:pt>
                <c:pt idx="594">
                  <c:v>2.8394409999999998E-3</c:v>
                </c:pt>
                <c:pt idx="595">
                  <c:v>2.2127919999999999E-3</c:v>
                </c:pt>
                <c:pt idx="596">
                  <c:v>2.4469660000000001E-3</c:v>
                </c:pt>
                <c:pt idx="597">
                  <c:v>5.0621729999999997E-3</c:v>
                </c:pt>
                <c:pt idx="598">
                  <c:v>1.566413E-3</c:v>
                </c:pt>
                <c:pt idx="599">
                  <c:v>6.3327119999999999E-3</c:v>
                </c:pt>
                <c:pt idx="600">
                  <c:v>2.401977E-3</c:v>
                </c:pt>
                <c:pt idx="601">
                  <c:v>6.6342099999999998E-4</c:v>
                </c:pt>
                <c:pt idx="602">
                  <c:v>8.4885600000000005E-4</c:v>
                </c:pt>
                <c:pt idx="603">
                  <c:v>1.976977E-3</c:v>
                </c:pt>
                <c:pt idx="604">
                  <c:v>1.8584700000000001E-3</c:v>
                </c:pt>
                <c:pt idx="605">
                  <c:v>2.8555049999999999E-3</c:v>
                </c:pt>
                <c:pt idx="606">
                  <c:v>2.2841710000000002E-3</c:v>
                </c:pt>
                <c:pt idx="607">
                  <c:v>1.8705250000000001E-3</c:v>
                </c:pt>
                <c:pt idx="608">
                  <c:v>4.4303060000000002E-3</c:v>
                </c:pt>
                <c:pt idx="609">
                  <c:v>4.1767169999999999E-3</c:v>
                </c:pt>
                <c:pt idx="610">
                  <c:v>2.1270830000000001E-3</c:v>
                </c:pt>
                <c:pt idx="611">
                  <c:v>1.493795E-3</c:v>
                </c:pt>
                <c:pt idx="612">
                  <c:v>2.4077090000000001E-3</c:v>
                </c:pt>
                <c:pt idx="613">
                  <c:v>3.016618E-3</c:v>
                </c:pt>
                <c:pt idx="614">
                  <c:v>2.0925240000000001E-3</c:v>
                </c:pt>
                <c:pt idx="615">
                  <c:v>2.5547360000000002E-3</c:v>
                </c:pt>
                <c:pt idx="616">
                  <c:v>2.1040070000000002E-3</c:v>
                </c:pt>
                <c:pt idx="617">
                  <c:v>2.4332999999999998E-3</c:v>
                </c:pt>
                <c:pt idx="618">
                  <c:v>4.0274539999999998E-3</c:v>
                </c:pt>
                <c:pt idx="619">
                  <c:v>3.1824739999999998E-3</c:v>
                </c:pt>
                <c:pt idx="620">
                  <c:v>3.126654E-3</c:v>
                </c:pt>
                <c:pt idx="621">
                  <c:v>2.1660690000000001E-3</c:v>
                </c:pt>
                <c:pt idx="622">
                  <c:v>6.0382689999999998E-3</c:v>
                </c:pt>
                <c:pt idx="623">
                  <c:v>3.834105E-3</c:v>
                </c:pt>
                <c:pt idx="624">
                  <c:v>8.9639899999999998E-4</c:v>
                </c:pt>
                <c:pt idx="625">
                  <c:v>8.6078299999999995E-4</c:v>
                </c:pt>
                <c:pt idx="626">
                  <c:v>3.1593739999999999E-3</c:v>
                </c:pt>
                <c:pt idx="627">
                  <c:v>1.821338E-3</c:v>
                </c:pt>
                <c:pt idx="628">
                  <c:v>7.7189750000000003E-3</c:v>
                </c:pt>
                <c:pt idx="629">
                  <c:v>2.0647780000000002E-3</c:v>
                </c:pt>
                <c:pt idx="630">
                  <c:v>1.2509789999999999E-3</c:v>
                </c:pt>
                <c:pt idx="631">
                  <c:v>4.7546890000000003E-3</c:v>
                </c:pt>
                <c:pt idx="632">
                  <c:v>3.962892E-3</c:v>
                </c:pt>
                <c:pt idx="633">
                  <c:v>2.3273230000000001E-3</c:v>
                </c:pt>
                <c:pt idx="634">
                  <c:v>3.2937460000000002E-3</c:v>
                </c:pt>
                <c:pt idx="635">
                  <c:v>2.8695040000000002E-3</c:v>
                </c:pt>
                <c:pt idx="636">
                  <c:v>1.2060759999999999E-3</c:v>
                </c:pt>
                <c:pt idx="637">
                  <c:v>2.9209409999999998E-3</c:v>
                </c:pt>
                <c:pt idx="638">
                  <c:v>4.1370260000000002E-3</c:v>
                </c:pt>
                <c:pt idx="639">
                  <c:v>8.6709999999999999E-4</c:v>
                </c:pt>
                <c:pt idx="640">
                  <c:v>2.256896E-3</c:v>
                </c:pt>
                <c:pt idx="641">
                  <c:v>8.2363409999999995E-3</c:v>
                </c:pt>
                <c:pt idx="642">
                  <c:v>1.8239650000000001E-3</c:v>
                </c:pt>
                <c:pt idx="643">
                  <c:v>4.2389690000000004E-3</c:v>
                </c:pt>
                <c:pt idx="644">
                  <c:v>6.1326820000000004E-3</c:v>
                </c:pt>
                <c:pt idx="645">
                  <c:v>8.2161199999999999E-4</c:v>
                </c:pt>
                <c:pt idx="646">
                  <c:v>2.9984090000000001E-3</c:v>
                </c:pt>
                <c:pt idx="647">
                  <c:v>6.3087600000000005E-4</c:v>
                </c:pt>
                <c:pt idx="648">
                  <c:v>8.4987799999999998E-4</c:v>
                </c:pt>
                <c:pt idx="649">
                  <c:v>6.9431500000000004E-4</c:v>
                </c:pt>
                <c:pt idx="650">
                  <c:v>1.0713770000000001E-3</c:v>
                </c:pt>
                <c:pt idx="651">
                  <c:v>1.6964324999999999E-2</c:v>
                </c:pt>
                <c:pt idx="652">
                  <c:v>6.0188180000000004E-3</c:v>
                </c:pt>
                <c:pt idx="653">
                  <c:v>2.6946769999999999E-3</c:v>
                </c:pt>
                <c:pt idx="654">
                  <c:v>5.1988800000000003E-4</c:v>
                </c:pt>
                <c:pt idx="655">
                  <c:v>2.6347089999999998E-3</c:v>
                </c:pt>
                <c:pt idx="656">
                  <c:v>6.6325669999999998E-3</c:v>
                </c:pt>
                <c:pt idx="657">
                  <c:v>1.0710554000000001E-2</c:v>
                </c:pt>
                <c:pt idx="658">
                  <c:v>7.6117600000000002E-4</c:v>
                </c:pt>
                <c:pt idx="659">
                  <c:v>3.799967E-3</c:v>
                </c:pt>
                <c:pt idx="660">
                  <c:v>2.5802080000000001E-3</c:v>
                </c:pt>
                <c:pt idx="661">
                  <c:v>1.8687910000000001E-3</c:v>
                </c:pt>
                <c:pt idx="662">
                  <c:v>2.0330040000000001E-3</c:v>
                </c:pt>
                <c:pt idx="663">
                  <c:v>3.5883479999999999E-3</c:v>
                </c:pt>
                <c:pt idx="664">
                  <c:v>6.3104629999999997E-3</c:v>
                </c:pt>
                <c:pt idx="665">
                  <c:v>1.1199283000000001E-2</c:v>
                </c:pt>
                <c:pt idx="666">
                  <c:v>1.1825850000000001E-3</c:v>
                </c:pt>
                <c:pt idx="667">
                  <c:v>2.87967E-3</c:v>
                </c:pt>
                <c:pt idx="668">
                  <c:v>3.0634120000000002E-3</c:v>
                </c:pt>
                <c:pt idx="669">
                  <c:v>5.4657519999999999E-3</c:v>
                </c:pt>
                <c:pt idx="670">
                  <c:v>4.0423610000000004E-3</c:v>
                </c:pt>
                <c:pt idx="671">
                  <c:v>6.3002999999999996E-4</c:v>
                </c:pt>
                <c:pt idx="672">
                  <c:v>2.8319790000000001E-3</c:v>
                </c:pt>
                <c:pt idx="673">
                  <c:v>2.1696549999999999E-3</c:v>
                </c:pt>
                <c:pt idx="674">
                  <c:v>4.1490850000000003E-3</c:v>
                </c:pt>
                <c:pt idx="675">
                  <c:v>3.064935E-3</c:v>
                </c:pt>
                <c:pt idx="676">
                  <c:v>2.6387339999999998E-3</c:v>
                </c:pt>
                <c:pt idx="677">
                  <c:v>1.2997659999999999E-3</c:v>
                </c:pt>
                <c:pt idx="678">
                  <c:v>6.574997E-3</c:v>
                </c:pt>
                <c:pt idx="679">
                  <c:v>5.4718329999999997E-3</c:v>
                </c:pt>
                <c:pt idx="680">
                  <c:v>6.9102699999999996E-3</c:v>
                </c:pt>
                <c:pt idx="681">
                  <c:v>5.0456390000000002E-3</c:v>
                </c:pt>
                <c:pt idx="682">
                  <c:v>1.5025279999999999E-3</c:v>
                </c:pt>
                <c:pt idx="683">
                  <c:v>1.6877019999999999E-3</c:v>
                </c:pt>
                <c:pt idx="684">
                  <c:v>2.3904619999999999E-3</c:v>
                </c:pt>
                <c:pt idx="685">
                  <c:v>9.8256899999999998E-4</c:v>
                </c:pt>
                <c:pt idx="686">
                  <c:v>2.4489400000000001E-3</c:v>
                </c:pt>
                <c:pt idx="687">
                  <c:v>8.0332199999999998E-4</c:v>
                </c:pt>
                <c:pt idx="688">
                  <c:v>2.8393670000000002E-3</c:v>
                </c:pt>
                <c:pt idx="689">
                  <c:v>2.380952E-3</c:v>
                </c:pt>
                <c:pt idx="690">
                  <c:v>4.594196E-3</c:v>
                </c:pt>
                <c:pt idx="691">
                  <c:v>6.88742E-3</c:v>
                </c:pt>
                <c:pt idx="692">
                  <c:v>2.3126729999999999E-3</c:v>
                </c:pt>
                <c:pt idx="693">
                  <c:v>1.946915E-3</c:v>
                </c:pt>
                <c:pt idx="694">
                  <c:v>4.4758589999999996E-3</c:v>
                </c:pt>
                <c:pt idx="695">
                  <c:v>8.4910520000000007E-3</c:v>
                </c:pt>
                <c:pt idx="696">
                  <c:v>2.6422220000000001E-3</c:v>
                </c:pt>
                <c:pt idx="697">
                  <c:v>6.1577699999999997E-4</c:v>
                </c:pt>
                <c:pt idx="698">
                  <c:v>6.9546160000000003E-3</c:v>
                </c:pt>
                <c:pt idx="699">
                  <c:v>2.4274919999999998E-3</c:v>
                </c:pt>
                <c:pt idx="700">
                  <c:v>2.0141310000000002E-3</c:v>
                </c:pt>
                <c:pt idx="701">
                  <c:v>4.868224E-3</c:v>
                </c:pt>
                <c:pt idx="702">
                  <c:v>3.323435E-3</c:v>
                </c:pt>
                <c:pt idx="703">
                  <c:v>5.8070799999999998E-4</c:v>
                </c:pt>
                <c:pt idx="704">
                  <c:v>3.4069909999999998E-3</c:v>
                </c:pt>
                <c:pt idx="705">
                  <c:v>2.5505520000000002E-3</c:v>
                </c:pt>
                <c:pt idx="706">
                  <c:v>3.6028520000000001E-3</c:v>
                </c:pt>
                <c:pt idx="707">
                  <c:v>1.2070130000000001E-3</c:v>
                </c:pt>
                <c:pt idx="708">
                  <c:v>9.9794100000000002E-4</c:v>
                </c:pt>
                <c:pt idx="709">
                  <c:v>2.7403060000000001E-3</c:v>
                </c:pt>
                <c:pt idx="710">
                  <c:v>6.7103479999999997E-3</c:v>
                </c:pt>
                <c:pt idx="711">
                  <c:v>1.9604940000000001E-3</c:v>
                </c:pt>
                <c:pt idx="712">
                  <c:v>1.959887E-3</c:v>
                </c:pt>
                <c:pt idx="713">
                  <c:v>2.9782139999999999E-3</c:v>
                </c:pt>
                <c:pt idx="714">
                  <c:v>1.342331E-3</c:v>
                </c:pt>
                <c:pt idx="715">
                  <c:v>8.9921499999999998E-4</c:v>
                </c:pt>
                <c:pt idx="716">
                  <c:v>1.5306810000000001E-3</c:v>
                </c:pt>
                <c:pt idx="717">
                  <c:v>1.794634E-3</c:v>
                </c:pt>
                <c:pt idx="718">
                  <c:v>2.7315529999999998E-3</c:v>
                </c:pt>
                <c:pt idx="719">
                  <c:v>4.0879669999999996E-3</c:v>
                </c:pt>
                <c:pt idx="720">
                  <c:v>6.3698280000000001E-3</c:v>
                </c:pt>
                <c:pt idx="721">
                  <c:v>1.7725779999999999E-3</c:v>
                </c:pt>
                <c:pt idx="722">
                  <c:v>2.5915209999999998E-3</c:v>
                </c:pt>
                <c:pt idx="723">
                  <c:v>2.708467E-3</c:v>
                </c:pt>
                <c:pt idx="724">
                  <c:v>2.817792E-3</c:v>
                </c:pt>
                <c:pt idx="725">
                  <c:v>2.4148110000000002E-3</c:v>
                </c:pt>
                <c:pt idx="726">
                  <c:v>6.5142209999999997E-3</c:v>
                </c:pt>
                <c:pt idx="727">
                  <c:v>1.596545E-3</c:v>
                </c:pt>
                <c:pt idx="728">
                  <c:v>2.9156030000000001E-3</c:v>
                </c:pt>
                <c:pt idx="729">
                  <c:v>5.586227E-3</c:v>
                </c:pt>
                <c:pt idx="730">
                  <c:v>7.1756000000000001E-4</c:v>
                </c:pt>
                <c:pt idx="731">
                  <c:v>3.042028E-3</c:v>
                </c:pt>
                <c:pt idx="732">
                  <c:v>4.7080209999999997E-3</c:v>
                </c:pt>
                <c:pt idx="733">
                  <c:v>6.5314350000000004E-3</c:v>
                </c:pt>
                <c:pt idx="734">
                  <c:v>2.6335590000000002E-3</c:v>
                </c:pt>
                <c:pt idx="735">
                  <c:v>6.5067E-4</c:v>
                </c:pt>
                <c:pt idx="736">
                  <c:v>3.6537570000000001E-3</c:v>
                </c:pt>
                <c:pt idx="737">
                  <c:v>8.9003400000000005E-4</c:v>
                </c:pt>
                <c:pt idx="738">
                  <c:v>6.5550369999999997E-3</c:v>
                </c:pt>
                <c:pt idx="739">
                  <c:v>1.01724E-3</c:v>
                </c:pt>
                <c:pt idx="740">
                  <c:v>1.4461599999999999E-3</c:v>
                </c:pt>
                <c:pt idx="741">
                  <c:v>2.3768600000000002E-3</c:v>
                </c:pt>
                <c:pt idx="742">
                  <c:v>7.0625870000000004E-3</c:v>
                </c:pt>
                <c:pt idx="743">
                  <c:v>3.717574E-3</c:v>
                </c:pt>
                <c:pt idx="744">
                  <c:v>2.4555459999999999E-3</c:v>
                </c:pt>
                <c:pt idx="745">
                  <c:v>2.101225E-3</c:v>
                </c:pt>
                <c:pt idx="746">
                  <c:v>3.7241050000000001E-3</c:v>
                </c:pt>
                <c:pt idx="747">
                  <c:v>6.0729000000000002E-4</c:v>
                </c:pt>
                <c:pt idx="748">
                  <c:v>2.363123E-3</c:v>
                </c:pt>
                <c:pt idx="749">
                  <c:v>3.561701E-3</c:v>
                </c:pt>
                <c:pt idx="750">
                  <c:v>5.8881849999999998E-3</c:v>
                </c:pt>
                <c:pt idx="751">
                  <c:v>8.9162900000000001E-4</c:v>
                </c:pt>
                <c:pt idx="752">
                  <c:v>8.7270499999999999E-4</c:v>
                </c:pt>
                <c:pt idx="753">
                  <c:v>2.2838839999999999E-3</c:v>
                </c:pt>
                <c:pt idx="754">
                  <c:v>1.834944E-3</c:v>
                </c:pt>
                <c:pt idx="755">
                  <c:v>2.0829669999999998E-3</c:v>
                </c:pt>
                <c:pt idx="756">
                  <c:v>1.950661E-3</c:v>
                </c:pt>
                <c:pt idx="757">
                  <c:v>2.505054E-3</c:v>
                </c:pt>
                <c:pt idx="758">
                  <c:v>5.9916099999999996E-4</c:v>
                </c:pt>
                <c:pt idx="759">
                  <c:v>1.1584970000000001E-3</c:v>
                </c:pt>
                <c:pt idx="760">
                  <c:v>7.1318399999999995E-4</c:v>
                </c:pt>
                <c:pt idx="761">
                  <c:v>6.2281299999999995E-4</c:v>
                </c:pt>
                <c:pt idx="762">
                  <c:v>8.1693200000000003E-4</c:v>
                </c:pt>
                <c:pt idx="763">
                  <c:v>1.8489940000000001E-3</c:v>
                </c:pt>
                <c:pt idx="764">
                  <c:v>4.726722E-3</c:v>
                </c:pt>
                <c:pt idx="765">
                  <c:v>3.2608300000000002E-4</c:v>
                </c:pt>
                <c:pt idx="766">
                  <c:v>7.9528340000000006E-3</c:v>
                </c:pt>
                <c:pt idx="767">
                  <c:v>1.787762E-3</c:v>
                </c:pt>
                <c:pt idx="768">
                  <c:v>1.4510160000000001E-3</c:v>
                </c:pt>
                <c:pt idx="769">
                  <c:v>6.2023299999999998E-4</c:v>
                </c:pt>
                <c:pt idx="770">
                  <c:v>2.2848819999999998E-3</c:v>
                </c:pt>
                <c:pt idx="771">
                  <c:v>2.346285E-3</c:v>
                </c:pt>
                <c:pt idx="772">
                  <c:v>1.090585E-3</c:v>
                </c:pt>
                <c:pt idx="773">
                  <c:v>2.1996590000000001E-3</c:v>
                </c:pt>
                <c:pt idx="774">
                  <c:v>1.1125779999999999E-3</c:v>
                </c:pt>
                <c:pt idx="775">
                  <c:v>1.258515E-3</c:v>
                </c:pt>
                <c:pt idx="776">
                  <c:v>2.8378710000000001E-3</c:v>
                </c:pt>
                <c:pt idx="777">
                  <c:v>2.6680739999999999E-3</c:v>
                </c:pt>
                <c:pt idx="778">
                  <c:v>2.5061939999999998E-3</c:v>
                </c:pt>
                <c:pt idx="779">
                  <c:v>4.0043680000000003E-3</c:v>
                </c:pt>
                <c:pt idx="780">
                  <c:v>2.3921680000000001E-3</c:v>
                </c:pt>
                <c:pt idx="781">
                  <c:v>9.8581699999999994E-4</c:v>
                </c:pt>
                <c:pt idx="782">
                  <c:v>2.4980029999999999E-3</c:v>
                </c:pt>
                <c:pt idx="783">
                  <c:v>3.2400630000000001E-3</c:v>
                </c:pt>
                <c:pt idx="784">
                  <c:v>3.5966660000000001E-3</c:v>
                </c:pt>
                <c:pt idx="785">
                  <c:v>5.0078600000000003E-4</c:v>
                </c:pt>
                <c:pt idx="786">
                  <c:v>1.40777E-3</c:v>
                </c:pt>
                <c:pt idx="787">
                  <c:v>2.1762790000000001E-3</c:v>
                </c:pt>
                <c:pt idx="788">
                  <c:v>5.2986709999999996E-3</c:v>
                </c:pt>
                <c:pt idx="789">
                  <c:v>1.6210599999999999E-3</c:v>
                </c:pt>
                <c:pt idx="790">
                  <c:v>3.0289179999999998E-3</c:v>
                </c:pt>
                <c:pt idx="791">
                  <c:v>7.3333239999999996E-3</c:v>
                </c:pt>
                <c:pt idx="792">
                  <c:v>7.2650099999999995E-4</c:v>
                </c:pt>
                <c:pt idx="793">
                  <c:v>8.35625E-4</c:v>
                </c:pt>
                <c:pt idx="794">
                  <c:v>3.8194119999999999E-3</c:v>
                </c:pt>
                <c:pt idx="795">
                  <c:v>2.484389E-3</c:v>
                </c:pt>
                <c:pt idx="796">
                  <c:v>8.2406799999999996E-4</c:v>
                </c:pt>
                <c:pt idx="797">
                  <c:v>2.83161E-3</c:v>
                </c:pt>
                <c:pt idx="798">
                  <c:v>2.7643670000000002E-3</c:v>
                </c:pt>
                <c:pt idx="799">
                  <c:v>1.9212420000000001E-3</c:v>
                </c:pt>
                <c:pt idx="800">
                  <c:v>2.2781849999999998E-3</c:v>
                </c:pt>
                <c:pt idx="801">
                  <c:v>1.2104889999999999E-3</c:v>
                </c:pt>
                <c:pt idx="802">
                  <c:v>3.6558269999999999E-3</c:v>
                </c:pt>
                <c:pt idx="803">
                  <c:v>2.2123360000000001E-3</c:v>
                </c:pt>
                <c:pt idx="804">
                  <c:v>9.1221200000000003E-4</c:v>
                </c:pt>
                <c:pt idx="805">
                  <c:v>1.007656E-3</c:v>
                </c:pt>
                <c:pt idx="806">
                  <c:v>3.8815830000000001E-3</c:v>
                </c:pt>
                <c:pt idx="807">
                  <c:v>2.1130239999999998E-3</c:v>
                </c:pt>
                <c:pt idx="808">
                  <c:v>2.9086490000000001E-3</c:v>
                </c:pt>
                <c:pt idx="809">
                  <c:v>3.2232519999999998E-3</c:v>
                </c:pt>
                <c:pt idx="810">
                  <c:v>3.1406619999999998E-3</c:v>
                </c:pt>
                <c:pt idx="811">
                  <c:v>2.1675010000000001E-3</c:v>
                </c:pt>
                <c:pt idx="812">
                  <c:v>4.2021080000000004E-3</c:v>
                </c:pt>
                <c:pt idx="813">
                  <c:v>1.2442600000000001E-3</c:v>
                </c:pt>
                <c:pt idx="814">
                  <c:v>2.0563619999999999E-3</c:v>
                </c:pt>
                <c:pt idx="815">
                  <c:v>2.4404790000000002E-3</c:v>
                </c:pt>
                <c:pt idx="816">
                  <c:v>1.9797719999999999E-3</c:v>
                </c:pt>
                <c:pt idx="817">
                  <c:v>2.2601460000000002E-3</c:v>
                </c:pt>
                <c:pt idx="818">
                  <c:v>1.0574479999999999E-3</c:v>
                </c:pt>
                <c:pt idx="819">
                  <c:v>8.0380499999999999E-4</c:v>
                </c:pt>
                <c:pt idx="820">
                  <c:v>2.9915639999999999E-3</c:v>
                </c:pt>
                <c:pt idx="821">
                  <c:v>1.0587109999999999E-3</c:v>
                </c:pt>
                <c:pt idx="822">
                  <c:v>7.5414099999999995E-4</c:v>
                </c:pt>
                <c:pt idx="823">
                  <c:v>3.0968979999999998E-3</c:v>
                </c:pt>
                <c:pt idx="824">
                  <c:v>2.8704870000000001E-3</c:v>
                </c:pt>
                <c:pt idx="825">
                  <c:v>5.7651600000000001E-4</c:v>
                </c:pt>
                <c:pt idx="826">
                  <c:v>3.7673559999999999E-3</c:v>
                </c:pt>
                <c:pt idx="827">
                  <c:v>1.3574380000000001E-3</c:v>
                </c:pt>
                <c:pt idx="828">
                  <c:v>8.8032099999999999E-4</c:v>
                </c:pt>
                <c:pt idx="829">
                  <c:v>1.8771840000000001E-3</c:v>
                </c:pt>
                <c:pt idx="830">
                  <c:v>2.5267219999999999E-3</c:v>
                </c:pt>
                <c:pt idx="831">
                  <c:v>7.1082899999999995E-4</c:v>
                </c:pt>
                <c:pt idx="832">
                  <c:v>2.892394E-3</c:v>
                </c:pt>
                <c:pt idx="833">
                  <c:v>3.4597849999999999E-3</c:v>
                </c:pt>
                <c:pt idx="834">
                  <c:v>6.2898010000000002E-3</c:v>
                </c:pt>
                <c:pt idx="835">
                  <c:v>1.46536E-3</c:v>
                </c:pt>
                <c:pt idx="836">
                  <c:v>1.019273E-3</c:v>
                </c:pt>
                <c:pt idx="837">
                  <c:v>4.1520419999999999E-3</c:v>
                </c:pt>
                <c:pt idx="838">
                  <c:v>4.2953879999999998E-3</c:v>
                </c:pt>
                <c:pt idx="839">
                  <c:v>2.1020320000000002E-3</c:v>
                </c:pt>
                <c:pt idx="840">
                  <c:v>4.2897480000000003E-3</c:v>
                </c:pt>
                <c:pt idx="841">
                  <c:v>2.6873119999999999E-3</c:v>
                </c:pt>
                <c:pt idx="842">
                  <c:v>7.13318E-4</c:v>
                </c:pt>
                <c:pt idx="843">
                  <c:v>4.6054750000000004E-3</c:v>
                </c:pt>
                <c:pt idx="844">
                  <c:v>5.7811879999999996E-3</c:v>
                </c:pt>
                <c:pt idx="845">
                  <c:v>3.5924310000000001E-3</c:v>
                </c:pt>
                <c:pt idx="846">
                  <c:v>2.2453220000000001E-3</c:v>
                </c:pt>
                <c:pt idx="847">
                  <c:v>2.8275869999999999E-3</c:v>
                </c:pt>
                <c:pt idx="848">
                  <c:v>1.854912E-3</c:v>
                </c:pt>
                <c:pt idx="849">
                  <c:v>1.5584850000000001E-3</c:v>
                </c:pt>
                <c:pt idx="850">
                  <c:v>3.9610820000000003E-3</c:v>
                </c:pt>
                <c:pt idx="851">
                  <c:v>1.3460290000000001E-3</c:v>
                </c:pt>
                <c:pt idx="852">
                  <c:v>1.692004E-3</c:v>
                </c:pt>
                <c:pt idx="853">
                  <c:v>9.5039300000000001E-4</c:v>
                </c:pt>
                <c:pt idx="854">
                  <c:v>2.469574E-3</c:v>
                </c:pt>
                <c:pt idx="855">
                  <c:v>9.8032299999999996E-4</c:v>
                </c:pt>
                <c:pt idx="856">
                  <c:v>1.3454910000000001E-3</c:v>
                </c:pt>
                <c:pt idx="857">
                  <c:v>2.0430560000000001E-3</c:v>
                </c:pt>
                <c:pt idx="858">
                  <c:v>4.4968129999999997E-3</c:v>
                </c:pt>
                <c:pt idx="859">
                  <c:v>1.942435E-3</c:v>
                </c:pt>
                <c:pt idx="860">
                  <c:v>4.0201990000000003E-3</c:v>
                </c:pt>
                <c:pt idx="861">
                  <c:v>1.052716E-3</c:v>
                </c:pt>
                <c:pt idx="862">
                  <c:v>2.3983810000000002E-3</c:v>
                </c:pt>
                <c:pt idx="863">
                  <c:v>3.353272E-3</c:v>
                </c:pt>
                <c:pt idx="864">
                  <c:v>4.0367249999999997E-3</c:v>
                </c:pt>
                <c:pt idx="865">
                  <c:v>6.4172860000000003E-3</c:v>
                </c:pt>
                <c:pt idx="866">
                  <c:v>5.9238499999999996E-4</c:v>
                </c:pt>
                <c:pt idx="867">
                  <c:v>2.3264190000000001E-3</c:v>
                </c:pt>
                <c:pt idx="868">
                  <c:v>1.7510539999999999E-3</c:v>
                </c:pt>
                <c:pt idx="869">
                  <c:v>2.131895E-3</c:v>
                </c:pt>
                <c:pt idx="870">
                  <c:v>6.4368230000000004E-3</c:v>
                </c:pt>
                <c:pt idx="871">
                  <c:v>8.2640899999999995E-4</c:v>
                </c:pt>
                <c:pt idx="872">
                  <c:v>7.7174800000000005E-4</c:v>
                </c:pt>
                <c:pt idx="873">
                  <c:v>4.4231219999999998E-3</c:v>
                </c:pt>
                <c:pt idx="874">
                  <c:v>2.2415550000000001E-3</c:v>
                </c:pt>
                <c:pt idx="875">
                  <c:v>2.2418080000000001E-3</c:v>
                </c:pt>
                <c:pt idx="876">
                  <c:v>5.0499170000000001E-3</c:v>
                </c:pt>
                <c:pt idx="877">
                  <c:v>7.2776199999999996E-4</c:v>
                </c:pt>
                <c:pt idx="878">
                  <c:v>2.9687860000000002E-3</c:v>
                </c:pt>
                <c:pt idx="879">
                  <c:v>1.2219500000000001E-3</c:v>
                </c:pt>
                <c:pt idx="880">
                  <c:v>3.9128030000000003E-3</c:v>
                </c:pt>
                <c:pt idx="881">
                  <c:v>5.2256500000000001E-4</c:v>
                </c:pt>
                <c:pt idx="882">
                  <c:v>3.472971E-3</c:v>
                </c:pt>
                <c:pt idx="883">
                  <c:v>3.3308270000000002E-3</c:v>
                </c:pt>
                <c:pt idx="884">
                  <c:v>3.1092810000000002E-3</c:v>
                </c:pt>
                <c:pt idx="885">
                  <c:v>1.8024359999999999E-3</c:v>
                </c:pt>
                <c:pt idx="886">
                  <c:v>9.0796799999999999E-4</c:v>
                </c:pt>
                <c:pt idx="887">
                  <c:v>5.0271860000000003E-3</c:v>
                </c:pt>
                <c:pt idx="888">
                  <c:v>5.0324410000000003E-3</c:v>
                </c:pt>
                <c:pt idx="889">
                  <c:v>6.4095489999999996E-3</c:v>
                </c:pt>
                <c:pt idx="890">
                  <c:v>2.5518229999999999E-3</c:v>
                </c:pt>
                <c:pt idx="891">
                  <c:v>5.4402549999999997E-3</c:v>
                </c:pt>
                <c:pt idx="892">
                  <c:v>7.7596999999999996E-4</c:v>
                </c:pt>
                <c:pt idx="893">
                  <c:v>3.5323080000000001E-3</c:v>
                </c:pt>
                <c:pt idx="894">
                  <c:v>1.6006659999999999E-3</c:v>
                </c:pt>
                <c:pt idx="895">
                  <c:v>3.1782730000000001E-3</c:v>
                </c:pt>
                <c:pt idx="896">
                  <c:v>4.9255610000000002E-3</c:v>
                </c:pt>
                <c:pt idx="897">
                  <c:v>2.2742639999999998E-3</c:v>
                </c:pt>
                <c:pt idx="898">
                  <c:v>2.6618010000000001E-3</c:v>
                </c:pt>
                <c:pt idx="899">
                  <c:v>1.715531E-3</c:v>
                </c:pt>
                <c:pt idx="900">
                  <c:v>4.6546349999999998E-3</c:v>
                </c:pt>
                <c:pt idx="901">
                  <c:v>4.5777049999999996E-3</c:v>
                </c:pt>
                <c:pt idx="902">
                  <c:v>2.3454600000000002E-3</c:v>
                </c:pt>
                <c:pt idx="903">
                  <c:v>5.1708500000000003E-4</c:v>
                </c:pt>
                <c:pt idx="904">
                  <c:v>4.1802009999999997E-3</c:v>
                </c:pt>
                <c:pt idx="905">
                  <c:v>1.227101E-3</c:v>
                </c:pt>
                <c:pt idx="906">
                  <c:v>7.3521000000000003E-4</c:v>
                </c:pt>
                <c:pt idx="907">
                  <c:v>2.0430359999999998E-3</c:v>
                </c:pt>
                <c:pt idx="908">
                  <c:v>2.6967810000000001E-3</c:v>
                </c:pt>
                <c:pt idx="909">
                  <c:v>5.5815179999999997E-3</c:v>
                </c:pt>
                <c:pt idx="910">
                  <c:v>3.1126069999999999E-3</c:v>
                </c:pt>
                <c:pt idx="911">
                  <c:v>1.250471E-3</c:v>
                </c:pt>
                <c:pt idx="912">
                  <c:v>3.3579130000000001E-3</c:v>
                </c:pt>
                <c:pt idx="913">
                  <c:v>2.8520970000000001E-3</c:v>
                </c:pt>
                <c:pt idx="914">
                  <c:v>4.3386850000000001E-3</c:v>
                </c:pt>
                <c:pt idx="915">
                  <c:v>8.9033000000000005E-4</c:v>
                </c:pt>
                <c:pt idx="916">
                  <c:v>2.9694610000000001E-3</c:v>
                </c:pt>
                <c:pt idx="917">
                  <c:v>7.9597100000000003E-4</c:v>
                </c:pt>
                <c:pt idx="918">
                  <c:v>1.17997E-3</c:v>
                </c:pt>
                <c:pt idx="919">
                  <c:v>3.2195449999999999E-3</c:v>
                </c:pt>
                <c:pt idx="920">
                  <c:v>6.17748E-4</c:v>
                </c:pt>
                <c:pt idx="921">
                  <c:v>3.0232449999999999E-3</c:v>
                </c:pt>
                <c:pt idx="922">
                  <c:v>3.0958880000000002E-3</c:v>
                </c:pt>
                <c:pt idx="923">
                  <c:v>3.3798399999999998E-3</c:v>
                </c:pt>
                <c:pt idx="924">
                  <c:v>2.6732800000000001E-3</c:v>
                </c:pt>
                <c:pt idx="925">
                  <c:v>5.1194810000000004E-3</c:v>
                </c:pt>
                <c:pt idx="926">
                  <c:v>5.179693E-3</c:v>
                </c:pt>
                <c:pt idx="927">
                  <c:v>4.0148320000000003E-3</c:v>
                </c:pt>
                <c:pt idx="928">
                  <c:v>3.4608040000000001E-3</c:v>
                </c:pt>
                <c:pt idx="929">
                  <c:v>1.1802710000000001E-3</c:v>
                </c:pt>
                <c:pt idx="930">
                  <c:v>3.9049649999999998E-3</c:v>
                </c:pt>
                <c:pt idx="931">
                  <c:v>7.9203100000000001E-4</c:v>
                </c:pt>
                <c:pt idx="932">
                  <c:v>1.5982539999999999E-3</c:v>
                </c:pt>
                <c:pt idx="933">
                  <c:v>1.4209369999999999E-3</c:v>
                </c:pt>
                <c:pt idx="934">
                  <c:v>6.0545820000000002E-3</c:v>
                </c:pt>
                <c:pt idx="935">
                  <c:v>2.553151E-3</c:v>
                </c:pt>
                <c:pt idx="936">
                  <c:v>2.4850940000000002E-3</c:v>
                </c:pt>
                <c:pt idx="937">
                  <c:v>3.7653090000000001E-3</c:v>
                </c:pt>
                <c:pt idx="938">
                  <c:v>3.1196660000000001E-3</c:v>
                </c:pt>
                <c:pt idx="939">
                  <c:v>7.3636899999999996E-4</c:v>
                </c:pt>
                <c:pt idx="940">
                  <c:v>1.5080810000000001E-3</c:v>
                </c:pt>
                <c:pt idx="941">
                  <c:v>2.1920809999999998E-3</c:v>
                </c:pt>
                <c:pt idx="942">
                  <c:v>6.9337700000000001E-4</c:v>
                </c:pt>
                <c:pt idx="943">
                  <c:v>3.3188599999999999E-3</c:v>
                </c:pt>
                <c:pt idx="944">
                  <c:v>2.3279640000000001E-3</c:v>
                </c:pt>
                <c:pt idx="945">
                  <c:v>2.2798300000000001E-3</c:v>
                </c:pt>
                <c:pt idx="946">
                  <c:v>2.7619210000000001E-3</c:v>
                </c:pt>
                <c:pt idx="947">
                  <c:v>1.4436449999999999E-3</c:v>
                </c:pt>
                <c:pt idx="948">
                  <c:v>1.6210599999999999E-3</c:v>
                </c:pt>
                <c:pt idx="949">
                  <c:v>4.0282629999999998E-3</c:v>
                </c:pt>
                <c:pt idx="950">
                  <c:v>2.366693E-3</c:v>
                </c:pt>
                <c:pt idx="951">
                  <c:v>3.4811199999999999E-3</c:v>
                </c:pt>
                <c:pt idx="952">
                  <c:v>4.3960630000000004E-3</c:v>
                </c:pt>
                <c:pt idx="953">
                  <c:v>3.8801619999999999E-3</c:v>
                </c:pt>
                <c:pt idx="954">
                  <c:v>3.1195419999999999E-3</c:v>
                </c:pt>
                <c:pt idx="955">
                  <c:v>2.6399510000000002E-3</c:v>
                </c:pt>
                <c:pt idx="956">
                  <c:v>5.7211199999999995E-4</c:v>
                </c:pt>
                <c:pt idx="957">
                  <c:v>2.995653E-3</c:v>
                </c:pt>
                <c:pt idx="958">
                  <c:v>5.1050480000000001E-3</c:v>
                </c:pt>
                <c:pt idx="959">
                  <c:v>4.847067E-3</c:v>
                </c:pt>
                <c:pt idx="960">
                  <c:v>4.436466E-3</c:v>
                </c:pt>
                <c:pt idx="961">
                  <c:v>3.446092E-3</c:v>
                </c:pt>
                <c:pt idx="962">
                  <c:v>1.358616E-3</c:v>
                </c:pt>
                <c:pt idx="963">
                  <c:v>2.0563040000000001E-3</c:v>
                </c:pt>
                <c:pt idx="964">
                  <c:v>1.3936459999999999E-3</c:v>
                </c:pt>
                <c:pt idx="965">
                  <c:v>3.3854000000000002E-3</c:v>
                </c:pt>
                <c:pt idx="966">
                  <c:v>3.661774E-3</c:v>
                </c:pt>
                <c:pt idx="967">
                  <c:v>3.9309039999999998E-3</c:v>
                </c:pt>
                <c:pt idx="968">
                  <c:v>3.7132860000000001E-3</c:v>
                </c:pt>
                <c:pt idx="969">
                  <c:v>1.691176E-3</c:v>
                </c:pt>
                <c:pt idx="970">
                  <c:v>2.924224E-3</c:v>
                </c:pt>
                <c:pt idx="971">
                  <c:v>1.7185569999999999E-3</c:v>
                </c:pt>
                <c:pt idx="972">
                  <c:v>4.086447E-3</c:v>
                </c:pt>
                <c:pt idx="973">
                  <c:v>1.7377079999999999E-3</c:v>
                </c:pt>
                <c:pt idx="974">
                  <c:v>3.834741E-3</c:v>
                </c:pt>
                <c:pt idx="975">
                  <c:v>2.4546500000000001E-3</c:v>
                </c:pt>
                <c:pt idx="976">
                  <c:v>2.5889229999999999E-3</c:v>
                </c:pt>
                <c:pt idx="977">
                  <c:v>3.390264E-3</c:v>
                </c:pt>
                <c:pt idx="978">
                  <c:v>9.5975499999999996E-4</c:v>
                </c:pt>
                <c:pt idx="979">
                  <c:v>2.760771E-3</c:v>
                </c:pt>
                <c:pt idx="980">
                  <c:v>2.789999E-3</c:v>
                </c:pt>
                <c:pt idx="981">
                  <c:v>6.1496499999999998E-4</c:v>
                </c:pt>
                <c:pt idx="982">
                  <c:v>2.6945910000000001E-3</c:v>
                </c:pt>
                <c:pt idx="983">
                  <c:v>1.8729020000000001E-3</c:v>
                </c:pt>
                <c:pt idx="984">
                  <c:v>3.9158769999999999E-3</c:v>
                </c:pt>
                <c:pt idx="985">
                  <c:v>8.6752599999999997E-4</c:v>
                </c:pt>
                <c:pt idx="986">
                  <c:v>1.9803939999999999E-3</c:v>
                </c:pt>
                <c:pt idx="987">
                  <c:v>2.9514670000000002E-3</c:v>
                </c:pt>
                <c:pt idx="988">
                  <c:v>2.8011960000000002E-3</c:v>
                </c:pt>
                <c:pt idx="989">
                  <c:v>2.567251E-3</c:v>
                </c:pt>
                <c:pt idx="990">
                  <c:v>1.7993110000000001E-3</c:v>
                </c:pt>
                <c:pt idx="991">
                  <c:v>1.14763E-3</c:v>
                </c:pt>
                <c:pt idx="992">
                  <c:v>1.3345119999999999E-3</c:v>
                </c:pt>
                <c:pt idx="993">
                  <c:v>2.778474E-3</c:v>
                </c:pt>
                <c:pt idx="994">
                  <c:v>1.653103E-3</c:v>
                </c:pt>
                <c:pt idx="995">
                  <c:v>4.0718860000000003E-3</c:v>
                </c:pt>
                <c:pt idx="996">
                  <c:v>2.0044619999999998E-3</c:v>
                </c:pt>
                <c:pt idx="997">
                  <c:v>1.20323E-3</c:v>
                </c:pt>
                <c:pt idx="998">
                  <c:v>5.2443489999999997E-3</c:v>
                </c:pt>
                <c:pt idx="999">
                  <c:v>2.3869389999999998E-3</c:v>
                </c:pt>
                <c:pt idx="1000">
                  <c:v>2.5881519999999998E-3</c:v>
                </c:pt>
                <c:pt idx="1001">
                  <c:v>2.6392550000000001E-3</c:v>
                </c:pt>
                <c:pt idx="1002">
                  <c:v>3.0586229999999999E-3</c:v>
                </c:pt>
                <c:pt idx="1003">
                  <c:v>5.3122680000000002E-3</c:v>
                </c:pt>
                <c:pt idx="1004">
                  <c:v>3.4963519999999999E-3</c:v>
                </c:pt>
                <c:pt idx="1005">
                  <c:v>2.988901E-3</c:v>
                </c:pt>
                <c:pt idx="1006">
                  <c:v>2.5159420000000002E-3</c:v>
                </c:pt>
                <c:pt idx="1007">
                  <c:v>1.2428680000000001E-3</c:v>
                </c:pt>
                <c:pt idx="1008">
                  <c:v>2.2466249999999999E-3</c:v>
                </c:pt>
                <c:pt idx="1009">
                  <c:v>4.442662E-3</c:v>
                </c:pt>
                <c:pt idx="1010">
                  <c:v>6.6781700000000002E-4</c:v>
                </c:pt>
                <c:pt idx="1011">
                  <c:v>2.8428199999999998E-3</c:v>
                </c:pt>
                <c:pt idx="1012">
                  <c:v>2.7340009999999998E-3</c:v>
                </c:pt>
                <c:pt idx="1013">
                  <c:v>3.3951820000000001E-3</c:v>
                </c:pt>
                <c:pt idx="1014">
                  <c:v>2.3187440000000002E-3</c:v>
                </c:pt>
                <c:pt idx="1015">
                  <c:v>3.7761629999999999E-3</c:v>
                </c:pt>
                <c:pt idx="1016">
                  <c:v>2.1270769999999998E-3</c:v>
                </c:pt>
                <c:pt idx="1017">
                  <c:v>4.3934869999999997E-3</c:v>
                </c:pt>
                <c:pt idx="1018">
                  <c:v>1.3459850000000001E-3</c:v>
                </c:pt>
                <c:pt idx="1019">
                  <c:v>2.8830710000000001E-3</c:v>
                </c:pt>
                <c:pt idx="1020">
                  <c:v>4.4136979999999998E-3</c:v>
                </c:pt>
                <c:pt idx="1021">
                  <c:v>2.563999E-3</c:v>
                </c:pt>
                <c:pt idx="1022">
                  <c:v>2.801535E-3</c:v>
                </c:pt>
                <c:pt idx="1023">
                  <c:v>2.367685E-3</c:v>
                </c:pt>
                <c:pt idx="1024">
                  <c:v>1.42296E-3</c:v>
                </c:pt>
                <c:pt idx="1025">
                  <c:v>4.8112290000000002E-3</c:v>
                </c:pt>
                <c:pt idx="1026">
                  <c:v>4.3157200000000002E-4</c:v>
                </c:pt>
                <c:pt idx="1027">
                  <c:v>1.3249830000000001E-3</c:v>
                </c:pt>
                <c:pt idx="1028">
                  <c:v>3.8679169999999998E-3</c:v>
                </c:pt>
                <c:pt idx="1029">
                  <c:v>5.3597599999999999E-3</c:v>
                </c:pt>
                <c:pt idx="1030">
                  <c:v>2.4145730000000002E-3</c:v>
                </c:pt>
                <c:pt idx="1031">
                  <c:v>1.7426080000000001E-3</c:v>
                </c:pt>
                <c:pt idx="1032">
                  <c:v>2.2426870000000002E-3</c:v>
                </c:pt>
                <c:pt idx="1033">
                  <c:v>4.6236970000000004E-3</c:v>
                </c:pt>
                <c:pt idx="1034">
                  <c:v>2.2938989999999999E-3</c:v>
                </c:pt>
                <c:pt idx="1035">
                  <c:v>4.1906000000000001E-3</c:v>
                </c:pt>
                <c:pt idx="1036">
                  <c:v>2.3292299999999998E-3</c:v>
                </c:pt>
                <c:pt idx="1037">
                  <c:v>1.961211E-3</c:v>
                </c:pt>
                <c:pt idx="1038">
                  <c:v>3.7154750000000002E-3</c:v>
                </c:pt>
                <c:pt idx="1039">
                  <c:v>2.6730180000000001E-3</c:v>
                </c:pt>
                <c:pt idx="1040">
                  <c:v>3.8172129999999999E-3</c:v>
                </c:pt>
                <c:pt idx="1041">
                  <c:v>1.1993335000000001E-2</c:v>
                </c:pt>
                <c:pt idx="1042">
                  <c:v>3.0743189999999998E-3</c:v>
                </c:pt>
                <c:pt idx="1043">
                  <c:v>7.5533999999999996E-4</c:v>
                </c:pt>
                <c:pt idx="1044">
                  <c:v>3.851363E-3</c:v>
                </c:pt>
                <c:pt idx="1045">
                  <c:v>1.206153E-3</c:v>
                </c:pt>
                <c:pt idx="1046">
                  <c:v>2.495386E-3</c:v>
                </c:pt>
                <c:pt idx="1047">
                  <c:v>4.2058369999999996E-3</c:v>
                </c:pt>
                <c:pt idx="1048">
                  <c:v>2.339509E-3</c:v>
                </c:pt>
                <c:pt idx="1049">
                  <c:v>1.9318759999999999E-3</c:v>
                </c:pt>
                <c:pt idx="1050">
                  <c:v>4.2291710000000003E-3</c:v>
                </c:pt>
                <c:pt idx="1051">
                  <c:v>3.3226309999999999E-3</c:v>
                </c:pt>
                <c:pt idx="1052">
                  <c:v>4.9634650000000002E-3</c:v>
                </c:pt>
                <c:pt idx="1053">
                  <c:v>1.3180329999999999E-3</c:v>
                </c:pt>
                <c:pt idx="1054">
                  <c:v>3.081692E-3</c:v>
                </c:pt>
                <c:pt idx="1055">
                  <c:v>3.1954090000000002E-3</c:v>
                </c:pt>
                <c:pt idx="1056">
                  <c:v>6.4306599999999997E-4</c:v>
                </c:pt>
                <c:pt idx="1057">
                  <c:v>2.1283360000000002E-3</c:v>
                </c:pt>
                <c:pt idx="1058">
                  <c:v>4.1175949999999999E-3</c:v>
                </c:pt>
                <c:pt idx="1059">
                  <c:v>5.5716910000000001E-3</c:v>
                </c:pt>
                <c:pt idx="1060">
                  <c:v>2.5295109999999999E-3</c:v>
                </c:pt>
                <c:pt idx="1061">
                  <c:v>3.4891589999999999E-3</c:v>
                </c:pt>
                <c:pt idx="1062">
                  <c:v>2.407143E-3</c:v>
                </c:pt>
                <c:pt idx="1063">
                  <c:v>2.5267969999999999E-3</c:v>
                </c:pt>
                <c:pt idx="1064">
                  <c:v>3.4293599999999998E-3</c:v>
                </c:pt>
                <c:pt idx="1065">
                  <c:v>2.007113E-3</c:v>
                </c:pt>
                <c:pt idx="1066">
                  <c:v>4.5862300000000002E-3</c:v>
                </c:pt>
                <c:pt idx="1067">
                  <c:v>8.6447200000000003E-4</c:v>
                </c:pt>
                <c:pt idx="1068">
                  <c:v>4.4246959999999997E-3</c:v>
                </c:pt>
                <c:pt idx="1069">
                  <c:v>2.4668509999999999E-3</c:v>
                </c:pt>
                <c:pt idx="1070">
                  <c:v>5.0743439999999997E-3</c:v>
                </c:pt>
                <c:pt idx="1071">
                  <c:v>2.7332179999999999E-3</c:v>
                </c:pt>
                <c:pt idx="1072">
                  <c:v>3.792517E-3</c:v>
                </c:pt>
                <c:pt idx="1073">
                  <c:v>4.0622499999999999E-3</c:v>
                </c:pt>
                <c:pt idx="1074">
                  <c:v>2.3974859999999999E-3</c:v>
                </c:pt>
                <c:pt idx="1075">
                  <c:v>1.4775750000000001E-3</c:v>
                </c:pt>
                <c:pt idx="1076">
                  <c:v>2.1376030000000001E-3</c:v>
                </c:pt>
                <c:pt idx="1077">
                  <c:v>2.402436E-3</c:v>
                </c:pt>
                <c:pt idx="1078">
                  <c:v>2.8881620000000001E-3</c:v>
                </c:pt>
                <c:pt idx="1079">
                  <c:v>1.4925660000000001E-3</c:v>
                </c:pt>
                <c:pt idx="1080">
                  <c:v>7.4584800000000002E-4</c:v>
                </c:pt>
                <c:pt idx="1081">
                  <c:v>2.2074289999999999E-3</c:v>
                </c:pt>
                <c:pt idx="1082">
                  <c:v>2.6520647000000001E-2</c:v>
                </c:pt>
                <c:pt idx="1083">
                  <c:v>4.1135779999999997E-3</c:v>
                </c:pt>
                <c:pt idx="1084">
                  <c:v>3.4244169999999999E-3</c:v>
                </c:pt>
                <c:pt idx="1085">
                  <c:v>2.4285510000000001E-3</c:v>
                </c:pt>
                <c:pt idx="1086">
                  <c:v>6.6083740000000002E-3</c:v>
                </c:pt>
                <c:pt idx="1087">
                  <c:v>3.9349709999999998E-3</c:v>
                </c:pt>
                <c:pt idx="1088">
                  <c:v>2.828737E-3</c:v>
                </c:pt>
                <c:pt idx="1089">
                  <c:v>3.3828080000000002E-3</c:v>
                </c:pt>
                <c:pt idx="1090">
                  <c:v>5.5094899999999997E-3</c:v>
                </c:pt>
                <c:pt idx="1091">
                  <c:v>2.7206859999999999E-3</c:v>
                </c:pt>
                <c:pt idx="1092">
                  <c:v>2.6372470000000001E-3</c:v>
                </c:pt>
                <c:pt idx="1093">
                  <c:v>2.4460100000000002E-3</c:v>
                </c:pt>
                <c:pt idx="1094">
                  <c:v>3.1251260000000002E-3</c:v>
                </c:pt>
                <c:pt idx="1095">
                  <c:v>2.174062E-3</c:v>
                </c:pt>
                <c:pt idx="1096">
                  <c:v>4.2832520000000004E-3</c:v>
                </c:pt>
                <c:pt idx="1097">
                  <c:v>1.039496E-3</c:v>
                </c:pt>
                <c:pt idx="1098">
                  <c:v>4.1479480000000003E-3</c:v>
                </c:pt>
                <c:pt idx="1099">
                  <c:v>2.7667680000000002E-3</c:v>
                </c:pt>
                <c:pt idx="1100">
                  <c:v>3.8267549999999998E-3</c:v>
                </c:pt>
                <c:pt idx="1101">
                  <c:v>2.4474800000000001E-3</c:v>
                </c:pt>
                <c:pt idx="1102">
                  <c:v>6.0755900000000003E-4</c:v>
                </c:pt>
                <c:pt idx="1103">
                  <c:v>1.2333229999999999E-3</c:v>
                </c:pt>
                <c:pt idx="1104">
                  <c:v>2.3683380000000002E-3</c:v>
                </c:pt>
                <c:pt idx="1105">
                  <c:v>4.028663E-3</c:v>
                </c:pt>
                <c:pt idx="1106">
                  <c:v>4.58357E-4</c:v>
                </c:pt>
                <c:pt idx="1107">
                  <c:v>4.3395309999999998E-3</c:v>
                </c:pt>
                <c:pt idx="1108">
                  <c:v>3.1376780000000001E-3</c:v>
                </c:pt>
                <c:pt idx="1109">
                  <c:v>2.4363200000000001E-3</c:v>
                </c:pt>
                <c:pt idx="1110">
                  <c:v>2.9209150000000001E-3</c:v>
                </c:pt>
                <c:pt idx="1111">
                  <c:v>4.8246519999999996E-3</c:v>
                </c:pt>
                <c:pt idx="1112">
                  <c:v>3.193244E-3</c:v>
                </c:pt>
                <c:pt idx="1113">
                  <c:v>9.1978899999999996E-4</c:v>
                </c:pt>
                <c:pt idx="1114">
                  <c:v>3.4317829999999999E-3</c:v>
                </c:pt>
                <c:pt idx="1115">
                  <c:v>3.8496820000000001E-3</c:v>
                </c:pt>
                <c:pt idx="1116">
                  <c:v>2.7917710000000002E-3</c:v>
                </c:pt>
                <c:pt idx="1117">
                  <c:v>3.2993319999999999E-3</c:v>
                </c:pt>
                <c:pt idx="1118">
                  <c:v>4.2075339999999998E-3</c:v>
                </c:pt>
                <c:pt idx="1119">
                  <c:v>7.8590599999999995E-4</c:v>
                </c:pt>
                <c:pt idx="1120">
                  <c:v>1.432834E-3</c:v>
                </c:pt>
                <c:pt idx="1121">
                  <c:v>2.8825650000000001E-3</c:v>
                </c:pt>
                <c:pt idx="1122">
                  <c:v>2.7244439999999999E-3</c:v>
                </c:pt>
                <c:pt idx="1123">
                  <c:v>3.3074480000000002E-3</c:v>
                </c:pt>
                <c:pt idx="1124">
                  <c:v>2.0966259999999999E-3</c:v>
                </c:pt>
                <c:pt idx="1125">
                  <c:v>5.9493800000000004E-4</c:v>
                </c:pt>
                <c:pt idx="1126">
                  <c:v>7.6677899999999998E-4</c:v>
                </c:pt>
                <c:pt idx="1127">
                  <c:v>5.1182240000000002E-3</c:v>
                </c:pt>
                <c:pt idx="1128">
                  <c:v>1.757684E-3</c:v>
                </c:pt>
                <c:pt idx="1129">
                  <c:v>1.232059E-3</c:v>
                </c:pt>
                <c:pt idx="1130">
                  <c:v>4.2286440000000002E-3</c:v>
                </c:pt>
                <c:pt idx="1131">
                  <c:v>3.5050139999999999E-3</c:v>
                </c:pt>
                <c:pt idx="1132">
                  <c:v>7.1226000000000004E-4</c:v>
                </c:pt>
                <c:pt idx="1133">
                  <c:v>2.868116E-3</c:v>
                </c:pt>
                <c:pt idx="1134">
                  <c:v>5.8556220000000004E-3</c:v>
                </c:pt>
                <c:pt idx="1135">
                  <c:v>6.75996E-4</c:v>
                </c:pt>
                <c:pt idx="1136">
                  <c:v>1.052327E-3</c:v>
                </c:pt>
                <c:pt idx="1137">
                  <c:v>1.4078579999999999E-3</c:v>
                </c:pt>
                <c:pt idx="1138">
                  <c:v>2.636387E-3</c:v>
                </c:pt>
                <c:pt idx="1139">
                  <c:v>5.5029279999999998E-3</c:v>
                </c:pt>
                <c:pt idx="1140">
                  <c:v>5.0514899999999998E-4</c:v>
                </c:pt>
                <c:pt idx="1141">
                  <c:v>2.8006810000000002E-3</c:v>
                </c:pt>
                <c:pt idx="1142">
                  <c:v>1.248292E-3</c:v>
                </c:pt>
                <c:pt idx="1143">
                  <c:v>5.5607599999999997E-3</c:v>
                </c:pt>
                <c:pt idx="1144">
                  <c:v>3.38748E-3</c:v>
                </c:pt>
                <c:pt idx="1145">
                  <c:v>2.4657659999999999E-3</c:v>
                </c:pt>
                <c:pt idx="1146">
                  <c:v>4.4572530000000004E-3</c:v>
                </c:pt>
                <c:pt idx="1147">
                  <c:v>3.5682259999999999E-3</c:v>
                </c:pt>
                <c:pt idx="1148">
                  <c:v>2.0939159999999999E-3</c:v>
                </c:pt>
                <c:pt idx="1149">
                  <c:v>2.0067470000000001E-3</c:v>
                </c:pt>
                <c:pt idx="1150">
                  <c:v>2.459073E-3</c:v>
                </c:pt>
                <c:pt idx="1151">
                  <c:v>4.529356E-3</c:v>
                </c:pt>
                <c:pt idx="1152">
                  <c:v>7.2001670000000004E-3</c:v>
                </c:pt>
                <c:pt idx="1153">
                  <c:v>4.7507119999999998E-3</c:v>
                </c:pt>
                <c:pt idx="1154">
                  <c:v>1.518372E-3</c:v>
                </c:pt>
                <c:pt idx="1155">
                  <c:v>2.2569140000000001E-3</c:v>
                </c:pt>
                <c:pt idx="1156">
                  <c:v>1.0940990000000001E-3</c:v>
                </c:pt>
                <c:pt idx="1157">
                  <c:v>1.9251959999999999E-3</c:v>
                </c:pt>
                <c:pt idx="1158">
                  <c:v>1.4242899999999999E-3</c:v>
                </c:pt>
                <c:pt idx="1159">
                  <c:v>3.143571E-3</c:v>
                </c:pt>
                <c:pt idx="1160">
                  <c:v>1.4818710000000001E-3</c:v>
                </c:pt>
                <c:pt idx="1161">
                  <c:v>1.7762209999999999E-3</c:v>
                </c:pt>
                <c:pt idx="1162">
                  <c:v>2.4494719999999998E-3</c:v>
                </c:pt>
                <c:pt idx="1163">
                  <c:v>1.288949E-3</c:v>
                </c:pt>
                <c:pt idx="1164">
                  <c:v>2.8811420000000002E-3</c:v>
                </c:pt>
                <c:pt idx="1165">
                  <c:v>2.9558399999999999E-3</c:v>
                </c:pt>
                <c:pt idx="1166">
                  <c:v>7.9335859999999994E-3</c:v>
                </c:pt>
                <c:pt idx="1167">
                  <c:v>2.5240340000000001E-3</c:v>
                </c:pt>
                <c:pt idx="1168">
                  <c:v>1.2943379999999999E-3</c:v>
                </c:pt>
                <c:pt idx="1169">
                  <c:v>3.4491460000000002E-3</c:v>
                </c:pt>
                <c:pt idx="1170">
                  <c:v>1.077155E-3</c:v>
                </c:pt>
                <c:pt idx="1171">
                  <c:v>3.622788E-3</c:v>
                </c:pt>
                <c:pt idx="1172">
                  <c:v>1.651446E-3</c:v>
                </c:pt>
                <c:pt idx="1173">
                  <c:v>4.5893790000000002E-3</c:v>
                </c:pt>
                <c:pt idx="1174">
                  <c:v>4.7631189999999997E-3</c:v>
                </c:pt>
                <c:pt idx="1175">
                  <c:v>9.3165499999999998E-3</c:v>
                </c:pt>
                <c:pt idx="1176">
                  <c:v>8.8164690000000004E-3</c:v>
                </c:pt>
                <c:pt idx="1177">
                  <c:v>4.1183299999999999E-3</c:v>
                </c:pt>
                <c:pt idx="1178">
                  <c:v>2.2354739999999999E-3</c:v>
                </c:pt>
                <c:pt idx="1179">
                  <c:v>2.6661649999999999E-3</c:v>
                </c:pt>
                <c:pt idx="1180">
                  <c:v>4.5059039999999998E-3</c:v>
                </c:pt>
                <c:pt idx="1181">
                  <c:v>4.5360970000000002E-3</c:v>
                </c:pt>
                <c:pt idx="1182">
                  <c:v>3.3028409999999999E-3</c:v>
                </c:pt>
                <c:pt idx="1183">
                  <c:v>9.1842499999999995E-4</c:v>
                </c:pt>
                <c:pt idx="1184">
                  <c:v>2.9080870000000002E-3</c:v>
                </c:pt>
                <c:pt idx="1185">
                  <c:v>2.4547319999999998E-3</c:v>
                </c:pt>
                <c:pt idx="1186">
                  <c:v>1.0168009999999999E-3</c:v>
                </c:pt>
                <c:pt idx="1187">
                  <c:v>3.2663639999999999E-3</c:v>
                </c:pt>
                <c:pt idx="1188">
                  <c:v>1.8996659999999999E-3</c:v>
                </c:pt>
                <c:pt idx="1189">
                  <c:v>1.378544E-3</c:v>
                </c:pt>
                <c:pt idx="1190">
                  <c:v>2.5145419999999998E-3</c:v>
                </c:pt>
                <c:pt idx="1191">
                  <c:v>2.246863E-3</c:v>
                </c:pt>
                <c:pt idx="1192">
                  <c:v>4.1369559999999998E-3</c:v>
                </c:pt>
                <c:pt idx="1193">
                  <c:v>2.256058E-3</c:v>
                </c:pt>
                <c:pt idx="1194">
                  <c:v>3.2353529999999998E-3</c:v>
                </c:pt>
                <c:pt idx="1195">
                  <c:v>9.7677599999999995E-4</c:v>
                </c:pt>
                <c:pt idx="1196">
                  <c:v>8.6359800000000003E-4</c:v>
                </c:pt>
                <c:pt idx="1197">
                  <c:v>1.834027E-3</c:v>
                </c:pt>
                <c:pt idx="1198">
                  <c:v>5.6459630000000004E-3</c:v>
                </c:pt>
                <c:pt idx="1199">
                  <c:v>8.8689400000000005E-4</c:v>
                </c:pt>
                <c:pt idx="1200">
                  <c:v>5.5085389999999998E-3</c:v>
                </c:pt>
                <c:pt idx="1201">
                  <c:v>2.2015699999999999E-3</c:v>
                </c:pt>
                <c:pt idx="1202">
                  <c:v>2.2993940000000002E-3</c:v>
                </c:pt>
                <c:pt idx="1203">
                  <c:v>4.7622139999999999E-3</c:v>
                </c:pt>
                <c:pt idx="1204">
                  <c:v>3.0544579999999999E-3</c:v>
                </c:pt>
                <c:pt idx="1205">
                  <c:v>2.2870859999999998E-3</c:v>
                </c:pt>
                <c:pt idx="1206">
                  <c:v>2.1973919999999998E-3</c:v>
                </c:pt>
                <c:pt idx="1207">
                  <c:v>6.2408699999999995E-4</c:v>
                </c:pt>
                <c:pt idx="1208">
                  <c:v>1.8939720000000001E-3</c:v>
                </c:pt>
                <c:pt idx="1209">
                  <c:v>2.5396580000000002E-3</c:v>
                </c:pt>
                <c:pt idx="1210">
                  <c:v>3.0410739999999999E-3</c:v>
                </c:pt>
                <c:pt idx="1211">
                  <c:v>1.900316E-3</c:v>
                </c:pt>
                <c:pt idx="1212">
                  <c:v>2.099002E-3</c:v>
                </c:pt>
                <c:pt idx="1213">
                  <c:v>2.8472049999999998E-3</c:v>
                </c:pt>
                <c:pt idx="1214">
                  <c:v>2.1424399999999998E-3</c:v>
                </c:pt>
                <c:pt idx="1215">
                  <c:v>7.3681099999999998E-4</c:v>
                </c:pt>
                <c:pt idx="1216">
                  <c:v>6.7042999999999996E-4</c:v>
                </c:pt>
                <c:pt idx="1217">
                  <c:v>1.795837E-3</c:v>
                </c:pt>
                <c:pt idx="1218">
                  <c:v>1.4782059999999999E-3</c:v>
                </c:pt>
                <c:pt idx="1219">
                  <c:v>2.799667E-3</c:v>
                </c:pt>
                <c:pt idx="1220">
                  <c:v>4.0595400000000004E-3</c:v>
                </c:pt>
                <c:pt idx="1221">
                  <c:v>2.0934619999999999E-3</c:v>
                </c:pt>
                <c:pt idx="1222">
                  <c:v>1.6118549999999999E-3</c:v>
                </c:pt>
                <c:pt idx="1223">
                  <c:v>4.8690010000000004E-3</c:v>
                </c:pt>
                <c:pt idx="1224">
                  <c:v>3.4943259999999999E-3</c:v>
                </c:pt>
                <c:pt idx="1225">
                  <c:v>3.1424500000000002E-3</c:v>
                </c:pt>
                <c:pt idx="1226">
                  <c:v>2.9946389999999999E-3</c:v>
                </c:pt>
                <c:pt idx="1227">
                  <c:v>2.5708010000000002E-3</c:v>
                </c:pt>
                <c:pt idx="1228">
                  <c:v>2.4166909999999999E-3</c:v>
                </c:pt>
                <c:pt idx="1229">
                  <c:v>2.125058E-3</c:v>
                </c:pt>
                <c:pt idx="1230">
                  <c:v>2.9868690000000001E-3</c:v>
                </c:pt>
                <c:pt idx="1231">
                  <c:v>8.8411429999999992E-3</c:v>
                </c:pt>
                <c:pt idx="1232">
                  <c:v>4.4810010000000001E-3</c:v>
                </c:pt>
                <c:pt idx="1233">
                  <c:v>1.058388E-3</c:v>
                </c:pt>
                <c:pt idx="1234">
                  <c:v>1.5616989999999999E-3</c:v>
                </c:pt>
                <c:pt idx="1235">
                  <c:v>1.9255959999999999E-3</c:v>
                </c:pt>
                <c:pt idx="1236">
                  <c:v>3.8393870000000001E-3</c:v>
                </c:pt>
                <c:pt idx="1237">
                  <c:v>4.7395989999999997E-3</c:v>
                </c:pt>
                <c:pt idx="1238">
                  <c:v>1.7161819999999999E-3</c:v>
                </c:pt>
                <c:pt idx="1239">
                  <c:v>8.7619599999999998E-4</c:v>
                </c:pt>
                <c:pt idx="1240">
                  <c:v>3.2899919999999998E-3</c:v>
                </c:pt>
                <c:pt idx="1241">
                  <c:v>4.02178E-3</c:v>
                </c:pt>
                <c:pt idx="1242">
                  <c:v>1.4016810000000001E-3</c:v>
                </c:pt>
                <c:pt idx="1243">
                  <c:v>9.2891200000000005E-4</c:v>
                </c:pt>
                <c:pt idx="1244">
                  <c:v>4.3143139999999996E-3</c:v>
                </c:pt>
                <c:pt idx="1245">
                  <c:v>3.105277E-3</c:v>
                </c:pt>
                <c:pt idx="1246">
                  <c:v>1.0434890000000001E-3</c:v>
                </c:pt>
                <c:pt idx="1247">
                  <c:v>2.5627649999999998E-3</c:v>
                </c:pt>
                <c:pt idx="1248">
                  <c:v>9.2675899999999998E-4</c:v>
                </c:pt>
                <c:pt idx="1249">
                  <c:v>2.4619419999999999E-3</c:v>
                </c:pt>
                <c:pt idx="1250">
                  <c:v>4.9781119999999998E-3</c:v>
                </c:pt>
                <c:pt idx="1251">
                  <c:v>5.12577E-3</c:v>
                </c:pt>
                <c:pt idx="1252">
                  <c:v>4.4043349999999997E-3</c:v>
                </c:pt>
                <c:pt idx="1253">
                  <c:v>1.7470910000000001E-3</c:v>
                </c:pt>
                <c:pt idx="1254">
                  <c:v>7.6285299999999997E-4</c:v>
                </c:pt>
                <c:pt idx="1255">
                  <c:v>7.3959539999999997E-3</c:v>
                </c:pt>
                <c:pt idx="1256">
                  <c:v>3.766377E-3</c:v>
                </c:pt>
                <c:pt idx="1257">
                  <c:v>1.2517248999999999E-2</c:v>
                </c:pt>
                <c:pt idx="1258">
                  <c:v>2.92859E-3</c:v>
                </c:pt>
                <c:pt idx="1259">
                  <c:v>2.8891300000000002E-3</c:v>
                </c:pt>
                <c:pt idx="1260">
                  <c:v>4.2760209999999996E-3</c:v>
                </c:pt>
                <c:pt idx="1261">
                  <c:v>7.4893599999999996E-4</c:v>
                </c:pt>
                <c:pt idx="1262">
                  <c:v>2.8763840000000001E-3</c:v>
                </c:pt>
                <c:pt idx="1263">
                  <c:v>2.353548E-3</c:v>
                </c:pt>
                <c:pt idx="1264">
                  <c:v>2.7969729999999999E-3</c:v>
                </c:pt>
                <c:pt idx="1265">
                  <c:v>4.9395139999999999E-3</c:v>
                </c:pt>
                <c:pt idx="1266">
                  <c:v>2.2965720000000002E-3</c:v>
                </c:pt>
                <c:pt idx="1267">
                  <c:v>5.2673069999999997E-3</c:v>
                </c:pt>
                <c:pt idx="1268">
                  <c:v>4.6804940000000003E-3</c:v>
                </c:pt>
                <c:pt idx="1269">
                  <c:v>3.5729970000000001E-3</c:v>
                </c:pt>
                <c:pt idx="1270">
                  <c:v>2.888308E-3</c:v>
                </c:pt>
                <c:pt idx="1271">
                  <c:v>9.7181700000000004E-4</c:v>
                </c:pt>
                <c:pt idx="1272">
                  <c:v>4.1680090000000003E-3</c:v>
                </c:pt>
                <c:pt idx="1273">
                  <c:v>8.65868E-4</c:v>
                </c:pt>
                <c:pt idx="1274">
                  <c:v>1.5686610000000001E-3</c:v>
                </c:pt>
                <c:pt idx="1275">
                  <c:v>5.1710500000000002E-4</c:v>
                </c:pt>
                <c:pt idx="1276">
                  <c:v>2.8709460000000001E-3</c:v>
                </c:pt>
                <c:pt idx="1277">
                  <c:v>2.5359079999999999E-3</c:v>
                </c:pt>
                <c:pt idx="1278">
                  <c:v>3.2981059999999999E-3</c:v>
                </c:pt>
                <c:pt idx="1279">
                  <c:v>5.5472300000000002E-3</c:v>
                </c:pt>
                <c:pt idx="1280">
                  <c:v>2.729876E-3</c:v>
                </c:pt>
                <c:pt idx="1281">
                  <c:v>2.0154349999999999E-3</c:v>
                </c:pt>
                <c:pt idx="1282">
                  <c:v>4.407953E-3</c:v>
                </c:pt>
                <c:pt idx="1283">
                  <c:v>1.708123E-3</c:v>
                </c:pt>
                <c:pt idx="1284">
                  <c:v>2.3957560000000002E-3</c:v>
                </c:pt>
                <c:pt idx="1285">
                  <c:v>2.6228696999999999E-2</c:v>
                </c:pt>
                <c:pt idx="1286">
                  <c:v>6.831897E-3</c:v>
                </c:pt>
                <c:pt idx="1287">
                  <c:v>5.949083E-3</c:v>
                </c:pt>
                <c:pt idx="1288">
                  <c:v>4.4631530000000001E-3</c:v>
                </c:pt>
                <c:pt idx="1289">
                  <c:v>4.4890396999999999E-2</c:v>
                </c:pt>
                <c:pt idx="1290">
                  <c:v>2.4962270000000002E-3</c:v>
                </c:pt>
                <c:pt idx="1291">
                  <c:v>7.7927780000000002E-3</c:v>
                </c:pt>
                <c:pt idx="1292">
                  <c:v>1.7109600000000001E-3</c:v>
                </c:pt>
                <c:pt idx="1293">
                  <c:v>3.2381150000000002E-3</c:v>
                </c:pt>
                <c:pt idx="1294">
                  <c:v>3.9412509999999998E-3</c:v>
                </c:pt>
                <c:pt idx="1295">
                  <c:v>3.0602580000000002E-3</c:v>
                </c:pt>
                <c:pt idx="1296">
                  <c:v>9.7006900000000005E-4</c:v>
                </c:pt>
                <c:pt idx="1297">
                  <c:v>6.4471179999999999E-3</c:v>
                </c:pt>
                <c:pt idx="1298">
                  <c:v>8.7320169999999999E-3</c:v>
                </c:pt>
                <c:pt idx="1299">
                  <c:v>1.424757E-3</c:v>
                </c:pt>
                <c:pt idx="1300">
                  <c:v>1.795165E-3</c:v>
                </c:pt>
                <c:pt idx="1301">
                  <c:v>2.3559129999999998E-3</c:v>
                </c:pt>
                <c:pt idx="1302">
                  <c:v>6.1888840000000004E-3</c:v>
                </c:pt>
                <c:pt idx="1303">
                  <c:v>6.9457379999999999E-3</c:v>
                </c:pt>
                <c:pt idx="1304">
                  <c:v>4.2957469999999999E-3</c:v>
                </c:pt>
                <c:pt idx="1305">
                  <c:v>4.057583E-3</c:v>
                </c:pt>
                <c:pt idx="1306">
                  <c:v>1.919652E-3</c:v>
                </c:pt>
                <c:pt idx="1307">
                  <c:v>4.1640410000000003E-3</c:v>
                </c:pt>
                <c:pt idx="1308">
                  <c:v>8.3244799999999996E-4</c:v>
                </c:pt>
                <c:pt idx="1309">
                  <c:v>2.9705439999999999E-3</c:v>
                </c:pt>
                <c:pt idx="1310">
                  <c:v>3.9537160000000003E-3</c:v>
                </c:pt>
                <c:pt idx="1311">
                  <c:v>2.6140299999999998E-3</c:v>
                </c:pt>
                <c:pt idx="1312">
                  <c:v>3.735253E-3</c:v>
                </c:pt>
                <c:pt idx="1313">
                  <c:v>1.99651E-3</c:v>
                </c:pt>
                <c:pt idx="1314">
                  <c:v>2.6235350000000002E-3</c:v>
                </c:pt>
                <c:pt idx="1315">
                  <c:v>7.5239929999999997E-3</c:v>
                </c:pt>
                <c:pt idx="1316">
                  <c:v>3.4027879999999999E-3</c:v>
                </c:pt>
                <c:pt idx="1317">
                  <c:v>1.1220760000000001E-3</c:v>
                </c:pt>
                <c:pt idx="1318">
                  <c:v>2.1138229999999999E-3</c:v>
                </c:pt>
                <c:pt idx="1319">
                  <c:v>5.8365759999999996E-3</c:v>
                </c:pt>
                <c:pt idx="1320">
                  <c:v>2.127678E-3</c:v>
                </c:pt>
                <c:pt idx="1321">
                  <c:v>3.8961550000000001E-3</c:v>
                </c:pt>
                <c:pt idx="1322">
                  <c:v>1.5038902999999999E-2</c:v>
                </c:pt>
                <c:pt idx="1323">
                  <c:v>3.0475200000000002E-3</c:v>
                </c:pt>
                <c:pt idx="1324">
                  <c:v>6.9835349999999999E-3</c:v>
                </c:pt>
                <c:pt idx="1325">
                  <c:v>3.6728440000000002E-3</c:v>
                </c:pt>
                <c:pt idx="1326">
                  <c:v>3.121932E-3</c:v>
                </c:pt>
                <c:pt idx="1327">
                  <c:v>2.7765770000000001E-3</c:v>
                </c:pt>
                <c:pt idx="1328">
                  <c:v>2.4354540000000001E-3</c:v>
                </c:pt>
                <c:pt idx="1329">
                  <c:v>2.9934129999999999E-3</c:v>
                </c:pt>
                <c:pt idx="1330">
                  <c:v>5.7746999999999996E-4</c:v>
                </c:pt>
                <c:pt idx="1331">
                  <c:v>7.6688099999999996E-4</c:v>
                </c:pt>
                <c:pt idx="1332">
                  <c:v>1.6141689999999999E-3</c:v>
                </c:pt>
                <c:pt idx="1333">
                  <c:v>3.3772580000000002E-3</c:v>
                </c:pt>
                <c:pt idx="1334">
                  <c:v>1.217866E-3</c:v>
                </c:pt>
                <c:pt idx="1335">
                  <c:v>1.44826E-3</c:v>
                </c:pt>
                <c:pt idx="1336">
                  <c:v>1.0158809999999999E-3</c:v>
                </c:pt>
                <c:pt idx="1337">
                  <c:v>2.7856930000000001E-3</c:v>
                </c:pt>
                <c:pt idx="1338">
                  <c:v>1.8422169999999999E-3</c:v>
                </c:pt>
                <c:pt idx="1339">
                  <c:v>2.6311899999999998E-3</c:v>
                </c:pt>
                <c:pt idx="1340">
                  <c:v>4.6103749999999999E-3</c:v>
                </c:pt>
                <c:pt idx="1341">
                  <c:v>5.110837E-3</c:v>
                </c:pt>
                <c:pt idx="1342">
                  <c:v>5.3580709999999998E-3</c:v>
                </c:pt>
                <c:pt idx="1343">
                  <c:v>8.303665E-3</c:v>
                </c:pt>
                <c:pt idx="1344">
                  <c:v>2.8496229999999999E-3</c:v>
                </c:pt>
                <c:pt idx="1345">
                  <c:v>3.0151510000000002E-3</c:v>
                </c:pt>
                <c:pt idx="1346">
                  <c:v>3.9037360000000001E-3</c:v>
                </c:pt>
                <c:pt idx="1347">
                  <c:v>2.177277E-3</c:v>
                </c:pt>
                <c:pt idx="1348">
                  <c:v>2.834296E-3</c:v>
                </c:pt>
                <c:pt idx="1349">
                  <c:v>1.0385839999999999E-3</c:v>
                </c:pt>
                <c:pt idx="1350">
                  <c:v>3.7378839999999999E-3</c:v>
                </c:pt>
                <c:pt idx="1351">
                  <c:v>1.9983259999999999E-3</c:v>
                </c:pt>
                <c:pt idx="1352">
                  <c:v>2.6576809999999998E-3</c:v>
                </c:pt>
                <c:pt idx="1353">
                  <c:v>4.5183339999999997E-3</c:v>
                </c:pt>
                <c:pt idx="1354">
                  <c:v>1.7088610000000001E-3</c:v>
                </c:pt>
                <c:pt idx="1355">
                  <c:v>3.3817740000000002E-3</c:v>
                </c:pt>
                <c:pt idx="1356">
                  <c:v>4.6177739999999998E-3</c:v>
                </c:pt>
                <c:pt idx="1357">
                  <c:v>2.261449E-3</c:v>
                </c:pt>
                <c:pt idx="1358">
                  <c:v>2.3219680000000002E-3</c:v>
                </c:pt>
                <c:pt idx="1359">
                  <c:v>3.747345E-3</c:v>
                </c:pt>
                <c:pt idx="1360">
                  <c:v>1.6442799999999999E-3</c:v>
                </c:pt>
                <c:pt idx="1361">
                  <c:v>2.1426399999999999E-3</c:v>
                </c:pt>
                <c:pt idx="1362">
                  <c:v>3.0787869999999999E-3</c:v>
                </c:pt>
                <c:pt idx="1363">
                  <c:v>2.6192920000000001E-3</c:v>
                </c:pt>
                <c:pt idx="1364">
                  <c:v>2.9384379999999998E-3</c:v>
                </c:pt>
                <c:pt idx="1365">
                  <c:v>1.3129870000000001E-3</c:v>
                </c:pt>
                <c:pt idx="1366">
                  <c:v>1.5030060000000001E-3</c:v>
                </c:pt>
                <c:pt idx="1367">
                  <c:v>5.2074759999999999E-3</c:v>
                </c:pt>
                <c:pt idx="1368">
                  <c:v>2.9431499999999998E-3</c:v>
                </c:pt>
                <c:pt idx="1369">
                  <c:v>5.8427260000000003E-3</c:v>
                </c:pt>
                <c:pt idx="1370">
                  <c:v>2.4013139999999999E-3</c:v>
                </c:pt>
                <c:pt idx="1371">
                  <c:v>8.9317699999999999E-4</c:v>
                </c:pt>
                <c:pt idx="1372">
                  <c:v>3.5924350000000002E-3</c:v>
                </c:pt>
                <c:pt idx="1373">
                  <c:v>1.591461E-3</c:v>
                </c:pt>
                <c:pt idx="1374">
                  <c:v>1.6246170000000001E-3</c:v>
                </c:pt>
                <c:pt idx="1375">
                  <c:v>1.863263E-3</c:v>
                </c:pt>
                <c:pt idx="1376">
                  <c:v>1.9867510000000001E-3</c:v>
                </c:pt>
                <c:pt idx="1377">
                  <c:v>2.6349659999999999E-3</c:v>
                </c:pt>
                <c:pt idx="1378">
                  <c:v>1.720271E-3</c:v>
                </c:pt>
                <c:pt idx="1379">
                  <c:v>7.5769069999999999E-3</c:v>
                </c:pt>
                <c:pt idx="1380">
                  <c:v>1.6354667999999999E-2</c:v>
                </c:pt>
                <c:pt idx="1381">
                  <c:v>3.069699E-3</c:v>
                </c:pt>
                <c:pt idx="1382">
                  <c:v>7.4522360000000001E-3</c:v>
                </c:pt>
                <c:pt idx="1383">
                  <c:v>1.9555670000000001E-3</c:v>
                </c:pt>
                <c:pt idx="1384">
                  <c:v>5.446055E-3</c:v>
                </c:pt>
                <c:pt idx="1385">
                  <c:v>1.5174507E-2</c:v>
                </c:pt>
                <c:pt idx="1386">
                  <c:v>1.9479779999999999E-3</c:v>
                </c:pt>
                <c:pt idx="1387">
                  <c:v>3.3300410000000002E-3</c:v>
                </c:pt>
                <c:pt idx="1388">
                  <c:v>2.3062320000000001E-3</c:v>
                </c:pt>
                <c:pt idx="1389">
                  <c:v>2.4472299999999999E-3</c:v>
                </c:pt>
                <c:pt idx="1390">
                  <c:v>3.075599E-3</c:v>
                </c:pt>
                <c:pt idx="1391">
                  <c:v>3.0614779999999999E-3</c:v>
                </c:pt>
                <c:pt idx="1392">
                  <c:v>3.1952299999999999E-3</c:v>
                </c:pt>
                <c:pt idx="1393">
                  <c:v>4.1588689999999999E-3</c:v>
                </c:pt>
                <c:pt idx="1394">
                  <c:v>9.67373E-4</c:v>
                </c:pt>
                <c:pt idx="1395">
                  <c:v>5.3778660000000002E-3</c:v>
                </c:pt>
                <c:pt idx="1396">
                  <c:v>7.0404810000000003E-3</c:v>
                </c:pt>
                <c:pt idx="1397">
                  <c:v>2.4345489999999998E-3</c:v>
                </c:pt>
                <c:pt idx="1398">
                  <c:v>2.9455079999999999E-3</c:v>
                </c:pt>
                <c:pt idx="1399">
                  <c:v>2.1072970000000002E-3</c:v>
                </c:pt>
                <c:pt idx="1400">
                  <c:v>2.2307360000000001E-3</c:v>
                </c:pt>
                <c:pt idx="1401">
                  <c:v>2.3548449999999999E-3</c:v>
                </c:pt>
                <c:pt idx="1402">
                  <c:v>2.9392929999999999E-3</c:v>
                </c:pt>
                <c:pt idx="1403">
                  <c:v>3.646182E-3</c:v>
                </c:pt>
                <c:pt idx="1404">
                  <c:v>3.2997009999999999E-3</c:v>
                </c:pt>
                <c:pt idx="1405">
                  <c:v>1.4725560000000001E-3</c:v>
                </c:pt>
                <c:pt idx="1406">
                  <c:v>3.8430640000000002E-3</c:v>
                </c:pt>
                <c:pt idx="1407">
                  <c:v>1.0462869999999999E-3</c:v>
                </c:pt>
                <c:pt idx="1408">
                  <c:v>2.2223910000000002E-3</c:v>
                </c:pt>
                <c:pt idx="1409">
                  <c:v>1.7340509999999999E-3</c:v>
                </c:pt>
                <c:pt idx="1410">
                  <c:v>3.7336460000000002E-3</c:v>
                </c:pt>
                <c:pt idx="1411">
                  <c:v>3.7312579999999999E-3</c:v>
                </c:pt>
                <c:pt idx="1412">
                  <c:v>2.9235950000000002E-3</c:v>
                </c:pt>
                <c:pt idx="1413">
                  <c:v>4.6163030000000004E-3</c:v>
                </c:pt>
                <c:pt idx="1414">
                  <c:v>2.2165930000000002E-3</c:v>
                </c:pt>
                <c:pt idx="1415">
                  <c:v>4.8111999999999997E-4</c:v>
                </c:pt>
                <c:pt idx="1416">
                  <c:v>2.9864919999999999E-3</c:v>
                </c:pt>
                <c:pt idx="1417">
                  <c:v>1.1371459999999999E-3</c:v>
                </c:pt>
                <c:pt idx="1418">
                  <c:v>3.1297809999999999E-3</c:v>
                </c:pt>
                <c:pt idx="1419">
                  <c:v>2.2965669999999998E-3</c:v>
                </c:pt>
                <c:pt idx="1420">
                  <c:v>3.6945609999999999E-3</c:v>
                </c:pt>
                <c:pt idx="1421">
                  <c:v>3.3444270000000001E-3</c:v>
                </c:pt>
                <c:pt idx="1422">
                  <c:v>6.3494099999999998E-4</c:v>
                </c:pt>
                <c:pt idx="1423">
                  <c:v>2.6193850000000001E-3</c:v>
                </c:pt>
                <c:pt idx="1424">
                  <c:v>6.6442400000000005E-4</c:v>
                </c:pt>
                <c:pt idx="1425">
                  <c:v>1.893336E-3</c:v>
                </c:pt>
                <c:pt idx="1426">
                  <c:v>2.178312E-3</c:v>
                </c:pt>
                <c:pt idx="1427">
                  <c:v>1.8253729999999999E-3</c:v>
                </c:pt>
                <c:pt idx="1428">
                  <c:v>1.0781950000000001E-3</c:v>
                </c:pt>
                <c:pt idx="1429">
                  <c:v>8.2830000000000002E-4</c:v>
                </c:pt>
                <c:pt idx="1430">
                  <c:v>3.2845019999999999E-3</c:v>
                </c:pt>
                <c:pt idx="1431">
                  <c:v>2.8941209999999999E-3</c:v>
                </c:pt>
                <c:pt idx="1432">
                  <c:v>3.5324760000000001E-3</c:v>
                </c:pt>
                <c:pt idx="1433">
                  <c:v>4.1685300000000002E-3</c:v>
                </c:pt>
                <c:pt idx="1434">
                  <c:v>3.02528E-3</c:v>
                </c:pt>
                <c:pt idx="1435">
                  <c:v>2.895477E-3</c:v>
                </c:pt>
                <c:pt idx="1436">
                  <c:v>5.9610729999999999E-3</c:v>
                </c:pt>
                <c:pt idx="1437">
                  <c:v>2.23997E-3</c:v>
                </c:pt>
                <c:pt idx="1438">
                  <c:v>1.0188512E-2</c:v>
                </c:pt>
                <c:pt idx="1439">
                  <c:v>3.5867730000000001E-3</c:v>
                </c:pt>
                <c:pt idx="1440">
                  <c:v>8.8794700000000004E-4</c:v>
                </c:pt>
                <c:pt idx="1441">
                  <c:v>2.2656659999999999E-3</c:v>
                </c:pt>
                <c:pt idx="1442">
                  <c:v>1.148891E-3</c:v>
                </c:pt>
                <c:pt idx="1443">
                  <c:v>1.015106E-3</c:v>
                </c:pt>
                <c:pt idx="1444">
                  <c:v>2.6238139999999999E-3</c:v>
                </c:pt>
                <c:pt idx="1445">
                  <c:v>2.4446649999999999E-3</c:v>
                </c:pt>
                <c:pt idx="1446">
                  <c:v>2.244078E-3</c:v>
                </c:pt>
                <c:pt idx="1447">
                  <c:v>6.2631799999999995E-4</c:v>
                </c:pt>
                <c:pt idx="1448">
                  <c:v>2.4629880000000002E-3</c:v>
                </c:pt>
                <c:pt idx="1449">
                  <c:v>1.0764185000000001E-2</c:v>
                </c:pt>
                <c:pt idx="1450">
                  <c:v>4.41927E-4</c:v>
                </c:pt>
                <c:pt idx="1451">
                  <c:v>9.7295609999999994E-3</c:v>
                </c:pt>
                <c:pt idx="1452">
                  <c:v>6.9690639999999996E-3</c:v>
                </c:pt>
                <c:pt idx="1453">
                  <c:v>3.0567229999999999E-3</c:v>
                </c:pt>
                <c:pt idx="1454">
                  <c:v>7.2191599999999996E-4</c:v>
                </c:pt>
                <c:pt idx="1455">
                  <c:v>2.167586E-3</c:v>
                </c:pt>
                <c:pt idx="1456">
                  <c:v>4.2057529999999996E-3</c:v>
                </c:pt>
                <c:pt idx="1457">
                  <c:v>5.3179229999999996E-3</c:v>
                </c:pt>
                <c:pt idx="1458">
                  <c:v>2.4178540000000001E-3</c:v>
                </c:pt>
                <c:pt idx="1459">
                  <c:v>3.5747980000000001E-3</c:v>
                </c:pt>
                <c:pt idx="1460">
                  <c:v>2.481498E-3</c:v>
                </c:pt>
                <c:pt idx="1461">
                  <c:v>2.1838080000000002E-3</c:v>
                </c:pt>
                <c:pt idx="1462">
                  <c:v>7.0074229999999996E-3</c:v>
                </c:pt>
                <c:pt idx="1463">
                  <c:v>1.3177239999999999E-3</c:v>
                </c:pt>
                <c:pt idx="1464">
                  <c:v>1.199107E-3</c:v>
                </c:pt>
                <c:pt idx="1465">
                  <c:v>4.330268E-3</c:v>
                </c:pt>
                <c:pt idx="1466">
                  <c:v>9.3831600000000002E-4</c:v>
                </c:pt>
                <c:pt idx="1467">
                  <c:v>2.2995569999999998E-3</c:v>
                </c:pt>
                <c:pt idx="1468">
                  <c:v>5.0402909999999997E-3</c:v>
                </c:pt>
                <c:pt idx="1469">
                  <c:v>6.2677299999999996E-4</c:v>
                </c:pt>
                <c:pt idx="1470">
                  <c:v>7.5674900000000003E-4</c:v>
                </c:pt>
                <c:pt idx="1471">
                  <c:v>6.4117700000000004E-4</c:v>
                </c:pt>
                <c:pt idx="1472">
                  <c:v>2.4737790000000002E-3</c:v>
                </c:pt>
                <c:pt idx="1473">
                  <c:v>1.028419E-3</c:v>
                </c:pt>
                <c:pt idx="1474">
                  <c:v>9.983329999999999E-4</c:v>
                </c:pt>
                <c:pt idx="1475">
                  <c:v>1.9041240000000001E-3</c:v>
                </c:pt>
                <c:pt idx="1476">
                  <c:v>6.3491000000000003E-4</c:v>
                </c:pt>
                <c:pt idx="1477">
                  <c:v>1.3300510000000001E-3</c:v>
                </c:pt>
                <c:pt idx="1478">
                  <c:v>1.9916700000000001E-3</c:v>
                </c:pt>
                <c:pt idx="1479">
                  <c:v>5.7019569999999997E-3</c:v>
                </c:pt>
                <c:pt idx="1480">
                  <c:v>6.8442199999999996E-4</c:v>
                </c:pt>
                <c:pt idx="1481">
                  <c:v>3.8128810000000002E-3</c:v>
                </c:pt>
                <c:pt idx="1482">
                  <c:v>7.1938790000000002E-3</c:v>
                </c:pt>
                <c:pt idx="1483">
                  <c:v>6.9492240000000004E-3</c:v>
                </c:pt>
                <c:pt idx="1484">
                  <c:v>2.4795920000000001E-3</c:v>
                </c:pt>
                <c:pt idx="1485">
                  <c:v>2.0878260000000001E-3</c:v>
                </c:pt>
                <c:pt idx="1486">
                  <c:v>2.8837210000000001E-3</c:v>
                </c:pt>
                <c:pt idx="1487">
                  <c:v>8.5756489999999994E-3</c:v>
                </c:pt>
                <c:pt idx="1488">
                  <c:v>5.1521100000000001E-4</c:v>
                </c:pt>
                <c:pt idx="1489">
                  <c:v>1.06872E-3</c:v>
                </c:pt>
                <c:pt idx="1490">
                  <c:v>3.4979880000000001E-3</c:v>
                </c:pt>
                <c:pt idx="1491">
                  <c:v>1.1830949999999999E-3</c:v>
                </c:pt>
                <c:pt idx="1492">
                  <c:v>1.7099979999999999E-3</c:v>
                </c:pt>
                <c:pt idx="1493">
                  <c:v>5.4444089999999999E-3</c:v>
                </c:pt>
                <c:pt idx="1494">
                  <c:v>1.218635E-3</c:v>
                </c:pt>
                <c:pt idx="1495">
                  <c:v>1.989963E-3</c:v>
                </c:pt>
                <c:pt idx="1496">
                  <c:v>2.968573E-3</c:v>
                </c:pt>
                <c:pt idx="1497">
                  <c:v>3.2500910000000001E-3</c:v>
                </c:pt>
                <c:pt idx="1498">
                  <c:v>1.071289E-3</c:v>
                </c:pt>
                <c:pt idx="1499">
                  <c:v>1.730709E-3</c:v>
                </c:pt>
                <c:pt idx="1500">
                  <c:v>1.197324E-3</c:v>
                </c:pt>
                <c:pt idx="1501">
                  <c:v>2.0169459999999999E-3</c:v>
                </c:pt>
                <c:pt idx="1502">
                  <c:v>4.7777900000000001E-4</c:v>
                </c:pt>
                <c:pt idx="1503">
                  <c:v>5.5040799999999995E-4</c:v>
                </c:pt>
                <c:pt idx="1504">
                  <c:v>9.2039159999999995E-3</c:v>
                </c:pt>
                <c:pt idx="1505">
                  <c:v>3.039964E-3</c:v>
                </c:pt>
                <c:pt idx="1506">
                  <c:v>8.0998670000000002E-3</c:v>
                </c:pt>
                <c:pt idx="1507">
                  <c:v>3.4063309999999999E-3</c:v>
                </c:pt>
                <c:pt idx="1508">
                  <c:v>6.4917299999999996E-4</c:v>
                </c:pt>
                <c:pt idx="1509">
                  <c:v>4.880863E-3</c:v>
                </c:pt>
                <c:pt idx="1510">
                  <c:v>8.5858199999999999E-4</c:v>
                </c:pt>
                <c:pt idx="1511">
                  <c:v>1.2424789E-2</c:v>
                </c:pt>
                <c:pt idx="1512">
                  <c:v>2.8968660000000001E-3</c:v>
                </c:pt>
                <c:pt idx="1513">
                  <c:v>9.4333899999999996E-4</c:v>
                </c:pt>
                <c:pt idx="1514">
                  <c:v>7.6587779999999998E-3</c:v>
                </c:pt>
                <c:pt idx="1515">
                  <c:v>1.6410000000000001E-3</c:v>
                </c:pt>
                <c:pt idx="1516">
                  <c:v>5.8984599999999999E-4</c:v>
                </c:pt>
                <c:pt idx="1517">
                  <c:v>8.1132899999999996E-4</c:v>
                </c:pt>
                <c:pt idx="1518">
                  <c:v>2.2250579999999998E-3</c:v>
                </c:pt>
                <c:pt idx="1519">
                  <c:v>4.0969409999999998E-3</c:v>
                </c:pt>
                <c:pt idx="1520">
                  <c:v>3.0899529999999999E-3</c:v>
                </c:pt>
                <c:pt idx="1521">
                  <c:v>7.4192750000000003E-3</c:v>
                </c:pt>
                <c:pt idx="1522">
                  <c:v>4.074299E-3</c:v>
                </c:pt>
                <c:pt idx="1523">
                  <c:v>6.8137700000000005E-4</c:v>
                </c:pt>
                <c:pt idx="1524">
                  <c:v>9.6615799999999995E-4</c:v>
                </c:pt>
                <c:pt idx="1525">
                  <c:v>6.7386920000000001E-3</c:v>
                </c:pt>
                <c:pt idx="1526">
                  <c:v>1.0696359999999999E-3</c:v>
                </c:pt>
                <c:pt idx="1527">
                  <c:v>1.6699830000000001E-3</c:v>
                </c:pt>
                <c:pt idx="1528">
                  <c:v>8.0097980000000003E-3</c:v>
                </c:pt>
                <c:pt idx="1529">
                  <c:v>4.1754280000000001E-3</c:v>
                </c:pt>
                <c:pt idx="1530">
                  <c:v>1.4933909999999999E-3</c:v>
                </c:pt>
                <c:pt idx="1531">
                  <c:v>7.5949770000000002E-3</c:v>
                </c:pt>
                <c:pt idx="1532">
                  <c:v>2.5238449999999998E-3</c:v>
                </c:pt>
                <c:pt idx="1533">
                  <c:v>1.8311969999999999E-3</c:v>
                </c:pt>
                <c:pt idx="1534">
                  <c:v>3.8349569999999999E-3</c:v>
                </c:pt>
                <c:pt idx="1535">
                  <c:v>1.1712879999999999E-3</c:v>
                </c:pt>
                <c:pt idx="1536">
                  <c:v>5.281623E-3</c:v>
                </c:pt>
                <c:pt idx="1537">
                  <c:v>2.078187E-3</c:v>
                </c:pt>
                <c:pt idx="1538">
                  <c:v>2.3162009999999999E-3</c:v>
                </c:pt>
                <c:pt idx="1539">
                  <c:v>8.6573100000000001E-4</c:v>
                </c:pt>
                <c:pt idx="1540">
                  <c:v>2.6692450000000002E-3</c:v>
                </c:pt>
                <c:pt idx="1541">
                  <c:v>4.3278799999999998E-4</c:v>
                </c:pt>
                <c:pt idx="1542">
                  <c:v>1.1268426E-2</c:v>
                </c:pt>
                <c:pt idx="1543">
                  <c:v>1.873874E-3</c:v>
                </c:pt>
                <c:pt idx="1544">
                  <c:v>3.6237209999999999E-3</c:v>
                </c:pt>
                <c:pt idx="1545">
                  <c:v>8.9964169999999996E-3</c:v>
                </c:pt>
                <c:pt idx="1546">
                  <c:v>2.6963780000000001E-3</c:v>
                </c:pt>
                <c:pt idx="1547">
                  <c:v>5.3518200000000004E-4</c:v>
                </c:pt>
                <c:pt idx="1548">
                  <c:v>5.2226099999999999E-4</c:v>
                </c:pt>
                <c:pt idx="1549">
                  <c:v>5.4333099999999998E-4</c:v>
                </c:pt>
                <c:pt idx="1550">
                  <c:v>6.7110200000000003E-4</c:v>
                </c:pt>
                <c:pt idx="1551">
                  <c:v>1.4506129999999999E-3</c:v>
                </c:pt>
                <c:pt idx="1552">
                  <c:v>2.115399E-3</c:v>
                </c:pt>
                <c:pt idx="1553">
                  <c:v>3.1772699999999998E-3</c:v>
                </c:pt>
                <c:pt idx="1554">
                  <c:v>2.2413289999999998E-3</c:v>
                </c:pt>
                <c:pt idx="1555">
                  <c:v>6.1531400000000005E-4</c:v>
                </c:pt>
                <c:pt idx="1556">
                  <c:v>1.8378828999999999E-2</c:v>
                </c:pt>
                <c:pt idx="1557">
                  <c:v>1.273129E-3</c:v>
                </c:pt>
                <c:pt idx="1558">
                  <c:v>1.355132E-3</c:v>
                </c:pt>
                <c:pt idx="1559">
                  <c:v>3.5085960000000001E-3</c:v>
                </c:pt>
                <c:pt idx="1560">
                  <c:v>1.3286560000000001E-3</c:v>
                </c:pt>
                <c:pt idx="1561">
                  <c:v>1.5435379999999999E-3</c:v>
                </c:pt>
                <c:pt idx="1562">
                  <c:v>8.0481760000000006E-3</c:v>
                </c:pt>
                <c:pt idx="1563">
                  <c:v>3.8985249999999999E-3</c:v>
                </c:pt>
                <c:pt idx="1564">
                  <c:v>3.7852720000000001E-3</c:v>
                </c:pt>
                <c:pt idx="1565">
                  <c:v>5.7660199999999995E-4</c:v>
                </c:pt>
                <c:pt idx="1566">
                  <c:v>7.5127099999999997E-4</c:v>
                </c:pt>
                <c:pt idx="1567">
                  <c:v>1.2826269999999999E-3</c:v>
                </c:pt>
                <c:pt idx="1568">
                  <c:v>4.5001600000000002E-4</c:v>
                </c:pt>
                <c:pt idx="1569">
                  <c:v>3.1735539999999999E-3</c:v>
                </c:pt>
                <c:pt idx="1570">
                  <c:v>1.4048699999999999E-3</c:v>
                </c:pt>
                <c:pt idx="1571">
                  <c:v>1.728858E-3</c:v>
                </c:pt>
                <c:pt idx="1572">
                  <c:v>2.516468E-3</c:v>
                </c:pt>
                <c:pt idx="1573">
                  <c:v>2.688172E-3</c:v>
                </c:pt>
                <c:pt idx="1574">
                  <c:v>2.3487959999999998E-3</c:v>
                </c:pt>
                <c:pt idx="1575">
                  <c:v>4.4581930000000001E-3</c:v>
                </c:pt>
                <c:pt idx="1576">
                  <c:v>1.2466440000000001E-3</c:v>
                </c:pt>
                <c:pt idx="1577">
                  <c:v>4.2462433000000001E-2</c:v>
                </c:pt>
                <c:pt idx="1578">
                  <c:v>2.7442826999999999E-2</c:v>
                </c:pt>
                <c:pt idx="1579">
                  <c:v>2.3786900000000001E-4</c:v>
                </c:pt>
                <c:pt idx="1580">
                  <c:v>1.2178619999999999E-3</c:v>
                </c:pt>
                <c:pt idx="1581">
                  <c:v>1.169762E-3</c:v>
                </c:pt>
                <c:pt idx="1582">
                  <c:v>5.9408900000000001E-4</c:v>
                </c:pt>
                <c:pt idx="1583">
                  <c:v>1.209007E-3</c:v>
                </c:pt>
                <c:pt idx="1584">
                  <c:v>3.4630609999999999E-3</c:v>
                </c:pt>
                <c:pt idx="1585">
                  <c:v>6.7596109999999996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BF-4EA4-9F2A-806A819FC30B}"/>
            </c:ext>
          </c:extLst>
        </c:ser>
        <c:ser>
          <c:idx val="0"/>
          <c:order val="1"/>
          <c:tx>
            <c:strRef>
              <c:f>'RNA1 DMS error rate'!$E$1</c:f>
              <c:strCache>
                <c:ptCount val="1"/>
                <c:pt idx="0">
                  <c:v>DMS+</c:v>
                </c:pt>
              </c:strCache>
            </c:strRef>
          </c:tx>
          <c:spPr>
            <a:ln w="19050" cap="rnd">
              <a:solidFill>
                <a:schemeClr val="accent2">
                  <a:alpha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NA1 DMS error rate'!$B$2:$B$1587</c:f>
              <c:numCache>
                <c:formatCode>General</c:formatCode>
                <c:ptCount val="1586"/>
                <c:pt idx="0">
                  <c:v>14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3</c:v>
                </c:pt>
                <c:pt idx="8">
                  <c:v>24</c:v>
                </c:pt>
                <c:pt idx="9">
                  <c:v>25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5</c:v>
                </c:pt>
                <c:pt idx="17">
                  <c:v>36</c:v>
                </c:pt>
                <c:pt idx="18">
                  <c:v>37</c:v>
                </c:pt>
                <c:pt idx="19">
                  <c:v>38</c:v>
                </c:pt>
                <c:pt idx="20">
                  <c:v>39</c:v>
                </c:pt>
                <c:pt idx="21">
                  <c:v>40</c:v>
                </c:pt>
                <c:pt idx="22">
                  <c:v>43</c:v>
                </c:pt>
                <c:pt idx="23">
                  <c:v>44</c:v>
                </c:pt>
                <c:pt idx="24">
                  <c:v>46</c:v>
                </c:pt>
                <c:pt idx="25">
                  <c:v>48</c:v>
                </c:pt>
                <c:pt idx="26">
                  <c:v>49</c:v>
                </c:pt>
                <c:pt idx="27">
                  <c:v>50</c:v>
                </c:pt>
                <c:pt idx="28">
                  <c:v>51</c:v>
                </c:pt>
                <c:pt idx="29">
                  <c:v>55</c:v>
                </c:pt>
                <c:pt idx="30">
                  <c:v>58</c:v>
                </c:pt>
                <c:pt idx="31">
                  <c:v>63</c:v>
                </c:pt>
                <c:pt idx="32">
                  <c:v>65</c:v>
                </c:pt>
                <c:pt idx="33">
                  <c:v>66</c:v>
                </c:pt>
                <c:pt idx="34">
                  <c:v>67</c:v>
                </c:pt>
                <c:pt idx="35">
                  <c:v>68</c:v>
                </c:pt>
                <c:pt idx="36">
                  <c:v>69</c:v>
                </c:pt>
                <c:pt idx="37">
                  <c:v>70</c:v>
                </c:pt>
                <c:pt idx="38">
                  <c:v>71</c:v>
                </c:pt>
                <c:pt idx="39">
                  <c:v>73</c:v>
                </c:pt>
                <c:pt idx="40">
                  <c:v>75</c:v>
                </c:pt>
                <c:pt idx="41">
                  <c:v>76</c:v>
                </c:pt>
                <c:pt idx="42">
                  <c:v>77</c:v>
                </c:pt>
                <c:pt idx="43">
                  <c:v>78</c:v>
                </c:pt>
                <c:pt idx="44">
                  <c:v>79</c:v>
                </c:pt>
                <c:pt idx="45">
                  <c:v>81</c:v>
                </c:pt>
                <c:pt idx="46">
                  <c:v>82</c:v>
                </c:pt>
                <c:pt idx="47">
                  <c:v>83</c:v>
                </c:pt>
                <c:pt idx="48">
                  <c:v>86</c:v>
                </c:pt>
                <c:pt idx="49">
                  <c:v>87</c:v>
                </c:pt>
                <c:pt idx="50">
                  <c:v>93</c:v>
                </c:pt>
                <c:pt idx="51">
                  <c:v>96</c:v>
                </c:pt>
                <c:pt idx="52">
                  <c:v>100</c:v>
                </c:pt>
                <c:pt idx="53">
                  <c:v>104</c:v>
                </c:pt>
                <c:pt idx="54">
                  <c:v>105</c:v>
                </c:pt>
                <c:pt idx="55">
                  <c:v>106</c:v>
                </c:pt>
                <c:pt idx="56">
                  <c:v>107</c:v>
                </c:pt>
                <c:pt idx="57">
                  <c:v>108</c:v>
                </c:pt>
                <c:pt idx="58">
                  <c:v>111</c:v>
                </c:pt>
                <c:pt idx="59">
                  <c:v>113</c:v>
                </c:pt>
                <c:pt idx="60">
                  <c:v>120</c:v>
                </c:pt>
                <c:pt idx="61">
                  <c:v>125</c:v>
                </c:pt>
                <c:pt idx="62">
                  <c:v>126</c:v>
                </c:pt>
                <c:pt idx="63">
                  <c:v>129</c:v>
                </c:pt>
                <c:pt idx="64">
                  <c:v>134</c:v>
                </c:pt>
                <c:pt idx="65">
                  <c:v>135</c:v>
                </c:pt>
                <c:pt idx="66">
                  <c:v>138</c:v>
                </c:pt>
                <c:pt idx="67">
                  <c:v>139</c:v>
                </c:pt>
                <c:pt idx="68">
                  <c:v>141</c:v>
                </c:pt>
                <c:pt idx="69">
                  <c:v>143</c:v>
                </c:pt>
                <c:pt idx="70">
                  <c:v>144</c:v>
                </c:pt>
                <c:pt idx="71">
                  <c:v>145</c:v>
                </c:pt>
                <c:pt idx="72">
                  <c:v>146</c:v>
                </c:pt>
                <c:pt idx="73">
                  <c:v>150</c:v>
                </c:pt>
                <c:pt idx="74">
                  <c:v>156</c:v>
                </c:pt>
                <c:pt idx="75">
                  <c:v>158</c:v>
                </c:pt>
                <c:pt idx="76">
                  <c:v>164</c:v>
                </c:pt>
                <c:pt idx="77">
                  <c:v>165</c:v>
                </c:pt>
                <c:pt idx="78">
                  <c:v>166</c:v>
                </c:pt>
                <c:pt idx="79">
                  <c:v>170</c:v>
                </c:pt>
                <c:pt idx="80">
                  <c:v>172</c:v>
                </c:pt>
                <c:pt idx="81">
                  <c:v>173</c:v>
                </c:pt>
                <c:pt idx="82">
                  <c:v>174</c:v>
                </c:pt>
                <c:pt idx="83">
                  <c:v>176</c:v>
                </c:pt>
                <c:pt idx="84">
                  <c:v>178</c:v>
                </c:pt>
                <c:pt idx="85">
                  <c:v>179</c:v>
                </c:pt>
                <c:pt idx="86">
                  <c:v>181</c:v>
                </c:pt>
                <c:pt idx="87">
                  <c:v>182</c:v>
                </c:pt>
                <c:pt idx="88">
                  <c:v>184</c:v>
                </c:pt>
                <c:pt idx="89">
                  <c:v>189</c:v>
                </c:pt>
                <c:pt idx="90">
                  <c:v>193</c:v>
                </c:pt>
                <c:pt idx="91">
                  <c:v>194</c:v>
                </c:pt>
                <c:pt idx="92">
                  <c:v>195</c:v>
                </c:pt>
                <c:pt idx="93">
                  <c:v>196</c:v>
                </c:pt>
                <c:pt idx="94">
                  <c:v>198</c:v>
                </c:pt>
                <c:pt idx="95">
                  <c:v>202</c:v>
                </c:pt>
                <c:pt idx="96">
                  <c:v>203</c:v>
                </c:pt>
                <c:pt idx="97">
                  <c:v>204</c:v>
                </c:pt>
                <c:pt idx="98">
                  <c:v>205</c:v>
                </c:pt>
                <c:pt idx="99">
                  <c:v>207</c:v>
                </c:pt>
                <c:pt idx="100">
                  <c:v>209</c:v>
                </c:pt>
                <c:pt idx="101">
                  <c:v>210</c:v>
                </c:pt>
                <c:pt idx="102">
                  <c:v>214</c:v>
                </c:pt>
                <c:pt idx="103">
                  <c:v>215</c:v>
                </c:pt>
                <c:pt idx="104">
                  <c:v>216</c:v>
                </c:pt>
                <c:pt idx="105">
                  <c:v>217</c:v>
                </c:pt>
                <c:pt idx="106">
                  <c:v>221</c:v>
                </c:pt>
                <c:pt idx="107">
                  <c:v>225</c:v>
                </c:pt>
                <c:pt idx="108">
                  <c:v>226</c:v>
                </c:pt>
                <c:pt idx="109">
                  <c:v>230</c:v>
                </c:pt>
                <c:pt idx="110">
                  <c:v>231</c:v>
                </c:pt>
                <c:pt idx="111">
                  <c:v>232</c:v>
                </c:pt>
                <c:pt idx="112">
                  <c:v>233</c:v>
                </c:pt>
                <c:pt idx="113">
                  <c:v>234</c:v>
                </c:pt>
                <c:pt idx="114">
                  <c:v>235</c:v>
                </c:pt>
                <c:pt idx="115">
                  <c:v>236</c:v>
                </c:pt>
                <c:pt idx="116">
                  <c:v>238</c:v>
                </c:pt>
                <c:pt idx="117">
                  <c:v>239</c:v>
                </c:pt>
                <c:pt idx="118">
                  <c:v>241</c:v>
                </c:pt>
                <c:pt idx="119">
                  <c:v>242</c:v>
                </c:pt>
                <c:pt idx="120">
                  <c:v>243</c:v>
                </c:pt>
                <c:pt idx="121">
                  <c:v>244</c:v>
                </c:pt>
                <c:pt idx="122">
                  <c:v>245</c:v>
                </c:pt>
                <c:pt idx="123">
                  <c:v>247</c:v>
                </c:pt>
                <c:pt idx="124">
                  <c:v>249</c:v>
                </c:pt>
                <c:pt idx="125">
                  <c:v>251</c:v>
                </c:pt>
                <c:pt idx="126">
                  <c:v>253</c:v>
                </c:pt>
                <c:pt idx="127">
                  <c:v>254</c:v>
                </c:pt>
                <c:pt idx="128">
                  <c:v>255</c:v>
                </c:pt>
                <c:pt idx="129">
                  <c:v>256</c:v>
                </c:pt>
                <c:pt idx="130">
                  <c:v>261</c:v>
                </c:pt>
                <c:pt idx="131">
                  <c:v>263</c:v>
                </c:pt>
                <c:pt idx="132">
                  <c:v>265</c:v>
                </c:pt>
                <c:pt idx="133">
                  <c:v>266</c:v>
                </c:pt>
                <c:pt idx="134">
                  <c:v>268</c:v>
                </c:pt>
                <c:pt idx="135">
                  <c:v>272</c:v>
                </c:pt>
                <c:pt idx="136">
                  <c:v>273</c:v>
                </c:pt>
                <c:pt idx="137">
                  <c:v>274</c:v>
                </c:pt>
                <c:pt idx="138">
                  <c:v>276</c:v>
                </c:pt>
                <c:pt idx="139">
                  <c:v>277</c:v>
                </c:pt>
                <c:pt idx="140">
                  <c:v>280</c:v>
                </c:pt>
                <c:pt idx="141">
                  <c:v>283</c:v>
                </c:pt>
                <c:pt idx="142">
                  <c:v>284</c:v>
                </c:pt>
                <c:pt idx="143">
                  <c:v>285</c:v>
                </c:pt>
                <c:pt idx="144">
                  <c:v>289</c:v>
                </c:pt>
                <c:pt idx="145">
                  <c:v>290</c:v>
                </c:pt>
                <c:pt idx="146">
                  <c:v>292</c:v>
                </c:pt>
                <c:pt idx="147">
                  <c:v>293</c:v>
                </c:pt>
                <c:pt idx="148">
                  <c:v>295</c:v>
                </c:pt>
                <c:pt idx="149">
                  <c:v>296</c:v>
                </c:pt>
                <c:pt idx="150">
                  <c:v>298</c:v>
                </c:pt>
                <c:pt idx="151">
                  <c:v>303</c:v>
                </c:pt>
                <c:pt idx="152">
                  <c:v>305</c:v>
                </c:pt>
                <c:pt idx="153">
                  <c:v>306</c:v>
                </c:pt>
                <c:pt idx="154">
                  <c:v>308</c:v>
                </c:pt>
                <c:pt idx="155">
                  <c:v>309</c:v>
                </c:pt>
                <c:pt idx="156">
                  <c:v>310</c:v>
                </c:pt>
                <c:pt idx="157">
                  <c:v>311</c:v>
                </c:pt>
                <c:pt idx="158">
                  <c:v>312</c:v>
                </c:pt>
                <c:pt idx="159">
                  <c:v>316</c:v>
                </c:pt>
                <c:pt idx="160">
                  <c:v>317</c:v>
                </c:pt>
                <c:pt idx="161">
                  <c:v>318</c:v>
                </c:pt>
                <c:pt idx="162">
                  <c:v>320</c:v>
                </c:pt>
                <c:pt idx="163">
                  <c:v>321</c:v>
                </c:pt>
                <c:pt idx="164">
                  <c:v>326</c:v>
                </c:pt>
                <c:pt idx="165">
                  <c:v>327</c:v>
                </c:pt>
                <c:pt idx="166">
                  <c:v>332</c:v>
                </c:pt>
                <c:pt idx="167">
                  <c:v>333</c:v>
                </c:pt>
                <c:pt idx="168">
                  <c:v>336</c:v>
                </c:pt>
                <c:pt idx="169">
                  <c:v>337</c:v>
                </c:pt>
                <c:pt idx="170">
                  <c:v>341</c:v>
                </c:pt>
                <c:pt idx="171">
                  <c:v>344</c:v>
                </c:pt>
                <c:pt idx="172">
                  <c:v>345</c:v>
                </c:pt>
                <c:pt idx="173">
                  <c:v>347</c:v>
                </c:pt>
                <c:pt idx="174">
                  <c:v>348</c:v>
                </c:pt>
                <c:pt idx="175">
                  <c:v>349</c:v>
                </c:pt>
                <c:pt idx="176">
                  <c:v>352</c:v>
                </c:pt>
                <c:pt idx="177">
                  <c:v>358</c:v>
                </c:pt>
                <c:pt idx="178">
                  <c:v>360</c:v>
                </c:pt>
                <c:pt idx="179">
                  <c:v>362</c:v>
                </c:pt>
                <c:pt idx="180">
                  <c:v>363</c:v>
                </c:pt>
                <c:pt idx="181">
                  <c:v>365</c:v>
                </c:pt>
                <c:pt idx="182">
                  <c:v>368</c:v>
                </c:pt>
                <c:pt idx="183">
                  <c:v>369</c:v>
                </c:pt>
                <c:pt idx="184">
                  <c:v>370</c:v>
                </c:pt>
                <c:pt idx="185">
                  <c:v>372</c:v>
                </c:pt>
                <c:pt idx="186">
                  <c:v>373</c:v>
                </c:pt>
                <c:pt idx="187">
                  <c:v>374</c:v>
                </c:pt>
                <c:pt idx="188">
                  <c:v>377</c:v>
                </c:pt>
                <c:pt idx="189">
                  <c:v>378</c:v>
                </c:pt>
                <c:pt idx="190">
                  <c:v>384</c:v>
                </c:pt>
                <c:pt idx="191">
                  <c:v>387</c:v>
                </c:pt>
                <c:pt idx="192">
                  <c:v>389</c:v>
                </c:pt>
                <c:pt idx="193">
                  <c:v>390</c:v>
                </c:pt>
                <c:pt idx="194">
                  <c:v>391</c:v>
                </c:pt>
                <c:pt idx="195">
                  <c:v>392</c:v>
                </c:pt>
                <c:pt idx="196">
                  <c:v>393</c:v>
                </c:pt>
                <c:pt idx="197">
                  <c:v>398</c:v>
                </c:pt>
                <c:pt idx="198">
                  <c:v>402</c:v>
                </c:pt>
                <c:pt idx="199">
                  <c:v>403</c:v>
                </c:pt>
                <c:pt idx="200">
                  <c:v>404</c:v>
                </c:pt>
                <c:pt idx="201">
                  <c:v>405</c:v>
                </c:pt>
                <c:pt idx="202">
                  <c:v>406</c:v>
                </c:pt>
                <c:pt idx="203">
                  <c:v>407</c:v>
                </c:pt>
                <c:pt idx="204">
                  <c:v>408</c:v>
                </c:pt>
                <c:pt idx="205">
                  <c:v>409</c:v>
                </c:pt>
                <c:pt idx="206">
                  <c:v>410</c:v>
                </c:pt>
                <c:pt idx="207">
                  <c:v>411</c:v>
                </c:pt>
                <c:pt idx="208">
                  <c:v>412</c:v>
                </c:pt>
                <c:pt idx="209">
                  <c:v>413</c:v>
                </c:pt>
                <c:pt idx="210">
                  <c:v>414</c:v>
                </c:pt>
                <c:pt idx="211">
                  <c:v>415</c:v>
                </c:pt>
                <c:pt idx="212">
                  <c:v>416</c:v>
                </c:pt>
                <c:pt idx="213">
                  <c:v>417</c:v>
                </c:pt>
                <c:pt idx="214">
                  <c:v>419</c:v>
                </c:pt>
                <c:pt idx="215">
                  <c:v>420</c:v>
                </c:pt>
                <c:pt idx="216">
                  <c:v>421</c:v>
                </c:pt>
                <c:pt idx="217">
                  <c:v>423</c:v>
                </c:pt>
                <c:pt idx="218">
                  <c:v>424</c:v>
                </c:pt>
                <c:pt idx="219">
                  <c:v>425</c:v>
                </c:pt>
                <c:pt idx="220">
                  <c:v>429</c:v>
                </c:pt>
                <c:pt idx="221">
                  <c:v>430</c:v>
                </c:pt>
                <c:pt idx="222">
                  <c:v>433</c:v>
                </c:pt>
                <c:pt idx="223">
                  <c:v>435</c:v>
                </c:pt>
                <c:pt idx="224">
                  <c:v>436</c:v>
                </c:pt>
                <c:pt idx="225">
                  <c:v>437</c:v>
                </c:pt>
                <c:pt idx="226">
                  <c:v>438</c:v>
                </c:pt>
                <c:pt idx="227">
                  <c:v>439</c:v>
                </c:pt>
                <c:pt idx="228">
                  <c:v>440</c:v>
                </c:pt>
                <c:pt idx="229">
                  <c:v>444</c:v>
                </c:pt>
                <c:pt idx="230">
                  <c:v>445</c:v>
                </c:pt>
                <c:pt idx="231">
                  <c:v>446</c:v>
                </c:pt>
                <c:pt idx="232">
                  <c:v>447</c:v>
                </c:pt>
                <c:pt idx="233">
                  <c:v>450</c:v>
                </c:pt>
                <c:pt idx="234">
                  <c:v>452</c:v>
                </c:pt>
                <c:pt idx="235">
                  <c:v>453</c:v>
                </c:pt>
                <c:pt idx="236">
                  <c:v>456</c:v>
                </c:pt>
                <c:pt idx="237">
                  <c:v>461</c:v>
                </c:pt>
                <c:pt idx="238">
                  <c:v>467</c:v>
                </c:pt>
                <c:pt idx="239">
                  <c:v>468</c:v>
                </c:pt>
                <c:pt idx="240">
                  <c:v>469</c:v>
                </c:pt>
                <c:pt idx="241">
                  <c:v>470</c:v>
                </c:pt>
                <c:pt idx="242">
                  <c:v>471</c:v>
                </c:pt>
                <c:pt idx="243">
                  <c:v>473</c:v>
                </c:pt>
                <c:pt idx="244">
                  <c:v>477</c:v>
                </c:pt>
                <c:pt idx="245">
                  <c:v>478</c:v>
                </c:pt>
                <c:pt idx="246">
                  <c:v>481</c:v>
                </c:pt>
                <c:pt idx="247">
                  <c:v>482</c:v>
                </c:pt>
                <c:pt idx="248">
                  <c:v>485</c:v>
                </c:pt>
                <c:pt idx="249">
                  <c:v>486</c:v>
                </c:pt>
                <c:pt idx="250">
                  <c:v>487</c:v>
                </c:pt>
                <c:pt idx="251">
                  <c:v>488</c:v>
                </c:pt>
                <c:pt idx="252">
                  <c:v>489</c:v>
                </c:pt>
                <c:pt idx="253">
                  <c:v>490</c:v>
                </c:pt>
                <c:pt idx="254">
                  <c:v>491</c:v>
                </c:pt>
                <c:pt idx="255">
                  <c:v>494</c:v>
                </c:pt>
                <c:pt idx="256">
                  <c:v>497</c:v>
                </c:pt>
                <c:pt idx="257">
                  <c:v>500</c:v>
                </c:pt>
                <c:pt idx="258">
                  <c:v>503</c:v>
                </c:pt>
                <c:pt idx="259">
                  <c:v>504</c:v>
                </c:pt>
                <c:pt idx="260">
                  <c:v>507</c:v>
                </c:pt>
                <c:pt idx="261">
                  <c:v>508</c:v>
                </c:pt>
                <c:pt idx="262">
                  <c:v>510</c:v>
                </c:pt>
                <c:pt idx="263">
                  <c:v>513</c:v>
                </c:pt>
                <c:pt idx="264">
                  <c:v>521</c:v>
                </c:pt>
                <c:pt idx="265">
                  <c:v>527</c:v>
                </c:pt>
                <c:pt idx="266">
                  <c:v>530</c:v>
                </c:pt>
                <c:pt idx="267">
                  <c:v>533</c:v>
                </c:pt>
                <c:pt idx="268">
                  <c:v>537</c:v>
                </c:pt>
                <c:pt idx="269">
                  <c:v>538</c:v>
                </c:pt>
                <c:pt idx="270">
                  <c:v>539</c:v>
                </c:pt>
                <c:pt idx="271">
                  <c:v>540</c:v>
                </c:pt>
                <c:pt idx="272">
                  <c:v>542</c:v>
                </c:pt>
                <c:pt idx="273">
                  <c:v>544</c:v>
                </c:pt>
                <c:pt idx="274">
                  <c:v>545</c:v>
                </c:pt>
                <c:pt idx="275">
                  <c:v>548</c:v>
                </c:pt>
                <c:pt idx="276">
                  <c:v>553</c:v>
                </c:pt>
                <c:pt idx="277">
                  <c:v>558</c:v>
                </c:pt>
                <c:pt idx="278">
                  <c:v>560</c:v>
                </c:pt>
                <c:pt idx="279">
                  <c:v>562</c:v>
                </c:pt>
                <c:pt idx="280">
                  <c:v>563</c:v>
                </c:pt>
                <c:pt idx="281">
                  <c:v>564</c:v>
                </c:pt>
                <c:pt idx="282">
                  <c:v>565</c:v>
                </c:pt>
                <c:pt idx="283">
                  <c:v>568</c:v>
                </c:pt>
                <c:pt idx="284">
                  <c:v>571</c:v>
                </c:pt>
                <c:pt idx="285">
                  <c:v>572</c:v>
                </c:pt>
                <c:pt idx="286">
                  <c:v>573</c:v>
                </c:pt>
                <c:pt idx="287">
                  <c:v>576</c:v>
                </c:pt>
                <c:pt idx="288">
                  <c:v>582</c:v>
                </c:pt>
                <c:pt idx="289">
                  <c:v>583</c:v>
                </c:pt>
                <c:pt idx="290">
                  <c:v>584</c:v>
                </c:pt>
                <c:pt idx="291">
                  <c:v>585</c:v>
                </c:pt>
                <c:pt idx="292">
                  <c:v>586</c:v>
                </c:pt>
                <c:pt idx="293">
                  <c:v>587</c:v>
                </c:pt>
                <c:pt idx="294">
                  <c:v>588</c:v>
                </c:pt>
                <c:pt idx="295">
                  <c:v>592</c:v>
                </c:pt>
                <c:pt idx="296">
                  <c:v>593</c:v>
                </c:pt>
                <c:pt idx="297">
                  <c:v>594</c:v>
                </c:pt>
                <c:pt idx="298">
                  <c:v>595</c:v>
                </c:pt>
                <c:pt idx="299">
                  <c:v>596</c:v>
                </c:pt>
                <c:pt idx="300">
                  <c:v>598</c:v>
                </c:pt>
                <c:pt idx="301">
                  <c:v>599</c:v>
                </c:pt>
                <c:pt idx="302">
                  <c:v>601</c:v>
                </c:pt>
                <c:pt idx="303">
                  <c:v>602</c:v>
                </c:pt>
                <c:pt idx="304">
                  <c:v>603</c:v>
                </c:pt>
                <c:pt idx="305">
                  <c:v>607</c:v>
                </c:pt>
                <c:pt idx="306">
                  <c:v>609</c:v>
                </c:pt>
                <c:pt idx="307">
                  <c:v>617</c:v>
                </c:pt>
                <c:pt idx="308">
                  <c:v>620</c:v>
                </c:pt>
                <c:pt idx="309">
                  <c:v>623</c:v>
                </c:pt>
                <c:pt idx="310">
                  <c:v>624</c:v>
                </c:pt>
                <c:pt idx="311">
                  <c:v>626</c:v>
                </c:pt>
                <c:pt idx="312">
                  <c:v>627</c:v>
                </c:pt>
                <c:pt idx="313">
                  <c:v>628</c:v>
                </c:pt>
                <c:pt idx="314">
                  <c:v>629</c:v>
                </c:pt>
                <c:pt idx="315">
                  <c:v>630</c:v>
                </c:pt>
                <c:pt idx="316">
                  <c:v>633</c:v>
                </c:pt>
                <c:pt idx="317">
                  <c:v>634</c:v>
                </c:pt>
                <c:pt idx="318">
                  <c:v>635</c:v>
                </c:pt>
                <c:pt idx="319">
                  <c:v>636</c:v>
                </c:pt>
                <c:pt idx="320">
                  <c:v>637</c:v>
                </c:pt>
                <c:pt idx="321">
                  <c:v>640</c:v>
                </c:pt>
                <c:pt idx="322">
                  <c:v>641</c:v>
                </c:pt>
                <c:pt idx="323">
                  <c:v>643</c:v>
                </c:pt>
                <c:pt idx="324">
                  <c:v>644</c:v>
                </c:pt>
                <c:pt idx="325">
                  <c:v>645</c:v>
                </c:pt>
                <c:pt idx="326">
                  <c:v>646</c:v>
                </c:pt>
                <c:pt idx="327">
                  <c:v>647</c:v>
                </c:pt>
                <c:pt idx="328">
                  <c:v>648</c:v>
                </c:pt>
                <c:pt idx="329">
                  <c:v>656</c:v>
                </c:pt>
                <c:pt idx="330">
                  <c:v>657</c:v>
                </c:pt>
                <c:pt idx="331">
                  <c:v>659</c:v>
                </c:pt>
                <c:pt idx="332">
                  <c:v>661</c:v>
                </c:pt>
                <c:pt idx="333">
                  <c:v>662</c:v>
                </c:pt>
                <c:pt idx="334">
                  <c:v>667</c:v>
                </c:pt>
                <c:pt idx="335">
                  <c:v>669</c:v>
                </c:pt>
                <c:pt idx="336">
                  <c:v>675</c:v>
                </c:pt>
                <c:pt idx="337">
                  <c:v>677</c:v>
                </c:pt>
                <c:pt idx="338">
                  <c:v>678</c:v>
                </c:pt>
                <c:pt idx="339">
                  <c:v>680</c:v>
                </c:pt>
                <c:pt idx="340">
                  <c:v>681</c:v>
                </c:pt>
                <c:pt idx="341">
                  <c:v>687</c:v>
                </c:pt>
                <c:pt idx="342">
                  <c:v>688</c:v>
                </c:pt>
                <c:pt idx="343">
                  <c:v>689</c:v>
                </c:pt>
                <c:pt idx="344">
                  <c:v>691</c:v>
                </c:pt>
                <c:pt idx="345">
                  <c:v>692</c:v>
                </c:pt>
                <c:pt idx="346">
                  <c:v>693</c:v>
                </c:pt>
                <c:pt idx="347">
                  <c:v>701</c:v>
                </c:pt>
                <c:pt idx="348">
                  <c:v>708</c:v>
                </c:pt>
                <c:pt idx="349">
                  <c:v>710</c:v>
                </c:pt>
                <c:pt idx="350">
                  <c:v>711</c:v>
                </c:pt>
                <c:pt idx="351">
                  <c:v>713</c:v>
                </c:pt>
                <c:pt idx="352">
                  <c:v>719</c:v>
                </c:pt>
                <c:pt idx="353">
                  <c:v>724</c:v>
                </c:pt>
                <c:pt idx="354">
                  <c:v>726</c:v>
                </c:pt>
                <c:pt idx="355">
                  <c:v>728</c:v>
                </c:pt>
                <c:pt idx="356">
                  <c:v>730</c:v>
                </c:pt>
                <c:pt idx="357">
                  <c:v>732</c:v>
                </c:pt>
                <c:pt idx="358">
                  <c:v>733</c:v>
                </c:pt>
                <c:pt idx="359">
                  <c:v>735</c:v>
                </c:pt>
                <c:pt idx="360">
                  <c:v>738</c:v>
                </c:pt>
                <c:pt idx="361">
                  <c:v>739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7</c:v>
                </c:pt>
                <c:pt idx="367">
                  <c:v>751</c:v>
                </c:pt>
                <c:pt idx="368">
                  <c:v>752</c:v>
                </c:pt>
                <c:pt idx="369">
                  <c:v>755</c:v>
                </c:pt>
                <c:pt idx="370">
                  <c:v>765</c:v>
                </c:pt>
                <c:pt idx="371">
                  <c:v>766</c:v>
                </c:pt>
                <c:pt idx="372">
                  <c:v>767</c:v>
                </c:pt>
                <c:pt idx="373">
                  <c:v>768</c:v>
                </c:pt>
                <c:pt idx="374">
                  <c:v>769</c:v>
                </c:pt>
                <c:pt idx="375">
                  <c:v>771</c:v>
                </c:pt>
                <c:pt idx="376">
                  <c:v>772</c:v>
                </c:pt>
                <c:pt idx="377">
                  <c:v>773</c:v>
                </c:pt>
                <c:pt idx="378">
                  <c:v>774</c:v>
                </c:pt>
                <c:pt idx="379">
                  <c:v>775</c:v>
                </c:pt>
                <c:pt idx="380">
                  <c:v>778</c:v>
                </c:pt>
                <c:pt idx="381">
                  <c:v>780</c:v>
                </c:pt>
                <c:pt idx="382">
                  <c:v>781</c:v>
                </c:pt>
                <c:pt idx="383">
                  <c:v>784</c:v>
                </c:pt>
                <c:pt idx="384">
                  <c:v>794</c:v>
                </c:pt>
                <c:pt idx="385">
                  <c:v>796</c:v>
                </c:pt>
                <c:pt idx="386">
                  <c:v>797</c:v>
                </c:pt>
                <c:pt idx="387">
                  <c:v>804</c:v>
                </c:pt>
                <c:pt idx="388">
                  <c:v>806</c:v>
                </c:pt>
                <c:pt idx="389">
                  <c:v>808</c:v>
                </c:pt>
                <c:pt idx="390">
                  <c:v>809</c:v>
                </c:pt>
                <c:pt idx="391">
                  <c:v>811</c:v>
                </c:pt>
                <c:pt idx="392">
                  <c:v>812</c:v>
                </c:pt>
                <c:pt idx="393">
                  <c:v>813</c:v>
                </c:pt>
                <c:pt idx="394">
                  <c:v>814</c:v>
                </c:pt>
                <c:pt idx="395">
                  <c:v>816</c:v>
                </c:pt>
                <c:pt idx="396">
                  <c:v>817</c:v>
                </c:pt>
                <c:pt idx="397">
                  <c:v>818</c:v>
                </c:pt>
                <c:pt idx="398">
                  <c:v>820</c:v>
                </c:pt>
                <c:pt idx="399">
                  <c:v>821</c:v>
                </c:pt>
                <c:pt idx="400">
                  <c:v>826</c:v>
                </c:pt>
                <c:pt idx="401">
                  <c:v>828</c:v>
                </c:pt>
                <c:pt idx="402">
                  <c:v>829</c:v>
                </c:pt>
                <c:pt idx="403">
                  <c:v>830</c:v>
                </c:pt>
                <c:pt idx="404">
                  <c:v>835</c:v>
                </c:pt>
                <c:pt idx="405">
                  <c:v>836</c:v>
                </c:pt>
                <c:pt idx="406">
                  <c:v>839</c:v>
                </c:pt>
                <c:pt idx="407">
                  <c:v>844</c:v>
                </c:pt>
                <c:pt idx="408">
                  <c:v>845</c:v>
                </c:pt>
                <c:pt idx="409">
                  <c:v>846</c:v>
                </c:pt>
                <c:pt idx="410">
                  <c:v>848</c:v>
                </c:pt>
                <c:pt idx="411">
                  <c:v>850</c:v>
                </c:pt>
                <c:pt idx="412">
                  <c:v>854</c:v>
                </c:pt>
                <c:pt idx="413">
                  <c:v>855</c:v>
                </c:pt>
                <c:pt idx="414">
                  <c:v>856</c:v>
                </c:pt>
                <c:pt idx="415">
                  <c:v>861</c:v>
                </c:pt>
                <c:pt idx="416">
                  <c:v>863</c:v>
                </c:pt>
                <c:pt idx="417">
                  <c:v>864</c:v>
                </c:pt>
                <c:pt idx="418">
                  <c:v>865</c:v>
                </c:pt>
                <c:pt idx="419">
                  <c:v>866</c:v>
                </c:pt>
                <c:pt idx="420">
                  <c:v>868</c:v>
                </c:pt>
                <c:pt idx="421">
                  <c:v>870</c:v>
                </c:pt>
                <c:pt idx="422">
                  <c:v>871</c:v>
                </c:pt>
                <c:pt idx="423">
                  <c:v>872</c:v>
                </c:pt>
                <c:pt idx="424">
                  <c:v>874</c:v>
                </c:pt>
                <c:pt idx="425">
                  <c:v>875</c:v>
                </c:pt>
                <c:pt idx="426">
                  <c:v>876</c:v>
                </c:pt>
                <c:pt idx="427">
                  <c:v>878</c:v>
                </c:pt>
                <c:pt idx="428">
                  <c:v>882</c:v>
                </c:pt>
                <c:pt idx="429">
                  <c:v>883</c:v>
                </c:pt>
                <c:pt idx="430">
                  <c:v>889</c:v>
                </c:pt>
                <c:pt idx="431">
                  <c:v>891</c:v>
                </c:pt>
                <c:pt idx="432">
                  <c:v>895</c:v>
                </c:pt>
                <c:pt idx="433">
                  <c:v>896</c:v>
                </c:pt>
                <c:pt idx="434">
                  <c:v>901</c:v>
                </c:pt>
                <c:pt idx="435">
                  <c:v>905</c:v>
                </c:pt>
                <c:pt idx="436">
                  <c:v>907</c:v>
                </c:pt>
                <c:pt idx="437">
                  <c:v>908</c:v>
                </c:pt>
                <c:pt idx="438">
                  <c:v>909</c:v>
                </c:pt>
                <c:pt idx="439">
                  <c:v>911</c:v>
                </c:pt>
                <c:pt idx="440">
                  <c:v>912</c:v>
                </c:pt>
                <c:pt idx="441">
                  <c:v>913</c:v>
                </c:pt>
                <c:pt idx="442">
                  <c:v>915</c:v>
                </c:pt>
                <c:pt idx="443">
                  <c:v>916</c:v>
                </c:pt>
                <c:pt idx="444">
                  <c:v>917</c:v>
                </c:pt>
                <c:pt idx="445">
                  <c:v>918</c:v>
                </c:pt>
                <c:pt idx="446">
                  <c:v>922</c:v>
                </c:pt>
                <c:pt idx="447">
                  <c:v>924</c:v>
                </c:pt>
                <c:pt idx="448">
                  <c:v>925</c:v>
                </c:pt>
                <c:pt idx="449">
                  <c:v>926</c:v>
                </c:pt>
                <c:pt idx="450">
                  <c:v>927</c:v>
                </c:pt>
                <c:pt idx="451">
                  <c:v>928</c:v>
                </c:pt>
                <c:pt idx="452">
                  <c:v>931</c:v>
                </c:pt>
                <c:pt idx="453">
                  <c:v>932</c:v>
                </c:pt>
                <c:pt idx="454">
                  <c:v>933</c:v>
                </c:pt>
                <c:pt idx="455">
                  <c:v>934</c:v>
                </c:pt>
                <c:pt idx="456">
                  <c:v>937</c:v>
                </c:pt>
                <c:pt idx="457">
                  <c:v>941</c:v>
                </c:pt>
                <c:pt idx="458">
                  <c:v>942</c:v>
                </c:pt>
                <c:pt idx="459">
                  <c:v>944</c:v>
                </c:pt>
                <c:pt idx="460">
                  <c:v>945</c:v>
                </c:pt>
                <c:pt idx="461">
                  <c:v>946</c:v>
                </c:pt>
                <c:pt idx="462">
                  <c:v>947</c:v>
                </c:pt>
                <c:pt idx="463">
                  <c:v>950</c:v>
                </c:pt>
                <c:pt idx="464">
                  <c:v>951</c:v>
                </c:pt>
                <c:pt idx="465">
                  <c:v>953</c:v>
                </c:pt>
                <c:pt idx="466">
                  <c:v>954</c:v>
                </c:pt>
                <c:pt idx="467">
                  <c:v>955</c:v>
                </c:pt>
                <c:pt idx="468">
                  <c:v>956</c:v>
                </c:pt>
                <c:pt idx="469">
                  <c:v>957</c:v>
                </c:pt>
                <c:pt idx="470">
                  <c:v>958</c:v>
                </c:pt>
                <c:pt idx="471">
                  <c:v>959</c:v>
                </c:pt>
                <c:pt idx="472">
                  <c:v>960</c:v>
                </c:pt>
                <c:pt idx="473">
                  <c:v>961</c:v>
                </c:pt>
                <c:pt idx="474">
                  <c:v>962</c:v>
                </c:pt>
                <c:pt idx="475">
                  <c:v>970</c:v>
                </c:pt>
                <c:pt idx="476">
                  <c:v>971</c:v>
                </c:pt>
                <c:pt idx="477">
                  <c:v>972</c:v>
                </c:pt>
                <c:pt idx="478">
                  <c:v>973</c:v>
                </c:pt>
                <c:pt idx="479">
                  <c:v>975</c:v>
                </c:pt>
                <c:pt idx="480">
                  <c:v>980</c:v>
                </c:pt>
                <c:pt idx="481">
                  <c:v>983</c:v>
                </c:pt>
                <c:pt idx="482">
                  <c:v>988</c:v>
                </c:pt>
                <c:pt idx="483">
                  <c:v>989</c:v>
                </c:pt>
                <c:pt idx="484">
                  <c:v>990</c:v>
                </c:pt>
                <c:pt idx="485">
                  <c:v>992</c:v>
                </c:pt>
                <c:pt idx="486">
                  <c:v>993</c:v>
                </c:pt>
                <c:pt idx="487">
                  <c:v>994</c:v>
                </c:pt>
                <c:pt idx="488">
                  <c:v>995</c:v>
                </c:pt>
                <c:pt idx="489">
                  <c:v>997</c:v>
                </c:pt>
                <c:pt idx="490">
                  <c:v>998</c:v>
                </c:pt>
                <c:pt idx="491">
                  <c:v>1001</c:v>
                </c:pt>
                <c:pt idx="492">
                  <c:v>1002</c:v>
                </c:pt>
                <c:pt idx="493">
                  <c:v>1003</c:v>
                </c:pt>
                <c:pt idx="494">
                  <c:v>1006</c:v>
                </c:pt>
                <c:pt idx="495">
                  <c:v>1013</c:v>
                </c:pt>
                <c:pt idx="496">
                  <c:v>1014</c:v>
                </c:pt>
                <c:pt idx="497">
                  <c:v>1015</c:v>
                </c:pt>
                <c:pt idx="498">
                  <c:v>1017</c:v>
                </c:pt>
                <c:pt idx="499">
                  <c:v>1021</c:v>
                </c:pt>
                <c:pt idx="500">
                  <c:v>1023</c:v>
                </c:pt>
                <c:pt idx="501">
                  <c:v>1025</c:v>
                </c:pt>
                <c:pt idx="502">
                  <c:v>1026</c:v>
                </c:pt>
                <c:pt idx="503">
                  <c:v>1031</c:v>
                </c:pt>
                <c:pt idx="504">
                  <c:v>1033</c:v>
                </c:pt>
                <c:pt idx="505">
                  <c:v>1034</c:v>
                </c:pt>
                <c:pt idx="506">
                  <c:v>1037</c:v>
                </c:pt>
                <c:pt idx="507">
                  <c:v>1039</c:v>
                </c:pt>
                <c:pt idx="508">
                  <c:v>1040</c:v>
                </c:pt>
                <c:pt idx="509">
                  <c:v>1042</c:v>
                </c:pt>
                <c:pt idx="510">
                  <c:v>1045</c:v>
                </c:pt>
                <c:pt idx="511">
                  <c:v>1046</c:v>
                </c:pt>
                <c:pt idx="512">
                  <c:v>1048</c:v>
                </c:pt>
                <c:pt idx="513">
                  <c:v>1050</c:v>
                </c:pt>
                <c:pt idx="514">
                  <c:v>1052</c:v>
                </c:pt>
                <c:pt idx="515">
                  <c:v>1054</c:v>
                </c:pt>
                <c:pt idx="516">
                  <c:v>1055</c:v>
                </c:pt>
                <c:pt idx="517">
                  <c:v>1056</c:v>
                </c:pt>
                <c:pt idx="518">
                  <c:v>1058</c:v>
                </c:pt>
                <c:pt idx="519">
                  <c:v>1059</c:v>
                </c:pt>
                <c:pt idx="520">
                  <c:v>1060</c:v>
                </c:pt>
                <c:pt idx="521">
                  <c:v>1061</c:v>
                </c:pt>
                <c:pt idx="522">
                  <c:v>1067</c:v>
                </c:pt>
                <c:pt idx="523">
                  <c:v>1069</c:v>
                </c:pt>
                <c:pt idx="524">
                  <c:v>1072</c:v>
                </c:pt>
                <c:pt idx="525">
                  <c:v>1074</c:v>
                </c:pt>
                <c:pt idx="526">
                  <c:v>1076</c:v>
                </c:pt>
                <c:pt idx="527">
                  <c:v>1080</c:v>
                </c:pt>
                <c:pt idx="528">
                  <c:v>1083</c:v>
                </c:pt>
                <c:pt idx="529">
                  <c:v>1085</c:v>
                </c:pt>
                <c:pt idx="530">
                  <c:v>1086</c:v>
                </c:pt>
                <c:pt idx="531">
                  <c:v>1088</c:v>
                </c:pt>
                <c:pt idx="532">
                  <c:v>1089</c:v>
                </c:pt>
                <c:pt idx="533">
                  <c:v>1090</c:v>
                </c:pt>
                <c:pt idx="534">
                  <c:v>1091</c:v>
                </c:pt>
                <c:pt idx="535">
                  <c:v>1092</c:v>
                </c:pt>
                <c:pt idx="536">
                  <c:v>1093</c:v>
                </c:pt>
                <c:pt idx="537">
                  <c:v>1094</c:v>
                </c:pt>
                <c:pt idx="538">
                  <c:v>1095</c:v>
                </c:pt>
                <c:pt idx="539">
                  <c:v>1097</c:v>
                </c:pt>
                <c:pt idx="540">
                  <c:v>1101</c:v>
                </c:pt>
                <c:pt idx="541">
                  <c:v>1102</c:v>
                </c:pt>
                <c:pt idx="542">
                  <c:v>1103</c:v>
                </c:pt>
                <c:pt idx="543">
                  <c:v>1104</c:v>
                </c:pt>
                <c:pt idx="544">
                  <c:v>1106</c:v>
                </c:pt>
                <c:pt idx="545">
                  <c:v>1108</c:v>
                </c:pt>
                <c:pt idx="546">
                  <c:v>1111</c:v>
                </c:pt>
                <c:pt idx="547">
                  <c:v>1114</c:v>
                </c:pt>
                <c:pt idx="548">
                  <c:v>1116</c:v>
                </c:pt>
                <c:pt idx="549">
                  <c:v>1120</c:v>
                </c:pt>
                <c:pt idx="550">
                  <c:v>1125</c:v>
                </c:pt>
                <c:pt idx="551">
                  <c:v>1126</c:v>
                </c:pt>
                <c:pt idx="552">
                  <c:v>1127</c:v>
                </c:pt>
                <c:pt idx="553">
                  <c:v>1128</c:v>
                </c:pt>
                <c:pt idx="554">
                  <c:v>1129</c:v>
                </c:pt>
                <c:pt idx="555">
                  <c:v>1130</c:v>
                </c:pt>
                <c:pt idx="556">
                  <c:v>1133</c:v>
                </c:pt>
                <c:pt idx="557">
                  <c:v>1134</c:v>
                </c:pt>
                <c:pt idx="558">
                  <c:v>1135</c:v>
                </c:pt>
                <c:pt idx="559">
                  <c:v>1136</c:v>
                </c:pt>
                <c:pt idx="560">
                  <c:v>1138</c:v>
                </c:pt>
                <c:pt idx="561">
                  <c:v>1139</c:v>
                </c:pt>
                <c:pt idx="562">
                  <c:v>1140</c:v>
                </c:pt>
                <c:pt idx="563">
                  <c:v>1142</c:v>
                </c:pt>
                <c:pt idx="564">
                  <c:v>1143</c:v>
                </c:pt>
                <c:pt idx="565">
                  <c:v>1144</c:v>
                </c:pt>
                <c:pt idx="566">
                  <c:v>1145</c:v>
                </c:pt>
                <c:pt idx="567">
                  <c:v>1146</c:v>
                </c:pt>
                <c:pt idx="568">
                  <c:v>1148</c:v>
                </c:pt>
                <c:pt idx="569">
                  <c:v>1149</c:v>
                </c:pt>
                <c:pt idx="570">
                  <c:v>1150</c:v>
                </c:pt>
                <c:pt idx="571">
                  <c:v>1153</c:v>
                </c:pt>
                <c:pt idx="572">
                  <c:v>1158</c:v>
                </c:pt>
                <c:pt idx="573">
                  <c:v>1159</c:v>
                </c:pt>
                <c:pt idx="574">
                  <c:v>1160</c:v>
                </c:pt>
                <c:pt idx="575">
                  <c:v>1163</c:v>
                </c:pt>
                <c:pt idx="576">
                  <c:v>1166</c:v>
                </c:pt>
                <c:pt idx="577">
                  <c:v>1168</c:v>
                </c:pt>
                <c:pt idx="578">
                  <c:v>1169</c:v>
                </c:pt>
                <c:pt idx="579">
                  <c:v>1173</c:v>
                </c:pt>
                <c:pt idx="580">
                  <c:v>1174</c:v>
                </c:pt>
                <c:pt idx="581">
                  <c:v>1175</c:v>
                </c:pt>
                <c:pt idx="582">
                  <c:v>1177</c:v>
                </c:pt>
                <c:pt idx="583">
                  <c:v>1178</c:v>
                </c:pt>
                <c:pt idx="584">
                  <c:v>1182</c:v>
                </c:pt>
                <c:pt idx="585">
                  <c:v>1187</c:v>
                </c:pt>
                <c:pt idx="586">
                  <c:v>1188</c:v>
                </c:pt>
                <c:pt idx="587">
                  <c:v>1189</c:v>
                </c:pt>
                <c:pt idx="588">
                  <c:v>1190</c:v>
                </c:pt>
                <c:pt idx="589">
                  <c:v>1191</c:v>
                </c:pt>
                <c:pt idx="590">
                  <c:v>1192</c:v>
                </c:pt>
                <c:pt idx="591">
                  <c:v>1195</c:v>
                </c:pt>
                <c:pt idx="592">
                  <c:v>1198</c:v>
                </c:pt>
                <c:pt idx="593">
                  <c:v>1199</c:v>
                </c:pt>
                <c:pt idx="594">
                  <c:v>1200</c:v>
                </c:pt>
                <c:pt idx="595">
                  <c:v>1201</c:v>
                </c:pt>
                <c:pt idx="596">
                  <c:v>1202</c:v>
                </c:pt>
                <c:pt idx="597">
                  <c:v>1208</c:v>
                </c:pt>
                <c:pt idx="598">
                  <c:v>1210</c:v>
                </c:pt>
                <c:pt idx="599">
                  <c:v>1211</c:v>
                </c:pt>
                <c:pt idx="600">
                  <c:v>1212</c:v>
                </c:pt>
                <c:pt idx="601">
                  <c:v>1213</c:v>
                </c:pt>
                <c:pt idx="602">
                  <c:v>1214</c:v>
                </c:pt>
                <c:pt idx="603">
                  <c:v>1216</c:v>
                </c:pt>
                <c:pt idx="604">
                  <c:v>1217</c:v>
                </c:pt>
                <c:pt idx="605">
                  <c:v>1218</c:v>
                </c:pt>
                <c:pt idx="606">
                  <c:v>1219</c:v>
                </c:pt>
                <c:pt idx="607">
                  <c:v>1222</c:v>
                </c:pt>
                <c:pt idx="608">
                  <c:v>1223</c:v>
                </c:pt>
                <c:pt idx="609">
                  <c:v>1224</c:v>
                </c:pt>
                <c:pt idx="610">
                  <c:v>1225</c:v>
                </c:pt>
                <c:pt idx="611">
                  <c:v>1227</c:v>
                </c:pt>
                <c:pt idx="612">
                  <c:v>1230</c:v>
                </c:pt>
                <c:pt idx="613">
                  <c:v>1231</c:v>
                </c:pt>
                <c:pt idx="614">
                  <c:v>1232</c:v>
                </c:pt>
                <c:pt idx="615">
                  <c:v>1237</c:v>
                </c:pt>
                <c:pt idx="616">
                  <c:v>1238</c:v>
                </c:pt>
                <c:pt idx="617">
                  <c:v>1239</c:v>
                </c:pt>
                <c:pt idx="618">
                  <c:v>1242</c:v>
                </c:pt>
                <c:pt idx="619">
                  <c:v>1243</c:v>
                </c:pt>
                <c:pt idx="620">
                  <c:v>1244</c:v>
                </c:pt>
                <c:pt idx="621">
                  <c:v>1245</c:v>
                </c:pt>
                <c:pt idx="622">
                  <c:v>1246</c:v>
                </c:pt>
                <c:pt idx="623">
                  <c:v>1250</c:v>
                </c:pt>
                <c:pt idx="624">
                  <c:v>1251</c:v>
                </c:pt>
                <c:pt idx="625">
                  <c:v>1253</c:v>
                </c:pt>
                <c:pt idx="626">
                  <c:v>1254</c:v>
                </c:pt>
                <c:pt idx="627">
                  <c:v>1256</c:v>
                </c:pt>
                <c:pt idx="628">
                  <c:v>1260</c:v>
                </c:pt>
                <c:pt idx="629">
                  <c:v>1261</c:v>
                </c:pt>
                <c:pt idx="630">
                  <c:v>1262</c:v>
                </c:pt>
                <c:pt idx="631">
                  <c:v>1263</c:v>
                </c:pt>
                <c:pt idx="632">
                  <c:v>1265</c:v>
                </c:pt>
                <c:pt idx="633">
                  <c:v>1266</c:v>
                </c:pt>
                <c:pt idx="634">
                  <c:v>1270</c:v>
                </c:pt>
                <c:pt idx="635">
                  <c:v>1272</c:v>
                </c:pt>
                <c:pt idx="636">
                  <c:v>1274</c:v>
                </c:pt>
                <c:pt idx="637">
                  <c:v>1276</c:v>
                </c:pt>
                <c:pt idx="638">
                  <c:v>1278</c:v>
                </c:pt>
                <c:pt idx="639">
                  <c:v>1279</c:v>
                </c:pt>
                <c:pt idx="640">
                  <c:v>1280</c:v>
                </c:pt>
                <c:pt idx="641">
                  <c:v>1281</c:v>
                </c:pt>
                <c:pt idx="642">
                  <c:v>1283</c:v>
                </c:pt>
                <c:pt idx="643">
                  <c:v>1284</c:v>
                </c:pt>
                <c:pt idx="644">
                  <c:v>1285</c:v>
                </c:pt>
                <c:pt idx="645">
                  <c:v>1286</c:v>
                </c:pt>
                <c:pt idx="646">
                  <c:v>1287</c:v>
                </c:pt>
                <c:pt idx="647">
                  <c:v>1288</c:v>
                </c:pt>
                <c:pt idx="648">
                  <c:v>1291</c:v>
                </c:pt>
                <c:pt idx="649">
                  <c:v>1292</c:v>
                </c:pt>
                <c:pt idx="650">
                  <c:v>1294</c:v>
                </c:pt>
                <c:pt idx="651">
                  <c:v>1296</c:v>
                </c:pt>
                <c:pt idx="652">
                  <c:v>1300</c:v>
                </c:pt>
                <c:pt idx="653">
                  <c:v>1304</c:v>
                </c:pt>
                <c:pt idx="654">
                  <c:v>1305</c:v>
                </c:pt>
                <c:pt idx="655">
                  <c:v>1309</c:v>
                </c:pt>
                <c:pt idx="656">
                  <c:v>1312</c:v>
                </c:pt>
                <c:pt idx="657">
                  <c:v>1315</c:v>
                </c:pt>
                <c:pt idx="658">
                  <c:v>1318</c:v>
                </c:pt>
                <c:pt idx="659">
                  <c:v>1319</c:v>
                </c:pt>
                <c:pt idx="660">
                  <c:v>1320</c:v>
                </c:pt>
                <c:pt idx="661">
                  <c:v>1321</c:v>
                </c:pt>
                <c:pt idx="662">
                  <c:v>1324</c:v>
                </c:pt>
                <c:pt idx="663">
                  <c:v>1326</c:v>
                </c:pt>
                <c:pt idx="664">
                  <c:v>1327</c:v>
                </c:pt>
                <c:pt idx="665">
                  <c:v>1328</c:v>
                </c:pt>
                <c:pt idx="666">
                  <c:v>1330</c:v>
                </c:pt>
                <c:pt idx="667">
                  <c:v>1332</c:v>
                </c:pt>
                <c:pt idx="668">
                  <c:v>1337</c:v>
                </c:pt>
                <c:pt idx="669">
                  <c:v>1338</c:v>
                </c:pt>
                <c:pt idx="670">
                  <c:v>1339</c:v>
                </c:pt>
                <c:pt idx="671">
                  <c:v>1340</c:v>
                </c:pt>
                <c:pt idx="672">
                  <c:v>1341</c:v>
                </c:pt>
                <c:pt idx="673">
                  <c:v>1342</c:v>
                </c:pt>
                <c:pt idx="674">
                  <c:v>1346</c:v>
                </c:pt>
                <c:pt idx="675">
                  <c:v>1349</c:v>
                </c:pt>
                <c:pt idx="676">
                  <c:v>1350</c:v>
                </c:pt>
                <c:pt idx="677">
                  <c:v>1352</c:v>
                </c:pt>
                <c:pt idx="678">
                  <c:v>1353</c:v>
                </c:pt>
                <c:pt idx="679">
                  <c:v>1354</c:v>
                </c:pt>
                <c:pt idx="680">
                  <c:v>1358</c:v>
                </c:pt>
                <c:pt idx="681">
                  <c:v>1359</c:v>
                </c:pt>
                <c:pt idx="682">
                  <c:v>1360</c:v>
                </c:pt>
                <c:pt idx="683">
                  <c:v>1363</c:v>
                </c:pt>
                <c:pt idx="684">
                  <c:v>1369</c:v>
                </c:pt>
                <c:pt idx="685">
                  <c:v>1370</c:v>
                </c:pt>
                <c:pt idx="686">
                  <c:v>1377</c:v>
                </c:pt>
                <c:pt idx="687">
                  <c:v>1379</c:v>
                </c:pt>
                <c:pt idx="688">
                  <c:v>1380</c:v>
                </c:pt>
                <c:pt idx="689">
                  <c:v>1381</c:v>
                </c:pt>
                <c:pt idx="690">
                  <c:v>1382</c:v>
                </c:pt>
                <c:pt idx="691">
                  <c:v>1385</c:v>
                </c:pt>
                <c:pt idx="692">
                  <c:v>1387</c:v>
                </c:pt>
                <c:pt idx="693">
                  <c:v>1388</c:v>
                </c:pt>
                <c:pt idx="694">
                  <c:v>1390</c:v>
                </c:pt>
                <c:pt idx="695">
                  <c:v>1391</c:v>
                </c:pt>
                <c:pt idx="696">
                  <c:v>1392</c:v>
                </c:pt>
                <c:pt idx="697">
                  <c:v>1393</c:v>
                </c:pt>
                <c:pt idx="698">
                  <c:v>1394</c:v>
                </c:pt>
                <c:pt idx="699">
                  <c:v>1395</c:v>
                </c:pt>
                <c:pt idx="700">
                  <c:v>1396</c:v>
                </c:pt>
                <c:pt idx="701">
                  <c:v>1398</c:v>
                </c:pt>
                <c:pt idx="702">
                  <c:v>1400</c:v>
                </c:pt>
                <c:pt idx="703">
                  <c:v>1401</c:v>
                </c:pt>
                <c:pt idx="704">
                  <c:v>1402</c:v>
                </c:pt>
                <c:pt idx="705">
                  <c:v>1404</c:v>
                </c:pt>
                <c:pt idx="706">
                  <c:v>1405</c:v>
                </c:pt>
                <c:pt idx="707">
                  <c:v>1407</c:v>
                </c:pt>
                <c:pt idx="708">
                  <c:v>1409</c:v>
                </c:pt>
                <c:pt idx="709">
                  <c:v>1410</c:v>
                </c:pt>
                <c:pt idx="710">
                  <c:v>1411</c:v>
                </c:pt>
                <c:pt idx="711">
                  <c:v>1412</c:v>
                </c:pt>
                <c:pt idx="712">
                  <c:v>1413</c:v>
                </c:pt>
                <c:pt idx="713">
                  <c:v>1414</c:v>
                </c:pt>
                <c:pt idx="714">
                  <c:v>1416</c:v>
                </c:pt>
                <c:pt idx="715">
                  <c:v>1418</c:v>
                </c:pt>
                <c:pt idx="716">
                  <c:v>1419</c:v>
                </c:pt>
                <c:pt idx="717">
                  <c:v>1421</c:v>
                </c:pt>
                <c:pt idx="718">
                  <c:v>1422</c:v>
                </c:pt>
                <c:pt idx="719">
                  <c:v>1423</c:v>
                </c:pt>
                <c:pt idx="720">
                  <c:v>1424</c:v>
                </c:pt>
                <c:pt idx="721">
                  <c:v>1432</c:v>
                </c:pt>
                <c:pt idx="722">
                  <c:v>1433</c:v>
                </c:pt>
                <c:pt idx="723">
                  <c:v>1434</c:v>
                </c:pt>
                <c:pt idx="724">
                  <c:v>1438</c:v>
                </c:pt>
                <c:pt idx="725">
                  <c:v>1441</c:v>
                </c:pt>
                <c:pt idx="726">
                  <c:v>1442</c:v>
                </c:pt>
                <c:pt idx="727">
                  <c:v>1447</c:v>
                </c:pt>
                <c:pt idx="728">
                  <c:v>1448</c:v>
                </c:pt>
                <c:pt idx="729">
                  <c:v>1449</c:v>
                </c:pt>
                <c:pt idx="730">
                  <c:v>1452</c:v>
                </c:pt>
                <c:pt idx="731">
                  <c:v>1453</c:v>
                </c:pt>
                <c:pt idx="732">
                  <c:v>1454</c:v>
                </c:pt>
                <c:pt idx="733">
                  <c:v>1455</c:v>
                </c:pt>
                <c:pt idx="734">
                  <c:v>1457</c:v>
                </c:pt>
                <c:pt idx="735">
                  <c:v>1459</c:v>
                </c:pt>
                <c:pt idx="736">
                  <c:v>1463</c:v>
                </c:pt>
                <c:pt idx="737">
                  <c:v>1464</c:v>
                </c:pt>
                <c:pt idx="738">
                  <c:v>1465</c:v>
                </c:pt>
                <c:pt idx="739">
                  <c:v>1466</c:v>
                </c:pt>
                <c:pt idx="740">
                  <c:v>1472</c:v>
                </c:pt>
                <c:pt idx="741">
                  <c:v>1474</c:v>
                </c:pt>
                <c:pt idx="742">
                  <c:v>1478</c:v>
                </c:pt>
                <c:pt idx="743">
                  <c:v>1479</c:v>
                </c:pt>
                <c:pt idx="744">
                  <c:v>1481</c:v>
                </c:pt>
                <c:pt idx="745">
                  <c:v>1482</c:v>
                </c:pt>
                <c:pt idx="746">
                  <c:v>1483</c:v>
                </c:pt>
                <c:pt idx="747">
                  <c:v>1484</c:v>
                </c:pt>
                <c:pt idx="748">
                  <c:v>1486</c:v>
                </c:pt>
                <c:pt idx="749">
                  <c:v>1490</c:v>
                </c:pt>
                <c:pt idx="750">
                  <c:v>1491</c:v>
                </c:pt>
                <c:pt idx="751">
                  <c:v>1492</c:v>
                </c:pt>
                <c:pt idx="752">
                  <c:v>1495</c:v>
                </c:pt>
                <c:pt idx="753">
                  <c:v>1498</c:v>
                </c:pt>
                <c:pt idx="754">
                  <c:v>1499</c:v>
                </c:pt>
                <c:pt idx="755">
                  <c:v>1501</c:v>
                </c:pt>
                <c:pt idx="756">
                  <c:v>1502</c:v>
                </c:pt>
                <c:pt idx="757">
                  <c:v>1503</c:v>
                </c:pt>
                <c:pt idx="758">
                  <c:v>1504</c:v>
                </c:pt>
                <c:pt idx="759">
                  <c:v>1505</c:v>
                </c:pt>
                <c:pt idx="760">
                  <c:v>1508</c:v>
                </c:pt>
                <c:pt idx="761">
                  <c:v>1509</c:v>
                </c:pt>
                <c:pt idx="762">
                  <c:v>1510</c:v>
                </c:pt>
                <c:pt idx="763">
                  <c:v>1511</c:v>
                </c:pt>
                <c:pt idx="764">
                  <c:v>1512</c:v>
                </c:pt>
                <c:pt idx="765">
                  <c:v>1513</c:v>
                </c:pt>
                <c:pt idx="766">
                  <c:v>1514</c:v>
                </c:pt>
                <c:pt idx="767">
                  <c:v>1515</c:v>
                </c:pt>
                <c:pt idx="768">
                  <c:v>1518</c:v>
                </c:pt>
                <c:pt idx="769">
                  <c:v>1519</c:v>
                </c:pt>
                <c:pt idx="770">
                  <c:v>1520</c:v>
                </c:pt>
                <c:pt idx="771">
                  <c:v>1521</c:v>
                </c:pt>
                <c:pt idx="772">
                  <c:v>1522</c:v>
                </c:pt>
                <c:pt idx="773">
                  <c:v>1525</c:v>
                </c:pt>
                <c:pt idx="774">
                  <c:v>1529</c:v>
                </c:pt>
                <c:pt idx="775">
                  <c:v>1536</c:v>
                </c:pt>
                <c:pt idx="776">
                  <c:v>1538</c:v>
                </c:pt>
                <c:pt idx="777">
                  <c:v>1539</c:v>
                </c:pt>
                <c:pt idx="778">
                  <c:v>1540</c:v>
                </c:pt>
                <c:pt idx="779">
                  <c:v>1543</c:v>
                </c:pt>
                <c:pt idx="780">
                  <c:v>1548</c:v>
                </c:pt>
                <c:pt idx="781">
                  <c:v>1552</c:v>
                </c:pt>
                <c:pt idx="782">
                  <c:v>1553</c:v>
                </c:pt>
                <c:pt idx="783">
                  <c:v>1554</c:v>
                </c:pt>
                <c:pt idx="784">
                  <c:v>1555</c:v>
                </c:pt>
                <c:pt idx="785">
                  <c:v>1556</c:v>
                </c:pt>
                <c:pt idx="786">
                  <c:v>1558</c:v>
                </c:pt>
                <c:pt idx="787">
                  <c:v>1561</c:v>
                </c:pt>
                <c:pt idx="788">
                  <c:v>1562</c:v>
                </c:pt>
                <c:pt idx="789">
                  <c:v>1563</c:v>
                </c:pt>
                <c:pt idx="790">
                  <c:v>1567</c:v>
                </c:pt>
                <c:pt idx="791">
                  <c:v>1571</c:v>
                </c:pt>
                <c:pt idx="792">
                  <c:v>1574</c:v>
                </c:pt>
                <c:pt idx="793">
                  <c:v>1578</c:v>
                </c:pt>
                <c:pt idx="794">
                  <c:v>1579</c:v>
                </c:pt>
                <c:pt idx="795">
                  <c:v>1580</c:v>
                </c:pt>
                <c:pt idx="796">
                  <c:v>1581</c:v>
                </c:pt>
                <c:pt idx="797">
                  <c:v>1582</c:v>
                </c:pt>
                <c:pt idx="798">
                  <c:v>1583</c:v>
                </c:pt>
                <c:pt idx="799">
                  <c:v>1585</c:v>
                </c:pt>
                <c:pt idx="800">
                  <c:v>1586</c:v>
                </c:pt>
                <c:pt idx="801">
                  <c:v>1587</c:v>
                </c:pt>
                <c:pt idx="802">
                  <c:v>1589</c:v>
                </c:pt>
                <c:pt idx="803">
                  <c:v>1590</c:v>
                </c:pt>
                <c:pt idx="804">
                  <c:v>1591</c:v>
                </c:pt>
                <c:pt idx="805">
                  <c:v>1592</c:v>
                </c:pt>
                <c:pt idx="806">
                  <c:v>1596</c:v>
                </c:pt>
                <c:pt idx="807">
                  <c:v>1597</c:v>
                </c:pt>
                <c:pt idx="808">
                  <c:v>1600</c:v>
                </c:pt>
                <c:pt idx="809">
                  <c:v>1601</c:v>
                </c:pt>
                <c:pt idx="810">
                  <c:v>1602</c:v>
                </c:pt>
                <c:pt idx="811">
                  <c:v>1604</c:v>
                </c:pt>
                <c:pt idx="812">
                  <c:v>1606</c:v>
                </c:pt>
                <c:pt idx="813">
                  <c:v>1608</c:v>
                </c:pt>
                <c:pt idx="814">
                  <c:v>1609</c:v>
                </c:pt>
                <c:pt idx="815">
                  <c:v>1612</c:v>
                </c:pt>
                <c:pt idx="816">
                  <c:v>1614</c:v>
                </c:pt>
                <c:pt idx="817">
                  <c:v>1615</c:v>
                </c:pt>
                <c:pt idx="818">
                  <c:v>1617</c:v>
                </c:pt>
                <c:pt idx="819">
                  <c:v>1619</c:v>
                </c:pt>
                <c:pt idx="820">
                  <c:v>1620</c:v>
                </c:pt>
                <c:pt idx="821">
                  <c:v>1627</c:v>
                </c:pt>
                <c:pt idx="822">
                  <c:v>1628</c:v>
                </c:pt>
                <c:pt idx="823">
                  <c:v>1629</c:v>
                </c:pt>
                <c:pt idx="824">
                  <c:v>1631</c:v>
                </c:pt>
                <c:pt idx="825">
                  <c:v>1632</c:v>
                </c:pt>
                <c:pt idx="826">
                  <c:v>1633</c:v>
                </c:pt>
                <c:pt idx="827">
                  <c:v>1635</c:v>
                </c:pt>
                <c:pt idx="828">
                  <c:v>1636</c:v>
                </c:pt>
                <c:pt idx="829">
                  <c:v>1641</c:v>
                </c:pt>
                <c:pt idx="830">
                  <c:v>1642</c:v>
                </c:pt>
                <c:pt idx="831">
                  <c:v>1644</c:v>
                </c:pt>
                <c:pt idx="832">
                  <c:v>1648</c:v>
                </c:pt>
                <c:pt idx="833">
                  <c:v>1649</c:v>
                </c:pt>
                <c:pt idx="834">
                  <c:v>1650</c:v>
                </c:pt>
                <c:pt idx="835">
                  <c:v>1655</c:v>
                </c:pt>
                <c:pt idx="836">
                  <c:v>1656</c:v>
                </c:pt>
                <c:pt idx="837">
                  <c:v>1657</c:v>
                </c:pt>
                <c:pt idx="838">
                  <c:v>1659</c:v>
                </c:pt>
                <c:pt idx="839">
                  <c:v>1661</c:v>
                </c:pt>
                <c:pt idx="840">
                  <c:v>1662</c:v>
                </c:pt>
                <c:pt idx="841">
                  <c:v>1663</c:v>
                </c:pt>
                <c:pt idx="842">
                  <c:v>1664</c:v>
                </c:pt>
                <c:pt idx="843">
                  <c:v>1665</c:v>
                </c:pt>
                <c:pt idx="844">
                  <c:v>1668</c:v>
                </c:pt>
                <c:pt idx="845">
                  <c:v>1670</c:v>
                </c:pt>
                <c:pt idx="846">
                  <c:v>1673</c:v>
                </c:pt>
                <c:pt idx="847">
                  <c:v>1676</c:v>
                </c:pt>
                <c:pt idx="848">
                  <c:v>1679</c:v>
                </c:pt>
                <c:pt idx="849">
                  <c:v>1681</c:v>
                </c:pt>
                <c:pt idx="850">
                  <c:v>1683</c:v>
                </c:pt>
                <c:pt idx="851">
                  <c:v>1687</c:v>
                </c:pt>
                <c:pt idx="852">
                  <c:v>1689</c:v>
                </c:pt>
                <c:pt idx="853">
                  <c:v>1690</c:v>
                </c:pt>
                <c:pt idx="854">
                  <c:v>1691</c:v>
                </c:pt>
                <c:pt idx="855">
                  <c:v>1694</c:v>
                </c:pt>
                <c:pt idx="856">
                  <c:v>1695</c:v>
                </c:pt>
                <c:pt idx="857">
                  <c:v>1697</c:v>
                </c:pt>
                <c:pt idx="858">
                  <c:v>1698</c:v>
                </c:pt>
                <c:pt idx="859">
                  <c:v>1699</c:v>
                </c:pt>
                <c:pt idx="860">
                  <c:v>1700</c:v>
                </c:pt>
                <c:pt idx="861">
                  <c:v>1701</c:v>
                </c:pt>
                <c:pt idx="862">
                  <c:v>1702</c:v>
                </c:pt>
                <c:pt idx="863">
                  <c:v>1703</c:v>
                </c:pt>
                <c:pt idx="864">
                  <c:v>1706</c:v>
                </c:pt>
                <c:pt idx="865">
                  <c:v>1707</c:v>
                </c:pt>
                <c:pt idx="866">
                  <c:v>1708</c:v>
                </c:pt>
                <c:pt idx="867">
                  <c:v>1709</c:v>
                </c:pt>
                <c:pt idx="868">
                  <c:v>1715</c:v>
                </c:pt>
                <c:pt idx="869">
                  <c:v>1718</c:v>
                </c:pt>
                <c:pt idx="870">
                  <c:v>1719</c:v>
                </c:pt>
                <c:pt idx="871">
                  <c:v>1720</c:v>
                </c:pt>
                <c:pt idx="872">
                  <c:v>1721</c:v>
                </c:pt>
                <c:pt idx="873">
                  <c:v>1722</c:v>
                </c:pt>
                <c:pt idx="874">
                  <c:v>1726</c:v>
                </c:pt>
                <c:pt idx="875">
                  <c:v>1729</c:v>
                </c:pt>
                <c:pt idx="876">
                  <c:v>1730</c:v>
                </c:pt>
                <c:pt idx="877">
                  <c:v>1731</c:v>
                </c:pt>
                <c:pt idx="878">
                  <c:v>1732</c:v>
                </c:pt>
                <c:pt idx="879">
                  <c:v>1733</c:v>
                </c:pt>
                <c:pt idx="880">
                  <c:v>1735</c:v>
                </c:pt>
                <c:pt idx="881">
                  <c:v>1736</c:v>
                </c:pt>
                <c:pt idx="882">
                  <c:v>1739</c:v>
                </c:pt>
                <c:pt idx="883">
                  <c:v>1741</c:v>
                </c:pt>
                <c:pt idx="884">
                  <c:v>1743</c:v>
                </c:pt>
                <c:pt idx="885">
                  <c:v>1745</c:v>
                </c:pt>
                <c:pt idx="886">
                  <c:v>1746</c:v>
                </c:pt>
                <c:pt idx="887">
                  <c:v>1748</c:v>
                </c:pt>
                <c:pt idx="888">
                  <c:v>1749</c:v>
                </c:pt>
                <c:pt idx="889">
                  <c:v>1760</c:v>
                </c:pt>
                <c:pt idx="890">
                  <c:v>1768</c:v>
                </c:pt>
                <c:pt idx="891">
                  <c:v>1772</c:v>
                </c:pt>
                <c:pt idx="892">
                  <c:v>1773</c:v>
                </c:pt>
                <c:pt idx="893">
                  <c:v>1778</c:v>
                </c:pt>
                <c:pt idx="894">
                  <c:v>1781</c:v>
                </c:pt>
                <c:pt idx="895">
                  <c:v>1784</c:v>
                </c:pt>
                <c:pt idx="896">
                  <c:v>1785</c:v>
                </c:pt>
                <c:pt idx="897">
                  <c:v>1788</c:v>
                </c:pt>
                <c:pt idx="898">
                  <c:v>1789</c:v>
                </c:pt>
                <c:pt idx="899">
                  <c:v>1791</c:v>
                </c:pt>
                <c:pt idx="900">
                  <c:v>1793</c:v>
                </c:pt>
                <c:pt idx="901">
                  <c:v>1794</c:v>
                </c:pt>
                <c:pt idx="902">
                  <c:v>1795</c:v>
                </c:pt>
                <c:pt idx="903">
                  <c:v>1796</c:v>
                </c:pt>
                <c:pt idx="904">
                  <c:v>1799</c:v>
                </c:pt>
                <c:pt idx="905">
                  <c:v>1800</c:v>
                </c:pt>
                <c:pt idx="906">
                  <c:v>1803</c:v>
                </c:pt>
                <c:pt idx="907">
                  <c:v>1805</c:v>
                </c:pt>
                <c:pt idx="908">
                  <c:v>1806</c:v>
                </c:pt>
                <c:pt idx="909">
                  <c:v>1807</c:v>
                </c:pt>
                <c:pt idx="910">
                  <c:v>1808</c:v>
                </c:pt>
                <c:pt idx="911">
                  <c:v>1809</c:v>
                </c:pt>
                <c:pt idx="912">
                  <c:v>1810</c:v>
                </c:pt>
                <c:pt idx="913">
                  <c:v>1812</c:v>
                </c:pt>
                <c:pt idx="914">
                  <c:v>1814</c:v>
                </c:pt>
                <c:pt idx="915">
                  <c:v>1818</c:v>
                </c:pt>
                <c:pt idx="916">
                  <c:v>1819</c:v>
                </c:pt>
                <c:pt idx="917">
                  <c:v>1826</c:v>
                </c:pt>
                <c:pt idx="918">
                  <c:v>1827</c:v>
                </c:pt>
                <c:pt idx="919">
                  <c:v>1828</c:v>
                </c:pt>
                <c:pt idx="920">
                  <c:v>1830</c:v>
                </c:pt>
                <c:pt idx="921">
                  <c:v>1834</c:v>
                </c:pt>
                <c:pt idx="922">
                  <c:v>1837</c:v>
                </c:pt>
                <c:pt idx="923">
                  <c:v>1838</c:v>
                </c:pt>
                <c:pt idx="924">
                  <c:v>1839</c:v>
                </c:pt>
                <c:pt idx="925">
                  <c:v>1840</c:v>
                </c:pt>
                <c:pt idx="926">
                  <c:v>1842</c:v>
                </c:pt>
                <c:pt idx="927">
                  <c:v>1843</c:v>
                </c:pt>
                <c:pt idx="928">
                  <c:v>1844</c:v>
                </c:pt>
                <c:pt idx="929">
                  <c:v>1845</c:v>
                </c:pt>
                <c:pt idx="930">
                  <c:v>1846</c:v>
                </c:pt>
                <c:pt idx="931">
                  <c:v>1848</c:v>
                </c:pt>
                <c:pt idx="932">
                  <c:v>1850</c:v>
                </c:pt>
                <c:pt idx="933">
                  <c:v>1851</c:v>
                </c:pt>
                <c:pt idx="934">
                  <c:v>1852</c:v>
                </c:pt>
                <c:pt idx="935">
                  <c:v>1853</c:v>
                </c:pt>
                <c:pt idx="936">
                  <c:v>1854</c:v>
                </c:pt>
                <c:pt idx="937">
                  <c:v>1855</c:v>
                </c:pt>
                <c:pt idx="938">
                  <c:v>1856</c:v>
                </c:pt>
                <c:pt idx="939">
                  <c:v>1859</c:v>
                </c:pt>
                <c:pt idx="940">
                  <c:v>1860</c:v>
                </c:pt>
                <c:pt idx="941">
                  <c:v>1861</c:v>
                </c:pt>
                <c:pt idx="942">
                  <c:v>1867</c:v>
                </c:pt>
                <c:pt idx="943">
                  <c:v>1868</c:v>
                </c:pt>
                <c:pt idx="944">
                  <c:v>1869</c:v>
                </c:pt>
                <c:pt idx="945">
                  <c:v>1871</c:v>
                </c:pt>
                <c:pt idx="946">
                  <c:v>1872</c:v>
                </c:pt>
                <c:pt idx="947">
                  <c:v>1875</c:v>
                </c:pt>
                <c:pt idx="948">
                  <c:v>1876</c:v>
                </c:pt>
                <c:pt idx="949">
                  <c:v>1878</c:v>
                </c:pt>
                <c:pt idx="950">
                  <c:v>1879</c:v>
                </c:pt>
                <c:pt idx="951">
                  <c:v>1880</c:v>
                </c:pt>
                <c:pt idx="952">
                  <c:v>1881</c:v>
                </c:pt>
                <c:pt idx="953">
                  <c:v>1883</c:v>
                </c:pt>
                <c:pt idx="954">
                  <c:v>1884</c:v>
                </c:pt>
                <c:pt idx="955">
                  <c:v>1886</c:v>
                </c:pt>
                <c:pt idx="956">
                  <c:v>1887</c:v>
                </c:pt>
                <c:pt idx="957">
                  <c:v>1888</c:v>
                </c:pt>
                <c:pt idx="958">
                  <c:v>1890</c:v>
                </c:pt>
                <c:pt idx="959">
                  <c:v>1892</c:v>
                </c:pt>
                <c:pt idx="960">
                  <c:v>1895</c:v>
                </c:pt>
                <c:pt idx="961">
                  <c:v>1897</c:v>
                </c:pt>
                <c:pt idx="962">
                  <c:v>1899</c:v>
                </c:pt>
                <c:pt idx="963">
                  <c:v>1900</c:v>
                </c:pt>
                <c:pt idx="964">
                  <c:v>1904</c:v>
                </c:pt>
                <c:pt idx="965">
                  <c:v>1905</c:v>
                </c:pt>
                <c:pt idx="966">
                  <c:v>1908</c:v>
                </c:pt>
                <c:pt idx="967">
                  <c:v>1909</c:v>
                </c:pt>
                <c:pt idx="968">
                  <c:v>1913</c:v>
                </c:pt>
                <c:pt idx="969">
                  <c:v>1914</c:v>
                </c:pt>
                <c:pt idx="970">
                  <c:v>1915</c:v>
                </c:pt>
                <c:pt idx="971">
                  <c:v>1916</c:v>
                </c:pt>
                <c:pt idx="972">
                  <c:v>1918</c:v>
                </c:pt>
                <c:pt idx="973">
                  <c:v>1920</c:v>
                </c:pt>
                <c:pt idx="974">
                  <c:v>1921</c:v>
                </c:pt>
                <c:pt idx="975">
                  <c:v>1923</c:v>
                </c:pt>
                <c:pt idx="976">
                  <c:v>1924</c:v>
                </c:pt>
                <c:pt idx="977">
                  <c:v>1925</c:v>
                </c:pt>
                <c:pt idx="978">
                  <c:v>1930</c:v>
                </c:pt>
                <c:pt idx="979">
                  <c:v>1931</c:v>
                </c:pt>
                <c:pt idx="980">
                  <c:v>1932</c:v>
                </c:pt>
                <c:pt idx="981">
                  <c:v>1934</c:v>
                </c:pt>
                <c:pt idx="982">
                  <c:v>1936</c:v>
                </c:pt>
                <c:pt idx="983">
                  <c:v>1937</c:v>
                </c:pt>
                <c:pt idx="984">
                  <c:v>1938</c:v>
                </c:pt>
                <c:pt idx="985">
                  <c:v>1940</c:v>
                </c:pt>
                <c:pt idx="986">
                  <c:v>1942</c:v>
                </c:pt>
                <c:pt idx="987">
                  <c:v>1943</c:v>
                </c:pt>
                <c:pt idx="988">
                  <c:v>1944</c:v>
                </c:pt>
                <c:pt idx="989">
                  <c:v>1945</c:v>
                </c:pt>
                <c:pt idx="990">
                  <c:v>1947</c:v>
                </c:pt>
                <c:pt idx="991">
                  <c:v>1956</c:v>
                </c:pt>
                <c:pt idx="992">
                  <c:v>1957</c:v>
                </c:pt>
                <c:pt idx="993">
                  <c:v>1959</c:v>
                </c:pt>
                <c:pt idx="994">
                  <c:v>1961</c:v>
                </c:pt>
                <c:pt idx="995">
                  <c:v>1964</c:v>
                </c:pt>
                <c:pt idx="996">
                  <c:v>1966</c:v>
                </c:pt>
                <c:pt idx="997">
                  <c:v>1967</c:v>
                </c:pt>
                <c:pt idx="998">
                  <c:v>1974</c:v>
                </c:pt>
                <c:pt idx="999">
                  <c:v>1977</c:v>
                </c:pt>
                <c:pt idx="1000">
                  <c:v>1981</c:v>
                </c:pt>
                <c:pt idx="1001">
                  <c:v>1982</c:v>
                </c:pt>
                <c:pt idx="1002">
                  <c:v>1983</c:v>
                </c:pt>
                <c:pt idx="1003">
                  <c:v>1984</c:v>
                </c:pt>
                <c:pt idx="1004">
                  <c:v>1989</c:v>
                </c:pt>
                <c:pt idx="1005">
                  <c:v>1990</c:v>
                </c:pt>
                <c:pt idx="1006">
                  <c:v>1993</c:v>
                </c:pt>
                <c:pt idx="1007">
                  <c:v>1994</c:v>
                </c:pt>
                <c:pt idx="1008">
                  <c:v>1995</c:v>
                </c:pt>
                <c:pt idx="1009">
                  <c:v>1996</c:v>
                </c:pt>
                <c:pt idx="1010">
                  <c:v>1997</c:v>
                </c:pt>
                <c:pt idx="1011">
                  <c:v>1998</c:v>
                </c:pt>
                <c:pt idx="1012">
                  <c:v>1999</c:v>
                </c:pt>
                <c:pt idx="1013">
                  <c:v>2000</c:v>
                </c:pt>
                <c:pt idx="1014">
                  <c:v>2001</c:v>
                </c:pt>
                <c:pt idx="1015">
                  <c:v>2002</c:v>
                </c:pt>
                <c:pt idx="1016">
                  <c:v>2003</c:v>
                </c:pt>
                <c:pt idx="1017">
                  <c:v>2005</c:v>
                </c:pt>
                <c:pt idx="1018">
                  <c:v>2006</c:v>
                </c:pt>
                <c:pt idx="1019">
                  <c:v>2007</c:v>
                </c:pt>
                <c:pt idx="1020">
                  <c:v>2008</c:v>
                </c:pt>
                <c:pt idx="1021">
                  <c:v>2009</c:v>
                </c:pt>
                <c:pt idx="1022">
                  <c:v>2011</c:v>
                </c:pt>
                <c:pt idx="1023">
                  <c:v>2012</c:v>
                </c:pt>
                <c:pt idx="1024">
                  <c:v>2013</c:v>
                </c:pt>
                <c:pt idx="1025">
                  <c:v>2014</c:v>
                </c:pt>
                <c:pt idx="1026">
                  <c:v>2015</c:v>
                </c:pt>
                <c:pt idx="1027">
                  <c:v>2016</c:v>
                </c:pt>
                <c:pt idx="1028">
                  <c:v>2017</c:v>
                </c:pt>
                <c:pt idx="1029">
                  <c:v>2018</c:v>
                </c:pt>
                <c:pt idx="1030">
                  <c:v>2019</c:v>
                </c:pt>
                <c:pt idx="1031">
                  <c:v>2021</c:v>
                </c:pt>
                <c:pt idx="1032">
                  <c:v>2022</c:v>
                </c:pt>
                <c:pt idx="1033">
                  <c:v>2023</c:v>
                </c:pt>
                <c:pt idx="1034">
                  <c:v>2024</c:v>
                </c:pt>
                <c:pt idx="1035">
                  <c:v>2028</c:v>
                </c:pt>
                <c:pt idx="1036">
                  <c:v>2034</c:v>
                </c:pt>
                <c:pt idx="1037">
                  <c:v>2036</c:v>
                </c:pt>
                <c:pt idx="1038">
                  <c:v>2037</c:v>
                </c:pt>
                <c:pt idx="1039">
                  <c:v>2041</c:v>
                </c:pt>
                <c:pt idx="1040">
                  <c:v>2042</c:v>
                </c:pt>
                <c:pt idx="1041">
                  <c:v>2043</c:v>
                </c:pt>
                <c:pt idx="1042">
                  <c:v>2045</c:v>
                </c:pt>
                <c:pt idx="1043">
                  <c:v>2047</c:v>
                </c:pt>
                <c:pt idx="1044">
                  <c:v>2050</c:v>
                </c:pt>
                <c:pt idx="1045">
                  <c:v>2051</c:v>
                </c:pt>
                <c:pt idx="1046">
                  <c:v>2052</c:v>
                </c:pt>
                <c:pt idx="1047">
                  <c:v>2057</c:v>
                </c:pt>
                <c:pt idx="1048">
                  <c:v>2059</c:v>
                </c:pt>
                <c:pt idx="1049">
                  <c:v>2060</c:v>
                </c:pt>
                <c:pt idx="1050">
                  <c:v>2062</c:v>
                </c:pt>
                <c:pt idx="1051">
                  <c:v>2063</c:v>
                </c:pt>
                <c:pt idx="1052">
                  <c:v>2066</c:v>
                </c:pt>
                <c:pt idx="1053">
                  <c:v>2069</c:v>
                </c:pt>
                <c:pt idx="1054">
                  <c:v>2072</c:v>
                </c:pt>
                <c:pt idx="1055">
                  <c:v>2073</c:v>
                </c:pt>
                <c:pt idx="1056">
                  <c:v>2074</c:v>
                </c:pt>
                <c:pt idx="1057">
                  <c:v>2075</c:v>
                </c:pt>
                <c:pt idx="1058">
                  <c:v>2078</c:v>
                </c:pt>
                <c:pt idx="1059">
                  <c:v>2079</c:v>
                </c:pt>
                <c:pt idx="1060">
                  <c:v>2081</c:v>
                </c:pt>
                <c:pt idx="1061">
                  <c:v>2088</c:v>
                </c:pt>
                <c:pt idx="1062">
                  <c:v>2089</c:v>
                </c:pt>
                <c:pt idx="1063">
                  <c:v>2094</c:v>
                </c:pt>
                <c:pt idx="1064">
                  <c:v>2095</c:v>
                </c:pt>
                <c:pt idx="1065">
                  <c:v>2097</c:v>
                </c:pt>
                <c:pt idx="1066">
                  <c:v>2100</c:v>
                </c:pt>
                <c:pt idx="1067">
                  <c:v>2101</c:v>
                </c:pt>
                <c:pt idx="1068">
                  <c:v>2102</c:v>
                </c:pt>
                <c:pt idx="1069">
                  <c:v>2104</c:v>
                </c:pt>
                <c:pt idx="1070">
                  <c:v>2105</c:v>
                </c:pt>
                <c:pt idx="1071">
                  <c:v>2109</c:v>
                </c:pt>
                <c:pt idx="1072">
                  <c:v>2114</c:v>
                </c:pt>
                <c:pt idx="1073">
                  <c:v>2117</c:v>
                </c:pt>
                <c:pt idx="1074">
                  <c:v>2122</c:v>
                </c:pt>
                <c:pt idx="1075">
                  <c:v>2126</c:v>
                </c:pt>
                <c:pt idx="1076">
                  <c:v>2127</c:v>
                </c:pt>
                <c:pt idx="1077">
                  <c:v>2128</c:v>
                </c:pt>
                <c:pt idx="1078">
                  <c:v>2132</c:v>
                </c:pt>
                <c:pt idx="1079">
                  <c:v>2134</c:v>
                </c:pt>
                <c:pt idx="1080">
                  <c:v>2136</c:v>
                </c:pt>
                <c:pt idx="1081">
                  <c:v>2137</c:v>
                </c:pt>
                <c:pt idx="1082">
                  <c:v>2140</c:v>
                </c:pt>
                <c:pt idx="1083">
                  <c:v>2141</c:v>
                </c:pt>
                <c:pt idx="1084">
                  <c:v>2142</c:v>
                </c:pt>
                <c:pt idx="1085">
                  <c:v>2143</c:v>
                </c:pt>
                <c:pt idx="1086">
                  <c:v>2144</c:v>
                </c:pt>
                <c:pt idx="1087">
                  <c:v>2145</c:v>
                </c:pt>
                <c:pt idx="1088">
                  <c:v>2147</c:v>
                </c:pt>
                <c:pt idx="1089">
                  <c:v>2148</c:v>
                </c:pt>
                <c:pt idx="1090">
                  <c:v>2149</c:v>
                </c:pt>
                <c:pt idx="1091">
                  <c:v>2152</c:v>
                </c:pt>
                <c:pt idx="1092">
                  <c:v>2153</c:v>
                </c:pt>
                <c:pt idx="1093">
                  <c:v>2155</c:v>
                </c:pt>
                <c:pt idx="1094">
                  <c:v>2157</c:v>
                </c:pt>
                <c:pt idx="1095">
                  <c:v>2159</c:v>
                </c:pt>
                <c:pt idx="1096">
                  <c:v>2162</c:v>
                </c:pt>
                <c:pt idx="1097">
                  <c:v>2163</c:v>
                </c:pt>
                <c:pt idx="1098">
                  <c:v>2164</c:v>
                </c:pt>
                <c:pt idx="1099">
                  <c:v>2165</c:v>
                </c:pt>
                <c:pt idx="1100">
                  <c:v>2172</c:v>
                </c:pt>
                <c:pt idx="1101">
                  <c:v>2175</c:v>
                </c:pt>
                <c:pt idx="1102">
                  <c:v>2176</c:v>
                </c:pt>
                <c:pt idx="1103">
                  <c:v>2178</c:v>
                </c:pt>
                <c:pt idx="1104">
                  <c:v>2180</c:v>
                </c:pt>
                <c:pt idx="1105">
                  <c:v>2181</c:v>
                </c:pt>
                <c:pt idx="1106">
                  <c:v>2182</c:v>
                </c:pt>
                <c:pt idx="1107">
                  <c:v>2184</c:v>
                </c:pt>
                <c:pt idx="1108">
                  <c:v>2185</c:v>
                </c:pt>
                <c:pt idx="1109">
                  <c:v>2186</c:v>
                </c:pt>
                <c:pt idx="1110">
                  <c:v>2187</c:v>
                </c:pt>
                <c:pt idx="1111">
                  <c:v>2192</c:v>
                </c:pt>
                <c:pt idx="1112">
                  <c:v>2193</c:v>
                </c:pt>
                <c:pt idx="1113">
                  <c:v>2194</c:v>
                </c:pt>
                <c:pt idx="1114">
                  <c:v>2196</c:v>
                </c:pt>
                <c:pt idx="1115">
                  <c:v>2198</c:v>
                </c:pt>
                <c:pt idx="1116">
                  <c:v>2199</c:v>
                </c:pt>
                <c:pt idx="1117">
                  <c:v>2200</c:v>
                </c:pt>
                <c:pt idx="1118">
                  <c:v>2201</c:v>
                </c:pt>
                <c:pt idx="1119">
                  <c:v>2203</c:v>
                </c:pt>
                <c:pt idx="1120">
                  <c:v>2204</c:v>
                </c:pt>
                <c:pt idx="1121">
                  <c:v>2205</c:v>
                </c:pt>
                <c:pt idx="1122">
                  <c:v>2207</c:v>
                </c:pt>
                <c:pt idx="1123">
                  <c:v>2209</c:v>
                </c:pt>
                <c:pt idx="1124">
                  <c:v>2211</c:v>
                </c:pt>
                <c:pt idx="1125">
                  <c:v>2215</c:v>
                </c:pt>
                <c:pt idx="1126">
                  <c:v>2223</c:v>
                </c:pt>
                <c:pt idx="1127">
                  <c:v>2224</c:v>
                </c:pt>
                <c:pt idx="1128">
                  <c:v>2228</c:v>
                </c:pt>
                <c:pt idx="1129">
                  <c:v>2230</c:v>
                </c:pt>
                <c:pt idx="1130">
                  <c:v>2235</c:v>
                </c:pt>
                <c:pt idx="1131">
                  <c:v>2243</c:v>
                </c:pt>
                <c:pt idx="1132">
                  <c:v>2244</c:v>
                </c:pt>
                <c:pt idx="1133">
                  <c:v>2245</c:v>
                </c:pt>
                <c:pt idx="1134">
                  <c:v>2246</c:v>
                </c:pt>
                <c:pt idx="1135">
                  <c:v>2248</c:v>
                </c:pt>
                <c:pt idx="1136">
                  <c:v>2250</c:v>
                </c:pt>
                <c:pt idx="1137">
                  <c:v>2252</c:v>
                </c:pt>
                <c:pt idx="1138">
                  <c:v>2253</c:v>
                </c:pt>
                <c:pt idx="1139">
                  <c:v>2254</c:v>
                </c:pt>
                <c:pt idx="1140">
                  <c:v>2255</c:v>
                </c:pt>
                <c:pt idx="1141">
                  <c:v>2257</c:v>
                </c:pt>
                <c:pt idx="1142">
                  <c:v>2258</c:v>
                </c:pt>
                <c:pt idx="1143">
                  <c:v>2260</c:v>
                </c:pt>
                <c:pt idx="1144">
                  <c:v>2261</c:v>
                </c:pt>
                <c:pt idx="1145">
                  <c:v>2262</c:v>
                </c:pt>
                <c:pt idx="1146">
                  <c:v>2263</c:v>
                </c:pt>
                <c:pt idx="1147">
                  <c:v>2264</c:v>
                </c:pt>
                <c:pt idx="1148">
                  <c:v>2265</c:v>
                </c:pt>
                <c:pt idx="1149">
                  <c:v>2266</c:v>
                </c:pt>
                <c:pt idx="1150">
                  <c:v>2269</c:v>
                </c:pt>
                <c:pt idx="1151">
                  <c:v>2270</c:v>
                </c:pt>
                <c:pt idx="1152">
                  <c:v>2271</c:v>
                </c:pt>
                <c:pt idx="1153">
                  <c:v>2273</c:v>
                </c:pt>
                <c:pt idx="1154">
                  <c:v>2274</c:v>
                </c:pt>
                <c:pt idx="1155">
                  <c:v>2275</c:v>
                </c:pt>
                <c:pt idx="1156">
                  <c:v>2276</c:v>
                </c:pt>
                <c:pt idx="1157">
                  <c:v>2277</c:v>
                </c:pt>
                <c:pt idx="1158">
                  <c:v>2278</c:v>
                </c:pt>
                <c:pt idx="1159">
                  <c:v>2281</c:v>
                </c:pt>
                <c:pt idx="1160">
                  <c:v>2284</c:v>
                </c:pt>
                <c:pt idx="1161">
                  <c:v>2285</c:v>
                </c:pt>
                <c:pt idx="1162">
                  <c:v>2287</c:v>
                </c:pt>
                <c:pt idx="1163">
                  <c:v>2290</c:v>
                </c:pt>
                <c:pt idx="1164">
                  <c:v>2292</c:v>
                </c:pt>
                <c:pt idx="1165">
                  <c:v>2293</c:v>
                </c:pt>
                <c:pt idx="1166">
                  <c:v>2294</c:v>
                </c:pt>
                <c:pt idx="1167">
                  <c:v>2295</c:v>
                </c:pt>
                <c:pt idx="1168">
                  <c:v>2296</c:v>
                </c:pt>
                <c:pt idx="1169">
                  <c:v>2298</c:v>
                </c:pt>
                <c:pt idx="1170">
                  <c:v>2299</c:v>
                </c:pt>
                <c:pt idx="1171">
                  <c:v>2300</c:v>
                </c:pt>
                <c:pt idx="1172">
                  <c:v>2302</c:v>
                </c:pt>
                <c:pt idx="1173">
                  <c:v>2305</c:v>
                </c:pt>
                <c:pt idx="1174">
                  <c:v>2306</c:v>
                </c:pt>
                <c:pt idx="1175">
                  <c:v>2307</c:v>
                </c:pt>
                <c:pt idx="1176">
                  <c:v>2308</c:v>
                </c:pt>
                <c:pt idx="1177">
                  <c:v>2309</c:v>
                </c:pt>
                <c:pt idx="1178">
                  <c:v>2310</c:v>
                </c:pt>
                <c:pt idx="1179">
                  <c:v>2311</c:v>
                </c:pt>
                <c:pt idx="1180">
                  <c:v>2313</c:v>
                </c:pt>
                <c:pt idx="1181">
                  <c:v>2315</c:v>
                </c:pt>
                <c:pt idx="1182">
                  <c:v>2317</c:v>
                </c:pt>
                <c:pt idx="1183">
                  <c:v>2318</c:v>
                </c:pt>
                <c:pt idx="1184">
                  <c:v>2319</c:v>
                </c:pt>
                <c:pt idx="1185">
                  <c:v>2320</c:v>
                </c:pt>
                <c:pt idx="1186">
                  <c:v>2321</c:v>
                </c:pt>
                <c:pt idx="1187">
                  <c:v>2323</c:v>
                </c:pt>
                <c:pt idx="1188">
                  <c:v>2325</c:v>
                </c:pt>
                <c:pt idx="1189">
                  <c:v>2326</c:v>
                </c:pt>
                <c:pt idx="1190">
                  <c:v>2327</c:v>
                </c:pt>
                <c:pt idx="1191">
                  <c:v>2328</c:v>
                </c:pt>
                <c:pt idx="1192">
                  <c:v>2331</c:v>
                </c:pt>
                <c:pt idx="1193">
                  <c:v>2333</c:v>
                </c:pt>
                <c:pt idx="1194">
                  <c:v>2336</c:v>
                </c:pt>
                <c:pt idx="1195">
                  <c:v>2339</c:v>
                </c:pt>
                <c:pt idx="1196">
                  <c:v>2342</c:v>
                </c:pt>
                <c:pt idx="1197">
                  <c:v>2346</c:v>
                </c:pt>
                <c:pt idx="1198">
                  <c:v>2348</c:v>
                </c:pt>
                <c:pt idx="1199">
                  <c:v>2349</c:v>
                </c:pt>
                <c:pt idx="1200">
                  <c:v>2350</c:v>
                </c:pt>
                <c:pt idx="1201">
                  <c:v>2355</c:v>
                </c:pt>
                <c:pt idx="1202">
                  <c:v>2357</c:v>
                </c:pt>
                <c:pt idx="1203">
                  <c:v>2358</c:v>
                </c:pt>
                <c:pt idx="1204">
                  <c:v>2361</c:v>
                </c:pt>
                <c:pt idx="1205">
                  <c:v>2363</c:v>
                </c:pt>
                <c:pt idx="1206">
                  <c:v>2365</c:v>
                </c:pt>
                <c:pt idx="1207">
                  <c:v>2367</c:v>
                </c:pt>
                <c:pt idx="1208">
                  <c:v>2371</c:v>
                </c:pt>
                <c:pt idx="1209">
                  <c:v>2372</c:v>
                </c:pt>
                <c:pt idx="1210">
                  <c:v>2373</c:v>
                </c:pt>
                <c:pt idx="1211">
                  <c:v>2375</c:v>
                </c:pt>
                <c:pt idx="1212">
                  <c:v>2378</c:v>
                </c:pt>
                <c:pt idx="1213">
                  <c:v>2380</c:v>
                </c:pt>
                <c:pt idx="1214">
                  <c:v>2383</c:v>
                </c:pt>
                <c:pt idx="1215">
                  <c:v>2384</c:v>
                </c:pt>
                <c:pt idx="1216">
                  <c:v>2386</c:v>
                </c:pt>
                <c:pt idx="1217">
                  <c:v>2387</c:v>
                </c:pt>
                <c:pt idx="1218">
                  <c:v>2391</c:v>
                </c:pt>
                <c:pt idx="1219">
                  <c:v>2392</c:v>
                </c:pt>
                <c:pt idx="1220">
                  <c:v>2396</c:v>
                </c:pt>
                <c:pt idx="1221">
                  <c:v>2399</c:v>
                </c:pt>
                <c:pt idx="1222">
                  <c:v>2402</c:v>
                </c:pt>
                <c:pt idx="1223">
                  <c:v>2406</c:v>
                </c:pt>
                <c:pt idx="1224">
                  <c:v>2407</c:v>
                </c:pt>
                <c:pt idx="1225">
                  <c:v>2408</c:v>
                </c:pt>
                <c:pt idx="1226">
                  <c:v>2409</c:v>
                </c:pt>
                <c:pt idx="1227">
                  <c:v>2410</c:v>
                </c:pt>
                <c:pt idx="1228">
                  <c:v>2415</c:v>
                </c:pt>
                <c:pt idx="1229">
                  <c:v>2416</c:v>
                </c:pt>
                <c:pt idx="1230">
                  <c:v>2418</c:v>
                </c:pt>
                <c:pt idx="1231">
                  <c:v>2419</c:v>
                </c:pt>
                <c:pt idx="1232">
                  <c:v>2421</c:v>
                </c:pt>
                <c:pt idx="1233">
                  <c:v>2422</c:v>
                </c:pt>
                <c:pt idx="1234">
                  <c:v>2424</c:v>
                </c:pt>
                <c:pt idx="1235">
                  <c:v>2426</c:v>
                </c:pt>
                <c:pt idx="1236">
                  <c:v>2427</c:v>
                </c:pt>
                <c:pt idx="1237">
                  <c:v>2431</c:v>
                </c:pt>
                <c:pt idx="1238">
                  <c:v>2432</c:v>
                </c:pt>
                <c:pt idx="1239">
                  <c:v>2433</c:v>
                </c:pt>
                <c:pt idx="1240">
                  <c:v>2434</c:v>
                </c:pt>
                <c:pt idx="1241">
                  <c:v>2435</c:v>
                </c:pt>
                <c:pt idx="1242">
                  <c:v>2438</c:v>
                </c:pt>
                <c:pt idx="1243">
                  <c:v>2441</c:v>
                </c:pt>
                <c:pt idx="1244">
                  <c:v>2442</c:v>
                </c:pt>
                <c:pt idx="1245">
                  <c:v>2443</c:v>
                </c:pt>
                <c:pt idx="1246">
                  <c:v>2444</c:v>
                </c:pt>
                <c:pt idx="1247">
                  <c:v>2447</c:v>
                </c:pt>
                <c:pt idx="1248">
                  <c:v>2449</c:v>
                </c:pt>
                <c:pt idx="1249">
                  <c:v>2450</c:v>
                </c:pt>
                <c:pt idx="1250">
                  <c:v>2455</c:v>
                </c:pt>
                <c:pt idx="1251">
                  <c:v>2458</c:v>
                </c:pt>
                <c:pt idx="1252">
                  <c:v>2459</c:v>
                </c:pt>
                <c:pt idx="1253">
                  <c:v>2460</c:v>
                </c:pt>
                <c:pt idx="1254">
                  <c:v>2461</c:v>
                </c:pt>
                <c:pt idx="1255">
                  <c:v>2462</c:v>
                </c:pt>
                <c:pt idx="1256">
                  <c:v>2463</c:v>
                </c:pt>
                <c:pt idx="1257">
                  <c:v>2464</c:v>
                </c:pt>
                <c:pt idx="1258">
                  <c:v>2467</c:v>
                </c:pt>
                <c:pt idx="1259">
                  <c:v>2469</c:v>
                </c:pt>
                <c:pt idx="1260">
                  <c:v>2470</c:v>
                </c:pt>
                <c:pt idx="1261">
                  <c:v>2472</c:v>
                </c:pt>
                <c:pt idx="1262">
                  <c:v>2473</c:v>
                </c:pt>
                <c:pt idx="1263">
                  <c:v>2476</c:v>
                </c:pt>
                <c:pt idx="1264">
                  <c:v>2477</c:v>
                </c:pt>
                <c:pt idx="1265">
                  <c:v>2479</c:v>
                </c:pt>
                <c:pt idx="1266">
                  <c:v>2480</c:v>
                </c:pt>
                <c:pt idx="1267">
                  <c:v>2481</c:v>
                </c:pt>
                <c:pt idx="1268">
                  <c:v>2483</c:v>
                </c:pt>
                <c:pt idx="1269">
                  <c:v>2485</c:v>
                </c:pt>
                <c:pt idx="1270">
                  <c:v>2486</c:v>
                </c:pt>
                <c:pt idx="1271">
                  <c:v>2488</c:v>
                </c:pt>
                <c:pt idx="1272">
                  <c:v>2489</c:v>
                </c:pt>
                <c:pt idx="1273">
                  <c:v>2490</c:v>
                </c:pt>
                <c:pt idx="1274">
                  <c:v>2492</c:v>
                </c:pt>
                <c:pt idx="1275">
                  <c:v>2493</c:v>
                </c:pt>
                <c:pt idx="1276">
                  <c:v>2500</c:v>
                </c:pt>
                <c:pt idx="1277">
                  <c:v>2501</c:v>
                </c:pt>
                <c:pt idx="1278">
                  <c:v>2507</c:v>
                </c:pt>
                <c:pt idx="1279">
                  <c:v>2508</c:v>
                </c:pt>
                <c:pt idx="1280">
                  <c:v>2511</c:v>
                </c:pt>
                <c:pt idx="1281">
                  <c:v>2513</c:v>
                </c:pt>
                <c:pt idx="1282">
                  <c:v>2514</c:v>
                </c:pt>
                <c:pt idx="1283">
                  <c:v>2518</c:v>
                </c:pt>
                <c:pt idx="1284">
                  <c:v>2519</c:v>
                </c:pt>
                <c:pt idx="1285">
                  <c:v>2520</c:v>
                </c:pt>
                <c:pt idx="1286">
                  <c:v>2521</c:v>
                </c:pt>
                <c:pt idx="1287">
                  <c:v>2522</c:v>
                </c:pt>
                <c:pt idx="1288">
                  <c:v>2524</c:v>
                </c:pt>
                <c:pt idx="1289">
                  <c:v>2525</c:v>
                </c:pt>
                <c:pt idx="1290">
                  <c:v>2527</c:v>
                </c:pt>
                <c:pt idx="1291">
                  <c:v>2528</c:v>
                </c:pt>
                <c:pt idx="1292">
                  <c:v>2530</c:v>
                </c:pt>
                <c:pt idx="1293">
                  <c:v>2531</c:v>
                </c:pt>
                <c:pt idx="1294">
                  <c:v>2532</c:v>
                </c:pt>
                <c:pt idx="1295">
                  <c:v>2534</c:v>
                </c:pt>
                <c:pt idx="1296">
                  <c:v>2535</c:v>
                </c:pt>
                <c:pt idx="1297">
                  <c:v>2537</c:v>
                </c:pt>
                <c:pt idx="1298">
                  <c:v>2538</c:v>
                </c:pt>
                <c:pt idx="1299">
                  <c:v>2539</c:v>
                </c:pt>
                <c:pt idx="1300">
                  <c:v>2540</c:v>
                </c:pt>
                <c:pt idx="1301">
                  <c:v>2545</c:v>
                </c:pt>
                <c:pt idx="1302">
                  <c:v>2548</c:v>
                </c:pt>
                <c:pt idx="1303">
                  <c:v>2549</c:v>
                </c:pt>
                <c:pt idx="1304">
                  <c:v>2551</c:v>
                </c:pt>
                <c:pt idx="1305">
                  <c:v>2552</c:v>
                </c:pt>
                <c:pt idx="1306">
                  <c:v>2559</c:v>
                </c:pt>
                <c:pt idx="1307">
                  <c:v>2560</c:v>
                </c:pt>
                <c:pt idx="1308">
                  <c:v>2562</c:v>
                </c:pt>
                <c:pt idx="1309">
                  <c:v>2563</c:v>
                </c:pt>
                <c:pt idx="1310">
                  <c:v>2564</c:v>
                </c:pt>
                <c:pt idx="1311">
                  <c:v>2565</c:v>
                </c:pt>
                <c:pt idx="1312">
                  <c:v>2566</c:v>
                </c:pt>
                <c:pt idx="1313">
                  <c:v>2569</c:v>
                </c:pt>
                <c:pt idx="1314">
                  <c:v>2570</c:v>
                </c:pt>
                <c:pt idx="1315">
                  <c:v>2571</c:v>
                </c:pt>
                <c:pt idx="1316">
                  <c:v>2573</c:v>
                </c:pt>
                <c:pt idx="1317">
                  <c:v>2574</c:v>
                </c:pt>
                <c:pt idx="1318">
                  <c:v>2575</c:v>
                </c:pt>
                <c:pt idx="1319">
                  <c:v>2579</c:v>
                </c:pt>
                <c:pt idx="1320">
                  <c:v>2580</c:v>
                </c:pt>
                <c:pt idx="1321">
                  <c:v>2582</c:v>
                </c:pt>
                <c:pt idx="1322">
                  <c:v>2583</c:v>
                </c:pt>
                <c:pt idx="1323">
                  <c:v>2585</c:v>
                </c:pt>
                <c:pt idx="1324">
                  <c:v>2587</c:v>
                </c:pt>
                <c:pt idx="1325">
                  <c:v>2588</c:v>
                </c:pt>
                <c:pt idx="1326">
                  <c:v>2592</c:v>
                </c:pt>
                <c:pt idx="1327">
                  <c:v>2594</c:v>
                </c:pt>
                <c:pt idx="1328">
                  <c:v>2597</c:v>
                </c:pt>
                <c:pt idx="1329">
                  <c:v>2598</c:v>
                </c:pt>
                <c:pt idx="1330">
                  <c:v>2599</c:v>
                </c:pt>
                <c:pt idx="1331">
                  <c:v>2601</c:v>
                </c:pt>
                <c:pt idx="1332">
                  <c:v>2602</c:v>
                </c:pt>
                <c:pt idx="1333">
                  <c:v>2608</c:v>
                </c:pt>
                <c:pt idx="1334">
                  <c:v>2615</c:v>
                </c:pt>
                <c:pt idx="1335">
                  <c:v>2616</c:v>
                </c:pt>
                <c:pt idx="1336">
                  <c:v>2618</c:v>
                </c:pt>
                <c:pt idx="1337">
                  <c:v>2619</c:v>
                </c:pt>
                <c:pt idx="1338">
                  <c:v>2620</c:v>
                </c:pt>
                <c:pt idx="1339">
                  <c:v>2623</c:v>
                </c:pt>
                <c:pt idx="1340">
                  <c:v>2624</c:v>
                </c:pt>
                <c:pt idx="1341">
                  <c:v>2627</c:v>
                </c:pt>
                <c:pt idx="1342">
                  <c:v>2631</c:v>
                </c:pt>
                <c:pt idx="1343">
                  <c:v>2636</c:v>
                </c:pt>
                <c:pt idx="1344">
                  <c:v>2638</c:v>
                </c:pt>
                <c:pt idx="1345">
                  <c:v>2639</c:v>
                </c:pt>
                <c:pt idx="1346">
                  <c:v>2640</c:v>
                </c:pt>
                <c:pt idx="1347">
                  <c:v>2641</c:v>
                </c:pt>
                <c:pt idx="1348">
                  <c:v>2644</c:v>
                </c:pt>
                <c:pt idx="1349">
                  <c:v>2645</c:v>
                </c:pt>
                <c:pt idx="1350">
                  <c:v>2646</c:v>
                </c:pt>
                <c:pt idx="1351">
                  <c:v>2647</c:v>
                </c:pt>
                <c:pt idx="1352">
                  <c:v>2648</c:v>
                </c:pt>
                <c:pt idx="1353">
                  <c:v>2651</c:v>
                </c:pt>
                <c:pt idx="1354">
                  <c:v>2652</c:v>
                </c:pt>
                <c:pt idx="1355">
                  <c:v>2653</c:v>
                </c:pt>
                <c:pt idx="1356">
                  <c:v>2655</c:v>
                </c:pt>
                <c:pt idx="1357">
                  <c:v>2657</c:v>
                </c:pt>
                <c:pt idx="1358">
                  <c:v>2660</c:v>
                </c:pt>
                <c:pt idx="1359">
                  <c:v>2662</c:v>
                </c:pt>
                <c:pt idx="1360">
                  <c:v>2664</c:v>
                </c:pt>
                <c:pt idx="1361">
                  <c:v>2666</c:v>
                </c:pt>
                <c:pt idx="1362">
                  <c:v>2667</c:v>
                </c:pt>
                <c:pt idx="1363">
                  <c:v>2669</c:v>
                </c:pt>
                <c:pt idx="1364">
                  <c:v>2672</c:v>
                </c:pt>
                <c:pt idx="1365">
                  <c:v>2677</c:v>
                </c:pt>
                <c:pt idx="1366">
                  <c:v>2678</c:v>
                </c:pt>
                <c:pt idx="1367">
                  <c:v>2684</c:v>
                </c:pt>
                <c:pt idx="1368">
                  <c:v>2687</c:v>
                </c:pt>
                <c:pt idx="1369">
                  <c:v>2688</c:v>
                </c:pt>
                <c:pt idx="1370">
                  <c:v>2690</c:v>
                </c:pt>
                <c:pt idx="1371">
                  <c:v>2691</c:v>
                </c:pt>
                <c:pt idx="1372">
                  <c:v>2694</c:v>
                </c:pt>
                <c:pt idx="1373">
                  <c:v>2699</c:v>
                </c:pt>
                <c:pt idx="1374">
                  <c:v>2701</c:v>
                </c:pt>
                <c:pt idx="1375">
                  <c:v>2702</c:v>
                </c:pt>
                <c:pt idx="1376">
                  <c:v>2704</c:v>
                </c:pt>
                <c:pt idx="1377">
                  <c:v>2705</c:v>
                </c:pt>
                <c:pt idx="1378">
                  <c:v>2706</c:v>
                </c:pt>
                <c:pt idx="1379">
                  <c:v>2708</c:v>
                </c:pt>
                <c:pt idx="1380">
                  <c:v>2709</c:v>
                </c:pt>
                <c:pt idx="1381">
                  <c:v>2714</c:v>
                </c:pt>
                <c:pt idx="1382">
                  <c:v>2715</c:v>
                </c:pt>
                <c:pt idx="1383">
                  <c:v>2717</c:v>
                </c:pt>
                <c:pt idx="1384">
                  <c:v>2718</c:v>
                </c:pt>
                <c:pt idx="1385">
                  <c:v>2720</c:v>
                </c:pt>
                <c:pt idx="1386">
                  <c:v>2724</c:v>
                </c:pt>
                <c:pt idx="1387">
                  <c:v>2725</c:v>
                </c:pt>
                <c:pt idx="1388">
                  <c:v>2726</c:v>
                </c:pt>
                <c:pt idx="1389">
                  <c:v>2727</c:v>
                </c:pt>
                <c:pt idx="1390">
                  <c:v>2728</c:v>
                </c:pt>
                <c:pt idx="1391">
                  <c:v>2733</c:v>
                </c:pt>
                <c:pt idx="1392">
                  <c:v>2734</c:v>
                </c:pt>
                <c:pt idx="1393">
                  <c:v>2735</c:v>
                </c:pt>
                <c:pt idx="1394">
                  <c:v>2736</c:v>
                </c:pt>
                <c:pt idx="1395">
                  <c:v>2738</c:v>
                </c:pt>
                <c:pt idx="1396">
                  <c:v>2741</c:v>
                </c:pt>
                <c:pt idx="1397">
                  <c:v>2742</c:v>
                </c:pt>
                <c:pt idx="1398">
                  <c:v>2743</c:v>
                </c:pt>
                <c:pt idx="1399">
                  <c:v>2744</c:v>
                </c:pt>
                <c:pt idx="1400">
                  <c:v>2746</c:v>
                </c:pt>
                <c:pt idx="1401">
                  <c:v>2747</c:v>
                </c:pt>
                <c:pt idx="1402">
                  <c:v>2748</c:v>
                </c:pt>
                <c:pt idx="1403">
                  <c:v>2749</c:v>
                </c:pt>
                <c:pt idx="1404">
                  <c:v>2750</c:v>
                </c:pt>
                <c:pt idx="1405">
                  <c:v>2752</c:v>
                </c:pt>
                <c:pt idx="1406">
                  <c:v>2754</c:v>
                </c:pt>
                <c:pt idx="1407">
                  <c:v>2756</c:v>
                </c:pt>
                <c:pt idx="1408">
                  <c:v>2758</c:v>
                </c:pt>
                <c:pt idx="1409">
                  <c:v>2759</c:v>
                </c:pt>
                <c:pt idx="1410">
                  <c:v>2761</c:v>
                </c:pt>
                <c:pt idx="1411">
                  <c:v>2762</c:v>
                </c:pt>
                <c:pt idx="1412">
                  <c:v>2763</c:v>
                </c:pt>
                <c:pt idx="1413">
                  <c:v>2766</c:v>
                </c:pt>
                <c:pt idx="1414">
                  <c:v>2767</c:v>
                </c:pt>
                <c:pt idx="1415">
                  <c:v>2768</c:v>
                </c:pt>
                <c:pt idx="1416">
                  <c:v>2771</c:v>
                </c:pt>
                <c:pt idx="1417">
                  <c:v>2772</c:v>
                </c:pt>
                <c:pt idx="1418">
                  <c:v>2773</c:v>
                </c:pt>
                <c:pt idx="1419">
                  <c:v>2775</c:v>
                </c:pt>
                <c:pt idx="1420">
                  <c:v>2776</c:v>
                </c:pt>
                <c:pt idx="1421">
                  <c:v>2777</c:v>
                </c:pt>
                <c:pt idx="1422">
                  <c:v>2779</c:v>
                </c:pt>
                <c:pt idx="1423">
                  <c:v>2780</c:v>
                </c:pt>
                <c:pt idx="1424">
                  <c:v>2783</c:v>
                </c:pt>
                <c:pt idx="1425">
                  <c:v>2784</c:v>
                </c:pt>
                <c:pt idx="1426">
                  <c:v>2785</c:v>
                </c:pt>
                <c:pt idx="1427">
                  <c:v>2786</c:v>
                </c:pt>
                <c:pt idx="1428">
                  <c:v>2787</c:v>
                </c:pt>
                <c:pt idx="1429">
                  <c:v>2790</c:v>
                </c:pt>
                <c:pt idx="1430">
                  <c:v>2796</c:v>
                </c:pt>
                <c:pt idx="1431">
                  <c:v>2797</c:v>
                </c:pt>
                <c:pt idx="1432">
                  <c:v>2799</c:v>
                </c:pt>
                <c:pt idx="1433">
                  <c:v>2800</c:v>
                </c:pt>
                <c:pt idx="1434">
                  <c:v>2802</c:v>
                </c:pt>
                <c:pt idx="1435">
                  <c:v>2803</c:v>
                </c:pt>
                <c:pt idx="1436">
                  <c:v>2804</c:v>
                </c:pt>
                <c:pt idx="1437">
                  <c:v>2809</c:v>
                </c:pt>
                <c:pt idx="1438">
                  <c:v>2810</c:v>
                </c:pt>
                <c:pt idx="1439">
                  <c:v>2813</c:v>
                </c:pt>
                <c:pt idx="1440">
                  <c:v>2815</c:v>
                </c:pt>
                <c:pt idx="1441">
                  <c:v>2817</c:v>
                </c:pt>
                <c:pt idx="1442">
                  <c:v>2818</c:v>
                </c:pt>
                <c:pt idx="1443">
                  <c:v>2819</c:v>
                </c:pt>
                <c:pt idx="1444">
                  <c:v>2820</c:v>
                </c:pt>
                <c:pt idx="1445">
                  <c:v>2821</c:v>
                </c:pt>
                <c:pt idx="1446">
                  <c:v>2823</c:v>
                </c:pt>
                <c:pt idx="1447">
                  <c:v>2824</c:v>
                </c:pt>
                <c:pt idx="1448">
                  <c:v>2826</c:v>
                </c:pt>
                <c:pt idx="1449">
                  <c:v>2827</c:v>
                </c:pt>
                <c:pt idx="1450">
                  <c:v>2828</c:v>
                </c:pt>
                <c:pt idx="1451">
                  <c:v>2829</c:v>
                </c:pt>
                <c:pt idx="1452">
                  <c:v>2831</c:v>
                </c:pt>
                <c:pt idx="1453">
                  <c:v>2832</c:v>
                </c:pt>
                <c:pt idx="1454">
                  <c:v>2833</c:v>
                </c:pt>
                <c:pt idx="1455">
                  <c:v>2834</c:v>
                </c:pt>
                <c:pt idx="1456">
                  <c:v>2835</c:v>
                </c:pt>
                <c:pt idx="1457">
                  <c:v>2836</c:v>
                </c:pt>
                <c:pt idx="1458">
                  <c:v>2840</c:v>
                </c:pt>
                <c:pt idx="1459">
                  <c:v>2842</c:v>
                </c:pt>
                <c:pt idx="1460">
                  <c:v>2843</c:v>
                </c:pt>
                <c:pt idx="1461">
                  <c:v>2847</c:v>
                </c:pt>
                <c:pt idx="1462">
                  <c:v>2848</c:v>
                </c:pt>
                <c:pt idx="1463">
                  <c:v>2849</c:v>
                </c:pt>
                <c:pt idx="1464">
                  <c:v>2851</c:v>
                </c:pt>
                <c:pt idx="1465">
                  <c:v>2853</c:v>
                </c:pt>
                <c:pt idx="1466">
                  <c:v>2854</c:v>
                </c:pt>
                <c:pt idx="1467">
                  <c:v>2855</c:v>
                </c:pt>
                <c:pt idx="1468">
                  <c:v>2856</c:v>
                </c:pt>
                <c:pt idx="1469">
                  <c:v>2857</c:v>
                </c:pt>
                <c:pt idx="1470">
                  <c:v>2858</c:v>
                </c:pt>
                <c:pt idx="1471">
                  <c:v>2861</c:v>
                </c:pt>
                <c:pt idx="1472">
                  <c:v>2862</c:v>
                </c:pt>
                <c:pt idx="1473">
                  <c:v>2863</c:v>
                </c:pt>
                <c:pt idx="1474">
                  <c:v>2865</c:v>
                </c:pt>
                <c:pt idx="1475">
                  <c:v>2869</c:v>
                </c:pt>
                <c:pt idx="1476">
                  <c:v>2870</c:v>
                </c:pt>
                <c:pt idx="1477">
                  <c:v>2872</c:v>
                </c:pt>
                <c:pt idx="1478">
                  <c:v>2873</c:v>
                </c:pt>
                <c:pt idx="1479">
                  <c:v>2874</c:v>
                </c:pt>
                <c:pt idx="1480">
                  <c:v>2875</c:v>
                </c:pt>
                <c:pt idx="1481">
                  <c:v>2876</c:v>
                </c:pt>
                <c:pt idx="1482">
                  <c:v>2877</c:v>
                </c:pt>
                <c:pt idx="1483">
                  <c:v>2880</c:v>
                </c:pt>
                <c:pt idx="1484">
                  <c:v>2881</c:v>
                </c:pt>
                <c:pt idx="1485">
                  <c:v>2882</c:v>
                </c:pt>
                <c:pt idx="1486">
                  <c:v>2883</c:v>
                </c:pt>
                <c:pt idx="1487">
                  <c:v>2884</c:v>
                </c:pt>
                <c:pt idx="1488">
                  <c:v>2885</c:v>
                </c:pt>
                <c:pt idx="1489">
                  <c:v>2887</c:v>
                </c:pt>
                <c:pt idx="1490">
                  <c:v>2888</c:v>
                </c:pt>
                <c:pt idx="1491">
                  <c:v>2889</c:v>
                </c:pt>
                <c:pt idx="1492">
                  <c:v>2893</c:v>
                </c:pt>
                <c:pt idx="1493">
                  <c:v>2894</c:v>
                </c:pt>
                <c:pt idx="1494">
                  <c:v>2897</c:v>
                </c:pt>
                <c:pt idx="1495">
                  <c:v>2900</c:v>
                </c:pt>
                <c:pt idx="1496">
                  <c:v>2905</c:v>
                </c:pt>
                <c:pt idx="1497">
                  <c:v>2906</c:v>
                </c:pt>
                <c:pt idx="1498">
                  <c:v>2907</c:v>
                </c:pt>
                <c:pt idx="1499">
                  <c:v>2908</c:v>
                </c:pt>
                <c:pt idx="1500">
                  <c:v>2910</c:v>
                </c:pt>
                <c:pt idx="1501">
                  <c:v>2911</c:v>
                </c:pt>
                <c:pt idx="1502">
                  <c:v>2912</c:v>
                </c:pt>
                <c:pt idx="1503">
                  <c:v>2915</c:v>
                </c:pt>
                <c:pt idx="1504">
                  <c:v>2919</c:v>
                </c:pt>
                <c:pt idx="1505">
                  <c:v>2921</c:v>
                </c:pt>
                <c:pt idx="1506">
                  <c:v>2922</c:v>
                </c:pt>
                <c:pt idx="1507">
                  <c:v>2923</c:v>
                </c:pt>
                <c:pt idx="1508">
                  <c:v>2924</c:v>
                </c:pt>
                <c:pt idx="1509">
                  <c:v>2925</c:v>
                </c:pt>
                <c:pt idx="1510">
                  <c:v>2926</c:v>
                </c:pt>
                <c:pt idx="1511">
                  <c:v>2927</c:v>
                </c:pt>
                <c:pt idx="1512">
                  <c:v>2929</c:v>
                </c:pt>
                <c:pt idx="1513">
                  <c:v>2937</c:v>
                </c:pt>
                <c:pt idx="1514">
                  <c:v>2938</c:v>
                </c:pt>
                <c:pt idx="1515">
                  <c:v>2940</c:v>
                </c:pt>
                <c:pt idx="1516">
                  <c:v>2941</c:v>
                </c:pt>
                <c:pt idx="1517">
                  <c:v>2942</c:v>
                </c:pt>
                <c:pt idx="1518">
                  <c:v>2944</c:v>
                </c:pt>
                <c:pt idx="1519">
                  <c:v>2946</c:v>
                </c:pt>
                <c:pt idx="1520">
                  <c:v>2950</c:v>
                </c:pt>
                <c:pt idx="1521">
                  <c:v>2951</c:v>
                </c:pt>
                <c:pt idx="1522">
                  <c:v>2952</c:v>
                </c:pt>
                <c:pt idx="1523">
                  <c:v>2955</c:v>
                </c:pt>
                <c:pt idx="1524">
                  <c:v>2956</c:v>
                </c:pt>
                <c:pt idx="1525">
                  <c:v>2957</c:v>
                </c:pt>
                <c:pt idx="1526">
                  <c:v>2958</c:v>
                </c:pt>
                <c:pt idx="1527">
                  <c:v>2959</c:v>
                </c:pt>
                <c:pt idx="1528">
                  <c:v>2961</c:v>
                </c:pt>
                <c:pt idx="1529">
                  <c:v>2964</c:v>
                </c:pt>
                <c:pt idx="1530">
                  <c:v>2967</c:v>
                </c:pt>
                <c:pt idx="1531">
                  <c:v>2968</c:v>
                </c:pt>
                <c:pt idx="1532">
                  <c:v>2969</c:v>
                </c:pt>
                <c:pt idx="1533">
                  <c:v>2970</c:v>
                </c:pt>
                <c:pt idx="1534">
                  <c:v>2971</c:v>
                </c:pt>
                <c:pt idx="1535">
                  <c:v>2972</c:v>
                </c:pt>
                <c:pt idx="1536">
                  <c:v>2973</c:v>
                </c:pt>
                <c:pt idx="1537">
                  <c:v>2974</c:v>
                </c:pt>
                <c:pt idx="1538">
                  <c:v>2975</c:v>
                </c:pt>
                <c:pt idx="1539">
                  <c:v>2976</c:v>
                </c:pt>
                <c:pt idx="1540">
                  <c:v>2977</c:v>
                </c:pt>
                <c:pt idx="1541">
                  <c:v>2978</c:v>
                </c:pt>
                <c:pt idx="1542">
                  <c:v>2980</c:v>
                </c:pt>
                <c:pt idx="1543">
                  <c:v>2982</c:v>
                </c:pt>
                <c:pt idx="1544">
                  <c:v>2983</c:v>
                </c:pt>
                <c:pt idx="1545">
                  <c:v>2985</c:v>
                </c:pt>
                <c:pt idx="1546">
                  <c:v>2986</c:v>
                </c:pt>
                <c:pt idx="1547">
                  <c:v>2987</c:v>
                </c:pt>
                <c:pt idx="1548">
                  <c:v>2989</c:v>
                </c:pt>
                <c:pt idx="1549">
                  <c:v>2990</c:v>
                </c:pt>
                <c:pt idx="1550">
                  <c:v>2992</c:v>
                </c:pt>
                <c:pt idx="1551">
                  <c:v>2993</c:v>
                </c:pt>
                <c:pt idx="1552">
                  <c:v>2995</c:v>
                </c:pt>
                <c:pt idx="1553">
                  <c:v>2996</c:v>
                </c:pt>
                <c:pt idx="1554">
                  <c:v>2997</c:v>
                </c:pt>
                <c:pt idx="1555">
                  <c:v>2999</c:v>
                </c:pt>
                <c:pt idx="1556">
                  <c:v>3003</c:v>
                </c:pt>
                <c:pt idx="1557">
                  <c:v>3005</c:v>
                </c:pt>
                <c:pt idx="1558">
                  <c:v>3007</c:v>
                </c:pt>
                <c:pt idx="1559">
                  <c:v>3008</c:v>
                </c:pt>
                <c:pt idx="1560">
                  <c:v>3010</c:v>
                </c:pt>
                <c:pt idx="1561">
                  <c:v>3011</c:v>
                </c:pt>
                <c:pt idx="1562">
                  <c:v>3012</c:v>
                </c:pt>
                <c:pt idx="1563">
                  <c:v>3013</c:v>
                </c:pt>
                <c:pt idx="1564">
                  <c:v>3014</c:v>
                </c:pt>
                <c:pt idx="1565">
                  <c:v>3016</c:v>
                </c:pt>
                <c:pt idx="1566">
                  <c:v>3017</c:v>
                </c:pt>
                <c:pt idx="1567">
                  <c:v>3020</c:v>
                </c:pt>
                <c:pt idx="1568">
                  <c:v>3021</c:v>
                </c:pt>
                <c:pt idx="1569">
                  <c:v>3022</c:v>
                </c:pt>
                <c:pt idx="1570">
                  <c:v>3023</c:v>
                </c:pt>
                <c:pt idx="1571">
                  <c:v>3024</c:v>
                </c:pt>
                <c:pt idx="1572">
                  <c:v>3025</c:v>
                </c:pt>
                <c:pt idx="1573">
                  <c:v>3026</c:v>
                </c:pt>
                <c:pt idx="1574">
                  <c:v>3027</c:v>
                </c:pt>
                <c:pt idx="1575">
                  <c:v>3028</c:v>
                </c:pt>
                <c:pt idx="1576">
                  <c:v>3031</c:v>
                </c:pt>
                <c:pt idx="1577">
                  <c:v>3032</c:v>
                </c:pt>
                <c:pt idx="1578">
                  <c:v>3036</c:v>
                </c:pt>
                <c:pt idx="1579">
                  <c:v>3037</c:v>
                </c:pt>
                <c:pt idx="1580">
                  <c:v>3038</c:v>
                </c:pt>
                <c:pt idx="1581">
                  <c:v>3039</c:v>
                </c:pt>
                <c:pt idx="1582">
                  <c:v>3040</c:v>
                </c:pt>
                <c:pt idx="1583">
                  <c:v>3041</c:v>
                </c:pt>
                <c:pt idx="1584">
                  <c:v>3042</c:v>
                </c:pt>
                <c:pt idx="1585">
                  <c:v>3043</c:v>
                </c:pt>
              </c:numCache>
            </c:numRef>
          </c:xVal>
          <c:yVal>
            <c:numRef>
              <c:f>'RNA1 DMS error rate'!$E$2:$E$1587</c:f>
              <c:numCache>
                <c:formatCode>General</c:formatCode>
                <c:ptCount val="1586"/>
                <c:pt idx="0">
                  <c:v>6.763285E-3</c:v>
                </c:pt>
                <c:pt idx="1">
                  <c:v>5.8690740000000002E-3</c:v>
                </c:pt>
                <c:pt idx="2">
                  <c:v>1.350743E-3</c:v>
                </c:pt>
                <c:pt idx="3">
                  <c:v>4.4603029999999997E-3</c:v>
                </c:pt>
                <c:pt idx="4">
                  <c:v>6.1629499999999999E-4</c:v>
                </c:pt>
                <c:pt idx="5">
                  <c:v>0</c:v>
                </c:pt>
                <c:pt idx="6">
                  <c:v>8.5075400000000001E-4</c:v>
                </c:pt>
                <c:pt idx="7">
                  <c:v>5.7395670000000001E-3</c:v>
                </c:pt>
                <c:pt idx="8">
                  <c:v>1.1924640000000001E-3</c:v>
                </c:pt>
                <c:pt idx="9">
                  <c:v>2.5782259999999999E-3</c:v>
                </c:pt>
                <c:pt idx="10">
                  <c:v>4.9865700999999998E-2</c:v>
                </c:pt>
                <c:pt idx="11">
                  <c:v>0.416326531</c:v>
                </c:pt>
                <c:pt idx="12">
                  <c:v>9.607951E-3</c:v>
                </c:pt>
                <c:pt idx="13">
                  <c:v>1.7634739999999999E-3</c:v>
                </c:pt>
                <c:pt idx="14">
                  <c:v>6.5595300000000003E-4</c:v>
                </c:pt>
                <c:pt idx="15">
                  <c:v>7.6088999999999996E-4</c:v>
                </c:pt>
                <c:pt idx="16">
                  <c:v>9.57354E-4</c:v>
                </c:pt>
                <c:pt idx="17">
                  <c:v>9.2994960000000008E-3</c:v>
                </c:pt>
                <c:pt idx="18">
                  <c:v>9.4139744999999997E-2</c:v>
                </c:pt>
                <c:pt idx="19">
                  <c:v>1.570681E-3</c:v>
                </c:pt>
                <c:pt idx="20">
                  <c:v>1.4132700000000001E-3</c:v>
                </c:pt>
                <c:pt idx="21">
                  <c:v>1.256746E-3</c:v>
                </c:pt>
                <c:pt idx="22">
                  <c:v>1.6042000000000001E-3</c:v>
                </c:pt>
                <c:pt idx="23" formatCode="0.00E+00">
                  <c:v>7.28863E-5</c:v>
                </c:pt>
                <c:pt idx="24">
                  <c:v>4.1994190000000002E-3</c:v>
                </c:pt>
                <c:pt idx="25">
                  <c:v>8.5998400000000005E-4</c:v>
                </c:pt>
                <c:pt idx="26">
                  <c:v>1.789641E-3</c:v>
                </c:pt>
                <c:pt idx="27">
                  <c:v>5.7151600000000004E-3</c:v>
                </c:pt>
                <c:pt idx="28">
                  <c:v>2.3957589999999999E-3</c:v>
                </c:pt>
                <c:pt idx="29">
                  <c:v>0.24330052999999999</c:v>
                </c:pt>
                <c:pt idx="30">
                  <c:v>1.145475E-3</c:v>
                </c:pt>
                <c:pt idx="31">
                  <c:v>8.8596609999999996E-3</c:v>
                </c:pt>
                <c:pt idx="32">
                  <c:v>6.8973325000000002E-2</c:v>
                </c:pt>
                <c:pt idx="33">
                  <c:v>3.2353730000000002E-3</c:v>
                </c:pt>
                <c:pt idx="34">
                  <c:v>5.6148199999999998E-4</c:v>
                </c:pt>
                <c:pt idx="35">
                  <c:v>1.763517E-3</c:v>
                </c:pt>
                <c:pt idx="36">
                  <c:v>7.1318599999999998E-4</c:v>
                </c:pt>
                <c:pt idx="37">
                  <c:v>6.7582000000000004E-4</c:v>
                </c:pt>
                <c:pt idx="38">
                  <c:v>2.1665009999999999E-3</c:v>
                </c:pt>
                <c:pt idx="39">
                  <c:v>2.0519599999999998E-3</c:v>
                </c:pt>
                <c:pt idx="40">
                  <c:v>1.5566309999999999E-3</c:v>
                </c:pt>
                <c:pt idx="41">
                  <c:v>2.0315569999999998E-3</c:v>
                </c:pt>
                <c:pt idx="42">
                  <c:v>5.0571500000000001E-4</c:v>
                </c:pt>
                <c:pt idx="43">
                  <c:v>8.0620799999999999E-4</c:v>
                </c:pt>
                <c:pt idx="44">
                  <c:v>1.509966E-3</c:v>
                </c:pt>
                <c:pt idx="45">
                  <c:v>2.8507229999999999E-3</c:v>
                </c:pt>
                <c:pt idx="46">
                  <c:v>9.1444637999999995E-2</c:v>
                </c:pt>
                <c:pt idx="47">
                  <c:v>7.0229400000000001E-4</c:v>
                </c:pt>
                <c:pt idx="48">
                  <c:v>1.9970758000000002E-2</c:v>
                </c:pt>
                <c:pt idx="49">
                  <c:v>2.9522009999999998E-3</c:v>
                </c:pt>
                <c:pt idx="50">
                  <c:v>3.5933909E-2</c:v>
                </c:pt>
                <c:pt idx="51">
                  <c:v>2.5590249999999999E-3</c:v>
                </c:pt>
                <c:pt idx="52">
                  <c:v>4.0964060000000004E-3</c:v>
                </c:pt>
                <c:pt idx="53">
                  <c:v>6.6742019999999997E-3</c:v>
                </c:pt>
                <c:pt idx="54">
                  <c:v>2.7774000000000002E-3</c:v>
                </c:pt>
                <c:pt idx="55">
                  <c:v>1.8232280000000001E-3</c:v>
                </c:pt>
                <c:pt idx="56">
                  <c:v>2.4596504000000002E-2</c:v>
                </c:pt>
                <c:pt idx="57">
                  <c:v>2.5730750000000002E-3</c:v>
                </c:pt>
                <c:pt idx="58">
                  <c:v>1.0099029000000001E-2</c:v>
                </c:pt>
                <c:pt idx="59">
                  <c:v>6.3802599999999998E-4</c:v>
                </c:pt>
                <c:pt idx="60">
                  <c:v>0.100186606</c:v>
                </c:pt>
                <c:pt idx="61">
                  <c:v>4.0980999999999998E-4</c:v>
                </c:pt>
                <c:pt idx="62">
                  <c:v>3.1647479999999999E-2</c:v>
                </c:pt>
                <c:pt idx="63">
                  <c:v>6.8696699999999996E-3</c:v>
                </c:pt>
                <c:pt idx="64">
                  <c:v>3.2032977999999997E-2</c:v>
                </c:pt>
                <c:pt idx="65">
                  <c:v>1.404244E-3</c:v>
                </c:pt>
                <c:pt idx="66">
                  <c:v>1.5039672E-2</c:v>
                </c:pt>
                <c:pt idx="67">
                  <c:v>3.1367130000000002E-3</c:v>
                </c:pt>
                <c:pt idx="68">
                  <c:v>1.0580388E-2</c:v>
                </c:pt>
                <c:pt idx="69">
                  <c:v>5.38416E-4</c:v>
                </c:pt>
                <c:pt idx="70">
                  <c:v>7.9862602000000005E-2</c:v>
                </c:pt>
                <c:pt idx="71">
                  <c:v>1.0140801E-2</c:v>
                </c:pt>
                <c:pt idx="72">
                  <c:v>2.2898828E-2</c:v>
                </c:pt>
                <c:pt idx="73">
                  <c:v>6.7683100000000003E-4</c:v>
                </c:pt>
                <c:pt idx="74">
                  <c:v>1.146102E-3</c:v>
                </c:pt>
                <c:pt idx="75">
                  <c:v>2.4530540000000001E-3</c:v>
                </c:pt>
                <c:pt idx="76">
                  <c:v>6.4204300000000002E-4</c:v>
                </c:pt>
                <c:pt idx="77">
                  <c:v>5.7831330000000002E-3</c:v>
                </c:pt>
                <c:pt idx="78">
                  <c:v>3.781258E-3</c:v>
                </c:pt>
                <c:pt idx="79">
                  <c:v>1.9112949999999999E-3</c:v>
                </c:pt>
                <c:pt idx="80">
                  <c:v>9.3275200000000002E-4</c:v>
                </c:pt>
                <c:pt idx="81">
                  <c:v>6.8207900000000004E-4</c:v>
                </c:pt>
                <c:pt idx="82">
                  <c:v>8.4342800000000002E-4</c:v>
                </c:pt>
                <c:pt idx="83">
                  <c:v>1.705577E-3</c:v>
                </c:pt>
                <c:pt idx="84">
                  <c:v>1.7856134999999999E-2</c:v>
                </c:pt>
                <c:pt idx="85">
                  <c:v>6.0212600000000003E-4</c:v>
                </c:pt>
                <c:pt idx="86">
                  <c:v>3.7011100000000001E-4</c:v>
                </c:pt>
                <c:pt idx="87">
                  <c:v>2.262797E-3</c:v>
                </c:pt>
                <c:pt idx="88">
                  <c:v>3.8631620999999998E-2</c:v>
                </c:pt>
                <c:pt idx="89">
                  <c:v>2.1434620000000001E-3</c:v>
                </c:pt>
                <c:pt idx="90">
                  <c:v>2.4579586E-2</c:v>
                </c:pt>
                <c:pt idx="91">
                  <c:v>3.0717266E-2</c:v>
                </c:pt>
                <c:pt idx="92">
                  <c:v>8.2960300000000005E-4</c:v>
                </c:pt>
                <c:pt idx="93">
                  <c:v>1.114784E-3</c:v>
                </c:pt>
                <c:pt idx="94">
                  <c:v>4.4905270000000002E-3</c:v>
                </c:pt>
                <c:pt idx="95">
                  <c:v>6.3343430000000001E-3</c:v>
                </c:pt>
                <c:pt idx="96">
                  <c:v>1.8996810999999999E-2</c:v>
                </c:pt>
                <c:pt idx="97">
                  <c:v>4.1770449999999999E-3</c:v>
                </c:pt>
                <c:pt idx="98">
                  <c:v>2.562476E-2</c:v>
                </c:pt>
                <c:pt idx="99">
                  <c:v>4.1016439999999998E-3</c:v>
                </c:pt>
                <c:pt idx="100">
                  <c:v>2.5147843999999999E-2</c:v>
                </c:pt>
                <c:pt idx="101">
                  <c:v>1.1025612000000001E-2</c:v>
                </c:pt>
                <c:pt idx="102">
                  <c:v>3.1332247000000001E-2</c:v>
                </c:pt>
                <c:pt idx="103">
                  <c:v>3.2928559000000003E-2</c:v>
                </c:pt>
                <c:pt idx="104">
                  <c:v>2.3788917999999999E-2</c:v>
                </c:pt>
                <c:pt idx="105">
                  <c:v>8.3972099999999998E-4</c:v>
                </c:pt>
                <c:pt idx="106">
                  <c:v>4.0394399999999999E-4</c:v>
                </c:pt>
                <c:pt idx="107">
                  <c:v>7.5293099999999998E-4</c:v>
                </c:pt>
                <c:pt idx="108">
                  <c:v>2.1043378000000001E-2</c:v>
                </c:pt>
                <c:pt idx="109">
                  <c:v>1.6738497000000001E-2</c:v>
                </c:pt>
                <c:pt idx="110">
                  <c:v>2.734682E-3</c:v>
                </c:pt>
                <c:pt idx="111">
                  <c:v>1.8627113000000001E-2</c:v>
                </c:pt>
                <c:pt idx="112">
                  <c:v>3.3603370000000001E-3</c:v>
                </c:pt>
                <c:pt idx="113">
                  <c:v>2.3285850000000002E-3</c:v>
                </c:pt>
                <c:pt idx="114">
                  <c:v>3.7682269999999999E-3</c:v>
                </c:pt>
                <c:pt idx="115">
                  <c:v>5.9517399999999996E-4</c:v>
                </c:pt>
                <c:pt idx="116">
                  <c:v>2.2820060000000001E-3</c:v>
                </c:pt>
                <c:pt idx="117">
                  <c:v>2.3887349999999999E-3</c:v>
                </c:pt>
                <c:pt idx="118">
                  <c:v>1.8606353999999999E-2</c:v>
                </c:pt>
                <c:pt idx="119">
                  <c:v>4.1863600000000001E-4</c:v>
                </c:pt>
                <c:pt idx="120">
                  <c:v>2.9183303000000001E-2</c:v>
                </c:pt>
                <c:pt idx="121">
                  <c:v>2.7770691E-2</c:v>
                </c:pt>
                <c:pt idx="122">
                  <c:v>1.7700403999999999E-2</c:v>
                </c:pt>
                <c:pt idx="123">
                  <c:v>1.0631850999999999E-2</c:v>
                </c:pt>
                <c:pt idx="124">
                  <c:v>5.3312289999999998E-3</c:v>
                </c:pt>
                <c:pt idx="125">
                  <c:v>6.5664420000000001E-2</c:v>
                </c:pt>
                <c:pt idx="126">
                  <c:v>2.5516522999999999E-2</c:v>
                </c:pt>
                <c:pt idx="127">
                  <c:v>3.7350799999999999E-4</c:v>
                </c:pt>
                <c:pt idx="128">
                  <c:v>1.0003368E-2</c:v>
                </c:pt>
                <c:pt idx="129">
                  <c:v>1.2129580000000001E-3</c:v>
                </c:pt>
                <c:pt idx="130">
                  <c:v>5.24203E-4</c:v>
                </c:pt>
                <c:pt idx="131">
                  <c:v>2.7481116999999999E-2</c:v>
                </c:pt>
                <c:pt idx="132">
                  <c:v>2.2325891E-2</c:v>
                </c:pt>
                <c:pt idx="133">
                  <c:v>3.144076E-3</c:v>
                </c:pt>
                <c:pt idx="134">
                  <c:v>4.0433891999999999E-2</c:v>
                </c:pt>
                <c:pt idx="135">
                  <c:v>6.1572100999999997E-2</c:v>
                </c:pt>
                <c:pt idx="136">
                  <c:v>1.1653508999999999E-2</c:v>
                </c:pt>
                <c:pt idx="137">
                  <c:v>3.1462030000000002E-3</c:v>
                </c:pt>
                <c:pt idx="138">
                  <c:v>4.6007699999999998E-4</c:v>
                </c:pt>
                <c:pt idx="139">
                  <c:v>4.15406E-4</c:v>
                </c:pt>
                <c:pt idx="140">
                  <c:v>2.9878470000000001E-3</c:v>
                </c:pt>
                <c:pt idx="141">
                  <c:v>1.1970240000000001E-3</c:v>
                </c:pt>
                <c:pt idx="142">
                  <c:v>8.6499799999999996E-4</c:v>
                </c:pt>
                <c:pt idx="143">
                  <c:v>5.787861E-3</c:v>
                </c:pt>
                <c:pt idx="144">
                  <c:v>3.5072203000000003E-2</c:v>
                </c:pt>
                <c:pt idx="145">
                  <c:v>1.085162E-3</c:v>
                </c:pt>
                <c:pt idx="146">
                  <c:v>4.43466E-4</c:v>
                </c:pt>
                <c:pt idx="147">
                  <c:v>1.7697770000000002E-2</c:v>
                </c:pt>
                <c:pt idx="148">
                  <c:v>2.6795370000000001E-3</c:v>
                </c:pt>
                <c:pt idx="149">
                  <c:v>3.4573457000000002E-2</c:v>
                </c:pt>
                <c:pt idx="150">
                  <c:v>1.3084279999999999E-3</c:v>
                </c:pt>
                <c:pt idx="151">
                  <c:v>7.8437500000000002E-4</c:v>
                </c:pt>
                <c:pt idx="152">
                  <c:v>5.4987500000000002E-3</c:v>
                </c:pt>
                <c:pt idx="153">
                  <c:v>4.9466801999999997E-2</c:v>
                </c:pt>
                <c:pt idx="154">
                  <c:v>3.1982331000000003E-2</c:v>
                </c:pt>
                <c:pt idx="155">
                  <c:v>3.8731300000000002E-4</c:v>
                </c:pt>
                <c:pt idx="156">
                  <c:v>2.5994125E-2</c:v>
                </c:pt>
                <c:pt idx="157">
                  <c:v>9.0928648000000001E-2</c:v>
                </c:pt>
                <c:pt idx="158">
                  <c:v>8.2541699999999995E-4</c:v>
                </c:pt>
                <c:pt idx="159">
                  <c:v>4.6511000000000002E-4</c:v>
                </c:pt>
                <c:pt idx="160">
                  <c:v>3.9091244999999997E-2</c:v>
                </c:pt>
                <c:pt idx="161">
                  <c:v>1.1615975000000001E-2</c:v>
                </c:pt>
                <c:pt idx="162">
                  <c:v>7.37584E-4</c:v>
                </c:pt>
                <c:pt idx="163">
                  <c:v>1.291164E-3</c:v>
                </c:pt>
                <c:pt idx="164">
                  <c:v>8.1816899999999999E-4</c:v>
                </c:pt>
                <c:pt idx="165">
                  <c:v>3.1786819999999999E-3</c:v>
                </c:pt>
                <c:pt idx="166">
                  <c:v>1.4074751999999999E-2</c:v>
                </c:pt>
                <c:pt idx="167">
                  <c:v>2.3145061000000001E-2</c:v>
                </c:pt>
                <c:pt idx="168">
                  <c:v>1.6687634E-2</c:v>
                </c:pt>
                <c:pt idx="169">
                  <c:v>9.9747220000000001E-3</c:v>
                </c:pt>
                <c:pt idx="170">
                  <c:v>2.7527514999999999E-2</c:v>
                </c:pt>
                <c:pt idx="171">
                  <c:v>5.6662190000000001E-3</c:v>
                </c:pt>
                <c:pt idx="172">
                  <c:v>1.2692719999999999E-3</c:v>
                </c:pt>
                <c:pt idx="173">
                  <c:v>4.8970999999999997E-4</c:v>
                </c:pt>
                <c:pt idx="174">
                  <c:v>5.4528224E-2</c:v>
                </c:pt>
                <c:pt idx="175">
                  <c:v>3.4231969999999998E-3</c:v>
                </c:pt>
                <c:pt idx="176">
                  <c:v>1.6881953000000002E-2</c:v>
                </c:pt>
                <c:pt idx="177">
                  <c:v>2.1654794000000002E-2</c:v>
                </c:pt>
                <c:pt idx="178">
                  <c:v>3.7137569999999998E-3</c:v>
                </c:pt>
                <c:pt idx="179">
                  <c:v>1.7374494000000001E-2</c:v>
                </c:pt>
                <c:pt idx="180">
                  <c:v>7.5957599999999998E-4</c:v>
                </c:pt>
                <c:pt idx="181">
                  <c:v>3.5003432000000001E-2</c:v>
                </c:pt>
                <c:pt idx="182">
                  <c:v>1.1584417E-2</c:v>
                </c:pt>
                <c:pt idx="183">
                  <c:v>2.4758129999999999E-3</c:v>
                </c:pt>
                <c:pt idx="184">
                  <c:v>1.5511169E-2</c:v>
                </c:pt>
                <c:pt idx="185">
                  <c:v>5.7576999999999997E-4</c:v>
                </c:pt>
                <c:pt idx="186">
                  <c:v>1.3880863E-2</c:v>
                </c:pt>
                <c:pt idx="187">
                  <c:v>1.067772E-3</c:v>
                </c:pt>
                <c:pt idx="188">
                  <c:v>8.2864400000000002E-4</c:v>
                </c:pt>
                <c:pt idx="189">
                  <c:v>1.809878E-3</c:v>
                </c:pt>
                <c:pt idx="190">
                  <c:v>2.1155146E-2</c:v>
                </c:pt>
                <c:pt idx="191">
                  <c:v>1.9894201E-2</c:v>
                </c:pt>
                <c:pt idx="192">
                  <c:v>1.097404E-3</c:v>
                </c:pt>
                <c:pt idx="193">
                  <c:v>1.5993069999999999E-3</c:v>
                </c:pt>
                <c:pt idx="194">
                  <c:v>2.327534E-3</c:v>
                </c:pt>
                <c:pt idx="195">
                  <c:v>2.8210927E-2</c:v>
                </c:pt>
                <c:pt idx="196">
                  <c:v>2.4966010000000002E-3</c:v>
                </c:pt>
                <c:pt idx="197">
                  <c:v>7.103224E-3</c:v>
                </c:pt>
                <c:pt idx="198">
                  <c:v>1.4877569E-2</c:v>
                </c:pt>
                <c:pt idx="199">
                  <c:v>1.4937449E-2</c:v>
                </c:pt>
                <c:pt idx="200">
                  <c:v>3.3473219999999998E-3</c:v>
                </c:pt>
                <c:pt idx="201">
                  <c:v>4.2328899999999998E-4</c:v>
                </c:pt>
                <c:pt idx="202">
                  <c:v>1.493624E-3</c:v>
                </c:pt>
                <c:pt idx="203">
                  <c:v>5.7753399999999999E-4</c:v>
                </c:pt>
                <c:pt idx="204">
                  <c:v>1.5040426000000001E-2</c:v>
                </c:pt>
                <c:pt idx="205">
                  <c:v>2.283921E-3</c:v>
                </c:pt>
                <c:pt idx="206">
                  <c:v>2.0803290000000001E-3</c:v>
                </c:pt>
                <c:pt idx="207">
                  <c:v>4.0815300000000002E-4</c:v>
                </c:pt>
                <c:pt idx="208">
                  <c:v>1.3478189E-2</c:v>
                </c:pt>
                <c:pt idx="209">
                  <c:v>8.3964100000000002E-4</c:v>
                </c:pt>
                <c:pt idx="210">
                  <c:v>1.3268017E-2</c:v>
                </c:pt>
                <c:pt idx="211">
                  <c:v>3.2715959999999999E-3</c:v>
                </c:pt>
                <c:pt idx="212">
                  <c:v>2.1182414E-2</c:v>
                </c:pt>
                <c:pt idx="213">
                  <c:v>2.9237322E-2</c:v>
                </c:pt>
                <c:pt idx="214">
                  <c:v>9.6304919999999992E-3</c:v>
                </c:pt>
                <c:pt idx="215">
                  <c:v>1.6896332E-2</c:v>
                </c:pt>
                <c:pt idx="216">
                  <c:v>6.6480920000000004E-3</c:v>
                </c:pt>
                <c:pt idx="217">
                  <c:v>1.2791899999999999E-3</c:v>
                </c:pt>
                <c:pt idx="218">
                  <c:v>2.8957291999999999E-2</c:v>
                </c:pt>
                <c:pt idx="219">
                  <c:v>2.4516099999999998E-4</c:v>
                </c:pt>
                <c:pt idx="220">
                  <c:v>3.0112730000000001E-3</c:v>
                </c:pt>
                <c:pt idx="221">
                  <c:v>6.6226000000000002E-4</c:v>
                </c:pt>
                <c:pt idx="222">
                  <c:v>1.2261806E-2</c:v>
                </c:pt>
                <c:pt idx="223">
                  <c:v>2.9924800000000001E-3</c:v>
                </c:pt>
                <c:pt idx="224">
                  <c:v>4.2066229999999996E-3</c:v>
                </c:pt>
                <c:pt idx="225">
                  <c:v>3.5756849999999999E-3</c:v>
                </c:pt>
                <c:pt idx="226">
                  <c:v>3.1660571999999998E-2</c:v>
                </c:pt>
                <c:pt idx="227">
                  <c:v>9.2661459999999994E-3</c:v>
                </c:pt>
                <c:pt idx="228">
                  <c:v>3.0216158999999999E-2</c:v>
                </c:pt>
                <c:pt idx="229">
                  <c:v>2.8549600000000001E-3</c:v>
                </c:pt>
                <c:pt idx="230">
                  <c:v>5.5293400000000004E-4</c:v>
                </c:pt>
                <c:pt idx="231">
                  <c:v>1.90238E-3</c:v>
                </c:pt>
                <c:pt idx="232">
                  <c:v>6.903785E-3</c:v>
                </c:pt>
                <c:pt idx="233">
                  <c:v>4.46957E-4</c:v>
                </c:pt>
                <c:pt idx="234">
                  <c:v>3.30592E-4</c:v>
                </c:pt>
                <c:pt idx="235">
                  <c:v>1.4117400000000001E-3</c:v>
                </c:pt>
                <c:pt idx="236">
                  <c:v>9.949850000000001E-4</c:v>
                </c:pt>
                <c:pt idx="237">
                  <c:v>4.7311384999999997E-2</c:v>
                </c:pt>
                <c:pt idx="238">
                  <c:v>5.2697499999999995E-4</c:v>
                </c:pt>
                <c:pt idx="239">
                  <c:v>2.0023624E-2</c:v>
                </c:pt>
                <c:pt idx="240">
                  <c:v>1.594488E-3</c:v>
                </c:pt>
                <c:pt idx="241">
                  <c:v>1.9948990000000001E-3</c:v>
                </c:pt>
                <c:pt idx="242">
                  <c:v>3.7867696999999999E-2</c:v>
                </c:pt>
                <c:pt idx="243">
                  <c:v>4.1858075000000002E-2</c:v>
                </c:pt>
                <c:pt idx="244">
                  <c:v>3.5063100000000001E-4</c:v>
                </c:pt>
                <c:pt idx="245">
                  <c:v>1.4846270000000001E-3</c:v>
                </c:pt>
                <c:pt idx="246">
                  <c:v>3.9043670000000002E-3</c:v>
                </c:pt>
                <c:pt idx="247">
                  <c:v>4.2595877999999997E-2</c:v>
                </c:pt>
                <c:pt idx="248">
                  <c:v>3.8052390000000002E-3</c:v>
                </c:pt>
                <c:pt idx="249">
                  <c:v>1.039445E-3</c:v>
                </c:pt>
                <c:pt idx="250">
                  <c:v>4.6137510000000001E-3</c:v>
                </c:pt>
                <c:pt idx="251">
                  <c:v>1.1910151000000001E-2</c:v>
                </c:pt>
                <c:pt idx="252">
                  <c:v>6.1706809999999999E-3</c:v>
                </c:pt>
                <c:pt idx="253">
                  <c:v>5.4193899999999996E-4</c:v>
                </c:pt>
                <c:pt idx="254">
                  <c:v>4.7411799999999999E-4</c:v>
                </c:pt>
                <c:pt idx="255">
                  <c:v>1.8320229999999999E-3</c:v>
                </c:pt>
                <c:pt idx="256">
                  <c:v>2.9263042999999999E-2</c:v>
                </c:pt>
                <c:pt idx="257">
                  <c:v>2.5158956999999999E-2</c:v>
                </c:pt>
                <c:pt idx="258">
                  <c:v>6.1125700000000003E-4</c:v>
                </c:pt>
                <c:pt idx="259">
                  <c:v>9.5065099999999995E-4</c:v>
                </c:pt>
                <c:pt idx="260">
                  <c:v>7.79939E-4</c:v>
                </c:pt>
                <c:pt idx="261">
                  <c:v>2.4792130000000001E-3</c:v>
                </c:pt>
                <c:pt idx="262">
                  <c:v>1.0785669999999999E-3</c:v>
                </c:pt>
                <c:pt idx="263">
                  <c:v>1.028529E-3</c:v>
                </c:pt>
                <c:pt idx="264">
                  <c:v>4.0300510999999997E-2</c:v>
                </c:pt>
                <c:pt idx="265">
                  <c:v>2.5588144E-2</c:v>
                </c:pt>
                <c:pt idx="266">
                  <c:v>3.1670265000000003E-2</c:v>
                </c:pt>
                <c:pt idx="267">
                  <c:v>9.6824830000000004E-3</c:v>
                </c:pt>
                <c:pt idx="268">
                  <c:v>5.978E-4</c:v>
                </c:pt>
                <c:pt idx="269">
                  <c:v>2.7045216E-2</c:v>
                </c:pt>
                <c:pt idx="270">
                  <c:v>5.7841900000000005E-4</c:v>
                </c:pt>
                <c:pt idx="271">
                  <c:v>1.5543589999999999E-3</c:v>
                </c:pt>
                <c:pt idx="272">
                  <c:v>2.9366513E-2</c:v>
                </c:pt>
                <c:pt idx="273">
                  <c:v>8.0502700000000004E-4</c:v>
                </c:pt>
                <c:pt idx="274">
                  <c:v>9.4509499999999996E-4</c:v>
                </c:pt>
                <c:pt idx="275">
                  <c:v>5.8637799999999999E-3</c:v>
                </c:pt>
                <c:pt idx="276">
                  <c:v>1.0066249999999999E-3</c:v>
                </c:pt>
                <c:pt idx="277">
                  <c:v>2.2658713E-2</c:v>
                </c:pt>
                <c:pt idx="278">
                  <c:v>2.3197460000000001E-3</c:v>
                </c:pt>
                <c:pt idx="279">
                  <c:v>6.6420840000000004E-3</c:v>
                </c:pt>
                <c:pt idx="280">
                  <c:v>2.5237859000000001E-2</c:v>
                </c:pt>
                <c:pt idx="281">
                  <c:v>6.3837300000000002E-4</c:v>
                </c:pt>
                <c:pt idx="282">
                  <c:v>2.4550879999999998E-3</c:v>
                </c:pt>
                <c:pt idx="283">
                  <c:v>3.0178692999999999E-2</c:v>
                </c:pt>
                <c:pt idx="284">
                  <c:v>5.6826299999999995E-4</c:v>
                </c:pt>
                <c:pt idx="285">
                  <c:v>1.003451E-3</c:v>
                </c:pt>
                <c:pt idx="286">
                  <c:v>1.7444509999999999E-3</c:v>
                </c:pt>
                <c:pt idx="287">
                  <c:v>9.2932899999999992E-3</c:v>
                </c:pt>
                <c:pt idx="288">
                  <c:v>2.4081879999999999E-3</c:v>
                </c:pt>
                <c:pt idx="289">
                  <c:v>9.8719400000000005E-4</c:v>
                </c:pt>
                <c:pt idx="290">
                  <c:v>3.092437E-2</c:v>
                </c:pt>
                <c:pt idx="291">
                  <c:v>1.0805756E-2</c:v>
                </c:pt>
                <c:pt idx="292">
                  <c:v>8.2077299999999999E-3</c:v>
                </c:pt>
                <c:pt idx="293">
                  <c:v>7.1613099999999995E-4</c:v>
                </c:pt>
                <c:pt idx="294">
                  <c:v>8.8999809999999995E-3</c:v>
                </c:pt>
                <c:pt idx="295">
                  <c:v>1.2175529999999999E-3</c:v>
                </c:pt>
                <c:pt idx="296">
                  <c:v>2.6452950000000002E-3</c:v>
                </c:pt>
                <c:pt idx="297">
                  <c:v>5.27343E-4</c:v>
                </c:pt>
                <c:pt idx="298">
                  <c:v>7.1120000000000005E-4</c:v>
                </c:pt>
                <c:pt idx="299">
                  <c:v>2.0102651999999999E-2</c:v>
                </c:pt>
                <c:pt idx="300">
                  <c:v>2.2707199999999999E-3</c:v>
                </c:pt>
                <c:pt idx="301">
                  <c:v>2.4836469999999999E-3</c:v>
                </c:pt>
                <c:pt idx="302">
                  <c:v>3.5906421000000001E-2</c:v>
                </c:pt>
                <c:pt idx="303">
                  <c:v>7.4022899999999997E-3</c:v>
                </c:pt>
                <c:pt idx="304">
                  <c:v>3.4461477999999997E-2</c:v>
                </c:pt>
                <c:pt idx="305">
                  <c:v>3.3886570000000002E-3</c:v>
                </c:pt>
                <c:pt idx="306">
                  <c:v>8.8637199999999996E-4</c:v>
                </c:pt>
                <c:pt idx="307">
                  <c:v>4.5833852000000001E-2</c:v>
                </c:pt>
                <c:pt idx="308">
                  <c:v>6.9970989999999997E-3</c:v>
                </c:pt>
                <c:pt idx="309">
                  <c:v>2.2935779999999999E-2</c:v>
                </c:pt>
                <c:pt idx="310">
                  <c:v>4.2350899999999997E-4</c:v>
                </c:pt>
                <c:pt idx="311">
                  <c:v>5.1728199999999998E-4</c:v>
                </c:pt>
                <c:pt idx="312">
                  <c:v>3.9185679999999999E-3</c:v>
                </c:pt>
                <c:pt idx="313">
                  <c:v>3.9414799999999998E-4</c:v>
                </c:pt>
                <c:pt idx="314">
                  <c:v>4.3607999999999999E-4</c:v>
                </c:pt>
                <c:pt idx="315">
                  <c:v>1.973654E-3</c:v>
                </c:pt>
                <c:pt idx="316">
                  <c:v>3.3830299999999998E-4</c:v>
                </c:pt>
                <c:pt idx="317">
                  <c:v>2.6090289999999999E-2</c:v>
                </c:pt>
                <c:pt idx="318">
                  <c:v>2.0247680000000001E-3</c:v>
                </c:pt>
                <c:pt idx="319">
                  <c:v>7.9894700000000005E-4</c:v>
                </c:pt>
                <c:pt idx="320">
                  <c:v>1.2606848E-2</c:v>
                </c:pt>
                <c:pt idx="321">
                  <c:v>1.5784950000000001E-3</c:v>
                </c:pt>
                <c:pt idx="322">
                  <c:v>9.4413850000000001E-3</c:v>
                </c:pt>
                <c:pt idx="323">
                  <c:v>2.1213130000000001E-3</c:v>
                </c:pt>
                <c:pt idx="324">
                  <c:v>1.9430507999999999E-2</c:v>
                </c:pt>
                <c:pt idx="325">
                  <c:v>5.4907899999999995E-4</c:v>
                </c:pt>
                <c:pt idx="326">
                  <c:v>4.9684300000000002E-3</c:v>
                </c:pt>
                <c:pt idx="327">
                  <c:v>2.438974E-3</c:v>
                </c:pt>
                <c:pt idx="328">
                  <c:v>5.9262300000000002E-4</c:v>
                </c:pt>
                <c:pt idx="329">
                  <c:v>5.7717189999999998E-3</c:v>
                </c:pt>
                <c:pt idx="330">
                  <c:v>2.4286907999999999E-2</c:v>
                </c:pt>
                <c:pt idx="331">
                  <c:v>2.2366539999999998E-3</c:v>
                </c:pt>
                <c:pt idx="332">
                  <c:v>1.299786E-3</c:v>
                </c:pt>
                <c:pt idx="333">
                  <c:v>2.573564E-3</c:v>
                </c:pt>
                <c:pt idx="334">
                  <c:v>2.3859839999999998E-3</c:v>
                </c:pt>
                <c:pt idx="335">
                  <c:v>1.055795E-3</c:v>
                </c:pt>
                <c:pt idx="336">
                  <c:v>1.3688423999999999E-2</c:v>
                </c:pt>
                <c:pt idx="337">
                  <c:v>6.4108700000000004E-4</c:v>
                </c:pt>
                <c:pt idx="338">
                  <c:v>2.303519E-3</c:v>
                </c:pt>
                <c:pt idx="339">
                  <c:v>1.0348418999999999E-2</c:v>
                </c:pt>
                <c:pt idx="340">
                  <c:v>2.6949457999999999E-2</c:v>
                </c:pt>
                <c:pt idx="341">
                  <c:v>4.1698899999999999E-4</c:v>
                </c:pt>
                <c:pt idx="342">
                  <c:v>1.0106041E-2</c:v>
                </c:pt>
                <c:pt idx="343">
                  <c:v>2.510179E-3</c:v>
                </c:pt>
                <c:pt idx="344">
                  <c:v>8.1575899999999999E-4</c:v>
                </c:pt>
                <c:pt idx="345">
                  <c:v>1.8788020999999999E-2</c:v>
                </c:pt>
                <c:pt idx="346">
                  <c:v>3.6559740000000002E-3</c:v>
                </c:pt>
                <c:pt idx="347">
                  <c:v>5.5827020000000002E-3</c:v>
                </c:pt>
                <c:pt idx="348">
                  <c:v>1.0156970000000001E-3</c:v>
                </c:pt>
                <c:pt idx="349">
                  <c:v>3.4046530000000001E-3</c:v>
                </c:pt>
                <c:pt idx="350">
                  <c:v>3.8258734000000003E-2</c:v>
                </c:pt>
                <c:pt idx="351">
                  <c:v>1.1040068E-2</c:v>
                </c:pt>
                <c:pt idx="352">
                  <c:v>3.9241636000000003E-2</c:v>
                </c:pt>
                <c:pt idx="353">
                  <c:v>2.7252029000000001E-2</c:v>
                </c:pt>
                <c:pt idx="354">
                  <c:v>6.9727999999999999E-4</c:v>
                </c:pt>
                <c:pt idx="355">
                  <c:v>6.9277499999999997E-4</c:v>
                </c:pt>
                <c:pt idx="356">
                  <c:v>1.6261709999999999E-2</c:v>
                </c:pt>
                <c:pt idx="357">
                  <c:v>6.6227300000000001E-4</c:v>
                </c:pt>
                <c:pt idx="358">
                  <c:v>1.5365177000000001E-2</c:v>
                </c:pt>
                <c:pt idx="359">
                  <c:v>5.9433755999999997E-2</c:v>
                </c:pt>
                <c:pt idx="360">
                  <c:v>5.9179000000000002E-4</c:v>
                </c:pt>
                <c:pt idx="361">
                  <c:v>9.5425700000000002E-4</c:v>
                </c:pt>
                <c:pt idx="362">
                  <c:v>1.2090003E-2</c:v>
                </c:pt>
                <c:pt idx="363">
                  <c:v>1.2245277000000001E-2</c:v>
                </c:pt>
                <c:pt idx="364">
                  <c:v>2.1827322999999999E-2</c:v>
                </c:pt>
                <c:pt idx="365">
                  <c:v>2.384433E-3</c:v>
                </c:pt>
                <c:pt idx="366">
                  <c:v>7.2293699999999999E-4</c:v>
                </c:pt>
                <c:pt idx="367">
                  <c:v>3.4300956000000001E-2</c:v>
                </c:pt>
                <c:pt idx="368">
                  <c:v>2.0243166999999999E-2</c:v>
                </c:pt>
                <c:pt idx="369">
                  <c:v>6.6702180000000003E-3</c:v>
                </c:pt>
                <c:pt idx="370">
                  <c:v>9.9733740000000001E-3</c:v>
                </c:pt>
                <c:pt idx="371">
                  <c:v>4.192777E-3</c:v>
                </c:pt>
                <c:pt idx="372">
                  <c:v>2.4807757E-2</c:v>
                </c:pt>
                <c:pt idx="373">
                  <c:v>1.0086466000000001E-2</c:v>
                </c:pt>
                <c:pt idx="374">
                  <c:v>5.6649900000000004E-4</c:v>
                </c:pt>
                <c:pt idx="375">
                  <c:v>6.7209405999999999E-2</c:v>
                </c:pt>
                <c:pt idx="376">
                  <c:v>1.1369227000000001E-2</c:v>
                </c:pt>
                <c:pt idx="377">
                  <c:v>5.3681699999999998E-4</c:v>
                </c:pt>
                <c:pt idx="378">
                  <c:v>1.7008069999999999E-3</c:v>
                </c:pt>
                <c:pt idx="379">
                  <c:v>4.4010499999999999E-4</c:v>
                </c:pt>
                <c:pt idx="380">
                  <c:v>1.6757839E-2</c:v>
                </c:pt>
                <c:pt idx="381">
                  <c:v>3.9291167000000002E-2</c:v>
                </c:pt>
                <c:pt idx="382">
                  <c:v>2.5439198999999999E-2</c:v>
                </c:pt>
                <c:pt idx="383">
                  <c:v>2.2248277E-2</c:v>
                </c:pt>
                <c:pt idx="384">
                  <c:v>8.3208659999999997E-3</c:v>
                </c:pt>
                <c:pt idx="385">
                  <c:v>2.6332101E-2</c:v>
                </c:pt>
                <c:pt idx="386">
                  <c:v>2.9576195999999999E-2</c:v>
                </c:pt>
                <c:pt idx="387">
                  <c:v>8.4486399999999997E-4</c:v>
                </c:pt>
                <c:pt idx="388">
                  <c:v>3.5596165999999999E-2</c:v>
                </c:pt>
                <c:pt idx="389">
                  <c:v>6.9454499999999997E-4</c:v>
                </c:pt>
                <c:pt idx="390">
                  <c:v>3.1440345000000001E-2</c:v>
                </c:pt>
                <c:pt idx="391">
                  <c:v>1.8988379999999999E-3</c:v>
                </c:pt>
                <c:pt idx="392">
                  <c:v>1.8447623E-2</c:v>
                </c:pt>
                <c:pt idx="393">
                  <c:v>2.552038E-3</c:v>
                </c:pt>
                <c:pt idx="394">
                  <c:v>2.3353470000000002E-3</c:v>
                </c:pt>
                <c:pt idx="395">
                  <c:v>7.7813700000000003E-4</c:v>
                </c:pt>
                <c:pt idx="396">
                  <c:v>8.2923100000000004E-4</c:v>
                </c:pt>
                <c:pt idx="397">
                  <c:v>4.2681000000000004E-3</c:v>
                </c:pt>
                <c:pt idx="398">
                  <c:v>3.8543599999999998E-3</c:v>
                </c:pt>
                <c:pt idx="399">
                  <c:v>2.5328460000000001E-2</c:v>
                </c:pt>
                <c:pt idx="400">
                  <c:v>2.5720568999999999E-2</c:v>
                </c:pt>
                <c:pt idx="401">
                  <c:v>3.103242E-3</c:v>
                </c:pt>
                <c:pt idx="402">
                  <c:v>5.4776499999999997E-4</c:v>
                </c:pt>
                <c:pt idx="403">
                  <c:v>5.5074499999999997E-3</c:v>
                </c:pt>
                <c:pt idx="404">
                  <c:v>5.5874710000000001E-3</c:v>
                </c:pt>
                <c:pt idx="405">
                  <c:v>2.021386E-3</c:v>
                </c:pt>
                <c:pt idx="406">
                  <c:v>4.2153449000000003E-2</c:v>
                </c:pt>
                <c:pt idx="407">
                  <c:v>1.5332286000000001E-2</c:v>
                </c:pt>
                <c:pt idx="408">
                  <c:v>5.2846719999999998E-3</c:v>
                </c:pt>
                <c:pt idx="409">
                  <c:v>3.1835321E-2</c:v>
                </c:pt>
                <c:pt idx="410">
                  <c:v>1.9950504000000001E-2</c:v>
                </c:pt>
                <c:pt idx="411">
                  <c:v>1.2748690000000001E-3</c:v>
                </c:pt>
                <c:pt idx="412">
                  <c:v>4.3679334E-2</c:v>
                </c:pt>
                <c:pt idx="413">
                  <c:v>9.0544969999999999E-3</c:v>
                </c:pt>
                <c:pt idx="414">
                  <c:v>8.3601699999999999E-4</c:v>
                </c:pt>
                <c:pt idx="415">
                  <c:v>5.4914000000000004E-4</c:v>
                </c:pt>
                <c:pt idx="416">
                  <c:v>1.0408132E-2</c:v>
                </c:pt>
                <c:pt idx="417">
                  <c:v>4.5426499999999997E-4</c:v>
                </c:pt>
                <c:pt idx="418">
                  <c:v>4.5212960000000002E-3</c:v>
                </c:pt>
                <c:pt idx="419">
                  <c:v>1.421758E-3</c:v>
                </c:pt>
                <c:pt idx="420">
                  <c:v>2.5926837000000001E-2</c:v>
                </c:pt>
                <c:pt idx="421">
                  <c:v>8.5567200000000003E-3</c:v>
                </c:pt>
                <c:pt idx="422">
                  <c:v>7.2710199999999998E-4</c:v>
                </c:pt>
                <c:pt idx="423">
                  <c:v>1.3490959999999999E-3</c:v>
                </c:pt>
                <c:pt idx="424">
                  <c:v>2.8900369999999998E-3</c:v>
                </c:pt>
                <c:pt idx="425">
                  <c:v>1.5486672999999999E-2</c:v>
                </c:pt>
                <c:pt idx="426">
                  <c:v>1.3745353E-2</c:v>
                </c:pt>
                <c:pt idx="427">
                  <c:v>3.2265055000000001E-2</c:v>
                </c:pt>
                <c:pt idx="428">
                  <c:v>5.4227119999999997E-3</c:v>
                </c:pt>
                <c:pt idx="429">
                  <c:v>9.5844499999999996E-3</c:v>
                </c:pt>
                <c:pt idx="430">
                  <c:v>8.2714400000000003E-4</c:v>
                </c:pt>
                <c:pt idx="431">
                  <c:v>5.6828E-4</c:v>
                </c:pt>
                <c:pt idx="432">
                  <c:v>1.2834194E-2</c:v>
                </c:pt>
                <c:pt idx="433">
                  <c:v>1.6517444999999999E-2</c:v>
                </c:pt>
                <c:pt idx="434">
                  <c:v>1.4050880999999999E-2</c:v>
                </c:pt>
                <c:pt idx="435">
                  <c:v>3.3192724E-2</c:v>
                </c:pt>
                <c:pt idx="436">
                  <c:v>1.5458290000000001E-3</c:v>
                </c:pt>
                <c:pt idx="437">
                  <c:v>3.2963350000000001E-3</c:v>
                </c:pt>
                <c:pt idx="438">
                  <c:v>3.0975740000000001E-3</c:v>
                </c:pt>
                <c:pt idx="439">
                  <c:v>2.086194E-3</c:v>
                </c:pt>
                <c:pt idx="440">
                  <c:v>2.1848507E-2</c:v>
                </c:pt>
                <c:pt idx="441">
                  <c:v>4.9875049999999997E-3</c:v>
                </c:pt>
                <c:pt idx="442">
                  <c:v>3.1558373000000001E-2</c:v>
                </c:pt>
                <c:pt idx="443">
                  <c:v>6.1820899999999999E-4</c:v>
                </c:pt>
                <c:pt idx="444">
                  <c:v>4.2540800000000004E-3</c:v>
                </c:pt>
                <c:pt idx="445">
                  <c:v>3.6317089999999999E-3</c:v>
                </c:pt>
                <c:pt idx="446">
                  <c:v>1.583238E-3</c:v>
                </c:pt>
                <c:pt idx="447">
                  <c:v>2.7886547000000001E-2</c:v>
                </c:pt>
                <c:pt idx="448">
                  <c:v>2.2724279999999999E-3</c:v>
                </c:pt>
                <c:pt idx="449">
                  <c:v>2.8368500000000001E-3</c:v>
                </c:pt>
                <c:pt idx="450">
                  <c:v>2.8616803E-2</c:v>
                </c:pt>
                <c:pt idx="451">
                  <c:v>1.6861949000000001E-2</c:v>
                </c:pt>
                <c:pt idx="452">
                  <c:v>3.7011650000000002E-3</c:v>
                </c:pt>
                <c:pt idx="453">
                  <c:v>1.1385522E-2</c:v>
                </c:pt>
                <c:pt idx="454">
                  <c:v>2.3835238000000002E-2</c:v>
                </c:pt>
                <c:pt idx="455">
                  <c:v>7.6480199999999997E-4</c:v>
                </c:pt>
                <c:pt idx="456">
                  <c:v>1.506424E-2</c:v>
                </c:pt>
                <c:pt idx="457">
                  <c:v>3.8711399999999999E-3</c:v>
                </c:pt>
                <c:pt idx="458">
                  <c:v>1.4623924E-2</c:v>
                </c:pt>
                <c:pt idx="459">
                  <c:v>8.5657479999999998E-3</c:v>
                </c:pt>
                <c:pt idx="460">
                  <c:v>6.4759099999999999E-4</c:v>
                </c:pt>
                <c:pt idx="461">
                  <c:v>4.7149039999999998E-3</c:v>
                </c:pt>
                <c:pt idx="462">
                  <c:v>3.290645E-3</c:v>
                </c:pt>
                <c:pt idx="463">
                  <c:v>0.122284482</c:v>
                </c:pt>
                <c:pt idx="464">
                  <c:v>1.2330850000000001E-3</c:v>
                </c:pt>
                <c:pt idx="465">
                  <c:v>1.783597E-3</c:v>
                </c:pt>
                <c:pt idx="466">
                  <c:v>3.1497690000000002E-3</c:v>
                </c:pt>
                <c:pt idx="467">
                  <c:v>4.9406600000000004E-3</c:v>
                </c:pt>
                <c:pt idx="468">
                  <c:v>5.5157800000000005E-4</c:v>
                </c:pt>
                <c:pt idx="469">
                  <c:v>3.9201599999999998E-3</c:v>
                </c:pt>
                <c:pt idx="470">
                  <c:v>2.2934122000000001E-2</c:v>
                </c:pt>
                <c:pt idx="471">
                  <c:v>1.3845025E-2</c:v>
                </c:pt>
                <c:pt idx="472">
                  <c:v>6.1427929999999997E-3</c:v>
                </c:pt>
                <c:pt idx="473">
                  <c:v>8.9122799999999999E-4</c:v>
                </c:pt>
                <c:pt idx="474">
                  <c:v>5.01232E-4</c:v>
                </c:pt>
                <c:pt idx="475">
                  <c:v>1.9548199999999999E-3</c:v>
                </c:pt>
                <c:pt idx="476">
                  <c:v>3.597912E-3</c:v>
                </c:pt>
                <c:pt idx="477">
                  <c:v>1.347624E-3</c:v>
                </c:pt>
                <c:pt idx="478">
                  <c:v>1.5502683999999999E-2</c:v>
                </c:pt>
                <c:pt idx="479">
                  <c:v>3.2985879999999999E-3</c:v>
                </c:pt>
                <c:pt idx="480">
                  <c:v>3.1370479999999999E-2</c:v>
                </c:pt>
                <c:pt idx="481">
                  <c:v>2.1187445999999999E-2</c:v>
                </c:pt>
                <c:pt idx="482">
                  <c:v>1.5811794000000001E-2</c:v>
                </c:pt>
                <c:pt idx="483">
                  <c:v>7.4420170000000004E-3</c:v>
                </c:pt>
                <c:pt idx="484">
                  <c:v>1.102921E-3</c:v>
                </c:pt>
                <c:pt idx="485">
                  <c:v>1.1104628E-2</c:v>
                </c:pt>
                <c:pt idx="486">
                  <c:v>9.5504699999999999E-4</c:v>
                </c:pt>
                <c:pt idx="487">
                  <c:v>2.8963991000000001E-2</c:v>
                </c:pt>
                <c:pt idx="488">
                  <c:v>5.5961412000000002E-2</c:v>
                </c:pt>
                <c:pt idx="489">
                  <c:v>2.2206806999999999E-2</c:v>
                </c:pt>
                <c:pt idx="490">
                  <c:v>2.0634579999999998E-3</c:v>
                </c:pt>
                <c:pt idx="491">
                  <c:v>2.3764157000000001E-2</c:v>
                </c:pt>
                <c:pt idx="492">
                  <c:v>8.9801719999999998E-3</c:v>
                </c:pt>
                <c:pt idx="493">
                  <c:v>2.54174E-2</c:v>
                </c:pt>
                <c:pt idx="494">
                  <c:v>1.1804599000000001E-2</c:v>
                </c:pt>
                <c:pt idx="495">
                  <c:v>8.3608E-4</c:v>
                </c:pt>
                <c:pt idx="496">
                  <c:v>9.9029499999999998E-4</c:v>
                </c:pt>
                <c:pt idx="497">
                  <c:v>2.0637367E-2</c:v>
                </c:pt>
                <c:pt idx="498">
                  <c:v>2.0265729999999998E-3</c:v>
                </c:pt>
                <c:pt idx="499">
                  <c:v>1.4421526E-2</c:v>
                </c:pt>
                <c:pt idx="500">
                  <c:v>1.0609242E-2</c:v>
                </c:pt>
                <c:pt idx="501">
                  <c:v>1.4392271E-2</c:v>
                </c:pt>
                <c:pt idx="502">
                  <c:v>3.2971910000000001E-3</c:v>
                </c:pt>
                <c:pt idx="503">
                  <c:v>1.912198E-2</c:v>
                </c:pt>
                <c:pt idx="504">
                  <c:v>9.4671200000000005E-4</c:v>
                </c:pt>
                <c:pt idx="505">
                  <c:v>1.2888172999999999E-2</c:v>
                </c:pt>
                <c:pt idx="506">
                  <c:v>9.8438400000000004E-4</c:v>
                </c:pt>
                <c:pt idx="507">
                  <c:v>1.043165E-3</c:v>
                </c:pt>
                <c:pt idx="508">
                  <c:v>1.8807969000000001E-2</c:v>
                </c:pt>
                <c:pt idx="509">
                  <c:v>9.6064919999999995E-3</c:v>
                </c:pt>
                <c:pt idx="510">
                  <c:v>1.6212793E-2</c:v>
                </c:pt>
                <c:pt idx="511">
                  <c:v>1.4546310000000001E-3</c:v>
                </c:pt>
                <c:pt idx="512">
                  <c:v>1.641768E-3</c:v>
                </c:pt>
                <c:pt idx="513">
                  <c:v>1.9206679999999999E-3</c:v>
                </c:pt>
                <c:pt idx="514">
                  <c:v>2.12813E-2</c:v>
                </c:pt>
                <c:pt idx="515">
                  <c:v>1.4132126E-2</c:v>
                </c:pt>
                <c:pt idx="516">
                  <c:v>2.3841642E-2</c:v>
                </c:pt>
                <c:pt idx="517">
                  <c:v>2.264209E-2</c:v>
                </c:pt>
                <c:pt idx="518">
                  <c:v>2.9713218999999999E-2</c:v>
                </c:pt>
                <c:pt idx="519">
                  <c:v>2.5778091999999999E-2</c:v>
                </c:pt>
                <c:pt idx="520">
                  <c:v>2.5803099999999999E-2</c:v>
                </c:pt>
                <c:pt idx="521">
                  <c:v>1.6131630000000001E-2</c:v>
                </c:pt>
                <c:pt idx="522">
                  <c:v>1.6982760000000001E-3</c:v>
                </c:pt>
                <c:pt idx="523">
                  <c:v>7.9750080000000004E-3</c:v>
                </c:pt>
                <c:pt idx="524">
                  <c:v>5.9108759999999998E-3</c:v>
                </c:pt>
                <c:pt idx="525">
                  <c:v>6.3474899999999999E-4</c:v>
                </c:pt>
                <c:pt idx="526">
                  <c:v>1.122912E-3</c:v>
                </c:pt>
                <c:pt idx="527">
                  <c:v>1.4771663000000001E-2</c:v>
                </c:pt>
                <c:pt idx="528">
                  <c:v>1.1561119999999999E-3</c:v>
                </c:pt>
                <c:pt idx="529">
                  <c:v>1.2650490000000001E-3</c:v>
                </c:pt>
                <c:pt idx="530">
                  <c:v>9.0425869999999995E-3</c:v>
                </c:pt>
                <c:pt idx="531">
                  <c:v>1.02257E-3</c:v>
                </c:pt>
                <c:pt idx="532">
                  <c:v>9.8426599999999992E-4</c:v>
                </c:pt>
                <c:pt idx="533">
                  <c:v>2.542852E-3</c:v>
                </c:pt>
                <c:pt idx="534">
                  <c:v>1.210294E-3</c:v>
                </c:pt>
                <c:pt idx="535">
                  <c:v>1.0916159999999999E-3</c:v>
                </c:pt>
                <c:pt idx="536">
                  <c:v>1.110689E-3</c:v>
                </c:pt>
                <c:pt idx="537">
                  <c:v>2.6830573E-2</c:v>
                </c:pt>
                <c:pt idx="538">
                  <c:v>2.015934E-3</c:v>
                </c:pt>
                <c:pt idx="539">
                  <c:v>1.0254208000000001E-2</c:v>
                </c:pt>
                <c:pt idx="540">
                  <c:v>1.0347760000000001E-3</c:v>
                </c:pt>
                <c:pt idx="541">
                  <c:v>2.9403420999999999E-2</c:v>
                </c:pt>
                <c:pt idx="542">
                  <c:v>1.4019265E-2</c:v>
                </c:pt>
                <c:pt idx="543">
                  <c:v>6.9026299999999999E-4</c:v>
                </c:pt>
                <c:pt idx="544">
                  <c:v>2.4443149999999999E-3</c:v>
                </c:pt>
                <c:pt idx="545">
                  <c:v>1.3098495E-2</c:v>
                </c:pt>
                <c:pt idx="546">
                  <c:v>5.60657E-3</c:v>
                </c:pt>
                <c:pt idx="547">
                  <c:v>1.0728507999999999E-2</c:v>
                </c:pt>
                <c:pt idx="548">
                  <c:v>1.0143210000000001E-3</c:v>
                </c:pt>
                <c:pt idx="549">
                  <c:v>1.0367998999999999E-2</c:v>
                </c:pt>
                <c:pt idx="550">
                  <c:v>2.6936390000000001E-2</c:v>
                </c:pt>
                <c:pt idx="551">
                  <c:v>7.99536E-4</c:v>
                </c:pt>
                <c:pt idx="552">
                  <c:v>6.3954449999999996E-3</c:v>
                </c:pt>
                <c:pt idx="553">
                  <c:v>6.5378300000000001E-4</c:v>
                </c:pt>
                <c:pt idx="554">
                  <c:v>1.2098579E-2</c:v>
                </c:pt>
                <c:pt idx="555">
                  <c:v>3.2895499000000002E-2</c:v>
                </c:pt>
                <c:pt idx="556">
                  <c:v>2.4167220000000001E-3</c:v>
                </c:pt>
                <c:pt idx="557">
                  <c:v>7.5180600000000005E-4</c:v>
                </c:pt>
                <c:pt idx="558">
                  <c:v>1.2752709999999999E-3</c:v>
                </c:pt>
                <c:pt idx="559">
                  <c:v>3.3430310000000002E-3</c:v>
                </c:pt>
                <c:pt idx="560">
                  <c:v>1.1359650000000001E-3</c:v>
                </c:pt>
                <c:pt idx="561">
                  <c:v>2.1931981E-2</c:v>
                </c:pt>
                <c:pt idx="562">
                  <c:v>2.8938927999999999E-2</c:v>
                </c:pt>
                <c:pt idx="563">
                  <c:v>7.5744480000000001E-3</c:v>
                </c:pt>
                <c:pt idx="564">
                  <c:v>4.9863000000000002E-4</c:v>
                </c:pt>
                <c:pt idx="565">
                  <c:v>2.4251287999999999E-2</c:v>
                </c:pt>
                <c:pt idx="566">
                  <c:v>5.8792979999999998E-3</c:v>
                </c:pt>
                <c:pt idx="567">
                  <c:v>3.7251454000000003E-2</c:v>
                </c:pt>
                <c:pt idx="568">
                  <c:v>7.1492580000000003E-3</c:v>
                </c:pt>
                <c:pt idx="569">
                  <c:v>5.8117469999999999E-3</c:v>
                </c:pt>
                <c:pt idx="570">
                  <c:v>2.2504560000000001E-3</c:v>
                </c:pt>
                <c:pt idx="571">
                  <c:v>2.9098144999999999E-2</c:v>
                </c:pt>
                <c:pt idx="572">
                  <c:v>8.7849169999999997E-3</c:v>
                </c:pt>
                <c:pt idx="573">
                  <c:v>5.5293649999999996E-3</c:v>
                </c:pt>
                <c:pt idx="574">
                  <c:v>1.6931871000000001E-2</c:v>
                </c:pt>
                <c:pt idx="575">
                  <c:v>2.0653255999999998E-2</c:v>
                </c:pt>
                <c:pt idx="576">
                  <c:v>1.5149219999999999E-3</c:v>
                </c:pt>
                <c:pt idx="577">
                  <c:v>1.3656822000000001E-2</c:v>
                </c:pt>
                <c:pt idx="578">
                  <c:v>9.2372500000000002E-4</c:v>
                </c:pt>
                <c:pt idx="579">
                  <c:v>9.5180579999999994E-3</c:v>
                </c:pt>
                <c:pt idx="580">
                  <c:v>2.574996E-3</c:v>
                </c:pt>
                <c:pt idx="581">
                  <c:v>6.1394459999999998E-3</c:v>
                </c:pt>
                <c:pt idx="582">
                  <c:v>5.2731496000000003E-2</c:v>
                </c:pt>
                <c:pt idx="583">
                  <c:v>7.1533839999999996E-3</c:v>
                </c:pt>
                <c:pt idx="584">
                  <c:v>9.1638440000000009E-3</c:v>
                </c:pt>
                <c:pt idx="585">
                  <c:v>1.545044E-3</c:v>
                </c:pt>
                <c:pt idx="586">
                  <c:v>1.5119562E-2</c:v>
                </c:pt>
                <c:pt idx="587">
                  <c:v>1.3932549999999999E-3</c:v>
                </c:pt>
                <c:pt idx="588">
                  <c:v>7.4788399999999996E-3</c:v>
                </c:pt>
                <c:pt idx="589">
                  <c:v>2.5206220000000001E-3</c:v>
                </c:pt>
                <c:pt idx="590">
                  <c:v>8.3372159999999997E-3</c:v>
                </c:pt>
                <c:pt idx="591">
                  <c:v>2.5176090000000001E-3</c:v>
                </c:pt>
                <c:pt idx="592">
                  <c:v>1.140269E-3</c:v>
                </c:pt>
                <c:pt idx="593">
                  <c:v>2.0292750000000001E-3</c:v>
                </c:pt>
                <c:pt idx="594">
                  <c:v>4.3394832000000001E-2</c:v>
                </c:pt>
                <c:pt idx="595">
                  <c:v>2.1600702999999999E-2</c:v>
                </c:pt>
                <c:pt idx="596">
                  <c:v>1.4915128999999999E-2</c:v>
                </c:pt>
                <c:pt idx="597">
                  <c:v>2.6882664000000001E-2</c:v>
                </c:pt>
                <c:pt idx="598">
                  <c:v>1.9243590000000001E-3</c:v>
                </c:pt>
                <c:pt idx="599">
                  <c:v>1.6929962999999999E-2</c:v>
                </c:pt>
                <c:pt idx="600">
                  <c:v>2.2061614E-2</c:v>
                </c:pt>
                <c:pt idx="601">
                  <c:v>1.2829594999999999E-2</c:v>
                </c:pt>
                <c:pt idx="602">
                  <c:v>1.0246261E-2</c:v>
                </c:pt>
                <c:pt idx="603">
                  <c:v>2.3650594E-2</c:v>
                </c:pt>
                <c:pt idx="604">
                  <c:v>4.9175399999999995E-4</c:v>
                </c:pt>
                <c:pt idx="605">
                  <c:v>5.334363E-3</c:v>
                </c:pt>
                <c:pt idx="606">
                  <c:v>2.8684969999999998E-3</c:v>
                </c:pt>
                <c:pt idx="607">
                  <c:v>6.8506299999999997E-4</c:v>
                </c:pt>
                <c:pt idx="608">
                  <c:v>1.448602E-3</c:v>
                </c:pt>
                <c:pt idx="609">
                  <c:v>2.2116610000000002E-3</c:v>
                </c:pt>
                <c:pt idx="610">
                  <c:v>1.0645880999999999E-2</c:v>
                </c:pt>
                <c:pt idx="611">
                  <c:v>7.7933339999999999E-3</c:v>
                </c:pt>
                <c:pt idx="612">
                  <c:v>1.2761389E-2</c:v>
                </c:pt>
                <c:pt idx="613">
                  <c:v>6.8150399999999999E-4</c:v>
                </c:pt>
                <c:pt idx="614">
                  <c:v>3.0890700000000002E-3</c:v>
                </c:pt>
                <c:pt idx="615">
                  <c:v>2.6576859999999998E-3</c:v>
                </c:pt>
                <c:pt idx="616">
                  <c:v>1.1264960000000001E-3</c:v>
                </c:pt>
                <c:pt idx="617">
                  <c:v>5.8602491E-2</c:v>
                </c:pt>
                <c:pt idx="618">
                  <c:v>1.9900358999999999E-2</c:v>
                </c:pt>
                <c:pt idx="619">
                  <c:v>4.3487894999999999E-2</c:v>
                </c:pt>
                <c:pt idx="620">
                  <c:v>5.2941399999999997E-4</c:v>
                </c:pt>
                <c:pt idx="621">
                  <c:v>8.4477100000000002E-4</c:v>
                </c:pt>
                <c:pt idx="622">
                  <c:v>2.4930870000000002E-3</c:v>
                </c:pt>
                <c:pt idx="623">
                  <c:v>1.6783267000000001E-2</c:v>
                </c:pt>
                <c:pt idx="624">
                  <c:v>5.00013E-4</c:v>
                </c:pt>
                <c:pt idx="625">
                  <c:v>8.3389100000000002E-4</c:v>
                </c:pt>
                <c:pt idx="626">
                  <c:v>2.6482879999999999E-3</c:v>
                </c:pt>
                <c:pt idx="627">
                  <c:v>3.2327469999999998E-3</c:v>
                </c:pt>
                <c:pt idx="628">
                  <c:v>2.8474434999999999E-2</c:v>
                </c:pt>
                <c:pt idx="629">
                  <c:v>4.5684389999999997E-3</c:v>
                </c:pt>
                <c:pt idx="630">
                  <c:v>6.6573200000000004E-4</c:v>
                </c:pt>
                <c:pt idx="631">
                  <c:v>1.6656846999999999E-2</c:v>
                </c:pt>
                <c:pt idx="632">
                  <c:v>1.183007E-2</c:v>
                </c:pt>
                <c:pt idx="633">
                  <c:v>6.5250476000000002E-2</c:v>
                </c:pt>
                <c:pt idx="634">
                  <c:v>2.0767582999999999E-2</c:v>
                </c:pt>
                <c:pt idx="635">
                  <c:v>1.070664E-3</c:v>
                </c:pt>
                <c:pt idx="636">
                  <c:v>1.314583E-3</c:v>
                </c:pt>
                <c:pt idx="637">
                  <c:v>3.6141749999999999E-3</c:v>
                </c:pt>
                <c:pt idx="638">
                  <c:v>1.419135E-3</c:v>
                </c:pt>
                <c:pt idx="639">
                  <c:v>8.5835499999999999E-4</c:v>
                </c:pt>
                <c:pt idx="640">
                  <c:v>4.1465909999999998E-3</c:v>
                </c:pt>
                <c:pt idx="641">
                  <c:v>2.3719399999999999E-3</c:v>
                </c:pt>
                <c:pt idx="642">
                  <c:v>1.9223113999999999E-2</c:v>
                </c:pt>
                <c:pt idx="643">
                  <c:v>7.9596699999999996E-4</c:v>
                </c:pt>
                <c:pt idx="644">
                  <c:v>4.9136259999999999E-3</c:v>
                </c:pt>
                <c:pt idx="645">
                  <c:v>5.6534E-4</c:v>
                </c:pt>
                <c:pt idx="646">
                  <c:v>1.0706235999999999E-2</c:v>
                </c:pt>
                <c:pt idx="647">
                  <c:v>2.206174E-3</c:v>
                </c:pt>
                <c:pt idx="648">
                  <c:v>2.6182549999999999E-2</c:v>
                </c:pt>
                <c:pt idx="649">
                  <c:v>1.839519E-3</c:v>
                </c:pt>
                <c:pt idx="650">
                  <c:v>1.0575109999999999E-3</c:v>
                </c:pt>
                <c:pt idx="651">
                  <c:v>3.3770190000000002E-3</c:v>
                </c:pt>
                <c:pt idx="652">
                  <c:v>6.7615980000000006E-2</c:v>
                </c:pt>
                <c:pt idx="653">
                  <c:v>4.7377390000000004E-3</c:v>
                </c:pt>
                <c:pt idx="654">
                  <c:v>4.08062E-4</c:v>
                </c:pt>
                <c:pt idx="655">
                  <c:v>3.4675673999999997E-2</c:v>
                </c:pt>
                <c:pt idx="656">
                  <c:v>2.7464410000000001E-3</c:v>
                </c:pt>
                <c:pt idx="657">
                  <c:v>6.2293757999999998E-2</c:v>
                </c:pt>
                <c:pt idx="658">
                  <c:v>9.2041900000000001E-4</c:v>
                </c:pt>
                <c:pt idx="659">
                  <c:v>1.5611139999999999E-3</c:v>
                </c:pt>
                <c:pt idx="660">
                  <c:v>2.506355E-3</c:v>
                </c:pt>
                <c:pt idx="661">
                  <c:v>4.8864670000000002E-3</c:v>
                </c:pt>
                <c:pt idx="662">
                  <c:v>1.9401720000000001E-2</c:v>
                </c:pt>
                <c:pt idx="663">
                  <c:v>9.0444899999999999E-4</c:v>
                </c:pt>
                <c:pt idx="664">
                  <c:v>2.7157510000000002E-3</c:v>
                </c:pt>
                <c:pt idx="665">
                  <c:v>3.7648262000000002E-2</c:v>
                </c:pt>
                <c:pt idx="666">
                  <c:v>1.6921074000000001E-2</c:v>
                </c:pt>
                <c:pt idx="667">
                  <c:v>3.9549723000000002E-2</c:v>
                </c:pt>
                <c:pt idx="668">
                  <c:v>1.6223735999999999E-2</c:v>
                </c:pt>
                <c:pt idx="669">
                  <c:v>8.1315799999999994E-3</c:v>
                </c:pt>
                <c:pt idx="670">
                  <c:v>2.2487098000000001E-2</c:v>
                </c:pt>
                <c:pt idx="671">
                  <c:v>1.9128182000000001E-2</c:v>
                </c:pt>
                <c:pt idx="672">
                  <c:v>1.5521393E-2</c:v>
                </c:pt>
                <c:pt idx="673">
                  <c:v>4.9586930000000001E-2</c:v>
                </c:pt>
                <c:pt idx="674">
                  <c:v>1.8699093999999999E-2</c:v>
                </c:pt>
                <c:pt idx="675">
                  <c:v>2.2396199999999999E-3</c:v>
                </c:pt>
                <c:pt idx="676">
                  <c:v>2.1269259999999999E-3</c:v>
                </c:pt>
                <c:pt idx="677">
                  <c:v>2.6004228000000001E-2</c:v>
                </c:pt>
                <c:pt idx="678">
                  <c:v>3.7601078000000003E-2</c:v>
                </c:pt>
                <c:pt idx="679">
                  <c:v>1.8897199999999999E-3</c:v>
                </c:pt>
                <c:pt idx="680">
                  <c:v>2.1550218999999999E-2</c:v>
                </c:pt>
                <c:pt idx="681">
                  <c:v>9.3259769999999992E-3</c:v>
                </c:pt>
                <c:pt idx="682">
                  <c:v>1.4198990000000001E-3</c:v>
                </c:pt>
                <c:pt idx="683">
                  <c:v>1.9666509999999998E-3</c:v>
                </c:pt>
                <c:pt idx="684">
                  <c:v>3.5928288000000003E-2</c:v>
                </c:pt>
                <c:pt idx="685">
                  <c:v>1.349144E-3</c:v>
                </c:pt>
                <c:pt idx="686">
                  <c:v>1.1963970000000001E-3</c:v>
                </c:pt>
                <c:pt idx="687">
                  <c:v>6.0335499999999997E-4</c:v>
                </c:pt>
                <c:pt idx="688">
                  <c:v>4.4014848000000002E-2</c:v>
                </c:pt>
                <c:pt idx="689">
                  <c:v>1.616171E-3</c:v>
                </c:pt>
                <c:pt idx="690">
                  <c:v>1.6553414999999998E-2</c:v>
                </c:pt>
                <c:pt idx="691">
                  <c:v>2.1855165999999999E-2</c:v>
                </c:pt>
                <c:pt idx="692">
                  <c:v>6.7876999999999998E-3</c:v>
                </c:pt>
                <c:pt idx="693">
                  <c:v>5.0324539999999996E-3</c:v>
                </c:pt>
                <c:pt idx="694">
                  <c:v>2.975821E-3</c:v>
                </c:pt>
                <c:pt idx="695">
                  <c:v>2.1214860000000001E-3</c:v>
                </c:pt>
                <c:pt idx="696">
                  <c:v>5.7951662000000001E-2</c:v>
                </c:pt>
                <c:pt idx="697">
                  <c:v>6.7283999999999996E-4</c:v>
                </c:pt>
                <c:pt idx="698">
                  <c:v>1.073334E-3</c:v>
                </c:pt>
                <c:pt idx="699">
                  <c:v>2.5285250000000002E-3</c:v>
                </c:pt>
                <c:pt idx="700">
                  <c:v>2.634586E-3</c:v>
                </c:pt>
                <c:pt idx="701">
                  <c:v>1.179352E-3</c:v>
                </c:pt>
                <c:pt idx="702">
                  <c:v>2.0280290000000002E-3</c:v>
                </c:pt>
                <c:pt idx="703">
                  <c:v>4.1759971E-2</c:v>
                </c:pt>
                <c:pt idx="704">
                  <c:v>3.8782000000000001E-3</c:v>
                </c:pt>
                <c:pt idx="705">
                  <c:v>4.1725490000000002E-3</c:v>
                </c:pt>
                <c:pt idx="706">
                  <c:v>1.5495400000000001E-3</c:v>
                </c:pt>
                <c:pt idx="707">
                  <c:v>1.5602453000000001E-2</c:v>
                </c:pt>
                <c:pt idx="708">
                  <c:v>6.3061200000000001E-4</c:v>
                </c:pt>
                <c:pt idx="709">
                  <c:v>3.4478590000000002E-3</c:v>
                </c:pt>
                <c:pt idx="710">
                  <c:v>8.2842750000000007E-3</c:v>
                </c:pt>
                <c:pt idx="711">
                  <c:v>4.4129259999999997E-2</c:v>
                </c:pt>
                <c:pt idx="712">
                  <c:v>5.3989184000000003E-2</c:v>
                </c:pt>
                <c:pt idx="713">
                  <c:v>2.796523E-3</c:v>
                </c:pt>
                <c:pt idx="714">
                  <c:v>4.8789402000000003E-2</c:v>
                </c:pt>
                <c:pt idx="715">
                  <c:v>2.2870735E-2</c:v>
                </c:pt>
                <c:pt idx="716">
                  <c:v>9.7623499999999999E-4</c:v>
                </c:pt>
                <c:pt idx="717">
                  <c:v>1.8401937E-2</c:v>
                </c:pt>
                <c:pt idx="718">
                  <c:v>2.679753E-3</c:v>
                </c:pt>
                <c:pt idx="719">
                  <c:v>4.3947129999999997E-3</c:v>
                </c:pt>
                <c:pt idx="720">
                  <c:v>7.1010699999999997E-4</c:v>
                </c:pt>
                <c:pt idx="721">
                  <c:v>1.0595540000000001E-3</c:v>
                </c:pt>
                <c:pt idx="722">
                  <c:v>2.4993392999999999E-2</c:v>
                </c:pt>
                <c:pt idx="723">
                  <c:v>1.774388E-3</c:v>
                </c:pt>
                <c:pt idx="724">
                  <c:v>1.2702079E-2</c:v>
                </c:pt>
                <c:pt idx="725">
                  <c:v>4.4060119999999999E-3</c:v>
                </c:pt>
                <c:pt idx="726">
                  <c:v>7.4620709999999998E-3</c:v>
                </c:pt>
                <c:pt idx="727">
                  <c:v>2.83999E-4</c:v>
                </c:pt>
                <c:pt idx="728">
                  <c:v>2.3877379999999999E-3</c:v>
                </c:pt>
                <c:pt idx="729">
                  <c:v>3.0242324000000001E-2</c:v>
                </c:pt>
                <c:pt idx="730">
                  <c:v>5.0994400000000002E-4</c:v>
                </c:pt>
                <c:pt idx="731">
                  <c:v>1.7330340000000001E-3</c:v>
                </c:pt>
                <c:pt idx="732">
                  <c:v>3.5993025999999997E-2</c:v>
                </c:pt>
                <c:pt idx="733">
                  <c:v>2.4656109999999999E-3</c:v>
                </c:pt>
                <c:pt idx="734">
                  <c:v>2.5903380000000002E-3</c:v>
                </c:pt>
                <c:pt idx="735">
                  <c:v>5.5828960000000004E-3</c:v>
                </c:pt>
                <c:pt idx="736">
                  <c:v>3.6366052000000003E-2</c:v>
                </c:pt>
                <c:pt idx="737">
                  <c:v>3.98742E-4</c:v>
                </c:pt>
                <c:pt idx="738">
                  <c:v>1.0187359999999999E-3</c:v>
                </c:pt>
                <c:pt idx="739">
                  <c:v>2.700549E-3</c:v>
                </c:pt>
                <c:pt idx="740">
                  <c:v>2.461338E-3</c:v>
                </c:pt>
                <c:pt idx="741">
                  <c:v>1.2920617000000001E-2</c:v>
                </c:pt>
                <c:pt idx="742">
                  <c:v>3.1479492999999997E-2</c:v>
                </c:pt>
                <c:pt idx="743">
                  <c:v>7.5145999999999998E-3</c:v>
                </c:pt>
                <c:pt idx="744">
                  <c:v>2.7825929999999999E-3</c:v>
                </c:pt>
                <c:pt idx="745">
                  <c:v>1.916496E-3</c:v>
                </c:pt>
                <c:pt idx="746">
                  <c:v>2.054419E-3</c:v>
                </c:pt>
                <c:pt idx="747">
                  <c:v>4.0638984000000003E-2</c:v>
                </c:pt>
                <c:pt idx="748">
                  <c:v>6.1957379999999999E-2</c:v>
                </c:pt>
                <c:pt idx="749">
                  <c:v>3.561888E-3</c:v>
                </c:pt>
                <c:pt idx="750">
                  <c:v>2.9629629999999999E-3</c:v>
                </c:pt>
                <c:pt idx="751">
                  <c:v>9.4736199999999999E-4</c:v>
                </c:pt>
                <c:pt idx="752">
                  <c:v>3.47122E-4</c:v>
                </c:pt>
                <c:pt idx="753">
                  <c:v>4.5856530000000003E-3</c:v>
                </c:pt>
                <c:pt idx="754">
                  <c:v>1.251701E-3</c:v>
                </c:pt>
                <c:pt idx="755">
                  <c:v>1.5828350000000001E-3</c:v>
                </c:pt>
                <c:pt idx="756">
                  <c:v>3.5174109999999998E-3</c:v>
                </c:pt>
                <c:pt idx="757">
                  <c:v>2.5687430000000001E-3</c:v>
                </c:pt>
                <c:pt idx="758">
                  <c:v>4.6737200000000002E-4</c:v>
                </c:pt>
                <c:pt idx="759">
                  <c:v>8.1599299999999999E-4</c:v>
                </c:pt>
                <c:pt idx="760">
                  <c:v>6.1581525999999998E-2</c:v>
                </c:pt>
                <c:pt idx="761">
                  <c:v>6.4076400000000005E-4</c:v>
                </c:pt>
                <c:pt idx="762">
                  <c:v>7.2800600000000001E-4</c:v>
                </c:pt>
                <c:pt idx="763">
                  <c:v>1.683691E-3</c:v>
                </c:pt>
                <c:pt idx="764">
                  <c:v>3.4236965000000001E-2</c:v>
                </c:pt>
                <c:pt idx="765">
                  <c:v>1.12429E-3</c:v>
                </c:pt>
                <c:pt idx="766">
                  <c:v>1.5188689999999999E-2</c:v>
                </c:pt>
                <c:pt idx="767">
                  <c:v>2.047742E-3</c:v>
                </c:pt>
                <c:pt idx="768">
                  <c:v>1.6051360000000001E-3</c:v>
                </c:pt>
                <c:pt idx="769">
                  <c:v>1.353513E-3</c:v>
                </c:pt>
                <c:pt idx="770">
                  <c:v>2.4914360000000001E-3</c:v>
                </c:pt>
                <c:pt idx="771">
                  <c:v>1.432219E-3</c:v>
                </c:pt>
                <c:pt idx="772">
                  <c:v>2.6145597E-2</c:v>
                </c:pt>
                <c:pt idx="773">
                  <c:v>1.230573E-3</c:v>
                </c:pt>
                <c:pt idx="774">
                  <c:v>1.0084950000000001E-3</c:v>
                </c:pt>
                <c:pt idx="775">
                  <c:v>7.64081E-4</c:v>
                </c:pt>
                <c:pt idx="776">
                  <c:v>2.6475065999999998E-2</c:v>
                </c:pt>
                <c:pt idx="777">
                  <c:v>2.376179E-3</c:v>
                </c:pt>
                <c:pt idx="778">
                  <c:v>6.4142970000000002E-3</c:v>
                </c:pt>
                <c:pt idx="779">
                  <c:v>2.9910660000000001E-3</c:v>
                </c:pt>
                <c:pt idx="780">
                  <c:v>1.9720750000000002E-3</c:v>
                </c:pt>
                <c:pt idx="781">
                  <c:v>5.9398899999999995E-4</c:v>
                </c:pt>
                <c:pt idx="782">
                  <c:v>4.1609392000000002E-2</c:v>
                </c:pt>
                <c:pt idx="783">
                  <c:v>5.5358069000000003E-2</c:v>
                </c:pt>
                <c:pt idx="784">
                  <c:v>7.0248100000000003E-4</c:v>
                </c:pt>
                <c:pt idx="785">
                  <c:v>5.5356700000000003E-4</c:v>
                </c:pt>
                <c:pt idx="786">
                  <c:v>1.6602100000000001E-3</c:v>
                </c:pt>
                <c:pt idx="787">
                  <c:v>5.50418E-4</c:v>
                </c:pt>
                <c:pt idx="788">
                  <c:v>2.458535E-3</c:v>
                </c:pt>
                <c:pt idx="789">
                  <c:v>2.1660910000000002E-3</c:v>
                </c:pt>
                <c:pt idx="790">
                  <c:v>2.6068440000000001E-3</c:v>
                </c:pt>
                <c:pt idx="791">
                  <c:v>3.6475050000000001E-3</c:v>
                </c:pt>
                <c:pt idx="792">
                  <c:v>3.5093244000000003E-2</c:v>
                </c:pt>
                <c:pt idx="793">
                  <c:v>1.532727E-3</c:v>
                </c:pt>
                <c:pt idx="794">
                  <c:v>3.064921E-3</c:v>
                </c:pt>
                <c:pt idx="795">
                  <c:v>1.6507052000000001E-2</c:v>
                </c:pt>
                <c:pt idx="796">
                  <c:v>8.6959500000000003E-4</c:v>
                </c:pt>
                <c:pt idx="797">
                  <c:v>1.0882665999999999E-2</c:v>
                </c:pt>
                <c:pt idx="798">
                  <c:v>1.809281E-3</c:v>
                </c:pt>
                <c:pt idx="799">
                  <c:v>2.2626030000000002E-3</c:v>
                </c:pt>
                <c:pt idx="800">
                  <c:v>3.7707919999999998E-3</c:v>
                </c:pt>
                <c:pt idx="801">
                  <c:v>8.3932347000000004E-2</c:v>
                </c:pt>
                <c:pt idx="802">
                  <c:v>2.107598E-3</c:v>
                </c:pt>
                <c:pt idx="803">
                  <c:v>1.7071180000000001E-3</c:v>
                </c:pt>
                <c:pt idx="804">
                  <c:v>2.2840486E-2</c:v>
                </c:pt>
                <c:pt idx="805">
                  <c:v>7.8737200000000005E-4</c:v>
                </c:pt>
                <c:pt idx="806">
                  <c:v>2.6296433000000001E-2</c:v>
                </c:pt>
                <c:pt idx="807">
                  <c:v>6.6921605999999995E-2</c:v>
                </c:pt>
                <c:pt idx="808">
                  <c:v>3.231018E-3</c:v>
                </c:pt>
                <c:pt idx="809">
                  <c:v>2.9184250000000001E-3</c:v>
                </c:pt>
                <c:pt idx="810">
                  <c:v>6.9995776999999995E-2</c:v>
                </c:pt>
                <c:pt idx="811">
                  <c:v>6.5736600000000005E-4</c:v>
                </c:pt>
                <c:pt idx="812">
                  <c:v>1.720655E-3</c:v>
                </c:pt>
                <c:pt idx="813">
                  <c:v>1.9777599999999998E-3</c:v>
                </c:pt>
                <c:pt idx="814">
                  <c:v>1.1566300000000001E-3</c:v>
                </c:pt>
                <c:pt idx="815">
                  <c:v>2.2944269999999999E-3</c:v>
                </c:pt>
                <c:pt idx="816">
                  <c:v>3.916063E-3</c:v>
                </c:pt>
                <c:pt idx="817">
                  <c:v>6.1856016E-2</c:v>
                </c:pt>
                <c:pt idx="818">
                  <c:v>1.869908E-3</c:v>
                </c:pt>
                <c:pt idx="819">
                  <c:v>3.5698099999999998E-4</c:v>
                </c:pt>
                <c:pt idx="820">
                  <c:v>8.9577999999999999E-4</c:v>
                </c:pt>
                <c:pt idx="821">
                  <c:v>5.4190200000000003E-4</c:v>
                </c:pt>
                <c:pt idx="822">
                  <c:v>5.2092963999999999E-2</c:v>
                </c:pt>
                <c:pt idx="823">
                  <c:v>2.5574629999999998E-3</c:v>
                </c:pt>
                <c:pt idx="824">
                  <c:v>3.4786489999999999E-3</c:v>
                </c:pt>
                <c:pt idx="825">
                  <c:v>6.6970699999999996E-4</c:v>
                </c:pt>
                <c:pt idx="826">
                  <c:v>3.238042E-3</c:v>
                </c:pt>
                <c:pt idx="827">
                  <c:v>1.2902429999999999E-3</c:v>
                </c:pt>
                <c:pt idx="828">
                  <c:v>1.014261E-3</c:v>
                </c:pt>
                <c:pt idx="829">
                  <c:v>1.0769880000000001E-3</c:v>
                </c:pt>
                <c:pt idx="830">
                  <c:v>2.3383200000000001E-3</c:v>
                </c:pt>
                <c:pt idx="831">
                  <c:v>4.3353E-4</c:v>
                </c:pt>
                <c:pt idx="832">
                  <c:v>3.0518189999999999E-3</c:v>
                </c:pt>
                <c:pt idx="833">
                  <c:v>5.3506283000000002E-2</c:v>
                </c:pt>
                <c:pt idx="834">
                  <c:v>3.8954160000000001E-3</c:v>
                </c:pt>
                <c:pt idx="835">
                  <c:v>2.4189179999999999E-3</c:v>
                </c:pt>
                <c:pt idx="836">
                  <c:v>1.300184E-3</c:v>
                </c:pt>
                <c:pt idx="837">
                  <c:v>1.6928159000000002E-2</c:v>
                </c:pt>
                <c:pt idx="838">
                  <c:v>7.8469990000000003E-3</c:v>
                </c:pt>
                <c:pt idx="839">
                  <c:v>1.3006789999999999E-3</c:v>
                </c:pt>
                <c:pt idx="840">
                  <c:v>7.6205000000000001E-4</c:v>
                </c:pt>
                <c:pt idx="841">
                  <c:v>1.5031544000000001E-2</c:v>
                </c:pt>
                <c:pt idx="842">
                  <c:v>8.6990099999999996E-4</c:v>
                </c:pt>
                <c:pt idx="843">
                  <c:v>1.0293839999999999E-3</c:v>
                </c:pt>
                <c:pt idx="844">
                  <c:v>1.5471110000000001E-3</c:v>
                </c:pt>
                <c:pt idx="845">
                  <c:v>1.467351E-3</c:v>
                </c:pt>
                <c:pt idx="846">
                  <c:v>1.86583E-3</c:v>
                </c:pt>
                <c:pt idx="847">
                  <c:v>2.8114640000000001E-3</c:v>
                </c:pt>
                <c:pt idx="848">
                  <c:v>2.5705910000000001E-3</c:v>
                </c:pt>
                <c:pt idx="849">
                  <c:v>3.6847410000000001E-3</c:v>
                </c:pt>
                <c:pt idx="850">
                  <c:v>1.843389E-3</c:v>
                </c:pt>
                <c:pt idx="851">
                  <c:v>1.151689E-3</c:v>
                </c:pt>
                <c:pt idx="852">
                  <c:v>8.0463589999999995E-3</c:v>
                </c:pt>
                <c:pt idx="853">
                  <c:v>8.5055999999999999E-4</c:v>
                </c:pt>
                <c:pt idx="854">
                  <c:v>2.365083E-3</c:v>
                </c:pt>
                <c:pt idx="855">
                  <c:v>7.7951400000000003E-4</c:v>
                </c:pt>
                <c:pt idx="856">
                  <c:v>2.3895700000000001E-3</c:v>
                </c:pt>
                <c:pt idx="857">
                  <c:v>1.9172729999999999E-3</c:v>
                </c:pt>
                <c:pt idx="858">
                  <c:v>2.275151E-3</c:v>
                </c:pt>
                <c:pt idx="859">
                  <c:v>6.1567900000000005E-4</c:v>
                </c:pt>
                <c:pt idx="860">
                  <c:v>2.0783469999999999E-3</c:v>
                </c:pt>
                <c:pt idx="861">
                  <c:v>5.3565199999999996E-4</c:v>
                </c:pt>
                <c:pt idx="862">
                  <c:v>1.8810249999999999E-3</c:v>
                </c:pt>
                <c:pt idx="863">
                  <c:v>3.9147161999999999E-2</c:v>
                </c:pt>
                <c:pt idx="864">
                  <c:v>5.9618727000000003E-2</c:v>
                </c:pt>
                <c:pt idx="865">
                  <c:v>2.9500149999999998E-3</c:v>
                </c:pt>
                <c:pt idx="866">
                  <c:v>8.2781499999999997E-4</c:v>
                </c:pt>
                <c:pt idx="867">
                  <c:v>2.4511099999999998E-3</c:v>
                </c:pt>
                <c:pt idx="868">
                  <c:v>1.6126230000000001E-3</c:v>
                </c:pt>
                <c:pt idx="869">
                  <c:v>1.3251109999999999E-3</c:v>
                </c:pt>
                <c:pt idx="870">
                  <c:v>1.530729E-3</c:v>
                </c:pt>
                <c:pt idx="871">
                  <c:v>5.09295E-4</c:v>
                </c:pt>
                <c:pt idx="872">
                  <c:v>6.4549799999999999E-4</c:v>
                </c:pt>
                <c:pt idx="873">
                  <c:v>1.687764E-3</c:v>
                </c:pt>
                <c:pt idx="874">
                  <c:v>1.0974590000000001E-3</c:v>
                </c:pt>
                <c:pt idx="875">
                  <c:v>2.1327400000000002E-3</c:v>
                </c:pt>
                <c:pt idx="876">
                  <c:v>3.9876238000000001E-2</c:v>
                </c:pt>
                <c:pt idx="877">
                  <c:v>1.821872E-3</c:v>
                </c:pt>
                <c:pt idx="878">
                  <c:v>8.5608500000000003E-4</c:v>
                </c:pt>
                <c:pt idx="879">
                  <c:v>1.3335440000000001E-3</c:v>
                </c:pt>
                <c:pt idx="880">
                  <c:v>2.2024929999999998E-3</c:v>
                </c:pt>
                <c:pt idx="881">
                  <c:v>4.1272999999999999E-4</c:v>
                </c:pt>
                <c:pt idx="882">
                  <c:v>3.369145E-3</c:v>
                </c:pt>
                <c:pt idx="883">
                  <c:v>2.2649517000000001E-2</c:v>
                </c:pt>
                <c:pt idx="884">
                  <c:v>1.1791950000000001E-3</c:v>
                </c:pt>
                <c:pt idx="885">
                  <c:v>8.6608699999999998E-4</c:v>
                </c:pt>
                <c:pt idx="886">
                  <c:v>5.7534999999999997E-4</c:v>
                </c:pt>
                <c:pt idx="887">
                  <c:v>2.7324424E-2</c:v>
                </c:pt>
                <c:pt idx="888">
                  <c:v>8.6182100000000003E-4</c:v>
                </c:pt>
                <c:pt idx="889">
                  <c:v>2.9560720000000001E-3</c:v>
                </c:pt>
                <c:pt idx="890">
                  <c:v>1.8292810000000001E-3</c:v>
                </c:pt>
                <c:pt idx="891">
                  <c:v>2.2021446E-2</c:v>
                </c:pt>
                <c:pt idx="892">
                  <c:v>5.2892399999999995E-4</c:v>
                </c:pt>
                <c:pt idx="893">
                  <c:v>1.7031541000000001E-2</c:v>
                </c:pt>
                <c:pt idx="894">
                  <c:v>6.8531400000000002E-4</c:v>
                </c:pt>
                <c:pt idx="895">
                  <c:v>2.9468403000000001E-2</c:v>
                </c:pt>
                <c:pt idx="896">
                  <c:v>1.3494155000000001E-2</c:v>
                </c:pt>
                <c:pt idx="897">
                  <c:v>6.3101699999999999E-4</c:v>
                </c:pt>
                <c:pt idx="898">
                  <c:v>3.2594059999999998E-3</c:v>
                </c:pt>
                <c:pt idx="899">
                  <c:v>2.3124967E-2</c:v>
                </c:pt>
                <c:pt idx="900">
                  <c:v>4.8958223000000002E-2</c:v>
                </c:pt>
                <c:pt idx="901">
                  <c:v>2.9534000000000001E-3</c:v>
                </c:pt>
                <c:pt idx="902">
                  <c:v>2.071799E-3</c:v>
                </c:pt>
                <c:pt idx="903">
                  <c:v>4.0061309999999996E-3</c:v>
                </c:pt>
                <c:pt idx="904">
                  <c:v>2.201242E-3</c:v>
                </c:pt>
                <c:pt idx="905">
                  <c:v>6.2023000000000004E-4</c:v>
                </c:pt>
                <c:pt idx="906">
                  <c:v>5.6875000000000003E-4</c:v>
                </c:pt>
                <c:pt idx="907">
                  <c:v>7.5794100000000004E-4</c:v>
                </c:pt>
                <c:pt idx="908">
                  <c:v>1.6170905999999999E-2</c:v>
                </c:pt>
                <c:pt idx="909">
                  <c:v>7.3883492999999995E-2</c:v>
                </c:pt>
                <c:pt idx="910">
                  <c:v>4.0623846999999998E-2</c:v>
                </c:pt>
                <c:pt idx="911">
                  <c:v>3.9622076999999999E-2</c:v>
                </c:pt>
                <c:pt idx="912">
                  <c:v>9.6698200000000002E-4</c:v>
                </c:pt>
                <c:pt idx="913">
                  <c:v>7.9306299999999999E-4</c:v>
                </c:pt>
                <c:pt idx="914">
                  <c:v>5.6406498999999999E-2</c:v>
                </c:pt>
                <c:pt idx="915">
                  <c:v>2.8285910000000001E-3</c:v>
                </c:pt>
                <c:pt idx="916">
                  <c:v>4.4465119999999997E-3</c:v>
                </c:pt>
                <c:pt idx="917">
                  <c:v>1.9982761000000002E-2</c:v>
                </c:pt>
                <c:pt idx="918">
                  <c:v>2.0058770000000001E-3</c:v>
                </c:pt>
                <c:pt idx="919">
                  <c:v>1.799164E-3</c:v>
                </c:pt>
                <c:pt idx="920">
                  <c:v>7.2255599999999996E-4</c:v>
                </c:pt>
                <c:pt idx="921">
                  <c:v>2.3226309999999999E-3</c:v>
                </c:pt>
                <c:pt idx="922">
                  <c:v>4.6980915999999998E-2</c:v>
                </c:pt>
                <c:pt idx="923">
                  <c:v>2.4117541999999999E-2</c:v>
                </c:pt>
                <c:pt idx="924">
                  <c:v>1.9975102000000002E-2</c:v>
                </c:pt>
                <c:pt idx="925">
                  <c:v>7.6007239999999997E-3</c:v>
                </c:pt>
                <c:pt idx="926">
                  <c:v>3.4131589999999998E-3</c:v>
                </c:pt>
                <c:pt idx="927">
                  <c:v>2.1517340000000002E-3</c:v>
                </c:pt>
                <c:pt idx="928">
                  <c:v>2.8942719999999998E-3</c:v>
                </c:pt>
                <c:pt idx="929">
                  <c:v>3.8776199999999999E-4</c:v>
                </c:pt>
                <c:pt idx="930">
                  <c:v>4.0804839999999997E-3</c:v>
                </c:pt>
                <c:pt idx="931">
                  <c:v>5.4263260000000004E-3</c:v>
                </c:pt>
                <c:pt idx="932">
                  <c:v>5.5971600000000003E-4</c:v>
                </c:pt>
                <c:pt idx="933">
                  <c:v>2.3676610000000001E-3</c:v>
                </c:pt>
                <c:pt idx="934">
                  <c:v>7.4052446999999993E-2</c:v>
                </c:pt>
                <c:pt idx="935">
                  <c:v>1.5755739999999999E-3</c:v>
                </c:pt>
                <c:pt idx="936">
                  <c:v>1.5837199999999999E-2</c:v>
                </c:pt>
                <c:pt idx="937">
                  <c:v>2.0427679999999999E-3</c:v>
                </c:pt>
                <c:pt idx="938">
                  <c:v>7.9744470000000008E-3</c:v>
                </c:pt>
                <c:pt idx="939">
                  <c:v>4.5267989999999998E-3</c:v>
                </c:pt>
                <c:pt idx="940">
                  <c:v>6.7544609999999998E-3</c:v>
                </c:pt>
                <c:pt idx="941">
                  <c:v>1.2282332E-2</c:v>
                </c:pt>
                <c:pt idx="942">
                  <c:v>7.8761300000000005E-4</c:v>
                </c:pt>
                <c:pt idx="943">
                  <c:v>1.9244799E-2</c:v>
                </c:pt>
                <c:pt idx="944">
                  <c:v>3.1967800000000002E-3</c:v>
                </c:pt>
                <c:pt idx="945">
                  <c:v>6.29723E-4</c:v>
                </c:pt>
                <c:pt idx="946">
                  <c:v>4.5525873000000001E-2</c:v>
                </c:pt>
                <c:pt idx="947">
                  <c:v>3.461567E-3</c:v>
                </c:pt>
                <c:pt idx="948">
                  <c:v>2.7117500000000002E-3</c:v>
                </c:pt>
                <c:pt idx="949">
                  <c:v>5.1513899999999996E-4</c:v>
                </c:pt>
                <c:pt idx="950">
                  <c:v>1.3725530000000001E-3</c:v>
                </c:pt>
                <c:pt idx="951">
                  <c:v>1.180817E-3</c:v>
                </c:pt>
                <c:pt idx="952">
                  <c:v>1.873017E-3</c:v>
                </c:pt>
                <c:pt idx="953">
                  <c:v>7.6923080000000001E-3</c:v>
                </c:pt>
                <c:pt idx="954">
                  <c:v>1.0292742000000001E-2</c:v>
                </c:pt>
                <c:pt idx="955">
                  <c:v>1.0661695000000001E-2</c:v>
                </c:pt>
                <c:pt idx="956">
                  <c:v>8.2464670000000004E-3</c:v>
                </c:pt>
                <c:pt idx="957">
                  <c:v>8.787418E-3</c:v>
                </c:pt>
                <c:pt idx="958">
                  <c:v>1.7937893E-2</c:v>
                </c:pt>
                <c:pt idx="959">
                  <c:v>9.9657685999999995E-2</c:v>
                </c:pt>
                <c:pt idx="960">
                  <c:v>3.5761930000000001E-3</c:v>
                </c:pt>
                <c:pt idx="961">
                  <c:v>4.7082560000000001E-3</c:v>
                </c:pt>
                <c:pt idx="962">
                  <c:v>7.7136399999999997E-4</c:v>
                </c:pt>
                <c:pt idx="963">
                  <c:v>2.2754379999999999E-3</c:v>
                </c:pt>
                <c:pt idx="964">
                  <c:v>5.6808190000000001E-3</c:v>
                </c:pt>
                <c:pt idx="965">
                  <c:v>4.1502529999999996E-3</c:v>
                </c:pt>
                <c:pt idx="966">
                  <c:v>7.7017299999999997E-4</c:v>
                </c:pt>
                <c:pt idx="967">
                  <c:v>4.0679132999999999E-2</c:v>
                </c:pt>
                <c:pt idx="968">
                  <c:v>2.5288099999999998E-3</c:v>
                </c:pt>
                <c:pt idx="969">
                  <c:v>1.175489E-3</c:v>
                </c:pt>
                <c:pt idx="970">
                  <c:v>1.3858700999999999E-2</c:v>
                </c:pt>
                <c:pt idx="971">
                  <c:v>7.4958299999999996E-4</c:v>
                </c:pt>
                <c:pt idx="972">
                  <c:v>1.9854038000000001E-2</c:v>
                </c:pt>
                <c:pt idx="973">
                  <c:v>2.3981710000000002E-3</c:v>
                </c:pt>
                <c:pt idx="974">
                  <c:v>2.4763687E-2</c:v>
                </c:pt>
                <c:pt idx="975">
                  <c:v>4.2989777999999999E-2</c:v>
                </c:pt>
                <c:pt idx="976">
                  <c:v>2.9826953999999999E-2</c:v>
                </c:pt>
                <c:pt idx="977">
                  <c:v>7.7042789999999996E-3</c:v>
                </c:pt>
                <c:pt idx="978">
                  <c:v>4.4836243999999997E-2</c:v>
                </c:pt>
                <c:pt idx="979">
                  <c:v>7.2470369999999996E-3</c:v>
                </c:pt>
                <c:pt idx="980">
                  <c:v>1.7776633E-2</c:v>
                </c:pt>
                <c:pt idx="981">
                  <c:v>3.1780623000000001E-2</c:v>
                </c:pt>
                <c:pt idx="982">
                  <c:v>1.6180050000000001E-3</c:v>
                </c:pt>
                <c:pt idx="983">
                  <c:v>2.4371610000000002E-3</c:v>
                </c:pt>
                <c:pt idx="984">
                  <c:v>3.0532160000000001E-3</c:v>
                </c:pt>
                <c:pt idx="985">
                  <c:v>7.2873000000000002E-4</c:v>
                </c:pt>
                <c:pt idx="986">
                  <c:v>2.6464549999999998E-3</c:v>
                </c:pt>
                <c:pt idx="987">
                  <c:v>1.8129445000000001E-2</c:v>
                </c:pt>
                <c:pt idx="988">
                  <c:v>2.4007014E-2</c:v>
                </c:pt>
                <c:pt idx="989">
                  <c:v>9.0060400000000005E-4</c:v>
                </c:pt>
                <c:pt idx="990">
                  <c:v>1.4641770000000001E-3</c:v>
                </c:pt>
                <c:pt idx="991">
                  <c:v>5.0438999999999996E-4</c:v>
                </c:pt>
                <c:pt idx="992">
                  <c:v>6.0646900000000002E-3</c:v>
                </c:pt>
                <c:pt idx="993">
                  <c:v>9.1892580000000005E-3</c:v>
                </c:pt>
                <c:pt idx="994">
                  <c:v>1.808346E-3</c:v>
                </c:pt>
                <c:pt idx="995">
                  <c:v>2.7960699999999999E-3</c:v>
                </c:pt>
                <c:pt idx="996">
                  <c:v>8.5046099999999995E-4</c:v>
                </c:pt>
                <c:pt idx="997">
                  <c:v>7.9222099999999996E-4</c:v>
                </c:pt>
                <c:pt idx="998">
                  <c:v>2.4741546E-2</c:v>
                </c:pt>
                <c:pt idx="999">
                  <c:v>2.4188230000000001E-3</c:v>
                </c:pt>
                <c:pt idx="1000">
                  <c:v>1.612259E-3</c:v>
                </c:pt>
                <c:pt idx="1001">
                  <c:v>1.1327161000000001E-2</c:v>
                </c:pt>
                <c:pt idx="1002">
                  <c:v>1.6546476000000001E-2</c:v>
                </c:pt>
                <c:pt idx="1003">
                  <c:v>1.6455385999999999E-2</c:v>
                </c:pt>
                <c:pt idx="1004">
                  <c:v>4.4680339999999999E-2</c:v>
                </c:pt>
                <c:pt idx="1005">
                  <c:v>4.9824149999999998E-2</c:v>
                </c:pt>
                <c:pt idx="1006">
                  <c:v>1.420592E-3</c:v>
                </c:pt>
                <c:pt idx="1007">
                  <c:v>1.0497058E-2</c:v>
                </c:pt>
                <c:pt idx="1008">
                  <c:v>3.1365759999999999E-3</c:v>
                </c:pt>
                <c:pt idx="1009">
                  <c:v>2.3239570000000002E-3</c:v>
                </c:pt>
                <c:pt idx="1010">
                  <c:v>5.3519600000000004E-4</c:v>
                </c:pt>
                <c:pt idx="1011">
                  <c:v>2.1473455999999998E-2</c:v>
                </c:pt>
                <c:pt idx="1012">
                  <c:v>3.619269E-3</c:v>
                </c:pt>
                <c:pt idx="1013">
                  <c:v>1.1391050000000001E-3</c:v>
                </c:pt>
                <c:pt idx="1014">
                  <c:v>1.2387279999999999E-3</c:v>
                </c:pt>
                <c:pt idx="1015">
                  <c:v>1.5746988E-2</c:v>
                </c:pt>
                <c:pt idx="1016">
                  <c:v>8.5238999999999996E-4</c:v>
                </c:pt>
                <c:pt idx="1017">
                  <c:v>1.9090330000000001E-3</c:v>
                </c:pt>
                <c:pt idx="1018">
                  <c:v>5.6539299999999997E-4</c:v>
                </c:pt>
                <c:pt idx="1019">
                  <c:v>1.906392E-3</c:v>
                </c:pt>
                <c:pt idx="1020">
                  <c:v>1.5559330999999999E-2</c:v>
                </c:pt>
                <c:pt idx="1021">
                  <c:v>1.3743406E-2</c:v>
                </c:pt>
                <c:pt idx="1022">
                  <c:v>3.6308166000000003E-2</c:v>
                </c:pt>
                <c:pt idx="1023">
                  <c:v>5.5173013E-2</c:v>
                </c:pt>
                <c:pt idx="1024">
                  <c:v>7.0646000000000001E-4</c:v>
                </c:pt>
                <c:pt idx="1025">
                  <c:v>2.1030948000000001E-2</c:v>
                </c:pt>
                <c:pt idx="1026">
                  <c:v>5.3684100000000003E-4</c:v>
                </c:pt>
                <c:pt idx="1027">
                  <c:v>8.5563100000000003E-4</c:v>
                </c:pt>
                <c:pt idx="1028">
                  <c:v>1.2895535E-2</c:v>
                </c:pt>
                <c:pt idx="1029">
                  <c:v>4.8861499999999997E-3</c:v>
                </c:pt>
                <c:pt idx="1030">
                  <c:v>2.67254E-2</c:v>
                </c:pt>
                <c:pt idx="1031">
                  <c:v>1.013992E-2</c:v>
                </c:pt>
                <c:pt idx="1032">
                  <c:v>3.3584488000000003E-2</c:v>
                </c:pt>
                <c:pt idx="1033">
                  <c:v>1.2516195000000001E-2</c:v>
                </c:pt>
                <c:pt idx="1034">
                  <c:v>2.2721210000000002E-3</c:v>
                </c:pt>
                <c:pt idx="1035">
                  <c:v>2.5970640000000001E-3</c:v>
                </c:pt>
                <c:pt idx="1036">
                  <c:v>2.9241955E-2</c:v>
                </c:pt>
                <c:pt idx="1037">
                  <c:v>3.2937623999999999E-2</c:v>
                </c:pt>
                <c:pt idx="1038">
                  <c:v>2.6499639999999999E-3</c:v>
                </c:pt>
                <c:pt idx="1039">
                  <c:v>1.7839329999999999E-3</c:v>
                </c:pt>
                <c:pt idx="1040">
                  <c:v>1.7664283999999999E-2</c:v>
                </c:pt>
                <c:pt idx="1041">
                  <c:v>3.8595710999999998E-2</c:v>
                </c:pt>
                <c:pt idx="1042">
                  <c:v>6.4277699999999998E-4</c:v>
                </c:pt>
                <c:pt idx="1043">
                  <c:v>1.578367E-3</c:v>
                </c:pt>
                <c:pt idx="1044">
                  <c:v>5.6781030000000003E-3</c:v>
                </c:pt>
                <c:pt idx="1045">
                  <c:v>1.4311867000000001E-2</c:v>
                </c:pt>
                <c:pt idx="1046">
                  <c:v>4.9517939999999998E-3</c:v>
                </c:pt>
                <c:pt idx="1047">
                  <c:v>1.1180976E-2</c:v>
                </c:pt>
                <c:pt idx="1048">
                  <c:v>7.0458300000000005E-4</c:v>
                </c:pt>
                <c:pt idx="1049">
                  <c:v>1.766784E-3</c:v>
                </c:pt>
                <c:pt idx="1050">
                  <c:v>2.6118076E-2</c:v>
                </c:pt>
                <c:pt idx="1051">
                  <c:v>8.9137400000000001E-4</c:v>
                </c:pt>
                <c:pt idx="1052">
                  <c:v>2.235496E-3</c:v>
                </c:pt>
                <c:pt idx="1053">
                  <c:v>5.7658399999999999E-4</c:v>
                </c:pt>
                <c:pt idx="1054">
                  <c:v>1.6772769E-2</c:v>
                </c:pt>
                <c:pt idx="1055">
                  <c:v>3.8199490000000003E-2</c:v>
                </c:pt>
                <c:pt idx="1056">
                  <c:v>5.2725600000000004E-4</c:v>
                </c:pt>
                <c:pt idx="1057">
                  <c:v>6.30632E-4</c:v>
                </c:pt>
                <c:pt idx="1058">
                  <c:v>3.3858370999999998E-2</c:v>
                </c:pt>
                <c:pt idx="1059">
                  <c:v>1.6963968999999999E-2</c:v>
                </c:pt>
                <c:pt idx="1060">
                  <c:v>3.6412027E-2</c:v>
                </c:pt>
                <c:pt idx="1061">
                  <c:v>2.8835034999999998E-2</c:v>
                </c:pt>
                <c:pt idx="1062">
                  <c:v>8.8180099999999998E-4</c:v>
                </c:pt>
                <c:pt idx="1063">
                  <c:v>2.5625959999999999E-3</c:v>
                </c:pt>
                <c:pt idx="1064">
                  <c:v>3.1029654E-2</c:v>
                </c:pt>
                <c:pt idx="1065">
                  <c:v>1.6214149000000001E-2</c:v>
                </c:pt>
                <c:pt idx="1066">
                  <c:v>3.854722E-2</c:v>
                </c:pt>
                <c:pt idx="1067">
                  <c:v>1.17522E-3</c:v>
                </c:pt>
                <c:pt idx="1068">
                  <c:v>4.8117150000000003E-3</c:v>
                </c:pt>
                <c:pt idx="1069">
                  <c:v>1.9062026999999999E-2</c:v>
                </c:pt>
                <c:pt idx="1070">
                  <c:v>6.20405E-3</c:v>
                </c:pt>
                <c:pt idx="1071">
                  <c:v>8.1869500000000003E-4</c:v>
                </c:pt>
                <c:pt idx="1072">
                  <c:v>1.1250868000000001E-2</c:v>
                </c:pt>
                <c:pt idx="1073">
                  <c:v>2.6762600000000002E-3</c:v>
                </c:pt>
                <c:pt idx="1074">
                  <c:v>6.8351800000000004E-4</c:v>
                </c:pt>
                <c:pt idx="1075">
                  <c:v>4.5528799999999996E-3</c:v>
                </c:pt>
                <c:pt idx="1076">
                  <c:v>7.1746500000000003E-4</c:v>
                </c:pt>
                <c:pt idx="1077">
                  <c:v>5.5112800000000003E-3</c:v>
                </c:pt>
                <c:pt idx="1078">
                  <c:v>1.3547986E-2</c:v>
                </c:pt>
                <c:pt idx="1079">
                  <c:v>5.2573469999999999E-3</c:v>
                </c:pt>
                <c:pt idx="1080">
                  <c:v>2.6386341000000001E-2</c:v>
                </c:pt>
                <c:pt idx="1081">
                  <c:v>1.4498709E-2</c:v>
                </c:pt>
                <c:pt idx="1082">
                  <c:v>1.7873988E-2</c:v>
                </c:pt>
                <c:pt idx="1083">
                  <c:v>2.9135229999999999E-3</c:v>
                </c:pt>
                <c:pt idx="1084">
                  <c:v>3.21105E-3</c:v>
                </c:pt>
                <c:pt idx="1085">
                  <c:v>2.2330649999999998E-3</c:v>
                </c:pt>
                <c:pt idx="1086">
                  <c:v>3.6800171E-2</c:v>
                </c:pt>
                <c:pt idx="1087">
                  <c:v>1.6010251E-2</c:v>
                </c:pt>
                <c:pt idx="1088">
                  <c:v>1.5962053E-2</c:v>
                </c:pt>
                <c:pt idx="1089">
                  <c:v>5.2506979999999998E-3</c:v>
                </c:pt>
                <c:pt idx="1090">
                  <c:v>2.0466290000000002E-2</c:v>
                </c:pt>
                <c:pt idx="1091">
                  <c:v>2.1740359999999999E-3</c:v>
                </c:pt>
                <c:pt idx="1092">
                  <c:v>5.9947380000000003E-3</c:v>
                </c:pt>
                <c:pt idx="1093">
                  <c:v>2.2716302000000001E-2</c:v>
                </c:pt>
                <c:pt idx="1094">
                  <c:v>3.8536628000000003E-2</c:v>
                </c:pt>
                <c:pt idx="1095">
                  <c:v>9.814139999999999E-4</c:v>
                </c:pt>
                <c:pt idx="1096">
                  <c:v>7.78045E-4</c:v>
                </c:pt>
                <c:pt idx="1097">
                  <c:v>1.1919699000000001E-2</c:v>
                </c:pt>
                <c:pt idx="1098">
                  <c:v>2.7399519999999999E-3</c:v>
                </c:pt>
                <c:pt idx="1099">
                  <c:v>2.5164459999999999E-3</c:v>
                </c:pt>
                <c:pt idx="1100">
                  <c:v>6.4327799999999999E-3</c:v>
                </c:pt>
                <c:pt idx="1101">
                  <c:v>1.0732820000000001E-3</c:v>
                </c:pt>
                <c:pt idx="1102">
                  <c:v>2.3033530000000002E-3</c:v>
                </c:pt>
                <c:pt idx="1103">
                  <c:v>1.3092970000000001E-3</c:v>
                </c:pt>
                <c:pt idx="1104">
                  <c:v>2.6387450000000001E-3</c:v>
                </c:pt>
                <c:pt idx="1105">
                  <c:v>2.7564009999999999E-3</c:v>
                </c:pt>
                <c:pt idx="1106">
                  <c:v>8.4619700000000003E-4</c:v>
                </c:pt>
                <c:pt idx="1107">
                  <c:v>1.4414269999999999E-3</c:v>
                </c:pt>
                <c:pt idx="1108">
                  <c:v>1.9015E-3</c:v>
                </c:pt>
                <c:pt idx="1109">
                  <c:v>2.7223590000000002E-3</c:v>
                </c:pt>
                <c:pt idx="1110">
                  <c:v>1.1445538999999999E-2</c:v>
                </c:pt>
                <c:pt idx="1111">
                  <c:v>9.4947390000000003E-3</c:v>
                </c:pt>
                <c:pt idx="1112">
                  <c:v>7.4616500000000002E-3</c:v>
                </c:pt>
                <c:pt idx="1113">
                  <c:v>1.0074019999999999E-3</c:v>
                </c:pt>
                <c:pt idx="1114">
                  <c:v>1.6602934999999999E-2</c:v>
                </c:pt>
                <c:pt idx="1115">
                  <c:v>6.479149E-3</c:v>
                </c:pt>
                <c:pt idx="1116">
                  <c:v>1.258882E-3</c:v>
                </c:pt>
                <c:pt idx="1117">
                  <c:v>7.027564E-3</c:v>
                </c:pt>
                <c:pt idx="1118">
                  <c:v>2.4613220000000002E-3</c:v>
                </c:pt>
                <c:pt idx="1119">
                  <c:v>2.2340870000000001E-3</c:v>
                </c:pt>
                <c:pt idx="1120">
                  <c:v>3.7093029999999999E-2</c:v>
                </c:pt>
                <c:pt idx="1121">
                  <c:v>6.1038209999999997E-3</c:v>
                </c:pt>
                <c:pt idx="1122">
                  <c:v>1.7700860999999998E-2</c:v>
                </c:pt>
                <c:pt idx="1123">
                  <c:v>2.1605823E-2</c:v>
                </c:pt>
                <c:pt idx="1124">
                  <c:v>2.6630429999999999E-3</c:v>
                </c:pt>
                <c:pt idx="1125">
                  <c:v>1.2024402999999999E-2</c:v>
                </c:pt>
                <c:pt idx="1126">
                  <c:v>4.0095099999999998E-4</c:v>
                </c:pt>
                <c:pt idx="1127">
                  <c:v>1.1334450000000001E-3</c:v>
                </c:pt>
                <c:pt idx="1128">
                  <c:v>1.9308500000000001E-4</c:v>
                </c:pt>
                <c:pt idx="1129">
                  <c:v>9.06901E-4</c:v>
                </c:pt>
                <c:pt idx="1130">
                  <c:v>1.6975693E-2</c:v>
                </c:pt>
                <c:pt idx="1131">
                  <c:v>2.0387510000000001E-3</c:v>
                </c:pt>
                <c:pt idx="1132">
                  <c:v>1.0099808E-2</c:v>
                </c:pt>
                <c:pt idx="1133">
                  <c:v>1.2205409999999999E-3</c:v>
                </c:pt>
                <c:pt idx="1134">
                  <c:v>1.2844480000000001E-3</c:v>
                </c:pt>
                <c:pt idx="1135">
                  <c:v>1.3970950000000001E-3</c:v>
                </c:pt>
                <c:pt idx="1136">
                  <c:v>6.9627339999999999E-3</c:v>
                </c:pt>
                <c:pt idx="1137">
                  <c:v>2.0481539999999999E-3</c:v>
                </c:pt>
                <c:pt idx="1138">
                  <c:v>2.0711226999999999E-2</c:v>
                </c:pt>
                <c:pt idx="1139">
                  <c:v>3.4041196000000003E-2</c:v>
                </c:pt>
                <c:pt idx="1140">
                  <c:v>1.1046617999999999E-2</c:v>
                </c:pt>
                <c:pt idx="1141">
                  <c:v>7.8221490000000005E-3</c:v>
                </c:pt>
                <c:pt idx="1142">
                  <c:v>2.2732160000000002E-3</c:v>
                </c:pt>
                <c:pt idx="1143">
                  <c:v>2.9650340000000001E-3</c:v>
                </c:pt>
                <c:pt idx="1144">
                  <c:v>1.8911208999999998E-2</c:v>
                </c:pt>
                <c:pt idx="1145">
                  <c:v>7.2851299999999997E-4</c:v>
                </c:pt>
                <c:pt idx="1146">
                  <c:v>3.4224551999999998E-2</c:v>
                </c:pt>
                <c:pt idx="1147">
                  <c:v>1.187958E-3</c:v>
                </c:pt>
                <c:pt idx="1148">
                  <c:v>9.6812240000000004E-3</c:v>
                </c:pt>
                <c:pt idx="1149">
                  <c:v>9.2312980000000006E-3</c:v>
                </c:pt>
                <c:pt idx="1150">
                  <c:v>1.5290950000000001E-3</c:v>
                </c:pt>
                <c:pt idx="1151">
                  <c:v>7.03975E-3</c:v>
                </c:pt>
                <c:pt idx="1152">
                  <c:v>3.2431810999999998E-2</c:v>
                </c:pt>
                <c:pt idx="1153">
                  <c:v>4.6106189999999998E-3</c:v>
                </c:pt>
                <c:pt idx="1154">
                  <c:v>2.3136430000000002E-3</c:v>
                </c:pt>
                <c:pt idx="1155">
                  <c:v>5.0844699999999998E-4</c:v>
                </c:pt>
                <c:pt idx="1156">
                  <c:v>9.9067600000000001E-4</c:v>
                </c:pt>
                <c:pt idx="1157">
                  <c:v>1.2951602E-2</c:v>
                </c:pt>
                <c:pt idx="1158">
                  <c:v>1.538209E-3</c:v>
                </c:pt>
                <c:pt idx="1159">
                  <c:v>2.5473750000000002E-3</c:v>
                </c:pt>
                <c:pt idx="1160">
                  <c:v>2.5686303000000001E-2</c:v>
                </c:pt>
                <c:pt idx="1161">
                  <c:v>1.24252E-3</c:v>
                </c:pt>
                <c:pt idx="1162">
                  <c:v>8.1484000000000005E-4</c:v>
                </c:pt>
                <c:pt idx="1163">
                  <c:v>9.2577800000000004E-4</c:v>
                </c:pt>
                <c:pt idx="1164">
                  <c:v>6.2191299999999998E-3</c:v>
                </c:pt>
                <c:pt idx="1165">
                  <c:v>1.2502666000000001E-2</c:v>
                </c:pt>
                <c:pt idx="1166">
                  <c:v>7.6501299999999998E-3</c:v>
                </c:pt>
                <c:pt idx="1167">
                  <c:v>3.1378700000000001E-3</c:v>
                </c:pt>
                <c:pt idx="1168">
                  <c:v>1.254867E-3</c:v>
                </c:pt>
                <c:pt idx="1169">
                  <c:v>8.7287990000000006E-3</c:v>
                </c:pt>
                <c:pt idx="1170">
                  <c:v>8.6065380000000004E-3</c:v>
                </c:pt>
                <c:pt idx="1171">
                  <c:v>9.0335970000000008E-3</c:v>
                </c:pt>
                <c:pt idx="1172">
                  <c:v>7.6397790000000002E-3</c:v>
                </c:pt>
                <c:pt idx="1173">
                  <c:v>1.5215301000000001E-2</c:v>
                </c:pt>
                <c:pt idx="1174">
                  <c:v>1.0269848999999999E-2</c:v>
                </c:pt>
                <c:pt idx="1175">
                  <c:v>3.2166040000000001E-3</c:v>
                </c:pt>
                <c:pt idx="1176">
                  <c:v>1.2013352E-2</c:v>
                </c:pt>
                <c:pt idx="1177">
                  <c:v>9.2455109999999997E-3</c:v>
                </c:pt>
                <c:pt idx="1178">
                  <c:v>1.3760919E-2</c:v>
                </c:pt>
                <c:pt idx="1179">
                  <c:v>4.1012009999999996E-3</c:v>
                </c:pt>
                <c:pt idx="1180">
                  <c:v>2.5429979999999999E-3</c:v>
                </c:pt>
                <c:pt idx="1181">
                  <c:v>4.8200509999999997E-3</c:v>
                </c:pt>
                <c:pt idx="1182">
                  <c:v>1.119692E-3</c:v>
                </c:pt>
                <c:pt idx="1183">
                  <c:v>9.3797800000000001E-4</c:v>
                </c:pt>
                <c:pt idx="1184">
                  <c:v>9.4923049999999995E-3</c:v>
                </c:pt>
                <c:pt idx="1185">
                  <c:v>1.1379847E-2</c:v>
                </c:pt>
                <c:pt idx="1186">
                  <c:v>7.9361199999999996E-4</c:v>
                </c:pt>
                <c:pt idx="1187">
                  <c:v>1.1979615000000001E-2</c:v>
                </c:pt>
                <c:pt idx="1188">
                  <c:v>2.0452010999999999E-2</c:v>
                </c:pt>
                <c:pt idx="1189">
                  <c:v>6.2930600000000005E-4</c:v>
                </c:pt>
                <c:pt idx="1190">
                  <c:v>7.0952899999999998E-4</c:v>
                </c:pt>
                <c:pt idx="1191">
                  <c:v>2.1947170000000001E-3</c:v>
                </c:pt>
                <c:pt idx="1192">
                  <c:v>3.4674885000000003E-2</c:v>
                </c:pt>
                <c:pt idx="1193">
                  <c:v>1.008262E-3</c:v>
                </c:pt>
                <c:pt idx="1194">
                  <c:v>2.8448869999999999E-3</c:v>
                </c:pt>
                <c:pt idx="1195">
                  <c:v>8.7531870000000008E-3</c:v>
                </c:pt>
                <c:pt idx="1196">
                  <c:v>8.1253200000000003E-4</c:v>
                </c:pt>
                <c:pt idx="1197">
                  <c:v>2.4296090000000001E-3</c:v>
                </c:pt>
                <c:pt idx="1198">
                  <c:v>1.333925E-2</c:v>
                </c:pt>
                <c:pt idx="1199">
                  <c:v>1.6767131000000001E-2</c:v>
                </c:pt>
                <c:pt idx="1200">
                  <c:v>1.3382820000000001E-3</c:v>
                </c:pt>
                <c:pt idx="1201">
                  <c:v>1.0186279999999999E-3</c:v>
                </c:pt>
                <c:pt idx="1202">
                  <c:v>1.8012047E-2</c:v>
                </c:pt>
                <c:pt idx="1203">
                  <c:v>1.0227691000000001E-2</c:v>
                </c:pt>
                <c:pt idx="1204">
                  <c:v>2.2357340000000001E-3</c:v>
                </c:pt>
                <c:pt idx="1205">
                  <c:v>2.0008211000000001E-2</c:v>
                </c:pt>
                <c:pt idx="1206">
                  <c:v>1.109322E-3</c:v>
                </c:pt>
                <c:pt idx="1207">
                  <c:v>1.3781290000000001E-3</c:v>
                </c:pt>
                <c:pt idx="1208">
                  <c:v>1.4657089999999999E-3</c:v>
                </c:pt>
                <c:pt idx="1209">
                  <c:v>4.3797399999999999E-4</c:v>
                </c:pt>
                <c:pt idx="1210">
                  <c:v>1.4716320000000001E-3</c:v>
                </c:pt>
                <c:pt idx="1211">
                  <c:v>1.802578E-3</c:v>
                </c:pt>
                <c:pt idx="1212">
                  <c:v>8.6307020000000005E-3</c:v>
                </c:pt>
                <c:pt idx="1213">
                  <c:v>2.2855589999999999E-3</c:v>
                </c:pt>
                <c:pt idx="1214">
                  <c:v>2.1110508E-2</c:v>
                </c:pt>
                <c:pt idx="1215">
                  <c:v>1.0189109999999999E-3</c:v>
                </c:pt>
                <c:pt idx="1216">
                  <c:v>2.7103320000000002E-3</c:v>
                </c:pt>
                <c:pt idx="1217">
                  <c:v>1.1258349999999999E-3</c:v>
                </c:pt>
                <c:pt idx="1218">
                  <c:v>1.2453667999999999E-2</c:v>
                </c:pt>
                <c:pt idx="1219">
                  <c:v>1.0342469E-2</c:v>
                </c:pt>
                <c:pt idx="1220">
                  <c:v>1.0347679999999999E-3</c:v>
                </c:pt>
                <c:pt idx="1221">
                  <c:v>1.6160443E-2</c:v>
                </c:pt>
                <c:pt idx="1222">
                  <c:v>3.0385970000000001E-3</c:v>
                </c:pt>
                <c:pt idx="1223">
                  <c:v>1.2015992E-2</c:v>
                </c:pt>
                <c:pt idx="1224">
                  <c:v>3.2898495E-2</c:v>
                </c:pt>
                <c:pt idx="1225">
                  <c:v>1.4342287E-2</c:v>
                </c:pt>
                <c:pt idx="1226">
                  <c:v>1.6491990000000002E-2</c:v>
                </c:pt>
                <c:pt idx="1227">
                  <c:v>2.3321515000000001E-2</c:v>
                </c:pt>
                <c:pt idx="1228">
                  <c:v>4.5854340000000002E-3</c:v>
                </c:pt>
                <c:pt idx="1229">
                  <c:v>8.034322E-3</c:v>
                </c:pt>
                <c:pt idx="1230">
                  <c:v>2.5802400000000001E-3</c:v>
                </c:pt>
                <c:pt idx="1231">
                  <c:v>3.8845419999999999E-3</c:v>
                </c:pt>
                <c:pt idx="1232">
                  <c:v>3.639855E-3</c:v>
                </c:pt>
                <c:pt idx="1233">
                  <c:v>1.3498550000000001E-3</c:v>
                </c:pt>
                <c:pt idx="1234">
                  <c:v>5.7169700000000003E-4</c:v>
                </c:pt>
                <c:pt idx="1235">
                  <c:v>1.256739E-3</c:v>
                </c:pt>
                <c:pt idx="1236">
                  <c:v>9.8491700000000008E-4</c:v>
                </c:pt>
                <c:pt idx="1237">
                  <c:v>7.5883199999999997E-4</c:v>
                </c:pt>
                <c:pt idx="1238">
                  <c:v>6.5165700000000004E-4</c:v>
                </c:pt>
                <c:pt idx="1239">
                  <c:v>1.7684015000000001E-2</c:v>
                </c:pt>
                <c:pt idx="1240">
                  <c:v>5.0748169999999997E-3</c:v>
                </c:pt>
                <c:pt idx="1241">
                  <c:v>6.2095320000000002E-3</c:v>
                </c:pt>
                <c:pt idx="1242">
                  <c:v>5.97676E-4</c:v>
                </c:pt>
                <c:pt idx="1243">
                  <c:v>7.2827409999999997E-3</c:v>
                </c:pt>
                <c:pt idx="1244">
                  <c:v>5.6599502000000003E-2</c:v>
                </c:pt>
                <c:pt idx="1245">
                  <c:v>1.7886012E-2</c:v>
                </c:pt>
                <c:pt idx="1246">
                  <c:v>6.561267E-3</c:v>
                </c:pt>
                <c:pt idx="1247">
                  <c:v>1.7204760999999999E-2</c:v>
                </c:pt>
                <c:pt idx="1248">
                  <c:v>1.386654E-3</c:v>
                </c:pt>
                <c:pt idx="1249">
                  <c:v>8.8246379999999992E-3</c:v>
                </c:pt>
                <c:pt idx="1250">
                  <c:v>9.1370410000000003E-3</c:v>
                </c:pt>
                <c:pt idx="1251">
                  <c:v>6.0270779999999999E-3</c:v>
                </c:pt>
                <c:pt idx="1252">
                  <c:v>1.0665098E-2</c:v>
                </c:pt>
                <c:pt idx="1253">
                  <c:v>4.7884300000000001E-4</c:v>
                </c:pt>
                <c:pt idx="1254">
                  <c:v>5.6712760000000003E-3</c:v>
                </c:pt>
                <c:pt idx="1255">
                  <c:v>1.720781E-2</c:v>
                </c:pt>
                <c:pt idx="1256">
                  <c:v>1.3408962999999999E-2</c:v>
                </c:pt>
                <c:pt idx="1257">
                  <c:v>1.7081169E-2</c:v>
                </c:pt>
                <c:pt idx="1258">
                  <c:v>4.6575649999999998E-3</c:v>
                </c:pt>
                <c:pt idx="1259">
                  <c:v>2.4737239000000001E-2</c:v>
                </c:pt>
                <c:pt idx="1260">
                  <c:v>1.1186592E-2</c:v>
                </c:pt>
                <c:pt idx="1261">
                  <c:v>7.0562700000000001E-4</c:v>
                </c:pt>
                <c:pt idx="1262">
                  <c:v>1.4147061000000001E-2</c:v>
                </c:pt>
                <c:pt idx="1263">
                  <c:v>1.5620317999999999E-2</c:v>
                </c:pt>
                <c:pt idx="1264">
                  <c:v>3.1318502999999998E-2</c:v>
                </c:pt>
                <c:pt idx="1265">
                  <c:v>1.2640850000000001E-3</c:v>
                </c:pt>
                <c:pt idx="1266">
                  <c:v>2.2155310000000002E-3</c:v>
                </c:pt>
                <c:pt idx="1267">
                  <c:v>2.2494660999999999E-2</c:v>
                </c:pt>
                <c:pt idx="1268">
                  <c:v>3.1695494999999997E-2</c:v>
                </c:pt>
                <c:pt idx="1269">
                  <c:v>1.4481997999999999E-2</c:v>
                </c:pt>
                <c:pt idx="1270">
                  <c:v>7.5130639999999999E-3</c:v>
                </c:pt>
                <c:pt idx="1271">
                  <c:v>5.5480700000000004E-4</c:v>
                </c:pt>
                <c:pt idx="1272">
                  <c:v>9.3022700000000005E-4</c:v>
                </c:pt>
                <c:pt idx="1273">
                  <c:v>7.1769800000000001E-4</c:v>
                </c:pt>
                <c:pt idx="1274">
                  <c:v>8.7211260999999998E-2</c:v>
                </c:pt>
                <c:pt idx="1275">
                  <c:v>3.5261714E-2</c:v>
                </c:pt>
                <c:pt idx="1276">
                  <c:v>5.4369880000000002E-2</c:v>
                </c:pt>
                <c:pt idx="1277">
                  <c:v>6.1759600000000003E-3</c:v>
                </c:pt>
                <c:pt idx="1278">
                  <c:v>3.5851809999999998E-3</c:v>
                </c:pt>
                <c:pt idx="1279">
                  <c:v>4.7655090000000002E-3</c:v>
                </c:pt>
                <c:pt idx="1280">
                  <c:v>1.4118609000000001E-2</c:v>
                </c:pt>
                <c:pt idx="1281">
                  <c:v>7.2078339999999998E-3</c:v>
                </c:pt>
                <c:pt idx="1282">
                  <c:v>9.443145E-3</c:v>
                </c:pt>
                <c:pt idx="1283">
                  <c:v>1.0417569999999999E-3</c:v>
                </c:pt>
                <c:pt idx="1284">
                  <c:v>1.056291E-3</c:v>
                </c:pt>
                <c:pt idx="1285">
                  <c:v>5.9209730000000004E-3</c:v>
                </c:pt>
                <c:pt idx="1286">
                  <c:v>1.6127716E-2</c:v>
                </c:pt>
                <c:pt idx="1287">
                  <c:v>5.1558990000000002E-3</c:v>
                </c:pt>
                <c:pt idx="1288">
                  <c:v>1.3583270000000001E-3</c:v>
                </c:pt>
                <c:pt idx="1289">
                  <c:v>6.7776424000000002E-2</c:v>
                </c:pt>
                <c:pt idx="1290">
                  <c:v>8.8814700000000005E-4</c:v>
                </c:pt>
                <c:pt idx="1291">
                  <c:v>6.3345550000000004E-3</c:v>
                </c:pt>
                <c:pt idx="1292">
                  <c:v>1.6144379999999999E-3</c:v>
                </c:pt>
                <c:pt idx="1293">
                  <c:v>4.6036439999999996E-3</c:v>
                </c:pt>
                <c:pt idx="1294">
                  <c:v>1.1553938E-2</c:v>
                </c:pt>
                <c:pt idx="1295">
                  <c:v>2.5343412999999999E-2</c:v>
                </c:pt>
                <c:pt idx="1296">
                  <c:v>5.1201199999999995E-4</c:v>
                </c:pt>
                <c:pt idx="1297">
                  <c:v>5.9901799999999999E-4</c:v>
                </c:pt>
                <c:pt idx="1298">
                  <c:v>1.1820089000000001E-2</c:v>
                </c:pt>
                <c:pt idx="1299">
                  <c:v>9.8698699999999993E-4</c:v>
                </c:pt>
                <c:pt idx="1300">
                  <c:v>8.5808489999999998E-3</c:v>
                </c:pt>
                <c:pt idx="1301">
                  <c:v>1.1592081000000001E-2</c:v>
                </c:pt>
                <c:pt idx="1302">
                  <c:v>9.0483930000000001E-3</c:v>
                </c:pt>
                <c:pt idx="1303">
                  <c:v>4.9417869999999996E-3</c:v>
                </c:pt>
                <c:pt idx="1304">
                  <c:v>1.6256129000000001E-2</c:v>
                </c:pt>
                <c:pt idx="1305">
                  <c:v>1.0474516E-2</c:v>
                </c:pt>
                <c:pt idx="1306">
                  <c:v>2.8231307000000001E-2</c:v>
                </c:pt>
                <c:pt idx="1307">
                  <c:v>1.5669977000000002E-2</c:v>
                </c:pt>
                <c:pt idx="1308">
                  <c:v>3.9096054999999998E-2</c:v>
                </c:pt>
                <c:pt idx="1309">
                  <c:v>1.2738219E-2</c:v>
                </c:pt>
                <c:pt idx="1310">
                  <c:v>1.8112067999999999E-2</c:v>
                </c:pt>
                <c:pt idx="1311">
                  <c:v>1.4413409E-2</c:v>
                </c:pt>
                <c:pt idx="1312">
                  <c:v>4.2504650000000001E-3</c:v>
                </c:pt>
                <c:pt idx="1313">
                  <c:v>1.535043E-2</c:v>
                </c:pt>
                <c:pt idx="1314">
                  <c:v>1.2587124999999999E-2</c:v>
                </c:pt>
                <c:pt idx="1315">
                  <c:v>1.5529703000000001E-2</c:v>
                </c:pt>
                <c:pt idx="1316">
                  <c:v>1.1543723000000001E-2</c:v>
                </c:pt>
                <c:pt idx="1317">
                  <c:v>1.2462869E-2</c:v>
                </c:pt>
                <c:pt idx="1318">
                  <c:v>1.8966645000000001E-2</c:v>
                </c:pt>
                <c:pt idx="1319">
                  <c:v>4.2217853E-2</c:v>
                </c:pt>
                <c:pt idx="1320">
                  <c:v>1.5070161E-2</c:v>
                </c:pt>
                <c:pt idx="1321">
                  <c:v>5.1090531000000002E-2</c:v>
                </c:pt>
                <c:pt idx="1322">
                  <c:v>1.3686633E-2</c:v>
                </c:pt>
                <c:pt idx="1323">
                  <c:v>1.1180925E-2</c:v>
                </c:pt>
                <c:pt idx="1324">
                  <c:v>9.9223220000000008E-3</c:v>
                </c:pt>
                <c:pt idx="1325">
                  <c:v>2.9079679999999999E-3</c:v>
                </c:pt>
                <c:pt idx="1326">
                  <c:v>3.9316029999999997E-3</c:v>
                </c:pt>
                <c:pt idx="1327">
                  <c:v>2.96218E-3</c:v>
                </c:pt>
                <c:pt idx="1328">
                  <c:v>5.0871559999999998E-3</c:v>
                </c:pt>
                <c:pt idx="1329">
                  <c:v>1.3711767999999999E-2</c:v>
                </c:pt>
                <c:pt idx="1330">
                  <c:v>4.7331209999999999E-3</c:v>
                </c:pt>
                <c:pt idx="1331">
                  <c:v>6.4211200000000002E-4</c:v>
                </c:pt>
                <c:pt idx="1332">
                  <c:v>1.2680083999999999E-2</c:v>
                </c:pt>
                <c:pt idx="1333">
                  <c:v>1.33113E-3</c:v>
                </c:pt>
                <c:pt idx="1334">
                  <c:v>1.163685E-3</c:v>
                </c:pt>
                <c:pt idx="1335">
                  <c:v>2.149239E-2</c:v>
                </c:pt>
                <c:pt idx="1336">
                  <c:v>1.73302E-3</c:v>
                </c:pt>
                <c:pt idx="1337">
                  <c:v>2.6841345999999999E-2</c:v>
                </c:pt>
                <c:pt idx="1338">
                  <c:v>9.5011880000000007E-3</c:v>
                </c:pt>
                <c:pt idx="1339">
                  <c:v>3.0360690000000002E-3</c:v>
                </c:pt>
                <c:pt idx="1340">
                  <c:v>2.3560246999999999E-2</c:v>
                </c:pt>
                <c:pt idx="1341">
                  <c:v>2.8357555999999999E-2</c:v>
                </c:pt>
                <c:pt idx="1342">
                  <c:v>7.7155419999999997E-3</c:v>
                </c:pt>
                <c:pt idx="1343">
                  <c:v>1.8256818000000001E-2</c:v>
                </c:pt>
                <c:pt idx="1344">
                  <c:v>2.1237159999999999E-3</c:v>
                </c:pt>
                <c:pt idx="1345">
                  <c:v>5.3013210000000003E-3</c:v>
                </c:pt>
                <c:pt idx="1346">
                  <c:v>1.8106240999999999E-2</c:v>
                </c:pt>
                <c:pt idx="1347">
                  <c:v>1.5908329999999998E-2</c:v>
                </c:pt>
                <c:pt idx="1348">
                  <c:v>1.485604E-3</c:v>
                </c:pt>
                <c:pt idx="1349">
                  <c:v>1.2624945E-2</c:v>
                </c:pt>
                <c:pt idx="1350">
                  <c:v>8.2978979999999997E-3</c:v>
                </c:pt>
                <c:pt idx="1351">
                  <c:v>1.295916E-3</c:v>
                </c:pt>
                <c:pt idx="1352">
                  <c:v>6.7815200000000001E-3</c:v>
                </c:pt>
                <c:pt idx="1353">
                  <c:v>9.0506119999999995E-3</c:v>
                </c:pt>
                <c:pt idx="1354">
                  <c:v>5.8152200000000001E-4</c:v>
                </c:pt>
                <c:pt idx="1355">
                  <c:v>6.1834220000000001E-3</c:v>
                </c:pt>
                <c:pt idx="1356">
                  <c:v>9.4328800000000003E-4</c:v>
                </c:pt>
                <c:pt idx="1357">
                  <c:v>6.2527470000000003E-3</c:v>
                </c:pt>
                <c:pt idx="1358">
                  <c:v>5.1109069999999996E-3</c:v>
                </c:pt>
                <c:pt idx="1359">
                  <c:v>2.5682050000000001E-3</c:v>
                </c:pt>
                <c:pt idx="1360">
                  <c:v>6.2292900000000004E-4</c:v>
                </c:pt>
                <c:pt idx="1361">
                  <c:v>2.9558119999999999E-3</c:v>
                </c:pt>
                <c:pt idx="1362">
                  <c:v>8.3372700000000004E-4</c:v>
                </c:pt>
                <c:pt idx="1363">
                  <c:v>3.6494099999999997E-4</c:v>
                </c:pt>
                <c:pt idx="1364">
                  <c:v>9.9110600000000006E-4</c:v>
                </c:pt>
                <c:pt idx="1365">
                  <c:v>2.5092309999999998E-3</c:v>
                </c:pt>
                <c:pt idx="1366">
                  <c:v>3.5420500000000001E-3</c:v>
                </c:pt>
                <c:pt idx="1367">
                  <c:v>4.0517498999999998E-2</c:v>
                </c:pt>
                <c:pt idx="1368">
                  <c:v>1.9260531000000001E-2</c:v>
                </c:pt>
                <c:pt idx="1369">
                  <c:v>7.0018190000000003E-3</c:v>
                </c:pt>
                <c:pt idx="1370">
                  <c:v>3.0281850000000001E-3</c:v>
                </c:pt>
                <c:pt idx="1371">
                  <c:v>7.4184359999999996E-3</c:v>
                </c:pt>
                <c:pt idx="1372">
                  <c:v>1.1140584E-2</c:v>
                </c:pt>
                <c:pt idx="1373">
                  <c:v>1.007007E-2</c:v>
                </c:pt>
                <c:pt idx="1374">
                  <c:v>9.9699599999999999E-4</c:v>
                </c:pt>
                <c:pt idx="1375">
                  <c:v>9.8934099999999992E-4</c:v>
                </c:pt>
                <c:pt idx="1376">
                  <c:v>1.977379E-3</c:v>
                </c:pt>
                <c:pt idx="1377">
                  <c:v>3.0023856000000002E-2</c:v>
                </c:pt>
                <c:pt idx="1378">
                  <c:v>5.0685239999999996E-3</c:v>
                </c:pt>
                <c:pt idx="1379">
                  <c:v>1.761096E-3</c:v>
                </c:pt>
                <c:pt idx="1380">
                  <c:v>1.7614891000000001E-2</c:v>
                </c:pt>
                <c:pt idx="1381">
                  <c:v>1.3677127000000001E-2</c:v>
                </c:pt>
                <c:pt idx="1382">
                  <c:v>4.6879699999999996E-3</c:v>
                </c:pt>
                <c:pt idx="1383">
                  <c:v>2.2937029000000001E-2</c:v>
                </c:pt>
                <c:pt idx="1384">
                  <c:v>6.295452E-3</c:v>
                </c:pt>
                <c:pt idx="1385">
                  <c:v>4.2254495000000003E-2</c:v>
                </c:pt>
                <c:pt idx="1386">
                  <c:v>4.2189881999999998E-2</c:v>
                </c:pt>
                <c:pt idx="1387">
                  <c:v>1.6949860000000001E-3</c:v>
                </c:pt>
                <c:pt idx="1388">
                  <c:v>1.6736170000000001E-3</c:v>
                </c:pt>
                <c:pt idx="1389">
                  <c:v>3.0280300000000001E-3</c:v>
                </c:pt>
                <c:pt idx="1390">
                  <c:v>5.8678669999999997E-3</c:v>
                </c:pt>
                <c:pt idx="1391">
                  <c:v>4.5404410000000001E-3</c:v>
                </c:pt>
                <c:pt idx="1392">
                  <c:v>2.491236E-3</c:v>
                </c:pt>
                <c:pt idx="1393">
                  <c:v>1.473557E-2</c:v>
                </c:pt>
                <c:pt idx="1394">
                  <c:v>1.8299200000000001E-3</c:v>
                </c:pt>
                <c:pt idx="1395">
                  <c:v>7.2811610000000004E-3</c:v>
                </c:pt>
                <c:pt idx="1396">
                  <c:v>1.2388709999999999E-3</c:v>
                </c:pt>
                <c:pt idx="1397">
                  <c:v>1.2975848E-2</c:v>
                </c:pt>
                <c:pt idx="1398">
                  <c:v>1.1209155E-2</c:v>
                </c:pt>
                <c:pt idx="1399">
                  <c:v>2.2398906E-2</c:v>
                </c:pt>
                <c:pt idx="1400">
                  <c:v>7.7863200000000002E-4</c:v>
                </c:pt>
                <c:pt idx="1401">
                  <c:v>1.1159192E-2</c:v>
                </c:pt>
                <c:pt idx="1402">
                  <c:v>4.9989530000000004E-3</c:v>
                </c:pt>
                <c:pt idx="1403">
                  <c:v>2.1021220000000001E-3</c:v>
                </c:pt>
                <c:pt idx="1404">
                  <c:v>3.8940070000000001E-3</c:v>
                </c:pt>
                <c:pt idx="1405">
                  <c:v>8.3568419999999997E-3</c:v>
                </c:pt>
                <c:pt idx="1406">
                  <c:v>1.567398E-3</c:v>
                </c:pt>
                <c:pt idx="1407">
                  <c:v>9.2664500000000003E-4</c:v>
                </c:pt>
                <c:pt idx="1408">
                  <c:v>1.6445520000000001E-3</c:v>
                </c:pt>
                <c:pt idx="1409">
                  <c:v>2.047068E-3</c:v>
                </c:pt>
                <c:pt idx="1410">
                  <c:v>7.1582000000000004E-4</c:v>
                </c:pt>
                <c:pt idx="1411">
                  <c:v>1.3281764E-2</c:v>
                </c:pt>
                <c:pt idx="1412">
                  <c:v>6.7866630000000001E-3</c:v>
                </c:pt>
                <c:pt idx="1413">
                  <c:v>0.12266065399999999</c:v>
                </c:pt>
                <c:pt idx="1414">
                  <c:v>2.0062228000000001E-2</c:v>
                </c:pt>
                <c:pt idx="1415">
                  <c:v>5.4660500000000003E-4</c:v>
                </c:pt>
                <c:pt idx="1416">
                  <c:v>4.2839700000000001E-4</c:v>
                </c:pt>
                <c:pt idx="1417">
                  <c:v>9.7725500000000001E-4</c:v>
                </c:pt>
                <c:pt idx="1418">
                  <c:v>1.0153393E-2</c:v>
                </c:pt>
                <c:pt idx="1419">
                  <c:v>2.4914780000000001E-3</c:v>
                </c:pt>
                <c:pt idx="1420">
                  <c:v>8.8188199999999996E-4</c:v>
                </c:pt>
                <c:pt idx="1421">
                  <c:v>9.2052400000000004E-4</c:v>
                </c:pt>
                <c:pt idx="1422">
                  <c:v>1.5861950000000001E-3</c:v>
                </c:pt>
                <c:pt idx="1423">
                  <c:v>3.1611388999999997E-2</c:v>
                </c:pt>
                <c:pt idx="1424">
                  <c:v>6.8606299999999999E-4</c:v>
                </c:pt>
                <c:pt idx="1425">
                  <c:v>2.2253697999999999E-2</c:v>
                </c:pt>
                <c:pt idx="1426">
                  <c:v>2.5635336000000002E-2</c:v>
                </c:pt>
                <c:pt idx="1427">
                  <c:v>3.2928340000000001E-3</c:v>
                </c:pt>
                <c:pt idx="1428">
                  <c:v>7.7779499999999996E-4</c:v>
                </c:pt>
                <c:pt idx="1429">
                  <c:v>6.5379399999999997E-4</c:v>
                </c:pt>
                <c:pt idx="1430">
                  <c:v>5.3770629999999996E-3</c:v>
                </c:pt>
                <c:pt idx="1431">
                  <c:v>2.1624191000000001E-2</c:v>
                </c:pt>
                <c:pt idx="1432">
                  <c:v>1.9823723000000001E-2</c:v>
                </c:pt>
                <c:pt idx="1433">
                  <c:v>4.5296909999999998E-3</c:v>
                </c:pt>
                <c:pt idx="1434">
                  <c:v>9.3772899999999999E-4</c:v>
                </c:pt>
                <c:pt idx="1435">
                  <c:v>1.0481220000000001E-3</c:v>
                </c:pt>
                <c:pt idx="1436">
                  <c:v>2.1997090000000002E-3</c:v>
                </c:pt>
                <c:pt idx="1437">
                  <c:v>2.1473709999999999E-3</c:v>
                </c:pt>
                <c:pt idx="1438">
                  <c:v>2.305316E-3</c:v>
                </c:pt>
                <c:pt idx="1439">
                  <c:v>2.7504040000000001E-3</c:v>
                </c:pt>
                <c:pt idx="1440">
                  <c:v>7.6621600000000001E-4</c:v>
                </c:pt>
                <c:pt idx="1441">
                  <c:v>3.0946458E-2</c:v>
                </c:pt>
                <c:pt idx="1442">
                  <c:v>7.4063099999999995E-4</c:v>
                </c:pt>
                <c:pt idx="1443">
                  <c:v>1.018375E-3</c:v>
                </c:pt>
                <c:pt idx="1444">
                  <c:v>1.786637E-3</c:v>
                </c:pt>
                <c:pt idx="1445">
                  <c:v>2.0106419E-2</c:v>
                </c:pt>
                <c:pt idx="1446">
                  <c:v>2.165915E-3</c:v>
                </c:pt>
                <c:pt idx="1447">
                  <c:v>7.90722E-4</c:v>
                </c:pt>
                <c:pt idx="1448">
                  <c:v>2.8607454000000001E-2</c:v>
                </c:pt>
                <c:pt idx="1449">
                  <c:v>3.1917899999999999E-3</c:v>
                </c:pt>
                <c:pt idx="1450">
                  <c:v>9.0187100000000005E-4</c:v>
                </c:pt>
                <c:pt idx="1451">
                  <c:v>1.5064119999999999E-3</c:v>
                </c:pt>
                <c:pt idx="1452">
                  <c:v>2.6675259999999999E-3</c:v>
                </c:pt>
                <c:pt idx="1453">
                  <c:v>3.1684629999999998E-2</c:v>
                </c:pt>
                <c:pt idx="1454">
                  <c:v>6.1015899999999998E-4</c:v>
                </c:pt>
                <c:pt idx="1455">
                  <c:v>2.073053E-3</c:v>
                </c:pt>
                <c:pt idx="1456">
                  <c:v>3.1109969999999999E-3</c:v>
                </c:pt>
                <c:pt idx="1457">
                  <c:v>3.1117326000000001E-2</c:v>
                </c:pt>
                <c:pt idx="1458">
                  <c:v>1.022614E-3</c:v>
                </c:pt>
                <c:pt idx="1459">
                  <c:v>6.70873E-4</c:v>
                </c:pt>
                <c:pt idx="1460">
                  <c:v>2.2482641000000001E-2</c:v>
                </c:pt>
                <c:pt idx="1461">
                  <c:v>2.4270889999999999E-3</c:v>
                </c:pt>
                <c:pt idx="1462">
                  <c:v>7.7445300000000003E-4</c:v>
                </c:pt>
                <c:pt idx="1463">
                  <c:v>3.0182770000000002E-3</c:v>
                </c:pt>
                <c:pt idx="1464">
                  <c:v>1.1229790000000001E-3</c:v>
                </c:pt>
                <c:pt idx="1465">
                  <c:v>3.2189586999999999E-2</c:v>
                </c:pt>
                <c:pt idx="1466">
                  <c:v>8.3611000000000004E-4</c:v>
                </c:pt>
                <c:pt idx="1467">
                  <c:v>2.1186059E-2</c:v>
                </c:pt>
                <c:pt idx="1468">
                  <c:v>1.6858049999999999E-2</c:v>
                </c:pt>
                <c:pt idx="1469">
                  <c:v>8.6675000000000001E-4</c:v>
                </c:pt>
                <c:pt idx="1470">
                  <c:v>7.9227300000000002E-4</c:v>
                </c:pt>
                <c:pt idx="1471">
                  <c:v>7.1190700000000001E-4</c:v>
                </c:pt>
                <c:pt idx="1472">
                  <c:v>3.1118309999999998E-3</c:v>
                </c:pt>
                <c:pt idx="1473">
                  <c:v>2.1015489999999999E-3</c:v>
                </c:pt>
                <c:pt idx="1474">
                  <c:v>1.7631226999999999E-2</c:v>
                </c:pt>
                <c:pt idx="1475">
                  <c:v>7.9909899999999995E-4</c:v>
                </c:pt>
                <c:pt idx="1476">
                  <c:v>6.4816699999999995E-4</c:v>
                </c:pt>
                <c:pt idx="1477">
                  <c:v>2.1676516E-2</c:v>
                </c:pt>
                <c:pt idx="1478">
                  <c:v>3.9379458999999999E-2</c:v>
                </c:pt>
                <c:pt idx="1479">
                  <c:v>3.0382650000000001E-3</c:v>
                </c:pt>
                <c:pt idx="1480">
                  <c:v>4.8039399999999998E-4</c:v>
                </c:pt>
                <c:pt idx="1481">
                  <c:v>1.9189249999999999E-3</c:v>
                </c:pt>
                <c:pt idx="1482">
                  <c:v>2.0628448000000001E-2</c:v>
                </c:pt>
                <c:pt idx="1483">
                  <c:v>2.0569548999999999E-2</c:v>
                </c:pt>
                <c:pt idx="1484">
                  <c:v>2.8632470000000002E-3</c:v>
                </c:pt>
                <c:pt idx="1485">
                  <c:v>4.3285677000000002E-2</c:v>
                </c:pt>
                <c:pt idx="1486">
                  <c:v>2.2901319999999998E-3</c:v>
                </c:pt>
                <c:pt idx="1487">
                  <c:v>2.6870060000000001E-2</c:v>
                </c:pt>
                <c:pt idx="1488">
                  <c:v>5.39311E-4</c:v>
                </c:pt>
                <c:pt idx="1489">
                  <c:v>3.0543319999999999E-3</c:v>
                </c:pt>
                <c:pt idx="1490">
                  <c:v>2.4688819999999999E-3</c:v>
                </c:pt>
                <c:pt idx="1491">
                  <c:v>1.264018E-3</c:v>
                </c:pt>
                <c:pt idx="1492">
                  <c:v>4.4962789999999997E-3</c:v>
                </c:pt>
                <c:pt idx="1493">
                  <c:v>1.4531125000000001E-2</c:v>
                </c:pt>
                <c:pt idx="1494">
                  <c:v>4.4850367000000002E-2</c:v>
                </c:pt>
                <c:pt idx="1495">
                  <c:v>3.7994558999999997E-2</c:v>
                </c:pt>
                <c:pt idx="1496">
                  <c:v>2.3638053999999999E-2</c:v>
                </c:pt>
                <c:pt idx="1497">
                  <c:v>1.8120790000000001E-3</c:v>
                </c:pt>
                <c:pt idx="1498">
                  <c:v>4.7256700000000002E-4</c:v>
                </c:pt>
                <c:pt idx="1499">
                  <c:v>2.1457870000000001E-3</c:v>
                </c:pt>
                <c:pt idx="1500">
                  <c:v>1.105853E-3</c:v>
                </c:pt>
                <c:pt idx="1501">
                  <c:v>3.8442120000000001E-3</c:v>
                </c:pt>
                <c:pt idx="1502">
                  <c:v>1.9973912E-2</c:v>
                </c:pt>
                <c:pt idx="1503">
                  <c:v>6.7116300000000001E-4</c:v>
                </c:pt>
                <c:pt idx="1504">
                  <c:v>2.1921250000000001E-3</c:v>
                </c:pt>
                <c:pt idx="1505">
                  <c:v>2.9436714999999999E-2</c:v>
                </c:pt>
                <c:pt idx="1506">
                  <c:v>9.4834169999999992E-3</c:v>
                </c:pt>
                <c:pt idx="1507">
                  <c:v>2.9868984000000001E-2</c:v>
                </c:pt>
                <c:pt idx="1508">
                  <c:v>5.3265500000000004E-4</c:v>
                </c:pt>
                <c:pt idx="1509">
                  <c:v>9.6340800000000002E-4</c:v>
                </c:pt>
                <c:pt idx="1510">
                  <c:v>1.3111536E-2</c:v>
                </c:pt>
                <c:pt idx="1511">
                  <c:v>1.594505E-3</c:v>
                </c:pt>
                <c:pt idx="1512">
                  <c:v>9.4682000000000002E-4</c:v>
                </c:pt>
                <c:pt idx="1513">
                  <c:v>1.067616E-3</c:v>
                </c:pt>
                <c:pt idx="1514">
                  <c:v>3.6952410000000002E-3</c:v>
                </c:pt>
                <c:pt idx="1515">
                  <c:v>2.2739560000000002E-3</c:v>
                </c:pt>
                <c:pt idx="1516">
                  <c:v>2.9888099999999997E-4</c:v>
                </c:pt>
                <c:pt idx="1517">
                  <c:v>1.1140779999999999E-3</c:v>
                </c:pt>
                <c:pt idx="1518">
                  <c:v>1.5226E-3</c:v>
                </c:pt>
                <c:pt idx="1519">
                  <c:v>3.3357442000000001E-2</c:v>
                </c:pt>
                <c:pt idx="1520">
                  <c:v>2.7548210000000002E-3</c:v>
                </c:pt>
                <c:pt idx="1521">
                  <c:v>4.2114240000000001E-3</c:v>
                </c:pt>
                <c:pt idx="1522">
                  <c:v>5.3102625000000001E-2</c:v>
                </c:pt>
                <c:pt idx="1523">
                  <c:v>5.1483900000000001E-4</c:v>
                </c:pt>
                <c:pt idx="1524">
                  <c:v>1.7989756999999999E-2</c:v>
                </c:pt>
                <c:pt idx="1525">
                  <c:v>1.607664E-3</c:v>
                </c:pt>
                <c:pt idx="1526">
                  <c:v>7.2280399999999996E-4</c:v>
                </c:pt>
                <c:pt idx="1527">
                  <c:v>1.688965E-3</c:v>
                </c:pt>
                <c:pt idx="1528">
                  <c:v>2.3845799999999999E-3</c:v>
                </c:pt>
                <c:pt idx="1529">
                  <c:v>4.6616749999999997E-3</c:v>
                </c:pt>
                <c:pt idx="1530">
                  <c:v>1.1959749999999999E-3</c:v>
                </c:pt>
                <c:pt idx="1531">
                  <c:v>1.8847345000000001E-2</c:v>
                </c:pt>
                <c:pt idx="1532">
                  <c:v>1.8878689999999999E-3</c:v>
                </c:pt>
                <c:pt idx="1533">
                  <c:v>1.4961499999999999E-3</c:v>
                </c:pt>
                <c:pt idx="1534">
                  <c:v>6.6660285999999999E-2</c:v>
                </c:pt>
                <c:pt idx="1535">
                  <c:v>8.1722900000000005E-4</c:v>
                </c:pt>
                <c:pt idx="1536">
                  <c:v>1.4243389999999999E-3</c:v>
                </c:pt>
                <c:pt idx="1537">
                  <c:v>4.2154569999999997E-3</c:v>
                </c:pt>
                <c:pt idx="1538">
                  <c:v>1.6591609999999999E-3</c:v>
                </c:pt>
                <c:pt idx="1539">
                  <c:v>4.2220533999999997E-2</c:v>
                </c:pt>
                <c:pt idx="1540">
                  <c:v>3.6698429999999999E-3</c:v>
                </c:pt>
                <c:pt idx="1541">
                  <c:v>9.7789899999999996E-4</c:v>
                </c:pt>
                <c:pt idx="1542">
                  <c:v>2.086418E-3</c:v>
                </c:pt>
                <c:pt idx="1543">
                  <c:v>2.0053940000000002E-3</c:v>
                </c:pt>
                <c:pt idx="1544">
                  <c:v>9.7591448999999997E-2</c:v>
                </c:pt>
                <c:pt idx="1545">
                  <c:v>2.328699E-3</c:v>
                </c:pt>
                <c:pt idx="1546">
                  <c:v>6.3694270000000004E-3</c:v>
                </c:pt>
                <c:pt idx="1547">
                  <c:v>1.940631E-3</c:v>
                </c:pt>
                <c:pt idx="1548">
                  <c:v>4.3888500000000002E-4</c:v>
                </c:pt>
                <c:pt idx="1549">
                  <c:v>2.21451E-4</c:v>
                </c:pt>
                <c:pt idx="1550">
                  <c:v>7.2487099999999998E-4</c:v>
                </c:pt>
                <c:pt idx="1551">
                  <c:v>7.4196199999999998E-4</c:v>
                </c:pt>
                <c:pt idx="1552">
                  <c:v>5.7739042999999997E-2</c:v>
                </c:pt>
                <c:pt idx="1553">
                  <c:v>5.0331350000000002E-3</c:v>
                </c:pt>
                <c:pt idx="1554">
                  <c:v>2.5305779999999999E-3</c:v>
                </c:pt>
                <c:pt idx="1555">
                  <c:v>1.2819420000000001E-3</c:v>
                </c:pt>
                <c:pt idx="1556">
                  <c:v>2.6653739999999999E-3</c:v>
                </c:pt>
                <c:pt idx="1557">
                  <c:v>6.0953299999999999E-4</c:v>
                </c:pt>
                <c:pt idx="1558">
                  <c:v>3.7188500000000002E-4</c:v>
                </c:pt>
                <c:pt idx="1559">
                  <c:v>1.27275E-3</c:v>
                </c:pt>
                <c:pt idx="1560">
                  <c:v>6.43832E-4</c:v>
                </c:pt>
                <c:pt idx="1561">
                  <c:v>1.933239E-3</c:v>
                </c:pt>
                <c:pt idx="1562">
                  <c:v>5.0111360000000002E-3</c:v>
                </c:pt>
                <c:pt idx="1563">
                  <c:v>1.672474E-3</c:v>
                </c:pt>
                <c:pt idx="1564">
                  <c:v>2.4137439999999998E-3</c:v>
                </c:pt>
                <c:pt idx="1565">
                  <c:v>5.6890900000000004E-4</c:v>
                </c:pt>
                <c:pt idx="1566">
                  <c:v>7.1255500000000002E-4</c:v>
                </c:pt>
                <c:pt idx="1567">
                  <c:v>1.48302E-4</c:v>
                </c:pt>
                <c:pt idx="1568">
                  <c:v>1.782002E-3</c:v>
                </c:pt>
                <c:pt idx="1569">
                  <c:v>1.349123E-3</c:v>
                </c:pt>
                <c:pt idx="1570">
                  <c:v>1.0687019999999999E-3</c:v>
                </c:pt>
                <c:pt idx="1571">
                  <c:v>1.418887E-3</c:v>
                </c:pt>
                <c:pt idx="1572">
                  <c:v>0.23965192900000001</c:v>
                </c:pt>
                <c:pt idx="1573">
                  <c:v>2.8436020000000002E-3</c:v>
                </c:pt>
                <c:pt idx="1574">
                  <c:v>7.7632220000000002E-3</c:v>
                </c:pt>
                <c:pt idx="1575">
                  <c:v>2.2959180000000001E-3</c:v>
                </c:pt>
                <c:pt idx="1576">
                  <c:v>2.6116479999999998E-3</c:v>
                </c:pt>
                <c:pt idx="1577">
                  <c:v>3.4120729999999998E-3</c:v>
                </c:pt>
                <c:pt idx="1578">
                  <c:v>7.1038250000000002E-3</c:v>
                </c:pt>
                <c:pt idx="1579">
                  <c:v>9.3370699999999998E-4</c:v>
                </c:pt>
                <c:pt idx="1580">
                  <c:v>2.2151900000000001E-3</c:v>
                </c:pt>
                <c:pt idx="1581">
                  <c:v>6.3918199999999997E-4</c:v>
                </c:pt>
                <c:pt idx="1582">
                  <c:v>9.85545E-4</c:v>
                </c:pt>
                <c:pt idx="1583">
                  <c:v>1.048584E-3</c:v>
                </c:pt>
                <c:pt idx="1584">
                  <c:v>1.0972930000000001E-3</c:v>
                </c:pt>
                <c:pt idx="1585">
                  <c:v>1.8058690000000001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BF-4EA4-9F2A-806A819FC3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758184"/>
        <c:axId val="607749000"/>
      </c:scatterChart>
      <c:valAx>
        <c:axId val="607758184"/>
        <c:scaling>
          <c:orientation val="minMax"/>
          <c:max val="31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Genomic</a:t>
                </a:r>
                <a:r>
                  <a:rPr lang="en-US" b="0" baseline="0" dirty="0"/>
                  <a:t> A/C</a:t>
                </a:r>
                <a:r>
                  <a:rPr lang="en-US" b="0" dirty="0"/>
                  <a:t> position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7749000"/>
        <c:crosses val="autoZero"/>
        <c:crossBetween val="midCat"/>
        <c:majorUnit val="500"/>
      </c:valAx>
      <c:valAx>
        <c:axId val="607749000"/>
        <c:scaling>
          <c:orientation val="minMax"/>
          <c:max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Mutation</a:t>
                </a:r>
                <a:r>
                  <a:rPr lang="en-US" b="0" baseline="0"/>
                  <a:t> rate</a:t>
                </a:r>
              </a:p>
            </c:rich>
          </c:tx>
          <c:overlay val="0"/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7758184"/>
        <c:crosses val="autoZero"/>
        <c:crossBetween val="midCat"/>
      </c:valAx>
    </c:plotArea>
    <c:legend>
      <c:legendPos val="b"/>
      <c:overlay val="0"/>
    </c:legend>
    <c:plotVisOnly val="1"/>
    <c:dispBlanksAs val="gap"/>
    <c:showDLblsOverMax val="0"/>
    <c:extLst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/C mutation rate: RNA 2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strRef>
              <c:f>'RNA2 DMS'!$C$1</c:f>
              <c:strCache>
                <c:ptCount val="1"/>
                <c:pt idx="0">
                  <c:v>DMS-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RNA2 DMS'!$A$2:$A$1424</c:f>
              <c:numCache>
                <c:formatCode>General</c:formatCode>
                <c:ptCount val="1423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9</c:v>
                </c:pt>
                <c:pt idx="11">
                  <c:v>30</c:v>
                </c:pt>
                <c:pt idx="12">
                  <c:v>32</c:v>
                </c:pt>
                <c:pt idx="13">
                  <c:v>33</c:v>
                </c:pt>
                <c:pt idx="14">
                  <c:v>34</c:v>
                </c:pt>
                <c:pt idx="15">
                  <c:v>35</c:v>
                </c:pt>
                <c:pt idx="16">
                  <c:v>36</c:v>
                </c:pt>
                <c:pt idx="17">
                  <c:v>37</c:v>
                </c:pt>
                <c:pt idx="18">
                  <c:v>38</c:v>
                </c:pt>
                <c:pt idx="19">
                  <c:v>40</c:v>
                </c:pt>
                <c:pt idx="20">
                  <c:v>41</c:v>
                </c:pt>
                <c:pt idx="21">
                  <c:v>42</c:v>
                </c:pt>
                <c:pt idx="22">
                  <c:v>43</c:v>
                </c:pt>
                <c:pt idx="23">
                  <c:v>44</c:v>
                </c:pt>
                <c:pt idx="24">
                  <c:v>46</c:v>
                </c:pt>
                <c:pt idx="25">
                  <c:v>47</c:v>
                </c:pt>
                <c:pt idx="26">
                  <c:v>50</c:v>
                </c:pt>
                <c:pt idx="27">
                  <c:v>51</c:v>
                </c:pt>
                <c:pt idx="28">
                  <c:v>52</c:v>
                </c:pt>
                <c:pt idx="29">
                  <c:v>53</c:v>
                </c:pt>
                <c:pt idx="30">
                  <c:v>55</c:v>
                </c:pt>
                <c:pt idx="31">
                  <c:v>57</c:v>
                </c:pt>
                <c:pt idx="32">
                  <c:v>59</c:v>
                </c:pt>
                <c:pt idx="33">
                  <c:v>60</c:v>
                </c:pt>
                <c:pt idx="34">
                  <c:v>61</c:v>
                </c:pt>
                <c:pt idx="35">
                  <c:v>62</c:v>
                </c:pt>
                <c:pt idx="36">
                  <c:v>64</c:v>
                </c:pt>
                <c:pt idx="37">
                  <c:v>70</c:v>
                </c:pt>
                <c:pt idx="38">
                  <c:v>73</c:v>
                </c:pt>
                <c:pt idx="39">
                  <c:v>74</c:v>
                </c:pt>
                <c:pt idx="40">
                  <c:v>75</c:v>
                </c:pt>
                <c:pt idx="41">
                  <c:v>76</c:v>
                </c:pt>
                <c:pt idx="42">
                  <c:v>77</c:v>
                </c:pt>
                <c:pt idx="43">
                  <c:v>78</c:v>
                </c:pt>
                <c:pt idx="44">
                  <c:v>79</c:v>
                </c:pt>
                <c:pt idx="45">
                  <c:v>80</c:v>
                </c:pt>
                <c:pt idx="46">
                  <c:v>81</c:v>
                </c:pt>
                <c:pt idx="47">
                  <c:v>82</c:v>
                </c:pt>
                <c:pt idx="48">
                  <c:v>83</c:v>
                </c:pt>
                <c:pt idx="49">
                  <c:v>84</c:v>
                </c:pt>
                <c:pt idx="50">
                  <c:v>85</c:v>
                </c:pt>
                <c:pt idx="51">
                  <c:v>86</c:v>
                </c:pt>
                <c:pt idx="52">
                  <c:v>87</c:v>
                </c:pt>
                <c:pt idx="53">
                  <c:v>88</c:v>
                </c:pt>
                <c:pt idx="54">
                  <c:v>90</c:v>
                </c:pt>
                <c:pt idx="55">
                  <c:v>92</c:v>
                </c:pt>
                <c:pt idx="56">
                  <c:v>93</c:v>
                </c:pt>
                <c:pt idx="57">
                  <c:v>98</c:v>
                </c:pt>
                <c:pt idx="58">
                  <c:v>99</c:v>
                </c:pt>
                <c:pt idx="59">
                  <c:v>100</c:v>
                </c:pt>
                <c:pt idx="60">
                  <c:v>101</c:v>
                </c:pt>
                <c:pt idx="61">
                  <c:v>102</c:v>
                </c:pt>
                <c:pt idx="62">
                  <c:v>104</c:v>
                </c:pt>
                <c:pt idx="63">
                  <c:v>105</c:v>
                </c:pt>
                <c:pt idx="64">
                  <c:v>106</c:v>
                </c:pt>
                <c:pt idx="65">
                  <c:v>107</c:v>
                </c:pt>
                <c:pt idx="66">
                  <c:v>108</c:v>
                </c:pt>
                <c:pt idx="67">
                  <c:v>109</c:v>
                </c:pt>
                <c:pt idx="68">
                  <c:v>113</c:v>
                </c:pt>
                <c:pt idx="69">
                  <c:v>114</c:v>
                </c:pt>
                <c:pt idx="70">
                  <c:v>115</c:v>
                </c:pt>
                <c:pt idx="71">
                  <c:v>116</c:v>
                </c:pt>
                <c:pt idx="72">
                  <c:v>119</c:v>
                </c:pt>
                <c:pt idx="73">
                  <c:v>120</c:v>
                </c:pt>
                <c:pt idx="74">
                  <c:v>125</c:v>
                </c:pt>
                <c:pt idx="75">
                  <c:v>127</c:v>
                </c:pt>
                <c:pt idx="76">
                  <c:v>128</c:v>
                </c:pt>
                <c:pt idx="77">
                  <c:v>130</c:v>
                </c:pt>
                <c:pt idx="78">
                  <c:v>131</c:v>
                </c:pt>
                <c:pt idx="79">
                  <c:v>133</c:v>
                </c:pt>
                <c:pt idx="80">
                  <c:v>134</c:v>
                </c:pt>
                <c:pt idx="81">
                  <c:v>137</c:v>
                </c:pt>
                <c:pt idx="82">
                  <c:v>138</c:v>
                </c:pt>
                <c:pt idx="83">
                  <c:v>140</c:v>
                </c:pt>
                <c:pt idx="84">
                  <c:v>142</c:v>
                </c:pt>
                <c:pt idx="85">
                  <c:v>143</c:v>
                </c:pt>
                <c:pt idx="86">
                  <c:v>144</c:v>
                </c:pt>
                <c:pt idx="87">
                  <c:v>146</c:v>
                </c:pt>
                <c:pt idx="88">
                  <c:v>149</c:v>
                </c:pt>
                <c:pt idx="89">
                  <c:v>152</c:v>
                </c:pt>
                <c:pt idx="90">
                  <c:v>153</c:v>
                </c:pt>
                <c:pt idx="91">
                  <c:v>155</c:v>
                </c:pt>
                <c:pt idx="92">
                  <c:v>157</c:v>
                </c:pt>
                <c:pt idx="93">
                  <c:v>158</c:v>
                </c:pt>
                <c:pt idx="94">
                  <c:v>160</c:v>
                </c:pt>
                <c:pt idx="95">
                  <c:v>161</c:v>
                </c:pt>
                <c:pt idx="96">
                  <c:v>167</c:v>
                </c:pt>
                <c:pt idx="97">
                  <c:v>169</c:v>
                </c:pt>
                <c:pt idx="98">
                  <c:v>172</c:v>
                </c:pt>
                <c:pt idx="99">
                  <c:v>173</c:v>
                </c:pt>
                <c:pt idx="100">
                  <c:v>176</c:v>
                </c:pt>
                <c:pt idx="101">
                  <c:v>177</c:v>
                </c:pt>
                <c:pt idx="102">
                  <c:v>178</c:v>
                </c:pt>
                <c:pt idx="103">
                  <c:v>179</c:v>
                </c:pt>
                <c:pt idx="104">
                  <c:v>183</c:v>
                </c:pt>
                <c:pt idx="105">
                  <c:v>186</c:v>
                </c:pt>
                <c:pt idx="106">
                  <c:v>188</c:v>
                </c:pt>
                <c:pt idx="107">
                  <c:v>190</c:v>
                </c:pt>
                <c:pt idx="108">
                  <c:v>191</c:v>
                </c:pt>
                <c:pt idx="109">
                  <c:v>192</c:v>
                </c:pt>
                <c:pt idx="110">
                  <c:v>193</c:v>
                </c:pt>
                <c:pt idx="111">
                  <c:v>194</c:v>
                </c:pt>
                <c:pt idx="112">
                  <c:v>196</c:v>
                </c:pt>
                <c:pt idx="113">
                  <c:v>199</c:v>
                </c:pt>
                <c:pt idx="114">
                  <c:v>200</c:v>
                </c:pt>
                <c:pt idx="115">
                  <c:v>203</c:v>
                </c:pt>
                <c:pt idx="116">
                  <c:v>204</c:v>
                </c:pt>
                <c:pt idx="117">
                  <c:v>205</c:v>
                </c:pt>
                <c:pt idx="118">
                  <c:v>206</c:v>
                </c:pt>
                <c:pt idx="119">
                  <c:v>207</c:v>
                </c:pt>
                <c:pt idx="120">
                  <c:v>216</c:v>
                </c:pt>
                <c:pt idx="121">
                  <c:v>221</c:v>
                </c:pt>
                <c:pt idx="122">
                  <c:v>223</c:v>
                </c:pt>
                <c:pt idx="123">
                  <c:v>224</c:v>
                </c:pt>
                <c:pt idx="124">
                  <c:v>225</c:v>
                </c:pt>
                <c:pt idx="125">
                  <c:v>226</c:v>
                </c:pt>
                <c:pt idx="126">
                  <c:v>231</c:v>
                </c:pt>
                <c:pt idx="127">
                  <c:v>232</c:v>
                </c:pt>
                <c:pt idx="128">
                  <c:v>237</c:v>
                </c:pt>
                <c:pt idx="129">
                  <c:v>238</c:v>
                </c:pt>
                <c:pt idx="130">
                  <c:v>239</c:v>
                </c:pt>
                <c:pt idx="131">
                  <c:v>240</c:v>
                </c:pt>
                <c:pt idx="132">
                  <c:v>241</c:v>
                </c:pt>
                <c:pt idx="133">
                  <c:v>242</c:v>
                </c:pt>
                <c:pt idx="134">
                  <c:v>243</c:v>
                </c:pt>
                <c:pt idx="135">
                  <c:v>246</c:v>
                </c:pt>
                <c:pt idx="136">
                  <c:v>247</c:v>
                </c:pt>
                <c:pt idx="137">
                  <c:v>250</c:v>
                </c:pt>
                <c:pt idx="138">
                  <c:v>251</c:v>
                </c:pt>
                <c:pt idx="139">
                  <c:v>252</c:v>
                </c:pt>
                <c:pt idx="140">
                  <c:v>253</c:v>
                </c:pt>
                <c:pt idx="141">
                  <c:v>254</c:v>
                </c:pt>
                <c:pt idx="142">
                  <c:v>255</c:v>
                </c:pt>
                <c:pt idx="143">
                  <c:v>256</c:v>
                </c:pt>
                <c:pt idx="144">
                  <c:v>258</c:v>
                </c:pt>
                <c:pt idx="145">
                  <c:v>259</c:v>
                </c:pt>
                <c:pt idx="146">
                  <c:v>260</c:v>
                </c:pt>
                <c:pt idx="147">
                  <c:v>261</c:v>
                </c:pt>
                <c:pt idx="148">
                  <c:v>262</c:v>
                </c:pt>
                <c:pt idx="149">
                  <c:v>266</c:v>
                </c:pt>
                <c:pt idx="150">
                  <c:v>267</c:v>
                </c:pt>
                <c:pt idx="151">
                  <c:v>271</c:v>
                </c:pt>
                <c:pt idx="152">
                  <c:v>272</c:v>
                </c:pt>
                <c:pt idx="153">
                  <c:v>274</c:v>
                </c:pt>
                <c:pt idx="154">
                  <c:v>275</c:v>
                </c:pt>
                <c:pt idx="155">
                  <c:v>276</c:v>
                </c:pt>
                <c:pt idx="156">
                  <c:v>279</c:v>
                </c:pt>
                <c:pt idx="157">
                  <c:v>281</c:v>
                </c:pt>
                <c:pt idx="158">
                  <c:v>283</c:v>
                </c:pt>
                <c:pt idx="159">
                  <c:v>288</c:v>
                </c:pt>
                <c:pt idx="160">
                  <c:v>289</c:v>
                </c:pt>
                <c:pt idx="161">
                  <c:v>292</c:v>
                </c:pt>
                <c:pt idx="162">
                  <c:v>293</c:v>
                </c:pt>
                <c:pt idx="163">
                  <c:v>294</c:v>
                </c:pt>
                <c:pt idx="164">
                  <c:v>295</c:v>
                </c:pt>
                <c:pt idx="165">
                  <c:v>301</c:v>
                </c:pt>
                <c:pt idx="166">
                  <c:v>302</c:v>
                </c:pt>
                <c:pt idx="167">
                  <c:v>304</c:v>
                </c:pt>
                <c:pt idx="168">
                  <c:v>305</c:v>
                </c:pt>
                <c:pt idx="169">
                  <c:v>307</c:v>
                </c:pt>
                <c:pt idx="170">
                  <c:v>308</c:v>
                </c:pt>
                <c:pt idx="171">
                  <c:v>309</c:v>
                </c:pt>
                <c:pt idx="172">
                  <c:v>312</c:v>
                </c:pt>
                <c:pt idx="173">
                  <c:v>316</c:v>
                </c:pt>
                <c:pt idx="174">
                  <c:v>317</c:v>
                </c:pt>
                <c:pt idx="175">
                  <c:v>319</c:v>
                </c:pt>
                <c:pt idx="176">
                  <c:v>320</c:v>
                </c:pt>
                <c:pt idx="177">
                  <c:v>321</c:v>
                </c:pt>
                <c:pt idx="178">
                  <c:v>323</c:v>
                </c:pt>
                <c:pt idx="179">
                  <c:v>324</c:v>
                </c:pt>
                <c:pt idx="180">
                  <c:v>325</c:v>
                </c:pt>
                <c:pt idx="181">
                  <c:v>327</c:v>
                </c:pt>
                <c:pt idx="182">
                  <c:v>329</c:v>
                </c:pt>
                <c:pt idx="183">
                  <c:v>331</c:v>
                </c:pt>
                <c:pt idx="184">
                  <c:v>332</c:v>
                </c:pt>
                <c:pt idx="185">
                  <c:v>334</c:v>
                </c:pt>
                <c:pt idx="186">
                  <c:v>338</c:v>
                </c:pt>
                <c:pt idx="187">
                  <c:v>339</c:v>
                </c:pt>
                <c:pt idx="188">
                  <c:v>342</c:v>
                </c:pt>
                <c:pt idx="189">
                  <c:v>343</c:v>
                </c:pt>
                <c:pt idx="190">
                  <c:v>346</c:v>
                </c:pt>
                <c:pt idx="191">
                  <c:v>347</c:v>
                </c:pt>
                <c:pt idx="192">
                  <c:v>348</c:v>
                </c:pt>
                <c:pt idx="193">
                  <c:v>351</c:v>
                </c:pt>
                <c:pt idx="194">
                  <c:v>352</c:v>
                </c:pt>
                <c:pt idx="195">
                  <c:v>353</c:v>
                </c:pt>
                <c:pt idx="196">
                  <c:v>354</c:v>
                </c:pt>
                <c:pt idx="197">
                  <c:v>359</c:v>
                </c:pt>
                <c:pt idx="198">
                  <c:v>361</c:v>
                </c:pt>
                <c:pt idx="199">
                  <c:v>362</c:v>
                </c:pt>
                <c:pt idx="200">
                  <c:v>364</c:v>
                </c:pt>
                <c:pt idx="201">
                  <c:v>365</c:v>
                </c:pt>
                <c:pt idx="202">
                  <c:v>367</c:v>
                </c:pt>
                <c:pt idx="203">
                  <c:v>369</c:v>
                </c:pt>
                <c:pt idx="204">
                  <c:v>370</c:v>
                </c:pt>
                <c:pt idx="205">
                  <c:v>371</c:v>
                </c:pt>
                <c:pt idx="206">
                  <c:v>372</c:v>
                </c:pt>
                <c:pt idx="207">
                  <c:v>374</c:v>
                </c:pt>
                <c:pt idx="208">
                  <c:v>375</c:v>
                </c:pt>
                <c:pt idx="209">
                  <c:v>376</c:v>
                </c:pt>
                <c:pt idx="210">
                  <c:v>377</c:v>
                </c:pt>
                <c:pt idx="211">
                  <c:v>378</c:v>
                </c:pt>
                <c:pt idx="212">
                  <c:v>379</c:v>
                </c:pt>
                <c:pt idx="213">
                  <c:v>382</c:v>
                </c:pt>
                <c:pt idx="214">
                  <c:v>385</c:v>
                </c:pt>
                <c:pt idx="215">
                  <c:v>387</c:v>
                </c:pt>
                <c:pt idx="216">
                  <c:v>388</c:v>
                </c:pt>
                <c:pt idx="217">
                  <c:v>390</c:v>
                </c:pt>
                <c:pt idx="218">
                  <c:v>391</c:v>
                </c:pt>
                <c:pt idx="219">
                  <c:v>395</c:v>
                </c:pt>
                <c:pt idx="220">
                  <c:v>399</c:v>
                </c:pt>
                <c:pt idx="221">
                  <c:v>401</c:v>
                </c:pt>
                <c:pt idx="222">
                  <c:v>403</c:v>
                </c:pt>
                <c:pt idx="223">
                  <c:v>407</c:v>
                </c:pt>
                <c:pt idx="224">
                  <c:v>408</c:v>
                </c:pt>
                <c:pt idx="225">
                  <c:v>411</c:v>
                </c:pt>
                <c:pt idx="226">
                  <c:v>416</c:v>
                </c:pt>
                <c:pt idx="227">
                  <c:v>417</c:v>
                </c:pt>
                <c:pt idx="228">
                  <c:v>422</c:v>
                </c:pt>
                <c:pt idx="229">
                  <c:v>423</c:v>
                </c:pt>
                <c:pt idx="230">
                  <c:v>425</c:v>
                </c:pt>
                <c:pt idx="231">
                  <c:v>426</c:v>
                </c:pt>
                <c:pt idx="232">
                  <c:v>428</c:v>
                </c:pt>
                <c:pt idx="233">
                  <c:v>432</c:v>
                </c:pt>
                <c:pt idx="234">
                  <c:v>434</c:v>
                </c:pt>
                <c:pt idx="235">
                  <c:v>435</c:v>
                </c:pt>
                <c:pt idx="236">
                  <c:v>437</c:v>
                </c:pt>
                <c:pt idx="237">
                  <c:v>438</c:v>
                </c:pt>
                <c:pt idx="238">
                  <c:v>443</c:v>
                </c:pt>
                <c:pt idx="239">
                  <c:v>444</c:v>
                </c:pt>
                <c:pt idx="240">
                  <c:v>445</c:v>
                </c:pt>
                <c:pt idx="241">
                  <c:v>446</c:v>
                </c:pt>
                <c:pt idx="242">
                  <c:v>447</c:v>
                </c:pt>
                <c:pt idx="243">
                  <c:v>448</c:v>
                </c:pt>
                <c:pt idx="244">
                  <c:v>452</c:v>
                </c:pt>
                <c:pt idx="245">
                  <c:v>453</c:v>
                </c:pt>
                <c:pt idx="246">
                  <c:v>456</c:v>
                </c:pt>
                <c:pt idx="247">
                  <c:v>458</c:v>
                </c:pt>
                <c:pt idx="248">
                  <c:v>459</c:v>
                </c:pt>
                <c:pt idx="249">
                  <c:v>467</c:v>
                </c:pt>
                <c:pt idx="250">
                  <c:v>468</c:v>
                </c:pt>
                <c:pt idx="251">
                  <c:v>469</c:v>
                </c:pt>
                <c:pt idx="252">
                  <c:v>471</c:v>
                </c:pt>
                <c:pt idx="253">
                  <c:v>473</c:v>
                </c:pt>
                <c:pt idx="254">
                  <c:v>478</c:v>
                </c:pt>
                <c:pt idx="255">
                  <c:v>481</c:v>
                </c:pt>
                <c:pt idx="256">
                  <c:v>482</c:v>
                </c:pt>
                <c:pt idx="257">
                  <c:v>483</c:v>
                </c:pt>
                <c:pt idx="258">
                  <c:v>484</c:v>
                </c:pt>
                <c:pt idx="259">
                  <c:v>485</c:v>
                </c:pt>
                <c:pt idx="260">
                  <c:v>486</c:v>
                </c:pt>
                <c:pt idx="261">
                  <c:v>489</c:v>
                </c:pt>
                <c:pt idx="262">
                  <c:v>490</c:v>
                </c:pt>
                <c:pt idx="263">
                  <c:v>491</c:v>
                </c:pt>
                <c:pt idx="264">
                  <c:v>492</c:v>
                </c:pt>
                <c:pt idx="265">
                  <c:v>493</c:v>
                </c:pt>
                <c:pt idx="266">
                  <c:v>495</c:v>
                </c:pt>
                <c:pt idx="267">
                  <c:v>497</c:v>
                </c:pt>
                <c:pt idx="268">
                  <c:v>501</c:v>
                </c:pt>
                <c:pt idx="269">
                  <c:v>502</c:v>
                </c:pt>
                <c:pt idx="270">
                  <c:v>504</c:v>
                </c:pt>
                <c:pt idx="271">
                  <c:v>506</c:v>
                </c:pt>
                <c:pt idx="272">
                  <c:v>507</c:v>
                </c:pt>
                <c:pt idx="273">
                  <c:v>513</c:v>
                </c:pt>
                <c:pt idx="274">
                  <c:v>514</c:v>
                </c:pt>
                <c:pt idx="275">
                  <c:v>516</c:v>
                </c:pt>
                <c:pt idx="276">
                  <c:v>517</c:v>
                </c:pt>
                <c:pt idx="277">
                  <c:v>520</c:v>
                </c:pt>
                <c:pt idx="278">
                  <c:v>521</c:v>
                </c:pt>
                <c:pt idx="279">
                  <c:v>525</c:v>
                </c:pt>
                <c:pt idx="280">
                  <c:v>526</c:v>
                </c:pt>
                <c:pt idx="281">
                  <c:v>528</c:v>
                </c:pt>
                <c:pt idx="282">
                  <c:v>531</c:v>
                </c:pt>
                <c:pt idx="283">
                  <c:v>532</c:v>
                </c:pt>
                <c:pt idx="284">
                  <c:v>533</c:v>
                </c:pt>
                <c:pt idx="285">
                  <c:v>536</c:v>
                </c:pt>
                <c:pt idx="286">
                  <c:v>537</c:v>
                </c:pt>
                <c:pt idx="287">
                  <c:v>538</c:v>
                </c:pt>
                <c:pt idx="288">
                  <c:v>545</c:v>
                </c:pt>
                <c:pt idx="289">
                  <c:v>549</c:v>
                </c:pt>
                <c:pt idx="290">
                  <c:v>550</c:v>
                </c:pt>
                <c:pt idx="291">
                  <c:v>551</c:v>
                </c:pt>
                <c:pt idx="292">
                  <c:v>552</c:v>
                </c:pt>
                <c:pt idx="293">
                  <c:v>553</c:v>
                </c:pt>
                <c:pt idx="294">
                  <c:v>554</c:v>
                </c:pt>
                <c:pt idx="295">
                  <c:v>555</c:v>
                </c:pt>
                <c:pt idx="296">
                  <c:v>558</c:v>
                </c:pt>
                <c:pt idx="297">
                  <c:v>560</c:v>
                </c:pt>
                <c:pt idx="298">
                  <c:v>561</c:v>
                </c:pt>
                <c:pt idx="299">
                  <c:v>562</c:v>
                </c:pt>
                <c:pt idx="300">
                  <c:v>566</c:v>
                </c:pt>
                <c:pt idx="301">
                  <c:v>569</c:v>
                </c:pt>
                <c:pt idx="302">
                  <c:v>570</c:v>
                </c:pt>
                <c:pt idx="303">
                  <c:v>576</c:v>
                </c:pt>
                <c:pt idx="304">
                  <c:v>577</c:v>
                </c:pt>
                <c:pt idx="305">
                  <c:v>580</c:v>
                </c:pt>
                <c:pt idx="306">
                  <c:v>581</c:v>
                </c:pt>
                <c:pt idx="307">
                  <c:v>583</c:v>
                </c:pt>
                <c:pt idx="308">
                  <c:v>584</c:v>
                </c:pt>
                <c:pt idx="309">
                  <c:v>586</c:v>
                </c:pt>
                <c:pt idx="310">
                  <c:v>587</c:v>
                </c:pt>
                <c:pt idx="311">
                  <c:v>588</c:v>
                </c:pt>
                <c:pt idx="312">
                  <c:v>596</c:v>
                </c:pt>
                <c:pt idx="313">
                  <c:v>597</c:v>
                </c:pt>
                <c:pt idx="314">
                  <c:v>598</c:v>
                </c:pt>
                <c:pt idx="315">
                  <c:v>601</c:v>
                </c:pt>
                <c:pt idx="316">
                  <c:v>602</c:v>
                </c:pt>
                <c:pt idx="317">
                  <c:v>603</c:v>
                </c:pt>
                <c:pt idx="318">
                  <c:v>607</c:v>
                </c:pt>
                <c:pt idx="319">
                  <c:v>608</c:v>
                </c:pt>
                <c:pt idx="320">
                  <c:v>609</c:v>
                </c:pt>
                <c:pt idx="321">
                  <c:v>611</c:v>
                </c:pt>
                <c:pt idx="322">
                  <c:v>614</c:v>
                </c:pt>
                <c:pt idx="323">
                  <c:v>617</c:v>
                </c:pt>
                <c:pt idx="324">
                  <c:v>618</c:v>
                </c:pt>
                <c:pt idx="325">
                  <c:v>623</c:v>
                </c:pt>
                <c:pt idx="326">
                  <c:v>624</c:v>
                </c:pt>
                <c:pt idx="327">
                  <c:v>625</c:v>
                </c:pt>
                <c:pt idx="328">
                  <c:v>628</c:v>
                </c:pt>
                <c:pt idx="329">
                  <c:v>629</c:v>
                </c:pt>
                <c:pt idx="330">
                  <c:v>630</c:v>
                </c:pt>
                <c:pt idx="331">
                  <c:v>636</c:v>
                </c:pt>
                <c:pt idx="332">
                  <c:v>637</c:v>
                </c:pt>
                <c:pt idx="333">
                  <c:v>638</c:v>
                </c:pt>
                <c:pt idx="334">
                  <c:v>639</c:v>
                </c:pt>
                <c:pt idx="335">
                  <c:v>640</c:v>
                </c:pt>
                <c:pt idx="336">
                  <c:v>642</c:v>
                </c:pt>
                <c:pt idx="337">
                  <c:v>644</c:v>
                </c:pt>
                <c:pt idx="338">
                  <c:v>645</c:v>
                </c:pt>
                <c:pt idx="339">
                  <c:v>646</c:v>
                </c:pt>
                <c:pt idx="340">
                  <c:v>648</c:v>
                </c:pt>
                <c:pt idx="341">
                  <c:v>649</c:v>
                </c:pt>
                <c:pt idx="342">
                  <c:v>650</c:v>
                </c:pt>
                <c:pt idx="343">
                  <c:v>651</c:v>
                </c:pt>
                <c:pt idx="344">
                  <c:v>652</c:v>
                </c:pt>
                <c:pt idx="345">
                  <c:v>653</c:v>
                </c:pt>
                <c:pt idx="346">
                  <c:v>657</c:v>
                </c:pt>
                <c:pt idx="347">
                  <c:v>659</c:v>
                </c:pt>
                <c:pt idx="348">
                  <c:v>661</c:v>
                </c:pt>
                <c:pt idx="349">
                  <c:v>665</c:v>
                </c:pt>
                <c:pt idx="350">
                  <c:v>666</c:v>
                </c:pt>
                <c:pt idx="351">
                  <c:v>668</c:v>
                </c:pt>
                <c:pt idx="352">
                  <c:v>669</c:v>
                </c:pt>
                <c:pt idx="353">
                  <c:v>671</c:v>
                </c:pt>
                <c:pt idx="354">
                  <c:v>682</c:v>
                </c:pt>
                <c:pt idx="355">
                  <c:v>684</c:v>
                </c:pt>
                <c:pt idx="356">
                  <c:v>692</c:v>
                </c:pt>
                <c:pt idx="357">
                  <c:v>694</c:v>
                </c:pt>
                <c:pt idx="358">
                  <c:v>696</c:v>
                </c:pt>
                <c:pt idx="359">
                  <c:v>704</c:v>
                </c:pt>
                <c:pt idx="360">
                  <c:v>705</c:v>
                </c:pt>
                <c:pt idx="361">
                  <c:v>708</c:v>
                </c:pt>
                <c:pt idx="362">
                  <c:v>709</c:v>
                </c:pt>
                <c:pt idx="363">
                  <c:v>710</c:v>
                </c:pt>
                <c:pt idx="364">
                  <c:v>711</c:v>
                </c:pt>
                <c:pt idx="365">
                  <c:v>712</c:v>
                </c:pt>
                <c:pt idx="366">
                  <c:v>715</c:v>
                </c:pt>
                <c:pt idx="367">
                  <c:v>717</c:v>
                </c:pt>
                <c:pt idx="368">
                  <c:v>720</c:v>
                </c:pt>
                <c:pt idx="369">
                  <c:v>723</c:v>
                </c:pt>
                <c:pt idx="370">
                  <c:v>724</c:v>
                </c:pt>
                <c:pt idx="371">
                  <c:v>727</c:v>
                </c:pt>
                <c:pt idx="372">
                  <c:v>728</c:v>
                </c:pt>
                <c:pt idx="373">
                  <c:v>730</c:v>
                </c:pt>
                <c:pt idx="374">
                  <c:v>731</c:v>
                </c:pt>
                <c:pt idx="375">
                  <c:v>732</c:v>
                </c:pt>
                <c:pt idx="376">
                  <c:v>733</c:v>
                </c:pt>
                <c:pt idx="377">
                  <c:v>736</c:v>
                </c:pt>
                <c:pt idx="378">
                  <c:v>744</c:v>
                </c:pt>
                <c:pt idx="379">
                  <c:v>745</c:v>
                </c:pt>
                <c:pt idx="380">
                  <c:v>746</c:v>
                </c:pt>
                <c:pt idx="381">
                  <c:v>747</c:v>
                </c:pt>
                <c:pt idx="382">
                  <c:v>750</c:v>
                </c:pt>
                <c:pt idx="383">
                  <c:v>753</c:v>
                </c:pt>
                <c:pt idx="384">
                  <c:v>758</c:v>
                </c:pt>
                <c:pt idx="385">
                  <c:v>759</c:v>
                </c:pt>
                <c:pt idx="386">
                  <c:v>760</c:v>
                </c:pt>
                <c:pt idx="387">
                  <c:v>762</c:v>
                </c:pt>
                <c:pt idx="388">
                  <c:v>764</c:v>
                </c:pt>
                <c:pt idx="389">
                  <c:v>765</c:v>
                </c:pt>
                <c:pt idx="390">
                  <c:v>768</c:v>
                </c:pt>
                <c:pt idx="391">
                  <c:v>769</c:v>
                </c:pt>
                <c:pt idx="392">
                  <c:v>774</c:v>
                </c:pt>
                <c:pt idx="393">
                  <c:v>775</c:v>
                </c:pt>
                <c:pt idx="394">
                  <c:v>778</c:v>
                </c:pt>
                <c:pt idx="395">
                  <c:v>779</c:v>
                </c:pt>
                <c:pt idx="396">
                  <c:v>780</c:v>
                </c:pt>
                <c:pt idx="397">
                  <c:v>783</c:v>
                </c:pt>
                <c:pt idx="398">
                  <c:v>784</c:v>
                </c:pt>
                <c:pt idx="399">
                  <c:v>785</c:v>
                </c:pt>
                <c:pt idx="400">
                  <c:v>787</c:v>
                </c:pt>
                <c:pt idx="401">
                  <c:v>792</c:v>
                </c:pt>
                <c:pt idx="402">
                  <c:v>797</c:v>
                </c:pt>
                <c:pt idx="403">
                  <c:v>799</c:v>
                </c:pt>
                <c:pt idx="404">
                  <c:v>800</c:v>
                </c:pt>
                <c:pt idx="405">
                  <c:v>801</c:v>
                </c:pt>
                <c:pt idx="406">
                  <c:v>803</c:v>
                </c:pt>
                <c:pt idx="407">
                  <c:v>804</c:v>
                </c:pt>
                <c:pt idx="408">
                  <c:v>805</c:v>
                </c:pt>
                <c:pt idx="409">
                  <c:v>809</c:v>
                </c:pt>
                <c:pt idx="410">
                  <c:v>810</c:v>
                </c:pt>
                <c:pt idx="411">
                  <c:v>811</c:v>
                </c:pt>
                <c:pt idx="412">
                  <c:v>812</c:v>
                </c:pt>
                <c:pt idx="413">
                  <c:v>813</c:v>
                </c:pt>
                <c:pt idx="414">
                  <c:v>816</c:v>
                </c:pt>
                <c:pt idx="415">
                  <c:v>818</c:v>
                </c:pt>
                <c:pt idx="416">
                  <c:v>819</c:v>
                </c:pt>
                <c:pt idx="417">
                  <c:v>825</c:v>
                </c:pt>
                <c:pt idx="418">
                  <c:v>826</c:v>
                </c:pt>
                <c:pt idx="419">
                  <c:v>827</c:v>
                </c:pt>
                <c:pt idx="420">
                  <c:v>834</c:v>
                </c:pt>
                <c:pt idx="421">
                  <c:v>836</c:v>
                </c:pt>
                <c:pt idx="422">
                  <c:v>837</c:v>
                </c:pt>
                <c:pt idx="423">
                  <c:v>842</c:v>
                </c:pt>
                <c:pt idx="424">
                  <c:v>843</c:v>
                </c:pt>
                <c:pt idx="425">
                  <c:v>844</c:v>
                </c:pt>
                <c:pt idx="426">
                  <c:v>845</c:v>
                </c:pt>
                <c:pt idx="427">
                  <c:v>846</c:v>
                </c:pt>
                <c:pt idx="428">
                  <c:v>851</c:v>
                </c:pt>
                <c:pt idx="429">
                  <c:v>852</c:v>
                </c:pt>
                <c:pt idx="430">
                  <c:v>853</c:v>
                </c:pt>
                <c:pt idx="431">
                  <c:v>854</c:v>
                </c:pt>
                <c:pt idx="432">
                  <c:v>858</c:v>
                </c:pt>
                <c:pt idx="433">
                  <c:v>859</c:v>
                </c:pt>
                <c:pt idx="434">
                  <c:v>861</c:v>
                </c:pt>
                <c:pt idx="435">
                  <c:v>862</c:v>
                </c:pt>
                <c:pt idx="436">
                  <c:v>865</c:v>
                </c:pt>
                <c:pt idx="437">
                  <c:v>867</c:v>
                </c:pt>
                <c:pt idx="438">
                  <c:v>868</c:v>
                </c:pt>
                <c:pt idx="439">
                  <c:v>870</c:v>
                </c:pt>
                <c:pt idx="440">
                  <c:v>871</c:v>
                </c:pt>
                <c:pt idx="441">
                  <c:v>873</c:v>
                </c:pt>
                <c:pt idx="442">
                  <c:v>874</c:v>
                </c:pt>
                <c:pt idx="443">
                  <c:v>875</c:v>
                </c:pt>
                <c:pt idx="444">
                  <c:v>876</c:v>
                </c:pt>
                <c:pt idx="445">
                  <c:v>877</c:v>
                </c:pt>
                <c:pt idx="446">
                  <c:v>878</c:v>
                </c:pt>
                <c:pt idx="447">
                  <c:v>883</c:v>
                </c:pt>
                <c:pt idx="448">
                  <c:v>886</c:v>
                </c:pt>
                <c:pt idx="449">
                  <c:v>889</c:v>
                </c:pt>
                <c:pt idx="450">
                  <c:v>892</c:v>
                </c:pt>
                <c:pt idx="451">
                  <c:v>898</c:v>
                </c:pt>
                <c:pt idx="452">
                  <c:v>899</c:v>
                </c:pt>
                <c:pt idx="453">
                  <c:v>900</c:v>
                </c:pt>
                <c:pt idx="454">
                  <c:v>902</c:v>
                </c:pt>
                <c:pt idx="455">
                  <c:v>906</c:v>
                </c:pt>
                <c:pt idx="456">
                  <c:v>907</c:v>
                </c:pt>
                <c:pt idx="457">
                  <c:v>908</c:v>
                </c:pt>
                <c:pt idx="458">
                  <c:v>909</c:v>
                </c:pt>
                <c:pt idx="459">
                  <c:v>911</c:v>
                </c:pt>
                <c:pt idx="460">
                  <c:v>916</c:v>
                </c:pt>
                <c:pt idx="461">
                  <c:v>917</c:v>
                </c:pt>
                <c:pt idx="462">
                  <c:v>919</c:v>
                </c:pt>
                <c:pt idx="463">
                  <c:v>920</c:v>
                </c:pt>
                <c:pt idx="464">
                  <c:v>925</c:v>
                </c:pt>
                <c:pt idx="465">
                  <c:v>927</c:v>
                </c:pt>
                <c:pt idx="466">
                  <c:v>930</c:v>
                </c:pt>
                <c:pt idx="467">
                  <c:v>931</c:v>
                </c:pt>
                <c:pt idx="468">
                  <c:v>932</c:v>
                </c:pt>
                <c:pt idx="469">
                  <c:v>933</c:v>
                </c:pt>
                <c:pt idx="470">
                  <c:v>936</c:v>
                </c:pt>
                <c:pt idx="471">
                  <c:v>940</c:v>
                </c:pt>
                <c:pt idx="472">
                  <c:v>942</c:v>
                </c:pt>
                <c:pt idx="473">
                  <c:v>943</c:v>
                </c:pt>
                <c:pt idx="474">
                  <c:v>947</c:v>
                </c:pt>
                <c:pt idx="475">
                  <c:v>948</c:v>
                </c:pt>
                <c:pt idx="476">
                  <c:v>949</c:v>
                </c:pt>
                <c:pt idx="477">
                  <c:v>951</c:v>
                </c:pt>
                <c:pt idx="478">
                  <c:v>954</c:v>
                </c:pt>
                <c:pt idx="479">
                  <c:v>955</c:v>
                </c:pt>
                <c:pt idx="480">
                  <c:v>956</c:v>
                </c:pt>
                <c:pt idx="481">
                  <c:v>958</c:v>
                </c:pt>
                <c:pt idx="482">
                  <c:v>959</c:v>
                </c:pt>
                <c:pt idx="483">
                  <c:v>961</c:v>
                </c:pt>
                <c:pt idx="484">
                  <c:v>962</c:v>
                </c:pt>
                <c:pt idx="485">
                  <c:v>963</c:v>
                </c:pt>
                <c:pt idx="486">
                  <c:v>966</c:v>
                </c:pt>
                <c:pt idx="487">
                  <c:v>967</c:v>
                </c:pt>
                <c:pt idx="488">
                  <c:v>972</c:v>
                </c:pt>
                <c:pt idx="489">
                  <c:v>973</c:v>
                </c:pt>
                <c:pt idx="490">
                  <c:v>976</c:v>
                </c:pt>
                <c:pt idx="491">
                  <c:v>977</c:v>
                </c:pt>
                <c:pt idx="492">
                  <c:v>981</c:v>
                </c:pt>
                <c:pt idx="493">
                  <c:v>984</c:v>
                </c:pt>
                <c:pt idx="494">
                  <c:v>986</c:v>
                </c:pt>
                <c:pt idx="495">
                  <c:v>988</c:v>
                </c:pt>
                <c:pt idx="496">
                  <c:v>989</c:v>
                </c:pt>
                <c:pt idx="497">
                  <c:v>990</c:v>
                </c:pt>
                <c:pt idx="498">
                  <c:v>991</c:v>
                </c:pt>
                <c:pt idx="499">
                  <c:v>992</c:v>
                </c:pt>
                <c:pt idx="500">
                  <c:v>993</c:v>
                </c:pt>
                <c:pt idx="501">
                  <c:v>995</c:v>
                </c:pt>
                <c:pt idx="502">
                  <c:v>996</c:v>
                </c:pt>
                <c:pt idx="503">
                  <c:v>997</c:v>
                </c:pt>
                <c:pt idx="504">
                  <c:v>998</c:v>
                </c:pt>
                <c:pt idx="505">
                  <c:v>999</c:v>
                </c:pt>
                <c:pt idx="506">
                  <c:v>1000</c:v>
                </c:pt>
                <c:pt idx="507">
                  <c:v>1002</c:v>
                </c:pt>
                <c:pt idx="508">
                  <c:v>1003</c:v>
                </c:pt>
                <c:pt idx="509">
                  <c:v>1004</c:v>
                </c:pt>
                <c:pt idx="510">
                  <c:v>1009</c:v>
                </c:pt>
                <c:pt idx="511">
                  <c:v>1011</c:v>
                </c:pt>
                <c:pt idx="512">
                  <c:v>1012</c:v>
                </c:pt>
                <c:pt idx="513">
                  <c:v>1013</c:v>
                </c:pt>
                <c:pt idx="514">
                  <c:v>1014</c:v>
                </c:pt>
                <c:pt idx="515">
                  <c:v>1015</c:v>
                </c:pt>
                <c:pt idx="516">
                  <c:v>1018</c:v>
                </c:pt>
                <c:pt idx="517">
                  <c:v>1021</c:v>
                </c:pt>
                <c:pt idx="518">
                  <c:v>1022</c:v>
                </c:pt>
                <c:pt idx="519">
                  <c:v>1023</c:v>
                </c:pt>
                <c:pt idx="520">
                  <c:v>1026</c:v>
                </c:pt>
                <c:pt idx="521">
                  <c:v>1029</c:v>
                </c:pt>
                <c:pt idx="522">
                  <c:v>1031</c:v>
                </c:pt>
                <c:pt idx="523">
                  <c:v>1032</c:v>
                </c:pt>
                <c:pt idx="524">
                  <c:v>1034</c:v>
                </c:pt>
                <c:pt idx="525">
                  <c:v>1035</c:v>
                </c:pt>
                <c:pt idx="526">
                  <c:v>1037</c:v>
                </c:pt>
                <c:pt idx="527">
                  <c:v>1039</c:v>
                </c:pt>
                <c:pt idx="528">
                  <c:v>1041</c:v>
                </c:pt>
                <c:pt idx="529">
                  <c:v>1044</c:v>
                </c:pt>
                <c:pt idx="530">
                  <c:v>1048</c:v>
                </c:pt>
                <c:pt idx="531">
                  <c:v>1050</c:v>
                </c:pt>
                <c:pt idx="532">
                  <c:v>1052</c:v>
                </c:pt>
                <c:pt idx="533">
                  <c:v>1055</c:v>
                </c:pt>
                <c:pt idx="534">
                  <c:v>1056</c:v>
                </c:pt>
                <c:pt idx="535">
                  <c:v>1059</c:v>
                </c:pt>
                <c:pt idx="536">
                  <c:v>1060</c:v>
                </c:pt>
                <c:pt idx="537">
                  <c:v>1062</c:v>
                </c:pt>
                <c:pt idx="538">
                  <c:v>1063</c:v>
                </c:pt>
                <c:pt idx="539">
                  <c:v>1064</c:v>
                </c:pt>
                <c:pt idx="540">
                  <c:v>1067</c:v>
                </c:pt>
                <c:pt idx="541">
                  <c:v>1068</c:v>
                </c:pt>
                <c:pt idx="542">
                  <c:v>1074</c:v>
                </c:pt>
                <c:pt idx="543">
                  <c:v>1075</c:v>
                </c:pt>
                <c:pt idx="544">
                  <c:v>1076</c:v>
                </c:pt>
                <c:pt idx="545">
                  <c:v>1078</c:v>
                </c:pt>
                <c:pt idx="546">
                  <c:v>1080</c:v>
                </c:pt>
                <c:pt idx="547">
                  <c:v>1085</c:v>
                </c:pt>
                <c:pt idx="548">
                  <c:v>1086</c:v>
                </c:pt>
                <c:pt idx="549">
                  <c:v>1092</c:v>
                </c:pt>
                <c:pt idx="550">
                  <c:v>1093</c:v>
                </c:pt>
                <c:pt idx="551">
                  <c:v>1097</c:v>
                </c:pt>
                <c:pt idx="552">
                  <c:v>1099</c:v>
                </c:pt>
                <c:pt idx="553">
                  <c:v>1101</c:v>
                </c:pt>
                <c:pt idx="554">
                  <c:v>1104</c:v>
                </c:pt>
                <c:pt idx="555">
                  <c:v>1105</c:v>
                </c:pt>
                <c:pt idx="556">
                  <c:v>1106</c:v>
                </c:pt>
                <c:pt idx="557">
                  <c:v>1107</c:v>
                </c:pt>
                <c:pt idx="558">
                  <c:v>1108</c:v>
                </c:pt>
                <c:pt idx="559">
                  <c:v>1109</c:v>
                </c:pt>
                <c:pt idx="560">
                  <c:v>1110</c:v>
                </c:pt>
                <c:pt idx="561">
                  <c:v>1113</c:v>
                </c:pt>
                <c:pt idx="562">
                  <c:v>1114</c:v>
                </c:pt>
                <c:pt idx="563">
                  <c:v>1116</c:v>
                </c:pt>
                <c:pt idx="564">
                  <c:v>1117</c:v>
                </c:pt>
                <c:pt idx="565">
                  <c:v>1118</c:v>
                </c:pt>
                <c:pt idx="566">
                  <c:v>1125</c:v>
                </c:pt>
                <c:pt idx="567">
                  <c:v>1127</c:v>
                </c:pt>
                <c:pt idx="568">
                  <c:v>1129</c:v>
                </c:pt>
                <c:pt idx="569">
                  <c:v>1133</c:v>
                </c:pt>
                <c:pt idx="570">
                  <c:v>1134</c:v>
                </c:pt>
                <c:pt idx="571">
                  <c:v>1135</c:v>
                </c:pt>
                <c:pt idx="572">
                  <c:v>1137</c:v>
                </c:pt>
                <c:pt idx="573">
                  <c:v>1138</c:v>
                </c:pt>
                <c:pt idx="574">
                  <c:v>1139</c:v>
                </c:pt>
                <c:pt idx="575">
                  <c:v>1141</c:v>
                </c:pt>
                <c:pt idx="576">
                  <c:v>1142</c:v>
                </c:pt>
                <c:pt idx="577">
                  <c:v>1145</c:v>
                </c:pt>
                <c:pt idx="578">
                  <c:v>1146</c:v>
                </c:pt>
                <c:pt idx="579">
                  <c:v>1147</c:v>
                </c:pt>
                <c:pt idx="580">
                  <c:v>1149</c:v>
                </c:pt>
                <c:pt idx="581">
                  <c:v>1150</c:v>
                </c:pt>
                <c:pt idx="582">
                  <c:v>1152</c:v>
                </c:pt>
                <c:pt idx="583">
                  <c:v>1153</c:v>
                </c:pt>
                <c:pt idx="584">
                  <c:v>1154</c:v>
                </c:pt>
                <c:pt idx="585">
                  <c:v>1158</c:v>
                </c:pt>
                <c:pt idx="586">
                  <c:v>1161</c:v>
                </c:pt>
                <c:pt idx="587">
                  <c:v>1164</c:v>
                </c:pt>
                <c:pt idx="588">
                  <c:v>1165</c:v>
                </c:pt>
                <c:pt idx="589">
                  <c:v>1166</c:v>
                </c:pt>
                <c:pt idx="590">
                  <c:v>1168</c:v>
                </c:pt>
                <c:pt idx="591">
                  <c:v>1169</c:v>
                </c:pt>
                <c:pt idx="592">
                  <c:v>1170</c:v>
                </c:pt>
                <c:pt idx="593">
                  <c:v>1171</c:v>
                </c:pt>
                <c:pt idx="594">
                  <c:v>1172</c:v>
                </c:pt>
                <c:pt idx="595">
                  <c:v>1175</c:v>
                </c:pt>
                <c:pt idx="596">
                  <c:v>1176</c:v>
                </c:pt>
                <c:pt idx="597">
                  <c:v>1177</c:v>
                </c:pt>
                <c:pt idx="598">
                  <c:v>1180</c:v>
                </c:pt>
                <c:pt idx="599">
                  <c:v>1181</c:v>
                </c:pt>
                <c:pt idx="600">
                  <c:v>1182</c:v>
                </c:pt>
                <c:pt idx="601">
                  <c:v>1184</c:v>
                </c:pt>
                <c:pt idx="602">
                  <c:v>1186</c:v>
                </c:pt>
                <c:pt idx="603">
                  <c:v>1192</c:v>
                </c:pt>
                <c:pt idx="604">
                  <c:v>1194</c:v>
                </c:pt>
                <c:pt idx="605">
                  <c:v>1195</c:v>
                </c:pt>
                <c:pt idx="606">
                  <c:v>1197</c:v>
                </c:pt>
                <c:pt idx="607">
                  <c:v>1198</c:v>
                </c:pt>
                <c:pt idx="608">
                  <c:v>1199</c:v>
                </c:pt>
                <c:pt idx="609">
                  <c:v>1205</c:v>
                </c:pt>
                <c:pt idx="610">
                  <c:v>1208</c:v>
                </c:pt>
                <c:pt idx="611">
                  <c:v>1213</c:v>
                </c:pt>
                <c:pt idx="612">
                  <c:v>1214</c:v>
                </c:pt>
                <c:pt idx="613">
                  <c:v>1218</c:v>
                </c:pt>
                <c:pt idx="614">
                  <c:v>1219</c:v>
                </c:pt>
                <c:pt idx="615">
                  <c:v>1221</c:v>
                </c:pt>
                <c:pt idx="616">
                  <c:v>1222</c:v>
                </c:pt>
                <c:pt idx="617">
                  <c:v>1223</c:v>
                </c:pt>
                <c:pt idx="618">
                  <c:v>1230</c:v>
                </c:pt>
                <c:pt idx="619">
                  <c:v>1231</c:v>
                </c:pt>
                <c:pt idx="620">
                  <c:v>1234</c:v>
                </c:pt>
                <c:pt idx="621">
                  <c:v>1240</c:v>
                </c:pt>
                <c:pt idx="622">
                  <c:v>1245</c:v>
                </c:pt>
                <c:pt idx="623">
                  <c:v>1247</c:v>
                </c:pt>
                <c:pt idx="624">
                  <c:v>1248</c:v>
                </c:pt>
                <c:pt idx="625">
                  <c:v>1250</c:v>
                </c:pt>
                <c:pt idx="626">
                  <c:v>1251</c:v>
                </c:pt>
                <c:pt idx="627">
                  <c:v>1253</c:v>
                </c:pt>
                <c:pt idx="628">
                  <c:v>1254</c:v>
                </c:pt>
                <c:pt idx="629">
                  <c:v>1257</c:v>
                </c:pt>
                <c:pt idx="630">
                  <c:v>1258</c:v>
                </c:pt>
                <c:pt idx="631">
                  <c:v>1260</c:v>
                </c:pt>
                <c:pt idx="632">
                  <c:v>1261</c:v>
                </c:pt>
                <c:pt idx="633">
                  <c:v>1262</c:v>
                </c:pt>
                <c:pt idx="634">
                  <c:v>1263</c:v>
                </c:pt>
                <c:pt idx="635">
                  <c:v>1264</c:v>
                </c:pt>
                <c:pt idx="636">
                  <c:v>1265</c:v>
                </c:pt>
                <c:pt idx="637">
                  <c:v>1267</c:v>
                </c:pt>
                <c:pt idx="638">
                  <c:v>1268</c:v>
                </c:pt>
                <c:pt idx="639">
                  <c:v>1269</c:v>
                </c:pt>
                <c:pt idx="640">
                  <c:v>1270</c:v>
                </c:pt>
                <c:pt idx="641">
                  <c:v>1274</c:v>
                </c:pt>
                <c:pt idx="642">
                  <c:v>1275</c:v>
                </c:pt>
                <c:pt idx="643">
                  <c:v>1276</c:v>
                </c:pt>
                <c:pt idx="644">
                  <c:v>1279</c:v>
                </c:pt>
                <c:pt idx="645">
                  <c:v>1281</c:v>
                </c:pt>
                <c:pt idx="646">
                  <c:v>1282</c:v>
                </c:pt>
                <c:pt idx="647">
                  <c:v>1284</c:v>
                </c:pt>
                <c:pt idx="648">
                  <c:v>1285</c:v>
                </c:pt>
                <c:pt idx="649">
                  <c:v>1286</c:v>
                </c:pt>
                <c:pt idx="650">
                  <c:v>1287</c:v>
                </c:pt>
                <c:pt idx="651">
                  <c:v>1288</c:v>
                </c:pt>
                <c:pt idx="652">
                  <c:v>1290</c:v>
                </c:pt>
                <c:pt idx="653">
                  <c:v>1293</c:v>
                </c:pt>
                <c:pt idx="654">
                  <c:v>1294</c:v>
                </c:pt>
                <c:pt idx="655">
                  <c:v>1295</c:v>
                </c:pt>
                <c:pt idx="656">
                  <c:v>1301</c:v>
                </c:pt>
                <c:pt idx="657">
                  <c:v>1302</c:v>
                </c:pt>
                <c:pt idx="658">
                  <c:v>1303</c:v>
                </c:pt>
                <c:pt idx="659">
                  <c:v>1304</c:v>
                </c:pt>
                <c:pt idx="660">
                  <c:v>1305</c:v>
                </c:pt>
                <c:pt idx="661">
                  <c:v>1306</c:v>
                </c:pt>
                <c:pt idx="662">
                  <c:v>1308</c:v>
                </c:pt>
                <c:pt idx="663">
                  <c:v>1309</c:v>
                </c:pt>
                <c:pt idx="664">
                  <c:v>1311</c:v>
                </c:pt>
                <c:pt idx="665">
                  <c:v>1312</c:v>
                </c:pt>
                <c:pt idx="666">
                  <c:v>1313</c:v>
                </c:pt>
                <c:pt idx="667">
                  <c:v>1314</c:v>
                </c:pt>
                <c:pt idx="668">
                  <c:v>1315</c:v>
                </c:pt>
                <c:pt idx="669">
                  <c:v>1324</c:v>
                </c:pt>
                <c:pt idx="670">
                  <c:v>1325</c:v>
                </c:pt>
                <c:pt idx="671">
                  <c:v>1327</c:v>
                </c:pt>
                <c:pt idx="672">
                  <c:v>1330</c:v>
                </c:pt>
                <c:pt idx="673">
                  <c:v>1331</c:v>
                </c:pt>
                <c:pt idx="674">
                  <c:v>1332</c:v>
                </c:pt>
                <c:pt idx="675">
                  <c:v>1335</c:v>
                </c:pt>
                <c:pt idx="676">
                  <c:v>1339</c:v>
                </c:pt>
                <c:pt idx="677">
                  <c:v>1341</c:v>
                </c:pt>
                <c:pt idx="678">
                  <c:v>1342</c:v>
                </c:pt>
                <c:pt idx="679">
                  <c:v>1343</c:v>
                </c:pt>
                <c:pt idx="680">
                  <c:v>1344</c:v>
                </c:pt>
                <c:pt idx="681">
                  <c:v>1345</c:v>
                </c:pt>
                <c:pt idx="682">
                  <c:v>1348</c:v>
                </c:pt>
                <c:pt idx="683">
                  <c:v>1350</c:v>
                </c:pt>
                <c:pt idx="684">
                  <c:v>1352</c:v>
                </c:pt>
                <c:pt idx="685">
                  <c:v>1354</c:v>
                </c:pt>
                <c:pt idx="686">
                  <c:v>1355</c:v>
                </c:pt>
                <c:pt idx="687">
                  <c:v>1356</c:v>
                </c:pt>
                <c:pt idx="688">
                  <c:v>1357</c:v>
                </c:pt>
                <c:pt idx="689">
                  <c:v>1358</c:v>
                </c:pt>
                <c:pt idx="690">
                  <c:v>1361</c:v>
                </c:pt>
                <c:pt idx="691">
                  <c:v>1362</c:v>
                </c:pt>
                <c:pt idx="692">
                  <c:v>1366</c:v>
                </c:pt>
                <c:pt idx="693">
                  <c:v>1368</c:v>
                </c:pt>
                <c:pt idx="694">
                  <c:v>1371</c:v>
                </c:pt>
                <c:pt idx="695">
                  <c:v>1372</c:v>
                </c:pt>
                <c:pt idx="696">
                  <c:v>1373</c:v>
                </c:pt>
                <c:pt idx="697">
                  <c:v>1374</c:v>
                </c:pt>
                <c:pt idx="698">
                  <c:v>1375</c:v>
                </c:pt>
                <c:pt idx="699">
                  <c:v>1376</c:v>
                </c:pt>
                <c:pt idx="700">
                  <c:v>1377</c:v>
                </c:pt>
                <c:pt idx="701">
                  <c:v>1378</c:v>
                </c:pt>
              </c:numCache>
            </c:numRef>
          </c:xVal>
          <c:yVal>
            <c:numRef>
              <c:f>'RNA2 DMS'!$C$2:$C$1424</c:f>
              <c:numCache>
                <c:formatCode>General</c:formatCode>
                <c:ptCount val="1423"/>
                <c:pt idx="0">
                  <c:v>2.7480076944199998E-4</c:v>
                </c:pt>
                <c:pt idx="1">
                  <c:v>2.74348422497E-4</c:v>
                </c:pt>
                <c:pt idx="2">
                  <c:v>8.1543897798299996E-4</c:v>
                </c:pt>
                <c:pt idx="3">
                  <c:v>1.48148148148E-3</c:v>
                </c:pt>
                <c:pt idx="4">
                  <c:v>2.60586319218E-4</c:v>
                </c:pt>
                <c:pt idx="5">
                  <c:v>1.3647642679900001E-3</c:v>
                </c:pt>
                <c:pt idx="6">
                  <c:v>1.38592750533E-3</c:v>
                </c:pt>
                <c:pt idx="7">
                  <c:v>3.5147513047200001E-3</c:v>
                </c:pt>
                <c:pt idx="8">
                  <c:v>2.3362112747599998E-3</c:v>
                </c:pt>
                <c:pt idx="9">
                  <c:v>1.11268460449E-3</c:v>
                </c:pt>
                <c:pt idx="10">
                  <c:v>1.0803024847E-3</c:v>
                </c:pt>
                <c:pt idx="11">
                  <c:v>1.43228001074E-3</c:v>
                </c:pt>
                <c:pt idx="12">
                  <c:v>6.8254209009599995E-4</c:v>
                </c:pt>
                <c:pt idx="13">
                  <c:v>2.57771038666E-3</c:v>
                </c:pt>
                <c:pt idx="14">
                  <c:v>7.4794315632000004E-5</c:v>
                </c:pt>
                <c:pt idx="15">
                  <c:v>3.2906252187900002E-3</c:v>
                </c:pt>
                <c:pt idx="16">
                  <c:v>3.4921078362899999E-3</c:v>
                </c:pt>
                <c:pt idx="17">
                  <c:v>2.5437201907800003E-4</c:v>
                </c:pt>
                <c:pt idx="18">
                  <c:v>1.29657816111E-3</c:v>
                </c:pt>
                <c:pt idx="19">
                  <c:v>3.8668752172399999E-3</c:v>
                </c:pt>
                <c:pt idx="20">
                  <c:v>2.9099979214300002E-4</c:v>
                </c:pt>
                <c:pt idx="21">
                  <c:v>8.5422469823600005E-4</c:v>
                </c:pt>
                <c:pt idx="22">
                  <c:v>4.8172390968600001E-3</c:v>
                </c:pt>
                <c:pt idx="23">
                  <c:v>1.22066055174E-3</c:v>
                </c:pt>
                <c:pt idx="24">
                  <c:v>1.22585199923E-2</c:v>
                </c:pt>
                <c:pt idx="25">
                  <c:v>6.0879874395199996E-4</c:v>
                </c:pt>
                <c:pt idx="26">
                  <c:v>4.2306777016800002E-4</c:v>
                </c:pt>
                <c:pt idx="27">
                  <c:v>1.8597584933300001E-3</c:v>
                </c:pt>
                <c:pt idx="28">
                  <c:v>2.0816528323499999E-3</c:v>
                </c:pt>
                <c:pt idx="29">
                  <c:v>8.5044648440400002E-4</c:v>
                </c:pt>
                <c:pt idx="30">
                  <c:v>1.90071832342E-3</c:v>
                </c:pt>
                <c:pt idx="31">
                  <c:v>1.09390572964E-2</c:v>
                </c:pt>
                <c:pt idx="32">
                  <c:v>1.08680243822E-3</c:v>
                </c:pt>
                <c:pt idx="33">
                  <c:v>1.7240157759299999E-3</c:v>
                </c:pt>
                <c:pt idx="34">
                  <c:v>1.62901055316E-3</c:v>
                </c:pt>
                <c:pt idx="35">
                  <c:v>5.2618334057799999E-4</c:v>
                </c:pt>
                <c:pt idx="36">
                  <c:v>8.9595944144599997E-4</c:v>
                </c:pt>
                <c:pt idx="37">
                  <c:v>1.08247637287E-3</c:v>
                </c:pt>
                <c:pt idx="38">
                  <c:v>1.23479430283E-2</c:v>
                </c:pt>
                <c:pt idx="39">
                  <c:v>4.0113355152900003E-3</c:v>
                </c:pt>
                <c:pt idx="40">
                  <c:v>6.9842156725799997E-4</c:v>
                </c:pt>
                <c:pt idx="41">
                  <c:v>3.2854718456199999E-2</c:v>
                </c:pt>
                <c:pt idx="42">
                  <c:v>2.5534509699300001E-3</c:v>
                </c:pt>
                <c:pt idx="43">
                  <c:v>1.4101057579300001E-2</c:v>
                </c:pt>
                <c:pt idx="44">
                  <c:v>2.1626617375200001E-3</c:v>
                </c:pt>
                <c:pt idx="45">
                  <c:v>5.2789144567899999E-3</c:v>
                </c:pt>
                <c:pt idx="46">
                  <c:v>1.5998623774300001E-3</c:v>
                </c:pt>
                <c:pt idx="47">
                  <c:v>1.89048456104E-3</c:v>
                </c:pt>
                <c:pt idx="48">
                  <c:v>1.1632168523E-3</c:v>
                </c:pt>
                <c:pt idx="49">
                  <c:v>1.73508858503E-3</c:v>
                </c:pt>
                <c:pt idx="50">
                  <c:v>1.8069424631500001E-3</c:v>
                </c:pt>
                <c:pt idx="51">
                  <c:v>2.2033079802E-3</c:v>
                </c:pt>
                <c:pt idx="52">
                  <c:v>8.5918422718599997E-4</c:v>
                </c:pt>
                <c:pt idx="53">
                  <c:v>2.9307217990599999E-3</c:v>
                </c:pt>
                <c:pt idx="54">
                  <c:v>1.28093935553E-3</c:v>
                </c:pt>
                <c:pt idx="55">
                  <c:v>5.8499298008399996E-4</c:v>
                </c:pt>
                <c:pt idx="56">
                  <c:v>5.9260786107200004E-4</c:v>
                </c:pt>
                <c:pt idx="57">
                  <c:v>1.1722756801599999E-3</c:v>
                </c:pt>
                <c:pt idx="58">
                  <c:v>1.10290977856E-2</c:v>
                </c:pt>
                <c:pt idx="59">
                  <c:v>7.3694638412999999E-3</c:v>
                </c:pt>
                <c:pt idx="60">
                  <c:v>7.7050877657700001E-4</c:v>
                </c:pt>
                <c:pt idx="61">
                  <c:v>3.0547727864700001E-3</c:v>
                </c:pt>
                <c:pt idx="62">
                  <c:v>2.1474504860899998E-3</c:v>
                </c:pt>
                <c:pt idx="63">
                  <c:v>2.1247272309600001E-3</c:v>
                </c:pt>
                <c:pt idx="64">
                  <c:v>2.19527846263E-3</c:v>
                </c:pt>
                <c:pt idx="65">
                  <c:v>2.3021998798899998E-3</c:v>
                </c:pt>
                <c:pt idx="66">
                  <c:v>9.0224580749899991E-3</c:v>
                </c:pt>
                <c:pt idx="67">
                  <c:v>6.8652611289800004E-3</c:v>
                </c:pt>
                <c:pt idx="68">
                  <c:v>1.0225268935000001E-3</c:v>
                </c:pt>
                <c:pt idx="69">
                  <c:v>1.23027711992E-3</c:v>
                </c:pt>
                <c:pt idx="70">
                  <c:v>2.1209885651099999E-3</c:v>
                </c:pt>
                <c:pt idx="71">
                  <c:v>6.8475650263199995E-4</c:v>
                </c:pt>
                <c:pt idx="72">
                  <c:v>1.14276549249E-3</c:v>
                </c:pt>
                <c:pt idx="73">
                  <c:v>2.3941178827599999E-3</c:v>
                </c:pt>
                <c:pt idx="74">
                  <c:v>2.9288544292999999E-3</c:v>
                </c:pt>
                <c:pt idx="75">
                  <c:v>5.1543534888900001E-3</c:v>
                </c:pt>
                <c:pt idx="76">
                  <c:v>6.7154291522199998E-4</c:v>
                </c:pt>
                <c:pt idx="77">
                  <c:v>7.4108466222599998E-4</c:v>
                </c:pt>
                <c:pt idx="78">
                  <c:v>1.03793964761E-3</c:v>
                </c:pt>
                <c:pt idx="79">
                  <c:v>2.5742062864E-3</c:v>
                </c:pt>
                <c:pt idx="80">
                  <c:v>1.3935432496099999E-3</c:v>
                </c:pt>
                <c:pt idx="81">
                  <c:v>1.33436568209E-3</c:v>
                </c:pt>
                <c:pt idx="82">
                  <c:v>1.9024402296100001E-3</c:v>
                </c:pt>
                <c:pt idx="83">
                  <c:v>2.31886416338E-3</c:v>
                </c:pt>
                <c:pt idx="84">
                  <c:v>1.0455757556099999E-3</c:v>
                </c:pt>
                <c:pt idx="85">
                  <c:v>3.9129627986199999E-3</c:v>
                </c:pt>
                <c:pt idx="86">
                  <c:v>7.0331759663599999E-3</c:v>
                </c:pt>
                <c:pt idx="87">
                  <c:v>4.7284086217500004E-3</c:v>
                </c:pt>
                <c:pt idx="88">
                  <c:v>3.1469180242699999E-3</c:v>
                </c:pt>
                <c:pt idx="89">
                  <c:v>1.5066646481700001E-3</c:v>
                </c:pt>
                <c:pt idx="90">
                  <c:v>2.20728258988E-3</c:v>
                </c:pt>
                <c:pt idx="91">
                  <c:v>3.6330868365000001E-3</c:v>
                </c:pt>
                <c:pt idx="92">
                  <c:v>3.24744843337E-3</c:v>
                </c:pt>
                <c:pt idx="93">
                  <c:v>1.4681357526700001E-3</c:v>
                </c:pt>
                <c:pt idx="94">
                  <c:v>6.1082403346499996E-3</c:v>
                </c:pt>
                <c:pt idx="95">
                  <c:v>1.4760895204899999E-3</c:v>
                </c:pt>
                <c:pt idx="96">
                  <c:v>1.82451839129E-3</c:v>
                </c:pt>
                <c:pt idx="97">
                  <c:v>1.1705780527300001E-3</c:v>
                </c:pt>
                <c:pt idx="98">
                  <c:v>3.9423637524599996E-3</c:v>
                </c:pt>
                <c:pt idx="99">
                  <c:v>6.5825105195199997E-3</c:v>
                </c:pt>
                <c:pt idx="100">
                  <c:v>3.4077498376400002E-3</c:v>
                </c:pt>
                <c:pt idx="101">
                  <c:v>2.9395541094400001E-3</c:v>
                </c:pt>
                <c:pt idx="102">
                  <c:v>1.2168749261200001E-3</c:v>
                </c:pt>
                <c:pt idx="103">
                  <c:v>4.8506457163E-3</c:v>
                </c:pt>
                <c:pt idx="104">
                  <c:v>2.18315445479E-3</c:v>
                </c:pt>
                <c:pt idx="105">
                  <c:v>1.14974780829E-3</c:v>
                </c:pt>
                <c:pt idx="106">
                  <c:v>5.7897714038500001E-4</c:v>
                </c:pt>
                <c:pt idx="107">
                  <c:v>1.5001200096E-3</c:v>
                </c:pt>
                <c:pt idx="108">
                  <c:v>1.88631623693E-3</c:v>
                </c:pt>
                <c:pt idx="109">
                  <c:v>5.7125959380099998E-4</c:v>
                </c:pt>
                <c:pt idx="110">
                  <c:v>1.00100768107E-3</c:v>
                </c:pt>
                <c:pt idx="111">
                  <c:v>1.9184021164799999E-3</c:v>
                </c:pt>
                <c:pt idx="112">
                  <c:v>2.4142602304299998E-3</c:v>
                </c:pt>
                <c:pt idx="113">
                  <c:v>1.5745956451600001E-3</c:v>
                </c:pt>
                <c:pt idx="114">
                  <c:v>5.0426080838100002E-3</c:v>
                </c:pt>
                <c:pt idx="115">
                  <c:v>1.40912440371E-3</c:v>
                </c:pt>
                <c:pt idx="116">
                  <c:v>3.0897843601399998E-3</c:v>
                </c:pt>
                <c:pt idx="117">
                  <c:v>2.5204094855499999E-3</c:v>
                </c:pt>
                <c:pt idx="118">
                  <c:v>5.9571851339400002E-4</c:v>
                </c:pt>
                <c:pt idx="119">
                  <c:v>4.9576284635199997E-3</c:v>
                </c:pt>
                <c:pt idx="120">
                  <c:v>3.3490441397900001E-3</c:v>
                </c:pt>
                <c:pt idx="121">
                  <c:v>1.51578947368E-3</c:v>
                </c:pt>
                <c:pt idx="122">
                  <c:v>3.8578484983199999E-3</c:v>
                </c:pt>
                <c:pt idx="123">
                  <c:v>3.6081720220399998E-3</c:v>
                </c:pt>
                <c:pt idx="124">
                  <c:v>4.0018441678200001E-3</c:v>
                </c:pt>
                <c:pt idx="125">
                  <c:v>1.6838288885999999E-2</c:v>
                </c:pt>
                <c:pt idx="126">
                  <c:v>1.99229814455E-3</c:v>
                </c:pt>
                <c:pt idx="127">
                  <c:v>3.44657172014E-3</c:v>
                </c:pt>
                <c:pt idx="128">
                  <c:v>2.3507909914999999E-3</c:v>
                </c:pt>
                <c:pt idx="129">
                  <c:v>3.8715889562800001E-3</c:v>
                </c:pt>
                <c:pt idx="130">
                  <c:v>1.31616057159E-3</c:v>
                </c:pt>
                <c:pt idx="131">
                  <c:v>5.8505368570399997E-3</c:v>
                </c:pt>
                <c:pt idx="132">
                  <c:v>4.3602698126900003E-3</c:v>
                </c:pt>
                <c:pt idx="133">
                  <c:v>4.8785051725500002E-4</c:v>
                </c:pt>
                <c:pt idx="134">
                  <c:v>1.1098421056000001E-3</c:v>
                </c:pt>
                <c:pt idx="135">
                  <c:v>7.5873415271499999E-3</c:v>
                </c:pt>
                <c:pt idx="136">
                  <c:v>2.6696343565899999E-3</c:v>
                </c:pt>
                <c:pt idx="137">
                  <c:v>8.1821276150099997E-4</c:v>
                </c:pt>
                <c:pt idx="138">
                  <c:v>5.1194539249099997E-3</c:v>
                </c:pt>
                <c:pt idx="139">
                  <c:v>2.67101545565E-3</c:v>
                </c:pt>
                <c:pt idx="140">
                  <c:v>6.6928580511700002E-4</c:v>
                </c:pt>
                <c:pt idx="141">
                  <c:v>2.27452597416E-3</c:v>
                </c:pt>
                <c:pt idx="142">
                  <c:v>8.1098687796600001E-4</c:v>
                </c:pt>
                <c:pt idx="143">
                  <c:v>1.80784788066E-3</c:v>
                </c:pt>
                <c:pt idx="144">
                  <c:v>4.0195177881600002E-3</c:v>
                </c:pt>
                <c:pt idx="145">
                  <c:v>4.4959341117600002E-4</c:v>
                </c:pt>
                <c:pt idx="146">
                  <c:v>4.2314019959899998E-3</c:v>
                </c:pt>
                <c:pt idx="147">
                  <c:v>1.03751151896E-3</c:v>
                </c:pt>
                <c:pt idx="148">
                  <c:v>1.4526212030799999E-3</c:v>
                </c:pt>
                <c:pt idx="149">
                  <c:v>1.3149503277499999E-3</c:v>
                </c:pt>
                <c:pt idx="150">
                  <c:v>6.2016932861099997E-3</c:v>
                </c:pt>
                <c:pt idx="151">
                  <c:v>3.46789799398E-3</c:v>
                </c:pt>
                <c:pt idx="152">
                  <c:v>2.2900763358799999E-3</c:v>
                </c:pt>
                <c:pt idx="153">
                  <c:v>3.02358145702E-3</c:v>
                </c:pt>
                <c:pt idx="154">
                  <c:v>2.0895068763799999E-3</c:v>
                </c:pt>
                <c:pt idx="155">
                  <c:v>2.9217992730199999E-3</c:v>
                </c:pt>
                <c:pt idx="156">
                  <c:v>2.9215145948200002E-3</c:v>
                </c:pt>
                <c:pt idx="157">
                  <c:v>1.78756057152E-3</c:v>
                </c:pt>
                <c:pt idx="158">
                  <c:v>3.6187955811300002E-3</c:v>
                </c:pt>
                <c:pt idx="159">
                  <c:v>2.8537986292099999E-3</c:v>
                </c:pt>
                <c:pt idx="160">
                  <c:v>4.5053362384099996E-3</c:v>
                </c:pt>
                <c:pt idx="161">
                  <c:v>2.53108566373E-3</c:v>
                </c:pt>
                <c:pt idx="162">
                  <c:v>2.55119587307E-3</c:v>
                </c:pt>
                <c:pt idx="163">
                  <c:v>3.90737517063E-3</c:v>
                </c:pt>
                <c:pt idx="164">
                  <c:v>5.4142379825900004E-3</c:v>
                </c:pt>
                <c:pt idx="165">
                  <c:v>1.44820361127E-3</c:v>
                </c:pt>
                <c:pt idx="166">
                  <c:v>5.8963356280699996E-3</c:v>
                </c:pt>
                <c:pt idx="167">
                  <c:v>3.3332149242799999E-3</c:v>
                </c:pt>
                <c:pt idx="168">
                  <c:v>1.62193519363E-3</c:v>
                </c:pt>
                <c:pt idx="169">
                  <c:v>2.5808681969100001E-3</c:v>
                </c:pt>
                <c:pt idx="170">
                  <c:v>4.54610453061E-3</c:v>
                </c:pt>
                <c:pt idx="171">
                  <c:v>2.9244093462699999E-3</c:v>
                </c:pt>
                <c:pt idx="172">
                  <c:v>4.8749272833E-3</c:v>
                </c:pt>
                <c:pt idx="173">
                  <c:v>2.0112331944899999E-3</c:v>
                </c:pt>
                <c:pt idx="174">
                  <c:v>1.43743725472E-3</c:v>
                </c:pt>
                <c:pt idx="175">
                  <c:v>1.6707342107099999E-3</c:v>
                </c:pt>
                <c:pt idx="176">
                  <c:v>2.5915460798599998E-3</c:v>
                </c:pt>
                <c:pt idx="177">
                  <c:v>4.5964804092900003E-3</c:v>
                </c:pt>
                <c:pt idx="178">
                  <c:v>7.9378414865199996E-4</c:v>
                </c:pt>
                <c:pt idx="179">
                  <c:v>3.0235804521499998E-3</c:v>
                </c:pt>
                <c:pt idx="180">
                  <c:v>2.82452560943E-3</c:v>
                </c:pt>
                <c:pt idx="181">
                  <c:v>5.6750605239199998E-4</c:v>
                </c:pt>
                <c:pt idx="182">
                  <c:v>1.4224490543500001E-3</c:v>
                </c:pt>
                <c:pt idx="183">
                  <c:v>6.8529018160200001E-4</c:v>
                </c:pt>
                <c:pt idx="184">
                  <c:v>2.5845135945399998E-3</c:v>
                </c:pt>
                <c:pt idx="185">
                  <c:v>2.7376465322099999E-3</c:v>
                </c:pt>
                <c:pt idx="186">
                  <c:v>1.4632065877099999E-3</c:v>
                </c:pt>
                <c:pt idx="187">
                  <c:v>1.0993685174899999E-3</c:v>
                </c:pt>
                <c:pt idx="188">
                  <c:v>1.25408424735E-3</c:v>
                </c:pt>
                <c:pt idx="189">
                  <c:v>9.3280931862299993E-3</c:v>
                </c:pt>
                <c:pt idx="190">
                  <c:v>9.1382588436899996E-3</c:v>
                </c:pt>
                <c:pt idx="191">
                  <c:v>4.0152951043799998E-3</c:v>
                </c:pt>
                <c:pt idx="192">
                  <c:v>2.5850785340300001E-3</c:v>
                </c:pt>
                <c:pt idx="193">
                  <c:v>2.4229465053899999E-3</c:v>
                </c:pt>
                <c:pt idx="194">
                  <c:v>1.32562506904E-3</c:v>
                </c:pt>
                <c:pt idx="195">
                  <c:v>4.5668495436200001E-3</c:v>
                </c:pt>
                <c:pt idx="196">
                  <c:v>6.5274073186100002E-3</c:v>
                </c:pt>
                <c:pt idx="197">
                  <c:v>1.3129653832800001E-3</c:v>
                </c:pt>
                <c:pt idx="198">
                  <c:v>2.5393229690000001E-3</c:v>
                </c:pt>
                <c:pt idx="199">
                  <c:v>1.1137765592900001E-3</c:v>
                </c:pt>
                <c:pt idx="200">
                  <c:v>1.3010521552200001E-3</c:v>
                </c:pt>
                <c:pt idx="201">
                  <c:v>1.9449619819699999E-3</c:v>
                </c:pt>
                <c:pt idx="202">
                  <c:v>2.4980843866599998E-3</c:v>
                </c:pt>
                <c:pt idx="203">
                  <c:v>2.3507199079700002E-3</c:v>
                </c:pt>
                <c:pt idx="204">
                  <c:v>6.1410201537100001E-3</c:v>
                </c:pt>
                <c:pt idx="205">
                  <c:v>3.3536376702500001E-3</c:v>
                </c:pt>
                <c:pt idx="206">
                  <c:v>7.7931408183999997E-4</c:v>
                </c:pt>
                <c:pt idx="207">
                  <c:v>7.5378727670699997E-3</c:v>
                </c:pt>
                <c:pt idx="208">
                  <c:v>1.1743545685499999E-3</c:v>
                </c:pt>
                <c:pt idx="209">
                  <c:v>2.3600870853799998E-3</c:v>
                </c:pt>
                <c:pt idx="210">
                  <c:v>2.4737960859000001E-3</c:v>
                </c:pt>
                <c:pt idx="211">
                  <c:v>7.1838639363899998E-4</c:v>
                </c:pt>
                <c:pt idx="212">
                  <c:v>1.8684580918399999E-3</c:v>
                </c:pt>
                <c:pt idx="213">
                  <c:v>2.1858434491900001E-3</c:v>
                </c:pt>
                <c:pt idx="214">
                  <c:v>1.7931893736100001E-3</c:v>
                </c:pt>
                <c:pt idx="215">
                  <c:v>7.9036462941300002E-4</c:v>
                </c:pt>
                <c:pt idx="216">
                  <c:v>7.8707563505300002E-4</c:v>
                </c:pt>
                <c:pt idx="217">
                  <c:v>1.8534168730899999E-3</c:v>
                </c:pt>
                <c:pt idx="218">
                  <c:v>2.2376213265199998E-3</c:v>
                </c:pt>
                <c:pt idx="219">
                  <c:v>2.25100092217E-3</c:v>
                </c:pt>
                <c:pt idx="220">
                  <c:v>6.19701007974E-4</c:v>
                </c:pt>
                <c:pt idx="221">
                  <c:v>2.3171702871299998E-3</c:v>
                </c:pt>
                <c:pt idx="222">
                  <c:v>1.64375954463E-3</c:v>
                </c:pt>
                <c:pt idx="223">
                  <c:v>4.4724526099600001E-3</c:v>
                </c:pt>
                <c:pt idx="224">
                  <c:v>1.19694526083E-3</c:v>
                </c:pt>
                <c:pt idx="225">
                  <c:v>4.7628841428400001E-4</c:v>
                </c:pt>
                <c:pt idx="226">
                  <c:v>1.3907035950799999E-3</c:v>
                </c:pt>
                <c:pt idx="227">
                  <c:v>4.1185454670300001E-3</c:v>
                </c:pt>
                <c:pt idx="228">
                  <c:v>5.4212232144900004E-4</c:v>
                </c:pt>
                <c:pt idx="229">
                  <c:v>2.3972722300500001E-3</c:v>
                </c:pt>
                <c:pt idx="230">
                  <c:v>1.9985758651000001E-3</c:v>
                </c:pt>
                <c:pt idx="231">
                  <c:v>2.2373238257E-3</c:v>
                </c:pt>
                <c:pt idx="232">
                  <c:v>3.6873554935000002E-3</c:v>
                </c:pt>
                <c:pt idx="233">
                  <c:v>1.4067883498799999E-3</c:v>
                </c:pt>
                <c:pt idx="234">
                  <c:v>3.2268530808499999E-3</c:v>
                </c:pt>
                <c:pt idx="235">
                  <c:v>2.67014774818E-3</c:v>
                </c:pt>
                <c:pt idx="236">
                  <c:v>1.98968224655E-3</c:v>
                </c:pt>
                <c:pt idx="237">
                  <c:v>2.42622715701E-3</c:v>
                </c:pt>
                <c:pt idx="238">
                  <c:v>5.1308836180400004E-3</c:v>
                </c:pt>
                <c:pt idx="239">
                  <c:v>6.0193634198400002E-3</c:v>
                </c:pt>
                <c:pt idx="240">
                  <c:v>4.1366602109699999E-4</c:v>
                </c:pt>
                <c:pt idx="241">
                  <c:v>7.9000242599199997E-4</c:v>
                </c:pt>
                <c:pt idx="242">
                  <c:v>1.17428808785E-3</c:v>
                </c:pt>
                <c:pt idx="243">
                  <c:v>2.3957646536600001E-3</c:v>
                </c:pt>
                <c:pt idx="244">
                  <c:v>1.3124225077200001E-3</c:v>
                </c:pt>
                <c:pt idx="245">
                  <c:v>2.0458183605599999E-3</c:v>
                </c:pt>
                <c:pt idx="246">
                  <c:v>1.45319226956E-3</c:v>
                </c:pt>
                <c:pt idx="247">
                  <c:v>7.8041907813900001E-4</c:v>
                </c:pt>
                <c:pt idx="248">
                  <c:v>1.2843870193099999E-3</c:v>
                </c:pt>
                <c:pt idx="249">
                  <c:v>1.6521900087099999E-3</c:v>
                </c:pt>
                <c:pt idx="250">
                  <c:v>8.9637617692100004E-4</c:v>
                </c:pt>
                <c:pt idx="251">
                  <c:v>2.6504753275900001E-3</c:v>
                </c:pt>
                <c:pt idx="252">
                  <c:v>3.6162590238100001E-3</c:v>
                </c:pt>
                <c:pt idx="253">
                  <c:v>1.90546519065E-3</c:v>
                </c:pt>
                <c:pt idx="254">
                  <c:v>5.3118302331100001E-3</c:v>
                </c:pt>
                <c:pt idx="255">
                  <c:v>5.8413502329999999E-3</c:v>
                </c:pt>
                <c:pt idx="256">
                  <c:v>5.29547299243E-3</c:v>
                </c:pt>
                <c:pt idx="257">
                  <c:v>1.4680342104400001E-3</c:v>
                </c:pt>
                <c:pt idx="258">
                  <c:v>3.92651154196E-3</c:v>
                </c:pt>
                <c:pt idx="259">
                  <c:v>1.51175042375E-3</c:v>
                </c:pt>
                <c:pt idx="260">
                  <c:v>5.5919213183799996E-4</c:v>
                </c:pt>
                <c:pt idx="261">
                  <c:v>2.65653125272E-3</c:v>
                </c:pt>
                <c:pt idx="262">
                  <c:v>2.41831360199E-3</c:v>
                </c:pt>
                <c:pt idx="263">
                  <c:v>4.3520443520399998E-3</c:v>
                </c:pt>
                <c:pt idx="264">
                  <c:v>3.4088936716799999E-3</c:v>
                </c:pt>
                <c:pt idx="265">
                  <c:v>3.9736102694100002E-3</c:v>
                </c:pt>
                <c:pt idx="266">
                  <c:v>6.5829863088699995E-4</c:v>
                </c:pt>
                <c:pt idx="267">
                  <c:v>4.4437055062699999E-3</c:v>
                </c:pt>
                <c:pt idx="268">
                  <c:v>4.2278978389000002E-3</c:v>
                </c:pt>
                <c:pt idx="269">
                  <c:v>1.06845105792E-3</c:v>
                </c:pt>
                <c:pt idx="270">
                  <c:v>2.0231826050100001E-3</c:v>
                </c:pt>
                <c:pt idx="271">
                  <c:v>8.4676456326500003E-4</c:v>
                </c:pt>
                <c:pt idx="272">
                  <c:v>2.5556983409600002E-3</c:v>
                </c:pt>
                <c:pt idx="273">
                  <c:v>4.7381190238300003E-3</c:v>
                </c:pt>
                <c:pt idx="274">
                  <c:v>1.4192202977499999E-3</c:v>
                </c:pt>
                <c:pt idx="275">
                  <c:v>1.21565949528E-3</c:v>
                </c:pt>
                <c:pt idx="276">
                  <c:v>2.37874001115E-3</c:v>
                </c:pt>
                <c:pt idx="277">
                  <c:v>7.1806702468200001E-4</c:v>
                </c:pt>
                <c:pt idx="278">
                  <c:v>2.5150597804499998E-3</c:v>
                </c:pt>
                <c:pt idx="279">
                  <c:v>4.1898991201200003E-3</c:v>
                </c:pt>
                <c:pt idx="280">
                  <c:v>3.5495268651300001E-3</c:v>
                </c:pt>
                <c:pt idx="281">
                  <c:v>6.1149776722899997E-4</c:v>
                </c:pt>
                <c:pt idx="282">
                  <c:v>7.2299160295800002E-3</c:v>
                </c:pt>
                <c:pt idx="283">
                  <c:v>8.4185882428400001E-4</c:v>
                </c:pt>
                <c:pt idx="284">
                  <c:v>4.3610117547300004E-3</c:v>
                </c:pt>
                <c:pt idx="285">
                  <c:v>2.2360466694900001E-3</c:v>
                </c:pt>
                <c:pt idx="286">
                  <c:v>4.7361190978199999E-3</c:v>
                </c:pt>
                <c:pt idx="287">
                  <c:v>2.3040364792399999E-3</c:v>
                </c:pt>
                <c:pt idx="288">
                  <c:v>3.31247699669E-3</c:v>
                </c:pt>
                <c:pt idx="289">
                  <c:v>1.8116244510899999E-3</c:v>
                </c:pt>
                <c:pt idx="290">
                  <c:v>7.1849283595800003E-4</c:v>
                </c:pt>
                <c:pt idx="291">
                  <c:v>9.6794245626500002E-4</c:v>
                </c:pt>
                <c:pt idx="292">
                  <c:v>4.0680208854900002E-3</c:v>
                </c:pt>
                <c:pt idx="293">
                  <c:v>3.20711494408E-3</c:v>
                </c:pt>
                <c:pt idx="294">
                  <c:v>5.8292304519000004E-3</c:v>
                </c:pt>
                <c:pt idx="295">
                  <c:v>5.1847220051100002E-3</c:v>
                </c:pt>
                <c:pt idx="296">
                  <c:v>2.9219753606399999E-3</c:v>
                </c:pt>
                <c:pt idx="297">
                  <c:v>2.49505444565E-3</c:v>
                </c:pt>
                <c:pt idx="298">
                  <c:v>2.3976754135799998E-3</c:v>
                </c:pt>
                <c:pt idx="299">
                  <c:v>3.3213048239699998E-4</c:v>
                </c:pt>
                <c:pt idx="300">
                  <c:v>3.8230425199199999E-3</c:v>
                </c:pt>
                <c:pt idx="301">
                  <c:v>1.1978254860399999E-3</c:v>
                </c:pt>
                <c:pt idx="302">
                  <c:v>2.77375895021E-3</c:v>
                </c:pt>
                <c:pt idx="303">
                  <c:v>1.3108368757100001E-3</c:v>
                </c:pt>
                <c:pt idx="304">
                  <c:v>1.2032122970199999E-3</c:v>
                </c:pt>
                <c:pt idx="305">
                  <c:v>6.5630171180699999E-3</c:v>
                </c:pt>
                <c:pt idx="306">
                  <c:v>3.0058651026400002E-3</c:v>
                </c:pt>
                <c:pt idx="307">
                  <c:v>5.9669647135399996E-4</c:v>
                </c:pt>
                <c:pt idx="308">
                  <c:v>2.13390951867E-3</c:v>
                </c:pt>
                <c:pt idx="309">
                  <c:v>6.1380891628799996E-3</c:v>
                </c:pt>
                <c:pt idx="310">
                  <c:v>3.7630459817E-3</c:v>
                </c:pt>
                <c:pt idx="311">
                  <c:v>4.7462969928199999E-4</c:v>
                </c:pt>
                <c:pt idx="312">
                  <c:v>2.4167279604900001E-3</c:v>
                </c:pt>
                <c:pt idx="313">
                  <c:v>2.68765429937E-3</c:v>
                </c:pt>
                <c:pt idx="314">
                  <c:v>2.56713716344E-3</c:v>
                </c:pt>
                <c:pt idx="315">
                  <c:v>8.3945795000900001E-4</c:v>
                </c:pt>
                <c:pt idx="316">
                  <c:v>9.0184491702999996E-4</c:v>
                </c:pt>
                <c:pt idx="317">
                  <c:v>3.2104524758400001E-3</c:v>
                </c:pt>
                <c:pt idx="318">
                  <c:v>2.4976750365400002E-3</c:v>
                </c:pt>
                <c:pt idx="319">
                  <c:v>2.93956189903E-3</c:v>
                </c:pt>
                <c:pt idx="320">
                  <c:v>6.0358272607900004E-3</c:v>
                </c:pt>
                <c:pt idx="321">
                  <c:v>3.5046423433999999E-3</c:v>
                </c:pt>
                <c:pt idx="322">
                  <c:v>2.6974243100999998E-3</c:v>
                </c:pt>
                <c:pt idx="323">
                  <c:v>2.4488774488799999E-3</c:v>
                </c:pt>
                <c:pt idx="324">
                  <c:v>7.9904115061900003E-4</c:v>
                </c:pt>
                <c:pt idx="325">
                  <c:v>5.6668021955699997E-3</c:v>
                </c:pt>
                <c:pt idx="326">
                  <c:v>3.31610425426E-3</c:v>
                </c:pt>
                <c:pt idx="327">
                  <c:v>6.6523218832199998E-3</c:v>
                </c:pt>
                <c:pt idx="328">
                  <c:v>1.1322114147499999E-3</c:v>
                </c:pt>
                <c:pt idx="329">
                  <c:v>1.8603195576999999E-3</c:v>
                </c:pt>
                <c:pt idx="330">
                  <c:v>3.0303821938899998E-3</c:v>
                </c:pt>
                <c:pt idx="331">
                  <c:v>1.4411550317500001E-2</c:v>
                </c:pt>
                <c:pt idx="332">
                  <c:v>5.2198601571199999E-3</c:v>
                </c:pt>
                <c:pt idx="333">
                  <c:v>3.8008060178000001E-3</c:v>
                </c:pt>
                <c:pt idx="334">
                  <c:v>1.14319623705E-3</c:v>
                </c:pt>
                <c:pt idx="335">
                  <c:v>2.4266172954899999E-3</c:v>
                </c:pt>
                <c:pt idx="336">
                  <c:v>3.81751216496E-3</c:v>
                </c:pt>
                <c:pt idx="337">
                  <c:v>1.0267029783100001E-3</c:v>
                </c:pt>
                <c:pt idx="338">
                  <c:v>2.1915444348600001E-3</c:v>
                </c:pt>
                <c:pt idx="339">
                  <c:v>2.2543452073700001E-3</c:v>
                </c:pt>
                <c:pt idx="340">
                  <c:v>1.90767932644E-3</c:v>
                </c:pt>
                <c:pt idx="341">
                  <c:v>4.5045045045000003E-3</c:v>
                </c:pt>
                <c:pt idx="342">
                  <c:v>2.2193163400599999E-3</c:v>
                </c:pt>
                <c:pt idx="343">
                  <c:v>6.9438014998600005E-4</c:v>
                </c:pt>
                <c:pt idx="344">
                  <c:v>1.11293080828E-3</c:v>
                </c:pt>
                <c:pt idx="345">
                  <c:v>6.9704801077400003E-3</c:v>
                </c:pt>
                <c:pt idx="346">
                  <c:v>5.0741894119800002E-3</c:v>
                </c:pt>
                <c:pt idx="347">
                  <c:v>7.5439064555600001E-4</c:v>
                </c:pt>
                <c:pt idx="348">
                  <c:v>5.4527138803900001E-3</c:v>
                </c:pt>
                <c:pt idx="349">
                  <c:v>6.9192811231099998E-4</c:v>
                </c:pt>
                <c:pt idx="350">
                  <c:v>3.52401245697E-3</c:v>
                </c:pt>
                <c:pt idx="351">
                  <c:v>1.64560471502E-3</c:v>
                </c:pt>
                <c:pt idx="352">
                  <c:v>6.1700244118399999E-4</c:v>
                </c:pt>
                <c:pt idx="353">
                  <c:v>8.66950731374E-4</c:v>
                </c:pt>
                <c:pt idx="354">
                  <c:v>2.0079328183300001E-3</c:v>
                </c:pt>
                <c:pt idx="355">
                  <c:v>6.6605536018400002E-3</c:v>
                </c:pt>
                <c:pt idx="356">
                  <c:v>2.8574120011299999E-3</c:v>
                </c:pt>
                <c:pt idx="357">
                  <c:v>1.83817769747E-3</c:v>
                </c:pt>
                <c:pt idx="358">
                  <c:v>8.3649072723300001E-3</c:v>
                </c:pt>
                <c:pt idx="359">
                  <c:v>3.71525944415E-3</c:v>
                </c:pt>
                <c:pt idx="360">
                  <c:v>1.0303967027300001E-3</c:v>
                </c:pt>
                <c:pt idx="361">
                  <c:v>6.9721954460799998E-3</c:v>
                </c:pt>
                <c:pt idx="362">
                  <c:v>6.6631005002000001E-4</c:v>
                </c:pt>
                <c:pt idx="363">
                  <c:v>3.47293346493E-3</c:v>
                </c:pt>
                <c:pt idx="364">
                  <c:v>3.3783783783800001E-3</c:v>
                </c:pt>
                <c:pt idx="365">
                  <c:v>4.3485099414299999E-4</c:v>
                </c:pt>
                <c:pt idx="366">
                  <c:v>6.1580882352900001E-4</c:v>
                </c:pt>
                <c:pt idx="367">
                  <c:v>5.4830780865900005E-4</c:v>
                </c:pt>
                <c:pt idx="368">
                  <c:v>6.6242306881099996E-3</c:v>
                </c:pt>
                <c:pt idx="369">
                  <c:v>1.5750161849799999E-3</c:v>
                </c:pt>
                <c:pt idx="370">
                  <c:v>5.4727062482600002E-3</c:v>
                </c:pt>
                <c:pt idx="371">
                  <c:v>7.2603563797799995E-4</c:v>
                </c:pt>
                <c:pt idx="372">
                  <c:v>2.36824020722E-3</c:v>
                </c:pt>
                <c:pt idx="373">
                  <c:v>9.9477147282300005E-3</c:v>
                </c:pt>
                <c:pt idx="374">
                  <c:v>6.1303907457799997E-3</c:v>
                </c:pt>
                <c:pt idx="375">
                  <c:v>3.9184526465899996E-3</c:v>
                </c:pt>
                <c:pt idx="376">
                  <c:v>3.2950007637399998E-3</c:v>
                </c:pt>
                <c:pt idx="377">
                  <c:v>3.35987921447E-3</c:v>
                </c:pt>
                <c:pt idx="378">
                  <c:v>8.5687967267199998E-4</c:v>
                </c:pt>
                <c:pt idx="379">
                  <c:v>2.5257389926999999E-3</c:v>
                </c:pt>
                <c:pt idx="380">
                  <c:v>4.8631046745800004E-3</c:v>
                </c:pt>
                <c:pt idx="381">
                  <c:v>3.0917833192999999E-3</c:v>
                </c:pt>
                <c:pt idx="382">
                  <c:v>9.4218415417599997E-4</c:v>
                </c:pt>
                <c:pt idx="383">
                  <c:v>7.2358900144700003E-4</c:v>
                </c:pt>
                <c:pt idx="384">
                  <c:v>1.4190450786899999E-3</c:v>
                </c:pt>
                <c:pt idx="385">
                  <c:v>2.9570303122900001E-3</c:v>
                </c:pt>
                <c:pt idx="386">
                  <c:v>1.08083069559E-3</c:v>
                </c:pt>
                <c:pt idx="387">
                  <c:v>2.27683726605E-3</c:v>
                </c:pt>
                <c:pt idx="388">
                  <c:v>5.4398677024199995E-4</c:v>
                </c:pt>
                <c:pt idx="389">
                  <c:v>5.3921145716500003E-4</c:v>
                </c:pt>
                <c:pt idx="390">
                  <c:v>3.0327034061300002E-3</c:v>
                </c:pt>
                <c:pt idx="391">
                  <c:v>1.14389263265E-3</c:v>
                </c:pt>
                <c:pt idx="392">
                  <c:v>4.8171092789100001E-3</c:v>
                </c:pt>
                <c:pt idx="393">
                  <c:v>2.9948984239800002E-3</c:v>
                </c:pt>
                <c:pt idx="394">
                  <c:v>9.0182942540599997E-4</c:v>
                </c:pt>
                <c:pt idx="395">
                  <c:v>2.0860095932899998E-3</c:v>
                </c:pt>
                <c:pt idx="396">
                  <c:v>1.28981341877E-2</c:v>
                </c:pt>
                <c:pt idx="397">
                  <c:v>3.9131021454599998E-3</c:v>
                </c:pt>
                <c:pt idx="398">
                  <c:v>8.5163105861399998E-4</c:v>
                </c:pt>
                <c:pt idx="399">
                  <c:v>6.7018708879100003E-3</c:v>
                </c:pt>
                <c:pt idx="400">
                  <c:v>1.26075620892E-3</c:v>
                </c:pt>
                <c:pt idx="401">
                  <c:v>1.2852399409100001E-2</c:v>
                </c:pt>
                <c:pt idx="402">
                  <c:v>1.2672244094499999E-3</c:v>
                </c:pt>
                <c:pt idx="403">
                  <c:v>6.30807262808E-3</c:v>
                </c:pt>
                <c:pt idx="404">
                  <c:v>1.0241904018700001E-3</c:v>
                </c:pt>
                <c:pt idx="405">
                  <c:v>5.6015586945899996E-3</c:v>
                </c:pt>
                <c:pt idx="406">
                  <c:v>2.52309836479E-3</c:v>
                </c:pt>
                <c:pt idx="407">
                  <c:v>7.20668780628E-4</c:v>
                </c:pt>
                <c:pt idx="408">
                  <c:v>9.3370793233299998E-3</c:v>
                </c:pt>
                <c:pt idx="409">
                  <c:v>1.2605042016799999E-3</c:v>
                </c:pt>
                <c:pt idx="410">
                  <c:v>6.0664037891699997E-4</c:v>
                </c:pt>
                <c:pt idx="411">
                  <c:v>8.5558252427199999E-3</c:v>
                </c:pt>
                <c:pt idx="412">
                  <c:v>7.0652438727299999E-3</c:v>
                </c:pt>
                <c:pt idx="413">
                  <c:v>7.0251937984500004E-4</c:v>
                </c:pt>
                <c:pt idx="414">
                  <c:v>6.0491676345299998E-4</c:v>
                </c:pt>
                <c:pt idx="415">
                  <c:v>1.7347654375700001E-3</c:v>
                </c:pt>
                <c:pt idx="416">
                  <c:v>2.4642073876899998E-3</c:v>
                </c:pt>
                <c:pt idx="417">
                  <c:v>1.0298784503899999E-3</c:v>
                </c:pt>
                <c:pt idx="418">
                  <c:v>7.3997159463900001E-4</c:v>
                </c:pt>
                <c:pt idx="419">
                  <c:v>9.5666315890200002E-4</c:v>
                </c:pt>
                <c:pt idx="420">
                  <c:v>7.5257757820499998E-4</c:v>
                </c:pt>
                <c:pt idx="421">
                  <c:v>1.26112573649E-2</c:v>
                </c:pt>
                <c:pt idx="422">
                  <c:v>9.6723947341999998E-4</c:v>
                </c:pt>
                <c:pt idx="423">
                  <c:v>6.3445067145999996E-4</c:v>
                </c:pt>
                <c:pt idx="424">
                  <c:v>3.2621067577199999E-3</c:v>
                </c:pt>
                <c:pt idx="425">
                  <c:v>2.3712307575299999E-3</c:v>
                </c:pt>
                <c:pt idx="426">
                  <c:v>3.6505079241200001E-4</c:v>
                </c:pt>
                <c:pt idx="427">
                  <c:v>2.6257271002700002E-3</c:v>
                </c:pt>
                <c:pt idx="428">
                  <c:v>2.5168236877499998E-3</c:v>
                </c:pt>
                <c:pt idx="429">
                  <c:v>8.2048361066999996E-3</c:v>
                </c:pt>
                <c:pt idx="430">
                  <c:v>6.2946147561799995E-4</c:v>
                </c:pt>
                <c:pt idx="431">
                  <c:v>2.40123724767E-3</c:v>
                </c:pt>
                <c:pt idx="432">
                  <c:v>2.7532893866000002E-3</c:v>
                </c:pt>
                <c:pt idx="433">
                  <c:v>8.15703610146E-4</c:v>
                </c:pt>
                <c:pt idx="434">
                  <c:v>2.1800062285900002E-3</c:v>
                </c:pt>
                <c:pt idx="435">
                  <c:v>2.6126880247600002E-3</c:v>
                </c:pt>
                <c:pt idx="436">
                  <c:v>2.6423753563700001E-3</c:v>
                </c:pt>
                <c:pt idx="437">
                  <c:v>9.6612866560600002E-4</c:v>
                </c:pt>
                <c:pt idx="438">
                  <c:v>2.63416032007E-3</c:v>
                </c:pt>
                <c:pt idx="439">
                  <c:v>3.2784434335E-3</c:v>
                </c:pt>
                <c:pt idx="440">
                  <c:v>4.9551373585399999E-3</c:v>
                </c:pt>
                <c:pt idx="441">
                  <c:v>3.6693196513600001E-3</c:v>
                </c:pt>
                <c:pt idx="442">
                  <c:v>2.2144475004000001E-3</c:v>
                </c:pt>
                <c:pt idx="443">
                  <c:v>3.3603578983600001E-3</c:v>
                </c:pt>
                <c:pt idx="444">
                  <c:v>4.7364462423500004E-3</c:v>
                </c:pt>
                <c:pt idx="445">
                  <c:v>5.42640315572E-3</c:v>
                </c:pt>
                <c:pt idx="446">
                  <c:v>2.2791622321700002E-3</c:v>
                </c:pt>
                <c:pt idx="447">
                  <c:v>2.4372715057999999E-3</c:v>
                </c:pt>
                <c:pt idx="448">
                  <c:v>2.89416223788E-3</c:v>
                </c:pt>
                <c:pt idx="449">
                  <c:v>8.21232446655E-3</c:v>
                </c:pt>
                <c:pt idx="450">
                  <c:v>1.90027437635E-3</c:v>
                </c:pt>
                <c:pt idx="451">
                  <c:v>9.948834565090001E-4</c:v>
                </c:pt>
                <c:pt idx="452">
                  <c:v>3.04806784288E-3</c:v>
                </c:pt>
                <c:pt idx="453">
                  <c:v>2.7768778636599999E-3</c:v>
                </c:pt>
                <c:pt idx="454">
                  <c:v>1.51301679036E-2</c:v>
                </c:pt>
                <c:pt idx="455">
                  <c:v>2.1478735161000002E-3</c:v>
                </c:pt>
                <c:pt idx="456">
                  <c:v>2.0790020790000001E-3</c:v>
                </c:pt>
                <c:pt idx="457">
                  <c:v>2.3873707207899999E-3</c:v>
                </c:pt>
                <c:pt idx="458">
                  <c:v>7.9223079730500001E-4</c:v>
                </c:pt>
                <c:pt idx="459">
                  <c:v>2.5391814571100002E-3</c:v>
                </c:pt>
                <c:pt idx="460">
                  <c:v>3.02107024847E-3</c:v>
                </c:pt>
                <c:pt idx="461">
                  <c:v>3.3014903870900001E-3</c:v>
                </c:pt>
                <c:pt idx="462">
                  <c:v>2.5308636679499999E-3</c:v>
                </c:pt>
                <c:pt idx="463">
                  <c:v>1.73807322169E-3</c:v>
                </c:pt>
                <c:pt idx="464">
                  <c:v>8.7245107431200002E-4</c:v>
                </c:pt>
                <c:pt idx="465">
                  <c:v>4.9132308111499998E-3</c:v>
                </c:pt>
                <c:pt idx="466">
                  <c:v>1.0611833063699999E-3</c:v>
                </c:pt>
                <c:pt idx="467">
                  <c:v>1.2242434692600001E-3</c:v>
                </c:pt>
                <c:pt idx="468">
                  <c:v>7.4868979286199999E-4</c:v>
                </c:pt>
                <c:pt idx="469">
                  <c:v>1.6994416120399999E-3</c:v>
                </c:pt>
                <c:pt idx="470">
                  <c:v>3.1229439887699999E-3</c:v>
                </c:pt>
                <c:pt idx="471">
                  <c:v>3.5045142127500001E-3</c:v>
                </c:pt>
                <c:pt idx="472">
                  <c:v>2.2569083966E-3</c:v>
                </c:pt>
                <c:pt idx="473">
                  <c:v>2.3206845571399999E-3</c:v>
                </c:pt>
                <c:pt idx="474">
                  <c:v>1.7015199069000001E-3</c:v>
                </c:pt>
                <c:pt idx="475">
                  <c:v>2.0640198992699999E-3</c:v>
                </c:pt>
                <c:pt idx="476">
                  <c:v>1.20309467565E-3</c:v>
                </c:pt>
                <c:pt idx="477">
                  <c:v>2.1713772992399999E-3</c:v>
                </c:pt>
                <c:pt idx="478">
                  <c:v>1.41046274028E-3</c:v>
                </c:pt>
                <c:pt idx="479">
                  <c:v>9.4816687736999996E-4</c:v>
                </c:pt>
                <c:pt idx="480">
                  <c:v>4.2454023196200003E-3</c:v>
                </c:pt>
                <c:pt idx="481">
                  <c:v>1.6677392163400001E-3</c:v>
                </c:pt>
                <c:pt idx="482">
                  <c:v>5.1704925339900003E-4</c:v>
                </c:pt>
                <c:pt idx="483">
                  <c:v>8.6564026463900004E-4</c:v>
                </c:pt>
                <c:pt idx="484">
                  <c:v>2.0983213429300001E-3</c:v>
                </c:pt>
                <c:pt idx="485">
                  <c:v>4.5577565611400004E-3</c:v>
                </c:pt>
                <c:pt idx="486">
                  <c:v>1.2945535067900001E-3</c:v>
                </c:pt>
                <c:pt idx="487">
                  <c:v>4.1995322676599998E-3</c:v>
                </c:pt>
                <c:pt idx="488">
                  <c:v>2.1033227773300002E-3</c:v>
                </c:pt>
                <c:pt idx="489">
                  <c:v>6.8460273369000001E-4</c:v>
                </c:pt>
                <c:pt idx="490">
                  <c:v>8.3153297377999995E-4</c:v>
                </c:pt>
                <c:pt idx="491">
                  <c:v>3.8758485700500001E-3</c:v>
                </c:pt>
                <c:pt idx="492">
                  <c:v>4.1616344992599997E-3</c:v>
                </c:pt>
                <c:pt idx="493">
                  <c:v>1.2930934952800001E-3</c:v>
                </c:pt>
                <c:pt idx="494">
                  <c:v>3.2151315067200001E-3</c:v>
                </c:pt>
                <c:pt idx="495">
                  <c:v>2.5705343760400001E-3</c:v>
                </c:pt>
                <c:pt idx="496">
                  <c:v>1.807937782E-3</c:v>
                </c:pt>
                <c:pt idx="497">
                  <c:v>2.5164256048200002E-3</c:v>
                </c:pt>
                <c:pt idx="498">
                  <c:v>4.0397691122499996E-3</c:v>
                </c:pt>
                <c:pt idx="499">
                  <c:v>6.9050176461599999E-3</c:v>
                </c:pt>
                <c:pt idx="500">
                  <c:v>1.8810679611700001E-3</c:v>
                </c:pt>
                <c:pt idx="501">
                  <c:v>7.8986564761499998E-4</c:v>
                </c:pt>
                <c:pt idx="502">
                  <c:v>2.1030494216599999E-3</c:v>
                </c:pt>
                <c:pt idx="503">
                  <c:v>2.5414213752500002E-3</c:v>
                </c:pt>
                <c:pt idx="504">
                  <c:v>4.2097584328099997E-3</c:v>
                </c:pt>
                <c:pt idx="505">
                  <c:v>2.9935127925300002E-3</c:v>
                </c:pt>
                <c:pt idx="506">
                  <c:v>1.5606205941000001E-3</c:v>
                </c:pt>
                <c:pt idx="507">
                  <c:v>8.9737689829700001E-4</c:v>
                </c:pt>
                <c:pt idx="508">
                  <c:v>7.0552356676300003E-4</c:v>
                </c:pt>
                <c:pt idx="509">
                  <c:v>2.2889907908E-3</c:v>
                </c:pt>
                <c:pt idx="510">
                  <c:v>3.9418615968600003E-3</c:v>
                </c:pt>
                <c:pt idx="511">
                  <c:v>1.55959107685E-3</c:v>
                </c:pt>
                <c:pt idx="512">
                  <c:v>2.3452898761699998E-3</c:v>
                </c:pt>
                <c:pt idx="513">
                  <c:v>1.4130907388200001E-3</c:v>
                </c:pt>
                <c:pt idx="514">
                  <c:v>6.2216043941100002E-3</c:v>
                </c:pt>
                <c:pt idx="515">
                  <c:v>1.5291045289000001E-3</c:v>
                </c:pt>
                <c:pt idx="516">
                  <c:v>5.7168698857499997E-3</c:v>
                </c:pt>
                <c:pt idx="517">
                  <c:v>8.3224245996999999E-4</c:v>
                </c:pt>
                <c:pt idx="518">
                  <c:v>1.1585081182000001E-3</c:v>
                </c:pt>
                <c:pt idx="519">
                  <c:v>2.3967487582100002E-3</c:v>
                </c:pt>
                <c:pt idx="520">
                  <c:v>2.3762615788699998E-3</c:v>
                </c:pt>
                <c:pt idx="521">
                  <c:v>1.06077076831E-3</c:v>
                </c:pt>
                <c:pt idx="522">
                  <c:v>1.12184481147E-3</c:v>
                </c:pt>
                <c:pt idx="523">
                  <c:v>6.2793785209400003E-4</c:v>
                </c:pt>
                <c:pt idx="524">
                  <c:v>7.17959903303E-4</c:v>
                </c:pt>
                <c:pt idx="525">
                  <c:v>6.71347957832E-4</c:v>
                </c:pt>
                <c:pt idx="526">
                  <c:v>6.7511328955900001E-4</c:v>
                </c:pt>
                <c:pt idx="527">
                  <c:v>1.2701970673399999E-3</c:v>
                </c:pt>
                <c:pt idx="528">
                  <c:v>2.1197464012499998E-3</c:v>
                </c:pt>
                <c:pt idx="529">
                  <c:v>3.2539784584599998E-3</c:v>
                </c:pt>
                <c:pt idx="530">
                  <c:v>9.9344327438899991E-4</c:v>
                </c:pt>
                <c:pt idx="531">
                  <c:v>1.09250541287E-3</c:v>
                </c:pt>
                <c:pt idx="532">
                  <c:v>3.2633328297299998E-3</c:v>
                </c:pt>
                <c:pt idx="533">
                  <c:v>1.3684210526300001E-3</c:v>
                </c:pt>
                <c:pt idx="534">
                  <c:v>3.0504389005600002E-3</c:v>
                </c:pt>
                <c:pt idx="535">
                  <c:v>3.5532307307599999E-3</c:v>
                </c:pt>
                <c:pt idx="536">
                  <c:v>2.7292235254899998E-3</c:v>
                </c:pt>
                <c:pt idx="537">
                  <c:v>1.4642463143099999E-3</c:v>
                </c:pt>
                <c:pt idx="538">
                  <c:v>4.3883270500500002E-4</c:v>
                </c:pt>
                <c:pt idx="539">
                  <c:v>2.6059403594999998E-3</c:v>
                </c:pt>
                <c:pt idx="540">
                  <c:v>3.8031430119699998E-3</c:v>
                </c:pt>
                <c:pt idx="541">
                  <c:v>7.1501147781599997E-4</c:v>
                </c:pt>
                <c:pt idx="542">
                  <c:v>1.0701195858600001E-3</c:v>
                </c:pt>
                <c:pt idx="543">
                  <c:v>1.30781013463E-3</c:v>
                </c:pt>
                <c:pt idx="544">
                  <c:v>3.1345703476900002E-3</c:v>
                </c:pt>
                <c:pt idx="545">
                  <c:v>3.0399703072700002E-3</c:v>
                </c:pt>
                <c:pt idx="546">
                  <c:v>8.7074303405599998E-4</c:v>
                </c:pt>
                <c:pt idx="547">
                  <c:v>1.05608906948E-3</c:v>
                </c:pt>
                <c:pt idx="548">
                  <c:v>4.4427045874600004E-3</c:v>
                </c:pt>
                <c:pt idx="549">
                  <c:v>2.1671943313699999E-3</c:v>
                </c:pt>
                <c:pt idx="550">
                  <c:v>3.7785630153100002E-3</c:v>
                </c:pt>
                <c:pt idx="551">
                  <c:v>3.0273201716100001E-3</c:v>
                </c:pt>
                <c:pt idx="552">
                  <c:v>4.59747002047E-3</c:v>
                </c:pt>
                <c:pt idx="553">
                  <c:v>4.8966906682800003E-3</c:v>
                </c:pt>
                <c:pt idx="554">
                  <c:v>3.26367756704E-3</c:v>
                </c:pt>
                <c:pt idx="555">
                  <c:v>1.73708495431E-3</c:v>
                </c:pt>
                <c:pt idx="556">
                  <c:v>1.7930835631E-3</c:v>
                </c:pt>
                <c:pt idx="557">
                  <c:v>3.8710026709000002E-3</c:v>
                </c:pt>
                <c:pt idx="558">
                  <c:v>5.0463612382999996E-3</c:v>
                </c:pt>
                <c:pt idx="559">
                  <c:v>3.1597980593600001E-3</c:v>
                </c:pt>
                <c:pt idx="560">
                  <c:v>3.4018823147199998E-3</c:v>
                </c:pt>
                <c:pt idx="561">
                  <c:v>2.8055646924500001E-3</c:v>
                </c:pt>
                <c:pt idx="562">
                  <c:v>3.0345126553000001E-3</c:v>
                </c:pt>
                <c:pt idx="563">
                  <c:v>3.0388756160200001E-3</c:v>
                </c:pt>
                <c:pt idx="564">
                  <c:v>3.82866714525E-3</c:v>
                </c:pt>
                <c:pt idx="565">
                  <c:v>1.67305681422E-3</c:v>
                </c:pt>
                <c:pt idx="566">
                  <c:v>4.0046442065500001E-3</c:v>
                </c:pt>
                <c:pt idx="567">
                  <c:v>2.9557041122000001E-3</c:v>
                </c:pt>
                <c:pt idx="568">
                  <c:v>5.9178463680699999E-3</c:v>
                </c:pt>
                <c:pt idx="569">
                  <c:v>3.46113377513E-3</c:v>
                </c:pt>
                <c:pt idx="570">
                  <c:v>2.54585870484E-3</c:v>
                </c:pt>
                <c:pt idx="571">
                  <c:v>3.1125150980199998E-3</c:v>
                </c:pt>
                <c:pt idx="572">
                  <c:v>7.3707287571800003E-4</c:v>
                </c:pt>
                <c:pt idx="573">
                  <c:v>5.3204123319599997E-4</c:v>
                </c:pt>
                <c:pt idx="574">
                  <c:v>5.3864593580199996E-3</c:v>
                </c:pt>
                <c:pt idx="575">
                  <c:v>1.2299768418400001E-3</c:v>
                </c:pt>
                <c:pt idx="576">
                  <c:v>1.86454198583E-3</c:v>
                </c:pt>
                <c:pt idx="577">
                  <c:v>1.6993605296500001E-3</c:v>
                </c:pt>
                <c:pt idx="578">
                  <c:v>5.7851484854800003E-3</c:v>
                </c:pt>
                <c:pt idx="579">
                  <c:v>3.3254061026200001E-3</c:v>
                </c:pt>
                <c:pt idx="580">
                  <c:v>6.2348600222800004E-4</c:v>
                </c:pt>
                <c:pt idx="581">
                  <c:v>1.51003091968E-3</c:v>
                </c:pt>
                <c:pt idx="582">
                  <c:v>3.8866780758399998E-3</c:v>
                </c:pt>
                <c:pt idx="583">
                  <c:v>3.0613822604800001E-3</c:v>
                </c:pt>
                <c:pt idx="584">
                  <c:v>6.2876226601799999E-4</c:v>
                </c:pt>
                <c:pt idx="585">
                  <c:v>1.3884973952599999E-3</c:v>
                </c:pt>
                <c:pt idx="586">
                  <c:v>7.1345180957300004E-4</c:v>
                </c:pt>
                <c:pt idx="587">
                  <c:v>2.01548060636E-3</c:v>
                </c:pt>
                <c:pt idx="588">
                  <c:v>3.8853917950900001E-3</c:v>
                </c:pt>
                <c:pt idx="589">
                  <c:v>2.6666086180399998E-3</c:v>
                </c:pt>
                <c:pt idx="590">
                  <c:v>1.16909687267E-3</c:v>
                </c:pt>
                <c:pt idx="591">
                  <c:v>1.8480470490999999E-3</c:v>
                </c:pt>
                <c:pt idx="592">
                  <c:v>2.83951826104E-3</c:v>
                </c:pt>
                <c:pt idx="593">
                  <c:v>5.4908378372600002E-4</c:v>
                </c:pt>
                <c:pt idx="594">
                  <c:v>1.8282115230200001E-3</c:v>
                </c:pt>
                <c:pt idx="595">
                  <c:v>3.5051953860399999E-3</c:v>
                </c:pt>
                <c:pt idx="596">
                  <c:v>2.1145172546700002E-3</c:v>
                </c:pt>
                <c:pt idx="597">
                  <c:v>5.09757317988E-3</c:v>
                </c:pt>
                <c:pt idx="598">
                  <c:v>3.7239454940299998E-3</c:v>
                </c:pt>
                <c:pt idx="599">
                  <c:v>8.94237951459E-4</c:v>
                </c:pt>
                <c:pt idx="600">
                  <c:v>1.07409123457E-3</c:v>
                </c:pt>
                <c:pt idx="601">
                  <c:v>2.2892426597199999E-3</c:v>
                </c:pt>
                <c:pt idx="602">
                  <c:v>1.2965191055099999E-3</c:v>
                </c:pt>
                <c:pt idx="603">
                  <c:v>5.9889253265999996E-3</c:v>
                </c:pt>
                <c:pt idx="604">
                  <c:v>5.3935430337E-3</c:v>
                </c:pt>
                <c:pt idx="605">
                  <c:v>3.6428068321899998E-3</c:v>
                </c:pt>
                <c:pt idx="606">
                  <c:v>6.4960803311900003E-4</c:v>
                </c:pt>
                <c:pt idx="607">
                  <c:v>3.4944221526499999E-3</c:v>
                </c:pt>
                <c:pt idx="608">
                  <c:v>3.80457426047E-3</c:v>
                </c:pt>
                <c:pt idx="609">
                  <c:v>2.3495874302600001E-3</c:v>
                </c:pt>
                <c:pt idx="610">
                  <c:v>2.38222222222E-3</c:v>
                </c:pt>
                <c:pt idx="611">
                  <c:v>3.5503108101300001E-3</c:v>
                </c:pt>
                <c:pt idx="612">
                  <c:v>2.3865752021099999E-3</c:v>
                </c:pt>
                <c:pt idx="613">
                  <c:v>1.359346478E-3</c:v>
                </c:pt>
                <c:pt idx="614">
                  <c:v>9.0825688073399996E-3</c:v>
                </c:pt>
                <c:pt idx="615">
                  <c:v>1.4307288768800001E-3</c:v>
                </c:pt>
                <c:pt idx="616">
                  <c:v>7.7626006073899995E-4</c:v>
                </c:pt>
                <c:pt idx="617">
                  <c:v>3.0635147728600001E-2</c:v>
                </c:pt>
                <c:pt idx="618">
                  <c:v>2.82161441717E-3</c:v>
                </c:pt>
                <c:pt idx="619">
                  <c:v>5.6255593596000004E-3</c:v>
                </c:pt>
                <c:pt idx="620">
                  <c:v>2.5775398023400002E-3</c:v>
                </c:pt>
                <c:pt idx="621">
                  <c:v>2.9212662565700001E-3</c:v>
                </c:pt>
                <c:pt idx="622">
                  <c:v>2.6531560565399999E-3</c:v>
                </c:pt>
                <c:pt idx="623">
                  <c:v>3.2203673041600002E-3</c:v>
                </c:pt>
                <c:pt idx="624">
                  <c:v>2.4630167393899999E-3</c:v>
                </c:pt>
                <c:pt idx="625">
                  <c:v>7.0930175016100001E-4</c:v>
                </c:pt>
                <c:pt idx="626">
                  <c:v>1.87318690427E-3</c:v>
                </c:pt>
                <c:pt idx="627">
                  <c:v>1.59457167091E-3</c:v>
                </c:pt>
                <c:pt idx="628">
                  <c:v>2.0867617868099999E-3</c:v>
                </c:pt>
                <c:pt idx="629">
                  <c:v>3.3717049247300001E-3</c:v>
                </c:pt>
                <c:pt idx="630">
                  <c:v>8.3934291440399998E-4</c:v>
                </c:pt>
                <c:pt idx="631">
                  <c:v>9.3998050410800001E-4</c:v>
                </c:pt>
                <c:pt idx="632">
                  <c:v>2.1812552772299998E-3</c:v>
                </c:pt>
                <c:pt idx="633">
                  <c:v>3.6167960479899998E-3</c:v>
                </c:pt>
                <c:pt idx="634">
                  <c:v>2.3070732361600002E-3</c:v>
                </c:pt>
                <c:pt idx="635">
                  <c:v>7.0478531155100004E-4</c:v>
                </c:pt>
                <c:pt idx="636">
                  <c:v>1.3194519755600001E-3</c:v>
                </c:pt>
                <c:pt idx="637">
                  <c:v>6.62058399752E-3</c:v>
                </c:pt>
                <c:pt idx="638">
                  <c:v>2.4037565684000002E-3</c:v>
                </c:pt>
                <c:pt idx="639">
                  <c:v>1.0724801591199999E-3</c:v>
                </c:pt>
                <c:pt idx="640">
                  <c:v>2.5224720225799999E-3</c:v>
                </c:pt>
                <c:pt idx="641">
                  <c:v>8.5785365016699999E-4</c:v>
                </c:pt>
                <c:pt idx="642">
                  <c:v>3.6918590979599999E-3</c:v>
                </c:pt>
                <c:pt idx="643">
                  <c:v>1.15072627806E-2</c:v>
                </c:pt>
                <c:pt idx="644">
                  <c:v>1.16156282999E-3</c:v>
                </c:pt>
                <c:pt idx="645">
                  <c:v>9.55135178159E-4</c:v>
                </c:pt>
                <c:pt idx="646">
                  <c:v>1.94127638923E-3</c:v>
                </c:pt>
                <c:pt idx="647">
                  <c:v>1.78257933828E-3</c:v>
                </c:pt>
                <c:pt idx="648">
                  <c:v>3.6472686010700001E-3</c:v>
                </c:pt>
                <c:pt idx="649">
                  <c:v>9.1876992920100005E-4</c:v>
                </c:pt>
                <c:pt idx="650">
                  <c:v>1.60754182333E-3</c:v>
                </c:pt>
                <c:pt idx="651">
                  <c:v>1.78635226867E-3</c:v>
                </c:pt>
                <c:pt idx="652">
                  <c:v>1.8726591760300001E-3</c:v>
                </c:pt>
                <c:pt idx="653">
                  <c:v>3.5856134157099999E-3</c:v>
                </c:pt>
                <c:pt idx="654">
                  <c:v>6.9257833060900004E-4</c:v>
                </c:pt>
                <c:pt idx="655">
                  <c:v>2.8535808283699999E-3</c:v>
                </c:pt>
                <c:pt idx="656">
                  <c:v>1.4832563181E-3</c:v>
                </c:pt>
                <c:pt idx="657">
                  <c:v>6.4669743378700003E-4</c:v>
                </c:pt>
                <c:pt idx="658">
                  <c:v>2.76370336251E-3</c:v>
                </c:pt>
                <c:pt idx="659">
                  <c:v>1.24351042994E-3</c:v>
                </c:pt>
                <c:pt idx="660">
                  <c:v>1.60944206009E-3</c:v>
                </c:pt>
                <c:pt idx="661">
                  <c:v>2.4950298210699998E-2</c:v>
                </c:pt>
                <c:pt idx="662">
                  <c:v>1.8006602420900001E-3</c:v>
                </c:pt>
                <c:pt idx="663">
                  <c:v>3.9389960610000004E-3</c:v>
                </c:pt>
                <c:pt idx="664">
                  <c:v>6.16712920136E-4</c:v>
                </c:pt>
                <c:pt idx="665">
                  <c:v>2.3817029175899999E-3</c:v>
                </c:pt>
                <c:pt idx="666">
                  <c:v>6.5717415115000002E-4</c:v>
                </c:pt>
                <c:pt idx="667">
                  <c:v>1.90511082616E-3</c:v>
                </c:pt>
                <c:pt idx="668">
                  <c:v>1.3926003989599999E-3</c:v>
                </c:pt>
                <c:pt idx="669">
                  <c:v>2.14562246373E-3</c:v>
                </c:pt>
                <c:pt idx="670">
                  <c:v>3.3754035808600002E-3</c:v>
                </c:pt>
                <c:pt idx="671">
                  <c:v>2.50588883877E-3</c:v>
                </c:pt>
                <c:pt idx="672">
                  <c:v>1.25093954687E-2</c:v>
                </c:pt>
                <c:pt idx="673">
                  <c:v>3.1260105637599999E-3</c:v>
                </c:pt>
                <c:pt idx="674">
                  <c:v>7.1753300104099998E-3</c:v>
                </c:pt>
                <c:pt idx="675">
                  <c:v>7.3736966415100004E-3</c:v>
                </c:pt>
                <c:pt idx="676">
                  <c:v>4.7345079707500001E-3</c:v>
                </c:pt>
                <c:pt idx="677">
                  <c:v>1.4674411494999999E-3</c:v>
                </c:pt>
                <c:pt idx="678">
                  <c:v>2.45957080489E-4</c:v>
                </c:pt>
                <c:pt idx="679">
                  <c:v>1.4002036659899999E-3</c:v>
                </c:pt>
                <c:pt idx="680">
                  <c:v>8.9577068270500001E-4</c:v>
                </c:pt>
                <c:pt idx="681">
                  <c:v>2.28479268866E-3</c:v>
                </c:pt>
                <c:pt idx="682">
                  <c:v>1.59385640803E-3</c:v>
                </c:pt>
                <c:pt idx="683">
                  <c:v>1.6601267733200001E-3</c:v>
                </c:pt>
                <c:pt idx="684">
                  <c:v>3.8290224271299998E-3</c:v>
                </c:pt>
                <c:pt idx="685">
                  <c:v>1.6656950112400001E-3</c:v>
                </c:pt>
                <c:pt idx="686">
                  <c:v>5.3038866185500001E-3</c:v>
                </c:pt>
                <c:pt idx="687">
                  <c:v>2.7956388034700002E-3</c:v>
                </c:pt>
                <c:pt idx="688">
                  <c:v>7.8934385791799996E-4</c:v>
                </c:pt>
                <c:pt idx="689">
                  <c:v>1.91509735078E-3</c:v>
                </c:pt>
                <c:pt idx="690">
                  <c:v>1.27574750831E-2</c:v>
                </c:pt>
                <c:pt idx="691">
                  <c:v>2.79366768658E-3</c:v>
                </c:pt>
                <c:pt idx="692">
                  <c:v>2.1765746156999998E-3</c:v>
                </c:pt>
                <c:pt idx="693">
                  <c:v>1.28638044702E-3</c:v>
                </c:pt>
                <c:pt idx="694">
                  <c:v>9.9108027750199998E-4</c:v>
                </c:pt>
                <c:pt idx="695">
                  <c:v>1.1564513464399999E-3</c:v>
                </c:pt>
                <c:pt idx="696">
                  <c:v>2.3478115042800001E-3</c:v>
                </c:pt>
                <c:pt idx="697">
                  <c:v>2.0239500758999999E-3</c:v>
                </c:pt>
                <c:pt idx="698">
                  <c:v>9.6479350033899999E-3</c:v>
                </c:pt>
                <c:pt idx="699">
                  <c:v>7.1994240460799999E-4</c:v>
                </c:pt>
                <c:pt idx="700">
                  <c:v>1.4542810398100001E-3</c:v>
                </c:pt>
                <c:pt idx="701">
                  <c:v>1.52700897118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0E-4D19-8684-577015353CDD}"/>
            </c:ext>
          </c:extLst>
        </c:ser>
        <c:ser>
          <c:idx val="0"/>
          <c:order val="1"/>
          <c:tx>
            <c:strRef>
              <c:f>'RNA2 DMS'!$D$1</c:f>
              <c:strCache>
                <c:ptCount val="1"/>
                <c:pt idx="0">
                  <c:v>DMS+</c:v>
                </c:pt>
              </c:strCache>
            </c:strRef>
          </c:tx>
          <c:spPr>
            <a:ln w="19050" cap="rnd">
              <a:solidFill>
                <a:schemeClr val="accent2">
                  <a:alpha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NA2 DMS'!$A$2:$A$1424</c:f>
              <c:numCache>
                <c:formatCode>General</c:formatCode>
                <c:ptCount val="1423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9</c:v>
                </c:pt>
                <c:pt idx="11">
                  <c:v>30</c:v>
                </c:pt>
                <c:pt idx="12">
                  <c:v>32</c:v>
                </c:pt>
                <c:pt idx="13">
                  <c:v>33</c:v>
                </c:pt>
                <c:pt idx="14">
                  <c:v>34</c:v>
                </c:pt>
                <c:pt idx="15">
                  <c:v>35</c:v>
                </c:pt>
                <c:pt idx="16">
                  <c:v>36</c:v>
                </c:pt>
                <c:pt idx="17">
                  <c:v>37</c:v>
                </c:pt>
                <c:pt idx="18">
                  <c:v>38</c:v>
                </c:pt>
                <c:pt idx="19">
                  <c:v>40</c:v>
                </c:pt>
                <c:pt idx="20">
                  <c:v>41</c:v>
                </c:pt>
                <c:pt idx="21">
                  <c:v>42</c:v>
                </c:pt>
                <c:pt idx="22">
                  <c:v>43</c:v>
                </c:pt>
                <c:pt idx="23">
                  <c:v>44</c:v>
                </c:pt>
                <c:pt idx="24">
                  <c:v>46</c:v>
                </c:pt>
                <c:pt idx="25">
                  <c:v>47</c:v>
                </c:pt>
                <c:pt idx="26">
                  <c:v>50</c:v>
                </c:pt>
                <c:pt idx="27">
                  <c:v>51</c:v>
                </c:pt>
                <c:pt idx="28">
                  <c:v>52</c:v>
                </c:pt>
                <c:pt idx="29">
                  <c:v>53</c:v>
                </c:pt>
                <c:pt idx="30">
                  <c:v>55</c:v>
                </c:pt>
                <c:pt idx="31">
                  <c:v>57</c:v>
                </c:pt>
                <c:pt idx="32">
                  <c:v>59</c:v>
                </c:pt>
                <c:pt idx="33">
                  <c:v>60</c:v>
                </c:pt>
                <c:pt idx="34">
                  <c:v>61</c:v>
                </c:pt>
                <c:pt idx="35">
                  <c:v>62</c:v>
                </c:pt>
                <c:pt idx="36">
                  <c:v>64</c:v>
                </c:pt>
                <c:pt idx="37">
                  <c:v>70</c:v>
                </c:pt>
                <c:pt idx="38">
                  <c:v>73</c:v>
                </c:pt>
                <c:pt idx="39">
                  <c:v>74</c:v>
                </c:pt>
                <c:pt idx="40">
                  <c:v>75</c:v>
                </c:pt>
                <c:pt idx="41">
                  <c:v>76</c:v>
                </c:pt>
                <c:pt idx="42">
                  <c:v>77</c:v>
                </c:pt>
                <c:pt idx="43">
                  <c:v>78</c:v>
                </c:pt>
                <c:pt idx="44">
                  <c:v>79</c:v>
                </c:pt>
                <c:pt idx="45">
                  <c:v>80</c:v>
                </c:pt>
                <c:pt idx="46">
                  <c:v>81</c:v>
                </c:pt>
                <c:pt idx="47">
                  <c:v>82</c:v>
                </c:pt>
                <c:pt idx="48">
                  <c:v>83</c:v>
                </c:pt>
                <c:pt idx="49">
                  <c:v>84</c:v>
                </c:pt>
                <c:pt idx="50">
                  <c:v>85</c:v>
                </c:pt>
                <c:pt idx="51">
                  <c:v>86</c:v>
                </c:pt>
                <c:pt idx="52">
                  <c:v>87</c:v>
                </c:pt>
                <c:pt idx="53">
                  <c:v>88</c:v>
                </c:pt>
                <c:pt idx="54">
                  <c:v>90</c:v>
                </c:pt>
                <c:pt idx="55">
                  <c:v>92</c:v>
                </c:pt>
                <c:pt idx="56">
                  <c:v>93</c:v>
                </c:pt>
                <c:pt idx="57">
                  <c:v>98</c:v>
                </c:pt>
                <c:pt idx="58">
                  <c:v>99</c:v>
                </c:pt>
                <c:pt idx="59">
                  <c:v>100</c:v>
                </c:pt>
                <c:pt idx="60">
                  <c:v>101</c:v>
                </c:pt>
                <c:pt idx="61">
                  <c:v>102</c:v>
                </c:pt>
                <c:pt idx="62">
                  <c:v>104</c:v>
                </c:pt>
                <c:pt idx="63">
                  <c:v>105</c:v>
                </c:pt>
                <c:pt idx="64">
                  <c:v>106</c:v>
                </c:pt>
                <c:pt idx="65">
                  <c:v>107</c:v>
                </c:pt>
                <c:pt idx="66">
                  <c:v>108</c:v>
                </c:pt>
                <c:pt idx="67">
                  <c:v>109</c:v>
                </c:pt>
                <c:pt idx="68">
                  <c:v>113</c:v>
                </c:pt>
                <c:pt idx="69">
                  <c:v>114</c:v>
                </c:pt>
                <c:pt idx="70">
                  <c:v>115</c:v>
                </c:pt>
                <c:pt idx="71">
                  <c:v>116</c:v>
                </c:pt>
                <c:pt idx="72">
                  <c:v>119</c:v>
                </c:pt>
                <c:pt idx="73">
                  <c:v>120</c:v>
                </c:pt>
                <c:pt idx="74">
                  <c:v>125</c:v>
                </c:pt>
                <c:pt idx="75">
                  <c:v>127</c:v>
                </c:pt>
                <c:pt idx="76">
                  <c:v>128</c:v>
                </c:pt>
                <c:pt idx="77">
                  <c:v>130</c:v>
                </c:pt>
                <c:pt idx="78">
                  <c:v>131</c:v>
                </c:pt>
                <c:pt idx="79">
                  <c:v>133</c:v>
                </c:pt>
                <c:pt idx="80">
                  <c:v>134</c:v>
                </c:pt>
                <c:pt idx="81">
                  <c:v>137</c:v>
                </c:pt>
                <c:pt idx="82">
                  <c:v>138</c:v>
                </c:pt>
                <c:pt idx="83">
                  <c:v>140</c:v>
                </c:pt>
                <c:pt idx="84">
                  <c:v>142</c:v>
                </c:pt>
                <c:pt idx="85">
                  <c:v>143</c:v>
                </c:pt>
                <c:pt idx="86">
                  <c:v>144</c:v>
                </c:pt>
                <c:pt idx="87">
                  <c:v>146</c:v>
                </c:pt>
                <c:pt idx="88">
                  <c:v>149</c:v>
                </c:pt>
                <c:pt idx="89">
                  <c:v>152</c:v>
                </c:pt>
                <c:pt idx="90">
                  <c:v>153</c:v>
                </c:pt>
                <c:pt idx="91">
                  <c:v>155</c:v>
                </c:pt>
                <c:pt idx="92">
                  <c:v>157</c:v>
                </c:pt>
                <c:pt idx="93">
                  <c:v>158</c:v>
                </c:pt>
                <c:pt idx="94">
                  <c:v>160</c:v>
                </c:pt>
                <c:pt idx="95">
                  <c:v>161</c:v>
                </c:pt>
                <c:pt idx="96">
                  <c:v>167</c:v>
                </c:pt>
                <c:pt idx="97">
                  <c:v>169</c:v>
                </c:pt>
                <c:pt idx="98">
                  <c:v>172</c:v>
                </c:pt>
                <c:pt idx="99">
                  <c:v>173</c:v>
                </c:pt>
                <c:pt idx="100">
                  <c:v>176</c:v>
                </c:pt>
                <c:pt idx="101">
                  <c:v>177</c:v>
                </c:pt>
                <c:pt idx="102">
                  <c:v>178</c:v>
                </c:pt>
                <c:pt idx="103">
                  <c:v>179</c:v>
                </c:pt>
                <c:pt idx="104">
                  <c:v>183</c:v>
                </c:pt>
                <c:pt idx="105">
                  <c:v>186</c:v>
                </c:pt>
                <c:pt idx="106">
                  <c:v>188</c:v>
                </c:pt>
                <c:pt idx="107">
                  <c:v>190</c:v>
                </c:pt>
                <c:pt idx="108">
                  <c:v>191</c:v>
                </c:pt>
                <c:pt idx="109">
                  <c:v>192</c:v>
                </c:pt>
                <c:pt idx="110">
                  <c:v>193</c:v>
                </c:pt>
                <c:pt idx="111">
                  <c:v>194</c:v>
                </c:pt>
                <c:pt idx="112">
                  <c:v>196</c:v>
                </c:pt>
                <c:pt idx="113">
                  <c:v>199</c:v>
                </c:pt>
                <c:pt idx="114">
                  <c:v>200</c:v>
                </c:pt>
                <c:pt idx="115">
                  <c:v>203</c:v>
                </c:pt>
                <c:pt idx="116">
                  <c:v>204</c:v>
                </c:pt>
                <c:pt idx="117">
                  <c:v>205</c:v>
                </c:pt>
                <c:pt idx="118">
                  <c:v>206</c:v>
                </c:pt>
                <c:pt idx="119">
                  <c:v>207</c:v>
                </c:pt>
                <c:pt idx="120">
                  <c:v>216</c:v>
                </c:pt>
                <c:pt idx="121">
                  <c:v>221</c:v>
                </c:pt>
                <c:pt idx="122">
                  <c:v>223</c:v>
                </c:pt>
                <c:pt idx="123">
                  <c:v>224</c:v>
                </c:pt>
                <c:pt idx="124">
                  <c:v>225</c:v>
                </c:pt>
                <c:pt idx="125">
                  <c:v>226</c:v>
                </c:pt>
                <c:pt idx="126">
                  <c:v>231</c:v>
                </c:pt>
                <c:pt idx="127">
                  <c:v>232</c:v>
                </c:pt>
                <c:pt idx="128">
                  <c:v>237</c:v>
                </c:pt>
                <c:pt idx="129">
                  <c:v>238</c:v>
                </c:pt>
                <c:pt idx="130">
                  <c:v>239</c:v>
                </c:pt>
                <c:pt idx="131">
                  <c:v>240</c:v>
                </c:pt>
                <c:pt idx="132">
                  <c:v>241</c:v>
                </c:pt>
                <c:pt idx="133">
                  <c:v>242</c:v>
                </c:pt>
                <c:pt idx="134">
                  <c:v>243</c:v>
                </c:pt>
                <c:pt idx="135">
                  <c:v>246</c:v>
                </c:pt>
                <c:pt idx="136">
                  <c:v>247</c:v>
                </c:pt>
                <c:pt idx="137">
                  <c:v>250</c:v>
                </c:pt>
                <c:pt idx="138">
                  <c:v>251</c:v>
                </c:pt>
                <c:pt idx="139">
                  <c:v>252</c:v>
                </c:pt>
                <c:pt idx="140">
                  <c:v>253</c:v>
                </c:pt>
                <c:pt idx="141">
                  <c:v>254</c:v>
                </c:pt>
                <c:pt idx="142">
                  <c:v>255</c:v>
                </c:pt>
                <c:pt idx="143">
                  <c:v>256</c:v>
                </c:pt>
                <c:pt idx="144">
                  <c:v>258</c:v>
                </c:pt>
                <c:pt idx="145">
                  <c:v>259</c:v>
                </c:pt>
                <c:pt idx="146">
                  <c:v>260</c:v>
                </c:pt>
                <c:pt idx="147">
                  <c:v>261</c:v>
                </c:pt>
                <c:pt idx="148">
                  <c:v>262</c:v>
                </c:pt>
                <c:pt idx="149">
                  <c:v>266</c:v>
                </c:pt>
                <c:pt idx="150">
                  <c:v>267</c:v>
                </c:pt>
                <c:pt idx="151">
                  <c:v>271</c:v>
                </c:pt>
                <c:pt idx="152">
                  <c:v>272</c:v>
                </c:pt>
                <c:pt idx="153">
                  <c:v>274</c:v>
                </c:pt>
                <c:pt idx="154">
                  <c:v>275</c:v>
                </c:pt>
                <c:pt idx="155">
                  <c:v>276</c:v>
                </c:pt>
                <c:pt idx="156">
                  <c:v>279</c:v>
                </c:pt>
                <c:pt idx="157">
                  <c:v>281</c:v>
                </c:pt>
                <c:pt idx="158">
                  <c:v>283</c:v>
                </c:pt>
                <c:pt idx="159">
                  <c:v>288</c:v>
                </c:pt>
                <c:pt idx="160">
                  <c:v>289</c:v>
                </c:pt>
                <c:pt idx="161">
                  <c:v>292</c:v>
                </c:pt>
                <c:pt idx="162">
                  <c:v>293</c:v>
                </c:pt>
                <c:pt idx="163">
                  <c:v>294</c:v>
                </c:pt>
                <c:pt idx="164">
                  <c:v>295</c:v>
                </c:pt>
                <c:pt idx="165">
                  <c:v>301</c:v>
                </c:pt>
                <c:pt idx="166">
                  <c:v>302</c:v>
                </c:pt>
                <c:pt idx="167">
                  <c:v>304</c:v>
                </c:pt>
                <c:pt idx="168">
                  <c:v>305</c:v>
                </c:pt>
                <c:pt idx="169">
                  <c:v>307</c:v>
                </c:pt>
                <c:pt idx="170">
                  <c:v>308</c:v>
                </c:pt>
                <c:pt idx="171">
                  <c:v>309</c:v>
                </c:pt>
                <c:pt idx="172">
                  <c:v>312</c:v>
                </c:pt>
                <c:pt idx="173">
                  <c:v>316</c:v>
                </c:pt>
                <c:pt idx="174">
                  <c:v>317</c:v>
                </c:pt>
                <c:pt idx="175">
                  <c:v>319</c:v>
                </c:pt>
                <c:pt idx="176">
                  <c:v>320</c:v>
                </c:pt>
                <c:pt idx="177">
                  <c:v>321</c:v>
                </c:pt>
                <c:pt idx="178">
                  <c:v>323</c:v>
                </c:pt>
                <c:pt idx="179">
                  <c:v>324</c:v>
                </c:pt>
                <c:pt idx="180">
                  <c:v>325</c:v>
                </c:pt>
                <c:pt idx="181">
                  <c:v>327</c:v>
                </c:pt>
                <c:pt idx="182">
                  <c:v>329</c:v>
                </c:pt>
                <c:pt idx="183">
                  <c:v>331</c:v>
                </c:pt>
                <c:pt idx="184">
                  <c:v>332</c:v>
                </c:pt>
                <c:pt idx="185">
                  <c:v>334</c:v>
                </c:pt>
                <c:pt idx="186">
                  <c:v>338</c:v>
                </c:pt>
                <c:pt idx="187">
                  <c:v>339</c:v>
                </c:pt>
                <c:pt idx="188">
                  <c:v>342</c:v>
                </c:pt>
                <c:pt idx="189">
                  <c:v>343</c:v>
                </c:pt>
                <c:pt idx="190">
                  <c:v>346</c:v>
                </c:pt>
                <c:pt idx="191">
                  <c:v>347</c:v>
                </c:pt>
                <c:pt idx="192">
                  <c:v>348</c:v>
                </c:pt>
                <c:pt idx="193">
                  <c:v>351</c:v>
                </c:pt>
                <c:pt idx="194">
                  <c:v>352</c:v>
                </c:pt>
                <c:pt idx="195">
                  <c:v>353</c:v>
                </c:pt>
                <c:pt idx="196">
                  <c:v>354</c:v>
                </c:pt>
                <c:pt idx="197">
                  <c:v>359</c:v>
                </c:pt>
                <c:pt idx="198">
                  <c:v>361</c:v>
                </c:pt>
                <c:pt idx="199">
                  <c:v>362</c:v>
                </c:pt>
                <c:pt idx="200">
                  <c:v>364</c:v>
                </c:pt>
                <c:pt idx="201">
                  <c:v>365</c:v>
                </c:pt>
                <c:pt idx="202">
                  <c:v>367</c:v>
                </c:pt>
                <c:pt idx="203">
                  <c:v>369</c:v>
                </c:pt>
                <c:pt idx="204">
                  <c:v>370</c:v>
                </c:pt>
                <c:pt idx="205">
                  <c:v>371</c:v>
                </c:pt>
                <c:pt idx="206">
                  <c:v>372</c:v>
                </c:pt>
                <c:pt idx="207">
                  <c:v>374</c:v>
                </c:pt>
                <c:pt idx="208">
                  <c:v>375</c:v>
                </c:pt>
                <c:pt idx="209">
                  <c:v>376</c:v>
                </c:pt>
                <c:pt idx="210">
                  <c:v>377</c:v>
                </c:pt>
                <c:pt idx="211">
                  <c:v>378</c:v>
                </c:pt>
                <c:pt idx="212">
                  <c:v>379</c:v>
                </c:pt>
                <c:pt idx="213">
                  <c:v>382</c:v>
                </c:pt>
                <c:pt idx="214">
                  <c:v>385</c:v>
                </c:pt>
                <c:pt idx="215">
                  <c:v>387</c:v>
                </c:pt>
                <c:pt idx="216">
                  <c:v>388</c:v>
                </c:pt>
                <c:pt idx="217">
                  <c:v>390</c:v>
                </c:pt>
                <c:pt idx="218">
                  <c:v>391</c:v>
                </c:pt>
                <c:pt idx="219">
                  <c:v>395</c:v>
                </c:pt>
                <c:pt idx="220">
                  <c:v>399</c:v>
                </c:pt>
                <c:pt idx="221">
                  <c:v>401</c:v>
                </c:pt>
                <c:pt idx="222">
                  <c:v>403</c:v>
                </c:pt>
                <c:pt idx="223">
                  <c:v>407</c:v>
                </c:pt>
                <c:pt idx="224">
                  <c:v>408</c:v>
                </c:pt>
                <c:pt idx="225">
                  <c:v>411</c:v>
                </c:pt>
                <c:pt idx="226">
                  <c:v>416</c:v>
                </c:pt>
                <c:pt idx="227">
                  <c:v>417</c:v>
                </c:pt>
                <c:pt idx="228">
                  <c:v>422</c:v>
                </c:pt>
                <c:pt idx="229">
                  <c:v>423</c:v>
                </c:pt>
                <c:pt idx="230">
                  <c:v>425</c:v>
                </c:pt>
                <c:pt idx="231">
                  <c:v>426</c:v>
                </c:pt>
                <c:pt idx="232">
                  <c:v>428</c:v>
                </c:pt>
                <c:pt idx="233">
                  <c:v>432</c:v>
                </c:pt>
                <c:pt idx="234">
                  <c:v>434</c:v>
                </c:pt>
                <c:pt idx="235">
                  <c:v>435</c:v>
                </c:pt>
                <c:pt idx="236">
                  <c:v>437</c:v>
                </c:pt>
                <c:pt idx="237">
                  <c:v>438</c:v>
                </c:pt>
                <c:pt idx="238">
                  <c:v>443</c:v>
                </c:pt>
                <c:pt idx="239">
                  <c:v>444</c:v>
                </c:pt>
                <c:pt idx="240">
                  <c:v>445</c:v>
                </c:pt>
                <c:pt idx="241">
                  <c:v>446</c:v>
                </c:pt>
                <c:pt idx="242">
                  <c:v>447</c:v>
                </c:pt>
                <c:pt idx="243">
                  <c:v>448</c:v>
                </c:pt>
                <c:pt idx="244">
                  <c:v>452</c:v>
                </c:pt>
                <c:pt idx="245">
                  <c:v>453</c:v>
                </c:pt>
                <c:pt idx="246">
                  <c:v>456</c:v>
                </c:pt>
                <c:pt idx="247">
                  <c:v>458</c:v>
                </c:pt>
                <c:pt idx="248">
                  <c:v>459</c:v>
                </c:pt>
                <c:pt idx="249">
                  <c:v>467</c:v>
                </c:pt>
                <c:pt idx="250">
                  <c:v>468</c:v>
                </c:pt>
                <c:pt idx="251">
                  <c:v>469</c:v>
                </c:pt>
                <c:pt idx="252">
                  <c:v>471</c:v>
                </c:pt>
                <c:pt idx="253">
                  <c:v>473</c:v>
                </c:pt>
                <c:pt idx="254">
                  <c:v>478</c:v>
                </c:pt>
                <c:pt idx="255">
                  <c:v>481</c:v>
                </c:pt>
                <c:pt idx="256">
                  <c:v>482</c:v>
                </c:pt>
                <c:pt idx="257">
                  <c:v>483</c:v>
                </c:pt>
                <c:pt idx="258">
                  <c:v>484</c:v>
                </c:pt>
                <c:pt idx="259">
                  <c:v>485</c:v>
                </c:pt>
                <c:pt idx="260">
                  <c:v>486</c:v>
                </c:pt>
                <c:pt idx="261">
                  <c:v>489</c:v>
                </c:pt>
                <c:pt idx="262">
                  <c:v>490</c:v>
                </c:pt>
                <c:pt idx="263">
                  <c:v>491</c:v>
                </c:pt>
                <c:pt idx="264">
                  <c:v>492</c:v>
                </c:pt>
                <c:pt idx="265">
                  <c:v>493</c:v>
                </c:pt>
                <c:pt idx="266">
                  <c:v>495</c:v>
                </c:pt>
                <c:pt idx="267">
                  <c:v>497</c:v>
                </c:pt>
                <c:pt idx="268">
                  <c:v>501</c:v>
                </c:pt>
                <c:pt idx="269">
                  <c:v>502</c:v>
                </c:pt>
                <c:pt idx="270">
                  <c:v>504</c:v>
                </c:pt>
                <c:pt idx="271">
                  <c:v>506</c:v>
                </c:pt>
                <c:pt idx="272">
                  <c:v>507</c:v>
                </c:pt>
                <c:pt idx="273">
                  <c:v>513</c:v>
                </c:pt>
                <c:pt idx="274">
                  <c:v>514</c:v>
                </c:pt>
                <c:pt idx="275">
                  <c:v>516</c:v>
                </c:pt>
                <c:pt idx="276">
                  <c:v>517</c:v>
                </c:pt>
                <c:pt idx="277">
                  <c:v>520</c:v>
                </c:pt>
                <c:pt idx="278">
                  <c:v>521</c:v>
                </c:pt>
                <c:pt idx="279">
                  <c:v>525</c:v>
                </c:pt>
                <c:pt idx="280">
                  <c:v>526</c:v>
                </c:pt>
                <c:pt idx="281">
                  <c:v>528</c:v>
                </c:pt>
                <c:pt idx="282">
                  <c:v>531</c:v>
                </c:pt>
                <c:pt idx="283">
                  <c:v>532</c:v>
                </c:pt>
                <c:pt idx="284">
                  <c:v>533</c:v>
                </c:pt>
                <c:pt idx="285">
                  <c:v>536</c:v>
                </c:pt>
                <c:pt idx="286">
                  <c:v>537</c:v>
                </c:pt>
                <c:pt idx="287">
                  <c:v>538</c:v>
                </c:pt>
                <c:pt idx="288">
                  <c:v>545</c:v>
                </c:pt>
                <c:pt idx="289">
                  <c:v>549</c:v>
                </c:pt>
                <c:pt idx="290">
                  <c:v>550</c:v>
                </c:pt>
                <c:pt idx="291">
                  <c:v>551</c:v>
                </c:pt>
                <c:pt idx="292">
                  <c:v>552</c:v>
                </c:pt>
                <c:pt idx="293">
                  <c:v>553</c:v>
                </c:pt>
                <c:pt idx="294">
                  <c:v>554</c:v>
                </c:pt>
                <c:pt idx="295">
                  <c:v>555</c:v>
                </c:pt>
                <c:pt idx="296">
                  <c:v>558</c:v>
                </c:pt>
                <c:pt idx="297">
                  <c:v>560</c:v>
                </c:pt>
                <c:pt idx="298">
                  <c:v>561</c:v>
                </c:pt>
                <c:pt idx="299">
                  <c:v>562</c:v>
                </c:pt>
                <c:pt idx="300">
                  <c:v>566</c:v>
                </c:pt>
                <c:pt idx="301">
                  <c:v>569</c:v>
                </c:pt>
                <c:pt idx="302">
                  <c:v>570</c:v>
                </c:pt>
                <c:pt idx="303">
                  <c:v>576</c:v>
                </c:pt>
                <c:pt idx="304">
                  <c:v>577</c:v>
                </c:pt>
                <c:pt idx="305">
                  <c:v>580</c:v>
                </c:pt>
                <c:pt idx="306">
                  <c:v>581</c:v>
                </c:pt>
                <c:pt idx="307">
                  <c:v>583</c:v>
                </c:pt>
                <c:pt idx="308">
                  <c:v>584</c:v>
                </c:pt>
                <c:pt idx="309">
                  <c:v>586</c:v>
                </c:pt>
                <c:pt idx="310">
                  <c:v>587</c:v>
                </c:pt>
                <c:pt idx="311">
                  <c:v>588</c:v>
                </c:pt>
                <c:pt idx="312">
                  <c:v>596</c:v>
                </c:pt>
                <c:pt idx="313">
                  <c:v>597</c:v>
                </c:pt>
                <c:pt idx="314">
                  <c:v>598</c:v>
                </c:pt>
                <c:pt idx="315">
                  <c:v>601</c:v>
                </c:pt>
                <c:pt idx="316">
                  <c:v>602</c:v>
                </c:pt>
                <c:pt idx="317">
                  <c:v>603</c:v>
                </c:pt>
                <c:pt idx="318">
                  <c:v>607</c:v>
                </c:pt>
                <c:pt idx="319">
                  <c:v>608</c:v>
                </c:pt>
                <c:pt idx="320">
                  <c:v>609</c:v>
                </c:pt>
                <c:pt idx="321">
                  <c:v>611</c:v>
                </c:pt>
                <c:pt idx="322">
                  <c:v>614</c:v>
                </c:pt>
                <c:pt idx="323">
                  <c:v>617</c:v>
                </c:pt>
                <c:pt idx="324">
                  <c:v>618</c:v>
                </c:pt>
                <c:pt idx="325">
                  <c:v>623</c:v>
                </c:pt>
                <c:pt idx="326">
                  <c:v>624</c:v>
                </c:pt>
                <c:pt idx="327">
                  <c:v>625</c:v>
                </c:pt>
                <c:pt idx="328">
                  <c:v>628</c:v>
                </c:pt>
                <c:pt idx="329">
                  <c:v>629</c:v>
                </c:pt>
                <c:pt idx="330">
                  <c:v>630</c:v>
                </c:pt>
                <c:pt idx="331">
                  <c:v>636</c:v>
                </c:pt>
                <c:pt idx="332">
                  <c:v>637</c:v>
                </c:pt>
                <c:pt idx="333">
                  <c:v>638</c:v>
                </c:pt>
                <c:pt idx="334">
                  <c:v>639</c:v>
                </c:pt>
                <c:pt idx="335">
                  <c:v>640</c:v>
                </c:pt>
                <c:pt idx="336">
                  <c:v>642</c:v>
                </c:pt>
                <c:pt idx="337">
                  <c:v>644</c:v>
                </c:pt>
                <c:pt idx="338">
                  <c:v>645</c:v>
                </c:pt>
                <c:pt idx="339">
                  <c:v>646</c:v>
                </c:pt>
                <c:pt idx="340">
                  <c:v>648</c:v>
                </c:pt>
                <c:pt idx="341">
                  <c:v>649</c:v>
                </c:pt>
                <c:pt idx="342">
                  <c:v>650</c:v>
                </c:pt>
                <c:pt idx="343">
                  <c:v>651</c:v>
                </c:pt>
                <c:pt idx="344">
                  <c:v>652</c:v>
                </c:pt>
                <c:pt idx="345">
                  <c:v>653</c:v>
                </c:pt>
                <c:pt idx="346">
                  <c:v>657</c:v>
                </c:pt>
                <c:pt idx="347">
                  <c:v>659</c:v>
                </c:pt>
                <c:pt idx="348">
                  <c:v>661</c:v>
                </c:pt>
                <c:pt idx="349">
                  <c:v>665</c:v>
                </c:pt>
                <c:pt idx="350">
                  <c:v>666</c:v>
                </c:pt>
                <c:pt idx="351">
                  <c:v>668</c:v>
                </c:pt>
                <c:pt idx="352">
                  <c:v>669</c:v>
                </c:pt>
                <c:pt idx="353">
                  <c:v>671</c:v>
                </c:pt>
                <c:pt idx="354">
                  <c:v>682</c:v>
                </c:pt>
                <c:pt idx="355">
                  <c:v>684</c:v>
                </c:pt>
                <c:pt idx="356">
                  <c:v>692</c:v>
                </c:pt>
                <c:pt idx="357">
                  <c:v>694</c:v>
                </c:pt>
                <c:pt idx="358">
                  <c:v>696</c:v>
                </c:pt>
                <c:pt idx="359">
                  <c:v>704</c:v>
                </c:pt>
                <c:pt idx="360">
                  <c:v>705</c:v>
                </c:pt>
                <c:pt idx="361">
                  <c:v>708</c:v>
                </c:pt>
                <c:pt idx="362">
                  <c:v>709</c:v>
                </c:pt>
                <c:pt idx="363">
                  <c:v>710</c:v>
                </c:pt>
                <c:pt idx="364">
                  <c:v>711</c:v>
                </c:pt>
                <c:pt idx="365">
                  <c:v>712</c:v>
                </c:pt>
                <c:pt idx="366">
                  <c:v>715</c:v>
                </c:pt>
                <c:pt idx="367">
                  <c:v>717</c:v>
                </c:pt>
                <c:pt idx="368">
                  <c:v>720</c:v>
                </c:pt>
                <c:pt idx="369">
                  <c:v>723</c:v>
                </c:pt>
                <c:pt idx="370">
                  <c:v>724</c:v>
                </c:pt>
                <c:pt idx="371">
                  <c:v>727</c:v>
                </c:pt>
                <c:pt idx="372">
                  <c:v>728</c:v>
                </c:pt>
                <c:pt idx="373">
                  <c:v>730</c:v>
                </c:pt>
                <c:pt idx="374">
                  <c:v>731</c:v>
                </c:pt>
                <c:pt idx="375">
                  <c:v>732</c:v>
                </c:pt>
                <c:pt idx="376">
                  <c:v>733</c:v>
                </c:pt>
                <c:pt idx="377">
                  <c:v>736</c:v>
                </c:pt>
                <c:pt idx="378">
                  <c:v>744</c:v>
                </c:pt>
                <c:pt idx="379">
                  <c:v>745</c:v>
                </c:pt>
                <c:pt idx="380">
                  <c:v>746</c:v>
                </c:pt>
                <c:pt idx="381">
                  <c:v>747</c:v>
                </c:pt>
                <c:pt idx="382">
                  <c:v>750</c:v>
                </c:pt>
                <c:pt idx="383">
                  <c:v>753</c:v>
                </c:pt>
                <c:pt idx="384">
                  <c:v>758</c:v>
                </c:pt>
                <c:pt idx="385">
                  <c:v>759</c:v>
                </c:pt>
                <c:pt idx="386">
                  <c:v>760</c:v>
                </c:pt>
                <c:pt idx="387">
                  <c:v>762</c:v>
                </c:pt>
                <c:pt idx="388">
                  <c:v>764</c:v>
                </c:pt>
                <c:pt idx="389">
                  <c:v>765</c:v>
                </c:pt>
                <c:pt idx="390">
                  <c:v>768</c:v>
                </c:pt>
                <c:pt idx="391">
                  <c:v>769</c:v>
                </c:pt>
                <c:pt idx="392">
                  <c:v>774</c:v>
                </c:pt>
                <c:pt idx="393">
                  <c:v>775</c:v>
                </c:pt>
                <c:pt idx="394">
                  <c:v>778</c:v>
                </c:pt>
                <c:pt idx="395">
                  <c:v>779</c:v>
                </c:pt>
                <c:pt idx="396">
                  <c:v>780</c:v>
                </c:pt>
                <c:pt idx="397">
                  <c:v>783</c:v>
                </c:pt>
                <c:pt idx="398">
                  <c:v>784</c:v>
                </c:pt>
                <c:pt idx="399">
                  <c:v>785</c:v>
                </c:pt>
                <c:pt idx="400">
                  <c:v>787</c:v>
                </c:pt>
                <c:pt idx="401">
                  <c:v>792</c:v>
                </c:pt>
                <c:pt idx="402">
                  <c:v>797</c:v>
                </c:pt>
                <c:pt idx="403">
                  <c:v>799</c:v>
                </c:pt>
                <c:pt idx="404">
                  <c:v>800</c:v>
                </c:pt>
                <c:pt idx="405">
                  <c:v>801</c:v>
                </c:pt>
                <c:pt idx="406">
                  <c:v>803</c:v>
                </c:pt>
                <c:pt idx="407">
                  <c:v>804</c:v>
                </c:pt>
                <c:pt idx="408">
                  <c:v>805</c:v>
                </c:pt>
                <c:pt idx="409">
                  <c:v>809</c:v>
                </c:pt>
                <c:pt idx="410">
                  <c:v>810</c:v>
                </c:pt>
                <c:pt idx="411">
                  <c:v>811</c:v>
                </c:pt>
                <c:pt idx="412">
                  <c:v>812</c:v>
                </c:pt>
                <c:pt idx="413">
                  <c:v>813</c:v>
                </c:pt>
                <c:pt idx="414">
                  <c:v>816</c:v>
                </c:pt>
                <c:pt idx="415">
                  <c:v>818</c:v>
                </c:pt>
                <c:pt idx="416">
                  <c:v>819</c:v>
                </c:pt>
                <c:pt idx="417">
                  <c:v>825</c:v>
                </c:pt>
                <c:pt idx="418">
                  <c:v>826</c:v>
                </c:pt>
                <c:pt idx="419">
                  <c:v>827</c:v>
                </c:pt>
                <c:pt idx="420">
                  <c:v>834</c:v>
                </c:pt>
                <c:pt idx="421">
                  <c:v>836</c:v>
                </c:pt>
                <c:pt idx="422">
                  <c:v>837</c:v>
                </c:pt>
                <c:pt idx="423">
                  <c:v>842</c:v>
                </c:pt>
                <c:pt idx="424">
                  <c:v>843</c:v>
                </c:pt>
                <c:pt idx="425">
                  <c:v>844</c:v>
                </c:pt>
                <c:pt idx="426">
                  <c:v>845</c:v>
                </c:pt>
                <c:pt idx="427">
                  <c:v>846</c:v>
                </c:pt>
                <c:pt idx="428">
                  <c:v>851</c:v>
                </c:pt>
                <c:pt idx="429">
                  <c:v>852</c:v>
                </c:pt>
                <c:pt idx="430">
                  <c:v>853</c:v>
                </c:pt>
                <c:pt idx="431">
                  <c:v>854</c:v>
                </c:pt>
                <c:pt idx="432">
                  <c:v>858</c:v>
                </c:pt>
                <c:pt idx="433">
                  <c:v>859</c:v>
                </c:pt>
                <c:pt idx="434">
                  <c:v>861</c:v>
                </c:pt>
                <c:pt idx="435">
                  <c:v>862</c:v>
                </c:pt>
                <c:pt idx="436">
                  <c:v>865</c:v>
                </c:pt>
                <c:pt idx="437">
                  <c:v>867</c:v>
                </c:pt>
                <c:pt idx="438">
                  <c:v>868</c:v>
                </c:pt>
                <c:pt idx="439">
                  <c:v>870</c:v>
                </c:pt>
                <c:pt idx="440">
                  <c:v>871</c:v>
                </c:pt>
                <c:pt idx="441">
                  <c:v>873</c:v>
                </c:pt>
                <c:pt idx="442">
                  <c:v>874</c:v>
                </c:pt>
                <c:pt idx="443">
                  <c:v>875</c:v>
                </c:pt>
                <c:pt idx="444">
                  <c:v>876</c:v>
                </c:pt>
                <c:pt idx="445">
                  <c:v>877</c:v>
                </c:pt>
                <c:pt idx="446">
                  <c:v>878</c:v>
                </c:pt>
                <c:pt idx="447">
                  <c:v>883</c:v>
                </c:pt>
                <c:pt idx="448">
                  <c:v>886</c:v>
                </c:pt>
                <c:pt idx="449">
                  <c:v>889</c:v>
                </c:pt>
                <c:pt idx="450">
                  <c:v>892</c:v>
                </c:pt>
                <c:pt idx="451">
                  <c:v>898</c:v>
                </c:pt>
                <c:pt idx="452">
                  <c:v>899</c:v>
                </c:pt>
                <c:pt idx="453">
                  <c:v>900</c:v>
                </c:pt>
                <c:pt idx="454">
                  <c:v>902</c:v>
                </c:pt>
                <c:pt idx="455">
                  <c:v>906</c:v>
                </c:pt>
                <c:pt idx="456">
                  <c:v>907</c:v>
                </c:pt>
                <c:pt idx="457">
                  <c:v>908</c:v>
                </c:pt>
                <c:pt idx="458">
                  <c:v>909</c:v>
                </c:pt>
                <c:pt idx="459">
                  <c:v>911</c:v>
                </c:pt>
                <c:pt idx="460">
                  <c:v>916</c:v>
                </c:pt>
                <c:pt idx="461">
                  <c:v>917</c:v>
                </c:pt>
                <c:pt idx="462">
                  <c:v>919</c:v>
                </c:pt>
                <c:pt idx="463">
                  <c:v>920</c:v>
                </c:pt>
                <c:pt idx="464">
                  <c:v>925</c:v>
                </c:pt>
                <c:pt idx="465">
                  <c:v>927</c:v>
                </c:pt>
                <c:pt idx="466">
                  <c:v>930</c:v>
                </c:pt>
                <c:pt idx="467">
                  <c:v>931</c:v>
                </c:pt>
                <c:pt idx="468">
                  <c:v>932</c:v>
                </c:pt>
                <c:pt idx="469">
                  <c:v>933</c:v>
                </c:pt>
                <c:pt idx="470">
                  <c:v>936</c:v>
                </c:pt>
                <c:pt idx="471">
                  <c:v>940</c:v>
                </c:pt>
                <c:pt idx="472">
                  <c:v>942</c:v>
                </c:pt>
                <c:pt idx="473">
                  <c:v>943</c:v>
                </c:pt>
                <c:pt idx="474">
                  <c:v>947</c:v>
                </c:pt>
                <c:pt idx="475">
                  <c:v>948</c:v>
                </c:pt>
                <c:pt idx="476">
                  <c:v>949</c:v>
                </c:pt>
                <c:pt idx="477">
                  <c:v>951</c:v>
                </c:pt>
                <c:pt idx="478">
                  <c:v>954</c:v>
                </c:pt>
                <c:pt idx="479">
                  <c:v>955</c:v>
                </c:pt>
                <c:pt idx="480">
                  <c:v>956</c:v>
                </c:pt>
                <c:pt idx="481">
                  <c:v>958</c:v>
                </c:pt>
                <c:pt idx="482">
                  <c:v>959</c:v>
                </c:pt>
                <c:pt idx="483">
                  <c:v>961</c:v>
                </c:pt>
                <c:pt idx="484">
                  <c:v>962</c:v>
                </c:pt>
                <c:pt idx="485">
                  <c:v>963</c:v>
                </c:pt>
                <c:pt idx="486">
                  <c:v>966</c:v>
                </c:pt>
                <c:pt idx="487">
                  <c:v>967</c:v>
                </c:pt>
                <c:pt idx="488">
                  <c:v>972</c:v>
                </c:pt>
                <c:pt idx="489">
                  <c:v>973</c:v>
                </c:pt>
                <c:pt idx="490">
                  <c:v>976</c:v>
                </c:pt>
                <c:pt idx="491">
                  <c:v>977</c:v>
                </c:pt>
                <c:pt idx="492">
                  <c:v>981</c:v>
                </c:pt>
                <c:pt idx="493">
                  <c:v>984</c:v>
                </c:pt>
                <c:pt idx="494">
                  <c:v>986</c:v>
                </c:pt>
                <c:pt idx="495">
                  <c:v>988</c:v>
                </c:pt>
                <c:pt idx="496">
                  <c:v>989</c:v>
                </c:pt>
                <c:pt idx="497">
                  <c:v>990</c:v>
                </c:pt>
                <c:pt idx="498">
                  <c:v>991</c:v>
                </c:pt>
                <c:pt idx="499">
                  <c:v>992</c:v>
                </c:pt>
                <c:pt idx="500">
                  <c:v>993</c:v>
                </c:pt>
                <c:pt idx="501">
                  <c:v>995</c:v>
                </c:pt>
                <c:pt idx="502">
                  <c:v>996</c:v>
                </c:pt>
                <c:pt idx="503">
                  <c:v>997</c:v>
                </c:pt>
                <c:pt idx="504">
                  <c:v>998</c:v>
                </c:pt>
                <c:pt idx="505">
                  <c:v>999</c:v>
                </c:pt>
                <c:pt idx="506">
                  <c:v>1000</c:v>
                </c:pt>
                <c:pt idx="507">
                  <c:v>1002</c:v>
                </c:pt>
                <c:pt idx="508">
                  <c:v>1003</c:v>
                </c:pt>
                <c:pt idx="509">
                  <c:v>1004</c:v>
                </c:pt>
                <c:pt idx="510">
                  <c:v>1009</c:v>
                </c:pt>
                <c:pt idx="511">
                  <c:v>1011</c:v>
                </c:pt>
                <c:pt idx="512">
                  <c:v>1012</c:v>
                </c:pt>
                <c:pt idx="513">
                  <c:v>1013</c:v>
                </c:pt>
                <c:pt idx="514">
                  <c:v>1014</c:v>
                </c:pt>
                <c:pt idx="515">
                  <c:v>1015</c:v>
                </c:pt>
                <c:pt idx="516">
                  <c:v>1018</c:v>
                </c:pt>
                <c:pt idx="517">
                  <c:v>1021</c:v>
                </c:pt>
                <c:pt idx="518">
                  <c:v>1022</c:v>
                </c:pt>
                <c:pt idx="519">
                  <c:v>1023</c:v>
                </c:pt>
                <c:pt idx="520">
                  <c:v>1026</c:v>
                </c:pt>
                <c:pt idx="521">
                  <c:v>1029</c:v>
                </c:pt>
                <c:pt idx="522">
                  <c:v>1031</c:v>
                </c:pt>
                <c:pt idx="523">
                  <c:v>1032</c:v>
                </c:pt>
                <c:pt idx="524">
                  <c:v>1034</c:v>
                </c:pt>
                <c:pt idx="525">
                  <c:v>1035</c:v>
                </c:pt>
                <c:pt idx="526">
                  <c:v>1037</c:v>
                </c:pt>
                <c:pt idx="527">
                  <c:v>1039</c:v>
                </c:pt>
                <c:pt idx="528">
                  <c:v>1041</c:v>
                </c:pt>
                <c:pt idx="529">
                  <c:v>1044</c:v>
                </c:pt>
                <c:pt idx="530">
                  <c:v>1048</c:v>
                </c:pt>
                <c:pt idx="531">
                  <c:v>1050</c:v>
                </c:pt>
                <c:pt idx="532">
                  <c:v>1052</c:v>
                </c:pt>
                <c:pt idx="533">
                  <c:v>1055</c:v>
                </c:pt>
                <c:pt idx="534">
                  <c:v>1056</c:v>
                </c:pt>
                <c:pt idx="535">
                  <c:v>1059</c:v>
                </c:pt>
                <c:pt idx="536">
                  <c:v>1060</c:v>
                </c:pt>
                <c:pt idx="537">
                  <c:v>1062</c:v>
                </c:pt>
                <c:pt idx="538">
                  <c:v>1063</c:v>
                </c:pt>
                <c:pt idx="539">
                  <c:v>1064</c:v>
                </c:pt>
                <c:pt idx="540">
                  <c:v>1067</c:v>
                </c:pt>
                <c:pt idx="541">
                  <c:v>1068</c:v>
                </c:pt>
                <c:pt idx="542">
                  <c:v>1074</c:v>
                </c:pt>
                <c:pt idx="543">
                  <c:v>1075</c:v>
                </c:pt>
                <c:pt idx="544">
                  <c:v>1076</c:v>
                </c:pt>
                <c:pt idx="545">
                  <c:v>1078</c:v>
                </c:pt>
                <c:pt idx="546">
                  <c:v>1080</c:v>
                </c:pt>
                <c:pt idx="547">
                  <c:v>1085</c:v>
                </c:pt>
                <c:pt idx="548">
                  <c:v>1086</c:v>
                </c:pt>
                <c:pt idx="549">
                  <c:v>1092</c:v>
                </c:pt>
                <c:pt idx="550">
                  <c:v>1093</c:v>
                </c:pt>
                <c:pt idx="551">
                  <c:v>1097</c:v>
                </c:pt>
                <c:pt idx="552">
                  <c:v>1099</c:v>
                </c:pt>
                <c:pt idx="553">
                  <c:v>1101</c:v>
                </c:pt>
                <c:pt idx="554">
                  <c:v>1104</c:v>
                </c:pt>
                <c:pt idx="555">
                  <c:v>1105</c:v>
                </c:pt>
                <c:pt idx="556">
                  <c:v>1106</c:v>
                </c:pt>
                <c:pt idx="557">
                  <c:v>1107</c:v>
                </c:pt>
                <c:pt idx="558">
                  <c:v>1108</c:v>
                </c:pt>
                <c:pt idx="559">
                  <c:v>1109</c:v>
                </c:pt>
                <c:pt idx="560">
                  <c:v>1110</c:v>
                </c:pt>
                <c:pt idx="561">
                  <c:v>1113</c:v>
                </c:pt>
                <c:pt idx="562">
                  <c:v>1114</c:v>
                </c:pt>
                <c:pt idx="563">
                  <c:v>1116</c:v>
                </c:pt>
                <c:pt idx="564">
                  <c:v>1117</c:v>
                </c:pt>
                <c:pt idx="565">
                  <c:v>1118</c:v>
                </c:pt>
                <c:pt idx="566">
                  <c:v>1125</c:v>
                </c:pt>
                <c:pt idx="567">
                  <c:v>1127</c:v>
                </c:pt>
                <c:pt idx="568">
                  <c:v>1129</c:v>
                </c:pt>
                <c:pt idx="569">
                  <c:v>1133</c:v>
                </c:pt>
                <c:pt idx="570">
                  <c:v>1134</c:v>
                </c:pt>
                <c:pt idx="571">
                  <c:v>1135</c:v>
                </c:pt>
                <c:pt idx="572">
                  <c:v>1137</c:v>
                </c:pt>
                <c:pt idx="573">
                  <c:v>1138</c:v>
                </c:pt>
                <c:pt idx="574">
                  <c:v>1139</c:v>
                </c:pt>
                <c:pt idx="575">
                  <c:v>1141</c:v>
                </c:pt>
                <c:pt idx="576">
                  <c:v>1142</c:v>
                </c:pt>
                <c:pt idx="577">
                  <c:v>1145</c:v>
                </c:pt>
                <c:pt idx="578">
                  <c:v>1146</c:v>
                </c:pt>
                <c:pt idx="579">
                  <c:v>1147</c:v>
                </c:pt>
                <c:pt idx="580">
                  <c:v>1149</c:v>
                </c:pt>
                <c:pt idx="581">
                  <c:v>1150</c:v>
                </c:pt>
                <c:pt idx="582">
                  <c:v>1152</c:v>
                </c:pt>
                <c:pt idx="583">
                  <c:v>1153</c:v>
                </c:pt>
                <c:pt idx="584">
                  <c:v>1154</c:v>
                </c:pt>
                <c:pt idx="585">
                  <c:v>1158</c:v>
                </c:pt>
                <c:pt idx="586">
                  <c:v>1161</c:v>
                </c:pt>
                <c:pt idx="587">
                  <c:v>1164</c:v>
                </c:pt>
                <c:pt idx="588">
                  <c:v>1165</c:v>
                </c:pt>
                <c:pt idx="589">
                  <c:v>1166</c:v>
                </c:pt>
                <c:pt idx="590">
                  <c:v>1168</c:v>
                </c:pt>
                <c:pt idx="591">
                  <c:v>1169</c:v>
                </c:pt>
                <c:pt idx="592">
                  <c:v>1170</c:v>
                </c:pt>
                <c:pt idx="593">
                  <c:v>1171</c:v>
                </c:pt>
                <c:pt idx="594">
                  <c:v>1172</c:v>
                </c:pt>
                <c:pt idx="595">
                  <c:v>1175</c:v>
                </c:pt>
                <c:pt idx="596">
                  <c:v>1176</c:v>
                </c:pt>
                <c:pt idx="597">
                  <c:v>1177</c:v>
                </c:pt>
                <c:pt idx="598">
                  <c:v>1180</c:v>
                </c:pt>
                <c:pt idx="599">
                  <c:v>1181</c:v>
                </c:pt>
                <c:pt idx="600">
                  <c:v>1182</c:v>
                </c:pt>
                <c:pt idx="601">
                  <c:v>1184</c:v>
                </c:pt>
                <c:pt idx="602">
                  <c:v>1186</c:v>
                </c:pt>
                <c:pt idx="603">
                  <c:v>1192</c:v>
                </c:pt>
                <c:pt idx="604">
                  <c:v>1194</c:v>
                </c:pt>
                <c:pt idx="605">
                  <c:v>1195</c:v>
                </c:pt>
                <c:pt idx="606">
                  <c:v>1197</c:v>
                </c:pt>
                <c:pt idx="607">
                  <c:v>1198</c:v>
                </c:pt>
                <c:pt idx="608">
                  <c:v>1199</c:v>
                </c:pt>
                <c:pt idx="609">
                  <c:v>1205</c:v>
                </c:pt>
                <c:pt idx="610">
                  <c:v>1208</c:v>
                </c:pt>
                <c:pt idx="611">
                  <c:v>1213</c:v>
                </c:pt>
                <c:pt idx="612">
                  <c:v>1214</c:v>
                </c:pt>
                <c:pt idx="613">
                  <c:v>1218</c:v>
                </c:pt>
                <c:pt idx="614">
                  <c:v>1219</c:v>
                </c:pt>
                <c:pt idx="615">
                  <c:v>1221</c:v>
                </c:pt>
                <c:pt idx="616">
                  <c:v>1222</c:v>
                </c:pt>
                <c:pt idx="617">
                  <c:v>1223</c:v>
                </c:pt>
                <c:pt idx="618">
                  <c:v>1230</c:v>
                </c:pt>
                <c:pt idx="619">
                  <c:v>1231</c:v>
                </c:pt>
                <c:pt idx="620">
                  <c:v>1234</c:v>
                </c:pt>
                <c:pt idx="621">
                  <c:v>1240</c:v>
                </c:pt>
                <c:pt idx="622">
                  <c:v>1245</c:v>
                </c:pt>
                <c:pt idx="623">
                  <c:v>1247</c:v>
                </c:pt>
                <c:pt idx="624">
                  <c:v>1248</c:v>
                </c:pt>
                <c:pt idx="625">
                  <c:v>1250</c:v>
                </c:pt>
                <c:pt idx="626">
                  <c:v>1251</c:v>
                </c:pt>
                <c:pt idx="627">
                  <c:v>1253</c:v>
                </c:pt>
                <c:pt idx="628">
                  <c:v>1254</c:v>
                </c:pt>
                <c:pt idx="629">
                  <c:v>1257</c:v>
                </c:pt>
                <c:pt idx="630">
                  <c:v>1258</c:v>
                </c:pt>
                <c:pt idx="631">
                  <c:v>1260</c:v>
                </c:pt>
                <c:pt idx="632">
                  <c:v>1261</c:v>
                </c:pt>
                <c:pt idx="633">
                  <c:v>1262</c:v>
                </c:pt>
                <c:pt idx="634">
                  <c:v>1263</c:v>
                </c:pt>
                <c:pt idx="635">
                  <c:v>1264</c:v>
                </c:pt>
                <c:pt idx="636">
                  <c:v>1265</c:v>
                </c:pt>
                <c:pt idx="637">
                  <c:v>1267</c:v>
                </c:pt>
                <c:pt idx="638">
                  <c:v>1268</c:v>
                </c:pt>
                <c:pt idx="639">
                  <c:v>1269</c:v>
                </c:pt>
                <c:pt idx="640">
                  <c:v>1270</c:v>
                </c:pt>
                <c:pt idx="641">
                  <c:v>1274</c:v>
                </c:pt>
                <c:pt idx="642">
                  <c:v>1275</c:v>
                </c:pt>
                <c:pt idx="643">
                  <c:v>1276</c:v>
                </c:pt>
                <c:pt idx="644">
                  <c:v>1279</c:v>
                </c:pt>
                <c:pt idx="645">
                  <c:v>1281</c:v>
                </c:pt>
                <c:pt idx="646">
                  <c:v>1282</c:v>
                </c:pt>
                <c:pt idx="647">
                  <c:v>1284</c:v>
                </c:pt>
                <c:pt idx="648">
                  <c:v>1285</c:v>
                </c:pt>
                <c:pt idx="649">
                  <c:v>1286</c:v>
                </c:pt>
                <c:pt idx="650">
                  <c:v>1287</c:v>
                </c:pt>
                <c:pt idx="651">
                  <c:v>1288</c:v>
                </c:pt>
                <c:pt idx="652">
                  <c:v>1290</c:v>
                </c:pt>
                <c:pt idx="653">
                  <c:v>1293</c:v>
                </c:pt>
                <c:pt idx="654">
                  <c:v>1294</c:v>
                </c:pt>
                <c:pt idx="655">
                  <c:v>1295</c:v>
                </c:pt>
                <c:pt idx="656">
                  <c:v>1301</c:v>
                </c:pt>
                <c:pt idx="657">
                  <c:v>1302</c:v>
                </c:pt>
                <c:pt idx="658">
                  <c:v>1303</c:v>
                </c:pt>
                <c:pt idx="659">
                  <c:v>1304</c:v>
                </c:pt>
                <c:pt idx="660">
                  <c:v>1305</c:v>
                </c:pt>
                <c:pt idx="661">
                  <c:v>1306</c:v>
                </c:pt>
                <c:pt idx="662">
                  <c:v>1308</c:v>
                </c:pt>
                <c:pt idx="663">
                  <c:v>1309</c:v>
                </c:pt>
                <c:pt idx="664">
                  <c:v>1311</c:v>
                </c:pt>
                <c:pt idx="665">
                  <c:v>1312</c:v>
                </c:pt>
                <c:pt idx="666">
                  <c:v>1313</c:v>
                </c:pt>
                <c:pt idx="667">
                  <c:v>1314</c:v>
                </c:pt>
                <c:pt idx="668">
                  <c:v>1315</c:v>
                </c:pt>
                <c:pt idx="669">
                  <c:v>1324</c:v>
                </c:pt>
                <c:pt idx="670">
                  <c:v>1325</c:v>
                </c:pt>
                <c:pt idx="671">
                  <c:v>1327</c:v>
                </c:pt>
                <c:pt idx="672">
                  <c:v>1330</c:v>
                </c:pt>
                <c:pt idx="673">
                  <c:v>1331</c:v>
                </c:pt>
                <c:pt idx="674">
                  <c:v>1332</c:v>
                </c:pt>
                <c:pt idx="675">
                  <c:v>1335</c:v>
                </c:pt>
                <c:pt idx="676">
                  <c:v>1339</c:v>
                </c:pt>
                <c:pt idx="677">
                  <c:v>1341</c:v>
                </c:pt>
                <c:pt idx="678">
                  <c:v>1342</c:v>
                </c:pt>
                <c:pt idx="679">
                  <c:v>1343</c:v>
                </c:pt>
                <c:pt idx="680">
                  <c:v>1344</c:v>
                </c:pt>
                <c:pt idx="681">
                  <c:v>1345</c:v>
                </c:pt>
                <c:pt idx="682">
                  <c:v>1348</c:v>
                </c:pt>
                <c:pt idx="683">
                  <c:v>1350</c:v>
                </c:pt>
                <c:pt idx="684">
                  <c:v>1352</c:v>
                </c:pt>
                <c:pt idx="685">
                  <c:v>1354</c:v>
                </c:pt>
                <c:pt idx="686">
                  <c:v>1355</c:v>
                </c:pt>
                <c:pt idx="687">
                  <c:v>1356</c:v>
                </c:pt>
                <c:pt idx="688">
                  <c:v>1357</c:v>
                </c:pt>
                <c:pt idx="689">
                  <c:v>1358</c:v>
                </c:pt>
                <c:pt idx="690">
                  <c:v>1361</c:v>
                </c:pt>
                <c:pt idx="691">
                  <c:v>1362</c:v>
                </c:pt>
                <c:pt idx="692">
                  <c:v>1366</c:v>
                </c:pt>
                <c:pt idx="693">
                  <c:v>1368</c:v>
                </c:pt>
                <c:pt idx="694">
                  <c:v>1371</c:v>
                </c:pt>
                <c:pt idx="695">
                  <c:v>1372</c:v>
                </c:pt>
                <c:pt idx="696">
                  <c:v>1373</c:v>
                </c:pt>
                <c:pt idx="697">
                  <c:v>1374</c:v>
                </c:pt>
                <c:pt idx="698">
                  <c:v>1375</c:v>
                </c:pt>
                <c:pt idx="699">
                  <c:v>1376</c:v>
                </c:pt>
                <c:pt idx="700">
                  <c:v>1377</c:v>
                </c:pt>
                <c:pt idx="701">
                  <c:v>1378</c:v>
                </c:pt>
              </c:numCache>
            </c:numRef>
          </c:xVal>
          <c:yVal>
            <c:numRef>
              <c:f>'RNA2 DMS'!$D$2:$D$1424</c:f>
              <c:numCache>
                <c:formatCode>General</c:formatCode>
                <c:ptCount val="1423"/>
                <c:pt idx="0">
                  <c:v>0</c:v>
                </c:pt>
                <c:pt idx="1">
                  <c:v>4.3649061545200001E-4</c:v>
                </c:pt>
                <c:pt idx="2">
                  <c:v>2.1701388888900001E-3</c:v>
                </c:pt>
                <c:pt idx="3">
                  <c:v>3.0211480362499999E-3</c:v>
                </c:pt>
                <c:pt idx="4">
                  <c:v>1.20288692863E-3</c:v>
                </c:pt>
                <c:pt idx="5">
                  <c:v>5.1999999999999998E-3</c:v>
                </c:pt>
                <c:pt idx="6">
                  <c:v>1.5590894917399999E-3</c:v>
                </c:pt>
                <c:pt idx="7">
                  <c:v>1.54281306248E-3</c:v>
                </c:pt>
                <c:pt idx="8">
                  <c:v>2.34741784038E-4</c:v>
                </c:pt>
                <c:pt idx="9">
                  <c:v>1.1636025133800001E-3</c:v>
                </c:pt>
                <c:pt idx="10">
                  <c:v>4.4863167339599999E-4</c:v>
                </c:pt>
                <c:pt idx="11">
                  <c:v>4.6370967741899999E-2</c:v>
                </c:pt>
                <c:pt idx="12">
                  <c:v>2.4890829694299999E-2</c:v>
                </c:pt>
                <c:pt idx="13">
                  <c:v>1.5283842794799999E-3</c:v>
                </c:pt>
                <c:pt idx="14">
                  <c:v>4.3318171973099999E-4</c:v>
                </c:pt>
                <c:pt idx="15">
                  <c:v>5.9009483666999998E-3</c:v>
                </c:pt>
                <c:pt idx="16">
                  <c:v>1.4718250630799999E-3</c:v>
                </c:pt>
                <c:pt idx="17">
                  <c:v>2.0828993959600001E-3</c:v>
                </c:pt>
                <c:pt idx="18">
                  <c:v>2.5777348155299998E-3</c:v>
                </c:pt>
                <c:pt idx="19">
                  <c:v>9.8760013167999996E-4</c:v>
                </c:pt>
                <c:pt idx="20">
                  <c:v>6.5552277941699998E-4</c:v>
                </c:pt>
                <c:pt idx="21">
                  <c:v>1.06814783166E-3</c:v>
                </c:pt>
                <c:pt idx="22">
                  <c:v>2.3489216314300002E-3</c:v>
                </c:pt>
                <c:pt idx="23">
                  <c:v>1.3129440840300001E-3</c:v>
                </c:pt>
                <c:pt idx="24">
                  <c:v>2.5762711864399999E-3</c:v>
                </c:pt>
                <c:pt idx="25">
                  <c:v>4.0620134046400001E-4</c:v>
                </c:pt>
                <c:pt idx="26">
                  <c:v>2.12211025489E-2</c:v>
                </c:pt>
                <c:pt idx="27">
                  <c:v>2.25025167288E-3</c:v>
                </c:pt>
                <c:pt idx="28">
                  <c:v>1.87075738949E-3</c:v>
                </c:pt>
                <c:pt idx="29">
                  <c:v>5.3231129564600002E-4</c:v>
                </c:pt>
                <c:pt idx="30">
                  <c:v>3.7090022783900002E-3</c:v>
                </c:pt>
                <c:pt idx="31">
                  <c:v>7.3626084670000002E-4</c:v>
                </c:pt>
                <c:pt idx="32">
                  <c:v>8.2221816188600004E-4</c:v>
                </c:pt>
                <c:pt idx="33">
                  <c:v>3.2825054784499999E-2</c:v>
                </c:pt>
                <c:pt idx="34">
                  <c:v>3.3746807734400001E-3</c:v>
                </c:pt>
                <c:pt idx="35">
                  <c:v>8.4292156614799996E-4</c:v>
                </c:pt>
                <c:pt idx="36">
                  <c:v>5.8705132505900001E-4</c:v>
                </c:pt>
                <c:pt idx="37">
                  <c:v>1.9165069577500001E-3</c:v>
                </c:pt>
                <c:pt idx="38">
                  <c:v>9.9796249324300007E-4</c:v>
                </c:pt>
                <c:pt idx="39">
                  <c:v>2.0784937033900002E-3</c:v>
                </c:pt>
                <c:pt idx="40">
                  <c:v>6.9271830813700001E-4</c:v>
                </c:pt>
                <c:pt idx="41">
                  <c:v>4.2502629631099999E-2</c:v>
                </c:pt>
                <c:pt idx="42">
                  <c:v>2.94294069131E-2</c:v>
                </c:pt>
                <c:pt idx="43">
                  <c:v>5.2352105302499996E-4</c:v>
                </c:pt>
                <c:pt idx="44">
                  <c:v>1.77188607429E-3</c:v>
                </c:pt>
                <c:pt idx="45">
                  <c:v>1.08741617834E-3</c:v>
                </c:pt>
                <c:pt idx="46">
                  <c:v>5.7534088947700001E-4</c:v>
                </c:pt>
                <c:pt idx="47">
                  <c:v>6.0234052317599996E-4</c:v>
                </c:pt>
                <c:pt idx="48">
                  <c:v>1.1424980720300001E-3</c:v>
                </c:pt>
                <c:pt idx="49">
                  <c:v>3.3997085964099999E-3</c:v>
                </c:pt>
                <c:pt idx="50">
                  <c:v>2.1969869892699999E-3</c:v>
                </c:pt>
                <c:pt idx="51">
                  <c:v>2.3418580514700002E-3</c:v>
                </c:pt>
                <c:pt idx="52">
                  <c:v>2.9252985134200002E-4</c:v>
                </c:pt>
                <c:pt idx="53">
                  <c:v>2.3887886187499998E-3</c:v>
                </c:pt>
                <c:pt idx="54">
                  <c:v>2.76331696726E-3</c:v>
                </c:pt>
                <c:pt idx="55">
                  <c:v>5.8999950833400002E-4</c:v>
                </c:pt>
                <c:pt idx="56">
                  <c:v>9.3340866105000005E-4</c:v>
                </c:pt>
                <c:pt idx="57">
                  <c:v>2.4722424563499998E-3</c:v>
                </c:pt>
                <c:pt idx="58">
                  <c:v>1.6191428322999999E-2</c:v>
                </c:pt>
                <c:pt idx="59">
                  <c:v>3.6897146475099998E-3</c:v>
                </c:pt>
                <c:pt idx="60">
                  <c:v>1.5403495408600001E-2</c:v>
                </c:pt>
                <c:pt idx="61">
                  <c:v>2.2216051096899999E-3</c:v>
                </c:pt>
                <c:pt idx="62">
                  <c:v>1.5670951156799999E-2</c:v>
                </c:pt>
                <c:pt idx="63">
                  <c:v>2.2216109853399999E-3</c:v>
                </c:pt>
                <c:pt idx="64">
                  <c:v>5.4089628365199998E-3</c:v>
                </c:pt>
                <c:pt idx="65">
                  <c:v>2.3626576817200001E-3</c:v>
                </c:pt>
                <c:pt idx="66">
                  <c:v>2.3374067087699999E-3</c:v>
                </c:pt>
                <c:pt idx="67">
                  <c:v>2.01374750549E-2</c:v>
                </c:pt>
                <c:pt idx="68">
                  <c:v>1.5086748805599999E-3</c:v>
                </c:pt>
                <c:pt idx="69">
                  <c:v>1.0427125975099999E-3</c:v>
                </c:pt>
                <c:pt idx="70">
                  <c:v>3.7839298814600002E-3</c:v>
                </c:pt>
                <c:pt idx="71">
                  <c:v>1.0615916153599999E-3</c:v>
                </c:pt>
                <c:pt idx="72">
                  <c:v>1.3059772116400001E-3</c:v>
                </c:pt>
                <c:pt idx="73">
                  <c:v>5.3708294695399998E-2</c:v>
                </c:pt>
                <c:pt idx="74">
                  <c:v>3.6016450169399999E-2</c:v>
                </c:pt>
                <c:pt idx="75">
                  <c:v>3.04305487932E-3</c:v>
                </c:pt>
                <c:pt idx="76">
                  <c:v>7.2164272124899996E-4</c:v>
                </c:pt>
                <c:pt idx="77">
                  <c:v>5.3613205094900005E-4</c:v>
                </c:pt>
                <c:pt idx="78">
                  <c:v>8.1099206163500002E-4</c:v>
                </c:pt>
                <c:pt idx="79">
                  <c:v>1.8151542881100001E-3</c:v>
                </c:pt>
                <c:pt idx="80">
                  <c:v>7.9842680348400001E-4</c:v>
                </c:pt>
                <c:pt idx="81">
                  <c:v>2.7773770018799999E-2</c:v>
                </c:pt>
                <c:pt idx="82">
                  <c:v>1.97076462832E-3</c:v>
                </c:pt>
                <c:pt idx="83">
                  <c:v>2.4393673110699999E-2</c:v>
                </c:pt>
                <c:pt idx="84">
                  <c:v>6.4659413567200001E-4</c:v>
                </c:pt>
                <c:pt idx="85">
                  <c:v>3.3067088297000002E-2</c:v>
                </c:pt>
                <c:pt idx="86">
                  <c:v>1.51097799053E-3</c:v>
                </c:pt>
                <c:pt idx="87">
                  <c:v>2.4879834308100001E-3</c:v>
                </c:pt>
                <c:pt idx="88">
                  <c:v>8.2490495660300005E-4</c:v>
                </c:pt>
                <c:pt idx="89">
                  <c:v>8.4407238875999994E-3</c:v>
                </c:pt>
                <c:pt idx="90">
                  <c:v>4.2093570153999997E-2</c:v>
                </c:pt>
                <c:pt idx="91">
                  <c:v>9.9644795610900005E-4</c:v>
                </c:pt>
                <c:pt idx="92">
                  <c:v>4.6195777705900003E-4</c:v>
                </c:pt>
                <c:pt idx="93">
                  <c:v>1.11971741565E-3</c:v>
                </c:pt>
                <c:pt idx="94">
                  <c:v>2.6414490234600001E-3</c:v>
                </c:pt>
                <c:pt idx="95">
                  <c:v>7.4286563274999996E-4</c:v>
                </c:pt>
                <c:pt idx="96">
                  <c:v>7.8203916712799998E-3</c:v>
                </c:pt>
                <c:pt idx="97">
                  <c:v>7.7095979064600005E-4</c:v>
                </c:pt>
                <c:pt idx="98">
                  <c:v>5.3133334802799997E-2</c:v>
                </c:pt>
                <c:pt idx="99">
                  <c:v>2.6673132880699999E-3</c:v>
                </c:pt>
                <c:pt idx="100">
                  <c:v>9.2903335783799997E-3</c:v>
                </c:pt>
                <c:pt idx="101">
                  <c:v>1.44336266218E-2</c:v>
                </c:pt>
                <c:pt idx="102">
                  <c:v>1.07054020298E-3</c:v>
                </c:pt>
                <c:pt idx="103">
                  <c:v>2.4207699951400001E-3</c:v>
                </c:pt>
                <c:pt idx="104">
                  <c:v>1.09583019342E-2</c:v>
                </c:pt>
                <c:pt idx="105">
                  <c:v>8.3523468057399995E-4</c:v>
                </c:pt>
                <c:pt idx="106">
                  <c:v>9.7386167652900001E-3</c:v>
                </c:pt>
                <c:pt idx="107">
                  <c:v>1.49900408633E-3</c:v>
                </c:pt>
                <c:pt idx="108">
                  <c:v>1.3787034320899999E-2</c:v>
                </c:pt>
                <c:pt idx="109">
                  <c:v>5.7187206404999997E-4</c:v>
                </c:pt>
                <c:pt idx="110">
                  <c:v>7.4791371437599998E-4</c:v>
                </c:pt>
                <c:pt idx="111">
                  <c:v>5.0972396486800003E-3</c:v>
                </c:pt>
                <c:pt idx="112">
                  <c:v>7.2573035128899996E-2</c:v>
                </c:pt>
                <c:pt idx="113">
                  <c:v>1.2327532141699999E-2</c:v>
                </c:pt>
                <c:pt idx="114">
                  <c:v>5.3950846959799998E-3</c:v>
                </c:pt>
                <c:pt idx="115">
                  <c:v>2.0334435340900001E-2</c:v>
                </c:pt>
                <c:pt idx="116">
                  <c:v>1.7176797432600002E-2</c:v>
                </c:pt>
                <c:pt idx="117">
                  <c:v>1.52793723689E-2</c:v>
                </c:pt>
                <c:pt idx="118">
                  <c:v>3.8089048947100002E-3</c:v>
                </c:pt>
                <c:pt idx="119">
                  <c:v>1.00099205463E-3</c:v>
                </c:pt>
                <c:pt idx="120">
                  <c:v>1.08514981096E-3</c:v>
                </c:pt>
                <c:pt idx="121">
                  <c:v>2.82679165562E-2</c:v>
                </c:pt>
                <c:pt idx="122">
                  <c:v>9.4191655142200001E-3</c:v>
                </c:pt>
                <c:pt idx="123">
                  <c:v>1.3763049262300001E-2</c:v>
                </c:pt>
                <c:pt idx="124">
                  <c:v>3.5105935427299999E-2</c:v>
                </c:pt>
                <c:pt idx="125">
                  <c:v>6.4469327446899996E-2</c:v>
                </c:pt>
                <c:pt idx="126">
                  <c:v>2.8209860268899999E-3</c:v>
                </c:pt>
                <c:pt idx="127">
                  <c:v>4.2388415762600003E-2</c:v>
                </c:pt>
                <c:pt idx="128">
                  <c:v>1.7183288409700001E-2</c:v>
                </c:pt>
                <c:pt idx="129">
                  <c:v>2.5976446365299999E-2</c:v>
                </c:pt>
                <c:pt idx="130">
                  <c:v>1.0220190351E-3</c:v>
                </c:pt>
                <c:pt idx="131">
                  <c:v>2.5491885681500001E-3</c:v>
                </c:pt>
                <c:pt idx="132">
                  <c:v>3.8257888502000001E-2</c:v>
                </c:pt>
                <c:pt idx="133">
                  <c:v>1.0677817059400001E-3</c:v>
                </c:pt>
                <c:pt idx="134">
                  <c:v>6.2724576385100005E-4</c:v>
                </c:pt>
                <c:pt idx="135">
                  <c:v>4.7741783782800001E-2</c:v>
                </c:pt>
                <c:pt idx="136">
                  <c:v>4.3064062316199997E-3</c:v>
                </c:pt>
                <c:pt idx="137">
                  <c:v>5.0428347121900002E-2</c:v>
                </c:pt>
                <c:pt idx="138">
                  <c:v>9.7433634826100003E-3</c:v>
                </c:pt>
                <c:pt idx="139">
                  <c:v>2.7603431627400001E-2</c:v>
                </c:pt>
                <c:pt idx="140">
                  <c:v>1.4729765456800001E-3</c:v>
                </c:pt>
                <c:pt idx="141">
                  <c:v>9.3404534382599998E-3</c:v>
                </c:pt>
                <c:pt idx="142">
                  <c:v>1.05926245336E-3</c:v>
                </c:pt>
                <c:pt idx="143">
                  <c:v>1.58762410529E-2</c:v>
                </c:pt>
                <c:pt idx="144">
                  <c:v>2.05731080088E-3</c:v>
                </c:pt>
                <c:pt idx="145">
                  <c:v>5.5129324206400004E-4</c:v>
                </c:pt>
                <c:pt idx="146">
                  <c:v>6.9982822398099997E-4</c:v>
                </c:pt>
                <c:pt idx="147">
                  <c:v>9.8213960932700003E-4</c:v>
                </c:pt>
                <c:pt idx="148">
                  <c:v>1.1642937687400001E-3</c:v>
                </c:pt>
                <c:pt idx="149">
                  <c:v>1.81716313381E-2</c:v>
                </c:pt>
                <c:pt idx="150">
                  <c:v>2.05871318702E-2</c:v>
                </c:pt>
                <c:pt idx="151">
                  <c:v>3.0529398857100001E-2</c:v>
                </c:pt>
                <c:pt idx="152">
                  <c:v>4.7064782164099997E-2</c:v>
                </c:pt>
                <c:pt idx="153">
                  <c:v>1.4920692244100001E-3</c:v>
                </c:pt>
                <c:pt idx="154">
                  <c:v>3.6646729326900002E-3</c:v>
                </c:pt>
                <c:pt idx="155">
                  <c:v>1.33031794599E-3</c:v>
                </c:pt>
                <c:pt idx="156">
                  <c:v>1.95859093315E-2</c:v>
                </c:pt>
                <c:pt idx="157">
                  <c:v>2.3542859434700001E-2</c:v>
                </c:pt>
                <c:pt idx="158">
                  <c:v>1.48955384412E-2</c:v>
                </c:pt>
                <c:pt idx="159">
                  <c:v>1.01036030023E-2</c:v>
                </c:pt>
                <c:pt idx="160">
                  <c:v>3.5118617060299999E-3</c:v>
                </c:pt>
                <c:pt idx="161">
                  <c:v>7.6898082963300005E-4</c:v>
                </c:pt>
                <c:pt idx="162">
                  <c:v>3.4929159298799999E-3</c:v>
                </c:pt>
                <c:pt idx="163">
                  <c:v>2.3377110280400001E-3</c:v>
                </c:pt>
                <c:pt idx="164">
                  <c:v>3.2622007391399997E-2</c:v>
                </c:pt>
                <c:pt idx="165">
                  <c:v>1.12199465717E-2</c:v>
                </c:pt>
                <c:pt idx="166">
                  <c:v>3.16290051341E-3</c:v>
                </c:pt>
                <c:pt idx="167">
                  <c:v>2.06799662827E-2</c:v>
                </c:pt>
                <c:pt idx="168">
                  <c:v>1.8543284521400001E-3</c:v>
                </c:pt>
                <c:pt idx="169">
                  <c:v>3.58401880141E-3</c:v>
                </c:pt>
                <c:pt idx="170">
                  <c:v>2.81213658949E-2</c:v>
                </c:pt>
                <c:pt idx="171">
                  <c:v>2.1454741885499999E-2</c:v>
                </c:pt>
                <c:pt idx="172">
                  <c:v>3.0259670193099998E-3</c:v>
                </c:pt>
                <c:pt idx="173">
                  <c:v>7.36101698876E-4</c:v>
                </c:pt>
                <c:pt idx="174">
                  <c:v>1.7398924982500001E-2</c:v>
                </c:pt>
                <c:pt idx="175">
                  <c:v>2.9241814043100001E-2</c:v>
                </c:pt>
                <c:pt idx="176">
                  <c:v>4.9733485627299996E-3</c:v>
                </c:pt>
                <c:pt idx="177">
                  <c:v>1.29165374615E-2</c:v>
                </c:pt>
                <c:pt idx="178">
                  <c:v>1.1323862466500001E-2</c:v>
                </c:pt>
                <c:pt idx="179">
                  <c:v>2.5672697328600002E-3</c:v>
                </c:pt>
                <c:pt idx="180">
                  <c:v>2.4982735015799999E-2</c:v>
                </c:pt>
                <c:pt idx="181">
                  <c:v>1.54115760822E-3</c:v>
                </c:pt>
                <c:pt idx="182">
                  <c:v>2.69299820467E-3</c:v>
                </c:pt>
                <c:pt idx="183">
                  <c:v>1.58157862992E-3</c:v>
                </c:pt>
                <c:pt idx="184">
                  <c:v>2.4391879207199998E-2</c:v>
                </c:pt>
                <c:pt idx="185">
                  <c:v>1.5358857633099999E-3</c:v>
                </c:pt>
                <c:pt idx="186">
                  <c:v>2.51769087523E-3</c:v>
                </c:pt>
                <c:pt idx="187">
                  <c:v>1.55188259933E-3</c:v>
                </c:pt>
                <c:pt idx="188">
                  <c:v>1.9725010152600001E-3</c:v>
                </c:pt>
                <c:pt idx="189">
                  <c:v>1.1728931364E-3</c:v>
                </c:pt>
                <c:pt idx="190">
                  <c:v>2.1448077348899999E-2</c:v>
                </c:pt>
                <c:pt idx="191">
                  <c:v>6.2852632502100004E-4</c:v>
                </c:pt>
                <c:pt idx="192">
                  <c:v>9.5424699741199995E-3</c:v>
                </c:pt>
                <c:pt idx="193">
                  <c:v>2.2806171649E-2</c:v>
                </c:pt>
                <c:pt idx="194">
                  <c:v>1.02184186997E-3</c:v>
                </c:pt>
                <c:pt idx="195">
                  <c:v>4.1979960050000001E-2</c:v>
                </c:pt>
                <c:pt idx="196">
                  <c:v>1.24219645815E-3</c:v>
                </c:pt>
                <c:pt idx="197">
                  <c:v>1.11809923131E-2</c:v>
                </c:pt>
                <c:pt idx="198">
                  <c:v>6.2731438426799997E-3</c:v>
                </c:pt>
                <c:pt idx="199">
                  <c:v>6.2892009817300002E-3</c:v>
                </c:pt>
                <c:pt idx="200">
                  <c:v>8.0277831102400004E-4</c:v>
                </c:pt>
                <c:pt idx="201">
                  <c:v>1.6617911394600001E-2</c:v>
                </c:pt>
                <c:pt idx="202">
                  <c:v>2.7787040124500001E-3</c:v>
                </c:pt>
                <c:pt idx="203">
                  <c:v>6.3184498736299996E-4</c:v>
                </c:pt>
                <c:pt idx="204">
                  <c:v>6.09870519797E-3</c:v>
                </c:pt>
                <c:pt idx="205">
                  <c:v>1.2416284144800001E-3</c:v>
                </c:pt>
                <c:pt idx="206">
                  <c:v>7.7486485987900003E-4</c:v>
                </c:pt>
                <c:pt idx="207">
                  <c:v>2.32210577444E-2</c:v>
                </c:pt>
                <c:pt idx="208">
                  <c:v>4.0402514773300001E-3</c:v>
                </c:pt>
                <c:pt idx="209">
                  <c:v>1.1839958945E-2</c:v>
                </c:pt>
                <c:pt idx="210">
                  <c:v>8.7834870443600002E-4</c:v>
                </c:pt>
                <c:pt idx="211">
                  <c:v>5.1245447391100004E-4</c:v>
                </c:pt>
                <c:pt idx="212">
                  <c:v>9.6994985542300002E-4</c:v>
                </c:pt>
                <c:pt idx="213">
                  <c:v>4.0436581286900003E-2</c:v>
                </c:pt>
                <c:pt idx="214">
                  <c:v>1.0180152338699999E-3</c:v>
                </c:pt>
                <c:pt idx="215">
                  <c:v>4.9850811440199996E-3</c:v>
                </c:pt>
                <c:pt idx="216">
                  <c:v>3.71201810051E-4</c:v>
                </c:pt>
                <c:pt idx="217">
                  <c:v>5.5335549112500004E-3</c:v>
                </c:pt>
                <c:pt idx="218">
                  <c:v>4.8793720837699998E-2</c:v>
                </c:pt>
                <c:pt idx="219">
                  <c:v>1.9716841831E-2</c:v>
                </c:pt>
                <c:pt idx="220">
                  <c:v>7.0189184336400001E-4</c:v>
                </c:pt>
                <c:pt idx="221">
                  <c:v>2.2800979548600001E-2</c:v>
                </c:pt>
                <c:pt idx="222">
                  <c:v>3.47031049268E-3</c:v>
                </c:pt>
                <c:pt idx="223">
                  <c:v>2.9869888789499999E-3</c:v>
                </c:pt>
                <c:pt idx="224">
                  <c:v>7.4284170718499996E-4</c:v>
                </c:pt>
                <c:pt idx="225">
                  <c:v>1.4174462621100001E-3</c:v>
                </c:pt>
                <c:pt idx="226">
                  <c:v>4.60612672815E-2</c:v>
                </c:pt>
                <c:pt idx="227">
                  <c:v>5.6369785794800002E-4</c:v>
                </c:pt>
                <c:pt idx="228">
                  <c:v>1.6671498985200001E-3</c:v>
                </c:pt>
                <c:pt idx="229">
                  <c:v>1.6491482421200001E-3</c:v>
                </c:pt>
                <c:pt idx="230">
                  <c:v>1.70706118747E-3</c:v>
                </c:pt>
                <c:pt idx="231">
                  <c:v>6.2654634129000004E-3</c:v>
                </c:pt>
                <c:pt idx="232">
                  <c:v>1.79712104767E-2</c:v>
                </c:pt>
                <c:pt idx="233">
                  <c:v>1.1974255350999999E-3</c:v>
                </c:pt>
                <c:pt idx="234">
                  <c:v>2.4558551391400001E-3</c:v>
                </c:pt>
                <c:pt idx="235">
                  <c:v>5.0158257951799998E-4</c:v>
                </c:pt>
                <c:pt idx="236">
                  <c:v>1.58087660476E-3</c:v>
                </c:pt>
                <c:pt idx="237">
                  <c:v>1.0250886093500001E-3</c:v>
                </c:pt>
                <c:pt idx="238">
                  <c:v>2.4653928803500002E-3</c:v>
                </c:pt>
                <c:pt idx="239">
                  <c:v>5.4612866591000004E-3</c:v>
                </c:pt>
                <c:pt idx="240">
                  <c:v>2.50368682129E-2</c:v>
                </c:pt>
                <c:pt idx="241">
                  <c:v>2.3957914488700002E-3</c:v>
                </c:pt>
                <c:pt idx="242">
                  <c:v>2.9258831987399999E-3</c:v>
                </c:pt>
                <c:pt idx="243">
                  <c:v>1.3990512181400001E-3</c:v>
                </c:pt>
                <c:pt idx="244">
                  <c:v>2.9949096420300001E-2</c:v>
                </c:pt>
                <c:pt idx="245">
                  <c:v>2.3476165668099999E-2</c:v>
                </c:pt>
                <c:pt idx="246">
                  <c:v>1.0670081092600001E-3</c:v>
                </c:pt>
                <c:pt idx="247">
                  <c:v>5.5835646133399995E-4</c:v>
                </c:pt>
                <c:pt idx="248">
                  <c:v>1.4212057112599999E-3</c:v>
                </c:pt>
                <c:pt idx="249">
                  <c:v>4.7167853931800001E-2</c:v>
                </c:pt>
                <c:pt idx="250">
                  <c:v>1.6431690164299999E-2</c:v>
                </c:pt>
                <c:pt idx="251">
                  <c:v>4.4554934943300002E-3</c:v>
                </c:pt>
                <c:pt idx="252">
                  <c:v>9.7435814157399996E-4</c:v>
                </c:pt>
                <c:pt idx="253">
                  <c:v>3.6883017178000001E-2</c:v>
                </c:pt>
                <c:pt idx="254">
                  <c:v>9.6590360282000002E-4</c:v>
                </c:pt>
                <c:pt idx="255">
                  <c:v>1.5083979328199999E-2</c:v>
                </c:pt>
                <c:pt idx="256">
                  <c:v>3.2325425993999998E-2</c:v>
                </c:pt>
                <c:pt idx="257">
                  <c:v>4.83922105228E-4</c:v>
                </c:pt>
                <c:pt idx="258">
                  <c:v>2.0775524724299999E-2</c:v>
                </c:pt>
                <c:pt idx="259">
                  <c:v>3.35978244032E-2</c:v>
                </c:pt>
                <c:pt idx="260">
                  <c:v>5.0478077353799996E-3</c:v>
                </c:pt>
                <c:pt idx="261">
                  <c:v>1.2045037968099999E-3</c:v>
                </c:pt>
                <c:pt idx="262">
                  <c:v>2.1674480442199998E-2</c:v>
                </c:pt>
                <c:pt idx="263">
                  <c:v>1.6857208488699999E-2</c:v>
                </c:pt>
                <c:pt idx="264">
                  <c:v>4.0580023806900001E-3</c:v>
                </c:pt>
                <c:pt idx="265">
                  <c:v>1.39975004463E-2</c:v>
                </c:pt>
                <c:pt idx="266">
                  <c:v>2.5038925299600001E-2</c:v>
                </c:pt>
                <c:pt idx="267">
                  <c:v>2.8372126644500002E-3</c:v>
                </c:pt>
                <c:pt idx="268">
                  <c:v>4.7015458682800001E-4</c:v>
                </c:pt>
                <c:pt idx="269">
                  <c:v>9.9182868413599991E-3</c:v>
                </c:pt>
                <c:pt idx="270">
                  <c:v>1.35322633139E-3</c:v>
                </c:pt>
                <c:pt idx="271">
                  <c:v>1.07793652152E-3</c:v>
                </c:pt>
                <c:pt idx="272">
                  <c:v>2.0992301112100001E-2</c:v>
                </c:pt>
                <c:pt idx="273">
                  <c:v>5.7532531262200002E-4</c:v>
                </c:pt>
                <c:pt idx="274">
                  <c:v>5.5275340288799999E-4</c:v>
                </c:pt>
                <c:pt idx="275">
                  <c:v>6.5163790066900004E-4</c:v>
                </c:pt>
                <c:pt idx="276">
                  <c:v>2.1405386437400001E-3</c:v>
                </c:pt>
                <c:pt idx="277">
                  <c:v>1.1608924360599999E-3</c:v>
                </c:pt>
                <c:pt idx="278">
                  <c:v>2.16446279489E-3</c:v>
                </c:pt>
                <c:pt idx="279">
                  <c:v>1.895456766E-3</c:v>
                </c:pt>
                <c:pt idx="280">
                  <c:v>2.1506868322500001E-2</c:v>
                </c:pt>
                <c:pt idx="281">
                  <c:v>1.3967310549800001E-2</c:v>
                </c:pt>
                <c:pt idx="282">
                  <c:v>4.5885591924099998E-4</c:v>
                </c:pt>
                <c:pt idx="283">
                  <c:v>2.22731297886E-2</c:v>
                </c:pt>
                <c:pt idx="284">
                  <c:v>2.55236648545E-2</c:v>
                </c:pt>
                <c:pt idx="285">
                  <c:v>2.93249398839E-3</c:v>
                </c:pt>
                <c:pt idx="286">
                  <c:v>2.6777357262E-2</c:v>
                </c:pt>
                <c:pt idx="287">
                  <c:v>2.3869116659499999E-2</c:v>
                </c:pt>
                <c:pt idx="288">
                  <c:v>2.2211806899900001E-3</c:v>
                </c:pt>
                <c:pt idx="289">
                  <c:v>2.1300655879299999E-2</c:v>
                </c:pt>
                <c:pt idx="290">
                  <c:v>4.5274010660000002E-4</c:v>
                </c:pt>
                <c:pt idx="291">
                  <c:v>8.1123244929800001E-4</c:v>
                </c:pt>
                <c:pt idx="292">
                  <c:v>6.0321158166200001E-4</c:v>
                </c:pt>
                <c:pt idx="293">
                  <c:v>3.2019294743800002E-3</c:v>
                </c:pt>
                <c:pt idx="294">
                  <c:v>2.9793958043100002E-2</c:v>
                </c:pt>
                <c:pt idx="295">
                  <c:v>2.2728629714400001E-2</c:v>
                </c:pt>
                <c:pt idx="296">
                  <c:v>1.0338383235900001E-3</c:v>
                </c:pt>
                <c:pt idx="297">
                  <c:v>2.6184865147899999E-3</c:v>
                </c:pt>
                <c:pt idx="298">
                  <c:v>5.3659224631299997E-2</c:v>
                </c:pt>
                <c:pt idx="299">
                  <c:v>4.0180813661499999E-4</c:v>
                </c:pt>
                <c:pt idx="300">
                  <c:v>2.7992693988999999E-2</c:v>
                </c:pt>
                <c:pt idx="301">
                  <c:v>2.4380000419999999E-2</c:v>
                </c:pt>
                <c:pt idx="302">
                  <c:v>2.1559777474500001E-2</c:v>
                </c:pt>
                <c:pt idx="303">
                  <c:v>2.55294117647E-2</c:v>
                </c:pt>
                <c:pt idx="304">
                  <c:v>6.5865634106400004E-4</c:v>
                </c:pt>
                <c:pt idx="305">
                  <c:v>5.5740870786499998E-3</c:v>
                </c:pt>
                <c:pt idx="306">
                  <c:v>2.30877687698E-2</c:v>
                </c:pt>
                <c:pt idx="307">
                  <c:v>4.6595220661699999E-4</c:v>
                </c:pt>
                <c:pt idx="308">
                  <c:v>3.69796279894E-3</c:v>
                </c:pt>
                <c:pt idx="309">
                  <c:v>1.63015001261E-3</c:v>
                </c:pt>
                <c:pt idx="310">
                  <c:v>3.1779433553100001E-3</c:v>
                </c:pt>
                <c:pt idx="311">
                  <c:v>4.7232599081099998E-4</c:v>
                </c:pt>
                <c:pt idx="312">
                  <c:v>1.45592555267E-2</c:v>
                </c:pt>
                <c:pt idx="313">
                  <c:v>3.51099092812E-3</c:v>
                </c:pt>
                <c:pt idx="314">
                  <c:v>3.33922608525E-3</c:v>
                </c:pt>
                <c:pt idx="315">
                  <c:v>3.9846676917099998E-2</c:v>
                </c:pt>
                <c:pt idx="316">
                  <c:v>4.7640702483800002E-4</c:v>
                </c:pt>
                <c:pt idx="317">
                  <c:v>6.4975850642199999E-4</c:v>
                </c:pt>
                <c:pt idx="318">
                  <c:v>9.2738752959699994E-3</c:v>
                </c:pt>
                <c:pt idx="319">
                  <c:v>3.3943724877199999E-3</c:v>
                </c:pt>
                <c:pt idx="320">
                  <c:v>6.07508989793E-3</c:v>
                </c:pt>
                <c:pt idx="321">
                  <c:v>5.7193746289299997E-2</c:v>
                </c:pt>
                <c:pt idx="322">
                  <c:v>5.7589110422800001E-3</c:v>
                </c:pt>
                <c:pt idx="323">
                  <c:v>4.0122960700800001E-2</c:v>
                </c:pt>
                <c:pt idx="324">
                  <c:v>7.5813537576299998E-4</c:v>
                </c:pt>
                <c:pt idx="325">
                  <c:v>2.42153727199E-2</c:v>
                </c:pt>
                <c:pt idx="326">
                  <c:v>2.2842282822599998E-3</c:v>
                </c:pt>
                <c:pt idx="327">
                  <c:v>2.2377696134400001E-2</c:v>
                </c:pt>
                <c:pt idx="328">
                  <c:v>4.1820589670299999E-4</c:v>
                </c:pt>
                <c:pt idx="329">
                  <c:v>7.1291081485699999E-4</c:v>
                </c:pt>
                <c:pt idx="330">
                  <c:v>1.08429520811E-3</c:v>
                </c:pt>
                <c:pt idx="331">
                  <c:v>2.0184355302900001E-2</c:v>
                </c:pt>
                <c:pt idx="332">
                  <c:v>2.6841910403599999E-3</c:v>
                </c:pt>
                <c:pt idx="333">
                  <c:v>6.1363593451999997E-3</c:v>
                </c:pt>
                <c:pt idx="334">
                  <c:v>9.4393052671299998E-4</c:v>
                </c:pt>
                <c:pt idx="335">
                  <c:v>5.2890135331000003E-3</c:v>
                </c:pt>
                <c:pt idx="336">
                  <c:v>3.0920755398900001E-2</c:v>
                </c:pt>
                <c:pt idx="337">
                  <c:v>4.9848734873500001E-4</c:v>
                </c:pt>
                <c:pt idx="338">
                  <c:v>8.9345543890999995E-4</c:v>
                </c:pt>
                <c:pt idx="339">
                  <c:v>2.4383542825700002E-3</c:v>
                </c:pt>
                <c:pt idx="340">
                  <c:v>5.8161350844299997E-4</c:v>
                </c:pt>
                <c:pt idx="341">
                  <c:v>2.3813181748300002E-3</c:v>
                </c:pt>
                <c:pt idx="342">
                  <c:v>2.2280698384599998E-3</c:v>
                </c:pt>
                <c:pt idx="343">
                  <c:v>6.34078856352E-4</c:v>
                </c:pt>
                <c:pt idx="344">
                  <c:v>8.0966260882800005E-3</c:v>
                </c:pt>
                <c:pt idx="345">
                  <c:v>2.72612246463E-2</c:v>
                </c:pt>
                <c:pt idx="346">
                  <c:v>2.05755808395E-2</c:v>
                </c:pt>
                <c:pt idx="347">
                  <c:v>1.5040986688699999E-3</c:v>
                </c:pt>
                <c:pt idx="348">
                  <c:v>1.94014137464E-2</c:v>
                </c:pt>
                <c:pt idx="349">
                  <c:v>1.4030356589700001E-3</c:v>
                </c:pt>
                <c:pt idx="350">
                  <c:v>2.04509414359E-2</c:v>
                </c:pt>
                <c:pt idx="351">
                  <c:v>3.1893302406500001E-3</c:v>
                </c:pt>
                <c:pt idx="352">
                  <c:v>1.0784260417200001E-2</c:v>
                </c:pt>
                <c:pt idx="353">
                  <c:v>7.5043154356300001E-3</c:v>
                </c:pt>
                <c:pt idx="354">
                  <c:v>3.41224427306E-2</c:v>
                </c:pt>
                <c:pt idx="355">
                  <c:v>2.8882385570299998E-3</c:v>
                </c:pt>
                <c:pt idx="356">
                  <c:v>5.9744540585099999E-4</c:v>
                </c:pt>
                <c:pt idx="357">
                  <c:v>1.2583466948099999E-3</c:v>
                </c:pt>
                <c:pt idx="358">
                  <c:v>1.4662159410299999E-3</c:v>
                </c:pt>
                <c:pt idx="359">
                  <c:v>1.00990853659E-3</c:v>
                </c:pt>
                <c:pt idx="360">
                  <c:v>5.7112397197699996E-4</c:v>
                </c:pt>
                <c:pt idx="361">
                  <c:v>2.9927951228500001E-3</c:v>
                </c:pt>
                <c:pt idx="362">
                  <c:v>7.2032802630100001E-4</c:v>
                </c:pt>
                <c:pt idx="363">
                  <c:v>2.49210832364E-2</c:v>
                </c:pt>
                <c:pt idx="364">
                  <c:v>2.3911076644700002E-2</c:v>
                </c:pt>
                <c:pt idx="365">
                  <c:v>3.8103532741799999E-4</c:v>
                </c:pt>
                <c:pt idx="366">
                  <c:v>5.8126861875999996E-4</c:v>
                </c:pt>
                <c:pt idx="367">
                  <c:v>4.0964183047200002E-2</c:v>
                </c:pt>
                <c:pt idx="368">
                  <c:v>3.5411316055699998E-3</c:v>
                </c:pt>
                <c:pt idx="369">
                  <c:v>7.1962035164200005E-4</c:v>
                </c:pt>
                <c:pt idx="370">
                  <c:v>3.92303749556E-3</c:v>
                </c:pt>
                <c:pt idx="371">
                  <c:v>5.7760869998199995E-4</c:v>
                </c:pt>
                <c:pt idx="372">
                  <c:v>2.2301479072700001E-2</c:v>
                </c:pt>
                <c:pt idx="373">
                  <c:v>1.0865549688199999E-3</c:v>
                </c:pt>
                <c:pt idx="374">
                  <c:v>3.0376095725299999E-2</c:v>
                </c:pt>
                <c:pt idx="375">
                  <c:v>4.1935338413699999E-3</c:v>
                </c:pt>
                <c:pt idx="376">
                  <c:v>3.76557579077E-3</c:v>
                </c:pt>
                <c:pt idx="377">
                  <c:v>2.3369575980800002E-3</c:v>
                </c:pt>
                <c:pt idx="378">
                  <c:v>4.8562352036599999E-4</c:v>
                </c:pt>
                <c:pt idx="379">
                  <c:v>1.8417324428300001E-3</c:v>
                </c:pt>
                <c:pt idx="380">
                  <c:v>1.9373253977900001E-2</c:v>
                </c:pt>
                <c:pt idx="381">
                  <c:v>2.1853058416499999E-3</c:v>
                </c:pt>
                <c:pt idx="382">
                  <c:v>2.8273225173099999E-2</c:v>
                </c:pt>
                <c:pt idx="383">
                  <c:v>5.9828354513900004E-4</c:v>
                </c:pt>
                <c:pt idx="384">
                  <c:v>6.0562483308299997E-2</c:v>
                </c:pt>
                <c:pt idx="385">
                  <c:v>1.56964907288E-2</c:v>
                </c:pt>
                <c:pt idx="386">
                  <c:v>2.2285741969899999E-3</c:v>
                </c:pt>
                <c:pt idx="387">
                  <c:v>1.91450117905E-3</c:v>
                </c:pt>
                <c:pt idx="388">
                  <c:v>2.7655797440000001E-2</c:v>
                </c:pt>
                <c:pt idx="389">
                  <c:v>4.2023673336E-4</c:v>
                </c:pt>
                <c:pt idx="390">
                  <c:v>3.0990376416100002E-2</c:v>
                </c:pt>
                <c:pt idx="391">
                  <c:v>3.95586193457E-2</c:v>
                </c:pt>
                <c:pt idx="392">
                  <c:v>2.62585340236E-3</c:v>
                </c:pt>
                <c:pt idx="393">
                  <c:v>2.4019816348499999E-3</c:v>
                </c:pt>
                <c:pt idx="394">
                  <c:v>4.2621471192899997E-4</c:v>
                </c:pt>
                <c:pt idx="395">
                  <c:v>2.8402664320700001E-3</c:v>
                </c:pt>
                <c:pt idx="396">
                  <c:v>3.9515806322500003E-3</c:v>
                </c:pt>
                <c:pt idx="397">
                  <c:v>1.4848687252700001E-2</c:v>
                </c:pt>
                <c:pt idx="398">
                  <c:v>6.6507326197700004E-3</c:v>
                </c:pt>
                <c:pt idx="399">
                  <c:v>2.5777893503499999E-3</c:v>
                </c:pt>
                <c:pt idx="400">
                  <c:v>8.5983643798299994E-2</c:v>
                </c:pt>
                <c:pt idx="401">
                  <c:v>3.4909347359800003E-2</c:v>
                </c:pt>
                <c:pt idx="402">
                  <c:v>5.7930213042400001E-3</c:v>
                </c:pt>
                <c:pt idx="403">
                  <c:v>1.22357272407E-2</c:v>
                </c:pt>
                <c:pt idx="404">
                  <c:v>1.81343700903E-2</c:v>
                </c:pt>
                <c:pt idx="405">
                  <c:v>2.0484429065700002E-3</c:v>
                </c:pt>
                <c:pt idx="406">
                  <c:v>3.4779978829599999E-3</c:v>
                </c:pt>
                <c:pt idx="407">
                  <c:v>1.1581942241399999E-3</c:v>
                </c:pt>
                <c:pt idx="408">
                  <c:v>4.0088749936999998E-3</c:v>
                </c:pt>
                <c:pt idx="409">
                  <c:v>1.28652821173E-3</c:v>
                </c:pt>
                <c:pt idx="410">
                  <c:v>8.6605080831399998E-4</c:v>
                </c:pt>
                <c:pt idx="411">
                  <c:v>1.52098222467E-2</c:v>
                </c:pt>
                <c:pt idx="412">
                  <c:v>6.8112752803100001E-4</c:v>
                </c:pt>
                <c:pt idx="413">
                  <c:v>1.51626190897E-3</c:v>
                </c:pt>
                <c:pt idx="414">
                  <c:v>2.1735833796700001E-3</c:v>
                </c:pt>
                <c:pt idx="415">
                  <c:v>1.3766864408900001E-3</c:v>
                </c:pt>
                <c:pt idx="416">
                  <c:v>1.45137880987E-3</c:v>
                </c:pt>
                <c:pt idx="417">
                  <c:v>5.5013753438399996E-4</c:v>
                </c:pt>
                <c:pt idx="418">
                  <c:v>1.17523504701E-3</c:v>
                </c:pt>
                <c:pt idx="419">
                  <c:v>1.0511562719E-3</c:v>
                </c:pt>
                <c:pt idx="420">
                  <c:v>6.5468096892800005E-4</c:v>
                </c:pt>
                <c:pt idx="421">
                  <c:v>1.78931451613E-2</c:v>
                </c:pt>
                <c:pt idx="422">
                  <c:v>1.41159561635E-3</c:v>
                </c:pt>
                <c:pt idx="423">
                  <c:v>7.2402558223700004E-4</c:v>
                </c:pt>
                <c:pt idx="424">
                  <c:v>2.8151774785799999E-2</c:v>
                </c:pt>
                <c:pt idx="425">
                  <c:v>2.00217958791E-3</c:v>
                </c:pt>
                <c:pt idx="426">
                  <c:v>6.0067576023E-4</c:v>
                </c:pt>
                <c:pt idx="427">
                  <c:v>4.5695165801000002E-3</c:v>
                </c:pt>
                <c:pt idx="428">
                  <c:v>1.77658142665E-3</c:v>
                </c:pt>
                <c:pt idx="429">
                  <c:v>7.4037512339599995E-4</c:v>
                </c:pt>
                <c:pt idx="430">
                  <c:v>6.87176234274E-4</c:v>
                </c:pt>
                <c:pt idx="431">
                  <c:v>3.78833910126E-2</c:v>
                </c:pt>
                <c:pt idx="432">
                  <c:v>4.2365445839899997E-3</c:v>
                </c:pt>
                <c:pt idx="433">
                  <c:v>6.7662389735400003E-4</c:v>
                </c:pt>
                <c:pt idx="434">
                  <c:v>8.7548151483300002E-4</c:v>
                </c:pt>
                <c:pt idx="435">
                  <c:v>2.6587814332600002E-3</c:v>
                </c:pt>
                <c:pt idx="436">
                  <c:v>4.0177334441700002E-3</c:v>
                </c:pt>
                <c:pt idx="437">
                  <c:v>2.79834417504E-2</c:v>
                </c:pt>
                <c:pt idx="438">
                  <c:v>2.0909311937800002E-3</c:v>
                </c:pt>
                <c:pt idx="439">
                  <c:v>1.09685680462E-2</c:v>
                </c:pt>
                <c:pt idx="440">
                  <c:v>9.0116138981300008E-3</c:v>
                </c:pt>
                <c:pt idx="441">
                  <c:v>7.5102357245000002E-4</c:v>
                </c:pt>
                <c:pt idx="442">
                  <c:v>9.836710603970001E-4</c:v>
                </c:pt>
                <c:pt idx="443">
                  <c:v>2.3294276596199999E-3</c:v>
                </c:pt>
                <c:pt idx="444">
                  <c:v>8.20493694786E-3</c:v>
                </c:pt>
                <c:pt idx="445">
                  <c:v>1.05492650679E-3</c:v>
                </c:pt>
                <c:pt idx="446">
                  <c:v>4.7677562054600003E-3</c:v>
                </c:pt>
                <c:pt idx="447">
                  <c:v>8.8191634892499995E-3</c:v>
                </c:pt>
                <c:pt idx="448">
                  <c:v>1.8273789030399999E-3</c:v>
                </c:pt>
                <c:pt idx="449">
                  <c:v>9.939152990230001E-4</c:v>
                </c:pt>
                <c:pt idx="450">
                  <c:v>3.0524597146300001E-3</c:v>
                </c:pt>
                <c:pt idx="451">
                  <c:v>1.2481660717799999E-3</c:v>
                </c:pt>
                <c:pt idx="452">
                  <c:v>3.49995705574E-3</c:v>
                </c:pt>
                <c:pt idx="453">
                  <c:v>2.7725402811099999E-2</c:v>
                </c:pt>
                <c:pt idx="454">
                  <c:v>2.8314946096700002E-3</c:v>
                </c:pt>
                <c:pt idx="455">
                  <c:v>1.17610259618E-2</c:v>
                </c:pt>
                <c:pt idx="456">
                  <c:v>7.4840962953700001E-4</c:v>
                </c:pt>
                <c:pt idx="457">
                  <c:v>2.8814884946299999E-3</c:v>
                </c:pt>
                <c:pt idx="458">
                  <c:v>1.6886673943E-3</c:v>
                </c:pt>
                <c:pt idx="459">
                  <c:v>7.6759957589000005E-2</c:v>
                </c:pt>
                <c:pt idx="460">
                  <c:v>1.25171854801E-3</c:v>
                </c:pt>
                <c:pt idx="461">
                  <c:v>5.5816920500800001E-3</c:v>
                </c:pt>
                <c:pt idx="462">
                  <c:v>2.4337278685300001E-2</c:v>
                </c:pt>
                <c:pt idx="463">
                  <c:v>9.19189548619E-4</c:v>
                </c:pt>
                <c:pt idx="464">
                  <c:v>1.2140199725900001E-3</c:v>
                </c:pt>
                <c:pt idx="465">
                  <c:v>1.19406491015E-3</c:v>
                </c:pt>
                <c:pt idx="466">
                  <c:v>6.1040744697100002E-4</c:v>
                </c:pt>
                <c:pt idx="467">
                  <c:v>5.34442938673E-4</c:v>
                </c:pt>
                <c:pt idx="468">
                  <c:v>1.5914611985699999E-2</c:v>
                </c:pt>
                <c:pt idx="469">
                  <c:v>5.3577237328000002E-4</c:v>
                </c:pt>
                <c:pt idx="470">
                  <c:v>2.6265359035100001E-2</c:v>
                </c:pt>
                <c:pt idx="471">
                  <c:v>1.9977911884199999E-2</c:v>
                </c:pt>
                <c:pt idx="472">
                  <c:v>9.6265299306499995E-4</c:v>
                </c:pt>
                <c:pt idx="473">
                  <c:v>2.7959536337699999E-3</c:v>
                </c:pt>
                <c:pt idx="474">
                  <c:v>3.6975547766899999E-2</c:v>
                </c:pt>
                <c:pt idx="475">
                  <c:v>2.37924315455E-3</c:v>
                </c:pt>
                <c:pt idx="476">
                  <c:v>2.3483286026400002E-3</c:v>
                </c:pt>
                <c:pt idx="477">
                  <c:v>2.3603220664600001E-2</c:v>
                </c:pt>
                <c:pt idx="478">
                  <c:v>7.1457737852199997E-4</c:v>
                </c:pt>
                <c:pt idx="479">
                  <c:v>1.11198056093E-3</c:v>
                </c:pt>
                <c:pt idx="480">
                  <c:v>1.3072432788E-2</c:v>
                </c:pt>
                <c:pt idx="481">
                  <c:v>1.7288635884500001E-3</c:v>
                </c:pt>
                <c:pt idx="482">
                  <c:v>1.4012528849299999E-3</c:v>
                </c:pt>
                <c:pt idx="483">
                  <c:v>9.6497053208299995E-3</c:v>
                </c:pt>
                <c:pt idx="484">
                  <c:v>2.35999833949E-2</c:v>
                </c:pt>
                <c:pt idx="485">
                  <c:v>3.7770306728099998E-3</c:v>
                </c:pt>
                <c:pt idx="486">
                  <c:v>2.2932386447699999E-3</c:v>
                </c:pt>
                <c:pt idx="487">
                  <c:v>1.46329993127E-2</c:v>
                </c:pt>
                <c:pt idx="488">
                  <c:v>8.7467636974300001E-4</c:v>
                </c:pt>
                <c:pt idx="489">
                  <c:v>2.0741508944799999E-3</c:v>
                </c:pt>
                <c:pt idx="490">
                  <c:v>9.0637024369399997E-4</c:v>
                </c:pt>
                <c:pt idx="491">
                  <c:v>2.8523604563800002E-3</c:v>
                </c:pt>
                <c:pt idx="492">
                  <c:v>4.2860289010500001E-3</c:v>
                </c:pt>
                <c:pt idx="493">
                  <c:v>2.28760878574E-3</c:v>
                </c:pt>
                <c:pt idx="494">
                  <c:v>2.0412113533599999E-3</c:v>
                </c:pt>
                <c:pt idx="495">
                  <c:v>3.6279893711200002E-2</c:v>
                </c:pt>
                <c:pt idx="496">
                  <c:v>9.2094333489799998E-4</c:v>
                </c:pt>
                <c:pt idx="497">
                  <c:v>7.1696037196799997E-3</c:v>
                </c:pt>
                <c:pt idx="498">
                  <c:v>2.3589963542799998E-3</c:v>
                </c:pt>
                <c:pt idx="499">
                  <c:v>1.3606899876799999E-2</c:v>
                </c:pt>
                <c:pt idx="500">
                  <c:v>2.01656078235E-3</c:v>
                </c:pt>
                <c:pt idx="501">
                  <c:v>4.7236655644799998E-4</c:v>
                </c:pt>
                <c:pt idx="502">
                  <c:v>1.6617397540600001E-2</c:v>
                </c:pt>
                <c:pt idx="503">
                  <c:v>2.0513927877300001E-3</c:v>
                </c:pt>
                <c:pt idx="504">
                  <c:v>7.9193274885400004E-3</c:v>
                </c:pt>
                <c:pt idx="505">
                  <c:v>4.6934086015699997E-2</c:v>
                </c:pt>
                <c:pt idx="506">
                  <c:v>2.0202387885800001E-3</c:v>
                </c:pt>
                <c:pt idx="507">
                  <c:v>7.6298020066399997E-4</c:v>
                </c:pt>
                <c:pt idx="508">
                  <c:v>7.8175647332499995E-4</c:v>
                </c:pt>
                <c:pt idx="509">
                  <c:v>1.1234023041199999E-2</c:v>
                </c:pt>
                <c:pt idx="510">
                  <c:v>1.7802848455799999E-3</c:v>
                </c:pt>
                <c:pt idx="511">
                  <c:v>3.0963437E-2</c:v>
                </c:pt>
                <c:pt idx="512">
                  <c:v>8.21917808219E-4</c:v>
                </c:pt>
                <c:pt idx="513">
                  <c:v>1.86849346701E-2</c:v>
                </c:pt>
                <c:pt idx="514">
                  <c:v>2.4984010233499998E-3</c:v>
                </c:pt>
                <c:pt idx="515">
                  <c:v>6.9646548782699999E-3</c:v>
                </c:pt>
                <c:pt idx="516">
                  <c:v>1.0084956932899999E-2</c:v>
                </c:pt>
                <c:pt idx="517">
                  <c:v>6.1770337883700001E-4</c:v>
                </c:pt>
                <c:pt idx="518">
                  <c:v>1.3367884172399999E-3</c:v>
                </c:pt>
                <c:pt idx="519">
                  <c:v>5.2943476203200002E-2</c:v>
                </c:pt>
                <c:pt idx="520">
                  <c:v>5.6810140913399997E-3</c:v>
                </c:pt>
                <c:pt idx="521">
                  <c:v>1.0274346923199999E-2</c:v>
                </c:pt>
                <c:pt idx="522">
                  <c:v>4.05533276258E-4</c:v>
                </c:pt>
                <c:pt idx="523">
                  <c:v>6.3124196857299996E-4</c:v>
                </c:pt>
                <c:pt idx="524">
                  <c:v>4.7418085257699998E-4</c:v>
                </c:pt>
                <c:pt idx="525">
                  <c:v>8.0532461687899998E-4</c:v>
                </c:pt>
                <c:pt idx="526">
                  <c:v>4.36448280879E-4</c:v>
                </c:pt>
                <c:pt idx="527">
                  <c:v>2.64257311119E-3</c:v>
                </c:pt>
                <c:pt idx="528">
                  <c:v>2.8941275520899998E-3</c:v>
                </c:pt>
                <c:pt idx="529">
                  <c:v>2.4364123159299998E-3</c:v>
                </c:pt>
                <c:pt idx="530">
                  <c:v>1.6009148084600001E-3</c:v>
                </c:pt>
                <c:pt idx="531">
                  <c:v>2.43431545371E-3</c:v>
                </c:pt>
                <c:pt idx="532">
                  <c:v>1.4282249589000001E-3</c:v>
                </c:pt>
                <c:pt idx="533">
                  <c:v>6.7110340585000003E-4</c:v>
                </c:pt>
                <c:pt idx="534">
                  <c:v>2.245443632E-2</c:v>
                </c:pt>
                <c:pt idx="535">
                  <c:v>3.1459078620399997E-2</c:v>
                </c:pt>
                <c:pt idx="536">
                  <c:v>2.8655641067599998E-3</c:v>
                </c:pt>
                <c:pt idx="537">
                  <c:v>5.4586079135699999E-3</c:v>
                </c:pt>
                <c:pt idx="538">
                  <c:v>4.5868929533900003E-4</c:v>
                </c:pt>
                <c:pt idx="539">
                  <c:v>2.3568932354499999E-3</c:v>
                </c:pt>
                <c:pt idx="540">
                  <c:v>3.0897658282699999E-3</c:v>
                </c:pt>
                <c:pt idx="541">
                  <c:v>6.85925339665E-4</c:v>
                </c:pt>
                <c:pt idx="542">
                  <c:v>5.8381561579900002E-4</c:v>
                </c:pt>
                <c:pt idx="543">
                  <c:v>2.2266313933E-2</c:v>
                </c:pt>
                <c:pt idx="544">
                  <c:v>9.2437414894700008E-3</c:v>
                </c:pt>
                <c:pt idx="545">
                  <c:v>3.68885719204E-3</c:v>
                </c:pt>
                <c:pt idx="546">
                  <c:v>1.7374706343E-3</c:v>
                </c:pt>
                <c:pt idx="547">
                  <c:v>6.5623177133999997E-4</c:v>
                </c:pt>
                <c:pt idx="548">
                  <c:v>1.4763184007399999E-3</c:v>
                </c:pt>
                <c:pt idx="549">
                  <c:v>8.8760945184099998E-4</c:v>
                </c:pt>
                <c:pt idx="550">
                  <c:v>2.6896038772499999E-2</c:v>
                </c:pt>
                <c:pt idx="551">
                  <c:v>2.0016242296900001E-2</c:v>
                </c:pt>
                <c:pt idx="552">
                  <c:v>1.93482928671E-3</c:v>
                </c:pt>
                <c:pt idx="553">
                  <c:v>3.35775335775E-3</c:v>
                </c:pt>
                <c:pt idx="554">
                  <c:v>4.9233099791700001E-3</c:v>
                </c:pt>
                <c:pt idx="555">
                  <c:v>2.0198698827999999E-3</c:v>
                </c:pt>
                <c:pt idx="556">
                  <c:v>4.1933141237400001E-3</c:v>
                </c:pt>
                <c:pt idx="557">
                  <c:v>1.2427020563199999E-3</c:v>
                </c:pt>
                <c:pt idx="558">
                  <c:v>2.7348367209800001E-3</c:v>
                </c:pt>
                <c:pt idx="559">
                  <c:v>2.18275622582E-3</c:v>
                </c:pt>
                <c:pt idx="560">
                  <c:v>3.2154798321099999E-2</c:v>
                </c:pt>
                <c:pt idx="561">
                  <c:v>1.04766893662E-3</c:v>
                </c:pt>
                <c:pt idx="562">
                  <c:v>2.568260403E-2</c:v>
                </c:pt>
                <c:pt idx="563">
                  <c:v>2.3486317603999999E-2</c:v>
                </c:pt>
                <c:pt idx="564">
                  <c:v>3.0571296543999999E-2</c:v>
                </c:pt>
                <c:pt idx="565">
                  <c:v>1.8703847648699999E-3</c:v>
                </c:pt>
                <c:pt idx="566">
                  <c:v>6.4545147869099996E-3</c:v>
                </c:pt>
                <c:pt idx="567">
                  <c:v>3.8988143017700001E-3</c:v>
                </c:pt>
                <c:pt idx="568">
                  <c:v>7.0164774330799998E-2</c:v>
                </c:pt>
                <c:pt idx="569">
                  <c:v>2.49287598945E-2</c:v>
                </c:pt>
                <c:pt idx="570">
                  <c:v>7.37494655836E-3</c:v>
                </c:pt>
                <c:pt idx="571">
                  <c:v>2.59585514277E-3</c:v>
                </c:pt>
                <c:pt idx="572">
                  <c:v>7.02935287351E-4</c:v>
                </c:pt>
                <c:pt idx="573">
                  <c:v>5.9739705568600003E-4</c:v>
                </c:pt>
                <c:pt idx="574">
                  <c:v>5.6869393536199998E-3</c:v>
                </c:pt>
                <c:pt idx="575">
                  <c:v>5.8502747539800005E-4</c:v>
                </c:pt>
                <c:pt idx="576">
                  <c:v>5.2486303375E-3</c:v>
                </c:pt>
                <c:pt idx="577">
                  <c:v>1.61317710987E-3</c:v>
                </c:pt>
                <c:pt idx="578">
                  <c:v>2.3774650279099999E-3</c:v>
                </c:pt>
                <c:pt idx="579">
                  <c:v>1.7387616624300001E-3</c:v>
                </c:pt>
                <c:pt idx="580">
                  <c:v>9.3949642991399997E-4</c:v>
                </c:pt>
                <c:pt idx="581">
                  <c:v>6.4038252182600005E-4</c:v>
                </c:pt>
                <c:pt idx="582">
                  <c:v>4.4850711204100002E-4</c:v>
                </c:pt>
                <c:pt idx="583">
                  <c:v>8.9609558352900004E-4</c:v>
                </c:pt>
                <c:pt idx="584">
                  <c:v>4.1806939952000001E-4</c:v>
                </c:pt>
                <c:pt idx="585">
                  <c:v>6.2143417675900002E-3</c:v>
                </c:pt>
                <c:pt idx="586">
                  <c:v>5.5694618272800001E-3</c:v>
                </c:pt>
                <c:pt idx="587">
                  <c:v>9.3747452514900001E-4</c:v>
                </c:pt>
                <c:pt idx="588">
                  <c:v>2.01249414973E-2</c:v>
                </c:pt>
                <c:pt idx="589">
                  <c:v>2.80236285559E-3</c:v>
                </c:pt>
                <c:pt idx="590">
                  <c:v>1.39587356827E-3</c:v>
                </c:pt>
                <c:pt idx="591">
                  <c:v>4.3634693408899999E-2</c:v>
                </c:pt>
                <c:pt idx="592">
                  <c:v>1.7711516378299999E-2</c:v>
                </c:pt>
                <c:pt idx="593">
                  <c:v>5.2504667081500005E-4</c:v>
                </c:pt>
                <c:pt idx="594">
                  <c:v>4.2194500231700002E-2</c:v>
                </c:pt>
                <c:pt idx="595">
                  <c:v>4.3440698657200003E-2</c:v>
                </c:pt>
                <c:pt idx="596">
                  <c:v>2.61096605744E-3</c:v>
                </c:pt>
                <c:pt idx="597">
                  <c:v>1.3692040114E-3</c:v>
                </c:pt>
                <c:pt idx="598">
                  <c:v>7.05486514354E-4</c:v>
                </c:pt>
                <c:pt idx="599">
                  <c:v>1.1906035005200001E-2</c:v>
                </c:pt>
                <c:pt idx="600">
                  <c:v>1.7808683853500001E-3</c:v>
                </c:pt>
                <c:pt idx="601">
                  <c:v>3.0351303764599999E-3</c:v>
                </c:pt>
                <c:pt idx="602">
                  <c:v>1.6963528413899999E-3</c:v>
                </c:pt>
                <c:pt idx="603">
                  <c:v>1.7020734058999999E-2</c:v>
                </c:pt>
                <c:pt idx="604">
                  <c:v>1.6339248995599999E-2</c:v>
                </c:pt>
                <c:pt idx="605">
                  <c:v>2.6668422612200001E-3</c:v>
                </c:pt>
                <c:pt idx="606">
                  <c:v>9.4435852719600005E-3</c:v>
                </c:pt>
                <c:pt idx="607">
                  <c:v>1.13520450133E-2</c:v>
                </c:pt>
                <c:pt idx="608">
                  <c:v>4.4253611028900004E-3</c:v>
                </c:pt>
                <c:pt idx="609">
                  <c:v>2.39206354112E-2</c:v>
                </c:pt>
                <c:pt idx="610">
                  <c:v>7.8783811851900004E-2</c:v>
                </c:pt>
                <c:pt idx="611">
                  <c:v>3.7716955941299998E-3</c:v>
                </c:pt>
                <c:pt idx="612">
                  <c:v>4.0676969320700002E-3</c:v>
                </c:pt>
                <c:pt idx="613">
                  <c:v>1.5835585314199999E-3</c:v>
                </c:pt>
                <c:pt idx="614">
                  <c:v>3.3410078418499999E-3</c:v>
                </c:pt>
                <c:pt idx="615">
                  <c:v>1.9527163679500001E-3</c:v>
                </c:pt>
                <c:pt idx="616">
                  <c:v>1.23943965131E-2</c:v>
                </c:pt>
                <c:pt idx="617">
                  <c:v>0.11080243956999999</c:v>
                </c:pt>
                <c:pt idx="618">
                  <c:v>6.8576340228299996E-3</c:v>
                </c:pt>
                <c:pt idx="619">
                  <c:v>4.9989740911399998E-3</c:v>
                </c:pt>
                <c:pt idx="620">
                  <c:v>1.5572943438600001E-2</c:v>
                </c:pt>
                <c:pt idx="621">
                  <c:v>1.39996490339E-2</c:v>
                </c:pt>
                <c:pt idx="622">
                  <c:v>1.4176291305700001E-2</c:v>
                </c:pt>
                <c:pt idx="623">
                  <c:v>2.8514056224900001E-3</c:v>
                </c:pt>
                <c:pt idx="624">
                  <c:v>6.2615396965599998E-3</c:v>
                </c:pt>
                <c:pt idx="625">
                  <c:v>3.74004580506E-3</c:v>
                </c:pt>
                <c:pt idx="626">
                  <c:v>2.4190664507E-3</c:v>
                </c:pt>
                <c:pt idx="627">
                  <c:v>3.1185031185000001E-3</c:v>
                </c:pt>
                <c:pt idx="628">
                  <c:v>1.8717187856700001E-3</c:v>
                </c:pt>
                <c:pt idx="629">
                  <c:v>1.3121180675700001E-2</c:v>
                </c:pt>
                <c:pt idx="630">
                  <c:v>2.4905123339699999E-3</c:v>
                </c:pt>
                <c:pt idx="631">
                  <c:v>1.16976166106E-3</c:v>
                </c:pt>
                <c:pt idx="632">
                  <c:v>1.0724906157100001E-3</c:v>
                </c:pt>
                <c:pt idx="633">
                  <c:v>4.5732303480599999E-2</c:v>
                </c:pt>
                <c:pt idx="634">
                  <c:v>1.68724782981E-3</c:v>
                </c:pt>
                <c:pt idx="635">
                  <c:v>4.6505935626E-4</c:v>
                </c:pt>
                <c:pt idx="636">
                  <c:v>6.3649048936299996E-4</c:v>
                </c:pt>
                <c:pt idx="637">
                  <c:v>3.5211079325199998E-2</c:v>
                </c:pt>
                <c:pt idx="638">
                  <c:v>5.2397693714E-2</c:v>
                </c:pt>
                <c:pt idx="639">
                  <c:v>3.5280835450200001E-3</c:v>
                </c:pt>
                <c:pt idx="640">
                  <c:v>4.4386644426199998E-3</c:v>
                </c:pt>
                <c:pt idx="641">
                  <c:v>8.55798031665E-4</c:v>
                </c:pt>
                <c:pt idx="642">
                  <c:v>3.814211012E-3</c:v>
                </c:pt>
                <c:pt idx="643">
                  <c:v>2.1850187726999998E-3</c:v>
                </c:pt>
                <c:pt idx="644">
                  <c:v>1.09226419943E-3</c:v>
                </c:pt>
                <c:pt idx="645">
                  <c:v>5.14668039115E-4</c:v>
                </c:pt>
                <c:pt idx="646">
                  <c:v>4.4086886564799997E-3</c:v>
                </c:pt>
                <c:pt idx="647">
                  <c:v>2.3530928665799998E-3</c:v>
                </c:pt>
                <c:pt idx="648">
                  <c:v>5.0717541786300002E-2</c:v>
                </c:pt>
                <c:pt idx="649">
                  <c:v>3.0097054546700001E-3</c:v>
                </c:pt>
                <c:pt idx="650">
                  <c:v>6.7997293640100001E-3</c:v>
                </c:pt>
                <c:pt idx="651">
                  <c:v>8.3243096913899993E-3</c:v>
                </c:pt>
                <c:pt idx="652">
                  <c:v>1.62706348937E-3</c:v>
                </c:pt>
                <c:pt idx="653">
                  <c:v>1.52967570875E-3</c:v>
                </c:pt>
                <c:pt idx="654">
                  <c:v>3.0592474251299999E-4</c:v>
                </c:pt>
                <c:pt idx="655">
                  <c:v>2.61824611513E-3</c:v>
                </c:pt>
                <c:pt idx="656">
                  <c:v>1.6008612008200002E-2</c:v>
                </c:pt>
                <c:pt idx="657">
                  <c:v>5.54016620499E-4</c:v>
                </c:pt>
                <c:pt idx="658">
                  <c:v>2.05450246153E-2</c:v>
                </c:pt>
                <c:pt idx="659">
                  <c:v>8.1534399751500002E-4</c:v>
                </c:pt>
                <c:pt idx="660">
                  <c:v>2.8412408048899998E-3</c:v>
                </c:pt>
                <c:pt idx="661">
                  <c:v>2.7086719173200001E-3</c:v>
                </c:pt>
                <c:pt idx="662">
                  <c:v>3.582395087E-3</c:v>
                </c:pt>
                <c:pt idx="663">
                  <c:v>4.2564168708899997E-3</c:v>
                </c:pt>
                <c:pt idx="664">
                  <c:v>6.1355032418099996E-3</c:v>
                </c:pt>
                <c:pt idx="665">
                  <c:v>2.2219110302000002E-2</c:v>
                </c:pt>
                <c:pt idx="666">
                  <c:v>2.70851850119E-2</c:v>
                </c:pt>
                <c:pt idx="667">
                  <c:v>2.3449957790100001E-3</c:v>
                </c:pt>
                <c:pt idx="668">
                  <c:v>4.4781747902300001E-3</c:v>
                </c:pt>
                <c:pt idx="669">
                  <c:v>2.31187145995E-3</c:v>
                </c:pt>
                <c:pt idx="670">
                  <c:v>2.14408233276E-3</c:v>
                </c:pt>
                <c:pt idx="671">
                  <c:v>1.9232248634499999E-3</c:v>
                </c:pt>
                <c:pt idx="672">
                  <c:v>1.12410071942E-3</c:v>
                </c:pt>
                <c:pt idx="673">
                  <c:v>3.05464419052E-3</c:v>
                </c:pt>
                <c:pt idx="674">
                  <c:v>6.1820263308500004E-3</c:v>
                </c:pt>
                <c:pt idx="675">
                  <c:v>1.30703422053E-3</c:v>
                </c:pt>
                <c:pt idx="676">
                  <c:v>0.22661343978699999</c:v>
                </c:pt>
                <c:pt idx="677">
                  <c:v>8.1422173972000005E-4</c:v>
                </c:pt>
                <c:pt idx="678">
                  <c:v>2.7207182696199999E-4</c:v>
                </c:pt>
                <c:pt idx="679">
                  <c:v>4.0944452026799998E-4</c:v>
                </c:pt>
                <c:pt idx="680">
                  <c:v>3.2813781788399999E-4</c:v>
                </c:pt>
                <c:pt idx="681">
                  <c:v>1.73310225303E-3</c:v>
                </c:pt>
                <c:pt idx="682">
                  <c:v>4.6992481202999996E-3</c:v>
                </c:pt>
                <c:pt idx="683">
                  <c:v>4.9677098857400001E-4</c:v>
                </c:pt>
                <c:pt idx="684">
                  <c:v>1.5037593985000001E-3</c:v>
                </c:pt>
                <c:pt idx="685">
                  <c:v>3.4980566352000003E-2</c:v>
                </c:pt>
                <c:pt idx="686">
                  <c:v>3.9106145251399998E-3</c:v>
                </c:pt>
                <c:pt idx="687">
                  <c:v>3.9259674705599996E-3</c:v>
                </c:pt>
                <c:pt idx="688">
                  <c:v>1.05152471083E-3</c:v>
                </c:pt>
                <c:pt idx="689">
                  <c:v>2.1598272138199999E-3</c:v>
                </c:pt>
                <c:pt idx="690">
                  <c:v>2.7548209366400002E-3</c:v>
                </c:pt>
                <c:pt idx="691">
                  <c:v>1.10375275938E-3</c:v>
                </c:pt>
                <c:pt idx="692">
                  <c:v>1.1350737798000001E-3</c:v>
                </c:pt>
                <c:pt idx="693">
                  <c:v>3.9473684210500001E-2</c:v>
                </c:pt>
                <c:pt idx="694">
                  <c:v>4.5632333767900001E-3</c:v>
                </c:pt>
                <c:pt idx="695">
                  <c:v>0</c:v>
                </c:pt>
                <c:pt idx="696">
                  <c:v>1.6103059581300001E-3</c:v>
                </c:pt>
                <c:pt idx="697">
                  <c:v>2.4174053182899999E-3</c:v>
                </c:pt>
                <c:pt idx="698">
                  <c:v>2.6019080659199999E-3</c:v>
                </c:pt>
                <c:pt idx="699">
                  <c:v>0</c:v>
                </c:pt>
                <c:pt idx="700">
                  <c:v>8.8105726872200003E-4</c:v>
                </c:pt>
                <c:pt idx="7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10E-4D19-8684-577015353C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2038896"/>
        <c:axId val="682039880"/>
      </c:scatterChart>
      <c:valAx>
        <c:axId val="682038896"/>
        <c:scaling>
          <c:orientation val="minMax"/>
          <c:max val="14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Genomic</a:t>
                </a:r>
                <a:r>
                  <a:rPr lang="en-US" b="0" baseline="0" dirty="0"/>
                  <a:t> A/C </a:t>
                </a:r>
                <a:r>
                  <a:rPr lang="en-US" b="0" dirty="0"/>
                  <a:t>position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2039880"/>
        <c:crosses val="autoZero"/>
        <c:crossBetween val="midCat"/>
        <c:majorUnit val="500"/>
      </c:valAx>
      <c:valAx>
        <c:axId val="6820398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Mutation rate</a:t>
                </a:r>
              </a:p>
            </c:rich>
          </c:tx>
          <c:overlay val="0"/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2038896"/>
        <c:crosses val="autoZero"/>
        <c:crossBetween val="midCat"/>
      </c:valAx>
    </c:plotArea>
    <c:legend>
      <c:legendPos val="b"/>
      <c:overlay val="0"/>
    </c:legend>
    <c:plotVisOnly val="1"/>
    <c:dispBlanksAs val="gap"/>
    <c:showDLblsOverMax val="0"/>
    <c:extLst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OI1combined(old)'!$I$46:$I$63</c:f>
                <c:numCache>
                  <c:formatCode>General</c:formatCode>
                  <c:ptCount val="18"/>
                  <c:pt idx="0">
                    <c:v>8.2374881862758945E-2</c:v>
                  </c:pt>
                  <c:pt idx="1">
                    <c:v>7.0213725209170394E-2</c:v>
                  </c:pt>
                  <c:pt idx="2">
                    <c:v>0.12292273710564894</c:v>
                  </c:pt>
                  <c:pt idx="3">
                    <c:v>0.11913655796569265</c:v>
                  </c:pt>
                  <c:pt idx="4">
                    <c:v>7.6428177221673749E-2</c:v>
                  </c:pt>
                  <c:pt idx="5">
                    <c:v>7.1249413441429946E-2</c:v>
                  </c:pt>
                  <c:pt idx="6">
                    <c:v>9.7149606135788977E-2</c:v>
                  </c:pt>
                  <c:pt idx="7">
                    <c:v>0.14546469740910109</c:v>
                  </c:pt>
                  <c:pt idx="8">
                    <c:v>0.1081626783528826</c:v>
                  </c:pt>
                  <c:pt idx="9">
                    <c:v>2.7684495742215705E-2</c:v>
                  </c:pt>
                  <c:pt idx="10">
                    <c:v>0.14007371014748493</c:v>
                  </c:pt>
                  <c:pt idx="11">
                    <c:v>0.11952846756536453</c:v>
                  </c:pt>
                  <c:pt idx="12">
                    <c:v>0.10068713656554713</c:v>
                  </c:pt>
                  <c:pt idx="13">
                    <c:v>9.1454006079466479E-2</c:v>
                  </c:pt>
                  <c:pt idx="14">
                    <c:v>3.7996310968386592E-2</c:v>
                  </c:pt>
                  <c:pt idx="15">
                    <c:v>0.24098706380042936</c:v>
                  </c:pt>
                  <c:pt idx="16">
                    <c:v>8.879472236457607E-2</c:v>
                  </c:pt>
                  <c:pt idx="17">
                    <c:v>4.0933544766314264E-2</c:v>
                  </c:pt>
                </c:numCache>
              </c:numRef>
            </c:plus>
            <c:minus>
              <c:numRef>
                <c:f>'MOI1combined(old)'!$I$46:$I$63</c:f>
                <c:numCache>
                  <c:formatCode>General</c:formatCode>
                  <c:ptCount val="18"/>
                  <c:pt idx="0">
                    <c:v>8.2374881862758945E-2</c:v>
                  </c:pt>
                  <c:pt idx="1">
                    <c:v>7.0213725209170394E-2</c:v>
                  </c:pt>
                  <c:pt idx="2">
                    <c:v>0.12292273710564894</c:v>
                  </c:pt>
                  <c:pt idx="3">
                    <c:v>0.11913655796569265</c:v>
                  </c:pt>
                  <c:pt idx="4">
                    <c:v>7.6428177221673749E-2</c:v>
                  </c:pt>
                  <c:pt idx="5">
                    <c:v>7.1249413441429946E-2</c:v>
                  </c:pt>
                  <c:pt idx="6">
                    <c:v>9.7149606135788977E-2</c:v>
                  </c:pt>
                  <c:pt idx="7">
                    <c:v>0.14546469740910109</c:v>
                  </c:pt>
                  <c:pt idx="8">
                    <c:v>0.1081626783528826</c:v>
                  </c:pt>
                  <c:pt idx="9">
                    <c:v>2.7684495742215705E-2</c:v>
                  </c:pt>
                  <c:pt idx="10">
                    <c:v>0.14007371014748493</c:v>
                  </c:pt>
                  <c:pt idx="11">
                    <c:v>0.11952846756536453</c:v>
                  </c:pt>
                  <c:pt idx="12">
                    <c:v>0.10068713656554713</c:v>
                  </c:pt>
                  <c:pt idx="13">
                    <c:v>9.1454006079466479E-2</c:v>
                  </c:pt>
                  <c:pt idx="14">
                    <c:v>3.7996310968386592E-2</c:v>
                  </c:pt>
                  <c:pt idx="15">
                    <c:v>0.24098706380042936</c:v>
                  </c:pt>
                  <c:pt idx="16">
                    <c:v>8.879472236457607E-2</c:v>
                  </c:pt>
                  <c:pt idx="17">
                    <c:v>4.09335447663142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OI1combined(old)'!$A$46:$A$63</c:f>
              <c:strCache>
                <c:ptCount val="18"/>
                <c:pt idx="0">
                  <c:v>U159
wt</c:v>
                </c:pt>
                <c:pt idx="1">
                  <c:v>U227
wt</c:v>
                </c:pt>
                <c:pt idx="2">
                  <c:v>U501
wt</c:v>
                </c:pt>
                <c:pt idx="3">
                  <c:v>U1070
wt</c:v>
                </c:pt>
                <c:pt idx="4">
                  <c:v>U1151
wt</c:v>
                </c:pt>
                <c:pt idx="5">
                  <c:v>U1233
wt</c:v>
                </c:pt>
                <c:pt idx="6">
                  <c:v>U1873
wt</c:v>
                </c:pt>
                <c:pt idx="7">
                  <c:v>U2070
wt</c:v>
                </c:pt>
                <c:pt idx="8">
                  <c:v>U2515
wt</c:v>
                </c:pt>
                <c:pt idx="9">
                  <c:v>U2576
wt</c:v>
                </c:pt>
                <c:pt idx="10">
                  <c:v>wt
U534</c:v>
                </c:pt>
                <c:pt idx="11">
                  <c:v>wt
U667</c:v>
                </c:pt>
                <c:pt idx="12">
                  <c:v>wt
U903</c:v>
                </c:pt>
                <c:pt idx="13">
                  <c:v>wt
U968</c:v>
                </c:pt>
                <c:pt idx="14">
                  <c:v>wt
U1155</c:v>
                </c:pt>
                <c:pt idx="15">
                  <c:v>n/a
n/a</c:v>
                </c:pt>
                <c:pt idx="16">
                  <c:v>wt
wt</c:v>
                </c:pt>
                <c:pt idx="17">
                  <c:v>purified
FHV</c:v>
                </c:pt>
              </c:strCache>
            </c:strRef>
          </c:cat>
          <c:val>
            <c:numRef>
              <c:f>'MOI1combined(old)'!$H$46:$H$63</c:f>
              <c:numCache>
                <c:formatCode>General</c:formatCode>
                <c:ptCount val="18"/>
                <c:pt idx="0">
                  <c:v>0.14464968747084617</c:v>
                </c:pt>
                <c:pt idx="1">
                  <c:v>0.42219423453680377</c:v>
                </c:pt>
                <c:pt idx="2">
                  <c:v>0.77012781043007739</c:v>
                </c:pt>
                <c:pt idx="3">
                  <c:v>0.67315048045526638</c:v>
                </c:pt>
                <c:pt idx="4">
                  <c:v>0.66974408811143493</c:v>
                </c:pt>
                <c:pt idx="5">
                  <c:v>0.16988525048978451</c:v>
                </c:pt>
                <c:pt idx="6">
                  <c:v>0.83291351805205704</c:v>
                </c:pt>
                <c:pt idx="7">
                  <c:v>0.68518518518518523</c:v>
                </c:pt>
                <c:pt idx="8">
                  <c:v>0.77518626498218335</c:v>
                </c:pt>
                <c:pt idx="9">
                  <c:v>0.76391318432134758</c:v>
                </c:pt>
                <c:pt idx="10">
                  <c:v>0.65938986845787861</c:v>
                </c:pt>
                <c:pt idx="11">
                  <c:v>0.85201382140157644</c:v>
                </c:pt>
                <c:pt idx="12">
                  <c:v>0.91945144136579915</c:v>
                </c:pt>
                <c:pt idx="13">
                  <c:v>0.97896258979382411</c:v>
                </c:pt>
                <c:pt idx="14">
                  <c:v>0.99188357122865944</c:v>
                </c:pt>
                <c:pt idx="15">
                  <c:v>0</c:v>
                </c:pt>
                <c:pt idx="16">
                  <c:v>0.94964542132074137</c:v>
                </c:pt>
                <c:pt idx="17">
                  <c:v>1.0000699692135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5C-4D71-9F28-D0792BEBEC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63085519"/>
        <c:axId val="1271426111"/>
      </c:barChart>
      <c:catAx>
        <c:axId val="12630855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426111"/>
        <c:crosses val="autoZero"/>
        <c:auto val="0"/>
        <c:lblAlgn val="ctr"/>
        <c:lblOffset val="100"/>
        <c:noMultiLvlLbl val="0"/>
      </c:catAx>
      <c:valAx>
        <c:axId val="1271426111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>
                    <a:effectLst/>
                  </a:rPr>
                  <a:t>Relative virulence</a:t>
                </a:r>
                <a:endParaRPr lang="en-US" sz="10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3085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ntrols!$D$1</c:f>
              <c:strCache>
                <c:ptCount val="1"/>
                <c:pt idx="0">
                  <c:v>3A/3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controls!$A$2:$A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D$2:$D$345</c:f>
              <c:numCache>
                <c:formatCode>0.00</c:formatCode>
                <c:ptCount val="344"/>
                <c:pt idx="0">
                  <c:v>0.81244711980603623</c:v>
                </c:pt>
                <c:pt idx="1">
                  <c:v>1.0113739939643991</c:v>
                </c:pt>
                <c:pt idx="2">
                  <c:v>1.1077358764583434</c:v>
                </c:pt>
                <c:pt idx="3">
                  <c:v>0.79171010193373914</c:v>
                </c:pt>
                <c:pt idx="4">
                  <c:v>1.1855048484295905</c:v>
                </c:pt>
                <c:pt idx="5">
                  <c:v>1.2815007367743811</c:v>
                </c:pt>
                <c:pt idx="6">
                  <c:v>1.2738958371850158</c:v>
                </c:pt>
                <c:pt idx="7">
                  <c:v>1.2851022720704897</c:v>
                </c:pt>
                <c:pt idx="8">
                  <c:v>1.0439961680771539</c:v>
                </c:pt>
                <c:pt idx="9">
                  <c:v>1.2244088864564902</c:v>
                </c:pt>
                <c:pt idx="10">
                  <c:v>1.0009100493475953</c:v>
                </c:pt>
                <c:pt idx="11">
                  <c:v>1.2251644565285873</c:v>
                </c:pt>
                <c:pt idx="12">
                  <c:v>1.1617504467040158</c:v>
                </c:pt>
                <c:pt idx="13">
                  <c:v>1.0394796012278893</c:v>
                </c:pt>
                <c:pt idx="14">
                  <c:v>1.5379897232443287</c:v>
                </c:pt>
                <c:pt idx="15">
                  <c:v>1.1755209754963827</c:v>
                </c:pt>
                <c:pt idx="16">
                  <c:v>1.0637276832212144</c:v>
                </c:pt>
                <c:pt idx="17">
                  <c:v>1.0971873506273468</c:v>
                </c:pt>
                <c:pt idx="18">
                  <c:v>1.3562822535082943</c:v>
                </c:pt>
                <c:pt idx="19">
                  <c:v>1.1834890648931444</c:v>
                </c:pt>
                <c:pt idx="20">
                  <c:v>1.3368796151985565</c:v>
                </c:pt>
                <c:pt idx="21">
                  <c:v>1.734952973300312</c:v>
                </c:pt>
                <c:pt idx="22">
                  <c:v>1.0070552365138012</c:v>
                </c:pt>
                <c:pt idx="23">
                  <c:v>1.1619606257472002</c:v>
                </c:pt>
                <c:pt idx="24">
                  <c:v>1.3505909470709094</c:v>
                </c:pt>
                <c:pt idx="25">
                  <c:v>1.3018220802210509</c:v>
                </c:pt>
                <c:pt idx="26">
                  <c:v>1.0207637206072402</c:v>
                </c:pt>
                <c:pt idx="27">
                  <c:v>1.3878600409830995</c:v>
                </c:pt>
                <c:pt idx="28">
                  <c:v>1.1295593859874222</c:v>
                </c:pt>
                <c:pt idx="29">
                  <c:v>1.6887149443588292</c:v>
                </c:pt>
                <c:pt idx="30">
                  <c:v>1.1124568506121388</c:v>
                </c:pt>
                <c:pt idx="31">
                  <c:v>1.0188108671786171</c:v>
                </c:pt>
                <c:pt idx="32">
                  <c:v>0.97197833418862911</c:v>
                </c:pt>
                <c:pt idx="33">
                  <c:v>1.0393654732227913</c:v>
                </c:pt>
                <c:pt idx="34">
                  <c:v>1.1533578247905267</c:v>
                </c:pt>
                <c:pt idx="35">
                  <c:v>1.5093208120704766</c:v>
                </c:pt>
                <c:pt idx="36">
                  <c:v>1.2139698019643601</c:v>
                </c:pt>
                <c:pt idx="37">
                  <c:v>1.0548668529989984</c:v>
                </c:pt>
                <c:pt idx="38">
                  <c:v>1.0274239513428725</c:v>
                </c:pt>
                <c:pt idx="39">
                  <c:v>0.95771781957921509</c:v>
                </c:pt>
                <c:pt idx="40">
                  <c:v>1.0079635933627118</c:v>
                </c:pt>
                <c:pt idx="41">
                  <c:v>0.99643962804311481</c:v>
                </c:pt>
                <c:pt idx="42">
                  <c:v>1.0290674884146669</c:v>
                </c:pt>
                <c:pt idx="43">
                  <c:v>1.9001927052376553</c:v>
                </c:pt>
                <c:pt idx="44">
                  <c:v>1.1752820974735567</c:v>
                </c:pt>
                <c:pt idx="45">
                  <c:v>1.2151426899265871</c:v>
                </c:pt>
                <c:pt idx="46">
                  <c:v>1.3159000437503092</c:v>
                </c:pt>
                <c:pt idx="47">
                  <c:v>1.1796989729695533</c:v>
                </c:pt>
                <c:pt idx="48">
                  <c:v>1.3471010164191821</c:v>
                </c:pt>
                <c:pt idx="49">
                  <c:v>1.1632463642984299</c:v>
                </c:pt>
                <c:pt idx="50">
                  <c:v>1.1679312189907116</c:v>
                </c:pt>
                <c:pt idx="51">
                  <c:v>1.3409926635057905</c:v>
                </c:pt>
                <c:pt idx="52">
                  <c:v>1.1193993674812088</c:v>
                </c:pt>
                <c:pt idx="53">
                  <c:v>1.1524889511091099</c:v>
                </c:pt>
                <c:pt idx="54">
                  <c:v>1.2994526918617504</c:v>
                </c:pt>
                <c:pt idx="55">
                  <c:v>1.3041352090859066</c:v>
                </c:pt>
                <c:pt idx="56">
                  <c:v>1.2350529589200596</c:v>
                </c:pt>
                <c:pt idx="57">
                  <c:v>1.0522311069719557</c:v>
                </c:pt>
                <c:pt idx="58">
                  <c:v>1.3514601155219594</c:v>
                </c:pt>
                <c:pt idx="59">
                  <c:v>1.1231921040171795</c:v>
                </c:pt>
                <c:pt idx="60">
                  <c:v>1.0219346699917395</c:v>
                </c:pt>
                <c:pt idx="61">
                  <c:v>1.1493081862585952</c:v>
                </c:pt>
                <c:pt idx="62">
                  <c:v>1.0649074080710395</c:v>
                </c:pt>
                <c:pt idx="63">
                  <c:v>1.4035510412594963</c:v>
                </c:pt>
                <c:pt idx="64">
                  <c:v>1.1294413775120398</c:v>
                </c:pt>
                <c:pt idx="65">
                  <c:v>1.009140888265873</c:v>
                </c:pt>
                <c:pt idx="66">
                  <c:v>1.2052949705311917</c:v>
                </c:pt>
                <c:pt idx="67">
                  <c:v>1.3776432323465293</c:v>
                </c:pt>
                <c:pt idx="68">
                  <c:v>1.2872643461488829</c:v>
                </c:pt>
                <c:pt idx="69">
                  <c:v>0.82742633901609619</c:v>
                </c:pt>
                <c:pt idx="70">
                  <c:v>0.87562095579221155</c:v>
                </c:pt>
                <c:pt idx="71">
                  <c:v>0.99655926979412779</c:v>
                </c:pt>
                <c:pt idx="72">
                  <c:v>0.99014167180691237</c:v>
                </c:pt>
                <c:pt idx="73">
                  <c:v>1.315496906124725</c:v>
                </c:pt>
                <c:pt idx="74">
                  <c:v>1.1008296039296201</c:v>
                </c:pt>
                <c:pt idx="75">
                  <c:v>1.331779458775848</c:v>
                </c:pt>
                <c:pt idx="76">
                  <c:v>1.0844590999215742</c:v>
                </c:pt>
                <c:pt idx="77">
                  <c:v>1.1349525642423772</c:v>
                </c:pt>
                <c:pt idx="78">
                  <c:v>1.0634889493914157</c:v>
                </c:pt>
                <c:pt idx="79">
                  <c:v>1.4664188161043721</c:v>
                </c:pt>
                <c:pt idx="80">
                  <c:v>1.1006800804286827</c:v>
                </c:pt>
                <c:pt idx="81">
                  <c:v>1.8129932428253757</c:v>
                </c:pt>
                <c:pt idx="82">
                  <c:v>1.2238879289188906</c:v>
                </c:pt>
                <c:pt idx="83">
                  <c:v>1.0360150413523912</c:v>
                </c:pt>
                <c:pt idx="84">
                  <c:v>1.1195377639699262</c:v>
                </c:pt>
                <c:pt idx="85">
                  <c:v>1.2178547651679923</c:v>
                </c:pt>
                <c:pt idx="86">
                  <c:v>1.0634821542447859</c:v>
                </c:pt>
                <c:pt idx="87">
                  <c:v>1.1118566431306929</c:v>
                </c:pt>
                <c:pt idx="88">
                  <c:v>1.1576783545835563</c:v>
                </c:pt>
                <c:pt idx="89">
                  <c:v>0.93603087766134607</c:v>
                </c:pt>
                <c:pt idx="90">
                  <c:v>1.1587993402349031</c:v>
                </c:pt>
                <c:pt idx="91">
                  <c:v>0.97446565048845479</c:v>
                </c:pt>
                <c:pt idx="92">
                  <c:v>1.1385327866914574</c:v>
                </c:pt>
                <c:pt idx="93">
                  <c:v>0.92302242661740252</c:v>
                </c:pt>
                <c:pt idx="94">
                  <c:v>0.8785399774379804</c:v>
                </c:pt>
                <c:pt idx="95">
                  <c:v>1.1465037112838838</c:v>
                </c:pt>
                <c:pt idx="96">
                  <c:v>1.1641761715796948</c:v>
                </c:pt>
                <c:pt idx="97">
                  <c:v>1.0157239236990525</c:v>
                </c:pt>
                <c:pt idx="98">
                  <c:v>1.1917006889127932</c:v>
                </c:pt>
                <c:pt idx="99">
                  <c:v>1.2742252761448056</c:v>
                </c:pt>
                <c:pt idx="100">
                  <c:v>1.4498383811961659</c:v>
                </c:pt>
                <c:pt idx="101">
                  <c:v>0.79580483834604043</c:v>
                </c:pt>
                <c:pt idx="102">
                  <c:v>1.0622624584899851</c:v>
                </c:pt>
                <c:pt idx="103">
                  <c:v>1.0050325351360707</c:v>
                </c:pt>
                <c:pt idx="104">
                  <c:v>1.0327121234112824</c:v>
                </c:pt>
                <c:pt idx="105">
                  <c:v>1.0565309458355003</c:v>
                </c:pt>
                <c:pt idx="106">
                  <c:v>0.95183515155490994</c:v>
                </c:pt>
                <c:pt idx="107">
                  <c:v>1.0247235129862338</c:v>
                </c:pt>
                <c:pt idx="108">
                  <c:v>1.3204147357172114</c:v>
                </c:pt>
                <c:pt idx="109">
                  <c:v>0.96975760117718968</c:v>
                </c:pt>
                <c:pt idx="110">
                  <c:v>0.94079496787174854</c:v>
                </c:pt>
                <c:pt idx="111">
                  <c:v>1.2032721960720663</c:v>
                </c:pt>
                <c:pt idx="112">
                  <c:v>1.2739314227189917</c:v>
                </c:pt>
                <c:pt idx="113">
                  <c:v>1.0931154634213869</c:v>
                </c:pt>
                <c:pt idx="114">
                  <c:v>1.2357566473892672</c:v>
                </c:pt>
                <c:pt idx="115">
                  <c:v>1.0358269528935502</c:v>
                </c:pt>
                <c:pt idx="116">
                  <c:v>1.1267066367535514</c:v>
                </c:pt>
                <c:pt idx="117">
                  <c:v>1.369573149384812</c:v>
                </c:pt>
                <c:pt idx="118">
                  <c:v>1.1674612176569985</c:v>
                </c:pt>
                <c:pt idx="119">
                  <c:v>1.1578863870370844</c:v>
                </c:pt>
                <c:pt idx="120">
                  <c:v>1.7553046555297842</c:v>
                </c:pt>
                <c:pt idx="121">
                  <c:v>1.2285136499166132</c:v>
                </c:pt>
                <c:pt idx="122">
                  <c:v>1.4009297568623926</c:v>
                </c:pt>
                <c:pt idx="123">
                  <c:v>1.0974435340678153</c:v>
                </c:pt>
                <c:pt idx="124">
                  <c:v>1.184580562890357</c:v>
                </c:pt>
                <c:pt idx="125">
                  <c:v>2.1410397622208763</c:v>
                </c:pt>
                <c:pt idx="126">
                  <c:v>0.84276237046360924</c:v>
                </c:pt>
                <c:pt idx="127">
                  <c:v>1.1710549904286027</c:v>
                </c:pt>
                <c:pt idx="128">
                  <c:v>1.2481559753140863</c:v>
                </c:pt>
                <c:pt idx="129">
                  <c:v>1.2814457912718642</c:v>
                </c:pt>
                <c:pt idx="130">
                  <c:v>1.320383016225831</c:v>
                </c:pt>
                <c:pt idx="131">
                  <c:v>0.97044114650626856</c:v>
                </c:pt>
                <c:pt idx="132">
                  <c:v>0.95212940899630016</c:v>
                </c:pt>
                <c:pt idx="133">
                  <c:v>1.3288092350230845</c:v>
                </c:pt>
                <c:pt idx="134">
                  <c:v>1.3498146866344782</c:v>
                </c:pt>
                <c:pt idx="135">
                  <c:v>1.1353207681863129</c:v>
                </c:pt>
                <c:pt idx="136">
                  <c:v>1.0975393037820484</c:v>
                </c:pt>
                <c:pt idx="137">
                  <c:v>1.4328472469895266</c:v>
                </c:pt>
                <c:pt idx="138">
                  <c:v>0.97186835982388997</c:v>
                </c:pt>
                <c:pt idx="139">
                  <c:v>1.5992004490377545</c:v>
                </c:pt>
                <c:pt idx="140">
                  <c:v>1.2796932277298783</c:v>
                </c:pt>
                <c:pt idx="141">
                  <c:v>1.2066706556626949</c:v>
                </c:pt>
                <c:pt idx="142">
                  <c:v>0.97062336276962669</c:v>
                </c:pt>
                <c:pt idx="143">
                  <c:v>1.2798241209321415</c:v>
                </c:pt>
                <c:pt idx="144">
                  <c:v>1.0845289534969935</c:v>
                </c:pt>
                <c:pt idx="145">
                  <c:v>1.1950265289257667</c:v>
                </c:pt>
                <c:pt idx="146">
                  <c:v>1.0081825939185984</c:v>
                </c:pt>
                <c:pt idx="147">
                  <c:v>1.1370386254108775</c:v>
                </c:pt>
                <c:pt idx="148">
                  <c:v>1.2647716856133839</c:v>
                </c:pt>
                <c:pt idx="149">
                  <c:v>1.1561049525870286</c:v>
                </c:pt>
                <c:pt idx="150">
                  <c:v>1.4034485074830705</c:v>
                </c:pt>
                <c:pt idx="151">
                  <c:v>1.0297775044182842</c:v>
                </c:pt>
                <c:pt idx="152">
                  <c:v>1.0471197551600679</c:v>
                </c:pt>
                <c:pt idx="153">
                  <c:v>1.1255781780180734</c:v>
                </c:pt>
                <c:pt idx="154">
                  <c:v>1.0407963020746007</c:v>
                </c:pt>
                <c:pt idx="155">
                  <c:v>1.2016916665661039</c:v>
                </c:pt>
                <c:pt idx="156">
                  <c:v>1.0618222445019418</c:v>
                </c:pt>
                <c:pt idx="157">
                  <c:v>1.1265842655121805</c:v>
                </c:pt>
                <c:pt idx="158">
                  <c:v>1.1637770687598172</c:v>
                </c:pt>
                <c:pt idx="159">
                  <c:v>1.1120572464568543</c:v>
                </c:pt>
                <c:pt idx="160">
                  <c:v>2.7708963253536205</c:v>
                </c:pt>
                <c:pt idx="161">
                  <c:v>1.0314007325554722</c:v>
                </c:pt>
                <c:pt idx="162">
                  <c:v>1.1773954329931131</c:v>
                </c:pt>
                <c:pt idx="163">
                  <c:v>1.5569703576937599</c:v>
                </c:pt>
                <c:pt idx="164">
                  <c:v>1.1842098965773122</c:v>
                </c:pt>
                <c:pt idx="165">
                  <c:v>1.1629734148017215</c:v>
                </c:pt>
                <c:pt idx="166">
                  <c:v>1.0564969617447866</c:v>
                </c:pt>
                <c:pt idx="167">
                  <c:v>1.1868533816198348</c:v>
                </c:pt>
                <c:pt idx="168">
                  <c:v>1.0290797829899994</c:v>
                </c:pt>
                <c:pt idx="169">
                  <c:v>1.2635066393280925</c:v>
                </c:pt>
                <c:pt idx="170">
                  <c:v>1.1350271313427367</c:v>
                </c:pt>
                <c:pt idx="171">
                  <c:v>1.2768481348502727</c:v>
                </c:pt>
                <c:pt idx="172">
                  <c:v>1.1747210969072428</c:v>
                </c:pt>
                <c:pt idx="173">
                  <c:v>1.3430239531075092</c:v>
                </c:pt>
                <c:pt idx="174">
                  <c:v>1.1144857035840188</c:v>
                </c:pt>
                <c:pt idx="175">
                  <c:v>1.0883570607430748</c:v>
                </c:pt>
                <c:pt idx="176">
                  <c:v>1.340406071596242</c:v>
                </c:pt>
                <c:pt idx="177">
                  <c:v>1.0462679596704059</c:v>
                </c:pt>
                <c:pt idx="178">
                  <c:v>1.1592213163679255</c:v>
                </c:pt>
                <c:pt idx="179">
                  <c:v>1.3688496583760779</c:v>
                </c:pt>
                <c:pt idx="180">
                  <c:v>0.88817112044835234</c:v>
                </c:pt>
                <c:pt idx="181">
                  <c:v>1.1572390961831411</c:v>
                </c:pt>
                <c:pt idx="182">
                  <c:v>1.1136202245850488</c:v>
                </c:pt>
                <c:pt idx="183">
                  <c:v>1.0361821424433992</c:v>
                </c:pt>
                <c:pt idx="184">
                  <c:v>1.1199289662156047</c:v>
                </c:pt>
                <c:pt idx="185">
                  <c:v>1.2420459563536044</c:v>
                </c:pt>
                <c:pt idx="186">
                  <c:v>1.0103975154694076</c:v>
                </c:pt>
                <c:pt idx="187">
                  <c:v>1.1038898174048384</c:v>
                </c:pt>
                <c:pt idx="188">
                  <c:v>1.0732447975692894</c:v>
                </c:pt>
                <c:pt idx="189">
                  <c:v>1.1610793700517104</c:v>
                </c:pt>
                <c:pt idx="190">
                  <c:v>1.2838414487697187</c:v>
                </c:pt>
                <c:pt idx="191">
                  <c:v>1.3303291339719028</c:v>
                </c:pt>
                <c:pt idx="192">
                  <c:v>0.95458234594775204</c:v>
                </c:pt>
                <c:pt idx="193">
                  <c:v>1.1860837103695745</c:v>
                </c:pt>
                <c:pt idx="194">
                  <c:v>1.093460161986141</c:v>
                </c:pt>
                <c:pt idx="195">
                  <c:v>1.0168938051572343</c:v>
                </c:pt>
                <c:pt idx="196">
                  <c:v>1.1402523657412884</c:v>
                </c:pt>
                <c:pt idx="197">
                  <c:v>0.98801271868244189</c:v>
                </c:pt>
                <c:pt idx="198">
                  <c:v>0.94639981901465864</c:v>
                </c:pt>
                <c:pt idx="199">
                  <c:v>1.4233751333975881</c:v>
                </c:pt>
                <c:pt idx="200">
                  <c:v>0.99239725075519969</c:v>
                </c:pt>
                <c:pt idx="201">
                  <c:v>1.1861408671841895</c:v>
                </c:pt>
                <c:pt idx="202">
                  <c:v>1.1392446711216326</c:v>
                </c:pt>
                <c:pt idx="203">
                  <c:v>1.0073128796921937</c:v>
                </c:pt>
                <c:pt idx="204">
                  <c:v>1.1254504022946026</c:v>
                </c:pt>
                <c:pt idx="205">
                  <c:v>1.1042355582249441</c:v>
                </c:pt>
                <c:pt idx="206">
                  <c:v>1.0436615642653742</c:v>
                </c:pt>
                <c:pt idx="207">
                  <c:v>1.0372430535644432</c:v>
                </c:pt>
                <c:pt idx="208">
                  <c:v>1.3069024386037005</c:v>
                </c:pt>
                <c:pt idx="209">
                  <c:v>1.078679325920098</c:v>
                </c:pt>
                <c:pt idx="210">
                  <c:v>1.2537645959732555</c:v>
                </c:pt>
                <c:pt idx="211">
                  <c:v>0.99785141237039809</c:v>
                </c:pt>
                <c:pt idx="212">
                  <c:v>1.0898099254269444</c:v>
                </c:pt>
                <c:pt idx="213">
                  <c:v>1.1933699089814067</c:v>
                </c:pt>
                <c:pt idx="214">
                  <c:v>0.91139279757416714</c:v>
                </c:pt>
                <c:pt idx="215">
                  <c:v>0.98997435406083234</c:v>
                </c:pt>
                <c:pt idx="216">
                  <c:v>1.8115781322986673</c:v>
                </c:pt>
                <c:pt idx="217">
                  <c:v>1.0129293306002971</c:v>
                </c:pt>
                <c:pt idx="218">
                  <c:v>1.1434081893050272</c:v>
                </c:pt>
                <c:pt idx="219">
                  <c:v>1.2239085014321376</c:v>
                </c:pt>
                <c:pt idx="220">
                  <c:v>1.440475585590163</c:v>
                </c:pt>
                <c:pt idx="221">
                  <c:v>1.2615474711137427</c:v>
                </c:pt>
                <c:pt idx="222">
                  <c:v>1.8508724957775757</c:v>
                </c:pt>
                <c:pt idx="223">
                  <c:v>0.98480430100117466</c:v>
                </c:pt>
                <c:pt idx="224">
                  <c:v>1.119938757707212</c:v>
                </c:pt>
                <c:pt idx="225">
                  <c:v>1.1957930109698369</c:v>
                </c:pt>
                <c:pt idx="226">
                  <c:v>1.1675162145237259</c:v>
                </c:pt>
                <c:pt idx="227">
                  <c:v>1.1965231485526671</c:v>
                </c:pt>
                <c:pt idx="228">
                  <c:v>1.3779204436547019</c:v>
                </c:pt>
                <c:pt idx="229">
                  <c:v>1.882620446408652</c:v>
                </c:pt>
                <c:pt idx="230">
                  <c:v>1.3068548264903277</c:v>
                </c:pt>
                <c:pt idx="231">
                  <c:v>1.2066108655118093</c:v>
                </c:pt>
                <c:pt idx="232">
                  <c:v>1.3273666999476796</c:v>
                </c:pt>
                <c:pt idx="233">
                  <c:v>1.0269684953406191</c:v>
                </c:pt>
                <c:pt idx="234">
                  <c:v>1.1125657248020344</c:v>
                </c:pt>
                <c:pt idx="235">
                  <c:v>1.1925332655683867</c:v>
                </c:pt>
                <c:pt idx="236">
                  <c:v>1.5586516948315428</c:v>
                </c:pt>
                <c:pt idx="237">
                  <c:v>1.1260940849825558</c:v>
                </c:pt>
                <c:pt idx="238">
                  <c:v>1.3455845586049529</c:v>
                </c:pt>
                <c:pt idx="239">
                  <c:v>1.2147636319693111</c:v>
                </c:pt>
                <c:pt idx="240">
                  <c:v>1.1522681764157041</c:v>
                </c:pt>
                <c:pt idx="241">
                  <c:v>1.2897813369843869</c:v>
                </c:pt>
                <c:pt idx="242">
                  <c:v>1.5931737840145517</c:v>
                </c:pt>
                <c:pt idx="243">
                  <c:v>1.0712274693551758</c:v>
                </c:pt>
                <c:pt idx="244">
                  <c:v>1.7234568831729435</c:v>
                </c:pt>
                <c:pt idx="245">
                  <c:v>1.0802875251961213</c:v>
                </c:pt>
                <c:pt idx="246">
                  <c:v>1.3675630365244356</c:v>
                </c:pt>
                <c:pt idx="247">
                  <c:v>1.1971674203608704</c:v>
                </c:pt>
                <c:pt idx="248">
                  <c:v>1.0305777080699985</c:v>
                </c:pt>
                <c:pt idx="249">
                  <c:v>0.87004731571867788</c:v>
                </c:pt>
                <c:pt idx="250">
                  <c:v>1.5821937547386347</c:v>
                </c:pt>
                <c:pt idx="251">
                  <c:v>0.97054922001913813</c:v>
                </c:pt>
                <c:pt idx="252">
                  <c:v>1.0351399392642027</c:v>
                </c:pt>
                <c:pt idx="253">
                  <c:v>1.1699002951339887</c:v>
                </c:pt>
                <c:pt idx="254">
                  <c:v>1.3743963714160303</c:v>
                </c:pt>
                <c:pt idx="255">
                  <c:v>1.0368843603813491</c:v>
                </c:pt>
                <c:pt idx="256">
                  <c:v>0.95452148408912119</c:v>
                </c:pt>
                <c:pt idx="257">
                  <c:v>1.004782441285027</c:v>
                </c:pt>
                <c:pt idx="258">
                  <c:v>1.2184523795596041</c:v>
                </c:pt>
                <c:pt idx="259">
                  <c:v>1.4317401769086191</c:v>
                </c:pt>
                <c:pt idx="260">
                  <c:v>1.1206278242923164</c:v>
                </c:pt>
                <c:pt idx="261">
                  <c:v>1.0533580362161574</c:v>
                </c:pt>
                <c:pt idx="262">
                  <c:v>1.0590056530907845</c:v>
                </c:pt>
                <c:pt idx="263">
                  <c:v>1.3221582672330232</c:v>
                </c:pt>
                <c:pt idx="264">
                  <c:v>1.3041305009405928</c:v>
                </c:pt>
                <c:pt idx="265">
                  <c:v>0.97972117372430523</c:v>
                </c:pt>
                <c:pt idx="266">
                  <c:v>1.0665147377109305</c:v>
                </c:pt>
                <c:pt idx="267">
                  <c:v>1.1474387207718644</c:v>
                </c:pt>
                <c:pt idx="268">
                  <c:v>1.5271891895471696</c:v>
                </c:pt>
                <c:pt idx="269">
                  <c:v>1.2358065597637828</c:v>
                </c:pt>
                <c:pt idx="270">
                  <c:v>1.4789813393937918</c:v>
                </c:pt>
                <c:pt idx="271">
                  <c:v>1.2095135720024168</c:v>
                </c:pt>
                <c:pt idx="272">
                  <c:v>1.0671092998570737</c:v>
                </c:pt>
                <c:pt idx="273">
                  <c:v>1.1335166198001811</c:v>
                </c:pt>
                <c:pt idx="274">
                  <c:v>1.2675013875488272</c:v>
                </c:pt>
                <c:pt idx="275">
                  <c:v>1.2658750613268464</c:v>
                </c:pt>
                <c:pt idx="276">
                  <c:v>1.2185428220910561</c:v>
                </c:pt>
                <c:pt idx="277">
                  <c:v>1.3092657840435091</c:v>
                </c:pt>
                <c:pt idx="278">
                  <c:v>1.0656533690921188</c:v>
                </c:pt>
                <c:pt idx="279">
                  <c:v>1.9894459492690126</c:v>
                </c:pt>
                <c:pt idx="280">
                  <c:v>1.0601301219933452</c:v>
                </c:pt>
                <c:pt idx="281">
                  <c:v>1.3723817410882673</c:v>
                </c:pt>
                <c:pt idx="282">
                  <c:v>1.161919326434262</c:v>
                </c:pt>
                <c:pt idx="283">
                  <c:v>1.0900079162008507</c:v>
                </c:pt>
                <c:pt idx="284">
                  <c:v>1.0477431888979536</c:v>
                </c:pt>
                <c:pt idx="285">
                  <c:v>0.98184661671447748</c:v>
                </c:pt>
                <c:pt idx="286">
                  <c:v>1.0646382731744362</c:v>
                </c:pt>
                <c:pt idx="287">
                  <c:v>1.3318601641479866</c:v>
                </c:pt>
                <c:pt idx="288">
                  <c:v>0.89233322066014531</c:v>
                </c:pt>
                <c:pt idx="289">
                  <c:v>1.1417202421047556</c:v>
                </c:pt>
                <c:pt idx="290">
                  <c:v>1.1177160667022339</c:v>
                </c:pt>
                <c:pt idx="291">
                  <c:v>1.6044297905827667</c:v>
                </c:pt>
                <c:pt idx="292">
                  <c:v>1.573524982473697</c:v>
                </c:pt>
                <c:pt idx="293">
                  <c:v>1.2595187693552838</c:v>
                </c:pt>
                <c:pt idx="294">
                  <c:v>1.4454235944123894</c:v>
                </c:pt>
                <c:pt idx="295">
                  <c:v>1.0221512111039259</c:v>
                </c:pt>
                <c:pt idx="296">
                  <c:v>1.2188631661335814</c:v>
                </c:pt>
                <c:pt idx="297">
                  <c:v>1.2264900826862384</c:v>
                </c:pt>
                <c:pt idx="298">
                  <c:v>1.2032507944818533</c:v>
                </c:pt>
                <c:pt idx="299">
                  <c:v>0.938401626082908</c:v>
                </c:pt>
                <c:pt idx="300">
                  <c:v>0.94710678018593586</c:v>
                </c:pt>
                <c:pt idx="301">
                  <c:v>1.1344416954984839</c:v>
                </c:pt>
                <c:pt idx="302">
                  <c:v>1.206558409065229</c:v>
                </c:pt>
                <c:pt idx="303">
                  <c:v>1.1980703231671928</c:v>
                </c:pt>
                <c:pt idx="304">
                  <c:v>1.0119534620357455</c:v>
                </c:pt>
                <c:pt idx="305">
                  <c:v>1.073287098367036</c:v>
                </c:pt>
                <c:pt idx="306">
                  <c:v>0.9616094072876884</c:v>
                </c:pt>
                <c:pt idx="307">
                  <c:v>0.99208732708935465</c:v>
                </c:pt>
                <c:pt idx="308">
                  <c:v>1.0366259854189812</c:v>
                </c:pt>
                <c:pt idx="309">
                  <c:v>1.0094114700527794</c:v>
                </c:pt>
                <c:pt idx="310">
                  <c:v>1.2001626371323568</c:v>
                </c:pt>
                <c:pt idx="311">
                  <c:v>1.3314309984589672</c:v>
                </c:pt>
                <c:pt idx="312">
                  <c:v>0.97962445202452897</c:v>
                </c:pt>
                <c:pt idx="313">
                  <c:v>1.1147300126195629</c:v>
                </c:pt>
                <c:pt idx="314">
                  <c:v>0.88906611075704045</c:v>
                </c:pt>
                <c:pt idx="315">
                  <c:v>0.95893746211539277</c:v>
                </c:pt>
                <c:pt idx="316">
                  <c:v>1.2083635766114171</c:v>
                </c:pt>
                <c:pt idx="317">
                  <c:v>1.169622782386698</c:v>
                </c:pt>
                <c:pt idx="318">
                  <c:v>0.95110459960380578</c:v>
                </c:pt>
                <c:pt idx="319">
                  <c:v>1.3287363742701299</c:v>
                </c:pt>
                <c:pt idx="320">
                  <c:v>1.3075217022692007</c:v>
                </c:pt>
                <c:pt idx="321">
                  <c:v>0.9700406069065991</c:v>
                </c:pt>
                <c:pt idx="322">
                  <c:v>0.92426350794472234</c:v>
                </c:pt>
                <c:pt idx="323">
                  <c:v>1.2142587874091868</c:v>
                </c:pt>
                <c:pt idx="324">
                  <c:v>0.99001647438208551</c:v>
                </c:pt>
                <c:pt idx="325">
                  <c:v>1.1488144489615086</c:v>
                </c:pt>
                <c:pt idx="326">
                  <c:v>0.91990908185630027</c:v>
                </c:pt>
                <c:pt idx="327">
                  <c:v>0.76624581005586589</c:v>
                </c:pt>
                <c:pt idx="328">
                  <c:v>1.1166381802012117</c:v>
                </c:pt>
                <c:pt idx="329">
                  <c:v>1.5832695152902687</c:v>
                </c:pt>
                <c:pt idx="330">
                  <c:v>1.0688761338645896</c:v>
                </c:pt>
                <c:pt idx="331">
                  <c:v>1.6628736309511716</c:v>
                </c:pt>
                <c:pt idx="332">
                  <c:v>0.81612800185846623</c:v>
                </c:pt>
                <c:pt idx="333">
                  <c:v>1.5578598814918088</c:v>
                </c:pt>
                <c:pt idx="334">
                  <c:v>1.1007773122001578</c:v>
                </c:pt>
                <c:pt idx="335">
                  <c:v>0.826408165783104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A17-4D7E-8CE0-CA6BEBA8F289}"/>
            </c:ext>
          </c:extLst>
        </c:ser>
        <c:ser>
          <c:idx val="1"/>
          <c:order val="1"/>
          <c:tx>
            <c:strRef>
              <c:f>controls!$E$1</c:f>
              <c:strCache>
                <c:ptCount val="1"/>
                <c:pt idx="0">
                  <c:v>ave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controls!$A$2:$A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E$2:$E$345</c:f>
              <c:numCache>
                <c:formatCode>0.00</c:formatCode>
                <c:ptCount val="344"/>
                <c:pt idx="0">
                  <c:v>1.1796494469804333</c:v>
                </c:pt>
                <c:pt idx="1">
                  <c:v>1.18</c:v>
                </c:pt>
                <c:pt idx="2">
                  <c:v>1.18</c:v>
                </c:pt>
                <c:pt idx="3">
                  <c:v>1.18</c:v>
                </c:pt>
                <c:pt idx="4">
                  <c:v>1.18</c:v>
                </c:pt>
                <c:pt idx="5">
                  <c:v>1.18</c:v>
                </c:pt>
                <c:pt idx="6">
                  <c:v>1.18</c:v>
                </c:pt>
                <c:pt idx="7">
                  <c:v>1.18</c:v>
                </c:pt>
                <c:pt idx="8">
                  <c:v>1.18</c:v>
                </c:pt>
                <c:pt idx="9">
                  <c:v>1.18</c:v>
                </c:pt>
                <c:pt idx="10">
                  <c:v>1.18</c:v>
                </c:pt>
                <c:pt idx="11">
                  <c:v>1.18</c:v>
                </c:pt>
                <c:pt idx="12">
                  <c:v>1.18</c:v>
                </c:pt>
                <c:pt idx="13">
                  <c:v>1.18</c:v>
                </c:pt>
                <c:pt idx="14">
                  <c:v>1.18</c:v>
                </c:pt>
                <c:pt idx="15">
                  <c:v>1.18</c:v>
                </c:pt>
                <c:pt idx="16">
                  <c:v>1.18</c:v>
                </c:pt>
                <c:pt idx="17">
                  <c:v>1.18</c:v>
                </c:pt>
                <c:pt idx="18">
                  <c:v>1.18</c:v>
                </c:pt>
                <c:pt idx="19">
                  <c:v>1.18</c:v>
                </c:pt>
                <c:pt idx="20">
                  <c:v>1.18</c:v>
                </c:pt>
                <c:pt idx="21">
                  <c:v>1.18</c:v>
                </c:pt>
                <c:pt idx="22">
                  <c:v>1.18</c:v>
                </c:pt>
                <c:pt idx="23">
                  <c:v>1.18</c:v>
                </c:pt>
                <c:pt idx="24">
                  <c:v>1.18</c:v>
                </c:pt>
                <c:pt idx="25">
                  <c:v>1.18</c:v>
                </c:pt>
                <c:pt idx="26">
                  <c:v>1.18</c:v>
                </c:pt>
                <c:pt idx="27">
                  <c:v>1.18</c:v>
                </c:pt>
                <c:pt idx="28">
                  <c:v>1.18</c:v>
                </c:pt>
                <c:pt idx="29">
                  <c:v>1.18</c:v>
                </c:pt>
                <c:pt idx="30">
                  <c:v>1.18</c:v>
                </c:pt>
                <c:pt idx="31">
                  <c:v>1.18</c:v>
                </c:pt>
                <c:pt idx="32">
                  <c:v>1.18</c:v>
                </c:pt>
                <c:pt idx="33">
                  <c:v>1.18</c:v>
                </c:pt>
                <c:pt idx="34">
                  <c:v>1.18</c:v>
                </c:pt>
                <c:pt idx="35">
                  <c:v>1.18</c:v>
                </c:pt>
                <c:pt idx="36">
                  <c:v>1.18</c:v>
                </c:pt>
                <c:pt idx="37">
                  <c:v>1.18</c:v>
                </c:pt>
                <c:pt idx="38">
                  <c:v>1.18</c:v>
                </c:pt>
                <c:pt idx="39">
                  <c:v>1.18</c:v>
                </c:pt>
                <c:pt idx="40">
                  <c:v>1.18</c:v>
                </c:pt>
                <c:pt idx="41">
                  <c:v>1.18</c:v>
                </c:pt>
                <c:pt idx="42">
                  <c:v>1.18</c:v>
                </c:pt>
                <c:pt idx="43">
                  <c:v>1.18</c:v>
                </c:pt>
                <c:pt idx="44">
                  <c:v>1.18</c:v>
                </c:pt>
                <c:pt idx="45">
                  <c:v>1.18</c:v>
                </c:pt>
                <c:pt idx="46">
                  <c:v>1.18</c:v>
                </c:pt>
                <c:pt idx="47">
                  <c:v>1.18</c:v>
                </c:pt>
                <c:pt idx="48">
                  <c:v>1.18</c:v>
                </c:pt>
                <c:pt idx="49">
                  <c:v>1.18</c:v>
                </c:pt>
                <c:pt idx="50">
                  <c:v>1.18</c:v>
                </c:pt>
                <c:pt idx="51">
                  <c:v>1.18</c:v>
                </c:pt>
                <c:pt idx="52">
                  <c:v>1.18</c:v>
                </c:pt>
                <c:pt idx="53">
                  <c:v>1.18</c:v>
                </c:pt>
                <c:pt idx="54">
                  <c:v>1.18</c:v>
                </c:pt>
                <c:pt idx="55">
                  <c:v>1.18</c:v>
                </c:pt>
                <c:pt idx="56">
                  <c:v>1.18</c:v>
                </c:pt>
                <c:pt idx="57">
                  <c:v>1.18</c:v>
                </c:pt>
                <c:pt idx="58">
                  <c:v>1.18</c:v>
                </c:pt>
                <c:pt idx="59">
                  <c:v>1.18</c:v>
                </c:pt>
                <c:pt idx="60">
                  <c:v>1.18</c:v>
                </c:pt>
                <c:pt idx="61">
                  <c:v>1.18</c:v>
                </c:pt>
                <c:pt idx="62">
                  <c:v>1.18</c:v>
                </c:pt>
                <c:pt idx="63">
                  <c:v>1.18</c:v>
                </c:pt>
                <c:pt idx="64">
                  <c:v>1.18</c:v>
                </c:pt>
                <c:pt idx="65">
                  <c:v>1.18</c:v>
                </c:pt>
                <c:pt idx="66">
                  <c:v>1.18</c:v>
                </c:pt>
                <c:pt idx="67">
                  <c:v>1.18</c:v>
                </c:pt>
                <c:pt idx="68">
                  <c:v>1.18</c:v>
                </c:pt>
                <c:pt idx="69">
                  <c:v>1.18</c:v>
                </c:pt>
                <c:pt idx="70">
                  <c:v>1.18</c:v>
                </c:pt>
                <c:pt idx="71">
                  <c:v>1.18</c:v>
                </c:pt>
                <c:pt idx="72">
                  <c:v>1.18</c:v>
                </c:pt>
                <c:pt idx="73">
                  <c:v>1.18</c:v>
                </c:pt>
                <c:pt idx="74">
                  <c:v>1.18</c:v>
                </c:pt>
                <c:pt idx="75">
                  <c:v>1.18</c:v>
                </c:pt>
                <c:pt idx="76">
                  <c:v>1.18</c:v>
                </c:pt>
                <c:pt idx="77">
                  <c:v>1.18</c:v>
                </c:pt>
                <c:pt idx="78">
                  <c:v>1.18</c:v>
                </c:pt>
                <c:pt idx="79">
                  <c:v>1.18</c:v>
                </c:pt>
                <c:pt idx="80">
                  <c:v>1.18</c:v>
                </c:pt>
                <c:pt idx="81">
                  <c:v>1.18</c:v>
                </c:pt>
                <c:pt idx="82">
                  <c:v>1.18</c:v>
                </c:pt>
                <c:pt idx="83">
                  <c:v>1.18</c:v>
                </c:pt>
                <c:pt idx="84">
                  <c:v>1.18</c:v>
                </c:pt>
                <c:pt idx="85">
                  <c:v>1.18</c:v>
                </c:pt>
                <c:pt idx="86">
                  <c:v>1.18</c:v>
                </c:pt>
                <c:pt idx="87">
                  <c:v>1.18</c:v>
                </c:pt>
                <c:pt idx="88">
                  <c:v>1.18</c:v>
                </c:pt>
                <c:pt idx="89">
                  <c:v>1.18</c:v>
                </c:pt>
                <c:pt idx="90">
                  <c:v>1.18</c:v>
                </c:pt>
                <c:pt idx="91">
                  <c:v>1.18</c:v>
                </c:pt>
                <c:pt idx="92">
                  <c:v>1.18</c:v>
                </c:pt>
                <c:pt idx="93">
                  <c:v>1.18</c:v>
                </c:pt>
                <c:pt idx="94">
                  <c:v>1.18</c:v>
                </c:pt>
                <c:pt idx="95">
                  <c:v>1.18</c:v>
                </c:pt>
                <c:pt idx="96">
                  <c:v>1.18</c:v>
                </c:pt>
                <c:pt idx="97">
                  <c:v>1.18</c:v>
                </c:pt>
                <c:pt idx="98">
                  <c:v>1.18</c:v>
                </c:pt>
                <c:pt idx="99">
                  <c:v>1.18</c:v>
                </c:pt>
                <c:pt idx="100">
                  <c:v>1.18</c:v>
                </c:pt>
                <c:pt idx="101">
                  <c:v>1.18</c:v>
                </c:pt>
                <c:pt idx="102">
                  <c:v>1.18</c:v>
                </c:pt>
                <c:pt idx="103">
                  <c:v>1.18</c:v>
                </c:pt>
                <c:pt idx="104">
                  <c:v>1.18</c:v>
                </c:pt>
                <c:pt idx="105">
                  <c:v>1.18</c:v>
                </c:pt>
                <c:pt idx="106">
                  <c:v>1.18</c:v>
                </c:pt>
                <c:pt idx="107">
                  <c:v>1.18</c:v>
                </c:pt>
                <c:pt idx="108">
                  <c:v>1.18</c:v>
                </c:pt>
                <c:pt idx="109">
                  <c:v>1.18</c:v>
                </c:pt>
                <c:pt idx="110">
                  <c:v>1.18</c:v>
                </c:pt>
                <c:pt idx="111">
                  <c:v>1.18</c:v>
                </c:pt>
                <c:pt idx="112">
                  <c:v>1.18</c:v>
                </c:pt>
                <c:pt idx="113">
                  <c:v>1.18</c:v>
                </c:pt>
                <c:pt idx="114">
                  <c:v>1.18</c:v>
                </c:pt>
                <c:pt idx="115">
                  <c:v>1.18</c:v>
                </c:pt>
                <c:pt idx="116">
                  <c:v>1.18</c:v>
                </c:pt>
                <c:pt idx="117">
                  <c:v>1.18</c:v>
                </c:pt>
                <c:pt idx="118">
                  <c:v>1.18</c:v>
                </c:pt>
                <c:pt idx="119">
                  <c:v>1.18</c:v>
                </c:pt>
                <c:pt idx="120">
                  <c:v>1.18</c:v>
                </c:pt>
                <c:pt idx="121">
                  <c:v>1.18</c:v>
                </c:pt>
                <c:pt idx="122">
                  <c:v>1.18</c:v>
                </c:pt>
                <c:pt idx="123">
                  <c:v>1.18</c:v>
                </c:pt>
                <c:pt idx="124">
                  <c:v>1.18</c:v>
                </c:pt>
                <c:pt idx="125">
                  <c:v>1.18</c:v>
                </c:pt>
                <c:pt idx="126">
                  <c:v>1.18</c:v>
                </c:pt>
                <c:pt idx="127">
                  <c:v>1.18</c:v>
                </c:pt>
                <c:pt idx="128">
                  <c:v>1.18</c:v>
                </c:pt>
                <c:pt idx="129">
                  <c:v>1.18</c:v>
                </c:pt>
                <c:pt idx="130">
                  <c:v>1.18</c:v>
                </c:pt>
                <c:pt idx="131">
                  <c:v>1.18</c:v>
                </c:pt>
                <c:pt idx="132">
                  <c:v>1.18</c:v>
                </c:pt>
                <c:pt idx="133">
                  <c:v>1.18</c:v>
                </c:pt>
                <c:pt idx="134">
                  <c:v>1.18</c:v>
                </c:pt>
                <c:pt idx="135">
                  <c:v>1.18</c:v>
                </c:pt>
                <c:pt idx="136">
                  <c:v>1.18</c:v>
                </c:pt>
                <c:pt idx="137">
                  <c:v>1.18</c:v>
                </c:pt>
                <c:pt idx="138">
                  <c:v>1.18</c:v>
                </c:pt>
                <c:pt idx="139">
                  <c:v>1.18</c:v>
                </c:pt>
                <c:pt idx="140">
                  <c:v>1.18</c:v>
                </c:pt>
                <c:pt idx="141">
                  <c:v>1.18</c:v>
                </c:pt>
                <c:pt idx="142">
                  <c:v>1.18</c:v>
                </c:pt>
                <c:pt idx="143">
                  <c:v>1.18</c:v>
                </c:pt>
                <c:pt idx="144">
                  <c:v>1.18</c:v>
                </c:pt>
                <c:pt idx="145">
                  <c:v>1.18</c:v>
                </c:pt>
                <c:pt idx="146">
                  <c:v>1.18</c:v>
                </c:pt>
                <c:pt idx="147">
                  <c:v>1.18</c:v>
                </c:pt>
                <c:pt idx="148">
                  <c:v>1.18</c:v>
                </c:pt>
                <c:pt idx="149">
                  <c:v>1.18</c:v>
                </c:pt>
                <c:pt idx="150">
                  <c:v>1.18</c:v>
                </c:pt>
                <c:pt idx="151">
                  <c:v>1.18</c:v>
                </c:pt>
                <c:pt idx="152">
                  <c:v>1.18</c:v>
                </c:pt>
                <c:pt idx="153">
                  <c:v>1.18</c:v>
                </c:pt>
                <c:pt idx="154">
                  <c:v>1.18</c:v>
                </c:pt>
                <c:pt idx="155">
                  <c:v>1.18</c:v>
                </c:pt>
                <c:pt idx="156">
                  <c:v>1.18</c:v>
                </c:pt>
                <c:pt idx="157">
                  <c:v>1.18</c:v>
                </c:pt>
                <c:pt idx="158">
                  <c:v>1.18</c:v>
                </c:pt>
                <c:pt idx="159">
                  <c:v>1.18</c:v>
                </c:pt>
                <c:pt idx="160">
                  <c:v>1.18</c:v>
                </c:pt>
                <c:pt idx="161">
                  <c:v>1.18</c:v>
                </c:pt>
                <c:pt idx="162">
                  <c:v>1.18</c:v>
                </c:pt>
                <c:pt idx="163">
                  <c:v>1.18</c:v>
                </c:pt>
                <c:pt idx="164">
                  <c:v>1.18</c:v>
                </c:pt>
                <c:pt idx="165">
                  <c:v>1.18</c:v>
                </c:pt>
                <c:pt idx="166">
                  <c:v>1.18</c:v>
                </c:pt>
                <c:pt idx="167">
                  <c:v>1.18</c:v>
                </c:pt>
                <c:pt idx="168">
                  <c:v>1.18</c:v>
                </c:pt>
                <c:pt idx="169">
                  <c:v>1.18</c:v>
                </c:pt>
                <c:pt idx="170">
                  <c:v>1.18</c:v>
                </c:pt>
                <c:pt idx="171">
                  <c:v>1.18</c:v>
                </c:pt>
                <c:pt idx="172">
                  <c:v>1.18</c:v>
                </c:pt>
                <c:pt idx="173">
                  <c:v>1.18</c:v>
                </c:pt>
                <c:pt idx="174">
                  <c:v>1.18</c:v>
                </c:pt>
                <c:pt idx="175">
                  <c:v>1.18</c:v>
                </c:pt>
                <c:pt idx="176">
                  <c:v>1.18</c:v>
                </c:pt>
                <c:pt idx="177">
                  <c:v>1.18</c:v>
                </c:pt>
                <c:pt idx="178">
                  <c:v>1.18</c:v>
                </c:pt>
                <c:pt idx="179">
                  <c:v>1.18</c:v>
                </c:pt>
                <c:pt idx="180">
                  <c:v>1.18</c:v>
                </c:pt>
                <c:pt idx="181">
                  <c:v>1.18</c:v>
                </c:pt>
                <c:pt idx="182">
                  <c:v>1.18</c:v>
                </c:pt>
                <c:pt idx="183">
                  <c:v>1.18</c:v>
                </c:pt>
                <c:pt idx="184">
                  <c:v>1.18</c:v>
                </c:pt>
                <c:pt idx="185">
                  <c:v>1.18</c:v>
                </c:pt>
                <c:pt idx="186">
                  <c:v>1.18</c:v>
                </c:pt>
                <c:pt idx="187">
                  <c:v>1.18</c:v>
                </c:pt>
                <c:pt idx="188">
                  <c:v>1.18</c:v>
                </c:pt>
                <c:pt idx="189">
                  <c:v>1.18</c:v>
                </c:pt>
                <c:pt idx="190">
                  <c:v>1.18</c:v>
                </c:pt>
                <c:pt idx="191">
                  <c:v>1.18</c:v>
                </c:pt>
                <c:pt idx="192">
                  <c:v>1.18</c:v>
                </c:pt>
                <c:pt idx="193">
                  <c:v>1.18</c:v>
                </c:pt>
                <c:pt idx="194">
                  <c:v>1.18</c:v>
                </c:pt>
                <c:pt idx="195">
                  <c:v>1.18</c:v>
                </c:pt>
                <c:pt idx="196">
                  <c:v>1.18</c:v>
                </c:pt>
                <c:pt idx="197">
                  <c:v>1.18</c:v>
                </c:pt>
                <c:pt idx="198">
                  <c:v>1.18</c:v>
                </c:pt>
                <c:pt idx="199">
                  <c:v>1.18</c:v>
                </c:pt>
                <c:pt idx="200">
                  <c:v>1.18</c:v>
                </c:pt>
                <c:pt idx="201">
                  <c:v>1.18</c:v>
                </c:pt>
                <c:pt idx="202">
                  <c:v>1.18</c:v>
                </c:pt>
                <c:pt idx="203">
                  <c:v>1.18</c:v>
                </c:pt>
                <c:pt idx="204">
                  <c:v>1.18</c:v>
                </c:pt>
                <c:pt idx="205">
                  <c:v>1.18</c:v>
                </c:pt>
                <c:pt idx="206">
                  <c:v>1.18</c:v>
                </c:pt>
                <c:pt idx="207">
                  <c:v>1.18</c:v>
                </c:pt>
                <c:pt idx="208">
                  <c:v>1.18</c:v>
                </c:pt>
                <c:pt idx="209">
                  <c:v>1.18</c:v>
                </c:pt>
                <c:pt idx="210">
                  <c:v>1.18</c:v>
                </c:pt>
                <c:pt idx="211">
                  <c:v>1.18</c:v>
                </c:pt>
                <c:pt idx="212">
                  <c:v>1.18</c:v>
                </c:pt>
                <c:pt idx="213">
                  <c:v>1.18</c:v>
                </c:pt>
                <c:pt idx="214">
                  <c:v>1.18</c:v>
                </c:pt>
                <c:pt idx="215">
                  <c:v>1.18</c:v>
                </c:pt>
                <c:pt idx="216">
                  <c:v>1.18</c:v>
                </c:pt>
                <c:pt idx="217">
                  <c:v>1.18</c:v>
                </c:pt>
                <c:pt idx="218">
                  <c:v>1.18</c:v>
                </c:pt>
                <c:pt idx="219">
                  <c:v>1.18</c:v>
                </c:pt>
                <c:pt idx="220">
                  <c:v>1.18</c:v>
                </c:pt>
                <c:pt idx="221">
                  <c:v>1.18</c:v>
                </c:pt>
                <c:pt idx="222">
                  <c:v>1.18</c:v>
                </c:pt>
                <c:pt idx="223">
                  <c:v>1.18</c:v>
                </c:pt>
                <c:pt idx="224">
                  <c:v>1.18</c:v>
                </c:pt>
                <c:pt idx="225">
                  <c:v>1.18</c:v>
                </c:pt>
                <c:pt idx="226">
                  <c:v>1.18</c:v>
                </c:pt>
                <c:pt idx="227">
                  <c:v>1.18</c:v>
                </c:pt>
                <c:pt idx="228">
                  <c:v>1.18</c:v>
                </c:pt>
                <c:pt idx="229">
                  <c:v>1.18</c:v>
                </c:pt>
                <c:pt idx="230">
                  <c:v>1.18</c:v>
                </c:pt>
                <c:pt idx="231">
                  <c:v>1.18</c:v>
                </c:pt>
                <c:pt idx="232">
                  <c:v>1.18</c:v>
                </c:pt>
                <c:pt idx="233">
                  <c:v>1.18</c:v>
                </c:pt>
                <c:pt idx="234">
                  <c:v>1.18</c:v>
                </c:pt>
                <c:pt idx="235">
                  <c:v>1.18</c:v>
                </c:pt>
                <c:pt idx="236">
                  <c:v>1.18</c:v>
                </c:pt>
                <c:pt idx="237">
                  <c:v>1.18</c:v>
                </c:pt>
                <c:pt idx="238">
                  <c:v>1.18</c:v>
                </c:pt>
                <c:pt idx="239">
                  <c:v>1.18</c:v>
                </c:pt>
                <c:pt idx="240">
                  <c:v>1.18</c:v>
                </c:pt>
                <c:pt idx="241">
                  <c:v>1.18</c:v>
                </c:pt>
                <c:pt idx="242">
                  <c:v>1.18</c:v>
                </c:pt>
                <c:pt idx="243">
                  <c:v>1.18</c:v>
                </c:pt>
                <c:pt idx="244">
                  <c:v>1.18</c:v>
                </c:pt>
                <c:pt idx="245">
                  <c:v>1.18</c:v>
                </c:pt>
                <c:pt idx="246">
                  <c:v>1.18</c:v>
                </c:pt>
                <c:pt idx="247">
                  <c:v>1.18</c:v>
                </c:pt>
                <c:pt idx="248">
                  <c:v>1.18</c:v>
                </c:pt>
                <c:pt idx="249">
                  <c:v>1.18</c:v>
                </c:pt>
                <c:pt idx="250">
                  <c:v>1.18</c:v>
                </c:pt>
                <c:pt idx="251">
                  <c:v>1.18</c:v>
                </c:pt>
                <c:pt idx="252">
                  <c:v>1.18</c:v>
                </c:pt>
                <c:pt idx="253">
                  <c:v>1.18</c:v>
                </c:pt>
                <c:pt idx="254">
                  <c:v>1.18</c:v>
                </c:pt>
                <c:pt idx="255">
                  <c:v>1.18</c:v>
                </c:pt>
                <c:pt idx="256">
                  <c:v>1.18</c:v>
                </c:pt>
                <c:pt idx="257">
                  <c:v>1.18</c:v>
                </c:pt>
                <c:pt idx="258">
                  <c:v>1.18</c:v>
                </c:pt>
                <c:pt idx="259">
                  <c:v>1.18</c:v>
                </c:pt>
                <c:pt idx="260">
                  <c:v>1.18</c:v>
                </c:pt>
                <c:pt idx="261">
                  <c:v>1.18</c:v>
                </c:pt>
                <c:pt idx="262">
                  <c:v>1.18</c:v>
                </c:pt>
                <c:pt idx="263">
                  <c:v>1.18</c:v>
                </c:pt>
                <c:pt idx="264">
                  <c:v>1.18</c:v>
                </c:pt>
                <c:pt idx="265">
                  <c:v>1.18</c:v>
                </c:pt>
                <c:pt idx="266">
                  <c:v>1.18</c:v>
                </c:pt>
                <c:pt idx="267">
                  <c:v>1.18</c:v>
                </c:pt>
                <c:pt idx="268">
                  <c:v>1.18</c:v>
                </c:pt>
                <c:pt idx="269">
                  <c:v>1.18</c:v>
                </c:pt>
                <c:pt idx="270">
                  <c:v>1.18</c:v>
                </c:pt>
                <c:pt idx="271">
                  <c:v>1.18</c:v>
                </c:pt>
                <c:pt idx="272">
                  <c:v>1.18</c:v>
                </c:pt>
                <c:pt idx="273">
                  <c:v>1.18</c:v>
                </c:pt>
                <c:pt idx="274">
                  <c:v>1.18</c:v>
                </c:pt>
                <c:pt idx="275">
                  <c:v>1.18</c:v>
                </c:pt>
                <c:pt idx="276">
                  <c:v>1.18</c:v>
                </c:pt>
                <c:pt idx="277">
                  <c:v>1.18</c:v>
                </c:pt>
                <c:pt idx="278">
                  <c:v>1.18</c:v>
                </c:pt>
                <c:pt idx="279">
                  <c:v>1.18</c:v>
                </c:pt>
                <c:pt idx="280">
                  <c:v>1.18</c:v>
                </c:pt>
                <c:pt idx="281">
                  <c:v>1.18</c:v>
                </c:pt>
                <c:pt idx="282">
                  <c:v>1.18</c:v>
                </c:pt>
                <c:pt idx="283">
                  <c:v>1.18</c:v>
                </c:pt>
                <c:pt idx="284">
                  <c:v>1.18</c:v>
                </c:pt>
                <c:pt idx="285">
                  <c:v>1.18</c:v>
                </c:pt>
                <c:pt idx="286">
                  <c:v>1.18</c:v>
                </c:pt>
                <c:pt idx="287">
                  <c:v>1.18</c:v>
                </c:pt>
                <c:pt idx="288">
                  <c:v>1.18</c:v>
                </c:pt>
                <c:pt idx="289">
                  <c:v>1.18</c:v>
                </c:pt>
                <c:pt idx="290">
                  <c:v>1.18</c:v>
                </c:pt>
                <c:pt idx="291">
                  <c:v>1.18</c:v>
                </c:pt>
                <c:pt idx="292">
                  <c:v>1.18</c:v>
                </c:pt>
                <c:pt idx="293">
                  <c:v>1.18</c:v>
                </c:pt>
                <c:pt idx="294">
                  <c:v>1.18</c:v>
                </c:pt>
                <c:pt idx="295">
                  <c:v>1.18</c:v>
                </c:pt>
                <c:pt idx="296">
                  <c:v>1.18</c:v>
                </c:pt>
                <c:pt idx="297">
                  <c:v>1.18</c:v>
                </c:pt>
                <c:pt idx="298">
                  <c:v>1.18</c:v>
                </c:pt>
                <c:pt idx="299">
                  <c:v>1.18</c:v>
                </c:pt>
                <c:pt idx="300">
                  <c:v>1.18</c:v>
                </c:pt>
                <c:pt idx="301">
                  <c:v>1.18</c:v>
                </c:pt>
                <c:pt idx="302">
                  <c:v>1.18</c:v>
                </c:pt>
                <c:pt idx="303">
                  <c:v>1.18</c:v>
                </c:pt>
                <c:pt idx="304">
                  <c:v>1.18</c:v>
                </c:pt>
                <c:pt idx="305">
                  <c:v>1.18</c:v>
                </c:pt>
                <c:pt idx="306">
                  <c:v>1.18</c:v>
                </c:pt>
                <c:pt idx="307">
                  <c:v>1.18</c:v>
                </c:pt>
                <c:pt idx="308">
                  <c:v>1.18</c:v>
                </c:pt>
                <c:pt idx="309">
                  <c:v>1.18</c:v>
                </c:pt>
                <c:pt idx="310">
                  <c:v>1.18</c:v>
                </c:pt>
                <c:pt idx="311">
                  <c:v>1.18</c:v>
                </c:pt>
                <c:pt idx="312">
                  <c:v>1.18</c:v>
                </c:pt>
                <c:pt idx="313">
                  <c:v>1.18</c:v>
                </c:pt>
                <c:pt idx="314">
                  <c:v>1.18</c:v>
                </c:pt>
                <c:pt idx="315">
                  <c:v>1.18</c:v>
                </c:pt>
                <c:pt idx="316">
                  <c:v>1.18</c:v>
                </c:pt>
                <c:pt idx="317">
                  <c:v>1.18</c:v>
                </c:pt>
                <c:pt idx="318">
                  <c:v>1.18</c:v>
                </c:pt>
                <c:pt idx="319">
                  <c:v>1.18</c:v>
                </c:pt>
                <c:pt idx="320">
                  <c:v>1.18</c:v>
                </c:pt>
                <c:pt idx="321">
                  <c:v>1.18</c:v>
                </c:pt>
                <c:pt idx="322">
                  <c:v>1.18</c:v>
                </c:pt>
                <c:pt idx="323">
                  <c:v>1.18</c:v>
                </c:pt>
                <c:pt idx="324">
                  <c:v>1.18</c:v>
                </c:pt>
                <c:pt idx="325">
                  <c:v>1.18</c:v>
                </c:pt>
                <c:pt idx="326">
                  <c:v>1.18</c:v>
                </c:pt>
                <c:pt idx="327">
                  <c:v>1.18</c:v>
                </c:pt>
                <c:pt idx="328">
                  <c:v>1.18</c:v>
                </c:pt>
                <c:pt idx="329">
                  <c:v>1.18</c:v>
                </c:pt>
                <c:pt idx="330">
                  <c:v>1.18</c:v>
                </c:pt>
                <c:pt idx="331">
                  <c:v>1.18</c:v>
                </c:pt>
                <c:pt idx="332">
                  <c:v>1.18</c:v>
                </c:pt>
                <c:pt idx="333">
                  <c:v>1.18</c:v>
                </c:pt>
                <c:pt idx="334">
                  <c:v>1.18</c:v>
                </c:pt>
                <c:pt idx="335">
                  <c:v>1.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A17-4D7E-8CE0-CA6BEBA8F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6864816"/>
        <c:axId val="656863832"/>
      </c:scatterChart>
      <c:valAx>
        <c:axId val="656864816"/>
        <c:scaling>
          <c:orientation val="minMax"/>
          <c:max val="14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enomic U 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6863832"/>
        <c:crosses val="autoZero"/>
        <c:crossBetween val="midCat"/>
        <c:majorUnit val="500"/>
      </c:valAx>
      <c:valAx>
        <c:axId val="656863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Fold change: 4SU+ virus, UV+/UV-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0"/>
              <c:y val="9.2592592592592587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68648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ntrols!$G$1</c:f>
              <c:strCache>
                <c:ptCount val="1"/>
                <c:pt idx="0">
                  <c:v>4SU-, UV+</c:v>
                </c:pt>
              </c:strCache>
            </c:strRef>
          </c:tx>
          <c:spPr>
            <a:ln w="19050" cap="rnd">
              <a:solidFill>
                <a:srgbClr val="0070C0">
                  <a:alpha val="90000"/>
                </a:srgbClr>
              </a:solidFill>
              <a:round/>
            </a:ln>
            <a:effectLst/>
          </c:spPr>
          <c:marker>
            <c:symbol val="none"/>
          </c:marker>
          <c:xVal>
            <c:numRef>
              <c:f>controls!$F$2:$F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G$2:$G$345</c:f>
              <c:numCache>
                <c:formatCode>0.000%</c:formatCode>
                <c:ptCount val="344"/>
                <c:pt idx="0">
                  <c:v>8.6299892125134845E-4</c:v>
                </c:pt>
                <c:pt idx="1">
                  <c:v>7.8117371350454052E-4</c:v>
                </c:pt>
                <c:pt idx="2">
                  <c:v>1.754660817797274E-3</c:v>
                </c:pt>
                <c:pt idx="3">
                  <c:v>1.5902712815715622E-3</c:v>
                </c:pt>
                <c:pt idx="4">
                  <c:v>4.879408894465356E-4</c:v>
                </c:pt>
                <c:pt idx="5">
                  <c:v>1.0389410497152532E-3</c:v>
                </c:pt>
                <c:pt idx="6">
                  <c:v>1.1129446981617223E-3</c:v>
                </c:pt>
                <c:pt idx="7">
                  <c:v>6.2008362270569062E-4</c:v>
                </c:pt>
                <c:pt idx="8">
                  <c:v>1.9361145271655157E-3</c:v>
                </c:pt>
                <c:pt idx="9">
                  <c:v>2.113072634934412E-3</c:v>
                </c:pt>
                <c:pt idx="10">
                  <c:v>1.4908616544019053E-3</c:v>
                </c:pt>
                <c:pt idx="11">
                  <c:v>1.8038871734127827E-3</c:v>
                </c:pt>
                <c:pt idx="12">
                  <c:v>1.5976453857301015E-3</c:v>
                </c:pt>
                <c:pt idx="13">
                  <c:v>2.5810356182915323E-3</c:v>
                </c:pt>
                <c:pt idx="14">
                  <c:v>1.8700004419498829E-3</c:v>
                </c:pt>
                <c:pt idx="15">
                  <c:v>2.3321727344313751E-3</c:v>
                </c:pt>
                <c:pt idx="16">
                  <c:v>1.3219495739318127E-3</c:v>
                </c:pt>
                <c:pt idx="17">
                  <c:v>1.970703649483286E-3</c:v>
                </c:pt>
                <c:pt idx="18">
                  <c:v>1.0369984790688973E-3</c:v>
                </c:pt>
                <c:pt idx="19">
                  <c:v>1.1392611077958011E-3</c:v>
                </c:pt>
                <c:pt idx="20">
                  <c:v>9.078209557945977E-4</c:v>
                </c:pt>
                <c:pt idx="21">
                  <c:v>8.2557561465001876E-4</c:v>
                </c:pt>
                <c:pt idx="22">
                  <c:v>1.4676167180687014E-3</c:v>
                </c:pt>
                <c:pt idx="23">
                  <c:v>8.6388782748824614E-4</c:v>
                </c:pt>
                <c:pt idx="24">
                  <c:v>9.7175947961288271E-4</c:v>
                </c:pt>
                <c:pt idx="25">
                  <c:v>1.3235573869333772E-3</c:v>
                </c:pt>
                <c:pt idx="26">
                  <c:v>1.0874111250522794E-3</c:v>
                </c:pt>
                <c:pt idx="27">
                  <c:v>1.1505532807688404E-3</c:v>
                </c:pt>
                <c:pt idx="28">
                  <c:v>1.1809507372552404E-3</c:v>
                </c:pt>
                <c:pt idx="29">
                  <c:v>1.1507365541814786E-3</c:v>
                </c:pt>
                <c:pt idx="30">
                  <c:v>1.1492368504286456E-3</c:v>
                </c:pt>
                <c:pt idx="31">
                  <c:v>6.7617611659987571E-4</c:v>
                </c:pt>
                <c:pt idx="32">
                  <c:v>1.814359171901225E-3</c:v>
                </c:pt>
                <c:pt idx="33">
                  <c:v>1.4183641855781892E-3</c:v>
                </c:pt>
                <c:pt idx="34">
                  <c:v>1.6809903728013192E-3</c:v>
                </c:pt>
                <c:pt idx="35">
                  <c:v>1.1723009814612868E-3</c:v>
                </c:pt>
                <c:pt idx="36">
                  <c:v>1.6202879299778935E-3</c:v>
                </c:pt>
                <c:pt idx="37">
                  <c:v>2.304567071765508E-3</c:v>
                </c:pt>
                <c:pt idx="38">
                  <c:v>1.3691870028835174E-3</c:v>
                </c:pt>
                <c:pt idx="39">
                  <c:v>2.1607612983643005E-3</c:v>
                </c:pt>
                <c:pt idx="40">
                  <c:v>2.0547346332080089E-3</c:v>
                </c:pt>
                <c:pt idx="41">
                  <c:v>1.1313690815031863E-3</c:v>
                </c:pt>
                <c:pt idx="42">
                  <c:v>2.1665387377126301E-3</c:v>
                </c:pt>
                <c:pt idx="43">
                  <c:v>1.0324563345381758E-3</c:v>
                </c:pt>
                <c:pt idx="44">
                  <c:v>1.5772870662460567E-3</c:v>
                </c:pt>
                <c:pt idx="45">
                  <c:v>2.108523045497974E-3</c:v>
                </c:pt>
                <c:pt idx="46">
                  <c:v>1.776403056504031E-3</c:v>
                </c:pt>
                <c:pt idx="47">
                  <c:v>2.3676391255576584E-3</c:v>
                </c:pt>
                <c:pt idx="48">
                  <c:v>1.6325581194998084E-3</c:v>
                </c:pt>
                <c:pt idx="49">
                  <c:v>8.4234170995367119E-4</c:v>
                </c:pt>
                <c:pt idx="50">
                  <c:v>8.5958477961883557E-4</c:v>
                </c:pt>
                <c:pt idx="51">
                  <c:v>1.8811302227567108E-3</c:v>
                </c:pt>
                <c:pt idx="52">
                  <c:v>6.8448019267691403E-4</c:v>
                </c:pt>
                <c:pt idx="53">
                  <c:v>8.7062817141701331E-4</c:v>
                </c:pt>
                <c:pt idx="54">
                  <c:v>9.6672134989453948E-4</c:v>
                </c:pt>
                <c:pt idx="55">
                  <c:v>9.2765195438066026E-4</c:v>
                </c:pt>
                <c:pt idx="56">
                  <c:v>1.2572208561510755E-3</c:v>
                </c:pt>
                <c:pt idx="57">
                  <c:v>1.6803635572003918E-3</c:v>
                </c:pt>
                <c:pt idx="58">
                  <c:v>1.5704750687082843E-3</c:v>
                </c:pt>
                <c:pt idx="59">
                  <c:v>1.8283976486732063E-3</c:v>
                </c:pt>
                <c:pt idx="60">
                  <c:v>2.2073464434035615E-3</c:v>
                </c:pt>
                <c:pt idx="61">
                  <c:v>1.3314407948661561E-3</c:v>
                </c:pt>
                <c:pt idx="62">
                  <c:v>1.4414677425976525E-3</c:v>
                </c:pt>
                <c:pt idx="63">
                  <c:v>1.3372596893084458E-3</c:v>
                </c:pt>
                <c:pt idx="64">
                  <c:v>1.6248927856666348E-3</c:v>
                </c:pt>
                <c:pt idx="65">
                  <c:v>3.8592902765181483E-3</c:v>
                </c:pt>
                <c:pt idx="66">
                  <c:v>1.1630978017959448E-3</c:v>
                </c:pt>
                <c:pt idx="67">
                  <c:v>8.3871323732273909E-4</c:v>
                </c:pt>
                <c:pt idx="68">
                  <c:v>1.5015205271160668E-3</c:v>
                </c:pt>
                <c:pt idx="69">
                  <c:v>2.2811384868763546E-3</c:v>
                </c:pt>
                <c:pt idx="70">
                  <c:v>7.5827946389641905E-4</c:v>
                </c:pt>
                <c:pt idx="71">
                  <c:v>1.458462418378533E-3</c:v>
                </c:pt>
                <c:pt idx="72">
                  <c:v>5.8193890595485676E-4</c:v>
                </c:pt>
                <c:pt idx="73">
                  <c:v>1.4671892272133454E-3</c:v>
                </c:pt>
                <c:pt idx="74">
                  <c:v>2.1081585736801422E-3</c:v>
                </c:pt>
                <c:pt idx="75">
                  <c:v>1.9531447654708295E-3</c:v>
                </c:pt>
                <c:pt idx="76">
                  <c:v>2.4683192989500787E-3</c:v>
                </c:pt>
                <c:pt idx="77">
                  <c:v>1.5246207348419939E-3</c:v>
                </c:pt>
                <c:pt idx="78">
                  <c:v>1.1919259969424506E-3</c:v>
                </c:pt>
                <c:pt idx="79">
                  <c:v>1.5326453458669664E-3</c:v>
                </c:pt>
                <c:pt idx="80">
                  <c:v>1.4147606696533837E-3</c:v>
                </c:pt>
                <c:pt idx="81">
                  <c:v>1.456834766321102E-3</c:v>
                </c:pt>
                <c:pt idx="82">
                  <c:v>1.6823216038132623E-3</c:v>
                </c:pt>
                <c:pt idx="83">
                  <c:v>1.4149680676125282E-3</c:v>
                </c:pt>
                <c:pt idx="84">
                  <c:v>1.4162664640976451E-3</c:v>
                </c:pt>
                <c:pt idx="85">
                  <c:v>1.1043196877086651E-3</c:v>
                </c:pt>
                <c:pt idx="86">
                  <c:v>1.0752973661852167E-3</c:v>
                </c:pt>
                <c:pt idx="87">
                  <c:v>2.8760916672138682E-3</c:v>
                </c:pt>
                <c:pt idx="88">
                  <c:v>1.4878209348255431E-3</c:v>
                </c:pt>
                <c:pt idx="89">
                  <c:v>1.7725419615222044E-3</c:v>
                </c:pt>
                <c:pt idx="90">
                  <c:v>1.6388517112343286E-3</c:v>
                </c:pt>
                <c:pt idx="91">
                  <c:v>1.5948305492541417E-3</c:v>
                </c:pt>
                <c:pt idx="92">
                  <c:v>1.2459851589323291E-3</c:v>
                </c:pt>
                <c:pt idx="93">
                  <c:v>1.4486133768352365E-3</c:v>
                </c:pt>
                <c:pt idx="94">
                  <c:v>1.2088204038257174E-3</c:v>
                </c:pt>
                <c:pt idx="95">
                  <c:v>1.2792108455979322E-3</c:v>
                </c:pt>
                <c:pt idx="96">
                  <c:v>1.1880539130672274E-3</c:v>
                </c:pt>
                <c:pt idx="97">
                  <c:v>8.0641854489291035E-4</c:v>
                </c:pt>
                <c:pt idx="98">
                  <c:v>1.7399229462695225E-3</c:v>
                </c:pt>
                <c:pt idx="99">
                  <c:v>9.846341598713042E-4</c:v>
                </c:pt>
                <c:pt idx="100">
                  <c:v>8.3510793770094789E-4</c:v>
                </c:pt>
                <c:pt idx="101">
                  <c:v>6.0665914221218957E-4</c:v>
                </c:pt>
                <c:pt idx="102">
                  <c:v>7.6355306693815222E-4</c:v>
                </c:pt>
                <c:pt idx="103">
                  <c:v>1.932945836679689E-3</c:v>
                </c:pt>
                <c:pt idx="104">
                  <c:v>1.3906499243322836E-3</c:v>
                </c:pt>
                <c:pt idx="105">
                  <c:v>1.8801858386582558E-3</c:v>
                </c:pt>
                <c:pt idx="106">
                  <c:v>1.3402992423206324E-3</c:v>
                </c:pt>
                <c:pt idx="107">
                  <c:v>1.0368134392020473E-3</c:v>
                </c:pt>
                <c:pt idx="108">
                  <c:v>1.1760731667646727E-3</c:v>
                </c:pt>
                <c:pt idx="109">
                  <c:v>2.0554221044550656E-3</c:v>
                </c:pt>
                <c:pt idx="110">
                  <c:v>9.9028284953889961E-4</c:v>
                </c:pt>
                <c:pt idx="111">
                  <c:v>1.8436706438932759E-3</c:v>
                </c:pt>
                <c:pt idx="112">
                  <c:v>1.4843505386568946E-3</c:v>
                </c:pt>
                <c:pt idx="113">
                  <c:v>1.3188412388012189E-3</c:v>
                </c:pt>
                <c:pt idx="114">
                  <c:v>9.1024132495615302E-4</c:v>
                </c:pt>
                <c:pt idx="115">
                  <c:v>1.664934569131901E-3</c:v>
                </c:pt>
                <c:pt idx="116">
                  <c:v>1.5837319058629755E-3</c:v>
                </c:pt>
                <c:pt idx="117">
                  <c:v>1.8384373282709697E-3</c:v>
                </c:pt>
                <c:pt idx="118">
                  <c:v>1.8081896770654503E-3</c:v>
                </c:pt>
                <c:pt idx="119">
                  <c:v>2.266720878227282E-3</c:v>
                </c:pt>
                <c:pt idx="120">
                  <c:v>1.2051697627062294E-3</c:v>
                </c:pt>
                <c:pt idx="121">
                  <c:v>1.8519280628832462E-3</c:v>
                </c:pt>
                <c:pt idx="122">
                  <c:v>1.1474870034624174E-3</c:v>
                </c:pt>
                <c:pt idx="123">
                  <c:v>2.4507834471675372E-3</c:v>
                </c:pt>
                <c:pt idx="124">
                  <c:v>1.9384516491904704E-3</c:v>
                </c:pt>
                <c:pt idx="125">
                  <c:v>1.2674908710478931E-3</c:v>
                </c:pt>
                <c:pt idx="126">
                  <c:v>1.3678582018882182E-3</c:v>
                </c:pt>
                <c:pt idx="127">
                  <c:v>1.1425804889857178E-3</c:v>
                </c:pt>
                <c:pt idx="128">
                  <c:v>1.1130576176695476E-3</c:v>
                </c:pt>
                <c:pt idx="129">
                  <c:v>1.2518753291140498E-3</c:v>
                </c:pt>
                <c:pt idx="130">
                  <c:v>1.1555626394644564E-3</c:v>
                </c:pt>
                <c:pt idx="131">
                  <c:v>1.7413357384603019E-3</c:v>
                </c:pt>
                <c:pt idx="132">
                  <c:v>1.3853553131425783E-3</c:v>
                </c:pt>
                <c:pt idx="133">
                  <c:v>1.7069453516220334E-3</c:v>
                </c:pt>
                <c:pt idx="134">
                  <c:v>1.8741241908167914E-3</c:v>
                </c:pt>
                <c:pt idx="135">
                  <c:v>1.359687775399723E-3</c:v>
                </c:pt>
                <c:pt idx="136">
                  <c:v>8.4889643463497452E-4</c:v>
                </c:pt>
                <c:pt idx="137">
                  <c:v>7.7591693329729825E-4</c:v>
                </c:pt>
                <c:pt idx="138">
                  <c:v>1.9008700458051065E-3</c:v>
                </c:pt>
                <c:pt idx="139">
                  <c:v>9.5396899199948692E-4</c:v>
                </c:pt>
                <c:pt idx="140">
                  <c:v>1.7462830284138201E-3</c:v>
                </c:pt>
                <c:pt idx="141">
                  <c:v>1.3329190108596102E-3</c:v>
                </c:pt>
                <c:pt idx="142">
                  <c:v>1.1205535698219384E-3</c:v>
                </c:pt>
                <c:pt idx="143">
                  <c:v>1.1839491458085021E-3</c:v>
                </c:pt>
                <c:pt idx="144">
                  <c:v>1.8970147389457907E-3</c:v>
                </c:pt>
                <c:pt idx="145">
                  <c:v>9.1546673286991068E-4</c:v>
                </c:pt>
                <c:pt idx="146">
                  <c:v>1.1722491458306529E-3</c:v>
                </c:pt>
                <c:pt idx="147">
                  <c:v>1.0226980097855277E-3</c:v>
                </c:pt>
                <c:pt idx="148">
                  <c:v>1.5346816436224251E-3</c:v>
                </c:pt>
                <c:pt idx="149">
                  <c:v>2.6342727474462585E-3</c:v>
                </c:pt>
                <c:pt idx="150">
                  <c:v>6.4244666280728017E-4</c:v>
                </c:pt>
                <c:pt idx="151">
                  <c:v>1.3302953538727163E-3</c:v>
                </c:pt>
                <c:pt idx="152">
                  <c:v>1.5467960262592227E-3</c:v>
                </c:pt>
                <c:pt idx="153">
                  <c:v>1.9340531501072455E-3</c:v>
                </c:pt>
                <c:pt idx="154">
                  <c:v>1.111397243192692E-3</c:v>
                </c:pt>
                <c:pt idx="155">
                  <c:v>1.2688789806672188E-3</c:v>
                </c:pt>
                <c:pt idx="156">
                  <c:v>1.1279123048183004E-3</c:v>
                </c:pt>
                <c:pt idx="157">
                  <c:v>1.3602979811543267E-3</c:v>
                </c:pt>
                <c:pt idx="158">
                  <c:v>1.3735947952826502E-3</c:v>
                </c:pt>
                <c:pt idx="159">
                  <c:v>2.2869751593125286E-3</c:v>
                </c:pt>
                <c:pt idx="160">
                  <c:v>1.0504883590545604E-3</c:v>
                </c:pt>
                <c:pt idx="161">
                  <c:v>2.0633051748379649E-3</c:v>
                </c:pt>
                <c:pt idx="162">
                  <c:v>1.3921194438482822E-3</c:v>
                </c:pt>
                <c:pt idx="163">
                  <c:v>1.1903863239128289E-3</c:v>
                </c:pt>
                <c:pt idx="164">
                  <c:v>1.4012467059169517E-3</c:v>
                </c:pt>
                <c:pt idx="165">
                  <c:v>1.2858139548292981E-3</c:v>
                </c:pt>
                <c:pt idx="166">
                  <c:v>1.3418140629084256E-3</c:v>
                </c:pt>
                <c:pt idx="167">
                  <c:v>1.2423954317178304E-3</c:v>
                </c:pt>
                <c:pt idx="168">
                  <c:v>5.3084129595277259E-4</c:v>
                </c:pt>
                <c:pt idx="169">
                  <c:v>1.1837175626910612E-3</c:v>
                </c:pt>
                <c:pt idx="170">
                  <c:v>1.6046213093709885E-3</c:v>
                </c:pt>
                <c:pt idx="171">
                  <c:v>1.9286565754256539E-3</c:v>
                </c:pt>
                <c:pt idx="172">
                  <c:v>1.8030646446719157E-3</c:v>
                </c:pt>
                <c:pt idx="173">
                  <c:v>1.3094693826867828E-3</c:v>
                </c:pt>
                <c:pt idx="174">
                  <c:v>1.1389143823877395E-3</c:v>
                </c:pt>
                <c:pt idx="175">
                  <c:v>2.0083457925155648E-3</c:v>
                </c:pt>
                <c:pt idx="176">
                  <c:v>1.711499338004973E-3</c:v>
                </c:pt>
                <c:pt idx="177">
                  <c:v>1.4014510408469076E-3</c:v>
                </c:pt>
                <c:pt idx="178">
                  <c:v>1.8064020205347828E-3</c:v>
                </c:pt>
                <c:pt idx="179">
                  <c:v>1.3373746896358943E-3</c:v>
                </c:pt>
                <c:pt idx="180">
                  <c:v>1.6315460487980591E-3</c:v>
                </c:pt>
                <c:pt idx="181">
                  <c:v>1.6569434454833639E-3</c:v>
                </c:pt>
                <c:pt idx="182">
                  <c:v>1.7928340156806079E-3</c:v>
                </c:pt>
                <c:pt idx="183">
                  <c:v>1.9146275330079573E-3</c:v>
                </c:pt>
                <c:pt idx="184">
                  <c:v>1.4005961511822981E-3</c:v>
                </c:pt>
                <c:pt idx="185">
                  <c:v>1.7211348118897853E-3</c:v>
                </c:pt>
                <c:pt idx="186">
                  <c:v>2.2792700133861888E-3</c:v>
                </c:pt>
                <c:pt idx="187">
                  <c:v>1.8450377370324686E-3</c:v>
                </c:pt>
                <c:pt idx="188">
                  <c:v>1.8580921487733443E-3</c:v>
                </c:pt>
                <c:pt idx="189">
                  <c:v>1.3171443057029212E-3</c:v>
                </c:pt>
                <c:pt idx="190">
                  <c:v>1.9654278027483769E-3</c:v>
                </c:pt>
                <c:pt idx="191">
                  <c:v>2.4011008295218412E-3</c:v>
                </c:pt>
                <c:pt idx="192">
                  <c:v>1.270513499205929E-3</c:v>
                </c:pt>
                <c:pt idx="193">
                  <c:v>1.8838803395524082E-3</c:v>
                </c:pt>
                <c:pt idx="194">
                  <c:v>1.7858161693387346E-3</c:v>
                </c:pt>
                <c:pt idx="195">
                  <c:v>1.0389222759859718E-3</c:v>
                </c:pt>
                <c:pt idx="196">
                  <c:v>1.3671011137853192E-3</c:v>
                </c:pt>
                <c:pt idx="197">
                  <c:v>1.0130656524432249E-3</c:v>
                </c:pt>
                <c:pt idx="198">
                  <c:v>1.5030147679939412E-3</c:v>
                </c:pt>
                <c:pt idx="199">
                  <c:v>1.2948336138806163E-3</c:v>
                </c:pt>
                <c:pt idx="200">
                  <c:v>1.1821744039317262E-3</c:v>
                </c:pt>
                <c:pt idx="201">
                  <c:v>1.1100486147796954E-3</c:v>
                </c:pt>
                <c:pt idx="202">
                  <c:v>9.7856539631898548E-4</c:v>
                </c:pt>
                <c:pt idx="203">
                  <c:v>1.1851149561507466E-3</c:v>
                </c:pt>
                <c:pt idx="204">
                  <c:v>1.3184881336067975E-3</c:v>
                </c:pt>
                <c:pt idx="205">
                  <c:v>9.4266000108174104E-4</c:v>
                </c:pt>
                <c:pt idx="206">
                  <c:v>1.4994396830658018E-3</c:v>
                </c:pt>
                <c:pt idx="207">
                  <c:v>1.6062321808617435E-3</c:v>
                </c:pt>
                <c:pt idx="208">
                  <c:v>1.0579485343833273E-3</c:v>
                </c:pt>
                <c:pt idx="209">
                  <c:v>2.2708554888336277E-3</c:v>
                </c:pt>
                <c:pt idx="210">
                  <c:v>2.2960197028680383E-3</c:v>
                </c:pt>
                <c:pt idx="211">
                  <c:v>1.9194011468421852E-3</c:v>
                </c:pt>
                <c:pt idx="212">
                  <c:v>1.4853737904506779E-3</c:v>
                </c:pt>
                <c:pt idx="213">
                  <c:v>1.2468613490179891E-3</c:v>
                </c:pt>
                <c:pt idx="214">
                  <c:v>2.2053069645016719E-3</c:v>
                </c:pt>
                <c:pt idx="215">
                  <c:v>1.4250723669561344E-3</c:v>
                </c:pt>
                <c:pt idx="216">
                  <c:v>1.0251930037263536E-3</c:v>
                </c:pt>
                <c:pt idx="217">
                  <c:v>2.24803649532051E-3</c:v>
                </c:pt>
                <c:pt idx="218">
                  <c:v>2.5643516270033996E-3</c:v>
                </c:pt>
                <c:pt idx="219">
                  <c:v>1.5698895190250986E-3</c:v>
                </c:pt>
                <c:pt idx="220">
                  <c:v>1.1630084465952435E-3</c:v>
                </c:pt>
                <c:pt idx="221">
                  <c:v>9.8956993290715846E-4</c:v>
                </c:pt>
                <c:pt idx="222">
                  <c:v>1.0357538155342763E-3</c:v>
                </c:pt>
                <c:pt idx="223">
                  <c:v>1.6862359695856825E-3</c:v>
                </c:pt>
                <c:pt idx="224">
                  <c:v>1.7300476844393023E-3</c:v>
                </c:pt>
                <c:pt idx="225">
                  <c:v>8.0850329869345866E-4</c:v>
                </c:pt>
                <c:pt idx="226">
                  <c:v>1.2611252958992754E-3</c:v>
                </c:pt>
                <c:pt idx="227">
                  <c:v>1.1042097998619738E-3</c:v>
                </c:pt>
                <c:pt idx="228">
                  <c:v>7.6756047063576227E-4</c:v>
                </c:pt>
                <c:pt idx="229">
                  <c:v>1.1889655999280627E-3</c:v>
                </c:pt>
                <c:pt idx="230">
                  <c:v>1.2611906786543477E-3</c:v>
                </c:pt>
                <c:pt idx="231">
                  <c:v>1.7431340413236449E-3</c:v>
                </c:pt>
                <c:pt idx="232">
                  <c:v>2.301105284997548E-3</c:v>
                </c:pt>
                <c:pt idx="233">
                  <c:v>1.2072282793224431E-3</c:v>
                </c:pt>
                <c:pt idx="234">
                  <c:v>2.1756237559598206E-3</c:v>
                </c:pt>
                <c:pt idx="235">
                  <c:v>1.7646843683710044E-3</c:v>
                </c:pt>
                <c:pt idx="236">
                  <c:v>1.440722577785166E-3</c:v>
                </c:pt>
                <c:pt idx="237">
                  <c:v>1.530207604385351E-3</c:v>
                </c:pt>
                <c:pt idx="238">
                  <c:v>1.6393301179454881E-3</c:v>
                </c:pt>
                <c:pt idx="239">
                  <c:v>9.751046295896794E-4</c:v>
                </c:pt>
                <c:pt idx="240">
                  <c:v>1.5385413245284976E-3</c:v>
                </c:pt>
                <c:pt idx="241">
                  <c:v>1.6227849419442179E-3</c:v>
                </c:pt>
                <c:pt idx="242">
                  <c:v>9.068098780648853E-4</c:v>
                </c:pt>
                <c:pt idx="243">
                  <c:v>1.7869846539516922E-3</c:v>
                </c:pt>
                <c:pt idx="244">
                  <c:v>1.4712211918456782E-3</c:v>
                </c:pt>
                <c:pt idx="245">
                  <c:v>1.8999887795938214E-3</c:v>
                </c:pt>
                <c:pt idx="246">
                  <c:v>2.1908906641230474E-3</c:v>
                </c:pt>
                <c:pt idx="247">
                  <c:v>1.3724065552595463E-3</c:v>
                </c:pt>
                <c:pt idx="248">
                  <c:v>1.3213187194038903E-3</c:v>
                </c:pt>
                <c:pt idx="249">
                  <c:v>9.6835059987895617E-4</c:v>
                </c:pt>
                <c:pt idx="250">
                  <c:v>1.4439607414238026E-3</c:v>
                </c:pt>
                <c:pt idx="251">
                  <c:v>1.1078509705445927E-3</c:v>
                </c:pt>
                <c:pt idx="252">
                  <c:v>1.6280917462260832E-3</c:v>
                </c:pt>
                <c:pt idx="253">
                  <c:v>1.7026178540685605E-3</c:v>
                </c:pt>
                <c:pt idx="254">
                  <c:v>1.1139607782181809E-3</c:v>
                </c:pt>
                <c:pt idx="255">
                  <c:v>1.03675593200446E-3</c:v>
                </c:pt>
                <c:pt idx="256">
                  <c:v>6.7641128382861667E-4</c:v>
                </c:pt>
                <c:pt idx="257">
                  <c:v>6.1544505188725572E-4</c:v>
                </c:pt>
                <c:pt idx="258">
                  <c:v>1.8826780078828676E-3</c:v>
                </c:pt>
                <c:pt idx="259">
                  <c:v>1.4207893565199173E-3</c:v>
                </c:pt>
                <c:pt idx="260">
                  <c:v>1.6838081368890506E-3</c:v>
                </c:pt>
                <c:pt idx="261">
                  <c:v>1.6882986887324413E-3</c:v>
                </c:pt>
                <c:pt idx="262">
                  <c:v>2.0504080844661616E-3</c:v>
                </c:pt>
                <c:pt idx="263">
                  <c:v>1.3920711887888315E-3</c:v>
                </c:pt>
                <c:pt idx="264">
                  <c:v>1.4105414464095003E-3</c:v>
                </c:pt>
                <c:pt idx="265">
                  <c:v>1.8945972402033533E-3</c:v>
                </c:pt>
                <c:pt idx="266">
                  <c:v>1.7641870038224052E-3</c:v>
                </c:pt>
                <c:pt idx="267">
                  <c:v>1.8489964457453481E-3</c:v>
                </c:pt>
                <c:pt idx="268">
                  <c:v>8.3708403595821859E-4</c:v>
                </c:pt>
                <c:pt idx="269">
                  <c:v>1.0863535502958579E-3</c:v>
                </c:pt>
                <c:pt idx="270">
                  <c:v>2.1090407177363699E-3</c:v>
                </c:pt>
                <c:pt idx="271">
                  <c:v>1.5966145142756122E-3</c:v>
                </c:pt>
                <c:pt idx="272">
                  <c:v>1.2392092067492458E-3</c:v>
                </c:pt>
                <c:pt idx="273">
                  <c:v>2.2509499421774328E-3</c:v>
                </c:pt>
                <c:pt idx="274">
                  <c:v>7.84536728429189E-4</c:v>
                </c:pt>
                <c:pt idx="275">
                  <c:v>1.0322047894302229E-3</c:v>
                </c:pt>
                <c:pt idx="276">
                  <c:v>1.8417570785922203E-3</c:v>
                </c:pt>
                <c:pt idx="277">
                  <c:v>1.9632434263095787E-3</c:v>
                </c:pt>
                <c:pt idx="278">
                  <c:v>1.4163807954836538E-3</c:v>
                </c:pt>
                <c:pt idx="279">
                  <c:v>8.3806407199369455E-4</c:v>
                </c:pt>
                <c:pt idx="280">
                  <c:v>1.6200166353947038E-3</c:v>
                </c:pt>
                <c:pt idx="281">
                  <c:v>2.0236153000808476E-3</c:v>
                </c:pt>
                <c:pt idx="282">
                  <c:v>1.2505811250581125E-3</c:v>
                </c:pt>
                <c:pt idx="283">
                  <c:v>1.7006021050696327E-3</c:v>
                </c:pt>
                <c:pt idx="284">
                  <c:v>1.3299668986016349E-3</c:v>
                </c:pt>
                <c:pt idx="285">
                  <c:v>1.2403311514265932E-3</c:v>
                </c:pt>
                <c:pt idx="286">
                  <c:v>1.6961452415611407E-3</c:v>
                </c:pt>
                <c:pt idx="287">
                  <c:v>8.5350448943361445E-4</c:v>
                </c:pt>
                <c:pt idx="288">
                  <c:v>4.7360000000000002E-4</c:v>
                </c:pt>
                <c:pt idx="289">
                  <c:v>1.3620208064892725E-3</c:v>
                </c:pt>
                <c:pt idx="290">
                  <c:v>1.8178401786377561E-3</c:v>
                </c:pt>
                <c:pt idx="291">
                  <c:v>1.394421445419912E-3</c:v>
                </c:pt>
                <c:pt idx="292">
                  <c:v>1.5172638235927927E-3</c:v>
                </c:pt>
                <c:pt idx="293">
                  <c:v>2.0471551602428348E-3</c:v>
                </c:pt>
                <c:pt idx="294">
                  <c:v>7.0123561094096527E-4</c:v>
                </c:pt>
                <c:pt idx="295">
                  <c:v>1.0895904149698784E-3</c:v>
                </c:pt>
                <c:pt idx="296">
                  <c:v>1.3019842578267009E-3</c:v>
                </c:pt>
                <c:pt idx="297">
                  <c:v>2.5329302433591216E-3</c:v>
                </c:pt>
                <c:pt idx="298">
                  <c:v>1.9267907690408374E-3</c:v>
                </c:pt>
                <c:pt idx="299">
                  <c:v>1.3146418770873664E-3</c:v>
                </c:pt>
                <c:pt idx="300">
                  <c:v>1.0199218802193055E-3</c:v>
                </c:pt>
                <c:pt idx="301">
                  <c:v>1.0590594650623042E-3</c:v>
                </c:pt>
                <c:pt idx="302">
                  <c:v>8.7824782802556377E-4</c:v>
                </c:pt>
                <c:pt idx="303">
                  <c:v>1.5617058633276349E-3</c:v>
                </c:pt>
                <c:pt idx="304">
                  <c:v>1.7832337574321434E-3</c:v>
                </c:pt>
                <c:pt idx="305">
                  <c:v>1.8484288354898336E-3</c:v>
                </c:pt>
                <c:pt idx="306">
                  <c:v>1.1778686336200352E-3</c:v>
                </c:pt>
                <c:pt idx="307">
                  <c:v>1.186825190102088E-3</c:v>
                </c:pt>
                <c:pt idx="308">
                  <c:v>1.1873551925774539E-3</c:v>
                </c:pt>
                <c:pt idx="309">
                  <c:v>6.7322712474162283E-4</c:v>
                </c:pt>
                <c:pt idx="310">
                  <c:v>1.278146844870844E-3</c:v>
                </c:pt>
                <c:pt idx="311">
                  <c:v>1.0927897515796764E-3</c:v>
                </c:pt>
                <c:pt idx="312">
                  <c:v>9.7731542312328281E-4</c:v>
                </c:pt>
                <c:pt idx="313">
                  <c:v>1.2317016012120816E-3</c:v>
                </c:pt>
                <c:pt idx="314">
                  <c:v>2.9564106809205079E-3</c:v>
                </c:pt>
                <c:pt idx="315">
                  <c:v>8.3564964351541809E-4</c:v>
                </c:pt>
                <c:pt idx="316">
                  <c:v>1.3108670278035495E-3</c:v>
                </c:pt>
                <c:pt idx="317">
                  <c:v>3.5444163427630828E-4</c:v>
                </c:pt>
                <c:pt idx="318">
                  <c:v>2.268882743065811E-3</c:v>
                </c:pt>
                <c:pt idx="319">
                  <c:v>1.0035370568396808E-3</c:v>
                </c:pt>
                <c:pt idx="320">
                  <c:v>9.3758825190624114E-4</c:v>
                </c:pt>
                <c:pt idx="321">
                  <c:v>1.0651106788922848E-3</c:v>
                </c:pt>
                <c:pt idx="322">
                  <c:v>1.0279632015198241E-3</c:v>
                </c:pt>
                <c:pt idx="323">
                  <c:v>1.0321814377014875E-3</c:v>
                </c:pt>
                <c:pt idx="324">
                  <c:v>1.1507479861910242E-3</c:v>
                </c:pt>
                <c:pt idx="325">
                  <c:v>7.8616352201257866E-4</c:v>
                </c:pt>
                <c:pt idx="326">
                  <c:v>6.6342326404245913E-4</c:v>
                </c:pt>
                <c:pt idx="327">
                  <c:v>1.2068350750157712E-3</c:v>
                </c:pt>
                <c:pt idx="328">
                  <c:v>1.23738554183738E-3</c:v>
                </c:pt>
                <c:pt idx="329">
                  <c:v>8.5055711491026625E-4</c:v>
                </c:pt>
                <c:pt idx="330">
                  <c:v>1.1945342773067623E-3</c:v>
                </c:pt>
                <c:pt idx="331">
                  <c:v>1.9033674963396779E-3</c:v>
                </c:pt>
                <c:pt idx="332">
                  <c:v>8.328336331534413E-4</c:v>
                </c:pt>
                <c:pt idx="333">
                  <c:v>7.6633458834505044E-4</c:v>
                </c:pt>
                <c:pt idx="334">
                  <c:v>8.7263080735802299E-4</c:v>
                </c:pt>
                <c:pt idx="335">
                  <c:v>1.4981561155500921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54B-4801-8906-8FA15F3F3362}"/>
            </c:ext>
          </c:extLst>
        </c:ser>
        <c:ser>
          <c:idx val="1"/>
          <c:order val="1"/>
          <c:tx>
            <c:strRef>
              <c:f>controls!$H$1</c:f>
              <c:strCache>
                <c:ptCount val="1"/>
                <c:pt idx="0">
                  <c:v>4SU-, UV-</c:v>
                </c:pt>
              </c:strCache>
            </c:strRef>
          </c:tx>
          <c:spPr>
            <a:ln w="19050" cap="rnd">
              <a:solidFill>
                <a:schemeClr val="accent2">
                  <a:alpha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controls!$F$2:$F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H$2:$H$345</c:f>
              <c:numCache>
                <c:formatCode>0.0000%</c:formatCode>
                <c:ptCount val="344"/>
                <c:pt idx="0">
                  <c:v>1.0089362928797925E-3</c:v>
                </c:pt>
                <c:pt idx="1">
                  <c:v>1.862923490165497E-3</c:v>
                </c:pt>
                <c:pt idx="2">
                  <c:v>1.9127662657585857E-3</c:v>
                </c:pt>
                <c:pt idx="3">
                  <c:v>1.7613767613767614E-3</c:v>
                </c:pt>
                <c:pt idx="4">
                  <c:v>9.9061073305194256E-4</c:v>
                </c:pt>
                <c:pt idx="5">
                  <c:v>1.5866224551645451E-3</c:v>
                </c:pt>
                <c:pt idx="6">
                  <c:v>1.6004837017409707E-3</c:v>
                </c:pt>
                <c:pt idx="7">
                  <c:v>9.8972337231743738E-4</c:v>
                </c:pt>
                <c:pt idx="8">
                  <c:v>2.2339785685352711E-3</c:v>
                </c:pt>
                <c:pt idx="9">
                  <c:v>2.3947860354670844E-3</c:v>
                </c:pt>
                <c:pt idx="10">
                  <c:v>1.884925939789316E-3</c:v>
                </c:pt>
                <c:pt idx="11">
                  <c:v>2.3576021590672406E-3</c:v>
                </c:pt>
                <c:pt idx="12">
                  <c:v>1.9727957207545171E-3</c:v>
                </c:pt>
                <c:pt idx="13">
                  <c:v>2.8396927889278193E-3</c:v>
                </c:pt>
                <c:pt idx="14">
                  <c:v>2.0386935718743498E-3</c:v>
                </c:pt>
                <c:pt idx="15">
                  <c:v>2.739235273854633E-3</c:v>
                </c:pt>
                <c:pt idx="16">
                  <c:v>1.8678200501391223E-3</c:v>
                </c:pt>
                <c:pt idx="17">
                  <c:v>2.3192990562852117E-3</c:v>
                </c:pt>
                <c:pt idx="18">
                  <c:v>1.1926931849092926E-3</c:v>
                </c:pt>
                <c:pt idx="19">
                  <c:v>1.3181310267764764E-3</c:v>
                </c:pt>
                <c:pt idx="20">
                  <c:v>1.3002069059906128E-3</c:v>
                </c:pt>
                <c:pt idx="21">
                  <c:v>1.0800451957374217E-3</c:v>
                </c:pt>
                <c:pt idx="22">
                  <c:v>1.8858170539023307E-3</c:v>
                </c:pt>
                <c:pt idx="23">
                  <c:v>1.1220691297368877E-3</c:v>
                </c:pt>
                <c:pt idx="24">
                  <c:v>1.5386426169888663E-3</c:v>
                </c:pt>
                <c:pt idx="25">
                  <c:v>1.8445730762251512E-3</c:v>
                </c:pt>
                <c:pt idx="26">
                  <c:v>1.5712902352450699E-3</c:v>
                </c:pt>
                <c:pt idx="27">
                  <c:v>1.4932969049245317E-3</c:v>
                </c:pt>
                <c:pt idx="28">
                  <c:v>1.5191189110316016E-3</c:v>
                </c:pt>
                <c:pt idx="29">
                  <c:v>1.440967273182365E-3</c:v>
                </c:pt>
                <c:pt idx="30">
                  <c:v>1.6036583017328613E-3</c:v>
                </c:pt>
                <c:pt idx="31">
                  <c:v>9.9610818783454815E-4</c:v>
                </c:pt>
                <c:pt idx="32">
                  <c:v>2.0237807107435462E-3</c:v>
                </c:pt>
                <c:pt idx="33">
                  <c:v>1.5833614953245376E-3</c:v>
                </c:pt>
                <c:pt idx="34">
                  <c:v>2.0677420291191351E-3</c:v>
                </c:pt>
                <c:pt idx="35">
                  <c:v>1.4374929576502966E-3</c:v>
                </c:pt>
                <c:pt idx="36">
                  <c:v>1.9350618519549589E-3</c:v>
                </c:pt>
                <c:pt idx="37">
                  <c:v>2.7986982958540414E-3</c:v>
                </c:pt>
                <c:pt idx="38">
                  <c:v>1.7769077676499578E-3</c:v>
                </c:pt>
                <c:pt idx="39">
                  <c:v>2.5125936309080554E-3</c:v>
                </c:pt>
                <c:pt idx="40">
                  <c:v>2.6829893810293281E-3</c:v>
                </c:pt>
                <c:pt idx="41">
                  <c:v>1.5279907975460122E-3</c:v>
                </c:pt>
                <c:pt idx="42">
                  <c:v>2.4104506171781733E-3</c:v>
                </c:pt>
                <c:pt idx="43">
                  <c:v>1.3089637839927826E-3</c:v>
                </c:pt>
                <c:pt idx="44">
                  <c:v>2.1687441759398935E-3</c:v>
                </c:pt>
                <c:pt idx="45">
                  <c:v>2.6832205359727775E-3</c:v>
                </c:pt>
                <c:pt idx="46">
                  <c:v>2.1532050848603692E-3</c:v>
                </c:pt>
                <c:pt idx="47">
                  <c:v>2.8345063119616168E-3</c:v>
                </c:pt>
                <c:pt idx="48">
                  <c:v>2.246612692318393E-3</c:v>
                </c:pt>
                <c:pt idx="49">
                  <c:v>1.1557010082681226E-3</c:v>
                </c:pt>
                <c:pt idx="50">
                  <c:v>1.1704709441700176E-3</c:v>
                </c:pt>
                <c:pt idx="51">
                  <c:v>2.058087805754857E-3</c:v>
                </c:pt>
                <c:pt idx="52">
                  <c:v>9.057187017001546E-4</c:v>
                </c:pt>
                <c:pt idx="53">
                  <c:v>1.3594860307185993E-3</c:v>
                </c:pt>
                <c:pt idx="54">
                  <c:v>1.5573623099054666E-3</c:v>
                </c:pt>
                <c:pt idx="55">
                  <c:v>1.6124412231380489E-3</c:v>
                </c:pt>
                <c:pt idx="56">
                  <c:v>1.5144286375202405E-3</c:v>
                </c:pt>
                <c:pt idx="57">
                  <c:v>2.1773787389379692E-3</c:v>
                </c:pt>
                <c:pt idx="58">
                  <c:v>1.9981372601312122E-3</c:v>
                </c:pt>
                <c:pt idx="59">
                  <c:v>2.1240054095762774E-3</c:v>
                </c:pt>
                <c:pt idx="60">
                  <c:v>2.7111521549423455E-3</c:v>
                </c:pt>
                <c:pt idx="61">
                  <c:v>1.8782583748358204E-3</c:v>
                </c:pt>
                <c:pt idx="62">
                  <c:v>1.8039038329101954E-3</c:v>
                </c:pt>
                <c:pt idx="63">
                  <c:v>1.4382673602544788E-3</c:v>
                </c:pt>
                <c:pt idx="64">
                  <c:v>1.7951493457082535E-3</c:v>
                </c:pt>
                <c:pt idx="65">
                  <c:v>4.2063724374193688E-3</c:v>
                </c:pt>
                <c:pt idx="66">
                  <c:v>1.6931798031106459E-3</c:v>
                </c:pt>
                <c:pt idx="67">
                  <c:v>1.1999325037966614E-3</c:v>
                </c:pt>
                <c:pt idx="68">
                  <c:v>1.8207857446150082E-3</c:v>
                </c:pt>
                <c:pt idx="69">
                  <c:v>2.7707943300347686E-3</c:v>
                </c:pt>
                <c:pt idx="70">
                  <c:v>1.3713600034284E-3</c:v>
                </c:pt>
                <c:pt idx="71">
                  <c:v>1.8412042121584082E-3</c:v>
                </c:pt>
                <c:pt idx="72">
                  <c:v>9.9094150213806394E-4</c:v>
                </c:pt>
                <c:pt idx="73">
                  <c:v>1.5769850299063946E-3</c:v>
                </c:pt>
                <c:pt idx="74">
                  <c:v>2.2250406069910778E-3</c:v>
                </c:pt>
                <c:pt idx="75">
                  <c:v>2.0944636716956197E-3</c:v>
                </c:pt>
                <c:pt idx="76">
                  <c:v>2.5444035473431979E-3</c:v>
                </c:pt>
                <c:pt idx="77">
                  <c:v>1.8178422461557616E-3</c:v>
                </c:pt>
                <c:pt idx="78">
                  <c:v>1.3302464793236209E-3</c:v>
                </c:pt>
                <c:pt idx="79">
                  <c:v>1.8751640768567249E-3</c:v>
                </c:pt>
                <c:pt idx="80">
                  <c:v>1.4643237486687967E-3</c:v>
                </c:pt>
                <c:pt idx="81">
                  <c:v>1.8098745744263456E-3</c:v>
                </c:pt>
                <c:pt idx="82">
                  <c:v>2.3634037887555583E-3</c:v>
                </c:pt>
                <c:pt idx="83">
                  <c:v>1.5843804463077842E-3</c:v>
                </c:pt>
                <c:pt idx="84">
                  <c:v>1.852419800036803E-3</c:v>
                </c:pt>
                <c:pt idx="85">
                  <c:v>1.6594877551767476E-3</c:v>
                </c:pt>
                <c:pt idx="86">
                  <c:v>1.4193305281668027E-3</c:v>
                </c:pt>
                <c:pt idx="87">
                  <c:v>3.3240244173689541E-3</c:v>
                </c:pt>
                <c:pt idx="88">
                  <c:v>2.7126117868556E-3</c:v>
                </c:pt>
                <c:pt idx="89">
                  <c:v>2.4161691574089462E-3</c:v>
                </c:pt>
                <c:pt idx="90">
                  <c:v>2.1516393442622952E-3</c:v>
                </c:pt>
                <c:pt idx="91">
                  <c:v>1.5078485449905922E-3</c:v>
                </c:pt>
                <c:pt idx="92">
                  <c:v>1.2738361769474252E-3</c:v>
                </c:pt>
                <c:pt idx="93">
                  <c:v>1.6841748149225158E-3</c:v>
                </c:pt>
                <c:pt idx="94">
                  <c:v>1.5734777517564403E-3</c:v>
                </c:pt>
                <c:pt idx="95">
                  <c:v>1.7683572322201905E-3</c:v>
                </c:pt>
                <c:pt idx="96">
                  <c:v>1.7774047422145969E-3</c:v>
                </c:pt>
                <c:pt idx="97">
                  <c:v>1.2333041451352317E-3</c:v>
                </c:pt>
                <c:pt idx="98">
                  <c:v>1.7768690593547287E-3</c:v>
                </c:pt>
                <c:pt idx="99">
                  <c:v>1.001159880349185E-3</c:v>
                </c:pt>
                <c:pt idx="100">
                  <c:v>1.5049553407561482E-3</c:v>
                </c:pt>
                <c:pt idx="101">
                  <c:v>1.0411760331193137E-3</c:v>
                </c:pt>
                <c:pt idx="102">
                  <c:v>1.8139349965212205E-3</c:v>
                </c:pt>
                <c:pt idx="103">
                  <c:v>2.0902510690141182E-3</c:v>
                </c:pt>
                <c:pt idx="104">
                  <c:v>2.0576623998085895E-3</c:v>
                </c:pt>
                <c:pt idx="105">
                  <c:v>1.9363398395945638E-3</c:v>
                </c:pt>
                <c:pt idx="106">
                  <c:v>1.3310150488638408E-3</c:v>
                </c:pt>
                <c:pt idx="107">
                  <c:v>1.5157778696431032E-3</c:v>
                </c:pt>
                <c:pt idx="108">
                  <c:v>1.5028686141796202E-3</c:v>
                </c:pt>
                <c:pt idx="109">
                  <c:v>2.6794818945130284E-3</c:v>
                </c:pt>
                <c:pt idx="110">
                  <c:v>1.3448148710496063E-3</c:v>
                </c:pt>
                <c:pt idx="111">
                  <c:v>2.2446119157407221E-3</c:v>
                </c:pt>
                <c:pt idx="112">
                  <c:v>2.2958380316744379E-3</c:v>
                </c:pt>
                <c:pt idx="113">
                  <c:v>1.621069906138051E-3</c:v>
                </c:pt>
                <c:pt idx="114">
                  <c:v>1.2721899281701995E-3</c:v>
                </c:pt>
                <c:pt idx="115">
                  <c:v>1.9749835418038184E-3</c:v>
                </c:pt>
                <c:pt idx="116">
                  <c:v>1.9021739130434783E-3</c:v>
                </c:pt>
                <c:pt idx="117">
                  <c:v>2.1677460793234492E-3</c:v>
                </c:pt>
                <c:pt idx="118">
                  <c:v>1.8312029734384916E-3</c:v>
                </c:pt>
                <c:pt idx="119">
                  <c:v>2.3128832130029386E-3</c:v>
                </c:pt>
                <c:pt idx="120">
                  <c:v>2.0591972840857441E-3</c:v>
                </c:pt>
                <c:pt idx="121">
                  <c:v>2.2666581016967816E-3</c:v>
                </c:pt>
                <c:pt idx="122">
                  <c:v>1.226982955606334E-3</c:v>
                </c:pt>
                <c:pt idx="123">
                  <c:v>2.5633901282591355E-3</c:v>
                </c:pt>
                <c:pt idx="124">
                  <c:v>2.3932451328385501E-3</c:v>
                </c:pt>
                <c:pt idx="125">
                  <c:v>1.8130087868099122E-3</c:v>
                </c:pt>
                <c:pt idx="126">
                  <c:v>1.3207675789904223E-3</c:v>
                </c:pt>
                <c:pt idx="127">
                  <c:v>1.1129132445303334E-3</c:v>
                </c:pt>
                <c:pt idx="128">
                  <c:v>1.966839771570539E-3</c:v>
                </c:pt>
                <c:pt idx="129">
                  <c:v>1.8926435698989701E-3</c:v>
                </c:pt>
                <c:pt idx="130">
                  <c:v>1.6848073168774904E-3</c:v>
                </c:pt>
                <c:pt idx="131">
                  <c:v>2.1249231113347872E-3</c:v>
                </c:pt>
                <c:pt idx="132">
                  <c:v>1.6722408026755853E-3</c:v>
                </c:pt>
                <c:pt idx="133">
                  <c:v>1.929416175850271E-3</c:v>
                </c:pt>
                <c:pt idx="134">
                  <c:v>2.0832208136906186E-3</c:v>
                </c:pt>
                <c:pt idx="135">
                  <c:v>1.6099164808586221E-3</c:v>
                </c:pt>
                <c:pt idx="136">
                  <c:v>1.2492334249437846E-3</c:v>
                </c:pt>
                <c:pt idx="137">
                  <c:v>1.4763856822001288E-3</c:v>
                </c:pt>
                <c:pt idx="138">
                  <c:v>1.6537075668499905E-3</c:v>
                </c:pt>
                <c:pt idx="139">
                  <c:v>1.3685140399403357E-3</c:v>
                </c:pt>
                <c:pt idx="140">
                  <c:v>2.2069026600927046E-3</c:v>
                </c:pt>
                <c:pt idx="141">
                  <c:v>1.7079987578190853E-3</c:v>
                </c:pt>
                <c:pt idx="142">
                  <c:v>1.7963407872851598E-3</c:v>
                </c:pt>
                <c:pt idx="143">
                  <c:v>1.534383149159331E-3</c:v>
                </c:pt>
                <c:pt idx="144">
                  <c:v>2.4907395580533913E-3</c:v>
                </c:pt>
                <c:pt idx="145">
                  <c:v>1.0436720331154314E-3</c:v>
                </c:pt>
                <c:pt idx="146">
                  <c:v>1.6584826509707001E-3</c:v>
                </c:pt>
                <c:pt idx="147">
                  <c:v>1.2955541682609366E-3</c:v>
                </c:pt>
                <c:pt idx="148">
                  <c:v>1.7873985107210932E-3</c:v>
                </c:pt>
                <c:pt idx="149">
                  <c:v>2.6323736001155357E-3</c:v>
                </c:pt>
                <c:pt idx="150">
                  <c:v>1.3469147234615709E-3</c:v>
                </c:pt>
                <c:pt idx="151">
                  <c:v>1.8101250218966736E-3</c:v>
                </c:pt>
                <c:pt idx="152">
                  <c:v>1.9715297734411549E-3</c:v>
                </c:pt>
                <c:pt idx="153">
                  <c:v>2.5079250431363108E-3</c:v>
                </c:pt>
                <c:pt idx="154">
                  <c:v>1.7260140332445312E-3</c:v>
                </c:pt>
                <c:pt idx="155">
                  <c:v>1.7437365312803303E-3</c:v>
                </c:pt>
                <c:pt idx="156">
                  <c:v>1.8371264052646011E-3</c:v>
                </c:pt>
                <c:pt idx="157">
                  <c:v>1.5153992913600437E-3</c:v>
                </c:pt>
                <c:pt idx="158">
                  <c:v>2.0320517288524536E-3</c:v>
                </c:pt>
                <c:pt idx="159">
                  <c:v>2.6276699003094216E-3</c:v>
                </c:pt>
                <c:pt idx="160">
                  <c:v>1.2580629141813486E-3</c:v>
                </c:pt>
                <c:pt idx="161">
                  <c:v>2.0918831739137377E-3</c:v>
                </c:pt>
                <c:pt idx="162">
                  <c:v>1.8552976048811095E-3</c:v>
                </c:pt>
                <c:pt idx="163">
                  <c:v>1.9715212669732273E-3</c:v>
                </c:pt>
                <c:pt idx="164">
                  <c:v>1.6695030266474225E-3</c:v>
                </c:pt>
                <c:pt idx="165">
                  <c:v>1.5189300699677362E-3</c:v>
                </c:pt>
                <c:pt idx="166">
                  <c:v>1.6564383859229892E-3</c:v>
                </c:pt>
                <c:pt idx="167">
                  <c:v>1.6691212567501227E-3</c:v>
                </c:pt>
                <c:pt idx="168">
                  <c:v>9.9260455071009408E-4</c:v>
                </c:pt>
                <c:pt idx="169">
                  <c:v>1.4328351752925146E-3</c:v>
                </c:pt>
                <c:pt idx="170">
                  <c:v>1.9077901430842607E-3</c:v>
                </c:pt>
                <c:pt idx="171">
                  <c:v>2.2767223669441089E-3</c:v>
                </c:pt>
                <c:pt idx="172">
                  <c:v>2.4733343638893182E-3</c:v>
                </c:pt>
                <c:pt idx="173">
                  <c:v>1.6614391684283956E-3</c:v>
                </c:pt>
                <c:pt idx="174">
                  <c:v>1.5146237716770633E-3</c:v>
                </c:pt>
                <c:pt idx="175">
                  <c:v>2.421919990527602E-3</c:v>
                </c:pt>
                <c:pt idx="176">
                  <c:v>2.0390770823421151E-3</c:v>
                </c:pt>
                <c:pt idx="177">
                  <c:v>2.230822000303727E-3</c:v>
                </c:pt>
                <c:pt idx="178">
                  <c:v>2.1184631803628602E-3</c:v>
                </c:pt>
                <c:pt idx="179">
                  <c:v>1.8539532356278668E-3</c:v>
                </c:pt>
                <c:pt idx="180">
                  <c:v>2.0440243415284528E-3</c:v>
                </c:pt>
                <c:pt idx="181">
                  <c:v>2.1834175185303198E-3</c:v>
                </c:pt>
                <c:pt idx="182">
                  <c:v>2.0161078617706046E-3</c:v>
                </c:pt>
                <c:pt idx="183">
                  <c:v>2.1054807786470516E-3</c:v>
                </c:pt>
                <c:pt idx="184">
                  <c:v>1.9592030850986838E-3</c:v>
                </c:pt>
                <c:pt idx="185">
                  <c:v>1.9470283023792373E-3</c:v>
                </c:pt>
                <c:pt idx="186">
                  <c:v>2.5788130151753229E-3</c:v>
                </c:pt>
                <c:pt idx="187">
                  <c:v>2.6525339096341934E-3</c:v>
                </c:pt>
                <c:pt idx="188">
                  <c:v>2.4039609634948179E-3</c:v>
                </c:pt>
                <c:pt idx="189">
                  <c:v>1.2806197776378387E-3</c:v>
                </c:pt>
                <c:pt idx="190">
                  <c:v>1.9752493615906759E-3</c:v>
                </c:pt>
                <c:pt idx="191">
                  <c:v>2.9586472154577935E-3</c:v>
                </c:pt>
                <c:pt idx="192">
                  <c:v>1.5320302533260433E-3</c:v>
                </c:pt>
                <c:pt idx="193">
                  <c:v>2.0289369179812369E-3</c:v>
                </c:pt>
                <c:pt idx="194">
                  <c:v>2.2231145718758548E-3</c:v>
                </c:pt>
                <c:pt idx="195">
                  <c:v>1.7410675030043673E-3</c:v>
                </c:pt>
                <c:pt idx="196">
                  <c:v>2.1649847453649377E-3</c:v>
                </c:pt>
                <c:pt idx="197">
                  <c:v>1.5542816618403167E-3</c:v>
                </c:pt>
                <c:pt idx="198">
                  <c:v>2.3485902512694278E-3</c:v>
                </c:pt>
                <c:pt idx="199">
                  <c:v>1.5501267739338371E-3</c:v>
                </c:pt>
                <c:pt idx="200">
                  <c:v>1.2435261482119187E-3</c:v>
                </c:pt>
                <c:pt idx="201">
                  <c:v>1.4199943475953153E-3</c:v>
                </c:pt>
                <c:pt idx="202">
                  <c:v>1.3678000525014162E-3</c:v>
                </c:pt>
                <c:pt idx="203">
                  <c:v>1.4734540615048244E-3</c:v>
                </c:pt>
                <c:pt idx="204">
                  <c:v>1.7829872632344828E-3</c:v>
                </c:pt>
                <c:pt idx="205">
                  <c:v>1.4077482463478988E-3</c:v>
                </c:pt>
                <c:pt idx="206">
                  <c:v>1.9563333195757151E-3</c:v>
                </c:pt>
                <c:pt idx="207">
                  <c:v>1.9064641048555258E-3</c:v>
                </c:pt>
                <c:pt idx="208">
                  <c:v>1.3903518011375605E-3</c:v>
                </c:pt>
                <c:pt idx="209">
                  <c:v>2.4282317903767565E-3</c:v>
                </c:pt>
                <c:pt idx="210">
                  <c:v>2.4804506852770538E-3</c:v>
                </c:pt>
                <c:pt idx="211">
                  <c:v>2.3126577774765771E-3</c:v>
                </c:pt>
                <c:pt idx="212">
                  <c:v>1.6834862805017521E-3</c:v>
                </c:pt>
                <c:pt idx="213">
                  <c:v>1.5221956296479692E-3</c:v>
                </c:pt>
                <c:pt idx="214">
                  <c:v>2.4003657700220984E-3</c:v>
                </c:pt>
                <c:pt idx="215">
                  <c:v>2.2989382911543341E-3</c:v>
                </c:pt>
                <c:pt idx="216">
                  <c:v>1.4322543683758235E-3</c:v>
                </c:pt>
                <c:pt idx="217">
                  <c:v>2.1663996453150348E-3</c:v>
                </c:pt>
                <c:pt idx="218">
                  <c:v>2.9234047371509155E-3</c:v>
                </c:pt>
                <c:pt idx="219">
                  <c:v>2.3544542748384556E-3</c:v>
                </c:pt>
                <c:pt idx="220">
                  <c:v>1.581159239379187E-3</c:v>
                </c:pt>
                <c:pt idx="221">
                  <c:v>1.2422489926300186E-3</c:v>
                </c:pt>
                <c:pt idx="222">
                  <c:v>1.6714524493207045E-3</c:v>
                </c:pt>
                <c:pt idx="223">
                  <c:v>2.2153832722193122E-3</c:v>
                </c:pt>
                <c:pt idx="224">
                  <c:v>1.6916538030492059E-3</c:v>
                </c:pt>
                <c:pt idx="225">
                  <c:v>1.1591148577449948E-3</c:v>
                </c:pt>
                <c:pt idx="226">
                  <c:v>1.7069327731092437E-3</c:v>
                </c:pt>
                <c:pt idx="227">
                  <c:v>1.2661906343407507E-3</c:v>
                </c:pt>
                <c:pt idx="228">
                  <c:v>8.2615366458161222E-4</c:v>
                </c:pt>
                <c:pt idx="229">
                  <c:v>1.4590020426028597E-3</c:v>
                </c:pt>
                <c:pt idx="230">
                  <c:v>1.7635218732110871E-3</c:v>
                </c:pt>
                <c:pt idx="231">
                  <c:v>2.2944166148670883E-3</c:v>
                </c:pt>
                <c:pt idx="232">
                  <c:v>2.4372055801094926E-3</c:v>
                </c:pt>
                <c:pt idx="233">
                  <c:v>2.0262595974739903E-3</c:v>
                </c:pt>
                <c:pt idx="234">
                  <c:v>2.4120835595588825E-3</c:v>
                </c:pt>
                <c:pt idx="235">
                  <c:v>2.189530701792953E-3</c:v>
                </c:pt>
                <c:pt idx="236">
                  <c:v>1.5614880271131103E-3</c:v>
                </c:pt>
                <c:pt idx="237">
                  <c:v>1.7399103139013453E-3</c:v>
                </c:pt>
                <c:pt idx="238">
                  <c:v>1.6267109219671701E-3</c:v>
                </c:pt>
                <c:pt idx="239">
                  <c:v>1.3221755947737108E-3</c:v>
                </c:pt>
                <c:pt idx="240">
                  <c:v>1.6070350610999625E-3</c:v>
                </c:pt>
                <c:pt idx="241">
                  <c:v>2.1267197801298934E-3</c:v>
                </c:pt>
                <c:pt idx="242">
                  <c:v>1.3778195798887843E-3</c:v>
                </c:pt>
                <c:pt idx="243">
                  <c:v>2.1282443947068757E-3</c:v>
                </c:pt>
                <c:pt idx="244">
                  <c:v>1.785561237608205E-3</c:v>
                </c:pt>
                <c:pt idx="245">
                  <c:v>1.7594630580690742E-3</c:v>
                </c:pt>
                <c:pt idx="246">
                  <c:v>2.5220084112023153E-3</c:v>
                </c:pt>
                <c:pt idx="247">
                  <c:v>1.9794877245190774E-3</c:v>
                </c:pt>
                <c:pt idx="248">
                  <c:v>1.681066499863169E-3</c:v>
                </c:pt>
                <c:pt idx="249">
                  <c:v>1.1814216653575238E-3</c:v>
                </c:pt>
                <c:pt idx="250">
                  <c:v>1.7780847852227083E-3</c:v>
                </c:pt>
                <c:pt idx="251">
                  <c:v>1.6041803051481214E-3</c:v>
                </c:pt>
                <c:pt idx="252">
                  <c:v>1.9862413729614522E-3</c:v>
                </c:pt>
                <c:pt idx="253">
                  <c:v>1.6913182586962845E-3</c:v>
                </c:pt>
                <c:pt idx="254">
                  <c:v>1.1706062421341305E-3</c:v>
                </c:pt>
                <c:pt idx="255">
                  <c:v>1.1934954497985976E-3</c:v>
                </c:pt>
                <c:pt idx="256">
                  <c:v>1.2641544958175313E-3</c:v>
                </c:pt>
                <c:pt idx="257">
                  <c:v>9.3637546478520526E-4</c:v>
                </c:pt>
                <c:pt idx="258">
                  <c:v>2.0022197310667535E-3</c:v>
                </c:pt>
                <c:pt idx="259">
                  <c:v>1.7372374707109268E-3</c:v>
                </c:pt>
                <c:pt idx="260">
                  <c:v>1.8245360199581899E-3</c:v>
                </c:pt>
                <c:pt idx="261">
                  <c:v>1.8078093031815279E-3</c:v>
                </c:pt>
                <c:pt idx="262">
                  <c:v>2.3798730734360834E-3</c:v>
                </c:pt>
                <c:pt idx="263">
                  <c:v>2.0776557567253988E-3</c:v>
                </c:pt>
                <c:pt idx="264">
                  <c:v>1.7275085427734364E-3</c:v>
                </c:pt>
                <c:pt idx="265">
                  <c:v>2.0446785085516269E-3</c:v>
                </c:pt>
                <c:pt idx="266">
                  <c:v>2.3901405423111177E-3</c:v>
                </c:pt>
                <c:pt idx="267">
                  <c:v>2.1620266649955348E-3</c:v>
                </c:pt>
                <c:pt idx="268">
                  <c:v>1.1067961165048543E-3</c:v>
                </c:pt>
                <c:pt idx="269">
                  <c:v>1.1977923765122129E-3</c:v>
                </c:pt>
                <c:pt idx="270">
                  <c:v>2.0004220670734926E-3</c:v>
                </c:pt>
                <c:pt idx="271">
                  <c:v>1.7110784632843909E-3</c:v>
                </c:pt>
                <c:pt idx="272">
                  <c:v>1.7592244369228197E-3</c:v>
                </c:pt>
                <c:pt idx="273">
                  <c:v>2.634095668376012E-3</c:v>
                </c:pt>
                <c:pt idx="274">
                  <c:v>1.3547123438201211E-3</c:v>
                </c:pt>
                <c:pt idx="275">
                  <c:v>1.8687655204343617E-3</c:v>
                </c:pt>
                <c:pt idx="276">
                  <c:v>2.0439834967258411E-3</c:v>
                </c:pt>
                <c:pt idx="277">
                  <c:v>2.3003393736516519E-3</c:v>
                </c:pt>
                <c:pt idx="278">
                  <c:v>1.6866243875470232E-3</c:v>
                </c:pt>
                <c:pt idx="279">
                  <c:v>1.274164327380597E-3</c:v>
                </c:pt>
                <c:pt idx="280">
                  <c:v>2.0562135352490971E-3</c:v>
                </c:pt>
                <c:pt idx="281">
                  <c:v>2.3255542635809649E-3</c:v>
                </c:pt>
                <c:pt idx="282">
                  <c:v>1.8112829858906658E-3</c:v>
                </c:pt>
                <c:pt idx="283">
                  <c:v>1.6007849009837081E-3</c:v>
                </c:pt>
                <c:pt idx="284">
                  <c:v>1.8003913894324853E-3</c:v>
                </c:pt>
                <c:pt idx="285">
                  <c:v>1.5559508264703563E-3</c:v>
                </c:pt>
                <c:pt idx="286">
                  <c:v>2.0941935618308044E-3</c:v>
                </c:pt>
                <c:pt idx="287">
                  <c:v>1.5143988629934733E-3</c:v>
                </c:pt>
                <c:pt idx="288">
                  <c:v>8.9653008375659897E-4</c:v>
                </c:pt>
                <c:pt idx="289">
                  <c:v>1.7110705212991539E-3</c:v>
                </c:pt>
                <c:pt idx="290">
                  <c:v>2.1755383040013604E-3</c:v>
                </c:pt>
                <c:pt idx="291">
                  <c:v>1.4808390010683195E-3</c:v>
                </c:pt>
                <c:pt idx="292">
                  <c:v>1.7208117633111435E-3</c:v>
                </c:pt>
                <c:pt idx="293">
                  <c:v>2.4641933199404547E-3</c:v>
                </c:pt>
                <c:pt idx="294">
                  <c:v>1.7915681939467867E-3</c:v>
                </c:pt>
                <c:pt idx="295">
                  <c:v>1.6329376998018381E-3</c:v>
                </c:pt>
                <c:pt idx="296">
                  <c:v>1.7113836519469159E-3</c:v>
                </c:pt>
                <c:pt idx="297">
                  <c:v>2.8814979546667894E-3</c:v>
                </c:pt>
                <c:pt idx="298">
                  <c:v>2.5669233590025669E-3</c:v>
                </c:pt>
                <c:pt idx="299">
                  <c:v>1.5825441451225131E-3</c:v>
                </c:pt>
                <c:pt idx="300">
                  <c:v>1.1423117534109654E-3</c:v>
                </c:pt>
                <c:pt idx="301">
                  <c:v>1.3693732074524334E-3</c:v>
                </c:pt>
                <c:pt idx="302">
                  <c:v>1.2714751776829458E-3</c:v>
                </c:pt>
                <c:pt idx="303">
                  <c:v>1.9365351764529918E-3</c:v>
                </c:pt>
                <c:pt idx="304">
                  <c:v>2.1970787903723512E-3</c:v>
                </c:pt>
                <c:pt idx="305">
                  <c:v>1.8348472880463402E-3</c:v>
                </c:pt>
                <c:pt idx="306">
                  <c:v>1.3623672924294504E-3</c:v>
                </c:pt>
                <c:pt idx="307">
                  <c:v>1.9873921997104341E-3</c:v>
                </c:pt>
                <c:pt idx="308">
                  <c:v>1.6554057093503432E-3</c:v>
                </c:pt>
                <c:pt idx="309">
                  <c:v>1.4461609158118098E-3</c:v>
                </c:pt>
                <c:pt idx="310">
                  <c:v>1.851776759525837E-3</c:v>
                </c:pt>
                <c:pt idx="311">
                  <c:v>1.613383176179583E-3</c:v>
                </c:pt>
                <c:pt idx="312">
                  <c:v>1.2320788530465949E-3</c:v>
                </c:pt>
                <c:pt idx="313">
                  <c:v>1.7376316689226216E-3</c:v>
                </c:pt>
                <c:pt idx="314">
                  <c:v>2.6870481221255723E-3</c:v>
                </c:pt>
                <c:pt idx="315">
                  <c:v>1.5995666349819602E-3</c:v>
                </c:pt>
                <c:pt idx="316">
                  <c:v>1.8375521327992732E-3</c:v>
                </c:pt>
                <c:pt idx="317">
                  <c:v>7.5659428926776184E-4</c:v>
                </c:pt>
                <c:pt idx="318">
                  <c:v>2.7121427662699653E-3</c:v>
                </c:pt>
                <c:pt idx="319">
                  <c:v>1.5204280366929966E-3</c:v>
                </c:pt>
                <c:pt idx="320">
                  <c:v>1.1543805165086629E-3</c:v>
                </c:pt>
                <c:pt idx="321">
                  <c:v>1.6907147207695376E-3</c:v>
                </c:pt>
                <c:pt idx="322">
                  <c:v>1.2827804872145511E-3</c:v>
                </c:pt>
                <c:pt idx="323">
                  <c:v>1.3012099911464063E-3</c:v>
                </c:pt>
                <c:pt idx="324">
                  <c:v>1.1493938315864372E-3</c:v>
                </c:pt>
                <c:pt idx="325">
                  <c:v>1.6245938515371157E-3</c:v>
                </c:pt>
                <c:pt idx="326">
                  <c:v>9.0903188104668529E-4</c:v>
                </c:pt>
                <c:pt idx="327">
                  <c:v>1.4752308736317233E-3</c:v>
                </c:pt>
                <c:pt idx="328">
                  <c:v>1.7480963527006608E-3</c:v>
                </c:pt>
                <c:pt idx="329">
                  <c:v>1.3260145553225606E-3</c:v>
                </c:pt>
                <c:pt idx="330">
                  <c:v>1.8872149185938649E-3</c:v>
                </c:pt>
                <c:pt idx="331">
                  <c:v>2.4813895781637717E-3</c:v>
                </c:pt>
                <c:pt idx="332">
                  <c:v>1.0313216195569138E-3</c:v>
                </c:pt>
                <c:pt idx="333">
                  <c:v>1.3753056234718827E-3</c:v>
                </c:pt>
                <c:pt idx="334">
                  <c:v>1.5618577887381833E-3</c:v>
                </c:pt>
                <c:pt idx="335">
                  <c:v>1.9028170975077738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54B-4801-8906-8FA15F3F33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6388184"/>
        <c:axId val="526385888"/>
      </c:scatterChart>
      <c:valAx>
        <c:axId val="526388184"/>
        <c:scaling>
          <c:orientation val="minMax"/>
          <c:max val="1400"/>
          <c:min val="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26385888"/>
        <c:crosses val="autoZero"/>
        <c:crossBetween val="midCat"/>
        <c:majorUnit val="500"/>
      </c:valAx>
      <c:valAx>
        <c:axId val="526385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U-C mutation rate</a:t>
                </a:r>
                <a:endParaRPr lang="en-US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0.264954068241469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638818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1"/>
          <c:order val="1"/>
          <c:tx>
            <c:strRef>
              <c:f>controls!$J$1</c:f>
              <c:strCache>
                <c:ptCount val="1"/>
                <c:pt idx="0">
                  <c:v>ave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controls!$F$2:$F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J$2:$J$345</c:f>
              <c:numCache>
                <c:formatCode>General</c:formatCode>
                <c:ptCount val="344"/>
                <c:pt idx="0" formatCode="0.00">
                  <c:v>0.78712653126966303</c:v>
                </c:pt>
                <c:pt idx="1">
                  <c:v>0.79</c:v>
                </c:pt>
                <c:pt idx="2">
                  <c:v>0.79</c:v>
                </c:pt>
                <c:pt idx="3">
                  <c:v>0.79</c:v>
                </c:pt>
                <c:pt idx="4">
                  <c:v>0.79</c:v>
                </c:pt>
                <c:pt idx="5">
                  <c:v>0.79</c:v>
                </c:pt>
                <c:pt idx="6">
                  <c:v>0.79</c:v>
                </c:pt>
                <c:pt idx="7">
                  <c:v>0.79</c:v>
                </c:pt>
                <c:pt idx="8">
                  <c:v>0.79</c:v>
                </c:pt>
                <c:pt idx="9">
                  <c:v>0.79</c:v>
                </c:pt>
                <c:pt idx="10">
                  <c:v>0.79</c:v>
                </c:pt>
                <c:pt idx="11">
                  <c:v>0.79</c:v>
                </c:pt>
                <c:pt idx="12">
                  <c:v>0.79</c:v>
                </c:pt>
                <c:pt idx="13">
                  <c:v>0.79</c:v>
                </c:pt>
                <c:pt idx="14">
                  <c:v>0.79</c:v>
                </c:pt>
                <c:pt idx="15">
                  <c:v>0.79</c:v>
                </c:pt>
                <c:pt idx="16">
                  <c:v>0.79</c:v>
                </c:pt>
                <c:pt idx="17">
                  <c:v>0.79</c:v>
                </c:pt>
                <c:pt idx="18">
                  <c:v>0.79</c:v>
                </c:pt>
                <c:pt idx="19">
                  <c:v>0.79</c:v>
                </c:pt>
                <c:pt idx="20">
                  <c:v>0.79</c:v>
                </c:pt>
                <c:pt idx="21">
                  <c:v>0.79</c:v>
                </c:pt>
                <c:pt idx="22">
                  <c:v>0.79</c:v>
                </c:pt>
                <c:pt idx="23">
                  <c:v>0.79</c:v>
                </c:pt>
                <c:pt idx="24">
                  <c:v>0.79</c:v>
                </c:pt>
                <c:pt idx="25">
                  <c:v>0.79</c:v>
                </c:pt>
                <c:pt idx="26">
                  <c:v>0.79</c:v>
                </c:pt>
                <c:pt idx="27">
                  <c:v>0.79</c:v>
                </c:pt>
                <c:pt idx="28">
                  <c:v>0.79</c:v>
                </c:pt>
                <c:pt idx="29">
                  <c:v>0.79</c:v>
                </c:pt>
                <c:pt idx="30">
                  <c:v>0.79</c:v>
                </c:pt>
                <c:pt idx="31">
                  <c:v>0.79</c:v>
                </c:pt>
                <c:pt idx="32">
                  <c:v>0.79</c:v>
                </c:pt>
                <c:pt idx="33">
                  <c:v>0.79</c:v>
                </c:pt>
                <c:pt idx="34">
                  <c:v>0.79</c:v>
                </c:pt>
                <c:pt idx="35">
                  <c:v>0.79</c:v>
                </c:pt>
                <c:pt idx="36">
                  <c:v>0.79</c:v>
                </c:pt>
                <c:pt idx="37">
                  <c:v>0.79</c:v>
                </c:pt>
                <c:pt idx="38">
                  <c:v>0.79</c:v>
                </c:pt>
                <c:pt idx="39">
                  <c:v>0.79</c:v>
                </c:pt>
                <c:pt idx="40">
                  <c:v>0.79</c:v>
                </c:pt>
                <c:pt idx="41">
                  <c:v>0.79</c:v>
                </c:pt>
                <c:pt idx="42">
                  <c:v>0.79</c:v>
                </c:pt>
                <c:pt idx="43">
                  <c:v>0.79</c:v>
                </c:pt>
                <c:pt idx="44">
                  <c:v>0.79</c:v>
                </c:pt>
                <c:pt idx="45">
                  <c:v>0.79</c:v>
                </c:pt>
                <c:pt idx="46">
                  <c:v>0.79</c:v>
                </c:pt>
                <c:pt idx="47">
                  <c:v>0.79</c:v>
                </c:pt>
                <c:pt idx="48">
                  <c:v>0.79</c:v>
                </c:pt>
                <c:pt idx="49">
                  <c:v>0.79</c:v>
                </c:pt>
                <c:pt idx="50">
                  <c:v>0.79</c:v>
                </c:pt>
                <c:pt idx="51">
                  <c:v>0.79</c:v>
                </c:pt>
                <c:pt idx="52">
                  <c:v>0.79</c:v>
                </c:pt>
                <c:pt idx="53">
                  <c:v>0.79</c:v>
                </c:pt>
                <c:pt idx="54">
                  <c:v>0.79</c:v>
                </c:pt>
                <c:pt idx="55">
                  <c:v>0.79</c:v>
                </c:pt>
                <c:pt idx="56">
                  <c:v>0.79</c:v>
                </c:pt>
                <c:pt idx="57">
                  <c:v>0.79</c:v>
                </c:pt>
                <c:pt idx="58">
                  <c:v>0.79</c:v>
                </c:pt>
                <c:pt idx="59">
                  <c:v>0.79</c:v>
                </c:pt>
                <c:pt idx="60">
                  <c:v>0.79</c:v>
                </c:pt>
                <c:pt idx="61">
                  <c:v>0.79</c:v>
                </c:pt>
                <c:pt idx="62">
                  <c:v>0.79</c:v>
                </c:pt>
                <c:pt idx="63">
                  <c:v>0.79</c:v>
                </c:pt>
                <c:pt idx="64">
                  <c:v>0.79</c:v>
                </c:pt>
                <c:pt idx="65">
                  <c:v>0.79</c:v>
                </c:pt>
                <c:pt idx="66">
                  <c:v>0.79</c:v>
                </c:pt>
                <c:pt idx="67">
                  <c:v>0.79</c:v>
                </c:pt>
                <c:pt idx="68">
                  <c:v>0.79</c:v>
                </c:pt>
                <c:pt idx="69">
                  <c:v>0.79</c:v>
                </c:pt>
                <c:pt idx="70">
                  <c:v>0.79</c:v>
                </c:pt>
                <c:pt idx="71">
                  <c:v>0.79</c:v>
                </c:pt>
                <c:pt idx="72">
                  <c:v>0.79</c:v>
                </c:pt>
                <c:pt idx="73">
                  <c:v>0.79</c:v>
                </c:pt>
                <c:pt idx="74">
                  <c:v>0.79</c:v>
                </c:pt>
                <c:pt idx="75">
                  <c:v>0.79</c:v>
                </c:pt>
                <c:pt idx="76">
                  <c:v>0.79</c:v>
                </c:pt>
                <c:pt idx="77">
                  <c:v>0.79</c:v>
                </c:pt>
                <c:pt idx="78">
                  <c:v>0.79</c:v>
                </c:pt>
                <c:pt idx="79">
                  <c:v>0.79</c:v>
                </c:pt>
                <c:pt idx="80">
                  <c:v>0.79</c:v>
                </c:pt>
                <c:pt idx="81">
                  <c:v>0.79</c:v>
                </c:pt>
                <c:pt idx="82">
                  <c:v>0.79</c:v>
                </c:pt>
                <c:pt idx="83">
                  <c:v>0.79</c:v>
                </c:pt>
                <c:pt idx="84">
                  <c:v>0.79</c:v>
                </c:pt>
                <c:pt idx="85">
                  <c:v>0.79</c:v>
                </c:pt>
                <c:pt idx="86">
                  <c:v>0.79</c:v>
                </c:pt>
                <c:pt idx="87">
                  <c:v>0.79</c:v>
                </c:pt>
                <c:pt idx="88">
                  <c:v>0.79</c:v>
                </c:pt>
                <c:pt idx="89">
                  <c:v>0.79</c:v>
                </c:pt>
                <c:pt idx="90">
                  <c:v>0.79</c:v>
                </c:pt>
                <c:pt idx="91">
                  <c:v>0.79</c:v>
                </c:pt>
                <c:pt idx="92">
                  <c:v>0.79</c:v>
                </c:pt>
                <c:pt idx="93">
                  <c:v>0.79</c:v>
                </c:pt>
                <c:pt idx="94">
                  <c:v>0.79</c:v>
                </c:pt>
                <c:pt idx="95">
                  <c:v>0.79</c:v>
                </c:pt>
                <c:pt idx="96">
                  <c:v>0.79</c:v>
                </c:pt>
                <c:pt idx="97">
                  <c:v>0.79</c:v>
                </c:pt>
                <c:pt idx="98">
                  <c:v>0.79</c:v>
                </c:pt>
                <c:pt idx="99">
                  <c:v>0.79</c:v>
                </c:pt>
                <c:pt idx="100">
                  <c:v>0.79</c:v>
                </c:pt>
                <c:pt idx="101">
                  <c:v>0.79</c:v>
                </c:pt>
                <c:pt idx="102">
                  <c:v>0.79</c:v>
                </c:pt>
                <c:pt idx="103">
                  <c:v>0.79</c:v>
                </c:pt>
                <c:pt idx="104">
                  <c:v>0.79</c:v>
                </c:pt>
                <c:pt idx="105">
                  <c:v>0.79</c:v>
                </c:pt>
                <c:pt idx="106">
                  <c:v>0.79</c:v>
                </c:pt>
                <c:pt idx="107">
                  <c:v>0.79</c:v>
                </c:pt>
                <c:pt idx="108">
                  <c:v>0.79</c:v>
                </c:pt>
                <c:pt idx="109">
                  <c:v>0.79</c:v>
                </c:pt>
                <c:pt idx="110">
                  <c:v>0.79</c:v>
                </c:pt>
                <c:pt idx="111">
                  <c:v>0.79</c:v>
                </c:pt>
                <c:pt idx="112">
                  <c:v>0.79</c:v>
                </c:pt>
                <c:pt idx="113">
                  <c:v>0.79</c:v>
                </c:pt>
                <c:pt idx="114">
                  <c:v>0.79</c:v>
                </c:pt>
                <c:pt idx="115">
                  <c:v>0.79</c:v>
                </c:pt>
                <c:pt idx="116">
                  <c:v>0.79</c:v>
                </c:pt>
                <c:pt idx="117">
                  <c:v>0.79</c:v>
                </c:pt>
                <c:pt idx="118">
                  <c:v>0.79</c:v>
                </c:pt>
                <c:pt idx="119">
                  <c:v>0.79</c:v>
                </c:pt>
                <c:pt idx="120">
                  <c:v>0.79</c:v>
                </c:pt>
                <c:pt idx="121">
                  <c:v>0.79</c:v>
                </c:pt>
                <c:pt idx="122">
                  <c:v>0.79</c:v>
                </c:pt>
                <c:pt idx="123">
                  <c:v>0.79</c:v>
                </c:pt>
                <c:pt idx="124">
                  <c:v>0.79</c:v>
                </c:pt>
                <c:pt idx="125">
                  <c:v>0.79</c:v>
                </c:pt>
                <c:pt idx="126">
                  <c:v>0.79</c:v>
                </c:pt>
                <c:pt idx="127">
                  <c:v>0.79</c:v>
                </c:pt>
                <c:pt idx="128">
                  <c:v>0.79</c:v>
                </c:pt>
                <c:pt idx="129">
                  <c:v>0.79</c:v>
                </c:pt>
                <c:pt idx="130">
                  <c:v>0.79</c:v>
                </c:pt>
                <c:pt idx="131">
                  <c:v>0.79</c:v>
                </c:pt>
                <c:pt idx="132">
                  <c:v>0.79</c:v>
                </c:pt>
                <c:pt idx="133">
                  <c:v>0.79</c:v>
                </c:pt>
                <c:pt idx="134">
                  <c:v>0.79</c:v>
                </c:pt>
                <c:pt idx="135">
                  <c:v>0.79</c:v>
                </c:pt>
                <c:pt idx="136">
                  <c:v>0.79</c:v>
                </c:pt>
                <c:pt idx="137">
                  <c:v>0.79</c:v>
                </c:pt>
                <c:pt idx="138">
                  <c:v>0.79</c:v>
                </c:pt>
                <c:pt idx="139">
                  <c:v>0.79</c:v>
                </c:pt>
                <c:pt idx="140">
                  <c:v>0.79</c:v>
                </c:pt>
                <c:pt idx="141">
                  <c:v>0.79</c:v>
                </c:pt>
                <c:pt idx="142">
                  <c:v>0.79</c:v>
                </c:pt>
                <c:pt idx="143">
                  <c:v>0.79</c:v>
                </c:pt>
                <c:pt idx="144">
                  <c:v>0.79</c:v>
                </c:pt>
                <c:pt idx="145">
                  <c:v>0.79</c:v>
                </c:pt>
                <c:pt idx="146">
                  <c:v>0.79</c:v>
                </c:pt>
                <c:pt idx="147">
                  <c:v>0.79</c:v>
                </c:pt>
                <c:pt idx="148">
                  <c:v>0.79</c:v>
                </c:pt>
                <c:pt idx="149">
                  <c:v>0.79</c:v>
                </c:pt>
                <c:pt idx="150">
                  <c:v>0.79</c:v>
                </c:pt>
                <c:pt idx="151">
                  <c:v>0.79</c:v>
                </c:pt>
                <c:pt idx="152">
                  <c:v>0.79</c:v>
                </c:pt>
                <c:pt idx="153">
                  <c:v>0.79</c:v>
                </c:pt>
                <c:pt idx="154">
                  <c:v>0.79</c:v>
                </c:pt>
                <c:pt idx="155">
                  <c:v>0.79</c:v>
                </c:pt>
                <c:pt idx="156">
                  <c:v>0.79</c:v>
                </c:pt>
                <c:pt idx="157">
                  <c:v>0.79</c:v>
                </c:pt>
                <c:pt idx="158">
                  <c:v>0.79</c:v>
                </c:pt>
                <c:pt idx="159">
                  <c:v>0.79</c:v>
                </c:pt>
                <c:pt idx="160">
                  <c:v>0.79</c:v>
                </c:pt>
                <c:pt idx="161">
                  <c:v>0.79</c:v>
                </c:pt>
                <c:pt idx="162">
                  <c:v>0.79</c:v>
                </c:pt>
                <c:pt idx="163">
                  <c:v>0.79</c:v>
                </c:pt>
                <c:pt idx="164">
                  <c:v>0.79</c:v>
                </c:pt>
                <c:pt idx="165">
                  <c:v>0.79</c:v>
                </c:pt>
                <c:pt idx="166">
                  <c:v>0.79</c:v>
                </c:pt>
                <c:pt idx="167">
                  <c:v>0.79</c:v>
                </c:pt>
                <c:pt idx="168">
                  <c:v>0.79</c:v>
                </c:pt>
                <c:pt idx="169">
                  <c:v>0.79</c:v>
                </c:pt>
                <c:pt idx="170">
                  <c:v>0.79</c:v>
                </c:pt>
                <c:pt idx="171">
                  <c:v>0.79</c:v>
                </c:pt>
                <c:pt idx="172">
                  <c:v>0.79</c:v>
                </c:pt>
                <c:pt idx="173">
                  <c:v>0.79</c:v>
                </c:pt>
                <c:pt idx="174">
                  <c:v>0.79</c:v>
                </c:pt>
                <c:pt idx="175">
                  <c:v>0.79</c:v>
                </c:pt>
                <c:pt idx="176">
                  <c:v>0.79</c:v>
                </c:pt>
                <c:pt idx="177">
                  <c:v>0.79</c:v>
                </c:pt>
                <c:pt idx="178">
                  <c:v>0.79</c:v>
                </c:pt>
                <c:pt idx="179">
                  <c:v>0.79</c:v>
                </c:pt>
                <c:pt idx="180">
                  <c:v>0.79</c:v>
                </c:pt>
                <c:pt idx="181">
                  <c:v>0.79</c:v>
                </c:pt>
                <c:pt idx="182">
                  <c:v>0.79</c:v>
                </c:pt>
                <c:pt idx="183">
                  <c:v>0.79</c:v>
                </c:pt>
                <c:pt idx="184">
                  <c:v>0.79</c:v>
                </c:pt>
                <c:pt idx="185">
                  <c:v>0.79</c:v>
                </c:pt>
                <c:pt idx="186">
                  <c:v>0.79</c:v>
                </c:pt>
                <c:pt idx="187">
                  <c:v>0.79</c:v>
                </c:pt>
                <c:pt idx="188">
                  <c:v>0.79</c:v>
                </c:pt>
                <c:pt idx="189">
                  <c:v>0.79</c:v>
                </c:pt>
                <c:pt idx="190">
                  <c:v>0.79</c:v>
                </c:pt>
                <c:pt idx="191">
                  <c:v>0.79</c:v>
                </c:pt>
                <c:pt idx="192">
                  <c:v>0.79</c:v>
                </c:pt>
                <c:pt idx="193">
                  <c:v>0.79</c:v>
                </c:pt>
                <c:pt idx="194">
                  <c:v>0.79</c:v>
                </c:pt>
                <c:pt idx="195">
                  <c:v>0.79</c:v>
                </c:pt>
                <c:pt idx="196">
                  <c:v>0.79</c:v>
                </c:pt>
                <c:pt idx="197">
                  <c:v>0.79</c:v>
                </c:pt>
                <c:pt idx="198">
                  <c:v>0.79</c:v>
                </c:pt>
                <c:pt idx="199">
                  <c:v>0.79</c:v>
                </c:pt>
                <c:pt idx="200">
                  <c:v>0.79</c:v>
                </c:pt>
                <c:pt idx="201">
                  <c:v>0.79</c:v>
                </c:pt>
                <c:pt idx="202">
                  <c:v>0.79</c:v>
                </c:pt>
                <c:pt idx="203">
                  <c:v>0.79</c:v>
                </c:pt>
                <c:pt idx="204">
                  <c:v>0.79</c:v>
                </c:pt>
                <c:pt idx="205">
                  <c:v>0.79</c:v>
                </c:pt>
                <c:pt idx="206">
                  <c:v>0.79</c:v>
                </c:pt>
                <c:pt idx="207">
                  <c:v>0.79</c:v>
                </c:pt>
                <c:pt idx="208">
                  <c:v>0.79</c:v>
                </c:pt>
                <c:pt idx="209">
                  <c:v>0.79</c:v>
                </c:pt>
                <c:pt idx="210">
                  <c:v>0.79</c:v>
                </c:pt>
                <c:pt idx="211">
                  <c:v>0.79</c:v>
                </c:pt>
                <c:pt idx="212">
                  <c:v>0.79</c:v>
                </c:pt>
                <c:pt idx="213">
                  <c:v>0.79</c:v>
                </c:pt>
                <c:pt idx="214">
                  <c:v>0.79</c:v>
                </c:pt>
                <c:pt idx="215">
                  <c:v>0.79</c:v>
                </c:pt>
                <c:pt idx="216">
                  <c:v>0.79</c:v>
                </c:pt>
                <c:pt idx="217">
                  <c:v>0.79</c:v>
                </c:pt>
                <c:pt idx="218">
                  <c:v>0.79</c:v>
                </c:pt>
                <c:pt idx="219">
                  <c:v>0.79</c:v>
                </c:pt>
                <c:pt idx="220">
                  <c:v>0.79</c:v>
                </c:pt>
                <c:pt idx="221">
                  <c:v>0.79</c:v>
                </c:pt>
                <c:pt idx="222">
                  <c:v>0.79</c:v>
                </c:pt>
                <c:pt idx="223">
                  <c:v>0.79</c:v>
                </c:pt>
                <c:pt idx="224">
                  <c:v>0.79</c:v>
                </c:pt>
                <c:pt idx="225">
                  <c:v>0.79</c:v>
                </c:pt>
                <c:pt idx="226">
                  <c:v>0.79</c:v>
                </c:pt>
                <c:pt idx="227">
                  <c:v>0.79</c:v>
                </c:pt>
                <c:pt idx="228">
                  <c:v>0.79</c:v>
                </c:pt>
                <c:pt idx="229">
                  <c:v>0.79</c:v>
                </c:pt>
                <c:pt idx="230">
                  <c:v>0.79</c:v>
                </c:pt>
                <c:pt idx="231">
                  <c:v>0.79</c:v>
                </c:pt>
                <c:pt idx="232">
                  <c:v>0.79</c:v>
                </c:pt>
                <c:pt idx="233">
                  <c:v>0.79</c:v>
                </c:pt>
                <c:pt idx="234">
                  <c:v>0.79</c:v>
                </c:pt>
                <c:pt idx="235">
                  <c:v>0.79</c:v>
                </c:pt>
                <c:pt idx="236">
                  <c:v>0.79</c:v>
                </c:pt>
                <c:pt idx="237">
                  <c:v>0.79</c:v>
                </c:pt>
                <c:pt idx="238">
                  <c:v>0.79</c:v>
                </c:pt>
                <c:pt idx="239">
                  <c:v>0.79</c:v>
                </c:pt>
                <c:pt idx="240">
                  <c:v>0.79</c:v>
                </c:pt>
                <c:pt idx="241">
                  <c:v>0.79</c:v>
                </c:pt>
                <c:pt idx="242">
                  <c:v>0.79</c:v>
                </c:pt>
                <c:pt idx="243">
                  <c:v>0.79</c:v>
                </c:pt>
                <c:pt idx="244">
                  <c:v>0.79</c:v>
                </c:pt>
                <c:pt idx="245">
                  <c:v>0.79</c:v>
                </c:pt>
                <c:pt idx="246">
                  <c:v>0.79</c:v>
                </c:pt>
                <c:pt idx="247">
                  <c:v>0.79</c:v>
                </c:pt>
                <c:pt idx="248">
                  <c:v>0.79</c:v>
                </c:pt>
                <c:pt idx="249">
                  <c:v>0.79</c:v>
                </c:pt>
                <c:pt idx="250">
                  <c:v>0.79</c:v>
                </c:pt>
                <c:pt idx="251">
                  <c:v>0.79</c:v>
                </c:pt>
                <c:pt idx="252">
                  <c:v>0.79</c:v>
                </c:pt>
                <c:pt idx="253">
                  <c:v>0.79</c:v>
                </c:pt>
                <c:pt idx="254">
                  <c:v>0.79</c:v>
                </c:pt>
                <c:pt idx="255">
                  <c:v>0.79</c:v>
                </c:pt>
                <c:pt idx="256">
                  <c:v>0.79</c:v>
                </c:pt>
                <c:pt idx="257">
                  <c:v>0.79</c:v>
                </c:pt>
                <c:pt idx="258">
                  <c:v>0.79</c:v>
                </c:pt>
                <c:pt idx="259">
                  <c:v>0.79</c:v>
                </c:pt>
                <c:pt idx="260">
                  <c:v>0.79</c:v>
                </c:pt>
                <c:pt idx="261">
                  <c:v>0.79</c:v>
                </c:pt>
                <c:pt idx="262">
                  <c:v>0.79</c:v>
                </c:pt>
                <c:pt idx="263">
                  <c:v>0.79</c:v>
                </c:pt>
                <c:pt idx="264">
                  <c:v>0.79</c:v>
                </c:pt>
                <c:pt idx="265">
                  <c:v>0.79</c:v>
                </c:pt>
                <c:pt idx="266">
                  <c:v>0.79</c:v>
                </c:pt>
                <c:pt idx="267">
                  <c:v>0.79</c:v>
                </c:pt>
                <c:pt idx="268">
                  <c:v>0.79</c:v>
                </c:pt>
                <c:pt idx="269">
                  <c:v>0.79</c:v>
                </c:pt>
                <c:pt idx="270">
                  <c:v>0.79</c:v>
                </c:pt>
                <c:pt idx="271">
                  <c:v>0.79</c:v>
                </c:pt>
                <c:pt idx="272">
                  <c:v>0.79</c:v>
                </c:pt>
                <c:pt idx="273">
                  <c:v>0.79</c:v>
                </c:pt>
                <c:pt idx="274">
                  <c:v>0.79</c:v>
                </c:pt>
                <c:pt idx="275">
                  <c:v>0.79</c:v>
                </c:pt>
                <c:pt idx="276">
                  <c:v>0.79</c:v>
                </c:pt>
                <c:pt idx="277">
                  <c:v>0.79</c:v>
                </c:pt>
                <c:pt idx="278">
                  <c:v>0.79</c:v>
                </c:pt>
                <c:pt idx="279">
                  <c:v>0.79</c:v>
                </c:pt>
                <c:pt idx="280">
                  <c:v>0.79</c:v>
                </c:pt>
                <c:pt idx="281">
                  <c:v>0.79</c:v>
                </c:pt>
                <c:pt idx="282">
                  <c:v>0.79</c:v>
                </c:pt>
                <c:pt idx="283">
                  <c:v>0.79</c:v>
                </c:pt>
                <c:pt idx="284">
                  <c:v>0.79</c:v>
                </c:pt>
                <c:pt idx="285">
                  <c:v>0.79</c:v>
                </c:pt>
                <c:pt idx="286">
                  <c:v>0.79</c:v>
                </c:pt>
                <c:pt idx="287">
                  <c:v>0.79</c:v>
                </c:pt>
                <c:pt idx="288">
                  <c:v>0.79</c:v>
                </c:pt>
                <c:pt idx="289">
                  <c:v>0.79</c:v>
                </c:pt>
                <c:pt idx="290">
                  <c:v>0.79</c:v>
                </c:pt>
                <c:pt idx="291">
                  <c:v>0.79</c:v>
                </c:pt>
                <c:pt idx="292">
                  <c:v>0.79</c:v>
                </c:pt>
                <c:pt idx="293">
                  <c:v>0.79</c:v>
                </c:pt>
                <c:pt idx="294">
                  <c:v>0.79</c:v>
                </c:pt>
                <c:pt idx="295">
                  <c:v>0.79</c:v>
                </c:pt>
                <c:pt idx="296">
                  <c:v>0.79</c:v>
                </c:pt>
                <c:pt idx="297">
                  <c:v>0.79</c:v>
                </c:pt>
                <c:pt idx="298">
                  <c:v>0.79</c:v>
                </c:pt>
                <c:pt idx="299">
                  <c:v>0.79</c:v>
                </c:pt>
                <c:pt idx="300">
                  <c:v>0.79</c:v>
                </c:pt>
                <c:pt idx="301">
                  <c:v>0.79</c:v>
                </c:pt>
                <c:pt idx="302">
                  <c:v>0.79</c:v>
                </c:pt>
                <c:pt idx="303">
                  <c:v>0.79</c:v>
                </c:pt>
                <c:pt idx="304">
                  <c:v>0.79</c:v>
                </c:pt>
                <c:pt idx="305">
                  <c:v>0.79</c:v>
                </c:pt>
                <c:pt idx="306">
                  <c:v>0.79</c:v>
                </c:pt>
                <c:pt idx="307">
                  <c:v>0.79</c:v>
                </c:pt>
                <c:pt idx="308">
                  <c:v>0.79</c:v>
                </c:pt>
                <c:pt idx="309">
                  <c:v>0.79</c:v>
                </c:pt>
                <c:pt idx="310">
                  <c:v>0.79</c:v>
                </c:pt>
                <c:pt idx="311">
                  <c:v>0.79</c:v>
                </c:pt>
                <c:pt idx="312">
                  <c:v>0.79</c:v>
                </c:pt>
                <c:pt idx="313">
                  <c:v>0.79</c:v>
                </c:pt>
                <c:pt idx="314">
                  <c:v>0.79</c:v>
                </c:pt>
                <c:pt idx="315">
                  <c:v>0.79</c:v>
                </c:pt>
                <c:pt idx="316">
                  <c:v>0.79</c:v>
                </c:pt>
                <c:pt idx="317">
                  <c:v>0.79</c:v>
                </c:pt>
                <c:pt idx="318">
                  <c:v>0.79</c:v>
                </c:pt>
                <c:pt idx="319">
                  <c:v>0.79</c:v>
                </c:pt>
                <c:pt idx="320">
                  <c:v>0.79</c:v>
                </c:pt>
                <c:pt idx="321">
                  <c:v>0.79</c:v>
                </c:pt>
                <c:pt idx="322">
                  <c:v>0.79</c:v>
                </c:pt>
                <c:pt idx="323">
                  <c:v>0.79</c:v>
                </c:pt>
                <c:pt idx="324">
                  <c:v>0.79</c:v>
                </c:pt>
                <c:pt idx="325">
                  <c:v>0.79</c:v>
                </c:pt>
                <c:pt idx="326">
                  <c:v>0.79</c:v>
                </c:pt>
                <c:pt idx="327">
                  <c:v>0.79</c:v>
                </c:pt>
                <c:pt idx="328">
                  <c:v>0.79</c:v>
                </c:pt>
                <c:pt idx="329">
                  <c:v>0.79</c:v>
                </c:pt>
                <c:pt idx="330">
                  <c:v>0.79</c:v>
                </c:pt>
                <c:pt idx="331">
                  <c:v>0.79</c:v>
                </c:pt>
                <c:pt idx="332">
                  <c:v>0.79</c:v>
                </c:pt>
                <c:pt idx="333">
                  <c:v>0.79</c:v>
                </c:pt>
                <c:pt idx="334">
                  <c:v>0.79</c:v>
                </c:pt>
                <c:pt idx="335">
                  <c:v>0.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41D-41F9-AC0C-506714ADA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6451424"/>
        <c:axId val="726449784"/>
      </c:scatterChart>
      <c:scatterChart>
        <c:scatterStyle val="lineMarker"/>
        <c:varyColors val="0"/>
        <c:ser>
          <c:idx val="0"/>
          <c:order val="0"/>
          <c:tx>
            <c:strRef>
              <c:f>controls!$I$1</c:f>
              <c:strCache>
                <c:ptCount val="1"/>
                <c:pt idx="0">
                  <c:v>4A/4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controls!$F$2:$F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I$2:$I$345</c:f>
              <c:numCache>
                <c:formatCode>0.00</c:formatCode>
                <c:ptCount val="344"/>
                <c:pt idx="0">
                  <c:v>0.85535521652026503</c:v>
                </c:pt>
                <c:pt idx="1">
                  <c:v>0.41932678267701867</c:v>
                </c:pt>
                <c:pt idx="2">
                  <c:v>0.91734199269840822</c:v>
                </c:pt>
                <c:pt idx="3">
                  <c:v>0.90285696759649736</c:v>
                </c:pt>
                <c:pt idx="4">
                  <c:v>0.49256572048563751</c:v>
                </c:pt>
                <c:pt idx="5">
                  <c:v>0.6548130251991845</c:v>
                </c:pt>
                <c:pt idx="6">
                  <c:v>0.69538021346364587</c:v>
                </c:pt>
                <c:pt idx="7">
                  <c:v>0.62652215765478469</c:v>
                </c:pt>
                <c:pt idx="8">
                  <c:v>0.86666656271234832</c:v>
                </c:pt>
                <c:pt idx="9">
                  <c:v>0.88236385365520709</c:v>
                </c:pt>
                <c:pt idx="10">
                  <c:v>0.79093911486439805</c:v>
                </c:pt>
                <c:pt idx="11">
                  <c:v>0.76513637658292222</c:v>
                </c:pt>
                <c:pt idx="12">
                  <c:v>0.80983822547986095</c:v>
                </c:pt>
                <c:pt idx="13">
                  <c:v>0.90891367839337722</c:v>
                </c:pt>
                <c:pt idx="14">
                  <c:v>0.9172542984135803</c:v>
                </c:pt>
                <c:pt idx="15">
                  <c:v>0.85139555433278191</c:v>
                </c:pt>
                <c:pt idx="16">
                  <c:v>0.70774996436800686</c:v>
                </c:pt>
                <c:pt idx="17">
                  <c:v>0.84969794824119582</c:v>
                </c:pt>
                <c:pt idx="18">
                  <c:v>0.86945954935406433</c:v>
                </c:pt>
                <c:pt idx="19">
                  <c:v>0.86430035000533567</c:v>
                </c:pt>
                <c:pt idx="20">
                  <c:v>0.69821268569785</c:v>
                </c:pt>
                <c:pt idx="21">
                  <c:v>0.76438987730170038</c:v>
                </c:pt>
                <c:pt idx="22">
                  <c:v>0.77823918021727234</c:v>
                </c:pt>
                <c:pt idx="23">
                  <c:v>0.76990606424652097</c:v>
                </c:pt>
                <c:pt idx="24">
                  <c:v>0.63156932538019939</c:v>
                </c:pt>
                <c:pt idx="25">
                  <c:v>0.71754131294271473</c:v>
                </c:pt>
                <c:pt idx="26">
                  <c:v>0.6920498203711416</c:v>
                </c:pt>
                <c:pt idx="27">
                  <c:v>0.77047858130194624</c:v>
                </c:pt>
                <c:pt idx="28">
                  <c:v>0.77739190044924245</c:v>
                </c:pt>
                <c:pt idx="29">
                  <c:v>0.798586182766029</c:v>
                </c:pt>
                <c:pt idx="30">
                  <c:v>0.7166344907682749</c:v>
                </c:pt>
                <c:pt idx="31">
                  <c:v>0.6788179485501703</c:v>
                </c:pt>
                <c:pt idx="32">
                  <c:v>0.89651964872944223</c:v>
                </c:pt>
                <c:pt idx="33">
                  <c:v>0.89579302627128155</c:v>
                </c:pt>
                <c:pt idx="34">
                  <c:v>0.81295942585131209</c:v>
                </c:pt>
                <c:pt idx="35">
                  <c:v>0.81551772147636226</c:v>
                </c:pt>
                <c:pt idx="36">
                  <c:v>0.83733133819001448</c:v>
                </c:pt>
                <c:pt idx="37">
                  <c:v>0.82344248223521144</c:v>
                </c:pt>
                <c:pt idx="38">
                  <c:v>0.77054477886285011</c:v>
                </c:pt>
                <c:pt idx="39">
                  <c:v>0.85997244909969695</c:v>
                </c:pt>
                <c:pt idx="40">
                  <c:v>0.7658377806995682</c:v>
                </c:pt>
                <c:pt idx="41">
                  <c:v>0.74042925083069255</c:v>
                </c:pt>
                <c:pt idx="42">
                  <c:v>0.89881067144570592</c:v>
                </c:pt>
                <c:pt idx="43">
                  <c:v>0.78875851812250641</c:v>
                </c:pt>
                <c:pt idx="44">
                  <c:v>0.72728129197741354</c:v>
                </c:pt>
                <c:pt idx="45">
                  <c:v>0.78581801876883295</c:v>
                </c:pt>
                <c:pt idx="46">
                  <c:v>0.82500411549010766</c:v>
                </c:pt>
                <c:pt idx="47">
                  <c:v>0.83529153403759282</c:v>
                </c:pt>
                <c:pt idx="48">
                  <c:v>0.7266753744790293</c:v>
                </c:pt>
                <c:pt idx="49">
                  <c:v>0.72885781350659506</c:v>
                </c:pt>
                <c:pt idx="50">
                  <c:v>0.73439224091834954</c:v>
                </c:pt>
                <c:pt idx="51">
                  <c:v>0.91401844833668677</c:v>
                </c:pt>
                <c:pt idx="52">
                  <c:v>0.75573154379174634</c:v>
                </c:pt>
                <c:pt idx="53">
                  <c:v>0.64040979586735092</c:v>
                </c:pt>
                <c:pt idx="54">
                  <c:v>0.62074274158671561</c:v>
                </c:pt>
                <c:pt idx="55">
                  <c:v>0.57530900417896313</c:v>
                </c:pt>
                <c:pt idx="56">
                  <c:v>0.83016183463730397</c:v>
                </c:pt>
                <c:pt idx="57">
                  <c:v>0.77173691795116917</c:v>
                </c:pt>
                <c:pt idx="58">
                  <c:v>0.78596956277425878</c:v>
                </c:pt>
                <c:pt idx="59">
                  <c:v>0.86082532578763893</c:v>
                </c:pt>
                <c:pt idx="60">
                  <c:v>0.81417283769176807</c:v>
                </c:pt>
                <c:pt idx="61">
                  <c:v>0.70886988324092426</c:v>
                </c:pt>
                <c:pt idx="62">
                  <c:v>0.79908236586656989</c:v>
                </c:pt>
                <c:pt idx="63">
                  <c:v>0.92977128332512438</c:v>
                </c:pt>
                <c:pt idx="64">
                  <c:v>0.90515743971460705</c:v>
                </c:pt>
                <c:pt idx="65">
                  <c:v>0.9174865834956456</c:v>
                </c:pt>
                <c:pt idx="66">
                  <c:v>0.68693106287893679</c:v>
                </c:pt>
                <c:pt idx="67">
                  <c:v>0.69896701245194881</c:v>
                </c:pt>
                <c:pt idx="68">
                  <c:v>0.82465525202887191</c:v>
                </c:pt>
                <c:pt idx="69">
                  <c:v>0.82327961413423645</c:v>
                </c:pt>
                <c:pt idx="70">
                  <c:v>0.5529397546965934</c:v>
                </c:pt>
                <c:pt idx="71">
                  <c:v>0.79212420259934424</c:v>
                </c:pt>
                <c:pt idx="72">
                  <c:v>0.58725858660603103</c:v>
                </c:pt>
                <c:pt idx="73">
                  <c:v>0.93037612874513698</c:v>
                </c:pt>
                <c:pt idx="74">
                  <c:v>0.94746970776906625</c:v>
                </c:pt>
                <c:pt idx="75">
                  <c:v>0.93252740158038538</c:v>
                </c:pt>
                <c:pt idx="76">
                  <c:v>0.97009741301745767</c:v>
                </c:pt>
                <c:pt idx="77">
                  <c:v>0.83869804327969</c:v>
                </c:pt>
                <c:pt idx="78">
                  <c:v>0.89601890737459355</c:v>
                </c:pt>
                <c:pt idx="79">
                  <c:v>0.81733932767957496</c:v>
                </c:pt>
                <c:pt idx="80">
                  <c:v>0.96615292276692888</c:v>
                </c:pt>
                <c:pt idx="81">
                  <c:v>0.80493686518738883</c:v>
                </c:pt>
                <c:pt idx="82">
                  <c:v>0.71182148891243113</c:v>
                </c:pt>
                <c:pt idx="83">
                  <c:v>0.89307342242827348</c:v>
                </c:pt>
                <c:pt idx="84">
                  <c:v>0.76454940941006322</c:v>
                </c:pt>
                <c:pt idx="85">
                  <c:v>0.6654581718146193</c:v>
                </c:pt>
                <c:pt idx="86">
                  <c:v>0.75760884786580562</c:v>
                </c:pt>
                <c:pt idx="87">
                  <c:v>0.8652438448362435</c:v>
                </c:pt>
                <c:pt idx="88">
                  <c:v>0.54848280982742192</c:v>
                </c:pt>
                <c:pt idx="89">
                  <c:v>0.73361666590556296</c:v>
                </c:pt>
                <c:pt idx="90">
                  <c:v>0.76167584293557367</c:v>
                </c:pt>
                <c:pt idx="91">
                  <c:v>1.0576861678532126</c:v>
                </c:pt>
                <c:pt idx="92">
                  <c:v>0.97813610688790664</c:v>
                </c:pt>
                <c:pt idx="93">
                  <c:v>0.86013243043411924</c:v>
                </c:pt>
                <c:pt idx="94">
                  <c:v>0.76824753478486529</c:v>
                </c:pt>
                <c:pt idx="95">
                  <c:v>0.7233893821283327</c:v>
                </c:pt>
                <c:pt idx="96">
                  <c:v>0.66842058246505254</c:v>
                </c:pt>
                <c:pt idx="97">
                  <c:v>0.65386834875551858</c:v>
                </c:pt>
                <c:pt idx="98">
                  <c:v>0.97920718305567023</c:v>
                </c:pt>
                <c:pt idx="99">
                  <c:v>0.98349342517389238</c:v>
                </c:pt>
                <c:pt idx="100">
                  <c:v>0.55490546136828023</c:v>
                </c:pt>
                <c:pt idx="101">
                  <c:v>0.58266721756422657</c:v>
                </c:pt>
                <c:pt idx="102">
                  <c:v>0.42093739213505477</c:v>
                </c:pt>
                <c:pt idx="103">
                  <c:v>0.92474337907712523</c:v>
                </c:pt>
                <c:pt idx="104">
                  <c:v>0.67583969287753243</c:v>
                </c:pt>
                <c:pt idx="105">
                  <c:v>0.97099992481275099</c:v>
                </c:pt>
                <c:pt idx="106">
                  <c:v>1.0069752730930552</c:v>
                </c:pt>
                <c:pt idx="107">
                  <c:v>0.68401410257175066</c:v>
                </c:pt>
                <c:pt idx="108">
                  <c:v>0.78255221758467741</c:v>
                </c:pt>
                <c:pt idx="109">
                  <c:v>0.76709684385780108</c:v>
                </c:pt>
                <c:pt idx="110">
                  <c:v>0.7363711324563208</c:v>
                </c:pt>
                <c:pt idx="111">
                  <c:v>0.82137612785721337</c:v>
                </c:pt>
                <c:pt idx="112">
                  <c:v>0.64653974634887634</c:v>
                </c:pt>
                <c:pt idx="113">
                  <c:v>0.81356222443432724</c:v>
                </c:pt>
                <c:pt idx="114">
                  <c:v>0.71549169255361111</c:v>
                </c:pt>
                <c:pt idx="115">
                  <c:v>0.84301187017045243</c:v>
                </c:pt>
                <c:pt idx="116">
                  <c:v>0.83259048765367849</c:v>
                </c:pt>
                <c:pt idx="117">
                  <c:v>0.84808702726139573</c:v>
                </c:pt>
                <c:pt idx="118">
                  <c:v>0.98743268949054364</c:v>
                </c:pt>
                <c:pt idx="119">
                  <c:v>0.98004121673064437</c:v>
                </c:pt>
                <c:pt idx="120">
                  <c:v>0.58526192318736892</c:v>
                </c:pt>
                <c:pt idx="121">
                  <c:v>0.8170301738479766</c:v>
                </c:pt>
                <c:pt idx="122">
                  <c:v>0.93521022294508371</c:v>
                </c:pt>
                <c:pt idx="123">
                  <c:v>0.95607118875499753</c:v>
                </c:pt>
                <c:pt idx="124">
                  <c:v>0.80996786438309232</c:v>
                </c:pt>
                <c:pt idx="125">
                  <c:v>0.69910906128486694</c:v>
                </c:pt>
                <c:pt idx="126">
                  <c:v>1.035653981553508</c:v>
                </c:pt>
                <c:pt idx="127">
                  <c:v>1.0266572840256785</c:v>
                </c:pt>
                <c:pt idx="128">
                  <c:v>0.5659116892784618</c:v>
                </c:pt>
                <c:pt idx="129">
                  <c:v>0.6614427296423675</c:v>
                </c:pt>
                <c:pt idx="130">
                  <c:v>0.68587228218245111</c:v>
                </c:pt>
                <c:pt idx="131">
                  <c:v>0.8194817634443573</c:v>
                </c:pt>
                <c:pt idx="132">
                  <c:v>0.82844247725926179</c:v>
                </c:pt>
                <c:pt idx="133">
                  <c:v>0.88469526325485626</c:v>
                </c:pt>
                <c:pt idx="134">
                  <c:v>0.89962819999700694</c:v>
                </c:pt>
                <c:pt idx="135">
                  <c:v>0.84457038086507208</c:v>
                </c:pt>
                <c:pt idx="136">
                  <c:v>0.67953387868498216</c:v>
                </c:pt>
                <c:pt idx="137">
                  <c:v>0.5255516513415498</c:v>
                </c:pt>
                <c:pt idx="138">
                  <c:v>1.1494596045332943</c:v>
                </c:pt>
                <c:pt idx="139">
                  <c:v>0.69708381803746633</c:v>
                </c:pt>
                <c:pt idx="140">
                  <c:v>0.79128230709571235</c:v>
                </c:pt>
                <c:pt idx="141">
                  <c:v>0.78039811490354472</c:v>
                </c:pt>
                <c:pt idx="142">
                  <c:v>0.62379787719202762</c:v>
                </c:pt>
                <c:pt idx="143">
                  <c:v>0.77161245315889504</c:v>
                </c:pt>
                <c:pt idx="144">
                  <c:v>0.76162709698495357</c:v>
                </c:pt>
                <c:pt idx="145">
                  <c:v>0.8771593985681313</c:v>
                </c:pt>
                <c:pt idx="146">
                  <c:v>0.70682026438114531</c:v>
                </c:pt>
                <c:pt idx="147">
                  <c:v>0.78939038971896303</c:v>
                </c:pt>
                <c:pt idx="148">
                  <c:v>0.85861190686753219</c:v>
                </c:pt>
                <c:pt idx="149">
                  <c:v>1.000721458128375</c:v>
                </c:pt>
                <c:pt idx="150">
                  <c:v>0.47697649421798005</c:v>
                </c:pt>
                <c:pt idx="151">
                  <c:v>0.73491904580094403</c:v>
                </c:pt>
                <c:pt idx="152">
                  <c:v>0.78456640477683892</c:v>
                </c:pt>
                <c:pt idx="153">
                  <c:v>0.77117661686116257</c:v>
                </c:pt>
                <c:pt idx="154">
                  <c:v>0.64390973757235725</c:v>
                </c:pt>
                <c:pt idx="155">
                  <c:v>0.7276781542998072</c:v>
                </c:pt>
                <c:pt idx="156">
                  <c:v>0.61395465308542407</c:v>
                </c:pt>
                <c:pt idx="157">
                  <c:v>0.89764987281568787</c:v>
                </c:pt>
                <c:pt idx="158">
                  <c:v>0.67596448248802743</c:v>
                </c:pt>
                <c:pt idx="159">
                  <c:v>0.87034340159820889</c:v>
                </c:pt>
                <c:pt idx="160">
                  <c:v>0.83500463070095199</c:v>
                </c:pt>
                <c:pt idx="161">
                  <c:v>0.98633862567845709</c:v>
                </c:pt>
                <c:pt idx="162">
                  <c:v>0.75034832157695341</c:v>
                </c:pt>
                <c:pt idx="163">
                  <c:v>0.60379075988379594</c:v>
                </c:pt>
                <c:pt idx="164">
                  <c:v>0.83931965594026858</c:v>
                </c:pt>
                <c:pt idx="165">
                  <c:v>0.84652610429696096</c:v>
                </c:pt>
                <c:pt idx="166">
                  <c:v>0.81005974886337184</c:v>
                </c:pt>
                <c:pt idx="167">
                  <c:v>0.74434102776741784</c:v>
                </c:pt>
                <c:pt idx="168">
                  <c:v>0.53479635527866243</c:v>
                </c:pt>
                <c:pt idx="169">
                  <c:v>0.82613658786636379</c:v>
                </c:pt>
                <c:pt idx="170">
                  <c:v>0.84108900299529321</c:v>
                </c:pt>
                <c:pt idx="171">
                  <c:v>0.8471197909011452</c:v>
                </c:pt>
                <c:pt idx="172">
                  <c:v>0.72900157414891398</c:v>
                </c:pt>
                <c:pt idx="173">
                  <c:v>0.78815367277361625</c:v>
                </c:pt>
                <c:pt idx="174">
                  <c:v>0.75194540300042922</c:v>
                </c:pt>
                <c:pt idx="175">
                  <c:v>0.82923705174837659</c:v>
                </c:pt>
                <c:pt idx="176">
                  <c:v>0.83934999457652604</c:v>
                </c:pt>
                <c:pt idx="177">
                  <c:v>0.6282218127022684</c:v>
                </c:pt>
                <c:pt idx="178">
                  <c:v>0.85269455578896292</c:v>
                </c:pt>
                <c:pt idx="179">
                  <c:v>0.72136376686058856</c:v>
                </c:pt>
                <c:pt idx="180">
                  <c:v>0.7982028470258058</c:v>
                </c:pt>
                <c:pt idx="181">
                  <c:v>0.75887613405184595</c:v>
                </c:pt>
                <c:pt idx="182">
                  <c:v>0.88925500945474656</c:v>
                </c:pt>
                <c:pt idx="183">
                  <c:v>0.90935407837741766</c:v>
                </c:pt>
                <c:pt idx="184">
                  <c:v>0.71488053578261435</c:v>
                </c:pt>
                <c:pt idx="185">
                  <c:v>0.88398037654952744</c:v>
                </c:pt>
                <c:pt idx="186">
                  <c:v>0.88384462152686571</c:v>
                </c:pt>
                <c:pt idx="187">
                  <c:v>0.69557555148726247</c:v>
                </c:pt>
                <c:pt idx="188">
                  <c:v>0.77292941815165617</c:v>
                </c:pt>
                <c:pt idx="189">
                  <c:v>1.0285209776569699</c:v>
                </c:pt>
                <c:pt idx="190">
                  <c:v>0.99502768661350705</c:v>
                </c:pt>
                <c:pt idx="191">
                  <c:v>0.81155361037200147</c:v>
                </c:pt>
                <c:pt idx="192">
                  <c:v>0.82930052879023741</c:v>
                </c:pt>
                <c:pt idx="193">
                  <c:v>0.92850611709842712</c:v>
                </c:pt>
                <c:pt idx="194">
                  <c:v>0.8032947073132044</c:v>
                </c:pt>
                <c:pt idx="195">
                  <c:v>0.59671567827968686</c:v>
                </c:pt>
                <c:pt idx="196">
                  <c:v>0.63145992908826509</c:v>
                </c:pt>
                <c:pt idx="197">
                  <c:v>0.65179026254721706</c:v>
                </c:pt>
                <c:pt idx="198">
                  <c:v>0.63996466270842789</c:v>
                </c:pt>
                <c:pt idx="199">
                  <c:v>0.83530820553124818</c:v>
                </c:pt>
                <c:pt idx="200">
                  <c:v>0.95066308467384386</c:v>
                </c:pt>
                <c:pt idx="201">
                  <c:v>0.78172748832381167</c:v>
                </c:pt>
                <c:pt idx="202">
                  <c:v>0.71543014969870555</c:v>
                </c:pt>
                <c:pt idx="203">
                  <c:v>0.80431076007921154</c:v>
                </c:pt>
                <c:pt idx="204">
                  <c:v>0.73948264286249232</c:v>
                </c:pt>
                <c:pt idx="205">
                  <c:v>0.66962257173984796</c:v>
                </c:pt>
                <c:pt idx="206">
                  <c:v>0.76645409453589264</c:v>
                </c:pt>
                <c:pt idx="207">
                  <c:v>0.84251897361763639</c:v>
                </c:pt>
                <c:pt idx="208">
                  <c:v>0.76092146859358401</c:v>
                </c:pt>
                <c:pt idx="209">
                  <c:v>0.93518892958785005</c:v>
                </c:pt>
                <c:pt idx="210">
                  <c:v>0.92564618054947723</c:v>
                </c:pt>
                <c:pt idx="211">
                  <c:v>0.82995468051330612</c:v>
                </c:pt>
                <c:pt idx="212">
                  <c:v>0.88232010421134643</c:v>
                </c:pt>
                <c:pt idx="213">
                  <c:v>0.81912030538830594</c:v>
                </c:pt>
                <c:pt idx="214">
                  <c:v>0.91873788238588705</c:v>
                </c:pt>
                <c:pt idx="215">
                  <c:v>0.61988282697252506</c:v>
                </c:pt>
                <c:pt idx="216">
                  <c:v>0.71578975520174015</c:v>
                </c:pt>
                <c:pt idx="217">
                  <c:v>1.0376831902562482</c:v>
                </c:pt>
                <c:pt idx="218">
                  <c:v>0.87717981517077204</c:v>
                </c:pt>
                <c:pt idx="219">
                  <c:v>0.66677426518840011</c:v>
                </c:pt>
                <c:pt idx="220">
                  <c:v>0.73554163150061802</c:v>
                </c:pt>
                <c:pt idx="221">
                  <c:v>0.79659548027654059</c:v>
                </c:pt>
                <c:pt idx="222">
                  <c:v>0.61967291738105823</c:v>
                </c:pt>
                <c:pt idx="223">
                  <c:v>0.7611486421924889</c:v>
                </c:pt>
                <c:pt idx="224">
                  <c:v>1.0226960630602382</c:v>
                </c:pt>
                <c:pt idx="225">
                  <c:v>0.69751784587281118</c:v>
                </c:pt>
                <c:pt idx="226">
                  <c:v>0.7388254041206832</c:v>
                </c:pt>
                <c:pt idx="227">
                  <c:v>0.87207231669099095</c:v>
                </c:pt>
                <c:pt idx="228">
                  <c:v>0.92907712395668762</c:v>
                </c:pt>
                <c:pt idx="229">
                  <c:v>0.81491702219069417</c:v>
                </c:pt>
                <c:pt idx="230">
                  <c:v>0.71515454263004075</c:v>
                </c:pt>
                <c:pt idx="231">
                  <c:v>0.75972865173163928</c:v>
                </c:pt>
                <c:pt idx="232">
                  <c:v>0.94415723637649385</c:v>
                </c:pt>
                <c:pt idx="233">
                  <c:v>0.59579151695440125</c:v>
                </c:pt>
                <c:pt idx="234">
                  <c:v>0.90196865168207307</c:v>
                </c:pt>
                <c:pt idx="235">
                  <c:v>0.80596466033837644</c:v>
                </c:pt>
                <c:pt idx="236">
                  <c:v>0.92266002221533761</c:v>
                </c:pt>
                <c:pt idx="237">
                  <c:v>0.87947498911838473</c:v>
                </c:pt>
                <c:pt idx="238">
                  <c:v>1.0077574913943883</c:v>
                </c:pt>
                <c:pt idx="239">
                  <c:v>0.73750009714599796</c:v>
                </c:pt>
                <c:pt idx="240">
                  <c:v>0.95737881628756549</c:v>
                </c:pt>
                <c:pt idx="241">
                  <c:v>0.76304596266326319</c:v>
                </c:pt>
                <c:pt idx="242">
                  <c:v>0.65814849150139221</c:v>
                </c:pt>
                <c:pt idx="243">
                  <c:v>0.83965199598132367</c:v>
                </c:pt>
                <c:pt idx="244">
                  <c:v>0.82395448605078836</c:v>
                </c:pt>
                <c:pt idx="245">
                  <c:v>1.079868526298567</c:v>
                </c:pt>
                <c:pt idx="246">
                  <c:v>0.86870870628008157</c:v>
                </c:pt>
                <c:pt idx="247">
                  <c:v>0.69331400152682265</c:v>
                </c:pt>
                <c:pt idx="248">
                  <c:v>0.7860002679914444</c:v>
                </c:pt>
                <c:pt idx="249">
                  <c:v>0.81964858803051688</c:v>
                </c:pt>
                <c:pt idx="250">
                  <c:v>0.81208767625945566</c:v>
                </c:pt>
                <c:pt idx="251">
                  <c:v>0.6906025257817261</c:v>
                </c:pt>
                <c:pt idx="252">
                  <c:v>0.81968474143634718</c:v>
                </c:pt>
                <c:pt idx="253">
                  <c:v>1.0066809397428169</c:v>
                </c:pt>
                <c:pt idx="254">
                  <c:v>0.95161014705279601</c:v>
                </c:pt>
                <c:pt idx="255">
                  <c:v>0.86867187652823696</c:v>
                </c:pt>
                <c:pt idx="256">
                  <c:v>0.5350701089673221</c:v>
                </c:pt>
                <c:pt idx="257">
                  <c:v>0.65726311189543218</c:v>
                </c:pt>
                <c:pt idx="258">
                  <c:v>0.94029540248302523</c:v>
                </c:pt>
                <c:pt idx="259">
                  <c:v>0.8178440659229449</c:v>
                </c:pt>
                <c:pt idx="260">
                  <c:v>0.9228692218022837</c:v>
                </c:pt>
                <c:pt idx="261">
                  <c:v>0.93389202376668701</c:v>
                </c:pt>
                <c:pt idx="262">
                  <c:v>0.86156194939663855</c:v>
                </c:pt>
                <c:pt idx="263">
                  <c:v>0.67002013412601147</c:v>
                </c:pt>
                <c:pt idx="264">
                  <c:v>0.81651778355025673</c:v>
                </c:pt>
                <c:pt idx="265">
                  <c:v>0.92659908747483954</c:v>
                </c:pt>
                <c:pt idx="266">
                  <c:v>0.73811015402322155</c:v>
                </c:pt>
                <c:pt idx="267">
                  <c:v>0.85521445025710019</c:v>
                </c:pt>
                <c:pt idx="268">
                  <c:v>0.75631276933067126</c:v>
                </c:pt>
                <c:pt idx="269">
                  <c:v>0.9069631528789257</c:v>
                </c:pt>
                <c:pt idx="270">
                  <c:v>1.0542978666605995</c:v>
                </c:pt>
                <c:pt idx="271">
                  <c:v>0.93310420798058158</c:v>
                </c:pt>
                <c:pt idx="272">
                  <c:v>0.70440654457758201</c:v>
                </c:pt>
                <c:pt idx="273">
                  <c:v>0.85454373172603926</c:v>
                </c:pt>
                <c:pt idx="274">
                  <c:v>0.57911683761357968</c:v>
                </c:pt>
                <c:pt idx="275">
                  <c:v>0.55234580162325819</c:v>
                </c:pt>
                <c:pt idx="276">
                  <c:v>0.90106259739496053</c:v>
                </c:pt>
                <c:pt idx="277">
                  <c:v>0.85345816743250646</c:v>
                </c:pt>
                <c:pt idx="278">
                  <c:v>0.8397725100747514</c:v>
                </c:pt>
                <c:pt idx="279">
                  <c:v>0.65773625425267623</c:v>
                </c:pt>
                <c:pt idx="280">
                  <c:v>0.78786400712922511</c:v>
                </c:pt>
                <c:pt idx="281">
                  <c:v>0.87016473095098557</c:v>
                </c:pt>
                <c:pt idx="282">
                  <c:v>0.69043939285012479</c:v>
                </c:pt>
                <c:pt idx="283">
                  <c:v>1.0623551634105153</c:v>
                </c:pt>
                <c:pt idx="284">
                  <c:v>0.73870987520156028</c:v>
                </c:pt>
                <c:pt idx="285">
                  <c:v>0.79715318140243541</c:v>
                </c:pt>
                <c:pt idx="286">
                  <c:v>0.8099276363347816</c:v>
                </c:pt>
                <c:pt idx="287">
                  <c:v>0.5635929280523323</c:v>
                </c:pt>
                <c:pt idx="288">
                  <c:v>0.52825890461538461</c:v>
                </c:pt>
                <c:pt idx="289">
                  <c:v>0.79600506790049741</c:v>
                </c:pt>
                <c:pt idx="290">
                  <c:v>0.83558178465269595</c:v>
                </c:pt>
                <c:pt idx="291">
                  <c:v>0.94164284193888503</c:v>
                </c:pt>
                <c:pt idx="292">
                  <c:v>0.88171400030024849</c:v>
                </c:pt>
                <c:pt idx="293">
                  <c:v>0.83076077825432249</c:v>
                </c:pt>
                <c:pt idx="294">
                  <c:v>0.39140883015798472</c:v>
                </c:pt>
                <c:pt idx="295">
                  <c:v>0.66725779869134227</c:v>
                </c:pt>
                <c:pt idx="296">
                  <c:v>0.76077871630100524</c:v>
                </c:pt>
                <c:pt idx="297">
                  <c:v>0.87903246270116631</c:v>
                </c:pt>
                <c:pt idx="298">
                  <c:v>0.75062263245348049</c:v>
                </c:pt>
                <c:pt idx="299">
                  <c:v>0.830714189641511</c:v>
                </c:pt>
                <c:pt idx="300">
                  <c:v>0.89285773097737864</c:v>
                </c:pt>
                <c:pt idx="301">
                  <c:v>0.77338994168913722</c:v>
                </c:pt>
                <c:pt idx="302">
                  <c:v>0.69073139880404577</c:v>
                </c:pt>
                <c:pt idx="303">
                  <c:v>0.80644332326980805</c:v>
                </c:pt>
                <c:pt idx="304">
                  <c:v>0.81163851075633431</c:v>
                </c:pt>
                <c:pt idx="305">
                  <c:v>1.0074020042605041</c:v>
                </c:pt>
                <c:pt idx="306">
                  <c:v>0.86457494991647466</c:v>
                </c:pt>
                <c:pt idx="307">
                  <c:v>0.59717714011105116</c:v>
                </c:pt>
                <c:pt idx="308">
                  <c:v>0.71725933157704669</c:v>
                </c:pt>
                <c:pt idx="309">
                  <c:v>0.46552711899540128</c:v>
                </c:pt>
                <c:pt idx="310">
                  <c:v>0.69022728484729678</c:v>
                </c:pt>
                <c:pt idx="311">
                  <c:v>0.67732809397910798</c:v>
                </c:pt>
                <c:pt idx="312">
                  <c:v>0.79322473614951539</c:v>
                </c:pt>
                <c:pt idx="313">
                  <c:v>0.70883929157194159</c:v>
                </c:pt>
                <c:pt idx="314">
                  <c:v>1.1002447840725154</c:v>
                </c:pt>
                <c:pt idx="315">
                  <c:v>0.52242252697702862</c:v>
                </c:pt>
                <c:pt idx="316">
                  <c:v>0.71337678229929347</c:v>
                </c:pt>
                <c:pt idx="317">
                  <c:v>0.46846987785136446</c:v>
                </c:pt>
                <c:pt idx="318">
                  <c:v>0.83656464227590277</c:v>
                </c:pt>
                <c:pt idx="319">
                  <c:v>0.6600358797792375</c:v>
                </c:pt>
                <c:pt idx="320">
                  <c:v>0.81220034338582425</c:v>
                </c:pt>
                <c:pt idx="321">
                  <c:v>0.62997658079625296</c:v>
                </c:pt>
                <c:pt idx="322">
                  <c:v>0.80135550218101526</c:v>
                </c:pt>
                <c:pt idx="323">
                  <c:v>0.79324739644221742</c:v>
                </c:pt>
                <c:pt idx="324">
                  <c:v>1.001178146747767</c:v>
                </c:pt>
                <c:pt idx="325">
                  <c:v>0.4839138848572811</c:v>
                </c:pt>
                <c:pt idx="326">
                  <c:v>0.72981297782270804</c:v>
                </c:pt>
                <c:pt idx="327">
                  <c:v>0.81806522395019077</c:v>
                </c:pt>
                <c:pt idx="328">
                  <c:v>0.70784744783988829</c:v>
                </c:pt>
                <c:pt idx="329">
                  <c:v>0.64143874703046777</c:v>
                </c:pt>
                <c:pt idx="330">
                  <c:v>0.63296144256680187</c:v>
                </c:pt>
                <c:pt idx="331">
                  <c:v>0.76705710102489022</c:v>
                </c:pt>
                <c:pt idx="332">
                  <c:v>0.80754016725767008</c:v>
                </c:pt>
                <c:pt idx="333">
                  <c:v>0.5572103940144455</c:v>
                </c:pt>
                <c:pt idx="334">
                  <c:v>0.55871335639528152</c:v>
                </c:pt>
                <c:pt idx="335">
                  <c:v>0.787335849311166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41D-41F9-AC0C-506714ADA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6451424"/>
        <c:axId val="726449784"/>
      </c:scatterChart>
      <c:valAx>
        <c:axId val="726451424"/>
        <c:scaling>
          <c:orientation val="minMax"/>
          <c:max val="14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enomic U 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6449784"/>
        <c:crosses val="autoZero"/>
        <c:crossBetween val="midCat"/>
        <c:majorUnit val="500"/>
      </c:valAx>
      <c:valAx>
        <c:axId val="726449784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Fold change: 4SU- virus, UV+/UV-</a:t>
                </a:r>
                <a:endParaRPr lang="en-US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4.629629629629629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64514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ntrols!$L$1</c:f>
              <c:strCache>
                <c:ptCount val="1"/>
                <c:pt idx="0">
                  <c:v>4SU+, UV-</c:v>
                </c:pt>
              </c:strCache>
            </c:strRef>
          </c:tx>
          <c:spPr>
            <a:ln w="19050" cap="rnd">
              <a:solidFill>
                <a:schemeClr val="tx1">
                  <a:alpha val="8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controls!$K$2:$K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L$2:$L$345</c:f>
              <c:numCache>
                <c:formatCode>0.000%</c:formatCode>
                <c:ptCount val="344"/>
                <c:pt idx="0">
                  <c:v>1.3706975327444412E-3</c:v>
                </c:pt>
                <c:pt idx="1">
                  <c:v>1.8930919354283552E-3</c:v>
                </c:pt>
                <c:pt idx="2">
                  <c:v>1.7283950617283952E-3</c:v>
                </c:pt>
                <c:pt idx="3">
                  <c:v>1.8537544110421226E-3</c:v>
                </c:pt>
                <c:pt idx="4">
                  <c:v>1.1169831452244802E-3</c:v>
                </c:pt>
                <c:pt idx="5">
                  <c:v>1.7895736684883608E-3</c:v>
                </c:pt>
                <c:pt idx="6">
                  <c:v>1.9906371411704945E-3</c:v>
                </c:pt>
                <c:pt idx="7">
                  <c:v>1.2057620031041957E-3</c:v>
                </c:pt>
                <c:pt idx="8">
                  <c:v>2.1841606878723785E-3</c:v>
                </c:pt>
                <c:pt idx="9">
                  <c:v>2.6391018723613715E-3</c:v>
                </c:pt>
                <c:pt idx="10">
                  <c:v>2.0757827569865776E-3</c:v>
                </c:pt>
                <c:pt idx="11">
                  <c:v>2.4535599860555455E-3</c:v>
                </c:pt>
                <c:pt idx="12">
                  <c:v>1.8649930228097906E-3</c:v>
                </c:pt>
                <c:pt idx="13">
                  <c:v>2.6025554147884075E-3</c:v>
                </c:pt>
                <c:pt idx="14">
                  <c:v>2.48908942199431E-3</c:v>
                </c:pt>
                <c:pt idx="15">
                  <c:v>2.6070493787566859E-3</c:v>
                </c:pt>
                <c:pt idx="16">
                  <c:v>2.0310531900151604E-3</c:v>
                </c:pt>
                <c:pt idx="17">
                  <c:v>2.4469972598375558E-3</c:v>
                </c:pt>
                <c:pt idx="18">
                  <c:v>1.2613549961983273E-3</c:v>
                </c:pt>
                <c:pt idx="19">
                  <c:v>1.4089345447004273E-3</c:v>
                </c:pt>
                <c:pt idx="20">
                  <c:v>1.4100112338599944E-3</c:v>
                </c:pt>
                <c:pt idx="21">
                  <c:v>1.2031032738778666E-3</c:v>
                </c:pt>
                <c:pt idx="22">
                  <c:v>1.9475672091403596E-3</c:v>
                </c:pt>
                <c:pt idx="23">
                  <c:v>1.2510106063378481E-3</c:v>
                </c:pt>
                <c:pt idx="24">
                  <c:v>1.6107053132608711E-3</c:v>
                </c:pt>
                <c:pt idx="25">
                  <c:v>1.9904153073254079E-3</c:v>
                </c:pt>
                <c:pt idx="26">
                  <c:v>1.8657044352540296E-3</c:v>
                </c:pt>
                <c:pt idx="27">
                  <c:v>1.5984291169342509E-3</c:v>
                </c:pt>
                <c:pt idx="28">
                  <c:v>1.7239322731924136E-3</c:v>
                </c:pt>
                <c:pt idx="29">
                  <c:v>1.5689595059022762E-3</c:v>
                </c:pt>
                <c:pt idx="30">
                  <c:v>1.5487222708921305E-3</c:v>
                </c:pt>
                <c:pt idx="31">
                  <c:v>1.0885524111435908E-3</c:v>
                </c:pt>
                <c:pt idx="32">
                  <c:v>2.2022019400849196E-3</c:v>
                </c:pt>
                <c:pt idx="33">
                  <c:v>1.8099369085173502E-3</c:v>
                </c:pt>
                <c:pt idx="34">
                  <c:v>1.8939914888266289E-3</c:v>
                </c:pt>
                <c:pt idx="35">
                  <c:v>1.6108120850194475E-3</c:v>
                </c:pt>
                <c:pt idx="36">
                  <c:v>1.9693834899362278E-3</c:v>
                </c:pt>
                <c:pt idx="37">
                  <c:v>2.8218153325692019E-3</c:v>
                </c:pt>
                <c:pt idx="38">
                  <c:v>2.1313883696932206E-3</c:v>
                </c:pt>
                <c:pt idx="39">
                  <c:v>2.7163258076641221E-3</c:v>
                </c:pt>
                <c:pt idx="40">
                  <c:v>2.7153953092687246E-3</c:v>
                </c:pt>
                <c:pt idx="41">
                  <c:v>1.706515108684332E-3</c:v>
                </c:pt>
                <c:pt idx="42">
                  <c:v>2.5030880326856382E-3</c:v>
                </c:pt>
                <c:pt idx="43">
                  <c:v>1.6317757244643622E-3</c:v>
                </c:pt>
                <c:pt idx="44">
                  <c:v>2.1980723839496461E-3</c:v>
                </c:pt>
                <c:pt idx="45">
                  <c:v>2.7957382280156678E-3</c:v>
                </c:pt>
                <c:pt idx="46">
                  <c:v>2.2629734673837733E-3</c:v>
                </c:pt>
                <c:pt idx="47">
                  <c:v>2.9178642975350578E-3</c:v>
                </c:pt>
                <c:pt idx="48">
                  <c:v>2.5291786191341671E-3</c:v>
                </c:pt>
                <c:pt idx="49">
                  <c:v>1.1310585328017427E-3</c:v>
                </c:pt>
                <c:pt idx="50">
                  <c:v>1.1724517601748774E-3</c:v>
                </c:pt>
                <c:pt idx="51">
                  <c:v>2.2211110206644727E-3</c:v>
                </c:pt>
                <c:pt idx="52">
                  <c:v>1.1114987188894636E-3</c:v>
                </c:pt>
                <c:pt idx="53">
                  <c:v>1.4768432475583441E-3</c:v>
                </c:pt>
                <c:pt idx="54">
                  <c:v>1.659788264848376E-3</c:v>
                </c:pt>
                <c:pt idx="55">
                  <c:v>1.695927027681825E-3</c:v>
                </c:pt>
                <c:pt idx="56">
                  <c:v>1.3672964430269312E-3</c:v>
                </c:pt>
                <c:pt idx="57">
                  <c:v>2.1317986788260373E-3</c:v>
                </c:pt>
                <c:pt idx="58">
                  <c:v>2.0977291092897075E-3</c:v>
                </c:pt>
                <c:pt idx="59">
                  <c:v>2.0583064508058087E-3</c:v>
                </c:pt>
                <c:pt idx="60">
                  <c:v>2.8126034672847113E-3</c:v>
                </c:pt>
                <c:pt idx="61">
                  <c:v>1.7517254857961845E-3</c:v>
                </c:pt>
                <c:pt idx="62">
                  <c:v>1.912594838104969E-3</c:v>
                </c:pt>
                <c:pt idx="63">
                  <c:v>1.2987294097274833E-3</c:v>
                </c:pt>
                <c:pt idx="64">
                  <c:v>2.0448537108993807E-3</c:v>
                </c:pt>
                <c:pt idx="65">
                  <c:v>4.1180937067309843E-3</c:v>
                </c:pt>
                <c:pt idx="66">
                  <c:v>1.7319277108433734E-3</c:v>
                </c:pt>
                <c:pt idx="67">
                  <c:v>1.5345874380114219E-3</c:v>
                </c:pt>
                <c:pt idx="68">
                  <c:v>2.0446107766531755E-3</c:v>
                </c:pt>
                <c:pt idx="69">
                  <c:v>3.1677820430071001E-3</c:v>
                </c:pt>
                <c:pt idx="70">
                  <c:v>1.7348561515107706E-3</c:v>
                </c:pt>
                <c:pt idx="71">
                  <c:v>1.9300567914940861E-3</c:v>
                </c:pt>
                <c:pt idx="72">
                  <c:v>1.2384059580137676E-3</c:v>
                </c:pt>
                <c:pt idx="73">
                  <c:v>1.2404969076184231E-3</c:v>
                </c:pt>
                <c:pt idx="74">
                  <c:v>2.3666390270867884E-3</c:v>
                </c:pt>
                <c:pt idx="75">
                  <c:v>2.0368180758973649E-3</c:v>
                </c:pt>
                <c:pt idx="76">
                  <c:v>2.2475393319383091E-3</c:v>
                </c:pt>
                <c:pt idx="77">
                  <c:v>1.7977898730001649E-3</c:v>
                </c:pt>
                <c:pt idx="78">
                  <c:v>1.4231016840036595E-3</c:v>
                </c:pt>
                <c:pt idx="79">
                  <c:v>1.559066218849774E-3</c:v>
                </c:pt>
                <c:pt idx="80">
                  <c:v>1.7593328995252212E-3</c:v>
                </c:pt>
                <c:pt idx="81">
                  <c:v>1.8153396197872018E-3</c:v>
                </c:pt>
                <c:pt idx="82">
                  <c:v>2.2915092269813024E-3</c:v>
                </c:pt>
                <c:pt idx="83">
                  <c:v>2.1458704186885806E-3</c:v>
                </c:pt>
                <c:pt idx="84">
                  <c:v>1.9890642394080281E-3</c:v>
                </c:pt>
                <c:pt idx="85">
                  <c:v>1.8669645113689171E-3</c:v>
                </c:pt>
                <c:pt idx="86">
                  <c:v>1.2876511727724898E-3</c:v>
                </c:pt>
                <c:pt idx="87">
                  <c:v>3.342900277054266E-3</c:v>
                </c:pt>
                <c:pt idx="88">
                  <c:v>2.3445489237522757E-3</c:v>
                </c:pt>
                <c:pt idx="89">
                  <c:v>2.4079600278635377E-3</c:v>
                </c:pt>
                <c:pt idx="90">
                  <c:v>1.8522187858059736E-3</c:v>
                </c:pt>
                <c:pt idx="91">
                  <c:v>1.6122880621337679E-3</c:v>
                </c:pt>
                <c:pt idx="92">
                  <c:v>1.380160411096837E-3</c:v>
                </c:pt>
                <c:pt idx="93">
                  <c:v>2.0650701144359013E-3</c:v>
                </c:pt>
                <c:pt idx="94">
                  <c:v>1.4934926392148496E-3</c:v>
                </c:pt>
                <c:pt idx="95">
                  <c:v>1.8256981083515636E-3</c:v>
                </c:pt>
                <c:pt idx="96">
                  <c:v>1.9483722459717199E-3</c:v>
                </c:pt>
                <c:pt idx="97">
                  <c:v>1.4876916122138659E-3</c:v>
                </c:pt>
                <c:pt idx="98">
                  <c:v>1.9805301112450985E-3</c:v>
                </c:pt>
                <c:pt idx="99">
                  <c:v>9.924287292110191E-4</c:v>
                </c:pt>
                <c:pt idx="100">
                  <c:v>1.4766307139188494E-3</c:v>
                </c:pt>
                <c:pt idx="101">
                  <c:v>1.3588504288108839E-3</c:v>
                </c:pt>
                <c:pt idx="102">
                  <c:v>1.6233633805114818E-3</c:v>
                </c:pt>
                <c:pt idx="103">
                  <c:v>2.1565463775530284E-3</c:v>
                </c:pt>
                <c:pt idx="104">
                  <c:v>2.1895108254770851E-3</c:v>
                </c:pt>
                <c:pt idx="105">
                  <c:v>2.3687544758442132E-3</c:v>
                </c:pt>
                <c:pt idx="106">
                  <c:v>1.5873391930630908E-3</c:v>
                </c:pt>
                <c:pt idx="107">
                  <c:v>1.6502399660868116E-3</c:v>
                </c:pt>
                <c:pt idx="108">
                  <c:v>1.6007069185305365E-3</c:v>
                </c:pt>
                <c:pt idx="109">
                  <c:v>2.4573202276254526E-3</c:v>
                </c:pt>
                <c:pt idx="110">
                  <c:v>1.6164605978748932E-3</c:v>
                </c:pt>
                <c:pt idx="111">
                  <c:v>2.5854223545958466E-3</c:v>
                </c:pt>
                <c:pt idx="112">
                  <c:v>2.1727884117951372E-3</c:v>
                </c:pt>
                <c:pt idx="113">
                  <c:v>1.8180812675413734E-3</c:v>
                </c:pt>
                <c:pt idx="114">
                  <c:v>1.3836699811441051E-3</c:v>
                </c:pt>
                <c:pt idx="115">
                  <c:v>1.899733382246009E-3</c:v>
                </c:pt>
                <c:pt idx="116">
                  <c:v>2.0255083372536721E-3</c:v>
                </c:pt>
                <c:pt idx="117">
                  <c:v>2.1268766099707477E-3</c:v>
                </c:pt>
                <c:pt idx="118">
                  <c:v>1.7999224061718893E-3</c:v>
                </c:pt>
                <c:pt idx="119">
                  <c:v>2.4276329622856707E-3</c:v>
                </c:pt>
                <c:pt idx="120">
                  <c:v>2.1383218764758358E-3</c:v>
                </c:pt>
                <c:pt idx="121">
                  <c:v>2.1309632863611852E-3</c:v>
                </c:pt>
                <c:pt idx="122">
                  <c:v>1.0487380603997763E-3</c:v>
                </c:pt>
                <c:pt idx="123">
                  <c:v>2.9303703327019158E-3</c:v>
                </c:pt>
                <c:pt idx="124">
                  <c:v>2.2253164717925241E-3</c:v>
                </c:pt>
                <c:pt idx="125">
                  <c:v>1.9427617791876071E-3</c:v>
                </c:pt>
                <c:pt idx="126">
                  <c:v>1.6021409884069799E-3</c:v>
                </c:pt>
                <c:pt idx="127">
                  <c:v>1.1646315942714684E-3</c:v>
                </c:pt>
                <c:pt idx="128">
                  <c:v>2.013524577735998E-3</c:v>
                </c:pt>
                <c:pt idx="129">
                  <c:v>1.9634203532906051E-3</c:v>
                </c:pt>
                <c:pt idx="130">
                  <c:v>1.4808958164693185E-3</c:v>
                </c:pt>
                <c:pt idx="131">
                  <c:v>2.2030753362072349E-3</c:v>
                </c:pt>
                <c:pt idx="132">
                  <c:v>1.9535108321078161E-3</c:v>
                </c:pt>
                <c:pt idx="133">
                  <c:v>2.1887239574762203E-3</c:v>
                </c:pt>
                <c:pt idx="134">
                  <c:v>2.3460950791603903E-3</c:v>
                </c:pt>
                <c:pt idx="135">
                  <c:v>1.3933627193354243E-3</c:v>
                </c:pt>
                <c:pt idx="136">
                  <c:v>1.4640977762688848E-3</c:v>
                </c:pt>
                <c:pt idx="137">
                  <c:v>1.6054375231023012E-3</c:v>
                </c:pt>
                <c:pt idx="138">
                  <c:v>1.9343387643614026E-3</c:v>
                </c:pt>
                <c:pt idx="139">
                  <c:v>1.3670227362814948E-3</c:v>
                </c:pt>
                <c:pt idx="140">
                  <c:v>1.9808243755477083E-3</c:v>
                </c:pt>
                <c:pt idx="141">
                  <c:v>1.7712997496285984E-3</c:v>
                </c:pt>
                <c:pt idx="142">
                  <c:v>1.7762542848239328E-3</c:v>
                </c:pt>
                <c:pt idx="143">
                  <c:v>1.6410411775101619E-3</c:v>
                </c:pt>
                <c:pt idx="144">
                  <c:v>2.5344763324636603E-3</c:v>
                </c:pt>
                <c:pt idx="145">
                  <c:v>1.1312049555668622E-3</c:v>
                </c:pt>
                <c:pt idx="146">
                  <c:v>1.5088884371258838E-3</c:v>
                </c:pt>
                <c:pt idx="147">
                  <c:v>1.2616974719493459E-3</c:v>
                </c:pt>
                <c:pt idx="148">
                  <c:v>2.1411907577258637E-3</c:v>
                </c:pt>
                <c:pt idx="149">
                  <c:v>2.5835217624249687E-3</c:v>
                </c:pt>
                <c:pt idx="150">
                  <c:v>1.4597428882311587E-3</c:v>
                </c:pt>
                <c:pt idx="151">
                  <c:v>1.945193936731895E-3</c:v>
                </c:pt>
                <c:pt idx="152">
                  <c:v>1.9710696368384225E-3</c:v>
                </c:pt>
                <c:pt idx="153">
                  <c:v>2.3147724569525518E-3</c:v>
                </c:pt>
                <c:pt idx="154">
                  <c:v>1.7922364732863331E-3</c:v>
                </c:pt>
                <c:pt idx="155">
                  <c:v>1.779147940422687E-3</c:v>
                </c:pt>
                <c:pt idx="156">
                  <c:v>1.8463824649391659E-3</c:v>
                </c:pt>
                <c:pt idx="157">
                  <c:v>1.5498555313236872E-3</c:v>
                </c:pt>
                <c:pt idx="158">
                  <c:v>2.1204287332616842E-3</c:v>
                </c:pt>
                <c:pt idx="159">
                  <c:v>2.4694317038715607E-3</c:v>
                </c:pt>
                <c:pt idx="160">
                  <c:v>1.3825299173479404E-3</c:v>
                </c:pt>
                <c:pt idx="161">
                  <c:v>2.4695113119550418E-3</c:v>
                </c:pt>
                <c:pt idx="162">
                  <c:v>1.9805843828344443E-3</c:v>
                </c:pt>
                <c:pt idx="163">
                  <c:v>1.8360597714879826E-3</c:v>
                </c:pt>
                <c:pt idx="164">
                  <c:v>1.6819532644184437E-3</c:v>
                </c:pt>
                <c:pt idx="165">
                  <c:v>1.6379986368333492E-3</c:v>
                </c:pt>
                <c:pt idx="166">
                  <c:v>1.6923230744733246E-3</c:v>
                </c:pt>
                <c:pt idx="167">
                  <c:v>1.6895034943695622E-3</c:v>
                </c:pt>
                <c:pt idx="168">
                  <c:v>1.0459355539922356E-3</c:v>
                </c:pt>
                <c:pt idx="169">
                  <c:v>1.4294082323598866E-3</c:v>
                </c:pt>
                <c:pt idx="170">
                  <c:v>1.9507049630991644E-3</c:v>
                </c:pt>
                <c:pt idx="171">
                  <c:v>2.3960566104459409E-3</c:v>
                </c:pt>
                <c:pt idx="172">
                  <c:v>2.2576149133250096E-3</c:v>
                </c:pt>
                <c:pt idx="173">
                  <c:v>1.5735127766336979E-3</c:v>
                </c:pt>
                <c:pt idx="174">
                  <c:v>1.3184080490776502E-3</c:v>
                </c:pt>
                <c:pt idx="175">
                  <c:v>2.7104291814431499E-3</c:v>
                </c:pt>
                <c:pt idx="176">
                  <c:v>2.0742949155164291E-3</c:v>
                </c:pt>
                <c:pt idx="177">
                  <c:v>2.3620855349542895E-3</c:v>
                </c:pt>
                <c:pt idx="178">
                  <c:v>2.2446084505018944E-3</c:v>
                </c:pt>
                <c:pt idx="179">
                  <c:v>1.9158737675980539E-3</c:v>
                </c:pt>
                <c:pt idx="180">
                  <c:v>2.2400959537164427E-3</c:v>
                </c:pt>
                <c:pt idx="181">
                  <c:v>2.9540049695534866E-3</c:v>
                </c:pt>
                <c:pt idx="182">
                  <c:v>2.2439711142317078E-3</c:v>
                </c:pt>
                <c:pt idx="183">
                  <c:v>2.6897877108237058E-3</c:v>
                </c:pt>
                <c:pt idx="184">
                  <c:v>1.8018874131037054E-3</c:v>
                </c:pt>
                <c:pt idx="185">
                  <c:v>2.0077277181046755E-3</c:v>
                </c:pt>
                <c:pt idx="186">
                  <c:v>2.895431652281955E-3</c:v>
                </c:pt>
                <c:pt idx="187">
                  <c:v>2.6806439535754399E-3</c:v>
                </c:pt>
                <c:pt idx="188">
                  <c:v>2.6813785218947907E-3</c:v>
                </c:pt>
                <c:pt idx="189">
                  <c:v>1.3012044578439754E-3</c:v>
                </c:pt>
                <c:pt idx="190">
                  <c:v>2.0303152413130407E-3</c:v>
                </c:pt>
                <c:pt idx="191">
                  <c:v>2.7534336698641151E-3</c:v>
                </c:pt>
                <c:pt idx="192">
                  <c:v>1.7112708116545266E-3</c:v>
                </c:pt>
                <c:pt idx="193">
                  <c:v>2.3861422107731432E-3</c:v>
                </c:pt>
                <c:pt idx="194">
                  <c:v>2.3047024234672691E-3</c:v>
                </c:pt>
                <c:pt idx="195">
                  <c:v>2.0936151007735094E-3</c:v>
                </c:pt>
                <c:pt idx="196">
                  <c:v>2.0409187480134499E-3</c:v>
                </c:pt>
                <c:pt idx="197">
                  <c:v>1.6992317617196395E-3</c:v>
                </c:pt>
                <c:pt idx="198">
                  <c:v>2.2968107869442652E-3</c:v>
                </c:pt>
                <c:pt idx="199">
                  <c:v>1.4823700784028105E-3</c:v>
                </c:pt>
                <c:pt idx="200">
                  <c:v>1.3235588592973905E-3</c:v>
                </c:pt>
                <c:pt idx="201">
                  <c:v>1.6682824564597963E-3</c:v>
                </c:pt>
                <c:pt idx="202">
                  <c:v>1.6817746915102436E-3</c:v>
                </c:pt>
                <c:pt idx="203">
                  <c:v>1.334184778890232E-3</c:v>
                </c:pt>
                <c:pt idx="204">
                  <c:v>1.9264609474737484E-3</c:v>
                </c:pt>
                <c:pt idx="205">
                  <c:v>1.7741322304528646E-3</c:v>
                </c:pt>
                <c:pt idx="206">
                  <c:v>2.0115010530799629E-3</c:v>
                </c:pt>
                <c:pt idx="207">
                  <c:v>2.2803772326166721E-3</c:v>
                </c:pt>
                <c:pt idx="208">
                  <c:v>1.5699904122722914E-3</c:v>
                </c:pt>
                <c:pt idx="209">
                  <c:v>3.3773411114522566E-3</c:v>
                </c:pt>
                <c:pt idx="210">
                  <c:v>2.3356530569576773E-3</c:v>
                </c:pt>
                <c:pt idx="211">
                  <c:v>2.5035356422832724E-3</c:v>
                </c:pt>
                <c:pt idx="212">
                  <c:v>1.9329432500966471E-3</c:v>
                </c:pt>
                <c:pt idx="213">
                  <c:v>1.470501349053693E-3</c:v>
                </c:pt>
                <c:pt idx="214">
                  <c:v>2.6994601079784043E-3</c:v>
                </c:pt>
                <c:pt idx="215">
                  <c:v>2.1984474318447159E-3</c:v>
                </c:pt>
                <c:pt idx="216">
                  <c:v>1.4350143501435015E-3</c:v>
                </c:pt>
                <c:pt idx="217">
                  <c:v>2.4673797878053383E-3</c:v>
                </c:pt>
                <c:pt idx="218">
                  <c:v>2.924718346638812E-3</c:v>
                </c:pt>
                <c:pt idx="219">
                  <c:v>2.3409332118958549E-3</c:v>
                </c:pt>
                <c:pt idx="220">
                  <c:v>1.6931216931216932E-3</c:v>
                </c:pt>
                <c:pt idx="221">
                  <c:v>1.3424345847554038E-3</c:v>
                </c:pt>
                <c:pt idx="222">
                  <c:v>1.9514022776767385E-3</c:v>
                </c:pt>
                <c:pt idx="223">
                  <c:v>2.3281314559959318E-3</c:v>
                </c:pt>
                <c:pt idx="224">
                  <c:v>1.5702108568864963E-3</c:v>
                </c:pt>
                <c:pt idx="225">
                  <c:v>1.2632403804582794E-3</c:v>
                </c:pt>
                <c:pt idx="226">
                  <c:v>1.4976562651953761E-3</c:v>
                </c:pt>
                <c:pt idx="227">
                  <c:v>1.4089491643128535E-3</c:v>
                </c:pt>
                <c:pt idx="228">
                  <c:v>8.7713165237620055E-4</c:v>
                </c:pt>
                <c:pt idx="229">
                  <c:v>1.497495784360607E-3</c:v>
                </c:pt>
                <c:pt idx="230">
                  <c:v>1.7295158569295935E-3</c:v>
                </c:pt>
                <c:pt idx="231">
                  <c:v>2.2277615211396505E-3</c:v>
                </c:pt>
                <c:pt idx="232">
                  <c:v>2.1490014346685557E-3</c:v>
                </c:pt>
                <c:pt idx="233">
                  <c:v>1.9150302862940261E-3</c:v>
                </c:pt>
                <c:pt idx="234">
                  <c:v>2.557590076786769E-3</c:v>
                </c:pt>
                <c:pt idx="235">
                  <c:v>2.1969033011977799E-3</c:v>
                </c:pt>
                <c:pt idx="236">
                  <c:v>1.5295757346688085E-3</c:v>
                </c:pt>
                <c:pt idx="237">
                  <c:v>1.8907449535116836E-3</c:v>
                </c:pt>
                <c:pt idx="238">
                  <c:v>1.699442960362992E-3</c:v>
                </c:pt>
                <c:pt idx="239">
                  <c:v>1.377303373282536E-3</c:v>
                </c:pt>
                <c:pt idx="240">
                  <c:v>1.9914984770894001E-3</c:v>
                </c:pt>
                <c:pt idx="241">
                  <c:v>2.4706435998565796E-3</c:v>
                </c:pt>
                <c:pt idx="242">
                  <c:v>1.67294495214467E-3</c:v>
                </c:pt>
                <c:pt idx="243">
                  <c:v>2.2651536601833904E-3</c:v>
                </c:pt>
                <c:pt idx="244">
                  <c:v>1.8387285937204933E-3</c:v>
                </c:pt>
                <c:pt idx="245">
                  <c:v>1.9714238324289742E-3</c:v>
                </c:pt>
                <c:pt idx="246">
                  <c:v>2.5740572810398245E-3</c:v>
                </c:pt>
                <c:pt idx="247">
                  <c:v>2.5423373672373733E-3</c:v>
                </c:pt>
                <c:pt idx="248">
                  <c:v>1.933210546280512E-3</c:v>
                </c:pt>
                <c:pt idx="249">
                  <c:v>1.3987272032202208E-3</c:v>
                </c:pt>
                <c:pt idx="250">
                  <c:v>1.9622437242032614E-3</c:v>
                </c:pt>
                <c:pt idx="251">
                  <c:v>1.6820224437024578E-3</c:v>
                </c:pt>
                <c:pt idx="252">
                  <c:v>2.4557898130495178E-3</c:v>
                </c:pt>
                <c:pt idx="253">
                  <c:v>1.859764532292275E-3</c:v>
                </c:pt>
                <c:pt idx="254">
                  <c:v>1.4032136343626188E-3</c:v>
                </c:pt>
                <c:pt idx="255">
                  <c:v>1.5538141590821031E-3</c:v>
                </c:pt>
                <c:pt idx="256">
                  <c:v>1.3695670624908375E-3</c:v>
                </c:pt>
                <c:pt idx="257">
                  <c:v>1.1423251010292661E-3</c:v>
                </c:pt>
                <c:pt idx="258">
                  <c:v>2.0934651679603206E-3</c:v>
                </c:pt>
                <c:pt idx="259">
                  <c:v>1.7366953279414551E-3</c:v>
                </c:pt>
                <c:pt idx="260">
                  <c:v>1.9382969087042964E-3</c:v>
                </c:pt>
                <c:pt idx="261">
                  <c:v>1.8330258664677945E-3</c:v>
                </c:pt>
                <c:pt idx="262">
                  <c:v>2.7174338653343151E-3</c:v>
                </c:pt>
                <c:pt idx="263">
                  <c:v>1.9920084846255298E-3</c:v>
                </c:pt>
                <c:pt idx="264">
                  <c:v>1.6881522406384285E-3</c:v>
                </c:pt>
                <c:pt idx="265">
                  <c:v>2.2009650385168881E-3</c:v>
                </c:pt>
                <c:pt idx="266">
                  <c:v>2.5164738234836298E-3</c:v>
                </c:pt>
                <c:pt idx="267">
                  <c:v>2.391312573309622E-3</c:v>
                </c:pt>
                <c:pt idx="268">
                  <c:v>1.2178822806852246E-3</c:v>
                </c:pt>
                <c:pt idx="269">
                  <c:v>1.3896820235882845E-3</c:v>
                </c:pt>
                <c:pt idx="270">
                  <c:v>1.802767184594535E-3</c:v>
                </c:pt>
                <c:pt idx="271">
                  <c:v>1.9328393504650797E-3</c:v>
                </c:pt>
                <c:pt idx="272">
                  <c:v>1.8547066909587523E-3</c:v>
                </c:pt>
                <c:pt idx="273">
                  <c:v>2.7341804971612255E-3</c:v>
                </c:pt>
                <c:pt idx="274">
                  <c:v>1.6173461120679825E-3</c:v>
                </c:pt>
                <c:pt idx="275">
                  <c:v>1.8838692564594108E-3</c:v>
                </c:pt>
                <c:pt idx="276">
                  <c:v>1.9492063301077176E-3</c:v>
                </c:pt>
                <c:pt idx="277">
                  <c:v>2.544207867195958E-3</c:v>
                </c:pt>
                <c:pt idx="278">
                  <c:v>1.7032087541512153E-3</c:v>
                </c:pt>
                <c:pt idx="279">
                  <c:v>1.2280979761850862E-3</c:v>
                </c:pt>
                <c:pt idx="280">
                  <c:v>2.0694634275384683E-3</c:v>
                </c:pt>
                <c:pt idx="281">
                  <c:v>2.5354480439845118E-3</c:v>
                </c:pt>
                <c:pt idx="282">
                  <c:v>1.8812367086536888E-3</c:v>
                </c:pt>
                <c:pt idx="283">
                  <c:v>1.6390670326382475E-3</c:v>
                </c:pt>
                <c:pt idx="284">
                  <c:v>1.6796927749519665E-3</c:v>
                </c:pt>
                <c:pt idx="285">
                  <c:v>1.7675504418876104E-3</c:v>
                </c:pt>
                <c:pt idx="286">
                  <c:v>2.3985897448247297E-3</c:v>
                </c:pt>
                <c:pt idx="287">
                  <c:v>1.6984580103436332E-3</c:v>
                </c:pt>
                <c:pt idx="288">
                  <c:v>9.8427307977378407E-4</c:v>
                </c:pt>
                <c:pt idx="289">
                  <c:v>1.6963774367301963E-3</c:v>
                </c:pt>
                <c:pt idx="290">
                  <c:v>2.1440760425783674E-3</c:v>
                </c:pt>
                <c:pt idx="291">
                  <c:v>1.7285832191088787E-3</c:v>
                </c:pt>
                <c:pt idx="292">
                  <c:v>1.8793031206844829E-3</c:v>
                </c:pt>
                <c:pt idx="293">
                  <c:v>2.4605601319596655E-3</c:v>
                </c:pt>
                <c:pt idx="294">
                  <c:v>1.9790275101374917E-3</c:v>
                </c:pt>
                <c:pt idx="295">
                  <c:v>1.7803441527704839E-3</c:v>
                </c:pt>
                <c:pt idx="296">
                  <c:v>1.7663338654374746E-3</c:v>
                </c:pt>
                <c:pt idx="297">
                  <c:v>2.8609276618046923E-3</c:v>
                </c:pt>
                <c:pt idx="298">
                  <c:v>2.662485944550944E-3</c:v>
                </c:pt>
                <c:pt idx="299">
                  <c:v>1.6702475572316462E-3</c:v>
                </c:pt>
                <c:pt idx="300">
                  <c:v>1.3393591232899965E-3</c:v>
                </c:pt>
                <c:pt idx="301">
                  <c:v>1.6390050970371624E-3</c:v>
                </c:pt>
                <c:pt idx="302">
                  <c:v>1.3255738764953119E-3</c:v>
                </c:pt>
                <c:pt idx="303">
                  <c:v>1.9013110365645354E-3</c:v>
                </c:pt>
                <c:pt idx="304">
                  <c:v>2.4551524509042752E-3</c:v>
                </c:pt>
                <c:pt idx="305">
                  <c:v>1.9630420706284956E-3</c:v>
                </c:pt>
                <c:pt idx="306">
                  <c:v>1.7086756007511786E-3</c:v>
                </c:pt>
                <c:pt idx="307">
                  <c:v>2.3287026211517947E-3</c:v>
                </c:pt>
                <c:pt idx="308">
                  <c:v>1.8522257151738304E-3</c:v>
                </c:pt>
                <c:pt idx="309">
                  <c:v>1.7935579505311691E-3</c:v>
                </c:pt>
                <c:pt idx="310">
                  <c:v>2.1659607239122064E-3</c:v>
                </c:pt>
                <c:pt idx="311">
                  <c:v>1.5250284073919024E-3</c:v>
                </c:pt>
                <c:pt idx="312">
                  <c:v>1.8338834983828481E-3</c:v>
                </c:pt>
                <c:pt idx="313">
                  <c:v>1.8918466432278588E-3</c:v>
                </c:pt>
                <c:pt idx="314">
                  <c:v>3.227251365799213E-3</c:v>
                </c:pt>
                <c:pt idx="315">
                  <c:v>1.7446739594528938E-3</c:v>
                </c:pt>
                <c:pt idx="316">
                  <c:v>1.5766008634120767E-3</c:v>
                </c:pt>
                <c:pt idx="317">
                  <c:v>8.2893041838582606E-4</c:v>
                </c:pt>
                <c:pt idx="318">
                  <c:v>2.4780128856670054E-3</c:v>
                </c:pt>
                <c:pt idx="319">
                  <c:v>1.9518473410733565E-3</c:v>
                </c:pt>
                <c:pt idx="320">
                  <c:v>1.1970066905539526E-3</c:v>
                </c:pt>
                <c:pt idx="321">
                  <c:v>1.9389040692442364E-3</c:v>
                </c:pt>
                <c:pt idx="322">
                  <c:v>1.4806642666356986E-3</c:v>
                </c:pt>
                <c:pt idx="323">
                  <c:v>1.5589909077033774E-3</c:v>
                </c:pt>
                <c:pt idx="324">
                  <c:v>1.750610483592208E-3</c:v>
                </c:pt>
                <c:pt idx="325">
                  <c:v>1.7988053217485745E-3</c:v>
                </c:pt>
                <c:pt idx="326">
                  <c:v>9.9737676248770352E-4</c:v>
                </c:pt>
                <c:pt idx="327">
                  <c:v>1.7012010479398455E-3</c:v>
                </c:pt>
                <c:pt idx="328">
                  <c:v>1.2319906916258856E-3</c:v>
                </c:pt>
                <c:pt idx="329">
                  <c:v>1.2484852935776447E-3</c:v>
                </c:pt>
                <c:pt idx="330">
                  <c:v>2.8608378727906884E-3</c:v>
                </c:pt>
                <c:pt idx="331">
                  <c:v>2.3034154090548053E-3</c:v>
                </c:pt>
                <c:pt idx="332">
                  <c:v>1.1741682974559687E-3</c:v>
                </c:pt>
                <c:pt idx="333">
                  <c:v>1.1746280344557558E-3</c:v>
                </c:pt>
                <c:pt idx="334">
                  <c:v>1.1585248117397182E-3</c:v>
                </c:pt>
                <c:pt idx="335">
                  <c:v>2.015376576845562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59A-41D5-A8EC-B43537951BA5}"/>
            </c:ext>
          </c:extLst>
        </c:ser>
        <c:ser>
          <c:idx val="1"/>
          <c:order val="1"/>
          <c:tx>
            <c:strRef>
              <c:f>controls!$M$1</c:f>
              <c:strCache>
                <c:ptCount val="1"/>
                <c:pt idx="0">
                  <c:v>4SU-, UV-</c:v>
                </c:pt>
              </c:strCache>
            </c:strRef>
          </c:tx>
          <c:spPr>
            <a:ln w="19050" cap="rnd">
              <a:solidFill>
                <a:schemeClr val="accent2">
                  <a:alpha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controls!$K$2:$K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M$2:$M$345</c:f>
              <c:numCache>
                <c:formatCode>0.0000%</c:formatCode>
                <c:ptCount val="344"/>
                <c:pt idx="0">
                  <c:v>1.0089362928797925E-3</c:v>
                </c:pt>
                <c:pt idx="1">
                  <c:v>1.862923490165497E-3</c:v>
                </c:pt>
                <c:pt idx="2">
                  <c:v>1.9127662657585857E-3</c:v>
                </c:pt>
                <c:pt idx="3">
                  <c:v>1.7613767613767614E-3</c:v>
                </c:pt>
                <c:pt idx="4">
                  <c:v>9.9061073305194256E-4</c:v>
                </c:pt>
                <c:pt idx="5">
                  <c:v>1.5866224551645451E-3</c:v>
                </c:pt>
                <c:pt idx="6">
                  <c:v>1.6004837017409707E-3</c:v>
                </c:pt>
                <c:pt idx="7">
                  <c:v>9.8972337231743738E-4</c:v>
                </c:pt>
                <c:pt idx="8">
                  <c:v>2.2339785685352711E-3</c:v>
                </c:pt>
                <c:pt idx="9">
                  <c:v>2.3947860354670844E-3</c:v>
                </c:pt>
                <c:pt idx="10">
                  <c:v>1.884925939789316E-3</c:v>
                </c:pt>
                <c:pt idx="11">
                  <c:v>2.3576021590672406E-3</c:v>
                </c:pt>
                <c:pt idx="12">
                  <c:v>1.9727957207545171E-3</c:v>
                </c:pt>
                <c:pt idx="13">
                  <c:v>2.8396927889278193E-3</c:v>
                </c:pt>
                <c:pt idx="14">
                  <c:v>2.0386935718743498E-3</c:v>
                </c:pt>
                <c:pt idx="15">
                  <c:v>2.739235273854633E-3</c:v>
                </c:pt>
                <c:pt idx="16">
                  <c:v>1.8678200501391223E-3</c:v>
                </c:pt>
                <c:pt idx="17">
                  <c:v>2.3192990562852117E-3</c:v>
                </c:pt>
                <c:pt idx="18">
                  <c:v>1.1926931849092926E-3</c:v>
                </c:pt>
                <c:pt idx="19">
                  <c:v>1.3181310267764764E-3</c:v>
                </c:pt>
                <c:pt idx="20">
                  <c:v>1.3002069059906128E-3</c:v>
                </c:pt>
                <c:pt idx="21">
                  <c:v>1.0800451957374217E-3</c:v>
                </c:pt>
                <c:pt idx="22">
                  <c:v>1.8858170539023307E-3</c:v>
                </c:pt>
                <c:pt idx="23">
                  <c:v>1.1220691297368877E-3</c:v>
                </c:pt>
                <c:pt idx="24">
                  <c:v>1.5386426169888663E-3</c:v>
                </c:pt>
                <c:pt idx="25">
                  <c:v>1.8445730762251512E-3</c:v>
                </c:pt>
                <c:pt idx="26">
                  <c:v>1.5712902352450699E-3</c:v>
                </c:pt>
                <c:pt idx="27">
                  <c:v>1.4932969049245317E-3</c:v>
                </c:pt>
                <c:pt idx="28">
                  <c:v>1.5191189110316016E-3</c:v>
                </c:pt>
                <c:pt idx="29">
                  <c:v>1.440967273182365E-3</c:v>
                </c:pt>
                <c:pt idx="30">
                  <c:v>1.6036583017328613E-3</c:v>
                </c:pt>
                <c:pt idx="31">
                  <c:v>9.9610818783454815E-4</c:v>
                </c:pt>
                <c:pt idx="32">
                  <c:v>2.0237807107435462E-3</c:v>
                </c:pt>
                <c:pt idx="33">
                  <c:v>1.5833614953245376E-3</c:v>
                </c:pt>
                <c:pt idx="34">
                  <c:v>2.0677420291191351E-3</c:v>
                </c:pt>
                <c:pt idx="35">
                  <c:v>1.4374929576502966E-3</c:v>
                </c:pt>
                <c:pt idx="36">
                  <c:v>1.9350618519549589E-3</c:v>
                </c:pt>
                <c:pt idx="37">
                  <c:v>2.7986982958540414E-3</c:v>
                </c:pt>
                <c:pt idx="38">
                  <c:v>1.7769077676499578E-3</c:v>
                </c:pt>
                <c:pt idx="39">
                  <c:v>2.5125936309080554E-3</c:v>
                </c:pt>
                <c:pt idx="40">
                  <c:v>2.6829893810293281E-3</c:v>
                </c:pt>
                <c:pt idx="41">
                  <c:v>1.5279907975460122E-3</c:v>
                </c:pt>
                <c:pt idx="42">
                  <c:v>2.4104506171781733E-3</c:v>
                </c:pt>
                <c:pt idx="43">
                  <c:v>1.3089637839927826E-3</c:v>
                </c:pt>
                <c:pt idx="44">
                  <c:v>2.1687441759398935E-3</c:v>
                </c:pt>
                <c:pt idx="45">
                  <c:v>2.6832205359727775E-3</c:v>
                </c:pt>
                <c:pt idx="46">
                  <c:v>2.1532050848603692E-3</c:v>
                </c:pt>
                <c:pt idx="47">
                  <c:v>2.8345063119616168E-3</c:v>
                </c:pt>
                <c:pt idx="48">
                  <c:v>2.246612692318393E-3</c:v>
                </c:pt>
                <c:pt idx="49">
                  <c:v>1.1557010082681226E-3</c:v>
                </c:pt>
                <c:pt idx="50">
                  <c:v>1.1704709441700176E-3</c:v>
                </c:pt>
                <c:pt idx="51">
                  <c:v>2.058087805754857E-3</c:v>
                </c:pt>
                <c:pt idx="52">
                  <c:v>9.057187017001546E-4</c:v>
                </c:pt>
                <c:pt idx="53">
                  <c:v>1.3594860307185993E-3</c:v>
                </c:pt>
                <c:pt idx="54">
                  <c:v>1.5573623099054666E-3</c:v>
                </c:pt>
                <c:pt idx="55">
                  <c:v>1.6124412231380489E-3</c:v>
                </c:pt>
                <c:pt idx="56">
                  <c:v>1.5144286375202405E-3</c:v>
                </c:pt>
                <c:pt idx="57">
                  <c:v>2.1773787389379692E-3</c:v>
                </c:pt>
                <c:pt idx="58">
                  <c:v>1.9981372601312122E-3</c:v>
                </c:pt>
                <c:pt idx="59">
                  <c:v>2.1240054095762774E-3</c:v>
                </c:pt>
                <c:pt idx="60">
                  <c:v>2.7111521549423455E-3</c:v>
                </c:pt>
                <c:pt idx="61">
                  <c:v>1.8782583748358204E-3</c:v>
                </c:pt>
                <c:pt idx="62">
                  <c:v>1.8039038329101954E-3</c:v>
                </c:pt>
                <c:pt idx="63">
                  <c:v>1.4382673602544788E-3</c:v>
                </c:pt>
                <c:pt idx="64">
                  <c:v>1.7951493457082535E-3</c:v>
                </c:pt>
                <c:pt idx="65">
                  <c:v>4.2063724374193688E-3</c:v>
                </c:pt>
                <c:pt idx="66">
                  <c:v>1.6931798031106459E-3</c:v>
                </c:pt>
                <c:pt idx="67">
                  <c:v>1.1999325037966614E-3</c:v>
                </c:pt>
                <c:pt idx="68">
                  <c:v>1.8207857446150082E-3</c:v>
                </c:pt>
                <c:pt idx="69">
                  <c:v>2.7707943300347686E-3</c:v>
                </c:pt>
                <c:pt idx="70">
                  <c:v>1.3713600034284E-3</c:v>
                </c:pt>
                <c:pt idx="71">
                  <c:v>1.8412042121584082E-3</c:v>
                </c:pt>
                <c:pt idx="72">
                  <c:v>9.9094150213806394E-4</c:v>
                </c:pt>
                <c:pt idx="73">
                  <c:v>1.5769850299063946E-3</c:v>
                </c:pt>
                <c:pt idx="74">
                  <c:v>2.2250406069910778E-3</c:v>
                </c:pt>
                <c:pt idx="75">
                  <c:v>2.0944636716956197E-3</c:v>
                </c:pt>
                <c:pt idx="76">
                  <c:v>2.5444035473431979E-3</c:v>
                </c:pt>
                <c:pt idx="77">
                  <c:v>1.8178422461557616E-3</c:v>
                </c:pt>
                <c:pt idx="78">
                  <c:v>1.3302464793236209E-3</c:v>
                </c:pt>
                <c:pt idx="79">
                  <c:v>1.8751640768567249E-3</c:v>
                </c:pt>
                <c:pt idx="80">
                  <c:v>1.4643237486687967E-3</c:v>
                </c:pt>
                <c:pt idx="81">
                  <c:v>1.8098745744263456E-3</c:v>
                </c:pt>
                <c:pt idx="82">
                  <c:v>2.3634037887555583E-3</c:v>
                </c:pt>
                <c:pt idx="83">
                  <c:v>1.5843804463077842E-3</c:v>
                </c:pt>
                <c:pt idx="84">
                  <c:v>1.852419800036803E-3</c:v>
                </c:pt>
                <c:pt idx="85">
                  <c:v>1.6594877551767476E-3</c:v>
                </c:pt>
                <c:pt idx="86">
                  <c:v>1.4193305281668027E-3</c:v>
                </c:pt>
                <c:pt idx="87">
                  <c:v>3.3240244173689541E-3</c:v>
                </c:pt>
                <c:pt idx="88">
                  <c:v>2.7126117868556E-3</c:v>
                </c:pt>
                <c:pt idx="89">
                  <c:v>2.4161691574089462E-3</c:v>
                </c:pt>
                <c:pt idx="90">
                  <c:v>2.1516393442622952E-3</c:v>
                </c:pt>
                <c:pt idx="91">
                  <c:v>1.5078485449905922E-3</c:v>
                </c:pt>
                <c:pt idx="92">
                  <c:v>1.2738361769474252E-3</c:v>
                </c:pt>
                <c:pt idx="93">
                  <c:v>1.6841748149225158E-3</c:v>
                </c:pt>
                <c:pt idx="94">
                  <c:v>1.5734777517564403E-3</c:v>
                </c:pt>
                <c:pt idx="95">
                  <c:v>1.7683572322201905E-3</c:v>
                </c:pt>
                <c:pt idx="96">
                  <c:v>1.7774047422145969E-3</c:v>
                </c:pt>
                <c:pt idx="97">
                  <c:v>1.2333041451352317E-3</c:v>
                </c:pt>
                <c:pt idx="98">
                  <c:v>1.7768690593547287E-3</c:v>
                </c:pt>
                <c:pt idx="99">
                  <c:v>1.001159880349185E-3</c:v>
                </c:pt>
                <c:pt idx="100">
                  <c:v>1.5049553407561482E-3</c:v>
                </c:pt>
                <c:pt idx="101">
                  <c:v>1.0411760331193137E-3</c:v>
                </c:pt>
                <c:pt idx="102">
                  <c:v>1.8139349965212205E-3</c:v>
                </c:pt>
                <c:pt idx="103">
                  <c:v>2.0902510690141182E-3</c:v>
                </c:pt>
                <c:pt idx="104">
                  <c:v>2.0576623998085895E-3</c:v>
                </c:pt>
                <c:pt idx="105">
                  <c:v>1.9363398395945638E-3</c:v>
                </c:pt>
                <c:pt idx="106">
                  <c:v>1.3310150488638408E-3</c:v>
                </c:pt>
                <c:pt idx="107">
                  <c:v>1.5157778696431032E-3</c:v>
                </c:pt>
                <c:pt idx="108">
                  <c:v>1.5028686141796202E-3</c:v>
                </c:pt>
                <c:pt idx="109">
                  <c:v>2.6794818945130284E-3</c:v>
                </c:pt>
                <c:pt idx="110">
                  <c:v>1.3448148710496063E-3</c:v>
                </c:pt>
                <c:pt idx="111">
                  <c:v>2.2446119157407221E-3</c:v>
                </c:pt>
                <c:pt idx="112">
                  <c:v>2.2958380316744379E-3</c:v>
                </c:pt>
                <c:pt idx="113">
                  <c:v>1.621069906138051E-3</c:v>
                </c:pt>
                <c:pt idx="114">
                  <c:v>1.2721899281701995E-3</c:v>
                </c:pt>
                <c:pt idx="115">
                  <c:v>1.9749835418038184E-3</c:v>
                </c:pt>
                <c:pt idx="116">
                  <c:v>1.9021739130434783E-3</c:v>
                </c:pt>
                <c:pt idx="117">
                  <c:v>2.1677460793234492E-3</c:v>
                </c:pt>
                <c:pt idx="118">
                  <c:v>1.8312029734384916E-3</c:v>
                </c:pt>
                <c:pt idx="119">
                  <c:v>2.3128832130029386E-3</c:v>
                </c:pt>
                <c:pt idx="120">
                  <c:v>2.0591972840857441E-3</c:v>
                </c:pt>
                <c:pt idx="121">
                  <c:v>2.2666581016967816E-3</c:v>
                </c:pt>
                <c:pt idx="122">
                  <c:v>1.226982955606334E-3</c:v>
                </c:pt>
                <c:pt idx="123">
                  <c:v>2.5633901282591355E-3</c:v>
                </c:pt>
                <c:pt idx="124">
                  <c:v>2.3932451328385501E-3</c:v>
                </c:pt>
                <c:pt idx="125">
                  <c:v>1.8130087868099122E-3</c:v>
                </c:pt>
                <c:pt idx="126">
                  <c:v>1.3207675789904223E-3</c:v>
                </c:pt>
                <c:pt idx="127">
                  <c:v>1.1129132445303334E-3</c:v>
                </c:pt>
                <c:pt idx="128">
                  <c:v>1.966839771570539E-3</c:v>
                </c:pt>
                <c:pt idx="129">
                  <c:v>1.8926435698989701E-3</c:v>
                </c:pt>
                <c:pt idx="130">
                  <c:v>1.6848073168774904E-3</c:v>
                </c:pt>
                <c:pt idx="131">
                  <c:v>2.1249231113347872E-3</c:v>
                </c:pt>
                <c:pt idx="132">
                  <c:v>1.6722408026755853E-3</c:v>
                </c:pt>
                <c:pt idx="133">
                  <c:v>1.929416175850271E-3</c:v>
                </c:pt>
                <c:pt idx="134">
                  <c:v>2.0832208136906186E-3</c:v>
                </c:pt>
                <c:pt idx="135">
                  <c:v>1.6099164808586221E-3</c:v>
                </c:pt>
                <c:pt idx="136">
                  <c:v>1.2492334249437846E-3</c:v>
                </c:pt>
                <c:pt idx="137">
                  <c:v>1.4763856822001288E-3</c:v>
                </c:pt>
                <c:pt idx="138">
                  <c:v>1.6537075668499905E-3</c:v>
                </c:pt>
                <c:pt idx="139">
                  <c:v>1.3685140399403357E-3</c:v>
                </c:pt>
                <c:pt idx="140">
                  <c:v>2.2069026600927046E-3</c:v>
                </c:pt>
                <c:pt idx="141">
                  <c:v>1.7079987578190853E-3</c:v>
                </c:pt>
                <c:pt idx="142">
                  <c:v>1.7963407872851598E-3</c:v>
                </c:pt>
                <c:pt idx="143">
                  <c:v>1.534383149159331E-3</c:v>
                </c:pt>
                <c:pt idx="144">
                  <c:v>2.4907395580533913E-3</c:v>
                </c:pt>
                <c:pt idx="145">
                  <c:v>1.0436720331154314E-3</c:v>
                </c:pt>
                <c:pt idx="146">
                  <c:v>1.6584826509707001E-3</c:v>
                </c:pt>
                <c:pt idx="147">
                  <c:v>1.2955541682609366E-3</c:v>
                </c:pt>
                <c:pt idx="148">
                  <c:v>1.7873985107210932E-3</c:v>
                </c:pt>
                <c:pt idx="149">
                  <c:v>2.6323736001155357E-3</c:v>
                </c:pt>
                <c:pt idx="150">
                  <c:v>1.3469147234615709E-3</c:v>
                </c:pt>
                <c:pt idx="151">
                  <c:v>1.8101250218966736E-3</c:v>
                </c:pt>
                <c:pt idx="152">
                  <c:v>1.9715297734411549E-3</c:v>
                </c:pt>
                <c:pt idx="153">
                  <c:v>2.5079250431363108E-3</c:v>
                </c:pt>
                <c:pt idx="154">
                  <c:v>1.7260140332445312E-3</c:v>
                </c:pt>
                <c:pt idx="155">
                  <c:v>1.7437365312803303E-3</c:v>
                </c:pt>
                <c:pt idx="156">
                  <c:v>1.8371264052646011E-3</c:v>
                </c:pt>
                <c:pt idx="157">
                  <c:v>1.5153992913600437E-3</c:v>
                </c:pt>
                <c:pt idx="158">
                  <c:v>2.0320517288524536E-3</c:v>
                </c:pt>
                <c:pt idx="159">
                  <c:v>2.6276699003094216E-3</c:v>
                </c:pt>
                <c:pt idx="160">
                  <c:v>1.2580629141813486E-3</c:v>
                </c:pt>
                <c:pt idx="161">
                  <c:v>2.0918831739137377E-3</c:v>
                </c:pt>
                <c:pt idx="162">
                  <c:v>1.8552976048811095E-3</c:v>
                </c:pt>
                <c:pt idx="163">
                  <c:v>1.9715212669732273E-3</c:v>
                </c:pt>
                <c:pt idx="164">
                  <c:v>1.6695030266474225E-3</c:v>
                </c:pt>
                <c:pt idx="165">
                  <c:v>1.5189300699677362E-3</c:v>
                </c:pt>
                <c:pt idx="166">
                  <c:v>1.6564383859229892E-3</c:v>
                </c:pt>
                <c:pt idx="167">
                  <c:v>1.6691212567501227E-3</c:v>
                </c:pt>
                <c:pt idx="168">
                  <c:v>9.9260455071009408E-4</c:v>
                </c:pt>
                <c:pt idx="169">
                  <c:v>1.4328351752925146E-3</c:v>
                </c:pt>
                <c:pt idx="170">
                  <c:v>1.9077901430842607E-3</c:v>
                </c:pt>
                <c:pt idx="171">
                  <c:v>2.2767223669441089E-3</c:v>
                </c:pt>
                <c:pt idx="172">
                  <c:v>2.4733343638893182E-3</c:v>
                </c:pt>
                <c:pt idx="173">
                  <c:v>1.6614391684283956E-3</c:v>
                </c:pt>
                <c:pt idx="174">
                  <c:v>1.5146237716770633E-3</c:v>
                </c:pt>
                <c:pt idx="175">
                  <c:v>2.421919990527602E-3</c:v>
                </c:pt>
                <c:pt idx="176">
                  <c:v>2.0390770823421151E-3</c:v>
                </c:pt>
                <c:pt idx="177">
                  <c:v>2.230822000303727E-3</c:v>
                </c:pt>
                <c:pt idx="178">
                  <c:v>2.1184631803628602E-3</c:v>
                </c:pt>
                <c:pt idx="179">
                  <c:v>1.8539532356278668E-3</c:v>
                </c:pt>
                <c:pt idx="180">
                  <c:v>2.0440243415284528E-3</c:v>
                </c:pt>
                <c:pt idx="181">
                  <c:v>2.1834175185303198E-3</c:v>
                </c:pt>
                <c:pt idx="182">
                  <c:v>2.0161078617706046E-3</c:v>
                </c:pt>
                <c:pt idx="183">
                  <c:v>2.1054807786470516E-3</c:v>
                </c:pt>
                <c:pt idx="184">
                  <c:v>1.9592030850986838E-3</c:v>
                </c:pt>
                <c:pt idx="185">
                  <c:v>1.9470283023792373E-3</c:v>
                </c:pt>
                <c:pt idx="186">
                  <c:v>2.5788130151753229E-3</c:v>
                </c:pt>
                <c:pt idx="187">
                  <c:v>2.6525339096341934E-3</c:v>
                </c:pt>
                <c:pt idx="188">
                  <c:v>2.4039609634948179E-3</c:v>
                </c:pt>
                <c:pt idx="189">
                  <c:v>1.2806197776378387E-3</c:v>
                </c:pt>
                <c:pt idx="190">
                  <c:v>1.9752493615906759E-3</c:v>
                </c:pt>
                <c:pt idx="191">
                  <c:v>2.9586472154577935E-3</c:v>
                </c:pt>
                <c:pt idx="192">
                  <c:v>1.5320302533260433E-3</c:v>
                </c:pt>
                <c:pt idx="193">
                  <c:v>2.0289369179812369E-3</c:v>
                </c:pt>
                <c:pt idx="194">
                  <c:v>2.2231145718758548E-3</c:v>
                </c:pt>
                <c:pt idx="195">
                  <c:v>1.7410675030043673E-3</c:v>
                </c:pt>
                <c:pt idx="196">
                  <c:v>2.1649847453649377E-3</c:v>
                </c:pt>
                <c:pt idx="197">
                  <c:v>1.5542816618403167E-3</c:v>
                </c:pt>
                <c:pt idx="198">
                  <c:v>2.3485902512694278E-3</c:v>
                </c:pt>
                <c:pt idx="199">
                  <c:v>1.5501267739338371E-3</c:v>
                </c:pt>
                <c:pt idx="200">
                  <c:v>1.2435261482119187E-3</c:v>
                </c:pt>
                <c:pt idx="201">
                  <c:v>1.4199943475953153E-3</c:v>
                </c:pt>
                <c:pt idx="202">
                  <c:v>1.3678000525014162E-3</c:v>
                </c:pt>
                <c:pt idx="203">
                  <c:v>1.4734540615048244E-3</c:v>
                </c:pt>
                <c:pt idx="204">
                  <c:v>1.7829872632344828E-3</c:v>
                </c:pt>
                <c:pt idx="205">
                  <c:v>1.4077482463478988E-3</c:v>
                </c:pt>
                <c:pt idx="206">
                  <c:v>1.9563333195757151E-3</c:v>
                </c:pt>
                <c:pt idx="207">
                  <c:v>1.9064641048555258E-3</c:v>
                </c:pt>
                <c:pt idx="208">
                  <c:v>1.3903518011375605E-3</c:v>
                </c:pt>
                <c:pt idx="209">
                  <c:v>2.4282317903767565E-3</c:v>
                </c:pt>
                <c:pt idx="210">
                  <c:v>2.4804506852770538E-3</c:v>
                </c:pt>
                <c:pt idx="211">
                  <c:v>2.3126577774765771E-3</c:v>
                </c:pt>
                <c:pt idx="212">
                  <c:v>1.6834862805017521E-3</c:v>
                </c:pt>
                <c:pt idx="213">
                  <c:v>1.5221956296479692E-3</c:v>
                </c:pt>
                <c:pt idx="214">
                  <c:v>2.4003657700220984E-3</c:v>
                </c:pt>
                <c:pt idx="215">
                  <c:v>2.2989382911543341E-3</c:v>
                </c:pt>
                <c:pt idx="216">
                  <c:v>1.4322543683758235E-3</c:v>
                </c:pt>
                <c:pt idx="217">
                  <c:v>2.1663996453150348E-3</c:v>
                </c:pt>
                <c:pt idx="218">
                  <c:v>2.9234047371509155E-3</c:v>
                </c:pt>
                <c:pt idx="219">
                  <c:v>2.3544542748384556E-3</c:v>
                </c:pt>
                <c:pt idx="220">
                  <c:v>1.581159239379187E-3</c:v>
                </c:pt>
                <c:pt idx="221">
                  <c:v>1.2422489926300186E-3</c:v>
                </c:pt>
                <c:pt idx="222">
                  <c:v>1.6714524493207045E-3</c:v>
                </c:pt>
                <c:pt idx="223">
                  <c:v>2.2153832722193122E-3</c:v>
                </c:pt>
                <c:pt idx="224">
                  <c:v>1.6916538030492059E-3</c:v>
                </c:pt>
                <c:pt idx="225">
                  <c:v>1.1591148577449948E-3</c:v>
                </c:pt>
                <c:pt idx="226">
                  <c:v>1.7069327731092437E-3</c:v>
                </c:pt>
                <c:pt idx="227">
                  <c:v>1.2661906343407507E-3</c:v>
                </c:pt>
                <c:pt idx="228">
                  <c:v>8.2615366458161222E-4</c:v>
                </c:pt>
                <c:pt idx="229">
                  <c:v>1.4590020426028597E-3</c:v>
                </c:pt>
                <c:pt idx="230">
                  <c:v>1.7635218732110871E-3</c:v>
                </c:pt>
                <c:pt idx="231">
                  <c:v>2.2944166148670883E-3</c:v>
                </c:pt>
                <c:pt idx="232">
                  <c:v>2.4372055801094926E-3</c:v>
                </c:pt>
                <c:pt idx="233">
                  <c:v>2.0262595974739903E-3</c:v>
                </c:pt>
                <c:pt idx="234">
                  <c:v>2.4120835595588825E-3</c:v>
                </c:pt>
                <c:pt idx="235">
                  <c:v>2.189530701792953E-3</c:v>
                </c:pt>
                <c:pt idx="236">
                  <c:v>1.5614880271131103E-3</c:v>
                </c:pt>
                <c:pt idx="237">
                  <c:v>1.7399103139013453E-3</c:v>
                </c:pt>
                <c:pt idx="238">
                  <c:v>1.6267109219671701E-3</c:v>
                </c:pt>
                <c:pt idx="239">
                  <c:v>1.3221755947737108E-3</c:v>
                </c:pt>
                <c:pt idx="240">
                  <c:v>1.6070350610999625E-3</c:v>
                </c:pt>
                <c:pt idx="241">
                  <c:v>2.1267197801298934E-3</c:v>
                </c:pt>
                <c:pt idx="242">
                  <c:v>1.3778195798887843E-3</c:v>
                </c:pt>
                <c:pt idx="243">
                  <c:v>2.1282443947068757E-3</c:v>
                </c:pt>
                <c:pt idx="244">
                  <c:v>1.785561237608205E-3</c:v>
                </c:pt>
                <c:pt idx="245">
                  <c:v>1.7594630580690742E-3</c:v>
                </c:pt>
                <c:pt idx="246">
                  <c:v>2.5220084112023153E-3</c:v>
                </c:pt>
                <c:pt idx="247">
                  <c:v>1.9794877245190774E-3</c:v>
                </c:pt>
                <c:pt idx="248">
                  <c:v>1.681066499863169E-3</c:v>
                </c:pt>
                <c:pt idx="249">
                  <c:v>1.1814216653575238E-3</c:v>
                </c:pt>
                <c:pt idx="250">
                  <c:v>1.7780847852227083E-3</c:v>
                </c:pt>
                <c:pt idx="251">
                  <c:v>1.6041803051481214E-3</c:v>
                </c:pt>
                <c:pt idx="252">
                  <c:v>1.9862413729614522E-3</c:v>
                </c:pt>
                <c:pt idx="253">
                  <c:v>1.6913182586962845E-3</c:v>
                </c:pt>
                <c:pt idx="254">
                  <c:v>1.1706062421341305E-3</c:v>
                </c:pt>
                <c:pt idx="255">
                  <c:v>1.1934954497985976E-3</c:v>
                </c:pt>
                <c:pt idx="256">
                  <c:v>1.2641544958175313E-3</c:v>
                </c:pt>
                <c:pt idx="257">
                  <c:v>9.3637546478520526E-4</c:v>
                </c:pt>
                <c:pt idx="258">
                  <c:v>2.0022197310667535E-3</c:v>
                </c:pt>
                <c:pt idx="259">
                  <c:v>1.7372374707109268E-3</c:v>
                </c:pt>
                <c:pt idx="260">
                  <c:v>1.8245360199581899E-3</c:v>
                </c:pt>
                <c:pt idx="261">
                  <c:v>1.8078093031815279E-3</c:v>
                </c:pt>
                <c:pt idx="262">
                  <c:v>2.3798730734360834E-3</c:v>
                </c:pt>
                <c:pt idx="263">
                  <c:v>2.0776557567253988E-3</c:v>
                </c:pt>
                <c:pt idx="264">
                  <c:v>1.7275085427734364E-3</c:v>
                </c:pt>
                <c:pt idx="265">
                  <c:v>2.0446785085516269E-3</c:v>
                </c:pt>
                <c:pt idx="266">
                  <c:v>2.3901405423111177E-3</c:v>
                </c:pt>
                <c:pt idx="267">
                  <c:v>2.1620266649955348E-3</c:v>
                </c:pt>
                <c:pt idx="268">
                  <c:v>1.1067961165048543E-3</c:v>
                </c:pt>
                <c:pt idx="269">
                  <c:v>1.1977923765122129E-3</c:v>
                </c:pt>
                <c:pt idx="270">
                  <c:v>2.0004220670734926E-3</c:v>
                </c:pt>
                <c:pt idx="271">
                  <c:v>1.7110784632843909E-3</c:v>
                </c:pt>
                <c:pt idx="272">
                  <c:v>1.7592244369228197E-3</c:v>
                </c:pt>
                <c:pt idx="273">
                  <c:v>2.634095668376012E-3</c:v>
                </c:pt>
                <c:pt idx="274">
                  <c:v>1.3547123438201211E-3</c:v>
                </c:pt>
                <c:pt idx="275">
                  <c:v>1.8687655204343617E-3</c:v>
                </c:pt>
                <c:pt idx="276">
                  <c:v>2.0439834967258411E-3</c:v>
                </c:pt>
                <c:pt idx="277">
                  <c:v>2.3003393736516519E-3</c:v>
                </c:pt>
                <c:pt idx="278">
                  <c:v>1.6866243875470232E-3</c:v>
                </c:pt>
                <c:pt idx="279">
                  <c:v>1.274164327380597E-3</c:v>
                </c:pt>
                <c:pt idx="280">
                  <c:v>2.0562135352490971E-3</c:v>
                </c:pt>
                <c:pt idx="281">
                  <c:v>2.3255542635809649E-3</c:v>
                </c:pt>
                <c:pt idx="282">
                  <c:v>1.8112829858906658E-3</c:v>
                </c:pt>
                <c:pt idx="283">
                  <c:v>1.6007849009837081E-3</c:v>
                </c:pt>
                <c:pt idx="284">
                  <c:v>1.8003913894324853E-3</c:v>
                </c:pt>
                <c:pt idx="285">
                  <c:v>1.5559508264703563E-3</c:v>
                </c:pt>
                <c:pt idx="286">
                  <c:v>2.0941935618308044E-3</c:v>
                </c:pt>
                <c:pt idx="287">
                  <c:v>1.5143988629934733E-3</c:v>
                </c:pt>
                <c:pt idx="288">
                  <c:v>8.9653008375659897E-4</c:v>
                </c:pt>
                <c:pt idx="289">
                  <c:v>1.7110705212991539E-3</c:v>
                </c:pt>
                <c:pt idx="290">
                  <c:v>2.1755383040013604E-3</c:v>
                </c:pt>
                <c:pt idx="291">
                  <c:v>1.4808390010683195E-3</c:v>
                </c:pt>
                <c:pt idx="292">
                  <c:v>1.7208117633111435E-3</c:v>
                </c:pt>
                <c:pt idx="293">
                  <c:v>2.4641933199404547E-3</c:v>
                </c:pt>
                <c:pt idx="294">
                  <c:v>1.7915681939467867E-3</c:v>
                </c:pt>
                <c:pt idx="295">
                  <c:v>1.6329376998018381E-3</c:v>
                </c:pt>
                <c:pt idx="296">
                  <c:v>1.7113836519469159E-3</c:v>
                </c:pt>
                <c:pt idx="297">
                  <c:v>2.8814979546667894E-3</c:v>
                </c:pt>
                <c:pt idx="298">
                  <c:v>2.5669233590025669E-3</c:v>
                </c:pt>
                <c:pt idx="299">
                  <c:v>1.5825441451225131E-3</c:v>
                </c:pt>
                <c:pt idx="300">
                  <c:v>1.1423117534109654E-3</c:v>
                </c:pt>
                <c:pt idx="301">
                  <c:v>1.3693732074524334E-3</c:v>
                </c:pt>
                <c:pt idx="302">
                  <c:v>1.2714751776829458E-3</c:v>
                </c:pt>
                <c:pt idx="303">
                  <c:v>1.9365351764529918E-3</c:v>
                </c:pt>
                <c:pt idx="304">
                  <c:v>2.1970787903723512E-3</c:v>
                </c:pt>
                <c:pt idx="305">
                  <c:v>1.8348472880463402E-3</c:v>
                </c:pt>
                <c:pt idx="306">
                  <c:v>1.3623672924294504E-3</c:v>
                </c:pt>
                <c:pt idx="307">
                  <c:v>1.9873921997104341E-3</c:v>
                </c:pt>
                <c:pt idx="308">
                  <c:v>1.6554057093503432E-3</c:v>
                </c:pt>
                <c:pt idx="309">
                  <c:v>1.4461609158118098E-3</c:v>
                </c:pt>
                <c:pt idx="310">
                  <c:v>1.851776759525837E-3</c:v>
                </c:pt>
                <c:pt idx="311">
                  <c:v>1.613383176179583E-3</c:v>
                </c:pt>
                <c:pt idx="312">
                  <c:v>1.2320788530465949E-3</c:v>
                </c:pt>
                <c:pt idx="313">
                  <c:v>1.7376316689226216E-3</c:v>
                </c:pt>
                <c:pt idx="314">
                  <c:v>2.6870481221255723E-3</c:v>
                </c:pt>
                <c:pt idx="315">
                  <c:v>1.5995666349819602E-3</c:v>
                </c:pt>
                <c:pt idx="316">
                  <c:v>1.8375521327992732E-3</c:v>
                </c:pt>
                <c:pt idx="317">
                  <c:v>7.5659428926776184E-4</c:v>
                </c:pt>
                <c:pt idx="318">
                  <c:v>2.7121427662699653E-3</c:v>
                </c:pt>
                <c:pt idx="319">
                  <c:v>1.5204280366929966E-3</c:v>
                </c:pt>
                <c:pt idx="320">
                  <c:v>1.1543805165086629E-3</c:v>
                </c:pt>
                <c:pt idx="321">
                  <c:v>1.6907147207695376E-3</c:v>
                </c:pt>
                <c:pt idx="322">
                  <c:v>1.2827804872145511E-3</c:v>
                </c:pt>
                <c:pt idx="323">
                  <c:v>1.3012099911464063E-3</c:v>
                </c:pt>
                <c:pt idx="324">
                  <c:v>1.1493938315864372E-3</c:v>
                </c:pt>
                <c:pt idx="325">
                  <c:v>1.6245938515371157E-3</c:v>
                </c:pt>
                <c:pt idx="326">
                  <c:v>9.0903188104668529E-4</c:v>
                </c:pt>
                <c:pt idx="327">
                  <c:v>1.4752308736317233E-3</c:v>
                </c:pt>
                <c:pt idx="328">
                  <c:v>1.7480963527006608E-3</c:v>
                </c:pt>
                <c:pt idx="329">
                  <c:v>1.3260145553225606E-3</c:v>
                </c:pt>
                <c:pt idx="330">
                  <c:v>1.8872149185938649E-3</c:v>
                </c:pt>
                <c:pt idx="331">
                  <c:v>2.4813895781637717E-3</c:v>
                </c:pt>
                <c:pt idx="332">
                  <c:v>1.0313216195569138E-3</c:v>
                </c:pt>
                <c:pt idx="333">
                  <c:v>1.3753056234718827E-3</c:v>
                </c:pt>
                <c:pt idx="334">
                  <c:v>1.5618577887381833E-3</c:v>
                </c:pt>
                <c:pt idx="335">
                  <c:v>1.9028170975077738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59A-41D5-A8EC-B43537951B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5462384"/>
        <c:axId val="535464024"/>
      </c:scatterChart>
      <c:valAx>
        <c:axId val="535462384"/>
        <c:scaling>
          <c:orientation val="minMax"/>
          <c:max val="1400"/>
          <c:min val="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35464024"/>
        <c:crosses val="autoZero"/>
        <c:crossBetween val="midCat"/>
        <c:majorUnit val="500"/>
      </c:valAx>
      <c:valAx>
        <c:axId val="5354640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U-C mutation rate</a:t>
                </a:r>
              </a:p>
            </c:rich>
          </c:tx>
          <c:layout>
            <c:manualLayout>
              <c:xMode val="edge"/>
              <c:yMode val="edge"/>
              <c:x val="5.5555555555555558E-3"/>
              <c:y val="0.261082677165354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46238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1"/>
          <c:order val="1"/>
          <c:tx>
            <c:strRef>
              <c:f>controls!$O$1</c:f>
              <c:strCache>
                <c:ptCount val="1"/>
                <c:pt idx="0">
                  <c:v>Ave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controls!$K$2:$K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O$2:$O$345</c:f>
              <c:numCache>
                <c:formatCode>General</c:formatCode>
                <c:ptCount val="344"/>
                <c:pt idx="0" formatCode="0.00">
                  <c:v>1.0648365551136858</c:v>
                </c:pt>
                <c:pt idx="1">
                  <c:v>1.06</c:v>
                </c:pt>
                <c:pt idx="2">
                  <c:v>1.06</c:v>
                </c:pt>
                <c:pt idx="3">
                  <c:v>1.06</c:v>
                </c:pt>
                <c:pt idx="4">
                  <c:v>1.06</c:v>
                </c:pt>
                <c:pt idx="5">
                  <c:v>1.06</c:v>
                </c:pt>
                <c:pt idx="6">
                  <c:v>1.06</c:v>
                </c:pt>
                <c:pt idx="7">
                  <c:v>1.06</c:v>
                </c:pt>
                <c:pt idx="8">
                  <c:v>1.06</c:v>
                </c:pt>
                <c:pt idx="9">
                  <c:v>1.06</c:v>
                </c:pt>
                <c:pt idx="10">
                  <c:v>1.06</c:v>
                </c:pt>
                <c:pt idx="11">
                  <c:v>1.06</c:v>
                </c:pt>
                <c:pt idx="12">
                  <c:v>1.06</c:v>
                </c:pt>
                <c:pt idx="13">
                  <c:v>1.06</c:v>
                </c:pt>
                <c:pt idx="14">
                  <c:v>1.06</c:v>
                </c:pt>
                <c:pt idx="15">
                  <c:v>1.06</c:v>
                </c:pt>
                <c:pt idx="16">
                  <c:v>1.06</c:v>
                </c:pt>
                <c:pt idx="17">
                  <c:v>1.06</c:v>
                </c:pt>
                <c:pt idx="18">
                  <c:v>1.06</c:v>
                </c:pt>
                <c:pt idx="19">
                  <c:v>1.06</c:v>
                </c:pt>
                <c:pt idx="20">
                  <c:v>1.06</c:v>
                </c:pt>
                <c:pt idx="21">
                  <c:v>1.06</c:v>
                </c:pt>
                <c:pt idx="22">
                  <c:v>1.06</c:v>
                </c:pt>
                <c:pt idx="23">
                  <c:v>1.06</c:v>
                </c:pt>
                <c:pt idx="24">
                  <c:v>1.06</c:v>
                </c:pt>
                <c:pt idx="25">
                  <c:v>1.06</c:v>
                </c:pt>
                <c:pt idx="26">
                  <c:v>1.06</c:v>
                </c:pt>
                <c:pt idx="27">
                  <c:v>1.06</c:v>
                </c:pt>
                <c:pt idx="28">
                  <c:v>1.06</c:v>
                </c:pt>
                <c:pt idx="29">
                  <c:v>1.06</c:v>
                </c:pt>
                <c:pt idx="30">
                  <c:v>1.06</c:v>
                </c:pt>
                <c:pt idx="31">
                  <c:v>1.06</c:v>
                </c:pt>
                <c:pt idx="32">
                  <c:v>1.06</c:v>
                </c:pt>
                <c:pt idx="33">
                  <c:v>1.06</c:v>
                </c:pt>
                <c:pt idx="34">
                  <c:v>1.06</c:v>
                </c:pt>
                <c:pt idx="35">
                  <c:v>1.06</c:v>
                </c:pt>
                <c:pt idx="36">
                  <c:v>1.06</c:v>
                </c:pt>
                <c:pt idx="37">
                  <c:v>1.06</c:v>
                </c:pt>
                <c:pt idx="38">
                  <c:v>1.06</c:v>
                </c:pt>
                <c:pt idx="39">
                  <c:v>1.06</c:v>
                </c:pt>
                <c:pt idx="40">
                  <c:v>1.06</c:v>
                </c:pt>
                <c:pt idx="41">
                  <c:v>1.06</c:v>
                </c:pt>
                <c:pt idx="42">
                  <c:v>1.06</c:v>
                </c:pt>
                <c:pt idx="43">
                  <c:v>1.06</c:v>
                </c:pt>
                <c:pt idx="44">
                  <c:v>1.06</c:v>
                </c:pt>
                <c:pt idx="45">
                  <c:v>1.06</c:v>
                </c:pt>
                <c:pt idx="46">
                  <c:v>1.06</c:v>
                </c:pt>
                <c:pt idx="47">
                  <c:v>1.06</c:v>
                </c:pt>
                <c:pt idx="48">
                  <c:v>1.06</c:v>
                </c:pt>
                <c:pt idx="49">
                  <c:v>1.06</c:v>
                </c:pt>
                <c:pt idx="50">
                  <c:v>1.06</c:v>
                </c:pt>
                <c:pt idx="51">
                  <c:v>1.06</c:v>
                </c:pt>
                <c:pt idx="52">
                  <c:v>1.06</c:v>
                </c:pt>
                <c:pt idx="53">
                  <c:v>1.06</c:v>
                </c:pt>
                <c:pt idx="54">
                  <c:v>1.06</c:v>
                </c:pt>
                <c:pt idx="55">
                  <c:v>1.06</c:v>
                </c:pt>
                <c:pt idx="56">
                  <c:v>1.06</c:v>
                </c:pt>
                <c:pt idx="57">
                  <c:v>1.06</c:v>
                </c:pt>
                <c:pt idx="58">
                  <c:v>1.06</c:v>
                </c:pt>
                <c:pt idx="59">
                  <c:v>1.06</c:v>
                </c:pt>
                <c:pt idx="60">
                  <c:v>1.06</c:v>
                </c:pt>
                <c:pt idx="61">
                  <c:v>1.06</c:v>
                </c:pt>
                <c:pt idx="62">
                  <c:v>1.06</c:v>
                </c:pt>
                <c:pt idx="63">
                  <c:v>1.06</c:v>
                </c:pt>
                <c:pt idx="64">
                  <c:v>1.06</c:v>
                </c:pt>
                <c:pt idx="65">
                  <c:v>1.06</c:v>
                </c:pt>
                <c:pt idx="66">
                  <c:v>1.06</c:v>
                </c:pt>
                <c:pt idx="67">
                  <c:v>1.06</c:v>
                </c:pt>
                <c:pt idx="68">
                  <c:v>1.06</c:v>
                </c:pt>
                <c:pt idx="69">
                  <c:v>1.06</c:v>
                </c:pt>
                <c:pt idx="70">
                  <c:v>1.06</c:v>
                </c:pt>
                <c:pt idx="71">
                  <c:v>1.06</c:v>
                </c:pt>
                <c:pt idx="72">
                  <c:v>1.06</c:v>
                </c:pt>
                <c:pt idx="73">
                  <c:v>1.06</c:v>
                </c:pt>
                <c:pt idx="74">
                  <c:v>1.06</c:v>
                </c:pt>
                <c:pt idx="75">
                  <c:v>1.06</c:v>
                </c:pt>
                <c:pt idx="76">
                  <c:v>1.06</c:v>
                </c:pt>
                <c:pt idx="77">
                  <c:v>1.06</c:v>
                </c:pt>
                <c:pt idx="78">
                  <c:v>1.06</c:v>
                </c:pt>
                <c:pt idx="79">
                  <c:v>1.06</c:v>
                </c:pt>
                <c:pt idx="80">
                  <c:v>1.06</c:v>
                </c:pt>
                <c:pt idx="81">
                  <c:v>1.06</c:v>
                </c:pt>
                <c:pt idx="82">
                  <c:v>1.06</c:v>
                </c:pt>
                <c:pt idx="83">
                  <c:v>1.06</c:v>
                </c:pt>
                <c:pt idx="84">
                  <c:v>1.06</c:v>
                </c:pt>
                <c:pt idx="85">
                  <c:v>1.06</c:v>
                </c:pt>
                <c:pt idx="86">
                  <c:v>1.06</c:v>
                </c:pt>
                <c:pt idx="87">
                  <c:v>1.06</c:v>
                </c:pt>
                <c:pt idx="88">
                  <c:v>1.06</c:v>
                </c:pt>
                <c:pt idx="89">
                  <c:v>1.06</c:v>
                </c:pt>
                <c:pt idx="90">
                  <c:v>1.06</c:v>
                </c:pt>
                <c:pt idx="91">
                  <c:v>1.06</c:v>
                </c:pt>
                <c:pt idx="92">
                  <c:v>1.06</c:v>
                </c:pt>
                <c:pt idx="93">
                  <c:v>1.06</c:v>
                </c:pt>
                <c:pt idx="94">
                  <c:v>1.06</c:v>
                </c:pt>
                <c:pt idx="95">
                  <c:v>1.06</c:v>
                </c:pt>
                <c:pt idx="96">
                  <c:v>1.06</c:v>
                </c:pt>
                <c:pt idx="97">
                  <c:v>1.06</c:v>
                </c:pt>
                <c:pt idx="98">
                  <c:v>1.06</c:v>
                </c:pt>
                <c:pt idx="99">
                  <c:v>1.06</c:v>
                </c:pt>
                <c:pt idx="100">
                  <c:v>1.06</c:v>
                </c:pt>
                <c:pt idx="101">
                  <c:v>1.06</c:v>
                </c:pt>
                <c:pt idx="102">
                  <c:v>1.06</c:v>
                </c:pt>
                <c:pt idx="103">
                  <c:v>1.06</c:v>
                </c:pt>
                <c:pt idx="104">
                  <c:v>1.06</c:v>
                </c:pt>
                <c:pt idx="105">
                  <c:v>1.06</c:v>
                </c:pt>
                <c:pt idx="106">
                  <c:v>1.06</c:v>
                </c:pt>
                <c:pt idx="107">
                  <c:v>1.06</c:v>
                </c:pt>
                <c:pt idx="108">
                  <c:v>1.06</c:v>
                </c:pt>
                <c:pt idx="109">
                  <c:v>1.06</c:v>
                </c:pt>
                <c:pt idx="110">
                  <c:v>1.06</c:v>
                </c:pt>
                <c:pt idx="111">
                  <c:v>1.06</c:v>
                </c:pt>
                <c:pt idx="112">
                  <c:v>1.06</c:v>
                </c:pt>
                <c:pt idx="113">
                  <c:v>1.06</c:v>
                </c:pt>
                <c:pt idx="114">
                  <c:v>1.06</c:v>
                </c:pt>
                <c:pt idx="115">
                  <c:v>1.06</c:v>
                </c:pt>
                <c:pt idx="116">
                  <c:v>1.06</c:v>
                </c:pt>
                <c:pt idx="117">
                  <c:v>1.06</c:v>
                </c:pt>
                <c:pt idx="118">
                  <c:v>1.06</c:v>
                </c:pt>
                <c:pt idx="119">
                  <c:v>1.06</c:v>
                </c:pt>
                <c:pt idx="120">
                  <c:v>1.06</c:v>
                </c:pt>
                <c:pt idx="121">
                  <c:v>1.06</c:v>
                </c:pt>
                <c:pt idx="122">
                  <c:v>1.06</c:v>
                </c:pt>
                <c:pt idx="123">
                  <c:v>1.06</c:v>
                </c:pt>
                <c:pt idx="124">
                  <c:v>1.06</c:v>
                </c:pt>
                <c:pt idx="125">
                  <c:v>1.06</c:v>
                </c:pt>
                <c:pt idx="126">
                  <c:v>1.06</c:v>
                </c:pt>
                <c:pt idx="127">
                  <c:v>1.06</c:v>
                </c:pt>
                <c:pt idx="128">
                  <c:v>1.06</c:v>
                </c:pt>
                <c:pt idx="129">
                  <c:v>1.06</c:v>
                </c:pt>
                <c:pt idx="130">
                  <c:v>1.06</c:v>
                </c:pt>
                <c:pt idx="131">
                  <c:v>1.06</c:v>
                </c:pt>
                <c:pt idx="132">
                  <c:v>1.06</c:v>
                </c:pt>
                <c:pt idx="133">
                  <c:v>1.06</c:v>
                </c:pt>
                <c:pt idx="134">
                  <c:v>1.06</c:v>
                </c:pt>
                <c:pt idx="135">
                  <c:v>1.06</c:v>
                </c:pt>
                <c:pt idx="136">
                  <c:v>1.06</c:v>
                </c:pt>
                <c:pt idx="137">
                  <c:v>1.06</c:v>
                </c:pt>
                <c:pt idx="138">
                  <c:v>1.06</c:v>
                </c:pt>
                <c:pt idx="139">
                  <c:v>1.06</c:v>
                </c:pt>
                <c:pt idx="140">
                  <c:v>1.06</c:v>
                </c:pt>
                <c:pt idx="141">
                  <c:v>1.06</c:v>
                </c:pt>
                <c:pt idx="142">
                  <c:v>1.06</c:v>
                </c:pt>
                <c:pt idx="143">
                  <c:v>1.06</c:v>
                </c:pt>
                <c:pt idx="144">
                  <c:v>1.06</c:v>
                </c:pt>
                <c:pt idx="145">
                  <c:v>1.06</c:v>
                </c:pt>
                <c:pt idx="146">
                  <c:v>1.06</c:v>
                </c:pt>
                <c:pt idx="147">
                  <c:v>1.06</c:v>
                </c:pt>
                <c:pt idx="148">
                  <c:v>1.06</c:v>
                </c:pt>
                <c:pt idx="149">
                  <c:v>1.06</c:v>
                </c:pt>
                <c:pt idx="150">
                  <c:v>1.06</c:v>
                </c:pt>
                <c:pt idx="151">
                  <c:v>1.06</c:v>
                </c:pt>
                <c:pt idx="152">
                  <c:v>1.06</c:v>
                </c:pt>
                <c:pt idx="153">
                  <c:v>1.06</c:v>
                </c:pt>
                <c:pt idx="154">
                  <c:v>1.06</c:v>
                </c:pt>
                <c:pt idx="155">
                  <c:v>1.06</c:v>
                </c:pt>
                <c:pt idx="156">
                  <c:v>1.06</c:v>
                </c:pt>
                <c:pt idx="157">
                  <c:v>1.06</c:v>
                </c:pt>
                <c:pt idx="158">
                  <c:v>1.06</c:v>
                </c:pt>
                <c:pt idx="159">
                  <c:v>1.06</c:v>
                </c:pt>
                <c:pt idx="160">
                  <c:v>1.06</c:v>
                </c:pt>
                <c:pt idx="161">
                  <c:v>1.06</c:v>
                </c:pt>
                <c:pt idx="162">
                  <c:v>1.06</c:v>
                </c:pt>
                <c:pt idx="163">
                  <c:v>1.06</c:v>
                </c:pt>
                <c:pt idx="164">
                  <c:v>1.06</c:v>
                </c:pt>
                <c:pt idx="165">
                  <c:v>1.06</c:v>
                </c:pt>
                <c:pt idx="166">
                  <c:v>1.06</c:v>
                </c:pt>
                <c:pt idx="167">
                  <c:v>1.06</c:v>
                </c:pt>
                <c:pt idx="168">
                  <c:v>1.06</c:v>
                </c:pt>
                <c:pt idx="169">
                  <c:v>1.06</c:v>
                </c:pt>
                <c:pt idx="170">
                  <c:v>1.06</c:v>
                </c:pt>
                <c:pt idx="171">
                  <c:v>1.06</c:v>
                </c:pt>
                <c:pt idx="172">
                  <c:v>1.06</c:v>
                </c:pt>
                <c:pt idx="173">
                  <c:v>1.06</c:v>
                </c:pt>
                <c:pt idx="174">
                  <c:v>1.06</c:v>
                </c:pt>
                <c:pt idx="175">
                  <c:v>1.06</c:v>
                </c:pt>
                <c:pt idx="176">
                  <c:v>1.06</c:v>
                </c:pt>
                <c:pt idx="177">
                  <c:v>1.06</c:v>
                </c:pt>
                <c:pt idx="178">
                  <c:v>1.06</c:v>
                </c:pt>
                <c:pt idx="179">
                  <c:v>1.06</c:v>
                </c:pt>
                <c:pt idx="180">
                  <c:v>1.06</c:v>
                </c:pt>
                <c:pt idx="181">
                  <c:v>1.06</c:v>
                </c:pt>
                <c:pt idx="182">
                  <c:v>1.06</c:v>
                </c:pt>
                <c:pt idx="183">
                  <c:v>1.06</c:v>
                </c:pt>
                <c:pt idx="184">
                  <c:v>1.06</c:v>
                </c:pt>
                <c:pt idx="185">
                  <c:v>1.06</c:v>
                </c:pt>
                <c:pt idx="186">
                  <c:v>1.06</c:v>
                </c:pt>
                <c:pt idx="187">
                  <c:v>1.06</c:v>
                </c:pt>
                <c:pt idx="188">
                  <c:v>1.06</c:v>
                </c:pt>
                <c:pt idx="189">
                  <c:v>1.06</c:v>
                </c:pt>
                <c:pt idx="190">
                  <c:v>1.06</c:v>
                </c:pt>
                <c:pt idx="191">
                  <c:v>1.06</c:v>
                </c:pt>
                <c:pt idx="192">
                  <c:v>1.06</c:v>
                </c:pt>
                <c:pt idx="193">
                  <c:v>1.06</c:v>
                </c:pt>
                <c:pt idx="194">
                  <c:v>1.06</c:v>
                </c:pt>
                <c:pt idx="195">
                  <c:v>1.06</c:v>
                </c:pt>
                <c:pt idx="196">
                  <c:v>1.06</c:v>
                </c:pt>
                <c:pt idx="197">
                  <c:v>1.06</c:v>
                </c:pt>
                <c:pt idx="198">
                  <c:v>1.06</c:v>
                </c:pt>
                <c:pt idx="199">
                  <c:v>1.06</c:v>
                </c:pt>
                <c:pt idx="200">
                  <c:v>1.06</c:v>
                </c:pt>
                <c:pt idx="201">
                  <c:v>1.06</c:v>
                </c:pt>
                <c:pt idx="202">
                  <c:v>1.06</c:v>
                </c:pt>
                <c:pt idx="203">
                  <c:v>1.06</c:v>
                </c:pt>
                <c:pt idx="204">
                  <c:v>1.06</c:v>
                </c:pt>
                <c:pt idx="205">
                  <c:v>1.06</c:v>
                </c:pt>
                <c:pt idx="206">
                  <c:v>1.06</c:v>
                </c:pt>
                <c:pt idx="207">
                  <c:v>1.06</c:v>
                </c:pt>
                <c:pt idx="208">
                  <c:v>1.06</c:v>
                </c:pt>
                <c:pt idx="209">
                  <c:v>1.06</c:v>
                </c:pt>
                <c:pt idx="210">
                  <c:v>1.06</c:v>
                </c:pt>
                <c:pt idx="211">
                  <c:v>1.06</c:v>
                </c:pt>
                <c:pt idx="212">
                  <c:v>1.06</c:v>
                </c:pt>
                <c:pt idx="213">
                  <c:v>1.06</c:v>
                </c:pt>
                <c:pt idx="214">
                  <c:v>1.06</c:v>
                </c:pt>
                <c:pt idx="215">
                  <c:v>1.06</c:v>
                </c:pt>
                <c:pt idx="216">
                  <c:v>1.06</c:v>
                </c:pt>
                <c:pt idx="217">
                  <c:v>1.06</c:v>
                </c:pt>
                <c:pt idx="218">
                  <c:v>1.06</c:v>
                </c:pt>
                <c:pt idx="219">
                  <c:v>1.06</c:v>
                </c:pt>
                <c:pt idx="220">
                  <c:v>1.06</c:v>
                </c:pt>
                <c:pt idx="221">
                  <c:v>1.06</c:v>
                </c:pt>
                <c:pt idx="222">
                  <c:v>1.06</c:v>
                </c:pt>
                <c:pt idx="223">
                  <c:v>1.06</c:v>
                </c:pt>
                <c:pt idx="224">
                  <c:v>1.06</c:v>
                </c:pt>
                <c:pt idx="225">
                  <c:v>1.06</c:v>
                </c:pt>
                <c:pt idx="226">
                  <c:v>1.06</c:v>
                </c:pt>
                <c:pt idx="227">
                  <c:v>1.06</c:v>
                </c:pt>
                <c:pt idx="228">
                  <c:v>1.06</c:v>
                </c:pt>
                <c:pt idx="229">
                  <c:v>1.06</c:v>
                </c:pt>
                <c:pt idx="230">
                  <c:v>1.06</c:v>
                </c:pt>
                <c:pt idx="231">
                  <c:v>1.06</c:v>
                </c:pt>
                <c:pt idx="232">
                  <c:v>1.06</c:v>
                </c:pt>
                <c:pt idx="233">
                  <c:v>1.06</c:v>
                </c:pt>
                <c:pt idx="234">
                  <c:v>1.06</c:v>
                </c:pt>
                <c:pt idx="235">
                  <c:v>1.06</c:v>
                </c:pt>
                <c:pt idx="236">
                  <c:v>1.06</c:v>
                </c:pt>
                <c:pt idx="237">
                  <c:v>1.06</c:v>
                </c:pt>
                <c:pt idx="238">
                  <c:v>1.06</c:v>
                </c:pt>
                <c:pt idx="239">
                  <c:v>1.06</c:v>
                </c:pt>
                <c:pt idx="240">
                  <c:v>1.06</c:v>
                </c:pt>
                <c:pt idx="241">
                  <c:v>1.06</c:v>
                </c:pt>
                <c:pt idx="242">
                  <c:v>1.06</c:v>
                </c:pt>
                <c:pt idx="243">
                  <c:v>1.06</c:v>
                </c:pt>
                <c:pt idx="244">
                  <c:v>1.06</c:v>
                </c:pt>
                <c:pt idx="245">
                  <c:v>1.06</c:v>
                </c:pt>
                <c:pt idx="246">
                  <c:v>1.06</c:v>
                </c:pt>
                <c:pt idx="247">
                  <c:v>1.06</c:v>
                </c:pt>
                <c:pt idx="248">
                  <c:v>1.06</c:v>
                </c:pt>
                <c:pt idx="249">
                  <c:v>1.06</c:v>
                </c:pt>
                <c:pt idx="250">
                  <c:v>1.06</c:v>
                </c:pt>
                <c:pt idx="251">
                  <c:v>1.06</c:v>
                </c:pt>
                <c:pt idx="252">
                  <c:v>1.06</c:v>
                </c:pt>
                <c:pt idx="253">
                  <c:v>1.06</c:v>
                </c:pt>
                <c:pt idx="254">
                  <c:v>1.06</c:v>
                </c:pt>
                <c:pt idx="255">
                  <c:v>1.06</c:v>
                </c:pt>
                <c:pt idx="256">
                  <c:v>1.06</c:v>
                </c:pt>
                <c:pt idx="257">
                  <c:v>1.06</c:v>
                </c:pt>
                <c:pt idx="258">
                  <c:v>1.06</c:v>
                </c:pt>
                <c:pt idx="259">
                  <c:v>1.06</c:v>
                </c:pt>
                <c:pt idx="260">
                  <c:v>1.06</c:v>
                </c:pt>
                <c:pt idx="261">
                  <c:v>1.06</c:v>
                </c:pt>
                <c:pt idx="262">
                  <c:v>1.06</c:v>
                </c:pt>
                <c:pt idx="263">
                  <c:v>1.06</c:v>
                </c:pt>
                <c:pt idx="264">
                  <c:v>1.06</c:v>
                </c:pt>
                <c:pt idx="265">
                  <c:v>1.06</c:v>
                </c:pt>
                <c:pt idx="266">
                  <c:v>1.06</c:v>
                </c:pt>
                <c:pt idx="267">
                  <c:v>1.06</c:v>
                </c:pt>
                <c:pt idx="268">
                  <c:v>1.06</c:v>
                </c:pt>
                <c:pt idx="269">
                  <c:v>1.06</c:v>
                </c:pt>
                <c:pt idx="270">
                  <c:v>1.06</c:v>
                </c:pt>
                <c:pt idx="271">
                  <c:v>1.06</c:v>
                </c:pt>
                <c:pt idx="272">
                  <c:v>1.06</c:v>
                </c:pt>
                <c:pt idx="273">
                  <c:v>1.06</c:v>
                </c:pt>
                <c:pt idx="274">
                  <c:v>1.06</c:v>
                </c:pt>
                <c:pt idx="275">
                  <c:v>1.06</c:v>
                </c:pt>
                <c:pt idx="276">
                  <c:v>1.06</c:v>
                </c:pt>
                <c:pt idx="277">
                  <c:v>1.06</c:v>
                </c:pt>
                <c:pt idx="278">
                  <c:v>1.06</c:v>
                </c:pt>
                <c:pt idx="279">
                  <c:v>1.06</c:v>
                </c:pt>
                <c:pt idx="280">
                  <c:v>1.06</c:v>
                </c:pt>
                <c:pt idx="281">
                  <c:v>1.06</c:v>
                </c:pt>
                <c:pt idx="282">
                  <c:v>1.06</c:v>
                </c:pt>
                <c:pt idx="283">
                  <c:v>1.06</c:v>
                </c:pt>
                <c:pt idx="284">
                  <c:v>1.06</c:v>
                </c:pt>
                <c:pt idx="285">
                  <c:v>1.06</c:v>
                </c:pt>
                <c:pt idx="286">
                  <c:v>1.06</c:v>
                </c:pt>
                <c:pt idx="287">
                  <c:v>1.06</c:v>
                </c:pt>
                <c:pt idx="288">
                  <c:v>1.06</c:v>
                </c:pt>
                <c:pt idx="289">
                  <c:v>1.06</c:v>
                </c:pt>
                <c:pt idx="290">
                  <c:v>1.06</c:v>
                </c:pt>
                <c:pt idx="291">
                  <c:v>1.06</c:v>
                </c:pt>
                <c:pt idx="292">
                  <c:v>1.06</c:v>
                </c:pt>
                <c:pt idx="293">
                  <c:v>1.06</c:v>
                </c:pt>
                <c:pt idx="294">
                  <c:v>1.06</c:v>
                </c:pt>
                <c:pt idx="295">
                  <c:v>1.06</c:v>
                </c:pt>
                <c:pt idx="296">
                  <c:v>1.06</c:v>
                </c:pt>
                <c:pt idx="297">
                  <c:v>1.06</c:v>
                </c:pt>
                <c:pt idx="298">
                  <c:v>1.06</c:v>
                </c:pt>
                <c:pt idx="299">
                  <c:v>1.06</c:v>
                </c:pt>
                <c:pt idx="300">
                  <c:v>1.06</c:v>
                </c:pt>
                <c:pt idx="301">
                  <c:v>1.06</c:v>
                </c:pt>
                <c:pt idx="302">
                  <c:v>1.06</c:v>
                </c:pt>
                <c:pt idx="303">
                  <c:v>1.06</c:v>
                </c:pt>
                <c:pt idx="304">
                  <c:v>1.06</c:v>
                </c:pt>
                <c:pt idx="305">
                  <c:v>1.06</c:v>
                </c:pt>
                <c:pt idx="306">
                  <c:v>1.06</c:v>
                </c:pt>
                <c:pt idx="307">
                  <c:v>1.06</c:v>
                </c:pt>
                <c:pt idx="308">
                  <c:v>1.06</c:v>
                </c:pt>
                <c:pt idx="309">
                  <c:v>1.06</c:v>
                </c:pt>
                <c:pt idx="310">
                  <c:v>1.06</c:v>
                </c:pt>
                <c:pt idx="311">
                  <c:v>1.06</c:v>
                </c:pt>
                <c:pt idx="312">
                  <c:v>1.06</c:v>
                </c:pt>
                <c:pt idx="313">
                  <c:v>1.06</c:v>
                </c:pt>
                <c:pt idx="314">
                  <c:v>1.06</c:v>
                </c:pt>
                <c:pt idx="315">
                  <c:v>1.06</c:v>
                </c:pt>
                <c:pt idx="316">
                  <c:v>1.06</c:v>
                </c:pt>
                <c:pt idx="317">
                  <c:v>1.06</c:v>
                </c:pt>
                <c:pt idx="318">
                  <c:v>1.06</c:v>
                </c:pt>
                <c:pt idx="319">
                  <c:v>1.06</c:v>
                </c:pt>
                <c:pt idx="320">
                  <c:v>1.06</c:v>
                </c:pt>
                <c:pt idx="321">
                  <c:v>1.06</c:v>
                </c:pt>
                <c:pt idx="322">
                  <c:v>1.06</c:v>
                </c:pt>
                <c:pt idx="323">
                  <c:v>1.06</c:v>
                </c:pt>
                <c:pt idx="324">
                  <c:v>1.06</c:v>
                </c:pt>
                <c:pt idx="325">
                  <c:v>1.06</c:v>
                </c:pt>
                <c:pt idx="326">
                  <c:v>1.06</c:v>
                </c:pt>
                <c:pt idx="327">
                  <c:v>1.06</c:v>
                </c:pt>
                <c:pt idx="328">
                  <c:v>1.06</c:v>
                </c:pt>
                <c:pt idx="329">
                  <c:v>1.06</c:v>
                </c:pt>
                <c:pt idx="330">
                  <c:v>1.06</c:v>
                </c:pt>
                <c:pt idx="331">
                  <c:v>1.06</c:v>
                </c:pt>
                <c:pt idx="332">
                  <c:v>1.06</c:v>
                </c:pt>
                <c:pt idx="333">
                  <c:v>1.06</c:v>
                </c:pt>
                <c:pt idx="334">
                  <c:v>1.06</c:v>
                </c:pt>
                <c:pt idx="335">
                  <c:v>1.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C00-401C-8B4E-6A0590530E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6445192"/>
        <c:axId val="726445848"/>
      </c:scatterChart>
      <c:scatterChart>
        <c:scatterStyle val="lineMarker"/>
        <c:varyColors val="0"/>
        <c:ser>
          <c:idx val="0"/>
          <c:order val="0"/>
          <c:tx>
            <c:strRef>
              <c:f>controls!$N$1</c:f>
              <c:strCache>
                <c:ptCount val="1"/>
                <c:pt idx="0">
                  <c:v>3B/4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controls!$K$2:$K$345</c:f>
              <c:numCache>
                <c:formatCode>General</c:formatCode>
                <c:ptCount val="344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controls!$N$2:$N$345</c:f>
              <c:numCache>
                <c:formatCode>0.00</c:formatCode>
                <c:ptCount val="344"/>
                <c:pt idx="0">
                  <c:v>1.3585570688829904</c:v>
                </c:pt>
                <c:pt idx="1">
                  <c:v>1.016194140780402</c:v>
                </c:pt>
                <c:pt idx="2">
                  <c:v>0.90361017583239811</c:v>
                </c:pt>
                <c:pt idx="3">
                  <c:v>1.0524462748067342</c:v>
                </c:pt>
                <c:pt idx="4">
                  <c:v>1.1275702028618251</c:v>
                </c:pt>
                <c:pt idx="5">
                  <c:v>1.12791399281108</c:v>
                </c:pt>
                <c:pt idx="6">
                  <c:v>1.2437722039937824</c:v>
                </c:pt>
                <c:pt idx="7">
                  <c:v>1.2182818319030941</c:v>
                </c:pt>
                <c:pt idx="8">
                  <c:v>0.97769992901249891</c:v>
                </c:pt>
                <c:pt idx="9">
                  <c:v>1.1020199021022916</c:v>
                </c:pt>
                <c:pt idx="10">
                  <c:v>1.1012542791037161</c:v>
                </c:pt>
                <c:pt idx="11">
                  <c:v>1.0407014502507368</c:v>
                </c:pt>
                <c:pt idx="12">
                  <c:v>0.9453553671013154</c:v>
                </c:pt>
                <c:pt idx="13">
                  <c:v>0.91649189128344144</c:v>
                </c:pt>
                <c:pt idx="14">
                  <c:v>1.2209237603598622</c:v>
                </c:pt>
                <c:pt idx="15">
                  <c:v>0.95174350434238675</c:v>
                </c:pt>
                <c:pt idx="16">
                  <c:v>1.0873923266129839</c:v>
                </c:pt>
                <c:pt idx="17">
                  <c:v>1.055058964132412</c:v>
                </c:pt>
                <c:pt idx="18">
                  <c:v>1.0575687126897237</c:v>
                </c:pt>
                <c:pt idx="19">
                  <c:v>1.0688880817455706</c:v>
                </c:pt>
                <c:pt idx="20">
                  <c:v>1.084451426433336</c:v>
                </c:pt>
                <c:pt idx="21">
                  <c:v>1.1139378968825695</c:v>
                </c:pt>
                <c:pt idx="22">
                  <c:v>1.0327445099248886</c:v>
                </c:pt>
                <c:pt idx="23">
                  <c:v>1.1149140219472891</c:v>
                </c:pt>
                <c:pt idx="24">
                  <c:v>1.0468352400202148</c:v>
                </c:pt>
                <c:pt idx="25">
                  <c:v>1.0790655751078821</c:v>
                </c:pt>
                <c:pt idx="26">
                  <c:v>1.1873709855792751</c:v>
                </c:pt>
                <c:pt idx="27">
                  <c:v>1.0704027522343471</c:v>
                </c:pt>
                <c:pt idx="28">
                  <c:v>1.1348237854676746</c:v>
                </c:pt>
                <c:pt idx="29">
                  <c:v>1.0888238304241575</c:v>
                </c:pt>
                <c:pt idx="30">
                  <c:v>0.96574330655017426</c:v>
                </c:pt>
                <c:pt idx="31">
                  <c:v>1.0928054045113396</c:v>
                </c:pt>
                <c:pt idx="32">
                  <c:v>1.0881623331985513</c:v>
                </c:pt>
                <c:pt idx="33">
                  <c:v>1.1430977157533895</c:v>
                </c:pt>
                <c:pt idx="34">
                  <c:v>0.91597088135480598</c:v>
                </c:pt>
                <c:pt idx="35">
                  <c:v>1.1205704184126617</c:v>
                </c:pt>
                <c:pt idx="36">
                  <c:v>1.0177367136593563</c:v>
                </c:pt>
                <c:pt idx="37">
                  <c:v>1.0082599245332753</c:v>
                </c:pt>
                <c:pt idx="38">
                  <c:v>1.1994929666563841</c:v>
                </c:pt>
                <c:pt idx="39">
                  <c:v>1.0810844118403808</c:v>
                </c:pt>
                <c:pt idx="40">
                  <c:v>1.0120782916505484</c:v>
                </c:pt>
                <c:pt idx="41">
                  <c:v>1.116835985808968</c:v>
                </c:pt>
                <c:pt idx="42">
                  <c:v>1.0384315757590221</c:v>
                </c:pt>
                <c:pt idx="43">
                  <c:v>1.2466164033101772</c:v>
                </c:pt>
                <c:pt idx="44">
                  <c:v>1.0135231293460614</c:v>
                </c:pt>
                <c:pt idx="45">
                  <c:v>1.0419338218884413</c:v>
                </c:pt>
                <c:pt idx="46">
                  <c:v>1.0509790652526358</c:v>
                </c:pt>
                <c:pt idx="47">
                  <c:v>1.02940829068599</c:v>
                </c:pt>
                <c:pt idx="48">
                  <c:v>1.1257742056661222</c:v>
                </c:pt>
                <c:pt idx="49">
                  <c:v>0.97867746476806494</c:v>
                </c:pt>
                <c:pt idx="50">
                  <c:v>1.001692323944243</c:v>
                </c:pt>
                <c:pt idx="51">
                  <c:v>1.0792110105573569</c:v>
                </c:pt>
                <c:pt idx="52">
                  <c:v>1.2272008039615749</c:v>
                </c:pt>
                <c:pt idx="53">
                  <c:v>1.0863246949126149</c:v>
                </c:pt>
                <c:pt idx="54">
                  <c:v>1.0657688672002898</c:v>
                </c:pt>
                <c:pt idx="55">
                  <c:v>1.0517760296287268</c:v>
                </c:pt>
                <c:pt idx="56">
                  <c:v>0.90284639972588809</c:v>
                </c:pt>
                <c:pt idx="57">
                  <c:v>0.9790665448794803</c:v>
                </c:pt>
                <c:pt idx="58">
                  <c:v>1.049842346241997</c:v>
                </c:pt>
                <c:pt idx="59">
                  <c:v>0.96906836561043641</c:v>
                </c:pt>
                <c:pt idx="60">
                  <c:v>1.0374199995221305</c:v>
                </c:pt>
                <c:pt idx="61">
                  <c:v>0.93263286311677107</c:v>
                </c:pt>
                <c:pt idx="62">
                  <c:v>1.0602532148398538</c:v>
                </c:pt>
                <c:pt idx="63">
                  <c:v>0.90298191116406445</c:v>
                </c:pt>
                <c:pt idx="64">
                  <c:v>1.1390994937485881</c:v>
                </c:pt>
                <c:pt idx="65">
                  <c:v>0.97901309691384719</c:v>
                </c:pt>
                <c:pt idx="66">
                  <c:v>1.02288469757408</c:v>
                </c:pt>
                <c:pt idx="67">
                  <c:v>1.2788947987956749</c:v>
                </c:pt>
                <c:pt idx="68">
                  <c:v>1.1229277155206931</c:v>
                </c:pt>
                <c:pt idx="69">
                  <c:v>1.1432757778767904</c:v>
                </c:pt>
                <c:pt idx="70">
                  <c:v>1.2650625271071274</c:v>
                </c:pt>
                <c:pt idx="71">
                  <c:v>1.0482578622995424</c:v>
                </c:pt>
                <c:pt idx="72">
                  <c:v>1.2497266037821326</c:v>
                </c:pt>
                <c:pt idx="73">
                  <c:v>0.78662567119743398</c:v>
                </c:pt>
                <c:pt idx="74">
                  <c:v>1.0636385779436153</c:v>
                </c:pt>
                <c:pt idx="75">
                  <c:v>0.97247715652590605</c:v>
                </c:pt>
                <c:pt idx="76">
                  <c:v>0.88332659899218147</c:v>
                </c:pt>
                <c:pt idx="77">
                  <c:v>0.98896913458909763</c:v>
                </c:pt>
                <c:pt idx="78">
                  <c:v>1.0698030072797124</c:v>
                </c:pt>
                <c:pt idx="79">
                  <c:v>0.83142922696299981</c:v>
                </c:pt>
                <c:pt idx="80">
                  <c:v>1.2014644310212237</c:v>
                </c:pt>
                <c:pt idx="81">
                  <c:v>1.0030195713217245</c:v>
                </c:pt>
                <c:pt idx="82">
                  <c:v>0.96958007678742375</c:v>
                </c:pt>
                <c:pt idx="83">
                  <c:v>1.3543908747985902</c:v>
                </c:pt>
                <c:pt idx="84">
                  <c:v>1.0737653740089101</c:v>
                </c:pt>
                <c:pt idx="85">
                  <c:v>1.125024577942771</c:v>
                </c:pt>
                <c:pt idx="86">
                  <c:v>0.90722431964851125</c:v>
                </c:pt>
                <c:pt idx="87">
                  <c:v>1.0056786164345486</c:v>
                </c:pt>
                <c:pt idx="88">
                  <c:v>0.86431421374527961</c:v>
                </c:pt>
                <c:pt idx="89">
                  <c:v>0.99660241936280158</c:v>
                </c:pt>
                <c:pt idx="90">
                  <c:v>0.86084073092696667</c:v>
                </c:pt>
                <c:pt idx="91">
                  <c:v>1.069263930711176</c:v>
                </c:pt>
                <c:pt idx="92">
                  <c:v>1.0834677457537776</c:v>
                </c:pt>
                <c:pt idx="93">
                  <c:v>1.2261613795304909</c:v>
                </c:pt>
                <c:pt idx="94">
                  <c:v>0.94916667080147465</c:v>
                </c:pt>
                <c:pt idx="95">
                  <c:v>1.0324260704152979</c:v>
                </c:pt>
                <c:pt idx="96">
                  <c:v>1.0961894045270197</c:v>
                </c:pt>
                <c:pt idx="97">
                  <c:v>1.2062649899313691</c:v>
                </c:pt>
                <c:pt idx="98">
                  <c:v>1.1146179291142193</c:v>
                </c:pt>
                <c:pt idx="99">
                  <c:v>0.99127896421986006</c:v>
                </c:pt>
                <c:pt idx="100">
                  <c:v>0.9811790914519315</c:v>
                </c:pt>
                <c:pt idx="101">
                  <c:v>1.3051111297095774</c:v>
                </c:pt>
                <c:pt idx="102">
                  <c:v>0.89494021760690512</c:v>
                </c:pt>
                <c:pt idx="103">
                  <c:v>1.0317164332656836</c:v>
                </c:pt>
                <c:pt idx="104">
                  <c:v>1.0640768017536602</c:v>
                </c:pt>
                <c:pt idx="105">
                  <c:v>1.223315467361447</c:v>
                </c:pt>
                <c:pt idx="106">
                  <c:v>1.1925779459954635</c:v>
                </c:pt>
                <c:pt idx="107">
                  <c:v>1.0887083121719991</c:v>
                </c:pt>
                <c:pt idx="108">
                  <c:v>1.0651010363965341</c:v>
                </c:pt>
                <c:pt idx="109">
                  <c:v>0.91708782681364165</c:v>
                </c:pt>
                <c:pt idx="110">
                  <c:v>1.2019948861907452</c:v>
                </c:pt>
                <c:pt idx="111">
                  <c:v>1.1518349058316644</c:v>
                </c:pt>
                <c:pt idx="112">
                  <c:v>0.94640317906505089</c:v>
                </c:pt>
                <c:pt idx="113">
                  <c:v>1.1215316875955532</c:v>
                </c:pt>
                <c:pt idx="114">
                  <c:v>1.0876284668707039</c:v>
                </c:pt>
                <c:pt idx="115">
                  <c:v>0.96189833587722917</c:v>
                </c:pt>
                <c:pt idx="116">
                  <c:v>1.0648386687276448</c:v>
                </c:pt>
                <c:pt idx="117">
                  <c:v>0.98114656059465377</c:v>
                </c:pt>
                <c:pt idx="118">
                  <c:v>0.98291802289515395</c:v>
                </c:pt>
                <c:pt idx="119">
                  <c:v>1.0496132915996854</c:v>
                </c:pt>
                <c:pt idx="120">
                  <c:v>1.0384249692837091</c:v>
                </c:pt>
                <c:pt idx="121">
                  <c:v>0.94013441408123377</c:v>
                </c:pt>
                <c:pt idx="122">
                  <c:v>0.8547291187769801</c:v>
                </c:pt>
                <c:pt idx="123">
                  <c:v>1.1431620573072918</c:v>
                </c:pt>
                <c:pt idx="124">
                  <c:v>0.92983223542719529</c:v>
                </c:pt>
                <c:pt idx="125">
                  <c:v>1.0715677680779487</c:v>
                </c:pt>
                <c:pt idx="126">
                  <c:v>1.2130377924870293</c:v>
                </c:pt>
                <c:pt idx="127">
                  <c:v>1.046471142288329</c:v>
                </c:pt>
                <c:pt idx="128">
                  <c:v>1.0237359478083874</c:v>
                </c:pt>
                <c:pt idx="129">
                  <c:v>1.0373957276041221</c:v>
                </c:pt>
                <c:pt idx="130">
                  <c:v>0.8789704327815433</c:v>
                </c:pt>
                <c:pt idx="131">
                  <c:v>1.0367788483524731</c:v>
                </c:pt>
                <c:pt idx="132">
                  <c:v>1.168199477600474</c:v>
                </c:pt>
                <c:pt idx="133">
                  <c:v>1.1343970185756711</c:v>
                </c:pt>
                <c:pt idx="134">
                  <c:v>1.1261864626842248</c:v>
                </c:pt>
                <c:pt idx="135">
                  <c:v>0.86548758019564942</c:v>
                </c:pt>
                <c:pt idx="136">
                  <c:v>1.1719969599234579</c:v>
                </c:pt>
                <c:pt idx="137">
                  <c:v>1.08741065594043</c:v>
                </c:pt>
                <c:pt idx="138">
                  <c:v>1.1696982000547793</c:v>
                </c:pt>
                <c:pt idx="139">
                  <c:v>0.99891027522165143</c:v>
                </c:pt>
                <c:pt idx="140">
                  <c:v>0.89755856085854757</c:v>
                </c:pt>
                <c:pt idx="141">
                  <c:v>1.0370614975682657</c:v>
                </c:pt>
                <c:pt idx="142">
                  <c:v>0.98881810032739714</c:v>
                </c:pt>
                <c:pt idx="143">
                  <c:v>1.0695119914535476</c:v>
                </c:pt>
                <c:pt idx="144">
                  <c:v>1.0175597541978458</c:v>
                </c:pt>
                <c:pt idx="145">
                  <c:v>1.0838701427977706</c:v>
                </c:pt>
                <c:pt idx="146">
                  <c:v>0.90980055549133443</c:v>
                </c:pt>
                <c:pt idx="147">
                  <c:v>0.9738670160298758</c:v>
                </c:pt>
                <c:pt idx="148">
                  <c:v>1.1979369709008203</c:v>
                </c:pt>
                <c:pt idx="149">
                  <c:v>0.98144190562904032</c:v>
                </c:pt>
                <c:pt idx="150">
                  <c:v>1.083767860581121</c:v>
                </c:pt>
                <c:pt idx="151">
                  <c:v>1.0746185557358321</c:v>
                </c:pt>
                <c:pt idx="152">
                  <c:v>0.99976660935638351</c:v>
                </c:pt>
                <c:pt idx="153">
                  <c:v>0.92298311039543268</c:v>
                </c:pt>
                <c:pt idx="154">
                  <c:v>1.0383672662946535</c:v>
                </c:pt>
                <c:pt idx="155">
                  <c:v>1.0203077750033465</c:v>
                </c:pt>
                <c:pt idx="156">
                  <c:v>1.0050383357661399</c:v>
                </c:pt>
                <c:pt idx="157">
                  <c:v>1.0227374000767282</c:v>
                </c:pt>
                <c:pt idx="158">
                  <c:v>1.0434915131117941</c:v>
                </c:pt>
                <c:pt idx="159">
                  <c:v>0.93978003233236118</c:v>
                </c:pt>
                <c:pt idx="160">
                  <c:v>1.0989354361880903</c:v>
                </c:pt>
                <c:pt idx="161">
                  <c:v>1.1805206632714549</c:v>
                </c:pt>
                <c:pt idx="162">
                  <c:v>1.0675292080492733</c:v>
                </c:pt>
                <c:pt idx="163">
                  <c:v>0.93129087788476583</c:v>
                </c:pt>
                <c:pt idx="164">
                  <c:v>1.0074574514524977</c:v>
                </c:pt>
                <c:pt idx="165">
                  <c:v>1.0783897621225855</c:v>
                </c:pt>
                <c:pt idx="166">
                  <c:v>1.0216637629599123</c:v>
                </c:pt>
                <c:pt idx="167">
                  <c:v>1.0122113582443524</c:v>
                </c:pt>
                <c:pt idx="168">
                  <c:v>1.0537283485593425</c:v>
                </c:pt>
                <c:pt idx="169">
                  <c:v>0.99760827833394838</c:v>
                </c:pt>
                <c:pt idx="170">
                  <c:v>1.022494518157812</c:v>
                </c:pt>
                <c:pt idx="171">
                  <c:v>1.0524149300039629</c:v>
                </c:pt>
                <c:pt idx="172">
                  <c:v>0.91278192964371796</c:v>
                </c:pt>
                <c:pt idx="173">
                  <c:v>0.94707817567713304</c:v>
                </c:pt>
                <c:pt idx="174">
                  <c:v>0.87045250030497434</c:v>
                </c:pt>
                <c:pt idx="175">
                  <c:v>1.1191241626659589</c:v>
                </c:pt>
                <c:pt idx="176">
                  <c:v>1.0172714575036379</c:v>
                </c:pt>
                <c:pt idx="177">
                  <c:v>1.0588408822544744</c:v>
                </c:pt>
                <c:pt idx="178">
                  <c:v>1.0595456514459825</c:v>
                </c:pt>
                <c:pt idx="179">
                  <c:v>1.0333991876279538</c:v>
                </c:pt>
                <c:pt idx="180">
                  <c:v>1.0959243039353308</c:v>
                </c:pt>
                <c:pt idx="181">
                  <c:v>1.352927209057962</c:v>
                </c:pt>
                <c:pt idx="182">
                  <c:v>1.1130213600084804</c:v>
                </c:pt>
                <c:pt idx="183">
                  <c:v>1.2775171058802639</c:v>
                </c:pt>
                <c:pt idx="184">
                  <c:v>0.91970425465767647</c:v>
                </c:pt>
                <c:pt idx="185">
                  <c:v>1.0311754151962067</c:v>
                </c:pt>
                <c:pt idx="186">
                  <c:v>1.1227768881432865</c:v>
                </c:pt>
                <c:pt idx="187">
                  <c:v>1.0105974305697465</c:v>
                </c:pt>
                <c:pt idx="188">
                  <c:v>1.1154001926872681</c:v>
                </c:pt>
                <c:pt idx="189">
                  <c:v>1.0160739983604705</c:v>
                </c:pt>
                <c:pt idx="190">
                  <c:v>1.0278779382457413</c:v>
                </c:pt>
                <c:pt idx="191">
                  <c:v>0.93063940015507207</c:v>
                </c:pt>
                <c:pt idx="192">
                  <c:v>1.116995443098693</c:v>
                </c:pt>
                <c:pt idx="193">
                  <c:v>1.1760553961171551</c:v>
                </c:pt>
                <c:pt idx="194">
                  <c:v>1.0366997961434667</c:v>
                </c:pt>
                <c:pt idx="195">
                  <c:v>1.2024893332170004</c:v>
                </c:pt>
                <c:pt idx="196">
                  <c:v>0.94269428566778435</c:v>
                </c:pt>
                <c:pt idx="197">
                  <c:v>1.0932585794698866</c:v>
                </c:pt>
                <c:pt idx="198">
                  <c:v>0.97795295952660311</c:v>
                </c:pt>
                <c:pt idx="199">
                  <c:v>0.95628957794266278</c:v>
                </c:pt>
                <c:pt idx="200">
                  <c:v>1.0643594919178434</c:v>
                </c:pt>
                <c:pt idx="201">
                  <c:v>1.1748514768984424</c:v>
                </c:pt>
                <c:pt idx="202">
                  <c:v>1.2295471757254537</c:v>
                </c:pt>
                <c:pt idx="203">
                  <c:v>0.90548108267972871</c:v>
                </c:pt>
                <c:pt idx="204">
                  <c:v>1.0804681487062295</c:v>
                </c:pt>
                <c:pt idx="205">
                  <c:v>1.2602624333260373</c:v>
                </c:pt>
                <c:pt idx="206">
                  <c:v>1.0281995572800511</c:v>
                </c:pt>
                <c:pt idx="207">
                  <c:v>1.1961291202959639</c:v>
                </c:pt>
                <c:pt idx="208">
                  <c:v>1.129203710160086</c:v>
                </c:pt>
                <c:pt idx="209">
                  <c:v>1.3908643832260508</c:v>
                </c:pt>
                <c:pt idx="210">
                  <c:v>0.94162446801347988</c:v>
                </c:pt>
                <c:pt idx="211">
                  <c:v>1.0825361480914695</c:v>
                </c:pt>
                <c:pt idx="212">
                  <c:v>1.1481787956837675</c:v>
                </c:pt>
                <c:pt idx="213">
                  <c:v>0.96603966035152045</c:v>
                </c:pt>
                <c:pt idx="214">
                  <c:v>1.1246036506984318</c:v>
                </c:pt>
                <c:pt idx="215">
                  <c:v>0.95628814409839591</c:v>
                </c:pt>
                <c:pt idx="216">
                  <c:v>1.0019270192701928</c:v>
                </c:pt>
                <c:pt idx="217">
                  <c:v>1.1389310338658847</c:v>
                </c:pt>
                <c:pt idx="218">
                  <c:v>1.0004493423271854</c:v>
                </c:pt>
                <c:pt idx="219">
                  <c:v>0.99425724122693848</c:v>
                </c:pt>
                <c:pt idx="220">
                  <c:v>1.0708103592314118</c:v>
                </c:pt>
                <c:pt idx="221">
                  <c:v>1.0806485597652029</c:v>
                </c:pt>
                <c:pt idx="222">
                  <c:v>1.1674889575649061</c:v>
                </c:pt>
                <c:pt idx="223">
                  <c:v>1.0508933082552669</c:v>
                </c:pt>
                <c:pt idx="224">
                  <c:v>0.92821052041274121</c:v>
                </c:pt>
                <c:pt idx="225">
                  <c:v>1.0898319282317337</c:v>
                </c:pt>
                <c:pt idx="226">
                  <c:v>0.87739616274830645</c:v>
                </c:pt>
                <c:pt idx="227">
                  <c:v>1.1127464744251807</c:v>
                </c:pt>
                <c:pt idx="228">
                  <c:v>1.0617052129405067</c:v>
                </c:pt>
                <c:pt idx="229">
                  <c:v>1.02638361060076</c:v>
                </c:pt>
                <c:pt idx="230">
                  <c:v>0.98071698639066263</c:v>
                </c:pt>
                <c:pt idx="231">
                  <c:v>0.97094900146053076</c:v>
                </c:pt>
                <c:pt idx="232">
                  <c:v>0.88174811850381973</c:v>
                </c:pt>
                <c:pt idx="233">
                  <c:v>0.94510609039501814</c:v>
                </c:pt>
                <c:pt idx="234">
                  <c:v>1.060323995265942</c:v>
                </c:pt>
                <c:pt idx="235">
                  <c:v>1.0033672053096994</c:v>
                </c:pt>
                <c:pt idx="236">
                  <c:v>0.97956289648707617</c:v>
                </c:pt>
                <c:pt idx="237">
                  <c:v>1.0866910428688286</c:v>
                </c:pt>
                <c:pt idx="238">
                  <c:v>1.0447111022700135</c:v>
                </c:pt>
                <c:pt idx="239">
                  <c:v>1.0416947482064667</c:v>
                </c:pt>
                <c:pt idx="240">
                  <c:v>1.2392377274745239</c:v>
                </c:pt>
                <c:pt idx="241">
                  <c:v>1.1617156256033319</c:v>
                </c:pt>
                <c:pt idx="242">
                  <c:v>1.2141974004170473</c:v>
                </c:pt>
                <c:pt idx="243">
                  <c:v>1.0643296727655054</c:v>
                </c:pt>
                <c:pt idx="244">
                  <c:v>1.0297762714559748</c:v>
                </c:pt>
                <c:pt idx="245">
                  <c:v>1.1204690109222961</c:v>
                </c:pt>
                <c:pt idx="246">
                  <c:v>1.0206378652847934</c:v>
                </c:pt>
                <c:pt idx="247">
                  <c:v>1.2843410624610172</c:v>
                </c:pt>
                <c:pt idx="248">
                  <c:v>1.1499905247281212</c:v>
                </c:pt>
                <c:pt idx="249">
                  <c:v>1.1839356296186896</c:v>
                </c:pt>
                <c:pt idx="250">
                  <c:v>1.1035715172364442</c:v>
                </c:pt>
                <c:pt idx="251">
                  <c:v>1.0485245569369765</c:v>
                </c:pt>
                <c:pt idx="252">
                  <c:v>1.2364004931525401</c:v>
                </c:pt>
                <c:pt idx="253">
                  <c:v>1.0995946639432803</c:v>
                </c:pt>
                <c:pt idx="254">
                  <c:v>1.1987067759047842</c:v>
                </c:pt>
                <c:pt idx="255">
                  <c:v>1.3019020385409172</c:v>
                </c:pt>
                <c:pt idx="256">
                  <c:v>1.0833858258797202</c:v>
                </c:pt>
                <c:pt idx="257">
                  <c:v>1.2199434350742024</c:v>
                </c:pt>
                <c:pt idx="258">
                  <c:v>1.0455721394998705</c:v>
                </c:pt>
                <c:pt idx="259">
                  <c:v>0.99968792823168284</c:v>
                </c:pt>
                <c:pt idx="260">
                  <c:v>1.062350585300428</c:v>
                </c:pt>
                <c:pt idx="261">
                  <c:v>1.013948685429314</c:v>
                </c:pt>
                <c:pt idx="262">
                  <c:v>1.1418398298909522</c:v>
                </c:pt>
                <c:pt idx="263">
                  <c:v>0.95877696686632152</c:v>
                </c:pt>
                <c:pt idx="264">
                  <c:v>0.97721788277132149</c:v>
                </c:pt>
                <c:pt idx="265">
                  <c:v>1.0764357473860127</c:v>
                </c:pt>
                <c:pt idx="266">
                  <c:v>1.0528560053001552</c:v>
                </c:pt>
                <c:pt idx="267">
                  <c:v>1.1060513785636223</c:v>
                </c:pt>
                <c:pt idx="268">
                  <c:v>1.1003673237770013</c:v>
                </c:pt>
                <c:pt idx="269">
                  <c:v>1.160202762046979</c:v>
                </c:pt>
                <c:pt idx="270">
                  <c:v>0.90119341026460698</c:v>
                </c:pt>
                <c:pt idx="271">
                  <c:v>1.1296029912941701</c:v>
                </c:pt>
                <c:pt idx="272">
                  <c:v>1.0542751976563871</c:v>
                </c:pt>
                <c:pt idx="273">
                  <c:v>1.0379958974105592</c:v>
                </c:pt>
                <c:pt idx="274">
                  <c:v>1.1938668156719283</c:v>
                </c:pt>
                <c:pt idx="275">
                  <c:v>1.0080821996445752</c:v>
                </c:pt>
                <c:pt idx="276">
                  <c:v>0.95363114879844069</c:v>
                </c:pt>
                <c:pt idx="277">
                  <c:v>1.1060141370171739</c:v>
                </c:pt>
                <c:pt idx="278">
                  <c:v>1.0098328748989049</c:v>
                </c:pt>
                <c:pt idx="279">
                  <c:v>0.96384583196563578</c:v>
                </c:pt>
                <c:pt idx="280">
                  <c:v>1.0064438308873238</c:v>
                </c:pt>
                <c:pt idx="281">
                  <c:v>1.0902553785523565</c:v>
                </c:pt>
                <c:pt idx="282">
                  <c:v>1.0386210897512651</c:v>
                </c:pt>
                <c:pt idx="283">
                  <c:v>1.0239146006630961</c:v>
                </c:pt>
                <c:pt idx="284">
                  <c:v>0.9329597913048423</c:v>
                </c:pt>
                <c:pt idx="285">
                  <c:v>1.1359937678090146</c:v>
                </c:pt>
                <c:pt idx="286">
                  <c:v>1.1453524585988191</c:v>
                </c:pt>
                <c:pt idx="287">
                  <c:v>1.1215394120055895</c:v>
                </c:pt>
                <c:pt idx="288">
                  <c:v>1.097869550176753</c:v>
                </c:pt>
                <c:pt idx="289">
                  <c:v>0.99141292869811015</c:v>
                </c:pt>
                <c:pt idx="290">
                  <c:v>0.98553817169519564</c:v>
                </c:pt>
                <c:pt idx="291">
                  <c:v>1.1672999008412321</c:v>
                </c:pt>
                <c:pt idx="292">
                  <c:v>1.0921026696542184</c:v>
                </c:pt>
                <c:pt idx="293">
                  <c:v>0.99852560756845288</c:v>
                </c:pt>
                <c:pt idx="294">
                  <c:v>1.1046342064031267</c:v>
                </c:pt>
                <c:pt idx="295">
                  <c:v>1.0902707145450399</c:v>
                </c:pt>
                <c:pt idx="296">
                  <c:v>1.0321086469582936</c:v>
                </c:pt>
                <c:pt idx="297">
                  <c:v>0.99286125022966543</c:v>
                </c:pt>
                <c:pt idx="298">
                  <c:v>1.0372284529700606</c:v>
                </c:pt>
                <c:pt idx="299">
                  <c:v>1.0554192515762923</c:v>
                </c:pt>
                <c:pt idx="300">
                  <c:v>1.1724987677756478</c:v>
                </c:pt>
                <c:pt idx="301">
                  <c:v>1.1969016832791326</c:v>
                </c:pt>
                <c:pt idx="302">
                  <c:v>1.0425479787273173</c:v>
                </c:pt>
                <c:pt idx="303">
                  <c:v>0.98181074099930687</c:v>
                </c:pt>
                <c:pt idx="304">
                  <c:v>1.1174621782627043</c:v>
                </c:pt>
                <c:pt idx="305">
                  <c:v>1.0698667313717707</c:v>
                </c:pt>
                <c:pt idx="306">
                  <c:v>1.2541959941684828</c:v>
                </c:pt>
                <c:pt idx="307">
                  <c:v>1.1717378288447997</c:v>
                </c:pt>
                <c:pt idx="308">
                  <c:v>1.1188953286265566</c:v>
                </c:pt>
                <c:pt idx="309">
                  <c:v>1.2402201794565484</c:v>
                </c:pt>
                <c:pt idx="310">
                  <c:v>1.1696662207094655</c:v>
                </c:pt>
                <c:pt idx="311">
                  <c:v>0.94523633933204843</c:v>
                </c:pt>
                <c:pt idx="312">
                  <c:v>1.4884465339601882</c:v>
                </c:pt>
                <c:pt idx="313">
                  <c:v>1.0887500942019861</c:v>
                </c:pt>
                <c:pt idx="314">
                  <c:v>1.2010396610412457</c:v>
                </c:pt>
                <c:pt idx="315">
                  <c:v>1.0907166486831417</c:v>
                </c:pt>
                <c:pt idx="316">
                  <c:v>0.85798973279214075</c:v>
                </c:pt>
                <c:pt idx="317">
                  <c:v>1.095607553670636</c:v>
                </c:pt>
                <c:pt idx="318">
                  <c:v>0.9136734675199415</c:v>
                </c:pt>
                <c:pt idx="319">
                  <c:v>1.2837485852462425</c:v>
                </c:pt>
                <c:pt idx="320">
                  <c:v>1.0369255834065958</c:v>
                </c:pt>
                <c:pt idx="321">
                  <c:v>1.1467955211046688</c:v>
                </c:pt>
                <c:pt idx="322">
                  <c:v>1.154261607027431</c:v>
                </c:pt>
                <c:pt idx="323">
                  <c:v>1.1981086206768656</c:v>
                </c:pt>
                <c:pt idx="324">
                  <c:v>1.5230728019272113</c:v>
                </c:pt>
                <c:pt idx="325">
                  <c:v>1.107233860356315</c:v>
                </c:pt>
                <c:pt idx="326">
                  <c:v>1.0971856799337945</c:v>
                </c:pt>
                <c:pt idx="327">
                  <c:v>1.1531761423565037</c:v>
                </c:pt>
                <c:pt idx="328">
                  <c:v>0.70476131920449592</c:v>
                </c:pt>
                <c:pt idx="329">
                  <c:v>0.94153211860781083</c:v>
                </c:pt>
                <c:pt idx="330">
                  <c:v>1.5159046511365304</c:v>
                </c:pt>
                <c:pt idx="331">
                  <c:v>0.92827640984908655</c:v>
                </c:pt>
                <c:pt idx="332">
                  <c:v>1.1385083713850837</c:v>
                </c:pt>
                <c:pt idx="333">
                  <c:v>0.85408509527538501</c:v>
                </c:pt>
                <c:pt idx="334">
                  <c:v>0.74176075446387746</c:v>
                </c:pt>
                <c:pt idx="335">
                  <c:v>1.05915412442173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C00-401C-8B4E-6A0590530E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6445192"/>
        <c:axId val="726445848"/>
      </c:scatterChart>
      <c:valAx>
        <c:axId val="726445192"/>
        <c:scaling>
          <c:orientation val="minMax"/>
          <c:max val="14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enomic U pos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6445848"/>
        <c:crosses val="autoZero"/>
        <c:crossBetween val="midCat"/>
        <c:majorUnit val="500"/>
      </c:valAx>
      <c:valAx>
        <c:axId val="726445848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Fold change: UV- virus, 4SU+/4SU-</a:t>
                </a:r>
                <a:endParaRPr lang="en-US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9.2592592592592587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6445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4SUdose'!$G$1</c:f>
              <c:strCache>
                <c:ptCount val="1"/>
                <c:pt idx="0">
                  <c:v>1A/1B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noFill/>
              </a:ln>
              <a:effectLst/>
            </c:spPr>
          </c:marker>
          <c:xVal>
            <c:numRef>
              <c:f>'4SUdose'!$D$2:$D$349</c:f>
              <c:numCache>
                <c:formatCode>General</c:formatCode>
                <c:ptCount val="348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'4SUdose'!$G$2:$G$349</c:f>
              <c:numCache>
                <c:formatCode>0.00</c:formatCode>
                <c:ptCount val="348"/>
                <c:pt idx="0">
                  <c:v>1.0841876226145888</c:v>
                </c:pt>
                <c:pt idx="1">
                  <c:v>1.4813302209067105</c:v>
                </c:pt>
                <c:pt idx="2">
                  <c:v>1.0382108984484517</c:v>
                </c:pt>
                <c:pt idx="3">
                  <c:v>1.019314607304608</c:v>
                </c:pt>
                <c:pt idx="4">
                  <c:v>1.3287917757350702</c:v>
                </c:pt>
                <c:pt idx="5">
                  <c:v>0.88141534307659886</c:v>
                </c:pt>
                <c:pt idx="6">
                  <c:v>1.0345022580548049</c:v>
                </c:pt>
                <c:pt idx="7">
                  <c:v>1.2919902212951035</c:v>
                </c:pt>
                <c:pt idx="8">
                  <c:v>0.97800183215586867</c:v>
                </c:pt>
                <c:pt idx="9">
                  <c:v>1.1992068341153617</c:v>
                </c:pt>
                <c:pt idx="10">
                  <c:v>1.271964824997293</c:v>
                </c:pt>
                <c:pt idx="11">
                  <c:v>1.2175489628283178</c:v>
                </c:pt>
                <c:pt idx="12">
                  <c:v>1.083947308144674</c:v>
                </c:pt>
                <c:pt idx="13">
                  <c:v>1.0346327059386045</c:v>
                </c:pt>
                <c:pt idx="14">
                  <c:v>1.3365194502672331</c:v>
                </c:pt>
                <c:pt idx="15">
                  <c:v>1.0420244315463758</c:v>
                </c:pt>
                <c:pt idx="16">
                  <c:v>1.0841187964582628</c:v>
                </c:pt>
                <c:pt idx="17">
                  <c:v>1.0705893614362498</c:v>
                </c:pt>
                <c:pt idx="18">
                  <c:v>1.2489250661565672</c:v>
                </c:pt>
                <c:pt idx="19">
                  <c:v>1.2041983223529449</c:v>
                </c:pt>
                <c:pt idx="20">
                  <c:v>1.391729978070319</c:v>
                </c:pt>
                <c:pt idx="21">
                  <c:v>1.4762417136293946</c:v>
                </c:pt>
                <c:pt idx="22">
                  <c:v>1.1175479305594125</c:v>
                </c:pt>
                <c:pt idx="23">
                  <c:v>1.1816989536214579</c:v>
                </c:pt>
                <c:pt idx="24">
                  <c:v>1.3484240487247117</c:v>
                </c:pt>
                <c:pt idx="25">
                  <c:v>1.2236125333850032</c:v>
                </c:pt>
                <c:pt idx="26">
                  <c:v>1.0494835883131208</c:v>
                </c:pt>
                <c:pt idx="27">
                  <c:v>1.4281176561364493</c:v>
                </c:pt>
                <c:pt idx="28">
                  <c:v>1.0792215997341512</c:v>
                </c:pt>
                <c:pt idx="29">
                  <c:v>1.2561013620471733</c:v>
                </c:pt>
                <c:pt idx="30">
                  <c:v>1.1860360350419807</c:v>
                </c:pt>
                <c:pt idx="31">
                  <c:v>1.0353405745370912</c:v>
                </c:pt>
                <c:pt idx="32">
                  <c:v>1.0582962997868137</c:v>
                </c:pt>
                <c:pt idx="33">
                  <c:v>1.0351534181471136</c:v>
                </c:pt>
                <c:pt idx="34">
                  <c:v>1.0234023104668613</c:v>
                </c:pt>
                <c:pt idx="35">
                  <c:v>1.2612378911207831</c:v>
                </c:pt>
                <c:pt idx="36">
                  <c:v>1.1765558123534701</c:v>
                </c:pt>
                <c:pt idx="37">
                  <c:v>1.0615423951307068</c:v>
                </c:pt>
                <c:pt idx="38">
                  <c:v>1.2260940163327336</c:v>
                </c:pt>
                <c:pt idx="39">
                  <c:v>0.98084042879943034</c:v>
                </c:pt>
                <c:pt idx="40">
                  <c:v>1.0409520333110183</c:v>
                </c:pt>
                <c:pt idx="41">
                  <c:v>1.0092623239442435</c:v>
                </c:pt>
                <c:pt idx="42">
                  <c:v>1.0166924269365087</c:v>
                </c:pt>
                <c:pt idx="43">
                  <c:v>1.7119115136856005</c:v>
                </c:pt>
                <c:pt idx="44">
                  <c:v>1.2356221670350023</c:v>
                </c:pt>
                <c:pt idx="45">
                  <c:v>1.1823595169024077</c:v>
                </c:pt>
                <c:pt idx="46">
                  <c:v>1.0944901389517743</c:v>
                </c:pt>
                <c:pt idx="47">
                  <c:v>1.1564172675757693</c:v>
                </c:pt>
                <c:pt idx="48">
                  <c:v>1.2884413473749936</c:v>
                </c:pt>
                <c:pt idx="49">
                  <c:v>1.2859248078387042</c:v>
                </c:pt>
                <c:pt idx="50">
                  <c:v>1.078946976792285</c:v>
                </c:pt>
                <c:pt idx="51">
                  <c:v>1.2493248416325158</c:v>
                </c:pt>
                <c:pt idx="52">
                  <c:v>1.2091299343407729</c:v>
                </c:pt>
                <c:pt idx="53">
                  <c:v>1.296589007207434</c:v>
                </c:pt>
                <c:pt idx="54">
                  <c:v>1.3558636569162368</c:v>
                </c:pt>
                <c:pt idx="55">
                  <c:v>1.3811127833281149</c:v>
                </c:pt>
                <c:pt idx="56">
                  <c:v>0.99297677257926553</c:v>
                </c:pt>
                <c:pt idx="57">
                  <c:v>1.080866727041315</c:v>
                </c:pt>
                <c:pt idx="58">
                  <c:v>1.316097444977913</c:v>
                </c:pt>
                <c:pt idx="59">
                  <c:v>1.1345521651550836</c:v>
                </c:pt>
                <c:pt idx="60">
                  <c:v>0.99056749640649233</c:v>
                </c:pt>
                <c:pt idx="61">
                  <c:v>0.97931135850267115</c:v>
                </c:pt>
                <c:pt idx="62">
                  <c:v>1.0470532624549334</c:v>
                </c:pt>
                <c:pt idx="63">
                  <c:v>1.0955663467808654</c:v>
                </c:pt>
                <c:pt idx="64">
                  <c:v>1.0796647181403163</c:v>
                </c:pt>
                <c:pt idx="65">
                  <c:v>0.96139819470240429</c:v>
                </c:pt>
                <c:pt idx="66">
                  <c:v>1.2602048464481734</c:v>
                </c:pt>
                <c:pt idx="67">
                  <c:v>1.4815270326581536</c:v>
                </c:pt>
                <c:pt idx="68">
                  <c:v>1.3443012592622721</c:v>
                </c:pt>
                <c:pt idx="69">
                  <c:v>1.2722697824140921</c:v>
                </c:pt>
                <c:pt idx="70">
                  <c:v>1.168496555266457</c:v>
                </c:pt>
                <c:pt idx="71">
                  <c:v>1.1931026231185433</c:v>
                </c:pt>
                <c:pt idx="72">
                  <c:v>0.99575757575757584</c:v>
                </c:pt>
                <c:pt idx="73">
                  <c:v>1.3779773235892245</c:v>
                </c:pt>
                <c:pt idx="74">
                  <c:v>1.0015404713416669</c:v>
                </c:pt>
                <c:pt idx="75">
                  <c:v>1.0291596633463511</c:v>
                </c:pt>
                <c:pt idx="76">
                  <c:v>1.1372977062470595</c:v>
                </c:pt>
                <c:pt idx="77">
                  <c:v>1.1231018530159331</c:v>
                </c:pt>
                <c:pt idx="78">
                  <c:v>1.1587800989945454</c:v>
                </c:pt>
                <c:pt idx="79">
                  <c:v>1.2310390708166672</c:v>
                </c:pt>
                <c:pt idx="80">
                  <c:v>0.93086296512204381</c:v>
                </c:pt>
                <c:pt idx="81">
                  <c:v>1.5506561694120045</c:v>
                </c:pt>
                <c:pt idx="82">
                  <c:v>0.98513828382943769</c:v>
                </c:pt>
                <c:pt idx="83">
                  <c:v>1.2277241991351073</c:v>
                </c:pt>
                <c:pt idx="84">
                  <c:v>1.3087085346586296</c:v>
                </c:pt>
                <c:pt idx="85">
                  <c:v>1.2816664772242903</c:v>
                </c:pt>
                <c:pt idx="86">
                  <c:v>1.0287464035535321</c:v>
                </c:pt>
                <c:pt idx="87">
                  <c:v>0.97349724944608851</c:v>
                </c:pt>
                <c:pt idx="88">
                  <c:v>1.2392316134217054</c:v>
                </c:pt>
                <c:pt idx="89">
                  <c:v>1.1477954451906887</c:v>
                </c:pt>
                <c:pt idx="90">
                  <c:v>1.1761730041210385</c:v>
                </c:pt>
                <c:pt idx="91">
                  <c:v>1.0400857913240158</c:v>
                </c:pt>
                <c:pt idx="92">
                  <c:v>1.1909474702213945</c:v>
                </c:pt>
                <c:pt idx="93">
                  <c:v>1.0488689521526458</c:v>
                </c:pt>
                <c:pt idx="94">
                  <c:v>0.99528281290461151</c:v>
                </c:pt>
                <c:pt idx="95">
                  <c:v>1.0642490262872228</c:v>
                </c:pt>
                <c:pt idx="96">
                  <c:v>1.5863424276512275</c:v>
                </c:pt>
                <c:pt idx="97">
                  <c:v>0.96754389797892681</c:v>
                </c:pt>
                <c:pt idx="98">
                  <c:v>1.2227275711627534</c:v>
                </c:pt>
                <c:pt idx="99">
                  <c:v>1.3612189574417899</c:v>
                </c:pt>
                <c:pt idx="100">
                  <c:v>1.3975443198818278</c:v>
                </c:pt>
                <c:pt idx="101">
                  <c:v>1.0288198800208914</c:v>
                </c:pt>
                <c:pt idx="102">
                  <c:v>1.0748051236520084</c:v>
                </c:pt>
                <c:pt idx="103">
                  <c:v>1.0535454017921067</c:v>
                </c:pt>
                <c:pt idx="104">
                  <c:v>0.92328395515094808</c:v>
                </c:pt>
                <c:pt idx="105">
                  <c:v>0.96471264110237598</c:v>
                </c:pt>
                <c:pt idx="106">
                  <c:v>1.1434341235690331</c:v>
                </c:pt>
                <c:pt idx="107">
                  <c:v>1.0097858056728528</c:v>
                </c:pt>
                <c:pt idx="108">
                  <c:v>1.1061925706456566</c:v>
                </c:pt>
                <c:pt idx="109">
                  <c:v>1.2990852862029645</c:v>
                </c:pt>
                <c:pt idx="110">
                  <c:v>1.1094822707433933</c:v>
                </c:pt>
                <c:pt idx="111">
                  <c:v>1.1145447481788524</c:v>
                </c:pt>
                <c:pt idx="112">
                  <c:v>1.2564847398349852</c:v>
                </c:pt>
                <c:pt idx="113">
                  <c:v>1.2406786603922675</c:v>
                </c:pt>
                <c:pt idx="114">
                  <c:v>1.4057944883450715</c:v>
                </c:pt>
                <c:pt idx="115">
                  <c:v>0.83548174785298412</c:v>
                </c:pt>
                <c:pt idx="116">
                  <c:v>0.99255076900186689</c:v>
                </c:pt>
                <c:pt idx="117">
                  <c:v>1.1838517513316533</c:v>
                </c:pt>
                <c:pt idx="118">
                  <c:v>1.1739268942704852</c:v>
                </c:pt>
                <c:pt idx="119">
                  <c:v>1.1072276982326361</c:v>
                </c:pt>
                <c:pt idx="120">
                  <c:v>1.9116829505372037</c:v>
                </c:pt>
                <c:pt idx="121">
                  <c:v>1.1086110567392011</c:v>
                </c:pt>
                <c:pt idx="122">
                  <c:v>1.0642902556526306</c:v>
                </c:pt>
                <c:pt idx="123">
                  <c:v>1.0063349198671891</c:v>
                </c:pt>
                <c:pt idx="124">
                  <c:v>1.1796013819051017</c:v>
                </c:pt>
                <c:pt idx="125">
                  <c:v>1.4862062166852856</c:v>
                </c:pt>
                <c:pt idx="126">
                  <c:v>1.0125050290870945</c:v>
                </c:pt>
                <c:pt idx="127">
                  <c:v>1.3067327366937334</c:v>
                </c:pt>
                <c:pt idx="128">
                  <c:v>1.5433448061611879</c:v>
                </c:pt>
                <c:pt idx="129">
                  <c:v>1.154332271940721</c:v>
                </c:pt>
                <c:pt idx="130">
                  <c:v>1.1897153734082344</c:v>
                </c:pt>
                <c:pt idx="131">
                  <c:v>1.0705942061521343</c:v>
                </c:pt>
                <c:pt idx="132">
                  <c:v>0.85902994541427835</c:v>
                </c:pt>
                <c:pt idx="133">
                  <c:v>1.3781278900779494</c:v>
                </c:pt>
                <c:pt idx="134">
                  <c:v>1.4254952182470124</c:v>
                </c:pt>
                <c:pt idx="135">
                  <c:v>0.94648069306141758</c:v>
                </c:pt>
                <c:pt idx="136">
                  <c:v>1.1619470493840904</c:v>
                </c:pt>
                <c:pt idx="137">
                  <c:v>1.8091707200795375</c:v>
                </c:pt>
                <c:pt idx="138">
                  <c:v>0.96741457423197208</c:v>
                </c:pt>
                <c:pt idx="139">
                  <c:v>1.2846435914016716</c:v>
                </c:pt>
                <c:pt idx="140">
                  <c:v>1.0527632795444497</c:v>
                </c:pt>
                <c:pt idx="141">
                  <c:v>1.0653647827328048</c:v>
                </c:pt>
                <c:pt idx="142">
                  <c:v>1.0974569933060656</c:v>
                </c:pt>
                <c:pt idx="143">
                  <c:v>1.0798417769725142</c:v>
                </c:pt>
                <c:pt idx="144">
                  <c:v>1.1757936636208515</c:v>
                </c:pt>
                <c:pt idx="145">
                  <c:v>1.1231701341391207</c:v>
                </c:pt>
                <c:pt idx="146">
                  <c:v>1.2463033774839749</c:v>
                </c:pt>
                <c:pt idx="147">
                  <c:v>0.98233129397597307</c:v>
                </c:pt>
                <c:pt idx="148">
                  <c:v>1.4047325200934795</c:v>
                </c:pt>
                <c:pt idx="149">
                  <c:v>1.1143013752656388</c:v>
                </c:pt>
                <c:pt idx="150">
                  <c:v>1.46804024247562</c:v>
                </c:pt>
                <c:pt idx="151">
                  <c:v>0.97646597664138013</c:v>
                </c:pt>
                <c:pt idx="152">
                  <c:v>1.1829925910825299</c:v>
                </c:pt>
                <c:pt idx="153">
                  <c:v>1.1206304926606883</c:v>
                </c:pt>
                <c:pt idx="154">
                  <c:v>0.98673207971541321</c:v>
                </c:pt>
                <c:pt idx="155">
                  <c:v>1.1815051278653046</c:v>
                </c:pt>
                <c:pt idx="156">
                  <c:v>0.99143052350903715</c:v>
                </c:pt>
                <c:pt idx="157">
                  <c:v>1.3711834390278632</c:v>
                </c:pt>
                <c:pt idx="158">
                  <c:v>1.3503388418773858</c:v>
                </c:pt>
                <c:pt idx="159">
                  <c:v>1.018324838015773</c:v>
                </c:pt>
                <c:pt idx="160">
                  <c:v>2.8217584403649658</c:v>
                </c:pt>
                <c:pt idx="161">
                  <c:v>1.0921666604658755</c:v>
                </c:pt>
                <c:pt idx="162">
                  <c:v>1.0461232635538398</c:v>
                </c:pt>
                <c:pt idx="163">
                  <c:v>1.2311950059697983</c:v>
                </c:pt>
                <c:pt idx="164">
                  <c:v>1.1813167745436011</c:v>
                </c:pt>
                <c:pt idx="165">
                  <c:v>0.95628944441496055</c:v>
                </c:pt>
                <c:pt idx="166">
                  <c:v>0.94122172763904355</c:v>
                </c:pt>
                <c:pt idx="167">
                  <c:v>1.0682223475846733</c:v>
                </c:pt>
                <c:pt idx="168">
                  <c:v>1.2301314738343183</c:v>
                </c:pt>
                <c:pt idx="169">
                  <c:v>1.0441534725257715</c:v>
                </c:pt>
                <c:pt idx="170">
                  <c:v>1.0690650512037612</c:v>
                </c:pt>
                <c:pt idx="171">
                  <c:v>1.2487484559796587</c:v>
                </c:pt>
                <c:pt idx="172">
                  <c:v>1.0070620265642067</c:v>
                </c:pt>
                <c:pt idx="173">
                  <c:v>1.4349675663150674</c:v>
                </c:pt>
                <c:pt idx="174">
                  <c:v>1.3057908506949467</c:v>
                </c:pt>
                <c:pt idx="175">
                  <c:v>1.0539005065505538</c:v>
                </c:pt>
                <c:pt idx="176">
                  <c:v>1.1750707656702828</c:v>
                </c:pt>
                <c:pt idx="177">
                  <c:v>1.1846349360717749</c:v>
                </c:pt>
                <c:pt idx="178">
                  <c:v>1.0488237591270058</c:v>
                </c:pt>
                <c:pt idx="179">
                  <c:v>1.173638173796087</c:v>
                </c:pt>
                <c:pt idx="180">
                  <c:v>0.97091310280401033</c:v>
                </c:pt>
                <c:pt idx="181">
                  <c:v>1.2054383349715891</c:v>
                </c:pt>
                <c:pt idx="182">
                  <c:v>1.120378539732247</c:v>
                </c:pt>
                <c:pt idx="183">
                  <c:v>1.078868932420199</c:v>
                </c:pt>
                <c:pt idx="184">
                  <c:v>1.1397602910866478</c:v>
                </c:pt>
                <c:pt idx="185">
                  <c:v>1.1305921163086483</c:v>
                </c:pt>
                <c:pt idx="186">
                  <c:v>1.0895360871032467</c:v>
                </c:pt>
                <c:pt idx="187">
                  <c:v>1.0410322276555712</c:v>
                </c:pt>
                <c:pt idx="188">
                  <c:v>1.0576792964358368</c:v>
                </c:pt>
                <c:pt idx="189">
                  <c:v>1.0784493425092303</c:v>
                </c:pt>
                <c:pt idx="190">
                  <c:v>1.1656399327721507</c:v>
                </c:pt>
                <c:pt idx="191">
                  <c:v>1.0337985873814923</c:v>
                </c:pt>
                <c:pt idx="192">
                  <c:v>1.1984730384584965</c:v>
                </c:pt>
                <c:pt idx="193">
                  <c:v>1.0224489888933246</c:v>
                </c:pt>
                <c:pt idx="194">
                  <c:v>1.2065771119502409</c:v>
                </c:pt>
                <c:pt idx="195">
                  <c:v>1.2460421536419473</c:v>
                </c:pt>
                <c:pt idx="196">
                  <c:v>1.3281810051598715</c:v>
                </c:pt>
                <c:pt idx="197">
                  <c:v>1.2232188292067274</c:v>
                </c:pt>
                <c:pt idx="198">
                  <c:v>1.2776790852803026</c:v>
                </c:pt>
                <c:pt idx="199">
                  <c:v>1.5045052980731566</c:v>
                </c:pt>
                <c:pt idx="200">
                  <c:v>1.1177270784905113</c:v>
                </c:pt>
                <c:pt idx="201">
                  <c:v>1.2402396436352805</c:v>
                </c:pt>
                <c:pt idx="202">
                  <c:v>1.1731442793838136</c:v>
                </c:pt>
                <c:pt idx="203">
                  <c:v>1.0919734408304058</c:v>
                </c:pt>
                <c:pt idx="204">
                  <c:v>1.2309383001162779</c:v>
                </c:pt>
                <c:pt idx="205">
                  <c:v>1.2582362021857589</c:v>
                </c:pt>
                <c:pt idx="206">
                  <c:v>1.1161173106804156</c:v>
                </c:pt>
                <c:pt idx="207">
                  <c:v>1.0094498281175914</c:v>
                </c:pt>
                <c:pt idx="208">
                  <c:v>1.112501096320081</c:v>
                </c:pt>
                <c:pt idx="209">
                  <c:v>1.0557364218163041</c:v>
                </c:pt>
                <c:pt idx="210">
                  <c:v>1.0099034630164918</c:v>
                </c:pt>
                <c:pt idx="211">
                  <c:v>1.0136237556971572</c:v>
                </c:pt>
                <c:pt idx="212">
                  <c:v>1.6971234258981982</c:v>
                </c:pt>
                <c:pt idx="213">
                  <c:v>1.1374284534578616</c:v>
                </c:pt>
                <c:pt idx="214">
                  <c:v>0.93950965216273119</c:v>
                </c:pt>
                <c:pt idx="215">
                  <c:v>1.3102618213281578</c:v>
                </c:pt>
                <c:pt idx="216">
                  <c:v>1.8213094945204715</c:v>
                </c:pt>
                <c:pt idx="217">
                  <c:v>1.1036726073077849</c:v>
                </c:pt>
                <c:pt idx="218">
                  <c:v>1.1351684400540141</c:v>
                </c:pt>
                <c:pt idx="219">
                  <c:v>1.4535204608923193</c:v>
                </c:pt>
                <c:pt idx="220">
                  <c:v>1.1373097211933998</c:v>
                </c:pt>
                <c:pt idx="221">
                  <c:v>1.2021663654607737</c:v>
                </c:pt>
                <c:pt idx="222">
                  <c:v>1.3783523503214932</c:v>
                </c:pt>
                <c:pt idx="223">
                  <c:v>1.0547502716466612</c:v>
                </c:pt>
                <c:pt idx="224">
                  <c:v>1.3193826254576517</c:v>
                </c:pt>
                <c:pt idx="225">
                  <c:v>1.109750009906586</c:v>
                </c:pt>
                <c:pt idx="226">
                  <c:v>1.0093447006997802</c:v>
                </c:pt>
                <c:pt idx="227">
                  <c:v>1.0981581443352519</c:v>
                </c:pt>
                <c:pt idx="228">
                  <c:v>1.0023416945663237</c:v>
                </c:pt>
                <c:pt idx="229">
                  <c:v>1.4198246153389669</c:v>
                </c:pt>
                <c:pt idx="230">
                  <c:v>1.3794729515833031</c:v>
                </c:pt>
                <c:pt idx="231">
                  <c:v>1.0366986643496112</c:v>
                </c:pt>
                <c:pt idx="232">
                  <c:v>1.1007010409483213</c:v>
                </c:pt>
                <c:pt idx="233">
                  <c:v>1.2497168929661786</c:v>
                </c:pt>
                <c:pt idx="234">
                  <c:v>0.98181954125987003</c:v>
                </c:pt>
                <c:pt idx="235">
                  <c:v>0.98286035471013533</c:v>
                </c:pt>
                <c:pt idx="236">
                  <c:v>1.3856439266084548</c:v>
                </c:pt>
                <c:pt idx="237">
                  <c:v>1.0032773316966603</c:v>
                </c:pt>
                <c:pt idx="238">
                  <c:v>0.99551157437499227</c:v>
                </c:pt>
                <c:pt idx="239">
                  <c:v>1.0014483461521759</c:v>
                </c:pt>
                <c:pt idx="240">
                  <c:v>1.0899099606124649</c:v>
                </c:pt>
                <c:pt idx="241">
                  <c:v>1.5587472889866008</c:v>
                </c:pt>
                <c:pt idx="242">
                  <c:v>1.4394239878050998</c:v>
                </c:pt>
                <c:pt idx="243">
                  <c:v>1.2037137367755673</c:v>
                </c:pt>
                <c:pt idx="244">
                  <c:v>1.7137454394111777</c:v>
                </c:pt>
                <c:pt idx="245">
                  <c:v>1.0324351027482324</c:v>
                </c:pt>
                <c:pt idx="246">
                  <c:v>1.0742335096024684</c:v>
                </c:pt>
                <c:pt idx="247">
                  <c:v>1.3032507840711962</c:v>
                </c:pt>
                <c:pt idx="248">
                  <c:v>1.0843984702117277</c:v>
                </c:pt>
                <c:pt idx="249">
                  <c:v>1.1605202997712791</c:v>
                </c:pt>
                <c:pt idx="250">
                  <c:v>1.3042578460703493</c:v>
                </c:pt>
                <c:pt idx="251">
                  <c:v>1.0443729776754693</c:v>
                </c:pt>
                <c:pt idx="252">
                  <c:v>1.1865481408370933</c:v>
                </c:pt>
                <c:pt idx="253">
                  <c:v>1.0617720095226257</c:v>
                </c:pt>
                <c:pt idx="254">
                  <c:v>1.3162825428328395</c:v>
                </c:pt>
                <c:pt idx="255">
                  <c:v>1.1309447754662076</c:v>
                </c:pt>
                <c:pt idx="256">
                  <c:v>1.103757101511416</c:v>
                </c:pt>
                <c:pt idx="257">
                  <c:v>1.3591709456167669</c:v>
                </c:pt>
                <c:pt idx="258">
                  <c:v>1.2178732290481351</c:v>
                </c:pt>
                <c:pt idx="259">
                  <c:v>1.1522510801013062</c:v>
                </c:pt>
                <c:pt idx="260">
                  <c:v>1.2162667212099532</c:v>
                </c:pt>
                <c:pt idx="261">
                  <c:v>1.0215692042506141</c:v>
                </c:pt>
                <c:pt idx="262">
                  <c:v>1.2324287441722428</c:v>
                </c:pt>
                <c:pt idx="263">
                  <c:v>1.0943192967424062</c:v>
                </c:pt>
                <c:pt idx="264">
                  <c:v>1.0273702089133339</c:v>
                </c:pt>
                <c:pt idx="265">
                  <c:v>1.077294596937733</c:v>
                </c:pt>
                <c:pt idx="266">
                  <c:v>1.167438794663183</c:v>
                </c:pt>
                <c:pt idx="267">
                  <c:v>1.1622058978774887</c:v>
                </c:pt>
                <c:pt idx="268">
                  <c:v>1.2612231750211078</c:v>
                </c:pt>
                <c:pt idx="269">
                  <c:v>1.2407606449797866</c:v>
                </c:pt>
                <c:pt idx="270">
                  <c:v>1.253734266065333</c:v>
                </c:pt>
                <c:pt idx="271">
                  <c:v>1.2379108588498884</c:v>
                </c:pt>
                <c:pt idx="272">
                  <c:v>1.0261811655751536</c:v>
                </c:pt>
                <c:pt idx="273">
                  <c:v>1.1096688352891169</c:v>
                </c:pt>
                <c:pt idx="274">
                  <c:v>1.664509244609566</c:v>
                </c:pt>
                <c:pt idx="275">
                  <c:v>1.3425150156880605</c:v>
                </c:pt>
                <c:pt idx="276">
                  <c:v>1.1570085659088503</c:v>
                </c:pt>
                <c:pt idx="277">
                  <c:v>1.2679801813892968</c:v>
                </c:pt>
                <c:pt idx="278">
                  <c:v>1.009600094839564</c:v>
                </c:pt>
                <c:pt idx="279">
                  <c:v>1.4838271231322109</c:v>
                </c:pt>
                <c:pt idx="280">
                  <c:v>1.0115883412134221</c:v>
                </c:pt>
                <c:pt idx="281">
                  <c:v>1.1901635096749059</c:v>
                </c:pt>
                <c:pt idx="282">
                  <c:v>1.2208727007751305</c:v>
                </c:pt>
                <c:pt idx="283">
                  <c:v>1.0456978034169071</c:v>
                </c:pt>
                <c:pt idx="284">
                  <c:v>1.048526388951851</c:v>
                </c:pt>
                <c:pt idx="285">
                  <c:v>0.97958851887869669</c:v>
                </c:pt>
                <c:pt idx="286">
                  <c:v>1.1903970764485137</c:v>
                </c:pt>
                <c:pt idx="287">
                  <c:v>1.4831550532516633</c:v>
                </c:pt>
                <c:pt idx="288">
                  <c:v>1.0030976143359529</c:v>
                </c:pt>
                <c:pt idx="289">
                  <c:v>1.1245542367542718</c:v>
                </c:pt>
                <c:pt idx="290">
                  <c:v>1.0374735160656257</c:v>
                </c:pt>
                <c:pt idx="291">
                  <c:v>1.3410614698063832</c:v>
                </c:pt>
                <c:pt idx="292">
                  <c:v>1.4727699216702181</c:v>
                </c:pt>
                <c:pt idx="293">
                  <c:v>1.2593522173023508</c:v>
                </c:pt>
                <c:pt idx="294">
                  <c:v>1.608667973563616</c:v>
                </c:pt>
                <c:pt idx="295">
                  <c:v>1.2150135869137024</c:v>
                </c:pt>
                <c:pt idx="296">
                  <c:v>1.0850493223464917</c:v>
                </c:pt>
                <c:pt idx="297">
                  <c:v>1.0868756704193441</c:v>
                </c:pt>
                <c:pt idx="298">
                  <c:v>1.0287814816464533</c:v>
                </c:pt>
                <c:pt idx="299">
                  <c:v>1.0156781156920192</c:v>
                </c:pt>
                <c:pt idx="300">
                  <c:v>1.2128764935570364</c:v>
                </c:pt>
                <c:pt idx="301">
                  <c:v>1.2097507972061319</c:v>
                </c:pt>
                <c:pt idx="302">
                  <c:v>1.1300446195318945</c:v>
                </c:pt>
                <c:pt idx="303">
                  <c:v>1.1917674928094553</c:v>
                </c:pt>
                <c:pt idx="304">
                  <c:v>1.0445092463581349</c:v>
                </c:pt>
                <c:pt idx="305">
                  <c:v>1.1524058964983976</c:v>
                </c:pt>
                <c:pt idx="306">
                  <c:v>1.2659226280848859</c:v>
                </c:pt>
                <c:pt idx="307">
                  <c:v>1.2411081375615651</c:v>
                </c:pt>
                <c:pt idx="308">
                  <c:v>1.1780382218562502</c:v>
                </c:pt>
                <c:pt idx="309">
                  <c:v>1.3530511843685271</c:v>
                </c:pt>
                <c:pt idx="310">
                  <c:v>1.465838498733754</c:v>
                </c:pt>
                <c:pt idx="311">
                  <c:v>1.3455552009867373</c:v>
                </c:pt>
                <c:pt idx="312">
                  <c:v>1.3510872636417965</c:v>
                </c:pt>
                <c:pt idx="313">
                  <c:v>1.1179704551277834</c:v>
                </c:pt>
                <c:pt idx="314">
                  <c:v>0.96911681717878873</c:v>
                </c:pt>
                <c:pt idx="315">
                  <c:v>1.3189941637790068</c:v>
                </c:pt>
                <c:pt idx="316">
                  <c:v>1.2277009971148514</c:v>
                </c:pt>
                <c:pt idx="317">
                  <c:v>1.3619590741361958</c:v>
                </c:pt>
                <c:pt idx="318">
                  <c:v>0.95253071389344168</c:v>
                </c:pt>
                <c:pt idx="319">
                  <c:v>1.2605235584719678</c:v>
                </c:pt>
                <c:pt idx="320">
                  <c:v>0.98722236686627562</c:v>
                </c:pt>
                <c:pt idx="321">
                  <c:v>1.5784311046017794</c:v>
                </c:pt>
                <c:pt idx="322">
                  <c:v>1.1666326697127938</c:v>
                </c:pt>
                <c:pt idx="323">
                  <c:v>1.2084578360558078</c:v>
                </c:pt>
                <c:pt idx="324">
                  <c:v>0.92348966935265075</c:v>
                </c:pt>
                <c:pt idx="325">
                  <c:v>1.4160526297150602</c:v>
                </c:pt>
                <c:pt idx="326">
                  <c:v>0.9834128136014928</c:v>
                </c:pt>
                <c:pt idx="327">
                  <c:v>0.98696792122273913</c:v>
                </c:pt>
                <c:pt idx="328">
                  <c:v>1.1947787934186471</c:v>
                </c:pt>
                <c:pt idx="329">
                  <c:v>0.9329862050311063</c:v>
                </c:pt>
                <c:pt idx="330">
                  <c:v>1.2730173985903692</c:v>
                </c:pt>
                <c:pt idx="331">
                  <c:v>1.598116522189903</c:v>
                </c:pt>
                <c:pt idx="332">
                  <c:v>1.2904295586345798</c:v>
                </c:pt>
                <c:pt idx="333">
                  <c:v>1.8722533198356459</c:v>
                </c:pt>
                <c:pt idx="334">
                  <c:v>0.76592781710572122</c:v>
                </c:pt>
                <c:pt idx="335">
                  <c:v>0.552180451127819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3C6-415D-84E8-A31E15665C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2927936"/>
        <c:axId val="758118672"/>
      </c:scatterChart>
      <c:valAx>
        <c:axId val="762927936"/>
        <c:scaling>
          <c:orientation val="minMax"/>
          <c:max val="1400"/>
          <c:min val="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58118672"/>
        <c:crosses val="autoZero"/>
        <c:crossBetween val="midCat"/>
        <c:majorUnit val="500"/>
      </c:valAx>
      <c:valAx>
        <c:axId val="758118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old chan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292793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4SUdose'!$L$1</c:f>
              <c:strCache>
                <c:ptCount val="1"/>
                <c:pt idx="0">
                  <c:v>2A/2B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xVal>
            <c:numRef>
              <c:f>'4SUdose'!$I$2:$I$349</c:f>
              <c:numCache>
                <c:formatCode>General</c:formatCode>
                <c:ptCount val="348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'4SUdose'!$L$2:$L$349</c:f>
              <c:numCache>
                <c:formatCode>0.00</c:formatCode>
                <c:ptCount val="348"/>
                <c:pt idx="0">
                  <c:v>1.0576671619613669</c:v>
                </c:pt>
                <c:pt idx="1">
                  <c:v>0.70138646837845164</c:v>
                </c:pt>
                <c:pt idx="2">
                  <c:v>0.91314087501398677</c:v>
                </c:pt>
                <c:pt idx="3">
                  <c:v>1.0482928527069357</c:v>
                </c:pt>
                <c:pt idx="4">
                  <c:v>1.0181388470220278</c:v>
                </c:pt>
                <c:pt idx="5">
                  <c:v>0.89607702437821446</c:v>
                </c:pt>
                <c:pt idx="6">
                  <c:v>1.1146446255799975</c:v>
                </c:pt>
                <c:pt idx="7">
                  <c:v>1.4213584058377773</c:v>
                </c:pt>
                <c:pt idx="8">
                  <c:v>1.0483170076835289</c:v>
                </c:pt>
                <c:pt idx="9">
                  <c:v>1.2384779894836562</c:v>
                </c:pt>
                <c:pt idx="10">
                  <c:v>1.1330847071024563</c:v>
                </c:pt>
                <c:pt idx="11">
                  <c:v>1.2360721601179152</c:v>
                </c:pt>
                <c:pt idx="12">
                  <c:v>1.0615348662335629</c:v>
                </c:pt>
                <c:pt idx="13">
                  <c:v>1.0261747176542269</c:v>
                </c:pt>
                <c:pt idx="14">
                  <c:v>1.5244555793860033</c:v>
                </c:pt>
                <c:pt idx="15">
                  <c:v>1.0455656108329214</c:v>
                </c:pt>
                <c:pt idx="16">
                  <c:v>1.068330525610264</c:v>
                </c:pt>
                <c:pt idx="17">
                  <c:v>1.0541192850735457</c:v>
                </c:pt>
                <c:pt idx="18">
                  <c:v>1.2203827045599469</c:v>
                </c:pt>
                <c:pt idx="19">
                  <c:v>1.1986062644721613</c:v>
                </c:pt>
                <c:pt idx="20">
                  <c:v>1.5019845039263262</c:v>
                </c:pt>
                <c:pt idx="21">
                  <c:v>1.5835925038160192</c:v>
                </c:pt>
                <c:pt idx="22">
                  <c:v>0.98395998765926629</c:v>
                </c:pt>
                <c:pt idx="23">
                  <c:v>1.066675625941105</c:v>
                </c:pt>
                <c:pt idx="24">
                  <c:v>1.2410502202652454</c:v>
                </c:pt>
                <c:pt idx="25">
                  <c:v>1.2638961817243786</c:v>
                </c:pt>
                <c:pt idx="26">
                  <c:v>0.97635267008701032</c:v>
                </c:pt>
                <c:pt idx="27">
                  <c:v>1.2046399411269308</c:v>
                </c:pt>
                <c:pt idx="28">
                  <c:v>0.98775574389769905</c:v>
                </c:pt>
                <c:pt idx="29">
                  <c:v>1.5510559531346226</c:v>
                </c:pt>
                <c:pt idx="30">
                  <c:v>1.1044766129617074</c:v>
                </c:pt>
                <c:pt idx="31">
                  <c:v>0.967493191467244</c:v>
                </c:pt>
                <c:pt idx="32">
                  <c:v>0.93830109320708432</c:v>
                </c:pt>
                <c:pt idx="33">
                  <c:v>1.0107642017739862</c:v>
                </c:pt>
                <c:pt idx="34">
                  <c:v>1.0763459276073448</c:v>
                </c:pt>
                <c:pt idx="35">
                  <c:v>1.3025111530336038</c:v>
                </c:pt>
                <c:pt idx="36">
                  <c:v>1.1494930834801806</c:v>
                </c:pt>
                <c:pt idx="37">
                  <c:v>1.0054524364700284</c:v>
                </c:pt>
                <c:pt idx="38">
                  <c:v>1.0732333357967778</c:v>
                </c:pt>
                <c:pt idx="39">
                  <c:v>0.98613532143549676</c:v>
                </c:pt>
                <c:pt idx="40">
                  <c:v>1.0638391493823793</c:v>
                </c:pt>
                <c:pt idx="41">
                  <c:v>1.1730066247314097</c:v>
                </c:pt>
                <c:pt idx="42">
                  <c:v>1.1125583543499142</c:v>
                </c:pt>
                <c:pt idx="43">
                  <c:v>1.6379644356788772</c:v>
                </c:pt>
                <c:pt idx="44">
                  <c:v>1.161750407184984</c:v>
                </c:pt>
                <c:pt idx="45">
                  <c:v>1.1579464557660375</c:v>
                </c:pt>
                <c:pt idx="46">
                  <c:v>1.1095110430345834</c:v>
                </c:pt>
                <c:pt idx="47">
                  <c:v>1.0857119991619628</c:v>
                </c:pt>
                <c:pt idx="48">
                  <c:v>1.1440615629370878</c:v>
                </c:pt>
                <c:pt idx="49">
                  <c:v>1.2579723674581353</c:v>
                </c:pt>
                <c:pt idx="50">
                  <c:v>1.1812163653331436</c:v>
                </c:pt>
                <c:pt idx="51">
                  <c:v>1.21248676342226</c:v>
                </c:pt>
                <c:pt idx="52">
                  <c:v>1.169181042861406</c:v>
                </c:pt>
                <c:pt idx="53">
                  <c:v>1.0189276244427938</c:v>
                </c:pt>
                <c:pt idx="54">
                  <c:v>1.1924846039277652</c:v>
                </c:pt>
                <c:pt idx="55">
                  <c:v>1.2708741296957555</c:v>
                </c:pt>
                <c:pt idx="56">
                  <c:v>1.0712755510074212</c:v>
                </c:pt>
                <c:pt idx="57">
                  <c:v>1.0304444077372583</c:v>
                </c:pt>
                <c:pt idx="58">
                  <c:v>1.3176266416218536</c:v>
                </c:pt>
                <c:pt idx="59">
                  <c:v>1.005967165018874</c:v>
                </c:pt>
                <c:pt idx="60">
                  <c:v>1.1157332318217139</c:v>
                </c:pt>
                <c:pt idx="61">
                  <c:v>1.0253262974067612</c:v>
                </c:pt>
                <c:pt idx="62">
                  <c:v>1.0659397143175462</c:v>
                </c:pt>
                <c:pt idx="63">
                  <c:v>1.0148718564547994</c:v>
                </c:pt>
                <c:pt idx="64">
                  <c:v>1.0832126772815487</c:v>
                </c:pt>
                <c:pt idx="65">
                  <c:v>1.1065120302761606</c:v>
                </c:pt>
                <c:pt idx="66">
                  <c:v>1.110844231824148</c:v>
                </c:pt>
                <c:pt idx="67">
                  <c:v>1.1771716468475559</c:v>
                </c:pt>
                <c:pt idx="68">
                  <c:v>1.5696106019356</c:v>
                </c:pt>
                <c:pt idx="69">
                  <c:v>0.85641350634666069</c:v>
                </c:pt>
                <c:pt idx="70">
                  <c:v>0.99628385832219368</c:v>
                </c:pt>
                <c:pt idx="71">
                  <c:v>1.1234563267045083</c:v>
                </c:pt>
                <c:pt idx="72">
                  <c:v>1.0013745953708357</c:v>
                </c:pt>
                <c:pt idx="73">
                  <c:v>1.9288688737909951</c:v>
                </c:pt>
                <c:pt idx="74">
                  <c:v>1.1731935897852761</c:v>
                </c:pt>
                <c:pt idx="75">
                  <c:v>0.88810946084405562</c:v>
                </c:pt>
                <c:pt idx="76">
                  <c:v>1.7295245659252461</c:v>
                </c:pt>
                <c:pt idx="77">
                  <c:v>0.9949416121056347</c:v>
                </c:pt>
                <c:pt idx="78">
                  <c:v>0.98247610135788943</c:v>
                </c:pt>
                <c:pt idx="79">
                  <c:v>1.2273645370751443</c:v>
                </c:pt>
                <c:pt idx="80">
                  <c:v>1.1564327916165393</c:v>
                </c:pt>
                <c:pt idx="81">
                  <c:v>1.4289691631416062</c:v>
                </c:pt>
                <c:pt idx="82">
                  <c:v>0.97168597252891198</c:v>
                </c:pt>
                <c:pt idx="83">
                  <c:v>0.99204602985471513</c:v>
                </c:pt>
                <c:pt idx="84">
                  <c:v>1.1239228113888382</c:v>
                </c:pt>
                <c:pt idx="85">
                  <c:v>0.78120213974923836</c:v>
                </c:pt>
                <c:pt idx="86">
                  <c:v>1.2597750920810313</c:v>
                </c:pt>
                <c:pt idx="87">
                  <c:v>0.89287144833887921</c:v>
                </c:pt>
                <c:pt idx="88">
                  <c:v>0.96195440397460907</c:v>
                </c:pt>
                <c:pt idx="89">
                  <c:v>1.0606569795207408</c:v>
                </c:pt>
                <c:pt idx="90">
                  <c:v>0.86047562367974417</c:v>
                </c:pt>
                <c:pt idx="91">
                  <c:v>1.4614679887906876</c:v>
                </c:pt>
                <c:pt idx="92">
                  <c:v>1.0124950104083954</c:v>
                </c:pt>
                <c:pt idx="93">
                  <c:v>0.97414542980423902</c:v>
                </c:pt>
                <c:pt idx="94">
                  <c:v>0.89645723728058935</c:v>
                </c:pt>
                <c:pt idx="95">
                  <c:v>0.84216746029720602</c:v>
                </c:pt>
                <c:pt idx="96">
                  <c:v>0.90834307376481205</c:v>
                </c:pt>
                <c:pt idx="97">
                  <c:v>0.85231057652315123</c:v>
                </c:pt>
                <c:pt idx="98">
                  <c:v>1.2200159760461069</c:v>
                </c:pt>
                <c:pt idx="99">
                  <c:v>1.1354561970125152</c:v>
                </c:pt>
                <c:pt idx="100">
                  <c:v>1.0966193553631405</c:v>
                </c:pt>
                <c:pt idx="101">
                  <c:v>1.3140669089379962</c:v>
                </c:pt>
                <c:pt idx="102">
                  <c:v>1.2695407568634169</c:v>
                </c:pt>
                <c:pt idx="103">
                  <c:v>1.154140819014488</c:v>
                </c:pt>
                <c:pt idx="104">
                  <c:v>0.94523256126594835</c:v>
                </c:pt>
                <c:pt idx="105">
                  <c:v>1.0846411600429775</c:v>
                </c:pt>
                <c:pt idx="106">
                  <c:v>1.223317956544103</c:v>
                </c:pt>
                <c:pt idx="107">
                  <c:v>1.1419783786507587</c:v>
                </c:pt>
                <c:pt idx="108">
                  <c:v>1.2428862216864203</c:v>
                </c:pt>
                <c:pt idx="109">
                  <c:v>1.0064086650677488</c:v>
                </c:pt>
                <c:pt idx="110">
                  <c:v>1.0074883446117486</c:v>
                </c:pt>
                <c:pt idx="111">
                  <c:v>1.2160011802192832</c:v>
                </c:pt>
                <c:pt idx="112">
                  <c:v>1.5138878047699003</c:v>
                </c:pt>
                <c:pt idx="113">
                  <c:v>0.92324456613099959</c:v>
                </c:pt>
                <c:pt idx="114">
                  <c:v>1.6594854842864932</c:v>
                </c:pt>
                <c:pt idx="115">
                  <c:v>1.0918165881581536</c:v>
                </c:pt>
                <c:pt idx="116">
                  <c:v>1.0933165732915151</c:v>
                </c:pt>
                <c:pt idx="117">
                  <c:v>1.076894425834124</c:v>
                </c:pt>
                <c:pt idx="118">
                  <c:v>0.91956481169557669</c:v>
                </c:pt>
                <c:pt idx="119">
                  <c:v>1.0627547579667094</c:v>
                </c:pt>
                <c:pt idx="120">
                  <c:v>1.5100315925492935</c:v>
                </c:pt>
                <c:pt idx="121">
                  <c:v>1.1416831489205512</c:v>
                </c:pt>
                <c:pt idx="122">
                  <c:v>1.2502949740373479</c:v>
                </c:pt>
                <c:pt idx="123">
                  <c:v>1.0113519719949589</c:v>
                </c:pt>
                <c:pt idx="124">
                  <c:v>0.91757648529589786</c:v>
                </c:pt>
                <c:pt idx="125">
                  <c:v>1.3887364930037336</c:v>
                </c:pt>
                <c:pt idx="126">
                  <c:v>1.0427900920037148</c:v>
                </c:pt>
                <c:pt idx="127">
                  <c:v>0.95499544200205411</c:v>
                </c:pt>
                <c:pt idx="128">
                  <c:v>1.2819604438740848</c:v>
                </c:pt>
                <c:pt idx="129">
                  <c:v>1.023296506983594</c:v>
                </c:pt>
                <c:pt idx="130">
                  <c:v>1.1043388241872172</c:v>
                </c:pt>
                <c:pt idx="131">
                  <c:v>1.0435808610077231</c:v>
                </c:pt>
                <c:pt idx="132">
                  <c:v>1.0703745060690459</c:v>
                </c:pt>
                <c:pt idx="133">
                  <c:v>1.4785096986145227</c:v>
                </c:pt>
                <c:pt idx="134">
                  <c:v>1.3471085077288194</c:v>
                </c:pt>
                <c:pt idx="135">
                  <c:v>1.1273770383114965</c:v>
                </c:pt>
                <c:pt idx="136">
                  <c:v>0.82754907505841901</c:v>
                </c:pt>
                <c:pt idx="137">
                  <c:v>1.3602281299586403</c:v>
                </c:pt>
                <c:pt idx="138">
                  <c:v>1.139871150407022</c:v>
                </c:pt>
                <c:pt idx="139">
                  <c:v>1.2249552804403212</c:v>
                </c:pt>
                <c:pt idx="140">
                  <c:v>1.1269429219589817</c:v>
                </c:pt>
                <c:pt idx="141">
                  <c:v>1.2435443796284391</c:v>
                </c:pt>
                <c:pt idx="142">
                  <c:v>0.87477171220429639</c:v>
                </c:pt>
                <c:pt idx="143">
                  <c:v>1.4646581121998112</c:v>
                </c:pt>
                <c:pt idx="144">
                  <c:v>1.0769500772023366</c:v>
                </c:pt>
                <c:pt idx="145">
                  <c:v>1.3524074539013029</c:v>
                </c:pt>
                <c:pt idx="146">
                  <c:v>0.92942115565017047</c:v>
                </c:pt>
                <c:pt idx="147">
                  <c:v>1.3524507570653139</c:v>
                </c:pt>
                <c:pt idx="148">
                  <c:v>1.5207314646272769</c:v>
                </c:pt>
                <c:pt idx="149">
                  <c:v>0.99766589521147009</c:v>
                </c:pt>
                <c:pt idx="150">
                  <c:v>1.2109755520668295</c:v>
                </c:pt>
                <c:pt idx="151">
                  <c:v>0.9722714186655963</c:v>
                </c:pt>
                <c:pt idx="152">
                  <c:v>0.99130698060630418</c:v>
                </c:pt>
                <c:pt idx="153">
                  <c:v>1.369146363627439</c:v>
                </c:pt>
                <c:pt idx="154">
                  <c:v>1.075250362680876</c:v>
                </c:pt>
                <c:pt idx="155">
                  <c:v>1.0832361992692785</c:v>
                </c:pt>
                <c:pt idx="156">
                  <c:v>1.0765484056083106</c:v>
                </c:pt>
                <c:pt idx="157">
                  <c:v>1.2251322162616107</c:v>
                </c:pt>
                <c:pt idx="158">
                  <c:v>1.1739564470991146</c:v>
                </c:pt>
                <c:pt idx="159">
                  <c:v>1.0539353961013846</c:v>
                </c:pt>
                <c:pt idx="160">
                  <c:v>2.2085141837389428</c:v>
                </c:pt>
                <c:pt idx="161">
                  <c:v>1.1130846870919593</c:v>
                </c:pt>
                <c:pt idx="162">
                  <c:v>1.2169647587587895</c:v>
                </c:pt>
                <c:pt idx="163">
                  <c:v>1.1488249471080441</c:v>
                </c:pt>
                <c:pt idx="164">
                  <c:v>1.0828731093194655</c:v>
                </c:pt>
                <c:pt idx="165">
                  <c:v>1.0969251601162044</c:v>
                </c:pt>
                <c:pt idx="166">
                  <c:v>1.030247670547187</c:v>
                </c:pt>
                <c:pt idx="167">
                  <c:v>1.1418427605222559</c:v>
                </c:pt>
                <c:pt idx="168">
                  <c:v>0.92320012091722692</c:v>
                </c:pt>
                <c:pt idx="169">
                  <c:v>1.1832403557971818</c:v>
                </c:pt>
                <c:pt idx="170">
                  <c:v>1.2618922614892194</c:v>
                </c:pt>
                <c:pt idx="171">
                  <c:v>1.0855781207209743</c:v>
                </c:pt>
                <c:pt idx="172">
                  <c:v>1.0066708508275537</c:v>
                </c:pt>
                <c:pt idx="173">
                  <c:v>1.3114772025168528</c:v>
                </c:pt>
                <c:pt idx="174">
                  <c:v>1.1306594845744642</c:v>
                </c:pt>
                <c:pt idx="175">
                  <c:v>1.2573561063488072</c:v>
                </c:pt>
                <c:pt idx="176">
                  <c:v>1.1673983506613188</c:v>
                </c:pt>
                <c:pt idx="177">
                  <c:v>1.0048544692347199</c:v>
                </c:pt>
                <c:pt idx="178">
                  <c:v>1.1442231376900542</c:v>
                </c:pt>
                <c:pt idx="179">
                  <c:v>1.0626125886377489</c:v>
                </c:pt>
                <c:pt idx="180">
                  <c:v>1.0886844313989408</c:v>
                </c:pt>
                <c:pt idx="181">
                  <c:v>1.1791760791700463</c:v>
                </c:pt>
                <c:pt idx="182">
                  <c:v>1.0562703608087458</c:v>
                </c:pt>
                <c:pt idx="183">
                  <c:v>1.0172610731000753</c:v>
                </c:pt>
                <c:pt idx="184">
                  <c:v>0.92359555607050015</c:v>
                </c:pt>
                <c:pt idx="185">
                  <c:v>1.1518546518979564</c:v>
                </c:pt>
                <c:pt idx="186">
                  <c:v>1.0247373991593562</c:v>
                </c:pt>
                <c:pt idx="187">
                  <c:v>1.047620987246497</c:v>
                </c:pt>
                <c:pt idx="188">
                  <c:v>1.1257420206066195</c:v>
                </c:pt>
                <c:pt idx="189">
                  <c:v>1.1158173525601034</c:v>
                </c:pt>
                <c:pt idx="190">
                  <c:v>0.9560249235392978</c:v>
                </c:pt>
                <c:pt idx="191">
                  <c:v>1.0781762882851875</c:v>
                </c:pt>
                <c:pt idx="192">
                  <c:v>1.149945105427703</c:v>
                </c:pt>
                <c:pt idx="193">
                  <c:v>0.99592781372570993</c:v>
                </c:pt>
                <c:pt idx="194">
                  <c:v>1.1095958250460931</c:v>
                </c:pt>
                <c:pt idx="195">
                  <c:v>1.0112394066499684</c:v>
                </c:pt>
                <c:pt idx="196">
                  <c:v>1.0748900690059182</c:v>
                </c:pt>
                <c:pt idx="197">
                  <c:v>0.92870125176378737</c:v>
                </c:pt>
                <c:pt idx="198">
                  <c:v>0.92380642806523872</c:v>
                </c:pt>
                <c:pt idx="199">
                  <c:v>1.4318898373045952</c:v>
                </c:pt>
                <c:pt idx="200">
                  <c:v>0.94795640030863193</c:v>
                </c:pt>
                <c:pt idx="201">
                  <c:v>0.99264172601810552</c:v>
                </c:pt>
                <c:pt idx="202">
                  <c:v>1.0019892462298401</c:v>
                </c:pt>
                <c:pt idx="203">
                  <c:v>1.1484775913296539</c:v>
                </c:pt>
                <c:pt idx="204">
                  <c:v>1.3023776967744383</c:v>
                </c:pt>
                <c:pt idx="205">
                  <c:v>1.130714494590116</c:v>
                </c:pt>
                <c:pt idx="206">
                  <c:v>1.1407643336534146</c:v>
                </c:pt>
                <c:pt idx="207">
                  <c:v>0.95049474683796942</c:v>
                </c:pt>
                <c:pt idx="208">
                  <c:v>1.3770324399569718</c:v>
                </c:pt>
                <c:pt idx="209">
                  <c:v>1.035333356424347</c:v>
                </c:pt>
                <c:pt idx="210">
                  <c:v>1.0556324159667758</c:v>
                </c:pt>
                <c:pt idx="211">
                  <c:v>1.2034266742742765</c:v>
                </c:pt>
                <c:pt idx="212">
                  <c:v>1.3291367376511554</c:v>
                </c:pt>
                <c:pt idx="213">
                  <c:v>1.0543607875259042</c:v>
                </c:pt>
                <c:pt idx="214">
                  <c:v>1.0283563910599893</c:v>
                </c:pt>
                <c:pt idx="215">
                  <c:v>0.95083705018724218</c:v>
                </c:pt>
                <c:pt idx="216">
                  <c:v>1.4930305403050372</c:v>
                </c:pt>
                <c:pt idx="217">
                  <c:v>1.0971503626044077</c:v>
                </c:pt>
                <c:pt idx="218">
                  <c:v>1.1457206857942792</c:v>
                </c:pt>
                <c:pt idx="219">
                  <c:v>1.2228836667755607</c:v>
                </c:pt>
                <c:pt idx="220">
                  <c:v>1.0062735650511885</c:v>
                </c:pt>
                <c:pt idx="221">
                  <c:v>1.0946505816117849</c:v>
                </c:pt>
                <c:pt idx="222">
                  <c:v>1.4304989901302307</c:v>
                </c:pt>
                <c:pt idx="223">
                  <c:v>1.0294165805812627</c:v>
                </c:pt>
                <c:pt idx="224">
                  <c:v>1.4558101356350388</c:v>
                </c:pt>
                <c:pt idx="225">
                  <c:v>0.92098518268033636</c:v>
                </c:pt>
                <c:pt idx="226">
                  <c:v>1.1795280288904928</c:v>
                </c:pt>
                <c:pt idx="227">
                  <c:v>1.4299056589503718</c:v>
                </c:pt>
                <c:pt idx="228">
                  <c:v>1.1863482063967554</c:v>
                </c:pt>
                <c:pt idx="229">
                  <c:v>1.5483319667557773</c:v>
                </c:pt>
                <c:pt idx="230">
                  <c:v>1.2994366295311459</c:v>
                </c:pt>
                <c:pt idx="231">
                  <c:v>0.97944128126470398</c:v>
                </c:pt>
                <c:pt idx="232">
                  <c:v>1.059881383332135</c:v>
                </c:pt>
                <c:pt idx="233">
                  <c:v>0.94628509529359384</c:v>
                </c:pt>
                <c:pt idx="234">
                  <c:v>1.0004089071335587</c:v>
                </c:pt>
                <c:pt idx="235">
                  <c:v>1.0098890276275385</c:v>
                </c:pt>
                <c:pt idx="236">
                  <c:v>1.4800486927989345</c:v>
                </c:pt>
                <c:pt idx="237">
                  <c:v>1.1474735209768443</c:v>
                </c:pt>
                <c:pt idx="238">
                  <c:v>0.80691094330762891</c:v>
                </c:pt>
                <c:pt idx="239">
                  <c:v>1.2015963037519473</c:v>
                </c:pt>
                <c:pt idx="240">
                  <c:v>1.0574934840462016</c:v>
                </c:pt>
                <c:pt idx="241">
                  <c:v>1.429488922151817</c:v>
                </c:pt>
                <c:pt idx="242">
                  <c:v>1.6155810608461805</c:v>
                </c:pt>
                <c:pt idx="243">
                  <c:v>0.97607901778687234</c:v>
                </c:pt>
                <c:pt idx="244">
                  <c:v>1.7800504243150592</c:v>
                </c:pt>
                <c:pt idx="245">
                  <c:v>0.93966282979870974</c:v>
                </c:pt>
                <c:pt idx="246">
                  <c:v>1.487339960000218</c:v>
                </c:pt>
                <c:pt idx="247">
                  <c:v>1.1699259467822507</c:v>
                </c:pt>
                <c:pt idx="248">
                  <c:v>1.0886191350821226</c:v>
                </c:pt>
                <c:pt idx="249">
                  <c:v>1.1319323154888097</c:v>
                </c:pt>
                <c:pt idx="250">
                  <c:v>1.4796746173823152</c:v>
                </c:pt>
                <c:pt idx="251">
                  <c:v>1.0639416514216196</c:v>
                </c:pt>
                <c:pt idx="252">
                  <c:v>1.0171690921195877</c:v>
                </c:pt>
                <c:pt idx="253">
                  <c:v>1.2842822734230126</c:v>
                </c:pt>
                <c:pt idx="254">
                  <c:v>1.4180184069865172</c:v>
                </c:pt>
                <c:pt idx="255">
                  <c:v>1.2744265377678663</c:v>
                </c:pt>
                <c:pt idx="256">
                  <c:v>1.0328911785187067</c:v>
                </c:pt>
                <c:pt idx="257">
                  <c:v>1.1548385422943532</c:v>
                </c:pt>
                <c:pt idx="258">
                  <c:v>1.2420222291324363</c:v>
                </c:pt>
                <c:pt idx="259">
                  <c:v>1.3383917035670354</c:v>
                </c:pt>
                <c:pt idx="260">
                  <c:v>1.0724506568761452</c:v>
                </c:pt>
                <c:pt idx="261">
                  <c:v>1.179819899192972</c:v>
                </c:pt>
                <c:pt idx="262">
                  <c:v>1.1529272782108924</c:v>
                </c:pt>
                <c:pt idx="263">
                  <c:v>1.2155687004915263</c:v>
                </c:pt>
                <c:pt idx="264">
                  <c:v>1.1556736244264372</c:v>
                </c:pt>
                <c:pt idx="265">
                  <c:v>0.91933982429074523</c:v>
                </c:pt>
                <c:pt idx="266">
                  <c:v>1.1188534562443677</c:v>
                </c:pt>
                <c:pt idx="267">
                  <c:v>1.0684535044501959</c:v>
                </c:pt>
                <c:pt idx="268">
                  <c:v>1.3229265437876352</c:v>
                </c:pt>
                <c:pt idx="269">
                  <c:v>1.2888077093976467</c:v>
                </c:pt>
                <c:pt idx="270">
                  <c:v>1.6892290765445819</c:v>
                </c:pt>
                <c:pt idx="271">
                  <c:v>1.2810082359592294</c:v>
                </c:pt>
                <c:pt idx="272">
                  <c:v>0.87498708489056898</c:v>
                </c:pt>
                <c:pt idx="273">
                  <c:v>1.2014587855496188</c:v>
                </c:pt>
                <c:pt idx="274">
                  <c:v>1.0497386851818238</c:v>
                </c:pt>
                <c:pt idx="275">
                  <c:v>1.132102256253001</c:v>
                </c:pt>
                <c:pt idx="276">
                  <c:v>0.99445592485793366</c:v>
                </c:pt>
                <c:pt idx="277">
                  <c:v>1.1165722561661064</c:v>
                </c:pt>
                <c:pt idx="278">
                  <c:v>1.0166352863067603</c:v>
                </c:pt>
                <c:pt idx="279">
                  <c:v>1.2827262686096788</c:v>
                </c:pt>
                <c:pt idx="280">
                  <c:v>1.1949527679199028</c:v>
                </c:pt>
                <c:pt idx="281">
                  <c:v>1.3611933521011197</c:v>
                </c:pt>
                <c:pt idx="282">
                  <c:v>1.2730996668370513</c:v>
                </c:pt>
                <c:pt idx="283">
                  <c:v>1.1988445727695443</c:v>
                </c:pt>
                <c:pt idx="284">
                  <c:v>1.0219978955413078</c:v>
                </c:pt>
                <c:pt idx="285">
                  <c:v>0.94320021938515075</c:v>
                </c:pt>
                <c:pt idx="286">
                  <c:v>0.99582529053393443</c:v>
                </c:pt>
                <c:pt idx="287">
                  <c:v>1.0282801720370476</c:v>
                </c:pt>
                <c:pt idx="288">
                  <c:v>0.96815477310752163</c:v>
                </c:pt>
                <c:pt idx="289">
                  <c:v>1.0218571332235831</c:v>
                </c:pt>
                <c:pt idx="290">
                  <c:v>1.1094322908825995</c:v>
                </c:pt>
                <c:pt idx="291">
                  <c:v>1.5101610994888353</c:v>
                </c:pt>
                <c:pt idx="292">
                  <c:v>1.4267798323123209</c:v>
                </c:pt>
                <c:pt idx="293">
                  <c:v>1.1308873187698514</c:v>
                </c:pt>
                <c:pt idx="294">
                  <c:v>1.4169875339352269</c:v>
                </c:pt>
                <c:pt idx="295">
                  <c:v>0.93002003513882447</c:v>
                </c:pt>
                <c:pt idx="296">
                  <c:v>0.99493489326857809</c:v>
                </c:pt>
                <c:pt idx="297">
                  <c:v>1.0576566443559616</c:v>
                </c:pt>
                <c:pt idx="298">
                  <c:v>1.2750914481200322</c:v>
                </c:pt>
                <c:pt idx="299">
                  <c:v>1.1419005450503761</c:v>
                </c:pt>
                <c:pt idx="300">
                  <c:v>0.92448284053805674</c:v>
                </c:pt>
                <c:pt idx="301">
                  <c:v>1.005281036375955</c:v>
                </c:pt>
                <c:pt idx="302">
                  <c:v>0.9882713451828623</c:v>
                </c:pt>
                <c:pt idx="303">
                  <c:v>1.2921529585406024</c:v>
                </c:pt>
                <c:pt idx="304">
                  <c:v>0.95382043042991593</c:v>
                </c:pt>
                <c:pt idx="305">
                  <c:v>1.0612301148364236</c:v>
                </c:pt>
                <c:pt idx="306">
                  <c:v>1.067662614396736</c:v>
                </c:pt>
                <c:pt idx="307">
                  <c:v>0.99308199311739787</c:v>
                </c:pt>
                <c:pt idx="308">
                  <c:v>0.87650488027162488</c:v>
                </c:pt>
                <c:pt idx="309">
                  <c:v>0.99283223913881791</c:v>
                </c:pt>
                <c:pt idx="310">
                  <c:v>1.136571876200329</c:v>
                </c:pt>
                <c:pt idx="311">
                  <c:v>1.0362933207872171</c:v>
                </c:pt>
                <c:pt idx="312">
                  <c:v>1.2019541521025647</c:v>
                </c:pt>
                <c:pt idx="313">
                  <c:v>0.98933605589153084</c:v>
                </c:pt>
                <c:pt idx="314">
                  <c:v>0.95329097476531965</c:v>
                </c:pt>
                <c:pt idx="315">
                  <c:v>0.81414295564398365</c:v>
                </c:pt>
                <c:pt idx="316">
                  <c:v>1.1699125429045532</c:v>
                </c:pt>
                <c:pt idx="317">
                  <c:v>0.96791233729960369</c:v>
                </c:pt>
                <c:pt idx="318">
                  <c:v>1.5180092444355162</c:v>
                </c:pt>
                <c:pt idx="319">
                  <c:v>1.465347385293559</c:v>
                </c:pt>
                <c:pt idx="320">
                  <c:v>0.94066883715577598</c:v>
                </c:pt>
                <c:pt idx="321">
                  <c:v>1.0788907374940275</c:v>
                </c:pt>
                <c:pt idx="322">
                  <c:v>1.0215140111351888</c:v>
                </c:pt>
                <c:pt idx="323">
                  <c:v>0.91409757654806101</c:v>
                </c:pt>
                <c:pt idx="324">
                  <c:v>0.84576674855287615</c:v>
                </c:pt>
                <c:pt idx="325">
                  <c:v>0.98965536347040528</c:v>
                </c:pt>
                <c:pt idx="326">
                  <c:v>1.2427364948594577</c:v>
                </c:pt>
                <c:pt idx="327">
                  <c:v>1.2876755773067405</c:v>
                </c:pt>
                <c:pt idx="328">
                  <c:v>0.84844076097633081</c:v>
                </c:pt>
                <c:pt idx="329">
                  <c:v>0.68838712087255338</c:v>
                </c:pt>
                <c:pt idx="330">
                  <c:v>1.2018945561839085</c:v>
                </c:pt>
                <c:pt idx="331">
                  <c:v>1.4655336371563481</c:v>
                </c:pt>
                <c:pt idx="332">
                  <c:v>1.4169392697919598</c:v>
                </c:pt>
                <c:pt idx="333">
                  <c:v>1.6809744748559281</c:v>
                </c:pt>
                <c:pt idx="334">
                  <c:v>1.1622886272421205</c:v>
                </c:pt>
                <c:pt idx="335">
                  <c:v>1.40612664456060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0A4-4E85-B14E-55255005B8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5916112"/>
        <c:axId val="758116592"/>
      </c:scatterChart>
      <c:valAx>
        <c:axId val="495916112"/>
        <c:scaling>
          <c:orientation val="minMax"/>
          <c:max val="1400"/>
          <c:min val="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58116592"/>
        <c:crosses val="autoZero"/>
        <c:crossBetween val="midCat"/>
        <c:majorUnit val="500"/>
      </c:valAx>
      <c:valAx>
        <c:axId val="758116592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old chan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591611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775371828521432E-2"/>
          <c:y val="4.7678122265966752E-2"/>
          <c:w val="0.8585579615048119"/>
          <c:h val="0.70314003718285212"/>
        </c:manualLayout>
      </c:layout>
      <c:scatterChart>
        <c:scatterStyle val="lineMarker"/>
        <c:varyColors val="0"/>
        <c:ser>
          <c:idx val="0"/>
          <c:order val="0"/>
          <c:tx>
            <c:strRef>
              <c:f>'4SUdose'!$B$1</c:f>
              <c:strCache>
                <c:ptCount val="1"/>
                <c:pt idx="0">
                  <c:v>3A/3B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4SUdose'!$A$2:$A$349</c:f>
              <c:numCache>
                <c:formatCode>General</c:formatCode>
                <c:ptCount val="348"/>
                <c:pt idx="0">
                  <c:v>9</c:v>
                </c:pt>
                <c:pt idx="1">
                  <c:v>10</c:v>
                </c:pt>
                <c:pt idx="2">
                  <c:v>16</c:v>
                </c:pt>
                <c:pt idx="3">
                  <c:v>17</c:v>
                </c:pt>
                <c:pt idx="4">
                  <c:v>24</c:v>
                </c:pt>
                <c:pt idx="5">
                  <c:v>27</c:v>
                </c:pt>
                <c:pt idx="6">
                  <c:v>28</c:v>
                </c:pt>
                <c:pt idx="7">
                  <c:v>31</c:v>
                </c:pt>
                <c:pt idx="8">
                  <c:v>49</c:v>
                </c:pt>
                <c:pt idx="9">
                  <c:v>58</c:v>
                </c:pt>
                <c:pt idx="10">
                  <c:v>66</c:v>
                </c:pt>
                <c:pt idx="11">
                  <c:v>67</c:v>
                </c:pt>
                <c:pt idx="12">
                  <c:v>69</c:v>
                </c:pt>
                <c:pt idx="13">
                  <c:v>72</c:v>
                </c:pt>
                <c:pt idx="14">
                  <c:v>94</c:v>
                </c:pt>
                <c:pt idx="15">
                  <c:v>96</c:v>
                </c:pt>
                <c:pt idx="16">
                  <c:v>97</c:v>
                </c:pt>
                <c:pt idx="17">
                  <c:v>111</c:v>
                </c:pt>
                <c:pt idx="18">
                  <c:v>118</c:v>
                </c:pt>
                <c:pt idx="19">
                  <c:v>121</c:v>
                </c:pt>
                <c:pt idx="20">
                  <c:v>124</c:v>
                </c:pt>
                <c:pt idx="21">
                  <c:v>136</c:v>
                </c:pt>
                <c:pt idx="22">
                  <c:v>139</c:v>
                </c:pt>
                <c:pt idx="23">
                  <c:v>151</c:v>
                </c:pt>
                <c:pt idx="24">
                  <c:v>154</c:v>
                </c:pt>
                <c:pt idx="25">
                  <c:v>163</c:v>
                </c:pt>
                <c:pt idx="26">
                  <c:v>165</c:v>
                </c:pt>
                <c:pt idx="27">
                  <c:v>174</c:v>
                </c:pt>
                <c:pt idx="28">
                  <c:v>180</c:v>
                </c:pt>
                <c:pt idx="29">
                  <c:v>189</c:v>
                </c:pt>
                <c:pt idx="30">
                  <c:v>197</c:v>
                </c:pt>
                <c:pt idx="31">
                  <c:v>198</c:v>
                </c:pt>
                <c:pt idx="32">
                  <c:v>202</c:v>
                </c:pt>
                <c:pt idx="33">
                  <c:v>208</c:v>
                </c:pt>
                <c:pt idx="34">
                  <c:v>211</c:v>
                </c:pt>
                <c:pt idx="35">
                  <c:v>212</c:v>
                </c:pt>
                <c:pt idx="36">
                  <c:v>213</c:v>
                </c:pt>
                <c:pt idx="37">
                  <c:v>218</c:v>
                </c:pt>
                <c:pt idx="38">
                  <c:v>219</c:v>
                </c:pt>
                <c:pt idx="39">
                  <c:v>220</c:v>
                </c:pt>
                <c:pt idx="40">
                  <c:v>222</c:v>
                </c:pt>
                <c:pt idx="41">
                  <c:v>227</c:v>
                </c:pt>
                <c:pt idx="42">
                  <c:v>229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44</c:v>
                </c:pt>
                <c:pt idx="47">
                  <c:v>248</c:v>
                </c:pt>
                <c:pt idx="48">
                  <c:v>249</c:v>
                </c:pt>
                <c:pt idx="49">
                  <c:v>265</c:v>
                </c:pt>
                <c:pt idx="50">
                  <c:v>273</c:v>
                </c:pt>
                <c:pt idx="51">
                  <c:v>277</c:v>
                </c:pt>
                <c:pt idx="52">
                  <c:v>280</c:v>
                </c:pt>
                <c:pt idx="53">
                  <c:v>284</c:v>
                </c:pt>
                <c:pt idx="54">
                  <c:v>285</c:v>
                </c:pt>
                <c:pt idx="55">
                  <c:v>286</c:v>
                </c:pt>
                <c:pt idx="56">
                  <c:v>297</c:v>
                </c:pt>
                <c:pt idx="57">
                  <c:v>300</c:v>
                </c:pt>
                <c:pt idx="58">
                  <c:v>313</c:v>
                </c:pt>
                <c:pt idx="59">
                  <c:v>315</c:v>
                </c:pt>
                <c:pt idx="60">
                  <c:v>318</c:v>
                </c:pt>
                <c:pt idx="61">
                  <c:v>322</c:v>
                </c:pt>
                <c:pt idx="62">
                  <c:v>326</c:v>
                </c:pt>
                <c:pt idx="63">
                  <c:v>328</c:v>
                </c:pt>
                <c:pt idx="64">
                  <c:v>330</c:v>
                </c:pt>
                <c:pt idx="65">
                  <c:v>335</c:v>
                </c:pt>
                <c:pt idx="66">
                  <c:v>336</c:v>
                </c:pt>
                <c:pt idx="67">
                  <c:v>337</c:v>
                </c:pt>
                <c:pt idx="68">
                  <c:v>340</c:v>
                </c:pt>
                <c:pt idx="69">
                  <c:v>355</c:v>
                </c:pt>
                <c:pt idx="70">
                  <c:v>356</c:v>
                </c:pt>
                <c:pt idx="71">
                  <c:v>357</c:v>
                </c:pt>
                <c:pt idx="72">
                  <c:v>358</c:v>
                </c:pt>
                <c:pt idx="73">
                  <c:v>360</c:v>
                </c:pt>
                <c:pt idx="74">
                  <c:v>363</c:v>
                </c:pt>
                <c:pt idx="75">
                  <c:v>366</c:v>
                </c:pt>
                <c:pt idx="76">
                  <c:v>373</c:v>
                </c:pt>
                <c:pt idx="77">
                  <c:v>384</c:v>
                </c:pt>
                <c:pt idx="78">
                  <c:v>389</c:v>
                </c:pt>
                <c:pt idx="79">
                  <c:v>392</c:v>
                </c:pt>
                <c:pt idx="80">
                  <c:v>397</c:v>
                </c:pt>
                <c:pt idx="81">
                  <c:v>400</c:v>
                </c:pt>
                <c:pt idx="82">
                  <c:v>405</c:v>
                </c:pt>
                <c:pt idx="83">
                  <c:v>406</c:v>
                </c:pt>
                <c:pt idx="84">
                  <c:v>409</c:v>
                </c:pt>
                <c:pt idx="85">
                  <c:v>412</c:v>
                </c:pt>
                <c:pt idx="86">
                  <c:v>415</c:v>
                </c:pt>
                <c:pt idx="87">
                  <c:v>418</c:v>
                </c:pt>
                <c:pt idx="88">
                  <c:v>419</c:v>
                </c:pt>
                <c:pt idx="89">
                  <c:v>420</c:v>
                </c:pt>
                <c:pt idx="90">
                  <c:v>421</c:v>
                </c:pt>
                <c:pt idx="91">
                  <c:v>424</c:v>
                </c:pt>
                <c:pt idx="92">
                  <c:v>427</c:v>
                </c:pt>
                <c:pt idx="93">
                  <c:v>430</c:v>
                </c:pt>
                <c:pt idx="94">
                  <c:v>436</c:v>
                </c:pt>
                <c:pt idx="95">
                  <c:v>440</c:v>
                </c:pt>
                <c:pt idx="96">
                  <c:v>441</c:v>
                </c:pt>
                <c:pt idx="97">
                  <c:v>442</c:v>
                </c:pt>
                <c:pt idx="98">
                  <c:v>450</c:v>
                </c:pt>
                <c:pt idx="99">
                  <c:v>451</c:v>
                </c:pt>
                <c:pt idx="100">
                  <c:v>454</c:v>
                </c:pt>
                <c:pt idx="101">
                  <c:v>455</c:v>
                </c:pt>
                <c:pt idx="102">
                  <c:v>457</c:v>
                </c:pt>
                <c:pt idx="103">
                  <c:v>463</c:v>
                </c:pt>
                <c:pt idx="104">
                  <c:v>464</c:v>
                </c:pt>
                <c:pt idx="105">
                  <c:v>465</c:v>
                </c:pt>
                <c:pt idx="106">
                  <c:v>466</c:v>
                </c:pt>
                <c:pt idx="107">
                  <c:v>470</c:v>
                </c:pt>
                <c:pt idx="108">
                  <c:v>474</c:v>
                </c:pt>
                <c:pt idx="109">
                  <c:v>476</c:v>
                </c:pt>
                <c:pt idx="110">
                  <c:v>477</c:v>
                </c:pt>
                <c:pt idx="111">
                  <c:v>487</c:v>
                </c:pt>
                <c:pt idx="112">
                  <c:v>488</c:v>
                </c:pt>
                <c:pt idx="113">
                  <c:v>494</c:v>
                </c:pt>
                <c:pt idx="114">
                  <c:v>496</c:v>
                </c:pt>
                <c:pt idx="115">
                  <c:v>500</c:v>
                </c:pt>
                <c:pt idx="116">
                  <c:v>505</c:v>
                </c:pt>
                <c:pt idx="117">
                  <c:v>510</c:v>
                </c:pt>
                <c:pt idx="118">
                  <c:v>512</c:v>
                </c:pt>
                <c:pt idx="119">
                  <c:v>515</c:v>
                </c:pt>
                <c:pt idx="120">
                  <c:v>518</c:v>
                </c:pt>
                <c:pt idx="121">
                  <c:v>519</c:v>
                </c:pt>
                <c:pt idx="122">
                  <c:v>524</c:v>
                </c:pt>
                <c:pt idx="123">
                  <c:v>529</c:v>
                </c:pt>
                <c:pt idx="124">
                  <c:v>530</c:v>
                </c:pt>
                <c:pt idx="125">
                  <c:v>534</c:v>
                </c:pt>
                <c:pt idx="126">
                  <c:v>540</c:v>
                </c:pt>
                <c:pt idx="127">
                  <c:v>544</c:v>
                </c:pt>
                <c:pt idx="128">
                  <c:v>546</c:v>
                </c:pt>
                <c:pt idx="129">
                  <c:v>547</c:v>
                </c:pt>
                <c:pt idx="130">
                  <c:v>548</c:v>
                </c:pt>
                <c:pt idx="131">
                  <c:v>557</c:v>
                </c:pt>
                <c:pt idx="132">
                  <c:v>563</c:v>
                </c:pt>
                <c:pt idx="133">
                  <c:v>564</c:v>
                </c:pt>
                <c:pt idx="134">
                  <c:v>567</c:v>
                </c:pt>
                <c:pt idx="135">
                  <c:v>572</c:v>
                </c:pt>
                <c:pt idx="136">
                  <c:v>573</c:v>
                </c:pt>
                <c:pt idx="137">
                  <c:v>574</c:v>
                </c:pt>
                <c:pt idx="138">
                  <c:v>585</c:v>
                </c:pt>
                <c:pt idx="139">
                  <c:v>589</c:v>
                </c:pt>
                <c:pt idx="140">
                  <c:v>591</c:v>
                </c:pt>
                <c:pt idx="141">
                  <c:v>592</c:v>
                </c:pt>
                <c:pt idx="142">
                  <c:v>593</c:v>
                </c:pt>
                <c:pt idx="143">
                  <c:v>599</c:v>
                </c:pt>
                <c:pt idx="144">
                  <c:v>604</c:v>
                </c:pt>
                <c:pt idx="145">
                  <c:v>606</c:v>
                </c:pt>
                <c:pt idx="146">
                  <c:v>612</c:v>
                </c:pt>
                <c:pt idx="147">
                  <c:v>616</c:v>
                </c:pt>
                <c:pt idx="148">
                  <c:v>619</c:v>
                </c:pt>
                <c:pt idx="149">
                  <c:v>621</c:v>
                </c:pt>
                <c:pt idx="150">
                  <c:v>626</c:v>
                </c:pt>
                <c:pt idx="151">
                  <c:v>627</c:v>
                </c:pt>
                <c:pt idx="152">
                  <c:v>633</c:v>
                </c:pt>
                <c:pt idx="153">
                  <c:v>634</c:v>
                </c:pt>
                <c:pt idx="154">
                  <c:v>643</c:v>
                </c:pt>
                <c:pt idx="155">
                  <c:v>655</c:v>
                </c:pt>
                <c:pt idx="156">
                  <c:v>656</c:v>
                </c:pt>
                <c:pt idx="157">
                  <c:v>660</c:v>
                </c:pt>
                <c:pt idx="158">
                  <c:v>663</c:v>
                </c:pt>
                <c:pt idx="159">
                  <c:v>664</c:v>
                </c:pt>
                <c:pt idx="160">
                  <c:v>667</c:v>
                </c:pt>
                <c:pt idx="161">
                  <c:v>670</c:v>
                </c:pt>
                <c:pt idx="162">
                  <c:v>672</c:v>
                </c:pt>
                <c:pt idx="163">
                  <c:v>673</c:v>
                </c:pt>
                <c:pt idx="164">
                  <c:v>675</c:v>
                </c:pt>
                <c:pt idx="165">
                  <c:v>676</c:v>
                </c:pt>
                <c:pt idx="166">
                  <c:v>679</c:v>
                </c:pt>
                <c:pt idx="167">
                  <c:v>680</c:v>
                </c:pt>
                <c:pt idx="168">
                  <c:v>681</c:v>
                </c:pt>
                <c:pt idx="169">
                  <c:v>685</c:v>
                </c:pt>
                <c:pt idx="170">
                  <c:v>688</c:v>
                </c:pt>
                <c:pt idx="171">
                  <c:v>690</c:v>
                </c:pt>
                <c:pt idx="172">
                  <c:v>691</c:v>
                </c:pt>
                <c:pt idx="173">
                  <c:v>693</c:v>
                </c:pt>
                <c:pt idx="174">
                  <c:v>699</c:v>
                </c:pt>
                <c:pt idx="175">
                  <c:v>706</c:v>
                </c:pt>
                <c:pt idx="176">
                  <c:v>713</c:v>
                </c:pt>
                <c:pt idx="177">
                  <c:v>714</c:v>
                </c:pt>
                <c:pt idx="178">
                  <c:v>716</c:v>
                </c:pt>
                <c:pt idx="179">
                  <c:v>718</c:v>
                </c:pt>
                <c:pt idx="180">
                  <c:v>722</c:v>
                </c:pt>
                <c:pt idx="181">
                  <c:v>725</c:v>
                </c:pt>
                <c:pt idx="182">
                  <c:v>726</c:v>
                </c:pt>
                <c:pt idx="183">
                  <c:v>729</c:v>
                </c:pt>
                <c:pt idx="184">
                  <c:v>738</c:v>
                </c:pt>
                <c:pt idx="185">
                  <c:v>740</c:v>
                </c:pt>
                <c:pt idx="186">
                  <c:v>741</c:v>
                </c:pt>
                <c:pt idx="187">
                  <c:v>742</c:v>
                </c:pt>
                <c:pt idx="188">
                  <c:v>743</c:v>
                </c:pt>
                <c:pt idx="189">
                  <c:v>749</c:v>
                </c:pt>
                <c:pt idx="190">
                  <c:v>754</c:v>
                </c:pt>
                <c:pt idx="191">
                  <c:v>755</c:v>
                </c:pt>
                <c:pt idx="192">
                  <c:v>757</c:v>
                </c:pt>
                <c:pt idx="193">
                  <c:v>766</c:v>
                </c:pt>
                <c:pt idx="194">
                  <c:v>770</c:v>
                </c:pt>
                <c:pt idx="195">
                  <c:v>771</c:v>
                </c:pt>
                <c:pt idx="196">
                  <c:v>772</c:v>
                </c:pt>
                <c:pt idx="197">
                  <c:v>776</c:v>
                </c:pt>
                <c:pt idx="198">
                  <c:v>777</c:v>
                </c:pt>
                <c:pt idx="199">
                  <c:v>781</c:v>
                </c:pt>
                <c:pt idx="200">
                  <c:v>786</c:v>
                </c:pt>
                <c:pt idx="201">
                  <c:v>788</c:v>
                </c:pt>
                <c:pt idx="202">
                  <c:v>789</c:v>
                </c:pt>
                <c:pt idx="203">
                  <c:v>796</c:v>
                </c:pt>
                <c:pt idx="204">
                  <c:v>798</c:v>
                </c:pt>
                <c:pt idx="205">
                  <c:v>806</c:v>
                </c:pt>
                <c:pt idx="206">
                  <c:v>807</c:v>
                </c:pt>
                <c:pt idx="207">
                  <c:v>814</c:v>
                </c:pt>
                <c:pt idx="208">
                  <c:v>817</c:v>
                </c:pt>
                <c:pt idx="209">
                  <c:v>820</c:v>
                </c:pt>
                <c:pt idx="210">
                  <c:v>822</c:v>
                </c:pt>
                <c:pt idx="211">
                  <c:v>824</c:v>
                </c:pt>
                <c:pt idx="212">
                  <c:v>828</c:v>
                </c:pt>
                <c:pt idx="213">
                  <c:v>829</c:v>
                </c:pt>
                <c:pt idx="214">
                  <c:v>832</c:v>
                </c:pt>
                <c:pt idx="215">
                  <c:v>833</c:v>
                </c:pt>
                <c:pt idx="216">
                  <c:v>835</c:v>
                </c:pt>
                <c:pt idx="217">
                  <c:v>841</c:v>
                </c:pt>
                <c:pt idx="218">
                  <c:v>847</c:v>
                </c:pt>
                <c:pt idx="219">
                  <c:v>848</c:v>
                </c:pt>
                <c:pt idx="220">
                  <c:v>849</c:v>
                </c:pt>
                <c:pt idx="221">
                  <c:v>850</c:v>
                </c:pt>
                <c:pt idx="222">
                  <c:v>855</c:v>
                </c:pt>
                <c:pt idx="223">
                  <c:v>860</c:v>
                </c:pt>
                <c:pt idx="224">
                  <c:v>880</c:v>
                </c:pt>
                <c:pt idx="225">
                  <c:v>885</c:v>
                </c:pt>
                <c:pt idx="226">
                  <c:v>888</c:v>
                </c:pt>
                <c:pt idx="227">
                  <c:v>893</c:v>
                </c:pt>
                <c:pt idx="228">
                  <c:v>901</c:v>
                </c:pt>
                <c:pt idx="229">
                  <c:v>903</c:v>
                </c:pt>
                <c:pt idx="230">
                  <c:v>912</c:v>
                </c:pt>
                <c:pt idx="231">
                  <c:v>913</c:v>
                </c:pt>
                <c:pt idx="232">
                  <c:v>915</c:v>
                </c:pt>
                <c:pt idx="233">
                  <c:v>918</c:v>
                </c:pt>
                <c:pt idx="234">
                  <c:v>922</c:v>
                </c:pt>
                <c:pt idx="235">
                  <c:v>924</c:v>
                </c:pt>
                <c:pt idx="236">
                  <c:v>926</c:v>
                </c:pt>
                <c:pt idx="237">
                  <c:v>934</c:v>
                </c:pt>
                <c:pt idx="238">
                  <c:v>945</c:v>
                </c:pt>
                <c:pt idx="239">
                  <c:v>946</c:v>
                </c:pt>
                <c:pt idx="240">
                  <c:v>950</c:v>
                </c:pt>
                <c:pt idx="241">
                  <c:v>952</c:v>
                </c:pt>
                <c:pt idx="242">
                  <c:v>957</c:v>
                </c:pt>
                <c:pt idx="243">
                  <c:v>960</c:v>
                </c:pt>
                <c:pt idx="244">
                  <c:v>968</c:v>
                </c:pt>
                <c:pt idx="245">
                  <c:v>971</c:v>
                </c:pt>
                <c:pt idx="246">
                  <c:v>974</c:v>
                </c:pt>
                <c:pt idx="247">
                  <c:v>978</c:v>
                </c:pt>
                <c:pt idx="248">
                  <c:v>979</c:v>
                </c:pt>
                <c:pt idx="249">
                  <c:v>983</c:v>
                </c:pt>
                <c:pt idx="250">
                  <c:v>985</c:v>
                </c:pt>
                <c:pt idx="251">
                  <c:v>994</c:v>
                </c:pt>
                <c:pt idx="252">
                  <c:v>1005</c:v>
                </c:pt>
                <c:pt idx="253">
                  <c:v>1007</c:v>
                </c:pt>
                <c:pt idx="254">
                  <c:v>1008</c:v>
                </c:pt>
                <c:pt idx="255">
                  <c:v>1010</c:v>
                </c:pt>
                <c:pt idx="256">
                  <c:v>1016</c:v>
                </c:pt>
                <c:pt idx="257">
                  <c:v>1017</c:v>
                </c:pt>
                <c:pt idx="258">
                  <c:v>1024</c:v>
                </c:pt>
                <c:pt idx="259">
                  <c:v>1027</c:v>
                </c:pt>
                <c:pt idx="260">
                  <c:v>1028</c:v>
                </c:pt>
                <c:pt idx="261">
                  <c:v>1033</c:v>
                </c:pt>
                <c:pt idx="262">
                  <c:v>1036</c:v>
                </c:pt>
                <c:pt idx="263">
                  <c:v>1038</c:v>
                </c:pt>
                <c:pt idx="264">
                  <c:v>1042</c:v>
                </c:pt>
                <c:pt idx="265">
                  <c:v>1047</c:v>
                </c:pt>
                <c:pt idx="266">
                  <c:v>1053</c:v>
                </c:pt>
                <c:pt idx="267">
                  <c:v>1054</c:v>
                </c:pt>
                <c:pt idx="268">
                  <c:v>1061</c:v>
                </c:pt>
                <c:pt idx="269">
                  <c:v>1066</c:v>
                </c:pt>
                <c:pt idx="270">
                  <c:v>1071</c:v>
                </c:pt>
                <c:pt idx="271">
                  <c:v>1072</c:v>
                </c:pt>
                <c:pt idx="272">
                  <c:v>1079</c:v>
                </c:pt>
                <c:pt idx="273">
                  <c:v>1081</c:v>
                </c:pt>
                <c:pt idx="274">
                  <c:v>1082</c:v>
                </c:pt>
                <c:pt idx="275">
                  <c:v>1083</c:v>
                </c:pt>
                <c:pt idx="276">
                  <c:v>1089</c:v>
                </c:pt>
                <c:pt idx="277">
                  <c:v>1090</c:v>
                </c:pt>
                <c:pt idx="278">
                  <c:v>1095</c:v>
                </c:pt>
                <c:pt idx="279">
                  <c:v>1098</c:v>
                </c:pt>
                <c:pt idx="280">
                  <c:v>1111</c:v>
                </c:pt>
                <c:pt idx="281">
                  <c:v>1115</c:v>
                </c:pt>
                <c:pt idx="282">
                  <c:v>1119</c:v>
                </c:pt>
                <c:pt idx="283">
                  <c:v>1121</c:v>
                </c:pt>
                <c:pt idx="284">
                  <c:v>1131</c:v>
                </c:pt>
                <c:pt idx="285">
                  <c:v>1136</c:v>
                </c:pt>
                <c:pt idx="286">
                  <c:v>1140</c:v>
                </c:pt>
                <c:pt idx="287">
                  <c:v>1143</c:v>
                </c:pt>
                <c:pt idx="288">
                  <c:v>1144</c:v>
                </c:pt>
                <c:pt idx="289">
                  <c:v>1148</c:v>
                </c:pt>
                <c:pt idx="290">
                  <c:v>1151</c:v>
                </c:pt>
                <c:pt idx="291">
                  <c:v>1155</c:v>
                </c:pt>
                <c:pt idx="292">
                  <c:v>1159</c:v>
                </c:pt>
                <c:pt idx="293">
                  <c:v>1162</c:v>
                </c:pt>
                <c:pt idx="294">
                  <c:v>1173</c:v>
                </c:pt>
                <c:pt idx="295">
                  <c:v>1174</c:v>
                </c:pt>
                <c:pt idx="296">
                  <c:v>1185</c:v>
                </c:pt>
                <c:pt idx="297">
                  <c:v>1189</c:v>
                </c:pt>
                <c:pt idx="298">
                  <c:v>1191</c:v>
                </c:pt>
                <c:pt idx="299">
                  <c:v>1201</c:v>
                </c:pt>
                <c:pt idx="300">
                  <c:v>1204</c:v>
                </c:pt>
                <c:pt idx="301">
                  <c:v>1206</c:v>
                </c:pt>
                <c:pt idx="302">
                  <c:v>1207</c:v>
                </c:pt>
                <c:pt idx="303">
                  <c:v>1210</c:v>
                </c:pt>
                <c:pt idx="304">
                  <c:v>1215</c:v>
                </c:pt>
                <c:pt idx="305">
                  <c:v>1217</c:v>
                </c:pt>
                <c:pt idx="306">
                  <c:v>1224</c:v>
                </c:pt>
                <c:pt idx="307">
                  <c:v>1225</c:v>
                </c:pt>
                <c:pt idx="308">
                  <c:v>1226</c:v>
                </c:pt>
                <c:pt idx="309">
                  <c:v>1227</c:v>
                </c:pt>
                <c:pt idx="310">
                  <c:v>1228</c:v>
                </c:pt>
                <c:pt idx="311">
                  <c:v>1235</c:v>
                </c:pt>
                <c:pt idx="312">
                  <c:v>1236</c:v>
                </c:pt>
                <c:pt idx="313">
                  <c:v>1237</c:v>
                </c:pt>
                <c:pt idx="314">
                  <c:v>1241</c:v>
                </c:pt>
                <c:pt idx="315">
                  <c:v>1242</c:v>
                </c:pt>
                <c:pt idx="316">
                  <c:v>1243</c:v>
                </c:pt>
                <c:pt idx="317">
                  <c:v>1244</c:v>
                </c:pt>
                <c:pt idx="318">
                  <c:v>1252</c:v>
                </c:pt>
                <c:pt idx="319">
                  <c:v>1266</c:v>
                </c:pt>
                <c:pt idx="320">
                  <c:v>1278</c:v>
                </c:pt>
                <c:pt idx="321">
                  <c:v>1280</c:v>
                </c:pt>
                <c:pt idx="322">
                  <c:v>1289</c:v>
                </c:pt>
                <c:pt idx="323">
                  <c:v>1296</c:v>
                </c:pt>
                <c:pt idx="324">
                  <c:v>1297</c:v>
                </c:pt>
                <c:pt idx="325">
                  <c:v>1298</c:v>
                </c:pt>
                <c:pt idx="326">
                  <c:v>1307</c:v>
                </c:pt>
                <c:pt idx="327">
                  <c:v>1316</c:v>
                </c:pt>
                <c:pt idx="328">
                  <c:v>1317</c:v>
                </c:pt>
                <c:pt idx="329">
                  <c:v>1318</c:v>
                </c:pt>
                <c:pt idx="330">
                  <c:v>1321</c:v>
                </c:pt>
                <c:pt idx="331">
                  <c:v>1322</c:v>
                </c:pt>
                <c:pt idx="332">
                  <c:v>1328</c:v>
                </c:pt>
                <c:pt idx="333">
                  <c:v>1329</c:v>
                </c:pt>
                <c:pt idx="334">
                  <c:v>1334</c:v>
                </c:pt>
                <c:pt idx="335">
                  <c:v>1337</c:v>
                </c:pt>
              </c:numCache>
            </c:numRef>
          </c:xVal>
          <c:yVal>
            <c:numRef>
              <c:f>'4SUdose'!$B$2:$B$349</c:f>
              <c:numCache>
                <c:formatCode>0.00</c:formatCode>
                <c:ptCount val="348"/>
                <c:pt idx="0">
                  <c:v>0.81244711980603623</c:v>
                </c:pt>
                <c:pt idx="1">
                  <c:v>1.0113739939643991</c:v>
                </c:pt>
                <c:pt idx="2">
                  <c:v>1.1077358764583434</c:v>
                </c:pt>
                <c:pt idx="3">
                  <c:v>0.79171010193373914</c:v>
                </c:pt>
                <c:pt idx="4">
                  <c:v>1.1855048484295905</c:v>
                </c:pt>
                <c:pt idx="5">
                  <c:v>1.2815007367743811</c:v>
                </c:pt>
                <c:pt idx="6">
                  <c:v>1.2738958371850158</c:v>
                </c:pt>
                <c:pt idx="7">
                  <c:v>1.2851022720704897</c:v>
                </c:pt>
                <c:pt idx="8">
                  <c:v>1.0439961680771539</c:v>
                </c:pt>
                <c:pt idx="9">
                  <c:v>1.2244088864564902</c:v>
                </c:pt>
                <c:pt idx="10">
                  <c:v>1.0009100493475953</c:v>
                </c:pt>
                <c:pt idx="11">
                  <c:v>1.2251644565285873</c:v>
                </c:pt>
                <c:pt idx="12">
                  <c:v>1.1617504467040158</c:v>
                </c:pt>
                <c:pt idx="13">
                  <c:v>1.0394796012278893</c:v>
                </c:pt>
                <c:pt idx="14">
                  <c:v>1.5379897232443287</c:v>
                </c:pt>
                <c:pt idx="15">
                  <c:v>1.1755209754963827</c:v>
                </c:pt>
                <c:pt idx="16">
                  <c:v>1.0637276832212144</c:v>
                </c:pt>
                <c:pt idx="17">
                  <c:v>1.0971873506273468</c:v>
                </c:pt>
                <c:pt idx="18">
                  <c:v>1.3562822535082943</c:v>
                </c:pt>
                <c:pt idx="19">
                  <c:v>1.1834890648931444</c:v>
                </c:pt>
                <c:pt idx="20">
                  <c:v>1.3368796151985565</c:v>
                </c:pt>
                <c:pt idx="21">
                  <c:v>1.734952973300312</c:v>
                </c:pt>
                <c:pt idx="22">
                  <c:v>1.0070552365138012</c:v>
                </c:pt>
                <c:pt idx="23">
                  <c:v>1.1619606257472002</c:v>
                </c:pt>
                <c:pt idx="24">
                  <c:v>1.3505909470709094</c:v>
                </c:pt>
                <c:pt idx="25">
                  <c:v>1.3018220802210509</c:v>
                </c:pt>
                <c:pt idx="26">
                  <c:v>1.0207637206072402</c:v>
                </c:pt>
                <c:pt idx="27">
                  <c:v>1.3878600409830995</c:v>
                </c:pt>
                <c:pt idx="28">
                  <c:v>1.1295593859874222</c:v>
                </c:pt>
                <c:pt idx="29">
                  <c:v>1.6887149443588292</c:v>
                </c:pt>
                <c:pt idx="30">
                  <c:v>1.1124568506121388</c:v>
                </c:pt>
                <c:pt idx="31">
                  <c:v>1.0188108671786171</c:v>
                </c:pt>
                <c:pt idx="32">
                  <c:v>0.97197833418862911</c:v>
                </c:pt>
                <c:pt idx="33">
                  <c:v>1.0393654732227913</c:v>
                </c:pt>
                <c:pt idx="34">
                  <c:v>1.1533578247905267</c:v>
                </c:pt>
                <c:pt idx="35">
                  <c:v>1.5093208120704766</c:v>
                </c:pt>
                <c:pt idx="36">
                  <c:v>1.2139698019643601</c:v>
                </c:pt>
                <c:pt idx="37">
                  <c:v>1.0548668529989984</c:v>
                </c:pt>
                <c:pt idx="38">
                  <c:v>1.0274239513428725</c:v>
                </c:pt>
                <c:pt idx="39">
                  <c:v>0.95771781957921509</c:v>
                </c:pt>
                <c:pt idx="40">
                  <c:v>1.0079635933627118</c:v>
                </c:pt>
                <c:pt idx="41">
                  <c:v>0.99643962804311481</c:v>
                </c:pt>
                <c:pt idx="42">
                  <c:v>1.0290674884146669</c:v>
                </c:pt>
                <c:pt idx="43">
                  <c:v>1.9001927052376553</c:v>
                </c:pt>
                <c:pt idx="44">
                  <c:v>1.1752820974735567</c:v>
                </c:pt>
                <c:pt idx="45">
                  <c:v>1.2151426899265871</c:v>
                </c:pt>
                <c:pt idx="46">
                  <c:v>1.3159000437503092</c:v>
                </c:pt>
                <c:pt idx="47">
                  <c:v>1.1796989729695533</c:v>
                </c:pt>
                <c:pt idx="48">
                  <c:v>1.3471010164191821</c:v>
                </c:pt>
                <c:pt idx="49">
                  <c:v>1.1632463642984299</c:v>
                </c:pt>
                <c:pt idx="50">
                  <c:v>1.1679312189907116</c:v>
                </c:pt>
                <c:pt idx="51">
                  <c:v>1.3409926635057905</c:v>
                </c:pt>
                <c:pt idx="52">
                  <c:v>1.1193993674812088</c:v>
                </c:pt>
                <c:pt idx="53">
                  <c:v>1.1524889511091099</c:v>
                </c:pt>
                <c:pt idx="54">
                  <c:v>1.2994526918617504</c:v>
                </c:pt>
                <c:pt idx="55">
                  <c:v>1.3041352090859066</c:v>
                </c:pt>
                <c:pt idx="56">
                  <c:v>1.2350529589200596</c:v>
                </c:pt>
                <c:pt idx="57">
                  <c:v>1.0522311069719557</c:v>
                </c:pt>
                <c:pt idx="58">
                  <c:v>1.3514601155219594</c:v>
                </c:pt>
                <c:pt idx="59">
                  <c:v>1.1231921040171795</c:v>
                </c:pt>
                <c:pt idx="60">
                  <c:v>1.0219346699917395</c:v>
                </c:pt>
                <c:pt idx="61">
                  <c:v>1.1493081862585952</c:v>
                </c:pt>
                <c:pt idx="62">
                  <c:v>1.0649074080710395</c:v>
                </c:pt>
                <c:pt idx="63">
                  <c:v>1.4035510412594963</c:v>
                </c:pt>
                <c:pt idx="64">
                  <c:v>1.1294413775120398</c:v>
                </c:pt>
                <c:pt idx="65">
                  <c:v>1.009140888265873</c:v>
                </c:pt>
                <c:pt idx="66">
                  <c:v>1.2052949705311917</c:v>
                </c:pt>
                <c:pt idx="67">
                  <c:v>1.3776432323465293</c:v>
                </c:pt>
                <c:pt idx="68">
                  <c:v>1.2872643461488829</c:v>
                </c:pt>
                <c:pt idx="69">
                  <c:v>0.82742633901609619</c:v>
                </c:pt>
                <c:pt idx="70">
                  <c:v>0.87562095579221155</c:v>
                </c:pt>
                <c:pt idx="71">
                  <c:v>0.99655926979412779</c:v>
                </c:pt>
                <c:pt idx="72">
                  <c:v>0.99014167180691237</c:v>
                </c:pt>
                <c:pt idx="73">
                  <c:v>1.315496906124725</c:v>
                </c:pt>
                <c:pt idx="74">
                  <c:v>1.1008296039296201</c:v>
                </c:pt>
                <c:pt idx="75">
                  <c:v>1.331779458775848</c:v>
                </c:pt>
                <c:pt idx="76">
                  <c:v>1.0844590999215742</c:v>
                </c:pt>
                <c:pt idx="77">
                  <c:v>1.1349525642423772</c:v>
                </c:pt>
                <c:pt idx="78">
                  <c:v>1.0634889493914157</c:v>
                </c:pt>
                <c:pt idx="79">
                  <c:v>1.4664188161043721</c:v>
                </c:pt>
                <c:pt idx="80">
                  <c:v>1.1006800804286827</c:v>
                </c:pt>
                <c:pt idx="81">
                  <c:v>1.8129932428253757</c:v>
                </c:pt>
                <c:pt idx="82">
                  <c:v>1.2238879289188906</c:v>
                </c:pt>
                <c:pt idx="83">
                  <c:v>1.0360150413523912</c:v>
                </c:pt>
                <c:pt idx="84">
                  <c:v>1.1195377639699262</c:v>
                </c:pt>
                <c:pt idx="85">
                  <c:v>1.2178547651679923</c:v>
                </c:pt>
                <c:pt idx="86">
                  <c:v>1.0634821542447859</c:v>
                </c:pt>
                <c:pt idx="87">
                  <c:v>1.1118566431306929</c:v>
                </c:pt>
                <c:pt idx="88">
                  <c:v>1.1576783545835563</c:v>
                </c:pt>
                <c:pt idx="89">
                  <c:v>0.93603087766134607</c:v>
                </c:pt>
                <c:pt idx="90">
                  <c:v>1.1587993402349031</c:v>
                </c:pt>
                <c:pt idx="91">
                  <c:v>0.97446565048845479</c:v>
                </c:pt>
                <c:pt idx="92">
                  <c:v>1.1385327866914574</c:v>
                </c:pt>
                <c:pt idx="93">
                  <c:v>0.92302242661740252</c:v>
                </c:pt>
                <c:pt idx="94">
                  <c:v>0.8785399774379804</c:v>
                </c:pt>
                <c:pt idx="95">
                  <c:v>1.1465037112838838</c:v>
                </c:pt>
                <c:pt idx="96">
                  <c:v>1.1641761715796948</c:v>
                </c:pt>
                <c:pt idx="97">
                  <c:v>1.0157239236990525</c:v>
                </c:pt>
                <c:pt idx="98">
                  <c:v>1.1917006889127932</c:v>
                </c:pt>
                <c:pt idx="99">
                  <c:v>1.2742252761448056</c:v>
                </c:pt>
                <c:pt idx="100">
                  <c:v>1.4498383811961659</c:v>
                </c:pt>
                <c:pt idx="101">
                  <c:v>0.79580483834604043</c:v>
                </c:pt>
                <c:pt idx="102">
                  <c:v>1.0622624584899851</c:v>
                </c:pt>
                <c:pt idx="103">
                  <c:v>1.0050325351360707</c:v>
                </c:pt>
                <c:pt idx="104">
                  <c:v>1.0327121234112824</c:v>
                </c:pt>
                <c:pt idx="105">
                  <c:v>1.0565309458355003</c:v>
                </c:pt>
                <c:pt idx="106">
                  <c:v>0.95183515155490994</c:v>
                </c:pt>
                <c:pt idx="107">
                  <c:v>1.0247235129862338</c:v>
                </c:pt>
                <c:pt idx="108">
                  <c:v>1.3204147357172114</c:v>
                </c:pt>
                <c:pt idx="109">
                  <c:v>0.96975760117718968</c:v>
                </c:pt>
                <c:pt idx="110">
                  <c:v>0.94079496787174854</c:v>
                </c:pt>
                <c:pt idx="111">
                  <c:v>1.2032721960720663</c:v>
                </c:pt>
                <c:pt idx="112">
                  <c:v>1.2739314227189917</c:v>
                </c:pt>
                <c:pt idx="113">
                  <c:v>1.0931154634213869</c:v>
                </c:pt>
                <c:pt idx="114">
                  <c:v>1.2357566473892672</c:v>
                </c:pt>
                <c:pt idx="115">
                  <c:v>1.0358269528935502</c:v>
                </c:pt>
                <c:pt idx="116">
                  <c:v>1.1267066367535514</c:v>
                </c:pt>
                <c:pt idx="117">
                  <c:v>1.369573149384812</c:v>
                </c:pt>
                <c:pt idx="118">
                  <c:v>1.1674612176569985</c:v>
                </c:pt>
                <c:pt idx="119">
                  <c:v>1.1578863870370844</c:v>
                </c:pt>
                <c:pt idx="120">
                  <c:v>1.7553046555297842</c:v>
                </c:pt>
                <c:pt idx="121">
                  <c:v>1.2285136499166132</c:v>
                </c:pt>
                <c:pt idx="122">
                  <c:v>1.4009297568623926</c:v>
                </c:pt>
                <c:pt idx="123">
                  <c:v>1.0974435340678153</c:v>
                </c:pt>
                <c:pt idx="124">
                  <c:v>1.184580562890357</c:v>
                </c:pt>
                <c:pt idx="125">
                  <c:v>2.1410397622208763</c:v>
                </c:pt>
                <c:pt idx="126">
                  <c:v>0.84276237046360924</c:v>
                </c:pt>
                <c:pt idx="127">
                  <c:v>1.1710549904286027</c:v>
                </c:pt>
                <c:pt idx="128">
                  <c:v>1.2481559753140863</c:v>
                </c:pt>
                <c:pt idx="129">
                  <c:v>1.2814457912718642</c:v>
                </c:pt>
                <c:pt idx="130">
                  <c:v>1.320383016225831</c:v>
                </c:pt>
                <c:pt idx="131">
                  <c:v>0.97044114650626856</c:v>
                </c:pt>
                <c:pt idx="132">
                  <c:v>0.95212940899630016</c:v>
                </c:pt>
                <c:pt idx="133">
                  <c:v>1.3288092350230845</c:v>
                </c:pt>
                <c:pt idx="134">
                  <c:v>1.3498146866344782</c:v>
                </c:pt>
                <c:pt idx="135">
                  <c:v>1.1353207681863129</c:v>
                </c:pt>
                <c:pt idx="136">
                  <c:v>1.0975393037820484</c:v>
                </c:pt>
                <c:pt idx="137">
                  <c:v>1.4328472469895266</c:v>
                </c:pt>
                <c:pt idx="138">
                  <c:v>0.97186835982388997</c:v>
                </c:pt>
                <c:pt idx="139">
                  <c:v>1.5992004490377545</c:v>
                </c:pt>
                <c:pt idx="140">
                  <c:v>1.2796932277298783</c:v>
                </c:pt>
                <c:pt idx="141">
                  <c:v>1.2066706556626949</c:v>
                </c:pt>
                <c:pt idx="142">
                  <c:v>0.97062336276962669</c:v>
                </c:pt>
                <c:pt idx="143">
                  <c:v>1.2798241209321415</c:v>
                </c:pt>
                <c:pt idx="144">
                  <c:v>1.0845289534969935</c:v>
                </c:pt>
                <c:pt idx="145">
                  <c:v>1.1950265289257667</c:v>
                </c:pt>
                <c:pt idx="146">
                  <c:v>1.0081825939185984</c:v>
                </c:pt>
                <c:pt idx="147">
                  <c:v>1.1370386254108775</c:v>
                </c:pt>
                <c:pt idx="148">
                  <c:v>1.2647716856133839</c:v>
                </c:pt>
                <c:pt idx="149">
                  <c:v>1.1561049525870286</c:v>
                </c:pt>
                <c:pt idx="150">
                  <c:v>1.4034485074830705</c:v>
                </c:pt>
                <c:pt idx="151">
                  <c:v>1.0297775044182842</c:v>
                </c:pt>
                <c:pt idx="152">
                  <c:v>1.0471197551600679</c:v>
                </c:pt>
                <c:pt idx="153">
                  <c:v>1.1255781780180734</c:v>
                </c:pt>
                <c:pt idx="154">
                  <c:v>1.0407963020746007</c:v>
                </c:pt>
                <c:pt idx="155">
                  <c:v>1.2016916665661039</c:v>
                </c:pt>
                <c:pt idx="156">
                  <c:v>1.0618222445019418</c:v>
                </c:pt>
                <c:pt idx="157">
                  <c:v>1.1265842655121805</c:v>
                </c:pt>
                <c:pt idx="158">
                  <c:v>1.1637770687598172</c:v>
                </c:pt>
                <c:pt idx="159">
                  <c:v>1.1120572464568543</c:v>
                </c:pt>
                <c:pt idx="160">
                  <c:v>2.7708963253536205</c:v>
                </c:pt>
                <c:pt idx="161">
                  <c:v>1.0314007325554722</c:v>
                </c:pt>
                <c:pt idx="162">
                  <c:v>1.1773954329931131</c:v>
                </c:pt>
                <c:pt idx="163">
                  <c:v>1.5569703576937599</c:v>
                </c:pt>
                <c:pt idx="164">
                  <c:v>1.1842098965773122</c:v>
                </c:pt>
                <c:pt idx="165">
                  <c:v>1.1629734148017215</c:v>
                </c:pt>
                <c:pt idx="166">
                  <c:v>1.0564969617447866</c:v>
                </c:pt>
                <c:pt idx="167">
                  <c:v>1.1868533816198348</c:v>
                </c:pt>
                <c:pt idx="168">
                  <c:v>1.0290797829899994</c:v>
                </c:pt>
                <c:pt idx="169">
                  <c:v>1.2635066393280925</c:v>
                </c:pt>
                <c:pt idx="170">
                  <c:v>1.1350271313427367</c:v>
                </c:pt>
                <c:pt idx="171">
                  <c:v>1.2768481348502727</c:v>
                </c:pt>
                <c:pt idx="172">
                  <c:v>1.1747210969072428</c:v>
                </c:pt>
                <c:pt idx="173">
                  <c:v>1.3430239531075092</c:v>
                </c:pt>
                <c:pt idx="174">
                  <c:v>1.1144857035840188</c:v>
                </c:pt>
                <c:pt idx="175">
                  <c:v>1.0883570607430748</c:v>
                </c:pt>
                <c:pt idx="176">
                  <c:v>1.340406071596242</c:v>
                </c:pt>
                <c:pt idx="177">
                  <c:v>1.0462679596704059</c:v>
                </c:pt>
                <c:pt idx="178">
                  <c:v>1.1592213163679255</c:v>
                </c:pt>
                <c:pt idx="179">
                  <c:v>1.3688496583760779</c:v>
                </c:pt>
                <c:pt idx="180">
                  <c:v>0.88817112044835234</c:v>
                </c:pt>
                <c:pt idx="181">
                  <c:v>1.1572390961831411</c:v>
                </c:pt>
                <c:pt idx="182">
                  <c:v>1.1136202245850488</c:v>
                </c:pt>
                <c:pt idx="183">
                  <c:v>1.0361821424433992</c:v>
                </c:pt>
                <c:pt idx="184">
                  <c:v>1.1199289662156047</c:v>
                </c:pt>
                <c:pt idx="185">
                  <c:v>1.2420459563536044</c:v>
                </c:pt>
                <c:pt idx="186">
                  <c:v>1.0103975154694076</c:v>
                </c:pt>
                <c:pt idx="187">
                  <c:v>1.1038898174048384</c:v>
                </c:pt>
                <c:pt idx="188">
                  <c:v>1.0732447975692894</c:v>
                </c:pt>
                <c:pt idx="189">
                  <c:v>1.1610793700517104</c:v>
                </c:pt>
                <c:pt idx="190">
                  <c:v>1.2838414487697187</c:v>
                </c:pt>
                <c:pt idx="191">
                  <c:v>1.3303291339719028</c:v>
                </c:pt>
                <c:pt idx="192">
                  <c:v>0.95458234594775204</c:v>
                </c:pt>
                <c:pt idx="193">
                  <c:v>1.1860837103695745</c:v>
                </c:pt>
                <c:pt idx="194">
                  <c:v>1.093460161986141</c:v>
                </c:pt>
                <c:pt idx="195">
                  <c:v>1.0168938051572343</c:v>
                </c:pt>
                <c:pt idx="196">
                  <c:v>1.1402523657412884</c:v>
                </c:pt>
                <c:pt idx="197">
                  <c:v>0.98801271868244189</c:v>
                </c:pt>
                <c:pt idx="198">
                  <c:v>0.94639981901465864</c:v>
                </c:pt>
                <c:pt idx="199">
                  <c:v>1.4233751333975881</c:v>
                </c:pt>
                <c:pt idx="200">
                  <c:v>0.99239725075519969</c:v>
                </c:pt>
                <c:pt idx="201">
                  <c:v>1.1861408671841895</c:v>
                </c:pt>
                <c:pt idx="202">
                  <c:v>1.1392446711216326</c:v>
                </c:pt>
                <c:pt idx="203">
                  <c:v>1.0073128796921937</c:v>
                </c:pt>
                <c:pt idx="204">
                  <c:v>1.1254504022946026</c:v>
                </c:pt>
                <c:pt idx="205">
                  <c:v>1.1042355582249441</c:v>
                </c:pt>
                <c:pt idx="206">
                  <c:v>1.0436615642653742</c:v>
                </c:pt>
                <c:pt idx="207">
                  <c:v>1.0372430535644432</c:v>
                </c:pt>
                <c:pt idx="208">
                  <c:v>1.3069024386037005</c:v>
                </c:pt>
                <c:pt idx="209">
                  <c:v>1.078679325920098</c:v>
                </c:pt>
                <c:pt idx="210">
                  <c:v>1.2537645959732555</c:v>
                </c:pt>
                <c:pt idx="211">
                  <c:v>0.99785141237039809</c:v>
                </c:pt>
                <c:pt idx="212">
                  <c:v>1.0898099254269444</c:v>
                </c:pt>
                <c:pt idx="213">
                  <c:v>1.1933699089814067</c:v>
                </c:pt>
                <c:pt idx="214">
                  <c:v>0.91139279757416714</c:v>
                </c:pt>
                <c:pt idx="215">
                  <c:v>0.98997435406083234</c:v>
                </c:pt>
                <c:pt idx="216">
                  <c:v>1.8115781322986673</c:v>
                </c:pt>
                <c:pt idx="217">
                  <c:v>1.0129293306002971</c:v>
                </c:pt>
                <c:pt idx="218">
                  <c:v>1.1434081893050272</c:v>
                </c:pt>
                <c:pt idx="219">
                  <c:v>1.2239085014321376</c:v>
                </c:pt>
                <c:pt idx="220">
                  <c:v>1.440475585590163</c:v>
                </c:pt>
                <c:pt idx="221">
                  <c:v>1.2615474711137427</c:v>
                </c:pt>
                <c:pt idx="222">
                  <c:v>1.8508724957775757</c:v>
                </c:pt>
                <c:pt idx="223">
                  <c:v>0.98480430100117466</c:v>
                </c:pt>
                <c:pt idx="224">
                  <c:v>1.119938757707212</c:v>
                </c:pt>
                <c:pt idx="225">
                  <c:v>1.1957930109698369</c:v>
                </c:pt>
                <c:pt idx="226">
                  <c:v>1.1675162145237259</c:v>
                </c:pt>
                <c:pt idx="227">
                  <c:v>1.1965231485526671</c:v>
                </c:pt>
                <c:pt idx="228">
                  <c:v>1.3779204436547019</c:v>
                </c:pt>
                <c:pt idx="229">
                  <c:v>1.882620446408652</c:v>
                </c:pt>
                <c:pt idx="230">
                  <c:v>1.3068548264903277</c:v>
                </c:pt>
                <c:pt idx="231">
                  <c:v>1.2066108655118093</c:v>
                </c:pt>
                <c:pt idx="232">
                  <c:v>1.3273666999476796</c:v>
                </c:pt>
                <c:pt idx="233">
                  <c:v>1.0269684953406191</c:v>
                </c:pt>
                <c:pt idx="234">
                  <c:v>1.1125657248020344</c:v>
                </c:pt>
                <c:pt idx="235">
                  <c:v>1.1925332655683867</c:v>
                </c:pt>
                <c:pt idx="236">
                  <c:v>1.5586516948315428</c:v>
                </c:pt>
                <c:pt idx="237">
                  <c:v>1.1260940849825558</c:v>
                </c:pt>
                <c:pt idx="238">
                  <c:v>1.3455845586049529</c:v>
                </c:pt>
                <c:pt idx="239">
                  <c:v>1.2147636319693111</c:v>
                </c:pt>
                <c:pt idx="240">
                  <c:v>1.1522681764157041</c:v>
                </c:pt>
                <c:pt idx="241">
                  <c:v>1.2897813369843869</c:v>
                </c:pt>
                <c:pt idx="242">
                  <c:v>1.5931737840145517</c:v>
                </c:pt>
                <c:pt idx="243">
                  <c:v>1.0712274693551758</c:v>
                </c:pt>
                <c:pt idx="244">
                  <c:v>1.7234568831729435</c:v>
                </c:pt>
                <c:pt idx="245">
                  <c:v>1.0802875251961213</c:v>
                </c:pt>
                <c:pt idx="246">
                  <c:v>1.3675630365244356</c:v>
                </c:pt>
                <c:pt idx="247">
                  <c:v>1.1971674203608704</c:v>
                </c:pt>
                <c:pt idx="248">
                  <c:v>1.0305777080699985</c:v>
                </c:pt>
                <c:pt idx="249">
                  <c:v>0.87004731571867788</c:v>
                </c:pt>
                <c:pt idx="250">
                  <c:v>1.5821937547386347</c:v>
                </c:pt>
                <c:pt idx="251">
                  <c:v>0.97054922001913813</c:v>
                </c:pt>
                <c:pt idx="252">
                  <c:v>1.0351399392642027</c:v>
                </c:pt>
                <c:pt idx="253">
                  <c:v>1.1699002951339887</c:v>
                </c:pt>
                <c:pt idx="254">
                  <c:v>1.3743963714160303</c:v>
                </c:pt>
                <c:pt idx="255">
                  <c:v>1.0368843603813491</c:v>
                </c:pt>
                <c:pt idx="256">
                  <c:v>0.95452148408912119</c:v>
                </c:pt>
                <c:pt idx="257">
                  <c:v>1.004782441285027</c:v>
                </c:pt>
                <c:pt idx="258">
                  <c:v>1.2184523795596041</c:v>
                </c:pt>
                <c:pt idx="259">
                  <c:v>1.4317401769086191</c:v>
                </c:pt>
                <c:pt idx="260">
                  <c:v>1.1206278242923164</c:v>
                </c:pt>
                <c:pt idx="261">
                  <c:v>1.0533580362161574</c:v>
                </c:pt>
                <c:pt idx="262">
                  <c:v>1.0590056530907845</c:v>
                </c:pt>
                <c:pt idx="263">
                  <c:v>1.3221582672330232</c:v>
                </c:pt>
                <c:pt idx="264">
                  <c:v>1.3041305009405928</c:v>
                </c:pt>
                <c:pt idx="265">
                  <c:v>0.97972117372430523</c:v>
                </c:pt>
                <c:pt idx="266">
                  <c:v>1.0665147377109305</c:v>
                </c:pt>
                <c:pt idx="267">
                  <c:v>1.1474387207718644</c:v>
                </c:pt>
                <c:pt idx="268">
                  <c:v>1.5271891895471696</c:v>
                </c:pt>
                <c:pt idx="269">
                  <c:v>1.2358065597637828</c:v>
                </c:pt>
                <c:pt idx="270">
                  <c:v>1.4789813393937918</c:v>
                </c:pt>
                <c:pt idx="271">
                  <c:v>1.2095135720024168</c:v>
                </c:pt>
                <c:pt idx="272">
                  <c:v>1.0671092998570737</c:v>
                </c:pt>
                <c:pt idx="273">
                  <c:v>1.1335166198001811</c:v>
                </c:pt>
                <c:pt idx="274">
                  <c:v>1.2675013875488272</c:v>
                </c:pt>
                <c:pt idx="275">
                  <c:v>1.2658750613268464</c:v>
                </c:pt>
                <c:pt idx="276">
                  <c:v>1.2185428220910561</c:v>
                </c:pt>
                <c:pt idx="277">
                  <c:v>1.3092657840435091</c:v>
                </c:pt>
                <c:pt idx="278">
                  <c:v>1.0656533690921188</c:v>
                </c:pt>
                <c:pt idx="279">
                  <c:v>1.9894459492690126</c:v>
                </c:pt>
                <c:pt idx="280">
                  <c:v>1.0601301219933452</c:v>
                </c:pt>
                <c:pt idx="281">
                  <c:v>1.3723817410882673</c:v>
                </c:pt>
                <c:pt idx="282">
                  <c:v>1.161919326434262</c:v>
                </c:pt>
                <c:pt idx="283">
                  <c:v>1.0900079162008507</c:v>
                </c:pt>
                <c:pt idx="284">
                  <c:v>1.0477431888979536</c:v>
                </c:pt>
                <c:pt idx="285">
                  <c:v>0.98184661671447748</c:v>
                </c:pt>
                <c:pt idx="286">
                  <c:v>1.0646382731744362</c:v>
                </c:pt>
                <c:pt idx="287">
                  <c:v>1.3318601641479866</c:v>
                </c:pt>
                <c:pt idx="288">
                  <c:v>0.89233322066014531</c:v>
                </c:pt>
                <c:pt idx="289">
                  <c:v>1.1417202421047556</c:v>
                </c:pt>
                <c:pt idx="290">
                  <c:v>1.1177160667022339</c:v>
                </c:pt>
                <c:pt idx="291">
                  <c:v>1.6044297905827667</c:v>
                </c:pt>
                <c:pt idx="292">
                  <c:v>1.573524982473697</c:v>
                </c:pt>
                <c:pt idx="293">
                  <c:v>1.2595187693552838</c:v>
                </c:pt>
                <c:pt idx="294">
                  <c:v>1.4454235944123894</c:v>
                </c:pt>
                <c:pt idx="295">
                  <c:v>1.0221512111039259</c:v>
                </c:pt>
                <c:pt idx="296">
                  <c:v>1.2188631661335814</c:v>
                </c:pt>
                <c:pt idx="297">
                  <c:v>1.2264900826862384</c:v>
                </c:pt>
                <c:pt idx="298">
                  <c:v>1.2032507944818533</c:v>
                </c:pt>
                <c:pt idx="299">
                  <c:v>0.938401626082908</c:v>
                </c:pt>
                <c:pt idx="300">
                  <c:v>0.94710678018593586</c:v>
                </c:pt>
                <c:pt idx="301">
                  <c:v>1.1344416954984839</c:v>
                </c:pt>
                <c:pt idx="302">
                  <c:v>1.206558409065229</c:v>
                </c:pt>
                <c:pt idx="303">
                  <c:v>1.1980703231671928</c:v>
                </c:pt>
                <c:pt idx="304">
                  <c:v>1.0119534620357455</c:v>
                </c:pt>
                <c:pt idx="305">
                  <c:v>1.073287098367036</c:v>
                </c:pt>
                <c:pt idx="306">
                  <c:v>0.9616094072876884</c:v>
                </c:pt>
                <c:pt idx="307">
                  <c:v>0.99208732708935465</c:v>
                </c:pt>
                <c:pt idx="308">
                  <c:v>1.0366259854189812</c:v>
                </c:pt>
                <c:pt idx="309">
                  <c:v>1.0094114700527794</c:v>
                </c:pt>
                <c:pt idx="310">
                  <c:v>1.2001626371323568</c:v>
                </c:pt>
                <c:pt idx="311">
                  <c:v>1.3314309984589672</c:v>
                </c:pt>
                <c:pt idx="312">
                  <c:v>0.97962445202452897</c:v>
                </c:pt>
                <c:pt idx="313">
                  <c:v>1.1147300126195629</c:v>
                </c:pt>
                <c:pt idx="314">
                  <c:v>0.88906611075704045</c:v>
                </c:pt>
                <c:pt idx="315">
                  <c:v>0.95893746211539277</c:v>
                </c:pt>
                <c:pt idx="316">
                  <c:v>1.2083635766114171</c:v>
                </c:pt>
                <c:pt idx="317">
                  <c:v>1.169622782386698</c:v>
                </c:pt>
                <c:pt idx="318">
                  <c:v>0.95110459960380578</c:v>
                </c:pt>
                <c:pt idx="319">
                  <c:v>1.3287363742701299</c:v>
                </c:pt>
                <c:pt idx="320">
                  <c:v>1.3075217022692007</c:v>
                </c:pt>
                <c:pt idx="321">
                  <c:v>0.9700406069065991</c:v>
                </c:pt>
                <c:pt idx="322">
                  <c:v>0.92426350794472234</c:v>
                </c:pt>
                <c:pt idx="323">
                  <c:v>1.2142587874091868</c:v>
                </c:pt>
                <c:pt idx="324">
                  <c:v>0.99001647438208551</c:v>
                </c:pt>
                <c:pt idx="325">
                  <c:v>1.1488144489615086</c:v>
                </c:pt>
                <c:pt idx="326">
                  <c:v>0.91990908185630027</c:v>
                </c:pt>
                <c:pt idx="327">
                  <c:v>0.76624581005586589</c:v>
                </c:pt>
                <c:pt idx="328">
                  <c:v>1.1166381802012117</c:v>
                </c:pt>
                <c:pt idx="329">
                  <c:v>1.5832695152902687</c:v>
                </c:pt>
                <c:pt idx="330">
                  <c:v>1.0688761338645896</c:v>
                </c:pt>
                <c:pt idx="331">
                  <c:v>1.6628736309511716</c:v>
                </c:pt>
                <c:pt idx="332">
                  <c:v>0.81612800185846623</c:v>
                </c:pt>
                <c:pt idx="333">
                  <c:v>1.5578598814918088</c:v>
                </c:pt>
                <c:pt idx="334">
                  <c:v>1.1007773122001578</c:v>
                </c:pt>
                <c:pt idx="335">
                  <c:v>0.826408165783104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872-47AD-AE6D-7515691924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1891776"/>
        <c:axId val="758114928"/>
      </c:scatterChart>
      <c:valAx>
        <c:axId val="491891776"/>
        <c:scaling>
          <c:orientation val="minMax"/>
          <c:max val="14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Genomic U position</a:t>
                </a:r>
              </a:p>
            </c:rich>
          </c:tx>
          <c:layout>
            <c:manualLayout>
              <c:xMode val="edge"/>
              <c:yMode val="edge"/>
              <c:x val="0.39236679790026247"/>
              <c:y val="0.859212598425196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8114928"/>
        <c:crosses val="autoZero"/>
        <c:crossBetween val="midCat"/>
        <c:majorUnit val="500"/>
      </c:valAx>
      <c:valAx>
        <c:axId val="758114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old</a:t>
                </a:r>
                <a:r>
                  <a:rPr lang="en-US" baseline="0" dirty="0"/>
                  <a:t> </a:t>
                </a:r>
                <a:r>
                  <a:rPr lang="en-US" dirty="0"/>
                  <a:t>chan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189177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276</cdr:x>
      <cdr:y>0.6873</cdr:y>
    </cdr:from>
    <cdr:to>
      <cdr:x>0.3276</cdr:x>
      <cdr:y>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DD64477A-8DE2-42C4-8F68-DD4CD9DA7CE8}"/>
            </a:ext>
          </a:extLst>
        </cdr:cNvPr>
        <cdr:cNvSpPr txBox="1"/>
      </cdr:nvSpPr>
      <cdr:spPr>
        <a:xfrm xmlns:a="http://schemas.openxmlformats.org/drawingml/2006/main">
          <a:off x="583407" y="2638426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89AF7-F546-4D69-B848-B2429100DE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3BE731-E2AB-4124-9FE6-63B13A3EC7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5DEB3E-E865-44DC-A577-90D1BA0BA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5B357D-34E9-45ED-89A4-71D83F705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05FFA-9E6F-4DDD-9673-F77A513A3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25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AED50-200B-4D91-82BF-9E783176B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99EC62-2B6E-4907-A732-430075D5D9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F91263-B9F9-4688-A875-C24CF3225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3636E4-9BB5-4DB8-B423-875EC8A86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61C4B-0029-44B8-A11F-8B034EF47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59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1D8D74-3750-4BC0-AA86-EC7871C78D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70F240-80FE-4C6E-B59D-3E620BA7D4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8CF8DD-F19F-4203-8CD6-0C326A613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DF66F-F0E2-4FA6-A747-8564D18DF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79C640-C772-4B57-A71B-ACB74C49E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800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DB65D-53CE-4BEF-B5A7-406E764051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2595C2-BA39-4FE2-B5A9-FCB07EE05A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EFD1A4-5002-48F0-AAC6-304FFF72A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A4DC9F-7CAA-4955-9204-00F913BD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C52F2B-0418-4709-9EE5-010420BE5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978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A0ACA-04FA-4DDF-9375-9FC7F03C5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91CB06-E621-42AB-9A63-419F1A0A7B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B1A0F8-ED45-4E54-B845-BAA35760E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A2509A-30AE-4306-9BC4-590D7CC98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5204A4-6897-41E6-8A61-AA5A336E1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141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3A03AA-76EC-4226-8116-598E2A285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BBFD0E-B6F2-4973-A485-B5CFEA4579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479404-1693-4B5D-869D-8C401BCE52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DE9189-F2A9-4782-ADCE-C9065C63B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C2A971-91A7-445D-B6C7-F79ED03C8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CA71E9-9794-4507-A3F4-FB90E6148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16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02891-50A6-4504-9479-28C1DE24F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A7D84D-BA3D-460C-A312-7FB51F08B7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C89355-A07D-48E9-BEBC-CBD4D4D857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BA25E2-35DC-4987-9F87-3C8DE33A93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E2BF8B-21BA-4223-BFAA-2B12862EDC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732DB1-0811-431C-A324-A6AD950F3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876823-54B2-4037-B3D7-29CEC7B97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730572-C12C-4182-9A4B-80D6E0E27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402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A2A750-E37A-4BEE-A6CB-C95972ECE0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79216B-C936-457F-BCBB-3F45CB9A0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47ABB7-93DE-4DF6-8A6D-BC241E313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20436A-BCAA-4FE7-88D3-10DE6D703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059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01D880-B3FE-4F3F-9109-245A12CFF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A16CEC-9319-4B88-B202-FB261D85F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20FD08-2F86-440A-A498-74A5B3E57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603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8EED1-7282-4A8C-9DF8-FDD9E34398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498926-A623-4644-86DD-D6294AF1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FD9ED8-1158-4B93-AC50-F595D72EE7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2725A6-3201-46B4-8C10-9C7B07AA9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ED0B25-17CD-4CDB-BD28-853796990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8A1166-D451-4550-B110-81ACDCFD6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711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65547-B136-4811-86AC-5343C8E2D5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DD4499-C2C5-47D7-9765-CE56C3C967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8A1CD4-F009-477C-92DE-40E36B7C67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F86E9F-815D-4C32-AFCA-D3D969790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786461-1204-449A-971E-418F38358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A3E93F-E31E-493D-A987-A6E814B77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65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946372-ED84-4FC3-A485-4FC2A06CD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24DE65-10A7-4BEF-ACFB-F833226EFA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B7935A-808C-4A58-8FFF-2B16A71F00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ABCF4-C71A-4CDE-8E9B-D0D8D4467DEF}" type="datetimeFigureOut">
              <a:rPr lang="en-US" smtClean="0"/>
              <a:t>7/1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07BE5-4E01-476D-AB71-C66169CDB5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E98693-DB43-4CA8-9B1B-BE7495FF2C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19D5CB-04CB-4933-AD22-88986616E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442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emf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13" Type="http://schemas.openxmlformats.org/officeDocument/2006/relationships/image" Target="../media/image22.jpg"/><Relationship Id="rId3" Type="http://schemas.openxmlformats.org/officeDocument/2006/relationships/image" Target="../media/image13.jpg"/><Relationship Id="rId7" Type="http://schemas.openxmlformats.org/officeDocument/2006/relationships/image" Target="../media/image16.jpg"/><Relationship Id="rId12" Type="http://schemas.openxmlformats.org/officeDocument/2006/relationships/image" Target="../media/image21.jpg"/><Relationship Id="rId2" Type="http://schemas.openxmlformats.org/officeDocument/2006/relationships/image" Target="../media/image12.jpg"/><Relationship Id="rId16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20.jpg"/><Relationship Id="rId5" Type="http://schemas.openxmlformats.org/officeDocument/2006/relationships/image" Target="../media/image15.png"/><Relationship Id="rId15" Type="http://schemas.openxmlformats.org/officeDocument/2006/relationships/image" Target="../media/image24.jpg"/><Relationship Id="rId10" Type="http://schemas.openxmlformats.org/officeDocument/2006/relationships/image" Target="../media/image19.jpg"/><Relationship Id="rId4" Type="http://schemas.openxmlformats.org/officeDocument/2006/relationships/image" Target="../media/image14.jpg"/><Relationship Id="rId9" Type="http://schemas.openxmlformats.org/officeDocument/2006/relationships/image" Target="../media/image18.jpg"/><Relationship Id="rId14" Type="http://schemas.openxmlformats.org/officeDocument/2006/relationships/image" Target="../media/image23.jp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"/><Relationship Id="rId5" Type="http://schemas.openxmlformats.org/officeDocument/2006/relationships/image" Target="../media/image29.jpg"/><Relationship Id="rId4" Type="http://schemas.openxmlformats.org/officeDocument/2006/relationships/image" Target="../media/image28.jp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175072B7-B9FE-49F9-A41F-3008594E74C1}"/>
              </a:ext>
            </a:extLst>
          </p:cNvPr>
          <p:cNvGrpSpPr/>
          <p:nvPr/>
        </p:nvGrpSpPr>
        <p:grpSpPr>
          <a:xfrm>
            <a:off x="3794760" y="3354201"/>
            <a:ext cx="4754880" cy="3116580"/>
            <a:chOff x="1050005" y="312420"/>
            <a:chExt cx="4754880" cy="3116580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3AE1CE4D-0EEC-4006-907D-F9572A84EFE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4140796"/>
                </p:ext>
              </p:extLst>
            </p:nvPr>
          </p:nvGraphicFramePr>
          <p:xfrm>
            <a:off x="1118585" y="312420"/>
            <a:ext cx="4572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C3B1D375-3597-4043-9779-AD0938C96F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6211188"/>
                </p:ext>
              </p:extLst>
            </p:nvPr>
          </p:nvGraphicFramePr>
          <p:xfrm>
            <a:off x="1050005" y="2057400"/>
            <a:ext cx="475488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FE84252D-641F-4DEF-9BB5-3DD3D660149F}"/>
              </a:ext>
            </a:extLst>
          </p:cNvPr>
          <p:cNvGrpSpPr/>
          <p:nvPr/>
        </p:nvGrpSpPr>
        <p:grpSpPr>
          <a:xfrm>
            <a:off x="1264920" y="289560"/>
            <a:ext cx="4754880" cy="3139440"/>
            <a:chOff x="6019800" y="312420"/>
            <a:chExt cx="4754880" cy="3139440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466D0225-DEFD-4C04-A01B-9A29CFF0283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0084842"/>
                </p:ext>
              </p:extLst>
            </p:nvPr>
          </p:nvGraphicFramePr>
          <p:xfrm>
            <a:off x="6096000" y="312420"/>
            <a:ext cx="4572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BC3DD5B7-4243-403A-B527-FC57914B08F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7015445"/>
                </p:ext>
              </p:extLst>
            </p:nvPr>
          </p:nvGraphicFramePr>
          <p:xfrm>
            <a:off x="6019800" y="2080260"/>
            <a:ext cx="475488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C85A72C-6CC6-48A4-9284-92BB6402E17E}"/>
              </a:ext>
            </a:extLst>
          </p:cNvPr>
          <p:cNvGrpSpPr/>
          <p:nvPr/>
        </p:nvGrpSpPr>
        <p:grpSpPr>
          <a:xfrm>
            <a:off x="6096000" y="289560"/>
            <a:ext cx="4754880" cy="3139440"/>
            <a:chOff x="3531793" y="3268203"/>
            <a:chExt cx="4754880" cy="3139440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F943C5A5-8BFC-459B-B702-0F01716D5E9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20529225"/>
                </p:ext>
              </p:extLst>
            </p:nvPr>
          </p:nvGraphicFramePr>
          <p:xfrm>
            <a:off x="3607993" y="3268203"/>
            <a:ext cx="4572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5562625C-37F3-480A-AF46-B18B97608CC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32978053"/>
                </p:ext>
              </p:extLst>
            </p:nvPr>
          </p:nvGraphicFramePr>
          <p:xfrm>
            <a:off x="3531793" y="5036043"/>
            <a:ext cx="475488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DFC74FE3-2878-4740-A728-17B558E10D15}"/>
              </a:ext>
            </a:extLst>
          </p:cNvPr>
          <p:cNvSpPr txBox="1"/>
          <p:nvPr/>
        </p:nvSpPr>
        <p:spPr>
          <a:xfrm>
            <a:off x="9563878" y="6488668"/>
            <a:ext cx="2628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32077726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FC4C38D-A3BE-4778-B15D-081E5E24A9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1028301"/>
            <a:ext cx="6095999" cy="3657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349438F-C4EC-4794-B8E1-729D501ABA90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6A598E-C6B9-4576-889C-F25E2E4CA744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186709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AD233CED-583A-4D01-87F8-8FED0E3EF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52D565-9B0B-487E-B293-0792D55E11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</a:t>
            </a:r>
            <a:r>
              <a:rPr lang="en-US" altLang="zh-CN" b="1" dirty="0"/>
              <a:t>Figure S5</a:t>
            </a:r>
            <a:r>
              <a:rPr lang="en-US" altLang="zh-CN" dirty="0"/>
              <a:t>. Triplicate FHV PAR-CL signals.</a:t>
            </a:r>
          </a:p>
          <a:p>
            <a:pPr marL="0" indent="0">
              <a:buNone/>
            </a:pPr>
            <a:r>
              <a:rPr lang="en-US" dirty="0"/>
              <a:t>Triplicate FHV PAR-CL signals were box-plotted for RNA 1 </a:t>
            </a:r>
            <a:r>
              <a:rPr lang="en-US" b="1" dirty="0"/>
              <a:t>(a)</a:t>
            </a:r>
            <a:r>
              <a:rPr lang="en-US" dirty="0"/>
              <a:t> and RNA 2 </a:t>
            </a:r>
            <a:r>
              <a:rPr lang="en-US" b="1" dirty="0"/>
              <a:t>(b)</a:t>
            </a:r>
            <a:r>
              <a:rPr lang="en-US" dirty="0"/>
              <a:t>, respectively, without background threshold filter. X-axis is not continuous. </a:t>
            </a:r>
          </a:p>
        </p:txBody>
      </p:sp>
    </p:spTree>
    <p:extLst>
      <p:ext uri="{BB962C8B-B14F-4D97-AF65-F5344CB8AC3E}">
        <p14:creationId xmlns:p14="http://schemas.microsoft.com/office/powerpoint/2010/main" val="17497589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B5AE8DA-3459-4CE9-9BB3-6DD9B9BDEDB1}"/>
              </a:ext>
            </a:extLst>
          </p:cNvPr>
          <p:cNvGraphicFramePr>
            <a:graphicFrameLocks noGrp="1"/>
          </p:cNvGraphicFramePr>
          <p:nvPr/>
        </p:nvGraphicFramePr>
        <p:xfrm>
          <a:off x="800560" y="538002"/>
          <a:ext cx="5029200" cy="3222248"/>
        </p:xfrm>
        <a:graphic>
          <a:graphicData uri="http://schemas.openxmlformats.org/drawingml/2006/table">
            <a:tbl>
              <a:tblPr/>
              <a:tblGrid>
                <a:gridCol w="529389">
                  <a:extLst>
                    <a:ext uri="{9D8B030D-6E8A-4147-A177-3AD203B41FA5}">
                      <a16:colId xmlns:a16="http://schemas.microsoft.com/office/drawing/2014/main" val="2191723797"/>
                    </a:ext>
                  </a:extLst>
                </a:gridCol>
                <a:gridCol w="4499811">
                  <a:extLst>
                    <a:ext uri="{9D8B030D-6E8A-4147-A177-3AD203B41FA5}">
                      <a16:colId xmlns:a16="http://schemas.microsoft.com/office/drawing/2014/main" val="872080380"/>
                    </a:ext>
                  </a:extLst>
                </a:gridCol>
              </a:tblGrid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 position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Flanking sequence (101nt.)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9554702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59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UAUCUGGGUGCGGUGCCGUAGUGUACUGCAUAUCCAAGUUCUGGGGCUAUGGGGCAAUUGCGCCCUAUCCUCAGAGUGGAGGGAACCGAGUUACACGCG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5053075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233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UGUCACCAAUUAGUCCAACUGUGUAUAAACCUACAAUGCCACGCGUCCAUUGGCCAGUAACCAGUGACGCAGAUGUACCAGAAGUGAGCGCGCGCCAAU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697335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91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AUGGUUCAAGCAUUCCGCCCAGAAUACAGAGAUGAGAUCAUUUCAUUCAUGGACACGAUAAUCAAUUGUCCAGCUAAAGCUAAACGCUUUGGUUUCCGAU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389408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515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UAGAAGCCGGAAUAAAGAGAAGCCCUACUGGUUGACUUGUGACGGAUCAUGGCCACAGCAUCCGCAAGACGCCCAUUUGAUGAAGCAGGUUUUAAUCAA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8727216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873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UUCCAGCUGGAUGCAAAGAAACAUCGCCCAAAAGGCCAUGGUUCAAGCAUUCCGCCCAGAAUACAGAGAUGAGAUCAUUUCAUUCAUGGACACGAUAAU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7925996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2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CUCAGAGUGGAGGGAACCGAGUUACACGCGCAUUGCAACGGGCUGUCAUUGACAAAACGAAGACCCCGAUAGAGACACGUUUCUAUCCGCUUGACAGC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8800925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50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CCGUCGGUGAUUUGGCACAAGAUUUCCGUAAUGACACACCUGCGGAUGAUGCCUUCAUCGUCGGUGUUGAUGUUGAUUAUUAUGUCACCGAGCCUGAUGU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755453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16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GUAUGGGACACAAGGACCCGCAAUACACAUCCAUGAUUGUCCAGUAUUAUACUGGCAAGAAGGUAGUGUCACCAAUUAGUCCAACUGUGUAUAAACCUA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430506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639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UUAACCCGAAGAAAGUGAGCGGUUUUGAUGCUGACUCACCAUUCACCAUUAAGAACAACUUGGUUGAAUAUAAGGUUAGCGGUGGAGCAGCAUGGGUCC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5824163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068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GUCGAGAAGGGGAGCAUGCUCAGAUUACUAUCGAGAAAGAAAAGUUGGAUAUGCUCUCGGGAUUAUCCGCCACCCAAUCUGUCAACGCUAGGCUUAUC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524117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07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ACAAUGGAUGUGUCGAAUUUACAGCUCUGACCUUUGAGCAUCCUGAUGCUGAACCUGAAGAUUUGUUCCGUUUAAUCGGACCGAAGUGCGGUGAUGAU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227585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69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AUUGUAGACCGUGGACUGAUUGUCCAGAUCGUGCACUUGUCUACACUAUACCGCAAUAUGUCAUUUGGCGAUUUAAUUGGAUUGAUACCGAACUACAC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7630062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63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ACACACCUUUAACCCGAAGAAAGUGAGCGGUUUUGAUGCUGACUCACCAUUCACCAUUAAGAACAACUUGGUUGAAUAUAAGGUUAGCGGUGGAGCAGC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700552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75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CGUGGACGAAUCGUUACCAAUGUUAAACGAUGCCAAGCAAACUCGCGCUAAUCCAGGAACUUCCCGACCGCAUUCAAACGGCGGUGGAAGCAGCCAU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9676464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48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UGCGAAACCAUUUCCACUUCGCCGUCGGUGAUUUGGCACAAGAUUUCCGUAAUGACACACCUGCGGAUGAUGCCUUCAUCGUCGGUGUUGAUGUUGAUU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165668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576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CGCAAGACGCCCAUUUGAUGAAGCAGGUUUUAAUCAAACGUACAGCCAUUGACGAAGAUCAGGUCGAUGCACUCAUUGGGCGUUUUGCCGCAAUGAA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1391393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8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ACUGAUUGUCCAGAUCGUGCACUUGUCUACACUAUACCGCAAUAUGUCAUUUGGCGAUUUAAUUGGAUUGAUACCGAACUACACGUGCGAAAACUGAAA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4183211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15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AACGCUAGGCUUAUCGGUAUGGGACACAAGGACCCGCAAUACACAUCCAUGAUUGUCCAGUAUUAUACUGGCAAGAAGGUAGUGUCACCAAUUAGUCCA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88821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65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AAAGUGAGCGGUUUUGAUGCUGACUCACCAUUCACCAUUAAGAACAACUUGGUUGAAUAUAAGGUUAGCGGUGGAGCAGCAUGGGUCCAUCCAGUUUG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8645352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5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AUAAAAUCCAUCAUUGUAGACCGUGGACUGAUUGUCCAGAUCGUGCACUUGUCUACACUAUACCGCAAUAUGUCAUUUGGCGAUUUAAUUGGAUUGAU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224105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07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GAGAAGGGGAGCAUGCUCAGAUUACUAUCGAGAAAGAAAAGUUGGAUAUGCUCUCGGGAUUAUCCGCCACCCAAUCUGUCAACGCUAGGCUUAUCGGU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313957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3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GAUUGGUUUGGAGAAGGUUGGCUAUCAUAAAAUCCAUCAUUGUAGACCGUGGACUGAUUGUCCAGAUCGUGCACUUGUCUACACUAUACCGCAAUAUGU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0706020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67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UUCCAGACAUACUUUUCAUCUUGAAAGUUUCCAGAUACACCUUAGCGUAUUCGGAUAUAGUUCUACAUGCCGAACACAAUGAACAUUGGUAUUACCCCG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008103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96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ACACGAUAAUCAAUUGUCCAGCUAAAGCUAAACGCUUUGGUUUCCGAUAUGAGCCUGGUGUAGGCGUUAAAAGUGGAAGUCCAACAACCACGCCACAUA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9411681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81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CAGGAACUUCCCGACCGCAUUCAAACGGCGGUGGAAGCAGCCAUGGGAAUGAGCUACCAAGACGCACCGAACAACGUGCGCAGGGACCUCGACAACCUGC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3174728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56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GAAACAAAUAAAACAGAAAAGCGAACCUAAACAAUGACUCUAAAAGUUAUUCUUGGAGAACACCAGAUCACCCGAACUGAAUUGUUAGUCGGGAUUGCAA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837082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118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CUGAACCUGAAGAUUUGUUCCGUUUAAUCGGACCGAAGUGCGGUGAUGAUGGUCUUUCCCGGGCUAUCAUUCAAAAAUCAAUUAAUCGCGCUGCCAAGUG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2233595"/>
                  </a:ext>
                </a:extLst>
              </a:tr>
              <a:tr h="1111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66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UCCGGUUUUCCAGACAUACUUUUCAUCUUGAAAGUUUCCAGAUACACCUUAGCGUAUUCGGAUAUAGUUCUACAUGCCGAACACAAUGAACAUUGGUAUU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7171313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E597F2DB-69AA-4350-8F4A-05DE47D554E0}"/>
              </a:ext>
            </a:extLst>
          </p:cNvPr>
          <p:cNvGraphicFramePr>
            <a:graphicFrameLocks noGrp="1"/>
          </p:cNvGraphicFramePr>
          <p:nvPr/>
        </p:nvGraphicFramePr>
        <p:xfrm>
          <a:off x="800560" y="4092966"/>
          <a:ext cx="5029200" cy="1755648"/>
        </p:xfrm>
        <a:graphic>
          <a:graphicData uri="http://schemas.openxmlformats.org/drawingml/2006/table">
            <a:tbl>
              <a:tblPr/>
              <a:tblGrid>
                <a:gridCol w="540931">
                  <a:extLst>
                    <a:ext uri="{9D8B030D-6E8A-4147-A177-3AD203B41FA5}">
                      <a16:colId xmlns:a16="http://schemas.microsoft.com/office/drawing/2014/main" val="2914626112"/>
                    </a:ext>
                  </a:extLst>
                </a:gridCol>
                <a:gridCol w="4488269">
                  <a:extLst>
                    <a:ext uri="{9D8B030D-6E8A-4147-A177-3AD203B41FA5}">
                      <a16:colId xmlns:a16="http://schemas.microsoft.com/office/drawing/2014/main" val="3595128349"/>
                    </a:ext>
                  </a:extLst>
                </a:gridCol>
              </a:tblGrid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 positio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Flanking sequence (101nt.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982223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6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CUGUGCAAUUCCCGGUUGCAACAGAUCCAGCCACCAGUUCGCUAGUUCAUACUCUUGUUGGUUUAGAUGGUGUUCUAGCGGUGGGGCCUGACAACUUCU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639573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3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CCGGGCAAGUAUCCGAACAAUCGGACAUUUGGCCACAAUAAGCCCAAUUUGGUUGAAGAUUAAAGUAGUGAGCCCCCUUAGCGCGAAACCGGAAUUUAU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921517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9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AUGGACUCAGGAGCAGAAGCCACCAGUGGAGUAGUCGGAUGGGGCAAUAUGGACACGAUUGUCAUCCGUGUCUCGGCCCCUGAGGGCGCAGUUAACUCU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398327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5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ACUUCAACAUCUAGGUCCGAUCAGGUGUCCUCAUUCAGGUACGCUUCCAUGAACGUGGGUAUUUACCCAACGUCGAACUUGAUGCAGUUUGCCGGAAG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092632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96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UCCGUGUCUCGGCCCCUGAGGGCGCAGUUAACUCUGCCAUACUCAAGGCAUGGUCCUGCAUUGAGUAUCGACCAAAUCCAAACGCCAUGUUAUACCAAUU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9980703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ACUUUGAAUUCAAUGACAUAUUGGAGGGUAUCCAGACAUUGCCACCUGCUAAUGUGUCCCUUGGUUCUACGGGUCAACCUUUUACCAUGGACUCAGGA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8912114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9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CCAUGGACUCAGGAGCAGAAGCCACCAGUGGAGUAGUCGGAUGGGGCAAUAUGGACACGAUUGUCAUCCGUGUCUCGGCCCCUGAGGGCGCAGUUAACU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1948843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49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CCGUUAAUUAUCCGGGUUUUACAUCGAUGUUCGGAACAACUUCAACAUCUAGGUCCGAUCAGGUGUCCUCAUUCAGGUACGCUUCCAUGAACGUGGGUA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02761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9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ACGAUUGUCAUCCGUGUCUCGGCCCCUGAGGGCGCAGUUAACUCUGCCAUACUCAAGGCAUGGUCCUGCAUUGAGUAUCGACCAAAUCCAAACGCCAUG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1621261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15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CAAAAUGCAUCAAUGUGGGAGAGAGUGAAAUCCAUCAUUAAAUCCUCCCUGGCUGCUGCAAGCAACAUUCCCGGCCCGAUCGGUGUCGCCGCAAGUGGU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084152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23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GGCGCUAACCAGAUUAAGUCAACCUGGUUUGGCGUUUCUCAAAUGUGCAUUUGCACCACCUGACUUCAACACCGACCCCGGUAAGGGAAUACCUGAUA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2154730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09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CGCGCUUCAGGAAUACCGUACGGUUGCCAGAUCUUUGCCGGUUGCAGUGAUAGCGGCCCAAAAUGCAUCAAUGUGGGAGAGAGUGAAAUCCAUCAUUAAA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295526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58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UGGGUAUUUACCCAACGUCGAACUUGAUGCAGUUUGCCGGAAGCAUAACUGUUUGGAAAUGCCCUGUAAAGCUGAGUACUGUGCAAUUCCCGGUUGC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3447565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126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GUCAGCCCUUUUUGAAGGAUUUGGCUUUUAGAAGCAUCCGGACGCCAACCUAACCGGGCAAGUAUCCGAACAAUCGGACAUUUGGCCACAAUAAGCCCAA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9697481"/>
                  </a:ext>
                </a:extLst>
              </a:tr>
              <a:tr h="109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8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onsolas" panose="020B0609020204030204" pitchFamily="49" charset="0"/>
                        </a:rPr>
                        <a:t>AUAUUGGAGGGUAUCCAGACAUUGCCACCUGCUAAUGUGUCCCUUGGUUCUACGGGUCAACCUUUUACCAUGGACUCAGGAGCAGAAGCCACCAGUGGAG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774789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D92C62A-4024-4A11-BDEA-9E2DBCE73D72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6</a:t>
            </a:r>
          </a:p>
        </p:txBody>
      </p:sp>
    </p:spTree>
    <p:extLst>
      <p:ext uri="{BB962C8B-B14F-4D97-AF65-F5344CB8AC3E}">
        <p14:creationId xmlns:p14="http://schemas.microsoft.com/office/powerpoint/2010/main" val="25215620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0286C-296C-4A20-BCD1-7F98996CD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047393-6172-4D75-8B10-3F67C1568F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6</a:t>
            </a:r>
            <a:r>
              <a:rPr lang="en-US" dirty="0"/>
              <a:t>. DREME analysis resulted in no common sequence among PAR-CL sites. The flanking sequences of 28 RNA 1 PAR-CL sites and 15 RNA 2 sites are listed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824065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A7BC842-8553-4833-A693-81C5DD5FDC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6311399"/>
              </p:ext>
            </p:extLst>
          </p:nvPr>
        </p:nvGraphicFramePr>
        <p:xfrm>
          <a:off x="1524000" y="2057400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A1C4385-0E98-46BF-99E3-869735ECF2FC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F130F7-750D-4C7C-B6EE-89126D427C23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7</a:t>
            </a:r>
          </a:p>
        </p:txBody>
      </p:sp>
    </p:spTree>
    <p:extLst>
      <p:ext uri="{BB962C8B-B14F-4D97-AF65-F5344CB8AC3E}">
        <p14:creationId xmlns:p14="http://schemas.microsoft.com/office/powerpoint/2010/main" val="4508829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EDD3B87-8928-4A60-AE4E-E5400D2C2D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073648"/>
              </p:ext>
            </p:extLst>
          </p:nvPr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700EDC0-33CF-4F42-A016-0C1CF23B005D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A301AA-C7CD-4095-ADBD-616EAD46489F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113092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4B5FAC1-F79A-4581-8EAD-8D9633B49B2F}"/>
              </a:ext>
            </a:extLst>
          </p:cNvPr>
          <p:cNvSpPr txBox="1"/>
          <p:nvPr/>
        </p:nvSpPr>
        <p:spPr>
          <a:xfrm>
            <a:off x="4701575" y="1581834"/>
            <a:ext cx="2788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-</a:t>
            </a:r>
            <a:r>
              <a:rPr lang="en-US" dirty="0" err="1"/>
              <a:t>MaPseq</a:t>
            </a:r>
            <a:r>
              <a:rPr lang="en-US" dirty="0"/>
              <a:t> signal : RNA 1</a:t>
            </a:r>
          </a:p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281A0F-8166-4517-87FE-2361AA76A1C2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7" name="Picture 6" descr="A picture containing object&#10;&#10;Description generated with very high confidence">
            <a:extLst>
              <a:ext uri="{FF2B5EF4-FFF2-40B4-BE49-F238E27FC236}">
                <a16:creationId xmlns:a16="http://schemas.microsoft.com/office/drawing/2014/main" id="{3D8CB1DE-5ABF-4F7A-A73E-FA84083E08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05000"/>
            <a:ext cx="12192000" cy="304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EAC0F07-F7F4-4458-B221-95BEE23C5D5A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7</a:t>
            </a:r>
          </a:p>
        </p:txBody>
      </p:sp>
    </p:spTree>
    <p:extLst>
      <p:ext uri="{BB962C8B-B14F-4D97-AF65-F5344CB8AC3E}">
        <p14:creationId xmlns:p14="http://schemas.microsoft.com/office/powerpoint/2010/main" val="321594290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people in a room&#10;&#10;Description generated with high confidence">
            <a:extLst>
              <a:ext uri="{FF2B5EF4-FFF2-40B4-BE49-F238E27FC236}">
                <a16:creationId xmlns:a16="http://schemas.microsoft.com/office/drawing/2014/main" id="{01006485-2146-40F2-91E1-5751552CBC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1048" y="1700559"/>
            <a:ext cx="6089903" cy="30449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B97BC32-FD99-419B-9442-360A9AE16BF4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AB242A-6527-432B-AE5B-12B0E7B424EE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5CBFD8-E4B0-474C-B327-BA365DA52793}"/>
              </a:ext>
            </a:extLst>
          </p:cNvPr>
          <p:cNvSpPr txBox="1"/>
          <p:nvPr/>
        </p:nvSpPr>
        <p:spPr>
          <a:xfrm>
            <a:off x="4985862" y="1377393"/>
            <a:ext cx="27968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-</a:t>
            </a:r>
            <a:r>
              <a:rPr lang="en-US" dirty="0" err="1"/>
              <a:t>MaPseq</a:t>
            </a:r>
            <a:r>
              <a:rPr lang="en-US" dirty="0"/>
              <a:t> signal: RNA 2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724987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8E341-7E24-4FC3-A1D4-230A18509E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8D5590-AB4B-461E-88EF-6F47016C02E4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0" y="1825625"/>
            <a:ext cx="10515600" cy="2675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buNone/>
            </a:pPr>
            <a:r>
              <a:rPr lang="en-US" b="1" dirty="0"/>
              <a:t>Supplemental Figure S7</a:t>
            </a:r>
            <a:r>
              <a:rPr lang="en-US" dirty="0"/>
              <a:t>. FHV in virion DMS-</a:t>
            </a:r>
            <a:r>
              <a:rPr lang="en-US" dirty="0" err="1"/>
              <a:t>MaPseq</a:t>
            </a:r>
            <a:r>
              <a:rPr lang="en-US" dirty="0"/>
              <a:t>.</a:t>
            </a:r>
          </a:p>
          <a:p>
            <a:pPr marL="0" indent="0">
              <a:buNone/>
            </a:pPr>
            <a:r>
              <a:rPr lang="en-US" b="1" dirty="0"/>
              <a:t>(</a:t>
            </a:r>
            <a:r>
              <a:rPr lang="en-US" b="1" dirty="0" err="1"/>
              <a:t>a,b</a:t>
            </a:r>
            <a:r>
              <a:rPr lang="en-US" b="1" dirty="0"/>
              <a:t>) </a:t>
            </a:r>
            <a:r>
              <a:rPr lang="en-US" dirty="0"/>
              <a:t>Error rates for adenine and cytosine positions are compared between DMS-treated virus (DMS+) and untreated virus (DMS-). </a:t>
            </a:r>
            <a:r>
              <a:rPr lang="en-US" b="1" dirty="0"/>
              <a:t>(</a:t>
            </a:r>
            <a:r>
              <a:rPr lang="en-US" b="1" dirty="0" err="1"/>
              <a:t>c,d</a:t>
            </a:r>
            <a:r>
              <a:rPr lang="en-US" b="1" dirty="0"/>
              <a:t>) </a:t>
            </a:r>
            <a:r>
              <a:rPr lang="en-US" dirty="0"/>
              <a:t>DMS-</a:t>
            </a:r>
            <a:r>
              <a:rPr lang="en-US" dirty="0" err="1"/>
              <a:t>MaPseq</a:t>
            </a:r>
            <a:r>
              <a:rPr lang="en-US" dirty="0"/>
              <a:t> signals represent the fold change of A/C mutation rates between DMS-treated virus and untreated virus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636781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4E61FBC-03B4-4DD7-A1D5-D56C747E31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1094620"/>
              </p:ext>
            </p:extLst>
          </p:nvPr>
        </p:nvGraphicFramePr>
        <p:xfrm>
          <a:off x="1073150" y="9525"/>
          <a:ext cx="10045700" cy="6838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Worksheet" r:id="rId3" imgW="12047114" imgH="8199057" progId="Excel.Sheet.12">
                  <p:embed/>
                </p:oleObj>
              </mc:Choice>
              <mc:Fallback>
                <p:oleObj name="Worksheet" r:id="rId3" imgW="12047114" imgH="8199057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3150" y="9525"/>
                        <a:ext cx="10045700" cy="6838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AAF673C-38FD-4474-850A-22B07599B060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B6F2FF-CD50-4C7F-A58A-9925EEB2BAFA}"/>
              </a:ext>
            </a:extLst>
          </p:cNvPr>
          <p:cNvSpPr txBox="1"/>
          <p:nvPr/>
        </p:nvSpPr>
        <p:spPr>
          <a:xfrm>
            <a:off x="144379" y="9525"/>
            <a:ext cx="1046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NA 1 </a:t>
            </a:r>
          </a:p>
        </p:txBody>
      </p:sp>
    </p:spTree>
    <p:extLst>
      <p:ext uri="{BB962C8B-B14F-4D97-AF65-F5344CB8AC3E}">
        <p14:creationId xmlns:p14="http://schemas.microsoft.com/office/powerpoint/2010/main" val="3114678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00BD1-160A-4E9B-8CB6-1A58EB13F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4AE609-FBBA-4693-B7A2-332BABB1EF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1</a:t>
            </a:r>
            <a:r>
              <a:rPr lang="en-US" dirty="0"/>
              <a:t>. “U-C” mutation rate elevating is specific for crosslinking events.</a:t>
            </a:r>
          </a:p>
          <a:p>
            <a:pPr marL="0" indent="0">
              <a:buNone/>
            </a:pPr>
            <a:r>
              <a:rPr lang="en-US" altLang="zh-CN" dirty="0"/>
              <a:t>In RNA 2, we observed the same phenomenon as that in RNA 1: UV irradiation or 4SU substitution alone was not sufficient to induce substantial U-C mutation rate change. Only when UV and 4SU substitution both presented, did we observe increased PAR-CL signals over certain sites.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97188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836F0B3-F4ED-493A-BF40-4064B2FF99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667914"/>
              </p:ext>
            </p:extLst>
          </p:nvPr>
        </p:nvGraphicFramePr>
        <p:xfrm>
          <a:off x="677863" y="1397000"/>
          <a:ext cx="10836275" cy="4060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name="Worksheet" r:id="rId3" imgW="10835853" imgH="4061350" progId="Excel.Sheet.12">
                  <p:embed/>
                </p:oleObj>
              </mc:Choice>
              <mc:Fallback>
                <p:oleObj name="Worksheet" r:id="rId3" imgW="10835853" imgH="406135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7863" y="1397000"/>
                        <a:ext cx="10836275" cy="4060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D254195-338C-49EF-B52B-4B93768C0A6B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0DD18F9-7683-4A7D-BCC3-6CFBB23DDE25}"/>
              </a:ext>
            </a:extLst>
          </p:cNvPr>
          <p:cNvSpPr txBox="1"/>
          <p:nvPr/>
        </p:nvSpPr>
        <p:spPr>
          <a:xfrm>
            <a:off x="144379" y="9525"/>
            <a:ext cx="1046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NA 2 </a:t>
            </a:r>
          </a:p>
        </p:txBody>
      </p:sp>
    </p:spTree>
    <p:extLst>
      <p:ext uri="{BB962C8B-B14F-4D97-AF65-F5344CB8AC3E}">
        <p14:creationId xmlns:p14="http://schemas.microsoft.com/office/powerpoint/2010/main" val="146300664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237B1-43A9-4DD0-9FD9-A37D11601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F9CB67-A122-49BC-82C9-262AD4193B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8</a:t>
            </a:r>
            <a:r>
              <a:rPr lang="en-US" dirty="0"/>
              <a:t>. Dot-bracket maps of FHV RNA secondary structures. </a:t>
            </a:r>
          </a:p>
          <a:p>
            <a:pPr marL="0" indent="0">
              <a:buNone/>
            </a:pPr>
            <a:r>
              <a:rPr lang="en-US" dirty="0"/>
              <a:t>DMS-</a:t>
            </a:r>
            <a:r>
              <a:rPr lang="en-US" dirty="0" err="1"/>
              <a:t>MaPseq</a:t>
            </a:r>
            <a:r>
              <a:rPr lang="en-US" dirty="0"/>
              <a:t>-imposed constrains allowed for substantial refolding and improvement over unconstrained thermodynamic predictions. The refolded nucleotides are highlighted in red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629836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1A2FA79-732B-452B-A12B-02AA0DEB49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9285" y="2334252"/>
            <a:ext cx="4928387" cy="284042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2AFF9AB-5503-4FB7-B606-57986E7B98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213" y="2159689"/>
            <a:ext cx="5617391" cy="3014984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B15C887C-BB27-4CD5-B176-4032D36AC0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0495552"/>
              </p:ext>
            </p:extLst>
          </p:nvPr>
        </p:nvGraphicFramePr>
        <p:xfrm>
          <a:off x="6905060" y="2272724"/>
          <a:ext cx="3018970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66722">
                  <a:extLst>
                    <a:ext uri="{9D8B030D-6E8A-4147-A177-3AD203B41FA5}">
                      <a16:colId xmlns:a16="http://schemas.microsoft.com/office/drawing/2014/main" val="8519100"/>
                    </a:ext>
                  </a:extLst>
                </a:gridCol>
                <a:gridCol w="2252248">
                  <a:extLst>
                    <a:ext uri="{9D8B030D-6E8A-4147-A177-3AD203B41FA5}">
                      <a16:colId xmlns:a16="http://schemas.microsoft.com/office/drawing/2014/main" val="249303691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: PAR-CL sites (&gt;2</a:t>
                      </a:r>
                      <a:r>
                        <a:rPr lang="el-GR" sz="1200" dirty="0"/>
                        <a:t>σ</a:t>
                      </a:r>
                      <a:r>
                        <a:rPr lang="en-US" sz="1200" dirty="0"/>
                        <a:t> significanc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366891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: PAR-CL sites (&gt;1</a:t>
                      </a:r>
                      <a:r>
                        <a:rPr lang="el-GR" sz="1200" dirty="0"/>
                        <a:t>σ</a:t>
                      </a:r>
                      <a:r>
                        <a:rPr lang="en-US" sz="1200" dirty="0"/>
                        <a:t> significanc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796373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: </a:t>
                      </a:r>
                      <a:r>
                        <a:rPr kumimoji="0" lang="en-US" altLang="en-US" sz="1200" u="none" strike="noStrike" cap="none" normalizeH="0" baseline="0" dirty="0">
                          <a:ln>
                            <a:noFill/>
                          </a:ln>
                          <a:effectLst/>
                        </a:rPr>
                        <a:t>DMS-</a:t>
                      </a:r>
                      <a:r>
                        <a:rPr kumimoji="0" lang="en-US" altLang="en-US" sz="1200" u="none" strike="noStrike" cap="none" normalizeH="0" baseline="0" dirty="0" err="1">
                          <a:ln>
                            <a:noFill/>
                          </a:ln>
                          <a:effectLst/>
                        </a:rPr>
                        <a:t>MaPseq</a:t>
                      </a:r>
                      <a:r>
                        <a:rPr kumimoji="0" lang="en-US" altLang="en-US" sz="1200" u="none" strike="noStrike" cap="none" normalizeH="0" baseline="0" dirty="0">
                          <a:ln>
                            <a:noFill/>
                          </a:ln>
                          <a:effectLst/>
                        </a:rPr>
                        <a:t> constraints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320507"/>
                  </a:ext>
                </a:extLst>
              </a:tr>
            </a:tbl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C38D0576-5789-4472-833F-D76797C50E96}"/>
              </a:ext>
            </a:extLst>
          </p:cNvPr>
          <p:cNvGrpSpPr/>
          <p:nvPr/>
        </p:nvGrpSpPr>
        <p:grpSpPr>
          <a:xfrm>
            <a:off x="7157881" y="2272723"/>
            <a:ext cx="618497" cy="984071"/>
            <a:chOff x="9462137" y="2430415"/>
            <a:chExt cx="618497" cy="984071"/>
          </a:xfrm>
        </p:grpSpPr>
        <p:pic>
          <p:nvPicPr>
            <p:cNvPr id="9" name="Picture 229">
              <a:extLst>
                <a:ext uri="{FF2B5EF4-FFF2-40B4-BE49-F238E27FC236}">
                  <a16:creationId xmlns:a16="http://schemas.microsoft.com/office/drawing/2014/main" id="{10F8D688-4F09-4AC1-9CAF-48FC813018E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59273" y="2723968"/>
              <a:ext cx="319461" cy="3657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234">
              <a:extLst>
                <a:ext uri="{FF2B5EF4-FFF2-40B4-BE49-F238E27FC236}">
                  <a16:creationId xmlns:a16="http://schemas.microsoft.com/office/drawing/2014/main" id="{031FEBBB-1351-4C4E-AF8E-CDC7AF56A47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62137" y="3003006"/>
              <a:ext cx="618497" cy="4114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228">
              <a:extLst>
                <a:ext uri="{FF2B5EF4-FFF2-40B4-BE49-F238E27FC236}">
                  <a16:creationId xmlns:a16="http://schemas.microsoft.com/office/drawing/2014/main" id="{4192D0D1-05DA-4A65-8925-06F7A184199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59274" y="2430415"/>
              <a:ext cx="319461" cy="3657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1E9705BA-EC45-4BBC-BA0C-3DEA47209D03}"/>
              </a:ext>
            </a:extLst>
          </p:cNvPr>
          <p:cNvSpPr txBox="1"/>
          <p:nvPr/>
        </p:nvSpPr>
        <p:spPr>
          <a:xfrm>
            <a:off x="7434827" y="2020042"/>
            <a:ext cx="236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ucleotide annotations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3DF1FD-D88F-43FD-A1C6-CEE974495B6D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9</a:t>
            </a:r>
          </a:p>
        </p:txBody>
      </p:sp>
    </p:spTree>
    <p:extLst>
      <p:ext uri="{BB962C8B-B14F-4D97-AF65-F5344CB8AC3E}">
        <p14:creationId xmlns:p14="http://schemas.microsoft.com/office/powerpoint/2010/main" val="373475561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B89535-E8D8-4491-A6E2-C30FE684A857}"/>
              </a:ext>
            </a:extLst>
          </p:cNvPr>
          <p:cNvSpPr txBox="1">
            <a:spLocks/>
          </p:cNvSpPr>
          <p:nvPr/>
        </p:nvSpPr>
        <p:spPr>
          <a:xfrm>
            <a:off x="838200" y="1800458"/>
            <a:ext cx="10515600" cy="4351338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b="1" dirty="0"/>
              <a:t>Supplemental Figure S9</a:t>
            </a:r>
            <a:r>
              <a:rPr lang="en-US" dirty="0"/>
              <a:t>. PAR-CL and DMS-</a:t>
            </a:r>
            <a:r>
              <a:rPr lang="en-US" dirty="0" err="1"/>
              <a:t>MaPseq</a:t>
            </a:r>
            <a:r>
              <a:rPr lang="en-US" dirty="0"/>
              <a:t> predicted near identical structure to RNA 2 packaging signal.  </a:t>
            </a:r>
          </a:p>
          <a:p>
            <a:pPr marL="0" indent="0">
              <a:buNone/>
            </a:pPr>
            <a:r>
              <a:rPr lang="en-US" dirty="0"/>
              <a:t>A previously established RNA 2 packaging signal stem-loop structure was listed on the left. The stem loop and the boxed sequence (nt. 210-249) are determined to be essential for RNA 2 </a:t>
            </a:r>
            <a:r>
              <a:rPr lang="en-US" dirty="0" err="1"/>
              <a:t>encapsidation</a:t>
            </a:r>
            <a:r>
              <a:rPr lang="en-US" dirty="0"/>
              <a:t> (Zhong, et al., 1992. PNAS). Our DMS-</a:t>
            </a:r>
            <a:r>
              <a:rPr lang="en-US" dirty="0" err="1"/>
              <a:t>MaPseq</a:t>
            </a:r>
            <a:r>
              <a:rPr lang="en-US" dirty="0"/>
              <a:t>-imposed RNA structure is shown on the right, describing near identical structure. Three PAR-CL sites were found in this region, explaining the importance of this site to RNA 2 </a:t>
            </a:r>
            <a:r>
              <a:rPr lang="en-US" dirty="0" err="1"/>
              <a:t>packaing</a:t>
            </a:r>
            <a:r>
              <a:rPr lang="en-US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3444517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932805C-0464-4718-88B1-FF41BD7E685C}"/>
              </a:ext>
            </a:extLst>
          </p:cNvPr>
          <p:cNvGrpSpPr/>
          <p:nvPr/>
        </p:nvGrpSpPr>
        <p:grpSpPr>
          <a:xfrm>
            <a:off x="557814" y="201753"/>
            <a:ext cx="10350262" cy="6320670"/>
            <a:chOff x="557814" y="201753"/>
            <a:chExt cx="10350262" cy="6320670"/>
          </a:xfrm>
        </p:grpSpPr>
        <p:pic>
          <p:nvPicPr>
            <p:cNvPr id="5" name="Picture 4" descr="A picture containing nature, outdoor, white, skating&#10;&#10;Description generated with high confidence">
              <a:extLst>
                <a:ext uri="{FF2B5EF4-FFF2-40B4-BE49-F238E27FC236}">
                  <a16:creationId xmlns:a16="http://schemas.microsoft.com/office/drawing/2014/main" id="{9A9D6EA7-BC20-45B0-96B3-245226DBD0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43" t="46686" r="20757" b="189"/>
            <a:stretch/>
          </p:blipFill>
          <p:spPr>
            <a:xfrm>
              <a:off x="1673412" y="201753"/>
              <a:ext cx="1828800" cy="1828800"/>
            </a:xfrm>
            <a:prstGeom prst="rect">
              <a:avLst/>
            </a:prstGeom>
          </p:spPr>
        </p:pic>
        <p:pic>
          <p:nvPicPr>
            <p:cNvPr id="7" name="Picture 6" descr="A picture containing nature, rain, outdoor, people&#10;&#10;Description generated with very high confidence">
              <a:extLst>
                <a:ext uri="{FF2B5EF4-FFF2-40B4-BE49-F238E27FC236}">
                  <a16:creationId xmlns:a16="http://schemas.microsoft.com/office/drawing/2014/main" id="{7DDEBCF3-A043-4995-ABDD-BCCD11B4A8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3" t="46669" r="20278" b="206"/>
            <a:stretch/>
          </p:blipFill>
          <p:spPr>
            <a:xfrm>
              <a:off x="3527195" y="201753"/>
              <a:ext cx="1828800" cy="1828800"/>
            </a:xfrm>
            <a:prstGeom prst="rect">
              <a:avLst/>
            </a:prstGeom>
          </p:spPr>
        </p:pic>
        <p:pic>
          <p:nvPicPr>
            <p:cNvPr id="9" name="Picture 8" descr="A picture containing outdoor, ground, nature, white&#10;&#10;Description generated with very high confidence">
              <a:extLst>
                <a:ext uri="{FF2B5EF4-FFF2-40B4-BE49-F238E27FC236}">
                  <a16:creationId xmlns:a16="http://schemas.microsoft.com/office/drawing/2014/main" id="{488EB1A9-6D03-4C0A-BF8F-5469BD9F11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45" t="46115" r="20555" b="760"/>
            <a:stretch/>
          </p:blipFill>
          <p:spPr>
            <a:xfrm>
              <a:off x="5380978" y="201753"/>
              <a:ext cx="1828800" cy="1828800"/>
            </a:xfrm>
            <a:prstGeom prst="rect">
              <a:avLst/>
            </a:prstGeom>
          </p:spPr>
        </p:pic>
        <p:pic>
          <p:nvPicPr>
            <p:cNvPr id="11" name="Picture 10" descr="A picture containing white, outdoor&#10;&#10;Description generated with high confidence">
              <a:extLst>
                <a:ext uri="{FF2B5EF4-FFF2-40B4-BE49-F238E27FC236}">
                  <a16:creationId xmlns:a16="http://schemas.microsoft.com/office/drawing/2014/main" id="{B7F775AD-894C-4037-A89B-B1307D399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83" t="46669" r="20417" b="206"/>
            <a:stretch/>
          </p:blipFill>
          <p:spPr>
            <a:xfrm>
              <a:off x="7230918" y="201753"/>
              <a:ext cx="1828800" cy="18288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493FB02-7909-4262-869C-41E1C5B07130}"/>
                </a:ext>
              </a:extLst>
            </p:cNvPr>
            <p:cNvSpPr txBox="1"/>
            <p:nvPr/>
          </p:nvSpPr>
          <p:spPr>
            <a:xfrm>
              <a:off x="2371875" y="1961759"/>
              <a:ext cx="4318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N/A</a:t>
              </a:r>
            </a:p>
            <a:p>
              <a:r>
                <a:rPr lang="en-US" sz="900" b="1" dirty="0"/>
                <a:t>N/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38C03A-5327-4479-AC8C-BF7A8C00F007}"/>
                </a:ext>
              </a:extLst>
            </p:cNvPr>
            <p:cNvSpPr txBox="1"/>
            <p:nvPr/>
          </p:nvSpPr>
          <p:spPr>
            <a:xfrm>
              <a:off x="4225658" y="1961759"/>
              <a:ext cx="4318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/>
                <a:t>wt</a:t>
              </a:r>
              <a:endParaRPr lang="en-US" sz="900" b="1" dirty="0"/>
            </a:p>
            <a:p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59652FD-D5EE-4CE7-B0F4-3DD6D7861908}"/>
                </a:ext>
              </a:extLst>
            </p:cNvPr>
            <p:cNvSpPr txBox="1"/>
            <p:nvPr/>
          </p:nvSpPr>
          <p:spPr>
            <a:xfrm>
              <a:off x="6079441" y="1961759"/>
              <a:ext cx="4318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/>
                <a:t>Wt</a:t>
              </a:r>
              <a:endParaRPr lang="en-US" sz="900" b="1" dirty="0"/>
            </a:p>
            <a:p>
              <a:r>
                <a:rPr lang="en-US" sz="900" b="1" dirty="0"/>
                <a:t>N/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0148870-9478-4B7B-8110-208DD9AE26F8}"/>
                </a:ext>
              </a:extLst>
            </p:cNvPr>
            <p:cNvSpPr txBox="1"/>
            <p:nvPr/>
          </p:nvSpPr>
          <p:spPr>
            <a:xfrm>
              <a:off x="7876343" y="1961759"/>
              <a:ext cx="4318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N/A</a:t>
              </a:r>
            </a:p>
            <a:p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pic>
          <p:nvPicPr>
            <p:cNvPr id="24" name="Picture 23" descr="A picture containing outdoor, nature, white, person&#10;&#10;Description generated with very high confidence">
              <a:extLst>
                <a:ext uri="{FF2B5EF4-FFF2-40B4-BE49-F238E27FC236}">
                  <a16:creationId xmlns:a16="http://schemas.microsoft.com/office/drawing/2014/main" id="{3A1AD591-4502-42DF-BF41-D1D185A2D1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10" t="11173" r="46390" b="35702"/>
            <a:stretch/>
          </p:blipFill>
          <p:spPr>
            <a:xfrm>
              <a:off x="1673412" y="2294350"/>
              <a:ext cx="1828800" cy="1828800"/>
            </a:xfrm>
            <a:prstGeom prst="rect">
              <a:avLst/>
            </a:prstGeom>
          </p:spPr>
        </p:pic>
        <p:pic>
          <p:nvPicPr>
            <p:cNvPr id="34" name="Picture 33" descr="A picture containing nature, rain, outdoor&#10;&#10;Description generated with very high confidence">
              <a:extLst>
                <a:ext uri="{FF2B5EF4-FFF2-40B4-BE49-F238E27FC236}">
                  <a16:creationId xmlns:a16="http://schemas.microsoft.com/office/drawing/2014/main" id="{C80E6BE4-095D-46AE-B1B8-55100290D6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62" t="8011" r="38038" b="38864"/>
            <a:stretch/>
          </p:blipFill>
          <p:spPr>
            <a:xfrm>
              <a:off x="1673412" y="4386947"/>
              <a:ext cx="1828800" cy="182880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02E951F-E5B3-46AA-A58A-48318FF2B585}"/>
                </a:ext>
              </a:extLst>
            </p:cNvPr>
            <p:cNvSpPr txBox="1"/>
            <p:nvPr/>
          </p:nvSpPr>
          <p:spPr>
            <a:xfrm>
              <a:off x="2238922" y="4061369"/>
              <a:ext cx="697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159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6BFDABC-99C6-4F2C-8196-C2F6AF34A225}"/>
                </a:ext>
              </a:extLst>
            </p:cNvPr>
            <p:cNvSpPr txBox="1"/>
            <p:nvPr/>
          </p:nvSpPr>
          <p:spPr>
            <a:xfrm>
              <a:off x="4092705" y="4061369"/>
              <a:ext cx="697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227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AD925F2-F322-4D6A-89BA-317AA7DA9AA4}"/>
                </a:ext>
              </a:extLst>
            </p:cNvPr>
            <p:cNvSpPr txBox="1"/>
            <p:nvPr/>
          </p:nvSpPr>
          <p:spPr>
            <a:xfrm>
              <a:off x="5946488" y="4061369"/>
              <a:ext cx="697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501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8E4C073-5795-4EB0-8842-AB7EF86F5C11}"/>
                </a:ext>
              </a:extLst>
            </p:cNvPr>
            <p:cNvSpPr txBox="1"/>
            <p:nvPr/>
          </p:nvSpPr>
          <p:spPr>
            <a:xfrm>
              <a:off x="7767951" y="4061369"/>
              <a:ext cx="75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1070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CAA2355-04F2-4537-AED4-EECDBD3D5A13}"/>
                </a:ext>
              </a:extLst>
            </p:cNvPr>
            <p:cNvSpPr txBox="1"/>
            <p:nvPr/>
          </p:nvSpPr>
          <p:spPr>
            <a:xfrm>
              <a:off x="9616309" y="4061369"/>
              <a:ext cx="75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1151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1BF5F11-A40D-4A77-9B8A-94F10E9E1CBB}"/>
                </a:ext>
              </a:extLst>
            </p:cNvPr>
            <p:cNvSpPr txBox="1"/>
            <p:nvPr/>
          </p:nvSpPr>
          <p:spPr>
            <a:xfrm>
              <a:off x="2228539" y="6153091"/>
              <a:ext cx="7185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1233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022D1A7-B6C2-45AD-9C29-597B857CF26A}"/>
                </a:ext>
              </a:extLst>
            </p:cNvPr>
            <p:cNvSpPr txBox="1"/>
            <p:nvPr/>
          </p:nvSpPr>
          <p:spPr>
            <a:xfrm>
              <a:off x="4076934" y="6153091"/>
              <a:ext cx="729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1873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AE0D0E9-AFF0-436C-95CB-540DEDFCEF6D}"/>
                </a:ext>
              </a:extLst>
            </p:cNvPr>
            <p:cNvSpPr txBox="1"/>
            <p:nvPr/>
          </p:nvSpPr>
          <p:spPr>
            <a:xfrm>
              <a:off x="5886001" y="6153091"/>
              <a:ext cx="818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2070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A5A26D7-AD5C-4A38-9AB8-63ECC1AB4BE3}"/>
                </a:ext>
              </a:extLst>
            </p:cNvPr>
            <p:cNvSpPr txBox="1"/>
            <p:nvPr/>
          </p:nvSpPr>
          <p:spPr>
            <a:xfrm>
              <a:off x="7767951" y="6153091"/>
              <a:ext cx="75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2515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91AA462-4247-4F51-A5C3-90B989C499E1}"/>
                </a:ext>
              </a:extLst>
            </p:cNvPr>
            <p:cNvSpPr txBox="1"/>
            <p:nvPr/>
          </p:nvSpPr>
          <p:spPr>
            <a:xfrm>
              <a:off x="9616309" y="6153091"/>
              <a:ext cx="75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U2576</a:t>
              </a:r>
            </a:p>
            <a:p>
              <a:pPr algn="ctr"/>
              <a:r>
                <a:rPr lang="en-US" sz="900" b="1" dirty="0" err="1"/>
                <a:t>wt</a:t>
              </a:r>
              <a:endParaRPr lang="en-US" sz="900" b="1" dirty="0"/>
            </a:p>
          </p:txBody>
        </p:sp>
        <p:pic>
          <p:nvPicPr>
            <p:cNvPr id="42" name="Picture 41" descr="A picture containing rain, nature&#10;&#10;Description generated with very high confidence">
              <a:extLst>
                <a:ext uri="{FF2B5EF4-FFF2-40B4-BE49-F238E27FC236}">
                  <a16:creationId xmlns:a16="http://schemas.microsoft.com/office/drawing/2014/main" id="{672B5B38-953F-42E3-BDD1-4052DD3064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73" t="22390" r="7727" b="24485"/>
            <a:stretch/>
          </p:blipFill>
          <p:spPr>
            <a:xfrm>
              <a:off x="3527195" y="2294350"/>
              <a:ext cx="1828800" cy="1828800"/>
            </a:xfrm>
            <a:prstGeom prst="rect">
              <a:avLst/>
            </a:prstGeom>
          </p:spPr>
        </p:pic>
        <p:pic>
          <p:nvPicPr>
            <p:cNvPr id="44" name="Picture 43" descr="A picture containing rain, nature&#10;&#10;Description generated with very high confidence">
              <a:extLst>
                <a:ext uri="{FF2B5EF4-FFF2-40B4-BE49-F238E27FC236}">
                  <a16:creationId xmlns:a16="http://schemas.microsoft.com/office/drawing/2014/main" id="{17181A81-093E-48B5-8BB0-F78BC43E99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61" t="23426" r="25139" b="23449"/>
            <a:stretch/>
          </p:blipFill>
          <p:spPr>
            <a:xfrm>
              <a:off x="5380978" y="2294350"/>
              <a:ext cx="1828800" cy="1828800"/>
            </a:xfrm>
            <a:prstGeom prst="rect">
              <a:avLst/>
            </a:prstGeom>
          </p:spPr>
        </p:pic>
        <p:pic>
          <p:nvPicPr>
            <p:cNvPr id="46" name="Picture 45" descr="A picture containing nature, rain, outdoor, group&#10;&#10;Description generated with very high confidence">
              <a:extLst>
                <a:ext uri="{FF2B5EF4-FFF2-40B4-BE49-F238E27FC236}">
                  <a16:creationId xmlns:a16="http://schemas.microsoft.com/office/drawing/2014/main" id="{BA4F29CC-3E89-4EFF-A7E0-E824B0A647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33" t="10699" r="41667" b="36176"/>
            <a:stretch/>
          </p:blipFill>
          <p:spPr>
            <a:xfrm>
              <a:off x="7230918" y="2294350"/>
              <a:ext cx="1828800" cy="1828800"/>
            </a:xfrm>
            <a:prstGeom prst="rect">
              <a:avLst/>
            </a:prstGeom>
          </p:spPr>
        </p:pic>
        <p:pic>
          <p:nvPicPr>
            <p:cNvPr id="54" name="Picture 53" descr="A close up of a street&#10;&#10;Description generated with high confidence">
              <a:extLst>
                <a:ext uri="{FF2B5EF4-FFF2-40B4-BE49-F238E27FC236}">
                  <a16:creationId xmlns:a16="http://schemas.microsoft.com/office/drawing/2014/main" id="{EB1A45D6-9243-41F0-86BA-DBBBD1B08D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33" t="44640" r="31667" b="2235"/>
            <a:stretch/>
          </p:blipFill>
          <p:spPr>
            <a:xfrm>
              <a:off x="9079276" y="2294350"/>
              <a:ext cx="1828800" cy="1828800"/>
            </a:xfrm>
            <a:prstGeom prst="rect">
              <a:avLst/>
            </a:prstGeom>
          </p:spPr>
        </p:pic>
        <p:pic>
          <p:nvPicPr>
            <p:cNvPr id="55" name="Picture 54" descr="A picture containing nature, rain&#10;&#10;Description generated with very high confidence">
              <a:extLst>
                <a:ext uri="{FF2B5EF4-FFF2-40B4-BE49-F238E27FC236}">
                  <a16:creationId xmlns:a16="http://schemas.microsoft.com/office/drawing/2014/main" id="{31844BE3-CAA1-44FB-8539-C2B842AD41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33" t="42980" r="44167" b="3895"/>
            <a:stretch/>
          </p:blipFill>
          <p:spPr>
            <a:xfrm>
              <a:off x="3527195" y="4390035"/>
              <a:ext cx="1828800" cy="1828800"/>
            </a:xfrm>
            <a:prstGeom prst="rect">
              <a:avLst/>
            </a:prstGeom>
          </p:spPr>
        </p:pic>
        <p:pic>
          <p:nvPicPr>
            <p:cNvPr id="56" name="Picture 55" descr="A picture containing rain, nature&#10;&#10;Description generated with very high confidence">
              <a:extLst>
                <a:ext uri="{FF2B5EF4-FFF2-40B4-BE49-F238E27FC236}">
                  <a16:creationId xmlns:a16="http://schemas.microsoft.com/office/drawing/2014/main" id="{CD218586-64DA-4765-B66A-4CE50A7CE5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889" t="26009" r="1111" b="20866"/>
            <a:stretch/>
          </p:blipFill>
          <p:spPr>
            <a:xfrm>
              <a:off x="5380978" y="4386947"/>
              <a:ext cx="1828800" cy="1828800"/>
            </a:xfrm>
            <a:prstGeom prst="rect">
              <a:avLst/>
            </a:prstGeom>
          </p:spPr>
        </p:pic>
        <p:pic>
          <p:nvPicPr>
            <p:cNvPr id="57" name="Picture 56" descr="A picture containing nature, rain&#10;&#10;Description generated with very high confidence">
              <a:extLst>
                <a:ext uri="{FF2B5EF4-FFF2-40B4-BE49-F238E27FC236}">
                  <a16:creationId xmlns:a16="http://schemas.microsoft.com/office/drawing/2014/main" id="{CDAE6D08-25B6-44D9-8CEB-AEF2653B28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56" t="30621" r="39444" b="16254"/>
            <a:stretch/>
          </p:blipFill>
          <p:spPr>
            <a:xfrm>
              <a:off x="7230918" y="4386947"/>
              <a:ext cx="1828800" cy="1828800"/>
            </a:xfrm>
            <a:prstGeom prst="rect">
              <a:avLst/>
            </a:prstGeom>
          </p:spPr>
        </p:pic>
        <p:pic>
          <p:nvPicPr>
            <p:cNvPr id="58" name="Picture 57" descr="A picture containing nature, rain, outdoor&#10;&#10;Description generated with very high confidence">
              <a:extLst>
                <a:ext uri="{FF2B5EF4-FFF2-40B4-BE49-F238E27FC236}">
                  <a16:creationId xmlns:a16="http://schemas.microsoft.com/office/drawing/2014/main" id="{576F6898-C35E-4F7C-9D85-F25A9CB3DE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167" t="8854" r="20833" b="38021"/>
            <a:stretch/>
          </p:blipFill>
          <p:spPr>
            <a:xfrm>
              <a:off x="9079276" y="4386947"/>
              <a:ext cx="1828800" cy="1828800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4433980-E22C-43D8-BE1A-E90B2A41A056}"/>
                </a:ext>
              </a:extLst>
            </p:cNvPr>
            <p:cNvSpPr txBox="1"/>
            <p:nvPr/>
          </p:nvSpPr>
          <p:spPr>
            <a:xfrm>
              <a:off x="557814" y="1961759"/>
              <a:ext cx="11497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/>
                <a:t>RNA 1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  <a:p>
              <a:pPr algn="r"/>
              <a:r>
                <a:rPr lang="en-US" sz="900" b="1" dirty="0"/>
                <a:t>RNA 2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DB84A79-EFA9-46B8-80BF-21C7314A0C23}"/>
                </a:ext>
              </a:extLst>
            </p:cNvPr>
            <p:cNvSpPr txBox="1"/>
            <p:nvPr/>
          </p:nvSpPr>
          <p:spPr>
            <a:xfrm>
              <a:off x="557814" y="4061369"/>
              <a:ext cx="11497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/>
                <a:t>RNA 1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  <a:p>
              <a:pPr algn="r"/>
              <a:r>
                <a:rPr lang="en-US" sz="900" b="1" dirty="0"/>
                <a:t>RNA 2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A35A50C-3896-400B-ADE3-F4E0B47D9ED9}"/>
                </a:ext>
              </a:extLst>
            </p:cNvPr>
            <p:cNvSpPr txBox="1"/>
            <p:nvPr/>
          </p:nvSpPr>
          <p:spPr>
            <a:xfrm>
              <a:off x="557814" y="6153091"/>
              <a:ext cx="11497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/>
                <a:t>RNA 1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  <a:p>
              <a:pPr algn="r"/>
              <a:r>
                <a:rPr lang="en-US" sz="900" b="1" dirty="0"/>
                <a:t>RNA 2 </a:t>
              </a:r>
              <a:r>
                <a:rPr lang="en-US" sz="900" b="1" dirty="0" err="1"/>
                <a:t>transfectant</a:t>
              </a:r>
              <a:r>
                <a:rPr lang="en-US" sz="900" b="1" dirty="0"/>
                <a:t>:</a:t>
              </a:r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676BA8EB-67D4-4041-8D91-024CB7288ED2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0</a:t>
            </a:r>
          </a:p>
        </p:txBody>
      </p:sp>
    </p:spTree>
    <p:extLst>
      <p:ext uri="{BB962C8B-B14F-4D97-AF65-F5344CB8AC3E}">
        <p14:creationId xmlns:p14="http://schemas.microsoft.com/office/powerpoint/2010/main" val="52324086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6011A623-C6BF-453B-ADF6-4910B20FA2D1}"/>
              </a:ext>
            </a:extLst>
          </p:cNvPr>
          <p:cNvSpPr txBox="1"/>
          <p:nvPr/>
        </p:nvSpPr>
        <p:spPr>
          <a:xfrm>
            <a:off x="2261077" y="1861210"/>
            <a:ext cx="718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/>
              <a:t>wt</a:t>
            </a:r>
            <a:endParaRPr lang="en-US" sz="900" b="1" dirty="0"/>
          </a:p>
          <a:p>
            <a:pPr algn="ctr"/>
            <a:r>
              <a:rPr lang="en-US" sz="900" b="1" dirty="0"/>
              <a:t>U53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6828D9-6CF8-4041-90CA-2AB8189BD507}"/>
              </a:ext>
            </a:extLst>
          </p:cNvPr>
          <p:cNvSpPr txBox="1"/>
          <p:nvPr/>
        </p:nvSpPr>
        <p:spPr>
          <a:xfrm>
            <a:off x="4124383" y="1861210"/>
            <a:ext cx="72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/>
              <a:t>wt</a:t>
            </a:r>
            <a:endParaRPr lang="en-US" sz="900" b="1" dirty="0"/>
          </a:p>
          <a:p>
            <a:pPr algn="ctr"/>
            <a:r>
              <a:rPr lang="en-US" sz="900" b="1" dirty="0"/>
              <a:t>U66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3D888E-70F8-4D89-9066-A959A6D7D514}"/>
              </a:ext>
            </a:extLst>
          </p:cNvPr>
          <p:cNvSpPr txBox="1"/>
          <p:nvPr/>
        </p:nvSpPr>
        <p:spPr>
          <a:xfrm>
            <a:off x="5948361" y="1861210"/>
            <a:ext cx="818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/>
              <a:t>wt</a:t>
            </a:r>
            <a:endParaRPr lang="en-US" sz="900" b="1" dirty="0"/>
          </a:p>
          <a:p>
            <a:pPr algn="ctr"/>
            <a:r>
              <a:rPr lang="en-US" sz="900" b="1" dirty="0"/>
              <a:t>U90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FA7DDA8-FF00-449D-868C-E585492C5294}"/>
              </a:ext>
            </a:extLst>
          </p:cNvPr>
          <p:cNvSpPr txBox="1"/>
          <p:nvPr/>
        </p:nvSpPr>
        <p:spPr>
          <a:xfrm>
            <a:off x="7849065" y="1861210"/>
            <a:ext cx="75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/>
              <a:t>wt</a:t>
            </a:r>
            <a:endParaRPr lang="en-US" sz="900" b="1" dirty="0"/>
          </a:p>
          <a:p>
            <a:pPr algn="ctr"/>
            <a:r>
              <a:rPr lang="en-US" sz="900" b="1" dirty="0"/>
              <a:t>U96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9DE33C-83DE-47CF-9C9C-8ADFBD761BE8}"/>
              </a:ext>
            </a:extLst>
          </p:cNvPr>
          <p:cNvSpPr txBox="1"/>
          <p:nvPr/>
        </p:nvSpPr>
        <p:spPr>
          <a:xfrm>
            <a:off x="9717760" y="1861210"/>
            <a:ext cx="75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/>
              <a:t>wt</a:t>
            </a:r>
            <a:endParaRPr lang="en-US" sz="900" b="1" dirty="0"/>
          </a:p>
          <a:p>
            <a:pPr algn="ctr"/>
            <a:r>
              <a:rPr lang="en-US" sz="900" b="1" dirty="0"/>
              <a:t>U1155</a:t>
            </a:r>
          </a:p>
        </p:txBody>
      </p:sp>
      <p:pic>
        <p:nvPicPr>
          <p:cNvPr id="19" name="Picture 18" descr="A picture containing nature, rain, outdoor&#10;&#10;Description generated with very high confidence">
            <a:extLst>
              <a:ext uri="{FF2B5EF4-FFF2-40B4-BE49-F238E27FC236}">
                <a16:creationId xmlns:a16="http://schemas.microsoft.com/office/drawing/2014/main" id="{970229C9-5880-4538-B034-D5F3A44059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28" t="21766" r="40972" b="25109"/>
          <a:stretch/>
        </p:blipFill>
        <p:spPr>
          <a:xfrm>
            <a:off x="1705950" y="104504"/>
            <a:ext cx="1828800" cy="1828800"/>
          </a:xfrm>
          <a:prstGeom prst="rect">
            <a:avLst/>
          </a:prstGeom>
        </p:spPr>
      </p:pic>
      <p:pic>
        <p:nvPicPr>
          <p:cNvPr id="20" name="Picture 19" descr="A picture containing nature, rain&#10;&#10;Description generated with very high confidence">
            <a:extLst>
              <a:ext uri="{FF2B5EF4-FFF2-40B4-BE49-F238E27FC236}">
                <a16:creationId xmlns:a16="http://schemas.microsoft.com/office/drawing/2014/main" id="{361F0465-B16A-46FC-ACAE-DB6B8EA24B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44" t="6456" r="20556" b="40419"/>
          <a:stretch/>
        </p:blipFill>
        <p:spPr>
          <a:xfrm>
            <a:off x="3574644" y="104504"/>
            <a:ext cx="1828800" cy="1828800"/>
          </a:xfrm>
          <a:prstGeom prst="rect">
            <a:avLst/>
          </a:prstGeom>
        </p:spPr>
      </p:pic>
      <p:pic>
        <p:nvPicPr>
          <p:cNvPr id="21" name="Picture 20" descr="A picture containing nature, rain&#10;&#10;Description generated with very high confidence">
            <a:extLst>
              <a:ext uri="{FF2B5EF4-FFF2-40B4-BE49-F238E27FC236}">
                <a16:creationId xmlns:a16="http://schemas.microsoft.com/office/drawing/2014/main" id="{9EC0BB37-7734-4836-8E86-CD583996A10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72" t="33941" r="31528" b="12934"/>
          <a:stretch/>
        </p:blipFill>
        <p:spPr>
          <a:xfrm>
            <a:off x="5443338" y="104504"/>
            <a:ext cx="1828800" cy="1828800"/>
          </a:xfrm>
          <a:prstGeom prst="rect">
            <a:avLst/>
          </a:prstGeom>
        </p:spPr>
      </p:pic>
      <p:pic>
        <p:nvPicPr>
          <p:cNvPr id="22" name="Picture 21" descr="A picture containing nature, rain, wall&#10;&#10;Description generated with very high confidence">
            <a:extLst>
              <a:ext uri="{FF2B5EF4-FFF2-40B4-BE49-F238E27FC236}">
                <a16:creationId xmlns:a16="http://schemas.microsoft.com/office/drawing/2014/main" id="{C62F4369-03CC-49E5-A4B1-85C7546725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00" t="10145" r="30000" b="36730"/>
          <a:stretch/>
        </p:blipFill>
        <p:spPr>
          <a:xfrm>
            <a:off x="7312032" y="104504"/>
            <a:ext cx="1828800" cy="1828800"/>
          </a:xfrm>
          <a:prstGeom prst="rect">
            <a:avLst/>
          </a:prstGeom>
        </p:spPr>
      </p:pic>
      <p:pic>
        <p:nvPicPr>
          <p:cNvPr id="23" name="Picture 22" descr="A picture containing nature, rain, outdoor&#10;&#10;Description generated with very high confidence">
            <a:extLst>
              <a:ext uri="{FF2B5EF4-FFF2-40B4-BE49-F238E27FC236}">
                <a16:creationId xmlns:a16="http://schemas.microsoft.com/office/drawing/2014/main" id="{BAC6F9A5-1677-46E9-BBD7-0B243A0E4E2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17" t="41872" r="12083" b="5003"/>
          <a:stretch/>
        </p:blipFill>
        <p:spPr>
          <a:xfrm>
            <a:off x="9180727" y="104504"/>
            <a:ext cx="1828800" cy="18288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A8316D0-B117-4587-AFC2-03751A3880B6}"/>
              </a:ext>
            </a:extLst>
          </p:cNvPr>
          <p:cNvSpPr txBox="1"/>
          <p:nvPr/>
        </p:nvSpPr>
        <p:spPr>
          <a:xfrm>
            <a:off x="626066" y="1861210"/>
            <a:ext cx="1149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/>
              <a:t>RNA 1 </a:t>
            </a:r>
            <a:r>
              <a:rPr lang="en-US" sz="900" b="1" dirty="0" err="1"/>
              <a:t>transfectant</a:t>
            </a:r>
            <a:r>
              <a:rPr lang="en-US" sz="900" b="1" dirty="0"/>
              <a:t>:</a:t>
            </a:r>
          </a:p>
          <a:p>
            <a:pPr algn="r"/>
            <a:r>
              <a:rPr lang="en-US" sz="900" b="1" dirty="0"/>
              <a:t>RNA 2 </a:t>
            </a:r>
            <a:r>
              <a:rPr lang="en-US" sz="900" b="1" dirty="0" err="1"/>
              <a:t>transfectant</a:t>
            </a:r>
            <a:r>
              <a:rPr lang="en-US" sz="900" b="1" dirty="0"/>
              <a:t>: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E2B8035-ABC0-4378-A9DF-C28EBC0F7245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0</a:t>
            </a:r>
          </a:p>
        </p:txBody>
      </p:sp>
    </p:spTree>
    <p:extLst>
      <p:ext uri="{BB962C8B-B14F-4D97-AF65-F5344CB8AC3E}">
        <p14:creationId xmlns:p14="http://schemas.microsoft.com/office/powerpoint/2010/main" val="328456955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D8F8F3D2-48E9-400D-A815-9E1C72101E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D50FE2-84DD-4F0B-A997-A1AEB15434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10</a:t>
            </a:r>
            <a:r>
              <a:rPr lang="en-US" dirty="0"/>
              <a:t>. Bright field microscopy of FHV PAR-CL mutants.</a:t>
            </a:r>
          </a:p>
          <a:p>
            <a:pPr marL="0" indent="0">
              <a:buNone/>
            </a:pPr>
            <a:r>
              <a:rPr lang="en-US" dirty="0"/>
              <a:t>After generation of p0 mutant viruses, the p0 cell/virus mix was used to inoculate naïve S2 cells to yield p1 culture. Varied degrees of cytopathic effects (CPE) were observed with different mutants. U159, U1233 gave near </a:t>
            </a:r>
            <a:r>
              <a:rPr lang="en-US" dirty="0" err="1"/>
              <a:t>wt</a:t>
            </a:r>
            <a:r>
              <a:rPr lang="en-US" dirty="0"/>
              <a:t> appearance, indicating little to none virulence in these mutants. The rest mutants showed variable but inferior cytotoxic effect than wild type transfection.</a:t>
            </a:r>
          </a:p>
        </p:txBody>
      </p:sp>
    </p:spTree>
    <p:extLst>
      <p:ext uri="{BB962C8B-B14F-4D97-AF65-F5344CB8AC3E}">
        <p14:creationId xmlns:p14="http://schemas.microsoft.com/office/powerpoint/2010/main" val="61304053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DEBE35B9-DFD6-43A6-8E9D-EB4A6A54FA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4777733"/>
              </p:ext>
            </p:extLst>
          </p:nvPr>
        </p:nvGraphicFramePr>
        <p:xfrm>
          <a:off x="1976599" y="2278067"/>
          <a:ext cx="8229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E307A54-6556-4E9D-ADA7-A66EFD3779D8}"/>
              </a:ext>
            </a:extLst>
          </p:cNvPr>
          <p:cNvSpPr txBox="1"/>
          <p:nvPr/>
        </p:nvSpPr>
        <p:spPr>
          <a:xfrm>
            <a:off x="1773406" y="3799090"/>
            <a:ext cx="958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RNA 1 </a:t>
            </a:r>
            <a:r>
              <a:rPr lang="en-US" sz="700" b="1" dirty="0" err="1"/>
              <a:t>transfectant</a:t>
            </a:r>
            <a:endParaRPr lang="en-US" sz="700" b="1" dirty="0"/>
          </a:p>
          <a:p>
            <a:r>
              <a:rPr lang="en-US" sz="700" b="1" dirty="0"/>
              <a:t>RNA 2 </a:t>
            </a:r>
            <a:r>
              <a:rPr lang="en-US" sz="700" b="1" dirty="0" err="1"/>
              <a:t>transfectant</a:t>
            </a:r>
            <a:endParaRPr lang="en-US" sz="7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F2CBAD-C85E-4871-B156-BCF8D9956FF1}"/>
              </a:ext>
            </a:extLst>
          </p:cNvPr>
          <p:cNvSpPr txBox="1"/>
          <p:nvPr/>
        </p:nvSpPr>
        <p:spPr>
          <a:xfrm>
            <a:off x="9638522" y="6488668"/>
            <a:ext cx="2553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1</a:t>
            </a:r>
          </a:p>
        </p:txBody>
      </p:sp>
    </p:spTree>
    <p:extLst>
      <p:ext uri="{BB962C8B-B14F-4D97-AF65-F5344CB8AC3E}">
        <p14:creationId xmlns:p14="http://schemas.microsoft.com/office/powerpoint/2010/main" val="359447160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96E1D008-F5C0-401C-B0D2-518F04049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383FC2-8889-452E-9012-3AE3F46FAF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11</a:t>
            </a:r>
            <a:r>
              <a:rPr lang="en-US" dirty="0"/>
              <a:t>. P1 PAR-CL mutants and relative virulence.</a:t>
            </a:r>
          </a:p>
          <a:p>
            <a:pPr marL="0" indent="0">
              <a:buNone/>
            </a:pPr>
            <a:r>
              <a:rPr lang="en-US" dirty="0"/>
              <a:t>Purified p1 PAR-CL mutants were serial diluted and 0.12 ng of each mutant virus (approximately equivalent to MOI = 1) was used to infect naïve S2 cells (25k). </a:t>
            </a:r>
            <a:r>
              <a:rPr lang="en-US" dirty="0" err="1"/>
              <a:t>AlamarBlue</a:t>
            </a:r>
            <a:r>
              <a:rPr lang="en-US" dirty="0"/>
              <a:t> assay was conducted 24 h post infection. For negative control and mutants U157, U1233 with undetectable virus production, equal amount of cellular proteins from virus samples was used as guide. </a:t>
            </a:r>
          </a:p>
        </p:txBody>
      </p:sp>
    </p:spTree>
    <p:extLst>
      <p:ext uri="{BB962C8B-B14F-4D97-AF65-F5344CB8AC3E}">
        <p14:creationId xmlns:p14="http://schemas.microsoft.com/office/powerpoint/2010/main" val="40415737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9D13552-784C-4BE2-8154-B459C15164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013957"/>
              </p:ext>
            </p:extLst>
          </p:nvPr>
        </p:nvGraphicFramePr>
        <p:xfrm>
          <a:off x="2377875" y="505839"/>
          <a:ext cx="7436250" cy="1200264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487250">
                  <a:extLst>
                    <a:ext uri="{9D8B030D-6E8A-4147-A177-3AD203B41FA5}">
                      <a16:colId xmlns:a16="http://schemas.microsoft.com/office/drawing/2014/main" val="2881622437"/>
                    </a:ext>
                  </a:extLst>
                </a:gridCol>
                <a:gridCol w="1487250">
                  <a:extLst>
                    <a:ext uri="{9D8B030D-6E8A-4147-A177-3AD203B41FA5}">
                      <a16:colId xmlns:a16="http://schemas.microsoft.com/office/drawing/2014/main" val="4062799746"/>
                    </a:ext>
                  </a:extLst>
                </a:gridCol>
                <a:gridCol w="1487250">
                  <a:extLst>
                    <a:ext uri="{9D8B030D-6E8A-4147-A177-3AD203B41FA5}">
                      <a16:colId xmlns:a16="http://schemas.microsoft.com/office/drawing/2014/main" val="1669181074"/>
                    </a:ext>
                  </a:extLst>
                </a:gridCol>
                <a:gridCol w="1487250">
                  <a:extLst>
                    <a:ext uri="{9D8B030D-6E8A-4147-A177-3AD203B41FA5}">
                      <a16:colId xmlns:a16="http://schemas.microsoft.com/office/drawing/2014/main" val="3571108042"/>
                    </a:ext>
                  </a:extLst>
                </a:gridCol>
                <a:gridCol w="1487250">
                  <a:extLst>
                    <a:ext uri="{9D8B030D-6E8A-4147-A177-3AD203B41FA5}">
                      <a16:colId xmlns:a16="http://schemas.microsoft.com/office/drawing/2014/main" val="4194168900"/>
                    </a:ext>
                  </a:extLst>
                </a:gridCol>
              </a:tblGrid>
              <a:tr h="300066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riming 4SU </a:t>
                      </a:r>
                      <a:r>
                        <a:rPr lang="en-US" sz="1400" dirty="0" err="1"/>
                        <a:t>cct</a:t>
                      </a:r>
                      <a:r>
                        <a:rPr lang="en-US" sz="1400" dirty="0"/>
                        <a:t>.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Boosting 4SU </a:t>
                      </a:r>
                      <a:r>
                        <a:rPr lang="en-US" sz="1400" dirty="0" err="1"/>
                        <a:t>cct</a:t>
                      </a:r>
                      <a:r>
                        <a:rPr lang="en-US" sz="1400" dirty="0"/>
                        <a:t>.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Final </a:t>
                      </a:r>
                      <a:r>
                        <a:rPr lang="en-US" sz="1400" dirty="0" err="1"/>
                        <a:t>cct</a:t>
                      </a:r>
                      <a:r>
                        <a:rPr lang="en-US" sz="1400" dirty="0"/>
                        <a:t>.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Incubation time</a:t>
                      </a:r>
                    </a:p>
                  </a:txBody>
                  <a:tcPr marL="73989" marR="73989" marT="36995" marB="36995"/>
                </a:tc>
                <a:extLst>
                  <a:ext uri="{0D108BD9-81ED-4DB2-BD59-A6C34878D82A}">
                    <a16:rowId xmlns:a16="http://schemas.microsoft.com/office/drawing/2014/main" val="2143526309"/>
                  </a:ext>
                </a:extLst>
              </a:tr>
              <a:tr h="300066">
                <a:tc>
                  <a:txBody>
                    <a:bodyPr/>
                    <a:lstStyle/>
                    <a:p>
                      <a:r>
                        <a:rPr lang="en-US" sz="1400" dirty="0"/>
                        <a:t>4SU16h</a:t>
                      </a:r>
                      <a:endParaRPr lang="en-US" sz="1400" b="1" dirty="0"/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-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6hr</a:t>
                      </a:r>
                    </a:p>
                  </a:txBody>
                  <a:tcPr marL="73989" marR="73989" marT="36995" marB="36995"/>
                </a:tc>
                <a:extLst>
                  <a:ext uri="{0D108BD9-81ED-4DB2-BD59-A6C34878D82A}">
                    <a16:rowId xmlns:a16="http://schemas.microsoft.com/office/drawing/2014/main" val="4005184716"/>
                  </a:ext>
                </a:extLst>
              </a:tr>
              <a:tr h="300066">
                <a:tc>
                  <a:txBody>
                    <a:bodyPr/>
                    <a:lstStyle/>
                    <a:p>
                      <a:r>
                        <a:rPr lang="en-US" sz="1400" dirty="0"/>
                        <a:t>4SU1.5X</a:t>
                      </a:r>
                      <a:endParaRPr lang="en-US" sz="1400" b="1" dirty="0"/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5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-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5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6hr</a:t>
                      </a:r>
                    </a:p>
                  </a:txBody>
                  <a:tcPr marL="73989" marR="73989" marT="36995" marB="36995"/>
                </a:tc>
                <a:extLst>
                  <a:ext uri="{0D108BD9-81ED-4DB2-BD59-A6C34878D82A}">
                    <a16:rowId xmlns:a16="http://schemas.microsoft.com/office/drawing/2014/main" val="2538586984"/>
                  </a:ext>
                </a:extLst>
              </a:tr>
              <a:tr h="300066">
                <a:tc>
                  <a:txBody>
                    <a:bodyPr/>
                    <a:lstStyle/>
                    <a:p>
                      <a:r>
                        <a:rPr lang="en-US" sz="1400" dirty="0"/>
                        <a:t>4SU40h</a:t>
                      </a:r>
                      <a:endParaRPr lang="en-US" sz="1400" b="1" dirty="0"/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0uM (@16hpi)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200uM</a:t>
                      </a:r>
                    </a:p>
                  </a:txBody>
                  <a:tcPr marL="73989" marR="73989" marT="36995" marB="36995"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40hr</a:t>
                      </a:r>
                    </a:p>
                  </a:txBody>
                  <a:tcPr marL="73989" marR="73989" marT="36995" marB="36995"/>
                </a:tc>
                <a:extLst>
                  <a:ext uri="{0D108BD9-81ED-4DB2-BD59-A6C34878D82A}">
                    <a16:rowId xmlns:a16="http://schemas.microsoft.com/office/drawing/2014/main" val="59454318"/>
                  </a:ext>
                </a:extLst>
              </a:tr>
            </a:tbl>
          </a:graphicData>
        </a:graphic>
      </p:graphicFrame>
      <p:grpSp>
        <p:nvGrpSpPr>
          <p:cNvPr id="11" name="Group 10">
            <a:extLst>
              <a:ext uri="{FF2B5EF4-FFF2-40B4-BE49-F238E27FC236}">
                <a16:creationId xmlns:a16="http://schemas.microsoft.com/office/drawing/2014/main" id="{3303A3CC-5E1B-4F2F-87BE-563688BAFC45}"/>
              </a:ext>
            </a:extLst>
          </p:cNvPr>
          <p:cNvGrpSpPr/>
          <p:nvPr/>
        </p:nvGrpSpPr>
        <p:grpSpPr>
          <a:xfrm>
            <a:off x="3335186" y="1790045"/>
            <a:ext cx="5521629" cy="3755664"/>
            <a:chOff x="3276007" y="1790045"/>
            <a:chExt cx="5521629" cy="3755664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848192E6-1064-4B19-AC41-D48BEDA12E7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18641676"/>
                </p:ext>
              </p:extLst>
            </p:nvPr>
          </p:nvGraphicFramePr>
          <p:xfrm>
            <a:off x="4092247" y="1790045"/>
            <a:ext cx="4572000" cy="12801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8DD888D3-BEA8-45E5-8C70-419395A16D5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63502316"/>
                </p:ext>
              </p:extLst>
            </p:nvPr>
          </p:nvGraphicFramePr>
          <p:xfrm>
            <a:off x="4092247" y="2984579"/>
            <a:ext cx="4572000" cy="12801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26729978-2808-4973-B864-80EF132D4BC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87081183"/>
                </p:ext>
              </p:extLst>
            </p:nvPr>
          </p:nvGraphicFramePr>
          <p:xfrm>
            <a:off x="4225636" y="4174109"/>
            <a:ext cx="4572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21913FC-836D-418C-8E69-6C43B73A3B0C}"/>
                </a:ext>
              </a:extLst>
            </p:cNvPr>
            <p:cNvSpPr txBox="1"/>
            <p:nvPr/>
          </p:nvSpPr>
          <p:spPr>
            <a:xfrm>
              <a:off x="3276007" y="2231138"/>
              <a:ext cx="1050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SU16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4C5410A-5D4E-4244-A2EA-52C8132B5C48}"/>
                </a:ext>
              </a:extLst>
            </p:cNvPr>
            <p:cNvSpPr txBox="1"/>
            <p:nvPr/>
          </p:nvSpPr>
          <p:spPr>
            <a:xfrm>
              <a:off x="3276008" y="3429000"/>
              <a:ext cx="1050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SU1.5X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731A605-6FCD-41F8-9376-3E84B9B37B1E}"/>
                </a:ext>
              </a:extLst>
            </p:cNvPr>
            <p:cNvSpPr txBox="1"/>
            <p:nvPr/>
          </p:nvSpPr>
          <p:spPr>
            <a:xfrm>
              <a:off x="3276008" y="4535892"/>
              <a:ext cx="1050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SU40h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B86EBF27-ED97-497E-B440-36D214C60C9B}"/>
              </a:ext>
            </a:extLst>
          </p:cNvPr>
          <p:cNvSpPr txBox="1"/>
          <p:nvPr/>
        </p:nvSpPr>
        <p:spPr>
          <a:xfrm>
            <a:off x="9563878" y="6488668"/>
            <a:ext cx="2628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2</a:t>
            </a:r>
          </a:p>
        </p:txBody>
      </p:sp>
    </p:spTree>
    <p:extLst>
      <p:ext uri="{BB962C8B-B14F-4D97-AF65-F5344CB8AC3E}">
        <p14:creationId xmlns:p14="http://schemas.microsoft.com/office/powerpoint/2010/main" val="146195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6A4C23-23BD-4B81-958E-8E950107B2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268B53-B292-4BF5-985B-EC525AD128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2</a:t>
            </a:r>
            <a:r>
              <a:rPr lang="en-US" dirty="0"/>
              <a:t>. PAR-CL signal intensities were correlated with 4SU dose and incubation time.</a:t>
            </a:r>
          </a:p>
          <a:p>
            <a:pPr marL="0" indent="0">
              <a:buNone/>
            </a:pPr>
            <a:r>
              <a:rPr lang="en-US" dirty="0"/>
              <a:t>Similar to RNA 1, in RNA 2, we also noticed the intensity of PAR-CL signals correlated to the dose of 4SU and time of incubation, with 4SU40h gave the best result.</a:t>
            </a:r>
          </a:p>
        </p:txBody>
      </p:sp>
    </p:spTree>
    <p:extLst>
      <p:ext uri="{BB962C8B-B14F-4D97-AF65-F5344CB8AC3E}">
        <p14:creationId xmlns:p14="http://schemas.microsoft.com/office/powerpoint/2010/main" val="219370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44C346A-6091-43CC-8D14-91A4204591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1695996"/>
              </p:ext>
            </p:extLst>
          </p:nvPr>
        </p:nvGraphicFramePr>
        <p:xfrm>
          <a:off x="3312319" y="2062162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8574D40-033E-4011-8458-6547C445F6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6138934"/>
              </p:ext>
            </p:extLst>
          </p:nvPr>
        </p:nvGraphicFramePr>
        <p:xfrm>
          <a:off x="6136481" y="2052637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7CEA57D-72AB-47D4-A65C-949A312CB125}"/>
              </a:ext>
            </a:extLst>
          </p:cNvPr>
          <p:cNvSpPr txBox="1"/>
          <p:nvPr/>
        </p:nvSpPr>
        <p:spPr>
          <a:xfrm>
            <a:off x="9685176" y="6488668"/>
            <a:ext cx="2506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altLang="zh-CN" dirty="0"/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24131833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D4D02-D77A-41EE-84FB-A4C112CEC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5E6AAF-442F-4187-B08C-8B895AAC91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3</a:t>
            </a:r>
            <a:r>
              <a:rPr lang="en-US" dirty="0"/>
              <a:t>. Good correlation coefficient of PAR-CL signals under different experimental conditions.  </a:t>
            </a:r>
          </a:p>
          <a:p>
            <a:pPr marL="0" indent="0">
              <a:buNone/>
            </a:pPr>
            <a:r>
              <a:rPr lang="en-US" dirty="0"/>
              <a:t>Despite varied signal intensities, we observed good (≥0.6) Pearson’s correlation coefficient between 4SU40h, 4SU1.5X, and 4SU16h experiments, indicating reproducibility of PAR-CL experiments. </a:t>
            </a:r>
          </a:p>
        </p:txBody>
      </p:sp>
    </p:spTree>
    <p:extLst>
      <p:ext uri="{BB962C8B-B14F-4D97-AF65-F5344CB8AC3E}">
        <p14:creationId xmlns:p14="http://schemas.microsoft.com/office/powerpoint/2010/main" val="8722750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EE7C69E-61F8-45C0-99A1-B5B5DAED34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3960301"/>
              </p:ext>
            </p:extLst>
          </p:nvPr>
        </p:nvGraphicFramePr>
        <p:xfrm>
          <a:off x="3432593" y="1990552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FDF445A6-303B-4D8D-ACA2-8AC5DC8313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7527461"/>
              </p:ext>
            </p:extLst>
          </p:nvPr>
        </p:nvGraphicFramePr>
        <p:xfrm>
          <a:off x="6175793" y="1990552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EA68C3A-B67E-49E4-BC4D-A5A3071A0493}"/>
              </a:ext>
            </a:extLst>
          </p:cNvPr>
          <p:cNvSpPr txBox="1"/>
          <p:nvPr/>
        </p:nvSpPr>
        <p:spPr>
          <a:xfrm>
            <a:off x="9685176" y="6488668"/>
            <a:ext cx="2506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4</a:t>
            </a:r>
          </a:p>
        </p:txBody>
      </p:sp>
    </p:spTree>
    <p:extLst>
      <p:ext uri="{BB962C8B-B14F-4D97-AF65-F5344CB8AC3E}">
        <p14:creationId xmlns:p14="http://schemas.microsoft.com/office/powerpoint/2010/main" val="36530297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B70ED-59E0-45BE-9215-7940F1760C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34FA27-547F-46E8-AEFC-563839854F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Supplemental Figure S4</a:t>
            </a:r>
            <a:r>
              <a:rPr lang="en-US" dirty="0"/>
              <a:t>. Good correlation coefficient of PAR-CL signals under FHV PAR-CL triplicate. </a:t>
            </a:r>
          </a:p>
          <a:p>
            <a:pPr marL="0" indent="0">
              <a:buNone/>
            </a:pPr>
            <a:r>
              <a:rPr lang="en-US" dirty="0"/>
              <a:t>Despite varied signal intensities, we observed good (≥0.6) Pearson’s correlation coefficient between FHV PAR-CL triplicate, under 4SU40h condition. This indicates reproducibility of PAR-CL experiments. </a:t>
            </a:r>
          </a:p>
        </p:txBody>
      </p:sp>
    </p:spTree>
    <p:extLst>
      <p:ext uri="{BB962C8B-B14F-4D97-AF65-F5344CB8AC3E}">
        <p14:creationId xmlns:p14="http://schemas.microsoft.com/office/powerpoint/2010/main" val="41213708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people&#10;&#10;Description generated with high confidence">
            <a:extLst>
              <a:ext uri="{FF2B5EF4-FFF2-40B4-BE49-F238E27FC236}">
                <a16:creationId xmlns:a16="http://schemas.microsoft.com/office/drawing/2014/main" id="{71D714B8-43B3-49A8-8C5F-90A331F1CA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0200"/>
            <a:ext cx="12192000" cy="3657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7FC088B-D1BD-4881-959D-285F29D06AF2}"/>
              </a:ext>
            </a:extLst>
          </p:cNvPr>
          <p:cNvSpPr txBox="1"/>
          <p:nvPr/>
        </p:nvSpPr>
        <p:spPr>
          <a:xfrm>
            <a:off x="9870375" y="6488668"/>
            <a:ext cx="2460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1C0BA9-FE9F-47AE-A55D-B71D438F54CA}"/>
              </a:ext>
            </a:extLst>
          </p:cNvPr>
          <p:cNvSpPr txBox="1"/>
          <p:nvPr/>
        </p:nvSpPr>
        <p:spPr>
          <a:xfrm>
            <a:off x="6096000" y="6041273"/>
            <a:ext cx="576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177480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0</TotalTime>
  <Words>1060</Words>
  <Application>Microsoft Office PowerPoint</Application>
  <PresentationFormat>Widescreen</PresentationFormat>
  <Paragraphs>244</Paragraphs>
  <Slides>2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4" baseType="lpstr">
      <vt:lpstr>Arial</vt:lpstr>
      <vt:lpstr>Calibri</vt:lpstr>
      <vt:lpstr>Calibri Light</vt:lpstr>
      <vt:lpstr>Consolas</vt:lpstr>
      <vt:lpstr>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my Zhou</dc:creator>
  <cp:lastModifiedBy>Tommy Zhou</cp:lastModifiedBy>
  <cp:revision>55</cp:revision>
  <dcterms:created xsi:type="dcterms:W3CDTF">2019-03-11T02:39:53Z</dcterms:created>
  <dcterms:modified xsi:type="dcterms:W3CDTF">2019-07-15T20:14:56Z</dcterms:modified>
</cp:coreProperties>
</file>